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8" r:id="rId2"/>
    <p:sldId id="277" r:id="rId3"/>
    <p:sldId id="294" r:id="rId4"/>
    <p:sldId id="291" r:id="rId5"/>
    <p:sldId id="295" r:id="rId6"/>
    <p:sldId id="267" r:id="rId7"/>
    <p:sldId id="280" r:id="rId8"/>
    <p:sldId id="292" r:id="rId9"/>
    <p:sldId id="290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rang, Sonali" initials="NS" lastIdx="14" clrIdx="0">
    <p:extLst>
      <p:ext uri="{19B8F6BF-5375-455C-9EA6-DF929625EA0E}">
        <p15:presenceInfo xmlns:p15="http://schemas.microsoft.com/office/powerpoint/2012/main" userId="S::sonali.narang@nyulangone.org::9e80b397-6e2f-49b1-9374-ccdad858914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10503"/>
    <a:srgbClr val="181C9A"/>
    <a:srgbClr val="242BE2"/>
    <a:srgbClr val="F5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80"/>
    <p:restoredTop sz="61001"/>
  </p:normalViewPr>
  <p:slideViewPr>
    <p:cSldViewPr snapToGrid="0" snapToObjects="1">
      <p:cViewPr>
        <p:scale>
          <a:sx n="122" d="100"/>
          <a:sy n="122" d="100"/>
        </p:scale>
        <p:origin x="3704" y="152"/>
      </p:cViewPr>
      <p:guideLst/>
    </p:cSldViewPr>
  </p:slideViewPr>
  <p:notesTextViewPr>
    <p:cViewPr>
      <p:scale>
        <a:sx n="155" d="100"/>
        <a:sy n="15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rang, Sonali" userId="9e80b397-6e2f-49b1-9374-ccdad8589140" providerId="ADAL" clId="{0B7BE2FF-CA73-044A-832B-45D8C814BD66}"/>
    <pc:docChg chg="undo redo custSel addSld delSld modSld sldOrd">
      <pc:chgData name="Narang, Sonali" userId="9e80b397-6e2f-49b1-9374-ccdad8589140" providerId="ADAL" clId="{0B7BE2FF-CA73-044A-832B-45D8C814BD66}" dt="2021-05-27T14:02:27.447" v="1935" actId="1076"/>
      <pc:docMkLst>
        <pc:docMk/>
      </pc:docMkLst>
      <pc:sldChg chg="addSp delSp modSp mod modNotesTx">
        <pc:chgData name="Narang, Sonali" userId="9e80b397-6e2f-49b1-9374-ccdad8589140" providerId="ADAL" clId="{0B7BE2FF-CA73-044A-832B-45D8C814BD66}" dt="2021-05-27T12:13:07.855" v="1916" actId="1076"/>
        <pc:sldMkLst>
          <pc:docMk/>
          <pc:sldMk cId="3911031167" sldId="256"/>
        </pc:sldMkLst>
        <pc:spChg chg="mod">
          <ac:chgData name="Narang, Sonali" userId="9e80b397-6e2f-49b1-9374-ccdad8589140" providerId="ADAL" clId="{0B7BE2FF-CA73-044A-832B-45D8C814BD66}" dt="2021-04-28T19:33:53.124" v="184" actId="1076"/>
          <ac:spMkLst>
            <pc:docMk/>
            <pc:sldMk cId="3911031167" sldId="256"/>
            <ac:spMk id="5" creationId="{FAFFEC37-A0C5-5846-8534-22E3DEF6CEF4}"/>
          </ac:spMkLst>
        </pc:spChg>
        <pc:spChg chg="mod">
          <ac:chgData name="Narang, Sonali" userId="9e80b397-6e2f-49b1-9374-ccdad8589140" providerId="ADAL" clId="{0B7BE2FF-CA73-044A-832B-45D8C814BD66}" dt="2021-05-27T12:13:06.247" v="1913" actId="1076"/>
          <ac:spMkLst>
            <pc:docMk/>
            <pc:sldMk cId="3911031167" sldId="256"/>
            <ac:spMk id="6" creationId="{41464C80-B659-484D-A16F-8018DEC5471A}"/>
          </ac:spMkLst>
        </pc:spChg>
        <pc:spChg chg="mod">
          <ac:chgData name="Narang, Sonali" userId="9e80b397-6e2f-49b1-9374-ccdad8589140" providerId="ADAL" clId="{0B7BE2FF-CA73-044A-832B-45D8C814BD66}" dt="2021-04-28T19:29:46.737" v="147" actId="1076"/>
          <ac:spMkLst>
            <pc:docMk/>
            <pc:sldMk cId="3911031167" sldId="256"/>
            <ac:spMk id="7" creationId="{4C5F5CAE-FBFD-964D-A356-746AAC86DC9E}"/>
          </ac:spMkLst>
        </pc:spChg>
        <pc:spChg chg="mod">
          <ac:chgData name="Narang, Sonali" userId="9e80b397-6e2f-49b1-9374-ccdad8589140" providerId="ADAL" clId="{0B7BE2FF-CA73-044A-832B-45D8C814BD66}" dt="2021-04-29T18:29:07.421" v="483" actId="1035"/>
          <ac:spMkLst>
            <pc:docMk/>
            <pc:sldMk cId="3911031167" sldId="256"/>
            <ac:spMk id="8" creationId="{8A9BAE78-C4FF-1843-94F6-3410EB884848}"/>
          </ac:spMkLst>
        </pc:spChg>
        <pc:spChg chg="del">
          <ac:chgData name="Narang, Sonali" userId="9e80b397-6e2f-49b1-9374-ccdad8589140" providerId="ADAL" clId="{0B7BE2FF-CA73-044A-832B-45D8C814BD66}" dt="2021-04-28T18:58:39.605" v="101" actId="478"/>
          <ac:spMkLst>
            <pc:docMk/>
            <pc:sldMk cId="3911031167" sldId="256"/>
            <ac:spMk id="16" creationId="{DA95FD96-8ABC-1E42-A60A-75AED4B0EA42}"/>
          </ac:spMkLst>
        </pc:spChg>
        <pc:spChg chg="del">
          <ac:chgData name="Narang, Sonali" userId="9e80b397-6e2f-49b1-9374-ccdad8589140" providerId="ADAL" clId="{0B7BE2FF-CA73-044A-832B-45D8C814BD66}" dt="2021-04-28T18:58:39.605" v="101" actId="478"/>
          <ac:spMkLst>
            <pc:docMk/>
            <pc:sldMk cId="3911031167" sldId="256"/>
            <ac:spMk id="18" creationId="{0DEFC6C6-9924-C44D-9E03-76EBD843D638}"/>
          </ac:spMkLst>
        </pc:spChg>
        <pc:spChg chg="del">
          <ac:chgData name="Narang, Sonali" userId="9e80b397-6e2f-49b1-9374-ccdad8589140" providerId="ADAL" clId="{0B7BE2FF-CA73-044A-832B-45D8C814BD66}" dt="2021-04-28T18:58:39.605" v="101" actId="478"/>
          <ac:spMkLst>
            <pc:docMk/>
            <pc:sldMk cId="3911031167" sldId="256"/>
            <ac:spMk id="19" creationId="{9FDBA7ED-E24E-5545-AFE8-1EEFBD16C032}"/>
          </ac:spMkLst>
        </pc:spChg>
        <pc:spChg chg="del">
          <ac:chgData name="Narang, Sonali" userId="9e80b397-6e2f-49b1-9374-ccdad8589140" providerId="ADAL" clId="{0B7BE2FF-CA73-044A-832B-45D8C814BD66}" dt="2021-04-28T18:58:39.605" v="101" actId="478"/>
          <ac:spMkLst>
            <pc:docMk/>
            <pc:sldMk cId="3911031167" sldId="256"/>
            <ac:spMk id="20" creationId="{8F466FB0-0B05-CE44-9E17-49921E2C2C6D}"/>
          </ac:spMkLst>
        </pc:spChg>
        <pc:spChg chg="mod">
          <ac:chgData name="Narang, Sonali" userId="9e80b397-6e2f-49b1-9374-ccdad8589140" providerId="ADAL" clId="{0B7BE2FF-CA73-044A-832B-45D8C814BD66}" dt="2021-04-29T18:29:07.421" v="483" actId="1035"/>
          <ac:spMkLst>
            <pc:docMk/>
            <pc:sldMk cId="3911031167" sldId="256"/>
            <ac:spMk id="32" creationId="{2863401C-2050-2E40-AE5C-C6CDD3A8A7D4}"/>
          </ac:spMkLst>
        </pc:spChg>
        <pc:spChg chg="mod">
          <ac:chgData name="Narang, Sonali" userId="9e80b397-6e2f-49b1-9374-ccdad8589140" providerId="ADAL" clId="{0B7BE2FF-CA73-044A-832B-45D8C814BD66}" dt="2021-04-28T23:58:52.785" v="458" actId="255"/>
          <ac:spMkLst>
            <pc:docMk/>
            <pc:sldMk cId="3911031167" sldId="256"/>
            <ac:spMk id="34" creationId="{6D8F17D5-0D48-D240-A514-46DF3B792DB3}"/>
          </ac:spMkLst>
        </pc:spChg>
        <pc:spChg chg="mod">
          <ac:chgData name="Narang, Sonali" userId="9e80b397-6e2f-49b1-9374-ccdad8589140" providerId="ADAL" clId="{0B7BE2FF-CA73-044A-832B-45D8C814BD66}" dt="2021-04-28T23:58:52.785" v="458" actId="255"/>
          <ac:spMkLst>
            <pc:docMk/>
            <pc:sldMk cId="3911031167" sldId="256"/>
            <ac:spMk id="35" creationId="{8E47D5FA-094C-AB4F-997F-C3C0BB4C2B2E}"/>
          </ac:spMkLst>
        </pc:spChg>
        <pc:spChg chg="mod">
          <ac:chgData name="Narang, Sonali" userId="9e80b397-6e2f-49b1-9374-ccdad8589140" providerId="ADAL" clId="{0B7BE2FF-CA73-044A-832B-45D8C814BD66}" dt="2021-04-29T18:29:17.010" v="496" actId="1035"/>
          <ac:spMkLst>
            <pc:docMk/>
            <pc:sldMk cId="3911031167" sldId="256"/>
            <ac:spMk id="36" creationId="{75B14C61-810F-134B-AC0D-0C1FD0CAB17A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1" creationId="{81F9C129-8682-2D4D-9503-C1DA7A961842}"/>
          </ac:spMkLst>
        </pc:spChg>
        <pc:spChg chg="mod topLvl">
          <ac:chgData name="Narang, Sonali" userId="9e80b397-6e2f-49b1-9374-ccdad8589140" providerId="ADAL" clId="{0B7BE2FF-CA73-044A-832B-45D8C814BD66}" dt="2021-04-28T21:54:52.843" v="280" actId="1036"/>
          <ac:spMkLst>
            <pc:docMk/>
            <pc:sldMk cId="3911031167" sldId="256"/>
            <ac:spMk id="42" creationId="{A774F168-515F-0F4B-A943-698B1719F653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4" creationId="{D5777EB2-CECE-7D48-B9F4-106AAEB54B7B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5" creationId="{844B0FBA-5BB1-C044-A53E-DEE5BFCBAADB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6" creationId="{F98FFBA7-E12A-3040-AC8E-7625F182C40A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7" creationId="{53B008C1-F956-2340-A15C-E74041DC90FF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8" creationId="{C192B359-DC58-7947-AD33-500A261F3F6B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49" creationId="{84C5A9BE-01AD-1946-BF6C-D96E4498D23A}"/>
          </ac:spMkLst>
        </pc:spChg>
        <pc:spChg chg="del mod">
          <ac:chgData name="Narang, Sonali" userId="9e80b397-6e2f-49b1-9374-ccdad8589140" providerId="ADAL" clId="{0B7BE2FF-CA73-044A-832B-45D8C814BD66}" dt="2021-04-28T22:12:30.156" v="384" actId="478"/>
          <ac:spMkLst>
            <pc:docMk/>
            <pc:sldMk cId="3911031167" sldId="256"/>
            <ac:spMk id="50" creationId="{5DC11782-057B-8846-AAA5-0EB64A5E1A34}"/>
          </ac:spMkLst>
        </pc:spChg>
        <pc:spChg chg="del mod">
          <ac:chgData name="Narang, Sonali" userId="9e80b397-6e2f-49b1-9374-ccdad8589140" providerId="ADAL" clId="{0B7BE2FF-CA73-044A-832B-45D8C814BD66}" dt="2021-04-28T22:12:36.887" v="387" actId="478"/>
          <ac:spMkLst>
            <pc:docMk/>
            <pc:sldMk cId="3911031167" sldId="256"/>
            <ac:spMk id="51" creationId="{80AC904A-F7AD-0249-B6EE-00B6D65E5EF4}"/>
          </ac:spMkLst>
        </pc:spChg>
        <pc:spChg chg="del mod topLvl">
          <ac:chgData name="Narang, Sonali" userId="9e80b397-6e2f-49b1-9374-ccdad8589140" providerId="ADAL" clId="{0B7BE2FF-CA73-044A-832B-45D8C814BD66}" dt="2021-04-28T22:16:19.693" v="405" actId="478"/>
          <ac:spMkLst>
            <pc:docMk/>
            <pc:sldMk cId="3911031167" sldId="256"/>
            <ac:spMk id="52" creationId="{CDD408D4-0BA1-2949-9A5A-1C037CF6C550}"/>
          </ac:spMkLst>
        </pc:spChg>
        <pc:spChg chg="del mod topLvl">
          <ac:chgData name="Narang, Sonali" userId="9e80b397-6e2f-49b1-9374-ccdad8589140" providerId="ADAL" clId="{0B7BE2FF-CA73-044A-832B-45D8C814BD66}" dt="2021-04-28T22:16:19.693" v="405" actId="478"/>
          <ac:spMkLst>
            <pc:docMk/>
            <pc:sldMk cId="3911031167" sldId="256"/>
            <ac:spMk id="53" creationId="{631FC2D7-D6F4-F24A-8FD6-87B7B818FAA7}"/>
          </ac:spMkLst>
        </pc:spChg>
        <pc:spChg chg="del mod">
          <ac:chgData name="Narang, Sonali" userId="9e80b397-6e2f-49b1-9374-ccdad8589140" providerId="ADAL" clId="{0B7BE2FF-CA73-044A-832B-45D8C814BD66}" dt="2021-04-28T22:12:36.887" v="387" actId="478"/>
          <ac:spMkLst>
            <pc:docMk/>
            <pc:sldMk cId="3911031167" sldId="256"/>
            <ac:spMk id="54" creationId="{F6D11232-9E1D-7940-8158-71054C3040C9}"/>
          </ac:spMkLst>
        </pc:spChg>
        <pc:spChg chg="del mod">
          <ac:chgData name="Narang, Sonali" userId="9e80b397-6e2f-49b1-9374-ccdad8589140" providerId="ADAL" clId="{0B7BE2FF-CA73-044A-832B-45D8C814BD66}" dt="2021-04-28T22:12:36.887" v="387" actId="478"/>
          <ac:spMkLst>
            <pc:docMk/>
            <pc:sldMk cId="3911031167" sldId="256"/>
            <ac:spMk id="55" creationId="{79FF6AAE-D62C-6149-9A74-5726F1F408C5}"/>
          </ac:spMkLst>
        </pc:spChg>
        <pc:spChg chg="del mod">
          <ac:chgData name="Narang, Sonali" userId="9e80b397-6e2f-49b1-9374-ccdad8589140" providerId="ADAL" clId="{0B7BE2FF-CA73-044A-832B-45D8C814BD66}" dt="2021-04-28T22:12:36.887" v="387" actId="478"/>
          <ac:spMkLst>
            <pc:docMk/>
            <pc:sldMk cId="3911031167" sldId="256"/>
            <ac:spMk id="56" creationId="{FD07D260-D1D4-2F49-9B04-9AD08525CB02}"/>
          </ac:spMkLst>
        </pc:spChg>
        <pc:spChg chg="del mod">
          <ac:chgData name="Narang, Sonali" userId="9e80b397-6e2f-49b1-9374-ccdad8589140" providerId="ADAL" clId="{0B7BE2FF-CA73-044A-832B-45D8C814BD66}" dt="2021-04-30T16:46:35.283" v="517" actId="478"/>
          <ac:spMkLst>
            <pc:docMk/>
            <pc:sldMk cId="3911031167" sldId="256"/>
            <ac:spMk id="57" creationId="{D0DEC274-2DF6-F14B-B281-D8C399BE34CF}"/>
          </ac:spMkLst>
        </pc:spChg>
        <pc:spChg chg="add mod">
          <ac:chgData name="Narang, Sonali" userId="9e80b397-6e2f-49b1-9374-ccdad8589140" providerId="ADAL" clId="{0B7BE2FF-CA73-044A-832B-45D8C814BD66}" dt="2021-04-29T18:29:17.010" v="496" actId="1035"/>
          <ac:spMkLst>
            <pc:docMk/>
            <pc:sldMk cId="3911031167" sldId="256"/>
            <ac:spMk id="58" creationId="{BD0FF247-589D-4B4C-8388-2FC80AF9DFEC}"/>
          </ac:spMkLst>
        </pc:spChg>
        <pc:spChg chg="add mod">
          <ac:chgData name="Narang, Sonali" userId="9e80b397-6e2f-49b1-9374-ccdad8589140" providerId="ADAL" clId="{0B7BE2FF-CA73-044A-832B-45D8C814BD66}" dt="2021-04-29T18:29:21.904" v="509" actId="1035"/>
          <ac:spMkLst>
            <pc:docMk/>
            <pc:sldMk cId="3911031167" sldId="256"/>
            <ac:spMk id="59" creationId="{1C85DEE8-F315-5047-B7B7-8827D96395BE}"/>
          </ac:spMkLst>
        </pc:spChg>
        <pc:spChg chg="mod topLvl">
          <ac:chgData name="Narang, Sonali" userId="9e80b397-6e2f-49b1-9374-ccdad8589140" providerId="ADAL" clId="{0B7BE2FF-CA73-044A-832B-45D8C814BD66}" dt="2021-04-28T21:54:41.131" v="269" actId="1037"/>
          <ac:spMkLst>
            <pc:docMk/>
            <pc:sldMk cId="3911031167" sldId="256"/>
            <ac:spMk id="60" creationId="{AA6BA435-EFC0-064C-8CE6-058DB76F21BE}"/>
          </ac:spMkLst>
        </pc:spChg>
        <pc:spChg chg="mod topLvl">
          <ac:chgData name="Narang, Sonali" userId="9e80b397-6e2f-49b1-9374-ccdad8589140" providerId="ADAL" clId="{0B7BE2FF-CA73-044A-832B-45D8C814BD66}" dt="2021-04-28T21:54:43.963" v="274" actId="1038"/>
          <ac:spMkLst>
            <pc:docMk/>
            <pc:sldMk cId="3911031167" sldId="256"/>
            <ac:spMk id="61" creationId="{9A62A9C2-4EF2-9E4B-BF75-4AEEEA3A3F38}"/>
          </ac:spMkLst>
        </pc:spChg>
        <pc:spChg chg="add mod">
          <ac:chgData name="Narang, Sonali" userId="9e80b397-6e2f-49b1-9374-ccdad8589140" providerId="ADAL" clId="{0B7BE2FF-CA73-044A-832B-45D8C814BD66}" dt="2021-04-28T21:59:27.330" v="289" actId="1076"/>
          <ac:spMkLst>
            <pc:docMk/>
            <pc:sldMk cId="3911031167" sldId="256"/>
            <ac:spMk id="63" creationId="{3AC0696E-2FD9-504A-9930-B191E254E3C9}"/>
          </ac:spMkLst>
        </pc:spChg>
        <pc:spChg chg="add mod">
          <ac:chgData name="Narang, Sonali" userId="9e80b397-6e2f-49b1-9374-ccdad8589140" providerId="ADAL" clId="{0B7BE2FF-CA73-044A-832B-45D8C814BD66}" dt="2021-04-28T22:10:32.690" v="341" actId="20577"/>
          <ac:spMkLst>
            <pc:docMk/>
            <pc:sldMk cId="3911031167" sldId="256"/>
            <ac:spMk id="64" creationId="{25F338D2-637A-AA4F-A1B1-C59036E5C8E3}"/>
          </ac:spMkLst>
        </pc:spChg>
        <pc:spChg chg="add mod">
          <ac:chgData name="Narang, Sonali" userId="9e80b397-6e2f-49b1-9374-ccdad8589140" providerId="ADAL" clId="{0B7BE2FF-CA73-044A-832B-45D8C814BD66}" dt="2021-04-28T22:10:22.456" v="323" actId="20577"/>
          <ac:spMkLst>
            <pc:docMk/>
            <pc:sldMk cId="3911031167" sldId="256"/>
            <ac:spMk id="65" creationId="{904702CD-3A66-7447-8DCA-F2E3574547A0}"/>
          </ac:spMkLst>
        </pc:spChg>
        <pc:spChg chg="add mod">
          <ac:chgData name="Narang, Sonali" userId="9e80b397-6e2f-49b1-9374-ccdad8589140" providerId="ADAL" clId="{0B7BE2FF-CA73-044A-832B-45D8C814BD66}" dt="2021-04-28T22:10:12.734" v="311" actId="20577"/>
          <ac:spMkLst>
            <pc:docMk/>
            <pc:sldMk cId="3911031167" sldId="256"/>
            <ac:spMk id="66" creationId="{F60F0442-DF47-7F40-A53A-5B1B35E6F9B5}"/>
          </ac:spMkLst>
        </pc:spChg>
        <pc:spChg chg="add mod">
          <ac:chgData name="Narang, Sonali" userId="9e80b397-6e2f-49b1-9374-ccdad8589140" providerId="ADAL" clId="{0B7BE2FF-CA73-044A-832B-45D8C814BD66}" dt="2021-04-28T22:10:25.654" v="329" actId="20577"/>
          <ac:spMkLst>
            <pc:docMk/>
            <pc:sldMk cId="3911031167" sldId="256"/>
            <ac:spMk id="67" creationId="{2F4A8184-8628-454A-A3BE-E60112770790}"/>
          </ac:spMkLst>
        </pc:spChg>
        <pc:spChg chg="add mod">
          <ac:chgData name="Narang, Sonali" userId="9e80b397-6e2f-49b1-9374-ccdad8589140" providerId="ADAL" clId="{0B7BE2FF-CA73-044A-832B-45D8C814BD66}" dt="2021-04-28T22:10:28.903" v="335" actId="20577"/>
          <ac:spMkLst>
            <pc:docMk/>
            <pc:sldMk cId="3911031167" sldId="256"/>
            <ac:spMk id="68" creationId="{ED0F1D6A-1B66-8141-B97A-4296BBD6DCA8}"/>
          </ac:spMkLst>
        </pc:spChg>
        <pc:spChg chg="add mod">
          <ac:chgData name="Narang, Sonali" userId="9e80b397-6e2f-49b1-9374-ccdad8589140" providerId="ADAL" clId="{0B7BE2FF-CA73-044A-832B-45D8C814BD66}" dt="2021-04-28T22:10:17.021" v="317" actId="20577"/>
          <ac:spMkLst>
            <pc:docMk/>
            <pc:sldMk cId="3911031167" sldId="256"/>
            <ac:spMk id="69" creationId="{D0B0FC79-6916-C149-88E7-53BDEE9D4071}"/>
          </ac:spMkLst>
        </pc:spChg>
        <pc:spChg chg="mod">
          <ac:chgData name="Narang, Sonali" userId="9e80b397-6e2f-49b1-9374-ccdad8589140" providerId="ADAL" clId="{0B7BE2FF-CA73-044A-832B-45D8C814BD66}" dt="2021-04-28T22:09:32.029" v="302"/>
          <ac:spMkLst>
            <pc:docMk/>
            <pc:sldMk cId="3911031167" sldId="256"/>
            <ac:spMk id="71" creationId="{6A1A1A59-D3B2-D045-BBF8-9A0C61848FEA}"/>
          </ac:spMkLst>
        </pc:spChg>
        <pc:spChg chg="mod">
          <ac:chgData name="Narang, Sonali" userId="9e80b397-6e2f-49b1-9374-ccdad8589140" providerId="ADAL" clId="{0B7BE2FF-CA73-044A-832B-45D8C814BD66}" dt="2021-04-28T22:09:32.029" v="302"/>
          <ac:spMkLst>
            <pc:docMk/>
            <pc:sldMk cId="3911031167" sldId="256"/>
            <ac:spMk id="72" creationId="{594CB37E-864F-C249-B71F-1A877B891778}"/>
          </ac:spMkLst>
        </pc:spChg>
        <pc:spChg chg="add mod">
          <ac:chgData name="Narang, Sonali" userId="9e80b397-6e2f-49b1-9374-ccdad8589140" providerId="ADAL" clId="{0B7BE2FF-CA73-044A-832B-45D8C814BD66}" dt="2021-05-24T17:55:17.988" v="1405" actId="1037"/>
          <ac:spMkLst>
            <pc:docMk/>
            <pc:sldMk cId="3911031167" sldId="256"/>
            <ac:spMk id="72" creationId="{E87FA026-087C-5C44-8204-B718606B65DE}"/>
          </ac:spMkLst>
        </pc:spChg>
        <pc:spChg chg="add mod">
          <ac:chgData name="Narang, Sonali" userId="9e80b397-6e2f-49b1-9374-ccdad8589140" providerId="ADAL" clId="{0B7BE2FF-CA73-044A-832B-45D8C814BD66}" dt="2021-05-24T17:55:21.421" v="1409" actId="1037"/>
          <ac:spMkLst>
            <pc:docMk/>
            <pc:sldMk cId="3911031167" sldId="256"/>
            <ac:spMk id="73" creationId="{64ABD8BF-3984-E74F-A48C-E6D4CDE1F995}"/>
          </ac:spMkLst>
        </pc:spChg>
        <pc:spChg chg="mod">
          <ac:chgData name="Narang, Sonali" userId="9e80b397-6e2f-49b1-9374-ccdad8589140" providerId="ADAL" clId="{0B7BE2FF-CA73-044A-832B-45D8C814BD66}" dt="2021-04-28T22:09:32.029" v="302"/>
          <ac:spMkLst>
            <pc:docMk/>
            <pc:sldMk cId="3911031167" sldId="256"/>
            <ac:spMk id="73" creationId="{6BFA6CE8-4A57-3546-B145-B95AE8D554AB}"/>
          </ac:spMkLst>
        </pc:spChg>
        <pc:spChg chg="mod">
          <ac:chgData name="Narang, Sonali" userId="9e80b397-6e2f-49b1-9374-ccdad8589140" providerId="ADAL" clId="{0B7BE2FF-CA73-044A-832B-45D8C814BD66}" dt="2021-04-28T22:10:46.284" v="349" actId="20577"/>
          <ac:spMkLst>
            <pc:docMk/>
            <pc:sldMk cId="3911031167" sldId="256"/>
            <ac:spMk id="77" creationId="{829F8CA4-F2B1-A94C-ADAB-084FEE65D57A}"/>
          </ac:spMkLst>
        </pc:spChg>
        <pc:spChg chg="mod">
          <ac:chgData name="Narang, Sonali" userId="9e80b397-6e2f-49b1-9374-ccdad8589140" providerId="ADAL" clId="{0B7BE2FF-CA73-044A-832B-45D8C814BD66}" dt="2021-04-28T22:11:22.057" v="377" actId="20577"/>
          <ac:spMkLst>
            <pc:docMk/>
            <pc:sldMk cId="3911031167" sldId="256"/>
            <ac:spMk id="78" creationId="{33106EAB-B2B4-4F48-946F-B59E0F97AE4F}"/>
          </ac:spMkLst>
        </pc:spChg>
        <pc:spChg chg="mod">
          <ac:chgData name="Narang, Sonali" userId="9e80b397-6e2f-49b1-9374-ccdad8589140" providerId="ADAL" clId="{0B7BE2FF-CA73-044A-832B-45D8C814BD66}" dt="2021-04-28T22:11:18.235" v="371" actId="1076"/>
          <ac:spMkLst>
            <pc:docMk/>
            <pc:sldMk cId="3911031167" sldId="256"/>
            <ac:spMk id="79" creationId="{002FC599-E5C1-884F-8CEA-4E88BA053BA6}"/>
          </ac:spMkLst>
        </pc:spChg>
        <pc:spChg chg="mod">
          <ac:chgData name="Narang, Sonali" userId="9e80b397-6e2f-49b1-9374-ccdad8589140" providerId="ADAL" clId="{0B7BE2FF-CA73-044A-832B-45D8C814BD66}" dt="2021-04-28T22:11:01.984" v="363" actId="1076"/>
          <ac:spMkLst>
            <pc:docMk/>
            <pc:sldMk cId="3911031167" sldId="256"/>
            <ac:spMk id="80" creationId="{4DF10DAC-EC31-254C-99AE-C63A1157B74B}"/>
          </ac:spMkLst>
        </pc:spChg>
        <pc:spChg chg="mod">
          <ac:chgData name="Narang, Sonali" userId="9e80b397-6e2f-49b1-9374-ccdad8589140" providerId="ADAL" clId="{0B7BE2FF-CA73-044A-832B-45D8C814BD66}" dt="2021-04-28T22:10:54.372" v="357" actId="20577"/>
          <ac:spMkLst>
            <pc:docMk/>
            <pc:sldMk cId="3911031167" sldId="256"/>
            <ac:spMk id="81" creationId="{AA9A73F8-BDAB-1C4A-8603-A1FF2F61F8F5}"/>
          </ac:spMkLst>
        </pc:spChg>
        <pc:spChg chg="mod">
          <ac:chgData name="Narang, Sonali" userId="9e80b397-6e2f-49b1-9374-ccdad8589140" providerId="ADAL" clId="{0B7BE2FF-CA73-044A-832B-45D8C814BD66}" dt="2021-04-28T22:10:49.506" v="353" actId="20577"/>
          <ac:spMkLst>
            <pc:docMk/>
            <pc:sldMk cId="3911031167" sldId="256"/>
            <ac:spMk id="82" creationId="{461E613F-A24C-1543-B732-CD8561548007}"/>
          </ac:spMkLst>
        </pc:spChg>
        <pc:spChg chg="mod">
          <ac:chgData name="Narang, Sonali" userId="9e80b397-6e2f-49b1-9374-ccdad8589140" providerId="ADAL" clId="{0B7BE2FF-CA73-044A-832B-45D8C814BD66}" dt="2021-04-28T22:11:06.162" v="369" actId="20577"/>
          <ac:spMkLst>
            <pc:docMk/>
            <pc:sldMk cId="3911031167" sldId="256"/>
            <ac:spMk id="83" creationId="{EBDBC63E-5AB8-174A-BB1F-F7D914A08173}"/>
          </ac:spMkLst>
        </pc:spChg>
        <pc:spChg chg="mod">
          <ac:chgData name="Narang, Sonali" userId="9e80b397-6e2f-49b1-9374-ccdad8589140" providerId="ADAL" clId="{0B7BE2FF-CA73-044A-832B-45D8C814BD66}" dt="2021-04-28T22:14:10.561" v="397" actId="207"/>
          <ac:spMkLst>
            <pc:docMk/>
            <pc:sldMk cId="3911031167" sldId="256"/>
            <ac:spMk id="84" creationId="{ABEEDABF-87C6-6E47-925F-190934716B1A}"/>
          </ac:spMkLst>
        </pc:spChg>
        <pc:spChg chg="mod">
          <ac:chgData name="Narang, Sonali" userId="9e80b397-6e2f-49b1-9374-ccdad8589140" providerId="ADAL" clId="{0B7BE2FF-CA73-044A-832B-45D8C814BD66}" dt="2021-04-28T22:14:10.561" v="397" actId="207"/>
          <ac:spMkLst>
            <pc:docMk/>
            <pc:sldMk cId="3911031167" sldId="256"/>
            <ac:spMk id="85" creationId="{0E49EB75-1683-9842-98B6-DEFCB88FE517}"/>
          </ac:spMkLst>
        </pc:spChg>
        <pc:spChg chg="mod">
          <ac:chgData name="Narang, Sonali" userId="9e80b397-6e2f-49b1-9374-ccdad8589140" providerId="ADAL" clId="{0B7BE2FF-CA73-044A-832B-45D8C814BD66}" dt="2021-04-28T22:14:10.561" v="397" actId="207"/>
          <ac:spMkLst>
            <pc:docMk/>
            <pc:sldMk cId="3911031167" sldId="256"/>
            <ac:spMk id="86" creationId="{C9AD06DF-9752-2B4B-A2F9-94821FA7A939}"/>
          </ac:spMkLst>
        </pc:spChg>
        <pc:spChg chg="add del mod topLvl">
          <ac:chgData name="Narang, Sonali" userId="9e80b397-6e2f-49b1-9374-ccdad8589140" providerId="ADAL" clId="{0B7BE2FF-CA73-044A-832B-45D8C814BD66}" dt="2021-04-28T22:16:19.693" v="405" actId="478"/>
          <ac:spMkLst>
            <pc:docMk/>
            <pc:sldMk cId="3911031167" sldId="256"/>
            <ac:spMk id="87" creationId="{F7E0529C-CB95-6446-A1D4-0C73492E682F}"/>
          </ac:spMkLst>
        </pc:spChg>
        <pc:spChg chg="add mod topLvl">
          <ac:chgData name="Narang, Sonali" userId="9e80b397-6e2f-49b1-9374-ccdad8589140" providerId="ADAL" clId="{0B7BE2FF-CA73-044A-832B-45D8C814BD66}" dt="2021-04-28T22:16:48.736" v="409" actId="1076"/>
          <ac:spMkLst>
            <pc:docMk/>
            <pc:sldMk cId="3911031167" sldId="256"/>
            <ac:spMk id="88" creationId="{DF3993D3-72E7-E54E-97D3-9D84F59F5654}"/>
          </ac:spMkLst>
        </pc:spChg>
        <pc:spChg chg="add mod topLvl">
          <ac:chgData name="Narang, Sonali" userId="9e80b397-6e2f-49b1-9374-ccdad8589140" providerId="ADAL" clId="{0B7BE2FF-CA73-044A-832B-45D8C814BD66}" dt="2021-04-28T22:16:48.736" v="409" actId="1076"/>
          <ac:spMkLst>
            <pc:docMk/>
            <pc:sldMk cId="3911031167" sldId="256"/>
            <ac:spMk id="89" creationId="{9795E54A-2B4A-9D4B-8972-CBAED713A584}"/>
          </ac:spMkLst>
        </pc:spChg>
        <pc:spChg chg="add mod topLvl">
          <ac:chgData name="Narang, Sonali" userId="9e80b397-6e2f-49b1-9374-ccdad8589140" providerId="ADAL" clId="{0B7BE2FF-CA73-044A-832B-45D8C814BD66}" dt="2021-04-28T22:16:48.736" v="409" actId="1076"/>
          <ac:spMkLst>
            <pc:docMk/>
            <pc:sldMk cId="3911031167" sldId="256"/>
            <ac:spMk id="90" creationId="{D21843D8-B24B-7440-962B-0D5326402052}"/>
          </ac:spMkLst>
        </pc:spChg>
        <pc:spChg chg="add mod">
          <ac:chgData name="Narang, Sonali" userId="9e80b397-6e2f-49b1-9374-ccdad8589140" providerId="ADAL" clId="{0B7BE2FF-CA73-044A-832B-45D8C814BD66}" dt="2021-04-28T22:17:14.540" v="412" actId="1076"/>
          <ac:spMkLst>
            <pc:docMk/>
            <pc:sldMk cId="3911031167" sldId="256"/>
            <ac:spMk id="93" creationId="{64285D9B-FC68-FC4E-A8AE-A691F45F91D3}"/>
          </ac:spMkLst>
        </pc:spChg>
        <pc:spChg chg="add mod">
          <ac:chgData name="Narang, Sonali" userId="9e80b397-6e2f-49b1-9374-ccdad8589140" providerId="ADAL" clId="{0B7BE2FF-CA73-044A-832B-45D8C814BD66}" dt="2021-04-28T22:17:14.540" v="412" actId="1076"/>
          <ac:spMkLst>
            <pc:docMk/>
            <pc:sldMk cId="3911031167" sldId="256"/>
            <ac:spMk id="94" creationId="{779ED364-B947-4649-AC6C-67DBDCE196B9}"/>
          </ac:spMkLst>
        </pc:spChg>
        <pc:spChg chg="add mod">
          <ac:chgData name="Narang, Sonali" userId="9e80b397-6e2f-49b1-9374-ccdad8589140" providerId="ADAL" clId="{0B7BE2FF-CA73-044A-832B-45D8C814BD66}" dt="2021-04-29T18:28:12.376" v="467" actId="1076"/>
          <ac:spMkLst>
            <pc:docMk/>
            <pc:sldMk cId="3911031167" sldId="256"/>
            <ac:spMk id="95" creationId="{6DD283A0-4643-074E-A722-EACAC130A59D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3" creationId="{8249D91C-2ED3-0D4F-96AE-C849A48C547D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4" creationId="{7AF6A2EC-1299-C045-B72E-AEC0E977AD97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5" creationId="{AD19BA57-153C-E84F-90CC-93AC5C1CC250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6" creationId="{6447F22C-96B5-8A47-88F2-DB513E003E17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7" creationId="{0C023516-C280-694C-8A4A-1FEB3B7B965D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08" creationId="{39DE4D3D-9DB2-494F-8A56-63BB657FA532}"/>
          </ac:spMkLst>
        </pc:spChg>
        <pc:spChg chg="add del mod">
          <ac:chgData name="Narang, Sonali" userId="9e80b397-6e2f-49b1-9374-ccdad8589140" providerId="ADAL" clId="{0B7BE2FF-CA73-044A-832B-45D8C814BD66}" dt="2021-04-30T16:55:14.702" v="589"/>
          <ac:spMkLst>
            <pc:docMk/>
            <pc:sldMk cId="3911031167" sldId="256"/>
            <ac:spMk id="109" creationId="{5F9347B1-1046-5E47-99C8-FE5BCBF6A1FB}"/>
          </ac:spMkLst>
        </pc:spChg>
        <pc:spChg chg="add del mod">
          <ac:chgData name="Narang, Sonali" userId="9e80b397-6e2f-49b1-9374-ccdad8589140" providerId="ADAL" clId="{0B7BE2FF-CA73-044A-832B-45D8C814BD66}" dt="2021-04-30T16:55:14.702" v="589"/>
          <ac:spMkLst>
            <pc:docMk/>
            <pc:sldMk cId="3911031167" sldId="256"/>
            <ac:spMk id="110" creationId="{3A5A8BDF-3554-824A-BBF9-58EA9FB84CCE}"/>
          </ac:spMkLst>
        </pc:spChg>
        <pc:spChg chg="add del mod">
          <ac:chgData name="Narang, Sonali" userId="9e80b397-6e2f-49b1-9374-ccdad8589140" providerId="ADAL" clId="{0B7BE2FF-CA73-044A-832B-45D8C814BD66}" dt="2021-04-30T16:55:14.702" v="589"/>
          <ac:spMkLst>
            <pc:docMk/>
            <pc:sldMk cId="3911031167" sldId="256"/>
            <ac:spMk id="111" creationId="{D619174C-D85C-BD40-9AED-1E51E1D39E1D}"/>
          </ac:spMkLst>
        </pc:spChg>
        <pc:spChg chg="add del mod">
          <ac:chgData name="Narang, Sonali" userId="9e80b397-6e2f-49b1-9374-ccdad8589140" providerId="ADAL" clId="{0B7BE2FF-CA73-044A-832B-45D8C814BD66}" dt="2021-04-30T16:55:14.702" v="589"/>
          <ac:spMkLst>
            <pc:docMk/>
            <pc:sldMk cId="3911031167" sldId="256"/>
            <ac:spMk id="112" creationId="{0EA966CB-37A0-F840-ADEE-F47B4571F546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3" creationId="{01B8E795-7B8F-FE44-8C33-2BE4CA2478B1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4" creationId="{C879539C-BF25-E04C-A09E-DD0E1A506176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5" creationId="{B5338A1E-38C4-EE41-BF92-ED3F5F0D4061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6" creationId="{A269B191-72B8-5648-95CE-2B976B6A7084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7" creationId="{0DE59DB0-705C-9942-8A07-11BBC6A40AF5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18" creationId="{D1A00D24-E347-8740-AE4B-E1CE6C743F18}"/>
          </ac:spMkLst>
        </pc:spChg>
        <pc:spChg chg="add del mod">
          <ac:chgData name="Narang, Sonali" userId="9e80b397-6e2f-49b1-9374-ccdad8589140" providerId="ADAL" clId="{0B7BE2FF-CA73-044A-832B-45D8C814BD66}" dt="2021-04-30T16:59:22.329" v="621"/>
          <ac:spMkLst>
            <pc:docMk/>
            <pc:sldMk cId="3911031167" sldId="256"/>
            <ac:spMk id="119" creationId="{ECE34E8A-620E-944F-A3E0-2E309649234C}"/>
          </ac:spMkLst>
        </pc:spChg>
        <pc:spChg chg="add mod">
          <ac:chgData name="Narang, Sonali" userId="9e80b397-6e2f-49b1-9374-ccdad8589140" providerId="ADAL" clId="{0B7BE2FF-CA73-044A-832B-45D8C814BD66}" dt="2021-05-24T17:57:04.317" v="1450" actId="465"/>
          <ac:spMkLst>
            <pc:docMk/>
            <pc:sldMk cId="3911031167" sldId="256"/>
            <ac:spMk id="120" creationId="{E79C65D0-E5EE-6749-9BE7-9B9A865D2F29}"/>
          </ac:spMkLst>
        </pc:spChg>
        <pc:spChg chg="add del mod">
          <ac:chgData name="Narang, Sonali" userId="9e80b397-6e2f-49b1-9374-ccdad8589140" providerId="ADAL" clId="{0B7BE2FF-CA73-044A-832B-45D8C814BD66}" dt="2021-04-30T17:02:13.078" v="688"/>
          <ac:spMkLst>
            <pc:docMk/>
            <pc:sldMk cId="3911031167" sldId="256"/>
            <ac:spMk id="126" creationId="{176BE726-EC0E-8640-9D5D-813ECFC3CB49}"/>
          </ac:spMkLst>
        </pc:spChg>
        <pc:spChg chg="add mod">
          <ac:chgData name="Narang, Sonali" userId="9e80b397-6e2f-49b1-9374-ccdad8589140" providerId="ADAL" clId="{0B7BE2FF-CA73-044A-832B-45D8C814BD66}" dt="2021-05-24T18:39:43.386" v="1474" actId="14100"/>
          <ac:spMkLst>
            <pc:docMk/>
            <pc:sldMk cId="3911031167" sldId="256"/>
            <ac:spMk id="127" creationId="{F6621CCC-C261-1F4D-A673-996B4DC6AECF}"/>
          </ac:spMkLst>
        </pc:spChg>
        <pc:spChg chg="add mod">
          <ac:chgData name="Narang, Sonali" userId="9e80b397-6e2f-49b1-9374-ccdad8589140" providerId="ADAL" clId="{0B7BE2FF-CA73-044A-832B-45D8C814BD66}" dt="2021-05-24T18:39:50.177" v="1475" actId="14100"/>
          <ac:spMkLst>
            <pc:docMk/>
            <pc:sldMk cId="3911031167" sldId="256"/>
            <ac:spMk id="128" creationId="{32047D85-46BE-FE47-A5A1-85A19B421502}"/>
          </ac:spMkLst>
        </pc:spChg>
        <pc:grpChg chg="add mod">
          <ac:chgData name="Narang, Sonali" userId="9e80b397-6e2f-49b1-9374-ccdad8589140" providerId="ADAL" clId="{0B7BE2FF-CA73-044A-832B-45D8C814BD66}" dt="2021-05-27T12:13:07.855" v="1916" actId="1076"/>
          <ac:grpSpMkLst>
            <pc:docMk/>
            <pc:sldMk cId="3911031167" sldId="256"/>
            <ac:grpSpMk id="10" creationId="{D88D7517-4649-454B-B33B-40859B6B3E1E}"/>
          </ac:grpSpMkLst>
        </pc:grpChg>
        <pc:grpChg chg="add mod">
          <ac:chgData name="Narang, Sonali" userId="9e80b397-6e2f-49b1-9374-ccdad8589140" providerId="ADAL" clId="{0B7BE2FF-CA73-044A-832B-45D8C814BD66}" dt="2021-04-28T18:50:00.790" v="99" actId="164"/>
          <ac:grpSpMkLst>
            <pc:docMk/>
            <pc:sldMk cId="3911031167" sldId="256"/>
            <ac:grpSpMk id="26" creationId="{94F6498D-BA73-D241-94C7-91EC16C6B4FC}"/>
          </ac:grpSpMkLst>
        </pc:grpChg>
        <pc:grpChg chg="add mod">
          <ac:chgData name="Narang, Sonali" userId="9e80b397-6e2f-49b1-9374-ccdad8589140" providerId="ADAL" clId="{0B7BE2FF-CA73-044A-832B-45D8C814BD66}" dt="2021-04-28T18:49:58.783" v="97" actId="164"/>
          <ac:grpSpMkLst>
            <pc:docMk/>
            <pc:sldMk cId="3911031167" sldId="256"/>
            <ac:grpSpMk id="27" creationId="{BE0163E0-F49D-C345-8490-EB3AA3C76E86}"/>
          </ac:grpSpMkLst>
        </pc:grpChg>
        <pc:grpChg chg="del mod">
          <ac:chgData name="Narang, Sonali" userId="9e80b397-6e2f-49b1-9374-ccdad8589140" providerId="ADAL" clId="{0B7BE2FF-CA73-044A-832B-45D8C814BD66}" dt="2021-04-28T21:50:02.636" v="204" actId="165"/>
          <ac:grpSpMkLst>
            <pc:docMk/>
            <pc:sldMk cId="3911031167" sldId="256"/>
            <ac:grpSpMk id="40" creationId="{A3F8B588-1FDC-054B-977B-08D566BD307D}"/>
          </ac:grpSpMkLst>
        </pc:grpChg>
        <pc:grpChg chg="add mod">
          <ac:chgData name="Narang, Sonali" userId="9e80b397-6e2f-49b1-9374-ccdad8589140" providerId="ADAL" clId="{0B7BE2FF-CA73-044A-832B-45D8C814BD66}" dt="2021-04-28T21:54:50.011" v="276" actId="1036"/>
          <ac:grpSpMkLst>
            <pc:docMk/>
            <pc:sldMk cId="3911031167" sldId="256"/>
            <ac:grpSpMk id="62" creationId="{AB069A6D-9F33-984A-8109-B0869C642FAE}"/>
          </ac:grpSpMkLst>
        </pc:grpChg>
        <pc:grpChg chg="add del mod">
          <ac:chgData name="Narang, Sonali" userId="9e80b397-6e2f-49b1-9374-ccdad8589140" providerId="ADAL" clId="{0B7BE2FF-CA73-044A-832B-45D8C814BD66}" dt="2021-04-28T22:09:33.774" v="303"/>
          <ac:grpSpMkLst>
            <pc:docMk/>
            <pc:sldMk cId="3911031167" sldId="256"/>
            <ac:grpSpMk id="70" creationId="{7067436A-C78B-F748-8FEC-B1D51382C749}"/>
          </ac:grpSpMkLst>
        </pc:grpChg>
        <pc:grpChg chg="add topLvl">
          <ac:chgData name="Narang, Sonali" userId="9e80b397-6e2f-49b1-9374-ccdad8589140" providerId="ADAL" clId="{0B7BE2FF-CA73-044A-832B-45D8C814BD66}" dt="2021-04-28T22:16:27.521" v="406" actId="165"/>
          <ac:grpSpMkLst>
            <pc:docMk/>
            <pc:sldMk cId="3911031167" sldId="256"/>
            <ac:grpSpMk id="74" creationId="{4EC58C4C-82C8-A14A-925C-632FEA68B22F}"/>
          </ac:grpSpMkLst>
        </pc:grpChg>
        <pc:grpChg chg="add mod topLvl">
          <ac:chgData name="Narang, Sonali" userId="9e80b397-6e2f-49b1-9374-ccdad8589140" providerId="ADAL" clId="{0B7BE2FF-CA73-044A-832B-45D8C814BD66}" dt="2021-04-28T22:17:00.148" v="410" actId="1076"/>
          <ac:grpSpMkLst>
            <pc:docMk/>
            <pc:sldMk cId="3911031167" sldId="256"/>
            <ac:grpSpMk id="75" creationId="{CB7AA65D-7023-604B-A9B6-218BCB47B7B9}"/>
          </ac:grpSpMkLst>
        </pc:grpChg>
        <pc:grpChg chg="mod">
          <ac:chgData name="Narang, Sonali" userId="9e80b397-6e2f-49b1-9374-ccdad8589140" providerId="ADAL" clId="{0B7BE2FF-CA73-044A-832B-45D8C814BD66}" dt="2021-04-28T22:10:40.236" v="342"/>
          <ac:grpSpMkLst>
            <pc:docMk/>
            <pc:sldMk cId="3911031167" sldId="256"/>
            <ac:grpSpMk id="76" creationId="{8C84B6F9-4E80-E442-A44B-836C7C14986E}"/>
          </ac:grpSpMkLst>
        </pc:grpChg>
        <pc:grpChg chg="add del mod">
          <ac:chgData name="Narang, Sonali" userId="9e80b397-6e2f-49b1-9374-ccdad8589140" providerId="ADAL" clId="{0B7BE2FF-CA73-044A-832B-45D8C814BD66}" dt="2021-04-28T22:16:27.521" v="406" actId="165"/>
          <ac:grpSpMkLst>
            <pc:docMk/>
            <pc:sldMk cId="3911031167" sldId="256"/>
            <ac:grpSpMk id="91" creationId="{2F8D48B7-262D-F14D-B952-E388B0A222C6}"/>
          </ac:grpSpMkLst>
        </pc:grpChg>
        <pc:grpChg chg="add del mod">
          <ac:chgData name="Narang, Sonali" userId="9e80b397-6e2f-49b1-9374-ccdad8589140" providerId="ADAL" clId="{0B7BE2FF-CA73-044A-832B-45D8C814BD66}" dt="2021-04-28T22:16:12.940" v="404" actId="165"/>
          <ac:grpSpMkLst>
            <pc:docMk/>
            <pc:sldMk cId="3911031167" sldId="256"/>
            <ac:grpSpMk id="92" creationId="{F4CCE15A-F63E-914F-A525-BDD41ED08CAE}"/>
          </ac:grpSpMkLst>
        </pc:grpChg>
        <pc:grpChg chg="add mod">
          <ac:chgData name="Narang, Sonali" userId="9e80b397-6e2f-49b1-9374-ccdad8589140" providerId="ADAL" clId="{0B7BE2FF-CA73-044A-832B-45D8C814BD66}" dt="2021-05-07T14:58:47.812" v="1098" actId="1076"/>
          <ac:grpSpMkLst>
            <pc:docMk/>
            <pc:sldMk cId="3911031167" sldId="256"/>
            <ac:grpSpMk id="96" creationId="{F3AA89EB-F925-3649-A3BE-B492BEBFEFFB}"/>
          </ac:grpSpMkLst>
        </pc:grpChg>
        <pc:grpChg chg="add mod">
          <ac:chgData name="Narang, Sonali" userId="9e80b397-6e2f-49b1-9374-ccdad8589140" providerId="ADAL" clId="{0B7BE2FF-CA73-044A-832B-45D8C814BD66}" dt="2021-05-24T17:57:04.317" v="1450" actId="465"/>
          <ac:grpSpMkLst>
            <pc:docMk/>
            <pc:sldMk cId="3911031167" sldId="256"/>
            <ac:grpSpMk id="121" creationId="{563F0160-42E3-664B-87C9-3CCE07D64746}"/>
          </ac:grpSpMkLst>
        </pc:grpChg>
        <pc:grpChg chg="add mod">
          <ac:chgData name="Narang, Sonali" userId="9e80b397-6e2f-49b1-9374-ccdad8589140" providerId="ADAL" clId="{0B7BE2FF-CA73-044A-832B-45D8C814BD66}" dt="2021-05-24T17:57:04.317" v="1450" actId="465"/>
          <ac:grpSpMkLst>
            <pc:docMk/>
            <pc:sldMk cId="3911031167" sldId="256"/>
            <ac:grpSpMk id="122" creationId="{D6ECC4B4-27CB-D442-985D-113B1C50E117}"/>
          </ac:grpSpMkLst>
        </pc:grpChg>
        <pc:grpChg chg="add mod">
          <ac:chgData name="Narang, Sonali" userId="9e80b397-6e2f-49b1-9374-ccdad8589140" providerId="ADAL" clId="{0B7BE2FF-CA73-044A-832B-45D8C814BD66}" dt="2021-05-24T18:39:54.380" v="1476" actId="1076"/>
          <ac:grpSpMkLst>
            <pc:docMk/>
            <pc:sldMk cId="3911031167" sldId="256"/>
            <ac:grpSpMk id="131" creationId="{E8F33C01-784E-8B49-9631-3F0E114ED4AE}"/>
          </ac:grpSpMkLst>
        </pc:grpChg>
        <pc:graphicFrameChg chg="del mod">
          <ac:chgData name="Narang, Sonali" userId="9e80b397-6e2f-49b1-9374-ccdad8589140" providerId="ADAL" clId="{0B7BE2FF-CA73-044A-832B-45D8C814BD66}" dt="2021-04-28T22:12:36.887" v="387" actId="478"/>
          <ac:graphicFrameMkLst>
            <pc:docMk/>
            <pc:sldMk cId="3911031167" sldId="256"/>
            <ac:graphicFrameMk id="30" creationId="{526C926A-59C1-0049-B837-DD2C019E530B}"/>
          </ac:graphicFrameMkLst>
        </pc:graphicFrameChg>
        <pc:graphicFrameChg chg="del mod">
          <ac:chgData name="Narang, Sonali" userId="9e80b397-6e2f-49b1-9374-ccdad8589140" providerId="ADAL" clId="{0B7BE2FF-CA73-044A-832B-45D8C814BD66}" dt="2021-04-28T22:12:36.887" v="387" actId="478"/>
          <ac:graphicFrameMkLst>
            <pc:docMk/>
            <pc:sldMk cId="3911031167" sldId="256"/>
            <ac:graphicFrameMk id="31" creationId="{448EBA65-72E9-1C41-A14C-45AA84AE94B5}"/>
          </ac:graphicFrameMkLst>
        </pc:graphicFrameChg>
        <pc:graphicFrameChg chg="add del mod modGraphic">
          <ac:chgData name="Narang, Sonali" userId="9e80b397-6e2f-49b1-9374-ccdad8589140" providerId="ADAL" clId="{0B7BE2FF-CA73-044A-832B-45D8C814BD66}" dt="2021-04-28T21:49:54.068" v="203" actId="18245"/>
          <ac:graphicFrameMkLst>
            <pc:docMk/>
            <pc:sldMk cId="3911031167" sldId="256"/>
            <ac:graphicFrameMk id="39" creationId="{7E1C03C8-EEE1-614C-A67E-19A21A697A6F}"/>
          </ac:graphicFrameMkLst>
        </pc:graphicFrameChg>
        <pc:picChg chg="add del mod">
          <ac:chgData name="Narang, Sonali" userId="9e80b397-6e2f-49b1-9374-ccdad8589140" providerId="ADAL" clId="{0B7BE2FF-CA73-044A-832B-45D8C814BD66}" dt="2021-04-28T17:57:30.867" v="18" actId="478"/>
          <ac:picMkLst>
            <pc:docMk/>
            <pc:sldMk cId="3911031167" sldId="256"/>
            <ac:picMk id="3" creationId="{35EB25F8-38B8-BF49-891F-81BF9D802E48}"/>
          </ac:picMkLst>
        </pc:picChg>
        <pc:picChg chg="add del mod">
          <ac:chgData name="Narang, Sonali" userId="9e80b397-6e2f-49b1-9374-ccdad8589140" providerId="ADAL" clId="{0B7BE2FF-CA73-044A-832B-45D8C814BD66}" dt="2021-05-24T18:21:20.383" v="1457" actId="478"/>
          <ac:picMkLst>
            <pc:docMk/>
            <pc:sldMk cId="3911031167" sldId="256"/>
            <ac:picMk id="3" creationId="{F2A57D41-1DD2-824A-A8D5-7E7068B5DD9C}"/>
          </ac:picMkLst>
        </pc:picChg>
        <pc:picChg chg="add del mod">
          <ac:chgData name="Narang, Sonali" userId="9e80b397-6e2f-49b1-9374-ccdad8589140" providerId="ADAL" clId="{0B7BE2FF-CA73-044A-832B-45D8C814BD66}" dt="2021-05-24T18:23:15.270" v="1463" actId="478"/>
          <ac:picMkLst>
            <pc:docMk/>
            <pc:sldMk cId="3911031167" sldId="256"/>
            <ac:picMk id="11" creationId="{46520C88-6088-644A-BF44-138BE1B009CF}"/>
          </ac:picMkLst>
        </pc:picChg>
        <pc:picChg chg="add del mod">
          <ac:chgData name="Narang, Sonali" userId="9e80b397-6e2f-49b1-9374-ccdad8589140" providerId="ADAL" clId="{0B7BE2FF-CA73-044A-832B-45D8C814BD66}" dt="2021-04-28T17:58:22.592" v="29" actId="478"/>
          <ac:picMkLst>
            <pc:docMk/>
            <pc:sldMk cId="3911031167" sldId="256"/>
            <ac:picMk id="12" creationId="{7A6A8456-1821-4744-9D3F-FF0FF3072F64}"/>
          </ac:picMkLst>
        </pc:picChg>
        <pc:picChg chg="add del mod">
          <ac:chgData name="Narang, Sonali" userId="9e80b397-6e2f-49b1-9374-ccdad8589140" providerId="ADAL" clId="{0B7BE2FF-CA73-044A-832B-45D8C814BD66}" dt="2021-05-24T18:23:42.020" v="1473" actId="478"/>
          <ac:picMkLst>
            <pc:docMk/>
            <pc:sldMk cId="3911031167" sldId="256"/>
            <ac:picMk id="13" creationId="{938CE52D-E55A-1749-8F6D-E5DBE72CEE77}"/>
          </ac:picMkLst>
        </pc:picChg>
        <pc:picChg chg="mod">
          <ac:chgData name="Narang, Sonali" userId="9e80b397-6e2f-49b1-9374-ccdad8589140" providerId="ADAL" clId="{0B7BE2FF-CA73-044A-832B-45D8C814BD66}" dt="2021-04-28T17:54:32.944" v="11" actId="14100"/>
          <ac:picMkLst>
            <pc:docMk/>
            <pc:sldMk cId="3911031167" sldId="256"/>
            <ac:picMk id="14" creationId="{EF770846-0D46-3443-852C-45BBB7CE5AB3}"/>
          </ac:picMkLst>
        </pc:picChg>
        <pc:picChg chg="del mod">
          <ac:chgData name="Narang, Sonali" userId="9e80b397-6e2f-49b1-9374-ccdad8589140" providerId="ADAL" clId="{0B7BE2FF-CA73-044A-832B-45D8C814BD66}" dt="2021-04-28T18:45:17.195" v="49" actId="478"/>
          <ac:picMkLst>
            <pc:docMk/>
            <pc:sldMk cId="3911031167" sldId="256"/>
            <ac:picMk id="15" creationId="{FF77D706-ADF1-BC48-989A-EF1FE9E2943C}"/>
          </ac:picMkLst>
        </pc:picChg>
        <pc:picChg chg="add del mod">
          <ac:chgData name="Narang, Sonali" userId="9e80b397-6e2f-49b1-9374-ccdad8589140" providerId="ADAL" clId="{0B7BE2FF-CA73-044A-832B-45D8C814BD66}" dt="2021-05-24T18:53:15.860" v="1513" actId="478"/>
          <ac:picMkLst>
            <pc:docMk/>
            <pc:sldMk cId="3911031167" sldId="256"/>
            <ac:picMk id="16" creationId="{B8194622-C0FF-7741-A8BC-41D4B73DD82E}"/>
          </ac:picMkLst>
        </pc:picChg>
        <pc:picChg chg="add del mod modCrop">
          <ac:chgData name="Narang, Sonali" userId="9e80b397-6e2f-49b1-9374-ccdad8589140" providerId="ADAL" clId="{0B7BE2FF-CA73-044A-832B-45D8C814BD66}" dt="2021-04-28T19:50:44.884" v="185" actId="478"/>
          <ac:picMkLst>
            <pc:docMk/>
            <pc:sldMk cId="3911031167" sldId="256"/>
            <ac:picMk id="17" creationId="{3F0DC4C7-B7FB-DF41-BD8D-F1C3C06EC32F}"/>
          </ac:picMkLst>
        </pc:picChg>
        <pc:picChg chg="add del mod">
          <ac:chgData name="Narang, Sonali" userId="9e80b397-6e2f-49b1-9374-ccdad8589140" providerId="ADAL" clId="{0B7BE2FF-CA73-044A-832B-45D8C814BD66}" dt="2021-05-24T18:54:12.917" v="1520" actId="478"/>
          <ac:picMkLst>
            <pc:docMk/>
            <pc:sldMk cId="3911031167" sldId="256"/>
            <ac:picMk id="17" creationId="{AC9FE801-C2D3-E648-B743-B9120FF8CE2E}"/>
          </ac:picMkLst>
        </pc:picChg>
        <pc:picChg chg="add del mod">
          <ac:chgData name="Narang, Sonali" userId="9e80b397-6e2f-49b1-9374-ccdad8589140" providerId="ADAL" clId="{0B7BE2FF-CA73-044A-832B-45D8C814BD66}" dt="2021-05-24T18:59:55.412" v="1527" actId="478"/>
          <ac:picMkLst>
            <pc:docMk/>
            <pc:sldMk cId="3911031167" sldId="256"/>
            <ac:picMk id="19" creationId="{73FC12EE-B81D-7341-90DF-0CD34FDE7FD7}"/>
          </ac:picMkLst>
        </pc:picChg>
        <pc:picChg chg="add mod">
          <ac:chgData name="Narang, Sonali" userId="9e80b397-6e2f-49b1-9374-ccdad8589140" providerId="ADAL" clId="{0B7BE2FF-CA73-044A-832B-45D8C814BD66}" dt="2021-05-24T21:50:26.381" v="1736" actId="1038"/>
          <ac:picMkLst>
            <pc:docMk/>
            <pc:sldMk cId="3911031167" sldId="256"/>
            <ac:picMk id="21" creationId="{8DC8A9F5-026A-0D4A-A691-B6079224F482}"/>
          </ac:picMkLst>
        </pc:picChg>
        <pc:picChg chg="add del mod">
          <ac:chgData name="Narang, Sonali" userId="9e80b397-6e2f-49b1-9374-ccdad8589140" providerId="ADAL" clId="{0B7BE2FF-CA73-044A-832B-45D8C814BD66}" dt="2021-04-28T18:46:04.306" v="60" actId="478"/>
          <ac:picMkLst>
            <pc:docMk/>
            <pc:sldMk cId="3911031167" sldId="256"/>
            <ac:picMk id="23" creationId="{45534584-D297-4A41-9FA7-5B2EF8903149}"/>
          </ac:picMkLst>
        </pc:picChg>
        <pc:picChg chg="add mod modCrop">
          <ac:chgData name="Narang, Sonali" userId="9e80b397-6e2f-49b1-9374-ccdad8589140" providerId="ADAL" clId="{0B7BE2FF-CA73-044A-832B-45D8C814BD66}" dt="2021-05-27T12:13:05.568" v="1912" actId="1076"/>
          <ac:picMkLst>
            <pc:docMk/>
            <pc:sldMk cId="3911031167" sldId="256"/>
            <ac:picMk id="23" creationId="{F4E04DD6-E91E-DA48-812D-B7942BE0CA2A}"/>
          </ac:picMkLst>
        </pc:picChg>
        <pc:picChg chg="add del mod">
          <ac:chgData name="Narang, Sonali" userId="9e80b397-6e2f-49b1-9374-ccdad8589140" providerId="ADAL" clId="{0B7BE2FF-CA73-044A-832B-45D8C814BD66}" dt="2021-04-28T19:09:27.523" v="107" actId="478"/>
          <ac:picMkLst>
            <pc:docMk/>
            <pc:sldMk cId="3911031167" sldId="256"/>
            <ac:picMk id="24" creationId="{A35F3B39-B3F1-BD4E-AFCB-7EBF8CAA95E8}"/>
          </ac:picMkLst>
        </pc:picChg>
        <pc:picChg chg="add mod">
          <ac:chgData name="Narang, Sonali" userId="9e80b397-6e2f-49b1-9374-ccdad8589140" providerId="ADAL" clId="{0B7BE2FF-CA73-044A-832B-45D8C814BD66}" dt="2021-05-27T12:13:07.342" v="1915" actId="1076"/>
          <ac:picMkLst>
            <pc:docMk/>
            <pc:sldMk cId="3911031167" sldId="256"/>
            <ac:picMk id="28" creationId="{1AB9209A-D5A4-B14E-9181-92CEA1124279}"/>
          </ac:picMkLst>
        </pc:picChg>
        <pc:picChg chg="add del mod">
          <ac:chgData name="Narang, Sonali" userId="9e80b397-6e2f-49b1-9374-ccdad8589140" providerId="ADAL" clId="{0B7BE2FF-CA73-044A-832B-45D8C814BD66}" dt="2021-04-28T22:41:44.626" v="425" actId="478"/>
          <ac:picMkLst>
            <pc:docMk/>
            <pc:sldMk cId="3911031167" sldId="256"/>
            <ac:picMk id="37" creationId="{8AC562E9-5B3E-334C-B0C9-AAAA6E69135E}"/>
          </ac:picMkLst>
        </pc:picChg>
        <pc:picChg chg="del">
          <ac:chgData name="Narang, Sonali" userId="9e80b397-6e2f-49b1-9374-ccdad8589140" providerId="ADAL" clId="{0B7BE2FF-CA73-044A-832B-45D8C814BD66}" dt="2021-04-28T17:32:04.256" v="0" actId="478"/>
          <ac:picMkLst>
            <pc:docMk/>
            <pc:sldMk cId="3911031167" sldId="256"/>
            <ac:picMk id="43" creationId="{9803FB0D-3A8B-7F45-BEAD-664DB0E4A011}"/>
          </ac:picMkLst>
        </pc:picChg>
        <pc:picChg chg="add del mod">
          <ac:chgData name="Narang, Sonali" userId="9e80b397-6e2f-49b1-9374-ccdad8589140" providerId="ADAL" clId="{0B7BE2FF-CA73-044A-832B-45D8C814BD66}" dt="2021-05-24T20:14:47.378" v="1622" actId="478"/>
          <ac:picMkLst>
            <pc:docMk/>
            <pc:sldMk cId="3911031167" sldId="256"/>
            <ac:picMk id="98" creationId="{54AF71D0-D019-D64F-A8C9-4E3BEA8AED4A}"/>
          </ac:picMkLst>
        </pc:picChg>
        <pc:picChg chg="add mod">
          <ac:chgData name="Narang, Sonali" userId="9e80b397-6e2f-49b1-9374-ccdad8589140" providerId="ADAL" clId="{0B7BE2FF-CA73-044A-832B-45D8C814BD66}" dt="2021-05-24T15:04:12.581" v="1344" actId="1076"/>
          <ac:picMkLst>
            <pc:docMk/>
            <pc:sldMk cId="3911031167" sldId="256"/>
            <ac:picMk id="100" creationId="{C473AFED-13EF-534F-BD83-A66FBE1CE3F1}"/>
          </ac:picMkLst>
        </pc:picChg>
        <pc:picChg chg="add mod modCrop">
          <ac:chgData name="Narang, Sonali" userId="9e80b397-6e2f-49b1-9374-ccdad8589140" providerId="ADAL" clId="{0B7BE2FF-CA73-044A-832B-45D8C814BD66}" dt="2021-05-24T17:57:04.317" v="1450" actId="465"/>
          <ac:picMkLst>
            <pc:docMk/>
            <pc:sldMk cId="3911031167" sldId="256"/>
            <ac:picMk id="101" creationId="{74A13826-2D9F-5343-9ADB-B173F3F12752}"/>
          </ac:picMkLst>
        </pc:picChg>
        <pc:picChg chg="add mod modCrop">
          <ac:chgData name="Narang, Sonali" userId="9e80b397-6e2f-49b1-9374-ccdad8589140" providerId="ADAL" clId="{0B7BE2FF-CA73-044A-832B-45D8C814BD66}" dt="2021-05-24T17:57:04.317" v="1450" actId="465"/>
          <ac:picMkLst>
            <pc:docMk/>
            <pc:sldMk cId="3911031167" sldId="256"/>
            <ac:picMk id="102" creationId="{83D19F2B-6F9E-2241-8FDD-4B5D1D10D1DC}"/>
          </ac:picMkLst>
        </pc:picChg>
        <pc:cxnChg chg="del">
          <ac:chgData name="Narang, Sonali" userId="9e80b397-6e2f-49b1-9374-ccdad8589140" providerId="ADAL" clId="{0B7BE2FF-CA73-044A-832B-45D8C814BD66}" dt="2021-04-28T18:58:39.605" v="101" actId="478"/>
          <ac:cxnSpMkLst>
            <pc:docMk/>
            <pc:sldMk cId="3911031167" sldId="256"/>
            <ac:cxnSpMk id="22" creationId="{F181C606-98F1-7849-AE76-A0D990193719}"/>
          </ac:cxnSpMkLst>
        </pc:cxnChg>
        <pc:cxnChg chg="del">
          <ac:chgData name="Narang, Sonali" userId="9e80b397-6e2f-49b1-9374-ccdad8589140" providerId="ADAL" clId="{0B7BE2FF-CA73-044A-832B-45D8C814BD66}" dt="2021-04-28T18:58:39.605" v="101" actId="478"/>
          <ac:cxnSpMkLst>
            <pc:docMk/>
            <pc:sldMk cId="3911031167" sldId="256"/>
            <ac:cxnSpMk id="25" creationId="{48D4A1BA-F684-D145-90FB-513303F637CB}"/>
          </ac:cxnSpMkLst>
        </pc:cxnChg>
        <pc:cxnChg chg="del">
          <ac:chgData name="Narang, Sonali" userId="9e80b397-6e2f-49b1-9374-ccdad8589140" providerId="ADAL" clId="{0B7BE2FF-CA73-044A-832B-45D8C814BD66}" dt="2021-04-28T18:58:39.605" v="101" actId="478"/>
          <ac:cxnSpMkLst>
            <pc:docMk/>
            <pc:sldMk cId="3911031167" sldId="256"/>
            <ac:cxnSpMk id="33" creationId="{ABC3F27C-CACA-254D-B46F-2F04DAF80BB4}"/>
          </ac:cxnSpMkLst>
        </pc:cxnChg>
        <pc:cxnChg chg="mod">
          <ac:chgData name="Narang, Sonali" userId="9e80b397-6e2f-49b1-9374-ccdad8589140" providerId="ADAL" clId="{0B7BE2FF-CA73-044A-832B-45D8C814BD66}" dt="2021-04-28T17:54:49.569" v="15" actId="1038"/>
          <ac:cxnSpMkLst>
            <pc:docMk/>
            <pc:sldMk cId="3911031167" sldId="256"/>
            <ac:cxnSpMk id="38" creationId="{D04C5AB0-7A62-3C42-BF5B-34A34D45C193}"/>
          </ac:cxnSpMkLst>
        </pc:cxnChg>
        <pc:cxnChg chg="add mod">
          <ac:chgData name="Narang, Sonali" userId="9e80b397-6e2f-49b1-9374-ccdad8589140" providerId="ADAL" clId="{0B7BE2FF-CA73-044A-832B-45D8C814BD66}" dt="2021-05-24T18:40:01.741" v="1481" actId="1038"/>
          <ac:cxnSpMkLst>
            <pc:docMk/>
            <pc:sldMk cId="3911031167" sldId="256"/>
            <ac:cxnSpMk id="124" creationId="{E6385412-B994-9D48-A674-AB23DE9E4E4B}"/>
          </ac:cxnSpMkLst>
        </pc:cxnChg>
        <pc:cxnChg chg="add mod">
          <ac:chgData name="Narang, Sonali" userId="9e80b397-6e2f-49b1-9374-ccdad8589140" providerId="ADAL" clId="{0B7BE2FF-CA73-044A-832B-45D8C814BD66}" dt="2021-05-24T18:40:01.741" v="1481" actId="1038"/>
          <ac:cxnSpMkLst>
            <pc:docMk/>
            <pc:sldMk cId="3911031167" sldId="256"/>
            <ac:cxnSpMk id="125" creationId="{F503F789-7260-9240-8C91-76C8BA2549A0}"/>
          </ac:cxnSpMkLst>
        </pc:cxnChg>
      </pc:sldChg>
      <pc:sldChg chg="addSp delSp modSp mod ord">
        <pc:chgData name="Narang, Sonali" userId="9e80b397-6e2f-49b1-9374-ccdad8589140" providerId="ADAL" clId="{0B7BE2FF-CA73-044A-832B-45D8C814BD66}" dt="2021-05-27T14:02:27.447" v="1935" actId="1076"/>
        <pc:sldMkLst>
          <pc:docMk/>
          <pc:sldMk cId="1854626235" sldId="257"/>
        </pc:sldMkLst>
        <pc:spChg chg="mod">
          <ac:chgData name="Narang, Sonali" userId="9e80b397-6e2f-49b1-9374-ccdad8589140" providerId="ADAL" clId="{0B7BE2FF-CA73-044A-832B-45D8C814BD66}" dt="2021-05-24T21:59:12.394" v="1785" actId="1076"/>
          <ac:spMkLst>
            <pc:docMk/>
            <pc:sldMk cId="1854626235" sldId="257"/>
            <ac:spMk id="4" creationId="{F6669B9D-B042-D548-BD0F-97015091799B}"/>
          </ac:spMkLst>
        </pc:spChg>
        <pc:spChg chg="mod">
          <ac:chgData name="Narang, Sonali" userId="9e80b397-6e2f-49b1-9374-ccdad8589140" providerId="ADAL" clId="{0B7BE2FF-CA73-044A-832B-45D8C814BD66}" dt="2021-05-24T21:59:19.480" v="1786" actId="1076"/>
          <ac:spMkLst>
            <pc:docMk/>
            <pc:sldMk cId="1854626235" sldId="257"/>
            <ac:spMk id="5" creationId="{FAFFEC37-A0C5-5846-8534-22E3DEF6CEF4}"/>
          </ac:spMkLst>
        </pc:spChg>
        <pc:spChg chg="mod">
          <ac:chgData name="Narang, Sonali" userId="9e80b397-6e2f-49b1-9374-ccdad8589140" providerId="ADAL" clId="{0B7BE2FF-CA73-044A-832B-45D8C814BD66}" dt="2021-05-24T21:59:19.480" v="1786" actId="1076"/>
          <ac:spMkLst>
            <pc:docMk/>
            <pc:sldMk cId="1854626235" sldId="257"/>
            <ac:spMk id="6" creationId="{41464C80-B659-484D-A16F-8018DEC5471A}"/>
          </ac:spMkLst>
        </pc:spChg>
        <pc:spChg chg="mod">
          <ac:chgData name="Narang, Sonali" userId="9e80b397-6e2f-49b1-9374-ccdad8589140" providerId="ADAL" clId="{0B7BE2FF-CA73-044A-832B-45D8C814BD66}" dt="2021-05-24T21:59:33.321" v="1788" actId="1076"/>
          <ac:spMkLst>
            <pc:docMk/>
            <pc:sldMk cId="1854626235" sldId="257"/>
            <ac:spMk id="7" creationId="{4C5F5CAE-FBFD-964D-A356-746AAC86DC9E}"/>
          </ac:spMkLst>
        </pc:spChg>
        <pc:spChg chg="mod">
          <ac:chgData name="Narang, Sonali" userId="9e80b397-6e2f-49b1-9374-ccdad8589140" providerId="ADAL" clId="{0B7BE2FF-CA73-044A-832B-45D8C814BD66}" dt="2021-05-24T21:59:40.750" v="1789" actId="1076"/>
          <ac:spMkLst>
            <pc:docMk/>
            <pc:sldMk cId="1854626235" sldId="257"/>
            <ac:spMk id="8" creationId="{8A9BAE78-C4FF-1843-94F6-3410EB884848}"/>
          </ac:spMkLst>
        </pc:spChg>
        <pc:spChg chg="add del mod">
          <ac:chgData name="Narang, Sonali" userId="9e80b397-6e2f-49b1-9374-ccdad8589140" providerId="ADAL" clId="{0B7BE2FF-CA73-044A-832B-45D8C814BD66}" dt="2021-05-24T17:06:57.915" v="1351" actId="478"/>
          <ac:spMkLst>
            <pc:docMk/>
            <pc:sldMk cId="1854626235" sldId="257"/>
            <ac:spMk id="22" creationId="{320B15F1-B95C-B145-B377-78CDF54B2C66}"/>
          </ac:spMkLst>
        </pc:spChg>
        <pc:spChg chg="add del mod">
          <ac:chgData name="Narang, Sonali" userId="9e80b397-6e2f-49b1-9374-ccdad8589140" providerId="ADAL" clId="{0B7BE2FF-CA73-044A-832B-45D8C814BD66}" dt="2021-05-06T19:57:47.386" v="1007"/>
          <ac:spMkLst>
            <pc:docMk/>
            <pc:sldMk cId="1854626235" sldId="257"/>
            <ac:spMk id="23" creationId="{B9A184F0-889E-6842-AB7A-6C22C638908F}"/>
          </ac:spMkLst>
        </pc:spChg>
        <pc:spChg chg="add del mod">
          <ac:chgData name="Narang, Sonali" userId="9e80b397-6e2f-49b1-9374-ccdad8589140" providerId="ADAL" clId="{0B7BE2FF-CA73-044A-832B-45D8C814BD66}" dt="2021-05-06T21:27:22.947" v="1083"/>
          <ac:spMkLst>
            <pc:docMk/>
            <pc:sldMk cId="1854626235" sldId="257"/>
            <ac:spMk id="36" creationId="{C316DBD8-CC34-7D42-95FD-2D7659D394DF}"/>
          </ac:spMkLst>
        </pc:spChg>
        <pc:spChg chg="mod">
          <ac:chgData name="Narang, Sonali" userId="9e80b397-6e2f-49b1-9374-ccdad8589140" providerId="ADAL" clId="{0B7BE2FF-CA73-044A-832B-45D8C814BD66}" dt="2021-05-07T14:59:55.409" v="1160" actId="1076"/>
          <ac:spMkLst>
            <pc:docMk/>
            <pc:sldMk cId="1854626235" sldId="257"/>
            <ac:spMk id="38" creationId="{5DEC1EB7-09AC-A246-AA4B-4356C08FE790}"/>
          </ac:spMkLst>
        </pc:spChg>
        <pc:spChg chg="mod">
          <ac:chgData name="Narang, Sonali" userId="9e80b397-6e2f-49b1-9374-ccdad8589140" providerId="ADAL" clId="{0B7BE2FF-CA73-044A-832B-45D8C814BD66}" dt="2021-05-07T14:59:55.409" v="1160" actId="1076"/>
          <ac:spMkLst>
            <pc:docMk/>
            <pc:sldMk cId="1854626235" sldId="257"/>
            <ac:spMk id="39" creationId="{A8B5930C-6DB0-8E49-93D4-BC9683A586FB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2" creationId="{9A612538-A340-3F4F-82F9-80593ED82B31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3" creationId="{C914DB7E-1A01-FD47-AC9D-353A004725F2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4" creationId="{33D7B724-8CAF-C44A-A09B-08B1ADC9FEE7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5" creationId="{F03CAA07-79DE-C747-9262-7CC3FA4FE62E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6" creationId="{61BD717A-09EE-AB45-87B7-345DFC2A9A65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47" creationId="{E25BC120-0007-C240-BB61-90F7D4216E78}"/>
          </ac:spMkLst>
        </pc:spChg>
        <pc:spChg chg="mod">
          <ac:chgData name="Narang, Sonali" userId="9e80b397-6e2f-49b1-9374-ccdad8589140" providerId="ADAL" clId="{0B7BE2FF-CA73-044A-832B-45D8C814BD66}" dt="2021-05-24T13:41:34.160" v="1282" actId="1076"/>
          <ac:spMkLst>
            <pc:docMk/>
            <pc:sldMk cId="1854626235" sldId="257"/>
            <ac:spMk id="49" creationId="{0AB8D4B3-DF49-C441-B8C8-1A7712A40DCB}"/>
          </ac:spMkLst>
        </pc:spChg>
        <pc:spChg chg="mod">
          <ac:chgData name="Narang, Sonali" userId="9e80b397-6e2f-49b1-9374-ccdad8589140" providerId="ADAL" clId="{0B7BE2FF-CA73-044A-832B-45D8C814BD66}" dt="2021-05-24T13:40:35.391" v="1261" actId="20577"/>
          <ac:spMkLst>
            <pc:docMk/>
            <pc:sldMk cId="1854626235" sldId="257"/>
            <ac:spMk id="50" creationId="{2CD717FA-25C1-8A46-83D8-D9B9D4B5D60D}"/>
          </ac:spMkLst>
        </pc:spChg>
        <pc:spChg chg="mod">
          <ac:chgData name="Narang, Sonali" userId="9e80b397-6e2f-49b1-9374-ccdad8589140" providerId="ADAL" clId="{0B7BE2FF-CA73-044A-832B-45D8C814BD66}" dt="2021-05-24T13:40:44.784" v="1269" actId="20577"/>
          <ac:spMkLst>
            <pc:docMk/>
            <pc:sldMk cId="1854626235" sldId="257"/>
            <ac:spMk id="51" creationId="{19F8C0D6-9CDF-1945-A87D-D37629D51F61}"/>
          </ac:spMkLst>
        </pc:spChg>
        <pc:spChg chg="mod">
          <ac:chgData name="Narang, Sonali" userId="9e80b397-6e2f-49b1-9374-ccdad8589140" providerId="ADAL" clId="{0B7BE2FF-CA73-044A-832B-45D8C814BD66}" dt="2021-05-24T13:41:23.356" v="1281" actId="1076"/>
          <ac:spMkLst>
            <pc:docMk/>
            <pc:sldMk cId="1854626235" sldId="257"/>
            <ac:spMk id="52" creationId="{29768CF3-BCEE-B243-B95A-E36F3DD479C4}"/>
          </ac:spMkLst>
        </pc:spChg>
        <pc:spChg chg="mod">
          <ac:chgData name="Narang, Sonali" userId="9e80b397-6e2f-49b1-9374-ccdad8589140" providerId="ADAL" clId="{0B7BE2FF-CA73-044A-832B-45D8C814BD66}" dt="2021-05-24T13:41:44.799" v="1284" actId="1076"/>
          <ac:spMkLst>
            <pc:docMk/>
            <pc:sldMk cId="1854626235" sldId="257"/>
            <ac:spMk id="53" creationId="{3948E009-D2BC-4345-BEB6-2FA9903759FB}"/>
          </ac:spMkLst>
        </pc:spChg>
        <pc:spChg chg="mod">
          <ac:chgData name="Narang, Sonali" userId="9e80b397-6e2f-49b1-9374-ccdad8589140" providerId="ADAL" clId="{0B7BE2FF-CA73-044A-832B-45D8C814BD66}" dt="2021-05-24T13:41:49.625" v="1285" actId="1076"/>
          <ac:spMkLst>
            <pc:docMk/>
            <pc:sldMk cId="1854626235" sldId="257"/>
            <ac:spMk id="54" creationId="{DB7BF86B-8350-6246-9BA3-F9C84105BC94}"/>
          </ac:spMkLst>
        </pc:spChg>
        <pc:spChg chg="mod">
          <ac:chgData name="Narang, Sonali" userId="9e80b397-6e2f-49b1-9374-ccdad8589140" providerId="ADAL" clId="{0B7BE2FF-CA73-044A-832B-45D8C814BD66}" dt="2021-05-24T13:41:07.521" v="1276" actId="1076"/>
          <ac:spMkLst>
            <pc:docMk/>
            <pc:sldMk cId="1854626235" sldId="257"/>
            <ac:spMk id="55" creationId="{9869DAE6-DAAB-3E46-A071-34CEDAC9026D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56" creationId="{F3C8BA3E-7F1B-E34D-9C51-61AE3654C96D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57" creationId="{F7F0031B-96C4-044B-99D5-1AFE0D23C5BA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58" creationId="{DEC70FC9-FD4B-3B4A-96B4-B397B771D2DC}"/>
          </ac:spMkLst>
        </pc:spChg>
        <pc:spChg chg="mod">
          <ac:chgData name="Narang, Sonali" userId="9e80b397-6e2f-49b1-9374-ccdad8589140" providerId="ADAL" clId="{0B7BE2FF-CA73-044A-832B-45D8C814BD66}" dt="2021-05-24T13:39:03.393" v="1240" actId="1076"/>
          <ac:spMkLst>
            <pc:docMk/>
            <pc:sldMk cId="1854626235" sldId="257"/>
            <ac:spMk id="60" creationId="{0749DC11-81E8-324C-8540-CA71FA7D76E8}"/>
          </ac:spMkLst>
        </pc:spChg>
        <pc:spChg chg="mod">
          <ac:chgData name="Narang, Sonali" userId="9e80b397-6e2f-49b1-9374-ccdad8589140" providerId="ADAL" clId="{0B7BE2FF-CA73-044A-832B-45D8C814BD66}" dt="2021-05-24T13:38:36.545" v="1235" actId="20577"/>
          <ac:spMkLst>
            <pc:docMk/>
            <pc:sldMk cId="1854626235" sldId="257"/>
            <ac:spMk id="61" creationId="{709D742F-24F9-1641-9DFA-3E1BD1B68BA5}"/>
          </ac:spMkLst>
        </pc:spChg>
        <pc:spChg chg="mod">
          <ac:chgData name="Narang, Sonali" userId="9e80b397-6e2f-49b1-9374-ccdad8589140" providerId="ADAL" clId="{0B7BE2FF-CA73-044A-832B-45D8C814BD66}" dt="2021-05-24T13:39:07.067" v="1241" actId="1076"/>
          <ac:spMkLst>
            <pc:docMk/>
            <pc:sldMk cId="1854626235" sldId="257"/>
            <ac:spMk id="62" creationId="{E9BE53A6-D920-424F-A508-507E234B764F}"/>
          </ac:spMkLst>
        </pc:spChg>
        <pc:spChg chg="mod">
          <ac:chgData name="Narang, Sonali" userId="9e80b397-6e2f-49b1-9374-ccdad8589140" providerId="ADAL" clId="{0B7BE2FF-CA73-044A-832B-45D8C814BD66}" dt="2021-05-24T13:38:51.623" v="1238" actId="1076"/>
          <ac:spMkLst>
            <pc:docMk/>
            <pc:sldMk cId="1854626235" sldId="257"/>
            <ac:spMk id="63" creationId="{CEB714C8-054C-9F4F-9B00-D9096547F3CD}"/>
          </ac:spMkLst>
        </pc:spChg>
        <pc:spChg chg="mod">
          <ac:chgData name="Narang, Sonali" userId="9e80b397-6e2f-49b1-9374-ccdad8589140" providerId="ADAL" clId="{0B7BE2FF-CA73-044A-832B-45D8C814BD66}" dt="2021-05-24T13:38:42.495" v="1236" actId="1076"/>
          <ac:spMkLst>
            <pc:docMk/>
            <pc:sldMk cId="1854626235" sldId="257"/>
            <ac:spMk id="64" creationId="{5B648410-CCBA-D341-9786-D4905C8612A3}"/>
          </ac:spMkLst>
        </pc:spChg>
        <pc:spChg chg="mod">
          <ac:chgData name="Narang, Sonali" userId="9e80b397-6e2f-49b1-9374-ccdad8589140" providerId="ADAL" clId="{0B7BE2FF-CA73-044A-832B-45D8C814BD66}" dt="2021-05-24T13:38:47.691" v="1237" actId="1076"/>
          <ac:spMkLst>
            <pc:docMk/>
            <pc:sldMk cId="1854626235" sldId="257"/>
            <ac:spMk id="65" creationId="{E5F24BA2-71B6-FE48-858D-A6BE10A9FF57}"/>
          </ac:spMkLst>
        </pc:spChg>
        <pc:spChg chg="mod">
          <ac:chgData name="Narang, Sonali" userId="9e80b397-6e2f-49b1-9374-ccdad8589140" providerId="ADAL" clId="{0B7BE2FF-CA73-044A-832B-45D8C814BD66}" dt="2021-05-24T13:38:59.319" v="1239" actId="1076"/>
          <ac:spMkLst>
            <pc:docMk/>
            <pc:sldMk cId="1854626235" sldId="257"/>
            <ac:spMk id="66" creationId="{CE8A6716-1C5D-D345-846E-77B398AC7E63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67" creationId="{9ADA499E-5B6F-4B4A-B023-19AFCC0FA2F3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68" creationId="{D223DDBF-0130-204B-BC3A-5696633A6FED}"/>
          </ac:spMkLst>
        </pc:spChg>
        <pc:spChg chg="mod">
          <ac:chgData name="Narang, Sonali" userId="9e80b397-6e2f-49b1-9374-ccdad8589140" providerId="ADAL" clId="{0B7BE2FF-CA73-044A-832B-45D8C814BD66}" dt="2021-05-07T14:59:05.971" v="1099"/>
          <ac:spMkLst>
            <pc:docMk/>
            <pc:sldMk cId="1854626235" sldId="257"/>
            <ac:spMk id="69" creationId="{F99DF66F-5AE0-5B49-8603-BECAD3E916C5}"/>
          </ac:spMkLst>
        </pc:spChg>
        <pc:spChg chg="add mod">
          <ac:chgData name="Narang, Sonali" userId="9e80b397-6e2f-49b1-9374-ccdad8589140" providerId="ADAL" clId="{0B7BE2FF-CA73-044A-832B-45D8C814BD66}" dt="2021-05-24T21:59:40.750" v="1789" actId="1076"/>
          <ac:spMkLst>
            <pc:docMk/>
            <pc:sldMk cId="1854626235" sldId="257"/>
            <ac:spMk id="70" creationId="{B246B051-DD4B-294D-B265-38CF288C0C5A}"/>
          </ac:spMkLst>
        </pc:spChg>
        <pc:spChg chg="add mod">
          <ac:chgData name="Narang, Sonali" userId="9e80b397-6e2f-49b1-9374-ccdad8589140" providerId="ADAL" clId="{0B7BE2FF-CA73-044A-832B-45D8C814BD66}" dt="2021-05-24T22:00:20.621" v="1798" actId="1076"/>
          <ac:spMkLst>
            <pc:docMk/>
            <pc:sldMk cId="1854626235" sldId="257"/>
            <ac:spMk id="71" creationId="{BDCB7AA1-749D-8C43-AF10-858D8E39FF31}"/>
          </ac:spMkLst>
        </pc:spChg>
        <pc:spChg chg="add mod">
          <ac:chgData name="Narang, Sonali" userId="9e80b397-6e2f-49b1-9374-ccdad8589140" providerId="ADAL" clId="{0B7BE2FF-CA73-044A-832B-45D8C814BD66}" dt="2021-05-24T20:12:08.276" v="1588" actId="1076"/>
          <ac:spMkLst>
            <pc:docMk/>
            <pc:sldMk cId="1854626235" sldId="257"/>
            <ac:spMk id="78" creationId="{AE692B16-99A6-5F46-AC90-BC9F8991FE3A}"/>
          </ac:spMkLst>
        </pc:spChg>
        <pc:spChg chg="add mod">
          <ac:chgData name="Narang, Sonali" userId="9e80b397-6e2f-49b1-9374-ccdad8589140" providerId="ADAL" clId="{0B7BE2FF-CA73-044A-832B-45D8C814BD66}" dt="2021-05-24T20:12:08.276" v="1588" actId="1076"/>
          <ac:spMkLst>
            <pc:docMk/>
            <pc:sldMk cId="1854626235" sldId="257"/>
            <ac:spMk id="79" creationId="{4CA9431C-F615-6544-91AF-8E63590AD04C}"/>
          </ac:spMkLst>
        </pc:spChg>
        <pc:spChg chg="add mod">
          <ac:chgData name="Narang, Sonali" userId="9e80b397-6e2f-49b1-9374-ccdad8589140" providerId="ADAL" clId="{0B7BE2FF-CA73-044A-832B-45D8C814BD66}" dt="2021-05-24T22:02:47.205" v="1820" actId="1036"/>
          <ac:spMkLst>
            <pc:docMk/>
            <pc:sldMk cId="1854626235" sldId="257"/>
            <ac:spMk id="80" creationId="{EEAFDDE8-7674-C440-99B7-B7430DE40677}"/>
          </ac:spMkLst>
        </pc:spChg>
        <pc:spChg chg="add mod">
          <ac:chgData name="Narang, Sonali" userId="9e80b397-6e2f-49b1-9374-ccdad8589140" providerId="ADAL" clId="{0B7BE2FF-CA73-044A-832B-45D8C814BD66}" dt="2021-05-24T22:02:43.295" v="1817" actId="1036"/>
          <ac:spMkLst>
            <pc:docMk/>
            <pc:sldMk cId="1854626235" sldId="257"/>
            <ac:spMk id="81" creationId="{A40B4853-301D-5B45-B69D-BEA17B88E1A1}"/>
          </ac:spMkLst>
        </pc:spChg>
        <pc:spChg chg="add mod">
          <ac:chgData name="Narang, Sonali" userId="9e80b397-6e2f-49b1-9374-ccdad8589140" providerId="ADAL" clId="{0B7BE2FF-CA73-044A-832B-45D8C814BD66}" dt="2021-05-24T21:53:41.130" v="1743" actId="1076"/>
          <ac:spMkLst>
            <pc:docMk/>
            <pc:sldMk cId="1854626235" sldId="257"/>
            <ac:spMk id="82" creationId="{10CF5DC1-A0FF-4D44-8B98-250CED7C2315}"/>
          </ac:spMkLst>
        </pc:spChg>
        <pc:spChg chg="add mod">
          <ac:chgData name="Narang, Sonali" userId="9e80b397-6e2f-49b1-9374-ccdad8589140" providerId="ADAL" clId="{0B7BE2FF-CA73-044A-832B-45D8C814BD66}" dt="2021-05-24T21:53:41.130" v="1743" actId="1076"/>
          <ac:spMkLst>
            <pc:docMk/>
            <pc:sldMk cId="1854626235" sldId="257"/>
            <ac:spMk id="83" creationId="{86E9338F-A08A-0C44-ACC7-6FA6090DD2A4}"/>
          </ac:spMkLst>
        </pc:spChg>
        <pc:spChg chg="add mod topLvl">
          <ac:chgData name="Narang, Sonali" userId="9e80b397-6e2f-49b1-9374-ccdad8589140" providerId="ADAL" clId="{0B7BE2FF-CA73-044A-832B-45D8C814BD66}" dt="2021-05-24T22:02:27.687" v="1810" actId="1076"/>
          <ac:spMkLst>
            <pc:docMk/>
            <pc:sldMk cId="1854626235" sldId="257"/>
            <ac:spMk id="99" creationId="{35554AB1-82A6-E844-8E2E-A98A1296D586}"/>
          </ac:spMkLst>
        </pc:spChg>
        <pc:spChg chg="add mod topLvl">
          <ac:chgData name="Narang, Sonali" userId="9e80b397-6e2f-49b1-9374-ccdad8589140" providerId="ADAL" clId="{0B7BE2FF-CA73-044A-832B-45D8C814BD66}" dt="2021-05-24T22:02:22.277" v="1809" actId="1076"/>
          <ac:spMkLst>
            <pc:docMk/>
            <pc:sldMk cId="1854626235" sldId="257"/>
            <ac:spMk id="100" creationId="{4760897C-1897-534A-9E74-D426D57D9B46}"/>
          </ac:spMkLst>
        </pc:spChg>
        <pc:spChg chg="add del mod">
          <ac:chgData name="Narang, Sonali" userId="9e80b397-6e2f-49b1-9374-ccdad8589140" providerId="ADAL" clId="{0B7BE2FF-CA73-044A-832B-45D8C814BD66}" dt="2021-05-24T20:45:03.858" v="1680"/>
          <ac:spMkLst>
            <pc:docMk/>
            <pc:sldMk cId="1854626235" sldId="257"/>
            <ac:spMk id="102" creationId="{5B506C92-5C0B-414A-B290-4CA275B62573}"/>
          </ac:spMkLst>
        </pc:spChg>
        <pc:spChg chg="add mod">
          <ac:chgData name="Narang, Sonali" userId="9e80b397-6e2f-49b1-9374-ccdad8589140" providerId="ADAL" clId="{0B7BE2FF-CA73-044A-832B-45D8C814BD66}" dt="2021-05-24T22:00:33.591" v="1802" actId="20577"/>
          <ac:spMkLst>
            <pc:docMk/>
            <pc:sldMk cId="1854626235" sldId="257"/>
            <ac:spMk id="113" creationId="{426C9910-5D3A-7B42-9C66-E53AF38D5621}"/>
          </ac:spMkLst>
        </pc:spChg>
        <pc:grpChg chg="add del mod">
          <ac:chgData name="Narang, Sonali" userId="9e80b397-6e2f-49b1-9374-ccdad8589140" providerId="ADAL" clId="{0B7BE2FF-CA73-044A-832B-45D8C814BD66}" dt="2021-05-24T17:48:19.832" v="1365" actId="478"/>
          <ac:grpSpMkLst>
            <pc:docMk/>
            <pc:sldMk cId="1854626235" sldId="257"/>
            <ac:grpSpMk id="21" creationId="{C3B6CF52-F7C8-E24D-930F-85E0486C7AEF}"/>
          </ac:grpSpMkLst>
        </pc:grpChg>
        <pc:grpChg chg="add mod">
          <ac:chgData name="Narang, Sonali" userId="9e80b397-6e2f-49b1-9374-ccdad8589140" providerId="ADAL" clId="{0B7BE2FF-CA73-044A-832B-45D8C814BD66}" dt="2021-05-24T21:59:40.750" v="1789" actId="1076"/>
          <ac:grpSpMkLst>
            <pc:docMk/>
            <pc:sldMk cId="1854626235" sldId="257"/>
            <ac:grpSpMk id="37" creationId="{083D8F37-8390-5541-85CA-5DB8B6ACA03B}"/>
          </ac:grpSpMkLst>
        </pc:grpChg>
        <pc:grpChg chg="mod">
          <ac:chgData name="Narang, Sonali" userId="9e80b397-6e2f-49b1-9374-ccdad8589140" providerId="ADAL" clId="{0B7BE2FF-CA73-044A-832B-45D8C814BD66}" dt="2021-05-07T14:59:05.971" v="1099"/>
          <ac:grpSpMkLst>
            <pc:docMk/>
            <pc:sldMk cId="1854626235" sldId="257"/>
            <ac:grpSpMk id="40" creationId="{87C58C7B-4597-E249-BAAD-7BD66AC7CBBF}"/>
          </ac:grpSpMkLst>
        </pc:grpChg>
        <pc:grpChg chg="mod">
          <ac:chgData name="Narang, Sonali" userId="9e80b397-6e2f-49b1-9374-ccdad8589140" providerId="ADAL" clId="{0B7BE2FF-CA73-044A-832B-45D8C814BD66}" dt="2021-05-07T14:59:05.971" v="1099"/>
          <ac:grpSpMkLst>
            <pc:docMk/>
            <pc:sldMk cId="1854626235" sldId="257"/>
            <ac:grpSpMk id="41" creationId="{7FB2B275-4687-8143-9125-2B8A2EB53E53}"/>
          </ac:grpSpMkLst>
        </pc:grpChg>
        <pc:grpChg chg="mod">
          <ac:chgData name="Narang, Sonali" userId="9e80b397-6e2f-49b1-9374-ccdad8589140" providerId="ADAL" clId="{0B7BE2FF-CA73-044A-832B-45D8C814BD66}" dt="2021-05-07T14:59:05.971" v="1099"/>
          <ac:grpSpMkLst>
            <pc:docMk/>
            <pc:sldMk cId="1854626235" sldId="257"/>
            <ac:grpSpMk id="48" creationId="{947BFC1E-61C1-E24F-87F3-B7D677B4E0E0}"/>
          </ac:grpSpMkLst>
        </pc:grpChg>
        <pc:grpChg chg="mod">
          <ac:chgData name="Narang, Sonali" userId="9e80b397-6e2f-49b1-9374-ccdad8589140" providerId="ADAL" clId="{0B7BE2FF-CA73-044A-832B-45D8C814BD66}" dt="2021-05-07T14:59:05.971" v="1099"/>
          <ac:grpSpMkLst>
            <pc:docMk/>
            <pc:sldMk cId="1854626235" sldId="257"/>
            <ac:grpSpMk id="59" creationId="{A91940CF-F435-9B49-BE9E-A55008E641F1}"/>
          </ac:grpSpMkLst>
        </pc:grpChg>
        <pc:grpChg chg="add mod">
          <ac:chgData name="Narang, Sonali" userId="9e80b397-6e2f-49b1-9374-ccdad8589140" providerId="ADAL" clId="{0B7BE2FF-CA73-044A-832B-45D8C814BD66}" dt="2021-05-24T21:59:33.321" v="1788" actId="1076"/>
          <ac:grpSpMkLst>
            <pc:docMk/>
            <pc:sldMk cId="1854626235" sldId="257"/>
            <ac:grpSpMk id="94" creationId="{AEE6DF85-0659-484C-AB45-73FA6E20C5C4}"/>
          </ac:grpSpMkLst>
        </pc:grpChg>
        <pc:grpChg chg="add del mod">
          <ac:chgData name="Narang, Sonali" userId="9e80b397-6e2f-49b1-9374-ccdad8589140" providerId="ADAL" clId="{0B7BE2FF-CA73-044A-832B-45D8C814BD66}" dt="2021-05-24T22:02:08.389" v="1805" actId="165"/>
          <ac:grpSpMkLst>
            <pc:docMk/>
            <pc:sldMk cId="1854626235" sldId="257"/>
            <ac:grpSpMk id="101" creationId="{28456E5D-CFA2-5B4A-B66F-A05F7A030F17}"/>
          </ac:grpSpMkLst>
        </pc:grpChg>
        <pc:picChg chg="add del mod">
          <ac:chgData name="Narang, Sonali" userId="9e80b397-6e2f-49b1-9374-ccdad8589140" providerId="ADAL" clId="{0B7BE2FF-CA73-044A-832B-45D8C814BD66}" dt="2021-05-06T19:47:06.139" v="943" actId="478"/>
          <ac:picMkLst>
            <pc:docMk/>
            <pc:sldMk cId="1854626235" sldId="257"/>
            <ac:picMk id="3" creationId="{A343E00C-E03B-7348-AEF6-CC586054F40D}"/>
          </ac:picMkLst>
        </pc:picChg>
        <pc:picChg chg="add del mod modCrop">
          <ac:chgData name="Narang, Sonali" userId="9e80b397-6e2f-49b1-9374-ccdad8589140" providerId="ADAL" clId="{0B7BE2FF-CA73-044A-832B-45D8C814BD66}" dt="2021-05-06T19:47:06.139" v="943" actId="478"/>
          <ac:picMkLst>
            <pc:docMk/>
            <pc:sldMk cId="1854626235" sldId="257"/>
            <ac:picMk id="10" creationId="{3262F4AC-ADDC-204F-96F4-AAFAD4BBD225}"/>
          </ac:picMkLst>
        </pc:picChg>
        <pc:picChg chg="add del mod modCrop">
          <ac:chgData name="Narang, Sonali" userId="9e80b397-6e2f-49b1-9374-ccdad8589140" providerId="ADAL" clId="{0B7BE2FF-CA73-044A-832B-45D8C814BD66}" dt="2021-05-06T19:47:06.139" v="943" actId="478"/>
          <ac:picMkLst>
            <pc:docMk/>
            <pc:sldMk cId="1854626235" sldId="257"/>
            <ac:picMk id="12" creationId="{90C5CEA4-C064-414A-AD25-824D3957F7BF}"/>
          </ac:picMkLst>
        </pc:picChg>
        <pc:picChg chg="add mod topLvl modCrop">
          <ac:chgData name="Narang, Sonali" userId="9e80b397-6e2f-49b1-9374-ccdad8589140" providerId="ADAL" clId="{0B7BE2FF-CA73-044A-832B-45D8C814BD66}" dt="2021-05-24T20:12:09.470" v="1592" actId="1076"/>
          <ac:picMkLst>
            <pc:docMk/>
            <pc:sldMk cId="1854626235" sldId="257"/>
            <ac:picMk id="14" creationId="{681572D7-6CDF-C840-9149-C3423BBB2368}"/>
          </ac:picMkLst>
        </pc:picChg>
        <pc:picChg chg="add del mod modCrop">
          <ac:chgData name="Narang, Sonali" userId="9e80b397-6e2f-49b1-9374-ccdad8589140" providerId="ADAL" clId="{0B7BE2FF-CA73-044A-832B-45D8C814BD66}" dt="2021-05-24T17:48:19.832" v="1365" actId="478"/>
          <ac:picMkLst>
            <pc:docMk/>
            <pc:sldMk cId="1854626235" sldId="257"/>
            <ac:picMk id="16" creationId="{118C1843-684D-6B41-9920-009238D7C544}"/>
          </ac:picMkLst>
        </pc:picChg>
        <pc:picChg chg="add del mod modCrop">
          <ac:chgData name="Narang, Sonali" userId="9e80b397-6e2f-49b1-9374-ccdad8589140" providerId="ADAL" clId="{0B7BE2FF-CA73-044A-832B-45D8C814BD66}" dt="2021-05-24T17:48:19.832" v="1365" actId="478"/>
          <ac:picMkLst>
            <pc:docMk/>
            <pc:sldMk cId="1854626235" sldId="257"/>
            <ac:picMk id="18" creationId="{C7ECB941-559B-2D49-9218-A095168124DA}"/>
          </ac:picMkLst>
        </pc:picChg>
        <pc:picChg chg="add del mod topLvl">
          <ac:chgData name="Narang, Sonali" userId="9e80b397-6e2f-49b1-9374-ccdad8589140" providerId="ADAL" clId="{0B7BE2FF-CA73-044A-832B-45D8C814BD66}" dt="2021-05-24T17:48:19.832" v="1365" actId="478"/>
          <ac:picMkLst>
            <pc:docMk/>
            <pc:sldMk cId="1854626235" sldId="257"/>
            <ac:picMk id="20" creationId="{65EF347B-4B4D-0944-B7D3-7AA97F4ED9DD}"/>
          </ac:picMkLst>
        </pc:picChg>
        <pc:picChg chg="add del mod">
          <ac:chgData name="Narang, Sonali" userId="9e80b397-6e2f-49b1-9374-ccdad8589140" providerId="ADAL" clId="{0B7BE2FF-CA73-044A-832B-45D8C814BD66}" dt="2021-05-06T20:26:19.573" v="1025" actId="478"/>
          <ac:picMkLst>
            <pc:docMk/>
            <pc:sldMk cId="1854626235" sldId="257"/>
            <ac:picMk id="25" creationId="{82AE4415-7AD3-6449-919C-37EFC796314B}"/>
          </ac:picMkLst>
        </pc:picChg>
        <pc:picChg chg="add del mod">
          <ac:chgData name="Narang, Sonali" userId="9e80b397-6e2f-49b1-9374-ccdad8589140" providerId="ADAL" clId="{0B7BE2FF-CA73-044A-832B-45D8C814BD66}" dt="2021-05-06T20:26:43.717" v="1034" actId="478"/>
          <ac:picMkLst>
            <pc:docMk/>
            <pc:sldMk cId="1854626235" sldId="257"/>
            <ac:picMk id="27" creationId="{3F32CEE2-D040-4D48-A6F3-966D311406C4}"/>
          </ac:picMkLst>
        </pc:picChg>
        <pc:picChg chg="add del mod">
          <ac:chgData name="Narang, Sonali" userId="9e80b397-6e2f-49b1-9374-ccdad8589140" providerId="ADAL" clId="{0B7BE2FF-CA73-044A-832B-45D8C814BD66}" dt="2021-05-06T20:28:39.860" v="1041" actId="478"/>
          <ac:picMkLst>
            <pc:docMk/>
            <pc:sldMk cId="1854626235" sldId="257"/>
            <ac:picMk id="29" creationId="{04ADDA16-A852-7F4F-9076-5B190BC549CE}"/>
          </ac:picMkLst>
        </pc:picChg>
        <pc:picChg chg="add del mod">
          <ac:chgData name="Narang, Sonali" userId="9e80b397-6e2f-49b1-9374-ccdad8589140" providerId="ADAL" clId="{0B7BE2FF-CA73-044A-832B-45D8C814BD66}" dt="2021-05-06T20:30:09.520" v="1051" actId="478"/>
          <ac:picMkLst>
            <pc:docMk/>
            <pc:sldMk cId="1854626235" sldId="257"/>
            <ac:picMk id="31" creationId="{90DA9AEC-3FED-B24E-8D3D-E56447BF1D6E}"/>
          </ac:picMkLst>
        </pc:picChg>
        <pc:picChg chg="add del mod">
          <ac:chgData name="Narang, Sonali" userId="9e80b397-6e2f-49b1-9374-ccdad8589140" providerId="ADAL" clId="{0B7BE2FF-CA73-044A-832B-45D8C814BD66}" dt="2021-05-06T20:44:49.431" v="1066" actId="478"/>
          <ac:picMkLst>
            <pc:docMk/>
            <pc:sldMk cId="1854626235" sldId="257"/>
            <ac:picMk id="33" creationId="{C6ABF6C5-0955-AA4E-818F-FCE4A8B943C5}"/>
          </ac:picMkLst>
        </pc:picChg>
        <pc:picChg chg="add del mod">
          <ac:chgData name="Narang, Sonali" userId="9e80b397-6e2f-49b1-9374-ccdad8589140" providerId="ADAL" clId="{0B7BE2FF-CA73-044A-832B-45D8C814BD66}" dt="2021-05-24T12:48:26.103" v="1170" actId="478"/>
          <ac:picMkLst>
            <pc:docMk/>
            <pc:sldMk cId="1854626235" sldId="257"/>
            <ac:picMk id="35" creationId="{0590BA12-C825-244A-BE38-C8A7D4A7ADBB}"/>
          </ac:picMkLst>
        </pc:picChg>
        <pc:picChg chg="add del mod">
          <ac:chgData name="Narang, Sonali" userId="9e80b397-6e2f-49b1-9374-ccdad8589140" providerId="ADAL" clId="{0B7BE2FF-CA73-044A-832B-45D8C814BD66}" dt="2021-05-24T12:48:49.152" v="1180" actId="478"/>
          <ac:picMkLst>
            <pc:docMk/>
            <pc:sldMk cId="1854626235" sldId="257"/>
            <ac:picMk id="73" creationId="{37113A02-E815-0E40-8D0F-BC9EAE93C2E0}"/>
          </ac:picMkLst>
        </pc:picChg>
        <pc:picChg chg="add del mod">
          <ac:chgData name="Narang, Sonali" userId="9e80b397-6e2f-49b1-9374-ccdad8589140" providerId="ADAL" clId="{0B7BE2FF-CA73-044A-832B-45D8C814BD66}" dt="2021-05-24T12:50:45.681" v="1195" actId="478"/>
          <ac:picMkLst>
            <pc:docMk/>
            <pc:sldMk cId="1854626235" sldId="257"/>
            <ac:picMk id="75" creationId="{6856CF11-177E-4640-8F2A-DAD35765267F}"/>
          </ac:picMkLst>
        </pc:picChg>
        <pc:picChg chg="add del mod">
          <ac:chgData name="Narang, Sonali" userId="9e80b397-6e2f-49b1-9374-ccdad8589140" providerId="ADAL" clId="{0B7BE2FF-CA73-044A-832B-45D8C814BD66}" dt="2021-05-24T17:49:07.292" v="1374" actId="478"/>
          <ac:picMkLst>
            <pc:docMk/>
            <pc:sldMk cId="1854626235" sldId="257"/>
            <ac:picMk id="77" creationId="{540E8324-8801-DE4B-B05E-CA80CEFA50CF}"/>
          </ac:picMkLst>
        </pc:picChg>
        <pc:picChg chg="add mod modCrop">
          <ac:chgData name="Narang, Sonali" userId="9e80b397-6e2f-49b1-9374-ccdad8589140" providerId="ADAL" clId="{0B7BE2FF-CA73-044A-832B-45D8C814BD66}" dt="2021-05-24T20:12:09.173" v="1591" actId="1076"/>
          <ac:picMkLst>
            <pc:docMk/>
            <pc:sldMk cId="1854626235" sldId="257"/>
            <ac:picMk id="85" creationId="{04BCF87E-AF8A-C640-BEBE-06979DA213FC}"/>
          </ac:picMkLst>
        </pc:picChg>
        <pc:picChg chg="add mod">
          <ac:chgData name="Narang, Sonali" userId="9e80b397-6e2f-49b1-9374-ccdad8589140" providerId="ADAL" clId="{0B7BE2FF-CA73-044A-832B-45D8C814BD66}" dt="2021-05-24T21:53:41.130" v="1743" actId="1076"/>
          <ac:picMkLst>
            <pc:docMk/>
            <pc:sldMk cId="1854626235" sldId="257"/>
            <ac:picMk id="87" creationId="{997BD2A9-3CE5-A840-B3FE-9D080BE91541}"/>
          </ac:picMkLst>
        </pc:picChg>
        <pc:picChg chg="add mod modCrop">
          <ac:chgData name="Narang, Sonali" userId="9e80b397-6e2f-49b1-9374-ccdad8589140" providerId="ADAL" clId="{0B7BE2FF-CA73-044A-832B-45D8C814BD66}" dt="2021-05-24T20:12:08.881" v="1590" actId="1076"/>
          <ac:picMkLst>
            <pc:docMk/>
            <pc:sldMk cId="1854626235" sldId="257"/>
            <ac:picMk id="89" creationId="{9F67AE90-47B7-5242-8591-AEF8D446E1CF}"/>
          </ac:picMkLst>
        </pc:picChg>
        <pc:picChg chg="add del mod">
          <ac:chgData name="Narang, Sonali" userId="9e80b397-6e2f-49b1-9374-ccdad8589140" providerId="ADAL" clId="{0B7BE2FF-CA73-044A-832B-45D8C814BD66}" dt="2021-05-24T21:59:19.480" v="1786" actId="1076"/>
          <ac:picMkLst>
            <pc:docMk/>
            <pc:sldMk cId="1854626235" sldId="257"/>
            <ac:picMk id="91" creationId="{06D63945-83A0-5C46-BB62-843DD22FD7F6}"/>
          </ac:picMkLst>
        </pc:picChg>
        <pc:picChg chg="add del mod">
          <ac:chgData name="Narang, Sonali" userId="9e80b397-6e2f-49b1-9374-ccdad8589140" providerId="ADAL" clId="{0B7BE2FF-CA73-044A-832B-45D8C814BD66}" dt="2021-05-24T19:57:02.812" v="1554" actId="478"/>
          <ac:picMkLst>
            <pc:docMk/>
            <pc:sldMk cId="1854626235" sldId="257"/>
            <ac:picMk id="93" creationId="{117B49D4-A40D-3E43-92CE-AFA6AD515F67}"/>
          </ac:picMkLst>
        </pc:picChg>
        <pc:picChg chg="add del mod">
          <ac:chgData name="Narang, Sonali" userId="9e80b397-6e2f-49b1-9374-ccdad8589140" providerId="ADAL" clId="{0B7BE2FF-CA73-044A-832B-45D8C814BD66}" dt="2021-05-24T19:59:00.638" v="1560" actId="478"/>
          <ac:picMkLst>
            <pc:docMk/>
            <pc:sldMk cId="1854626235" sldId="257"/>
            <ac:picMk id="95" creationId="{A58F1B77-F3FC-524E-B471-E6C610E47615}"/>
          </ac:picMkLst>
        </pc:picChg>
        <pc:picChg chg="add del mod">
          <ac:chgData name="Narang, Sonali" userId="9e80b397-6e2f-49b1-9374-ccdad8589140" providerId="ADAL" clId="{0B7BE2FF-CA73-044A-832B-45D8C814BD66}" dt="2021-05-27T14:01:23.593" v="1921" actId="478"/>
          <ac:picMkLst>
            <pc:docMk/>
            <pc:sldMk cId="1854626235" sldId="257"/>
            <ac:picMk id="96" creationId="{57CDB673-88B3-C947-83C7-33E8E8D1096E}"/>
          </ac:picMkLst>
        </pc:picChg>
        <pc:picChg chg="add mod topLvl">
          <ac:chgData name="Narang, Sonali" userId="9e80b397-6e2f-49b1-9374-ccdad8589140" providerId="ADAL" clId="{0B7BE2FF-CA73-044A-832B-45D8C814BD66}" dt="2021-05-24T22:02:15.539" v="1807" actId="1076"/>
          <ac:picMkLst>
            <pc:docMk/>
            <pc:sldMk cId="1854626235" sldId="257"/>
            <ac:picMk id="98" creationId="{AB015502-B36C-654D-AE21-0AAD426C43F1}"/>
          </ac:picMkLst>
        </pc:picChg>
        <pc:picChg chg="add del mod">
          <ac:chgData name="Narang, Sonali" userId="9e80b397-6e2f-49b1-9374-ccdad8589140" providerId="ADAL" clId="{0B7BE2FF-CA73-044A-832B-45D8C814BD66}" dt="2021-05-24T21:36:39.658" v="1694" actId="478"/>
          <ac:picMkLst>
            <pc:docMk/>
            <pc:sldMk cId="1854626235" sldId="257"/>
            <ac:picMk id="104" creationId="{268C090D-EE71-5842-A69B-16990294EBD2}"/>
          </ac:picMkLst>
        </pc:picChg>
        <pc:picChg chg="add del mod">
          <ac:chgData name="Narang, Sonali" userId="9e80b397-6e2f-49b1-9374-ccdad8589140" providerId="ADAL" clId="{0B7BE2FF-CA73-044A-832B-45D8C814BD66}" dt="2021-05-24T21:44:13.719" v="1707" actId="478"/>
          <ac:picMkLst>
            <pc:docMk/>
            <pc:sldMk cId="1854626235" sldId="257"/>
            <ac:picMk id="106" creationId="{7CC6B6CE-4BAB-D34C-870D-E66C8B784699}"/>
          </ac:picMkLst>
        </pc:picChg>
        <pc:picChg chg="add del mod">
          <ac:chgData name="Narang, Sonali" userId="9e80b397-6e2f-49b1-9374-ccdad8589140" providerId="ADAL" clId="{0B7BE2FF-CA73-044A-832B-45D8C814BD66}" dt="2021-05-24T21:44:51.790" v="1723" actId="478"/>
          <ac:picMkLst>
            <pc:docMk/>
            <pc:sldMk cId="1854626235" sldId="257"/>
            <ac:picMk id="107" creationId="{FC33B937-202D-034C-AF4A-0C884144696E}"/>
          </ac:picMkLst>
        </pc:picChg>
        <pc:picChg chg="add mod">
          <ac:chgData name="Narang, Sonali" userId="9e80b397-6e2f-49b1-9374-ccdad8589140" providerId="ADAL" clId="{0B7BE2FF-CA73-044A-832B-45D8C814BD66}" dt="2021-05-24T22:00:15.216" v="1797" actId="1076"/>
          <ac:picMkLst>
            <pc:docMk/>
            <pc:sldMk cId="1854626235" sldId="257"/>
            <ac:picMk id="109" creationId="{83518A59-DE1F-C64E-95A4-9EE0523C4D94}"/>
          </ac:picMkLst>
        </pc:picChg>
        <pc:picChg chg="add mod">
          <ac:chgData name="Narang, Sonali" userId="9e80b397-6e2f-49b1-9374-ccdad8589140" providerId="ADAL" clId="{0B7BE2FF-CA73-044A-832B-45D8C814BD66}" dt="2021-05-24T22:00:15.216" v="1797" actId="1076"/>
          <ac:picMkLst>
            <pc:docMk/>
            <pc:sldMk cId="1854626235" sldId="257"/>
            <ac:picMk id="111" creationId="{3DBF3880-6CBA-8041-B9CD-F2A215E3C8DD}"/>
          </ac:picMkLst>
        </pc:picChg>
        <pc:picChg chg="add mod">
          <ac:chgData name="Narang, Sonali" userId="9e80b397-6e2f-49b1-9374-ccdad8589140" providerId="ADAL" clId="{0B7BE2FF-CA73-044A-832B-45D8C814BD66}" dt="2021-05-27T13:23:01.268" v="1920" actId="1076"/>
          <ac:picMkLst>
            <pc:docMk/>
            <pc:sldMk cId="1854626235" sldId="257"/>
            <ac:picMk id="112" creationId="{6B6DD000-238E-8F48-B8CA-73434CB731ED}"/>
          </ac:picMkLst>
        </pc:picChg>
        <pc:picChg chg="add del">
          <ac:chgData name="Narang, Sonali" userId="9e80b397-6e2f-49b1-9374-ccdad8589140" providerId="ADAL" clId="{0B7BE2FF-CA73-044A-832B-45D8C814BD66}" dt="2021-05-27T14:01:28.296" v="1923"/>
          <ac:picMkLst>
            <pc:docMk/>
            <pc:sldMk cId="1854626235" sldId="257"/>
            <ac:picMk id="114" creationId="{EA3911A3-7B00-9F48-8AED-F1001E619CC1}"/>
          </ac:picMkLst>
        </pc:picChg>
        <pc:picChg chg="add del mod">
          <ac:chgData name="Narang, Sonali" userId="9e80b397-6e2f-49b1-9374-ccdad8589140" providerId="ADAL" clId="{0B7BE2FF-CA73-044A-832B-45D8C814BD66}" dt="2021-05-27T14:01:39.881" v="1927" actId="478"/>
          <ac:picMkLst>
            <pc:docMk/>
            <pc:sldMk cId="1854626235" sldId="257"/>
            <ac:picMk id="115" creationId="{C391C1EA-C592-2142-9908-F5DCD84E3351}"/>
          </ac:picMkLst>
        </pc:picChg>
        <pc:picChg chg="add del">
          <ac:chgData name="Narang, Sonali" userId="9e80b397-6e2f-49b1-9374-ccdad8589140" providerId="ADAL" clId="{0B7BE2FF-CA73-044A-832B-45D8C814BD66}" dt="2021-05-27T14:01:51.349" v="1929"/>
          <ac:picMkLst>
            <pc:docMk/>
            <pc:sldMk cId="1854626235" sldId="257"/>
            <ac:picMk id="116" creationId="{6C578901-ACD9-EF41-AFDF-EA43960B22F1}"/>
          </ac:picMkLst>
        </pc:picChg>
        <pc:picChg chg="add mod">
          <ac:chgData name="Narang, Sonali" userId="9e80b397-6e2f-49b1-9374-ccdad8589140" providerId="ADAL" clId="{0B7BE2FF-CA73-044A-832B-45D8C814BD66}" dt="2021-05-27T14:02:27.447" v="1935" actId="1076"/>
          <ac:picMkLst>
            <pc:docMk/>
            <pc:sldMk cId="1854626235" sldId="257"/>
            <ac:picMk id="117" creationId="{5AF2AB47-DAE2-F643-8CDC-5611248A02A7}"/>
          </ac:picMkLst>
        </pc:picChg>
      </pc:sldChg>
      <pc:sldChg chg="addSp modSp mod">
        <pc:chgData name="Narang, Sonali" userId="9e80b397-6e2f-49b1-9374-ccdad8589140" providerId="ADAL" clId="{0B7BE2FF-CA73-044A-832B-45D8C814BD66}" dt="2021-05-24T22:23:26.936" v="1854" actId="1076"/>
        <pc:sldMkLst>
          <pc:docMk/>
          <pc:sldMk cId="1155223781" sldId="258"/>
        </pc:sldMkLst>
        <pc:spChg chg="mod">
          <ac:chgData name="Narang, Sonali" userId="9e80b397-6e2f-49b1-9374-ccdad8589140" providerId="ADAL" clId="{0B7BE2FF-CA73-044A-832B-45D8C814BD66}" dt="2021-05-24T22:21:50.810" v="1843" actId="1076"/>
          <ac:spMkLst>
            <pc:docMk/>
            <pc:sldMk cId="1155223781" sldId="258"/>
            <ac:spMk id="7" creationId="{4C5F5CAE-FBFD-964D-A356-746AAC86DC9E}"/>
          </ac:spMkLst>
        </pc:spChg>
        <pc:picChg chg="add mod modCrop">
          <ac:chgData name="Narang, Sonali" userId="9e80b397-6e2f-49b1-9374-ccdad8589140" providerId="ADAL" clId="{0B7BE2FF-CA73-044A-832B-45D8C814BD66}" dt="2021-05-24T22:23:26.936" v="1854" actId="1076"/>
          <ac:picMkLst>
            <pc:docMk/>
            <pc:sldMk cId="1155223781" sldId="258"/>
            <ac:picMk id="2" creationId="{565ED7F5-1C52-8F4C-8691-D4485816FEBB}"/>
          </ac:picMkLst>
        </pc:picChg>
        <pc:picChg chg="add mod">
          <ac:chgData name="Narang, Sonali" userId="9e80b397-6e2f-49b1-9374-ccdad8589140" providerId="ADAL" clId="{0B7BE2FF-CA73-044A-832B-45D8C814BD66}" dt="2021-05-24T22:22:53.016" v="1846" actId="1076"/>
          <ac:picMkLst>
            <pc:docMk/>
            <pc:sldMk cId="1155223781" sldId="258"/>
            <ac:picMk id="3" creationId="{A03C310D-8531-2D4A-9D9D-C21C507CB6FE}"/>
          </ac:picMkLst>
        </pc:picChg>
      </pc:sldChg>
      <pc:sldChg chg="addSp delSp modSp add mod">
        <pc:chgData name="Narang, Sonali" userId="9e80b397-6e2f-49b1-9374-ccdad8589140" providerId="ADAL" clId="{0B7BE2FF-CA73-044A-832B-45D8C814BD66}" dt="2021-05-24T22:24:58.809" v="1891" actId="20577"/>
        <pc:sldMkLst>
          <pc:docMk/>
          <pc:sldMk cId="209215240" sldId="259"/>
        </pc:sldMkLst>
        <pc:spChg chg="mod">
          <ac:chgData name="Narang, Sonali" userId="9e80b397-6e2f-49b1-9374-ccdad8589140" providerId="ADAL" clId="{0B7BE2FF-CA73-044A-832B-45D8C814BD66}" dt="2021-05-24T22:24:58.809" v="1891" actId="20577"/>
          <ac:spMkLst>
            <pc:docMk/>
            <pc:sldMk cId="209215240" sldId="259"/>
            <ac:spMk id="4" creationId="{F6669B9D-B042-D548-BD0F-97015091799B}"/>
          </ac:spMkLst>
        </pc:spChg>
        <pc:spChg chg="del">
          <ac:chgData name="Narang, Sonali" userId="9e80b397-6e2f-49b1-9374-ccdad8589140" providerId="ADAL" clId="{0B7BE2FF-CA73-044A-832B-45D8C814BD66}" dt="2021-05-06T21:27:30.717" v="1086" actId="478"/>
          <ac:spMkLst>
            <pc:docMk/>
            <pc:sldMk cId="209215240" sldId="259"/>
            <ac:spMk id="22" creationId="{320B15F1-B95C-B145-B377-78CDF54B2C66}"/>
          </ac:spMkLst>
        </pc:spChg>
        <pc:grpChg chg="del">
          <ac:chgData name="Narang, Sonali" userId="9e80b397-6e2f-49b1-9374-ccdad8589140" providerId="ADAL" clId="{0B7BE2FF-CA73-044A-832B-45D8C814BD66}" dt="2021-05-06T21:27:28.006" v="1085" actId="478"/>
          <ac:grpSpMkLst>
            <pc:docMk/>
            <pc:sldMk cId="209215240" sldId="259"/>
            <ac:grpSpMk id="21" creationId="{C3B6CF52-F7C8-E24D-930F-85E0486C7AEF}"/>
          </ac:grpSpMkLst>
        </pc:grpChg>
        <pc:picChg chg="add mod modCrop">
          <ac:chgData name="Narang, Sonali" userId="9e80b397-6e2f-49b1-9374-ccdad8589140" providerId="ADAL" clId="{0B7BE2FF-CA73-044A-832B-45D8C814BD66}" dt="2021-05-24T22:24:19.031" v="1862" actId="1076"/>
          <ac:picMkLst>
            <pc:docMk/>
            <pc:sldMk cId="209215240" sldId="259"/>
            <ac:picMk id="3" creationId="{B4D62D87-34E6-D740-84D7-71365F0F47AC}"/>
          </ac:picMkLst>
        </pc:picChg>
        <pc:picChg chg="add mod">
          <ac:chgData name="Narang, Sonali" userId="9e80b397-6e2f-49b1-9374-ccdad8589140" providerId="ADAL" clId="{0B7BE2FF-CA73-044A-832B-45D8C814BD66}" dt="2021-05-24T22:24:46.509" v="1868" actId="14100"/>
          <ac:picMkLst>
            <pc:docMk/>
            <pc:sldMk cId="209215240" sldId="259"/>
            <ac:picMk id="9" creationId="{80ABA082-A86B-184A-A8AB-B0AA0DC40A58}"/>
          </ac:picMkLst>
        </pc:picChg>
        <pc:picChg chg="del">
          <ac:chgData name="Narang, Sonali" userId="9e80b397-6e2f-49b1-9374-ccdad8589140" providerId="ADAL" clId="{0B7BE2FF-CA73-044A-832B-45D8C814BD66}" dt="2021-05-06T21:27:28.006" v="1085" actId="478"/>
          <ac:picMkLst>
            <pc:docMk/>
            <pc:sldMk cId="209215240" sldId="259"/>
            <ac:picMk id="35" creationId="{0590BA12-C825-244A-BE38-C8A7D4A7ADBB}"/>
          </ac:picMkLst>
        </pc:picChg>
      </pc:sldChg>
      <pc:sldChg chg="add del">
        <pc:chgData name="Narang, Sonali" userId="9e80b397-6e2f-49b1-9374-ccdad8589140" providerId="ADAL" clId="{0B7BE2FF-CA73-044A-832B-45D8C814BD66}" dt="2021-04-30T16:46:59.063" v="525" actId="2890"/>
        <pc:sldMkLst>
          <pc:docMk/>
          <pc:sldMk cId="3551018968" sldId="259"/>
        </pc:sldMkLst>
      </pc:sldChg>
      <pc:sldChg chg="modSp add mod ord">
        <pc:chgData name="Narang, Sonali" userId="9e80b397-6e2f-49b1-9374-ccdad8589140" providerId="ADAL" clId="{0B7BE2FF-CA73-044A-832B-45D8C814BD66}" dt="2021-05-27T12:11:33.574" v="1900" actId="20578"/>
        <pc:sldMkLst>
          <pc:docMk/>
          <pc:sldMk cId="2209615388" sldId="260"/>
        </pc:sldMkLst>
        <pc:spChg chg="mod">
          <ac:chgData name="Narang, Sonali" userId="9e80b397-6e2f-49b1-9374-ccdad8589140" providerId="ADAL" clId="{0B7BE2FF-CA73-044A-832B-45D8C814BD66}" dt="2021-05-24T22:26:00.800" v="1893" actId="20577"/>
          <ac:spMkLst>
            <pc:docMk/>
            <pc:sldMk cId="2209615388" sldId="260"/>
            <ac:spMk id="4" creationId="{F6669B9D-B042-D548-BD0F-97015091799B}"/>
          </ac:spMkLst>
        </pc:spChg>
      </pc:sldChg>
      <pc:sldChg chg="modSp add mod ord">
        <pc:chgData name="Narang, Sonali" userId="9e80b397-6e2f-49b1-9374-ccdad8589140" providerId="ADAL" clId="{0B7BE2FF-CA73-044A-832B-45D8C814BD66}" dt="2021-05-27T12:13:15.035" v="1918" actId="20577"/>
        <pc:sldMkLst>
          <pc:docMk/>
          <pc:sldMk cId="304432944" sldId="261"/>
        </pc:sldMkLst>
        <pc:spChg chg="mod">
          <ac:chgData name="Narang, Sonali" userId="9e80b397-6e2f-49b1-9374-ccdad8589140" providerId="ADAL" clId="{0B7BE2FF-CA73-044A-832B-45D8C814BD66}" dt="2021-05-27T12:13:15.035" v="1918" actId="20577"/>
          <ac:spMkLst>
            <pc:docMk/>
            <pc:sldMk cId="304432944" sldId="261"/>
            <ac:spMk id="4" creationId="{F6669B9D-B042-D548-BD0F-97015091799B}"/>
          </ac:spMkLst>
        </pc:spChg>
      </pc:sldChg>
      <pc:sldChg chg="add">
        <pc:chgData name="Narang, Sonali" userId="9e80b397-6e2f-49b1-9374-ccdad8589140" providerId="ADAL" clId="{0B7BE2FF-CA73-044A-832B-45D8C814BD66}" dt="2021-05-27T12:11:17.096" v="1895" actId="2890"/>
        <pc:sldMkLst>
          <pc:docMk/>
          <pc:sldMk cId="4098972693" sldId="262"/>
        </pc:sldMkLst>
      </pc:sldChg>
    </pc:docChg>
  </pc:docChgLst>
  <pc:docChgLst>
    <pc:chgData name="Narang, Sonali" userId="9e80b397-6e2f-49b1-9374-ccdad8589140" providerId="ADAL" clId="{6649061F-1686-6E42-8CBD-4F0AAB90E7CD}"/>
    <pc:docChg chg="undo redo custSel addSld delSld modSld sldOrd">
      <pc:chgData name="Narang, Sonali" userId="9e80b397-6e2f-49b1-9374-ccdad8589140" providerId="ADAL" clId="{6649061F-1686-6E42-8CBD-4F0AAB90E7CD}" dt="2022-01-24T19:33:30.938" v="1335" actId="12788"/>
      <pc:docMkLst>
        <pc:docMk/>
      </pc:docMkLst>
      <pc:sldChg chg="addSp modSp mod">
        <pc:chgData name="Narang, Sonali" userId="9e80b397-6e2f-49b1-9374-ccdad8589140" providerId="ADAL" clId="{6649061F-1686-6E42-8CBD-4F0AAB90E7CD}" dt="2022-01-06T17:58:35.809" v="711" actId="1076"/>
        <pc:sldMkLst>
          <pc:docMk/>
          <pc:sldMk cId="1155223781" sldId="258"/>
        </pc:sldMkLst>
        <pc:spChg chg="mod">
          <ac:chgData name="Narang, Sonali" userId="9e80b397-6e2f-49b1-9374-ccdad8589140" providerId="ADAL" clId="{6649061F-1686-6E42-8CBD-4F0AAB90E7CD}" dt="2022-01-06T17:51:13.751" v="702" actId="12788"/>
          <ac:spMkLst>
            <pc:docMk/>
            <pc:sldMk cId="1155223781" sldId="258"/>
            <ac:spMk id="5" creationId="{FAFFEC37-A0C5-5846-8534-22E3DEF6CEF4}"/>
          </ac:spMkLst>
        </pc:spChg>
        <pc:spChg chg="mod">
          <ac:chgData name="Narang, Sonali" userId="9e80b397-6e2f-49b1-9374-ccdad8589140" providerId="ADAL" clId="{6649061F-1686-6E42-8CBD-4F0AAB90E7CD}" dt="2022-01-06T17:51:13.751" v="702" actId="12788"/>
          <ac:spMkLst>
            <pc:docMk/>
            <pc:sldMk cId="1155223781" sldId="258"/>
            <ac:spMk id="6" creationId="{41464C80-B659-484D-A16F-8018DEC5471A}"/>
          </ac:spMkLst>
        </pc:spChg>
        <pc:spChg chg="mod">
          <ac:chgData name="Narang, Sonali" userId="9e80b397-6e2f-49b1-9374-ccdad8589140" providerId="ADAL" clId="{6649061F-1686-6E42-8CBD-4F0AAB90E7CD}" dt="2022-01-06T17:51:13.751" v="702" actId="12788"/>
          <ac:spMkLst>
            <pc:docMk/>
            <pc:sldMk cId="1155223781" sldId="258"/>
            <ac:spMk id="7" creationId="{4C5F5CAE-FBFD-964D-A356-746AAC86DC9E}"/>
          </ac:spMkLst>
        </pc:spChg>
        <pc:picChg chg="add mod">
          <ac:chgData name="Narang, Sonali" userId="9e80b397-6e2f-49b1-9374-ccdad8589140" providerId="ADAL" clId="{6649061F-1686-6E42-8CBD-4F0AAB90E7CD}" dt="2022-01-06T17:58:31.053" v="709" actId="1076"/>
          <ac:picMkLst>
            <pc:docMk/>
            <pc:sldMk cId="1155223781" sldId="258"/>
            <ac:picMk id="3" creationId="{EA617364-550B-E04F-924F-48C74EA2D11B}"/>
          </ac:picMkLst>
        </pc:picChg>
        <pc:picChg chg="mod">
          <ac:chgData name="Narang, Sonali" userId="9e80b397-6e2f-49b1-9374-ccdad8589140" providerId="ADAL" clId="{6649061F-1686-6E42-8CBD-4F0AAB90E7CD}" dt="2022-01-06T17:58:35.809" v="711" actId="1076"/>
          <ac:picMkLst>
            <pc:docMk/>
            <pc:sldMk cId="1155223781" sldId="258"/>
            <ac:picMk id="9" creationId="{CE344B95-A4B4-8E48-8BA1-DBCEB948F1E4}"/>
          </ac:picMkLst>
        </pc:picChg>
        <pc:picChg chg="mod">
          <ac:chgData name="Narang, Sonali" userId="9e80b397-6e2f-49b1-9374-ccdad8589140" providerId="ADAL" clId="{6649061F-1686-6E42-8CBD-4F0AAB90E7CD}" dt="2022-01-06T17:50:54.350" v="699" actId="1076"/>
          <ac:picMkLst>
            <pc:docMk/>
            <pc:sldMk cId="1155223781" sldId="258"/>
            <ac:picMk id="10" creationId="{8F08C599-E1EB-3044-A41D-ED696091AEE1}"/>
          </ac:picMkLst>
        </pc:picChg>
        <pc:picChg chg="mod">
          <ac:chgData name="Narang, Sonali" userId="9e80b397-6e2f-49b1-9374-ccdad8589140" providerId="ADAL" clId="{6649061F-1686-6E42-8CBD-4F0AAB90E7CD}" dt="2022-01-06T17:50:54.350" v="699" actId="1076"/>
          <ac:picMkLst>
            <pc:docMk/>
            <pc:sldMk cId="1155223781" sldId="258"/>
            <ac:picMk id="11" creationId="{49516C8B-9616-3B4D-A203-229E3B7B51D9}"/>
          </ac:picMkLst>
        </pc:picChg>
        <pc:picChg chg="mod">
          <ac:chgData name="Narang, Sonali" userId="9e80b397-6e2f-49b1-9374-ccdad8589140" providerId="ADAL" clId="{6649061F-1686-6E42-8CBD-4F0AAB90E7CD}" dt="2022-01-06T17:51:01.379" v="700" actId="1076"/>
          <ac:picMkLst>
            <pc:docMk/>
            <pc:sldMk cId="1155223781" sldId="258"/>
            <ac:picMk id="64" creationId="{F64170D4-AD39-6E41-B3C6-F2183A925A2E}"/>
          </ac:picMkLst>
        </pc:picChg>
        <pc:picChg chg="mod">
          <ac:chgData name="Narang, Sonali" userId="9e80b397-6e2f-49b1-9374-ccdad8589140" providerId="ADAL" clId="{6649061F-1686-6E42-8CBD-4F0AAB90E7CD}" dt="2022-01-06T17:51:01.379" v="700" actId="1076"/>
          <ac:picMkLst>
            <pc:docMk/>
            <pc:sldMk cId="1155223781" sldId="258"/>
            <ac:picMk id="65" creationId="{F660B100-D24F-D145-8E9B-D3B0C1D6ED83}"/>
          </ac:picMkLst>
        </pc:picChg>
        <pc:picChg chg="mod">
          <ac:chgData name="Narang, Sonali" userId="9e80b397-6e2f-49b1-9374-ccdad8589140" providerId="ADAL" clId="{6649061F-1686-6E42-8CBD-4F0AAB90E7CD}" dt="2022-01-06T17:51:01.379" v="700" actId="1076"/>
          <ac:picMkLst>
            <pc:docMk/>
            <pc:sldMk cId="1155223781" sldId="258"/>
            <ac:picMk id="66" creationId="{DA560F45-414B-1D48-AB88-6A33A254C80C}"/>
          </ac:picMkLst>
        </pc:picChg>
      </pc:sldChg>
      <pc:sldChg chg="addSp delSp modSp mod modNotesTx">
        <pc:chgData name="Narang, Sonali" userId="9e80b397-6e2f-49b1-9374-ccdad8589140" providerId="ADAL" clId="{6649061F-1686-6E42-8CBD-4F0AAB90E7CD}" dt="2022-01-13T16:25:50.612" v="1311" actId="20577"/>
        <pc:sldMkLst>
          <pc:docMk/>
          <pc:sldMk cId="743684689" sldId="267"/>
        </pc:sldMkLst>
        <pc:spChg chg="mod">
          <ac:chgData name="Narang, Sonali" userId="9e80b397-6e2f-49b1-9374-ccdad8589140" providerId="ADAL" clId="{6649061F-1686-6E42-8CBD-4F0AAB90E7CD}" dt="2022-01-06T19:08:35.231" v="729" actId="1076"/>
          <ac:spMkLst>
            <pc:docMk/>
            <pc:sldMk cId="743684689" sldId="267"/>
            <ac:spMk id="8" creationId="{8A9BAE78-C4FF-1843-94F6-3410EB884848}"/>
          </ac:spMkLst>
        </pc:spChg>
        <pc:spChg chg="add mod">
          <ac:chgData name="Narang, Sonali" userId="9e80b397-6e2f-49b1-9374-ccdad8589140" providerId="ADAL" clId="{6649061F-1686-6E42-8CBD-4F0AAB90E7CD}" dt="2022-01-06T19:10:21.617" v="751" actId="1076"/>
          <ac:spMkLst>
            <pc:docMk/>
            <pc:sldMk cId="743684689" sldId="267"/>
            <ac:spMk id="46" creationId="{7406AFD2-D7AD-D246-9AA9-8D2A7E07C320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51" creationId="{3DC1E52F-7BDC-4948-9DE5-37F95C21CFF5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54" creationId="{23898AA4-4694-8F48-A89B-066AE54A2C04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55" creationId="{83B2DBA8-FFD7-164B-9FF1-C92D53D3F37A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57" creationId="{7798ACCC-F8D8-874E-9E93-D76E785A287B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2" creationId="{008CC80B-AD7B-3B4B-B365-D9A219690DD0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3" creationId="{5DBBA057-028F-2A4D-A2D1-E9A292BFBEDC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4" creationId="{3C5275DE-15D5-944A-BF18-C25EB54256A3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5" creationId="{3519DE9C-2C2D-5E4F-B21C-6308A8A7F671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6" creationId="{616CE034-C8F4-B544-8DB0-72348E38F909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7" creationId="{7FBA2917-AE7F-3540-9A34-3C4717C59740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8" creationId="{D4250405-AA09-784A-BF06-EBB7DDB57018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69" creationId="{4639790B-F989-7641-916A-C42A2505F7DA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0" creationId="{A8F9C39B-5458-E543-B00C-2DFBCF182CD3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1" creationId="{2ECD01C8-AE64-6E47-8E26-7A0A59BFA6CB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2" creationId="{DB8DB24E-1586-6D4B-9B3B-112D95E4DEDF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3" creationId="{3B3DC107-C9A4-6A4C-ABB9-D1FCC6B206C9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4" creationId="{C50D725F-417E-B943-87F7-274B35C4F12F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5" creationId="{F6589498-EFE2-0049-83E8-89DE06232865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6" creationId="{C5B1814D-BB1D-B94C-A9C4-25B3B028FBEC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7" creationId="{8096DF66-1FF1-184B-A7A9-1AEB77C3B759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8" creationId="{4DA9D2B5-4025-C947-AEC5-4C7C16C9CAD0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79" creationId="{744EA697-ADEA-4E4E-859E-B78371D40548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87" creationId="{7D455060-65F7-4D46-9804-B4FB7F442D6E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89" creationId="{15C47B12-63E2-F540-8D30-0211D8944BB2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90" creationId="{AA4238D3-0811-0145-B827-EF55DE96E183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92" creationId="{850A082D-9372-204B-82B0-DD4D68670ED2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97" creationId="{C39DCFF4-724B-2949-94D6-1E0DE5CF23D1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98" creationId="{C2CA281F-B6A5-3F40-ACD6-D50702AD9BA5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99" creationId="{137FC4AE-285A-5746-9A12-C235BD471414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0" creationId="{EBCB1240-7411-9549-995B-E33A30CBFC6A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1" creationId="{060EB9F8-8173-8043-8791-E4C6FFE56A3D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2" creationId="{C82F29F0-F277-4F42-B50B-721D77CD7627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3" creationId="{B6F44F49-84C3-624F-9F39-FADD8171C11E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4" creationId="{85888F3A-72FB-5241-9B90-AB298A33B860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6" creationId="{A8E12618-19A1-7842-8970-AF43031F6909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7" creationId="{EDE1D43B-5367-FC44-9DCD-AF4A03695A4A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8" creationId="{8167A3AE-7BEF-C746-A4ED-F77F76FA965B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09" creationId="{7ABF4552-62FD-6940-9B65-36FB2B13F39F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0" creationId="{CA36ADBD-1903-2B4B-AC83-214AEF895EF8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1" creationId="{F173ECB2-4EA2-CB40-A5F6-C1D3EB3ECF84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2" creationId="{E23EFC05-2819-244C-84FE-31783BCEB84E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3" creationId="{CB910B2A-B222-FA4F-A7D3-F35F11D500C5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4" creationId="{B2DA6B96-6B6A-C347-AD82-2A6BB57B1A2B}"/>
          </ac:spMkLst>
        </pc:spChg>
        <pc:spChg chg="mod">
          <ac:chgData name="Narang, Sonali" userId="9e80b397-6e2f-49b1-9374-ccdad8589140" providerId="ADAL" clId="{6649061F-1686-6E42-8CBD-4F0AAB90E7CD}" dt="2022-01-06T19:09:14.932" v="739"/>
          <ac:spMkLst>
            <pc:docMk/>
            <pc:sldMk cId="743684689" sldId="267"/>
            <ac:spMk id="115" creationId="{0B07479E-3209-1A49-BF13-446F1AB34C60}"/>
          </ac:spMkLst>
        </pc:spChg>
        <pc:spChg chg="mod">
          <ac:chgData name="Narang, Sonali" userId="9e80b397-6e2f-49b1-9374-ccdad8589140" providerId="ADAL" clId="{6649061F-1686-6E42-8CBD-4F0AAB90E7CD}" dt="2022-01-06T19:07:55.558" v="724" actId="1038"/>
          <ac:spMkLst>
            <pc:docMk/>
            <pc:sldMk cId="743684689" sldId="267"/>
            <ac:spMk id="119" creationId="{F96847DC-C3E6-5F43-B748-6197693F0C5F}"/>
          </ac:spMkLst>
        </pc:spChg>
        <pc:spChg chg="mod">
          <ac:chgData name="Narang, Sonali" userId="9e80b397-6e2f-49b1-9374-ccdad8589140" providerId="ADAL" clId="{6649061F-1686-6E42-8CBD-4F0AAB90E7CD}" dt="2022-01-06T19:08:46.681" v="731" actId="1076"/>
          <ac:spMkLst>
            <pc:docMk/>
            <pc:sldMk cId="743684689" sldId="267"/>
            <ac:spMk id="124" creationId="{2BE84DAC-7C05-C445-9DD3-6B3EE69AFBF9}"/>
          </ac:spMkLst>
        </pc:spChg>
        <pc:spChg chg="del">
          <ac:chgData name="Narang, Sonali" userId="9e80b397-6e2f-49b1-9374-ccdad8589140" providerId="ADAL" clId="{6649061F-1686-6E42-8CBD-4F0AAB90E7CD}" dt="2022-01-06T19:09:28.533" v="743" actId="478"/>
          <ac:spMkLst>
            <pc:docMk/>
            <pc:sldMk cId="743684689" sldId="267"/>
            <ac:spMk id="125" creationId="{F77578BF-D28B-AC46-B202-F16CA20F451A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28" creationId="{A6A057D2-5FF7-4149-94F5-B140DE2FABD5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29" creationId="{F119B312-680E-2C4F-B5C8-8938B9E422AB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30" creationId="{B1493AFF-CA4E-6F4D-A0BA-1B90E4BA8A6E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3" creationId="{CDB74C8A-8DFE-7246-A4E5-82AC375D6524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4" creationId="{563E4695-FACC-A643-BBE8-1CC93B44D1BA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5" creationId="{D890D106-88F0-AD48-A6DD-50F067183F9D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6" creationId="{E2932365-5FC6-AA44-B04E-AE3D6664BA4E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7" creationId="{9A109801-764A-424C-A341-23242F15F561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8" creationId="{EA11B04E-C8FF-4842-9F12-E83E6092CA91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49" creationId="{D8349D72-B0AA-8340-BEDB-964FDDBD372D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50" creationId="{FBE03226-AE8E-AF42-8BBD-E1FDA5B497F8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51" creationId="{0CBB35CC-33A4-0B4F-870C-2374E6EF5CB8}"/>
          </ac:spMkLst>
        </pc:spChg>
        <pc:spChg chg="mod">
          <ac:chgData name="Narang, Sonali" userId="9e80b397-6e2f-49b1-9374-ccdad8589140" providerId="ADAL" clId="{6649061F-1686-6E42-8CBD-4F0AAB90E7CD}" dt="2022-01-06T19:07:51.463" v="718" actId="1076"/>
          <ac:spMkLst>
            <pc:docMk/>
            <pc:sldMk cId="743684689" sldId="267"/>
            <ac:spMk id="152" creationId="{76912FDE-67EB-554E-B5D2-687F992A13CE}"/>
          </ac:spMkLst>
        </pc:spChg>
        <pc:spChg chg="add mod">
          <ac:chgData name="Narang, Sonali" userId="9e80b397-6e2f-49b1-9374-ccdad8589140" providerId="ADAL" clId="{6649061F-1686-6E42-8CBD-4F0AAB90E7CD}" dt="2022-01-06T19:10:21.617" v="751" actId="1076"/>
          <ac:spMkLst>
            <pc:docMk/>
            <pc:sldMk cId="743684689" sldId="267"/>
            <ac:spMk id="154" creationId="{BBD260DC-3C03-814B-9AFA-CAC72344B1C9}"/>
          </ac:spMkLst>
        </pc:spChg>
        <pc:spChg chg="add mod">
          <ac:chgData name="Narang, Sonali" userId="9e80b397-6e2f-49b1-9374-ccdad8589140" providerId="ADAL" clId="{6649061F-1686-6E42-8CBD-4F0AAB90E7CD}" dt="2022-01-06T19:10:21.617" v="751" actId="1076"/>
          <ac:spMkLst>
            <pc:docMk/>
            <pc:sldMk cId="743684689" sldId="267"/>
            <ac:spMk id="155" creationId="{015E078D-E107-AA44-B5C6-75D51E21ED5C}"/>
          </ac:spMkLst>
        </pc:spChg>
        <pc:spChg chg="add mod">
          <ac:chgData name="Narang, Sonali" userId="9e80b397-6e2f-49b1-9374-ccdad8589140" providerId="ADAL" clId="{6649061F-1686-6E42-8CBD-4F0AAB90E7CD}" dt="2022-01-06T19:10:21.617" v="751" actId="1076"/>
          <ac:spMkLst>
            <pc:docMk/>
            <pc:sldMk cId="743684689" sldId="267"/>
            <ac:spMk id="156" creationId="{8FF60A7D-1E41-ED47-BB8F-AFE0553750EE}"/>
          </ac:spMkLst>
        </pc:spChg>
        <pc:grpChg chg="add mod">
          <ac:chgData name="Narang, Sonali" userId="9e80b397-6e2f-49b1-9374-ccdad8589140" providerId="ADAL" clId="{6649061F-1686-6E42-8CBD-4F0AAB90E7CD}" dt="2022-01-06T19:10:21.617" v="751" actId="1076"/>
          <ac:grpSpMkLst>
            <pc:docMk/>
            <pc:sldMk cId="743684689" sldId="267"/>
            <ac:grpSpMk id="47" creationId="{72F4671B-3E29-E441-A783-B731F5D5E901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48" creationId="{8353435A-B3A6-014B-967B-C88517259C26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53" creationId="{4C92F8FB-9650-F447-9ED4-B59DA4B731D3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56" creationId="{B7CBFF5F-968F-7746-9568-E836F0C492B3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58" creationId="{3B2404E4-5C64-0E43-8BC4-0B24252A2615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59" creationId="{E465CCA1-C5D9-D141-8BF4-96B89AE53A9B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60" creationId="{0A84E679-B4D7-3749-9D0C-10EF203144F0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61" creationId="{CE7F5AC8-809A-254F-BBB3-E289ED48B5D7}"/>
          </ac:grpSpMkLst>
        </pc:grpChg>
        <pc:grpChg chg="add mod">
          <ac:chgData name="Narang, Sonali" userId="9e80b397-6e2f-49b1-9374-ccdad8589140" providerId="ADAL" clId="{6649061F-1686-6E42-8CBD-4F0AAB90E7CD}" dt="2022-01-06T19:10:21.617" v="751" actId="1076"/>
          <ac:grpSpMkLst>
            <pc:docMk/>
            <pc:sldMk cId="743684689" sldId="267"/>
            <ac:grpSpMk id="83" creationId="{6241C5F6-3B10-7F49-951A-CDB5F3FFB077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84" creationId="{7DF3C250-3AC0-9841-B117-20058CF34CDD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88" creationId="{19AF269D-AB89-0343-BE43-14FA37865E59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91" creationId="{8171CC8E-B8D7-0441-9EF2-EDBD81C88077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93" creationId="{1451406E-6E92-0846-BBCF-EEE310B209B2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94" creationId="{ACA21D39-DCE5-9D44-8996-20C1E00E6107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95" creationId="{B23C864D-88F5-D446-A798-48CE658DFDCB}"/>
          </ac:grpSpMkLst>
        </pc:grpChg>
        <pc:grpChg chg="mod">
          <ac:chgData name="Narang, Sonali" userId="9e80b397-6e2f-49b1-9374-ccdad8589140" providerId="ADAL" clId="{6649061F-1686-6E42-8CBD-4F0AAB90E7CD}" dt="2022-01-06T19:09:14.932" v="739"/>
          <ac:grpSpMkLst>
            <pc:docMk/>
            <pc:sldMk cId="743684689" sldId="267"/>
            <ac:grpSpMk id="96" creationId="{03E00FA7-E4B1-AD49-BE12-115AD712F718}"/>
          </ac:grpSpMkLst>
        </pc:grpChg>
        <pc:grpChg chg="mod">
          <ac:chgData name="Narang, Sonali" userId="9e80b397-6e2f-49b1-9374-ccdad8589140" providerId="ADAL" clId="{6649061F-1686-6E42-8CBD-4F0AAB90E7CD}" dt="2022-01-06T19:07:33.502" v="717" actId="1076"/>
          <ac:grpSpMkLst>
            <pc:docMk/>
            <pc:sldMk cId="743684689" sldId="267"/>
            <ac:grpSpMk id="117" creationId="{B05B94FA-BBA9-A64D-8CA4-F0D3B7616FE1}"/>
          </ac:grpSpMkLst>
        </pc:grpChg>
        <pc:picChg chg="mod">
          <ac:chgData name="Narang, Sonali" userId="9e80b397-6e2f-49b1-9374-ccdad8589140" providerId="ADAL" clId="{6649061F-1686-6E42-8CBD-4F0AAB90E7CD}" dt="2022-01-06T19:07:18.858" v="714" actId="1076"/>
          <ac:picMkLst>
            <pc:docMk/>
            <pc:sldMk cId="743684689" sldId="267"/>
            <ac:picMk id="13" creationId="{8E13C50A-DD07-A546-AF0A-4883E062BFDF}"/>
          </ac:picMkLst>
        </pc:picChg>
        <pc:picChg chg="mod">
          <ac:chgData name="Narang, Sonali" userId="9e80b397-6e2f-49b1-9374-ccdad8589140" providerId="ADAL" clId="{6649061F-1686-6E42-8CBD-4F0AAB90E7CD}" dt="2022-01-06T19:09:14.932" v="739"/>
          <ac:picMkLst>
            <pc:docMk/>
            <pc:sldMk cId="743684689" sldId="267"/>
            <ac:picMk id="49" creationId="{9228088B-A4B5-8B4A-8ADF-FF44F32E2E7D}"/>
          </ac:picMkLst>
        </pc:picChg>
        <pc:picChg chg="mod">
          <ac:chgData name="Narang, Sonali" userId="9e80b397-6e2f-49b1-9374-ccdad8589140" providerId="ADAL" clId="{6649061F-1686-6E42-8CBD-4F0AAB90E7CD}" dt="2022-01-06T19:09:14.932" v="739"/>
          <ac:picMkLst>
            <pc:docMk/>
            <pc:sldMk cId="743684689" sldId="267"/>
            <ac:picMk id="50" creationId="{67014982-76D6-8545-874F-8FB4823B3972}"/>
          </ac:picMkLst>
        </pc:picChg>
        <pc:picChg chg="mod">
          <ac:chgData name="Narang, Sonali" userId="9e80b397-6e2f-49b1-9374-ccdad8589140" providerId="ADAL" clId="{6649061F-1686-6E42-8CBD-4F0AAB90E7CD}" dt="2022-01-06T19:09:14.932" v="739"/>
          <ac:picMkLst>
            <pc:docMk/>
            <pc:sldMk cId="743684689" sldId="267"/>
            <ac:picMk id="52" creationId="{00564066-F251-9840-88E1-AAEF38995D41}"/>
          </ac:picMkLst>
        </pc:picChg>
        <pc:picChg chg="mod">
          <ac:chgData name="Narang, Sonali" userId="9e80b397-6e2f-49b1-9374-ccdad8589140" providerId="ADAL" clId="{6649061F-1686-6E42-8CBD-4F0AAB90E7CD}" dt="2022-01-06T19:09:14.932" v="739"/>
          <ac:picMkLst>
            <pc:docMk/>
            <pc:sldMk cId="743684689" sldId="267"/>
            <ac:picMk id="85" creationId="{0CA10CB1-EFD3-6E42-9F1B-C198814D1F2D}"/>
          </ac:picMkLst>
        </pc:picChg>
        <pc:picChg chg="mod">
          <ac:chgData name="Narang, Sonali" userId="9e80b397-6e2f-49b1-9374-ccdad8589140" providerId="ADAL" clId="{6649061F-1686-6E42-8CBD-4F0AAB90E7CD}" dt="2022-01-06T19:09:14.932" v="739"/>
          <ac:picMkLst>
            <pc:docMk/>
            <pc:sldMk cId="743684689" sldId="267"/>
            <ac:picMk id="86" creationId="{DBB4F19B-F352-7047-B6C7-C1ECFA95070E}"/>
          </ac:picMkLst>
        </pc:picChg>
        <pc:picChg chg="mod">
          <ac:chgData name="Narang, Sonali" userId="9e80b397-6e2f-49b1-9374-ccdad8589140" providerId="ADAL" clId="{6649061F-1686-6E42-8CBD-4F0AAB90E7CD}" dt="2022-01-06T19:07:19.190" v="715" actId="1076"/>
          <ac:picMkLst>
            <pc:docMk/>
            <pc:sldMk cId="743684689" sldId="267"/>
            <ac:picMk id="105" creationId="{97BF178D-FAD3-E44E-B50E-E66B7B262246}"/>
          </ac:picMkLst>
        </pc:picChg>
        <pc:picChg chg="mod">
          <ac:chgData name="Narang, Sonali" userId="9e80b397-6e2f-49b1-9374-ccdad8589140" providerId="ADAL" clId="{6649061F-1686-6E42-8CBD-4F0AAB90E7CD}" dt="2022-01-06T19:08:46.681" v="731" actId="1076"/>
          <ac:picMkLst>
            <pc:docMk/>
            <pc:sldMk cId="743684689" sldId="267"/>
            <ac:picMk id="167" creationId="{58CAA980-D1E6-AA4C-A334-C0D57A74D895}"/>
          </ac:picMkLst>
        </pc:picChg>
        <pc:picChg chg="mod">
          <ac:chgData name="Narang, Sonali" userId="9e80b397-6e2f-49b1-9374-ccdad8589140" providerId="ADAL" clId="{6649061F-1686-6E42-8CBD-4F0AAB90E7CD}" dt="2022-01-06T19:08:46.681" v="731" actId="1076"/>
          <ac:picMkLst>
            <pc:docMk/>
            <pc:sldMk cId="743684689" sldId="267"/>
            <ac:picMk id="169" creationId="{5A30999A-89D7-8C40-9571-87F0979C7EAA}"/>
          </ac:picMkLst>
        </pc:picChg>
        <pc:picChg chg="mod">
          <ac:chgData name="Narang, Sonali" userId="9e80b397-6e2f-49b1-9374-ccdad8589140" providerId="ADAL" clId="{6649061F-1686-6E42-8CBD-4F0AAB90E7CD}" dt="2022-01-06T19:08:46.681" v="731" actId="1076"/>
          <ac:picMkLst>
            <pc:docMk/>
            <pc:sldMk cId="743684689" sldId="267"/>
            <ac:picMk id="171" creationId="{9C4DDE62-3BC7-ED45-A82E-A3C21D506B79}"/>
          </ac:picMkLst>
        </pc:pic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80" creationId="{02726A21-ADD2-1243-8977-5A816477394E}"/>
          </ac:cxnSpMkLst>
        </pc:cxn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81" creationId="{79072AE3-9898-A948-BFAA-5649EB750CCA}"/>
          </ac:cxnSpMkLst>
        </pc:cxn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82" creationId="{7F37C0B0-D99F-C641-A6F6-8728D64CAA11}"/>
          </ac:cxnSpMkLst>
        </pc:cxn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116" creationId="{549ACEAA-DD9B-1743-8EF5-638D8166CECF}"/>
          </ac:cxnSpMkLst>
        </pc:cxn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121" creationId="{8F1FF133-BC51-1A4B-B0C1-EBDCCE727E2B}"/>
          </ac:cxnSpMkLst>
        </pc:cxnChg>
        <pc:cxnChg chg="mod">
          <ac:chgData name="Narang, Sonali" userId="9e80b397-6e2f-49b1-9374-ccdad8589140" providerId="ADAL" clId="{6649061F-1686-6E42-8CBD-4F0AAB90E7CD}" dt="2022-01-06T19:09:14.932" v="739"/>
          <ac:cxnSpMkLst>
            <pc:docMk/>
            <pc:sldMk cId="743684689" sldId="267"/>
            <ac:cxnSpMk id="153" creationId="{82885967-112C-8E4B-A863-B154AEC3EFBD}"/>
          </ac:cxnSpMkLst>
        </pc:cxnChg>
      </pc:sldChg>
      <pc:sldChg chg="del">
        <pc:chgData name="Narang, Sonali" userId="9e80b397-6e2f-49b1-9374-ccdad8589140" providerId="ADAL" clId="{6649061F-1686-6E42-8CBD-4F0AAB90E7CD}" dt="2022-01-04T21:46:01.722" v="64" actId="2696"/>
        <pc:sldMkLst>
          <pc:docMk/>
          <pc:sldMk cId="2720918902" sldId="269"/>
        </pc:sldMkLst>
      </pc:sldChg>
      <pc:sldChg chg="addSp delSp modSp mod">
        <pc:chgData name="Narang, Sonali" userId="9e80b397-6e2f-49b1-9374-ccdad8589140" providerId="ADAL" clId="{6649061F-1686-6E42-8CBD-4F0AAB90E7CD}" dt="2022-01-24T19:33:23.891" v="1333" actId="478"/>
        <pc:sldMkLst>
          <pc:docMk/>
          <pc:sldMk cId="2078269342" sldId="277"/>
        </pc:sldMkLst>
        <pc:spChg chg="mod">
          <ac:chgData name="Narang, Sonali" userId="9e80b397-6e2f-49b1-9374-ccdad8589140" providerId="ADAL" clId="{6649061F-1686-6E42-8CBD-4F0AAB90E7CD}" dt="2022-01-04T21:43:45.291" v="22" actId="12788"/>
          <ac:spMkLst>
            <pc:docMk/>
            <pc:sldMk cId="2078269342" sldId="277"/>
            <ac:spMk id="5" creationId="{FAFFEC37-A0C5-5846-8534-22E3DEF6CEF4}"/>
          </ac:spMkLst>
        </pc:spChg>
        <pc:spChg chg="mod">
          <ac:chgData name="Narang, Sonali" userId="9e80b397-6e2f-49b1-9374-ccdad8589140" providerId="ADAL" clId="{6649061F-1686-6E42-8CBD-4F0AAB90E7CD}" dt="2022-01-04T21:43:56.191" v="30" actId="1035"/>
          <ac:spMkLst>
            <pc:docMk/>
            <pc:sldMk cId="2078269342" sldId="277"/>
            <ac:spMk id="7" creationId="{4C5F5CAE-FBFD-964D-A356-746AAC86DC9E}"/>
          </ac:spMkLst>
        </pc:spChg>
        <pc:spChg chg="mod">
          <ac:chgData name="Narang, Sonali" userId="9e80b397-6e2f-49b1-9374-ccdad8589140" providerId="ADAL" clId="{6649061F-1686-6E42-8CBD-4F0AAB90E7CD}" dt="2022-01-04T21:43:45.291" v="22" actId="12788"/>
          <ac:spMkLst>
            <pc:docMk/>
            <pc:sldMk cId="2078269342" sldId="277"/>
            <ac:spMk id="30" creationId="{655ACA25-EBE0-DD45-930F-AD76C4C0A2A8}"/>
          </ac:spMkLst>
        </pc:spChg>
        <pc:spChg chg="mod">
          <ac:chgData name="Narang, Sonali" userId="9e80b397-6e2f-49b1-9374-ccdad8589140" providerId="ADAL" clId="{6649061F-1686-6E42-8CBD-4F0AAB90E7CD}" dt="2022-01-05T18:59:53.719" v="538" actId="20577"/>
          <ac:spMkLst>
            <pc:docMk/>
            <pc:sldMk cId="2078269342" sldId="277"/>
            <ac:spMk id="43" creationId="{80550978-24C0-3343-83A5-8C1A9BAE7634}"/>
          </ac:spMkLst>
        </pc:spChg>
        <pc:spChg chg="mod">
          <ac:chgData name="Narang, Sonali" userId="9e80b397-6e2f-49b1-9374-ccdad8589140" providerId="ADAL" clId="{6649061F-1686-6E42-8CBD-4F0AAB90E7CD}" dt="2022-01-05T19:00:24.871" v="547" actId="20577"/>
          <ac:spMkLst>
            <pc:docMk/>
            <pc:sldMk cId="2078269342" sldId="277"/>
            <ac:spMk id="44" creationId="{1DCDF1E7-F2D5-7040-8B69-A9D74ED63E9D}"/>
          </ac:spMkLst>
        </pc:spChg>
        <pc:spChg chg="mod">
          <ac:chgData name="Narang, Sonali" userId="9e80b397-6e2f-49b1-9374-ccdad8589140" providerId="ADAL" clId="{6649061F-1686-6E42-8CBD-4F0AAB90E7CD}" dt="2022-01-05T19:00:46.973" v="559" actId="1038"/>
          <ac:spMkLst>
            <pc:docMk/>
            <pc:sldMk cId="2078269342" sldId="277"/>
            <ac:spMk id="45" creationId="{0EECBD3B-E09F-6A4A-85ED-701545048DDA}"/>
          </ac:spMkLst>
        </pc:spChg>
        <pc:spChg chg="mod">
          <ac:chgData name="Narang, Sonali" userId="9e80b397-6e2f-49b1-9374-ccdad8589140" providerId="ADAL" clId="{6649061F-1686-6E42-8CBD-4F0AAB90E7CD}" dt="2022-01-05T18:59:31.734" v="532" actId="1037"/>
          <ac:spMkLst>
            <pc:docMk/>
            <pc:sldMk cId="2078269342" sldId="277"/>
            <ac:spMk id="46" creationId="{DA1162E1-4AFD-CB46-A7EE-BE6EE201DCAB}"/>
          </ac:spMkLst>
        </pc:spChg>
        <pc:spChg chg="mod">
          <ac:chgData name="Narang, Sonali" userId="9e80b397-6e2f-49b1-9374-ccdad8589140" providerId="ADAL" clId="{6649061F-1686-6E42-8CBD-4F0AAB90E7CD}" dt="2022-01-05T18:59:25.276" v="528" actId="20577"/>
          <ac:spMkLst>
            <pc:docMk/>
            <pc:sldMk cId="2078269342" sldId="277"/>
            <ac:spMk id="47" creationId="{EA48E1D2-7D85-BC4B-8305-622111AA60CF}"/>
          </ac:spMkLst>
        </pc:spChg>
        <pc:spChg chg="mod">
          <ac:chgData name="Narang, Sonali" userId="9e80b397-6e2f-49b1-9374-ccdad8589140" providerId="ADAL" clId="{6649061F-1686-6E42-8CBD-4F0AAB90E7CD}" dt="2022-01-05T18:59:03.774" v="521" actId="20577"/>
          <ac:spMkLst>
            <pc:docMk/>
            <pc:sldMk cId="2078269342" sldId="277"/>
            <ac:spMk id="48" creationId="{B4179409-2FD8-7C4E-AC9F-D25DB456593D}"/>
          </ac:spMkLst>
        </pc:spChg>
        <pc:spChg chg="mod">
          <ac:chgData name="Narang, Sonali" userId="9e80b397-6e2f-49b1-9374-ccdad8589140" providerId="ADAL" clId="{6649061F-1686-6E42-8CBD-4F0AAB90E7CD}" dt="2022-01-05T18:59:16.592" v="525" actId="20577"/>
          <ac:spMkLst>
            <pc:docMk/>
            <pc:sldMk cId="2078269342" sldId="277"/>
            <ac:spMk id="49" creationId="{1F5B7F0C-765C-174A-8D4A-2F5F300226DF}"/>
          </ac:spMkLst>
        </pc:spChg>
        <pc:spChg chg="mod">
          <ac:chgData name="Narang, Sonali" userId="9e80b397-6e2f-49b1-9374-ccdad8589140" providerId="ADAL" clId="{6649061F-1686-6E42-8CBD-4F0AAB90E7CD}" dt="2022-01-04T21:41:48.131" v="7" actId="207"/>
          <ac:spMkLst>
            <pc:docMk/>
            <pc:sldMk cId="2078269342" sldId="277"/>
            <ac:spMk id="50" creationId="{0F0B45AA-52DB-1447-8A33-BBF5E33B5452}"/>
          </ac:spMkLst>
        </pc:spChg>
        <pc:spChg chg="mod">
          <ac:chgData name="Narang, Sonali" userId="9e80b397-6e2f-49b1-9374-ccdad8589140" providerId="ADAL" clId="{6649061F-1686-6E42-8CBD-4F0AAB90E7CD}" dt="2022-01-04T21:41:48.131" v="7" actId="207"/>
          <ac:spMkLst>
            <pc:docMk/>
            <pc:sldMk cId="2078269342" sldId="277"/>
            <ac:spMk id="51" creationId="{E015A8BF-3A6B-9D4E-8103-F499E63459D8}"/>
          </ac:spMkLst>
        </pc:spChg>
        <pc:spChg chg="mod">
          <ac:chgData name="Narang, Sonali" userId="9e80b397-6e2f-49b1-9374-ccdad8589140" providerId="ADAL" clId="{6649061F-1686-6E42-8CBD-4F0AAB90E7CD}" dt="2022-01-04T21:41:48.131" v="7" actId="207"/>
          <ac:spMkLst>
            <pc:docMk/>
            <pc:sldMk cId="2078269342" sldId="277"/>
            <ac:spMk id="52" creationId="{980B69CD-ADC7-284F-A16B-05F87958BC66}"/>
          </ac:spMkLst>
        </pc:spChg>
        <pc:spChg chg="mod">
          <ac:chgData name="Narang, Sonali" userId="9e80b397-6e2f-49b1-9374-ccdad8589140" providerId="ADAL" clId="{6649061F-1686-6E42-8CBD-4F0AAB90E7CD}" dt="2022-01-05T18:56:55.262" v="490" actId="20577"/>
          <ac:spMkLst>
            <pc:docMk/>
            <pc:sldMk cId="2078269342" sldId="277"/>
            <ac:spMk id="54" creationId="{630EF4BB-5676-3B48-8C65-19F74E7421C4}"/>
          </ac:spMkLst>
        </pc:spChg>
        <pc:spChg chg="mod">
          <ac:chgData name="Narang, Sonali" userId="9e80b397-6e2f-49b1-9374-ccdad8589140" providerId="ADAL" clId="{6649061F-1686-6E42-8CBD-4F0AAB90E7CD}" dt="2022-01-05T18:57:16.310" v="496" actId="20577"/>
          <ac:spMkLst>
            <pc:docMk/>
            <pc:sldMk cId="2078269342" sldId="277"/>
            <ac:spMk id="55" creationId="{F988E475-74C4-3C4F-9891-2EA2F939D523}"/>
          </ac:spMkLst>
        </pc:spChg>
        <pc:spChg chg="add del mod">
          <ac:chgData name="Narang, Sonali" userId="9e80b397-6e2f-49b1-9374-ccdad8589140" providerId="ADAL" clId="{6649061F-1686-6E42-8CBD-4F0AAB90E7CD}" dt="2022-01-05T19:01:00.264" v="563" actId="1038"/>
          <ac:spMkLst>
            <pc:docMk/>
            <pc:sldMk cId="2078269342" sldId="277"/>
            <ac:spMk id="56" creationId="{D63EC677-39AE-414C-9352-563C974F82EA}"/>
          </ac:spMkLst>
        </pc:spChg>
        <pc:spChg chg="mod">
          <ac:chgData name="Narang, Sonali" userId="9e80b397-6e2f-49b1-9374-ccdad8589140" providerId="ADAL" clId="{6649061F-1686-6E42-8CBD-4F0AAB90E7CD}" dt="2022-01-05T18:55:43.985" v="475" actId="20577"/>
          <ac:spMkLst>
            <pc:docMk/>
            <pc:sldMk cId="2078269342" sldId="277"/>
            <ac:spMk id="57" creationId="{057C0F8D-04C2-0542-8ABC-5B2FE168C537}"/>
          </ac:spMkLst>
        </pc:spChg>
        <pc:spChg chg="mod">
          <ac:chgData name="Narang, Sonali" userId="9e80b397-6e2f-49b1-9374-ccdad8589140" providerId="ADAL" clId="{6649061F-1686-6E42-8CBD-4F0AAB90E7CD}" dt="2022-01-05T18:56:31.444" v="487" actId="20577"/>
          <ac:spMkLst>
            <pc:docMk/>
            <pc:sldMk cId="2078269342" sldId="277"/>
            <ac:spMk id="58" creationId="{5BD00D48-3568-4142-9CE5-0DD04E862D3C}"/>
          </ac:spMkLst>
        </pc:spChg>
        <pc:spChg chg="mod">
          <ac:chgData name="Narang, Sonali" userId="9e80b397-6e2f-49b1-9374-ccdad8589140" providerId="ADAL" clId="{6649061F-1686-6E42-8CBD-4F0AAB90E7CD}" dt="2022-01-05T18:56:10.341" v="479" actId="20577"/>
          <ac:spMkLst>
            <pc:docMk/>
            <pc:sldMk cId="2078269342" sldId="277"/>
            <ac:spMk id="59" creationId="{EB23BEA0-6350-324D-A12E-7DEB49AF3BE8}"/>
          </ac:spMkLst>
        </pc:spChg>
        <pc:spChg chg="mod">
          <ac:chgData name="Narang, Sonali" userId="9e80b397-6e2f-49b1-9374-ccdad8589140" providerId="ADAL" clId="{6649061F-1686-6E42-8CBD-4F0AAB90E7CD}" dt="2022-01-05T18:56:20.973" v="483" actId="20577"/>
          <ac:spMkLst>
            <pc:docMk/>
            <pc:sldMk cId="2078269342" sldId="277"/>
            <ac:spMk id="60" creationId="{E62460AA-D9B6-E345-A0C7-8FBD7230EDC2}"/>
          </ac:spMkLst>
        </pc:spChg>
        <pc:spChg chg="mod">
          <ac:chgData name="Narang, Sonali" userId="9e80b397-6e2f-49b1-9374-ccdad8589140" providerId="ADAL" clId="{6649061F-1686-6E42-8CBD-4F0AAB90E7CD}" dt="2022-01-04T21:41:54.045" v="8" actId="207"/>
          <ac:spMkLst>
            <pc:docMk/>
            <pc:sldMk cId="2078269342" sldId="277"/>
            <ac:spMk id="61" creationId="{FC1C0D10-87A7-4243-8678-5514D2F29956}"/>
          </ac:spMkLst>
        </pc:spChg>
        <pc:spChg chg="mod">
          <ac:chgData name="Narang, Sonali" userId="9e80b397-6e2f-49b1-9374-ccdad8589140" providerId="ADAL" clId="{6649061F-1686-6E42-8CBD-4F0AAB90E7CD}" dt="2022-01-04T21:41:54.045" v="8" actId="207"/>
          <ac:spMkLst>
            <pc:docMk/>
            <pc:sldMk cId="2078269342" sldId="277"/>
            <ac:spMk id="62" creationId="{82C2B934-697C-EA44-BEC5-478C948B0590}"/>
          </ac:spMkLst>
        </pc:spChg>
        <pc:spChg chg="mod">
          <ac:chgData name="Narang, Sonali" userId="9e80b397-6e2f-49b1-9374-ccdad8589140" providerId="ADAL" clId="{6649061F-1686-6E42-8CBD-4F0AAB90E7CD}" dt="2022-01-04T21:41:54.045" v="8" actId="207"/>
          <ac:spMkLst>
            <pc:docMk/>
            <pc:sldMk cId="2078269342" sldId="277"/>
            <ac:spMk id="63" creationId="{C9C6D42A-C6D9-7849-8C5B-4178D8D71A28}"/>
          </ac:spMkLst>
        </pc:spChg>
        <pc:spChg chg="del">
          <ac:chgData name="Narang, Sonali" userId="9e80b397-6e2f-49b1-9374-ccdad8589140" providerId="ADAL" clId="{6649061F-1686-6E42-8CBD-4F0AAB90E7CD}" dt="2022-01-04T21:14:59.493" v="6" actId="478"/>
          <ac:spMkLst>
            <pc:docMk/>
            <pc:sldMk cId="2078269342" sldId="277"/>
            <ac:spMk id="65" creationId="{2EDEF6A0-F103-5349-A53F-A2BE3FD1BBD5}"/>
          </ac:spMkLst>
        </pc:spChg>
        <pc:spChg chg="add del mod">
          <ac:chgData name="Narang, Sonali" userId="9e80b397-6e2f-49b1-9374-ccdad8589140" providerId="ADAL" clId="{6649061F-1686-6E42-8CBD-4F0AAB90E7CD}" dt="2022-01-24T19:33:20.238" v="1331" actId="1076"/>
          <ac:spMkLst>
            <pc:docMk/>
            <pc:sldMk cId="2078269342" sldId="277"/>
            <ac:spMk id="72" creationId="{6EFCDAB7-F8A1-714A-A38C-A603CDFDE6F4}"/>
          </ac:spMkLst>
        </pc:spChg>
        <pc:grpChg chg="del mod">
          <ac:chgData name="Narang, Sonali" userId="9e80b397-6e2f-49b1-9374-ccdad8589140" providerId="ADAL" clId="{6649061F-1686-6E42-8CBD-4F0AAB90E7CD}" dt="2022-01-04T21:42:51.253" v="13" actId="478"/>
          <ac:grpSpMkLst>
            <pc:docMk/>
            <pc:sldMk cId="2078269342" sldId="277"/>
            <ac:grpSpMk id="14" creationId="{86D7D6E9-6736-D243-B10A-A0E8A40C0FDA}"/>
          </ac:grpSpMkLst>
        </pc:grpChg>
        <pc:grpChg chg="del mod">
          <ac:chgData name="Narang, Sonali" userId="9e80b397-6e2f-49b1-9374-ccdad8589140" providerId="ADAL" clId="{6649061F-1686-6E42-8CBD-4F0AAB90E7CD}" dt="2022-01-04T21:42:51.253" v="13" actId="478"/>
          <ac:grpSpMkLst>
            <pc:docMk/>
            <pc:sldMk cId="2078269342" sldId="277"/>
            <ac:grpSpMk id="19" creationId="{6FB40037-B603-9443-A847-58CB44679B55}"/>
          </ac:grpSpMkLst>
        </pc:grpChg>
        <pc:grpChg chg="del mod">
          <ac:chgData name="Narang, Sonali" userId="9e80b397-6e2f-49b1-9374-ccdad8589140" providerId="ADAL" clId="{6649061F-1686-6E42-8CBD-4F0AAB90E7CD}" dt="2022-01-04T21:42:51.253" v="13" actId="478"/>
          <ac:grpSpMkLst>
            <pc:docMk/>
            <pc:sldMk cId="2078269342" sldId="277"/>
            <ac:grpSpMk id="24" creationId="{27C39882-C3D6-6943-83E0-2D2C3AC6B4EE}"/>
          </ac:grpSpMkLst>
        </pc:grpChg>
        <pc:grpChg chg="mod">
          <ac:chgData name="Narang, Sonali" userId="9e80b397-6e2f-49b1-9374-ccdad8589140" providerId="ADAL" clId="{6649061F-1686-6E42-8CBD-4F0AAB90E7CD}" dt="2022-01-04T21:42:55.895" v="14" actId="1076"/>
          <ac:grpSpMkLst>
            <pc:docMk/>
            <pc:sldMk cId="2078269342" sldId="277"/>
            <ac:grpSpMk id="31" creationId="{D470D811-2477-3546-A8D8-048846B3651A}"/>
          </ac:grpSpMkLst>
        </pc:grpChg>
        <pc:picChg chg="del">
          <ac:chgData name="Narang, Sonali" userId="9e80b397-6e2f-49b1-9374-ccdad8589140" providerId="ADAL" clId="{6649061F-1686-6E42-8CBD-4F0AAB90E7CD}" dt="2022-01-04T21:14:17.859" v="0" actId="478"/>
          <ac:picMkLst>
            <pc:docMk/>
            <pc:sldMk cId="2078269342" sldId="277"/>
            <ac:picMk id="64" creationId="{BDC1A47A-9479-3E4D-A349-CF06699F2793}"/>
          </ac:picMkLst>
        </pc:picChg>
        <pc:picChg chg="add del mod">
          <ac:chgData name="Narang, Sonali" userId="9e80b397-6e2f-49b1-9374-ccdad8589140" providerId="ADAL" clId="{6649061F-1686-6E42-8CBD-4F0AAB90E7CD}" dt="2022-01-24T19:33:23.891" v="1333" actId="478"/>
          <ac:picMkLst>
            <pc:docMk/>
            <pc:sldMk cId="2078269342" sldId="277"/>
            <ac:picMk id="66" creationId="{3947B4BD-5497-734B-B72A-856B61E23828}"/>
          </ac:picMkLst>
        </pc:picChg>
        <pc:picChg chg="add del mod">
          <ac:chgData name="Narang, Sonali" userId="9e80b397-6e2f-49b1-9374-ccdad8589140" providerId="ADAL" clId="{6649061F-1686-6E42-8CBD-4F0AAB90E7CD}" dt="2022-01-24T19:33:23.891" v="1333" actId="478"/>
          <ac:picMkLst>
            <pc:docMk/>
            <pc:sldMk cId="2078269342" sldId="277"/>
            <ac:picMk id="67" creationId="{35277A42-A4F2-E644-8DD1-70306EA4FB98}"/>
          </ac:picMkLst>
        </pc:picChg>
        <pc:picChg chg="add del mod">
          <ac:chgData name="Narang, Sonali" userId="9e80b397-6e2f-49b1-9374-ccdad8589140" providerId="ADAL" clId="{6649061F-1686-6E42-8CBD-4F0AAB90E7CD}" dt="2022-01-24T19:33:23.891" v="1333" actId="478"/>
          <ac:picMkLst>
            <pc:docMk/>
            <pc:sldMk cId="2078269342" sldId="277"/>
            <ac:picMk id="68" creationId="{8F8E5938-471E-244A-AC6A-995ED39B84DC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69" creationId="{6B3A249F-75CB-FC48-8C84-664E3D850410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70" creationId="{FF23310C-2E41-8843-8460-13FAE233DEF8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71" creationId="{0E8A457F-217F-2E4E-8670-43D6977E3918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73" creationId="{ECEFC19C-720B-AE4D-99C2-274672AB20E1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74" creationId="{FBB6F25E-F52E-B649-96A1-89ECC153CB27}"/>
          </ac:picMkLst>
        </pc:picChg>
        <pc:picChg chg="add mod">
          <ac:chgData name="Narang, Sonali" userId="9e80b397-6e2f-49b1-9374-ccdad8589140" providerId="ADAL" clId="{6649061F-1686-6E42-8CBD-4F0AAB90E7CD}" dt="2022-01-24T19:33:20.877" v="1332" actId="1076"/>
          <ac:picMkLst>
            <pc:docMk/>
            <pc:sldMk cId="2078269342" sldId="277"/>
            <ac:picMk id="75" creationId="{6D93B34D-FCFC-2347-8BDA-8740FF1F0AAA}"/>
          </ac:picMkLst>
        </pc:picChg>
      </pc:sldChg>
      <pc:sldChg chg="addSp delSp modSp mod">
        <pc:chgData name="Narang, Sonali" userId="9e80b397-6e2f-49b1-9374-ccdad8589140" providerId="ADAL" clId="{6649061F-1686-6E42-8CBD-4F0AAB90E7CD}" dt="2022-01-18T16:12:38.358" v="1316"/>
        <pc:sldMkLst>
          <pc:docMk/>
          <pc:sldMk cId="3214590643" sldId="280"/>
        </pc:sldMkLst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15" creationId="{375E8C0A-6F89-6E40-A475-867009B238D9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16" creationId="{D31BF6C7-815B-4F41-853D-6BECC57D8652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8" creationId="{1A104620-61A4-3542-875A-AA42D8D5B5C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9" creationId="{523D9102-748D-1F48-AD1E-B92DCFC25BB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20" creationId="{C4D9EC67-F86E-C94E-AC78-95C7E0F2ACFC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21" creationId="{D791F170-59D2-4544-A02E-B046E26C683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22" creationId="{C42F90B6-D415-D348-BD08-27B6EB96CF64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23" creationId="{A7731E67-A549-174E-A445-45ADEA08EC36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24" creationId="{963C536B-7A00-9F44-96D8-38525AE65ED6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25" creationId="{805B86B2-9FAD-D444-A38C-0986F274B888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26" creationId="{22BEC20B-6D30-ED4F-9D18-3587C631B304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27" creationId="{DD07F794-0ED7-3B45-934F-75C5198EA08C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29" creationId="{A9E1861C-7CC4-7C48-AEE3-56FE3E797472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0" creationId="{4377C775-FD17-CF4E-9AB2-CCCEF55DA30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1" creationId="{D74EEC57-CFC3-D740-A75C-29D18A2469A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2" creationId="{823EC379-9686-D54D-9AEA-8300CFD6EF5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3" creationId="{28C8520A-356A-9F41-9A57-F0E7CFFB7B9D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5" creationId="{566EF984-86BD-684E-B65E-E01778B11BB1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6" creationId="{0B1ABF64-B281-254E-829A-97914DE8030C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7" creationId="{C36EA696-FF47-304B-ABC8-842974CE6818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8" creationId="{1451F896-34F7-3248-9198-9E1323A4ACAA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39" creationId="{46AA5AE4-2176-CA43-B751-85C16F0FA0E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41" creationId="{AC304915-3F54-7749-88AE-6F5017F0DAE0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42" creationId="{E671A400-3CD1-0D4C-A088-AC330C373C1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43" creationId="{DCC3FA21-9DE9-594D-AA12-EBE99F45B164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44" creationId="{9A819F2E-F413-E44A-99EE-090FAE5D73F7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58" creationId="{7D6679C5-C692-1C46-BA7D-EA8FEFE71BAC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0" creationId="{ECB9655B-38F0-C449-A868-F2054E4A43D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1" creationId="{DC3F2768-21F9-3F44-AE83-808C8833D66D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2" creationId="{AD98F0E6-0A23-3E4E-9D42-7D0C90F74E02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3" creationId="{B97781F2-EDA9-E747-A322-153B6A099908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4" creationId="{A8603FF3-8A62-1148-86DB-3104FDAD94C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6" creationId="{BE3BDC07-BD0A-AF4E-AB35-34E1C3EB2CDB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7" creationId="{A7F636AD-97DF-0746-8996-3BCBC4B78E69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8" creationId="{5004A834-367F-5642-B3B2-F743BF73AE71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69" creationId="{21BFEE40-A6D8-4541-818D-EB5BF147E018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0" creationId="{35D96E96-97A9-6644-B89E-CAE28FCD69B7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71" creationId="{FA398458-CA10-A84F-8ACD-F81CC8FEF7AB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72" creationId="{5BBA44E2-403C-8346-9D3B-1A68856E243A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4" creationId="{879DDFCE-6002-D74F-9052-45B5CC6C9E5B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5" creationId="{DA535674-480C-DF41-B7A7-54A8C6AB996E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6" creationId="{A667425D-5F45-8B44-B4F7-D2D73F08071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7" creationId="{80F6F94A-50AE-BF43-A7D3-5458F2006CD3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78" creationId="{7CD7EA6F-8007-F94B-B50A-8D5E1F6D3DA2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79" creationId="{B03DAF63-75E8-954C-8C8B-70F8509B7313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80" creationId="{D36C9534-C4DA-9642-961E-E0566905C894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81" creationId="{C532206B-BBB4-3145-8DB1-2B27BCE53619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82" creationId="{20867B7C-8670-CC4D-A74E-E2959477325B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83" creationId="{689C272F-98E9-AE4D-BE28-4FD5844E4250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85" creationId="{3CACBD6E-4259-1147-8CE5-60D397D42603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86" creationId="{55B7F8B7-56C7-4A46-97E7-C2ED40AD72C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87" creationId="{A3068D93-C61F-614D-B818-7A5920385DE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88" creationId="{BDDD1A45-676B-5F42-86EA-B2E7EDB28EDE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89" creationId="{2279CC8A-473B-8B4A-BB51-39A9B95F705D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1" creationId="{097A6F2E-363C-5A47-8D54-5C200FF7C5A2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2" creationId="{04FB8AFB-57F9-0847-B324-FEEB76A9274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3" creationId="{D7B9A224-63E3-4F48-BE69-6DB2719BC3E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4" creationId="{D1A3FE16-E872-F143-BDF9-DF7B7AA60E07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5" creationId="{E71187F0-B461-3540-AE9B-9276BE326A2C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7" creationId="{27EE31BD-835D-5842-9F39-BAB751182AB6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8" creationId="{89E2E195-5561-EF44-9D74-29698C819892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99" creationId="{6357FA04-9117-2E46-A788-41ED6CE7B1F8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0" creationId="{235AB6AD-4AC8-2545-9BE4-F6814DF5BEC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1" creationId="{D6311875-AEEB-EF43-B11B-C1AAF0E86AD3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3" creationId="{802B9EE2-ECD0-E04C-9030-04B738D7CDAD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4" creationId="{79649139-268E-0F42-AAC9-DE8D4F8E65A5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5" creationId="{4E3EEF87-B726-D248-8402-29EBF8FF3990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6" creationId="{F1F50485-087C-AB41-8F1D-29FC35AEED80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7" creationId="{2259AE08-28B7-AC46-A232-AB24702FA0B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09" creationId="{D2358122-5FFF-4449-822D-97FE2EF347D9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10" creationId="{0201B91F-DD3D-3949-A927-91ACC06367EF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11" creationId="{700BC039-9083-0D47-83E6-0E53BAA36E77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12" creationId="{1073D2DB-2D7B-B84A-AFB0-C0E6C097F0D1}"/>
          </ac:spMkLst>
        </pc:spChg>
        <pc:spChg chg="mod">
          <ac:chgData name="Narang, Sonali" userId="9e80b397-6e2f-49b1-9374-ccdad8589140" providerId="ADAL" clId="{6649061F-1686-6E42-8CBD-4F0AAB90E7CD}" dt="2022-01-18T16:12:32.449" v="1313"/>
          <ac:spMkLst>
            <pc:docMk/>
            <pc:sldMk cId="3214590643" sldId="280"/>
            <ac:spMk id="113" creationId="{6F15E995-6682-A440-B8F8-B0B2776772A0}"/>
          </ac:spMkLst>
        </pc:spChg>
        <pc:spChg chg="add del mod">
          <ac:chgData name="Narang, Sonali" userId="9e80b397-6e2f-49b1-9374-ccdad8589140" providerId="ADAL" clId="{6649061F-1686-6E42-8CBD-4F0AAB90E7CD}" dt="2022-01-18T16:12:38.358" v="1316"/>
          <ac:spMkLst>
            <pc:docMk/>
            <pc:sldMk cId="3214590643" sldId="280"/>
            <ac:spMk id="114" creationId="{EB780DAD-5BA3-C246-9D14-5BE4D06D33E7}"/>
          </ac:spMkLst>
        </pc:s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17" creationId="{0202A5CD-96A9-D643-AF2D-697E8A64905F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28" creationId="{7B6CA663-B3D7-DD40-9FC6-73C4A4DD96F5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34" creationId="{CE977FC1-E6B3-8441-91AB-DF959B109090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40" creationId="{20119EAE-DD92-BF42-91D3-FF7CF3983D40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59" creationId="{8C28EC04-76BC-0146-A341-CD4019DA2030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65" creationId="{8EF14D8D-DF3A-FA4A-ABF3-F3C770DD86D0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73" creationId="{24BC37F8-D4CF-594E-8A3D-4AA954AF819A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84" creationId="{78B08532-C5CB-F04D-960F-EA6F6349BB41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90" creationId="{2F7C7449-4C26-D54F-9B2A-15B6C980ABE1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96" creationId="{2191FFDA-2E91-0F46-9859-49182CD4344D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102" creationId="{7609D048-6903-874A-9CEF-1C35D2880888}"/>
          </ac:grpSpMkLst>
        </pc:grpChg>
        <pc:grpChg chg="add del mod">
          <ac:chgData name="Narang, Sonali" userId="9e80b397-6e2f-49b1-9374-ccdad8589140" providerId="ADAL" clId="{6649061F-1686-6E42-8CBD-4F0AAB90E7CD}" dt="2022-01-18T16:12:38.358" v="1316"/>
          <ac:grpSpMkLst>
            <pc:docMk/>
            <pc:sldMk cId="3214590643" sldId="280"/>
            <ac:grpSpMk id="108" creationId="{B02B882C-85D3-0140-B889-56EB7F7BAE82}"/>
          </ac:grpSpMkLst>
        </pc:grpChg>
        <pc:graphicFrameChg chg="add del mod">
          <ac:chgData name="Narang, Sonali" userId="9e80b397-6e2f-49b1-9374-ccdad8589140" providerId="ADAL" clId="{6649061F-1686-6E42-8CBD-4F0AAB90E7CD}" dt="2022-01-18T16:12:38.358" v="1316"/>
          <ac:graphicFrameMkLst>
            <pc:docMk/>
            <pc:sldMk cId="3214590643" sldId="280"/>
            <ac:graphicFrameMk id="115" creationId="{A7DBFC29-A457-3947-BF4F-1B1CF6608736}"/>
          </ac:graphicFrameMkLst>
        </pc:graphicFrameChg>
        <pc:graphicFrameChg chg="add del mod">
          <ac:chgData name="Narang, Sonali" userId="9e80b397-6e2f-49b1-9374-ccdad8589140" providerId="ADAL" clId="{6649061F-1686-6E42-8CBD-4F0AAB90E7CD}" dt="2022-01-18T16:12:38.358" v="1316"/>
          <ac:graphicFrameMkLst>
            <pc:docMk/>
            <pc:sldMk cId="3214590643" sldId="280"/>
            <ac:graphicFrameMk id="116" creationId="{6A83438D-8E02-2A42-BBA9-6EA7B85EBE38}"/>
          </ac:graphicFrameMkLst>
        </pc:graphicFrameChg>
      </pc:sldChg>
      <pc:sldChg chg="del">
        <pc:chgData name="Narang, Sonali" userId="9e80b397-6e2f-49b1-9374-ccdad8589140" providerId="ADAL" clId="{6649061F-1686-6E42-8CBD-4F0AAB90E7CD}" dt="2022-01-04T21:58:51.479" v="135" actId="2696"/>
        <pc:sldMkLst>
          <pc:docMk/>
          <pc:sldMk cId="2252998334" sldId="285"/>
        </pc:sldMkLst>
      </pc:sldChg>
      <pc:sldChg chg="addSp delSp modSp del mod">
        <pc:chgData name="Narang, Sonali" userId="9e80b397-6e2f-49b1-9374-ccdad8589140" providerId="ADAL" clId="{6649061F-1686-6E42-8CBD-4F0AAB90E7CD}" dt="2022-01-06T19:10:23.379" v="752" actId="2696"/>
        <pc:sldMkLst>
          <pc:docMk/>
          <pc:sldMk cId="2363090238" sldId="286"/>
        </pc:sldMkLst>
        <pc:spChg chg="add del">
          <ac:chgData name="Narang, Sonali" userId="9e80b397-6e2f-49b1-9374-ccdad8589140" providerId="ADAL" clId="{6649061F-1686-6E42-8CBD-4F0AAB90E7CD}" dt="2022-01-06T19:09:13.646" v="738" actId="21"/>
          <ac:spMkLst>
            <pc:docMk/>
            <pc:sldMk cId="2363090238" sldId="286"/>
            <ac:spMk id="46" creationId="{BC4BD7F9-9550-3841-BBB5-1A58285A1D88}"/>
          </ac:spMkLst>
        </pc:spChg>
        <pc:spChg chg="del">
          <ac:chgData name="Narang, Sonali" userId="9e80b397-6e2f-49b1-9374-ccdad8589140" providerId="ADAL" clId="{6649061F-1686-6E42-8CBD-4F0AAB90E7CD}" dt="2022-01-06T19:09:13.646" v="738" actId="21"/>
          <ac:spMkLst>
            <pc:docMk/>
            <pc:sldMk cId="2363090238" sldId="286"/>
            <ac:spMk id="99" creationId="{A6CF131F-A22F-0D4F-BC16-1F904597B70D}"/>
          </ac:spMkLst>
        </pc:spChg>
        <pc:spChg chg="del">
          <ac:chgData name="Narang, Sonali" userId="9e80b397-6e2f-49b1-9374-ccdad8589140" providerId="ADAL" clId="{6649061F-1686-6E42-8CBD-4F0AAB90E7CD}" dt="2022-01-06T19:09:13.646" v="738" actId="21"/>
          <ac:spMkLst>
            <pc:docMk/>
            <pc:sldMk cId="2363090238" sldId="286"/>
            <ac:spMk id="100" creationId="{C1DAD01B-B0ED-F74F-B46D-C8C31DDDF537}"/>
          </ac:spMkLst>
        </pc:spChg>
        <pc:spChg chg="add del">
          <ac:chgData name="Narang, Sonali" userId="9e80b397-6e2f-49b1-9374-ccdad8589140" providerId="ADAL" clId="{6649061F-1686-6E42-8CBD-4F0AAB90E7CD}" dt="2022-01-06T19:09:13.646" v="738" actId="21"/>
          <ac:spMkLst>
            <pc:docMk/>
            <pc:sldMk cId="2363090238" sldId="286"/>
            <ac:spMk id="101" creationId="{5D5CA9D1-4434-2546-9649-E09C57218793}"/>
          </ac:spMkLst>
        </pc:spChg>
        <pc:grpChg chg="add del mod">
          <ac:chgData name="Narang, Sonali" userId="9e80b397-6e2f-49b1-9374-ccdad8589140" providerId="ADAL" clId="{6649061F-1686-6E42-8CBD-4F0AAB90E7CD}" dt="2022-01-06T19:09:13.646" v="738" actId="21"/>
          <ac:grpSpMkLst>
            <pc:docMk/>
            <pc:sldMk cId="2363090238" sldId="286"/>
            <ac:grpSpMk id="15" creationId="{FD22AA87-E326-E24C-81D2-69BC843CB881}"/>
          </ac:grpSpMkLst>
        </pc:grpChg>
        <pc:grpChg chg="add del mod">
          <ac:chgData name="Narang, Sonali" userId="9e80b397-6e2f-49b1-9374-ccdad8589140" providerId="ADAL" clId="{6649061F-1686-6E42-8CBD-4F0AAB90E7CD}" dt="2022-01-06T19:09:13.646" v="738" actId="21"/>
          <ac:grpSpMkLst>
            <pc:docMk/>
            <pc:sldMk cId="2363090238" sldId="286"/>
            <ac:grpSpMk id="64" creationId="{6E509F57-A7C6-7041-B6B6-87A1D93E0DF6}"/>
          </ac:grpSpMkLst>
        </pc:grpChg>
      </pc:sldChg>
      <pc:sldChg chg="delSp del mod">
        <pc:chgData name="Narang, Sonali" userId="9e80b397-6e2f-49b1-9374-ccdad8589140" providerId="ADAL" clId="{6649061F-1686-6E42-8CBD-4F0AAB90E7CD}" dt="2022-01-04T21:43:15.345" v="17" actId="2696"/>
        <pc:sldMkLst>
          <pc:docMk/>
          <pc:sldMk cId="4017312032" sldId="288"/>
        </pc:sldMkLst>
        <pc:picChg chg="del">
          <ac:chgData name="Narang, Sonali" userId="9e80b397-6e2f-49b1-9374-ccdad8589140" providerId="ADAL" clId="{6649061F-1686-6E42-8CBD-4F0AAB90E7CD}" dt="2022-01-04T21:42:14.515" v="9" actId="21"/>
          <ac:picMkLst>
            <pc:docMk/>
            <pc:sldMk cId="4017312032" sldId="288"/>
            <ac:picMk id="18" creationId="{B459A2BC-8172-5F41-881F-534AA8597A5E}"/>
          </ac:picMkLst>
        </pc:picChg>
        <pc:picChg chg="del">
          <ac:chgData name="Narang, Sonali" userId="9e80b397-6e2f-49b1-9374-ccdad8589140" providerId="ADAL" clId="{6649061F-1686-6E42-8CBD-4F0AAB90E7CD}" dt="2022-01-04T21:42:14.515" v="9" actId="21"/>
          <ac:picMkLst>
            <pc:docMk/>
            <pc:sldMk cId="4017312032" sldId="288"/>
            <ac:picMk id="20" creationId="{D8C3B42D-60C4-C141-A8FF-5F319D258264}"/>
          </ac:picMkLst>
        </pc:picChg>
        <pc:picChg chg="del">
          <ac:chgData name="Narang, Sonali" userId="9e80b397-6e2f-49b1-9374-ccdad8589140" providerId="ADAL" clId="{6649061F-1686-6E42-8CBD-4F0AAB90E7CD}" dt="2022-01-04T21:42:14.515" v="9" actId="21"/>
          <ac:picMkLst>
            <pc:docMk/>
            <pc:sldMk cId="4017312032" sldId="288"/>
            <ac:picMk id="22" creationId="{ACB215F7-DBEF-F943-978A-ECD3D03D267B}"/>
          </ac:picMkLst>
        </pc:picChg>
      </pc:sldChg>
      <pc:sldChg chg="addSp delSp modSp add del mod ord modShow">
        <pc:chgData name="Narang, Sonali" userId="9e80b397-6e2f-49b1-9374-ccdad8589140" providerId="ADAL" clId="{6649061F-1686-6E42-8CBD-4F0AAB90E7CD}" dt="2022-01-07T17:25:11.155" v="935" actId="2696"/>
        <pc:sldMkLst>
          <pc:docMk/>
          <pc:sldMk cId="3228625230" sldId="289"/>
        </pc:sldMkLst>
        <pc:spChg chg="add del mod">
          <ac:chgData name="Narang, Sonali" userId="9e80b397-6e2f-49b1-9374-ccdad8589140" providerId="ADAL" clId="{6649061F-1686-6E42-8CBD-4F0AAB90E7CD}" dt="2022-01-05T20:50:12.761" v="672" actId="478"/>
          <ac:spMkLst>
            <pc:docMk/>
            <pc:sldMk cId="3228625230" sldId="289"/>
            <ac:spMk id="2" creationId="{F4332411-AB8A-2545-9509-5EDF2225DAEB}"/>
          </ac:spMkLst>
        </pc:spChg>
        <pc:spChg chg="mod">
          <ac:chgData name="Narang, Sonali" userId="9e80b397-6e2f-49b1-9374-ccdad8589140" providerId="ADAL" clId="{6649061F-1686-6E42-8CBD-4F0AAB90E7CD}" dt="2022-01-04T21:44:36.483" v="58" actId="20577"/>
          <ac:spMkLst>
            <pc:docMk/>
            <pc:sldMk cId="3228625230" sldId="289"/>
            <ac:spMk id="4" creationId="{F6669B9D-B042-D548-BD0F-97015091799B}"/>
          </ac:spMkLst>
        </pc:spChg>
        <pc:spChg chg="add del mod">
          <ac:chgData name="Narang, Sonali" userId="9e80b397-6e2f-49b1-9374-ccdad8589140" providerId="ADAL" clId="{6649061F-1686-6E42-8CBD-4F0AAB90E7CD}" dt="2022-01-04T21:56:39.565" v="93" actId="21"/>
          <ac:spMkLst>
            <pc:docMk/>
            <pc:sldMk cId="3228625230" sldId="289"/>
            <ac:spMk id="12" creationId="{5D5A8000-1C0F-8942-B228-0B0E7699B307}"/>
          </ac:spMkLst>
        </pc:spChg>
        <pc:spChg chg="add del mod">
          <ac:chgData name="Narang, Sonali" userId="9e80b397-6e2f-49b1-9374-ccdad8589140" providerId="ADAL" clId="{6649061F-1686-6E42-8CBD-4F0AAB90E7CD}" dt="2022-01-04T21:56:39.565" v="93" actId="21"/>
          <ac:spMkLst>
            <pc:docMk/>
            <pc:sldMk cId="3228625230" sldId="289"/>
            <ac:spMk id="13" creationId="{FBDDEF83-BCBA-054C-B578-D53079AD7089}"/>
          </ac:spMkLst>
        </pc:spChg>
        <pc:graphicFrameChg chg="add del mod modGraphic">
          <ac:chgData name="Narang, Sonali" userId="9e80b397-6e2f-49b1-9374-ccdad8589140" providerId="ADAL" clId="{6649061F-1686-6E42-8CBD-4F0AAB90E7CD}" dt="2022-01-05T15:11:03.274" v="260" actId="478"/>
          <ac:graphicFrameMkLst>
            <pc:docMk/>
            <pc:sldMk cId="3228625230" sldId="289"/>
            <ac:graphicFrameMk id="10" creationId="{2AD806D8-8056-A543-AE25-457F49328268}"/>
          </ac:graphicFrameMkLst>
        </pc:graphicFrameChg>
        <pc:graphicFrameChg chg="add del mod modGraphic">
          <ac:chgData name="Narang, Sonali" userId="9e80b397-6e2f-49b1-9374-ccdad8589140" providerId="ADAL" clId="{6649061F-1686-6E42-8CBD-4F0AAB90E7CD}" dt="2022-01-04T21:56:39.565" v="93" actId="21"/>
          <ac:graphicFrameMkLst>
            <pc:docMk/>
            <pc:sldMk cId="3228625230" sldId="289"/>
            <ac:graphicFrameMk id="10" creationId="{5C07D058-9A73-6842-8072-310F3E7D7413}"/>
          </ac:graphicFrameMkLst>
        </pc:graphicFrameChg>
        <pc:graphicFrameChg chg="add del mod modGraphic">
          <ac:chgData name="Narang, Sonali" userId="9e80b397-6e2f-49b1-9374-ccdad8589140" providerId="ADAL" clId="{6649061F-1686-6E42-8CBD-4F0AAB90E7CD}" dt="2022-01-04T21:56:39.565" v="93" actId="21"/>
          <ac:graphicFrameMkLst>
            <pc:docMk/>
            <pc:sldMk cId="3228625230" sldId="289"/>
            <ac:graphicFrameMk id="11" creationId="{C8F85094-51E5-E844-82C7-EA321D9E7008}"/>
          </ac:graphicFrameMkLst>
        </pc:graphicFrameChg>
        <pc:graphicFrameChg chg="modGraphic">
          <ac:chgData name="Narang, Sonali" userId="9e80b397-6e2f-49b1-9374-ccdad8589140" providerId="ADAL" clId="{6649061F-1686-6E42-8CBD-4F0AAB90E7CD}" dt="2022-01-04T21:45:34.828" v="62" actId="12385"/>
          <ac:graphicFrameMkLst>
            <pc:docMk/>
            <pc:sldMk cId="3228625230" sldId="289"/>
            <ac:graphicFrameMk id="23" creationId="{0759C56F-7A2A-C44B-B409-4AB318968FB8}"/>
          </ac:graphicFrameMkLst>
        </pc:graphicFrameChg>
        <pc:graphicFrameChg chg="modGraphic">
          <ac:chgData name="Narang, Sonali" userId="9e80b397-6e2f-49b1-9374-ccdad8589140" providerId="ADAL" clId="{6649061F-1686-6E42-8CBD-4F0AAB90E7CD}" dt="2022-01-04T21:45:38.554" v="63" actId="12385"/>
          <ac:graphicFrameMkLst>
            <pc:docMk/>
            <pc:sldMk cId="3228625230" sldId="289"/>
            <ac:graphicFrameMk id="29" creationId="{BC405748-4B2C-FA41-AF30-80A906608DE3}"/>
          </ac:graphicFrameMkLst>
        </pc:graphicFrameChg>
      </pc:sldChg>
      <pc:sldChg chg="addSp delSp modSp mod">
        <pc:chgData name="Narang, Sonali" userId="9e80b397-6e2f-49b1-9374-ccdad8589140" providerId="ADAL" clId="{6649061F-1686-6E42-8CBD-4F0AAB90E7CD}" dt="2022-01-07T17:27:13.369" v="998" actId="20577"/>
        <pc:sldMkLst>
          <pc:docMk/>
          <pc:sldMk cId="2292075898" sldId="290"/>
        </pc:sldMkLst>
        <pc:spChg chg="mod">
          <ac:chgData name="Narang, Sonali" userId="9e80b397-6e2f-49b1-9374-ccdad8589140" providerId="ADAL" clId="{6649061F-1686-6E42-8CBD-4F0AAB90E7CD}" dt="2022-01-07T17:27:13.369" v="998" actId="20577"/>
          <ac:spMkLst>
            <pc:docMk/>
            <pc:sldMk cId="2292075898" sldId="290"/>
            <ac:spMk id="4" creationId="{F6669B9D-B042-D548-BD0F-97015091799B}"/>
          </ac:spMkLst>
        </pc:spChg>
        <pc:spChg chg="del">
          <ac:chgData name="Narang, Sonali" userId="9e80b397-6e2f-49b1-9374-ccdad8589140" providerId="ADAL" clId="{6649061F-1686-6E42-8CBD-4F0AAB90E7CD}" dt="2022-01-07T17:26:15.262" v="938" actId="478"/>
          <ac:spMkLst>
            <pc:docMk/>
            <pc:sldMk cId="2292075898" sldId="290"/>
            <ac:spMk id="5" creationId="{FAFFEC37-A0C5-5846-8534-22E3DEF6CEF4}"/>
          </ac:spMkLst>
        </pc:spChg>
        <pc:spChg chg="del">
          <ac:chgData name="Narang, Sonali" userId="9e80b397-6e2f-49b1-9374-ccdad8589140" providerId="ADAL" clId="{6649061F-1686-6E42-8CBD-4F0AAB90E7CD}" dt="2022-01-07T17:26:03.402" v="937" actId="478"/>
          <ac:spMkLst>
            <pc:docMk/>
            <pc:sldMk cId="2292075898" sldId="290"/>
            <ac:spMk id="6" creationId="{41464C80-B659-484D-A16F-8018DEC5471A}"/>
          </ac:spMkLst>
        </pc:spChg>
        <pc:spChg chg="add mod">
          <ac:chgData name="Narang, Sonali" userId="9e80b397-6e2f-49b1-9374-ccdad8589140" providerId="ADAL" clId="{6649061F-1686-6E42-8CBD-4F0AAB90E7CD}" dt="2022-01-04T21:58:42.065" v="133" actId="1076"/>
          <ac:spMkLst>
            <pc:docMk/>
            <pc:sldMk cId="2292075898" sldId="290"/>
            <ac:spMk id="7" creationId="{CB9C2CA2-B854-C447-B990-0E438B105C86}"/>
          </ac:spMkLst>
        </pc:spChg>
        <pc:graphicFrameChg chg="mod modGraphic">
          <ac:chgData name="Narang, Sonali" userId="9e80b397-6e2f-49b1-9374-ccdad8589140" providerId="ADAL" clId="{6649061F-1686-6E42-8CBD-4F0AAB90E7CD}" dt="2022-01-07T02:09:32.057" v="933" actId="20577"/>
          <ac:graphicFrameMkLst>
            <pc:docMk/>
            <pc:sldMk cId="2292075898" sldId="290"/>
            <ac:graphicFrameMk id="16" creationId="{14172837-94DE-3847-8367-932256827593}"/>
          </ac:graphicFrameMkLst>
        </pc:graphicFrameChg>
      </pc:sldChg>
      <pc:sldChg chg="addSp delSp modSp add mod ord">
        <pc:chgData name="Narang, Sonali" userId="9e80b397-6e2f-49b1-9374-ccdad8589140" providerId="ADAL" clId="{6649061F-1686-6E42-8CBD-4F0AAB90E7CD}" dt="2022-01-07T17:26:43.674" v="955" actId="20577"/>
        <pc:sldMkLst>
          <pc:docMk/>
          <pc:sldMk cId="2856672376" sldId="291"/>
        </pc:sldMkLst>
        <pc:spChg chg="mod">
          <ac:chgData name="Narang, Sonali" userId="9e80b397-6e2f-49b1-9374-ccdad8589140" providerId="ADAL" clId="{6649061F-1686-6E42-8CBD-4F0AAB90E7CD}" dt="2022-01-07T17:26:43.674" v="955" actId="20577"/>
          <ac:spMkLst>
            <pc:docMk/>
            <pc:sldMk cId="2856672376" sldId="291"/>
            <ac:spMk id="4" creationId="{F6669B9D-B042-D548-BD0F-97015091799B}"/>
          </ac:spMkLst>
        </pc:spChg>
        <pc:spChg chg="del">
          <ac:chgData name="Narang, Sonali" userId="9e80b397-6e2f-49b1-9374-ccdad8589140" providerId="ADAL" clId="{6649061F-1686-6E42-8CBD-4F0AAB90E7CD}" dt="2022-01-07T17:26:24.884" v="940" actId="478"/>
          <ac:spMkLst>
            <pc:docMk/>
            <pc:sldMk cId="2856672376" sldId="291"/>
            <ac:spMk id="5" creationId="{FAFFEC37-A0C5-5846-8534-22E3DEF6CEF4}"/>
          </ac:spMkLst>
        </pc:spChg>
        <pc:spChg chg="del mod">
          <ac:chgData name="Narang, Sonali" userId="9e80b397-6e2f-49b1-9374-ccdad8589140" providerId="ADAL" clId="{6649061F-1686-6E42-8CBD-4F0AAB90E7CD}" dt="2022-01-07T17:26:24.884" v="940" actId="478"/>
          <ac:spMkLst>
            <pc:docMk/>
            <pc:sldMk cId="2856672376" sldId="291"/>
            <ac:spMk id="7" creationId="{4C5F5CAE-FBFD-964D-A356-746AAC86DC9E}"/>
          </ac:spMkLst>
        </pc:spChg>
        <pc:spChg chg="add mod">
          <ac:chgData name="Narang, Sonali" userId="9e80b397-6e2f-49b1-9374-ccdad8589140" providerId="ADAL" clId="{6649061F-1686-6E42-8CBD-4F0AAB90E7CD}" dt="2022-01-05T20:52:22.956" v="691" actId="20577"/>
          <ac:spMkLst>
            <pc:docMk/>
            <pc:sldMk cId="2856672376" sldId="291"/>
            <ac:spMk id="12" creationId="{31606FD8-5728-9D4A-95DD-454ACBFD8CA6}"/>
          </ac:spMkLst>
        </pc:spChg>
        <pc:spChg chg="add mod">
          <ac:chgData name="Narang, Sonali" userId="9e80b397-6e2f-49b1-9374-ccdad8589140" providerId="ADAL" clId="{6649061F-1686-6E42-8CBD-4F0AAB90E7CD}" dt="2022-01-05T21:07:42.791" v="694" actId="1076"/>
          <ac:spMkLst>
            <pc:docMk/>
            <pc:sldMk cId="2856672376" sldId="291"/>
            <ac:spMk id="13" creationId="{11A1380E-3E08-254E-96AE-9121C17A4CBD}"/>
          </ac:spMkLst>
        </pc:spChg>
        <pc:spChg chg="del">
          <ac:chgData name="Narang, Sonali" userId="9e80b397-6e2f-49b1-9374-ccdad8589140" providerId="ADAL" clId="{6649061F-1686-6E42-8CBD-4F0AAB90E7CD}" dt="2022-01-04T21:56:45.950" v="95" actId="478"/>
          <ac:spMkLst>
            <pc:docMk/>
            <pc:sldMk cId="2856672376" sldId="291"/>
            <ac:spMk id="17" creationId="{02C42890-6447-EB45-84F5-FDC1189AED29}"/>
          </ac:spMkLst>
        </pc:spChg>
        <pc:spChg chg="del">
          <ac:chgData name="Narang, Sonali" userId="9e80b397-6e2f-49b1-9374-ccdad8589140" providerId="ADAL" clId="{6649061F-1686-6E42-8CBD-4F0AAB90E7CD}" dt="2022-01-04T21:56:45.950" v="95" actId="478"/>
          <ac:spMkLst>
            <pc:docMk/>
            <pc:sldMk cId="2856672376" sldId="291"/>
            <ac:spMk id="19" creationId="{AD1A0C94-7B28-0C42-873A-DD66B1F10735}"/>
          </ac:spMkLst>
        </pc:spChg>
        <pc:spChg chg="del">
          <ac:chgData name="Narang, Sonali" userId="9e80b397-6e2f-49b1-9374-ccdad8589140" providerId="ADAL" clId="{6649061F-1686-6E42-8CBD-4F0AAB90E7CD}" dt="2022-01-07T17:26:35.957" v="941" actId="478"/>
          <ac:spMkLst>
            <pc:docMk/>
            <pc:sldMk cId="2856672376" sldId="291"/>
            <ac:spMk id="25" creationId="{6593D040-450B-C74A-8B7E-FF945A3E00B1}"/>
          </ac:spMkLst>
        </pc:spChg>
        <pc:graphicFrameChg chg="add mod modGraphic">
          <ac:chgData name="Narang, Sonali" userId="9e80b397-6e2f-49b1-9374-ccdad8589140" providerId="ADAL" clId="{6649061F-1686-6E42-8CBD-4F0AAB90E7CD}" dt="2022-01-07T01:36:03.295" v="905" actId="20577"/>
          <ac:graphicFrameMkLst>
            <pc:docMk/>
            <pc:sldMk cId="2856672376" sldId="291"/>
            <ac:graphicFrameMk id="10" creationId="{DF601479-C34D-1449-B26E-C8EB919E8EE6}"/>
          </ac:graphicFrameMkLst>
        </pc:graphicFrameChg>
        <pc:graphicFrameChg chg="add mod modGraphic">
          <ac:chgData name="Narang, Sonali" userId="9e80b397-6e2f-49b1-9374-ccdad8589140" providerId="ADAL" clId="{6649061F-1686-6E42-8CBD-4F0AAB90E7CD}" dt="2022-01-07T01:36:04.682" v="906" actId="20577"/>
          <ac:graphicFrameMkLst>
            <pc:docMk/>
            <pc:sldMk cId="2856672376" sldId="291"/>
            <ac:graphicFrameMk id="11" creationId="{B692A8E4-A415-F14E-8B83-E4DD77BD84F0}"/>
          </ac:graphicFrameMkLst>
        </pc:graphicFrameChg>
        <pc:graphicFrameChg chg="del">
          <ac:chgData name="Narang, Sonali" userId="9e80b397-6e2f-49b1-9374-ccdad8589140" providerId="ADAL" clId="{6649061F-1686-6E42-8CBD-4F0AAB90E7CD}" dt="2022-01-04T21:56:45.950" v="95" actId="478"/>
          <ac:graphicFrameMkLst>
            <pc:docMk/>
            <pc:sldMk cId="2856672376" sldId="291"/>
            <ac:graphicFrameMk id="23" creationId="{0759C56F-7A2A-C44B-B409-4AB318968FB8}"/>
          </ac:graphicFrameMkLst>
        </pc:graphicFrameChg>
        <pc:graphicFrameChg chg="del">
          <ac:chgData name="Narang, Sonali" userId="9e80b397-6e2f-49b1-9374-ccdad8589140" providerId="ADAL" clId="{6649061F-1686-6E42-8CBD-4F0AAB90E7CD}" dt="2022-01-04T21:56:45.950" v="95" actId="478"/>
          <ac:graphicFrameMkLst>
            <pc:docMk/>
            <pc:sldMk cId="2856672376" sldId="291"/>
            <ac:graphicFrameMk id="29" creationId="{BC405748-4B2C-FA41-AF30-80A906608DE3}"/>
          </ac:graphicFrameMkLst>
        </pc:graphicFrameChg>
      </pc:sldChg>
      <pc:sldChg chg="addSp delSp modSp add mod ord">
        <pc:chgData name="Narang, Sonali" userId="9e80b397-6e2f-49b1-9374-ccdad8589140" providerId="ADAL" clId="{6649061F-1686-6E42-8CBD-4F0AAB90E7CD}" dt="2022-01-07T17:27:07.435" v="984" actId="20577"/>
        <pc:sldMkLst>
          <pc:docMk/>
          <pc:sldMk cId="2985018669" sldId="292"/>
        </pc:sldMkLst>
        <pc:spChg chg="mod">
          <ac:chgData name="Narang, Sonali" userId="9e80b397-6e2f-49b1-9374-ccdad8589140" providerId="ADAL" clId="{6649061F-1686-6E42-8CBD-4F0AAB90E7CD}" dt="2022-01-07T17:27:07.435" v="984" actId="20577"/>
          <ac:spMkLst>
            <pc:docMk/>
            <pc:sldMk cId="2985018669" sldId="292"/>
            <ac:spMk id="4" creationId="{F6669B9D-B042-D548-BD0F-97015091799B}"/>
          </ac:spMkLst>
        </pc:spChg>
        <pc:spChg chg="del">
          <ac:chgData name="Narang, Sonali" userId="9e80b397-6e2f-49b1-9374-ccdad8589140" providerId="ADAL" clId="{6649061F-1686-6E42-8CBD-4F0AAB90E7CD}" dt="2022-01-07T17:26:18.331" v="939" actId="478"/>
          <ac:spMkLst>
            <pc:docMk/>
            <pc:sldMk cId="2985018669" sldId="292"/>
            <ac:spMk id="5" creationId="{FAFFEC37-A0C5-5846-8534-22E3DEF6CEF4}"/>
          </ac:spMkLst>
        </pc:spChg>
        <pc:spChg chg="del">
          <ac:chgData name="Narang, Sonali" userId="9e80b397-6e2f-49b1-9374-ccdad8589140" providerId="ADAL" clId="{6649061F-1686-6E42-8CBD-4F0AAB90E7CD}" dt="2022-01-07T17:25:47.448" v="936" actId="478"/>
          <ac:spMkLst>
            <pc:docMk/>
            <pc:sldMk cId="2985018669" sldId="292"/>
            <ac:spMk id="6" creationId="{41464C80-B659-484D-A16F-8018DEC5471A}"/>
          </ac:spMkLst>
        </pc:spChg>
        <pc:spChg chg="mod">
          <ac:chgData name="Narang, Sonali" userId="9e80b397-6e2f-49b1-9374-ccdad8589140" providerId="ADAL" clId="{6649061F-1686-6E42-8CBD-4F0AAB90E7CD}" dt="2022-01-04T22:11:37.051" v="193" actId="20577"/>
          <ac:spMkLst>
            <pc:docMk/>
            <pc:sldMk cId="2985018669" sldId="292"/>
            <ac:spMk id="7" creationId="{CB9C2CA2-B854-C447-B990-0E438B105C86}"/>
          </ac:spMkLst>
        </pc:spChg>
        <pc:graphicFrameChg chg="add mod modGraphic">
          <ac:chgData name="Narang, Sonali" userId="9e80b397-6e2f-49b1-9374-ccdad8589140" providerId="ADAL" clId="{6649061F-1686-6E42-8CBD-4F0AAB90E7CD}" dt="2022-01-07T01:14:07.702" v="891" actId="14734"/>
          <ac:graphicFrameMkLst>
            <pc:docMk/>
            <pc:sldMk cId="2985018669" sldId="292"/>
            <ac:graphicFrameMk id="2" creationId="{CB22FEC9-C591-6748-8C4D-7EBE833290E6}"/>
          </ac:graphicFrameMkLst>
        </pc:graphicFrameChg>
        <pc:graphicFrameChg chg="del mod modGraphic">
          <ac:chgData name="Narang, Sonali" userId="9e80b397-6e2f-49b1-9374-ccdad8589140" providerId="ADAL" clId="{6649061F-1686-6E42-8CBD-4F0AAB90E7CD}" dt="2022-01-04T22:10:49.759" v="175" actId="478"/>
          <ac:graphicFrameMkLst>
            <pc:docMk/>
            <pc:sldMk cId="2985018669" sldId="292"/>
            <ac:graphicFrameMk id="16" creationId="{14172837-94DE-3847-8367-932256827593}"/>
          </ac:graphicFrameMkLst>
        </pc:graphicFrameChg>
      </pc:sldChg>
      <pc:sldChg chg="delSp modSp add del mod">
        <pc:chgData name="Narang, Sonali" userId="9e80b397-6e2f-49b1-9374-ccdad8589140" providerId="ADAL" clId="{6649061F-1686-6E42-8CBD-4F0AAB90E7CD}" dt="2022-01-07T01:37:52.281" v="907" actId="2696"/>
        <pc:sldMkLst>
          <pc:docMk/>
          <pc:sldMk cId="642671396" sldId="293"/>
        </pc:sldMkLst>
        <pc:spChg chg="mod">
          <ac:chgData name="Narang, Sonali" userId="9e80b397-6e2f-49b1-9374-ccdad8589140" providerId="ADAL" clId="{6649061F-1686-6E42-8CBD-4F0AAB90E7CD}" dt="2022-01-04T22:12:07.979" v="203" actId="20577"/>
          <ac:spMkLst>
            <pc:docMk/>
            <pc:sldMk cId="642671396" sldId="293"/>
            <ac:spMk id="45" creationId="{A37EFDC5-08ED-BB45-B24A-B00535A392F0}"/>
          </ac:spMkLst>
        </pc:spChg>
        <pc:grpChg chg="del">
          <ac:chgData name="Narang, Sonali" userId="9e80b397-6e2f-49b1-9374-ccdad8589140" providerId="ADAL" clId="{6649061F-1686-6E42-8CBD-4F0AAB90E7CD}" dt="2022-01-04T22:12:02.337" v="199" actId="478"/>
          <ac:grpSpMkLst>
            <pc:docMk/>
            <pc:sldMk cId="642671396" sldId="293"/>
            <ac:grpSpMk id="47" creationId="{4B802D37-9378-E54E-99B5-1E00E308EBB8}"/>
          </ac:grpSpMkLst>
        </pc:grpChg>
      </pc:sldChg>
      <pc:sldChg chg="addSp delSp modSp add mod ord">
        <pc:chgData name="Narang, Sonali" userId="9e80b397-6e2f-49b1-9374-ccdad8589140" providerId="ADAL" clId="{6649061F-1686-6E42-8CBD-4F0AAB90E7CD}" dt="2022-01-07T17:26:57.364" v="970" actId="20577"/>
        <pc:sldMkLst>
          <pc:docMk/>
          <pc:sldMk cId="2574176189" sldId="294"/>
        </pc:sldMkLst>
        <pc:spChg chg="add del mod">
          <ac:chgData name="Narang, Sonali" userId="9e80b397-6e2f-49b1-9374-ccdad8589140" providerId="ADAL" clId="{6649061F-1686-6E42-8CBD-4F0AAB90E7CD}" dt="2022-01-07T01:38:02.570" v="908" actId="478"/>
          <ac:spMkLst>
            <pc:docMk/>
            <pc:sldMk cId="2574176189" sldId="294"/>
            <ac:spMk id="2" creationId="{298DA7AF-489E-D446-A135-88CC0F739194}"/>
          </ac:spMkLst>
        </pc:spChg>
        <pc:spChg chg="add del mod">
          <ac:chgData name="Narang, Sonali" userId="9e80b397-6e2f-49b1-9374-ccdad8589140" providerId="ADAL" clId="{6649061F-1686-6E42-8CBD-4F0AAB90E7CD}" dt="2022-01-05T20:50:06.268" v="669" actId="767"/>
          <ac:spMkLst>
            <pc:docMk/>
            <pc:sldMk cId="2574176189" sldId="294"/>
            <ac:spMk id="3" creationId="{442C9673-501D-5248-BED8-D761EE890683}"/>
          </ac:spMkLst>
        </pc:spChg>
        <pc:spChg chg="mod">
          <ac:chgData name="Narang, Sonali" userId="9e80b397-6e2f-49b1-9374-ccdad8589140" providerId="ADAL" clId="{6649061F-1686-6E42-8CBD-4F0AAB90E7CD}" dt="2022-01-07T17:26:57.364" v="970" actId="20577"/>
          <ac:spMkLst>
            <pc:docMk/>
            <pc:sldMk cId="2574176189" sldId="294"/>
            <ac:spMk id="4" creationId="{F6669B9D-B042-D548-BD0F-97015091799B}"/>
          </ac:spMkLst>
        </pc:spChg>
        <pc:spChg chg="del">
          <ac:chgData name="Narang, Sonali" userId="9e80b397-6e2f-49b1-9374-ccdad8589140" providerId="ADAL" clId="{6649061F-1686-6E42-8CBD-4F0AAB90E7CD}" dt="2022-01-07T17:26:53.463" v="956" actId="478"/>
          <ac:spMkLst>
            <pc:docMk/>
            <pc:sldMk cId="2574176189" sldId="294"/>
            <ac:spMk id="5" creationId="{FAFFEC37-A0C5-5846-8534-22E3DEF6CEF4}"/>
          </ac:spMkLst>
        </pc:spChg>
        <pc:spChg chg="del">
          <ac:chgData name="Narang, Sonali" userId="9e80b397-6e2f-49b1-9374-ccdad8589140" providerId="ADAL" clId="{6649061F-1686-6E42-8CBD-4F0AAB90E7CD}" dt="2022-01-07T17:26:53.463" v="956" actId="478"/>
          <ac:spMkLst>
            <pc:docMk/>
            <pc:sldMk cId="2574176189" sldId="294"/>
            <ac:spMk id="7" creationId="{4C5F5CAE-FBFD-964D-A356-746AAC86DC9E}"/>
          </ac:spMkLst>
        </pc:spChg>
        <pc:spChg chg="mod">
          <ac:chgData name="Narang, Sonali" userId="9e80b397-6e2f-49b1-9374-ccdad8589140" providerId="ADAL" clId="{6649061F-1686-6E42-8CBD-4F0AAB90E7CD}" dt="2022-01-05T20:52:20.246" v="687" actId="20577"/>
          <ac:spMkLst>
            <pc:docMk/>
            <pc:sldMk cId="2574176189" sldId="294"/>
            <ac:spMk id="17" creationId="{02C42890-6447-EB45-84F5-FDC1189AED29}"/>
          </ac:spMkLst>
        </pc:spChg>
        <pc:spChg chg="mod">
          <ac:chgData name="Narang, Sonali" userId="9e80b397-6e2f-49b1-9374-ccdad8589140" providerId="ADAL" clId="{6649061F-1686-6E42-8CBD-4F0AAB90E7CD}" dt="2022-01-05T20:52:18.919" v="685" actId="20577"/>
          <ac:spMkLst>
            <pc:docMk/>
            <pc:sldMk cId="2574176189" sldId="294"/>
            <ac:spMk id="19" creationId="{AD1A0C94-7B28-0C42-873A-DD66B1F10735}"/>
          </ac:spMkLst>
        </pc:spChg>
        <pc:spChg chg="del">
          <ac:chgData name="Narang, Sonali" userId="9e80b397-6e2f-49b1-9374-ccdad8589140" providerId="ADAL" clId="{6649061F-1686-6E42-8CBD-4F0AAB90E7CD}" dt="2022-01-07T01:38:04.745" v="909" actId="478"/>
          <ac:spMkLst>
            <pc:docMk/>
            <pc:sldMk cId="2574176189" sldId="294"/>
            <ac:spMk id="25" creationId="{6593D040-450B-C74A-8B7E-FF945A3E00B1}"/>
          </ac:spMkLst>
        </pc:spChg>
        <pc:graphicFrameChg chg="mod modGraphic">
          <ac:chgData name="Narang, Sonali" userId="9e80b397-6e2f-49b1-9374-ccdad8589140" providerId="ADAL" clId="{6649061F-1686-6E42-8CBD-4F0AAB90E7CD}" dt="2022-01-05T20:47:41.174" v="627" actId="20577"/>
          <ac:graphicFrameMkLst>
            <pc:docMk/>
            <pc:sldMk cId="2574176189" sldId="294"/>
            <ac:graphicFrameMk id="10" creationId="{2AD806D8-8056-A543-AE25-457F49328268}"/>
          </ac:graphicFrameMkLst>
        </pc:graphicFrameChg>
        <pc:graphicFrameChg chg="add mod modGraphic">
          <ac:chgData name="Narang, Sonali" userId="9e80b397-6e2f-49b1-9374-ccdad8589140" providerId="ADAL" clId="{6649061F-1686-6E42-8CBD-4F0AAB90E7CD}" dt="2022-01-05T20:49:32.086" v="660" actId="20577"/>
          <ac:graphicFrameMkLst>
            <pc:docMk/>
            <pc:sldMk cId="2574176189" sldId="294"/>
            <ac:graphicFrameMk id="11" creationId="{B8484720-E1AE-8F49-B5E4-BD103B77A2DC}"/>
          </ac:graphicFrameMkLst>
        </pc:graphicFrameChg>
        <pc:graphicFrameChg chg="del">
          <ac:chgData name="Narang, Sonali" userId="9e80b397-6e2f-49b1-9374-ccdad8589140" providerId="ADAL" clId="{6649061F-1686-6E42-8CBD-4F0AAB90E7CD}" dt="2022-01-05T18:42:06.133" v="309" actId="478"/>
          <ac:graphicFrameMkLst>
            <pc:docMk/>
            <pc:sldMk cId="2574176189" sldId="294"/>
            <ac:graphicFrameMk id="23" creationId="{0759C56F-7A2A-C44B-B409-4AB318968FB8}"/>
          </ac:graphicFrameMkLst>
        </pc:graphicFrameChg>
        <pc:graphicFrameChg chg="del">
          <ac:chgData name="Narang, Sonali" userId="9e80b397-6e2f-49b1-9374-ccdad8589140" providerId="ADAL" clId="{6649061F-1686-6E42-8CBD-4F0AAB90E7CD}" dt="2022-01-05T18:42:06.133" v="309" actId="478"/>
          <ac:graphicFrameMkLst>
            <pc:docMk/>
            <pc:sldMk cId="2574176189" sldId="294"/>
            <ac:graphicFrameMk id="29" creationId="{BC405748-4B2C-FA41-AF30-80A906608DE3}"/>
          </ac:graphicFrameMkLst>
        </pc:graphicFrameChg>
      </pc:sldChg>
      <pc:sldChg chg="addSp delSp modSp add mod">
        <pc:chgData name="Narang, Sonali" userId="9e80b397-6e2f-49b1-9374-ccdad8589140" providerId="ADAL" clId="{6649061F-1686-6E42-8CBD-4F0AAB90E7CD}" dt="2022-01-24T19:33:30.938" v="1335" actId="12788"/>
        <pc:sldMkLst>
          <pc:docMk/>
          <pc:sldMk cId="4154367766" sldId="295"/>
        </pc:sldMkLst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15" creationId="{41475153-9CCC-1C49-81B0-27247F124E6D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7" creationId="{C4AAFE58-7B99-F24A-8EB5-0B20F6FC716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8" creationId="{951E52D4-3979-654F-9B28-86FF99CC4E59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9" creationId="{4E73C630-74EC-AE41-9FA3-41F68582501B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20" creationId="{B8992B9C-494D-2840-A750-CBA72C5A9AED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21" creationId="{80080CCA-1FE6-464E-A782-736F48EDB3D1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22" creationId="{B1BB7369-2013-E24A-B30C-28378B7018C1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23" creationId="{E7E24790-13CF-854B-9A4A-E42EE3056D34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24" creationId="{8F8114E8-A901-F14A-8FF5-35B3C135810E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25" creationId="{77F91B42-3441-7A46-8B49-D253FA8EA588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26" creationId="{E2024997-0160-E54E-8E02-2782E50AEC23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28" creationId="{B01FB8CA-18A4-884C-A543-9BDA8B98FEA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29" creationId="{098A46EB-A595-BD4B-8F63-398C74C5C800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0" creationId="{DF065122-C265-9D4D-BECE-BC2A7DAC160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1" creationId="{1398A495-F322-0244-A939-793647725DCD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2" creationId="{FFE138BF-0B35-E64C-B363-693FDC6D2592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4" creationId="{CCFE64A3-1F62-4041-A4E7-25C3FEFB11CB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5" creationId="{67C9755B-0C26-A34B-B57A-46A2B0B46C56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6" creationId="{4BFF2A47-7ECD-5A49-9656-79E690A5D0E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7" creationId="{A4979356-F849-D347-AE6A-154065050AC4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38" creationId="{9F79F552-E04C-0147-B851-57C0097423EF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40" creationId="{1EE51D61-2A62-1D49-8DB8-7B89A6ED1FFF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41" creationId="{0D9D49F0-7AA9-ED4A-A377-4EA00BCEEAD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42" creationId="{13C7751C-DC18-FB47-9C8E-11066C5B44EA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43" creationId="{D92AF65C-56A7-FC4B-B4E7-B0E00300A80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44" creationId="{482E468F-2904-864E-9F9E-8CBC641BC8DD}"/>
          </ac:spMkLst>
        </pc:spChg>
        <pc:spChg chg="mod">
          <ac:chgData name="Narang, Sonali" userId="9e80b397-6e2f-49b1-9374-ccdad8589140" providerId="ADAL" clId="{6649061F-1686-6E42-8CBD-4F0AAB90E7CD}" dt="2022-01-11T18:43:29.972" v="1003" actId="20577"/>
          <ac:spMkLst>
            <pc:docMk/>
            <pc:sldMk cId="4154367766" sldId="295"/>
            <ac:spMk id="45" creationId="{A37EFDC5-08ED-BB45-B24A-B00535A392F0}"/>
          </ac:spMkLst>
        </pc:spChg>
        <pc:spChg chg="add del mod">
          <ac:chgData name="Narang, Sonali" userId="9e80b397-6e2f-49b1-9374-ccdad8589140" providerId="ADAL" clId="{6649061F-1686-6E42-8CBD-4F0AAB90E7CD}" dt="2022-01-24T19:33:30.938" v="1335" actId="12788"/>
          <ac:spMkLst>
            <pc:docMk/>
            <pc:sldMk cId="4154367766" sldId="295"/>
            <ac:spMk id="46" creationId="{BC4BD7F9-9550-3841-BBB5-1A58285A1D8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59" creationId="{D59D43AC-3B6B-814F-89F8-441BE0002AD9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0" creationId="{53CC831E-E826-8A40-8AFD-308730429070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1" creationId="{DB933519-BBC3-894E-B38D-EFDA5F91B271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2" creationId="{D9AD6592-EA4B-3D41-AE12-14685150733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3" creationId="{69D98142-DE5C-2E4F-BBDF-06AF6CD40BA7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5" creationId="{3A9D9BF9-8EDB-0A47-AE14-CE02CBBCC420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6" creationId="{71788AC5-4A6E-0C46-98C6-F44B9A0EDB59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7" creationId="{42A142B6-4C74-8C4B-B214-C77BA43CADAB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8" creationId="{68106FC8-0A3D-2146-BA2E-3B63B8C6AEC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69" creationId="{54EAC310-2D9E-5343-88DA-E469D531BF61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70" creationId="{F91B81AD-A47C-3741-A21D-BD8E4AF3372B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71" creationId="{6C9E9C38-430D-6B4D-8D7A-964AAF818C1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73" creationId="{86ACFA14-3A74-4648-9241-D2D04D44A14B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74" creationId="{C3810D26-D368-7B40-9884-D5EC9CFA4F5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75" creationId="{51875437-C8B3-5D4F-8407-4223820A8F8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76" creationId="{82B6B834-6F37-A04A-9484-9940B2744117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77" creationId="{856BFEB2-255E-D34D-BBFB-000EB719D7D4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78" creationId="{5CF15D04-924B-9E45-B013-9F8B35A58231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79" creationId="{E4CF7FFC-E10C-4C44-B383-ED58BE00B4E0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80" creationId="{79E5D586-C2E2-3542-9BF0-2287D94CE67D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81" creationId="{9D428634-13C9-9D47-8CDA-D13551AF8DE0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82" creationId="{144A4486-8816-5044-8E19-E653E7D0ED7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84" creationId="{489BFBF2-8DE5-324B-86CF-A09FC9BB66FF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85" creationId="{7B3A406D-4E52-3847-A495-6D67C37E7FC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86" creationId="{71AE2C58-2999-5D41-8EEA-D326BB2D9AE3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87" creationId="{354CC329-9D7A-DC49-8FF0-EFF6AD12A157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88" creationId="{DF03B20A-30A7-1F41-AE97-D8311DDE1726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0" creationId="{A3C84DE9-5CF7-1B44-BEA6-8346811FCF8B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1" creationId="{22594033-5BA3-FB47-B110-E632859302F4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2" creationId="{07604A7B-57F7-1C42-916D-76B52ADC0662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3" creationId="{EA5DCFFF-C481-3B44-8642-8AFA0D04B57E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4" creationId="{A7B58F4A-C041-6141-9BED-A5BFF240A9C9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6" creationId="{B61E7790-F06A-A142-B8FD-BD06BDC9AAA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7" creationId="{EF0C88B6-DCE2-3F43-872E-2A664A947925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8" creationId="{3BFB8E4A-D865-404B-93B6-EF2EA063C972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99" creationId="{1EA98FF0-DB26-1C49-A6C8-D13D436186F5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0" creationId="{49F4B43C-8A99-404D-BC76-1CEB9F23406A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2" creationId="{F3FCB0D1-64D6-9040-90A3-95D1748F0734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3" creationId="{2E359EC2-20C2-1742-9AA0-77B957E4829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4" creationId="{C03670DE-70D6-134F-8444-D3FC98383511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5" creationId="{B7FCFEE2-1DA2-0541-96C0-D4EB42F6AC84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6" creationId="{32422885-1352-8843-A2E3-C3F4E6FF7A9A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8" creationId="{B4C7268B-F092-C545-95D8-AC003DF9ACF8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09" creationId="{50BAFB2F-6408-4E46-B5C5-F6FF4357D67C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10" creationId="{85411C23-A772-0046-AEB6-155F9D0F9201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11" creationId="{B7AEEF45-E2C8-5D49-8989-44CF8C877DE5}"/>
          </ac:spMkLst>
        </pc:spChg>
        <pc:spChg chg="mod">
          <ac:chgData name="Narang, Sonali" userId="9e80b397-6e2f-49b1-9374-ccdad8589140" providerId="ADAL" clId="{6649061F-1686-6E42-8CBD-4F0AAB90E7CD}" dt="2022-01-11T18:43:26.368" v="1001"/>
          <ac:spMkLst>
            <pc:docMk/>
            <pc:sldMk cId="4154367766" sldId="295"/>
            <ac:spMk id="112" creationId="{18156836-4980-374C-988D-1324111DE682}"/>
          </ac:spMkLst>
        </pc:spChg>
        <pc:spChg chg="add del mod">
          <ac:chgData name="Narang, Sonali" userId="9e80b397-6e2f-49b1-9374-ccdad8589140" providerId="ADAL" clId="{6649061F-1686-6E42-8CBD-4F0AAB90E7CD}" dt="2022-01-18T16:12:40.040" v="1317" actId="21"/>
          <ac:spMkLst>
            <pc:docMk/>
            <pc:sldMk cId="4154367766" sldId="295"/>
            <ac:spMk id="113" creationId="{1E4826DE-E84B-C644-AE98-3284FD9DA61B}"/>
          </ac:spMkLst>
        </pc:spChg>
        <pc:spChg chg="add del mod">
          <ac:chgData name="Narang, Sonali" userId="9e80b397-6e2f-49b1-9374-ccdad8589140" providerId="ADAL" clId="{6649061F-1686-6E42-8CBD-4F0AAB90E7CD}" dt="2022-01-11T20:33:52.607" v="1054" actId="478"/>
          <ac:spMkLst>
            <pc:docMk/>
            <pc:sldMk cId="4154367766" sldId="295"/>
            <ac:spMk id="114" creationId="{14CFF837-6D3D-7040-B8E0-A7865ECD038E}"/>
          </ac:spMkLst>
        </pc:spChg>
        <pc:spChg chg="add mod">
          <ac:chgData name="Narang, Sonali" userId="9e80b397-6e2f-49b1-9374-ccdad8589140" providerId="ADAL" clId="{6649061F-1686-6E42-8CBD-4F0AAB90E7CD}" dt="2022-01-24T19:33:30.938" v="1335" actId="12788"/>
          <ac:spMkLst>
            <pc:docMk/>
            <pc:sldMk cId="4154367766" sldId="295"/>
            <ac:spMk id="114" creationId="{3A736F9A-10B2-FE40-82FF-D51AB6E0A5AB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16" creationId="{7A590362-7EE2-8D48-A1A3-BEDFA107E858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17" creationId="{F63400DB-46C2-E243-A540-076930F504F7}"/>
          </ac:spMkLst>
        </pc:spChg>
        <pc:spChg chg="mod">
          <ac:chgData name="Narang, Sonali" userId="9e80b397-6e2f-49b1-9374-ccdad8589140" providerId="ADAL" clId="{6649061F-1686-6E42-8CBD-4F0AAB90E7CD}" dt="2022-01-11T18:45:23.539" v="1019" actId="20577"/>
          <ac:spMkLst>
            <pc:docMk/>
            <pc:sldMk cId="4154367766" sldId="295"/>
            <ac:spMk id="118" creationId="{7E04E2E6-CAA3-BA47-8525-B41E15FEAF6C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19" creationId="{BC250EB2-39BB-8B44-99B7-81E4E6DA7477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0" creationId="{5E9D9D04-8DAF-5D4D-941A-E08689741A6D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2" creationId="{44E12B44-BF40-2949-8147-BAE970A845C3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3" creationId="{57746467-9844-DD49-874A-F2D280E1E4D4}"/>
          </ac:spMkLst>
        </pc:spChg>
        <pc:spChg chg="mod">
          <ac:chgData name="Narang, Sonali" userId="9e80b397-6e2f-49b1-9374-ccdad8589140" providerId="ADAL" clId="{6649061F-1686-6E42-8CBD-4F0AAB90E7CD}" dt="2022-01-11T18:45:29.483" v="1023" actId="20577"/>
          <ac:spMkLst>
            <pc:docMk/>
            <pc:sldMk cId="4154367766" sldId="295"/>
            <ac:spMk id="124" creationId="{2ED81711-1B98-0C4A-BEBE-FEDD8E5D3F30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5" creationId="{FEDF9B53-846D-0947-958D-C2B3E4E3B98B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6" creationId="{4C226688-AC5A-7D42-8941-5ED2D50B9602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8" creationId="{8492C6E3-4296-3D4B-B3EC-0A48D321DF4C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29" creationId="{942A7A8D-270A-6D4D-8B0B-ECCE04DF42C7}"/>
          </ac:spMkLst>
        </pc:spChg>
        <pc:spChg chg="mod">
          <ac:chgData name="Narang, Sonali" userId="9e80b397-6e2f-49b1-9374-ccdad8589140" providerId="ADAL" clId="{6649061F-1686-6E42-8CBD-4F0AAB90E7CD}" dt="2022-01-11T18:45:31.735" v="1027" actId="20577"/>
          <ac:spMkLst>
            <pc:docMk/>
            <pc:sldMk cId="4154367766" sldId="295"/>
            <ac:spMk id="130" creationId="{669ACCEB-B9CE-D740-9398-D630BB219BDB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31" creationId="{64FCCF90-557B-6C4E-B9C2-B13835863C97}"/>
          </ac:spMkLst>
        </pc:spChg>
        <pc:spChg chg="mod">
          <ac:chgData name="Narang, Sonali" userId="9e80b397-6e2f-49b1-9374-ccdad8589140" providerId="ADAL" clId="{6649061F-1686-6E42-8CBD-4F0AAB90E7CD}" dt="2022-01-11T18:43:57.046" v="1006"/>
          <ac:spMkLst>
            <pc:docMk/>
            <pc:sldMk cId="4154367766" sldId="295"/>
            <ac:spMk id="132" creationId="{8D1F133E-0FEB-9F48-936D-1AA96D8E5D80}"/>
          </ac:spMkLst>
        </pc:spChg>
        <pc:spChg chg="add del mod">
          <ac:chgData name="Narang, Sonali" userId="9e80b397-6e2f-49b1-9374-ccdad8589140" providerId="ADAL" clId="{6649061F-1686-6E42-8CBD-4F0AAB90E7CD}" dt="2022-01-11T20:36:11.790" v="1246" actId="478"/>
          <ac:spMkLst>
            <pc:docMk/>
            <pc:sldMk cId="4154367766" sldId="295"/>
            <ac:spMk id="133" creationId="{103C60C5-A6A7-454A-A0A3-EA8FF6EA5493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35" creationId="{247245BF-2F8B-8940-A59C-B0D3F07641C5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36" creationId="{3CAA56D1-0A3F-264E-A717-7EF42FA18446}"/>
          </ac:spMkLst>
        </pc:spChg>
        <pc:spChg chg="mod">
          <ac:chgData name="Narang, Sonali" userId="9e80b397-6e2f-49b1-9374-ccdad8589140" providerId="ADAL" clId="{6649061F-1686-6E42-8CBD-4F0AAB90E7CD}" dt="2022-01-11T18:45:34.879" v="1031" actId="20577"/>
          <ac:spMkLst>
            <pc:docMk/>
            <pc:sldMk cId="4154367766" sldId="295"/>
            <ac:spMk id="137" creationId="{6A578351-BF57-4741-A238-2C6F7E3085D8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38" creationId="{292E8E8C-60E6-0349-85B8-C586A93ED290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39" creationId="{0DC01BE8-2BF7-BA45-9605-7631B5120E78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1" creationId="{A5F07FFD-D4E7-A340-B34F-F7C07A7CE9C9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2" creationId="{CBF72270-BD5E-9742-ADD6-8E9FBD580A82}"/>
          </ac:spMkLst>
        </pc:spChg>
        <pc:spChg chg="mod">
          <ac:chgData name="Narang, Sonali" userId="9e80b397-6e2f-49b1-9374-ccdad8589140" providerId="ADAL" clId="{6649061F-1686-6E42-8CBD-4F0AAB90E7CD}" dt="2022-01-11T18:45:40.280" v="1037" actId="20577"/>
          <ac:spMkLst>
            <pc:docMk/>
            <pc:sldMk cId="4154367766" sldId="295"/>
            <ac:spMk id="143" creationId="{A77A2408-A212-F447-993F-0E06B78159BD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4" creationId="{A734550B-ED39-DE44-B498-E4B3BA93A066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5" creationId="{A004CF5D-5593-5F4B-91BD-C2A110FAE8C2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7" creationId="{F106222D-2D15-8147-B397-C76248AFBFDE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48" creationId="{EC0D8055-534F-D24B-8076-5339736EBCBA}"/>
          </ac:spMkLst>
        </pc:spChg>
        <pc:spChg chg="mod">
          <ac:chgData name="Narang, Sonali" userId="9e80b397-6e2f-49b1-9374-ccdad8589140" providerId="ADAL" clId="{6649061F-1686-6E42-8CBD-4F0AAB90E7CD}" dt="2022-01-11T18:45:49.793" v="1041" actId="20577"/>
          <ac:spMkLst>
            <pc:docMk/>
            <pc:sldMk cId="4154367766" sldId="295"/>
            <ac:spMk id="149" creationId="{04CBB936-01AB-9A49-9D7A-C98E04503D99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50" creationId="{2160A176-3038-8B48-93EA-7B25131C13F9}"/>
          </ac:spMkLst>
        </pc:spChg>
        <pc:spChg chg="mod">
          <ac:chgData name="Narang, Sonali" userId="9e80b397-6e2f-49b1-9374-ccdad8589140" providerId="ADAL" clId="{6649061F-1686-6E42-8CBD-4F0AAB90E7CD}" dt="2022-01-11T18:44:08.217" v="1008"/>
          <ac:spMkLst>
            <pc:docMk/>
            <pc:sldMk cId="4154367766" sldId="295"/>
            <ac:spMk id="151" creationId="{A1E9D779-E65C-0B42-8A92-7903E910BB85}"/>
          </ac:spMkLst>
        </pc:spChg>
        <pc:spChg chg="add del mod">
          <ac:chgData name="Narang, Sonali" userId="9e80b397-6e2f-49b1-9374-ccdad8589140" providerId="ADAL" clId="{6649061F-1686-6E42-8CBD-4F0AAB90E7CD}" dt="2022-01-18T16:12:44.048" v="1318" actId="478"/>
          <ac:spMkLst>
            <pc:docMk/>
            <pc:sldMk cId="4154367766" sldId="295"/>
            <ac:spMk id="152" creationId="{60BF8983-C5D4-AD4B-A7C3-34F232257EFE}"/>
          </ac:spMkLst>
        </pc:spChg>
        <pc:spChg chg="add del mod">
          <ac:chgData name="Narang, Sonali" userId="9e80b397-6e2f-49b1-9374-ccdad8589140" providerId="ADAL" clId="{6649061F-1686-6E42-8CBD-4F0AAB90E7CD}" dt="2022-01-11T20:36:11.790" v="1246" actId="478"/>
          <ac:spMkLst>
            <pc:docMk/>
            <pc:sldMk cId="4154367766" sldId="295"/>
            <ac:spMk id="153" creationId="{A300AE85-2908-2042-8475-04431533DCF4}"/>
          </ac:spMkLst>
        </pc:s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16" creationId="{0B88348C-71F4-034E-8BE6-1DA8AF48B28B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27" creationId="{AD28354D-0D05-EA4B-9A5D-6F5E44A0A0C2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33" creationId="{47DF78CB-368F-0E4F-B327-B5A2B29E1E61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39" creationId="{40AAC5F9-F9A3-1140-A1BF-041C11BD5737}"/>
          </ac:grpSpMkLst>
        </pc:grpChg>
        <pc:grpChg chg="del">
          <ac:chgData name="Narang, Sonali" userId="9e80b397-6e2f-49b1-9374-ccdad8589140" providerId="ADAL" clId="{6649061F-1686-6E42-8CBD-4F0AAB90E7CD}" dt="2022-01-11T18:43:24.915" v="1000" actId="478"/>
          <ac:grpSpMkLst>
            <pc:docMk/>
            <pc:sldMk cId="4154367766" sldId="295"/>
            <ac:grpSpMk id="47" creationId="{4B802D37-9378-E54E-99B5-1E00E308EBB8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58" creationId="{1166626B-BD7B-DC42-B837-7CEBE44A472A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64" creationId="{2EB8E366-B7F2-414A-A21E-7D31542517D8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72" creationId="{FD67D9FC-2896-D947-AB6A-0B8F0EC147EE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83" creationId="{A8ACB6FC-C43F-A342-B4DB-E35FCF33D311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89" creationId="{37E7C870-E43B-5C45-9C11-E8E988931DE2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95" creationId="{62FA0AC6-043A-1849-846C-CC8017806BE8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101" creationId="{6D8B34DB-0B4E-9B44-BE56-D647F7073658}"/>
          </ac:grpSpMkLst>
        </pc:grpChg>
        <pc:grpChg chg="add del mod">
          <ac:chgData name="Narang, Sonali" userId="9e80b397-6e2f-49b1-9374-ccdad8589140" providerId="ADAL" clId="{6649061F-1686-6E42-8CBD-4F0AAB90E7CD}" dt="2022-01-18T16:12:40.040" v="1317" actId="21"/>
          <ac:grpSpMkLst>
            <pc:docMk/>
            <pc:sldMk cId="4154367766" sldId="295"/>
            <ac:grpSpMk id="107" creationId="{0BA70FBE-9434-184B-B402-887547386963}"/>
          </ac:grpSpMkLst>
        </pc:grpChg>
        <pc:grpChg chg="add del mod">
          <ac:chgData name="Narang, Sonali" userId="9e80b397-6e2f-49b1-9374-ccdad8589140" providerId="ADAL" clId="{6649061F-1686-6E42-8CBD-4F0AAB90E7CD}" dt="2022-01-11T20:33:52.607" v="1054" actId="478"/>
          <ac:grpSpMkLst>
            <pc:docMk/>
            <pc:sldMk cId="4154367766" sldId="295"/>
            <ac:grpSpMk id="115" creationId="{F20F8AD8-E662-0B4B-9BB0-1CE0A4DDC820}"/>
          </ac:grpSpMkLst>
        </pc:grpChg>
        <pc:grpChg chg="add del mod">
          <ac:chgData name="Narang, Sonali" userId="9e80b397-6e2f-49b1-9374-ccdad8589140" providerId="ADAL" clId="{6649061F-1686-6E42-8CBD-4F0AAB90E7CD}" dt="2022-01-11T20:33:52.607" v="1054" actId="478"/>
          <ac:grpSpMkLst>
            <pc:docMk/>
            <pc:sldMk cId="4154367766" sldId="295"/>
            <ac:grpSpMk id="121" creationId="{F2B82D48-1675-0447-B850-1CEEF7C3C8A8}"/>
          </ac:grpSpMkLst>
        </pc:grpChg>
        <pc:grpChg chg="add del mod">
          <ac:chgData name="Narang, Sonali" userId="9e80b397-6e2f-49b1-9374-ccdad8589140" providerId="ADAL" clId="{6649061F-1686-6E42-8CBD-4F0AAB90E7CD}" dt="2022-01-11T20:33:52.607" v="1054" actId="478"/>
          <ac:grpSpMkLst>
            <pc:docMk/>
            <pc:sldMk cId="4154367766" sldId="295"/>
            <ac:grpSpMk id="127" creationId="{3D243E91-1785-6947-AD62-072A57063A69}"/>
          </ac:grpSpMkLst>
        </pc:grpChg>
        <pc:grpChg chg="add del mod">
          <ac:chgData name="Narang, Sonali" userId="9e80b397-6e2f-49b1-9374-ccdad8589140" providerId="ADAL" clId="{6649061F-1686-6E42-8CBD-4F0AAB90E7CD}" dt="2022-01-11T20:36:11.790" v="1246" actId="478"/>
          <ac:grpSpMkLst>
            <pc:docMk/>
            <pc:sldMk cId="4154367766" sldId="295"/>
            <ac:grpSpMk id="134" creationId="{76BD9927-1F59-C34C-B7A8-8BAB47D93234}"/>
          </ac:grpSpMkLst>
        </pc:grpChg>
        <pc:grpChg chg="add del mod">
          <ac:chgData name="Narang, Sonali" userId="9e80b397-6e2f-49b1-9374-ccdad8589140" providerId="ADAL" clId="{6649061F-1686-6E42-8CBD-4F0AAB90E7CD}" dt="2022-01-11T20:36:11.790" v="1246" actId="478"/>
          <ac:grpSpMkLst>
            <pc:docMk/>
            <pc:sldMk cId="4154367766" sldId="295"/>
            <ac:grpSpMk id="140" creationId="{4B20BEF1-AFCD-E948-9FB1-5A0D5B0FB310}"/>
          </ac:grpSpMkLst>
        </pc:grpChg>
        <pc:grpChg chg="add del mod">
          <ac:chgData name="Narang, Sonali" userId="9e80b397-6e2f-49b1-9374-ccdad8589140" providerId="ADAL" clId="{6649061F-1686-6E42-8CBD-4F0AAB90E7CD}" dt="2022-01-11T20:36:11.790" v="1246" actId="478"/>
          <ac:grpSpMkLst>
            <pc:docMk/>
            <pc:sldMk cId="4154367766" sldId="295"/>
            <ac:grpSpMk id="146" creationId="{C280C03C-B341-B449-8A5F-4D62F1D644ED}"/>
          </ac:grpSpMkLst>
        </pc:grpChg>
        <pc:graphicFrameChg chg="add del mod modGraphic">
          <ac:chgData name="Narang, Sonali" userId="9e80b397-6e2f-49b1-9374-ccdad8589140" providerId="ADAL" clId="{6649061F-1686-6E42-8CBD-4F0AAB90E7CD}" dt="2022-01-18T16:12:40.040" v="1317" actId="21"/>
          <ac:graphicFrameMkLst>
            <pc:docMk/>
            <pc:sldMk cId="4154367766" sldId="295"/>
            <ac:graphicFrameMk id="2" creationId="{C2C8F5CF-E830-0B44-BA36-6BE96741738C}"/>
          </ac:graphicFrameMkLst>
        </pc:graphicFrameChg>
        <pc:graphicFrameChg chg="add del mod modGraphic">
          <ac:chgData name="Narang, Sonali" userId="9e80b397-6e2f-49b1-9374-ccdad8589140" providerId="ADAL" clId="{6649061F-1686-6E42-8CBD-4F0AAB90E7CD}" dt="2022-01-18T16:12:40.040" v="1317" actId="21"/>
          <ac:graphicFrameMkLst>
            <pc:docMk/>
            <pc:sldMk cId="4154367766" sldId="295"/>
            <ac:graphicFrameMk id="154" creationId="{3CC96BEF-FBBA-2C44-8E69-3D45840055E1}"/>
          </ac:graphicFrameMkLst>
        </pc:graphicFrameChg>
      </pc:sldChg>
    </pc:docChg>
  </pc:docChgLst>
  <pc:docChgLst>
    <pc:chgData name="Narang, Sonali" userId="9e80b397-6e2f-49b1-9374-ccdad8589140" providerId="ADAL" clId="{F81D094D-588F-3F49-A3F9-58CC1A6CC615}"/>
    <pc:docChg chg="undo redo custSel addSld delSld modSld sldOrd">
      <pc:chgData name="Narang, Sonali" userId="9e80b397-6e2f-49b1-9374-ccdad8589140" providerId="ADAL" clId="{F81D094D-588F-3F49-A3F9-58CC1A6CC615}" dt="2021-12-06T16:35:52.477" v="3760" actId="20577"/>
      <pc:docMkLst>
        <pc:docMk/>
      </pc:docMkLst>
      <pc:sldChg chg="addSp delSp modSp mod">
        <pc:chgData name="Narang, Sonali" userId="9e80b397-6e2f-49b1-9374-ccdad8589140" providerId="ADAL" clId="{F81D094D-588F-3F49-A3F9-58CC1A6CC615}" dt="2021-11-30T17:18:41.616" v="2434" actId="20577"/>
        <pc:sldMkLst>
          <pc:docMk/>
          <pc:sldMk cId="1854626235" sldId="257"/>
        </pc:sldMkLst>
        <pc:spChg chg="mod">
          <ac:chgData name="Narang, Sonali" userId="9e80b397-6e2f-49b1-9374-ccdad8589140" providerId="ADAL" clId="{F81D094D-588F-3F49-A3F9-58CC1A6CC615}" dt="2021-11-30T17:18:41.616" v="2434" actId="20577"/>
          <ac:spMkLst>
            <pc:docMk/>
            <pc:sldMk cId="1854626235" sldId="257"/>
            <ac:spMk id="4" creationId="{F6669B9D-B042-D548-BD0F-97015091799B}"/>
          </ac:spMkLst>
        </pc:spChg>
        <pc:spChg chg="mod">
          <ac:chgData name="Narang, Sonali" userId="9e80b397-6e2f-49b1-9374-ccdad8589140" providerId="ADAL" clId="{F81D094D-588F-3F49-A3F9-58CC1A6CC615}" dt="2021-11-29T17:53:16.874" v="1391" actId="20577"/>
          <ac:spMkLst>
            <pc:docMk/>
            <pc:sldMk cId="1854626235" sldId="257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3:18.801" v="1393" actId="20577"/>
          <ac:spMkLst>
            <pc:docMk/>
            <pc:sldMk cId="1854626235" sldId="257"/>
            <ac:spMk id="6" creationId="{41464C80-B659-484D-A16F-8018DEC5471A}"/>
          </ac:spMkLst>
        </pc:spChg>
        <pc:spChg chg="mod">
          <ac:chgData name="Narang, Sonali" userId="9e80b397-6e2f-49b1-9374-ccdad8589140" providerId="ADAL" clId="{F81D094D-588F-3F49-A3F9-58CC1A6CC615}" dt="2021-11-29T17:53:20.691" v="1395" actId="20577"/>
          <ac:spMkLst>
            <pc:docMk/>
            <pc:sldMk cId="1854626235" sldId="257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29T17:53:24.875" v="1401" actId="20577"/>
          <ac:spMkLst>
            <pc:docMk/>
            <pc:sldMk cId="1854626235" sldId="257"/>
            <ac:spMk id="8" creationId="{8A9BAE78-C4FF-1843-94F6-3410EB884848}"/>
          </ac:spMkLst>
        </pc:spChg>
        <pc:spChg chg="mod">
          <ac:chgData name="Narang, Sonali" userId="9e80b397-6e2f-49b1-9374-ccdad8589140" providerId="ADAL" clId="{F81D094D-588F-3F49-A3F9-58CC1A6CC615}" dt="2021-11-29T22:51:40.513" v="1762" actId="207"/>
          <ac:spMkLst>
            <pc:docMk/>
            <pc:sldMk cId="1854626235" sldId="257"/>
            <ac:spMk id="56" creationId="{F3C8BA3E-7F1B-E34D-9C51-61AE3654C96D}"/>
          </ac:spMkLst>
        </pc:spChg>
        <pc:spChg chg="mod">
          <ac:chgData name="Narang, Sonali" userId="9e80b397-6e2f-49b1-9374-ccdad8589140" providerId="ADAL" clId="{F81D094D-588F-3F49-A3F9-58CC1A6CC615}" dt="2021-11-29T22:51:40.513" v="1762" actId="207"/>
          <ac:spMkLst>
            <pc:docMk/>
            <pc:sldMk cId="1854626235" sldId="257"/>
            <ac:spMk id="57" creationId="{F7F0031B-96C4-044B-99D5-1AFE0D23C5BA}"/>
          </ac:spMkLst>
        </pc:spChg>
        <pc:spChg chg="mod">
          <ac:chgData name="Narang, Sonali" userId="9e80b397-6e2f-49b1-9374-ccdad8589140" providerId="ADAL" clId="{F81D094D-588F-3F49-A3F9-58CC1A6CC615}" dt="2021-11-29T22:51:40.513" v="1762" actId="207"/>
          <ac:spMkLst>
            <pc:docMk/>
            <pc:sldMk cId="1854626235" sldId="257"/>
            <ac:spMk id="58" creationId="{DEC70FC9-FD4B-3B4A-96B4-B397B771D2DC}"/>
          </ac:spMkLst>
        </pc:spChg>
        <pc:spChg chg="mod">
          <ac:chgData name="Narang, Sonali" userId="9e80b397-6e2f-49b1-9374-ccdad8589140" providerId="ADAL" clId="{F81D094D-588F-3F49-A3F9-58CC1A6CC615}" dt="2021-11-29T22:51:47.637" v="1763" actId="207"/>
          <ac:spMkLst>
            <pc:docMk/>
            <pc:sldMk cId="1854626235" sldId="257"/>
            <ac:spMk id="67" creationId="{9ADA499E-5B6F-4B4A-B023-19AFCC0FA2F3}"/>
          </ac:spMkLst>
        </pc:spChg>
        <pc:spChg chg="mod">
          <ac:chgData name="Narang, Sonali" userId="9e80b397-6e2f-49b1-9374-ccdad8589140" providerId="ADAL" clId="{F81D094D-588F-3F49-A3F9-58CC1A6CC615}" dt="2021-11-29T22:51:47.637" v="1763" actId="207"/>
          <ac:spMkLst>
            <pc:docMk/>
            <pc:sldMk cId="1854626235" sldId="257"/>
            <ac:spMk id="68" creationId="{D223DDBF-0130-204B-BC3A-5696633A6FED}"/>
          </ac:spMkLst>
        </pc:spChg>
        <pc:spChg chg="mod">
          <ac:chgData name="Narang, Sonali" userId="9e80b397-6e2f-49b1-9374-ccdad8589140" providerId="ADAL" clId="{F81D094D-588F-3F49-A3F9-58CC1A6CC615}" dt="2021-11-29T22:51:47.637" v="1763" actId="207"/>
          <ac:spMkLst>
            <pc:docMk/>
            <pc:sldMk cId="1854626235" sldId="257"/>
            <ac:spMk id="69" creationId="{F99DF66F-5AE0-5B49-8603-BECAD3E916C5}"/>
          </ac:spMkLst>
        </pc:spChg>
        <pc:spChg chg="mod">
          <ac:chgData name="Narang, Sonali" userId="9e80b397-6e2f-49b1-9374-ccdad8589140" providerId="ADAL" clId="{F81D094D-588F-3F49-A3F9-58CC1A6CC615}" dt="2021-11-29T17:53:23.357" v="1399" actId="20577"/>
          <ac:spMkLst>
            <pc:docMk/>
            <pc:sldMk cId="1854626235" sldId="257"/>
            <ac:spMk id="70" creationId="{B246B051-DD4B-294D-B265-38CF288C0C5A}"/>
          </ac:spMkLst>
        </pc:spChg>
        <pc:spChg chg="mod">
          <ac:chgData name="Narang, Sonali" userId="9e80b397-6e2f-49b1-9374-ccdad8589140" providerId="ADAL" clId="{F81D094D-588F-3F49-A3F9-58CC1A6CC615}" dt="2021-11-29T22:58:09.069" v="1831" actId="1035"/>
          <ac:spMkLst>
            <pc:docMk/>
            <pc:sldMk cId="1854626235" sldId="257"/>
            <ac:spMk id="71" creationId="{BDCB7AA1-749D-8C43-AF10-858D8E39FF31}"/>
          </ac:spMkLst>
        </pc:spChg>
        <pc:spChg chg="mod">
          <ac:chgData name="Narang, Sonali" userId="9e80b397-6e2f-49b1-9374-ccdad8589140" providerId="ADAL" clId="{F81D094D-588F-3F49-A3F9-58CC1A6CC615}" dt="2021-11-29T22:58:09.069" v="1831" actId="1035"/>
          <ac:spMkLst>
            <pc:docMk/>
            <pc:sldMk cId="1854626235" sldId="257"/>
            <ac:spMk id="73" creationId="{3402C79D-781C-C242-A2D1-8D957E624560}"/>
          </ac:spMkLst>
        </pc:spChg>
        <pc:spChg chg="add mod">
          <ac:chgData name="Narang, Sonali" userId="9e80b397-6e2f-49b1-9374-ccdad8589140" providerId="ADAL" clId="{F81D094D-588F-3F49-A3F9-58CC1A6CC615}" dt="2021-11-30T17:17:32.833" v="2428" actId="20577"/>
          <ac:spMkLst>
            <pc:docMk/>
            <pc:sldMk cId="1854626235" sldId="257"/>
            <ac:spMk id="74" creationId="{5690E7BF-7573-AA46-9A87-07E1BC3E547C}"/>
          </ac:spMkLst>
        </pc:spChg>
        <pc:spChg chg="mod">
          <ac:chgData name="Narang, Sonali" userId="9e80b397-6e2f-49b1-9374-ccdad8589140" providerId="ADAL" clId="{F81D094D-588F-3F49-A3F9-58CC1A6CC615}" dt="2021-11-29T22:58:09.069" v="1831" actId="1035"/>
          <ac:spMkLst>
            <pc:docMk/>
            <pc:sldMk cId="1854626235" sldId="257"/>
            <ac:spMk id="76" creationId="{2027CEAE-7CD6-1546-8D11-7908F5DCCD3D}"/>
          </ac:spMkLst>
        </pc:spChg>
        <pc:spChg chg="mod">
          <ac:chgData name="Narang, Sonali" userId="9e80b397-6e2f-49b1-9374-ccdad8589140" providerId="ADAL" clId="{F81D094D-588F-3F49-A3F9-58CC1A6CC615}" dt="2021-11-29T22:58:13.941" v="1834" actId="1035"/>
          <ac:spMkLst>
            <pc:docMk/>
            <pc:sldMk cId="1854626235" sldId="257"/>
            <ac:spMk id="86" creationId="{D21029A0-FE16-1A4C-9ACD-753672358A12}"/>
          </ac:spMkLst>
        </pc:spChg>
        <pc:spChg chg="mod">
          <ac:chgData name="Narang, Sonali" userId="9e80b397-6e2f-49b1-9374-ccdad8589140" providerId="ADAL" clId="{F81D094D-588F-3F49-A3F9-58CC1A6CC615}" dt="2021-11-29T22:58:09.069" v="1831" actId="1035"/>
          <ac:spMkLst>
            <pc:docMk/>
            <pc:sldMk cId="1854626235" sldId="257"/>
            <ac:spMk id="88" creationId="{764069F7-4C54-4A4E-BB12-FC6C688BF41D}"/>
          </ac:spMkLst>
        </pc:spChg>
        <pc:grpChg chg="mod">
          <ac:chgData name="Narang, Sonali" userId="9e80b397-6e2f-49b1-9374-ccdad8589140" providerId="ADAL" clId="{F81D094D-588F-3F49-A3F9-58CC1A6CC615}" dt="2021-11-29T23:01:13.747" v="1862" actId="1035"/>
          <ac:grpSpMkLst>
            <pc:docMk/>
            <pc:sldMk cId="1854626235" sldId="257"/>
            <ac:grpSpMk id="37" creationId="{083D8F37-8390-5541-85CA-5DB8B6ACA03B}"/>
          </ac:grpSpMkLst>
        </pc:grpChg>
        <pc:picChg chg="mod">
          <ac:chgData name="Narang, Sonali" userId="9e80b397-6e2f-49b1-9374-ccdad8589140" providerId="ADAL" clId="{F81D094D-588F-3F49-A3F9-58CC1A6CC615}" dt="2021-11-29T22:58:09.069" v="1831" actId="1035"/>
          <ac:picMkLst>
            <pc:docMk/>
            <pc:sldMk cId="1854626235" sldId="257"/>
            <ac:picMk id="3" creationId="{BD3CD7DF-0565-8E43-8606-2D54B4F82EE0}"/>
          </ac:picMkLst>
        </pc:picChg>
        <pc:picChg chg="mod">
          <ac:chgData name="Narang, Sonali" userId="9e80b397-6e2f-49b1-9374-ccdad8589140" providerId="ADAL" clId="{F81D094D-588F-3F49-A3F9-58CC1A6CC615}" dt="2021-11-29T22:58:09.069" v="1831" actId="1035"/>
          <ac:picMkLst>
            <pc:docMk/>
            <pc:sldMk cId="1854626235" sldId="257"/>
            <ac:picMk id="10" creationId="{9207B711-ECE0-6148-9095-5E74B5385440}"/>
          </ac:picMkLst>
        </pc:picChg>
        <pc:picChg chg="mod">
          <ac:chgData name="Narang, Sonali" userId="9e80b397-6e2f-49b1-9374-ccdad8589140" providerId="ADAL" clId="{F81D094D-588F-3F49-A3F9-58CC1A6CC615}" dt="2021-11-29T22:58:09.069" v="1831" actId="1035"/>
          <ac:picMkLst>
            <pc:docMk/>
            <pc:sldMk cId="1854626235" sldId="257"/>
            <ac:picMk id="12" creationId="{D0F39CAB-5EF2-4E4D-A638-29E753D6ECCC}"/>
          </ac:picMkLst>
        </pc:picChg>
        <pc:picChg chg="add del mod">
          <ac:chgData name="Narang, Sonali" userId="9e80b397-6e2f-49b1-9374-ccdad8589140" providerId="ADAL" clId="{F81D094D-588F-3F49-A3F9-58CC1A6CC615}" dt="2021-11-29T22:45:59.935" v="1707" actId="478"/>
          <ac:picMkLst>
            <pc:docMk/>
            <pc:sldMk cId="1854626235" sldId="257"/>
            <ac:picMk id="13" creationId="{31FAA17E-B2EC-7845-BBD4-747331C60057}"/>
          </ac:picMkLst>
        </pc:picChg>
        <pc:picChg chg="add del mod">
          <ac:chgData name="Narang, Sonali" userId="9e80b397-6e2f-49b1-9374-ccdad8589140" providerId="ADAL" clId="{F81D094D-588F-3F49-A3F9-58CC1A6CC615}" dt="2021-11-29T22:45:59.935" v="1707" actId="478"/>
          <ac:picMkLst>
            <pc:docMk/>
            <pc:sldMk cId="1854626235" sldId="257"/>
            <ac:picMk id="15" creationId="{895AA347-B750-974C-BD4B-02BC6ADA6A60}"/>
          </ac:picMkLst>
        </pc:picChg>
        <pc:picChg chg="add del mod">
          <ac:chgData name="Narang, Sonali" userId="9e80b397-6e2f-49b1-9374-ccdad8589140" providerId="ADAL" clId="{F81D094D-588F-3F49-A3F9-58CC1A6CC615}" dt="2021-11-29T22:45:59.935" v="1707" actId="478"/>
          <ac:picMkLst>
            <pc:docMk/>
            <pc:sldMk cId="1854626235" sldId="257"/>
            <ac:picMk id="17" creationId="{5B1B5E2A-9C6F-4D44-9F07-51D2C3A8E490}"/>
          </ac:picMkLst>
        </pc:picChg>
        <pc:picChg chg="add del mod">
          <ac:chgData name="Narang, Sonali" userId="9e80b397-6e2f-49b1-9374-ccdad8589140" providerId="ADAL" clId="{F81D094D-588F-3F49-A3F9-58CC1A6CC615}" dt="2021-11-29T22:48:14.179" v="1729" actId="478"/>
          <ac:picMkLst>
            <pc:docMk/>
            <pc:sldMk cId="1854626235" sldId="257"/>
            <ac:picMk id="19" creationId="{67453A35-1C4B-3649-93F3-C6387F5751FF}"/>
          </ac:picMkLst>
        </pc:picChg>
        <pc:picChg chg="add del mod">
          <ac:chgData name="Narang, Sonali" userId="9e80b397-6e2f-49b1-9374-ccdad8589140" providerId="ADAL" clId="{F81D094D-588F-3F49-A3F9-58CC1A6CC615}" dt="2021-11-29T22:48:14.179" v="1729" actId="478"/>
          <ac:picMkLst>
            <pc:docMk/>
            <pc:sldMk cId="1854626235" sldId="257"/>
            <ac:picMk id="21" creationId="{08622D71-2979-FB49-95EB-79ACB576BE18}"/>
          </ac:picMkLst>
        </pc:picChg>
        <pc:picChg chg="add del mod">
          <ac:chgData name="Narang, Sonali" userId="9e80b397-6e2f-49b1-9374-ccdad8589140" providerId="ADAL" clId="{F81D094D-588F-3F49-A3F9-58CC1A6CC615}" dt="2021-11-29T22:48:14.179" v="1729" actId="478"/>
          <ac:picMkLst>
            <pc:docMk/>
            <pc:sldMk cId="1854626235" sldId="257"/>
            <ac:picMk id="23" creationId="{6E69FECC-8212-2949-988D-44B67EB12CBF}"/>
          </ac:picMkLst>
        </pc:picChg>
        <pc:picChg chg="add del mod modCrop">
          <ac:chgData name="Narang, Sonali" userId="9e80b397-6e2f-49b1-9374-ccdad8589140" providerId="ADAL" clId="{F81D094D-588F-3F49-A3F9-58CC1A6CC615}" dt="2021-11-29T22:56:02.506" v="1766" actId="478"/>
          <ac:picMkLst>
            <pc:docMk/>
            <pc:sldMk cId="1854626235" sldId="257"/>
            <ac:picMk id="25" creationId="{58D2E583-FA17-5C42-A78D-D9351EE1A58B}"/>
          </ac:picMkLst>
        </pc:picChg>
        <pc:picChg chg="add del mod modCrop">
          <ac:chgData name="Narang, Sonali" userId="9e80b397-6e2f-49b1-9374-ccdad8589140" providerId="ADAL" clId="{F81D094D-588F-3F49-A3F9-58CC1A6CC615}" dt="2021-11-29T22:56:02.506" v="1766" actId="478"/>
          <ac:picMkLst>
            <pc:docMk/>
            <pc:sldMk cId="1854626235" sldId="257"/>
            <ac:picMk id="27" creationId="{ACF8DCB1-B0AB-844E-BB6C-F401DFDFDF0C}"/>
          </ac:picMkLst>
        </pc:picChg>
        <pc:picChg chg="add del mod modCrop">
          <ac:chgData name="Narang, Sonali" userId="9e80b397-6e2f-49b1-9374-ccdad8589140" providerId="ADAL" clId="{F81D094D-588F-3F49-A3F9-58CC1A6CC615}" dt="2021-11-29T22:56:02.506" v="1766" actId="478"/>
          <ac:picMkLst>
            <pc:docMk/>
            <pc:sldMk cId="1854626235" sldId="257"/>
            <ac:picMk id="29" creationId="{ABF64481-344E-214F-92AC-815464C54154}"/>
          </ac:picMkLst>
        </pc:picChg>
        <pc:picChg chg="add mod modCrop">
          <ac:chgData name="Narang, Sonali" userId="9e80b397-6e2f-49b1-9374-ccdad8589140" providerId="ADAL" clId="{F81D094D-588F-3F49-A3F9-58CC1A6CC615}" dt="2021-11-29T22:57:59.689" v="1824" actId="1035"/>
          <ac:picMkLst>
            <pc:docMk/>
            <pc:sldMk cId="1854626235" sldId="257"/>
            <ac:picMk id="31" creationId="{6348F06A-7EF6-0045-9F47-34AB0389DB1F}"/>
          </ac:picMkLst>
        </pc:picChg>
        <pc:picChg chg="add mod modCrop">
          <ac:chgData name="Narang, Sonali" userId="9e80b397-6e2f-49b1-9374-ccdad8589140" providerId="ADAL" clId="{F81D094D-588F-3F49-A3F9-58CC1A6CC615}" dt="2021-11-29T22:57:59.689" v="1824" actId="1035"/>
          <ac:picMkLst>
            <pc:docMk/>
            <pc:sldMk cId="1854626235" sldId="257"/>
            <ac:picMk id="33" creationId="{385A9B95-8CF9-6043-8E9E-30408EEBB969}"/>
          </ac:picMkLst>
        </pc:picChg>
        <pc:picChg chg="add mod modCrop">
          <ac:chgData name="Narang, Sonali" userId="9e80b397-6e2f-49b1-9374-ccdad8589140" providerId="ADAL" clId="{F81D094D-588F-3F49-A3F9-58CC1A6CC615}" dt="2021-11-29T22:57:59.689" v="1824" actId="1035"/>
          <ac:picMkLst>
            <pc:docMk/>
            <pc:sldMk cId="1854626235" sldId="257"/>
            <ac:picMk id="35" creationId="{CFAF91A0-9932-974C-9606-E0C3D4E93E28}"/>
          </ac:picMkLst>
        </pc:picChg>
        <pc:picChg chg="del">
          <ac:chgData name="Narang, Sonali" userId="9e80b397-6e2f-49b1-9374-ccdad8589140" providerId="ADAL" clId="{F81D094D-588F-3F49-A3F9-58CC1A6CC615}" dt="2021-11-29T22:45:42.143" v="1696" actId="478"/>
          <ac:picMkLst>
            <pc:docMk/>
            <pc:sldMk cId="1854626235" sldId="257"/>
            <ac:picMk id="92" creationId="{C36DDAB6-9373-B94D-A081-5989767880BD}"/>
          </ac:picMkLst>
        </pc:picChg>
        <pc:picChg chg="del mod">
          <ac:chgData name="Narang, Sonali" userId="9e80b397-6e2f-49b1-9374-ccdad8589140" providerId="ADAL" clId="{F81D094D-588F-3F49-A3F9-58CC1A6CC615}" dt="2021-11-29T22:45:42.143" v="1696" actId="478"/>
          <ac:picMkLst>
            <pc:docMk/>
            <pc:sldMk cId="1854626235" sldId="257"/>
            <ac:picMk id="93" creationId="{8B06C99B-009E-C246-9F27-4E7DB4B9E545}"/>
          </ac:picMkLst>
        </pc:picChg>
        <pc:picChg chg="del mod">
          <ac:chgData name="Narang, Sonali" userId="9e80b397-6e2f-49b1-9374-ccdad8589140" providerId="ADAL" clId="{F81D094D-588F-3F49-A3F9-58CC1A6CC615}" dt="2021-11-29T22:45:42.143" v="1696" actId="478"/>
          <ac:picMkLst>
            <pc:docMk/>
            <pc:sldMk cId="1854626235" sldId="257"/>
            <ac:picMk id="95" creationId="{53B17A5D-C3AE-5544-9BBA-AFC9E02D9677}"/>
          </ac:picMkLst>
        </pc:picChg>
        <pc:picChg chg="mod">
          <ac:chgData name="Narang, Sonali" userId="9e80b397-6e2f-49b1-9374-ccdad8589140" providerId="ADAL" clId="{F81D094D-588F-3F49-A3F9-58CC1A6CC615}" dt="2021-11-30T17:17:38.900" v="2429" actId="1076"/>
          <ac:picMkLst>
            <pc:docMk/>
            <pc:sldMk cId="1854626235" sldId="257"/>
            <ac:picMk id="117" creationId="{5AF2AB47-DAE2-F643-8CDC-5611248A02A7}"/>
          </ac:picMkLst>
        </pc:picChg>
        <pc:cxnChg chg="add mod">
          <ac:chgData name="Narang, Sonali" userId="9e80b397-6e2f-49b1-9374-ccdad8589140" providerId="ADAL" clId="{F81D094D-588F-3F49-A3F9-58CC1A6CC615}" dt="2021-11-29T22:59:57.172" v="1844" actId="208"/>
          <ac:cxnSpMkLst>
            <pc:docMk/>
            <pc:sldMk cId="1854626235" sldId="257"/>
            <ac:cxnSpMk id="87" creationId="{BFEFC5B3-690B-7A4E-932F-1584CA64FDBF}"/>
          </ac:cxnSpMkLst>
        </pc:cxnChg>
        <pc:cxnChg chg="add mod">
          <ac:chgData name="Narang, Sonali" userId="9e80b397-6e2f-49b1-9374-ccdad8589140" providerId="ADAL" clId="{F81D094D-588F-3F49-A3F9-58CC1A6CC615}" dt="2021-11-29T23:00:08.163" v="1847" actId="1037"/>
          <ac:cxnSpMkLst>
            <pc:docMk/>
            <pc:sldMk cId="1854626235" sldId="257"/>
            <ac:cxnSpMk id="89" creationId="{88BFCBE1-046C-7F44-852A-BEF9AAFFFF98}"/>
          </ac:cxnSpMkLst>
        </pc:cxnChg>
        <pc:cxnChg chg="add mod">
          <ac:chgData name="Narang, Sonali" userId="9e80b397-6e2f-49b1-9374-ccdad8589140" providerId="ADAL" clId="{F81D094D-588F-3F49-A3F9-58CC1A6CC615}" dt="2021-11-29T23:00:16.856" v="1850" actId="1038"/>
          <ac:cxnSpMkLst>
            <pc:docMk/>
            <pc:sldMk cId="1854626235" sldId="257"/>
            <ac:cxnSpMk id="94" creationId="{08E207BD-4C8C-7843-89E3-F3B0159643D6}"/>
          </ac:cxnSpMkLst>
        </pc:cxnChg>
      </pc:sldChg>
      <pc:sldChg chg="addSp delSp modSp mod">
        <pc:chgData name="Narang, Sonali" userId="9e80b397-6e2f-49b1-9374-ccdad8589140" providerId="ADAL" clId="{F81D094D-588F-3F49-A3F9-58CC1A6CC615}" dt="2021-11-29T17:53:47.742" v="1419" actId="20577"/>
        <pc:sldMkLst>
          <pc:docMk/>
          <pc:sldMk cId="1155223781" sldId="258"/>
        </pc:sldMkLst>
        <pc:spChg chg="del mod">
          <ac:chgData name="Narang, Sonali" userId="9e80b397-6e2f-49b1-9374-ccdad8589140" providerId="ADAL" clId="{F81D094D-588F-3F49-A3F9-58CC1A6CC615}" dt="2021-11-17T18:50:32.172" v="420" actId="478"/>
          <ac:spMkLst>
            <pc:docMk/>
            <pc:sldMk cId="1155223781" sldId="258"/>
            <ac:spMk id="2" creationId="{13096F00-9D05-944B-BA69-2B04C7E9EDAD}"/>
          </ac:spMkLst>
        </pc:spChg>
        <pc:spChg chg="add del mod">
          <ac:chgData name="Narang, Sonali" userId="9e80b397-6e2f-49b1-9374-ccdad8589140" providerId="ADAL" clId="{F81D094D-588F-3F49-A3F9-58CC1A6CC615}" dt="2021-11-17T18:50:17.421" v="414" actId="478"/>
          <ac:spMkLst>
            <pc:docMk/>
            <pc:sldMk cId="1155223781" sldId="258"/>
            <ac:spMk id="3" creationId="{9BDB14D1-8E10-854A-A042-9BEFB5816309}"/>
          </ac:spMkLst>
        </pc:spChg>
        <pc:spChg chg="mod">
          <ac:chgData name="Narang, Sonali" userId="9e80b397-6e2f-49b1-9374-ccdad8589140" providerId="ADAL" clId="{F81D094D-588F-3F49-A3F9-58CC1A6CC615}" dt="2021-11-29T17:53:40.979" v="1413" actId="20577"/>
          <ac:spMkLst>
            <pc:docMk/>
            <pc:sldMk cId="1155223781" sldId="258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3:43.383" v="1415" actId="20577"/>
          <ac:spMkLst>
            <pc:docMk/>
            <pc:sldMk cId="1155223781" sldId="258"/>
            <ac:spMk id="6" creationId="{41464C80-B659-484D-A16F-8018DEC5471A}"/>
          </ac:spMkLst>
        </pc:spChg>
        <pc:spChg chg="mod">
          <ac:chgData name="Narang, Sonali" userId="9e80b397-6e2f-49b1-9374-ccdad8589140" providerId="ADAL" clId="{F81D094D-588F-3F49-A3F9-58CC1A6CC615}" dt="2021-11-29T17:53:46.143" v="1417" actId="20577"/>
          <ac:spMkLst>
            <pc:docMk/>
            <pc:sldMk cId="1155223781" sldId="258"/>
            <ac:spMk id="7" creationId="{4C5F5CAE-FBFD-964D-A356-746AAC86DC9E}"/>
          </ac:spMkLst>
        </pc:spChg>
        <pc:spChg chg="add mod">
          <ac:chgData name="Narang, Sonali" userId="9e80b397-6e2f-49b1-9374-ccdad8589140" providerId="ADAL" clId="{F81D094D-588F-3F49-A3F9-58CC1A6CC615}" dt="2021-11-29T17:53:47.742" v="1419" actId="20577"/>
          <ac:spMkLst>
            <pc:docMk/>
            <pc:sldMk cId="1155223781" sldId="258"/>
            <ac:spMk id="15" creationId="{9A26DAF7-4AE4-234D-A980-14F8878AB7B7}"/>
          </ac:spMkLst>
        </pc:spChg>
        <pc:picChg chg="mod">
          <ac:chgData name="Narang, Sonali" userId="9e80b397-6e2f-49b1-9374-ccdad8589140" providerId="ADAL" clId="{F81D094D-588F-3F49-A3F9-58CC1A6CC615}" dt="2021-11-17T18:50:39.286" v="422" actId="1076"/>
          <ac:picMkLst>
            <pc:docMk/>
            <pc:sldMk cId="1155223781" sldId="258"/>
            <ac:picMk id="10" creationId="{8F08C599-E1EB-3044-A41D-ED696091AEE1}"/>
          </ac:picMkLst>
        </pc:picChg>
        <pc:picChg chg="mod">
          <ac:chgData name="Narang, Sonali" userId="9e80b397-6e2f-49b1-9374-ccdad8589140" providerId="ADAL" clId="{F81D094D-588F-3F49-A3F9-58CC1A6CC615}" dt="2021-11-17T18:50:36.776" v="421" actId="1076"/>
          <ac:picMkLst>
            <pc:docMk/>
            <pc:sldMk cId="1155223781" sldId="258"/>
            <ac:picMk id="11" creationId="{49516C8B-9616-3B4D-A203-229E3B7B51D9}"/>
          </ac:picMkLst>
        </pc:picChg>
        <pc:picChg chg="add mod">
          <ac:chgData name="Narang, Sonali" userId="9e80b397-6e2f-49b1-9374-ccdad8589140" providerId="ADAL" clId="{F81D094D-588F-3F49-A3F9-58CC1A6CC615}" dt="2021-11-17T18:51:06.990" v="432" actId="1076"/>
          <ac:picMkLst>
            <pc:docMk/>
            <pc:sldMk cId="1155223781" sldId="258"/>
            <ac:picMk id="14" creationId="{97488199-8FF7-4A42-B148-0C15F8B3E126}"/>
          </ac:picMkLst>
        </pc:picChg>
      </pc:sldChg>
      <pc:sldChg chg="addSp delSp modSp mod">
        <pc:chgData name="Narang, Sonali" userId="9e80b397-6e2f-49b1-9374-ccdad8589140" providerId="ADAL" clId="{F81D094D-588F-3F49-A3F9-58CC1A6CC615}" dt="2021-11-30T17:16:24.566" v="2376" actId="1076"/>
        <pc:sldMkLst>
          <pc:docMk/>
          <pc:sldMk cId="743684689" sldId="267"/>
        </pc:sldMkLst>
        <pc:spChg chg="mod">
          <ac:chgData name="Narang, Sonali" userId="9e80b397-6e2f-49b1-9374-ccdad8589140" providerId="ADAL" clId="{F81D094D-588F-3F49-A3F9-58CC1A6CC615}" dt="2021-11-29T17:54:00.053" v="1429" actId="20577"/>
          <ac:spMkLst>
            <pc:docMk/>
            <pc:sldMk cId="743684689" sldId="267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4:01.821" v="1431" actId="20577"/>
          <ac:spMkLst>
            <pc:docMk/>
            <pc:sldMk cId="743684689" sldId="267"/>
            <ac:spMk id="6" creationId="{41464C80-B659-484D-A16F-8018DEC5471A}"/>
          </ac:spMkLst>
        </pc:spChg>
        <pc:spChg chg="mod">
          <ac:chgData name="Narang, Sonali" userId="9e80b397-6e2f-49b1-9374-ccdad8589140" providerId="ADAL" clId="{F81D094D-588F-3F49-A3F9-58CC1A6CC615}" dt="2021-11-29T17:54:03.725" v="1433" actId="20577"/>
          <ac:spMkLst>
            <pc:docMk/>
            <pc:sldMk cId="743684689" sldId="267"/>
            <ac:spMk id="8" creationId="{8A9BAE78-C4FF-1843-94F6-3410EB884848}"/>
          </ac:spMkLst>
        </pc:spChg>
        <pc:spChg chg="add mod">
          <ac:chgData name="Narang, Sonali" userId="9e80b397-6e2f-49b1-9374-ccdad8589140" providerId="ADAL" clId="{F81D094D-588F-3F49-A3F9-58CC1A6CC615}" dt="2021-11-30T17:16:24.566" v="2376" actId="1076"/>
          <ac:spMkLst>
            <pc:docMk/>
            <pc:sldMk cId="743684689" sldId="267"/>
            <ac:spMk id="61" creationId="{70A48721-2BC2-9244-9AEB-337662624A03}"/>
          </ac:spMkLst>
        </pc:spChg>
        <pc:spChg chg="mod">
          <ac:chgData name="Narang, Sonali" userId="9e80b397-6e2f-49b1-9374-ccdad8589140" providerId="ADAL" clId="{F81D094D-588F-3F49-A3F9-58CC1A6CC615}" dt="2021-11-29T17:54:05.139" v="1435" actId="20577"/>
          <ac:spMkLst>
            <pc:docMk/>
            <pc:sldMk cId="743684689" sldId="267"/>
            <ac:spMk id="124" creationId="{2BE84DAC-7C05-C445-9DD3-6B3EE69AFBF9}"/>
          </ac:spMkLst>
        </pc:spChg>
        <pc:spChg chg="mod">
          <ac:chgData name="Narang, Sonali" userId="9e80b397-6e2f-49b1-9374-ccdad8589140" providerId="ADAL" clId="{F81D094D-588F-3F49-A3F9-58CC1A6CC615}" dt="2021-11-29T17:54:07.918" v="1439" actId="20577"/>
          <ac:spMkLst>
            <pc:docMk/>
            <pc:sldMk cId="743684689" sldId="267"/>
            <ac:spMk id="125" creationId="{F77578BF-D28B-AC46-B202-F16CA20F451A}"/>
          </ac:spMkLst>
        </pc:spChg>
        <pc:grpChg chg="del">
          <ac:chgData name="Narang, Sonali" userId="9e80b397-6e2f-49b1-9374-ccdad8589140" providerId="ADAL" clId="{F81D094D-588F-3F49-A3F9-58CC1A6CC615}" dt="2021-11-30T16:24:20.230" v="2153" actId="21"/>
          <ac:grpSpMkLst>
            <pc:docMk/>
            <pc:sldMk cId="743684689" sldId="267"/>
            <ac:grpSpMk id="28" creationId="{93914C90-1944-5F48-8DBD-1C5C8C5416FC}"/>
          </ac:grpSpMkLst>
        </pc:grpChg>
        <pc:grpChg chg="del">
          <ac:chgData name="Narang, Sonali" userId="9e80b397-6e2f-49b1-9374-ccdad8589140" providerId="ADAL" clId="{F81D094D-588F-3F49-A3F9-58CC1A6CC615}" dt="2021-11-30T16:24:20.230" v="2153" actId="21"/>
          <ac:grpSpMkLst>
            <pc:docMk/>
            <pc:sldMk cId="743684689" sldId="267"/>
            <ac:grpSpMk id="79" creationId="{ECB34D7D-4B4C-0247-A1C3-B0B54BCB2CB6}"/>
          </ac:grpSpMkLst>
        </pc:grpChg>
        <pc:grpChg chg="del">
          <ac:chgData name="Narang, Sonali" userId="9e80b397-6e2f-49b1-9374-ccdad8589140" providerId="ADAL" clId="{F81D094D-588F-3F49-A3F9-58CC1A6CC615}" dt="2021-11-30T16:24:20.230" v="2153" actId="21"/>
          <ac:grpSpMkLst>
            <pc:docMk/>
            <pc:sldMk cId="743684689" sldId="267"/>
            <ac:grpSpMk id="80" creationId="{65CB00CD-5C89-6D44-9656-518239B36C6F}"/>
          </ac:grpSpMkLst>
        </pc:grpChg>
        <pc:grpChg chg="mod">
          <ac:chgData name="Narang, Sonali" userId="9e80b397-6e2f-49b1-9374-ccdad8589140" providerId="ADAL" clId="{F81D094D-588F-3F49-A3F9-58CC1A6CC615}" dt="2021-11-30T17:16:11.751" v="2372" actId="1076"/>
          <ac:grpSpMkLst>
            <pc:docMk/>
            <pc:sldMk cId="743684689" sldId="267"/>
            <ac:grpSpMk id="117" creationId="{B05B94FA-BBA9-A64D-8CA4-F0D3B7616FE1}"/>
          </ac:grpSpMkLst>
        </pc:grpChg>
        <pc:picChg chg="add mod">
          <ac:chgData name="Narang, Sonali" userId="9e80b397-6e2f-49b1-9374-ccdad8589140" providerId="ADAL" clId="{F81D094D-588F-3F49-A3F9-58CC1A6CC615}" dt="2021-11-30T17:16:24.566" v="2376" actId="1076"/>
          <ac:picMkLst>
            <pc:docMk/>
            <pc:sldMk cId="743684689" sldId="267"/>
            <ac:picMk id="58" creationId="{C7001BD1-4EB1-EC4E-B296-37C694FBD138}"/>
          </ac:picMkLst>
        </pc:picChg>
        <pc:picChg chg="add mod">
          <ac:chgData name="Narang, Sonali" userId="9e80b397-6e2f-49b1-9374-ccdad8589140" providerId="ADAL" clId="{F81D094D-588F-3F49-A3F9-58CC1A6CC615}" dt="2021-11-30T17:16:24.566" v="2376" actId="1076"/>
          <ac:picMkLst>
            <pc:docMk/>
            <pc:sldMk cId="743684689" sldId="267"/>
            <ac:picMk id="59" creationId="{C102C116-1F08-9540-A57A-4BCAAD3C4325}"/>
          </ac:picMkLst>
        </pc:picChg>
        <pc:picChg chg="add mod">
          <ac:chgData name="Narang, Sonali" userId="9e80b397-6e2f-49b1-9374-ccdad8589140" providerId="ADAL" clId="{F81D094D-588F-3F49-A3F9-58CC1A6CC615}" dt="2021-11-30T17:16:24.566" v="2376" actId="1076"/>
          <ac:picMkLst>
            <pc:docMk/>
            <pc:sldMk cId="743684689" sldId="267"/>
            <ac:picMk id="60" creationId="{1F2B4104-CFDC-8645-9E46-63B2C37E19DC}"/>
          </ac:picMkLst>
        </pc:picChg>
        <pc:picChg chg="mod">
          <ac:chgData name="Narang, Sonali" userId="9e80b397-6e2f-49b1-9374-ccdad8589140" providerId="ADAL" clId="{F81D094D-588F-3F49-A3F9-58CC1A6CC615}" dt="2021-11-30T17:16:15.347" v="2373" actId="1076"/>
          <ac:picMkLst>
            <pc:docMk/>
            <pc:sldMk cId="743684689" sldId="267"/>
            <ac:picMk id="167" creationId="{58CAA980-D1E6-AA4C-A334-C0D57A74D895}"/>
          </ac:picMkLst>
        </pc:picChg>
        <pc:picChg chg="mod">
          <ac:chgData name="Narang, Sonali" userId="9e80b397-6e2f-49b1-9374-ccdad8589140" providerId="ADAL" clId="{F81D094D-588F-3F49-A3F9-58CC1A6CC615}" dt="2021-11-30T17:16:15.347" v="2373" actId="1076"/>
          <ac:picMkLst>
            <pc:docMk/>
            <pc:sldMk cId="743684689" sldId="267"/>
            <ac:picMk id="169" creationId="{5A30999A-89D7-8C40-9571-87F0979C7EAA}"/>
          </ac:picMkLst>
        </pc:picChg>
        <pc:picChg chg="mod">
          <ac:chgData name="Narang, Sonali" userId="9e80b397-6e2f-49b1-9374-ccdad8589140" providerId="ADAL" clId="{F81D094D-588F-3F49-A3F9-58CC1A6CC615}" dt="2021-11-30T17:16:15.347" v="2373" actId="1076"/>
          <ac:picMkLst>
            <pc:docMk/>
            <pc:sldMk cId="743684689" sldId="267"/>
            <ac:picMk id="171" creationId="{9C4DDE62-3BC7-ED45-A82E-A3C21D506B79}"/>
          </ac:picMkLst>
        </pc:picChg>
      </pc:sldChg>
      <pc:sldChg chg="modSp mod">
        <pc:chgData name="Narang, Sonali" userId="9e80b397-6e2f-49b1-9374-ccdad8589140" providerId="ADAL" clId="{F81D094D-588F-3F49-A3F9-58CC1A6CC615}" dt="2021-11-29T17:54:40.295" v="1447" actId="1076"/>
        <pc:sldMkLst>
          <pc:docMk/>
          <pc:sldMk cId="2720918902" sldId="269"/>
        </pc:sldMkLst>
        <pc:spChg chg="mod">
          <ac:chgData name="Narang, Sonali" userId="9e80b397-6e2f-49b1-9374-ccdad8589140" providerId="ADAL" clId="{F81D094D-588F-3F49-A3F9-58CC1A6CC615}" dt="2021-11-29T17:54:40.295" v="1447" actId="1076"/>
          <ac:spMkLst>
            <pc:docMk/>
            <pc:sldMk cId="2720918902" sldId="269"/>
            <ac:spMk id="45" creationId="{A37EFDC5-08ED-BB45-B24A-B00535A392F0}"/>
          </ac:spMkLst>
        </pc:spChg>
      </pc:sldChg>
      <pc:sldChg chg="addSp modSp del mod modNotesTx">
        <pc:chgData name="Narang, Sonali" userId="9e80b397-6e2f-49b1-9374-ccdad8589140" providerId="ADAL" clId="{F81D094D-588F-3F49-A3F9-58CC1A6CC615}" dt="2021-11-29T18:07:13.976" v="1562" actId="2696"/>
        <pc:sldMkLst>
          <pc:docMk/>
          <pc:sldMk cId="3689715634" sldId="270"/>
        </pc:sldMkLst>
        <pc:spChg chg="add mod">
          <ac:chgData name="Narang, Sonali" userId="9e80b397-6e2f-49b1-9374-ccdad8589140" providerId="ADAL" clId="{F81D094D-588F-3F49-A3F9-58CC1A6CC615}" dt="2021-11-29T17:55:59.049" v="1519" actId="207"/>
          <ac:spMkLst>
            <pc:docMk/>
            <pc:sldMk cId="3689715634" sldId="270"/>
            <ac:spMk id="2" creationId="{1A2212E3-3516-5441-A4AE-B008F9F1E87A}"/>
          </ac:spMkLst>
        </pc:spChg>
        <pc:spChg chg="mod">
          <ac:chgData name="Narang, Sonali" userId="9e80b397-6e2f-49b1-9374-ccdad8589140" providerId="ADAL" clId="{F81D094D-588F-3F49-A3F9-58CC1A6CC615}" dt="2021-11-29T17:51:56.483" v="1337" actId="20577"/>
          <ac:spMkLst>
            <pc:docMk/>
            <pc:sldMk cId="3689715634" sldId="270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1:58.161" v="1339" actId="20577"/>
          <ac:spMkLst>
            <pc:docMk/>
            <pc:sldMk cId="3689715634" sldId="270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29T17:52:01.476" v="1341" actId="20577"/>
          <ac:spMkLst>
            <pc:docMk/>
            <pc:sldMk cId="3689715634" sldId="270"/>
            <ac:spMk id="8" creationId="{8A9BAE78-C4FF-1843-94F6-3410EB884848}"/>
          </ac:spMkLst>
        </pc:spChg>
        <pc:spChg chg="mod">
          <ac:chgData name="Narang, Sonali" userId="9e80b397-6e2f-49b1-9374-ccdad8589140" providerId="ADAL" clId="{F81D094D-588F-3F49-A3F9-58CC1A6CC615}" dt="2021-11-29T17:52:03.284" v="1343" actId="20577"/>
          <ac:spMkLst>
            <pc:docMk/>
            <pc:sldMk cId="3689715634" sldId="270"/>
            <ac:spMk id="32" creationId="{2863401C-2050-2E40-AE5C-C6CDD3A8A7D4}"/>
          </ac:spMkLst>
        </pc:spChg>
        <pc:spChg chg="mod">
          <ac:chgData name="Narang, Sonali" userId="9e80b397-6e2f-49b1-9374-ccdad8589140" providerId="ADAL" clId="{F81D094D-588F-3F49-A3F9-58CC1A6CC615}" dt="2021-11-29T17:52:05.581" v="1345" actId="20577"/>
          <ac:spMkLst>
            <pc:docMk/>
            <pc:sldMk cId="3689715634" sldId="270"/>
            <ac:spMk id="36" creationId="{75B14C61-810F-134B-AC0D-0C1FD0CAB17A}"/>
          </ac:spMkLst>
        </pc:spChg>
        <pc:spChg chg="mod">
          <ac:chgData name="Narang, Sonali" userId="9e80b397-6e2f-49b1-9374-ccdad8589140" providerId="ADAL" clId="{F81D094D-588F-3F49-A3F9-58CC1A6CC615}" dt="2021-11-29T17:52:07.501" v="1347" actId="20577"/>
          <ac:spMkLst>
            <pc:docMk/>
            <pc:sldMk cId="3689715634" sldId="270"/>
            <ac:spMk id="59" creationId="{1C85DEE8-F315-5047-B7B7-8827D96395BE}"/>
          </ac:spMkLst>
        </pc:spChg>
        <pc:spChg chg="add mod">
          <ac:chgData name="Narang, Sonali" userId="9e80b397-6e2f-49b1-9374-ccdad8589140" providerId="ADAL" clId="{F81D094D-588F-3F49-A3F9-58CC1A6CC615}" dt="2021-11-29T17:56:31.860" v="1524" actId="14100"/>
          <ac:spMkLst>
            <pc:docMk/>
            <pc:sldMk cId="3689715634" sldId="270"/>
            <ac:spMk id="178" creationId="{078B8EEC-B802-234A-9C18-9B5824E69F09}"/>
          </ac:spMkLst>
        </pc:spChg>
        <pc:spChg chg="mod">
          <ac:chgData name="Narang, Sonali" userId="9e80b397-6e2f-49b1-9374-ccdad8589140" providerId="ADAL" clId="{F81D094D-588F-3F49-A3F9-58CC1A6CC615}" dt="2021-11-29T17:52:09.639" v="1349" actId="20577"/>
          <ac:spMkLst>
            <pc:docMk/>
            <pc:sldMk cId="3689715634" sldId="270"/>
            <ac:spMk id="259" creationId="{B6297CA1-726C-9C44-8F9B-04A44BC1D29F}"/>
          </ac:spMkLst>
        </pc:spChg>
      </pc:sldChg>
      <pc:sldChg chg="addSp delSp modSp mod modNotesTx">
        <pc:chgData name="Narang, Sonali" userId="9e80b397-6e2f-49b1-9374-ccdad8589140" providerId="ADAL" clId="{F81D094D-588F-3F49-A3F9-58CC1A6CC615}" dt="2021-12-01T19:16:25.522" v="3479" actId="1037"/>
        <pc:sldMkLst>
          <pc:docMk/>
          <pc:sldMk cId="454596918" sldId="276"/>
        </pc:sldMkLst>
        <pc:spChg chg="mod">
          <ac:chgData name="Narang, Sonali" userId="9e80b397-6e2f-49b1-9374-ccdad8589140" providerId="ADAL" clId="{F81D094D-588F-3F49-A3F9-58CC1A6CC615}" dt="2021-11-29T17:52:41.124" v="1375" actId="20577"/>
          <ac:spMkLst>
            <pc:docMk/>
            <pc:sldMk cId="454596918" sldId="276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30T16:25:33.769" v="2197" actId="1035"/>
          <ac:spMkLst>
            <pc:docMk/>
            <pc:sldMk cId="454596918" sldId="276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30T16:25:33.769" v="2197" actId="1035"/>
          <ac:spMkLst>
            <pc:docMk/>
            <pc:sldMk cId="454596918" sldId="276"/>
            <ac:spMk id="8" creationId="{8A9BAE78-C4FF-1843-94F6-3410EB884848}"/>
          </ac:spMkLst>
        </pc:spChg>
        <pc:spChg chg="add mod">
          <ac:chgData name="Narang, Sonali" userId="9e80b397-6e2f-49b1-9374-ccdad8589140" providerId="ADAL" clId="{F81D094D-588F-3F49-A3F9-58CC1A6CC615}" dt="2021-11-30T17:02:40.021" v="2348" actId="20577"/>
          <ac:spMkLst>
            <pc:docMk/>
            <pc:sldMk cId="454596918" sldId="276"/>
            <ac:spMk id="33" creationId="{0939E132-6C14-0D4B-8CF4-9230FDB86D23}"/>
          </ac:spMkLst>
        </pc:spChg>
        <pc:spChg chg="add mod">
          <ac:chgData name="Narang, Sonali" userId="9e80b397-6e2f-49b1-9374-ccdad8589140" providerId="ADAL" clId="{F81D094D-588F-3F49-A3F9-58CC1A6CC615}" dt="2021-11-30T16:54:53.187" v="2335" actId="255"/>
          <ac:spMkLst>
            <pc:docMk/>
            <pc:sldMk cId="454596918" sldId="276"/>
            <ac:spMk id="34" creationId="{CC4BF2EF-8D29-FD49-A68E-73AC9188D1CF}"/>
          </ac:spMkLst>
        </pc:spChg>
        <pc:spChg chg="mod">
          <ac:chgData name="Narang, Sonali" userId="9e80b397-6e2f-49b1-9374-ccdad8589140" providerId="ADAL" clId="{F81D094D-588F-3F49-A3F9-58CC1A6CC615}" dt="2021-11-30T16:25:51.802" v="2212" actId="1035"/>
          <ac:spMkLst>
            <pc:docMk/>
            <pc:sldMk cId="454596918" sldId="276"/>
            <ac:spMk id="36" creationId="{75B14C61-810F-134B-AC0D-0C1FD0CAB17A}"/>
          </ac:spMkLst>
        </pc:spChg>
        <pc:spChg chg="mod">
          <ac:chgData name="Narang, Sonali" userId="9e80b397-6e2f-49b1-9374-ccdad8589140" providerId="ADAL" clId="{F81D094D-588F-3F49-A3F9-58CC1A6CC615}" dt="2021-11-30T16:24:24.845" v="2154"/>
          <ac:spMkLst>
            <pc:docMk/>
            <pc:sldMk cId="454596918" sldId="276"/>
            <ac:spMk id="42" creationId="{0B6F99AC-D72C-CB4D-95F8-7D357C4DA10D}"/>
          </ac:spMkLst>
        </pc:spChg>
        <pc:spChg chg="mod">
          <ac:chgData name="Narang, Sonali" userId="9e80b397-6e2f-49b1-9374-ccdad8589140" providerId="ADAL" clId="{F81D094D-588F-3F49-A3F9-58CC1A6CC615}" dt="2021-11-30T16:24:24.845" v="2154"/>
          <ac:spMkLst>
            <pc:docMk/>
            <pc:sldMk cId="454596918" sldId="276"/>
            <ac:spMk id="43" creationId="{B8EE453C-3984-FD46-8D0B-40F4BE0D73E9}"/>
          </ac:spMkLst>
        </pc:spChg>
        <pc:spChg chg="mod">
          <ac:chgData name="Narang, Sonali" userId="9e80b397-6e2f-49b1-9374-ccdad8589140" providerId="ADAL" clId="{F81D094D-588F-3F49-A3F9-58CC1A6CC615}" dt="2021-11-30T16:24:24.845" v="2154"/>
          <ac:spMkLst>
            <pc:docMk/>
            <pc:sldMk cId="454596918" sldId="276"/>
            <ac:spMk id="46" creationId="{A34B9C33-8AFA-CE47-9EF5-663D8AFD196E}"/>
          </ac:spMkLst>
        </pc:spChg>
        <pc:spChg chg="mod">
          <ac:chgData name="Narang, Sonali" userId="9e80b397-6e2f-49b1-9374-ccdad8589140" providerId="ADAL" clId="{F81D094D-588F-3F49-A3F9-58CC1A6CC615}" dt="2021-11-30T16:24:24.845" v="2154"/>
          <ac:spMkLst>
            <pc:docMk/>
            <pc:sldMk cId="454596918" sldId="276"/>
            <ac:spMk id="47" creationId="{FC97B07C-CD6C-8445-A963-E3E7F668651D}"/>
          </ac:spMkLst>
        </pc:spChg>
        <pc:spChg chg="mod">
          <ac:chgData name="Narang, Sonali" userId="9e80b397-6e2f-49b1-9374-ccdad8589140" providerId="ADAL" clId="{F81D094D-588F-3F49-A3F9-58CC1A6CC615}" dt="2021-12-01T19:11:49.315" v="3463" actId="255"/>
          <ac:spMkLst>
            <pc:docMk/>
            <pc:sldMk cId="454596918" sldId="276"/>
            <ac:spMk id="50" creationId="{0DF14D68-CA6C-7B4D-999B-BAE2AC8C9B3A}"/>
          </ac:spMkLst>
        </pc:spChg>
        <pc:spChg chg="mod">
          <ac:chgData name="Narang, Sonali" userId="9e80b397-6e2f-49b1-9374-ccdad8589140" providerId="ADAL" clId="{F81D094D-588F-3F49-A3F9-58CC1A6CC615}" dt="2021-12-01T19:11:49.315" v="3463" actId="255"/>
          <ac:spMkLst>
            <pc:docMk/>
            <pc:sldMk cId="454596918" sldId="276"/>
            <ac:spMk id="51" creationId="{7EE85789-26CC-CD4C-9582-0B9BB601EAD1}"/>
          </ac:spMkLst>
        </pc:spChg>
        <pc:spChg chg="add del mod">
          <ac:chgData name="Narang, Sonali" userId="9e80b397-6e2f-49b1-9374-ccdad8589140" providerId="ADAL" clId="{F81D094D-588F-3F49-A3F9-58CC1A6CC615}" dt="2021-11-29T18:03:27.788" v="1559" actId="478"/>
          <ac:spMkLst>
            <pc:docMk/>
            <pc:sldMk cId="454596918" sldId="276"/>
            <ac:spMk id="59" creationId="{1C85DEE8-F315-5047-B7B7-8827D96395BE}"/>
          </ac:spMkLst>
        </pc:spChg>
        <pc:spChg chg="del">
          <ac:chgData name="Narang, Sonali" userId="9e80b397-6e2f-49b1-9374-ccdad8589140" providerId="ADAL" clId="{F81D094D-588F-3F49-A3F9-58CC1A6CC615}" dt="2021-11-29T18:01:39.816" v="1539" actId="21"/>
          <ac:spMkLst>
            <pc:docMk/>
            <pc:sldMk cId="454596918" sldId="276"/>
            <ac:spMk id="80" creationId="{28D38C57-B22A-6B41-AD79-1CA71ACA6A49}"/>
          </ac:spMkLst>
        </pc:spChg>
        <pc:spChg chg="del">
          <ac:chgData name="Narang, Sonali" userId="9e80b397-6e2f-49b1-9374-ccdad8589140" providerId="ADAL" clId="{F81D094D-588F-3F49-A3F9-58CC1A6CC615}" dt="2021-11-29T18:01:39.816" v="1539" actId="21"/>
          <ac:spMkLst>
            <pc:docMk/>
            <pc:sldMk cId="454596918" sldId="276"/>
            <ac:spMk id="81" creationId="{BFDA3492-5E10-ED45-A723-BF91EA0B4F44}"/>
          </ac:spMkLst>
        </pc:spChg>
        <pc:spChg chg="mod">
          <ac:chgData name="Narang, Sonali" userId="9e80b397-6e2f-49b1-9374-ccdad8589140" providerId="ADAL" clId="{F81D094D-588F-3F49-A3F9-58CC1A6CC615}" dt="2021-11-30T16:25:51.802" v="2212" actId="1035"/>
          <ac:spMkLst>
            <pc:docMk/>
            <pc:sldMk cId="454596918" sldId="276"/>
            <ac:spMk id="88" creationId="{450581AC-1A52-B042-8CFD-0D1AB13EB01E}"/>
          </ac:spMkLst>
        </pc:spChg>
        <pc:spChg chg="add del mod">
          <ac:chgData name="Narang, Sonali" userId="9e80b397-6e2f-49b1-9374-ccdad8589140" providerId="ADAL" clId="{F81D094D-588F-3F49-A3F9-58CC1A6CC615}" dt="2021-11-29T18:03:15.917" v="1554"/>
          <ac:spMkLst>
            <pc:docMk/>
            <pc:sldMk cId="454596918" sldId="276"/>
            <ac:spMk id="92" creationId="{8D69B728-3BD9-ED43-ADC3-B7C2535EA9FD}"/>
          </ac:spMkLst>
        </pc:spChg>
        <pc:spChg chg="add mod">
          <ac:chgData name="Narang, Sonali" userId="9e80b397-6e2f-49b1-9374-ccdad8589140" providerId="ADAL" clId="{F81D094D-588F-3F49-A3F9-58CC1A6CC615}" dt="2021-11-30T16:23:55.154" v="2149" actId="1076"/>
          <ac:spMkLst>
            <pc:docMk/>
            <pc:sldMk cId="454596918" sldId="276"/>
            <ac:spMk id="97" creationId="{016F0B8D-C704-F44C-9227-A2CF5D7F50B1}"/>
          </ac:spMkLst>
        </pc:spChg>
        <pc:spChg chg="add mod">
          <ac:chgData name="Narang, Sonali" userId="9e80b397-6e2f-49b1-9374-ccdad8589140" providerId="ADAL" clId="{F81D094D-588F-3F49-A3F9-58CC1A6CC615}" dt="2021-12-01T19:16:25.522" v="3479" actId="1037"/>
          <ac:spMkLst>
            <pc:docMk/>
            <pc:sldMk cId="454596918" sldId="276"/>
            <ac:spMk id="103" creationId="{7A568BEE-AEA8-0D46-802F-C9E8DFFC6D61}"/>
          </ac:spMkLst>
        </pc:spChg>
        <pc:grpChg chg="add del">
          <ac:chgData name="Narang, Sonali" userId="9e80b397-6e2f-49b1-9374-ccdad8589140" providerId="ADAL" clId="{F81D094D-588F-3F49-A3F9-58CC1A6CC615}" dt="2021-11-29T18:01:39.816" v="1539" actId="21"/>
          <ac:grpSpMkLst>
            <pc:docMk/>
            <pc:sldMk cId="454596918" sldId="276"/>
            <ac:grpSpMk id="24" creationId="{1C799EA5-FBE0-5B46-813F-EF20A1A81420}"/>
          </ac:grpSpMkLst>
        </pc:grpChg>
        <pc:grpChg chg="add del">
          <ac:chgData name="Narang, Sonali" userId="9e80b397-6e2f-49b1-9374-ccdad8589140" providerId="ADAL" clId="{F81D094D-588F-3F49-A3F9-58CC1A6CC615}" dt="2021-11-29T18:01:39.816" v="1539" actId="21"/>
          <ac:grpSpMkLst>
            <pc:docMk/>
            <pc:sldMk cId="454596918" sldId="276"/>
            <ac:grpSpMk id="25" creationId="{209DE69F-C181-9B41-A954-044CD88589A7}"/>
          </ac:grpSpMkLst>
        </pc:grpChg>
        <pc:grpChg chg="add mod">
          <ac:chgData name="Narang, Sonali" userId="9e80b397-6e2f-49b1-9374-ccdad8589140" providerId="ADAL" clId="{F81D094D-588F-3F49-A3F9-58CC1A6CC615}" dt="2021-11-30T16:26:15.782" v="2231" actId="1036"/>
          <ac:grpSpMkLst>
            <pc:docMk/>
            <pc:sldMk cId="454596918" sldId="276"/>
            <ac:grpSpMk id="40" creationId="{B6B06801-60F2-504D-BD9C-278DDB7012B7}"/>
          </ac:grpSpMkLst>
        </pc:grpChg>
        <pc:grpChg chg="add mod">
          <ac:chgData name="Narang, Sonali" userId="9e80b397-6e2f-49b1-9374-ccdad8589140" providerId="ADAL" clId="{F81D094D-588F-3F49-A3F9-58CC1A6CC615}" dt="2021-11-30T16:26:15.782" v="2231" actId="1036"/>
          <ac:grpSpMkLst>
            <pc:docMk/>
            <pc:sldMk cId="454596918" sldId="276"/>
            <ac:grpSpMk id="44" creationId="{5A8363F9-A836-8745-B519-00A75F887FBF}"/>
          </ac:grpSpMkLst>
        </pc:grpChg>
        <pc:grpChg chg="add mod">
          <ac:chgData name="Narang, Sonali" userId="9e80b397-6e2f-49b1-9374-ccdad8589140" providerId="ADAL" clId="{F81D094D-588F-3F49-A3F9-58CC1A6CC615}" dt="2021-11-30T16:53:42.589" v="2275" actId="1076"/>
          <ac:grpSpMkLst>
            <pc:docMk/>
            <pc:sldMk cId="454596918" sldId="276"/>
            <ac:grpSpMk id="48" creationId="{A3ADBD5A-2723-6D4B-9604-F13BDA7528B6}"/>
          </ac:grpSpMkLst>
        </pc:grpChg>
        <pc:picChg chg="del mod">
          <ac:chgData name="Narang, Sonali" userId="9e80b397-6e2f-49b1-9374-ccdad8589140" providerId="ADAL" clId="{F81D094D-588F-3F49-A3F9-58CC1A6CC615}" dt="2021-11-30T16:04:59.594" v="2048" actId="478"/>
          <ac:picMkLst>
            <pc:docMk/>
            <pc:sldMk cId="454596918" sldId="276"/>
            <ac:picMk id="3" creationId="{891FE0AC-8ED7-4848-8237-AF85468F7E28}"/>
          </ac:picMkLst>
        </pc:picChg>
        <pc:picChg chg="del mod">
          <ac:chgData name="Narang, Sonali" userId="9e80b397-6e2f-49b1-9374-ccdad8589140" providerId="ADAL" clId="{F81D094D-588F-3F49-A3F9-58CC1A6CC615}" dt="2021-11-30T15:52:21.022" v="1976" actId="478"/>
          <ac:picMkLst>
            <pc:docMk/>
            <pc:sldMk cId="454596918" sldId="276"/>
            <ac:picMk id="6" creationId="{179D512F-EFF3-A14A-8AD8-0EF69CE85A7B}"/>
          </ac:picMkLst>
        </pc:picChg>
        <pc:picChg chg="del mod">
          <ac:chgData name="Narang, Sonali" userId="9e80b397-6e2f-49b1-9374-ccdad8589140" providerId="ADAL" clId="{F81D094D-588F-3F49-A3F9-58CC1A6CC615}" dt="2021-11-30T16:04:59.594" v="2048" actId="478"/>
          <ac:picMkLst>
            <pc:docMk/>
            <pc:sldMk cId="454596918" sldId="276"/>
            <ac:picMk id="9" creationId="{E2A187F8-372D-4244-927F-D2CFCE5636A6}"/>
          </ac:picMkLst>
        </pc:picChg>
        <pc:picChg chg="add del mod">
          <ac:chgData name="Narang, Sonali" userId="9e80b397-6e2f-49b1-9374-ccdad8589140" providerId="ADAL" clId="{F81D094D-588F-3F49-A3F9-58CC1A6CC615}" dt="2021-11-30T15:54:27.204" v="1990" actId="478"/>
          <ac:picMkLst>
            <pc:docMk/>
            <pc:sldMk cId="454596918" sldId="276"/>
            <ac:picMk id="10" creationId="{36AF3D3B-56B3-CE49-8858-FCFC4DB01184}"/>
          </ac:picMkLst>
        </pc:picChg>
        <pc:picChg chg="add del mod">
          <ac:chgData name="Narang, Sonali" userId="9e80b397-6e2f-49b1-9374-ccdad8589140" providerId="ADAL" clId="{F81D094D-588F-3F49-A3F9-58CC1A6CC615}" dt="2021-11-29T21:38:48.335" v="1572" actId="478"/>
          <ac:picMkLst>
            <pc:docMk/>
            <pc:sldMk cId="454596918" sldId="276"/>
            <ac:picMk id="10" creationId="{67A96121-7D52-AD47-A227-6B0584694836}"/>
          </ac:picMkLst>
        </pc:picChg>
        <pc:picChg chg="del mod">
          <ac:chgData name="Narang, Sonali" userId="9e80b397-6e2f-49b1-9374-ccdad8589140" providerId="ADAL" clId="{F81D094D-588F-3F49-A3F9-58CC1A6CC615}" dt="2021-11-30T16:04:59.594" v="2048" actId="478"/>
          <ac:picMkLst>
            <pc:docMk/>
            <pc:sldMk cId="454596918" sldId="276"/>
            <ac:picMk id="11" creationId="{FE67D655-CDFC-1648-BF25-A33327F76990}"/>
          </ac:picMkLst>
        </pc:picChg>
        <pc:picChg chg="del mod">
          <ac:chgData name="Narang, Sonali" userId="9e80b397-6e2f-49b1-9374-ccdad8589140" providerId="ADAL" clId="{F81D094D-588F-3F49-A3F9-58CC1A6CC615}" dt="2021-11-30T15:52:21.022" v="1976" actId="478"/>
          <ac:picMkLst>
            <pc:docMk/>
            <pc:sldMk cId="454596918" sldId="276"/>
            <ac:picMk id="12" creationId="{29B679E3-3B24-D449-AD45-AA101DE16CCE}"/>
          </ac:picMkLst>
        </pc:picChg>
        <pc:picChg chg="add del mod">
          <ac:chgData name="Narang, Sonali" userId="9e80b397-6e2f-49b1-9374-ccdad8589140" providerId="ADAL" clId="{F81D094D-588F-3F49-A3F9-58CC1A6CC615}" dt="2021-11-29T21:39:50.211" v="1583" actId="478"/>
          <ac:picMkLst>
            <pc:docMk/>
            <pc:sldMk cId="454596918" sldId="276"/>
            <ac:picMk id="14" creationId="{0F17E31A-B95E-0642-9A67-BF3957FF3CA7}"/>
          </ac:picMkLst>
        </pc:picChg>
        <pc:picChg chg="add del mod">
          <ac:chgData name="Narang, Sonali" userId="9e80b397-6e2f-49b1-9374-ccdad8589140" providerId="ADAL" clId="{F81D094D-588F-3F49-A3F9-58CC1A6CC615}" dt="2021-11-30T15:54:27.204" v="1990" actId="478"/>
          <ac:picMkLst>
            <pc:docMk/>
            <pc:sldMk cId="454596918" sldId="276"/>
            <ac:picMk id="14" creationId="{AFE1EC93-AEA0-FC41-986D-6DBC6E478EA1}"/>
          </ac:picMkLst>
        </pc:picChg>
        <pc:picChg chg="add del mod">
          <ac:chgData name="Narang, Sonali" userId="9e80b397-6e2f-49b1-9374-ccdad8589140" providerId="ADAL" clId="{F81D094D-588F-3F49-A3F9-58CC1A6CC615}" dt="2021-11-30T15:54:27.204" v="1990" actId="478"/>
          <ac:picMkLst>
            <pc:docMk/>
            <pc:sldMk cId="454596918" sldId="276"/>
            <ac:picMk id="16" creationId="{37D056BF-0157-D548-AEFA-2F896DD4A738}"/>
          </ac:picMkLst>
        </pc:picChg>
        <pc:picChg chg="add mod">
          <ac:chgData name="Narang, Sonali" userId="9e80b397-6e2f-49b1-9374-ccdad8589140" providerId="ADAL" clId="{F81D094D-588F-3F49-A3F9-58CC1A6CC615}" dt="2021-11-30T16:24:10.629" v="2152" actId="1076"/>
          <ac:picMkLst>
            <pc:docMk/>
            <pc:sldMk cId="454596918" sldId="276"/>
            <ac:picMk id="18" creationId="{DF333FF1-F863-D141-B010-A34F13819DB2}"/>
          </ac:picMkLst>
        </pc:picChg>
        <pc:picChg chg="add mod">
          <ac:chgData name="Narang, Sonali" userId="9e80b397-6e2f-49b1-9374-ccdad8589140" providerId="ADAL" clId="{F81D094D-588F-3F49-A3F9-58CC1A6CC615}" dt="2021-11-30T16:24:10.629" v="2152" actId="1076"/>
          <ac:picMkLst>
            <pc:docMk/>
            <pc:sldMk cId="454596918" sldId="276"/>
            <ac:picMk id="20" creationId="{794727B0-2E46-B848-A584-460333580DFF}"/>
          </ac:picMkLst>
        </pc:picChg>
        <pc:picChg chg="del mod">
          <ac:chgData name="Narang, Sonali" userId="9e80b397-6e2f-49b1-9374-ccdad8589140" providerId="ADAL" clId="{F81D094D-588F-3F49-A3F9-58CC1A6CC615}" dt="2021-11-30T15:52:21.022" v="1976" actId="478"/>
          <ac:picMkLst>
            <pc:docMk/>
            <pc:sldMk cId="454596918" sldId="276"/>
            <ac:picMk id="21" creationId="{212D3512-6F35-B14B-9D2B-C83017203A6D}"/>
          </ac:picMkLst>
        </pc:picChg>
        <pc:picChg chg="add mod">
          <ac:chgData name="Narang, Sonali" userId="9e80b397-6e2f-49b1-9374-ccdad8589140" providerId="ADAL" clId="{F81D094D-588F-3F49-A3F9-58CC1A6CC615}" dt="2021-11-30T16:24:10.629" v="2152" actId="1076"/>
          <ac:picMkLst>
            <pc:docMk/>
            <pc:sldMk cId="454596918" sldId="276"/>
            <ac:picMk id="23" creationId="{F554E1E1-64F6-5142-9BDC-E8FA54A580C4}"/>
          </ac:picMkLst>
        </pc:picChg>
        <pc:picChg chg="add mod">
          <ac:chgData name="Narang, Sonali" userId="9e80b397-6e2f-49b1-9374-ccdad8589140" providerId="ADAL" clId="{F81D094D-588F-3F49-A3F9-58CC1A6CC615}" dt="2021-11-30T16:24:10.629" v="2152" actId="1076"/>
          <ac:picMkLst>
            <pc:docMk/>
            <pc:sldMk cId="454596918" sldId="276"/>
            <ac:picMk id="24" creationId="{2A63ABD2-6134-CC42-848C-BACA2F426C53}"/>
          </ac:picMkLst>
        </pc:picChg>
        <pc:picChg chg="add del mod modCrop">
          <ac:chgData name="Narang, Sonali" userId="9e80b397-6e2f-49b1-9374-ccdad8589140" providerId="ADAL" clId="{F81D094D-588F-3F49-A3F9-58CC1A6CC615}" dt="2021-11-30T16:25:59.559" v="2217" actId="1037"/>
          <ac:picMkLst>
            <pc:docMk/>
            <pc:sldMk cId="454596918" sldId="276"/>
            <ac:picMk id="26" creationId="{FEB31D7A-5450-F241-9EE0-68E75BEE9629}"/>
          </ac:picMkLst>
        </pc:picChg>
        <pc:picChg chg="add del mod modCrop">
          <ac:chgData name="Narang, Sonali" userId="9e80b397-6e2f-49b1-9374-ccdad8589140" providerId="ADAL" clId="{F81D094D-588F-3F49-A3F9-58CC1A6CC615}" dt="2021-11-30T16:26:02.119" v="2222" actId="1037"/>
          <ac:picMkLst>
            <pc:docMk/>
            <pc:sldMk cId="454596918" sldId="276"/>
            <ac:picMk id="28" creationId="{762CEA4D-15FF-A64B-8311-0EA4E88B0EA1}"/>
          </ac:picMkLst>
        </pc:picChg>
        <pc:picChg chg="add del mod modCrop">
          <ac:chgData name="Narang, Sonali" userId="9e80b397-6e2f-49b1-9374-ccdad8589140" providerId="ADAL" clId="{F81D094D-588F-3F49-A3F9-58CC1A6CC615}" dt="2021-11-30T16:26:07.313" v="2227" actId="1037"/>
          <ac:picMkLst>
            <pc:docMk/>
            <pc:sldMk cId="454596918" sldId="276"/>
            <ac:picMk id="30" creationId="{466A44AB-2888-8046-AB16-A9A24C91A569}"/>
          </ac:picMkLst>
        </pc:picChg>
        <pc:picChg chg="add del mod modCrop">
          <ac:chgData name="Narang, Sonali" userId="9e80b397-6e2f-49b1-9374-ccdad8589140" providerId="ADAL" clId="{F81D094D-588F-3F49-A3F9-58CC1A6CC615}" dt="2021-11-30T16:25:51.802" v="2212" actId="1035"/>
          <ac:picMkLst>
            <pc:docMk/>
            <pc:sldMk cId="454596918" sldId="276"/>
            <ac:picMk id="32" creationId="{8D2FF6CF-5CE3-A043-99BC-93276306EBA4}"/>
          </ac:picMkLst>
        </pc:picChg>
        <pc:picChg chg="mod">
          <ac:chgData name="Narang, Sonali" userId="9e80b397-6e2f-49b1-9374-ccdad8589140" providerId="ADAL" clId="{F81D094D-588F-3F49-A3F9-58CC1A6CC615}" dt="2021-11-30T16:24:24.845" v="2154"/>
          <ac:picMkLst>
            <pc:docMk/>
            <pc:sldMk cId="454596918" sldId="276"/>
            <ac:picMk id="41" creationId="{78CF2939-DFB6-D34C-B506-D3EDE21866CC}"/>
          </ac:picMkLst>
        </pc:picChg>
        <pc:picChg chg="mod">
          <ac:chgData name="Narang, Sonali" userId="9e80b397-6e2f-49b1-9374-ccdad8589140" providerId="ADAL" clId="{F81D094D-588F-3F49-A3F9-58CC1A6CC615}" dt="2021-11-30T16:24:24.845" v="2154"/>
          <ac:picMkLst>
            <pc:docMk/>
            <pc:sldMk cId="454596918" sldId="276"/>
            <ac:picMk id="45" creationId="{39C995D1-DCD6-B24B-8B1F-C51C07EF227C}"/>
          </ac:picMkLst>
        </pc:picChg>
        <pc:picChg chg="mod">
          <ac:chgData name="Narang, Sonali" userId="9e80b397-6e2f-49b1-9374-ccdad8589140" providerId="ADAL" clId="{F81D094D-588F-3F49-A3F9-58CC1A6CC615}" dt="2021-11-30T16:24:24.845" v="2154"/>
          <ac:picMkLst>
            <pc:docMk/>
            <pc:sldMk cId="454596918" sldId="276"/>
            <ac:picMk id="49" creationId="{169FA213-A7FA-5248-94BC-604809DDCFCC}"/>
          </ac:picMkLst>
        </pc:picChg>
        <pc:picChg chg="add del mod">
          <ac:chgData name="Narang, Sonali" userId="9e80b397-6e2f-49b1-9374-ccdad8589140" providerId="ADAL" clId="{F81D094D-588F-3F49-A3F9-58CC1A6CC615}" dt="2021-11-29T18:03:15.917" v="1554"/>
          <ac:picMkLst>
            <pc:docMk/>
            <pc:sldMk cId="454596918" sldId="276"/>
            <ac:picMk id="89" creationId="{383E7D9B-5648-9145-BEE2-1370B8668BE6}"/>
          </ac:picMkLst>
        </pc:picChg>
        <pc:picChg chg="add del mod">
          <ac:chgData name="Narang, Sonali" userId="9e80b397-6e2f-49b1-9374-ccdad8589140" providerId="ADAL" clId="{F81D094D-588F-3F49-A3F9-58CC1A6CC615}" dt="2021-11-29T18:03:15.917" v="1554"/>
          <ac:picMkLst>
            <pc:docMk/>
            <pc:sldMk cId="454596918" sldId="276"/>
            <ac:picMk id="90" creationId="{6572620A-BDD9-0247-8523-88E2E1E6245D}"/>
          </ac:picMkLst>
        </pc:picChg>
        <pc:picChg chg="add del mod">
          <ac:chgData name="Narang, Sonali" userId="9e80b397-6e2f-49b1-9374-ccdad8589140" providerId="ADAL" clId="{F81D094D-588F-3F49-A3F9-58CC1A6CC615}" dt="2021-11-29T18:03:15.917" v="1554"/>
          <ac:picMkLst>
            <pc:docMk/>
            <pc:sldMk cId="454596918" sldId="276"/>
            <ac:picMk id="91" creationId="{DC376A16-6D2A-1E4E-8AEB-00FC4E1BAA55}"/>
          </ac:picMkLst>
        </pc:picChg>
        <pc:picChg chg="add mod">
          <ac:chgData name="Narang, Sonali" userId="9e80b397-6e2f-49b1-9374-ccdad8589140" providerId="ADAL" clId="{F81D094D-588F-3F49-A3F9-58CC1A6CC615}" dt="2021-11-30T16:23:55.154" v="2149" actId="1076"/>
          <ac:picMkLst>
            <pc:docMk/>
            <pc:sldMk cId="454596918" sldId="276"/>
            <ac:picMk id="93" creationId="{190DF6F8-5B22-BB47-82E8-E00AE986BB24}"/>
          </ac:picMkLst>
        </pc:picChg>
        <pc:picChg chg="add mod">
          <ac:chgData name="Narang, Sonali" userId="9e80b397-6e2f-49b1-9374-ccdad8589140" providerId="ADAL" clId="{F81D094D-588F-3F49-A3F9-58CC1A6CC615}" dt="2021-11-30T16:23:55.154" v="2149" actId="1076"/>
          <ac:picMkLst>
            <pc:docMk/>
            <pc:sldMk cId="454596918" sldId="276"/>
            <ac:picMk id="94" creationId="{727A2963-749B-574F-AB37-AEEAE05E336F}"/>
          </ac:picMkLst>
        </pc:picChg>
        <pc:picChg chg="del mod">
          <ac:chgData name="Narang, Sonali" userId="9e80b397-6e2f-49b1-9374-ccdad8589140" providerId="ADAL" clId="{F81D094D-588F-3F49-A3F9-58CC1A6CC615}" dt="2021-11-29T21:29:02.230" v="1563" actId="478"/>
          <ac:picMkLst>
            <pc:docMk/>
            <pc:sldMk cId="454596918" sldId="276"/>
            <ac:picMk id="95" creationId="{FE3DA984-9E5D-B94A-9937-57A51C53C87F}"/>
          </ac:picMkLst>
        </pc:picChg>
        <pc:picChg chg="add mod">
          <ac:chgData name="Narang, Sonali" userId="9e80b397-6e2f-49b1-9374-ccdad8589140" providerId="ADAL" clId="{F81D094D-588F-3F49-A3F9-58CC1A6CC615}" dt="2021-11-30T16:23:55.154" v="2149" actId="1076"/>
          <ac:picMkLst>
            <pc:docMk/>
            <pc:sldMk cId="454596918" sldId="276"/>
            <ac:picMk id="96" creationId="{7BEB95D3-0AC4-6647-9BFB-1B7B37EDB0DC}"/>
          </ac:picMkLst>
        </pc:picChg>
      </pc:sldChg>
      <pc:sldChg chg="modSp mod">
        <pc:chgData name="Narang, Sonali" userId="9e80b397-6e2f-49b1-9374-ccdad8589140" providerId="ADAL" clId="{F81D094D-588F-3F49-A3F9-58CC1A6CC615}" dt="2021-11-29T17:53:56.268" v="1427" actId="20577"/>
        <pc:sldMkLst>
          <pc:docMk/>
          <pc:sldMk cId="2078269342" sldId="277"/>
        </pc:sldMkLst>
        <pc:spChg chg="mod">
          <ac:chgData name="Narang, Sonali" userId="9e80b397-6e2f-49b1-9374-ccdad8589140" providerId="ADAL" clId="{F81D094D-588F-3F49-A3F9-58CC1A6CC615}" dt="2021-11-29T17:53:51.044" v="1421" actId="20577"/>
          <ac:spMkLst>
            <pc:docMk/>
            <pc:sldMk cId="2078269342" sldId="277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3:52.910" v="1423" actId="20577"/>
          <ac:spMkLst>
            <pc:docMk/>
            <pc:sldMk cId="2078269342" sldId="277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29T17:53:54.595" v="1425" actId="20577"/>
          <ac:spMkLst>
            <pc:docMk/>
            <pc:sldMk cId="2078269342" sldId="277"/>
            <ac:spMk id="30" creationId="{655ACA25-EBE0-DD45-930F-AD76C4C0A2A8}"/>
          </ac:spMkLst>
        </pc:spChg>
        <pc:spChg chg="mod">
          <ac:chgData name="Narang, Sonali" userId="9e80b397-6e2f-49b1-9374-ccdad8589140" providerId="ADAL" clId="{F81D094D-588F-3F49-A3F9-58CC1A6CC615}" dt="2021-11-29T17:53:56.268" v="1427" actId="20577"/>
          <ac:spMkLst>
            <pc:docMk/>
            <pc:sldMk cId="2078269342" sldId="277"/>
            <ac:spMk id="65" creationId="{2EDEF6A0-F103-5349-A53F-A2BE3FD1BBD5}"/>
          </ac:spMkLst>
        </pc:spChg>
      </pc:sldChg>
      <pc:sldChg chg="modSp mod modNotesTx">
        <pc:chgData name="Narang, Sonali" userId="9e80b397-6e2f-49b1-9374-ccdad8589140" providerId="ADAL" clId="{F81D094D-588F-3F49-A3F9-58CC1A6CC615}" dt="2021-11-30T17:18:38.659" v="2432" actId="20577"/>
        <pc:sldMkLst>
          <pc:docMk/>
          <pc:sldMk cId="3296066017" sldId="279"/>
        </pc:sldMkLst>
        <pc:spChg chg="mod">
          <ac:chgData name="Narang, Sonali" userId="9e80b397-6e2f-49b1-9374-ccdad8589140" providerId="ADAL" clId="{F81D094D-588F-3F49-A3F9-58CC1A6CC615}" dt="2021-11-30T17:18:38.659" v="2432" actId="20577"/>
          <ac:spMkLst>
            <pc:docMk/>
            <pc:sldMk cId="3296066017" sldId="279"/>
            <ac:spMk id="4" creationId="{F6669B9D-B042-D548-BD0F-97015091799B}"/>
          </ac:spMkLst>
        </pc:spChg>
        <pc:spChg chg="mod">
          <ac:chgData name="Narang, Sonali" userId="9e80b397-6e2f-49b1-9374-ccdad8589140" providerId="ADAL" clId="{F81D094D-588F-3F49-A3F9-58CC1A6CC615}" dt="2021-11-29T17:53:30.481" v="1405" actId="20577"/>
          <ac:spMkLst>
            <pc:docMk/>
            <pc:sldMk cId="3296066017" sldId="279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29T17:53:33.401" v="1407" actId="20577"/>
          <ac:spMkLst>
            <pc:docMk/>
            <pc:sldMk cId="3296066017" sldId="279"/>
            <ac:spMk id="6" creationId="{41464C80-B659-484D-A16F-8018DEC5471A}"/>
          </ac:spMkLst>
        </pc:spChg>
        <pc:spChg chg="mod">
          <ac:chgData name="Narang, Sonali" userId="9e80b397-6e2f-49b1-9374-ccdad8589140" providerId="ADAL" clId="{F81D094D-588F-3F49-A3F9-58CC1A6CC615}" dt="2021-11-29T17:53:35.353" v="1409" actId="20577"/>
          <ac:spMkLst>
            <pc:docMk/>
            <pc:sldMk cId="3296066017" sldId="279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29T17:53:37.601" v="1411" actId="20577"/>
          <ac:spMkLst>
            <pc:docMk/>
            <pc:sldMk cId="3296066017" sldId="279"/>
            <ac:spMk id="8" creationId="{8A9BAE78-C4FF-1843-94F6-3410EB884848}"/>
          </ac:spMkLst>
        </pc:spChg>
      </pc:sldChg>
      <pc:sldChg chg="modSp mod">
        <pc:chgData name="Narang, Sonali" userId="9e80b397-6e2f-49b1-9374-ccdad8589140" providerId="ADAL" clId="{F81D094D-588F-3F49-A3F9-58CC1A6CC615}" dt="2021-11-29T17:54:30.567" v="1443" actId="20577"/>
        <pc:sldMkLst>
          <pc:docMk/>
          <pc:sldMk cId="3214590643" sldId="280"/>
        </pc:sldMkLst>
        <pc:spChg chg="mod">
          <ac:chgData name="Narang, Sonali" userId="9e80b397-6e2f-49b1-9374-ccdad8589140" providerId="ADAL" clId="{F81D094D-588F-3F49-A3F9-58CC1A6CC615}" dt="2021-11-29T17:54:30.567" v="1443" actId="20577"/>
          <ac:spMkLst>
            <pc:docMk/>
            <pc:sldMk cId="3214590643" sldId="280"/>
            <ac:spMk id="46" creationId="{BC4BD7F9-9550-3841-BBB5-1A58285A1D88}"/>
          </ac:spMkLst>
        </pc:spChg>
        <pc:grpChg chg="mod">
          <ac:chgData name="Narang, Sonali" userId="9e80b397-6e2f-49b1-9374-ccdad8589140" providerId="ADAL" clId="{F81D094D-588F-3F49-A3F9-58CC1A6CC615}" dt="2021-11-29T17:54:27.895" v="1441" actId="167"/>
          <ac:grpSpMkLst>
            <pc:docMk/>
            <pc:sldMk cId="3214590643" sldId="280"/>
            <ac:grpSpMk id="47" creationId="{4B802D37-9378-E54E-99B5-1E00E308EBB8}"/>
          </ac:grpSpMkLst>
        </pc:grpChg>
        <pc:picChg chg="mod">
          <ac:chgData name="Narang, Sonali" userId="9e80b397-6e2f-49b1-9374-ccdad8589140" providerId="ADAL" clId="{F81D094D-588F-3F49-A3F9-58CC1A6CC615}" dt="2021-11-29T17:54:20.872" v="1440" actId="167"/>
          <ac:picMkLst>
            <pc:docMk/>
            <pc:sldMk cId="3214590643" sldId="280"/>
            <ac:picMk id="50" creationId="{EC1A4915-BF55-6D40-8B7A-411B554E98BC}"/>
          </ac:picMkLst>
        </pc:picChg>
      </pc:sldChg>
      <pc:sldChg chg="add del mod modShow">
        <pc:chgData name="Narang, Sonali" userId="9e80b397-6e2f-49b1-9374-ccdad8589140" providerId="ADAL" clId="{F81D094D-588F-3F49-A3F9-58CC1A6CC615}" dt="2021-11-29T18:01:05.729" v="1532" actId="2696"/>
        <pc:sldMkLst>
          <pc:docMk/>
          <pc:sldMk cId="539443018" sldId="281"/>
        </pc:sldMkLst>
      </pc:sldChg>
      <pc:sldChg chg="addSp delSp modSp del mod modNotesTx">
        <pc:chgData name="Narang, Sonali" userId="9e80b397-6e2f-49b1-9374-ccdad8589140" providerId="ADAL" clId="{F81D094D-588F-3F49-A3F9-58CC1A6CC615}" dt="2021-11-30T17:18:22.542" v="2430" actId="2696"/>
        <pc:sldMkLst>
          <pc:docMk/>
          <pc:sldMk cId="2795549752" sldId="282"/>
        </pc:sldMkLst>
        <pc:spChg chg="del mod">
          <ac:chgData name="Narang, Sonali" userId="9e80b397-6e2f-49b1-9374-ccdad8589140" providerId="ADAL" clId="{F81D094D-588F-3F49-A3F9-58CC1A6CC615}" dt="2021-11-30T17:15:33.732" v="2364" actId="21"/>
          <ac:spMkLst>
            <pc:docMk/>
            <pc:sldMk cId="2795549752" sldId="282"/>
            <ac:spMk id="17" creationId="{E45D6726-42ED-614F-ABA3-4FFC2E3999BE}"/>
          </ac:spMkLst>
        </pc:spChg>
        <pc:spChg chg="mod">
          <ac:chgData name="Narang, Sonali" userId="9e80b397-6e2f-49b1-9374-ccdad8589140" providerId="ADAL" clId="{F81D094D-588F-3F49-A3F9-58CC1A6CC615}" dt="2021-11-29T17:53:12.598" v="1389" actId="20577"/>
          <ac:spMkLst>
            <pc:docMk/>
            <pc:sldMk cId="2795549752" sldId="282"/>
            <ac:spMk id="19" creationId="{424268A8-EAFB-1440-B224-100A4FAE616F}"/>
          </ac:spMkLst>
        </pc:spChg>
        <pc:spChg chg="add del">
          <ac:chgData name="Narang, Sonali" userId="9e80b397-6e2f-49b1-9374-ccdad8589140" providerId="ADAL" clId="{F81D094D-588F-3F49-A3F9-58CC1A6CC615}" dt="2021-11-29T18:03:17.117" v="1555" actId="21"/>
          <ac:spMkLst>
            <pc:docMk/>
            <pc:sldMk cId="2795549752" sldId="282"/>
            <ac:spMk id="26" creationId="{582E48A0-98F5-5147-B0F7-81FC68C3CE07}"/>
          </ac:spMkLst>
        </pc:spChg>
        <pc:spChg chg="del">
          <ac:chgData name="Narang, Sonali" userId="9e80b397-6e2f-49b1-9374-ccdad8589140" providerId="ADAL" clId="{F81D094D-588F-3F49-A3F9-58CC1A6CC615}" dt="2021-11-30T17:15:33.732" v="2364" actId="21"/>
          <ac:spMkLst>
            <pc:docMk/>
            <pc:sldMk cId="2795549752" sldId="282"/>
            <ac:spMk id="27" creationId="{F3520D55-6519-8141-AFD0-370D291E5F3A}"/>
          </ac:spMkLst>
        </pc:spChg>
        <pc:picChg chg="add del">
          <ac:chgData name="Narang, Sonali" userId="9e80b397-6e2f-49b1-9374-ccdad8589140" providerId="ADAL" clId="{F81D094D-588F-3F49-A3F9-58CC1A6CC615}" dt="2021-11-29T18:03:17.117" v="1555" actId="21"/>
          <ac:picMkLst>
            <pc:docMk/>
            <pc:sldMk cId="2795549752" sldId="282"/>
            <ac:picMk id="4" creationId="{5545EA01-02C8-C14F-B87F-AA3D42DFC498}"/>
          </ac:picMkLst>
        </pc:picChg>
        <pc:picChg chg="del">
          <ac:chgData name="Narang, Sonali" userId="9e80b397-6e2f-49b1-9374-ccdad8589140" providerId="ADAL" clId="{F81D094D-588F-3F49-A3F9-58CC1A6CC615}" dt="2021-11-30T17:15:33.732" v="2364" actId="21"/>
          <ac:picMkLst>
            <pc:docMk/>
            <pc:sldMk cId="2795549752" sldId="282"/>
            <ac:picMk id="6" creationId="{908EF18F-76FC-214C-8868-63513D6759E0}"/>
          </ac:picMkLst>
        </pc:picChg>
        <pc:picChg chg="add del">
          <ac:chgData name="Narang, Sonali" userId="9e80b397-6e2f-49b1-9374-ccdad8589140" providerId="ADAL" clId="{F81D094D-588F-3F49-A3F9-58CC1A6CC615}" dt="2021-11-29T18:03:17.117" v="1555" actId="21"/>
          <ac:picMkLst>
            <pc:docMk/>
            <pc:sldMk cId="2795549752" sldId="282"/>
            <ac:picMk id="8" creationId="{A54CB23C-0DE8-7846-AD80-B7F14481E3D7}"/>
          </ac:picMkLst>
        </pc:picChg>
        <pc:picChg chg="del">
          <ac:chgData name="Narang, Sonali" userId="9e80b397-6e2f-49b1-9374-ccdad8589140" providerId="ADAL" clId="{F81D094D-588F-3F49-A3F9-58CC1A6CC615}" dt="2021-11-30T17:15:33.732" v="2364" actId="21"/>
          <ac:picMkLst>
            <pc:docMk/>
            <pc:sldMk cId="2795549752" sldId="282"/>
            <ac:picMk id="10" creationId="{03662B50-9879-9043-BD79-ABBE911A9710}"/>
          </ac:picMkLst>
        </pc:picChg>
        <pc:picChg chg="add del">
          <ac:chgData name="Narang, Sonali" userId="9e80b397-6e2f-49b1-9374-ccdad8589140" providerId="ADAL" clId="{F81D094D-588F-3F49-A3F9-58CC1A6CC615}" dt="2021-11-29T18:03:17.117" v="1555" actId="21"/>
          <ac:picMkLst>
            <pc:docMk/>
            <pc:sldMk cId="2795549752" sldId="282"/>
            <ac:picMk id="12" creationId="{E5A1ECD6-2FDF-7946-9EA0-DC6200266DBA}"/>
          </ac:picMkLst>
        </pc:picChg>
        <pc:picChg chg="del">
          <ac:chgData name="Narang, Sonali" userId="9e80b397-6e2f-49b1-9374-ccdad8589140" providerId="ADAL" clId="{F81D094D-588F-3F49-A3F9-58CC1A6CC615}" dt="2021-11-30T17:15:33.732" v="2364" actId="21"/>
          <ac:picMkLst>
            <pc:docMk/>
            <pc:sldMk cId="2795549752" sldId="282"/>
            <ac:picMk id="36" creationId="{7AAF5A3C-4CC4-B644-9E7A-899F148CD272}"/>
          </ac:picMkLst>
        </pc:picChg>
      </pc:sldChg>
      <pc:sldChg chg="addSp delSp modSp mod modNotesTx">
        <pc:chgData name="Narang, Sonali" userId="9e80b397-6e2f-49b1-9374-ccdad8589140" providerId="ADAL" clId="{F81D094D-588F-3F49-A3F9-58CC1A6CC615}" dt="2021-11-30T19:20:52" v="2850" actId="478"/>
        <pc:sldMkLst>
          <pc:docMk/>
          <pc:sldMk cId="3858847110" sldId="283"/>
        </pc:sldMkLst>
        <pc:spChg chg="mod">
          <ac:chgData name="Narang, Sonali" userId="9e80b397-6e2f-49b1-9374-ccdad8589140" providerId="ADAL" clId="{F81D094D-588F-3F49-A3F9-58CC1A6CC615}" dt="2021-11-30T19:16:16.925" v="2765" actId="12788"/>
          <ac:spMkLst>
            <pc:docMk/>
            <pc:sldMk cId="3858847110" sldId="283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30T19:16:25.784" v="2766" actId="12788"/>
          <ac:spMkLst>
            <pc:docMk/>
            <pc:sldMk cId="3858847110" sldId="283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30T19:16:16.925" v="2765" actId="12788"/>
          <ac:spMkLst>
            <pc:docMk/>
            <pc:sldMk cId="3858847110" sldId="283"/>
            <ac:spMk id="8" creationId="{8A9BAE78-C4FF-1843-94F6-3410EB884848}"/>
          </ac:spMkLst>
        </pc:spChg>
        <pc:spChg chg="add del mod">
          <ac:chgData name="Narang, Sonali" userId="9e80b397-6e2f-49b1-9374-ccdad8589140" providerId="ADAL" clId="{F81D094D-588F-3F49-A3F9-58CC1A6CC615}" dt="2021-11-30T19:20:52" v="2850" actId="478"/>
          <ac:spMkLst>
            <pc:docMk/>
            <pc:sldMk cId="3858847110" sldId="283"/>
            <ac:spMk id="17" creationId="{3EA8DCC5-919A-2147-8AF5-DF44E483E631}"/>
          </ac:spMkLst>
        </pc:spChg>
        <pc:spChg chg="mod">
          <ac:chgData name="Narang, Sonali" userId="9e80b397-6e2f-49b1-9374-ccdad8589140" providerId="ADAL" clId="{F81D094D-588F-3F49-A3F9-58CC1A6CC615}" dt="2021-11-30T19:16:25.784" v="2766" actId="12788"/>
          <ac:spMkLst>
            <pc:docMk/>
            <pc:sldMk cId="3858847110" sldId="283"/>
            <ac:spMk id="32" creationId="{2863401C-2050-2E40-AE5C-C6CDD3A8A7D4}"/>
          </ac:spMkLst>
        </pc:spChg>
        <pc:spChg chg="mod">
          <ac:chgData name="Narang, Sonali" userId="9e80b397-6e2f-49b1-9374-ccdad8589140" providerId="ADAL" clId="{F81D094D-588F-3F49-A3F9-58CC1A6CC615}" dt="2021-11-30T19:18:09.433" v="2821" actId="255"/>
          <ac:spMkLst>
            <pc:docMk/>
            <pc:sldMk cId="3858847110" sldId="283"/>
            <ac:spMk id="34" creationId="{6D8F17D5-0D48-D240-A514-46DF3B792DB3}"/>
          </ac:spMkLst>
        </pc:spChg>
        <pc:spChg chg="mod">
          <ac:chgData name="Narang, Sonali" userId="9e80b397-6e2f-49b1-9374-ccdad8589140" providerId="ADAL" clId="{F81D094D-588F-3F49-A3F9-58CC1A6CC615}" dt="2021-11-30T19:18:09.433" v="2821" actId="255"/>
          <ac:spMkLst>
            <pc:docMk/>
            <pc:sldMk cId="3858847110" sldId="283"/>
            <ac:spMk id="35" creationId="{8E47D5FA-094C-AB4F-997F-C3C0BB4C2B2E}"/>
          </ac:spMkLst>
        </pc:spChg>
        <pc:spChg chg="mod">
          <ac:chgData name="Narang, Sonali" userId="9e80b397-6e2f-49b1-9374-ccdad8589140" providerId="ADAL" clId="{F81D094D-588F-3F49-A3F9-58CC1A6CC615}" dt="2021-11-30T19:17:55.375" v="2820" actId="1035"/>
          <ac:spMkLst>
            <pc:docMk/>
            <pc:sldMk cId="3858847110" sldId="283"/>
            <ac:spMk id="36" creationId="{75B14C61-810F-134B-AC0D-0C1FD0CAB17A}"/>
          </ac:spMkLst>
        </pc:spChg>
        <pc:spChg chg="mod">
          <ac:chgData name="Narang, Sonali" userId="9e80b397-6e2f-49b1-9374-ccdad8589140" providerId="ADAL" clId="{F81D094D-588F-3F49-A3F9-58CC1A6CC615}" dt="2021-11-30T19:17:55.375" v="2820" actId="1035"/>
          <ac:spMkLst>
            <pc:docMk/>
            <pc:sldMk cId="3858847110" sldId="283"/>
            <ac:spMk id="59" creationId="{1C85DEE8-F315-5047-B7B7-8827D96395BE}"/>
          </ac:spMkLst>
        </pc:spChg>
        <pc:spChg chg="mod">
          <ac:chgData name="Narang, Sonali" userId="9e80b397-6e2f-49b1-9374-ccdad8589140" providerId="ADAL" clId="{F81D094D-588F-3F49-A3F9-58CC1A6CC615}" dt="2021-11-30T19:18:31.281" v="2830" actId="1037"/>
          <ac:spMkLst>
            <pc:docMk/>
            <pc:sldMk cId="3858847110" sldId="283"/>
            <ac:spMk id="88" creationId="{DF3993D3-72E7-E54E-97D3-9D84F59F5654}"/>
          </ac:spMkLst>
        </pc:spChg>
        <pc:spChg chg="mod">
          <ac:chgData name="Narang, Sonali" userId="9e80b397-6e2f-49b1-9374-ccdad8589140" providerId="ADAL" clId="{F81D094D-588F-3F49-A3F9-58CC1A6CC615}" dt="2021-11-30T19:18:09.433" v="2821" actId="255"/>
          <ac:spMkLst>
            <pc:docMk/>
            <pc:sldMk cId="3858847110" sldId="283"/>
            <ac:spMk id="89" creationId="{9795E54A-2B4A-9D4B-8972-CBAED713A584}"/>
          </ac:spMkLst>
        </pc:spChg>
        <pc:spChg chg="mod">
          <ac:chgData name="Narang, Sonali" userId="9e80b397-6e2f-49b1-9374-ccdad8589140" providerId="ADAL" clId="{F81D094D-588F-3F49-A3F9-58CC1A6CC615}" dt="2021-11-30T19:18:37.434" v="2833" actId="1035"/>
          <ac:spMkLst>
            <pc:docMk/>
            <pc:sldMk cId="3858847110" sldId="283"/>
            <ac:spMk id="90" creationId="{D21843D8-B24B-7440-962B-0D5326402052}"/>
          </ac:spMkLst>
        </pc:spChg>
        <pc:spChg chg="mod">
          <ac:chgData name="Narang, Sonali" userId="9e80b397-6e2f-49b1-9374-ccdad8589140" providerId="ADAL" clId="{F81D094D-588F-3F49-A3F9-58CC1A6CC615}" dt="2021-11-30T19:18:09.433" v="2821" actId="255"/>
          <ac:spMkLst>
            <pc:docMk/>
            <pc:sldMk cId="3858847110" sldId="283"/>
            <ac:spMk id="93" creationId="{64285D9B-FC68-FC4E-A8AE-A691F45F91D3}"/>
          </ac:spMkLst>
        </pc:spChg>
        <pc:spChg chg="mod">
          <ac:chgData name="Narang, Sonali" userId="9e80b397-6e2f-49b1-9374-ccdad8589140" providerId="ADAL" clId="{F81D094D-588F-3F49-A3F9-58CC1A6CC615}" dt="2021-11-30T19:18:28.922" v="2828" actId="1038"/>
          <ac:spMkLst>
            <pc:docMk/>
            <pc:sldMk cId="3858847110" sldId="283"/>
            <ac:spMk id="94" creationId="{779ED364-B947-4649-AC6C-67DBDCE196B9}"/>
          </ac:spMkLst>
        </pc:spChg>
        <pc:spChg chg="mod">
          <ac:chgData name="Narang, Sonali" userId="9e80b397-6e2f-49b1-9374-ccdad8589140" providerId="ADAL" clId="{F81D094D-588F-3F49-A3F9-58CC1A6CC615}" dt="2021-11-30T19:18:37.434" v="2833" actId="1035"/>
          <ac:spMkLst>
            <pc:docMk/>
            <pc:sldMk cId="3858847110" sldId="283"/>
            <ac:spMk id="95" creationId="{6DD283A0-4643-074E-A722-EACAC130A59D}"/>
          </ac:spMkLst>
        </pc:spChg>
        <pc:spChg chg="mod">
          <ac:chgData name="Narang, Sonali" userId="9e80b397-6e2f-49b1-9374-ccdad8589140" providerId="ADAL" clId="{F81D094D-588F-3F49-A3F9-58CC1A6CC615}" dt="2021-11-30T18:43:57.130" v="2559" actId="1037"/>
          <ac:spMkLst>
            <pc:docMk/>
            <pc:sldMk cId="3858847110" sldId="283"/>
            <ac:spMk id="124" creationId="{B23F7538-E8A8-CC40-A117-196EA9C2ACE1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32" creationId="{F0403695-AD5B-9047-8D05-54346F3F120D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36" creationId="{9A9CF7D7-0D48-D043-BB37-5753524DD92B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37" creationId="{FC560F8A-A1EE-C647-AA5D-17B7F2C0F448}"/>
          </ac:spMkLst>
        </pc:spChg>
        <pc:spChg chg="mod">
          <ac:chgData name="Narang, Sonali" userId="9e80b397-6e2f-49b1-9374-ccdad8589140" providerId="ADAL" clId="{F81D094D-588F-3F49-A3F9-58CC1A6CC615}" dt="2021-11-30T18:43:57.130" v="2559" actId="1037"/>
          <ac:spMkLst>
            <pc:docMk/>
            <pc:sldMk cId="3858847110" sldId="283"/>
            <ac:spMk id="139" creationId="{FE0FD528-1245-F14D-AB89-4DFD4EF28ADA}"/>
          </ac:spMkLst>
        </pc:spChg>
        <pc:spChg chg="mod">
          <ac:chgData name="Narang, Sonali" userId="9e80b397-6e2f-49b1-9374-ccdad8589140" providerId="ADAL" clId="{F81D094D-588F-3F49-A3F9-58CC1A6CC615}" dt="2021-11-30T18:43:57.130" v="2559" actId="1037"/>
          <ac:spMkLst>
            <pc:docMk/>
            <pc:sldMk cId="3858847110" sldId="283"/>
            <ac:spMk id="140" creationId="{7E0A8E22-7013-7A4F-8D7D-18E045FC74A0}"/>
          </ac:spMkLst>
        </pc:spChg>
        <pc:spChg chg="mod">
          <ac:chgData name="Narang, Sonali" userId="9e80b397-6e2f-49b1-9374-ccdad8589140" providerId="ADAL" clId="{F81D094D-588F-3F49-A3F9-58CC1A6CC615}" dt="2021-11-30T18:43:57.130" v="2559" actId="1037"/>
          <ac:spMkLst>
            <pc:docMk/>
            <pc:sldMk cId="3858847110" sldId="283"/>
            <ac:spMk id="141" creationId="{F00BFF25-4547-7142-A56A-EC7337477F73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44" creationId="{5FCB19E8-7E4E-9642-AB00-A99D96D59684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45" creationId="{8F29B37B-156F-694D-A339-8025AE60D4B8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49" creationId="{470B4D70-8F9B-A145-8C6F-56AA5F38EA82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50" creationId="{96090C8E-D773-6A41-99CA-0DBDB8915E72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51" creationId="{96351EF7-130F-5745-8550-0E125D4A2660}"/>
          </ac:spMkLst>
        </pc:spChg>
        <pc:spChg chg="add mod">
          <ac:chgData name="Narang, Sonali" userId="9e80b397-6e2f-49b1-9374-ccdad8589140" providerId="ADAL" clId="{F81D094D-588F-3F49-A3F9-58CC1A6CC615}" dt="2021-11-29T17:56:37.134" v="1525"/>
          <ac:spMkLst>
            <pc:docMk/>
            <pc:sldMk cId="3858847110" sldId="283"/>
            <ac:spMk id="152" creationId="{61B75775-F749-AD41-85AE-319A491F6A2B}"/>
          </ac:spMkLst>
        </pc:spChg>
        <pc:spChg chg="add mod">
          <ac:chgData name="Narang, Sonali" userId="9e80b397-6e2f-49b1-9374-ccdad8589140" providerId="ADAL" clId="{F81D094D-588F-3F49-A3F9-58CC1A6CC615}" dt="2021-11-29T17:56:37.134" v="1525"/>
          <ac:spMkLst>
            <pc:docMk/>
            <pc:sldMk cId="3858847110" sldId="283"/>
            <ac:spMk id="153" creationId="{AECCD5D5-346B-0D48-9842-C19626A90332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56" creationId="{6144D5A7-177A-2249-859E-3D7B885FC027}"/>
          </ac:spMkLst>
        </pc:spChg>
        <pc:spChg chg="add mod">
          <ac:chgData name="Narang, Sonali" userId="9e80b397-6e2f-49b1-9374-ccdad8589140" providerId="ADAL" clId="{F81D094D-588F-3F49-A3F9-58CC1A6CC615}" dt="2021-11-30T19:17:55.375" v="2820" actId="1035"/>
          <ac:spMkLst>
            <pc:docMk/>
            <pc:sldMk cId="3858847110" sldId="283"/>
            <ac:spMk id="164" creationId="{918834F8-0A4A-A042-87EE-07AD02FCDDD9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66" creationId="{191813A5-20BE-C344-95C8-FA01F56C9914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67" creationId="{2A901228-C2CB-674F-A8E6-CA5D0B4A47D9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68" creationId="{4E47A89F-0DE6-1242-BAFC-8D1AE01C361F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69" creationId="{5486342B-C30C-F546-B62F-8DA753AD748C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0" creationId="{616C7D43-7EB6-C44C-A9DD-21BA83A70CCB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1" creationId="{36F8D3FC-32FB-1A4C-A9B6-A856B1866E91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2" creationId="{3F37522B-FC9F-3A4F-83AB-A143AE7607F5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3" creationId="{FD66ED2E-18FC-2841-AC37-AB88755817CF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4" creationId="{B77BE25F-E898-1044-9363-72612FA91FFA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5" creationId="{C0D3769C-94E8-4148-9CB4-C5D295EE7E12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6" creationId="{34AA1C5A-7C3E-394D-8AE4-CFE58FC6C99F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7" creationId="{9F540659-5FAD-4E4A-B32C-97CDADF346B6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79" creationId="{BC95457B-7010-3146-8AE4-C7E5D5F50B1A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0" creationId="{CCE1272A-9C36-A346-88A6-D717B5D2A9F8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1" creationId="{B3A331DA-04FF-2242-A5F1-900558D382D9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2" creationId="{6E1FC018-637A-DD45-B7BA-0989FA78FBC6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3" creationId="{D95A63C1-EFC0-8047-B140-344843A82E7B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4" creationId="{CBBEB65C-0B2E-4B4C-B4AB-A9302D4BE246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8" creationId="{DEED389C-ED74-C047-BB06-A1A7254A6EAD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89" creationId="{193882B9-A2A5-0740-B0C3-4E860AE6CF87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90" creationId="{AA597927-0156-7940-AA7B-9E532BBC24AB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191" creationId="{5BD8C462-331F-3848-A13F-17FA4BD62FD7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37" creationId="{326BD118-D012-0E49-9FD4-24726A366775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38" creationId="{138CC95D-4E71-CB43-97B6-C57B77A27223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39" creationId="{1937FA0E-6652-7F4F-B6B6-4E1D63304F90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0" creationId="{C1772F08-6BE6-7742-B4F7-BBE8D9553B02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1" creationId="{B43FE6F3-535C-BF41-BA1C-6DA8E15173F0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2" creationId="{7A1997C9-EE3B-6641-A7FF-A44629BC2173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3" creationId="{0745A6CC-1E16-4D44-A892-759D74AD2D27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4" creationId="{BBCA8CB8-C781-3C4F-B02E-9E40B89C94D0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5" creationId="{8CA6C6C0-C678-484E-88FF-04E9986B8FAA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6" creationId="{1D4AFF91-5114-2541-945C-9C8B343D3E7E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7" creationId="{BC9E7717-DDE5-D442-9A31-A865DA9F44BE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8" creationId="{B3EF87E3-5756-2444-A2EB-3BD31BE1BC99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49" creationId="{1AE193AC-B053-1746-8002-4FB3BB4DB3E1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50" creationId="{320F4740-B1A7-634D-A280-6747D29B6401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51" creationId="{4A99B960-2241-8B44-89DB-5E638C0DD45C}"/>
          </ac:spMkLst>
        </pc:spChg>
        <pc:spChg chg="mod">
          <ac:chgData name="Narang, Sonali" userId="9e80b397-6e2f-49b1-9374-ccdad8589140" providerId="ADAL" clId="{F81D094D-588F-3F49-A3F9-58CC1A6CC615}" dt="2021-11-30T18:43:15.910" v="2501" actId="465"/>
          <ac:spMkLst>
            <pc:docMk/>
            <pc:sldMk cId="3858847110" sldId="283"/>
            <ac:spMk id="252" creationId="{05C49839-5E70-9246-8371-A0E772CDB077}"/>
          </ac:spMkLst>
        </pc:spChg>
        <pc:spChg chg="mod">
          <ac:chgData name="Narang, Sonali" userId="9e80b397-6e2f-49b1-9374-ccdad8589140" providerId="ADAL" clId="{F81D094D-588F-3F49-A3F9-58CC1A6CC615}" dt="2021-11-30T19:17:55.375" v="2820" actId="1035"/>
          <ac:spMkLst>
            <pc:docMk/>
            <pc:sldMk cId="3858847110" sldId="283"/>
            <ac:spMk id="254" creationId="{90B8E414-E61D-C54E-870F-4AA87CD05251}"/>
          </ac:spMkLst>
        </pc:spChg>
        <pc:spChg chg="mod">
          <ac:chgData name="Narang, Sonali" userId="9e80b397-6e2f-49b1-9374-ccdad8589140" providerId="ADAL" clId="{F81D094D-588F-3F49-A3F9-58CC1A6CC615}" dt="2021-11-30T19:14:48.367" v="2750" actId="12789"/>
          <ac:spMkLst>
            <pc:docMk/>
            <pc:sldMk cId="3858847110" sldId="283"/>
            <ac:spMk id="258" creationId="{5DDF1B8D-8C73-DA43-A850-4409A0D356A4}"/>
          </ac:spMkLst>
        </pc:spChg>
        <pc:spChg chg="mod">
          <ac:chgData name="Narang, Sonali" userId="9e80b397-6e2f-49b1-9374-ccdad8589140" providerId="ADAL" clId="{F81D094D-588F-3F49-A3F9-58CC1A6CC615}" dt="2021-11-30T19:16:33.651" v="2769" actId="1035"/>
          <ac:spMkLst>
            <pc:docMk/>
            <pc:sldMk cId="3858847110" sldId="283"/>
            <ac:spMk id="259" creationId="{B6297CA1-726C-9C44-8F9B-04A44BC1D29F}"/>
          </ac:spMkLst>
        </pc:spChg>
        <pc:spChg chg="mod">
          <ac:chgData name="Narang, Sonali" userId="9e80b397-6e2f-49b1-9374-ccdad8589140" providerId="ADAL" clId="{F81D094D-588F-3F49-A3F9-58CC1A6CC615}" dt="2021-11-30T19:14:48.367" v="2750" actId="12789"/>
          <ac:spMkLst>
            <pc:docMk/>
            <pc:sldMk cId="3858847110" sldId="283"/>
            <ac:spMk id="312" creationId="{ABB99236-9992-4743-8EBE-B4E070E31B71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2" creationId="{379A5418-0E89-D844-B7FF-C6B4B29344FD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3" creationId="{5A42789A-FAFE-E146-94FD-4A73FB5F6F05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4" creationId="{AB76E6A2-9C4C-5148-9DBB-0D59EE70DD3E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5" creationId="{D9375BB2-126F-9449-949B-3B28757B31BC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6" creationId="{AB71242E-B111-534E-91D1-C3D3BDA97407}"/>
          </ac:spMkLst>
        </pc:spChg>
        <pc:spChg chg="mod">
          <ac:chgData name="Narang, Sonali" userId="9e80b397-6e2f-49b1-9374-ccdad8589140" providerId="ADAL" clId="{F81D094D-588F-3F49-A3F9-58CC1A6CC615}" dt="2021-11-30T19:20:48.286" v="2848" actId="255"/>
          <ac:spMkLst>
            <pc:docMk/>
            <pc:sldMk cId="3858847110" sldId="283"/>
            <ac:spMk id="357" creationId="{867BDA95-4AAB-584E-80E8-1C4B3090CB4D}"/>
          </ac:spMkLst>
        </pc:spChg>
        <pc:spChg chg="mod">
          <ac:chgData name="Narang, Sonali" userId="9e80b397-6e2f-49b1-9374-ccdad8589140" providerId="ADAL" clId="{F81D094D-588F-3F49-A3F9-58CC1A6CC615}" dt="2021-11-30T19:16:33.651" v="2769" actId="1035"/>
          <ac:spMkLst>
            <pc:docMk/>
            <pc:sldMk cId="3858847110" sldId="283"/>
            <ac:spMk id="364" creationId="{46AF8751-42C1-C242-A60E-5FECA6CB32E9}"/>
          </ac:spMkLst>
        </pc:spChg>
        <pc:grpChg chg="mod">
          <ac:chgData name="Narang, Sonali" userId="9e80b397-6e2f-49b1-9374-ccdad8589140" providerId="ADAL" clId="{F81D094D-588F-3F49-A3F9-58CC1A6CC615}" dt="2021-11-30T18:57:46.639" v="2678" actId="1076"/>
          <ac:grpSpMkLst>
            <pc:docMk/>
            <pc:sldMk cId="3858847110" sldId="283"/>
            <ac:grpSpMk id="16" creationId="{58DB6EAF-55BB-A84E-BB46-C61DAC1C6351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22" creationId="{239EC649-4054-9B49-9002-BC392B726FB3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23" creationId="{7C13DB68-C53B-EC42-812E-C4159D83C6AB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33" creationId="{497978F6-6248-0448-BDB6-E930C0A72DC5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34" creationId="{6ADD9F58-CF53-6949-9EF6-BD4229FB636E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46" creationId="{B901738C-025B-3743-85CC-6F9FA17C0389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47" creationId="{A59F7185-D039-AA4D-9E54-8587A4AB6665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48" creationId="{286E0120-519E-C641-B03F-ABF9A696ADD0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85" creationId="{336C0266-122B-3F45-AA85-12F09DDD0A00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86" creationId="{E3610C00-C173-6143-9E74-979DF156322F}"/>
          </ac:grpSpMkLst>
        </pc:grpChg>
        <pc:grpChg chg="mod">
          <ac:chgData name="Narang, Sonali" userId="9e80b397-6e2f-49b1-9374-ccdad8589140" providerId="ADAL" clId="{F81D094D-588F-3F49-A3F9-58CC1A6CC615}" dt="2021-11-30T18:43:15.910" v="2501" actId="465"/>
          <ac:grpSpMkLst>
            <pc:docMk/>
            <pc:sldMk cId="3858847110" sldId="283"/>
            <ac:grpSpMk id="187" creationId="{92ACC8F8-83AD-C846-A9E0-D13727C22868}"/>
          </ac:grpSpMkLst>
        </pc:grpChg>
        <pc:picChg chg="add del mod modCrop">
          <ac:chgData name="Narang, Sonali" userId="9e80b397-6e2f-49b1-9374-ccdad8589140" providerId="ADAL" clId="{F81D094D-588F-3F49-A3F9-58CC1A6CC615}" dt="2021-11-30T19:02:23.517" v="2696" actId="478"/>
          <ac:picMkLst>
            <pc:docMk/>
            <pc:sldMk cId="3858847110" sldId="283"/>
            <ac:picMk id="3" creationId="{080954CC-F88D-5442-8F72-6590A3C2E0CA}"/>
          </ac:picMkLst>
        </pc:picChg>
        <pc:picChg chg="del">
          <ac:chgData name="Narang, Sonali" userId="9e80b397-6e2f-49b1-9374-ccdad8589140" providerId="ADAL" clId="{F81D094D-588F-3F49-A3F9-58CC1A6CC615}" dt="2021-11-30T19:00:47.155" v="2680" actId="478"/>
          <ac:picMkLst>
            <pc:docMk/>
            <pc:sldMk cId="3858847110" sldId="283"/>
            <ac:picMk id="9" creationId="{E181CE47-AFDF-9D42-9092-D68576E07B87}"/>
          </ac:picMkLst>
        </pc:picChg>
        <pc:picChg chg="add del mod">
          <ac:chgData name="Narang, Sonali" userId="9e80b397-6e2f-49b1-9374-ccdad8589140" providerId="ADAL" clId="{F81D094D-588F-3F49-A3F9-58CC1A6CC615}" dt="2021-11-30T19:03:29.340" v="2701" actId="478"/>
          <ac:picMkLst>
            <pc:docMk/>
            <pc:sldMk cId="3858847110" sldId="283"/>
            <ac:picMk id="11" creationId="{AE6F7A59-D8C2-B04B-AC24-B040289E1601}"/>
          </ac:picMkLst>
        </pc:picChg>
        <pc:picChg chg="mod">
          <ac:chgData name="Narang, Sonali" userId="9e80b397-6e2f-49b1-9374-ccdad8589140" providerId="ADAL" clId="{F81D094D-588F-3F49-A3F9-58CC1A6CC615}" dt="2021-11-30T19:17:02.906" v="2774" actId="1036"/>
          <ac:picMkLst>
            <pc:docMk/>
            <pc:sldMk cId="3858847110" sldId="283"/>
            <ac:picMk id="12" creationId="{28C8A256-08EE-4349-B43E-6F7FEDDEA277}"/>
          </ac:picMkLst>
        </pc:picChg>
        <pc:picChg chg="del mod">
          <ac:chgData name="Narang, Sonali" userId="9e80b397-6e2f-49b1-9374-ccdad8589140" providerId="ADAL" clId="{F81D094D-588F-3F49-A3F9-58CC1A6CC615}" dt="2021-11-30T19:13:57.536" v="2739" actId="478"/>
          <ac:picMkLst>
            <pc:docMk/>
            <pc:sldMk cId="3858847110" sldId="283"/>
            <ac:picMk id="15" creationId="{0E21C0CF-B23A-2F45-AD3C-0305B7C37521}"/>
          </ac:picMkLst>
        </pc:picChg>
        <pc:picChg chg="add mod modCrop">
          <ac:chgData name="Narang, Sonali" userId="9e80b397-6e2f-49b1-9374-ccdad8589140" providerId="ADAL" clId="{F81D094D-588F-3F49-A3F9-58CC1A6CC615}" dt="2021-11-30T19:06:57.273" v="2730" actId="1076"/>
          <ac:picMkLst>
            <pc:docMk/>
            <pc:sldMk cId="3858847110" sldId="283"/>
            <ac:picMk id="18" creationId="{09C1F4B6-DF38-0240-88BE-9B045665BC9C}"/>
          </ac:picMkLst>
        </pc:picChg>
        <pc:picChg chg="add mod">
          <ac:chgData name="Narang, Sonali" userId="9e80b397-6e2f-49b1-9374-ccdad8589140" providerId="ADAL" clId="{F81D094D-588F-3F49-A3F9-58CC1A6CC615}" dt="2021-11-30T19:14:13.757" v="2745" actId="1076"/>
          <ac:picMkLst>
            <pc:docMk/>
            <pc:sldMk cId="3858847110" sldId="283"/>
            <ac:picMk id="20" creationId="{D8253DBD-35EE-2A4F-8760-1B2CE716E409}"/>
          </ac:picMkLst>
        </pc:picChg>
        <pc:picChg chg="mod">
          <ac:chgData name="Narang, Sonali" userId="9e80b397-6e2f-49b1-9374-ccdad8589140" providerId="ADAL" clId="{F81D094D-588F-3F49-A3F9-58CC1A6CC615}" dt="2021-11-30T19:08:02.822" v="2737" actId="1582"/>
          <ac:picMkLst>
            <pc:docMk/>
            <pc:sldMk cId="3858847110" sldId="283"/>
            <ac:picMk id="44" creationId="{45F9C4F8-7759-4642-9E93-C322F93DD2DA}"/>
          </ac:picMkLst>
        </pc:picChg>
        <pc:picChg chg="mod">
          <ac:chgData name="Narang, Sonali" userId="9e80b397-6e2f-49b1-9374-ccdad8589140" providerId="ADAL" clId="{F81D094D-588F-3F49-A3F9-58CC1A6CC615}" dt="2021-11-30T19:08:11.230" v="2738" actId="1582"/>
          <ac:picMkLst>
            <pc:docMk/>
            <pc:sldMk cId="3858847110" sldId="283"/>
            <ac:picMk id="45" creationId="{583C3CDA-E65C-DA47-BFAF-ADC04F7DE9AF}"/>
          </ac:picMkLst>
        </pc:picChg>
        <pc:picChg chg="mod">
          <ac:chgData name="Narang, Sonali" userId="9e80b397-6e2f-49b1-9374-ccdad8589140" providerId="ADAL" clId="{F81D094D-588F-3F49-A3F9-58CC1A6CC615}" dt="2021-11-30T18:43:57.130" v="2559" actId="1037"/>
          <ac:picMkLst>
            <pc:docMk/>
            <pc:sldMk cId="3858847110" sldId="283"/>
            <ac:picMk id="129" creationId="{B0F792E7-B882-3E44-A0DE-5A8104EE8479}"/>
          </ac:picMkLst>
        </pc:picChg>
        <pc:picChg chg="mod">
          <ac:chgData name="Narang, Sonali" userId="9e80b397-6e2f-49b1-9374-ccdad8589140" providerId="ADAL" clId="{F81D094D-588F-3F49-A3F9-58CC1A6CC615}" dt="2021-11-30T18:43:57.130" v="2559" actId="1037"/>
          <ac:picMkLst>
            <pc:docMk/>
            <pc:sldMk cId="3858847110" sldId="283"/>
            <ac:picMk id="138" creationId="{0A4C2E55-3F88-1A47-B4F1-1D1EF8D53A08}"/>
          </ac:picMkLst>
        </pc:picChg>
        <pc:picChg chg="mod">
          <ac:chgData name="Narang, Sonali" userId="9e80b397-6e2f-49b1-9374-ccdad8589140" providerId="ADAL" clId="{F81D094D-588F-3F49-A3F9-58CC1A6CC615}" dt="2021-11-30T18:43:57.130" v="2559" actId="1037"/>
          <ac:picMkLst>
            <pc:docMk/>
            <pc:sldMk cId="3858847110" sldId="283"/>
            <ac:picMk id="142" creationId="{84ED2F54-6C51-1B4F-B4DE-9B25C5508A73}"/>
          </ac:picMkLst>
        </pc:picChg>
        <pc:picChg chg="mod">
          <ac:chgData name="Narang, Sonali" userId="9e80b397-6e2f-49b1-9374-ccdad8589140" providerId="ADAL" clId="{F81D094D-588F-3F49-A3F9-58CC1A6CC615}" dt="2021-11-30T18:43:57.130" v="2559" actId="1037"/>
          <ac:picMkLst>
            <pc:docMk/>
            <pc:sldMk cId="3858847110" sldId="283"/>
            <ac:picMk id="143" creationId="{A47EF50E-E2E9-4849-AB8E-424B95974F50}"/>
          </ac:picMkLst>
        </pc:picChg>
        <pc:picChg chg="add del mod modCrop">
          <ac:chgData name="Narang, Sonali" userId="9e80b397-6e2f-49b1-9374-ccdad8589140" providerId="ADAL" clId="{F81D094D-588F-3F49-A3F9-58CC1A6CC615}" dt="2021-11-30T19:02:23.517" v="2696" actId="478"/>
          <ac:picMkLst>
            <pc:docMk/>
            <pc:sldMk cId="3858847110" sldId="283"/>
            <ac:picMk id="155" creationId="{AD3C7869-3030-AF48-85E0-EA9A27B6D39C}"/>
          </ac:picMkLst>
        </pc:picChg>
        <pc:picChg chg="add mod modCrop">
          <ac:chgData name="Narang, Sonali" userId="9e80b397-6e2f-49b1-9374-ccdad8589140" providerId="ADAL" clId="{F81D094D-588F-3F49-A3F9-58CC1A6CC615}" dt="2021-11-30T19:06:57.273" v="2730" actId="1076"/>
          <ac:picMkLst>
            <pc:docMk/>
            <pc:sldMk cId="3858847110" sldId="283"/>
            <ac:picMk id="160" creationId="{1CB61788-6CB9-4C43-900F-B69B56278756}"/>
          </ac:picMkLst>
        </pc:picChg>
        <pc:picChg chg="add mod modCrop">
          <ac:chgData name="Narang, Sonali" userId="9e80b397-6e2f-49b1-9374-ccdad8589140" providerId="ADAL" clId="{F81D094D-588F-3F49-A3F9-58CC1A6CC615}" dt="2021-11-30T19:07:27.255" v="2736" actId="732"/>
          <ac:picMkLst>
            <pc:docMk/>
            <pc:sldMk cId="3858847110" sldId="283"/>
            <ac:picMk id="161" creationId="{D7908C11-90AE-F448-93BC-6247230F2EB8}"/>
          </ac:picMkLst>
        </pc:picChg>
        <pc:picChg chg="mod">
          <ac:chgData name="Narang, Sonali" userId="9e80b397-6e2f-49b1-9374-ccdad8589140" providerId="ADAL" clId="{F81D094D-588F-3F49-A3F9-58CC1A6CC615}" dt="2021-11-30T18:39:27.579" v="2442" actId="1038"/>
          <ac:picMkLst>
            <pc:docMk/>
            <pc:sldMk cId="3858847110" sldId="283"/>
            <ac:picMk id="192" creationId="{EC366B67-B3CE-5749-AB74-BC5A19C67D22}"/>
          </ac:picMkLst>
        </pc:picChg>
        <pc:picChg chg="del mod">
          <ac:chgData name="Narang, Sonali" userId="9e80b397-6e2f-49b1-9374-ccdad8589140" providerId="ADAL" clId="{F81D094D-588F-3F49-A3F9-58CC1A6CC615}" dt="2021-11-30T19:00:47.155" v="2680" actId="478"/>
          <ac:picMkLst>
            <pc:docMk/>
            <pc:sldMk cId="3858847110" sldId="283"/>
            <ac:picMk id="197" creationId="{04900471-6903-234E-B618-857449153541}"/>
          </ac:picMkLst>
        </pc:picChg>
        <pc:picChg chg="mod">
          <ac:chgData name="Narang, Sonali" userId="9e80b397-6e2f-49b1-9374-ccdad8589140" providerId="ADAL" clId="{F81D094D-588F-3F49-A3F9-58CC1A6CC615}" dt="2021-11-30T19:08:02.822" v="2737" actId="1582"/>
          <ac:picMkLst>
            <pc:docMk/>
            <pc:sldMk cId="3858847110" sldId="283"/>
            <ac:picMk id="350" creationId="{04585CD6-CFC4-E542-B9D6-CF23C5C8D7F6}"/>
          </ac:picMkLst>
        </pc:picChg>
        <pc:picChg chg="mod">
          <ac:chgData name="Narang, Sonali" userId="9e80b397-6e2f-49b1-9374-ccdad8589140" providerId="ADAL" clId="{F81D094D-588F-3F49-A3F9-58CC1A6CC615}" dt="2021-11-30T19:08:11.230" v="2738" actId="1582"/>
          <ac:picMkLst>
            <pc:docMk/>
            <pc:sldMk cId="3858847110" sldId="283"/>
            <ac:picMk id="351" creationId="{50747652-4CDB-D741-ADF4-E1FA3601696A}"/>
          </ac:picMkLst>
        </pc:picChg>
        <pc:cxnChg chg="add del">
          <ac:chgData name="Narang, Sonali" userId="9e80b397-6e2f-49b1-9374-ccdad8589140" providerId="ADAL" clId="{F81D094D-588F-3F49-A3F9-58CC1A6CC615}" dt="2021-11-29T22:59:18.635" v="1836" actId="478"/>
          <ac:cxnSpMkLst>
            <pc:docMk/>
            <pc:sldMk cId="3858847110" sldId="283"/>
            <ac:cxnSpMk id="3" creationId="{37B06EF3-8713-1A4F-873C-F87D3F42AC00}"/>
          </ac:cxnSpMkLst>
        </pc:cxnChg>
        <pc:cxnChg chg="mod">
          <ac:chgData name="Narang, Sonali" userId="9e80b397-6e2f-49b1-9374-ccdad8589140" providerId="ADAL" clId="{F81D094D-588F-3F49-A3F9-58CC1A6CC615}" dt="2021-11-30T18:43:15.910" v="2501" actId="465"/>
          <ac:cxnSpMkLst>
            <pc:docMk/>
            <pc:sldMk cId="3858847110" sldId="283"/>
            <ac:cxnSpMk id="130" creationId="{D127FA20-59CF-AF4C-A355-72D556FF9D43}"/>
          </ac:cxnSpMkLst>
        </pc:cxnChg>
        <pc:cxnChg chg="mod">
          <ac:chgData name="Narang, Sonali" userId="9e80b397-6e2f-49b1-9374-ccdad8589140" providerId="ADAL" clId="{F81D094D-588F-3F49-A3F9-58CC1A6CC615}" dt="2021-11-30T18:43:15.910" v="2501" actId="465"/>
          <ac:cxnSpMkLst>
            <pc:docMk/>
            <pc:sldMk cId="3858847110" sldId="283"/>
            <ac:cxnSpMk id="131" creationId="{4AC924D3-9FF2-BC4E-A7B0-E41570383C00}"/>
          </ac:cxnSpMkLst>
        </pc:cxnChg>
        <pc:cxnChg chg="mod">
          <ac:chgData name="Narang, Sonali" userId="9e80b397-6e2f-49b1-9374-ccdad8589140" providerId="ADAL" clId="{F81D094D-588F-3F49-A3F9-58CC1A6CC615}" dt="2021-11-30T18:43:15.910" v="2501" actId="465"/>
          <ac:cxnSpMkLst>
            <pc:docMk/>
            <pc:sldMk cId="3858847110" sldId="283"/>
            <ac:cxnSpMk id="135" creationId="{1B6C8F03-B833-244A-9EDE-4128B1822E3A}"/>
          </ac:cxnSpMkLst>
        </pc:cxnChg>
      </pc:sldChg>
      <pc:sldChg chg="addSp delSp modSp mod modNotesTx">
        <pc:chgData name="Narang, Sonali" userId="9e80b397-6e2f-49b1-9374-ccdad8589140" providerId="ADAL" clId="{F81D094D-588F-3F49-A3F9-58CC1A6CC615}" dt="2021-12-06T14:47:40.611" v="3729" actId="478"/>
        <pc:sldMkLst>
          <pc:docMk/>
          <pc:sldMk cId="4004272488" sldId="284"/>
        </pc:sldMkLst>
        <pc:spChg chg="mod">
          <ac:chgData name="Narang, Sonali" userId="9e80b397-6e2f-49b1-9374-ccdad8589140" providerId="ADAL" clId="{F81D094D-588F-3F49-A3F9-58CC1A6CC615}" dt="2021-11-30T15:33:51.157" v="1941" actId="1037"/>
          <ac:spMkLst>
            <pc:docMk/>
            <pc:sldMk cId="4004272488" sldId="284"/>
            <ac:spMk id="5" creationId="{FAFFEC37-A0C5-5846-8534-22E3DEF6CEF4}"/>
          </ac:spMkLst>
        </pc:spChg>
        <pc:spChg chg="mod">
          <ac:chgData name="Narang, Sonali" userId="9e80b397-6e2f-49b1-9374-ccdad8589140" providerId="ADAL" clId="{F81D094D-588F-3F49-A3F9-58CC1A6CC615}" dt="2021-11-30T15:33:51.157" v="1941" actId="1037"/>
          <ac:spMkLst>
            <pc:docMk/>
            <pc:sldMk cId="4004272488" sldId="284"/>
            <ac:spMk id="7" creationId="{4C5F5CAE-FBFD-964D-A356-746AAC86DC9E}"/>
          </ac:spMkLst>
        </pc:spChg>
        <pc:spChg chg="mod">
          <ac:chgData name="Narang, Sonali" userId="9e80b397-6e2f-49b1-9374-ccdad8589140" providerId="ADAL" clId="{F81D094D-588F-3F49-A3F9-58CC1A6CC615}" dt="2021-11-29T17:52:33.440" v="1369" actId="20577"/>
          <ac:spMkLst>
            <pc:docMk/>
            <pc:sldMk cId="4004272488" sldId="284"/>
            <ac:spMk id="8" creationId="{8A9BAE78-C4FF-1843-94F6-3410EB884848}"/>
          </ac:spMkLst>
        </pc:spChg>
        <pc:spChg chg="mod">
          <ac:chgData name="Narang, Sonali" userId="9e80b397-6e2f-49b1-9374-ccdad8589140" providerId="ADAL" clId="{F81D094D-588F-3F49-A3F9-58CC1A6CC615}" dt="2021-12-01T18:34:54.474" v="3141" actId="1036"/>
          <ac:spMkLst>
            <pc:docMk/>
            <pc:sldMk cId="4004272488" sldId="284"/>
            <ac:spMk id="22" creationId="{815B8AA3-2588-D94F-B9D1-7042D5C89A34}"/>
          </ac:spMkLst>
        </pc:spChg>
        <pc:spChg chg="add mod">
          <ac:chgData name="Narang, Sonali" userId="9e80b397-6e2f-49b1-9374-ccdad8589140" providerId="ADAL" clId="{F81D094D-588F-3F49-A3F9-58CC1A6CC615}" dt="2021-11-30T17:09:30.834" v="2363" actId="1076"/>
          <ac:spMkLst>
            <pc:docMk/>
            <pc:sldMk cId="4004272488" sldId="284"/>
            <ac:spMk id="25" creationId="{6593D040-450B-C74A-8B7E-FF945A3E00B1}"/>
          </ac:spMkLst>
        </pc:spChg>
        <pc:spChg chg="mod">
          <ac:chgData name="Narang, Sonali" userId="9e80b397-6e2f-49b1-9374-ccdad8589140" providerId="ADAL" clId="{F81D094D-588F-3F49-A3F9-58CC1A6CC615}" dt="2021-11-30T17:09:30.834" v="2363" actId="1076"/>
          <ac:spMkLst>
            <pc:docMk/>
            <pc:sldMk cId="4004272488" sldId="284"/>
            <ac:spMk id="29" creationId="{E4C2B977-FA04-3F48-B9BD-9F31456B3DDF}"/>
          </ac:spMkLst>
        </pc:spChg>
        <pc:spChg chg="del">
          <ac:chgData name="Narang, Sonali" userId="9e80b397-6e2f-49b1-9374-ccdad8589140" providerId="ADAL" clId="{F81D094D-588F-3F49-A3F9-58CC1A6CC615}" dt="2021-11-30T14:28:11.456" v="1863" actId="21"/>
          <ac:spMkLst>
            <pc:docMk/>
            <pc:sldMk cId="4004272488" sldId="284"/>
            <ac:spMk id="31" creationId="{8EF461AC-923C-4449-8C5F-E3BB3E1A2E00}"/>
          </ac:spMkLst>
        </pc:spChg>
        <pc:spChg chg="del mod">
          <ac:chgData name="Narang, Sonali" userId="9e80b397-6e2f-49b1-9374-ccdad8589140" providerId="ADAL" clId="{F81D094D-588F-3F49-A3F9-58CC1A6CC615}" dt="2021-12-01T17:33:50.956" v="2994" actId="478"/>
          <ac:spMkLst>
            <pc:docMk/>
            <pc:sldMk cId="4004272488" sldId="284"/>
            <ac:spMk id="32" creationId="{2863401C-2050-2E40-AE5C-C6CDD3A8A7D4}"/>
          </ac:spMkLst>
        </pc:spChg>
        <pc:spChg chg="del mod">
          <ac:chgData name="Narang, Sonali" userId="9e80b397-6e2f-49b1-9374-ccdad8589140" providerId="ADAL" clId="{F81D094D-588F-3F49-A3F9-58CC1A6CC615}" dt="2021-12-01T20:59:42.031" v="3486" actId="478"/>
          <ac:spMkLst>
            <pc:docMk/>
            <pc:sldMk cId="4004272488" sldId="284"/>
            <ac:spMk id="35" creationId="{035B29FF-8D31-C74D-84CD-B2F72D9111E7}"/>
          </ac:spMkLst>
        </pc:spChg>
        <pc:spChg chg="add del mod">
          <ac:chgData name="Narang, Sonali" userId="9e80b397-6e2f-49b1-9374-ccdad8589140" providerId="ADAL" clId="{F81D094D-588F-3F49-A3F9-58CC1A6CC615}" dt="2021-11-30T17:08:35.898" v="2349" actId="478"/>
          <ac:spMkLst>
            <pc:docMk/>
            <pc:sldMk cId="4004272488" sldId="284"/>
            <ac:spMk id="43" creationId="{DD777FF1-5F6C-D940-A61A-9A2DC891591C}"/>
          </ac:spMkLst>
        </pc:spChg>
        <pc:spChg chg="add del mod">
          <ac:chgData name="Narang, Sonali" userId="9e80b397-6e2f-49b1-9374-ccdad8589140" providerId="ADAL" clId="{F81D094D-588F-3F49-A3F9-58CC1A6CC615}" dt="2021-12-01T17:20:19.013" v="2966" actId="478"/>
          <ac:spMkLst>
            <pc:docMk/>
            <pc:sldMk cId="4004272488" sldId="284"/>
            <ac:spMk id="81" creationId="{2A773444-E0BB-EB45-BED1-171CA099FFF5}"/>
          </ac:spMkLst>
        </pc:spChg>
        <pc:spChg chg="add del mod">
          <ac:chgData name="Narang, Sonali" userId="9e80b397-6e2f-49b1-9374-ccdad8589140" providerId="ADAL" clId="{F81D094D-588F-3F49-A3F9-58CC1A6CC615}" dt="2021-12-01T17:20:19.013" v="2966" actId="478"/>
          <ac:spMkLst>
            <pc:docMk/>
            <pc:sldMk cId="4004272488" sldId="284"/>
            <ac:spMk id="82" creationId="{1252E7C0-1A3B-5542-97CA-9925323B731F}"/>
          </ac:spMkLst>
        </pc:spChg>
        <pc:spChg chg="add del mod">
          <ac:chgData name="Narang, Sonali" userId="9e80b397-6e2f-49b1-9374-ccdad8589140" providerId="ADAL" clId="{F81D094D-588F-3F49-A3F9-58CC1A6CC615}" dt="2021-12-01T17:20:19.013" v="2966" actId="478"/>
          <ac:spMkLst>
            <pc:docMk/>
            <pc:sldMk cId="4004272488" sldId="284"/>
            <ac:spMk id="83" creationId="{5BE6F70F-5865-9344-AB7D-BB8C0FBAD9E2}"/>
          </ac:spMkLst>
        </pc:spChg>
        <pc:spChg chg="add mod">
          <ac:chgData name="Narang, Sonali" userId="9e80b397-6e2f-49b1-9374-ccdad8589140" providerId="ADAL" clId="{F81D094D-588F-3F49-A3F9-58CC1A6CC615}" dt="2021-12-01T19:03:27.550" v="3407" actId="1036"/>
          <ac:spMkLst>
            <pc:docMk/>
            <pc:sldMk cId="4004272488" sldId="284"/>
            <ac:spMk id="101" creationId="{B8264B62-3E19-2049-91A6-C9AD5F1A87C2}"/>
          </ac:spMkLst>
        </pc:spChg>
        <pc:spChg chg="add mod">
          <ac:chgData name="Narang, Sonali" userId="9e80b397-6e2f-49b1-9374-ccdad8589140" providerId="ADAL" clId="{F81D094D-588F-3F49-A3F9-58CC1A6CC615}" dt="2021-12-01T19:03:27.550" v="3407" actId="1036"/>
          <ac:spMkLst>
            <pc:docMk/>
            <pc:sldMk cId="4004272488" sldId="284"/>
            <ac:spMk id="140" creationId="{B160352D-695D-184C-ACFE-154A13C25E06}"/>
          </ac:spMkLst>
        </pc:spChg>
        <pc:spChg chg="add del mod">
          <ac:chgData name="Narang, Sonali" userId="9e80b397-6e2f-49b1-9374-ccdad8589140" providerId="ADAL" clId="{F81D094D-588F-3F49-A3F9-58CC1A6CC615}" dt="2021-12-06T14:47:40.151" v="3728" actId="478"/>
          <ac:spMkLst>
            <pc:docMk/>
            <pc:sldMk cId="4004272488" sldId="284"/>
            <ac:spMk id="143" creationId="{20129D71-3918-E547-A9C5-11F1801D30D0}"/>
          </ac:spMkLst>
        </pc:spChg>
        <pc:spChg chg="add del mod">
          <ac:chgData name="Narang, Sonali" userId="9e80b397-6e2f-49b1-9374-ccdad8589140" providerId="ADAL" clId="{F81D094D-588F-3F49-A3F9-58CC1A6CC615}" dt="2021-12-06T14:47:40.611" v="3729" actId="478"/>
          <ac:spMkLst>
            <pc:docMk/>
            <pc:sldMk cId="4004272488" sldId="284"/>
            <ac:spMk id="144" creationId="{04F4E0B9-91A9-A04B-A9CF-77FA1F46893D}"/>
          </ac:spMkLst>
        </pc:spChg>
        <pc:spChg chg="add mod">
          <ac:chgData name="Narang, Sonali" userId="9e80b397-6e2f-49b1-9374-ccdad8589140" providerId="ADAL" clId="{F81D094D-588F-3F49-A3F9-58CC1A6CC615}" dt="2021-12-06T14:47:39.611" v="3727" actId="1076"/>
          <ac:spMkLst>
            <pc:docMk/>
            <pc:sldMk cId="4004272488" sldId="284"/>
            <ac:spMk id="145" creationId="{58C6D6E7-5376-8247-90FE-13ED6E414D6E}"/>
          </ac:spMkLst>
        </pc:spChg>
        <pc:grpChg chg="add mod">
          <ac:chgData name="Narang, Sonali" userId="9e80b397-6e2f-49b1-9374-ccdad8589140" providerId="ADAL" clId="{F81D094D-588F-3F49-A3F9-58CC1A6CC615}" dt="2021-12-01T19:08:07.758" v="3461" actId="1037"/>
          <ac:grpSpMkLst>
            <pc:docMk/>
            <pc:sldMk cId="4004272488" sldId="284"/>
            <ac:grpSpMk id="142" creationId="{7ECCC13B-D4CC-0648-8B6B-34B386F98D04}"/>
          </ac:grpSpMkLst>
        </pc:grpChg>
        <pc:picChg chg="add del mod">
          <ac:chgData name="Narang, Sonali" userId="9e80b397-6e2f-49b1-9374-ccdad8589140" providerId="ADAL" clId="{F81D094D-588F-3F49-A3F9-58CC1A6CC615}" dt="2021-11-30T14:31:02.930" v="1885" actId="478"/>
          <ac:picMkLst>
            <pc:docMk/>
            <pc:sldMk cId="4004272488" sldId="284"/>
            <ac:picMk id="3" creationId="{6F10275A-FA40-1A42-88C7-AD79527AD3E8}"/>
          </ac:picMkLst>
        </pc:picChg>
        <pc:picChg chg="del">
          <ac:chgData name="Narang, Sonali" userId="9e80b397-6e2f-49b1-9374-ccdad8589140" providerId="ADAL" clId="{F81D094D-588F-3F49-A3F9-58CC1A6CC615}" dt="2021-12-01T18:57:35.419" v="3220" actId="478"/>
          <ac:picMkLst>
            <pc:docMk/>
            <pc:sldMk cId="4004272488" sldId="284"/>
            <ac:picMk id="6" creationId="{07A34510-79AF-D945-8CDE-E6C2A3F41F8A}"/>
          </ac:picMkLst>
        </pc:picChg>
        <pc:picChg chg="mod">
          <ac:chgData name="Narang, Sonali" userId="9e80b397-6e2f-49b1-9374-ccdad8589140" providerId="ADAL" clId="{F81D094D-588F-3F49-A3F9-58CC1A6CC615}" dt="2021-12-01T18:43:00.666" v="3196" actId="1076"/>
          <ac:picMkLst>
            <pc:docMk/>
            <pc:sldMk cId="4004272488" sldId="284"/>
            <ac:picMk id="9" creationId="{582BC744-B55E-444D-9186-996C5EEEF91A}"/>
          </ac:picMkLst>
        </pc:picChg>
        <pc:picChg chg="del">
          <ac:chgData name="Narang, Sonali" userId="9e80b397-6e2f-49b1-9374-ccdad8589140" providerId="ADAL" clId="{F81D094D-588F-3F49-A3F9-58CC1A6CC615}" dt="2021-12-01T18:57:35.419" v="3220" actId="478"/>
          <ac:picMkLst>
            <pc:docMk/>
            <pc:sldMk cId="4004272488" sldId="284"/>
            <ac:picMk id="10" creationId="{EA3B9FA7-8C12-3D46-A087-17F1BE11CF56}"/>
          </ac:picMkLst>
        </pc:picChg>
        <pc:picChg chg="del">
          <ac:chgData name="Narang, Sonali" userId="9e80b397-6e2f-49b1-9374-ccdad8589140" providerId="ADAL" clId="{F81D094D-588F-3F49-A3F9-58CC1A6CC615}" dt="2021-12-01T18:57:35.419" v="3220" actId="478"/>
          <ac:picMkLst>
            <pc:docMk/>
            <pc:sldMk cId="4004272488" sldId="284"/>
            <ac:picMk id="12" creationId="{676E61DD-D5A0-DD48-9AC2-F419B394C32F}"/>
          </ac:picMkLst>
        </pc:picChg>
        <pc:picChg chg="mod">
          <ac:chgData name="Narang, Sonali" userId="9e80b397-6e2f-49b1-9374-ccdad8589140" providerId="ADAL" clId="{F81D094D-588F-3F49-A3F9-58CC1A6CC615}" dt="2021-12-01T18:43:00.666" v="3196" actId="1076"/>
          <ac:picMkLst>
            <pc:docMk/>
            <pc:sldMk cId="4004272488" sldId="284"/>
            <ac:picMk id="13" creationId="{1700A0E7-E7CE-114B-A2B5-15E8E6D46524}"/>
          </ac:picMkLst>
        </pc:picChg>
        <pc:picChg chg="add del mod">
          <ac:chgData name="Narang, Sonali" userId="9e80b397-6e2f-49b1-9374-ccdad8589140" providerId="ADAL" clId="{F81D094D-588F-3F49-A3F9-58CC1A6CC615}" dt="2021-11-30T14:31:02.930" v="1885" actId="478"/>
          <ac:picMkLst>
            <pc:docMk/>
            <pc:sldMk cId="4004272488" sldId="284"/>
            <ac:picMk id="14" creationId="{C8C8423E-42D0-A84D-ADBE-EAD2ACC453A6}"/>
          </ac:picMkLst>
        </pc:picChg>
        <pc:picChg chg="mod">
          <ac:chgData name="Narang, Sonali" userId="9e80b397-6e2f-49b1-9374-ccdad8589140" providerId="ADAL" clId="{F81D094D-588F-3F49-A3F9-58CC1A6CC615}" dt="2021-12-01T18:43:00.666" v="3196" actId="1076"/>
          <ac:picMkLst>
            <pc:docMk/>
            <pc:sldMk cId="4004272488" sldId="284"/>
            <ac:picMk id="16" creationId="{49314A01-A50F-FE40-ACB7-0D83933DE24E}"/>
          </ac:picMkLst>
        </pc:picChg>
        <pc:picChg chg="add del mod">
          <ac:chgData name="Narang, Sonali" userId="9e80b397-6e2f-49b1-9374-ccdad8589140" providerId="ADAL" clId="{F81D094D-588F-3F49-A3F9-58CC1A6CC615}" dt="2021-11-30T14:31:02.930" v="1885" actId="478"/>
          <ac:picMkLst>
            <pc:docMk/>
            <pc:sldMk cId="4004272488" sldId="284"/>
            <ac:picMk id="17" creationId="{9D81CC87-52D5-E343-BF78-94F83035D17D}"/>
          </ac:picMkLst>
        </pc:picChg>
        <pc:picChg chg="add del mod">
          <ac:chgData name="Narang, Sonali" userId="9e80b397-6e2f-49b1-9374-ccdad8589140" providerId="ADAL" clId="{F81D094D-588F-3F49-A3F9-58CC1A6CC615}" dt="2021-11-30T15:36:39.538" v="1943" actId="478"/>
          <ac:picMkLst>
            <pc:docMk/>
            <pc:sldMk cId="4004272488" sldId="284"/>
            <ac:picMk id="19" creationId="{0EC81A0E-4E78-4041-86DC-FBAF669D97A2}"/>
          </ac:picMkLst>
        </pc:picChg>
        <pc:picChg chg="del">
          <ac:chgData name="Narang, Sonali" userId="9e80b397-6e2f-49b1-9374-ccdad8589140" providerId="ADAL" clId="{F81D094D-588F-3F49-A3F9-58CC1A6CC615}" dt="2021-11-30T14:28:11.456" v="1863" actId="21"/>
          <ac:picMkLst>
            <pc:docMk/>
            <pc:sldMk cId="4004272488" sldId="284"/>
            <ac:picMk id="20" creationId="{7BB6B16B-28D9-194D-87FA-A12DE15B0D69}"/>
          </ac:picMkLst>
        </pc:picChg>
        <pc:picChg chg="add del mod">
          <ac:chgData name="Narang, Sonali" userId="9e80b397-6e2f-49b1-9374-ccdad8589140" providerId="ADAL" clId="{F81D094D-588F-3F49-A3F9-58CC1A6CC615}" dt="2021-11-30T15:36:39.538" v="1943" actId="478"/>
          <ac:picMkLst>
            <pc:docMk/>
            <pc:sldMk cId="4004272488" sldId="284"/>
            <ac:picMk id="23" creationId="{E8B6A881-8AE3-1C46-92BE-39582D3CBEDE}"/>
          </ac:picMkLst>
        </pc:picChg>
        <pc:picChg chg="del">
          <ac:chgData name="Narang, Sonali" userId="9e80b397-6e2f-49b1-9374-ccdad8589140" providerId="ADAL" clId="{F81D094D-588F-3F49-A3F9-58CC1A6CC615}" dt="2021-11-30T14:28:11.456" v="1863" actId="21"/>
          <ac:picMkLst>
            <pc:docMk/>
            <pc:sldMk cId="4004272488" sldId="284"/>
            <ac:picMk id="24" creationId="{4061DD9D-7877-F24B-BD70-11D9D12D2A5F}"/>
          </ac:picMkLst>
        </pc:picChg>
        <pc:picChg chg="del mod">
          <ac:chgData name="Narang, Sonali" userId="9e80b397-6e2f-49b1-9374-ccdad8589140" providerId="ADAL" clId="{F81D094D-588F-3F49-A3F9-58CC1A6CC615}" dt="2021-12-01T18:33:01.335" v="3086" actId="478"/>
          <ac:picMkLst>
            <pc:docMk/>
            <pc:sldMk cId="4004272488" sldId="284"/>
            <ac:picMk id="26" creationId="{6622012E-829C-D245-ACED-5089C4B5C9C4}"/>
          </ac:picMkLst>
        </pc:picChg>
        <pc:picChg chg="del mod">
          <ac:chgData name="Narang, Sonali" userId="9e80b397-6e2f-49b1-9374-ccdad8589140" providerId="ADAL" clId="{F81D094D-588F-3F49-A3F9-58CC1A6CC615}" dt="2021-12-01T18:33:01.335" v="3086" actId="478"/>
          <ac:picMkLst>
            <pc:docMk/>
            <pc:sldMk cId="4004272488" sldId="284"/>
            <ac:picMk id="28" creationId="{E4F0C550-AE7A-2142-8FFA-261CC21C45B1}"/>
          </ac:picMkLst>
        </pc:picChg>
        <pc:picChg chg="del">
          <ac:chgData name="Narang, Sonali" userId="9e80b397-6e2f-49b1-9374-ccdad8589140" providerId="ADAL" clId="{F81D094D-588F-3F49-A3F9-58CC1A6CC615}" dt="2021-12-01T18:33:01.335" v="3086" actId="478"/>
          <ac:picMkLst>
            <pc:docMk/>
            <pc:sldMk cId="4004272488" sldId="284"/>
            <ac:picMk id="30" creationId="{E442FC1C-4929-E044-99A7-21D2850971B1}"/>
          </ac:picMkLst>
        </pc:picChg>
        <pc:picChg chg="del mod">
          <ac:chgData name="Narang, Sonali" userId="9e80b397-6e2f-49b1-9374-ccdad8589140" providerId="ADAL" clId="{F81D094D-588F-3F49-A3F9-58CC1A6CC615}" dt="2021-12-01T17:22:01.232" v="2972" actId="478"/>
          <ac:picMkLst>
            <pc:docMk/>
            <pc:sldMk cId="4004272488" sldId="284"/>
            <ac:picMk id="33" creationId="{4A396834-A78E-BA4E-B81C-727FA6F833D7}"/>
          </ac:picMkLst>
        </pc:picChg>
        <pc:picChg chg="del">
          <ac:chgData name="Narang, Sonali" userId="9e80b397-6e2f-49b1-9374-ccdad8589140" providerId="ADAL" clId="{F81D094D-588F-3F49-A3F9-58CC1A6CC615}" dt="2021-11-30T14:28:11.456" v="1863" actId="21"/>
          <ac:picMkLst>
            <pc:docMk/>
            <pc:sldMk cId="4004272488" sldId="284"/>
            <ac:picMk id="34" creationId="{2A40C706-D4BB-D74C-BE24-A8B4D915A296}"/>
          </ac:picMkLst>
        </pc:picChg>
        <pc:picChg chg="add del mod">
          <ac:chgData name="Narang, Sonali" userId="9e80b397-6e2f-49b1-9374-ccdad8589140" providerId="ADAL" clId="{F81D094D-588F-3F49-A3F9-58CC1A6CC615}" dt="2021-11-30T15:36:39.538" v="1943" actId="478"/>
          <ac:picMkLst>
            <pc:docMk/>
            <pc:sldMk cId="4004272488" sldId="284"/>
            <ac:picMk id="36" creationId="{6149BE4F-0A3D-4B45-8504-5F404121D7D5}"/>
          </ac:picMkLst>
        </pc:picChg>
        <pc:picChg chg="add del mod">
          <ac:chgData name="Narang, Sonali" userId="9e80b397-6e2f-49b1-9374-ccdad8589140" providerId="ADAL" clId="{F81D094D-588F-3F49-A3F9-58CC1A6CC615}" dt="2021-11-30T16:53:18.302" v="2232" actId="478"/>
          <ac:picMkLst>
            <pc:docMk/>
            <pc:sldMk cId="4004272488" sldId="284"/>
            <ac:picMk id="38" creationId="{A52F26F2-9795-C443-A695-D2403513DE94}"/>
          </ac:picMkLst>
        </pc:picChg>
        <pc:picChg chg="add del mod">
          <ac:chgData name="Narang, Sonali" userId="9e80b397-6e2f-49b1-9374-ccdad8589140" providerId="ADAL" clId="{F81D094D-588F-3F49-A3F9-58CC1A6CC615}" dt="2021-11-30T16:53:18.302" v="2232" actId="478"/>
          <ac:picMkLst>
            <pc:docMk/>
            <pc:sldMk cId="4004272488" sldId="284"/>
            <ac:picMk id="40" creationId="{A7E2FBE7-5948-FF40-B40B-87946C8139FD}"/>
          </ac:picMkLst>
        </pc:picChg>
        <pc:picChg chg="add del mod">
          <ac:chgData name="Narang, Sonali" userId="9e80b397-6e2f-49b1-9374-ccdad8589140" providerId="ADAL" clId="{F81D094D-588F-3F49-A3F9-58CC1A6CC615}" dt="2021-11-30T16:53:18.302" v="2232" actId="478"/>
          <ac:picMkLst>
            <pc:docMk/>
            <pc:sldMk cId="4004272488" sldId="284"/>
            <ac:picMk id="42" creationId="{DFE9AD3F-E1D8-5F4C-8990-BD4D26FE1C4B}"/>
          </ac:picMkLst>
        </pc:picChg>
        <pc:picChg chg="add del mod">
          <ac:chgData name="Narang, Sonali" userId="9e80b397-6e2f-49b1-9374-ccdad8589140" providerId="ADAL" clId="{F81D094D-588F-3F49-A3F9-58CC1A6CC615}" dt="2021-12-01T16:49:32.982" v="2851" actId="478"/>
          <ac:picMkLst>
            <pc:docMk/>
            <pc:sldMk cId="4004272488" sldId="284"/>
            <ac:picMk id="45" creationId="{CF75F310-1256-8342-9F32-DB7FFCE393EC}"/>
          </ac:picMkLst>
        </pc:picChg>
        <pc:picChg chg="add del mod">
          <ac:chgData name="Narang, Sonali" userId="9e80b397-6e2f-49b1-9374-ccdad8589140" providerId="ADAL" clId="{F81D094D-588F-3F49-A3F9-58CC1A6CC615}" dt="2021-12-01T16:49:32.982" v="2851" actId="478"/>
          <ac:picMkLst>
            <pc:docMk/>
            <pc:sldMk cId="4004272488" sldId="284"/>
            <ac:picMk id="47" creationId="{E84C6BFE-A243-6E49-BCEB-71EAFD3B0C4B}"/>
          </ac:picMkLst>
        </pc:picChg>
        <pc:picChg chg="add del mod">
          <ac:chgData name="Narang, Sonali" userId="9e80b397-6e2f-49b1-9374-ccdad8589140" providerId="ADAL" clId="{F81D094D-588F-3F49-A3F9-58CC1A6CC615}" dt="2021-12-01T16:49:32.982" v="2851" actId="478"/>
          <ac:picMkLst>
            <pc:docMk/>
            <pc:sldMk cId="4004272488" sldId="284"/>
            <ac:picMk id="49" creationId="{AA70BBAF-1386-BC42-8301-E83394DAC977}"/>
          </ac:picMkLst>
        </pc:picChg>
        <pc:picChg chg="add del mod">
          <ac:chgData name="Narang, Sonali" userId="9e80b397-6e2f-49b1-9374-ccdad8589140" providerId="ADAL" clId="{F81D094D-588F-3F49-A3F9-58CC1A6CC615}" dt="2021-12-01T17:31:03.248" v="2980" actId="478"/>
          <ac:picMkLst>
            <pc:docMk/>
            <pc:sldMk cId="4004272488" sldId="284"/>
            <ac:picMk id="51" creationId="{BC7C3C17-A195-2948-AA2C-1FBED1C79A0F}"/>
          </ac:picMkLst>
        </pc:picChg>
        <pc:picChg chg="add del mod">
          <ac:chgData name="Narang, Sonali" userId="9e80b397-6e2f-49b1-9374-ccdad8589140" providerId="ADAL" clId="{F81D094D-588F-3F49-A3F9-58CC1A6CC615}" dt="2021-12-01T17:31:03.248" v="2980" actId="478"/>
          <ac:picMkLst>
            <pc:docMk/>
            <pc:sldMk cId="4004272488" sldId="284"/>
            <ac:picMk id="53" creationId="{75C3B48C-A30F-AF45-9CD9-E6C46FF9A639}"/>
          </ac:picMkLst>
        </pc:picChg>
        <pc:picChg chg="add del mod">
          <ac:chgData name="Narang, Sonali" userId="9e80b397-6e2f-49b1-9374-ccdad8589140" providerId="ADAL" clId="{F81D094D-588F-3F49-A3F9-58CC1A6CC615}" dt="2021-12-01T17:31:03.248" v="2980" actId="478"/>
          <ac:picMkLst>
            <pc:docMk/>
            <pc:sldMk cId="4004272488" sldId="284"/>
            <ac:picMk id="55" creationId="{9B7CB568-47CE-9F43-8F34-49665D4EAE21}"/>
          </ac:picMkLst>
        </pc:picChg>
        <pc:picChg chg="add del mod">
          <ac:chgData name="Narang, Sonali" userId="9e80b397-6e2f-49b1-9374-ccdad8589140" providerId="ADAL" clId="{F81D094D-588F-3F49-A3F9-58CC1A6CC615}" dt="2021-12-01T17:16:03.427" v="2884" actId="478"/>
          <ac:picMkLst>
            <pc:docMk/>
            <pc:sldMk cId="4004272488" sldId="284"/>
            <ac:picMk id="57" creationId="{D7FE7E94-0FC7-4242-ACAC-51D9F3A23A94}"/>
          </ac:picMkLst>
        </pc:picChg>
        <pc:picChg chg="add del mod">
          <ac:chgData name="Narang, Sonali" userId="9e80b397-6e2f-49b1-9374-ccdad8589140" providerId="ADAL" clId="{F81D094D-588F-3F49-A3F9-58CC1A6CC615}" dt="2021-12-01T17:20:19.013" v="2966" actId="478"/>
          <ac:picMkLst>
            <pc:docMk/>
            <pc:sldMk cId="4004272488" sldId="284"/>
            <ac:picMk id="59" creationId="{77DDEFA4-4AC7-8F40-A6FC-F20328C7AF41}"/>
          </ac:picMkLst>
        </pc:picChg>
        <pc:picChg chg="add mod">
          <ac:chgData name="Narang, Sonali" userId="9e80b397-6e2f-49b1-9374-ccdad8589140" providerId="ADAL" clId="{F81D094D-588F-3F49-A3F9-58CC1A6CC615}" dt="2021-12-01T19:07:02.441" v="3449" actId="167"/>
          <ac:picMkLst>
            <pc:docMk/>
            <pc:sldMk cId="4004272488" sldId="284"/>
            <ac:picMk id="85" creationId="{C23CE7FA-8A81-974A-9461-9E446D5D22BE}"/>
          </ac:picMkLst>
        </pc:picChg>
        <pc:picChg chg="add del mod">
          <ac:chgData name="Narang, Sonali" userId="9e80b397-6e2f-49b1-9374-ccdad8589140" providerId="ADAL" clId="{F81D094D-588F-3F49-A3F9-58CC1A6CC615}" dt="2021-12-01T17:31:00.969" v="2979" actId="478"/>
          <ac:picMkLst>
            <pc:docMk/>
            <pc:sldMk cId="4004272488" sldId="284"/>
            <ac:picMk id="87" creationId="{07D5CBC3-4C0F-7343-9E28-933E47FE5DB5}"/>
          </ac:picMkLst>
        </pc:picChg>
        <pc:picChg chg="add del mod">
          <ac:chgData name="Narang, Sonali" userId="9e80b397-6e2f-49b1-9374-ccdad8589140" providerId="ADAL" clId="{F81D094D-588F-3F49-A3F9-58CC1A6CC615}" dt="2021-12-01T17:33:53.438" v="2995" actId="478"/>
          <ac:picMkLst>
            <pc:docMk/>
            <pc:sldMk cId="4004272488" sldId="284"/>
            <ac:picMk id="89" creationId="{1D0DEFBA-6D2A-B241-B26E-7CA73737130D}"/>
          </ac:picMkLst>
        </pc:picChg>
        <pc:picChg chg="add del mod">
          <ac:chgData name="Narang, Sonali" userId="9e80b397-6e2f-49b1-9374-ccdad8589140" providerId="ADAL" clId="{F81D094D-588F-3F49-A3F9-58CC1A6CC615}" dt="2021-12-01T17:33:53.438" v="2995" actId="478"/>
          <ac:picMkLst>
            <pc:docMk/>
            <pc:sldMk cId="4004272488" sldId="284"/>
            <ac:picMk id="91" creationId="{E792EE14-38F8-2547-9F34-1C50FB9117FF}"/>
          </ac:picMkLst>
        </pc:picChg>
        <pc:picChg chg="add del mod modCrop">
          <ac:chgData name="Narang, Sonali" userId="9e80b397-6e2f-49b1-9374-ccdad8589140" providerId="ADAL" clId="{F81D094D-588F-3F49-A3F9-58CC1A6CC615}" dt="2021-12-01T17:33:50.956" v="2994" actId="478"/>
          <ac:picMkLst>
            <pc:docMk/>
            <pc:sldMk cId="4004272488" sldId="284"/>
            <ac:picMk id="93" creationId="{E5187DCC-4F7B-974F-95CB-AF074A055387}"/>
          </ac:picMkLst>
        </pc:picChg>
        <pc:picChg chg="add del mod modCrop">
          <ac:chgData name="Narang, Sonali" userId="9e80b397-6e2f-49b1-9374-ccdad8589140" providerId="ADAL" clId="{F81D094D-588F-3F49-A3F9-58CC1A6CC615}" dt="2021-12-01T18:40:01.717" v="3142" actId="478"/>
          <ac:picMkLst>
            <pc:docMk/>
            <pc:sldMk cId="4004272488" sldId="284"/>
            <ac:picMk id="95" creationId="{D27CD6D1-DD93-2F43-9936-B72635833905}"/>
          </ac:picMkLst>
        </pc:picChg>
        <pc:picChg chg="add del mod modCrop">
          <ac:chgData name="Narang, Sonali" userId="9e80b397-6e2f-49b1-9374-ccdad8589140" providerId="ADAL" clId="{F81D094D-588F-3F49-A3F9-58CC1A6CC615}" dt="2021-12-01T18:40:01.717" v="3142" actId="478"/>
          <ac:picMkLst>
            <pc:docMk/>
            <pc:sldMk cId="4004272488" sldId="284"/>
            <ac:picMk id="97" creationId="{8104AF00-D04E-1A4D-858E-A1E6D6581D45}"/>
          </ac:picMkLst>
        </pc:picChg>
        <pc:picChg chg="add del mod modCrop">
          <ac:chgData name="Narang, Sonali" userId="9e80b397-6e2f-49b1-9374-ccdad8589140" providerId="ADAL" clId="{F81D094D-588F-3F49-A3F9-58CC1A6CC615}" dt="2021-12-01T18:40:01.717" v="3142" actId="478"/>
          <ac:picMkLst>
            <pc:docMk/>
            <pc:sldMk cId="4004272488" sldId="284"/>
            <ac:picMk id="99" creationId="{215A2E58-C65A-D24A-9262-EF186637C1D6}"/>
          </ac:picMkLst>
        </pc:picChg>
        <pc:picChg chg="add mod modCrop">
          <ac:chgData name="Narang, Sonali" userId="9e80b397-6e2f-49b1-9374-ccdad8589140" providerId="ADAL" clId="{F81D094D-588F-3F49-A3F9-58CC1A6CC615}" dt="2021-12-01T19:04:49.851" v="3420" actId="1037"/>
          <ac:picMkLst>
            <pc:docMk/>
            <pc:sldMk cId="4004272488" sldId="284"/>
            <ac:picMk id="100" creationId="{C84B6BE0-EDF1-6647-9F04-CD7FD264319C}"/>
          </ac:picMkLst>
        </pc:picChg>
        <pc:picChg chg="add del mod">
          <ac:chgData name="Narang, Sonali" userId="9e80b397-6e2f-49b1-9374-ccdad8589140" providerId="ADAL" clId="{F81D094D-588F-3F49-A3F9-58CC1A6CC615}" dt="2021-12-01T18:29:19.557" v="3058" actId="478"/>
          <ac:picMkLst>
            <pc:docMk/>
            <pc:sldMk cId="4004272488" sldId="284"/>
            <ac:picMk id="103" creationId="{CD1AA552-125A-534F-B05C-CFA14C133C11}"/>
          </ac:picMkLst>
        </pc:picChg>
        <pc:picChg chg="add del mod">
          <ac:chgData name="Narang, Sonali" userId="9e80b397-6e2f-49b1-9374-ccdad8589140" providerId="ADAL" clId="{F81D094D-588F-3F49-A3F9-58CC1A6CC615}" dt="2021-12-01T18:30:20.707" v="3064" actId="478"/>
          <ac:picMkLst>
            <pc:docMk/>
            <pc:sldMk cId="4004272488" sldId="284"/>
            <ac:picMk id="105" creationId="{4E8BCBEA-CA3A-E740-AE3E-19025D0811FB}"/>
          </ac:picMkLst>
        </pc:picChg>
        <pc:picChg chg="add del mod">
          <ac:chgData name="Narang, Sonali" userId="9e80b397-6e2f-49b1-9374-ccdad8589140" providerId="ADAL" clId="{F81D094D-588F-3F49-A3F9-58CC1A6CC615}" dt="2021-12-01T18:30:55.389" v="3073" actId="478"/>
          <ac:picMkLst>
            <pc:docMk/>
            <pc:sldMk cId="4004272488" sldId="284"/>
            <ac:picMk id="107" creationId="{BE427FEB-5AF7-6941-B261-DE914F29DE80}"/>
          </ac:picMkLst>
        </pc:picChg>
        <pc:picChg chg="add del mod">
          <ac:chgData name="Narang, Sonali" userId="9e80b397-6e2f-49b1-9374-ccdad8589140" providerId="ADAL" clId="{F81D094D-588F-3F49-A3F9-58CC1A6CC615}" dt="2021-12-01T18:32:44.068" v="3077" actId="478"/>
          <ac:picMkLst>
            <pc:docMk/>
            <pc:sldMk cId="4004272488" sldId="284"/>
            <ac:picMk id="109" creationId="{08CCF227-8875-164E-908E-D4FC85B551DF}"/>
          </ac:picMkLst>
        </pc:picChg>
        <pc:picChg chg="add del mod">
          <ac:chgData name="Narang, Sonali" userId="9e80b397-6e2f-49b1-9374-ccdad8589140" providerId="ADAL" clId="{F81D094D-588F-3F49-A3F9-58CC1A6CC615}" dt="2021-12-01T18:32:44.068" v="3077" actId="478"/>
          <ac:picMkLst>
            <pc:docMk/>
            <pc:sldMk cId="4004272488" sldId="284"/>
            <ac:picMk id="111" creationId="{CC21AB74-E4D1-2145-B395-08386A017E6E}"/>
          </ac:picMkLst>
        </pc:picChg>
        <pc:picChg chg="add del mod">
          <ac:chgData name="Narang, Sonali" userId="9e80b397-6e2f-49b1-9374-ccdad8589140" providerId="ADAL" clId="{F81D094D-588F-3F49-A3F9-58CC1A6CC615}" dt="2021-12-01T18:32:44.068" v="3077" actId="478"/>
          <ac:picMkLst>
            <pc:docMk/>
            <pc:sldMk cId="4004272488" sldId="284"/>
            <ac:picMk id="113" creationId="{B7739DD1-0C55-B54C-9E72-CCF16FC017E5}"/>
          </ac:picMkLst>
        </pc:picChg>
        <pc:picChg chg="add mod">
          <ac:chgData name="Narang, Sonali" userId="9e80b397-6e2f-49b1-9374-ccdad8589140" providerId="ADAL" clId="{F81D094D-588F-3F49-A3F9-58CC1A6CC615}" dt="2021-12-01T18:59:17.238" v="3246" actId="14100"/>
          <ac:picMkLst>
            <pc:docMk/>
            <pc:sldMk cId="4004272488" sldId="284"/>
            <ac:picMk id="115" creationId="{CDF0BAAE-1283-9347-A476-BAAAC8083BAD}"/>
          </ac:picMkLst>
        </pc:picChg>
        <pc:picChg chg="add mod">
          <ac:chgData name="Narang, Sonali" userId="9e80b397-6e2f-49b1-9374-ccdad8589140" providerId="ADAL" clId="{F81D094D-588F-3F49-A3F9-58CC1A6CC615}" dt="2021-12-01T18:34:19.943" v="3121" actId="1037"/>
          <ac:picMkLst>
            <pc:docMk/>
            <pc:sldMk cId="4004272488" sldId="284"/>
            <ac:picMk id="117" creationId="{83EEABCA-B7F6-AA46-8E59-A59E409143FB}"/>
          </ac:picMkLst>
        </pc:picChg>
        <pc:picChg chg="add mod">
          <ac:chgData name="Narang, Sonali" userId="9e80b397-6e2f-49b1-9374-ccdad8589140" providerId="ADAL" clId="{F81D094D-588F-3F49-A3F9-58CC1A6CC615}" dt="2021-12-01T18:34:24.893" v="3139" actId="1038"/>
          <ac:picMkLst>
            <pc:docMk/>
            <pc:sldMk cId="4004272488" sldId="284"/>
            <ac:picMk id="119" creationId="{0C34A903-91D3-1C48-A7CA-8CE6C0AF0A6A}"/>
          </ac:picMkLst>
        </pc:picChg>
        <pc:picChg chg="add mod modCrop">
          <ac:chgData name="Narang, Sonali" userId="9e80b397-6e2f-49b1-9374-ccdad8589140" providerId="ADAL" clId="{F81D094D-588F-3F49-A3F9-58CC1A6CC615}" dt="2021-12-01T20:52:50.529" v="3482" actId="1038"/>
          <ac:picMkLst>
            <pc:docMk/>
            <pc:sldMk cId="4004272488" sldId="284"/>
            <ac:picMk id="121" creationId="{35A6EBFB-771F-A848-8EEF-3CAB0C1ECBB0}"/>
          </ac:picMkLst>
        </pc:picChg>
        <pc:picChg chg="add mod modCrop">
          <ac:chgData name="Narang, Sonali" userId="9e80b397-6e2f-49b1-9374-ccdad8589140" providerId="ADAL" clId="{F81D094D-588F-3F49-A3F9-58CC1A6CC615}" dt="2021-12-01T20:52:52.526" v="3485" actId="1038"/>
          <ac:picMkLst>
            <pc:docMk/>
            <pc:sldMk cId="4004272488" sldId="284"/>
            <ac:picMk id="123" creationId="{326296D9-2F01-004D-83DC-A4E092A44846}"/>
          </ac:picMkLst>
        </pc:picChg>
        <pc:picChg chg="add mod modCrop">
          <ac:chgData name="Narang, Sonali" userId="9e80b397-6e2f-49b1-9374-ccdad8589140" providerId="ADAL" clId="{F81D094D-588F-3F49-A3F9-58CC1A6CC615}" dt="2021-12-01T21:25:59.806" v="3522" actId="1076"/>
          <ac:picMkLst>
            <pc:docMk/>
            <pc:sldMk cId="4004272488" sldId="284"/>
            <ac:picMk id="125" creationId="{0C9C66A5-8688-C740-97CB-5231C1238BAD}"/>
          </ac:picMkLst>
        </pc:picChg>
        <pc:picChg chg="add del mod">
          <ac:chgData name="Narang, Sonali" userId="9e80b397-6e2f-49b1-9374-ccdad8589140" providerId="ADAL" clId="{F81D094D-588F-3F49-A3F9-58CC1A6CC615}" dt="2021-12-01T18:52:32.091" v="3202" actId="478"/>
          <ac:picMkLst>
            <pc:docMk/>
            <pc:sldMk cId="4004272488" sldId="284"/>
            <ac:picMk id="127" creationId="{283916D7-6E0A-FD4B-8626-4928455688DE}"/>
          </ac:picMkLst>
        </pc:picChg>
        <pc:picChg chg="add del mod">
          <ac:chgData name="Narang, Sonali" userId="9e80b397-6e2f-49b1-9374-ccdad8589140" providerId="ADAL" clId="{F81D094D-588F-3F49-A3F9-58CC1A6CC615}" dt="2021-12-01T18:55:21.113" v="3211" actId="478"/>
          <ac:picMkLst>
            <pc:docMk/>
            <pc:sldMk cId="4004272488" sldId="284"/>
            <ac:picMk id="129" creationId="{C227C83A-F669-7C4D-93E5-FAA0EFFA3418}"/>
          </ac:picMkLst>
        </pc:picChg>
        <pc:picChg chg="add del mod">
          <ac:chgData name="Narang, Sonali" userId="9e80b397-6e2f-49b1-9374-ccdad8589140" providerId="ADAL" clId="{F81D094D-588F-3F49-A3F9-58CC1A6CC615}" dt="2021-12-01T18:55:57.057" v="3215" actId="478"/>
          <ac:picMkLst>
            <pc:docMk/>
            <pc:sldMk cId="4004272488" sldId="284"/>
            <ac:picMk id="131" creationId="{DF0617CB-E486-2743-8F3D-15CD2A42EC20}"/>
          </ac:picMkLst>
        </pc:picChg>
        <pc:picChg chg="add del mod">
          <ac:chgData name="Narang, Sonali" userId="9e80b397-6e2f-49b1-9374-ccdad8589140" providerId="ADAL" clId="{F81D094D-588F-3F49-A3F9-58CC1A6CC615}" dt="2021-12-01T18:56:46.503" v="3219" actId="478"/>
          <ac:picMkLst>
            <pc:docMk/>
            <pc:sldMk cId="4004272488" sldId="284"/>
            <ac:picMk id="133" creationId="{0756E6AF-91F3-A549-9B31-2F4FBA409F50}"/>
          </ac:picMkLst>
        </pc:picChg>
        <pc:picChg chg="add mod modCrop">
          <ac:chgData name="Narang, Sonali" userId="9e80b397-6e2f-49b1-9374-ccdad8589140" providerId="ADAL" clId="{F81D094D-588F-3F49-A3F9-58CC1A6CC615}" dt="2021-12-01T19:07:30.980" v="3450" actId="732"/>
          <ac:picMkLst>
            <pc:docMk/>
            <pc:sldMk cId="4004272488" sldId="284"/>
            <ac:picMk id="135" creationId="{B9B95728-CDEF-B844-9DE6-8EA351E88EE8}"/>
          </ac:picMkLst>
        </pc:picChg>
        <pc:picChg chg="add mod modCrop">
          <ac:chgData name="Narang, Sonali" userId="9e80b397-6e2f-49b1-9374-ccdad8589140" providerId="ADAL" clId="{F81D094D-588F-3F49-A3F9-58CC1A6CC615}" dt="2021-12-01T19:00:46.294" v="3273" actId="408"/>
          <ac:picMkLst>
            <pc:docMk/>
            <pc:sldMk cId="4004272488" sldId="284"/>
            <ac:picMk id="137" creationId="{208AECE9-4A6F-B243-8DB1-8CA558FBED72}"/>
          </ac:picMkLst>
        </pc:picChg>
        <pc:picChg chg="add mod modCrop">
          <ac:chgData name="Narang, Sonali" userId="9e80b397-6e2f-49b1-9374-ccdad8589140" providerId="ADAL" clId="{F81D094D-588F-3F49-A3F9-58CC1A6CC615}" dt="2021-12-01T19:07:35.790" v="3451" actId="732"/>
          <ac:picMkLst>
            <pc:docMk/>
            <pc:sldMk cId="4004272488" sldId="284"/>
            <ac:picMk id="139" creationId="{FC2245F0-410F-BB4F-A1AD-9A9244B22323}"/>
          </ac:picMkLst>
        </pc:picChg>
        <pc:picChg chg="add mod modCrop">
          <ac:chgData name="Narang, Sonali" userId="9e80b397-6e2f-49b1-9374-ccdad8589140" providerId="ADAL" clId="{F81D094D-588F-3F49-A3F9-58CC1A6CC615}" dt="2021-12-01T19:05:04.132" v="3425" actId="1037"/>
          <ac:picMkLst>
            <pc:docMk/>
            <pc:sldMk cId="4004272488" sldId="284"/>
            <ac:picMk id="141" creationId="{CD205847-80EB-4D4D-AA0C-006B69AE5386}"/>
          </ac:picMkLst>
        </pc:pic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61" creationId="{76DD902A-73BD-9746-81AE-E21B6A0E9640}"/>
          </ac:cxnSpMkLst>
        </pc:cxn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62" creationId="{7E70767D-D308-E64A-8A04-8870FD349A49}"/>
          </ac:cxnSpMkLst>
        </pc:cxn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64" creationId="{F55E6BB4-FA58-FF45-9DD4-78EDCE86934A}"/>
          </ac:cxnSpMkLst>
        </pc:cxn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69" creationId="{87F3FA5C-1730-2841-98F7-F223B2DDD0AE}"/>
          </ac:cxnSpMkLst>
        </pc:cxn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70" creationId="{C5B9695B-2176-444C-8924-7707C10D4FD8}"/>
          </ac:cxnSpMkLst>
        </pc:cxnChg>
        <pc:cxnChg chg="add del mod">
          <ac:chgData name="Narang, Sonali" userId="9e80b397-6e2f-49b1-9374-ccdad8589140" providerId="ADAL" clId="{F81D094D-588F-3F49-A3F9-58CC1A6CC615}" dt="2021-12-01T17:20:19.013" v="2966" actId="478"/>
          <ac:cxnSpMkLst>
            <pc:docMk/>
            <pc:sldMk cId="4004272488" sldId="284"/>
            <ac:cxnSpMk id="71" creationId="{7C79EFBE-47D3-8141-9629-883BCB9A6B4F}"/>
          </ac:cxnSpMkLst>
        </pc:cxnChg>
      </pc:sldChg>
      <pc:sldChg chg="modSp mod modNotesTx">
        <pc:chgData name="Narang, Sonali" userId="9e80b397-6e2f-49b1-9374-ccdad8589140" providerId="ADAL" clId="{F81D094D-588F-3F49-A3F9-58CC1A6CC615}" dt="2021-11-29T17:54:34.446" v="1445" actId="20577"/>
        <pc:sldMkLst>
          <pc:docMk/>
          <pc:sldMk cId="2252998334" sldId="285"/>
        </pc:sldMkLst>
        <pc:spChg chg="mod">
          <ac:chgData name="Narang, Sonali" userId="9e80b397-6e2f-49b1-9374-ccdad8589140" providerId="ADAL" clId="{F81D094D-588F-3F49-A3F9-58CC1A6CC615}" dt="2021-11-29T17:54:34.446" v="1445" actId="20577"/>
          <ac:spMkLst>
            <pc:docMk/>
            <pc:sldMk cId="2252998334" sldId="285"/>
            <ac:spMk id="5" creationId="{FAFFEC37-A0C5-5846-8534-22E3DEF6CEF4}"/>
          </ac:spMkLst>
        </pc:spChg>
      </pc:sldChg>
      <pc:sldChg chg="addSp delSp modSp add mod ord">
        <pc:chgData name="Narang, Sonali" userId="9e80b397-6e2f-49b1-9374-ccdad8589140" providerId="ADAL" clId="{F81D094D-588F-3F49-A3F9-58CC1A6CC615}" dt="2021-11-29T18:02:03.939" v="1545" actId="20577"/>
        <pc:sldMkLst>
          <pc:docMk/>
          <pc:sldMk cId="2363090238" sldId="286"/>
        </pc:sldMkLst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19" creationId="{9E40459F-EA2D-304F-A66A-4FABD61EA034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22" creationId="{85685F96-CE13-6F4B-B868-A1A4B0AEA53E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23" creationId="{8C97CB45-632D-7240-A18A-E83E126C2573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25" creationId="{BAD9AE42-BBAF-8449-B985-4A46C79B9F3C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0" creationId="{7ACB5BE7-3750-354F-BF4C-95F6EDD5031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1" creationId="{341A631A-1777-0447-900E-B6690647AEBF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2" creationId="{2FCA175B-D098-3040-96A0-E1CB2AF02A09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3" creationId="{71B7BE0F-8079-D24F-8411-0CF44CBEED68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4" creationId="{77045A3D-3DE2-724D-A0DE-831C705F0FFF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5" creationId="{D54E4A4C-F4AA-584E-A51A-B83D86D4D969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6" creationId="{C05C3F6E-9398-FA4D-B24D-4EC87DB00CE5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7" creationId="{3B8DD1F7-061D-FF49-887D-AC918DB64D9D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8" creationId="{87286582-DCD4-B146-AE48-6F1BA967D960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39" creationId="{1859D75C-A3EC-6B4E-85FF-CC76E9BB474A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40" creationId="{22BF3F78-9E90-A140-B5FE-E78BB97638AD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41" creationId="{4909FC66-2BD7-7643-AF2C-B1FB13B2D35B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42" creationId="{31A162AF-B0AF-AF49-AFBD-7188D45F6D6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43" creationId="{301409DF-33C7-D540-AE0B-FE95B015D313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44" creationId="{F7B292A7-E9A1-B040-BEB5-8140BDA5B09A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58" creationId="{8A4E17D2-A9B7-8044-895A-AC674A0FD76A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59" creationId="{F5C8B535-6BAA-2349-B109-5489C05984C0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60" creationId="{CC26D8E8-C042-854D-A356-CAF991A8989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68" creationId="{7AD07C9B-46FC-1448-9E9D-F76907AED111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70" creationId="{27BBB433-91E5-074E-B9C9-96296C2BEA6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71" creationId="{FFE1D916-9EF9-3047-A3B4-466BD5E3DCA3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73" creationId="{7AE29F2C-5048-E941-A1E5-C20BF17D91A4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78" creationId="{9935C82D-7402-FD42-AA2C-F92C8E224FDD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79" creationId="{34D63E6E-0E55-5743-80F7-78CB260021AC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0" creationId="{153F3E82-6F3B-DC4F-8C30-D8E97AB2E78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1" creationId="{7FCB25B7-0222-614B-A0A5-7D9971973DC4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2" creationId="{DC4838C5-DBDA-5E4F-83EA-021ADF2D0B4F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3" creationId="{193B9BCA-AC9D-7846-B83F-7F8A67D6A14F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4" creationId="{AF0B3B0B-0FC5-5B4D-8FBA-AD42211EF47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5" creationId="{CBF94B23-6C24-274F-9CE9-2E27D3727272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6" creationId="{B236DB49-C713-0F49-8D62-3DE8F11C4EF6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7" creationId="{67B4D711-4E11-F745-8D47-B3654A592651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8" creationId="{18EC1071-3ACC-9D45-BFFD-428761A4A7FB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89" creationId="{11BA5F35-2B8D-974D-ADA0-C7B38F34D463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0" creationId="{C881CAD3-B3B6-CC48-A461-2155A4772E45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1" creationId="{2C7031A4-4A83-0143-8008-6219DCC10441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2" creationId="{23B9EB42-391F-6642-881B-089F4430C5E6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3" creationId="{A7E43A38-DC14-764E-A968-CA5CF78DE6EE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4" creationId="{5EF66AA2-0789-3840-97E3-64747C7D2FBD}"/>
          </ac:spMkLst>
        </pc:spChg>
        <pc:spChg chg="mod">
          <ac:chgData name="Narang, Sonali" userId="9e80b397-6e2f-49b1-9374-ccdad8589140" providerId="ADAL" clId="{F81D094D-588F-3F49-A3F9-58CC1A6CC615}" dt="2021-11-29T18:01:43.953" v="1540"/>
          <ac:spMkLst>
            <pc:docMk/>
            <pc:sldMk cId="2363090238" sldId="286"/>
            <ac:spMk id="95" creationId="{92F2BD78-709C-A445-886A-A2FEC2113F02}"/>
          </ac:spMkLst>
        </pc:spChg>
        <pc:spChg chg="add mod">
          <ac:chgData name="Narang, Sonali" userId="9e80b397-6e2f-49b1-9374-ccdad8589140" providerId="ADAL" clId="{F81D094D-588F-3F49-A3F9-58CC1A6CC615}" dt="2021-11-29T18:01:52.631" v="1541" actId="1076"/>
          <ac:spMkLst>
            <pc:docMk/>
            <pc:sldMk cId="2363090238" sldId="286"/>
            <ac:spMk id="99" creationId="{A6CF131F-A22F-0D4F-BC16-1F904597B70D}"/>
          </ac:spMkLst>
        </pc:spChg>
        <pc:spChg chg="add mod">
          <ac:chgData name="Narang, Sonali" userId="9e80b397-6e2f-49b1-9374-ccdad8589140" providerId="ADAL" clId="{F81D094D-588F-3F49-A3F9-58CC1A6CC615}" dt="2021-11-29T18:01:52.631" v="1541" actId="1076"/>
          <ac:spMkLst>
            <pc:docMk/>
            <pc:sldMk cId="2363090238" sldId="286"/>
            <ac:spMk id="100" creationId="{C1DAD01B-B0ED-F74F-B46D-C8C31DDDF537}"/>
          </ac:spMkLst>
        </pc:spChg>
        <pc:spChg chg="add mod">
          <ac:chgData name="Narang, Sonali" userId="9e80b397-6e2f-49b1-9374-ccdad8589140" providerId="ADAL" clId="{F81D094D-588F-3F49-A3F9-58CC1A6CC615}" dt="2021-11-29T18:02:03.939" v="1545" actId="20577"/>
          <ac:spMkLst>
            <pc:docMk/>
            <pc:sldMk cId="2363090238" sldId="286"/>
            <ac:spMk id="101" creationId="{5D5CA9D1-4434-2546-9649-E09C57218793}"/>
          </ac:spMkLst>
        </pc:spChg>
        <pc:grpChg chg="add mod">
          <ac:chgData name="Narang, Sonali" userId="9e80b397-6e2f-49b1-9374-ccdad8589140" providerId="ADAL" clId="{F81D094D-588F-3F49-A3F9-58CC1A6CC615}" dt="2021-11-29T18:01:52.631" v="1541" actId="1076"/>
          <ac:grpSpMkLst>
            <pc:docMk/>
            <pc:sldMk cId="2363090238" sldId="286"/>
            <ac:grpSpMk id="15" creationId="{FD22AA87-E326-E24C-81D2-69BC843CB881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16" creationId="{31EF80B3-4D0A-A144-94B6-C48402D9BB75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1" creationId="{E8F81446-1D47-C44A-8C75-8B4EA842C9D4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4" creationId="{D11F9376-0BA5-1D4E-9244-08887A48B0F7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6" creationId="{238CA40F-15D7-6C4E-9AD4-AC836120AD97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7" creationId="{5BC5B9DF-2280-1647-A860-203E04BE74D1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8" creationId="{3B205C8F-E5CF-7E4F-9FEF-58A1CAAA9DD2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29" creationId="{181CCA7E-A89D-B04B-939A-3DB203E5D0D3}"/>
          </ac:grpSpMkLst>
        </pc:grpChg>
        <pc:grpChg chg="del mod">
          <ac:chgData name="Narang, Sonali" userId="9e80b397-6e2f-49b1-9374-ccdad8589140" providerId="ADAL" clId="{F81D094D-588F-3F49-A3F9-58CC1A6CC615}" dt="2021-11-29T18:01:19.718" v="1536" actId="478"/>
          <ac:grpSpMkLst>
            <pc:docMk/>
            <pc:sldMk cId="2363090238" sldId="286"/>
            <ac:grpSpMk id="47" creationId="{4B802D37-9378-E54E-99B5-1E00E308EBB8}"/>
          </ac:grpSpMkLst>
        </pc:grpChg>
        <pc:grpChg chg="add mod">
          <ac:chgData name="Narang, Sonali" userId="9e80b397-6e2f-49b1-9374-ccdad8589140" providerId="ADAL" clId="{F81D094D-588F-3F49-A3F9-58CC1A6CC615}" dt="2021-11-29T18:01:52.631" v="1541" actId="1076"/>
          <ac:grpSpMkLst>
            <pc:docMk/>
            <pc:sldMk cId="2363090238" sldId="286"/>
            <ac:grpSpMk id="64" creationId="{6E509F57-A7C6-7041-B6B6-87A1D93E0DF6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65" creationId="{A9500557-8D4C-0742-B6FC-06CD748C02F6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69" creationId="{5E7BA25E-5D15-914E-AF94-11953DE167ED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72" creationId="{D02A18A0-3838-1A4B-9DE1-6AA9C46FB341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74" creationId="{1AA94F77-BCB6-0D47-811C-FCE56AD46B79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75" creationId="{8C83B07A-36A7-424E-9F9E-3C48DFEFCCD9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76" creationId="{9572D97D-E9E4-BA4D-A73A-3F20C2FE4EB0}"/>
          </ac:grpSpMkLst>
        </pc:grpChg>
        <pc:grpChg chg="mod">
          <ac:chgData name="Narang, Sonali" userId="9e80b397-6e2f-49b1-9374-ccdad8589140" providerId="ADAL" clId="{F81D094D-588F-3F49-A3F9-58CC1A6CC615}" dt="2021-11-29T18:01:43.953" v="1540"/>
          <ac:grpSpMkLst>
            <pc:docMk/>
            <pc:sldMk cId="2363090238" sldId="286"/>
            <ac:grpSpMk id="77" creationId="{D0B22413-A675-6D4C-A1AF-C1EABB953A99}"/>
          </ac:grpSpMkLst>
        </pc:grpChg>
        <pc:picChg chg="mod">
          <ac:chgData name="Narang, Sonali" userId="9e80b397-6e2f-49b1-9374-ccdad8589140" providerId="ADAL" clId="{F81D094D-588F-3F49-A3F9-58CC1A6CC615}" dt="2021-11-29T18:01:43.953" v="1540"/>
          <ac:picMkLst>
            <pc:docMk/>
            <pc:sldMk cId="2363090238" sldId="286"/>
            <ac:picMk id="17" creationId="{43A1CE6A-79B0-9B4D-BFE9-CABBDD902CD3}"/>
          </ac:picMkLst>
        </pc:picChg>
        <pc:picChg chg="mod">
          <ac:chgData name="Narang, Sonali" userId="9e80b397-6e2f-49b1-9374-ccdad8589140" providerId="ADAL" clId="{F81D094D-588F-3F49-A3F9-58CC1A6CC615}" dt="2021-11-29T18:01:43.953" v="1540"/>
          <ac:picMkLst>
            <pc:docMk/>
            <pc:sldMk cId="2363090238" sldId="286"/>
            <ac:picMk id="18" creationId="{9FF1F370-CC5C-7140-9037-FF8847D76E50}"/>
          </ac:picMkLst>
        </pc:picChg>
        <pc:picChg chg="mod">
          <ac:chgData name="Narang, Sonali" userId="9e80b397-6e2f-49b1-9374-ccdad8589140" providerId="ADAL" clId="{F81D094D-588F-3F49-A3F9-58CC1A6CC615}" dt="2021-11-29T18:01:43.953" v="1540"/>
          <ac:picMkLst>
            <pc:docMk/>
            <pc:sldMk cId="2363090238" sldId="286"/>
            <ac:picMk id="20" creationId="{D2BEF617-C267-B447-B7E8-73F4A6E70452}"/>
          </ac:picMkLst>
        </pc:picChg>
        <pc:picChg chg="mod">
          <ac:chgData name="Narang, Sonali" userId="9e80b397-6e2f-49b1-9374-ccdad8589140" providerId="ADAL" clId="{F81D094D-588F-3F49-A3F9-58CC1A6CC615}" dt="2021-11-29T18:01:43.953" v="1540"/>
          <ac:picMkLst>
            <pc:docMk/>
            <pc:sldMk cId="2363090238" sldId="286"/>
            <ac:picMk id="66" creationId="{4678C378-8E87-5546-8C63-9268156C1D15}"/>
          </ac:picMkLst>
        </pc:picChg>
        <pc:picChg chg="mod">
          <ac:chgData name="Narang, Sonali" userId="9e80b397-6e2f-49b1-9374-ccdad8589140" providerId="ADAL" clId="{F81D094D-588F-3F49-A3F9-58CC1A6CC615}" dt="2021-11-29T18:01:43.953" v="1540"/>
          <ac:picMkLst>
            <pc:docMk/>
            <pc:sldMk cId="2363090238" sldId="286"/>
            <ac:picMk id="67" creationId="{7E5F91F5-98DD-B546-B5AB-69E09B675319}"/>
          </ac:picMkLst>
        </pc:pic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61" creationId="{F057B336-3E39-024F-B612-34FD93ADE26C}"/>
          </ac:cxnSpMkLst>
        </pc:cxn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62" creationId="{D83A82A8-C3F5-9A4B-AF0B-2F77717B9CAC}"/>
          </ac:cxnSpMkLst>
        </pc:cxn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63" creationId="{45887B02-4019-284B-8211-D231E27F5326}"/>
          </ac:cxnSpMkLst>
        </pc:cxn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96" creationId="{F83DC9E1-BB01-5F48-8706-050228DBFE98}"/>
          </ac:cxnSpMkLst>
        </pc:cxn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97" creationId="{C9BA93AF-F7B7-0444-A684-3F52D4F19DD0}"/>
          </ac:cxnSpMkLst>
        </pc:cxnChg>
        <pc:cxnChg chg="mod">
          <ac:chgData name="Narang, Sonali" userId="9e80b397-6e2f-49b1-9374-ccdad8589140" providerId="ADAL" clId="{F81D094D-588F-3F49-A3F9-58CC1A6CC615}" dt="2021-11-29T18:01:43.953" v="1540"/>
          <ac:cxnSpMkLst>
            <pc:docMk/>
            <pc:sldMk cId="2363090238" sldId="286"/>
            <ac:cxnSpMk id="98" creationId="{D2471E14-1928-214A-85BC-D055F9DAAA88}"/>
          </ac:cxnSpMkLst>
        </pc:cxnChg>
      </pc:sldChg>
      <pc:sldChg chg="addSp delSp modSp add mod">
        <pc:chgData name="Narang, Sonali" userId="9e80b397-6e2f-49b1-9374-ccdad8589140" providerId="ADAL" clId="{F81D094D-588F-3F49-A3F9-58CC1A6CC615}" dt="2021-11-30T14:32:52.268" v="1919" actId="1038"/>
        <pc:sldMkLst>
          <pc:docMk/>
          <pc:sldMk cId="1525852547" sldId="287"/>
        </pc:sldMkLst>
        <pc:spChg chg="mod">
          <ac:chgData name="Narang, Sonali" userId="9e80b397-6e2f-49b1-9374-ccdad8589140" providerId="ADAL" clId="{F81D094D-588F-3F49-A3F9-58CC1A6CC615}" dt="2021-11-30T14:32:25.387" v="1907" actId="1076"/>
          <ac:spMkLst>
            <pc:docMk/>
            <pc:sldMk cId="1525852547" sldId="287"/>
            <ac:spMk id="7" creationId="{4C5F5CAE-FBFD-964D-A356-746AAC86DC9E}"/>
          </ac:spMkLst>
        </pc:spChg>
        <pc:spChg chg="add mod">
          <ac:chgData name="Narang, Sonali" userId="9e80b397-6e2f-49b1-9374-ccdad8589140" providerId="ADAL" clId="{F81D094D-588F-3F49-A3F9-58CC1A6CC615}" dt="2021-11-30T14:32:11.331" v="1905" actId="1076"/>
          <ac:spMkLst>
            <pc:docMk/>
            <pc:sldMk cId="1525852547" sldId="287"/>
            <ac:spMk id="69" creationId="{FAC97054-BAE1-FC49-AC42-478F2DF03724}"/>
          </ac:spMkLst>
        </pc:spChg>
        <pc:grpChg chg="del">
          <ac:chgData name="Narang, Sonali" userId="9e80b397-6e2f-49b1-9374-ccdad8589140" providerId="ADAL" clId="{F81D094D-588F-3F49-A3F9-58CC1A6CC615}" dt="2021-11-30T14:28:33.433" v="1865" actId="478"/>
          <ac:grpSpMkLst>
            <pc:docMk/>
            <pc:sldMk cId="1525852547" sldId="287"/>
            <ac:grpSpMk id="14" creationId="{86D7D6E9-6736-D243-B10A-A0E8A40C0FDA}"/>
          </ac:grpSpMkLst>
        </pc:grpChg>
        <pc:grpChg chg="del">
          <ac:chgData name="Narang, Sonali" userId="9e80b397-6e2f-49b1-9374-ccdad8589140" providerId="ADAL" clId="{F81D094D-588F-3F49-A3F9-58CC1A6CC615}" dt="2021-11-30T14:28:33.433" v="1865" actId="478"/>
          <ac:grpSpMkLst>
            <pc:docMk/>
            <pc:sldMk cId="1525852547" sldId="287"/>
            <ac:grpSpMk id="19" creationId="{6FB40037-B603-9443-A847-58CB44679B55}"/>
          </ac:grpSpMkLst>
        </pc:grpChg>
        <pc:grpChg chg="del">
          <ac:chgData name="Narang, Sonali" userId="9e80b397-6e2f-49b1-9374-ccdad8589140" providerId="ADAL" clId="{F81D094D-588F-3F49-A3F9-58CC1A6CC615}" dt="2021-11-30T14:28:33.433" v="1865" actId="478"/>
          <ac:grpSpMkLst>
            <pc:docMk/>
            <pc:sldMk cId="1525852547" sldId="287"/>
            <ac:grpSpMk id="24" creationId="{27C39882-C3D6-6943-83E0-2D2C3AC6B4EE}"/>
          </ac:grpSpMkLst>
        </pc:grpChg>
        <pc:grpChg chg="del">
          <ac:chgData name="Narang, Sonali" userId="9e80b397-6e2f-49b1-9374-ccdad8589140" providerId="ADAL" clId="{F81D094D-588F-3F49-A3F9-58CC1A6CC615}" dt="2021-11-30T14:28:33.433" v="1865" actId="478"/>
          <ac:grpSpMkLst>
            <pc:docMk/>
            <pc:sldMk cId="1525852547" sldId="287"/>
            <ac:grpSpMk id="31" creationId="{D470D811-2477-3546-A8D8-048846B3651A}"/>
          </ac:grpSpMkLst>
        </pc:grpChg>
        <pc:picChg chg="add mod">
          <ac:chgData name="Narang, Sonali" userId="9e80b397-6e2f-49b1-9374-ccdad8589140" providerId="ADAL" clId="{F81D094D-588F-3F49-A3F9-58CC1A6CC615}" dt="2021-11-30T14:32:48.566" v="1914" actId="1038"/>
          <ac:picMkLst>
            <pc:docMk/>
            <pc:sldMk cId="1525852547" sldId="287"/>
            <ac:picMk id="3" creationId="{B271A6ED-AB7A-904C-9688-AF011E3E88E6}"/>
          </ac:picMkLst>
        </pc:picChg>
        <pc:picChg chg="add mod">
          <ac:chgData name="Narang, Sonali" userId="9e80b397-6e2f-49b1-9374-ccdad8589140" providerId="ADAL" clId="{F81D094D-588F-3F49-A3F9-58CC1A6CC615}" dt="2021-11-30T14:32:41.711" v="1909" actId="1076"/>
          <ac:picMkLst>
            <pc:docMk/>
            <pc:sldMk cId="1525852547" sldId="287"/>
            <ac:picMk id="8" creationId="{7E3A4B83-EC23-FE43-A915-66708BDA86BB}"/>
          </ac:picMkLst>
        </pc:picChg>
        <pc:picChg chg="add mod">
          <ac:chgData name="Narang, Sonali" userId="9e80b397-6e2f-49b1-9374-ccdad8589140" providerId="ADAL" clId="{F81D094D-588F-3F49-A3F9-58CC1A6CC615}" dt="2021-11-30T14:32:52.268" v="1919" actId="1038"/>
          <ac:picMkLst>
            <pc:docMk/>
            <pc:sldMk cId="1525852547" sldId="287"/>
            <ac:picMk id="10" creationId="{9B822C3D-6EA5-7B45-94EA-D0A27DB1F383}"/>
          </ac:picMkLst>
        </pc:picChg>
        <pc:picChg chg="del">
          <ac:chgData name="Narang, Sonali" userId="9e80b397-6e2f-49b1-9374-ccdad8589140" providerId="ADAL" clId="{F81D094D-588F-3F49-A3F9-58CC1A6CC615}" dt="2021-11-30T14:28:36.798" v="1867" actId="478"/>
          <ac:picMkLst>
            <pc:docMk/>
            <pc:sldMk cId="1525852547" sldId="287"/>
            <ac:picMk id="64" creationId="{BDC1A47A-9479-3E4D-A349-CF06699F2793}"/>
          </ac:picMkLst>
        </pc:picChg>
        <pc:picChg chg="del">
          <ac:chgData name="Narang, Sonali" userId="9e80b397-6e2f-49b1-9374-ccdad8589140" providerId="ADAL" clId="{F81D094D-588F-3F49-A3F9-58CC1A6CC615}" dt="2021-11-30T14:28:35.381" v="1866" actId="478"/>
          <ac:picMkLst>
            <pc:docMk/>
            <pc:sldMk cId="1525852547" sldId="287"/>
            <ac:picMk id="66" creationId="{3947B4BD-5497-734B-B72A-856B61E23828}"/>
          </ac:picMkLst>
        </pc:picChg>
        <pc:picChg chg="del">
          <ac:chgData name="Narang, Sonali" userId="9e80b397-6e2f-49b1-9374-ccdad8589140" providerId="ADAL" clId="{F81D094D-588F-3F49-A3F9-58CC1A6CC615}" dt="2021-11-30T14:28:35.381" v="1866" actId="478"/>
          <ac:picMkLst>
            <pc:docMk/>
            <pc:sldMk cId="1525852547" sldId="287"/>
            <ac:picMk id="67" creationId="{35277A42-A4F2-E644-8DD1-70306EA4FB98}"/>
          </ac:picMkLst>
        </pc:picChg>
        <pc:picChg chg="del">
          <ac:chgData name="Narang, Sonali" userId="9e80b397-6e2f-49b1-9374-ccdad8589140" providerId="ADAL" clId="{F81D094D-588F-3F49-A3F9-58CC1A6CC615}" dt="2021-11-30T14:28:35.381" v="1866" actId="478"/>
          <ac:picMkLst>
            <pc:docMk/>
            <pc:sldMk cId="1525852547" sldId="287"/>
            <ac:picMk id="68" creationId="{8F8E5938-471E-244A-AC6A-995ED39B84DC}"/>
          </ac:picMkLst>
        </pc:picChg>
        <pc:picChg chg="add mod">
          <ac:chgData name="Narang, Sonali" userId="9e80b397-6e2f-49b1-9374-ccdad8589140" providerId="ADAL" clId="{F81D094D-588F-3F49-A3F9-58CC1A6CC615}" dt="2021-11-30T14:32:19.711" v="1906" actId="167"/>
          <ac:picMkLst>
            <pc:docMk/>
            <pc:sldMk cId="1525852547" sldId="287"/>
            <ac:picMk id="70" creationId="{6CD412CC-8615-4F49-BFC7-1A42F0A16375}"/>
          </ac:picMkLst>
        </pc:picChg>
        <pc:picChg chg="add mod">
          <ac:chgData name="Narang, Sonali" userId="9e80b397-6e2f-49b1-9374-ccdad8589140" providerId="ADAL" clId="{F81D094D-588F-3F49-A3F9-58CC1A6CC615}" dt="2021-11-30T14:32:11.331" v="1905" actId="1076"/>
          <ac:picMkLst>
            <pc:docMk/>
            <pc:sldMk cId="1525852547" sldId="287"/>
            <ac:picMk id="71" creationId="{117DE466-397D-594C-BCD8-10C5E82EC2F8}"/>
          </ac:picMkLst>
        </pc:picChg>
        <pc:picChg chg="add mod">
          <ac:chgData name="Narang, Sonali" userId="9e80b397-6e2f-49b1-9374-ccdad8589140" providerId="ADAL" clId="{F81D094D-588F-3F49-A3F9-58CC1A6CC615}" dt="2021-11-30T14:32:11.331" v="1905" actId="1076"/>
          <ac:picMkLst>
            <pc:docMk/>
            <pc:sldMk cId="1525852547" sldId="287"/>
            <ac:picMk id="72" creationId="{D11FFE54-3A7D-234D-A5E5-D366414C28C3}"/>
          </ac:picMkLst>
        </pc:picChg>
      </pc:sldChg>
      <pc:sldChg chg="addSp delSp modSp add del mod">
        <pc:chgData name="Narang, Sonali" userId="9e80b397-6e2f-49b1-9374-ccdad8589140" providerId="ADAL" clId="{F81D094D-588F-3F49-A3F9-58CC1A6CC615}" dt="2021-11-30T17:16:25.761" v="2377" actId="2696"/>
        <pc:sldMkLst>
          <pc:docMk/>
          <pc:sldMk cId="1596410662" sldId="288"/>
        </pc:sldMkLst>
        <pc:spChg chg="add mod">
          <ac:chgData name="Narang, Sonali" userId="9e80b397-6e2f-49b1-9374-ccdad8589140" providerId="ADAL" clId="{F81D094D-588F-3F49-A3F9-58CC1A6CC615}" dt="2021-11-30T17:15:55.921" v="2369" actId="1076"/>
          <ac:spMkLst>
            <pc:docMk/>
            <pc:sldMk cId="1596410662" sldId="288"/>
            <ac:spMk id="49" creationId="{78A49470-9360-3941-8111-AEE8CBCC129D}"/>
          </ac:spMkLst>
        </pc:spChg>
        <pc:spChg chg="add del mod">
          <ac:chgData name="Narang, Sonali" userId="9e80b397-6e2f-49b1-9374-ccdad8589140" providerId="ADAL" clId="{F81D094D-588F-3F49-A3F9-58CC1A6CC615}" dt="2021-11-30T17:16:20.110" v="2374" actId="21"/>
          <ac:spMkLst>
            <pc:docMk/>
            <pc:sldMk cId="1596410662" sldId="288"/>
            <ac:spMk id="50" creationId="{C146923E-F4AC-B042-9FF6-4F949DED422A}"/>
          </ac:spMkLst>
        </pc:spChg>
        <pc:spChg chg="del">
          <ac:chgData name="Narang, Sonali" userId="9e80b397-6e2f-49b1-9374-ccdad8589140" providerId="ADAL" clId="{F81D094D-588F-3F49-A3F9-58CC1A6CC615}" dt="2021-11-30T17:15:48.159" v="2366" actId="478"/>
          <ac:spMkLst>
            <pc:docMk/>
            <pc:sldMk cId="1596410662" sldId="288"/>
            <ac:spMk id="124" creationId="{2BE84DAC-7C05-C445-9DD3-6B3EE69AFBF9}"/>
          </ac:spMkLst>
        </pc:spChg>
        <pc:spChg chg="del">
          <ac:chgData name="Narang, Sonali" userId="9e80b397-6e2f-49b1-9374-ccdad8589140" providerId="ADAL" clId="{F81D094D-588F-3F49-A3F9-58CC1A6CC615}" dt="2021-11-30T17:15:48.159" v="2366" actId="478"/>
          <ac:spMkLst>
            <pc:docMk/>
            <pc:sldMk cId="1596410662" sldId="288"/>
            <ac:spMk id="125" creationId="{F77578BF-D28B-AC46-B202-F16CA20F451A}"/>
          </ac:spMkLst>
        </pc:spChg>
        <pc:grpChg chg="del">
          <ac:chgData name="Narang, Sonali" userId="9e80b397-6e2f-49b1-9374-ccdad8589140" providerId="ADAL" clId="{F81D094D-588F-3F49-A3F9-58CC1A6CC615}" dt="2021-11-30T17:15:48.159" v="2366" actId="478"/>
          <ac:grpSpMkLst>
            <pc:docMk/>
            <pc:sldMk cId="1596410662" sldId="288"/>
            <ac:grpSpMk id="117" creationId="{B05B94FA-BBA9-A64D-8CA4-F0D3B7616FE1}"/>
          </ac:grpSpMkLst>
        </pc:grpChg>
        <pc:picChg chg="del">
          <ac:chgData name="Narang, Sonali" userId="9e80b397-6e2f-49b1-9374-ccdad8589140" providerId="ADAL" clId="{F81D094D-588F-3F49-A3F9-58CC1A6CC615}" dt="2021-11-30T17:15:57.286" v="2370" actId="478"/>
          <ac:picMkLst>
            <pc:docMk/>
            <pc:sldMk cId="1596410662" sldId="288"/>
            <ac:picMk id="13" creationId="{8E13C50A-DD07-A546-AF0A-4883E062BFDF}"/>
          </ac:picMkLst>
        </pc:picChg>
        <pc:picChg chg="add del mod">
          <ac:chgData name="Narang, Sonali" userId="9e80b397-6e2f-49b1-9374-ccdad8589140" providerId="ADAL" clId="{F81D094D-588F-3F49-A3F9-58CC1A6CC615}" dt="2021-11-30T17:16:20.110" v="2374" actId="21"/>
          <ac:picMkLst>
            <pc:docMk/>
            <pc:sldMk cId="1596410662" sldId="288"/>
            <ac:picMk id="46" creationId="{76AC4853-E46A-8A4D-A604-DC4BDD2DA8DF}"/>
          </ac:picMkLst>
        </pc:picChg>
        <pc:picChg chg="add del mod">
          <ac:chgData name="Narang, Sonali" userId="9e80b397-6e2f-49b1-9374-ccdad8589140" providerId="ADAL" clId="{F81D094D-588F-3F49-A3F9-58CC1A6CC615}" dt="2021-11-30T17:16:20.110" v="2374" actId="21"/>
          <ac:picMkLst>
            <pc:docMk/>
            <pc:sldMk cId="1596410662" sldId="288"/>
            <ac:picMk id="47" creationId="{35CAE81E-7955-0C48-9A28-F9FC2C2285B8}"/>
          </ac:picMkLst>
        </pc:picChg>
        <pc:picChg chg="add del mod">
          <ac:chgData name="Narang, Sonali" userId="9e80b397-6e2f-49b1-9374-ccdad8589140" providerId="ADAL" clId="{F81D094D-588F-3F49-A3F9-58CC1A6CC615}" dt="2021-11-30T17:16:20.110" v="2374" actId="21"/>
          <ac:picMkLst>
            <pc:docMk/>
            <pc:sldMk cId="1596410662" sldId="288"/>
            <ac:picMk id="48" creationId="{68690A58-58E0-D340-B823-0ED84FDC2DAD}"/>
          </ac:picMkLst>
        </pc:picChg>
        <pc:picChg chg="del">
          <ac:chgData name="Narang, Sonali" userId="9e80b397-6e2f-49b1-9374-ccdad8589140" providerId="ADAL" clId="{F81D094D-588F-3F49-A3F9-58CC1A6CC615}" dt="2021-11-30T17:15:57.286" v="2370" actId="478"/>
          <ac:picMkLst>
            <pc:docMk/>
            <pc:sldMk cId="1596410662" sldId="288"/>
            <ac:picMk id="105" creationId="{97BF178D-FAD3-E44E-B50E-E66B7B262246}"/>
          </ac:picMkLst>
        </pc:picChg>
        <pc:picChg chg="del">
          <ac:chgData name="Narang, Sonali" userId="9e80b397-6e2f-49b1-9374-ccdad8589140" providerId="ADAL" clId="{F81D094D-588F-3F49-A3F9-58CC1A6CC615}" dt="2021-11-30T17:15:52.313" v="2367" actId="478"/>
          <ac:picMkLst>
            <pc:docMk/>
            <pc:sldMk cId="1596410662" sldId="288"/>
            <ac:picMk id="167" creationId="{58CAA980-D1E6-AA4C-A334-C0D57A74D895}"/>
          </ac:picMkLst>
        </pc:picChg>
        <pc:picChg chg="del">
          <ac:chgData name="Narang, Sonali" userId="9e80b397-6e2f-49b1-9374-ccdad8589140" providerId="ADAL" clId="{F81D094D-588F-3F49-A3F9-58CC1A6CC615}" dt="2021-11-30T17:15:52.313" v="2367" actId="478"/>
          <ac:picMkLst>
            <pc:docMk/>
            <pc:sldMk cId="1596410662" sldId="288"/>
            <ac:picMk id="169" creationId="{5A30999A-89D7-8C40-9571-87F0979C7EAA}"/>
          </ac:picMkLst>
        </pc:picChg>
        <pc:picChg chg="del">
          <ac:chgData name="Narang, Sonali" userId="9e80b397-6e2f-49b1-9374-ccdad8589140" providerId="ADAL" clId="{F81D094D-588F-3F49-A3F9-58CC1A6CC615}" dt="2021-11-30T17:15:52.313" v="2367" actId="478"/>
          <ac:picMkLst>
            <pc:docMk/>
            <pc:sldMk cId="1596410662" sldId="288"/>
            <ac:picMk id="171" creationId="{9C4DDE62-3BC7-ED45-A82E-A3C21D506B79}"/>
          </ac:picMkLst>
        </pc:picChg>
      </pc:sldChg>
      <pc:sldChg chg="delSp modSp add mod">
        <pc:chgData name="Narang, Sonali" userId="9e80b397-6e2f-49b1-9374-ccdad8589140" providerId="ADAL" clId="{F81D094D-588F-3F49-A3F9-58CC1A6CC615}" dt="2021-12-06T16:35:52.477" v="3760" actId="20577"/>
        <pc:sldMkLst>
          <pc:docMk/>
          <pc:sldMk cId="4017312032" sldId="288"/>
        </pc:sldMkLst>
        <pc:spChg chg="mod">
          <ac:chgData name="Narang, Sonali" userId="9e80b397-6e2f-49b1-9374-ccdad8589140" providerId="ADAL" clId="{F81D094D-588F-3F49-A3F9-58CC1A6CC615}" dt="2021-12-06T16:35:52.477" v="3760" actId="20577"/>
          <ac:spMkLst>
            <pc:docMk/>
            <pc:sldMk cId="4017312032" sldId="288"/>
            <ac:spMk id="4" creationId="{F6669B9D-B042-D548-BD0F-97015091799B}"/>
          </ac:spMkLst>
        </pc:spChg>
        <pc:spChg chg="mod">
          <ac:chgData name="Narang, Sonali" userId="9e80b397-6e2f-49b1-9374-ccdad8589140" providerId="ADAL" clId="{F81D094D-588F-3F49-A3F9-58CC1A6CC615}" dt="2021-12-06T16:35:37.357" v="3735" actId="20577"/>
          <ac:spMkLst>
            <pc:docMk/>
            <pc:sldMk cId="4017312032" sldId="288"/>
            <ac:spMk id="7" creationId="{4C5F5CAE-FBFD-964D-A356-746AAC86DC9E}"/>
          </ac:spMkLst>
        </pc:spChg>
        <pc:spChg chg="del mod">
          <ac:chgData name="Narang, Sonali" userId="9e80b397-6e2f-49b1-9374-ccdad8589140" providerId="ADAL" clId="{F81D094D-588F-3F49-A3F9-58CC1A6CC615}" dt="2021-12-06T16:35:39.296" v="3737" actId="478"/>
          <ac:spMkLst>
            <pc:docMk/>
            <pc:sldMk cId="4017312032" sldId="288"/>
            <ac:spMk id="8" creationId="{8A9BAE78-C4FF-1843-94F6-3410EB884848}"/>
          </ac:spMkLst>
        </pc:spChg>
        <pc:spChg chg="del">
          <ac:chgData name="Narang, Sonali" userId="9e80b397-6e2f-49b1-9374-ccdad8589140" providerId="ADAL" clId="{F81D094D-588F-3F49-A3F9-58CC1A6CC615}" dt="2021-12-06T16:35:26.405" v="3731" actId="478"/>
          <ac:spMkLst>
            <pc:docMk/>
            <pc:sldMk cId="4017312032" sldId="288"/>
            <ac:spMk id="22" creationId="{815B8AA3-2588-D94F-B9D1-7042D5C89A34}"/>
          </ac:spMkLst>
        </pc:spChg>
        <pc:spChg chg="del">
          <ac:chgData name="Narang, Sonali" userId="9e80b397-6e2f-49b1-9374-ccdad8589140" providerId="ADAL" clId="{F81D094D-588F-3F49-A3F9-58CC1A6CC615}" dt="2021-12-06T16:35:30.872" v="3733" actId="478"/>
          <ac:spMkLst>
            <pc:docMk/>
            <pc:sldMk cId="4017312032" sldId="288"/>
            <ac:spMk id="29" creationId="{E4C2B977-FA04-3F48-B9BD-9F31456B3DDF}"/>
          </ac:spMkLst>
        </pc:spChg>
        <pc:spChg chg="del">
          <ac:chgData name="Narang, Sonali" userId="9e80b397-6e2f-49b1-9374-ccdad8589140" providerId="ADAL" clId="{F81D094D-588F-3F49-A3F9-58CC1A6CC615}" dt="2021-12-06T16:35:26.405" v="3731" actId="478"/>
          <ac:spMkLst>
            <pc:docMk/>
            <pc:sldMk cId="4017312032" sldId="288"/>
            <ac:spMk id="140" creationId="{B160352D-695D-184C-ACFE-154A13C25E06}"/>
          </ac:spMkLst>
        </pc:spChg>
        <pc:grpChg chg="del">
          <ac:chgData name="Narang, Sonali" userId="9e80b397-6e2f-49b1-9374-ccdad8589140" providerId="ADAL" clId="{F81D094D-588F-3F49-A3F9-58CC1A6CC615}" dt="2021-12-06T16:35:27.645" v="3732" actId="478"/>
          <ac:grpSpMkLst>
            <pc:docMk/>
            <pc:sldMk cId="4017312032" sldId="288"/>
            <ac:grpSpMk id="142" creationId="{7ECCC13B-D4CC-0648-8B6B-34B386F98D04}"/>
          </ac:grpSpMkLst>
        </pc:grpChg>
        <pc:picChg chg="del">
          <ac:chgData name="Narang, Sonali" userId="9e80b397-6e2f-49b1-9374-ccdad8589140" providerId="ADAL" clId="{F81D094D-588F-3F49-A3F9-58CC1A6CC615}" dt="2021-12-06T16:35:30.872" v="3733" actId="478"/>
          <ac:picMkLst>
            <pc:docMk/>
            <pc:sldMk cId="4017312032" sldId="288"/>
            <ac:picMk id="9" creationId="{582BC744-B55E-444D-9186-996C5EEEF91A}"/>
          </ac:picMkLst>
        </pc:picChg>
        <pc:picChg chg="del">
          <ac:chgData name="Narang, Sonali" userId="9e80b397-6e2f-49b1-9374-ccdad8589140" providerId="ADAL" clId="{F81D094D-588F-3F49-A3F9-58CC1A6CC615}" dt="2021-12-06T16:35:30.872" v="3733" actId="478"/>
          <ac:picMkLst>
            <pc:docMk/>
            <pc:sldMk cId="4017312032" sldId="288"/>
            <ac:picMk id="13" creationId="{1700A0E7-E7CE-114B-A2B5-15E8E6D46524}"/>
          </ac:picMkLst>
        </pc:picChg>
        <pc:picChg chg="del">
          <ac:chgData name="Narang, Sonali" userId="9e80b397-6e2f-49b1-9374-ccdad8589140" providerId="ADAL" clId="{F81D094D-588F-3F49-A3F9-58CC1A6CC615}" dt="2021-12-06T16:35:30.872" v="3733" actId="478"/>
          <ac:picMkLst>
            <pc:docMk/>
            <pc:sldMk cId="4017312032" sldId="288"/>
            <ac:picMk id="16" creationId="{49314A01-A50F-FE40-ACB7-0D83933DE24E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85" creationId="{C23CE7FA-8A81-974A-9461-9E446D5D22BE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15" creationId="{CDF0BAAE-1283-9347-A476-BAAAC8083BAD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17" creationId="{83EEABCA-B7F6-AA46-8E59-A59E409143FB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19" creationId="{0C34A903-91D3-1C48-A7CA-8CE6C0AF0A6A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21" creationId="{35A6EBFB-771F-A848-8EEF-3CAB0C1ECBB0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23" creationId="{326296D9-2F01-004D-83DC-A4E092A44846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25" creationId="{0C9C66A5-8688-C740-97CB-5231C1238BAD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35" creationId="{B9B95728-CDEF-B844-9DE6-8EA351E88EE8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37" creationId="{208AECE9-4A6F-B243-8DB1-8CA558FBED72}"/>
          </ac:picMkLst>
        </pc:picChg>
        <pc:picChg chg="del">
          <ac:chgData name="Narang, Sonali" userId="9e80b397-6e2f-49b1-9374-ccdad8589140" providerId="ADAL" clId="{F81D094D-588F-3F49-A3F9-58CC1A6CC615}" dt="2021-12-06T16:35:26.405" v="3731" actId="478"/>
          <ac:picMkLst>
            <pc:docMk/>
            <pc:sldMk cId="4017312032" sldId="288"/>
            <ac:picMk id="139" creationId="{FC2245F0-410F-BB4F-A1AD-9A9244B22323}"/>
          </ac:picMkLst>
        </pc:picChg>
      </pc:sldChg>
    </pc:docChg>
  </pc:docChgLst>
  <pc:docChgLst>
    <pc:chgData name="Narang, Sonali" userId="9e80b397-6e2f-49b1-9374-ccdad8589140" providerId="ADAL" clId="{6EE2BC00-DBDB-EC4A-82B9-AA9A11C4C476}"/>
    <pc:docChg chg="sldOrd">
      <pc:chgData name="Narang, Sonali" userId="9e80b397-6e2f-49b1-9374-ccdad8589140" providerId="ADAL" clId="{6EE2BC00-DBDB-EC4A-82B9-AA9A11C4C476}" dt="2021-08-31T19:50:09.549" v="0" actId="20578"/>
      <pc:docMkLst>
        <pc:docMk/>
      </pc:docMkLst>
      <pc:sldChg chg="ord">
        <pc:chgData name="Narang, Sonali" userId="9e80b397-6e2f-49b1-9374-ccdad8589140" providerId="ADAL" clId="{6EE2BC00-DBDB-EC4A-82B9-AA9A11C4C476}" dt="2021-08-31T19:50:09.549" v="0" actId="20578"/>
        <pc:sldMkLst>
          <pc:docMk/>
          <pc:sldMk cId="743684689" sldId="267"/>
        </pc:sldMkLst>
      </pc:sldChg>
      <pc:sldChg chg="ord">
        <pc:chgData name="Narang, Sonali" userId="9e80b397-6e2f-49b1-9374-ccdad8589140" providerId="ADAL" clId="{6EE2BC00-DBDB-EC4A-82B9-AA9A11C4C476}" dt="2021-08-31T19:50:09.549" v="0" actId="20578"/>
        <pc:sldMkLst>
          <pc:docMk/>
          <pc:sldMk cId="2499962631" sldId="271"/>
        </pc:sldMkLst>
      </pc:sldChg>
    </pc:docChg>
  </pc:docChgLst>
  <pc:docChgLst>
    <pc:chgData name="Narang, Sonali" userId="9e80b397-6e2f-49b1-9374-ccdad8589140" providerId="ADAL" clId="{D9E64A59-FFAE-C541-8390-09152522AD04}"/>
    <pc:docChg chg="undo redo custSel modSld">
      <pc:chgData name="Narang, Sonali" userId="9e80b397-6e2f-49b1-9374-ccdad8589140" providerId="ADAL" clId="{D9E64A59-FFAE-C541-8390-09152522AD04}" dt="2022-07-19T15:42:39.435" v="107" actId="20577"/>
      <pc:docMkLst>
        <pc:docMk/>
      </pc:docMkLst>
      <pc:sldChg chg="addSp delSp modSp mod">
        <pc:chgData name="Narang, Sonali" userId="9e80b397-6e2f-49b1-9374-ccdad8589140" providerId="ADAL" clId="{D9E64A59-FFAE-C541-8390-09152522AD04}" dt="2022-07-19T15:42:39.435" v="107" actId="20577"/>
        <pc:sldMkLst>
          <pc:docMk/>
          <pc:sldMk cId="1155223781" sldId="258"/>
        </pc:sldMkLst>
        <pc:spChg chg="mod">
          <ac:chgData name="Narang, Sonali" userId="9e80b397-6e2f-49b1-9374-ccdad8589140" providerId="ADAL" clId="{D9E64A59-FFAE-C541-8390-09152522AD04}" dt="2022-07-19T15:42:02.444" v="28" actId="20577"/>
          <ac:spMkLst>
            <pc:docMk/>
            <pc:sldMk cId="1155223781" sldId="258"/>
            <ac:spMk id="14" creationId="{9482EB10-BC65-7742-9F9A-C8E6179C9F00}"/>
          </ac:spMkLst>
        </pc:spChg>
        <pc:spChg chg="mod">
          <ac:chgData name="Narang, Sonali" userId="9e80b397-6e2f-49b1-9374-ccdad8589140" providerId="ADAL" clId="{D9E64A59-FFAE-C541-8390-09152522AD04}" dt="2022-07-19T15:42:05.330" v="35" actId="20577"/>
          <ac:spMkLst>
            <pc:docMk/>
            <pc:sldMk cId="1155223781" sldId="258"/>
            <ac:spMk id="15" creationId="{B882E5B6-51CB-0E4E-98CD-A1543D1D9B29}"/>
          </ac:spMkLst>
        </pc:spChg>
        <pc:spChg chg="mod">
          <ac:chgData name="Narang, Sonali" userId="9e80b397-6e2f-49b1-9374-ccdad8589140" providerId="ADAL" clId="{D9E64A59-FFAE-C541-8390-09152522AD04}" dt="2022-07-19T15:42:09.510" v="42" actId="20577"/>
          <ac:spMkLst>
            <pc:docMk/>
            <pc:sldMk cId="1155223781" sldId="258"/>
            <ac:spMk id="18" creationId="{367D5BDE-1C52-044D-8DF4-14BCB0ED0FB9}"/>
          </ac:spMkLst>
        </pc:spChg>
        <pc:spChg chg="mod">
          <ac:chgData name="Narang, Sonali" userId="9e80b397-6e2f-49b1-9374-ccdad8589140" providerId="ADAL" clId="{D9E64A59-FFAE-C541-8390-09152522AD04}" dt="2022-07-19T15:42:11.803" v="49" actId="20577"/>
          <ac:spMkLst>
            <pc:docMk/>
            <pc:sldMk cId="1155223781" sldId="258"/>
            <ac:spMk id="19" creationId="{C7082FB9-D9DD-9B46-AB0D-77C63E208142}"/>
          </ac:spMkLst>
        </pc:spChg>
        <pc:spChg chg="mod">
          <ac:chgData name="Narang, Sonali" userId="9e80b397-6e2f-49b1-9374-ccdad8589140" providerId="ADAL" clId="{D9E64A59-FFAE-C541-8390-09152522AD04}" dt="2022-07-19T15:42:15.333" v="56" actId="20577"/>
          <ac:spMkLst>
            <pc:docMk/>
            <pc:sldMk cId="1155223781" sldId="258"/>
            <ac:spMk id="20" creationId="{44EFDA2E-01BB-5C4D-BFA4-1B654C633262}"/>
          </ac:spMkLst>
        </pc:spChg>
        <pc:spChg chg="mod">
          <ac:chgData name="Narang, Sonali" userId="9e80b397-6e2f-49b1-9374-ccdad8589140" providerId="ADAL" clId="{D9E64A59-FFAE-C541-8390-09152522AD04}" dt="2022-07-19T15:42:17.579" v="63" actId="20577"/>
          <ac:spMkLst>
            <pc:docMk/>
            <pc:sldMk cId="1155223781" sldId="258"/>
            <ac:spMk id="21" creationId="{FB6E0053-C3C0-954D-BD99-12FE11770FF5}"/>
          </ac:spMkLst>
        </pc:spChg>
        <pc:spChg chg="mod">
          <ac:chgData name="Narang, Sonali" userId="9e80b397-6e2f-49b1-9374-ccdad8589140" providerId="ADAL" clId="{D9E64A59-FFAE-C541-8390-09152522AD04}" dt="2022-07-19T15:42:21.998" v="70" actId="20577"/>
          <ac:spMkLst>
            <pc:docMk/>
            <pc:sldMk cId="1155223781" sldId="258"/>
            <ac:spMk id="22" creationId="{A213DA13-9A0F-094F-B9BB-3833A654F806}"/>
          </ac:spMkLst>
        </pc:spChg>
        <pc:spChg chg="mod">
          <ac:chgData name="Narang, Sonali" userId="9e80b397-6e2f-49b1-9374-ccdad8589140" providerId="ADAL" clId="{D9E64A59-FFAE-C541-8390-09152522AD04}" dt="2022-07-19T15:42:24.697" v="77" actId="20577"/>
          <ac:spMkLst>
            <pc:docMk/>
            <pc:sldMk cId="1155223781" sldId="258"/>
            <ac:spMk id="23" creationId="{276AAB1C-9B21-624A-86D0-3955181A06CB}"/>
          </ac:spMkLst>
        </pc:spChg>
        <pc:spChg chg="mod">
          <ac:chgData name="Narang, Sonali" userId="9e80b397-6e2f-49b1-9374-ccdad8589140" providerId="ADAL" clId="{D9E64A59-FFAE-C541-8390-09152522AD04}" dt="2022-07-19T15:42:28.705" v="84" actId="20577"/>
          <ac:spMkLst>
            <pc:docMk/>
            <pc:sldMk cId="1155223781" sldId="258"/>
            <ac:spMk id="24" creationId="{678B4FA7-538E-1B4B-96E0-2825C9C14C3E}"/>
          </ac:spMkLst>
        </pc:spChg>
        <pc:spChg chg="mod">
          <ac:chgData name="Narang, Sonali" userId="9e80b397-6e2f-49b1-9374-ccdad8589140" providerId="ADAL" clId="{D9E64A59-FFAE-C541-8390-09152522AD04}" dt="2022-07-19T15:42:32.879" v="91" actId="20577"/>
          <ac:spMkLst>
            <pc:docMk/>
            <pc:sldMk cId="1155223781" sldId="258"/>
            <ac:spMk id="25" creationId="{96BA6AB2-3E59-4E49-A7B2-C2C829B1304A}"/>
          </ac:spMkLst>
        </pc:spChg>
        <pc:spChg chg="mod">
          <ac:chgData name="Narang, Sonali" userId="9e80b397-6e2f-49b1-9374-ccdad8589140" providerId="ADAL" clId="{D9E64A59-FFAE-C541-8390-09152522AD04}" dt="2022-07-19T15:42:36.132" v="98" actId="20577"/>
          <ac:spMkLst>
            <pc:docMk/>
            <pc:sldMk cId="1155223781" sldId="258"/>
            <ac:spMk id="26" creationId="{3FA6B5BD-099D-0A4E-89E1-6DD379FE4966}"/>
          </ac:spMkLst>
        </pc:spChg>
        <pc:spChg chg="mod">
          <ac:chgData name="Narang, Sonali" userId="9e80b397-6e2f-49b1-9374-ccdad8589140" providerId="ADAL" clId="{D9E64A59-FFAE-C541-8390-09152522AD04}" dt="2022-07-19T15:42:39.435" v="107" actId="20577"/>
          <ac:spMkLst>
            <pc:docMk/>
            <pc:sldMk cId="1155223781" sldId="258"/>
            <ac:spMk id="27" creationId="{2C0D8070-7A7B-AD49-BEFD-379D5F209C30}"/>
          </ac:spMkLst>
        </pc:spChg>
        <pc:grpChg chg="topLvl">
          <ac:chgData name="Narang, Sonali" userId="9e80b397-6e2f-49b1-9374-ccdad8589140" providerId="ADAL" clId="{D9E64A59-FFAE-C541-8390-09152522AD04}" dt="2022-07-19T15:41:10.165" v="11" actId="478"/>
          <ac:grpSpMkLst>
            <pc:docMk/>
            <pc:sldMk cId="1155223781" sldId="258"/>
            <ac:grpSpMk id="2" creationId="{97DF425C-8C95-EF48-AE1B-9A37CA1698E0}"/>
          </ac:grpSpMkLst>
        </pc:grpChg>
        <pc:grpChg chg="add del">
          <ac:chgData name="Narang, Sonali" userId="9e80b397-6e2f-49b1-9374-ccdad8589140" providerId="ADAL" clId="{D9E64A59-FFAE-C541-8390-09152522AD04}" dt="2022-07-19T15:41:10.165" v="11" actId="478"/>
          <ac:grpSpMkLst>
            <pc:docMk/>
            <pc:sldMk cId="1155223781" sldId="258"/>
            <ac:grpSpMk id="8" creationId="{F0573D55-2BC4-0041-9C05-358981365A10}"/>
          </ac:grpSpMkLst>
        </pc:grpChg>
        <pc:grpChg chg="add del">
          <ac:chgData name="Narang, Sonali" userId="9e80b397-6e2f-49b1-9374-ccdad8589140" providerId="ADAL" clId="{D9E64A59-FFAE-C541-8390-09152522AD04}" dt="2022-07-19T15:41:05.643" v="10" actId="478"/>
          <ac:grpSpMkLst>
            <pc:docMk/>
            <pc:sldMk cId="1155223781" sldId="258"/>
            <ac:grpSpMk id="12" creationId="{94EF64BB-6C18-C844-ADCD-FA540E5D2A21}"/>
          </ac:grpSpMkLst>
        </pc:grpChg>
        <pc:picChg chg="del">
          <ac:chgData name="Narang, Sonali" userId="9e80b397-6e2f-49b1-9374-ccdad8589140" providerId="ADAL" clId="{D9E64A59-FFAE-C541-8390-09152522AD04}" dt="2022-07-19T15:41:12.904" v="12" actId="478"/>
          <ac:picMkLst>
            <pc:docMk/>
            <pc:sldMk cId="1155223781" sldId="258"/>
            <ac:picMk id="3" creationId="{EA617364-550B-E04F-924F-48C74EA2D11B}"/>
          </ac:picMkLst>
        </pc:picChg>
        <pc:picChg chg="del topLvl">
          <ac:chgData name="Narang, Sonali" userId="9e80b397-6e2f-49b1-9374-ccdad8589140" providerId="ADAL" clId="{D9E64A59-FFAE-C541-8390-09152522AD04}" dt="2022-07-19T15:41:10.165" v="11" actId="478"/>
          <ac:picMkLst>
            <pc:docMk/>
            <pc:sldMk cId="1155223781" sldId="258"/>
            <ac:picMk id="9" creationId="{CE344B95-A4B4-8E48-8BA1-DBCEB948F1E4}"/>
          </ac:picMkLst>
        </pc:picChg>
        <pc:picChg chg="add mod modCrop">
          <ac:chgData name="Narang, Sonali" userId="9e80b397-6e2f-49b1-9374-ccdad8589140" providerId="ADAL" clId="{D9E64A59-FFAE-C541-8390-09152522AD04}" dt="2022-07-19T15:41:55.471" v="19" actId="732"/>
          <ac:picMkLst>
            <pc:docMk/>
            <pc:sldMk cId="1155223781" sldId="258"/>
            <ac:picMk id="16" creationId="{9CDA57FA-1198-9B4F-940C-790315364100}"/>
          </ac:picMkLst>
        </pc:picChg>
        <pc:picChg chg="add mod modCrop">
          <ac:chgData name="Narang, Sonali" userId="9e80b397-6e2f-49b1-9374-ccdad8589140" providerId="ADAL" clId="{D9E64A59-FFAE-C541-8390-09152522AD04}" dt="2022-07-19T15:41:22.395" v="13" actId="732"/>
          <ac:picMkLst>
            <pc:docMk/>
            <pc:sldMk cId="1155223781" sldId="258"/>
            <ac:picMk id="43" creationId="{85FB7F86-5BAF-D041-8C2E-CAE9C81D11AA}"/>
          </ac:picMkLst>
        </pc:picChg>
      </pc:sldChg>
    </pc:docChg>
  </pc:docChgLst>
  <pc:docChgLst>
    <pc:chgData name="Narang, Sonali" userId="9e80b397-6e2f-49b1-9374-ccdad8589140" providerId="ADAL" clId="{46A0A03D-11B0-3C41-BA86-9337C96006C0}"/>
    <pc:docChg chg="undo custSel modSld">
      <pc:chgData name="Narang, Sonali" userId="9e80b397-6e2f-49b1-9374-ccdad8589140" providerId="ADAL" clId="{46A0A03D-11B0-3C41-BA86-9337C96006C0}" dt="2022-08-18T21:54:07.996" v="76" actId="14100"/>
      <pc:docMkLst>
        <pc:docMk/>
      </pc:docMkLst>
      <pc:sldChg chg="addSp delSp modSp mod modNotesTx">
        <pc:chgData name="Narang, Sonali" userId="9e80b397-6e2f-49b1-9374-ccdad8589140" providerId="ADAL" clId="{46A0A03D-11B0-3C41-BA86-9337C96006C0}" dt="2022-08-18T21:54:07.996" v="76" actId="14100"/>
        <pc:sldMkLst>
          <pc:docMk/>
          <pc:sldMk cId="1155223781" sldId="258"/>
        </pc:sldMkLst>
        <pc:spChg chg="mod">
          <ac:chgData name="Narang, Sonali" userId="9e80b397-6e2f-49b1-9374-ccdad8589140" providerId="ADAL" clId="{46A0A03D-11B0-3C41-BA86-9337C96006C0}" dt="2022-08-18T21:53:41.026" v="64" actId="20577"/>
          <ac:spMkLst>
            <pc:docMk/>
            <pc:sldMk cId="1155223781" sldId="258"/>
            <ac:spMk id="31" creationId="{0277FEDF-F9D9-6646-B3AE-0577C6D0A4E5}"/>
          </ac:spMkLst>
        </pc:spChg>
        <pc:spChg chg="mod">
          <ac:chgData name="Narang, Sonali" userId="9e80b397-6e2f-49b1-9374-ccdad8589140" providerId="ADAL" clId="{46A0A03D-11B0-3C41-BA86-9337C96006C0}" dt="2022-08-18T21:53:37.568" v="57" actId="20577"/>
          <ac:spMkLst>
            <pc:docMk/>
            <pc:sldMk cId="1155223781" sldId="258"/>
            <ac:spMk id="32" creationId="{DD3B71C5-63C4-9A4E-B9E8-48BA183A2733}"/>
          </ac:spMkLst>
        </pc:spChg>
        <pc:spChg chg="mod">
          <ac:chgData name="Narang, Sonali" userId="9e80b397-6e2f-49b1-9374-ccdad8589140" providerId="ADAL" clId="{46A0A03D-11B0-3C41-BA86-9337C96006C0}" dt="2022-08-18T21:53:34.184" v="50" actId="20577"/>
          <ac:spMkLst>
            <pc:docMk/>
            <pc:sldMk cId="1155223781" sldId="258"/>
            <ac:spMk id="33" creationId="{3A625BF6-F4DC-B840-B7B1-195A5D97A316}"/>
          </ac:spMkLst>
        </pc:spChg>
        <pc:spChg chg="mod">
          <ac:chgData name="Narang, Sonali" userId="9e80b397-6e2f-49b1-9374-ccdad8589140" providerId="ADAL" clId="{46A0A03D-11B0-3C41-BA86-9337C96006C0}" dt="2022-08-18T21:53:31.003" v="43" actId="20577"/>
          <ac:spMkLst>
            <pc:docMk/>
            <pc:sldMk cId="1155223781" sldId="258"/>
            <ac:spMk id="34" creationId="{E0CB58FF-AA16-8B46-BA34-A9E03598E3C0}"/>
          </ac:spMkLst>
        </pc:spChg>
        <pc:spChg chg="mod">
          <ac:chgData name="Narang, Sonali" userId="9e80b397-6e2f-49b1-9374-ccdad8589140" providerId="ADAL" clId="{46A0A03D-11B0-3C41-BA86-9337C96006C0}" dt="2022-08-18T21:53:27.672" v="36" actId="20577"/>
          <ac:spMkLst>
            <pc:docMk/>
            <pc:sldMk cId="1155223781" sldId="258"/>
            <ac:spMk id="35" creationId="{7CD68B35-8C02-F04C-946C-DACA785D3773}"/>
          </ac:spMkLst>
        </pc:spChg>
        <pc:spChg chg="mod">
          <ac:chgData name="Narang, Sonali" userId="9e80b397-6e2f-49b1-9374-ccdad8589140" providerId="ADAL" clId="{46A0A03D-11B0-3C41-BA86-9337C96006C0}" dt="2022-08-18T21:53:24.193" v="29" actId="20577"/>
          <ac:spMkLst>
            <pc:docMk/>
            <pc:sldMk cId="1155223781" sldId="258"/>
            <ac:spMk id="36" creationId="{93CD5B23-1D64-BB47-A2DB-669B7E5879CE}"/>
          </ac:spMkLst>
        </pc:spChg>
        <pc:grpChg chg="mod topLvl">
          <ac:chgData name="Narang, Sonali" userId="9e80b397-6e2f-49b1-9374-ccdad8589140" providerId="ADAL" clId="{46A0A03D-11B0-3C41-BA86-9337C96006C0}" dt="2022-08-18T21:54:05.664" v="75" actId="1076"/>
          <ac:grpSpMkLst>
            <pc:docMk/>
            <pc:sldMk cId="1155223781" sldId="258"/>
            <ac:grpSpMk id="29" creationId="{70F7DDDB-B9EC-E547-B6B0-91E941A82272}"/>
          </ac:grpSpMkLst>
        </pc:grpChg>
        <pc:grpChg chg="del">
          <ac:chgData name="Narang, Sonali" userId="9e80b397-6e2f-49b1-9374-ccdad8589140" providerId="ADAL" clId="{46A0A03D-11B0-3C41-BA86-9337C96006C0}" dt="2022-08-18T21:52:33.481" v="11" actId="478"/>
          <ac:grpSpMkLst>
            <pc:docMk/>
            <pc:sldMk cId="1155223781" sldId="258"/>
            <ac:grpSpMk id="30" creationId="{4F417D1A-6ED4-324C-9FBD-E75CD252B780}"/>
          </ac:grpSpMkLst>
        </pc:grpChg>
        <pc:picChg chg="add mod modCrop">
          <ac:chgData name="Narang, Sonali" userId="9e80b397-6e2f-49b1-9374-ccdad8589140" providerId="ADAL" clId="{46A0A03D-11B0-3C41-BA86-9337C96006C0}" dt="2022-08-18T21:54:07.996" v="76" actId="14100"/>
          <ac:picMkLst>
            <pc:docMk/>
            <pc:sldMk cId="1155223781" sldId="258"/>
            <ac:picMk id="8" creationId="{0AB5AC39-6BB3-9C42-81CF-A8B498911692}"/>
          </ac:picMkLst>
        </pc:picChg>
        <pc:picChg chg="del topLvl">
          <ac:chgData name="Narang, Sonali" userId="9e80b397-6e2f-49b1-9374-ccdad8589140" providerId="ADAL" clId="{46A0A03D-11B0-3C41-BA86-9337C96006C0}" dt="2022-08-18T21:52:33.481" v="11" actId="478"/>
          <ac:picMkLst>
            <pc:docMk/>
            <pc:sldMk cId="1155223781" sldId="258"/>
            <ac:picMk id="10" creationId="{8F08C599-E1EB-3044-A41D-ED696091AEE1}"/>
          </ac:picMkLst>
        </pc:picChg>
      </pc:sldChg>
    </pc:docChg>
  </pc:docChgLst>
  <pc:docChgLst>
    <pc:chgData name="Narang, Sonali" userId="9e80b397-6e2f-49b1-9374-ccdad8589140" providerId="ADAL" clId="{08EB3AD7-677B-AA4A-90AD-5577AE246557}"/>
    <pc:docChg chg="undo redo custSel addSld delSld modSld sldOrd">
      <pc:chgData name="Narang, Sonali" userId="9e80b397-6e2f-49b1-9374-ccdad8589140" providerId="ADAL" clId="{08EB3AD7-677B-AA4A-90AD-5577AE246557}" dt="2021-08-17T19:41:23.265" v="10239" actId="1076"/>
      <pc:docMkLst>
        <pc:docMk/>
      </pc:docMkLst>
      <pc:sldChg chg="addSp delSp modSp mod ord modNotesTx">
        <pc:chgData name="Narang, Sonali" userId="9e80b397-6e2f-49b1-9374-ccdad8589140" providerId="ADAL" clId="{08EB3AD7-677B-AA4A-90AD-5577AE246557}" dt="2021-08-16T20:59:16.794" v="10024" actId="1076"/>
        <pc:sldMkLst>
          <pc:docMk/>
          <pc:sldMk cId="3911031167" sldId="256"/>
        </pc:sldMkLst>
        <pc:spChg chg="add del mod">
          <ac:chgData name="Narang, Sonali" userId="9e80b397-6e2f-49b1-9374-ccdad8589140" providerId="ADAL" clId="{08EB3AD7-677B-AA4A-90AD-5577AE246557}" dt="2021-08-16T15:18:13.156" v="9178" actId="478"/>
          <ac:spMkLst>
            <pc:docMk/>
            <pc:sldMk cId="3911031167" sldId="256"/>
            <ac:spMk id="2" creationId="{2DF8F3DB-6CF6-A742-9CE5-307AF8750C23}"/>
          </ac:spMkLst>
        </pc:spChg>
        <pc:spChg chg="mod">
          <ac:chgData name="Narang, Sonali" userId="9e80b397-6e2f-49b1-9374-ccdad8589140" providerId="ADAL" clId="{08EB3AD7-677B-AA4A-90AD-5577AE246557}" dt="2021-06-22T21:08:28.384" v="1347" actId="20577"/>
          <ac:spMkLst>
            <pc:docMk/>
            <pc:sldMk cId="3911031167" sldId="256"/>
            <ac:spMk id="4" creationId="{F6669B9D-B042-D548-BD0F-97015091799B}"/>
          </ac:spMkLst>
        </pc:spChg>
        <pc:spChg chg="del mod">
          <ac:chgData name="Narang, Sonali" userId="9e80b397-6e2f-49b1-9374-ccdad8589140" providerId="ADAL" clId="{08EB3AD7-677B-AA4A-90AD-5577AE246557}" dt="2021-06-08T17:35:33.483" v="822" actId="478"/>
          <ac:spMkLst>
            <pc:docMk/>
            <pc:sldMk cId="3911031167" sldId="256"/>
            <ac:spMk id="6" creationId="{41464C80-B659-484D-A16F-8018DEC5471A}"/>
          </ac:spMkLst>
        </pc:spChg>
        <pc:spChg chg="add del mod">
          <ac:chgData name="Narang, Sonali" userId="9e80b397-6e2f-49b1-9374-ccdad8589140" providerId="ADAL" clId="{08EB3AD7-677B-AA4A-90AD-5577AE246557}" dt="2021-08-16T15:36:29.123" v="9188" actId="478"/>
          <ac:spMkLst>
            <pc:docMk/>
            <pc:sldMk cId="3911031167" sldId="256"/>
            <ac:spMk id="6" creationId="{5D5156F5-15A4-0C4F-8E0D-B4337BA01E1A}"/>
          </ac:spMkLst>
        </pc:spChg>
        <pc:spChg chg="add del mod">
          <ac:chgData name="Narang, Sonali" userId="9e80b397-6e2f-49b1-9374-ccdad8589140" providerId="ADAL" clId="{08EB3AD7-677B-AA4A-90AD-5577AE246557}" dt="2021-06-30T20:09:21.507" v="3339" actId="21"/>
          <ac:spMkLst>
            <pc:docMk/>
            <pc:sldMk cId="3911031167" sldId="256"/>
            <ac:spMk id="6" creationId="{7D614603-58D0-B044-AD8F-92047BB60F04}"/>
          </ac:spMkLst>
        </pc:spChg>
        <pc:spChg chg="add del mod">
          <ac:chgData name="Narang, Sonali" userId="9e80b397-6e2f-49b1-9374-ccdad8589140" providerId="ADAL" clId="{08EB3AD7-677B-AA4A-90AD-5577AE246557}" dt="2021-06-24T21:22:14.990" v="1913" actId="478"/>
          <ac:spMkLst>
            <pc:docMk/>
            <pc:sldMk cId="3911031167" sldId="256"/>
            <ac:spMk id="6" creationId="{E20E99A8-685F-6B4D-B09E-14EFBD5767B5}"/>
          </ac:spMkLst>
        </pc:spChg>
        <pc:spChg chg="del mod">
          <ac:chgData name="Narang, Sonali" userId="9e80b397-6e2f-49b1-9374-ccdad8589140" providerId="ADAL" clId="{08EB3AD7-677B-AA4A-90AD-5577AE246557}" dt="2021-08-16T20:59:02.314" v="10021" actId="478"/>
          <ac:spMkLst>
            <pc:docMk/>
            <pc:sldMk cId="3911031167" sldId="256"/>
            <ac:spMk id="7" creationId="{4C5F5CAE-FBFD-964D-A356-746AAC86DC9E}"/>
          </ac:spMkLst>
        </pc:spChg>
        <pc:spChg chg="mod">
          <ac:chgData name="Narang, Sonali" userId="9e80b397-6e2f-49b1-9374-ccdad8589140" providerId="ADAL" clId="{08EB3AD7-677B-AA4A-90AD-5577AE246557}" dt="2021-06-30T00:11:43.540" v="2573" actId="1076"/>
          <ac:spMkLst>
            <pc:docMk/>
            <pc:sldMk cId="3911031167" sldId="256"/>
            <ac:spMk id="8" creationId="{8A9BAE78-C4FF-1843-94F6-3410EB884848}"/>
          </ac:spMkLst>
        </pc:spChg>
        <pc:spChg chg="add mod">
          <ac:chgData name="Narang, Sonali" userId="9e80b397-6e2f-49b1-9374-ccdad8589140" providerId="ADAL" clId="{08EB3AD7-677B-AA4A-90AD-5577AE246557}" dt="2021-06-02T22:39:16.407" v="773" actId="1076"/>
          <ac:spMkLst>
            <pc:docMk/>
            <pc:sldMk cId="3911031167" sldId="256"/>
            <ac:spMk id="9" creationId="{11A0F8B4-69EA-5249-B581-5DD36FED4774}"/>
          </ac:spMkLst>
        </pc:spChg>
        <pc:spChg chg="add del mod">
          <ac:chgData name="Narang, Sonali" userId="9e80b397-6e2f-49b1-9374-ccdad8589140" providerId="ADAL" clId="{08EB3AD7-677B-AA4A-90AD-5577AE246557}" dt="2021-08-16T15:36:39.743" v="9201" actId="478"/>
          <ac:spMkLst>
            <pc:docMk/>
            <pc:sldMk cId="3911031167" sldId="256"/>
            <ac:spMk id="9" creationId="{82FD3A7B-872D-F945-B026-F1B5EF578555}"/>
          </ac:spMkLst>
        </pc:spChg>
        <pc:spChg chg="add mod">
          <ac:chgData name="Narang, Sonali" userId="9e80b397-6e2f-49b1-9374-ccdad8589140" providerId="ADAL" clId="{08EB3AD7-677B-AA4A-90AD-5577AE246557}" dt="2021-06-02T22:39:16.407" v="773" actId="1076"/>
          <ac:spMkLst>
            <pc:docMk/>
            <pc:sldMk cId="3911031167" sldId="256"/>
            <ac:spMk id="11" creationId="{64B505AB-73F1-7F4C-ADED-67FC3F461194}"/>
          </ac:spMkLst>
        </pc:spChg>
        <pc:spChg chg="add del mod">
          <ac:chgData name="Narang, Sonali" userId="9e80b397-6e2f-49b1-9374-ccdad8589140" providerId="ADAL" clId="{08EB3AD7-677B-AA4A-90AD-5577AE246557}" dt="2021-06-30T20:09:21.507" v="3339" actId="21"/>
          <ac:spMkLst>
            <pc:docMk/>
            <pc:sldMk cId="3911031167" sldId="256"/>
            <ac:spMk id="12" creationId="{FA757C74-AC47-0849-B292-1ECC6387B738}"/>
          </ac:spMkLst>
        </pc:spChg>
        <pc:spChg chg="add del mod">
          <ac:chgData name="Narang, Sonali" userId="9e80b397-6e2f-49b1-9374-ccdad8589140" providerId="ADAL" clId="{08EB3AD7-677B-AA4A-90AD-5577AE246557}" dt="2021-06-14T20:26:29.181" v="1032" actId="478"/>
          <ac:spMkLst>
            <pc:docMk/>
            <pc:sldMk cId="3911031167" sldId="256"/>
            <ac:spMk id="13" creationId="{E12C9C15-9182-964D-A02F-7C0E4D1EEE7D}"/>
          </ac:spMkLst>
        </pc:spChg>
        <pc:spChg chg="add del mod">
          <ac:chgData name="Narang, Sonali" userId="9e80b397-6e2f-49b1-9374-ccdad8589140" providerId="ADAL" clId="{08EB3AD7-677B-AA4A-90AD-5577AE246557}" dt="2021-06-02T22:42:18.530" v="814"/>
          <ac:spMkLst>
            <pc:docMk/>
            <pc:sldMk cId="3911031167" sldId="256"/>
            <ac:spMk id="16" creationId="{EBC96EC8-7E24-6F40-B6EC-8C96BB20C15E}"/>
          </ac:spMkLst>
        </pc:spChg>
        <pc:spChg chg="add del mod">
          <ac:chgData name="Narang, Sonali" userId="9e80b397-6e2f-49b1-9374-ccdad8589140" providerId="ADAL" clId="{08EB3AD7-677B-AA4A-90AD-5577AE246557}" dt="2021-06-14T20:26:27.281" v="1031" actId="478"/>
          <ac:spMkLst>
            <pc:docMk/>
            <pc:sldMk cId="3911031167" sldId="256"/>
            <ac:spMk id="17" creationId="{890055F9-448C-EC49-AD75-AFE1AAE923ED}"/>
          </ac:spMkLst>
        </pc:spChg>
        <pc:spChg chg="del mod">
          <ac:chgData name="Narang, Sonali" userId="9e80b397-6e2f-49b1-9374-ccdad8589140" providerId="ADAL" clId="{08EB3AD7-677B-AA4A-90AD-5577AE246557}" dt="2021-08-16T18:38:45.925" v="9793" actId="478"/>
          <ac:spMkLst>
            <pc:docMk/>
            <pc:sldMk cId="3911031167" sldId="256"/>
            <ac:spMk id="32" creationId="{2863401C-2050-2E40-AE5C-C6CDD3A8A7D4}"/>
          </ac:spMkLst>
        </pc:spChg>
        <pc:spChg chg="mod">
          <ac:chgData name="Narang, Sonali" userId="9e80b397-6e2f-49b1-9374-ccdad8589140" providerId="ADAL" clId="{08EB3AD7-677B-AA4A-90AD-5577AE246557}" dt="2021-08-16T17:40:17.409" v="9559" actId="1035"/>
          <ac:spMkLst>
            <pc:docMk/>
            <pc:sldMk cId="3911031167" sldId="256"/>
            <ac:spMk id="36" creationId="{75B14C61-810F-134B-AC0D-0C1FD0CAB17A}"/>
          </ac:spMkLst>
        </pc:spChg>
        <pc:spChg chg="del mod">
          <ac:chgData name="Narang, Sonali" userId="9e80b397-6e2f-49b1-9374-ccdad8589140" providerId="ADAL" clId="{08EB3AD7-677B-AA4A-90AD-5577AE246557}" dt="2021-08-16T15:39:01.872" v="9231" actId="478"/>
          <ac:spMkLst>
            <pc:docMk/>
            <pc:sldMk cId="3911031167" sldId="256"/>
            <ac:spMk id="58" creationId="{BD0FF247-589D-4B4C-8388-2FC80AF9DFEC}"/>
          </ac:spMkLst>
        </pc:spChg>
        <pc:spChg chg="mod">
          <ac:chgData name="Narang, Sonali" userId="9e80b397-6e2f-49b1-9374-ccdad8589140" providerId="ADAL" clId="{08EB3AD7-677B-AA4A-90AD-5577AE246557}" dt="2021-08-16T17:40:31.354" v="9561" actId="20577"/>
          <ac:spMkLst>
            <pc:docMk/>
            <pc:sldMk cId="3911031167" sldId="256"/>
            <ac:spMk id="59" creationId="{1C85DEE8-F315-5047-B7B7-8827D96395BE}"/>
          </ac:spMkLst>
        </pc:spChg>
        <pc:spChg chg="del mod">
          <ac:chgData name="Narang, Sonali" userId="9e80b397-6e2f-49b1-9374-ccdad8589140" providerId="ADAL" clId="{08EB3AD7-677B-AA4A-90AD-5577AE246557}" dt="2021-06-22T18:53:59.869" v="1127" actId="478"/>
          <ac:spMkLst>
            <pc:docMk/>
            <pc:sldMk cId="3911031167" sldId="256"/>
            <ac:spMk id="72" creationId="{E87FA026-087C-5C44-8204-B718606B65DE}"/>
          </ac:spMkLst>
        </pc:spChg>
        <pc:spChg chg="del mod">
          <ac:chgData name="Narang, Sonali" userId="9e80b397-6e2f-49b1-9374-ccdad8589140" providerId="ADAL" clId="{08EB3AD7-677B-AA4A-90AD-5577AE246557}" dt="2021-06-22T18:53:59.869" v="1127" actId="478"/>
          <ac:spMkLst>
            <pc:docMk/>
            <pc:sldMk cId="3911031167" sldId="256"/>
            <ac:spMk id="73" creationId="{64ABD8BF-3984-E74F-A48C-E6D4CDE1F995}"/>
          </ac:spMkLst>
        </pc:spChg>
        <pc:spChg chg="add mod">
          <ac:chgData name="Narang, Sonali" userId="9e80b397-6e2f-49b1-9374-ccdad8589140" providerId="ADAL" clId="{08EB3AD7-677B-AA4A-90AD-5577AE246557}" dt="2021-06-02T22:39:20.802" v="774" actId="1076"/>
          <ac:spMkLst>
            <pc:docMk/>
            <pc:sldMk cId="3911031167" sldId="256"/>
            <ac:spMk id="91" creationId="{067324D9-1637-7743-A2A0-5A477213325A}"/>
          </ac:spMkLst>
        </pc:spChg>
        <pc:spChg chg="add mod">
          <ac:chgData name="Narang, Sonali" userId="9e80b397-6e2f-49b1-9374-ccdad8589140" providerId="ADAL" clId="{08EB3AD7-677B-AA4A-90AD-5577AE246557}" dt="2021-06-02T22:39:20.802" v="774" actId="1076"/>
          <ac:spMkLst>
            <pc:docMk/>
            <pc:sldMk cId="3911031167" sldId="256"/>
            <ac:spMk id="92" creationId="{1AC4BF1B-E54B-A648-AB91-0F9D48688404}"/>
          </ac:spMkLst>
        </pc:spChg>
        <pc:spChg chg="add mod">
          <ac:chgData name="Narang, Sonali" userId="9e80b397-6e2f-49b1-9374-ccdad8589140" providerId="ADAL" clId="{08EB3AD7-677B-AA4A-90AD-5577AE246557}" dt="2021-06-02T22:39:10.894" v="772" actId="1076"/>
          <ac:spMkLst>
            <pc:docMk/>
            <pc:sldMk cId="3911031167" sldId="256"/>
            <ac:spMk id="97" creationId="{3F641113-F329-E041-8EED-FCF0327D91AA}"/>
          </ac:spMkLst>
        </pc:spChg>
        <pc:spChg chg="add mod">
          <ac:chgData name="Narang, Sonali" userId="9e80b397-6e2f-49b1-9374-ccdad8589140" providerId="ADAL" clId="{08EB3AD7-677B-AA4A-90AD-5577AE246557}" dt="2021-06-02T22:39:10.894" v="772" actId="1076"/>
          <ac:spMkLst>
            <pc:docMk/>
            <pc:sldMk cId="3911031167" sldId="256"/>
            <ac:spMk id="98" creationId="{CABF976A-9466-304A-A0CF-99AFCEEACAE8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99" creationId="{B1BDB161-0CD7-B54D-99F6-64C4465AB29C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0" creationId="{C67B2BF7-EC26-174D-8E12-3651764BF59B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02" creationId="{F566A106-AA96-AF48-97A0-9768CA0FB5E7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03" creationId="{D4C1827E-7F80-D842-B7E0-37745A7EB71E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4" creationId="{67029BC7-70F1-D748-8B69-8CE3983A0D01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5" creationId="{260852BA-DA97-7242-BEFA-7A434864B14F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6" creationId="{AEF54A9D-ED26-8248-A021-D9EFEB1E15F5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7" creationId="{4CF4A81D-185E-C845-98A9-CF2E3DD4D69A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07" creationId="{CD607BA9-E4EE-0942-A0C0-A7724B78472F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8" creationId="{12C6A427-B23F-4240-BF47-43A7B266B0DC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08" creationId="{C0F73472-BB13-704B-91F2-9906CC1D3B57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09" creationId="{18ADD9D7-9B2B-694A-A5F1-E03A53484677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09" creationId="{57102F4D-A861-9F41-BF6E-77B7C02E2859}"/>
          </ac:spMkLst>
        </pc:spChg>
        <pc:spChg chg="mod">
          <ac:chgData name="Narang, Sonali" userId="9e80b397-6e2f-49b1-9374-ccdad8589140" providerId="ADAL" clId="{08EB3AD7-677B-AA4A-90AD-5577AE246557}" dt="2021-06-02T22:40:52.807" v="789" actId="692"/>
          <ac:spMkLst>
            <pc:docMk/>
            <pc:sldMk cId="3911031167" sldId="256"/>
            <ac:spMk id="109" creationId="{CD5BC612-9417-7B47-99FC-320EDC1D0F96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0" creationId="{09E46FC9-9524-FC45-91AC-E815DACBB8AE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0" creationId="{D9EB2DA5-7058-4847-83BD-5C255F901CB3}"/>
          </ac:spMkLst>
        </pc:spChg>
        <pc:spChg chg="mod">
          <ac:chgData name="Narang, Sonali" userId="9e80b397-6e2f-49b1-9374-ccdad8589140" providerId="ADAL" clId="{08EB3AD7-677B-AA4A-90AD-5577AE246557}" dt="2021-06-02T22:41:08.409" v="793" actId="2085"/>
          <ac:spMkLst>
            <pc:docMk/>
            <pc:sldMk cId="3911031167" sldId="256"/>
            <ac:spMk id="110" creationId="{DB0BC995-597E-4642-AE49-15078A37F4C3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1" creationId="{0C08E0F0-B82B-D446-B25E-7391BA893EA1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1" creationId="{8864B289-C299-3F41-99B8-1198B138BC69}"/>
          </ac:spMkLst>
        </pc:spChg>
        <pc:spChg chg="mod">
          <ac:chgData name="Narang, Sonali" userId="9e80b397-6e2f-49b1-9374-ccdad8589140" providerId="ADAL" clId="{08EB3AD7-677B-AA4A-90AD-5577AE246557}" dt="2021-06-02T22:40:52.807" v="789" actId="692"/>
          <ac:spMkLst>
            <pc:docMk/>
            <pc:sldMk cId="3911031167" sldId="256"/>
            <ac:spMk id="111" creationId="{EDC65155-556E-B541-8497-CC35A4841745}"/>
          </ac:spMkLst>
        </pc:spChg>
        <pc:spChg chg="mod">
          <ac:chgData name="Narang, Sonali" userId="9e80b397-6e2f-49b1-9374-ccdad8589140" providerId="ADAL" clId="{08EB3AD7-677B-AA4A-90AD-5577AE246557}" dt="2021-06-02T22:41:08.409" v="793" actId="2085"/>
          <ac:spMkLst>
            <pc:docMk/>
            <pc:sldMk cId="3911031167" sldId="256"/>
            <ac:spMk id="112" creationId="{1F680A79-E0C3-124C-BFB9-15E2723F9E83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2" creationId="{5D0B2B25-B4CF-A34F-A2CA-0B40D42C6435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2" creationId="{F1E43EAD-D5E3-144D-AF63-8616AEB94294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3" creationId="{E22EBE77-9A42-0540-BB9A-1F568A7C4DCA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3" creationId="{EF2C7D23-D01B-484C-905F-BC9074819581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4" creationId="{1D1F5461-4593-8447-8138-0786752D0E12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4" creationId="{2EDAE544-D3EA-7145-B6B3-406F6D188A26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5" creationId="{6F8EF3BB-D633-124E-9BF6-C88508CBC05D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5" creationId="{AB70135A-FA81-4F41-9646-81D3ECB9639E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6" creationId="{0CBCC5E3-2EB0-174D-879D-FD529D19A7D1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6" creationId="{AA1708EC-0384-FC4B-9669-54FE1E87157D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7" creationId="{105D21E5-B099-3B47-A219-1DC0E05F5E80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7" creationId="{E8003426-4E81-5B45-BC54-3C268FA26CEA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8" creationId="{0576626E-FF47-6749-8EDE-55E3844DF33B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8" creationId="{D4381240-26E6-2E4C-AF36-42579F0828DD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19" creationId="{BB7A2345-796A-2B4B-BA62-A3500022381A}"/>
          </ac:spMkLst>
        </pc:spChg>
        <pc:spChg chg="mod">
          <ac:chgData name="Narang, Sonali" userId="9e80b397-6e2f-49b1-9374-ccdad8589140" providerId="ADAL" clId="{08EB3AD7-677B-AA4A-90AD-5577AE246557}" dt="2021-06-02T22:40:52.807" v="789" actId="692"/>
          <ac:spMkLst>
            <pc:docMk/>
            <pc:sldMk cId="3911031167" sldId="256"/>
            <ac:spMk id="119" creationId="{E99A7147-0838-D340-9846-888253DAD4D7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19" creationId="{F0D69C78-1AF1-AA47-814F-8BA0E035582E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0" creationId="{2F823ACD-28C6-CB46-99A3-F49B7E8B8036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20" creationId="{35A36BFA-1FBC-F94B-B65C-4516D416EA45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1" creationId="{6A3C4ACC-0FDF-D540-B21F-619BAAB05869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21" creationId="{925C1939-08C3-3A46-963B-F2A2CA16C2B1}"/>
          </ac:spMkLst>
        </pc:spChg>
        <pc:spChg chg="mod">
          <ac:chgData name="Narang, Sonali" userId="9e80b397-6e2f-49b1-9374-ccdad8589140" providerId="ADAL" clId="{08EB3AD7-677B-AA4A-90AD-5577AE246557}" dt="2021-08-16T15:36:16.978" v="9185"/>
          <ac:spMkLst>
            <pc:docMk/>
            <pc:sldMk cId="3911031167" sldId="256"/>
            <ac:spMk id="122" creationId="{0FBD9CBD-1AB5-6F4B-8D1C-0367C47A4C25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2" creationId="{9BBAC7A0-8F74-D641-964D-B2F002F59C7B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3" creationId="{D6B595AD-8FF7-A149-A7E3-CE2509412588}"/>
          </ac:spMkLst>
        </pc:spChg>
        <pc:spChg chg="mod">
          <ac:chgData name="Narang, Sonali" userId="9e80b397-6e2f-49b1-9374-ccdad8589140" providerId="ADAL" clId="{08EB3AD7-677B-AA4A-90AD-5577AE246557}" dt="2021-06-02T22:41:08.409" v="793" actId="2085"/>
          <ac:spMkLst>
            <pc:docMk/>
            <pc:sldMk cId="3911031167" sldId="256"/>
            <ac:spMk id="123" creationId="{F2528B47-BF07-0842-877A-B018E14BBF10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4" creationId="{230F689C-DF61-F547-B5C5-335507933E67}"/>
          </ac:spMkLst>
        </pc:spChg>
        <pc:spChg chg="mod">
          <ac:chgData name="Narang, Sonali" userId="9e80b397-6e2f-49b1-9374-ccdad8589140" providerId="ADAL" clId="{08EB3AD7-677B-AA4A-90AD-5577AE246557}" dt="2021-07-09T20:13:14.100" v="4977"/>
          <ac:spMkLst>
            <pc:docMk/>
            <pc:sldMk cId="3911031167" sldId="256"/>
            <ac:spMk id="125" creationId="{42FC7F38-F5F2-2144-9DFA-71D554BF85A8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27" creationId="{83ED1720-3FE2-CE47-A325-A75D5CCA9B39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28" creationId="{9C82F1DC-767D-F042-9E9F-153E6CB0AAF6}"/>
          </ac:spMkLst>
        </pc:spChg>
        <pc:spChg chg="mod">
          <ac:chgData name="Narang, Sonali" userId="9e80b397-6e2f-49b1-9374-ccdad8589140" providerId="ADAL" clId="{08EB3AD7-677B-AA4A-90AD-5577AE246557}" dt="2021-06-02T22:40:18.169" v="783" actId="692"/>
          <ac:spMkLst>
            <pc:docMk/>
            <pc:sldMk cId="3911031167" sldId="256"/>
            <ac:spMk id="129" creationId="{B2E5B69B-57B4-A041-8D85-CDCD2BFDB814}"/>
          </ac:spMkLst>
        </pc:spChg>
        <pc:spChg chg="mod">
          <ac:chgData name="Narang, Sonali" userId="9e80b397-6e2f-49b1-9374-ccdad8589140" providerId="ADAL" clId="{08EB3AD7-677B-AA4A-90AD-5577AE246557}" dt="2021-06-02T22:40:37.790" v="787" actId="2085"/>
          <ac:spMkLst>
            <pc:docMk/>
            <pc:sldMk cId="3911031167" sldId="256"/>
            <ac:spMk id="130" creationId="{9B6AC341-C9D9-8546-88B5-5BB8AA3562CA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2" creationId="{19846EB5-86F7-5B4F-8424-68F11298A97B}"/>
          </ac:spMkLst>
        </pc:spChg>
        <pc:spChg chg="mod">
          <ac:chgData name="Narang, Sonali" userId="9e80b397-6e2f-49b1-9374-ccdad8589140" providerId="ADAL" clId="{08EB3AD7-677B-AA4A-90AD-5577AE246557}" dt="2021-06-02T22:40:18.169" v="783" actId="692"/>
          <ac:spMkLst>
            <pc:docMk/>
            <pc:sldMk cId="3911031167" sldId="256"/>
            <ac:spMk id="132" creationId="{84204C42-A558-2546-9177-9586D342D3B4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3" creationId="{3446A690-4C59-4644-BA4D-967DB89FAFE1}"/>
          </ac:spMkLst>
        </pc:spChg>
        <pc:spChg chg="mod">
          <ac:chgData name="Narang, Sonali" userId="9e80b397-6e2f-49b1-9374-ccdad8589140" providerId="ADAL" clId="{08EB3AD7-677B-AA4A-90AD-5577AE246557}" dt="2021-06-02T22:40:37.790" v="787" actId="2085"/>
          <ac:spMkLst>
            <pc:docMk/>
            <pc:sldMk cId="3911031167" sldId="256"/>
            <ac:spMk id="133" creationId="{D67481CC-D59A-0C47-852B-3A6BAD722599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33" creationId="{EB046023-C3BA-B046-96C0-17C24017679F}"/>
          </ac:spMkLst>
        </pc:spChg>
        <pc:spChg chg="mod">
          <ac:chgData name="Narang, Sonali" userId="9e80b397-6e2f-49b1-9374-ccdad8589140" providerId="ADAL" clId="{08EB3AD7-677B-AA4A-90AD-5577AE246557}" dt="2021-06-02T22:40:18.169" v="783" actId="692"/>
          <ac:spMkLst>
            <pc:docMk/>
            <pc:sldMk cId="3911031167" sldId="256"/>
            <ac:spMk id="134" creationId="{9BF3372C-C742-0F4F-8B39-F80A037A6C38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34" creationId="{9DD32114-401B-8240-A438-5460CB10A4E8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4" creationId="{ACE638E6-B8F3-6043-9A6A-FA0D21C838D2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5" creationId="{1224DF59-1D49-9049-9E1C-613B4D4E83C9}"/>
          </ac:spMkLst>
        </pc:spChg>
        <pc:spChg chg="mod">
          <ac:chgData name="Narang, Sonali" userId="9e80b397-6e2f-49b1-9374-ccdad8589140" providerId="ADAL" clId="{08EB3AD7-677B-AA4A-90AD-5577AE246557}" dt="2021-06-02T22:40:37.790" v="787" actId="2085"/>
          <ac:spMkLst>
            <pc:docMk/>
            <pc:sldMk cId="3911031167" sldId="256"/>
            <ac:spMk id="135" creationId="{6947AD86-E456-C342-86CB-DA4F54C47D96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6" creationId="{8E77E587-9C75-0846-BFB7-555E504630AF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7" creationId="{80B84D8E-2C22-474E-ACA1-B765FF70D034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8" creationId="{3788425D-CFA6-C942-8A66-E1A5C04828E4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38" creationId="{AEFB5054-6B0E-C545-9D89-4B6E0406F2EF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38" creationId="{D1440DC9-47A7-6142-848B-5EB57A8A6005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39" creationId="{184BD858-9E78-E34E-9EF3-2B189BDE297B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39" creationId="{673ABB10-4B24-3644-9DAA-23F14EE1109D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39" creationId="{B6D8EAE0-23D7-BD43-AA3C-826CB34ADCD5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0" creationId="{0D4B0B4B-D6D0-8947-8BEB-50BB4A726924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0" creationId="{1E0E200B-9F14-0941-8822-A4A93DEB3D04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0" creationId="{AC60C40F-B6A8-3E40-82C9-C257B45DBCCE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1" creationId="{2080B23A-6F0F-294E-885D-78C19188C0BA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1" creationId="{70E26B25-A23E-2F4D-B9A7-437F436F5400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1" creationId="{8DB66FE2-D46B-BD42-A55C-8C21517BF66F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2" creationId="{4DC03710-BE28-F44F-B51C-608A79EADC33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2" creationId="{A5185921-EDC2-A24D-B9EA-EF579E3E22B1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2" creationId="{FC379037-F452-D649-8CD2-453D6AC5981E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3" creationId="{248CD30B-91D4-4243-9C8B-CAAB90D89388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3" creationId="{79570168-4994-1B42-A444-3855E7C292AB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3" creationId="{9CF02F57-1390-0F41-BDBE-E2C155BB7DF2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4" creationId="{7208B108-ACD9-464C-B8FA-B94695BA2229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4" creationId="{A39419A9-B0D2-F745-BCAB-20249ADFF46F}"/>
          </ac:spMkLst>
        </pc:spChg>
        <pc:spChg chg="mod">
          <ac:chgData name="Narang, Sonali" userId="9e80b397-6e2f-49b1-9374-ccdad8589140" providerId="ADAL" clId="{08EB3AD7-677B-AA4A-90AD-5577AE246557}" dt="2021-06-22T18:55:14.604" v="1138"/>
          <ac:spMkLst>
            <pc:docMk/>
            <pc:sldMk cId="3911031167" sldId="256"/>
            <ac:spMk id="145" creationId="{0A03548D-13F0-5D4D-9F96-49C99467AE48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5" creationId="{3B3242B8-EBBF-AD47-A8C7-DA76AC91CCEC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5" creationId="{468C69B6-D5AD-674E-97CC-ADDDE9769F31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5" creationId="{B8C8CB4F-E11F-7F4F-AFA6-92D8A7341440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46" creationId="{257F0B62-910A-D246-9CA2-D61A38FE6DE4}"/>
          </ac:spMkLst>
        </pc:spChg>
        <pc:spChg chg="mod">
          <ac:chgData name="Narang, Sonali" userId="9e80b397-6e2f-49b1-9374-ccdad8589140" providerId="ADAL" clId="{08EB3AD7-677B-AA4A-90AD-5577AE246557}" dt="2021-06-22T18:55:14.604" v="1138"/>
          <ac:spMkLst>
            <pc:docMk/>
            <pc:sldMk cId="3911031167" sldId="256"/>
            <ac:spMk id="146" creationId="{2778F491-3683-DF47-A63E-905BDB243F9C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6" creationId="{352971A6-B0FF-8549-BAD6-096B5197CC5B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46" creationId="{5738E29C-E29D-7144-9052-0C8AE08E2C6E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7" creationId="{C28B6932-6ED5-6A42-A04E-565FC6ED5060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8" creationId="{DE9DDAAF-421D-9441-9978-C6B2F7DF6F17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49" creationId="{98309920-2F4A-A44F-B095-7FA55101F86A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0" creationId="{07354205-7C9C-4E40-931E-036961E4A0AB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2" creationId="{E3D18E34-2B0C-F34E-B32F-9EDDF2EB67A8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3" creationId="{8D61E3D3-E200-E04B-809B-E082EFC056FC}"/>
          </ac:spMkLst>
        </pc:spChg>
        <pc:spChg chg="mod topLvl">
          <ac:chgData name="Narang, Sonali" userId="9e80b397-6e2f-49b1-9374-ccdad8589140" providerId="ADAL" clId="{08EB3AD7-677B-AA4A-90AD-5577AE246557}" dt="2021-08-16T17:36:52.817" v="9510" actId="12788"/>
          <ac:spMkLst>
            <pc:docMk/>
            <pc:sldMk cId="3911031167" sldId="256"/>
            <ac:spMk id="154" creationId="{14FF3388-F642-A44D-AE92-41262C2B078F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4" creationId="{8E569FF3-0E48-2B44-859E-71DF2E4876BD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5" creationId="{BE6864BB-36FD-2F42-B03C-99B2D3A6B412}"/>
          </ac:spMkLst>
        </pc:spChg>
        <pc:spChg chg="mod topLvl">
          <ac:chgData name="Narang, Sonali" userId="9e80b397-6e2f-49b1-9374-ccdad8589140" providerId="ADAL" clId="{08EB3AD7-677B-AA4A-90AD-5577AE246557}" dt="2021-08-16T17:36:52.817" v="9510" actId="12788"/>
          <ac:spMkLst>
            <pc:docMk/>
            <pc:sldMk cId="3911031167" sldId="256"/>
            <ac:spMk id="155" creationId="{C99CF9BD-F7A7-C048-9876-1ABE09443ABC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6" creationId="{BF169059-3CBD-4C45-A31F-CB5C5E6D5ED8}"/>
          </ac:spMkLst>
        </pc:spChg>
        <pc:spChg chg="mod">
          <ac:chgData name="Narang, Sonali" userId="9e80b397-6e2f-49b1-9374-ccdad8589140" providerId="ADAL" clId="{08EB3AD7-677B-AA4A-90AD-5577AE246557}" dt="2021-06-02T22:41:47.434" v="798"/>
          <ac:spMkLst>
            <pc:docMk/>
            <pc:sldMk cId="3911031167" sldId="256"/>
            <ac:spMk id="157" creationId="{9777D790-A26D-CD4A-A592-617953C927C8}"/>
          </ac:spMkLst>
        </pc:spChg>
        <pc:spChg chg="mod topLvl">
          <ac:chgData name="Narang, Sonali" userId="9e80b397-6e2f-49b1-9374-ccdad8589140" providerId="ADAL" clId="{08EB3AD7-677B-AA4A-90AD-5577AE246557}" dt="2021-08-16T17:36:52.817" v="9510" actId="12788"/>
          <ac:spMkLst>
            <pc:docMk/>
            <pc:sldMk cId="3911031167" sldId="256"/>
            <ac:spMk id="159" creationId="{3A53118B-4762-424D-87CB-BCE868975CA5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0" creationId="{82FC6D59-4818-B44B-97A0-2E25F4B54C62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61" creationId="{1A5EA2F4-B792-5A4D-87C1-B022D65D82CA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1" creationId="{A096C2EC-4566-0D42-959B-2841870D744A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2" creationId="{459DD9BC-385B-4241-B634-2228832E147A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3" creationId="{6E9F6ACF-86A3-5948-9A89-A60F1DDDAD25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4" creationId="{25B7AFCD-BDAE-6048-BBFB-7C19591F5B5C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5" creationId="{C826322F-63B4-704D-BF56-ADB39C47E76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65" creationId="{D4E7502B-C5FB-7748-A2F6-8339DC6E2D1F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6" creationId="{468463DA-E59F-6C41-89FA-56866BADA1EB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66" creationId="{B390AE47-4B98-C447-B189-3184D9E2D1EB}"/>
          </ac:spMkLst>
        </pc:spChg>
        <pc:spChg chg="mod">
          <ac:chgData name="Narang, Sonali" userId="9e80b397-6e2f-49b1-9374-ccdad8589140" providerId="ADAL" clId="{08EB3AD7-677B-AA4A-90AD-5577AE246557}" dt="2021-08-16T17:35:03.309" v="9402" actId="1035"/>
          <ac:spMkLst>
            <pc:docMk/>
            <pc:sldMk cId="3911031167" sldId="256"/>
            <ac:spMk id="167" creationId="{2CCC239A-7B2D-4247-B9B3-58D5AD4B7F1A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68" creationId="{097D678D-439F-8E40-B750-A082A69BAD8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68" creationId="{ADD623A2-8CFB-3647-8D94-8CB194F6DD6F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69" creationId="{CBBEF7DB-9750-8C47-A784-8BF41B601507}"/>
          </ac:spMkLst>
        </pc:spChg>
        <pc:spChg chg="mod">
          <ac:chgData name="Narang, Sonali" userId="9e80b397-6e2f-49b1-9374-ccdad8589140" providerId="ADAL" clId="{08EB3AD7-677B-AA4A-90AD-5577AE246557}" dt="2021-08-16T17:34:50.735" v="9391" actId="1036"/>
          <ac:spMkLst>
            <pc:docMk/>
            <pc:sldMk cId="3911031167" sldId="256"/>
            <ac:spMk id="169" creationId="{DB48F954-1F10-B540-A80C-0A451838FAD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70" creationId="{35BC2A4B-3B2C-2A4B-8018-547C24F49FE1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0" creationId="{4ED0E1D8-4AE5-EC4F-98D2-681332F33DB5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1" creationId="{0AE19539-8B68-894F-A5B4-4AAA523F5804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71" creationId="{D7166239-DD51-7C43-AD88-A5AA3E662386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2" creationId="{EBF57C9F-B3D2-3148-910C-28A0BB7BA998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3" creationId="{3E30DBC4-EDAD-FC45-882C-B0F92E988608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4" creationId="{BAD7BC3F-E455-FD4A-88EA-629C71C848F6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75" creationId="{A6977C39-EDA0-A44B-A78E-9FA472136634}"/>
          </ac:spMkLst>
        </pc:spChg>
        <pc:spChg chg="mod">
          <ac:chgData name="Narang, Sonali" userId="9e80b397-6e2f-49b1-9374-ccdad8589140" providerId="ADAL" clId="{08EB3AD7-677B-AA4A-90AD-5577AE246557}" dt="2021-08-16T17:34:28.840" v="9381" actId="1035"/>
          <ac:spMkLst>
            <pc:docMk/>
            <pc:sldMk cId="3911031167" sldId="256"/>
            <ac:spMk id="175" creationId="{DB3810A4-DAF1-F44E-A03D-0738DBAD83F1}"/>
          </ac:spMkLst>
        </pc:spChg>
        <pc:spChg chg="mod">
          <ac:chgData name="Narang, Sonali" userId="9e80b397-6e2f-49b1-9374-ccdad8589140" providerId="ADAL" clId="{08EB3AD7-677B-AA4A-90AD-5577AE246557}" dt="2021-08-16T15:38:12.522" v="9223" actId="2710"/>
          <ac:spMkLst>
            <pc:docMk/>
            <pc:sldMk cId="3911031167" sldId="256"/>
            <ac:spMk id="176" creationId="{1E1383D3-F3F1-1B4F-9758-6BF6897B0658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76" creationId="{FC411575-0C0D-1E49-8597-E593425CCA34}"/>
          </ac:spMkLst>
        </pc:spChg>
        <pc:spChg chg="mod">
          <ac:chgData name="Narang, Sonali" userId="9e80b397-6e2f-49b1-9374-ccdad8589140" providerId="ADAL" clId="{08EB3AD7-677B-AA4A-90AD-5577AE246557}" dt="2021-08-16T17:34:33.330" v="9383" actId="1036"/>
          <ac:spMkLst>
            <pc:docMk/>
            <pc:sldMk cId="3911031167" sldId="256"/>
            <ac:spMk id="177" creationId="{648460FB-59DD-7642-8707-36490C9A81A0}"/>
          </ac:spMkLst>
        </pc:spChg>
        <pc:spChg chg="add mod topLvl">
          <ac:chgData name="Narang, Sonali" userId="9e80b397-6e2f-49b1-9374-ccdad8589140" providerId="ADAL" clId="{08EB3AD7-677B-AA4A-90AD-5577AE246557}" dt="2021-08-16T17:33:26.180" v="9370" actId="1036"/>
          <ac:spMkLst>
            <pc:docMk/>
            <pc:sldMk cId="3911031167" sldId="256"/>
            <ac:spMk id="178" creationId="{24504B2C-9F67-184D-9FAF-0C1CF83269D2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79" creationId="{4B958CD1-C86B-C04E-84FD-1F9E953550D7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79" creationId="{ED989FB6-7CE5-E340-92A6-6420A5867331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0" creationId="{17D31DEF-A022-0041-82CE-42AE293AF508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80" creationId="{279A0AC8-1CDB-5948-86AE-16C8B4BC193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0" creationId="{A024FD85-6630-5E45-AE4A-FE36A7B3A582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1" creationId="{2541EDAB-B71C-E840-9C85-441C5D2C6117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1" creationId="{5B483810-19DB-3B49-8D3A-D0B5F4F5A85C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81" creationId="{7079DE93-BE9A-A744-8037-FE00442AD833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2" creationId="{803D77F4-93EB-9E4C-9647-386D9799A93C}"/>
          </ac:spMkLst>
        </pc:spChg>
        <pc:spChg chg="mod">
          <ac:chgData name="Narang, Sonali" userId="9e80b397-6e2f-49b1-9374-ccdad8589140" providerId="ADAL" clId="{08EB3AD7-677B-AA4A-90AD-5577AE246557}" dt="2021-08-16T15:38:52.246" v="9227"/>
          <ac:spMkLst>
            <pc:docMk/>
            <pc:sldMk cId="3911031167" sldId="256"/>
            <ac:spMk id="182" creationId="{E7CD2965-195E-C24B-B337-5D508B638186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2" creationId="{EA5A0F46-EE6E-8D4D-AFC1-D2B37132D333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3" creationId="{2599D05A-62BA-5C4C-93AC-F5A9A6ED05A5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3" creationId="{4F54C46E-D647-D94B-A777-05EAE5463230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4" creationId="{59D8A5C4-A7CA-E44C-AC1D-C21B1AE041B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4" creationId="{C727B2AC-2586-3D4F-A311-8FC61DE9E2E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5" creationId="{512FD943-7CFF-C047-BD9D-A64D8A402E19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5" creationId="{F20EF0EB-0E0C-7B46-8D16-AE0F821CABC8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6" creationId="{2953A572-BFF5-DF46-AB45-818F3FE441DD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6" creationId="{A542815B-9137-5C4A-BB99-25DC5439DF5C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7" creationId="{07291B2F-3D34-0846-8E36-2C5FE69A9F93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7" creationId="{F3224387-761D-3F41-A77D-DAE0CECBFFE6}"/>
          </ac:spMkLst>
        </pc:spChg>
        <pc:spChg chg="mod">
          <ac:chgData name="Narang, Sonali" userId="9e80b397-6e2f-49b1-9374-ccdad8589140" providerId="ADAL" clId="{08EB3AD7-677B-AA4A-90AD-5577AE246557}" dt="2021-07-09T20:16:57.761" v="5055"/>
          <ac:spMkLst>
            <pc:docMk/>
            <pc:sldMk cId="3911031167" sldId="256"/>
            <ac:spMk id="188" creationId="{26002FBF-ECEE-5D4C-8DFF-E4B09162F7A9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8" creationId="{93109207-11A3-CD41-AC70-DA9B1E29F76F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89" creationId="{F9AAB0B0-135E-A64D-BC0D-89EE4D0B17BB}"/>
          </ac:spMkLst>
        </pc:spChg>
        <pc:spChg chg="add del mod">
          <ac:chgData name="Narang, Sonali" userId="9e80b397-6e2f-49b1-9374-ccdad8589140" providerId="ADAL" clId="{08EB3AD7-677B-AA4A-90AD-5577AE246557}" dt="2021-08-16T15:39:50.603" v="9234" actId="478"/>
          <ac:spMkLst>
            <pc:docMk/>
            <pc:sldMk cId="3911031167" sldId="256"/>
            <ac:spMk id="190" creationId="{266C3B46-D378-344A-BAE4-E2A30BC1B40C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0" creationId="{E1EA1D8C-0446-354A-8D84-B4DAEA74F7EC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1" creationId="{07C43013-DA55-FB46-B998-7755D634D9C3}"/>
          </ac:spMkLst>
        </pc:spChg>
        <pc:spChg chg="add mod">
          <ac:chgData name="Narang, Sonali" userId="9e80b397-6e2f-49b1-9374-ccdad8589140" providerId="ADAL" clId="{08EB3AD7-677B-AA4A-90AD-5577AE246557}" dt="2021-08-16T17:33:31.274" v="9371" actId="1036"/>
          <ac:spMkLst>
            <pc:docMk/>
            <pc:sldMk cId="3911031167" sldId="256"/>
            <ac:spMk id="192" creationId="{25C68709-E17A-6242-8480-1FEF3D96B0E3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2" creationId="{65A985AD-AE43-974E-8C51-A8978152B05D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3" creationId="{6BF69430-9111-8942-8AD5-2A10BE702EF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4" creationId="{74B8A319-88BA-274C-9DC3-8FEEE152DC0C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4" creationId="{F9095176-45B6-6D49-AEE1-FC2FC73A1483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5" creationId="{02C16940-0C9F-8C4F-8F22-FFC39B632565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5" creationId="{FE542D4B-27AD-CD48-AF99-E5E8B95C534C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6" creationId="{3BA1BE5A-8C30-0C45-BEA0-9689CB9D08B9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6" creationId="{3FC9EC6F-0B8B-794D-BE62-9AE552BB3B47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7" creationId="{43810E6C-458F-6541-AC41-74BAE311361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7" creationId="{9DA528DF-82A5-AB40-9690-02631B88EF57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8" creationId="{394A9667-BA38-304D-B861-A09A54D61878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8" creationId="{7AD80C80-8DF2-AB4D-AF13-CA9067877B18}"/>
          </ac:spMkLst>
        </pc:spChg>
        <pc:spChg chg="mod">
          <ac:chgData name="Narang, Sonali" userId="9e80b397-6e2f-49b1-9374-ccdad8589140" providerId="ADAL" clId="{08EB3AD7-677B-AA4A-90AD-5577AE246557}" dt="2021-08-16T17:35:32.489" v="9406"/>
          <ac:spMkLst>
            <pc:docMk/>
            <pc:sldMk cId="3911031167" sldId="256"/>
            <ac:spMk id="199" creationId="{0F23526B-E9C8-AD4B-9394-E0B51AE8A2F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199" creationId="{A4C7D0E9-3E00-894A-B5D1-D72485975863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0" creationId="{22F852BC-7681-4941-A77F-A83CEE8BEFDC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1" creationId="{0B2D105E-C00D-9047-9B14-8496523F65EC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1" creationId="{9E69E0D9-462B-A64A-9BA5-62CFD1E997A1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2" creationId="{89590D26-D726-E042-9894-B5A48B725AF4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3" creationId="{E5533D7F-0BA2-0947-8905-49BE94C55399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4" creationId="{7A395468-C80A-8941-A8A6-6D63017DB58F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5" creationId="{2C2FE6B4-BF14-234F-89B0-6CCDA0B0E9E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5" creationId="{D7EDCDB7-820D-4F40-8DB2-F7FF900E8B8F}"/>
          </ac:spMkLst>
        </pc:spChg>
        <pc:spChg chg="mod">
          <ac:chgData name="Narang, Sonali" userId="9e80b397-6e2f-49b1-9374-ccdad8589140" providerId="ADAL" clId="{08EB3AD7-677B-AA4A-90AD-5577AE246557}" dt="2021-08-16T17:35:49.269" v="9408"/>
          <ac:spMkLst>
            <pc:docMk/>
            <pc:sldMk cId="3911031167" sldId="256"/>
            <ac:spMk id="206" creationId="{2F773465-F337-5D48-9BA9-335263D4776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6" creationId="{8D076AA6-12D7-4C42-A39D-B9BF86054E6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7" creationId="{B1FAD7F2-9FC4-0D46-A5A7-4AD8868F2FD1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08" creationId="{5AAA3738-0827-F143-BC69-115B044D6A54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8" creationId="{8D8A98FD-FBA2-FF41-89E5-EA25F0BE6FAD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09" creationId="{2A7FFDBD-47AE-F348-BDF8-7B989EDF33E6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09" creationId="{AADED559-70ED-6642-8A24-8EF363BD499D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0" creationId="{54D43A35-67CB-4C46-8681-708B86FA8B79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11" creationId="{7B8F5364-A815-E24B-8386-43A6BD235DE9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1" creationId="{A374D684-9B96-CA41-A7EE-849BDF8394D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2" creationId="{5F86953F-DCBC-564A-BBBB-8A36ECC9BACB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3" creationId="{A1EF1079-0CB3-6747-982E-620BF98AE51A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4" creationId="{0A4A3560-9A63-834A-BD65-E827C53BE27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5" creationId="{4E6B5FC7-91DE-9E49-9E0C-A520AA228FFE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16" creationId="{96339A84-2EB3-0849-9F1B-BB418CC800E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6" creationId="{E74560F7-D84F-6349-8DD8-2250D714A15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7" creationId="{3F90A370-383B-8645-B7AB-6E130B7048EB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17" creationId="{93831466-4D43-A544-89B6-90D09022AF89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8" creationId="{D57C77CB-5A82-9E4B-BB51-C69700213683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18" creationId="{F9A66AD9-BAD2-BC43-86FF-3A00AB2B3A03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19" creationId="{2EDBA915-8959-E44D-A595-FB687CF22386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19" creationId="{A04674AE-2738-844E-B880-B0CD5469C686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0" creationId="{2ECD72AD-9C83-F04D-A92D-C47BA93A3C40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20" creationId="{77F2C9F8-0C77-AC44-AA44-E02E94DCBF01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21" creationId="{3B21A699-1A44-9246-ACDD-BC28D5648E87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1" creationId="{CD21A19F-E21F-D142-971D-91DCA98B50DB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2" creationId="{2801199B-BE2E-CA42-82B3-C70806A45E1E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22" creationId="{A25913A9-8823-ED43-B315-62A30E51BC7B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23" creationId="{0536CE7F-7C1A-7440-9764-FE30A1F8DC4E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3" creationId="{E2E07B56-F8C7-134E-AFA3-8074713BB833}"/>
          </ac:spMkLst>
        </pc:spChg>
        <pc:spChg chg="mod">
          <ac:chgData name="Narang, Sonali" userId="9e80b397-6e2f-49b1-9374-ccdad8589140" providerId="ADAL" clId="{08EB3AD7-677B-AA4A-90AD-5577AE246557}" dt="2021-06-14T20:26:43.059" v="1033"/>
          <ac:spMkLst>
            <pc:docMk/>
            <pc:sldMk cId="3911031167" sldId="256"/>
            <ac:spMk id="224" creationId="{54C0B486-600F-8E44-8845-B6FEECCCC40E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4" creationId="{686CDC3B-15FD-3240-9D21-4835BAE832BE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5" creationId="{F6DA13B4-4706-8846-9104-944C40BD1130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6" creationId="{EAEC98EB-3C93-0A4A-9E30-1EE79A8D5047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7" creationId="{F07E6E0A-BA2F-6B44-8F87-0DA6E841649E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8" creationId="{01CA1951-FF10-224C-A3D7-7AE1368A8FF7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28" creationId="{7BAAD675-4E0D-A646-8CD4-1342C1EE2312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29" creationId="{4F4B96D0-C739-2743-9912-524D90486257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30" creationId="{A84F3475-66EB-5445-8407-DEC868BE2C03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31" creationId="{F6211086-B408-074B-B11D-347723036BD9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32" creationId="{0BA08D14-2D06-B14D-866B-3DA172931C27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2" creationId="{3FC18985-AF20-0F49-A57A-ECA761AB68D3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3" creationId="{0DD5DE21-A97B-664E-977F-2418FDA73BA7}"/>
          </ac:spMkLst>
        </pc:spChg>
        <pc:spChg chg="mod">
          <ac:chgData name="Narang, Sonali" userId="9e80b397-6e2f-49b1-9374-ccdad8589140" providerId="ADAL" clId="{08EB3AD7-677B-AA4A-90AD-5577AE246557}" dt="2021-08-16T17:39:12.366" v="9528"/>
          <ac:spMkLst>
            <pc:docMk/>
            <pc:sldMk cId="3911031167" sldId="256"/>
            <ac:spMk id="233" creationId="{620C5770-2A81-144E-AEA8-C596E7DA942B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5" creationId="{337FAEAF-E3D1-224E-AFFB-1A44A4E33409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6" creationId="{A454A657-958B-234D-B1B1-1512D8C9879E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7" creationId="{1DDB4B15-2F81-1B40-B69E-A5E14F403BE9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38" creationId="{DB5ACEBB-E50E-7A48-BEEB-55051B7AF2C3}"/>
          </ac:spMkLst>
        </pc:spChg>
        <pc:spChg chg="add 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38" creationId="{F2223E0E-28AA-BB4A-ABB3-4E0E380A21C7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0" creationId="{AD5C7794-D8C3-DB4A-9A3F-5850C0FBEF32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1" creationId="{ED022677-CB04-784A-833B-7262E437ACAF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42" creationId="{164380FC-31F9-F340-A240-6AE86B8F074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43" creationId="{9572CA2B-91F2-A448-B91D-076A1EB92789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4" creationId="{0E01C683-51CC-A746-919A-1E239563B8D8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5" creationId="{593DE80A-D267-B941-B131-634ED5D75D61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6" creationId="{CD5EFE12-716B-5841-9B50-F59D4E6425C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47" creationId="{6888DF30-9ADB-444A-B754-69393F48E600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7" creationId="{9EAA361E-8C74-624F-B54F-9E8E0EB74217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48" creationId="{3175AB00-6A32-0545-B529-7CEA310F3C53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8" creationId="{E07E8981-095C-694E-807D-8C533DD6B67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49" creationId="{3586E4CD-A9AC-3449-9578-65621B14D8CA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49" creationId="{AAEC3864-F77F-8B4D-932D-2EB70EBAC2A9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0" creationId="{48FBCAC7-8A67-0B4A-8F58-FDBE70978A35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1" creationId="{039E7201-7693-4C42-95F3-B4A1D4A8BDDD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1" creationId="{DB07E2F9-BD6B-A148-9820-23D26C92834F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2" creationId="{C50EA744-CDF8-2A44-BC6A-DAEE504A7C83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2" creationId="{E4C20AF0-2D93-634B-8E96-7EEC0ED5DFF0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3" creationId="{4843D190-E8B1-494F-8548-C2B284F686B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3" creationId="{96C0B87E-A473-0E48-8651-64B3F31FF091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4" creationId="{E0B2DA2D-D723-874C-9969-91477A428C56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4" creationId="{F43425EC-6A11-504B-996B-FF8AF4C125F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5" creationId="{5E6E4F80-06A1-7D4A-816E-7765490F008B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5" creationId="{A286D862-9552-7344-B6A4-3C346489C1BE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6" creationId="{0166C9AC-3C2D-1644-A452-6BDD6036250C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6" creationId="{287A8DD9-97C5-9148-A1D8-1E5F343C5367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7" creationId="{96892891-7BBB-A842-B03C-D23F452E6D10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7" creationId="{C4D74DCD-48BC-A247-9DB7-3A2111808BC2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8" creationId="{8FF0F74A-8319-A64F-ACC7-4C031A93B2FC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8" creationId="{FE5E8D5D-40F7-824E-8830-953B7F66BBC9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59" creationId="{22203458-4368-2C41-AA20-243EA0218D6B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59" creationId="{A070455D-27C6-DB42-A4FA-60A738965720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0" creationId="{6D7FE494-35E7-4F4E-8624-DC02925AD9F2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0" creationId="{901D1741-EEDD-3643-96B9-A2F4FBAB5A93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1" creationId="{24002BB7-74E8-A242-AAB0-1A9E68F9EFE3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2" creationId="{8594F611-F015-464B-9A65-CD7EEEE80243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2" creationId="{C9A3313D-82A2-154F-8AF8-2F84FC6D9DF3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3" creationId="{26B5DEB8-E885-3741-A538-DB5D79C8D8D6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3" creationId="{A61026CE-BCEC-1342-8E4C-875EE1549B35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4" creationId="{0A65CCAF-BD2F-EA4A-9774-043A4BF99D36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4" creationId="{77D656D9-C5D8-6242-8A90-EF180E6112BC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5" creationId="{0980B8F8-C9EF-414B-A785-1A079F77249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5" creationId="{2569E7CF-13B3-F040-8D88-3A9517D71107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6" creationId="{7A92896A-3DD9-CF47-9665-5DAC8FC28D1C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6" creationId="{A37B828F-2E86-4548-BA2E-5A36BEDB813F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7" creationId="{B5B74152-16A1-FA45-9D1B-CE58DA3AD1FB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7" creationId="{DB2BBD03-3685-814D-9507-CD360D6EA346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68" creationId="{16B647B0-6716-7349-81AD-0A2AF55F25E4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8" creationId="{580EAE7D-B97B-8A4F-B844-46834959BDF7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69" creationId="{65EBBFE2-DA49-0846-9DF0-D55A38B2F21D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70" creationId="{9B161CFE-F9B0-054F-998B-F6E4391B02F4}"/>
          </ac:spMkLst>
        </pc:spChg>
        <pc:spChg chg="mod">
          <ac:chgData name="Narang, Sonali" userId="9e80b397-6e2f-49b1-9374-ccdad8589140" providerId="ADAL" clId="{08EB3AD7-677B-AA4A-90AD-5577AE246557}" dt="2021-08-16T18:38:51.078" v="9794"/>
          <ac:spMkLst>
            <pc:docMk/>
            <pc:sldMk cId="3911031167" sldId="256"/>
            <ac:spMk id="271" creationId="{F72D52D4-5FD3-9143-B780-FB241CD0311C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2" creationId="{8A6D3FE3-2B36-F946-A3D8-515BC2684FFA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3" creationId="{91FB8300-4E3E-3C4E-B3C8-79BE39D07638}"/>
          </ac:spMkLst>
        </pc:spChg>
        <pc:spChg chg="add mod">
          <ac:chgData name="Narang, Sonali" userId="9e80b397-6e2f-49b1-9374-ccdad8589140" providerId="ADAL" clId="{08EB3AD7-677B-AA4A-90AD-5577AE246557}" dt="2021-08-16T20:59:02.996" v="10022"/>
          <ac:spMkLst>
            <pc:docMk/>
            <pc:sldMk cId="3911031167" sldId="256"/>
            <ac:spMk id="273" creationId="{FDDDFDBA-A942-204F-8394-C2FEA9B014E1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4" creationId="{105810DE-7EE3-ED4D-859D-A5653B3CBA3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5" creationId="{FC311DD2-059D-494C-9D4F-31879A47D46B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6" creationId="{0E77830F-C859-1F4A-A8C4-DF2B5EC4B2A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7" creationId="{97AFCC68-69A9-AB4C-B101-87B6BEBAB81F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8" creationId="{C1C56159-17BA-AA4A-BFF4-242BACB94C39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79" creationId="{08BF11EC-DF6D-2C46-98DE-78D62D7A6EA0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0" creationId="{81E077D1-FDCD-C043-B999-B524E97726B3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1" creationId="{4FE67029-2799-5049-B98D-78236D37F9C7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2" creationId="{87D8FE4E-E6C0-7A4E-BC7D-74FB0961266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3" creationId="{D69CA0D6-0F4A-AB4E-8910-F2C545D2DA16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4" creationId="{3FEAD3B6-E95B-9F44-A83D-914F2EBAE775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5" creationId="{43ED9175-3125-CF46-BBB9-C079381FBFBC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6" creationId="{5D9B369A-EF38-D741-866F-38971E59570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7" creationId="{F1DE02D9-86D3-6341-B673-79CE0DE7A908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8" creationId="{DC240356-346C-6B49-80DD-5759D460D922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89" creationId="{7EE95B17-90F9-4748-8A2A-97C3A83888AA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90" creationId="{45B0D728-6DA9-DE44-8E3A-3FF81787269C}"/>
          </ac:spMkLst>
        </pc:spChg>
        <pc:spChg chg="mod">
          <ac:chgData name="Narang, Sonali" userId="9e80b397-6e2f-49b1-9374-ccdad8589140" providerId="ADAL" clId="{08EB3AD7-677B-AA4A-90AD-5577AE246557}" dt="2021-06-14T20:26:54.988" v="1037"/>
          <ac:spMkLst>
            <pc:docMk/>
            <pc:sldMk cId="3911031167" sldId="256"/>
            <ac:spMk id="291" creationId="{CEE2315D-2389-3B4C-9E1C-49AF2B85D983}"/>
          </ac:spMkLst>
        </pc:spChg>
        <pc:spChg chg="mod">
          <ac:chgData name="Narang, Sonali" userId="9e80b397-6e2f-49b1-9374-ccdad8589140" providerId="ADAL" clId="{08EB3AD7-677B-AA4A-90AD-5577AE246557}" dt="2021-06-14T20:29:11.007" v="1070" actId="14100"/>
          <ac:spMkLst>
            <pc:docMk/>
            <pc:sldMk cId="3911031167" sldId="256"/>
            <ac:spMk id="295" creationId="{8C94B428-2D18-2245-92F9-686E6505906E}"/>
          </ac:spMkLst>
        </pc:spChg>
        <pc:spChg chg="mod">
          <ac:chgData name="Narang, Sonali" userId="9e80b397-6e2f-49b1-9374-ccdad8589140" providerId="ADAL" clId="{08EB3AD7-677B-AA4A-90AD-5577AE246557}" dt="2021-06-14T20:30:35.205" v="1118" actId="255"/>
          <ac:spMkLst>
            <pc:docMk/>
            <pc:sldMk cId="3911031167" sldId="256"/>
            <ac:spMk id="299" creationId="{A4C41033-6EBB-4A46-8156-4EDEDAE46D67}"/>
          </ac:spMkLst>
        </pc:spChg>
        <pc:spChg chg="mod">
          <ac:chgData name="Narang, Sonali" userId="9e80b397-6e2f-49b1-9374-ccdad8589140" providerId="ADAL" clId="{08EB3AD7-677B-AA4A-90AD-5577AE246557}" dt="2021-06-14T20:30:35.205" v="1118" actId="255"/>
          <ac:spMkLst>
            <pc:docMk/>
            <pc:sldMk cId="3911031167" sldId="256"/>
            <ac:spMk id="300" creationId="{D9311867-B8CD-7F4C-B6ED-3D87A6F8D97F}"/>
          </ac:spMkLst>
        </pc:spChg>
        <pc:spChg chg="mod">
          <ac:chgData name="Narang, Sonali" userId="9e80b397-6e2f-49b1-9374-ccdad8589140" providerId="ADAL" clId="{08EB3AD7-677B-AA4A-90AD-5577AE246557}" dt="2021-06-14T20:29:57.947" v="1093" actId="255"/>
          <ac:spMkLst>
            <pc:docMk/>
            <pc:sldMk cId="3911031167" sldId="256"/>
            <ac:spMk id="302" creationId="{B5072312-3DC4-5045-8057-1E55482EBEFF}"/>
          </ac:spMkLst>
        </pc:spChg>
        <pc:spChg chg="mod">
          <ac:chgData name="Narang, Sonali" userId="9e80b397-6e2f-49b1-9374-ccdad8589140" providerId="ADAL" clId="{08EB3AD7-677B-AA4A-90AD-5577AE246557}" dt="2021-06-14T20:29:57.947" v="1093" actId="255"/>
          <ac:spMkLst>
            <pc:docMk/>
            <pc:sldMk cId="3911031167" sldId="256"/>
            <ac:spMk id="303" creationId="{D6CA25E7-96A5-D641-B6A5-9193F72BE860}"/>
          </ac:spMkLst>
        </pc:spChg>
        <pc:spChg chg="mod">
          <ac:chgData name="Narang, Sonali" userId="9e80b397-6e2f-49b1-9374-ccdad8589140" providerId="ADAL" clId="{08EB3AD7-677B-AA4A-90AD-5577AE246557}" dt="2021-06-14T20:29:57.947" v="1093" actId="255"/>
          <ac:spMkLst>
            <pc:docMk/>
            <pc:sldMk cId="3911031167" sldId="256"/>
            <ac:spMk id="304" creationId="{524E74BC-C056-1442-B1D5-1D92678D63CC}"/>
          </ac:spMkLst>
        </pc:spChg>
        <pc:spChg chg="mod">
          <ac:chgData name="Narang, Sonali" userId="9e80b397-6e2f-49b1-9374-ccdad8589140" providerId="ADAL" clId="{08EB3AD7-677B-AA4A-90AD-5577AE246557}" dt="2021-06-14T20:29:57.947" v="1093" actId="255"/>
          <ac:spMkLst>
            <pc:docMk/>
            <pc:sldMk cId="3911031167" sldId="256"/>
            <ac:spMk id="305" creationId="{0A76B2B6-FBDA-D549-A88E-5C5053D20056}"/>
          </ac:spMkLst>
        </pc:spChg>
        <pc:spChg chg="mod">
          <ac:chgData name="Narang, Sonali" userId="9e80b397-6e2f-49b1-9374-ccdad8589140" providerId="ADAL" clId="{08EB3AD7-677B-AA4A-90AD-5577AE246557}" dt="2021-06-14T20:28:37.328" v="1062" actId="1076"/>
          <ac:spMkLst>
            <pc:docMk/>
            <pc:sldMk cId="3911031167" sldId="256"/>
            <ac:spMk id="309" creationId="{30BC4E6F-0998-BC41-BA53-5F048CF1966A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10" creationId="{79A29B8E-F495-5744-8561-9431A9898DE4}"/>
          </ac:spMkLst>
        </pc:spChg>
        <pc:spChg chg="mod">
          <ac:chgData name="Narang, Sonali" userId="9e80b397-6e2f-49b1-9374-ccdad8589140" providerId="ADAL" clId="{08EB3AD7-677B-AA4A-90AD-5577AE246557}" dt="2021-06-14T20:28:30.568" v="1061" actId="1076"/>
          <ac:spMkLst>
            <pc:docMk/>
            <pc:sldMk cId="3911031167" sldId="256"/>
            <ac:spMk id="314" creationId="{403247D8-022D-EB44-AC38-240E20DCF786}"/>
          </ac:spMkLst>
        </pc:spChg>
        <pc:spChg chg="mod">
          <ac:chgData name="Narang, Sonali" userId="9e80b397-6e2f-49b1-9374-ccdad8589140" providerId="ADAL" clId="{08EB3AD7-677B-AA4A-90AD-5577AE246557}" dt="2021-06-14T20:28:43.241" v="1063" actId="1076"/>
          <ac:spMkLst>
            <pc:docMk/>
            <pc:sldMk cId="3911031167" sldId="256"/>
            <ac:spMk id="315" creationId="{D3CDDA3E-E26E-E146-8054-8BC76CD21D1F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16" creationId="{6616C2CA-05B6-CB4C-BC60-FEED62C268DB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17" creationId="{4F6AB81B-9C6C-D84C-8F6D-845B57F4342D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18" creationId="{A64DD7EB-C265-8D4A-AB4B-BF5D1667DBCF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19" creationId="{D8143588-BDDA-144B-B982-16171DE5697F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0" creationId="{798B526E-C098-B240-9E64-5DE95CFD9350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1" creationId="{0547DB8A-CEB9-0146-9327-DCE4465E148D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2" creationId="{55BF7CFA-AABC-D14D-B573-05A063FEEBBF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3" creationId="{369E8A64-ACB0-4B4A-B9F7-41A94EFA490B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4" creationId="{3E845AF8-15A6-5449-9162-E09758720CD3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5" creationId="{4CE29143-428A-1A46-A10F-ECB7AA0EBF1C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6" creationId="{9CCF63A9-77E0-CE48-988C-B5EC6600AF35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7" creationId="{7926A449-677C-2047-8DB1-F2A478BF5977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8" creationId="{93455FFC-3B20-E743-AC3C-4D33680CE047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29" creationId="{88EE6433-9BAC-C349-A1FA-F458ADBF9418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30" creationId="{3F8375C6-A227-E749-B14C-8E9229DC930D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31" creationId="{35DA3CEE-6FA1-4342-81EE-C0224C7A0A7F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32" creationId="{86955194-3A65-5C40-AE7E-2B74E429A2A5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33" creationId="{81A76C34-5EC9-2740-BE8C-71FDB8479731}"/>
          </ac:spMkLst>
        </pc:spChg>
        <pc:spChg chg="mod">
          <ac:chgData name="Narang, Sonali" userId="9e80b397-6e2f-49b1-9374-ccdad8589140" providerId="ADAL" clId="{08EB3AD7-677B-AA4A-90AD-5577AE246557}" dt="2021-06-14T20:28:37.328" v="1062" actId="1076"/>
          <ac:spMkLst>
            <pc:docMk/>
            <pc:sldMk cId="3911031167" sldId="256"/>
            <ac:spMk id="334" creationId="{32958403-2DB5-8942-9558-C889C6D373C7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35" creationId="{C63E8B11-412A-4F4B-9C59-FA519B2E2430}"/>
          </ac:spMkLst>
        </pc:spChg>
        <pc:spChg chg="mod">
          <ac:chgData name="Narang, Sonali" userId="9e80b397-6e2f-49b1-9374-ccdad8589140" providerId="ADAL" clId="{08EB3AD7-677B-AA4A-90AD-5577AE246557}" dt="2021-06-14T20:28:30.568" v="1061" actId="1076"/>
          <ac:spMkLst>
            <pc:docMk/>
            <pc:sldMk cId="3911031167" sldId="256"/>
            <ac:spMk id="339" creationId="{96332935-95CD-6641-BB72-3FE8F00E4F3B}"/>
          </ac:spMkLst>
        </pc:spChg>
        <pc:spChg chg="mod">
          <ac:chgData name="Narang, Sonali" userId="9e80b397-6e2f-49b1-9374-ccdad8589140" providerId="ADAL" clId="{08EB3AD7-677B-AA4A-90AD-5577AE246557}" dt="2021-06-14T20:28:43.241" v="1063" actId="1076"/>
          <ac:spMkLst>
            <pc:docMk/>
            <pc:sldMk cId="3911031167" sldId="256"/>
            <ac:spMk id="340" creationId="{C6B691B7-A55A-024C-871C-7B848C991C25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1" creationId="{C5A96917-A8C1-E84D-9068-80CE52E23148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2" creationId="{E6B775A1-F400-9640-9EAC-5D4D15D33E6A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3" creationId="{526FDB68-3E4F-2648-9FC2-40CCBF755F24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4" creationId="{131690A6-3032-0A46-89C8-5B4AFF09FB0E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5" creationId="{4D065D6F-6CD0-6449-8E06-2FF13CD8516D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6" creationId="{806E674A-C576-F84D-819B-3DF3BA554DB8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7" creationId="{5A071F3B-9FCA-0E4B-BA9B-5728A7D33053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8" creationId="{F076F5E2-9752-E64E-A209-FCC2BE18FBB6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49" creationId="{EC25B277-9FE4-4D47-BE06-64D25B7B2CB0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0" creationId="{20AD0A84-A63B-6C4E-A296-120367779546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1" creationId="{073D7927-8E0B-3641-9716-82911FDB2724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2" creationId="{1926D8C1-2A3B-3348-8073-F3E715F7B455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3" creationId="{8F1FFA53-DAB2-C04C-B354-6CD158F954E9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4" creationId="{DE62412E-7569-DA4F-BE3A-D569684FB0A1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5" creationId="{13713456-2B99-7649-9A66-1DE7A28EB259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6" creationId="{1DADD989-03D7-4D4B-92D1-5B8AE83A28E0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7" creationId="{97378B25-5530-234B-9197-D8867D1BA8C9}"/>
          </ac:spMkLst>
        </pc:spChg>
        <pc:spChg chg="mod">
          <ac:chgData name="Narang, Sonali" userId="9e80b397-6e2f-49b1-9374-ccdad8589140" providerId="ADAL" clId="{08EB3AD7-677B-AA4A-90AD-5577AE246557}" dt="2021-06-14T20:26:57.886" v="1039"/>
          <ac:spMkLst>
            <pc:docMk/>
            <pc:sldMk cId="3911031167" sldId="256"/>
            <ac:spMk id="358" creationId="{D762B4A6-38AE-6A4F-9989-A1159D986E7D}"/>
          </ac:spMkLst>
        </pc:spChg>
        <pc:grpChg chg="mod">
          <ac:chgData name="Narang, Sonali" userId="9e80b397-6e2f-49b1-9374-ccdad8589140" providerId="ADAL" clId="{08EB3AD7-677B-AA4A-90AD-5577AE246557}" dt="2021-07-09T20:11:46.684" v="4961" actId="1076"/>
          <ac:grpSpMkLst>
            <pc:docMk/>
            <pc:sldMk cId="3911031167" sldId="256"/>
            <ac:grpSpMk id="10" creationId="{D88D7517-4649-454B-B33B-40859B6B3E1E}"/>
          </ac:grpSpMkLst>
        </pc:grpChg>
        <pc:grpChg chg="add del mod">
          <ac:chgData name="Narang, Sonali" userId="9e80b397-6e2f-49b1-9374-ccdad8589140" providerId="ADAL" clId="{08EB3AD7-677B-AA4A-90AD-5577AE246557}" dt="2021-08-16T15:36:12.425" v="9184" actId="165"/>
          <ac:grpSpMkLst>
            <pc:docMk/>
            <pc:sldMk cId="3911031167" sldId="256"/>
            <ac:grpSpMk id="11" creationId="{DB407D4F-0A95-AF40-A984-46A43C3631A4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12" creationId="{2CDEDD4C-0E23-9047-BC1C-6340BBB0854C}"/>
          </ac:grpSpMkLst>
        </pc:grpChg>
        <pc:grpChg chg="add">
          <ac:chgData name="Narang, Sonali" userId="9e80b397-6e2f-49b1-9374-ccdad8589140" providerId="ADAL" clId="{08EB3AD7-677B-AA4A-90AD-5577AE246557}" dt="2021-08-16T17:37:13.544" v="9511" actId="164"/>
          <ac:grpSpMkLst>
            <pc:docMk/>
            <pc:sldMk cId="3911031167" sldId="256"/>
            <ac:grpSpMk id="17" creationId="{3F67FD86-D91B-4140-AB7A-5F7A63EFE7A3}"/>
          </ac:grpSpMkLst>
        </pc:grpChg>
        <pc:grpChg chg="add mod">
          <ac:chgData name="Narang, Sonali" userId="9e80b397-6e2f-49b1-9374-ccdad8589140" providerId="ADAL" clId="{08EB3AD7-677B-AA4A-90AD-5577AE246557}" dt="2021-08-16T17:38:40.480" v="9522" actId="408"/>
          <ac:grpSpMkLst>
            <pc:docMk/>
            <pc:sldMk cId="3911031167" sldId="256"/>
            <ac:grpSpMk id="18" creationId="{32DCAE30-6732-4841-8CE2-B79D87B48FD6}"/>
          </ac:grpSpMkLst>
        </pc:grpChg>
        <pc:grpChg chg="add">
          <ac:chgData name="Narang, Sonali" userId="9e80b397-6e2f-49b1-9374-ccdad8589140" providerId="ADAL" clId="{08EB3AD7-677B-AA4A-90AD-5577AE246557}" dt="2021-08-16T17:39:11.047" v="9527" actId="164"/>
          <ac:grpSpMkLst>
            <pc:docMk/>
            <pc:sldMk cId="3911031167" sldId="256"/>
            <ac:grpSpMk id="19" creationId="{6203E5D2-60A7-6F4E-870B-8B72DD09A72D}"/>
          </ac:grpSpMkLst>
        </pc:grpChg>
        <pc:grpChg chg="add mod">
          <ac:chgData name="Narang, Sonali" userId="9e80b397-6e2f-49b1-9374-ccdad8589140" providerId="ADAL" clId="{08EB3AD7-677B-AA4A-90AD-5577AE246557}" dt="2021-08-16T17:40:11.075" v="9544" actId="167"/>
          <ac:grpSpMkLst>
            <pc:docMk/>
            <pc:sldMk cId="3911031167" sldId="256"/>
            <ac:grpSpMk id="20" creationId="{4A113A93-4C9C-3949-B1DB-412F52E05721}"/>
          </ac:grpSpMkLst>
        </pc:grpChg>
        <pc:grpChg chg="add mod">
          <ac:chgData name="Narang, Sonali" userId="9e80b397-6e2f-49b1-9374-ccdad8589140" providerId="ADAL" clId="{08EB3AD7-677B-AA4A-90AD-5577AE246557}" dt="2021-08-16T17:40:11.075" v="9544" actId="167"/>
          <ac:grpSpMkLst>
            <pc:docMk/>
            <pc:sldMk cId="3911031167" sldId="256"/>
            <ac:grpSpMk id="22" creationId="{617CA9D0-AC14-7E48-AE00-CE1CFE9310EF}"/>
          </ac:grpSpMkLst>
        </pc:grpChg>
        <pc:grpChg chg="add del mod">
          <ac:chgData name="Narang, Sonali" userId="9e80b397-6e2f-49b1-9374-ccdad8589140" providerId="ADAL" clId="{08EB3AD7-677B-AA4A-90AD-5577AE246557}" dt="2021-07-09T20:13:20.934" v="4980"/>
          <ac:grpSpMkLst>
            <pc:docMk/>
            <pc:sldMk cId="3911031167" sldId="256"/>
            <ac:grpSpMk id="91" creationId="{2850C49E-83F9-C945-9F69-1F44EEBD49DA}"/>
          </ac:grpSpMkLst>
        </pc:grpChg>
        <pc:grpChg chg="add del mod">
          <ac:chgData name="Narang, Sonali" userId="9e80b397-6e2f-49b1-9374-ccdad8589140" providerId="ADAL" clId="{08EB3AD7-677B-AA4A-90AD-5577AE246557}" dt="2021-08-16T17:38:58.426" v="9526" actId="478"/>
          <ac:grpSpMkLst>
            <pc:docMk/>
            <pc:sldMk cId="3911031167" sldId="256"/>
            <ac:grpSpMk id="91" creationId="{FD9B064F-3485-5542-AFE3-10600C55AAFB}"/>
          </ac:grpSpMkLst>
        </pc:grpChg>
        <pc:grpChg chg="mod">
          <ac:chgData name="Narang, Sonali" userId="9e80b397-6e2f-49b1-9374-ccdad8589140" providerId="ADAL" clId="{08EB3AD7-677B-AA4A-90AD-5577AE246557}" dt="2021-08-16T15:36:16.978" v="9185"/>
          <ac:grpSpMkLst>
            <pc:docMk/>
            <pc:sldMk cId="3911031167" sldId="256"/>
            <ac:grpSpMk id="92" creationId="{B3EF9FD5-2771-684D-A642-6E8D212855B5}"/>
          </ac:grpSpMkLst>
        </pc:grpChg>
        <pc:grpChg chg="del mod">
          <ac:chgData name="Narang, Sonali" userId="9e80b397-6e2f-49b1-9374-ccdad8589140" providerId="ADAL" clId="{08EB3AD7-677B-AA4A-90AD-5577AE246557}" dt="2021-08-16T18:38:44.460" v="9792" actId="478"/>
          <ac:grpSpMkLst>
            <pc:docMk/>
            <pc:sldMk cId="3911031167" sldId="256"/>
            <ac:grpSpMk id="96" creationId="{F3AA89EB-F925-3649-A3BE-B492BEBFEFFB}"/>
          </ac:grpSpMkLst>
        </pc:grpChg>
        <pc:grpChg chg="mod">
          <ac:chgData name="Narang, Sonali" userId="9e80b397-6e2f-49b1-9374-ccdad8589140" providerId="ADAL" clId="{08EB3AD7-677B-AA4A-90AD-5577AE246557}" dt="2021-07-09T20:13:14.100" v="4977"/>
          <ac:grpSpMkLst>
            <pc:docMk/>
            <pc:sldMk cId="3911031167" sldId="256"/>
            <ac:grpSpMk id="98" creationId="{B5D671A5-7A76-9842-81C0-21B2841C1BE7}"/>
          </ac:grpSpMkLst>
        </pc:grpChg>
        <pc:grpChg chg="mod">
          <ac:chgData name="Narang, Sonali" userId="9e80b397-6e2f-49b1-9374-ccdad8589140" providerId="ADAL" clId="{08EB3AD7-677B-AA4A-90AD-5577AE246557}" dt="2021-07-09T20:13:14.100" v="4977"/>
          <ac:grpSpMkLst>
            <pc:docMk/>
            <pc:sldMk cId="3911031167" sldId="256"/>
            <ac:grpSpMk id="99" creationId="{0EF5134E-F6D1-F94B-88A9-CA1C5D02C444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99" creationId="{80BC806D-5439-004C-A4BE-E2E79858E9BC}"/>
          </ac:grpSpMkLst>
        </pc:grpChg>
        <pc:grpChg chg="mod">
          <ac:chgData name="Narang, Sonali" userId="9e80b397-6e2f-49b1-9374-ccdad8589140" providerId="ADAL" clId="{08EB3AD7-677B-AA4A-90AD-5577AE246557}" dt="2021-08-16T15:36:16.978" v="9185"/>
          <ac:grpSpMkLst>
            <pc:docMk/>
            <pc:sldMk cId="3911031167" sldId="256"/>
            <ac:grpSpMk id="101" creationId="{9B7E4869-060B-CB48-ACF0-4EF041B70790}"/>
          </ac:grpSpMkLst>
        </pc:grpChg>
        <pc:grpChg chg="mod">
          <ac:chgData name="Narang, Sonali" userId="9e80b397-6e2f-49b1-9374-ccdad8589140" providerId="ADAL" clId="{08EB3AD7-677B-AA4A-90AD-5577AE246557}" dt="2021-08-16T15:36:16.978" v="9185"/>
          <ac:grpSpMkLst>
            <pc:docMk/>
            <pc:sldMk cId="3911031167" sldId="256"/>
            <ac:grpSpMk id="102" creationId="{8DB65607-058B-DD46-B84B-5E5E5E5280C7}"/>
          </ac:grpSpMkLst>
        </pc:grpChg>
        <pc:grpChg chg="mod">
          <ac:chgData name="Narang, Sonali" userId="9e80b397-6e2f-49b1-9374-ccdad8589140" providerId="ADAL" clId="{08EB3AD7-677B-AA4A-90AD-5577AE246557}" dt="2021-07-09T20:13:14.100" v="4977"/>
          <ac:grpSpMkLst>
            <pc:docMk/>
            <pc:sldMk cId="3911031167" sldId="256"/>
            <ac:grpSpMk id="104" creationId="{CB6EA139-6F96-EE42-B369-284DD842A48C}"/>
          </ac:grpSpMkLst>
        </pc:grpChg>
        <pc:grpChg chg="mod">
          <ac:chgData name="Narang, Sonali" userId="9e80b397-6e2f-49b1-9374-ccdad8589140" providerId="ADAL" clId="{08EB3AD7-677B-AA4A-90AD-5577AE246557}" dt="2021-07-09T20:13:14.100" v="4977"/>
          <ac:grpSpMkLst>
            <pc:docMk/>
            <pc:sldMk cId="3911031167" sldId="256"/>
            <ac:grpSpMk id="105" creationId="{AF0BDF64-20A6-CF4B-AF0B-1933049AB031}"/>
          </ac:grpSpMkLst>
        </pc:grpChg>
        <pc:grpChg chg="add del mod">
          <ac:chgData name="Narang, Sonali" userId="9e80b397-6e2f-49b1-9374-ccdad8589140" providerId="ADAL" clId="{08EB3AD7-677B-AA4A-90AD-5577AE246557}" dt="2021-08-16T15:38:53.823" v="9228"/>
          <ac:grpSpMkLst>
            <pc:docMk/>
            <pc:sldMk cId="3911031167" sldId="256"/>
            <ac:grpSpMk id="123" creationId="{456319F6-30B7-7845-98A3-CFBDBF027FD6}"/>
          </ac:grpSpMkLst>
        </pc:grpChg>
        <pc:grpChg chg="mod">
          <ac:chgData name="Narang, Sonali" userId="9e80b397-6e2f-49b1-9374-ccdad8589140" providerId="ADAL" clId="{08EB3AD7-677B-AA4A-90AD-5577AE246557}" dt="2021-08-16T15:38:52.246" v="9227"/>
          <ac:grpSpMkLst>
            <pc:docMk/>
            <pc:sldMk cId="3911031167" sldId="256"/>
            <ac:grpSpMk id="124" creationId="{96EB068F-2F96-814F-BF72-941A989D534F}"/>
          </ac:grpSpMkLst>
        </pc:grpChg>
        <pc:grpChg chg="add del mod">
          <ac:chgData name="Narang, Sonali" userId="9e80b397-6e2f-49b1-9374-ccdad8589140" providerId="ADAL" clId="{08EB3AD7-677B-AA4A-90AD-5577AE246557}" dt="2021-07-12T15:39:55.241" v="6160" actId="478"/>
          <ac:grpSpMkLst>
            <pc:docMk/>
            <pc:sldMk cId="3911031167" sldId="256"/>
            <ac:grpSpMk id="126" creationId="{AB43D948-B6A6-9849-ADF0-AF4FA9D2CBAF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126" creationId="{B7ACA5C8-FB2E-A948-85CF-E320C23C655B}"/>
          </ac:grpSpMkLst>
        </pc:grpChg>
        <pc:grpChg chg="mod">
          <ac:chgData name="Narang, Sonali" userId="9e80b397-6e2f-49b1-9374-ccdad8589140" providerId="ADAL" clId="{08EB3AD7-677B-AA4A-90AD-5577AE246557}" dt="2021-07-09T20:16:57.761" v="5055"/>
          <ac:grpSpMkLst>
            <pc:docMk/>
            <pc:sldMk cId="3911031167" sldId="256"/>
            <ac:grpSpMk id="129" creationId="{5240326B-6650-6F47-A9C2-EB2AD1DC1288}"/>
          </ac:grpSpMkLst>
        </pc:grpChg>
        <pc:grpChg chg="mod">
          <ac:chgData name="Narang, Sonali" userId="9e80b397-6e2f-49b1-9374-ccdad8589140" providerId="ADAL" clId="{08EB3AD7-677B-AA4A-90AD-5577AE246557}" dt="2021-08-16T15:38:52.246" v="9227"/>
          <ac:grpSpMkLst>
            <pc:docMk/>
            <pc:sldMk cId="3911031167" sldId="256"/>
            <ac:grpSpMk id="129" creationId="{7C00A7A1-7379-C44C-B506-1D76B254ED3D}"/>
          </ac:grpSpMkLst>
        </pc:grpChg>
        <pc:grpChg chg="mod">
          <ac:chgData name="Narang, Sonali" userId="9e80b397-6e2f-49b1-9374-ccdad8589140" providerId="ADAL" clId="{08EB3AD7-677B-AA4A-90AD-5577AE246557}" dt="2021-08-16T15:38:52.246" v="9227"/>
          <ac:grpSpMkLst>
            <pc:docMk/>
            <pc:sldMk cId="3911031167" sldId="256"/>
            <ac:grpSpMk id="130" creationId="{47D0E479-C2B7-9A41-9F2B-1EDBF375E65E}"/>
          </ac:grpSpMkLst>
        </pc:grpChg>
        <pc:grpChg chg="mod">
          <ac:chgData name="Narang, Sonali" userId="9e80b397-6e2f-49b1-9374-ccdad8589140" providerId="ADAL" clId="{08EB3AD7-677B-AA4A-90AD-5577AE246557}" dt="2021-07-09T20:16:57.761" v="5055"/>
          <ac:grpSpMkLst>
            <pc:docMk/>
            <pc:sldMk cId="3911031167" sldId="256"/>
            <ac:grpSpMk id="130" creationId="{7C6ADF0B-D252-F64E-80E7-FD41B6FCA0ED}"/>
          </ac:grpSpMkLst>
        </pc:grpChg>
        <pc:grpChg chg="del mod">
          <ac:chgData name="Narang, Sonali" userId="9e80b397-6e2f-49b1-9374-ccdad8589140" providerId="ADAL" clId="{08EB3AD7-677B-AA4A-90AD-5577AE246557}" dt="2021-06-22T18:57:57.583" v="1173" actId="478"/>
          <ac:grpSpMkLst>
            <pc:docMk/>
            <pc:sldMk cId="3911031167" sldId="256"/>
            <ac:grpSpMk id="131" creationId="{E8F33C01-784E-8B49-9631-3F0E114ED4AE}"/>
          </ac:grpSpMkLst>
        </pc:grpChg>
        <pc:grpChg chg="mod">
          <ac:chgData name="Narang, Sonali" userId="9e80b397-6e2f-49b1-9374-ccdad8589140" providerId="ADAL" clId="{08EB3AD7-677B-AA4A-90AD-5577AE246557}" dt="2021-07-09T20:16:57.761" v="5055"/>
          <ac:grpSpMkLst>
            <pc:docMk/>
            <pc:sldMk cId="3911031167" sldId="256"/>
            <ac:grpSpMk id="135" creationId="{211B992D-44B7-4747-9112-2F2D661EF90F}"/>
          </ac:grpSpMkLst>
        </pc:grpChg>
        <pc:grpChg chg="mod">
          <ac:chgData name="Narang, Sonali" userId="9e80b397-6e2f-49b1-9374-ccdad8589140" providerId="ADAL" clId="{08EB3AD7-677B-AA4A-90AD-5577AE246557}" dt="2021-07-09T20:16:57.761" v="5055"/>
          <ac:grpSpMkLst>
            <pc:docMk/>
            <pc:sldMk cId="3911031167" sldId="256"/>
            <ac:grpSpMk id="136" creationId="{89F232AA-0EA9-4A4E-AC3E-876B8AE1C107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137" creationId="{04118381-E0B0-F347-BA43-7A822B6699D7}"/>
          </ac:grpSpMkLst>
        </pc:grpChg>
        <pc:grpChg chg="add del mod">
          <ac:chgData name="Narang, Sonali" userId="9e80b397-6e2f-49b1-9374-ccdad8589140" providerId="ADAL" clId="{08EB3AD7-677B-AA4A-90AD-5577AE246557}" dt="2021-06-22T20:56:34.755" v="1281" actId="21"/>
          <ac:grpSpMkLst>
            <pc:docMk/>
            <pc:sldMk cId="3911031167" sldId="256"/>
            <ac:grpSpMk id="143" creationId="{54BD94FB-8CC4-5048-AB6D-DA1D6FB10AC2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144" creationId="{5CE26BE2-A767-644A-92DA-B94BBBFC23EB}"/>
          </ac:grpSpMkLst>
        </pc:grpChg>
        <pc:grpChg chg="add del mod">
          <ac:chgData name="Narang, Sonali" userId="9e80b397-6e2f-49b1-9374-ccdad8589140" providerId="ADAL" clId="{08EB3AD7-677B-AA4A-90AD-5577AE246557}" dt="2021-07-28T15:02:39.915" v="8986" actId="165"/>
          <ac:grpSpMkLst>
            <pc:docMk/>
            <pc:sldMk cId="3911031167" sldId="256"/>
            <ac:grpSpMk id="147" creationId="{A3BE3092-5868-2A40-8A4A-2896CABD9CEE}"/>
          </ac:grpSpMkLst>
        </pc:grpChg>
        <pc:grpChg chg="del mod topLvl">
          <ac:chgData name="Narang, Sonali" userId="9e80b397-6e2f-49b1-9374-ccdad8589140" providerId="ADAL" clId="{08EB3AD7-677B-AA4A-90AD-5577AE246557}" dt="2021-08-16T15:37:55.099" v="9220" actId="165"/>
          <ac:grpSpMkLst>
            <pc:docMk/>
            <pc:sldMk cId="3911031167" sldId="256"/>
            <ac:grpSpMk id="150" creationId="{32CD1CB6-7B51-6A46-825C-2A1AA1FBCBF0}"/>
          </ac:grpSpMkLst>
        </pc:grpChg>
        <pc:grpChg chg="del mod topLvl">
          <ac:chgData name="Narang, Sonali" userId="9e80b397-6e2f-49b1-9374-ccdad8589140" providerId="ADAL" clId="{08EB3AD7-677B-AA4A-90AD-5577AE246557}" dt="2021-08-16T17:35:29.962" v="9405" actId="478"/>
          <ac:grpSpMkLst>
            <pc:docMk/>
            <pc:sldMk cId="3911031167" sldId="256"/>
            <ac:grpSpMk id="151" creationId="{1DB3589B-2A1F-A049-A9FD-9C54FFFA1578}"/>
          </ac:grpSpMkLst>
        </pc:grpChg>
        <pc:grpChg chg="add del mod">
          <ac:chgData name="Narang, Sonali" userId="9e80b397-6e2f-49b1-9374-ccdad8589140" providerId="ADAL" clId="{08EB3AD7-677B-AA4A-90AD-5577AE246557}" dt="2021-06-14T20:26:27.281" v="1031" actId="478"/>
          <ac:grpSpMkLst>
            <pc:docMk/>
            <pc:sldMk cId="3911031167" sldId="256"/>
            <ac:grpSpMk id="151" creationId="{647C4C78-71F6-8743-AF6B-2EDF405B396D}"/>
          </ac:grpSpMkLst>
        </pc:grpChg>
        <pc:grpChg chg="del mod topLvl">
          <ac:chgData name="Narang, Sonali" userId="9e80b397-6e2f-49b1-9374-ccdad8589140" providerId="ADAL" clId="{08EB3AD7-677B-AA4A-90AD-5577AE246557}" dt="2021-08-16T17:35:29.962" v="9405" actId="478"/>
          <ac:grpSpMkLst>
            <pc:docMk/>
            <pc:sldMk cId="3911031167" sldId="256"/>
            <ac:grpSpMk id="156" creationId="{0F4FAD38-FE37-824D-ACD6-12D8D5D86405}"/>
          </ac:grpSpMkLst>
        </pc:grpChg>
        <pc:grpChg chg="mod topLvl">
          <ac:chgData name="Narang, Sonali" userId="9e80b397-6e2f-49b1-9374-ccdad8589140" providerId="ADAL" clId="{08EB3AD7-677B-AA4A-90AD-5577AE246557}" dt="2021-08-16T17:36:01.328" v="9410" actId="12788"/>
          <ac:grpSpMkLst>
            <pc:docMk/>
            <pc:sldMk cId="3911031167" sldId="256"/>
            <ac:grpSpMk id="157" creationId="{53F43BE7-9BF8-A445-B67A-98C624B56CF3}"/>
          </ac:grpSpMkLst>
        </pc:grpChg>
        <pc:grpChg chg="add del mod">
          <ac:chgData name="Narang, Sonali" userId="9e80b397-6e2f-49b1-9374-ccdad8589140" providerId="ADAL" clId="{08EB3AD7-677B-AA4A-90AD-5577AE246557}" dt="2021-06-14T20:26:54.122" v="1036"/>
          <ac:grpSpMkLst>
            <pc:docMk/>
            <pc:sldMk cId="3911031167" sldId="256"/>
            <ac:grpSpMk id="158" creationId="{EA3FFD27-8525-E141-A65B-5C3AB896F6BD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162" creationId="{54443102-E515-F247-98ED-46A263AB683D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163" creationId="{BD01CEE5-5D7A-6A4C-B8D7-DBA09203F5FA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177" creationId="{59B94367-AB87-7342-9742-0A717B384BF0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178" creationId="{AEA738CB-16C1-D648-9673-7D73410E25E2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179" creationId="{FF2E79FC-43C4-7A48-A167-ACA5124A0356}"/>
          </ac:grpSpMkLst>
        </pc:grpChg>
        <pc:grpChg chg="add mod">
          <ac:chgData name="Narang, Sonali" userId="9e80b397-6e2f-49b1-9374-ccdad8589140" providerId="ADAL" clId="{08EB3AD7-677B-AA4A-90AD-5577AE246557}" dt="2021-08-16T17:36:01.328" v="9410" actId="12788"/>
          <ac:grpSpMkLst>
            <pc:docMk/>
            <pc:sldMk cId="3911031167" sldId="256"/>
            <ac:grpSpMk id="193" creationId="{CB7CCBF0-E4A0-A54F-B0D5-A52217475942}"/>
          </ac:grpSpMkLst>
        </pc:grpChg>
        <pc:grpChg chg="add mod">
          <ac:chgData name="Narang, Sonali" userId="9e80b397-6e2f-49b1-9374-ccdad8589140" providerId="ADAL" clId="{08EB3AD7-677B-AA4A-90AD-5577AE246557}" dt="2021-08-16T17:36:01.328" v="9410" actId="12788"/>
          <ac:grpSpMkLst>
            <pc:docMk/>
            <pc:sldMk cId="3911031167" sldId="256"/>
            <ac:grpSpMk id="200" creationId="{2CD1DEAD-8926-B14E-B1BE-657ED3D63B2F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202" creationId="{25E2E5A6-5258-054A-8BE3-78CF0D7045B8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203" creationId="{C8CE6344-928F-FF4A-AAB0-93274C39F7B6}"/>
          </ac:grpSpMkLst>
        </pc:grpChg>
        <pc:grpChg chg="mod">
          <ac:chgData name="Narang, Sonali" userId="9e80b397-6e2f-49b1-9374-ccdad8589140" providerId="ADAL" clId="{08EB3AD7-677B-AA4A-90AD-5577AE246557}" dt="2021-06-14T20:26:43.059" v="1033"/>
          <ac:grpSpMkLst>
            <pc:docMk/>
            <pc:sldMk cId="3911031167" sldId="256"/>
            <ac:grpSpMk id="204" creationId="{28279818-C989-AE4D-B9BE-9E15899D15B2}"/>
          </ac:grpSpMkLst>
        </pc:grpChg>
        <pc:grpChg chg="add mod">
          <ac:chgData name="Narang, Sonali" userId="9e80b397-6e2f-49b1-9374-ccdad8589140" providerId="ADAL" clId="{08EB3AD7-677B-AA4A-90AD-5577AE246557}" dt="2021-08-16T17:39:22.703" v="9529" actId="1076"/>
          <ac:grpSpMkLst>
            <pc:docMk/>
            <pc:sldMk cId="3911031167" sldId="256"/>
            <ac:grpSpMk id="207" creationId="{2D28F141-FC80-C847-8AF0-B6A0CA712B66}"/>
          </ac:grpSpMkLst>
        </pc:grpChg>
        <pc:grpChg chg="mod">
          <ac:chgData name="Narang, Sonali" userId="9e80b397-6e2f-49b1-9374-ccdad8589140" providerId="ADAL" clId="{08EB3AD7-677B-AA4A-90AD-5577AE246557}" dt="2021-08-16T17:39:12.366" v="9528"/>
          <ac:grpSpMkLst>
            <pc:docMk/>
            <pc:sldMk cId="3911031167" sldId="256"/>
            <ac:grpSpMk id="210" creationId="{99F4887F-A04F-7B47-8E22-5061C9D7EECD}"/>
          </ac:grpSpMkLst>
        </pc:grpChg>
        <pc:grpChg chg="mod">
          <ac:chgData name="Narang, Sonali" userId="9e80b397-6e2f-49b1-9374-ccdad8589140" providerId="ADAL" clId="{08EB3AD7-677B-AA4A-90AD-5577AE246557}" dt="2021-08-16T17:39:12.366" v="9528"/>
          <ac:grpSpMkLst>
            <pc:docMk/>
            <pc:sldMk cId="3911031167" sldId="256"/>
            <ac:grpSpMk id="212" creationId="{65340C33-6E35-284F-B225-05EB6466C85A}"/>
          </ac:grpSpMkLst>
        </pc:grpChg>
        <pc:grpChg chg="mod">
          <ac:chgData name="Narang, Sonali" userId="9e80b397-6e2f-49b1-9374-ccdad8589140" providerId="ADAL" clId="{08EB3AD7-677B-AA4A-90AD-5577AE246557}" dt="2021-08-16T17:39:12.366" v="9528"/>
          <ac:grpSpMkLst>
            <pc:docMk/>
            <pc:sldMk cId="3911031167" sldId="256"/>
            <ac:grpSpMk id="213" creationId="{3EE05FE6-C08E-5441-9D88-BF399B13C98E}"/>
          </ac:grpSpMkLst>
        </pc:grpChg>
        <pc:grpChg chg="mod">
          <ac:chgData name="Narang, Sonali" userId="9e80b397-6e2f-49b1-9374-ccdad8589140" providerId="ADAL" clId="{08EB3AD7-677B-AA4A-90AD-5577AE246557}" dt="2021-08-16T17:39:12.366" v="9528"/>
          <ac:grpSpMkLst>
            <pc:docMk/>
            <pc:sldMk cId="3911031167" sldId="256"/>
            <ac:grpSpMk id="214" creationId="{500CB809-E30F-4B4C-BA46-E1D06C568E06}"/>
          </ac:grpSpMkLst>
        </pc:grpChg>
        <pc:grpChg chg="mod">
          <ac:chgData name="Narang, Sonali" userId="9e80b397-6e2f-49b1-9374-ccdad8589140" providerId="ADAL" clId="{08EB3AD7-677B-AA4A-90AD-5577AE246557}" dt="2021-08-16T17:39:12.366" v="9528"/>
          <ac:grpSpMkLst>
            <pc:docMk/>
            <pc:sldMk cId="3911031167" sldId="256"/>
            <ac:grpSpMk id="215" creationId="{41C2F825-F13A-D243-AC4B-8F5401AE67DC}"/>
          </ac:grpSpMkLst>
        </pc:grpChg>
        <pc:grpChg chg="add del mod">
          <ac:chgData name="Narang, Sonali" userId="9e80b397-6e2f-49b1-9374-ccdad8589140" providerId="ADAL" clId="{08EB3AD7-677B-AA4A-90AD-5577AE246557}" dt="2021-06-14T20:26:57.788" v="1038"/>
          <ac:grpSpMkLst>
            <pc:docMk/>
            <pc:sldMk cId="3911031167" sldId="256"/>
            <ac:grpSpMk id="225" creationId="{B535E2BC-4B55-D745-82B7-B067D8F4DB3A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29" creationId="{BD4C2229-444F-9D46-A355-7D975C35B18F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30" creationId="{9C1C214D-C9AC-3D4A-93B6-6683FE9B031C}"/>
          </ac:grpSpMkLst>
        </pc:grpChg>
        <pc:grpChg chg="add mod">
          <ac:chgData name="Narang, Sonali" userId="9e80b397-6e2f-49b1-9374-ccdad8589140" providerId="ADAL" clId="{08EB3AD7-677B-AA4A-90AD-5577AE246557}" dt="2021-08-16T18:38:51.078" v="9794"/>
          <ac:grpSpMkLst>
            <pc:docMk/>
            <pc:sldMk cId="3911031167" sldId="256"/>
            <ac:grpSpMk id="239" creationId="{4152092A-3528-194E-B84D-DD5D62F2F50D}"/>
          </ac:grpSpMkLst>
        </pc:grpChg>
        <pc:grpChg chg="mod">
          <ac:chgData name="Narang, Sonali" userId="9e80b397-6e2f-49b1-9374-ccdad8589140" providerId="ADAL" clId="{08EB3AD7-677B-AA4A-90AD-5577AE246557}" dt="2021-08-16T18:38:51.078" v="9794"/>
          <ac:grpSpMkLst>
            <pc:docMk/>
            <pc:sldMk cId="3911031167" sldId="256"/>
            <ac:grpSpMk id="242" creationId="{31F22AD0-C824-7C44-8AC7-E476F625C837}"/>
          </ac:grpSpMkLst>
        </pc:grpChg>
        <pc:grpChg chg="mod">
          <ac:chgData name="Narang, Sonali" userId="9e80b397-6e2f-49b1-9374-ccdad8589140" providerId="ADAL" clId="{08EB3AD7-677B-AA4A-90AD-5577AE246557}" dt="2021-08-16T18:38:51.078" v="9794"/>
          <ac:grpSpMkLst>
            <pc:docMk/>
            <pc:sldMk cId="3911031167" sldId="256"/>
            <ac:grpSpMk id="243" creationId="{51BF5FB3-8DF9-EB40-B6D9-0AD597F62FBB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44" creationId="{436456AD-403F-034E-9EAF-987A026C7D1E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45" creationId="{FE680FB4-5836-874D-9B68-3A93C2C108D5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46" creationId="{6EF16BC8-E80C-5A49-9B52-19B494818B96}"/>
          </ac:grpSpMkLst>
        </pc:grpChg>
        <pc:grpChg chg="mod">
          <ac:chgData name="Narang, Sonali" userId="9e80b397-6e2f-49b1-9374-ccdad8589140" providerId="ADAL" clId="{08EB3AD7-677B-AA4A-90AD-5577AE246557}" dt="2021-08-16T18:38:51.078" v="9794"/>
          <ac:grpSpMkLst>
            <pc:docMk/>
            <pc:sldMk cId="3911031167" sldId="256"/>
            <ac:grpSpMk id="250" creationId="{97E59F00-2370-7944-AFEB-833E8BA82A95}"/>
          </ac:grpSpMkLst>
        </pc:grpChg>
        <pc:grpChg chg="mod">
          <ac:chgData name="Narang, Sonali" userId="9e80b397-6e2f-49b1-9374-ccdad8589140" providerId="ADAL" clId="{08EB3AD7-677B-AA4A-90AD-5577AE246557}" dt="2021-08-16T18:38:51.078" v="9794"/>
          <ac:grpSpMkLst>
            <pc:docMk/>
            <pc:sldMk cId="3911031167" sldId="256"/>
            <ac:grpSpMk id="261" creationId="{A67D9BAC-154F-994A-B8EE-D7A40DF82D4F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69" creationId="{2EF50184-3DF4-B843-82BC-34C05B60C5DC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70" creationId="{9FF809C3-23CA-054F-8515-C30322058B18}"/>
          </ac:grpSpMkLst>
        </pc:grpChg>
        <pc:grpChg chg="mod">
          <ac:chgData name="Narang, Sonali" userId="9e80b397-6e2f-49b1-9374-ccdad8589140" providerId="ADAL" clId="{08EB3AD7-677B-AA4A-90AD-5577AE246557}" dt="2021-06-14T20:26:54.988" v="1037"/>
          <ac:grpSpMkLst>
            <pc:docMk/>
            <pc:sldMk cId="3911031167" sldId="256"/>
            <ac:grpSpMk id="271" creationId="{B7238862-1C00-694F-8509-F8B4F863AE92}"/>
          </ac:grpSpMkLst>
        </pc:grpChg>
        <pc:grpChg chg="add del mod">
          <ac:chgData name="Narang, Sonali" userId="9e80b397-6e2f-49b1-9374-ccdad8589140" providerId="ADAL" clId="{08EB3AD7-677B-AA4A-90AD-5577AE246557}" dt="2021-06-22T18:54:08.340" v="1130" actId="21"/>
          <ac:grpSpMkLst>
            <pc:docMk/>
            <pc:sldMk cId="3911031167" sldId="256"/>
            <ac:grpSpMk id="292" creationId="{927285AB-98A2-7049-ABF4-FE5F6F4970CF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296" creationId="{BDAA936F-A8C4-C04C-92EE-D0C69B784C29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297" creationId="{CED204C8-8C71-AB4B-9087-472F43B75541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11" creationId="{172D0517-59B0-E741-B874-90B39762F1FC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12" creationId="{5FF639A7-01E3-834E-A79F-4B483D08635E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13" creationId="{F9B77B17-DA8A-B34E-99F3-95A6C9CC87F1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36" creationId="{BBB0A0AD-65D7-FC40-9298-C478F6A14925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37" creationId="{68BD7DBD-9F80-5247-BA5D-0F5B7E9F69B8}"/>
          </ac:grpSpMkLst>
        </pc:grpChg>
        <pc:grpChg chg="mod">
          <ac:chgData name="Narang, Sonali" userId="9e80b397-6e2f-49b1-9374-ccdad8589140" providerId="ADAL" clId="{08EB3AD7-677B-AA4A-90AD-5577AE246557}" dt="2021-06-14T20:26:57.886" v="1039"/>
          <ac:grpSpMkLst>
            <pc:docMk/>
            <pc:sldMk cId="3911031167" sldId="256"/>
            <ac:grpSpMk id="338" creationId="{B2F130D5-6F21-9A44-BF9B-63556E7F5A3E}"/>
          </ac:grpSpMkLst>
        </pc:grpChg>
        <pc:picChg chg="add del mod">
          <ac:chgData name="Narang, Sonali" userId="9e80b397-6e2f-49b1-9374-ccdad8589140" providerId="ADAL" clId="{08EB3AD7-677B-AA4A-90AD-5577AE246557}" dt="2021-08-16T15:39:50.603" v="9234" actId="478"/>
          <ac:picMkLst>
            <pc:docMk/>
            <pc:sldMk cId="3911031167" sldId="256"/>
            <ac:picMk id="3" creationId="{DE8B04CD-E65E-D14E-B5FE-25EE470C397D}"/>
          </ac:picMkLst>
        </pc:picChg>
        <pc:picChg chg="add mod modCrop">
          <ac:chgData name="Narang, Sonali" userId="9e80b397-6e2f-49b1-9374-ccdad8589140" providerId="ADAL" clId="{08EB3AD7-677B-AA4A-90AD-5577AE246557}" dt="2021-08-16T17:32:02.577" v="9337" actId="1076"/>
          <ac:picMkLst>
            <pc:docMk/>
            <pc:sldMk cId="3911031167" sldId="256"/>
            <ac:picMk id="13" creationId="{ADF3F9FF-BAA5-444E-A368-F85CD5ED5512}"/>
          </ac:picMkLst>
        </pc:picChg>
        <pc:picChg chg="add mod modCrop">
          <ac:chgData name="Narang, Sonali" userId="9e80b397-6e2f-49b1-9374-ccdad8589140" providerId="ADAL" clId="{08EB3AD7-677B-AA4A-90AD-5577AE246557}" dt="2021-08-16T17:32:07.897" v="9338" actId="1076"/>
          <ac:picMkLst>
            <pc:docMk/>
            <pc:sldMk cId="3911031167" sldId="256"/>
            <ac:picMk id="16" creationId="{F859B519-4B52-9549-B250-8B880A32C66B}"/>
          </ac:picMkLst>
        </pc:picChg>
        <pc:picChg chg="del mod">
          <ac:chgData name="Narang, Sonali" userId="9e80b397-6e2f-49b1-9374-ccdad8589140" providerId="ADAL" clId="{08EB3AD7-677B-AA4A-90AD-5577AE246557}" dt="2021-08-16T18:35:12.834" v="9713" actId="478"/>
          <ac:picMkLst>
            <pc:docMk/>
            <pc:sldMk cId="3911031167" sldId="256"/>
            <ac:picMk id="21" creationId="{8DC8A9F5-026A-0D4A-A691-B6079224F482}"/>
          </ac:picMkLst>
        </pc:picChg>
        <pc:picChg chg="del mod modCrop">
          <ac:chgData name="Narang, Sonali" userId="9e80b397-6e2f-49b1-9374-ccdad8589140" providerId="ADAL" clId="{08EB3AD7-677B-AA4A-90AD-5577AE246557}" dt="2021-08-16T18:38:44.460" v="9792" actId="478"/>
          <ac:picMkLst>
            <pc:docMk/>
            <pc:sldMk cId="3911031167" sldId="256"/>
            <ac:picMk id="23" creationId="{F4E04DD6-E91E-DA48-812D-B7942BE0CA2A}"/>
          </ac:picMkLst>
        </pc:picChg>
        <pc:picChg chg="add del mod">
          <ac:chgData name="Narang, Sonali" userId="9e80b397-6e2f-49b1-9374-ccdad8589140" providerId="ADAL" clId="{08EB3AD7-677B-AA4A-90AD-5577AE246557}" dt="2021-08-16T18:35:31.499" v="9719" actId="21"/>
          <ac:picMkLst>
            <pc:docMk/>
            <pc:sldMk cId="3911031167" sldId="256"/>
            <ac:picMk id="25" creationId="{524BCA32-5D21-5A43-8ADB-9D49AB08AABA}"/>
          </ac:picMkLst>
        </pc:picChg>
        <pc:picChg chg="add mod">
          <ac:chgData name="Narang, Sonali" userId="9e80b397-6e2f-49b1-9374-ccdad8589140" providerId="ADAL" clId="{08EB3AD7-677B-AA4A-90AD-5577AE246557}" dt="2021-08-16T18:38:05.202" v="9789" actId="1076"/>
          <ac:picMkLst>
            <pc:docMk/>
            <pc:sldMk cId="3911031167" sldId="256"/>
            <ac:picMk id="27" creationId="{B5054D06-FEA0-924A-A2E3-B92A7BF18837}"/>
          </ac:picMkLst>
        </pc:picChg>
        <pc:picChg chg="del">
          <ac:chgData name="Narang, Sonali" userId="9e80b397-6e2f-49b1-9374-ccdad8589140" providerId="ADAL" clId="{08EB3AD7-677B-AA4A-90AD-5577AE246557}" dt="2021-06-02T21:20:47" v="713" actId="21"/>
          <ac:picMkLst>
            <pc:docMk/>
            <pc:sldMk cId="3911031167" sldId="256"/>
            <ac:picMk id="28" creationId="{1AB9209A-D5A4-B14E-9181-92CEA1124279}"/>
          </ac:picMkLst>
        </pc:picChg>
        <pc:picChg chg="add mod">
          <ac:chgData name="Narang, Sonali" userId="9e80b397-6e2f-49b1-9374-ccdad8589140" providerId="ADAL" clId="{08EB3AD7-677B-AA4A-90AD-5577AE246557}" dt="2021-08-16T18:37:56.931" v="9788" actId="1076"/>
          <ac:picMkLst>
            <pc:docMk/>
            <pc:sldMk cId="3911031167" sldId="256"/>
            <ac:picMk id="29" creationId="{1C0E2E32-3EF6-7545-ADDF-48949AF91153}"/>
          </ac:picMkLst>
        </pc:picChg>
        <pc:picChg chg="add mod">
          <ac:chgData name="Narang, Sonali" userId="9e80b397-6e2f-49b1-9374-ccdad8589140" providerId="ADAL" clId="{08EB3AD7-677B-AA4A-90AD-5577AE246557}" dt="2021-08-16T18:38:05.202" v="9789" actId="1076"/>
          <ac:picMkLst>
            <pc:docMk/>
            <pc:sldMk cId="3911031167" sldId="256"/>
            <ac:picMk id="31" creationId="{07C41BC9-5DF7-F148-B048-BB28AE1446C7}"/>
          </ac:picMkLst>
        </pc:picChg>
        <pc:picChg chg="add del mod">
          <ac:chgData name="Narang, Sonali" userId="9e80b397-6e2f-49b1-9374-ccdad8589140" providerId="ADAL" clId="{08EB3AD7-677B-AA4A-90AD-5577AE246557}" dt="2021-08-16T18:35:25.322" v="9717" actId="21"/>
          <ac:picMkLst>
            <pc:docMk/>
            <pc:sldMk cId="3911031167" sldId="256"/>
            <ac:picMk id="37" creationId="{D01C0C16-6285-EE4B-BF71-9323BED015BF}"/>
          </ac:picMkLst>
        </pc:picChg>
        <pc:picChg chg="add del mod">
          <ac:chgData name="Narang, Sonali" userId="9e80b397-6e2f-49b1-9374-ccdad8589140" providerId="ADAL" clId="{08EB3AD7-677B-AA4A-90AD-5577AE246557}" dt="2021-08-16T15:39:50.603" v="9234" actId="478"/>
          <ac:picMkLst>
            <pc:docMk/>
            <pc:sldMk cId="3911031167" sldId="256"/>
            <ac:picMk id="87" creationId="{9416909D-08EE-0941-89F1-3CF00C3AEF40}"/>
          </ac:picMkLst>
        </pc:picChg>
        <pc:picChg chg="mod">
          <ac:chgData name="Narang, Sonali" userId="9e80b397-6e2f-49b1-9374-ccdad8589140" providerId="ADAL" clId="{08EB3AD7-677B-AA4A-90AD-5577AE246557}" dt="2021-07-09T20:13:14.100" v="4977"/>
          <ac:picMkLst>
            <pc:docMk/>
            <pc:sldMk cId="3911031167" sldId="256"/>
            <ac:picMk id="92" creationId="{2AFC607C-D3E7-CF41-8ADA-FAC61F7AA46A}"/>
          </ac:picMkLst>
        </pc:picChg>
        <pc:picChg chg="mod">
          <ac:chgData name="Narang, Sonali" userId="9e80b397-6e2f-49b1-9374-ccdad8589140" providerId="ADAL" clId="{08EB3AD7-677B-AA4A-90AD-5577AE246557}" dt="2021-07-09T20:13:14.100" v="4977"/>
          <ac:picMkLst>
            <pc:docMk/>
            <pc:sldMk cId="3911031167" sldId="256"/>
            <ac:picMk id="97" creationId="{84E6D387-A6C2-D048-AD83-95E05D354E82}"/>
          </ac:picMkLst>
        </pc:picChg>
        <pc:picChg chg="del mod">
          <ac:chgData name="Narang, Sonali" userId="9e80b397-6e2f-49b1-9374-ccdad8589140" providerId="ADAL" clId="{08EB3AD7-677B-AA4A-90AD-5577AE246557}" dt="2021-06-22T18:53:59.869" v="1127" actId="478"/>
          <ac:picMkLst>
            <pc:docMk/>
            <pc:sldMk cId="3911031167" sldId="256"/>
            <ac:picMk id="100" creationId="{C473AFED-13EF-534F-BD83-A66FBE1CE3F1}"/>
          </ac:picMkLst>
        </pc:picChg>
        <pc:picChg chg="mod">
          <ac:chgData name="Narang, Sonali" userId="9e80b397-6e2f-49b1-9374-ccdad8589140" providerId="ADAL" clId="{08EB3AD7-677B-AA4A-90AD-5577AE246557}" dt="2021-07-09T20:16:57.761" v="5055"/>
          <ac:picMkLst>
            <pc:docMk/>
            <pc:sldMk cId="3911031167" sldId="256"/>
            <ac:picMk id="127" creationId="{90856B5B-96FC-0040-AD49-6BAB8153A721}"/>
          </ac:picMkLst>
        </pc:picChg>
        <pc:picChg chg="mod">
          <ac:chgData name="Narang, Sonali" userId="9e80b397-6e2f-49b1-9374-ccdad8589140" providerId="ADAL" clId="{08EB3AD7-677B-AA4A-90AD-5577AE246557}" dt="2021-07-09T20:16:57.761" v="5055"/>
          <ac:picMkLst>
            <pc:docMk/>
            <pc:sldMk cId="3911031167" sldId="256"/>
            <ac:picMk id="128" creationId="{1C73E0FF-02FF-414A-9A21-91F244C5B24E}"/>
          </ac:picMkLst>
        </pc:picChg>
        <pc:picChg chg="mod">
          <ac:chgData name="Narang, Sonali" userId="9e80b397-6e2f-49b1-9374-ccdad8589140" providerId="ADAL" clId="{08EB3AD7-677B-AA4A-90AD-5577AE246557}" dt="2021-06-22T18:55:14.604" v="1138"/>
          <ac:picMkLst>
            <pc:docMk/>
            <pc:sldMk cId="3911031167" sldId="256"/>
            <ac:picMk id="144" creationId="{7707E6C6-EC8B-B94C-B96E-832BEAA2707B}"/>
          </ac:picMkLst>
        </pc:picChg>
        <pc:picChg chg="del mod topLvl">
          <ac:chgData name="Narang, Sonali" userId="9e80b397-6e2f-49b1-9374-ccdad8589140" providerId="ADAL" clId="{08EB3AD7-677B-AA4A-90AD-5577AE246557}" dt="2021-08-16T17:23:58.949" v="9264" actId="478"/>
          <ac:picMkLst>
            <pc:docMk/>
            <pc:sldMk cId="3911031167" sldId="256"/>
            <ac:picMk id="148" creationId="{5F2D1631-0BEC-6747-B695-EA97B349F560}"/>
          </ac:picMkLst>
        </pc:picChg>
        <pc:picChg chg="del mod topLvl modCrop">
          <ac:chgData name="Narang, Sonali" userId="9e80b397-6e2f-49b1-9374-ccdad8589140" providerId="ADAL" clId="{08EB3AD7-677B-AA4A-90AD-5577AE246557}" dt="2021-08-16T17:23:58.949" v="9264" actId="478"/>
          <ac:picMkLst>
            <pc:docMk/>
            <pc:sldMk cId="3911031167" sldId="256"/>
            <ac:picMk id="149" creationId="{5BBDEAFC-9226-5B40-AB9D-00382BD0B6C3}"/>
          </ac:picMkLst>
        </pc:picChg>
        <pc:picChg chg="mod">
          <ac:chgData name="Narang, Sonali" userId="9e80b397-6e2f-49b1-9374-ccdad8589140" providerId="ADAL" clId="{08EB3AD7-677B-AA4A-90AD-5577AE246557}" dt="2021-06-14T20:26:43.059" v="1033"/>
          <ac:picMkLst>
            <pc:docMk/>
            <pc:sldMk cId="3911031167" sldId="256"/>
            <ac:picMk id="167" creationId="{29DC7741-95AB-F143-82EB-17F373E1A526}"/>
          </ac:picMkLst>
        </pc:picChg>
        <pc:picChg chg="mod">
          <ac:chgData name="Narang, Sonali" userId="9e80b397-6e2f-49b1-9374-ccdad8589140" providerId="ADAL" clId="{08EB3AD7-677B-AA4A-90AD-5577AE246557}" dt="2021-06-14T20:26:43.059" v="1033"/>
          <ac:picMkLst>
            <pc:docMk/>
            <pc:sldMk cId="3911031167" sldId="256"/>
            <ac:picMk id="172" creationId="{F4465221-50DA-B64B-AEC2-443BF4AB0C2B}"/>
          </ac:picMkLst>
        </pc:picChg>
        <pc:picChg chg="mod">
          <ac:chgData name="Narang, Sonali" userId="9e80b397-6e2f-49b1-9374-ccdad8589140" providerId="ADAL" clId="{08EB3AD7-677B-AA4A-90AD-5577AE246557}" dt="2021-06-14T20:26:43.059" v="1033"/>
          <ac:picMkLst>
            <pc:docMk/>
            <pc:sldMk cId="3911031167" sldId="256"/>
            <ac:picMk id="173" creationId="{5D03A170-CA0B-1C41-91DB-9B058D1E9061}"/>
          </ac:picMkLst>
        </pc:picChg>
        <pc:picChg chg="mod">
          <ac:chgData name="Narang, Sonali" userId="9e80b397-6e2f-49b1-9374-ccdad8589140" providerId="ADAL" clId="{08EB3AD7-677B-AA4A-90AD-5577AE246557}" dt="2021-06-14T20:26:43.059" v="1033"/>
          <ac:picMkLst>
            <pc:docMk/>
            <pc:sldMk cId="3911031167" sldId="256"/>
            <ac:picMk id="174" creationId="{2FE38683-22D3-E849-956B-5887BFDF0480}"/>
          </ac:picMkLst>
        </pc:picChg>
        <pc:picChg chg="add del mod">
          <ac:chgData name="Narang, Sonali" userId="9e80b397-6e2f-49b1-9374-ccdad8589140" providerId="ADAL" clId="{08EB3AD7-677B-AA4A-90AD-5577AE246557}" dt="2021-06-30T20:09:21.507" v="3339" actId="21"/>
          <ac:picMkLst>
            <pc:docMk/>
            <pc:sldMk cId="3911031167" sldId="256"/>
            <ac:picMk id="180" creationId="{58391000-796D-EA4A-A6C1-7A87624F445D}"/>
          </ac:picMkLst>
        </pc:picChg>
        <pc:picChg chg="add del mod">
          <ac:chgData name="Narang, Sonali" userId="9e80b397-6e2f-49b1-9374-ccdad8589140" providerId="ADAL" clId="{08EB3AD7-677B-AA4A-90AD-5577AE246557}" dt="2021-06-30T20:09:21.507" v="3339" actId="21"/>
          <ac:picMkLst>
            <pc:docMk/>
            <pc:sldMk cId="3911031167" sldId="256"/>
            <ac:picMk id="181" creationId="{9B1DE6A2-67D8-B442-9A73-C29F1887C51E}"/>
          </ac:picMkLst>
        </pc:picChg>
        <pc:picChg chg="add del mod">
          <ac:chgData name="Narang, Sonali" userId="9e80b397-6e2f-49b1-9374-ccdad8589140" providerId="ADAL" clId="{08EB3AD7-677B-AA4A-90AD-5577AE246557}" dt="2021-08-16T17:23:58.949" v="9264" actId="478"/>
          <ac:picMkLst>
            <pc:docMk/>
            <pc:sldMk cId="3911031167" sldId="256"/>
            <ac:picMk id="183" creationId="{364D1510-644A-9547-8DDF-6A4255476647}"/>
          </ac:picMkLst>
        </pc:picChg>
        <pc:picChg chg="add del mod">
          <ac:chgData name="Narang, Sonali" userId="9e80b397-6e2f-49b1-9374-ccdad8589140" providerId="ADAL" clId="{08EB3AD7-677B-AA4A-90AD-5577AE246557}" dt="2021-08-16T17:23:58.949" v="9264" actId="478"/>
          <ac:picMkLst>
            <pc:docMk/>
            <pc:sldMk cId="3911031167" sldId="256"/>
            <ac:picMk id="184" creationId="{74A42F31-4188-5C4C-B691-1BF2EB9F1719}"/>
          </ac:picMkLst>
        </pc:picChg>
        <pc:picChg chg="add del mod modCrop">
          <ac:chgData name="Narang, Sonali" userId="9e80b397-6e2f-49b1-9374-ccdad8589140" providerId="ADAL" clId="{08EB3AD7-677B-AA4A-90AD-5577AE246557}" dt="2021-08-16T17:28:55.289" v="9309" actId="21"/>
          <ac:picMkLst>
            <pc:docMk/>
            <pc:sldMk cId="3911031167" sldId="256"/>
            <ac:picMk id="185" creationId="{8AF1AEF2-8BFC-D347-A290-0F6D3C9A51FD}"/>
          </ac:picMkLst>
        </pc:picChg>
        <pc:picChg chg="add del mod modCrop">
          <ac:chgData name="Narang, Sonali" userId="9e80b397-6e2f-49b1-9374-ccdad8589140" providerId="ADAL" clId="{08EB3AD7-677B-AA4A-90AD-5577AE246557}" dt="2021-08-16T17:28:55.289" v="9309" actId="21"/>
          <ac:picMkLst>
            <pc:docMk/>
            <pc:sldMk cId="3911031167" sldId="256"/>
            <ac:picMk id="186" creationId="{106F16A8-E0FF-7046-9B98-725005EBFFA9}"/>
          </ac:picMkLst>
        </pc:picChg>
        <pc:picChg chg="add mod">
          <ac:chgData name="Narang, Sonali" userId="9e80b397-6e2f-49b1-9374-ccdad8589140" providerId="ADAL" clId="{08EB3AD7-677B-AA4A-90AD-5577AE246557}" dt="2021-08-16T17:33:05.747" v="9366" actId="1036"/>
          <ac:picMkLst>
            <pc:docMk/>
            <pc:sldMk cId="3911031167" sldId="256"/>
            <ac:picMk id="187" creationId="{BB6CA039-90F7-E447-92C7-22DE6A1790B6}"/>
          </ac:picMkLst>
        </pc:picChg>
        <pc:picChg chg="add mod">
          <ac:chgData name="Narang, Sonali" userId="9e80b397-6e2f-49b1-9374-ccdad8589140" providerId="ADAL" clId="{08EB3AD7-677B-AA4A-90AD-5577AE246557}" dt="2021-08-16T17:33:05.747" v="9366" actId="1036"/>
          <ac:picMkLst>
            <pc:docMk/>
            <pc:sldMk cId="3911031167" sldId="256"/>
            <ac:picMk id="188" creationId="{EE2FBEFD-5454-8441-B026-E0C9439B8CA3}"/>
          </ac:picMkLst>
        </pc:picChg>
        <pc:picChg chg="add del mod">
          <ac:chgData name="Narang, Sonali" userId="9e80b397-6e2f-49b1-9374-ccdad8589140" providerId="ADAL" clId="{08EB3AD7-677B-AA4A-90AD-5577AE246557}" dt="2021-08-16T17:32:14.976" v="9340"/>
          <ac:picMkLst>
            <pc:docMk/>
            <pc:sldMk cId="3911031167" sldId="256"/>
            <ac:picMk id="189" creationId="{299D1324-FE4F-B34F-A35E-B835D663F282}"/>
          </ac:picMkLst>
        </pc:picChg>
        <pc:picChg chg="add del mod">
          <ac:chgData name="Narang, Sonali" userId="9e80b397-6e2f-49b1-9374-ccdad8589140" providerId="ADAL" clId="{08EB3AD7-677B-AA4A-90AD-5577AE246557}" dt="2021-07-09T20:17:49.545" v="5100" actId="478"/>
          <ac:picMkLst>
            <pc:docMk/>
            <pc:sldMk cId="3911031167" sldId="256"/>
            <ac:picMk id="189" creationId="{A9CA07D5-32B7-3F4A-9638-F05BFDEF964C}"/>
          </ac:picMkLst>
        </pc:picChg>
        <pc:picChg chg="add del mod">
          <ac:chgData name="Narang, Sonali" userId="9e80b397-6e2f-49b1-9374-ccdad8589140" providerId="ADAL" clId="{08EB3AD7-677B-AA4A-90AD-5577AE246557}" dt="2021-08-16T17:32:14.976" v="9340"/>
          <ac:picMkLst>
            <pc:docMk/>
            <pc:sldMk cId="3911031167" sldId="256"/>
            <ac:picMk id="191" creationId="{A1F8745B-813A-B14D-B8E8-8D9D33835D0C}"/>
          </ac:picMkLst>
        </pc:picChg>
        <pc:picChg chg="mod">
          <ac:chgData name="Narang, Sonali" userId="9e80b397-6e2f-49b1-9374-ccdad8589140" providerId="ADAL" clId="{08EB3AD7-677B-AA4A-90AD-5577AE246557}" dt="2021-06-14T20:26:54.988" v="1037"/>
          <ac:picMkLst>
            <pc:docMk/>
            <pc:sldMk cId="3911031167" sldId="256"/>
            <ac:picMk id="234" creationId="{5F748EB8-9962-8444-87E4-1A614E043D56}"/>
          </ac:picMkLst>
        </pc:picChg>
        <pc:picChg chg="add mod">
          <ac:chgData name="Narang, Sonali" userId="9e80b397-6e2f-49b1-9374-ccdad8589140" providerId="ADAL" clId="{08EB3AD7-677B-AA4A-90AD-5577AE246557}" dt="2021-08-16T18:38:53.923" v="9795" actId="167"/>
          <ac:picMkLst>
            <pc:docMk/>
            <pc:sldMk cId="3911031167" sldId="256"/>
            <ac:picMk id="237" creationId="{A1F60B50-B2DB-7D41-A319-2ADE34765EAF}"/>
          </ac:picMkLst>
        </pc:picChg>
        <pc:picChg chg="mod">
          <ac:chgData name="Narang, Sonali" userId="9e80b397-6e2f-49b1-9374-ccdad8589140" providerId="ADAL" clId="{08EB3AD7-677B-AA4A-90AD-5577AE246557}" dt="2021-06-14T20:26:54.988" v="1037"/>
          <ac:picMkLst>
            <pc:docMk/>
            <pc:sldMk cId="3911031167" sldId="256"/>
            <ac:picMk id="239" creationId="{5A74DDB0-0F29-5C4A-8747-89B6EC8095FD}"/>
          </ac:picMkLst>
        </pc:picChg>
        <pc:picChg chg="mod">
          <ac:chgData name="Narang, Sonali" userId="9e80b397-6e2f-49b1-9374-ccdad8589140" providerId="ADAL" clId="{08EB3AD7-677B-AA4A-90AD-5577AE246557}" dt="2021-06-14T20:26:54.988" v="1037"/>
          <ac:picMkLst>
            <pc:docMk/>
            <pc:sldMk cId="3911031167" sldId="256"/>
            <ac:picMk id="240" creationId="{11A58659-E728-6F4E-B51E-E4154654D88E}"/>
          </ac:picMkLst>
        </pc:picChg>
        <pc:picChg chg="mod">
          <ac:chgData name="Narang, Sonali" userId="9e80b397-6e2f-49b1-9374-ccdad8589140" providerId="ADAL" clId="{08EB3AD7-677B-AA4A-90AD-5577AE246557}" dt="2021-06-14T20:26:54.988" v="1037"/>
          <ac:picMkLst>
            <pc:docMk/>
            <pc:sldMk cId="3911031167" sldId="256"/>
            <ac:picMk id="241" creationId="{63381C5D-3313-D64F-AA57-736ED8ECA6AF}"/>
          </ac:picMkLst>
        </pc:picChg>
        <pc:picChg chg="add mod">
          <ac:chgData name="Narang, Sonali" userId="9e80b397-6e2f-49b1-9374-ccdad8589140" providerId="ADAL" clId="{08EB3AD7-677B-AA4A-90AD-5577AE246557}" dt="2021-08-16T20:59:16.794" v="10024" actId="1076"/>
          <ac:picMkLst>
            <pc:docMk/>
            <pc:sldMk cId="3911031167" sldId="256"/>
            <ac:picMk id="272" creationId="{F13535B0-5D4B-5342-8F0C-63D008B2CAB2}"/>
          </ac:picMkLst>
        </pc:picChg>
        <pc:picChg chg="mod">
          <ac:chgData name="Narang, Sonali" userId="9e80b397-6e2f-49b1-9374-ccdad8589140" providerId="ADAL" clId="{08EB3AD7-677B-AA4A-90AD-5577AE246557}" dt="2021-06-14T20:26:57.886" v="1039"/>
          <ac:picMkLst>
            <pc:docMk/>
            <pc:sldMk cId="3911031167" sldId="256"/>
            <ac:picMk id="301" creationId="{81646CB3-C215-E843-95B4-A7E8065F5E96}"/>
          </ac:picMkLst>
        </pc:picChg>
        <pc:picChg chg="mod">
          <ac:chgData name="Narang, Sonali" userId="9e80b397-6e2f-49b1-9374-ccdad8589140" providerId="ADAL" clId="{08EB3AD7-677B-AA4A-90AD-5577AE246557}" dt="2021-06-14T20:29:24.117" v="1076" actId="1036"/>
          <ac:picMkLst>
            <pc:docMk/>
            <pc:sldMk cId="3911031167" sldId="256"/>
            <ac:picMk id="306" creationId="{295AEC35-6319-B644-9D4F-7D9F319FACB0}"/>
          </ac:picMkLst>
        </pc:picChg>
        <pc:picChg chg="mod">
          <ac:chgData name="Narang, Sonali" userId="9e80b397-6e2f-49b1-9374-ccdad8589140" providerId="ADAL" clId="{08EB3AD7-677B-AA4A-90AD-5577AE246557}" dt="2021-06-14T20:29:24.117" v="1076" actId="1036"/>
          <ac:picMkLst>
            <pc:docMk/>
            <pc:sldMk cId="3911031167" sldId="256"/>
            <ac:picMk id="307" creationId="{AEC32718-9F13-E14B-A268-FF8928953254}"/>
          </ac:picMkLst>
        </pc:picChg>
        <pc:picChg chg="mod">
          <ac:chgData name="Narang, Sonali" userId="9e80b397-6e2f-49b1-9374-ccdad8589140" providerId="ADAL" clId="{08EB3AD7-677B-AA4A-90AD-5577AE246557}" dt="2021-06-14T20:29:24.117" v="1076" actId="1036"/>
          <ac:picMkLst>
            <pc:docMk/>
            <pc:sldMk cId="3911031167" sldId="256"/>
            <ac:picMk id="308" creationId="{FB0A5546-F3AB-E448-87F7-7EA92FF98DD1}"/>
          </ac:picMkLst>
        </pc:picChg>
        <pc:cxnChg chg="add del mod">
          <ac:chgData name="Narang, Sonali" userId="9e80b397-6e2f-49b1-9374-ccdad8589140" providerId="ADAL" clId="{08EB3AD7-677B-AA4A-90AD-5577AE246557}" dt="2021-06-14T20:26:27.281" v="1031" actId="478"/>
          <ac:cxnSpMkLst>
            <pc:docMk/>
            <pc:sldMk cId="3911031167" sldId="256"/>
            <ac:cxnSpMk id="15" creationId="{C786D0A6-860C-E847-B539-9F466C4B3A4F}"/>
          </ac:cxnSpMkLst>
        </pc:cxnChg>
        <pc:cxnChg chg="mod">
          <ac:chgData name="Narang, Sonali" userId="9e80b397-6e2f-49b1-9374-ccdad8589140" providerId="ADAL" clId="{08EB3AD7-677B-AA4A-90AD-5577AE246557}" dt="2021-08-16T15:36:16.978" v="9185"/>
          <ac:cxnSpMkLst>
            <pc:docMk/>
            <pc:sldMk cId="3911031167" sldId="256"/>
            <ac:cxnSpMk id="97" creationId="{32C3F420-BC93-BC42-8CE8-A2F0CCED569F}"/>
          </ac:cxnSpMkLst>
        </pc:cxnChg>
        <pc:cxnChg chg="mod">
          <ac:chgData name="Narang, Sonali" userId="9e80b397-6e2f-49b1-9374-ccdad8589140" providerId="ADAL" clId="{08EB3AD7-677B-AA4A-90AD-5577AE246557}" dt="2021-08-16T15:36:16.978" v="9185"/>
          <ac:cxnSpMkLst>
            <pc:docMk/>
            <pc:sldMk cId="3911031167" sldId="256"/>
            <ac:cxnSpMk id="98" creationId="{9CB4489E-E6F8-6344-80BF-3CFF8883C823}"/>
          </ac:cxnSpMkLst>
        </pc:cxnChg>
        <pc:cxnChg chg="mod">
          <ac:chgData name="Narang, Sonali" userId="9e80b397-6e2f-49b1-9374-ccdad8589140" providerId="ADAL" clId="{08EB3AD7-677B-AA4A-90AD-5577AE246557}" dt="2021-07-09T20:13:14.100" v="4977"/>
          <ac:cxnSpMkLst>
            <pc:docMk/>
            <pc:sldMk cId="3911031167" sldId="256"/>
            <ac:cxnSpMk id="100" creationId="{A6083C1A-C5CD-7549-9BBA-BB32CFCD949D}"/>
          </ac:cxnSpMkLst>
        </pc:cxnChg>
        <pc:cxnChg chg="mod">
          <ac:chgData name="Narang, Sonali" userId="9e80b397-6e2f-49b1-9374-ccdad8589140" providerId="ADAL" clId="{08EB3AD7-677B-AA4A-90AD-5577AE246557}" dt="2021-07-09T20:13:14.100" v="4977"/>
          <ac:cxnSpMkLst>
            <pc:docMk/>
            <pc:sldMk cId="3911031167" sldId="256"/>
            <ac:cxnSpMk id="101" creationId="{8E9B0407-586C-E74C-8BF1-083CFBF2A7FF}"/>
          </ac:cxnSpMkLst>
        </pc:cxnChg>
        <pc:cxnChg chg="mod">
          <ac:chgData name="Narang, Sonali" userId="9e80b397-6e2f-49b1-9374-ccdad8589140" providerId="ADAL" clId="{08EB3AD7-677B-AA4A-90AD-5577AE246557}" dt="2021-08-16T15:36:16.978" v="9185"/>
          <ac:cxnSpMkLst>
            <pc:docMk/>
            <pc:sldMk cId="3911031167" sldId="256"/>
            <ac:cxnSpMk id="103" creationId="{44457225-4E6F-EA4D-B1AF-997283707A4E}"/>
          </ac:cxnSpMkLst>
        </pc:cxnChg>
        <pc:cxnChg chg="mod">
          <ac:chgData name="Narang, Sonali" userId="9e80b397-6e2f-49b1-9374-ccdad8589140" providerId="ADAL" clId="{08EB3AD7-677B-AA4A-90AD-5577AE246557}" dt="2021-07-09T20:13:14.100" v="4977"/>
          <ac:cxnSpMkLst>
            <pc:docMk/>
            <pc:sldMk cId="3911031167" sldId="256"/>
            <ac:cxnSpMk id="106" creationId="{4338556A-A53C-2A40-8508-197DEE84AC4C}"/>
          </ac:cxnSpMkLst>
        </pc:cxnChg>
        <pc:cxnChg chg="mod">
          <ac:chgData name="Narang, Sonali" userId="9e80b397-6e2f-49b1-9374-ccdad8589140" providerId="ADAL" clId="{08EB3AD7-677B-AA4A-90AD-5577AE246557}" dt="2021-08-16T15:38:52.246" v="9227"/>
          <ac:cxnSpMkLst>
            <pc:docMk/>
            <pc:sldMk cId="3911031167" sldId="256"/>
            <ac:cxnSpMk id="125" creationId="{EEF5A356-0640-BA46-97B9-47D8A180E020}"/>
          </ac:cxnSpMkLst>
        </pc:cxnChg>
        <pc:cxnChg chg="mod">
          <ac:chgData name="Narang, Sonali" userId="9e80b397-6e2f-49b1-9374-ccdad8589140" providerId="ADAL" clId="{08EB3AD7-677B-AA4A-90AD-5577AE246557}" dt="2021-08-16T15:38:52.246" v="9227"/>
          <ac:cxnSpMkLst>
            <pc:docMk/>
            <pc:sldMk cId="3911031167" sldId="256"/>
            <ac:cxnSpMk id="126" creationId="{50417F05-2266-B54D-BEF2-32FE5388AB12}"/>
          </ac:cxnSpMkLst>
        </pc:cxnChg>
        <pc:cxnChg chg="mod">
          <ac:chgData name="Narang, Sonali" userId="9e80b397-6e2f-49b1-9374-ccdad8589140" providerId="ADAL" clId="{08EB3AD7-677B-AA4A-90AD-5577AE246557}" dt="2021-07-09T20:16:57.761" v="5055"/>
          <ac:cxnSpMkLst>
            <pc:docMk/>
            <pc:sldMk cId="3911031167" sldId="256"/>
            <ac:cxnSpMk id="131" creationId="{193A9722-CF9A-9743-BE94-DA6EBF6CE580}"/>
          </ac:cxnSpMkLst>
        </pc:cxnChg>
        <pc:cxnChg chg="mod">
          <ac:chgData name="Narang, Sonali" userId="9e80b397-6e2f-49b1-9374-ccdad8589140" providerId="ADAL" clId="{08EB3AD7-677B-AA4A-90AD-5577AE246557}" dt="2021-08-16T15:38:52.246" v="9227"/>
          <ac:cxnSpMkLst>
            <pc:docMk/>
            <pc:sldMk cId="3911031167" sldId="256"/>
            <ac:cxnSpMk id="131" creationId="{7520B5F4-EC7C-CF4D-8F29-6CE376451F66}"/>
          </ac:cxnSpMkLst>
        </pc:cxnChg>
        <pc:cxnChg chg="mod">
          <ac:chgData name="Narang, Sonali" userId="9e80b397-6e2f-49b1-9374-ccdad8589140" providerId="ADAL" clId="{08EB3AD7-677B-AA4A-90AD-5577AE246557}" dt="2021-07-09T20:16:57.761" v="5055"/>
          <ac:cxnSpMkLst>
            <pc:docMk/>
            <pc:sldMk cId="3911031167" sldId="256"/>
            <ac:cxnSpMk id="132" creationId="{512CCCC8-DBE3-1945-8154-335A7F284A4B}"/>
          </ac:cxnSpMkLst>
        </pc:cxnChg>
        <pc:cxnChg chg="add del mod">
          <ac:chgData name="Narang, Sonali" userId="9e80b397-6e2f-49b1-9374-ccdad8589140" providerId="ADAL" clId="{08EB3AD7-677B-AA4A-90AD-5577AE246557}" dt="2021-06-14T20:26:27.281" v="1031" actId="478"/>
          <ac:cxnSpMkLst>
            <pc:docMk/>
            <pc:sldMk cId="3911031167" sldId="256"/>
            <ac:cxnSpMk id="136" creationId="{23E988D9-A6D1-D845-AE5F-712C9E4C617E}"/>
          </ac:cxnSpMkLst>
        </pc:cxnChg>
        <pc:cxnChg chg="mod">
          <ac:chgData name="Narang, Sonali" userId="9e80b397-6e2f-49b1-9374-ccdad8589140" providerId="ADAL" clId="{08EB3AD7-677B-AA4A-90AD-5577AE246557}" dt="2021-07-09T20:16:57.761" v="5055"/>
          <ac:cxnSpMkLst>
            <pc:docMk/>
            <pc:sldMk cId="3911031167" sldId="256"/>
            <ac:cxnSpMk id="137" creationId="{536F90FD-AF5C-8246-847E-2AB3558769A0}"/>
          </ac:cxnSpMkLst>
        </pc:cxnChg>
        <pc:cxnChg chg="mod topLvl">
          <ac:chgData name="Narang, Sonali" userId="9e80b397-6e2f-49b1-9374-ccdad8589140" providerId="ADAL" clId="{08EB3AD7-677B-AA4A-90AD-5577AE246557}" dt="2021-08-16T17:38:40.480" v="9522" actId="408"/>
          <ac:cxnSpMkLst>
            <pc:docMk/>
            <pc:sldMk cId="3911031167" sldId="256"/>
            <ac:cxnSpMk id="152" creationId="{A3EB3746-3DC8-8646-8FB1-8D70591527D5}"/>
          </ac:cxnSpMkLst>
        </pc:cxnChg>
        <pc:cxnChg chg="mod topLvl">
          <ac:chgData name="Narang, Sonali" userId="9e80b397-6e2f-49b1-9374-ccdad8589140" providerId="ADAL" clId="{08EB3AD7-677B-AA4A-90AD-5577AE246557}" dt="2021-08-16T17:38:40.480" v="9522" actId="408"/>
          <ac:cxnSpMkLst>
            <pc:docMk/>
            <pc:sldMk cId="3911031167" sldId="256"/>
            <ac:cxnSpMk id="153" creationId="{DE87E0FE-8534-A24C-A0E1-EB34608A9675}"/>
          </ac:cxnSpMkLst>
        </pc:cxnChg>
        <pc:cxnChg chg="mod topLvl">
          <ac:chgData name="Narang, Sonali" userId="9e80b397-6e2f-49b1-9374-ccdad8589140" providerId="ADAL" clId="{08EB3AD7-677B-AA4A-90AD-5577AE246557}" dt="2021-08-16T17:38:49.194" v="9525" actId="1035"/>
          <ac:cxnSpMkLst>
            <pc:docMk/>
            <pc:sldMk cId="3911031167" sldId="256"/>
            <ac:cxnSpMk id="158" creationId="{A0057418-2D51-7A43-A8C8-B95FB38A160D}"/>
          </ac:cxnSpMkLst>
        </pc:cxnChg>
        <pc:cxnChg chg="mod">
          <ac:chgData name="Narang, Sonali" userId="9e80b397-6e2f-49b1-9374-ccdad8589140" providerId="ADAL" clId="{08EB3AD7-677B-AA4A-90AD-5577AE246557}" dt="2021-06-14T20:26:43.059" v="1033"/>
          <ac:cxnSpMkLst>
            <pc:docMk/>
            <pc:sldMk cId="3911031167" sldId="256"/>
            <ac:cxnSpMk id="159" creationId="{0D55B188-C714-2146-92B2-D733C767F2FF}"/>
          </ac:cxnSpMkLst>
        </pc:cxnChg>
        <pc:cxnChg chg="mod">
          <ac:chgData name="Narang, Sonali" userId="9e80b397-6e2f-49b1-9374-ccdad8589140" providerId="ADAL" clId="{08EB3AD7-677B-AA4A-90AD-5577AE246557}" dt="2021-06-14T20:26:43.059" v="1033"/>
          <ac:cxnSpMkLst>
            <pc:docMk/>
            <pc:sldMk cId="3911031167" sldId="256"/>
            <ac:cxnSpMk id="160" creationId="{A4D8BE40-4662-2344-A3BC-EF4BA5DF949B}"/>
          </ac:cxnSpMkLst>
        </pc:cxnChg>
        <pc:cxnChg chg="mod">
          <ac:chgData name="Narang, Sonali" userId="9e80b397-6e2f-49b1-9374-ccdad8589140" providerId="ADAL" clId="{08EB3AD7-677B-AA4A-90AD-5577AE246557}" dt="2021-06-14T20:26:43.059" v="1033"/>
          <ac:cxnSpMkLst>
            <pc:docMk/>
            <pc:sldMk cId="3911031167" sldId="256"/>
            <ac:cxnSpMk id="164" creationId="{58110604-741C-4F48-99FE-C11098C7BC19}"/>
          </ac:cxnSpMkLst>
        </pc:cxnChg>
        <pc:cxnChg chg="mod">
          <ac:chgData name="Narang, Sonali" userId="9e80b397-6e2f-49b1-9374-ccdad8589140" providerId="ADAL" clId="{08EB3AD7-677B-AA4A-90AD-5577AE246557}" dt="2021-06-14T20:26:54.988" v="1037"/>
          <ac:cxnSpMkLst>
            <pc:docMk/>
            <pc:sldMk cId="3911031167" sldId="256"/>
            <ac:cxnSpMk id="226" creationId="{263405E3-7A54-7049-BE5D-3D71582807B0}"/>
          </ac:cxnSpMkLst>
        </pc:cxnChg>
        <pc:cxnChg chg="mod">
          <ac:chgData name="Narang, Sonali" userId="9e80b397-6e2f-49b1-9374-ccdad8589140" providerId="ADAL" clId="{08EB3AD7-677B-AA4A-90AD-5577AE246557}" dt="2021-06-14T20:26:54.988" v="1037"/>
          <ac:cxnSpMkLst>
            <pc:docMk/>
            <pc:sldMk cId="3911031167" sldId="256"/>
            <ac:cxnSpMk id="227" creationId="{524D1D1A-7303-9640-91E9-260DD0E9B11A}"/>
          </ac:cxnSpMkLst>
        </pc:cxnChg>
        <pc:cxnChg chg="mod">
          <ac:chgData name="Narang, Sonali" userId="9e80b397-6e2f-49b1-9374-ccdad8589140" providerId="ADAL" clId="{08EB3AD7-677B-AA4A-90AD-5577AE246557}" dt="2021-06-14T20:26:54.988" v="1037"/>
          <ac:cxnSpMkLst>
            <pc:docMk/>
            <pc:sldMk cId="3911031167" sldId="256"/>
            <ac:cxnSpMk id="231" creationId="{E727671C-EDBF-5B40-B690-6B6AFE238DBE}"/>
          </ac:cxnSpMkLst>
        </pc:cxnChg>
        <pc:cxnChg chg="mod">
          <ac:chgData name="Narang, Sonali" userId="9e80b397-6e2f-49b1-9374-ccdad8589140" providerId="ADAL" clId="{08EB3AD7-677B-AA4A-90AD-5577AE246557}" dt="2021-08-16T17:39:12.366" v="9528"/>
          <ac:cxnSpMkLst>
            <pc:docMk/>
            <pc:sldMk cId="3911031167" sldId="256"/>
            <ac:cxnSpMk id="234" creationId="{17B48C50-2AA1-9645-9914-3CC324B1A9FC}"/>
          </ac:cxnSpMkLst>
        </pc:cxnChg>
        <pc:cxnChg chg="mod">
          <ac:chgData name="Narang, Sonali" userId="9e80b397-6e2f-49b1-9374-ccdad8589140" providerId="ADAL" clId="{08EB3AD7-677B-AA4A-90AD-5577AE246557}" dt="2021-08-16T17:39:12.366" v="9528"/>
          <ac:cxnSpMkLst>
            <pc:docMk/>
            <pc:sldMk cId="3911031167" sldId="256"/>
            <ac:cxnSpMk id="235" creationId="{A445F44A-CE5F-6B47-A31A-A6C88ED4D220}"/>
          </ac:cxnSpMkLst>
        </pc:cxnChg>
        <pc:cxnChg chg="mod">
          <ac:chgData name="Narang, Sonali" userId="9e80b397-6e2f-49b1-9374-ccdad8589140" providerId="ADAL" clId="{08EB3AD7-677B-AA4A-90AD-5577AE246557}" dt="2021-08-16T17:39:12.366" v="9528"/>
          <ac:cxnSpMkLst>
            <pc:docMk/>
            <pc:sldMk cId="3911031167" sldId="256"/>
            <ac:cxnSpMk id="236" creationId="{6BC29306-5CCB-AB48-9073-8B44A653415F}"/>
          </ac:cxnSpMkLst>
        </pc:cxnChg>
        <pc:cxnChg chg="mod">
          <ac:chgData name="Narang, Sonali" userId="9e80b397-6e2f-49b1-9374-ccdad8589140" providerId="ADAL" clId="{08EB3AD7-677B-AA4A-90AD-5577AE246557}" dt="2021-06-14T20:30:46.312" v="1119" actId="14100"/>
          <ac:cxnSpMkLst>
            <pc:docMk/>
            <pc:sldMk cId="3911031167" sldId="256"/>
            <ac:cxnSpMk id="293" creationId="{B7C0041D-9D2B-EA45-8804-91E734860841}"/>
          </ac:cxnSpMkLst>
        </pc:cxnChg>
        <pc:cxnChg chg="mod">
          <ac:chgData name="Narang, Sonali" userId="9e80b397-6e2f-49b1-9374-ccdad8589140" providerId="ADAL" clId="{08EB3AD7-677B-AA4A-90AD-5577AE246557}" dt="2021-06-14T20:26:57.886" v="1039"/>
          <ac:cxnSpMkLst>
            <pc:docMk/>
            <pc:sldMk cId="3911031167" sldId="256"/>
            <ac:cxnSpMk id="294" creationId="{77D13EED-E26F-3A40-8BF3-B6FC5FDE38EF}"/>
          </ac:cxnSpMkLst>
        </pc:cxnChg>
        <pc:cxnChg chg="mod">
          <ac:chgData name="Narang, Sonali" userId="9e80b397-6e2f-49b1-9374-ccdad8589140" providerId="ADAL" clId="{08EB3AD7-677B-AA4A-90AD-5577AE246557}" dt="2021-06-14T20:26:57.886" v="1039"/>
          <ac:cxnSpMkLst>
            <pc:docMk/>
            <pc:sldMk cId="3911031167" sldId="256"/>
            <ac:cxnSpMk id="298" creationId="{CEB42594-92C4-A443-9D92-86B21DAE2294}"/>
          </ac:cxnSpMkLst>
        </pc:cxnChg>
      </pc:sldChg>
      <pc:sldChg chg="addSp delSp modSp mod ord modNotesTx">
        <pc:chgData name="Narang, Sonali" userId="9e80b397-6e2f-49b1-9374-ccdad8589140" providerId="ADAL" clId="{08EB3AD7-677B-AA4A-90AD-5577AE246557}" dt="2021-08-16T18:42:46.206" v="9870" actId="1038"/>
        <pc:sldMkLst>
          <pc:docMk/>
          <pc:sldMk cId="1854626235" sldId="257"/>
        </pc:sldMkLst>
        <pc:spChg chg="add del mod">
          <ac:chgData name="Narang, Sonali" userId="9e80b397-6e2f-49b1-9374-ccdad8589140" providerId="ADAL" clId="{08EB3AD7-677B-AA4A-90AD-5577AE246557}" dt="2021-06-02T20:55:19.265" v="670" actId="478"/>
          <ac:spMkLst>
            <pc:docMk/>
            <pc:sldMk cId="1854626235" sldId="257"/>
            <ac:spMk id="2" creationId="{7B0D3BDA-92F5-A940-BA38-BEF8F917BECA}"/>
          </ac:spMkLst>
        </pc:spChg>
        <pc:spChg chg="add del mod">
          <ac:chgData name="Narang, Sonali" userId="9e80b397-6e2f-49b1-9374-ccdad8589140" providerId="ADAL" clId="{08EB3AD7-677B-AA4A-90AD-5577AE246557}" dt="2021-08-16T15:40:26.363" v="9256" actId="21"/>
          <ac:spMkLst>
            <pc:docMk/>
            <pc:sldMk cId="1854626235" sldId="257"/>
            <ac:spMk id="2" creationId="{E2E5F4B0-265F-BD41-B1DE-7A6D24A6C916}"/>
          </ac:spMkLst>
        </pc:spChg>
        <pc:spChg chg="mod">
          <ac:chgData name="Narang, Sonali" userId="9e80b397-6e2f-49b1-9374-ccdad8589140" providerId="ADAL" clId="{08EB3AD7-677B-AA4A-90AD-5577AE246557}" dt="2021-06-22T21:08:34.782" v="1349" actId="20577"/>
          <ac:spMkLst>
            <pc:docMk/>
            <pc:sldMk cId="1854626235" sldId="257"/>
            <ac:spMk id="4" creationId="{F6669B9D-B042-D548-BD0F-97015091799B}"/>
          </ac:spMkLst>
        </pc:spChg>
        <pc:spChg chg="add del mod">
          <ac:chgData name="Narang, Sonali" userId="9e80b397-6e2f-49b1-9374-ccdad8589140" providerId="ADAL" clId="{08EB3AD7-677B-AA4A-90AD-5577AE246557}" dt="2021-06-24T21:21:26.199" v="1912" actId="478"/>
          <ac:spMkLst>
            <pc:docMk/>
            <pc:sldMk cId="1854626235" sldId="257"/>
            <ac:spMk id="72" creationId="{DEFDFD08-1810-4448-8965-46E6E45D11A0}"/>
          </ac:spMkLst>
        </pc:spChg>
        <pc:spChg chg="mod">
          <ac:chgData name="Narang, Sonali" userId="9e80b397-6e2f-49b1-9374-ccdad8589140" providerId="ADAL" clId="{08EB3AD7-677B-AA4A-90AD-5577AE246557}" dt="2021-08-16T18:42:46.206" v="9870" actId="1038"/>
          <ac:spMkLst>
            <pc:docMk/>
            <pc:sldMk cId="1854626235" sldId="257"/>
            <ac:spMk id="78" creationId="{AE692B16-99A6-5F46-AC90-BC9F8991FE3A}"/>
          </ac:spMkLst>
        </pc:spChg>
        <pc:spChg chg="mod">
          <ac:chgData name="Narang, Sonali" userId="9e80b397-6e2f-49b1-9374-ccdad8589140" providerId="ADAL" clId="{08EB3AD7-677B-AA4A-90AD-5577AE246557}" dt="2021-08-16T18:42:46.206" v="9870" actId="1038"/>
          <ac:spMkLst>
            <pc:docMk/>
            <pc:sldMk cId="1854626235" sldId="257"/>
            <ac:spMk id="79" creationId="{4CA9431C-F615-6544-91AF-8E63590AD04C}"/>
          </ac:spMkLst>
        </pc:spChg>
        <pc:spChg chg="mod">
          <ac:chgData name="Narang, Sonali" userId="9e80b397-6e2f-49b1-9374-ccdad8589140" providerId="ADAL" clId="{08EB3AD7-677B-AA4A-90AD-5577AE246557}" dt="2021-08-16T18:42:25.788" v="9834" actId="1038"/>
          <ac:spMkLst>
            <pc:docMk/>
            <pc:sldMk cId="1854626235" sldId="257"/>
            <ac:spMk id="80" creationId="{EEAFDDE8-7674-C440-99B7-B7430DE40677}"/>
          </ac:spMkLst>
        </pc:spChg>
        <pc:spChg chg="mod">
          <ac:chgData name="Narang, Sonali" userId="9e80b397-6e2f-49b1-9374-ccdad8589140" providerId="ADAL" clId="{08EB3AD7-677B-AA4A-90AD-5577AE246557}" dt="2021-08-16T18:42:25.788" v="9834" actId="1038"/>
          <ac:spMkLst>
            <pc:docMk/>
            <pc:sldMk cId="1854626235" sldId="257"/>
            <ac:spMk id="81" creationId="{A40B4853-301D-5B45-B69D-BEA17B88E1A1}"/>
          </ac:spMkLst>
        </pc:spChg>
        <pc:grpChg chg="add del">
          <ac:chgData name="Narang, Sonali" userId="9e80b397-6e2f-49b1-9374-ccdad8589140" providerId="ADAL" clId="{08EB3AD7-677B-AA4A-90AD-5577AE246557}" dt="2021-06-24T21:17:01.580" v="1878" actId="478"/>
          <ac:grpSpMkLst>
            <pc:docMk/>
            <pc:sldMk cId="1854626235" sldId="257"/>
            <ac:grpSpMk id="2" creationId="{DF18BFDE-AFD5-B644-BC98-7069D10BD34E}"/>
          </ac:grpSpMkLst>
        </pc:grpChg>
        <pc:grpChg chg="mod">
          <ac:chgData name="Narang, Sonali" userId="9e80b397-6e2f-49b1-9374-ccdad8589140" providerId="ADAL" clId="{08EB3AD7-677B-AA4A-90AD-5577AE246557}" dt="2021-07-09T20:26:57.941" v="5133" actId="1076"/>
          <ac:grpSpMkLst>
            <pc:docMk/>
            <pc:sldMk cId="1854626235" sldId="257"/>
            <ac:grpSpMk id="94" creationId="{AEE6DF85-0659-484C-AB45-73FA6E20C5C4}"/>
          </ac:grpSpMkLst>
        </pc:grpChg>
        <pc:picChg chg="add del mod">
          <ac:chgData name="Narang, Sonali" userId="9e80b397-6e2f-49b1-9374-ccdad8589140" providerId="ADAL" clId="{08EB3AD7-677B-AA4A-90AD-5577AE246557}" dt="2021-06-24T21:17:06.860" v="1891"/>
          <ac:picMkLst>
            <pc:docMk/>
            <pc:sldMk cId="1854626235" sldId="257"/>
            <ac:picMk id="9" creationId="{DBD12E31-7DC8-6D4E-A662-83AE7447D739}"/>
          </ac:picMkLst>
        </pc:picChg>
        <pc:picChg chg="add del mod">
          <ac:chgData name="Narang, Sonali" userId="9e80b397-6e2f-49b1-9374-ccdad8589140" providerId="ADAL" clId="{08EB3AD7-677B-AA4A-90AD-5577AE246557}" dt="2021-06-24T21:17:06.860" v="1891"/>
          <ac:picMkLst>
            <pc:docMk/>
            <pc:sldMk cId="1854626235" sldId="257"/>
            <ac:picMk id="11" creationId="{2DA8C93E-81F4-F843-92F1-5AC27DC263DA}"/>
          </ac:picMkLst>
        </pc:picChg>
        <pc:picChg chg="add del mod">
          <ac:chgData name="Narang, Sonali" userId="9e80b397-6e2f-49b1-9374-ccdad8589140" providerId="ADAL" clId="{08EB3AD7-677B-AA4A-90AD-5577AE246557}" dt="2021-06-24T21:17:06.860" v="1891"/>
          <ac:picMkLst>
            <pc:docMk/>
            <pc:sldMk cId="1854626235" sldId="257"/>
            <ac:picMk id="13" creationId="{982B05B0-A9FD-8945-891C-9DF2A3FD58B9}"/>
          </ac:picMkLst>
        </pc:picChg>
        <pc:picChg chg="add del mod">
          <ac:chgData name="Narang, Sonali" userId="9e80b397-6e2f-49b1-9374-ccdad8589140" providerId="ADAL" clId="{08EB3AD7-677B-AA4A-90AD-5577AE246557}" dt="2021-06-24T21:17:06.860" v="1891"/>
          <ac:picMkLst>
            <pc:docMk/>
            <pc:sldMk cId="1854626235" sldId="257"/>
            <ac:picMk id="16" creationId="{43C1DBEF-D964-2F47-9D7D-A427A83C1B9D}"/>
          </ac:picMkLst>
        </pc:picChg>
        <pc:picChg chg="add del mod">
          <ac:chgData name="Narang, Sonali" userId="9e80b397-6e2f-49b1-9374-ccdad8589140" providerId="ADAL" clId="{08EB3AD7-677B-AA4A-90AD-5577AE246557}" dt="2021-06-24T21:17:06.860" v="1891"/>
          <ac:picMkLst>
            <pc:docMk/>
            <pc:sldMk cId="1854626235" sldId="257"/>
            <ac:picMk id="18" creationId="{4D45DEBE-EAC8-C442-8540-8B8B541BFAA9}"/>
          </ac:picMkLst>
        </pc:picChg>
        <pc:picChg chg="add del mod">
          <ac:chgData name="Narang, Sonali" userId="9e80b397-6e2f-49b1-9374-ccdad8589140" providerId="ADAL" clId="{08EB3AD7-677B-AA4A-90AD-5577AE246557}" dt="2021-06-24T21:31:20.479" v="1914" actId="21"/>
          <ac:picMkLst>
            <pc:docMk/>
            <pc:sldMk cId="1854626235" sldId="257"/>
            <ac:picMk id="20" creationId="{4FD20FA3-89A0-D547-94B4-BF42EA0037EA}"/>
          </ac:picMkLst>
        </pc:picChg>
        <pc:picChg chg="add del mod">
          <ac:chgData name="Narang, Sonali" userId="9e80b397-6e2f-49b1-9374-ccdad8589140" providerId="ADAL" clId="{08EB3AD7-677B-AA4A-90AD-5577AE246557}" dt="2021-06-24T21:31:20.479" v="1914" actId="21"/>
          <ac:picMkLst>
            <pc:docMk/>
            <pc:sldMk cId="1854626235" sldId="257"/>
            <ac:picMk id="22" creationId="{63094FA5-DDF4-E64D-8736-77CEF631211E}"/>
          </ac:picMkLst>
        </pc:picChg>
        <pc:picChg chg="add del mod">
          <ac:chgData name="Narang, Sonali" userId="9e80b397-6e2f-49b1-9374-ccdad8589140" providerId="ADAL" clId="{08EB3AD7-677B-AA4A-90AD-5577AE246557}" dt="2021-06-02T21:19:09.085" v="696"/>
          <ac:picMkLst>
            <pc:docMk/>
            <pc:sldMk cId="1854626235" sldId="257"/>
            <ac:picMk id="72" creationId="{74E65424-1EE4-FA4D-814A-AC2C37778C62}"/>
          </ac:picMkLst>
        </pc:picChg>
        <pc:picChg chg="add del mod">
          <ac:chgData name="Narang, Sonali" userId="9e80b397-6e2f-49b1-9374-ccdad8589140" providerId="ADAL" clId="{08EB3AD7-677B-AA4A-90AD-5577AE246557}" dt="2021-06-02T21:19:33.962" v="707"/>
          <ac:picMkLst>
            <pc:docMk/>
            <pc:sldMk cId="1854626235" sldId="257"/>
            <ac:picMk id="73" creationId="{FC405BCF-F688-774D-9A74-43BA8BFFC1DE}"/>
          </ac:picMkLst>
        </pc:picChg>
        <pc:picChg chg="add del mod modCrop">
          <ac:chgData name="Narang, Sonali" userId="9e80b397-6e2f-49b1-9374-ccdad8589140" providerId="ADAL" clId="{08EB3AD7-677B-AA4A-90AD-5577AE246557}" dt="2021-08-16T15:40:23.604" v="9255" actId="478"/>
          <ac:picMkLst>
            <pc:docMk/>
            <pc:sldMk cId="1854626235" sldId="257"/>
            <ac:picMk id="74" creationId="{EC5CAA65-0D50-9349-84B0-4519D7D53827}"/>
          </ac:picMkLst>
        </pc:picChg>
        <pc:picChg chg="mod">
          <ac:chgData name="Narang, Sonali" userId="9e80b397-6e2f-49b1-9374-ccdad8589140" providerId="ADAL" clId="{08EB3AD7-677B-AA4A-90AD-5577AE246557}" dt="2021-08-16T18:42:46.206" v="9870" actId="1038"/>
          <ac:picMkLst>
            <pc:docMk/>
            <pc:sldMk cId="1854626235" sldId="257"/>
            <ac:picMk id="85" creationId="{04BCF87E-AF8A-C640-BEBE-06979DA213FC}"/>
          </ac:picMkLst>
        </pc:picChg>
        <pc:picChg chg="mod">
          <ac:chgData name="Narang, Sonali" userId="9e80b397-6e2f-49b1-9374-ccdad8589140" providerId="ADAL" clId="{08EB3AD7-677B-AA4A-90AD-5577AE246557}" dt="2021-08-16T18:42:25.788" v="9834" actId="1038"/>
          <ac:picMkLst>
            <pc:docMk/>
            <pc:sldMk cId="1854626235" sldId="257"/>
            <ac:picMk id="89" creationId="{9F67AE90-47B7-5242-8591-AEF8D446E1CF}"/>
          </ac:picMkLst>
        </pc:picChg>
        <pc:picChg chg="add del mod">
          <ac:chgData name="Narang, Sonali" userId="9e80b397-6e2f-49b1-9374-ccdad8589140" providerId="ADAL" clId="{08EB3AD7-677B-AA4A-90AD-5577AE246557}" dt="2021-06-02T21:23:47.817" v="739" actId="1038"/>
          <ac:picMkLst>
            <pc:docMk/>
            <pc:sldMk cId="1854626235" sldId="257"/>
            <ac:picMk id="91" creationId="{06D63945-83A0-5C46-BB62-843DD22FD7F6}"/>
          </ac:picMkLst>
        </pc:picChg>
        <pc:picChg chg="mod">
          <ac:chgData name="Narang, Sonali" userId="9e80b397-6e2f-49b1-9374-ccdad8589140" providerId="ADAL" clId="{08EB3AD7-677B-AA4A-90AD-5577AE246557}" dt="2021-06-22T18:55:36.526" v="1142" actId="1076"/>
          <ac:picMkLst>
            <pc:docMk/>
            <pc:sldMk cId="1854626235" sldId="257"/>
            <ac:picMk id="98" creationId="{AB015502-B36C-654D-AE21-0AAD426C43F1}"/>
          </ac:picMkLst>
        </pc:picChg>
        <pc:picChg chg="mod">
          <ac:chgData name="Narang, Sonali" userId="9e80b397-6e2f-49b1-9374-ccdad8589140" providerId="ADAL" clId="{08EB3AD7-677B-AA4A-90AD-5577AE246557}" dt="2021-07-12T21:53:33.272" v="8824" actId="1076"/>
          <ac:picMkLst>
            <pc:docMk/>
            <pc:sldMk cId="1854626235" sldId="257"/>
            <ac:picMk id="109" creationId="{83518A59-DE1F-C64E-95A4-9EE0523C4D94}"/>
          </ac:picMkLst>
        </pc:picChg>
        <pc:picChg chg="mod">
          <ac:chgData name="Narang, Sonali" userId="9e80b397-6e2f-49b1-9374-ccdad8589140" providerId="ADAL" clId="{08EB3AD7-677B-AA4A-90AD-5577AE246557}" dt="2021-07-12T21:53:33.272" v="8824" actId="1076"/>
          <ac:picMkLst>
            <pc:docMk/>
            <pc:sldMk cId="1854626235" sldId="257"/>
            <ac:picMk id="111" creationId="{3DBF3880-6CBA-8041-B9CD-F2A215E3C8DD}"/>
          </ac:picMkLst>
        </pc:picChg>
        <pc:picChg chg="mod">
          <ac:chgData name="Narang, Sonali" userId="9e80b397-6e2f-49b1-9374-ccdad8589140" providerId="ADAL" clId="{08EB3AD7-677B-AA4A-90AD-5577AE246557}" dt="2021-07-20T21:30:28.485" v="8955" actId="1076"/>
          <ac:picMkLst>
            <pc:docMk/>
            <pc:sldMk cId="1854626235" sldId="257"/>
            <ac:picMk id="112" creationId="{6B6DD000-238E-8F48-B8CA-73434CB731ED}"/>
          </ac:picMkLst>
        </pc:picChg>
        <pc:picChg chg="mod">
          <ac:chgData name="Narang, Sonali" userId="9e80b397-6e2f-49b1-9374-ccdad8589140" providerId="ADAL" clId="{08EB3AD7-677B-AA4A-90AD-5577AE246557}" dt="2021-06-14T17:20:11.208" v="1028" actId="1076"/>
          <ac:picMkLst>
            <pc:docMk/>
            <pc:sldMk cId="1854626235" sldId="257"/>
            <ac:picMk id="117" creationId="{5AF2AB47-DAE2-F643-8CDC-5611248A02A7}"/>
          </ac:picMkLst>
        </pc:picChg>
      </pc:sldChg>
      <pc:sldChg chg="addSp delSp modSp mod ord">
        <pc:chgData name="Narang, Sonali" userId="9e80b397-6e2f-49b1-9374-ccdad8589140" providerId="ADAL" clId="{08EB3AD7-677B-AA4A-90AD-5577AE246557}" dt="2021-07-09T19:52:19.287" v="4919" actId="20578"/>
        <pc:sldMkLst>
          <pc:docMk/>
          <pc:sldMk cId="1155223781" sldId="258"/>
        </pc:sldMkLst>
        <pc:spChg chg="mod">
          <ac:chgData name="Narang, Sonali" userId="9e80b397-6e2f-49b1-9374-ccdad8589140" providerId="ADAL" clId="{08EB3AD7-677B-AA4A-90AD-5577AE246557}" dt="2021-07-09T17:02:59.515" v="4477" actId="20577"/>
          <ac:spMkLst>
            <pc:docMk/>
            <pc:sldMk cId="1155223781" sldId="258"/>
            <ac:spMk id="4" creationId="{F6669B9D-B042-D548-BD0F-97015091799B}"/>
          </ac:spMkLst>
        </pc:spChg>
        <pc:picChg chg="del mod">
          <ac:chgData name="Narang, Sonali" userId="9e80b397-6e2f-49b1-9374-ccdad8589140" providerId="ADAL" clId="{08EB3AD7-677B-AA4A-90AD-5577AE246557}" dt="2021-06-28T19:45:08.958" v="2533" actId="21"/>
          <ac:picMkLst>
            <pc:docMk/>
            <pc:sldMk cId="1155223781" sldId="258"/>
            <ac:picMk id="2" creationId="{565ED7F5-1C52-8F4C-8691-D4485816FEBB}"/>
          </ac:picMkLst>
        </pc:picChg>
        <pc:picChg chg="del mod modCrop">
          <ac:chgData name="Narang, Sonali" userId="9e80b397-6e2f-49b1-9374-ccdad8589140" providerId="ADAL" clId="{08EB3AD7-677B-AA4A-90AD-5577AE246557}" dt="2021-06-28T19:45:08.958" v="2533" actId="21"/>
          <ac:picMkLst>
            <pc:docMk/>
            <pc:sldMk cId="1155223781" sldId="258"/>
            <ac:picMk id="3" creationId="{A03C310D-8531-2D4A-9D9D-C21C507CB6FE}"/>
          </ac:picMkLst>
        </pc:picChg>
        <pc:picChg chg="add del mod">
          <ac:chgData name="Narang, Sonali" userId="9e80b397-6e2f-49b1-9374-ccdad8589140" providerId="ADAL" clId="{08EB3AD7-677B-AA4A-90AD-5577AE246557}" dt="2021-07-09T17:03:07.837" v="4478" actId="478"/>
          <ac:picMkLst>
            <pc:docMk/>
            <pc:sldMk cId="1155223781" sldId="258"/>
            <ac:picMk id="12" creationId="{6922D9DC-D3C5-1641-860E-0889271BE70D}"/>
          </ac:picMkLst>
        </pc:picChg>
      </pc:sldChg>
      <pc:sldChg chg="addSp delSp modSp mod ord">
        <pc:chgData name="Narang, Sonali" userId="9e80b397-6e2f-49b1-9374-ccdad8589140" providerId="ADAL" clId="{08EB3AD7-677B-AA4A-90AD-5577AE246557}" dt="2021-07-09T21:10:50.663" v="5471" actId="1076"/>
        <pc:sldMkLst>
          <pc:docMk/>
          <pc:sldMk cId="209215240" sldId="259"/>
        </pc:sldMkLst>
        <pc:spChg chg="mod">
          <ac:chgData name="Narang, Sonali" userId="9e80b397-6e2f-49b1-9374-ccdad8589140" providerId="ADAL" clId="{08EB3AD7-677B-AA4A-90AD-5577AE246557}" dt="2021-07-09T20:20:24.648" v="5125" actId="1076"/>
          <ac:spMkLst>
            <pc:docMk/>
            <pc:sldMk cId="209215240" sldId="259"/>
            <ac:spMk id="7" creationId="{4C5F5CAE-FBFD-964D-A356-746AAC86DC9E}"/>
          </ac:spMkLst>
        </pc:spChg>
        <pc:spChg chg="add del mod">
          <ac:chgData name="Narang, Sonali" userId="9e80b397-6e2f-49b1-9374-ccdad8589140" providerId="ADAL" clId="{08EB3AD7-677B-AA4A-90AD-5577AE246557}" dt="2021-07-09T21:10:50.663" v="5471" actId="1076"/>
          <ac:spMkLst>
            <pc:docMk/>
            <pc:sldMk cId="209215240" sldId="259"/>
            <ac:spMk id="14" creationId="{D37AA046-AD02-C64A-811C-6B07892F0020}"/>
          </ac:spMkLst>
        </pc:spChg>
        <pc:picChg chg="del mod">
          <ac:chgData name="Narang, Sonali" userId="9e80b397-6e2f-49b1-9374-ccdad8589140" providerId="ADAL" clId="{08EB3AD7-677B-AA4A-90AD-5577AE246557}" dt="2021-07-09T16:33:54.769" v="4202" actId="21"/>
          <ac:picMkLst>
            <pc:docMk/>
            <pc:sldMk cId="209215240" sldId="259"/>
            <ac:picMk id="3" creationId="{B4D62D87-34E6-D740-84D7-71365F0F47AC}"/>
          </ac:picMkLst>
        </pc:picChg>
        <pc:picChg chg="del mod">
          <ac:chgData name="Narang, Sonali" userId="9e80b397-6e2f-49b1-9374-ccdad8589140" providerId="ADAL" clId="{08EB3AD7-677B-AA4A-90AD-5577AE246557}" dt="2021-07-09T16:33:54.769" v="4202" actId="21"/>
          <ac:picMkLst>
            <pc:docMk/>
            <pc:sldMk cId="209215240" sldId="259"/>
            <ac:picMk id="9" creationId="{80ABA082-A86B-184A-A8AB-B0AA0DC40A58}"/>
          </ac:picMkLst>
        </pc:picChg>
        <pc:picChg chg="add mod">
          <ac:chgData name="Narang, Sonali" userId="9e80b397-6e2f-49b1-9374-ccdad8589140" providerId="ADAL" clId="{08EB3AD7-677B-AA4A-90AD-5577AE246557}" dt="2021-07-09T20:20:09.224" v="5123" actId="1076"/>
          <ac:picMkLst>
            <pc:docMk/>
            <pc:sldMk cId="209215240" sldId="259"/>
            <ac:picMk id="10" creationId="{0B12A9B1-F17C-0849-AC0C-CB2A4EFD0F60}"/>
          </ac:picMkLst>
        </pc:picChg>
        <pc:picChg chg="add mod">
          <ac:chgData name="Narang, Sonali" userId="9e80b397-6e2f-49b1-9374-ccdad8589140" providerId="ADAL" clId="{08EB3AD7-677B-AA4A-90AD-5577AE246557}" dt="2021-07-09T20:20:09.224" v="5123" actId="1076"/>
          <ac:picMkLst>
            <pc:docMk/>
            <pc:sldMk cId="209215240" sldId="259"/>
            <ac:picMk id="11" creationId="{1F524B48-6322-8447-83C7-60DC15692CA3}"/>
          </ac:picMkLst>
        </pc:picChg>
        <pc:picChg chg="add mod">
          <ac:chgData name="Narang, Sonali" userId="9e80b397-6e2f-49b1-9374-ccdad8589140" providerId="ADAL" clId="{08EB3AD7-677B-AA4A-90AD-5577AE246557}" dt="2021-07-09T20:20:09.224" v="5123" actId="1076"/>
          <ac:picMkLst>
            <pc:docMk/>
            <pc:sldMk cId="209215240" sldId="259"/>
            <ac:picMk id="12" creationId="{48AEAC96-9CE5-8E43-939C-B35343B002B4}"/>
          </ac:picMkLst>
        </pc:picChg>
        <pc:picChg chg="add mod">
          <ac:chgData name="Narang, Sonali" userId="9e80b397-6e2f-49b1-9374-ccdad8589140" providerId="ADAL" clId="{08EB3AD7-677B-AA4A-90AD-5577AE246557}" dt="2021-07-09T20:20:13.298" v="5124" actId="1076"/>
          <ac:picMkLst>
            <pc:docMk/>
            <pc:sldMk cId="209215240" sldId="259"/>
            <ac:picMk id="13" creationId="{C8748E8A-87FA-1D4C-A3AD-8DA8B7A14462}"/>
          </ac:picMkLst>
        </pc:picChg>
      </pc:sldChg>
      <pc:sldChg chg="addSp delSp modSp mod ord">
        <pc:chgData name="Narang, Sonali" userId="9e80b397-6e2f-49b1-9374-ccdad8589140" providerId="ADAL" clId="{08EB3AD7-677B-AA4A-90AD-5577AE246557}" dt="2021-08-16T15:40:35.334" v="9260" actId="1076"/>
        <pc:sldMkLst>
          <pc:docMk/>
          <pc:sldMk cId="2209615388" sldId="260"/>
        </pc:sldMkLst>
        <pc:spChg chg="mod">
          <ac:chgData name="Narang, Sonali" userId="9e80b397-6e2f-49b1-9374-ccdad8589140" providerId="ADAL" clId="{08EB3AD7-677B-AA4A-90AD-5577AE246557}" dt="2021-06-02T21:19:41.430" v="712" actId="1076"/>
          <ac:spMkLst>
            <pc:docMk/>
            <pc:sldMk cId="2209615388" sldId="260"/>
            <ac:spMk id="6" creationId="{41464C80-B659-484D-A16F-8018DEC5471A}"/>
          </ac:spMkLst>
        </pc:spChg>
        <pc:spChg chg="add mod">
          <ac:chgData name="Narang, Sonali" userId="9e80b397-6e2f-49b1-9374-ccdad8589140" providerId="ADAL" clId="{08EB3AD7-677B-AA4A-90AD-5577AE246557}" dt="2021-08-16T15:40:35.334" v="9260" actId="1076"/>
          <ac:spMkLst>
            <pc:docMk/>
            <pc:sldMk cId="2209615388" sldId="260"/>
            <ac:spMk id="10" creationId="{5BCE36BA-509D-494A-96F7-EBB2E2AD0A92}"/>
          </ac:spMkLst>
        </pc:spChg>
        <pc:picChg chg="add mod modCrop">
          <ac:chgData name="Narang, Sonali" userId="9e80b397-6e2f-49b1-9374-ccdad8589140" providerId="ADAL" clId="{08EB3AD7-677B-AA4A-90AD-5577AE246557}" dt="2021-06-02T20:57:11.682" v="690" actId="167"/>
          <ac:picMkLst>
            <pc:docMk/>
            <pc:sldMk cId="2209615388" sldId="260"/>
            <ac:picMk id="2" creationId="{FFF37771-971D-4C4C-B781-0D37188A46A1}"/>
          </ac:picMkLst>
        </pc:picChg>
        <pc:picChg chg="add mod modCrop">
          <ac:chgData name="Narang, Sonali" userId="9e80b397-6e2f-49b1-9374-ccdad8589140" providerId="ADAL" clId="{08EB3AD7-677B-AA4A-90AD-5577AE246557}" dt="2021-06-02T20:57:11.682" v="690" actId="167"/>
          <ac:picMkLst>
            <pc:docMk/>
            <pc:sldMk cId="2209615388" sldId="260"/>
            <ac:picMk id="3" creationId="{969BAEF7-6218-824D-A489-ADB0661F7F74}"/>
          </ac:picMkLst>
        </pc:picChg>
        <pc:picChg chg="add mod modCrop">
          <ac:chgData name="Narang, Sonali" userId="9e80b397-6e2f-49b1-9374-ccdad8589140" providerId="ADAL" clId="{08EB3AD7-677B-AA4A-90AD-5577AE246557}" dt="2021-06-02T20:57:11.682" v="690" actId="167"/>
          <ac:picMkLst>
            <pc:docMk/>
            <pc:sldMk cId="2209615388" sldId="260"/>
            <ac:picMk id="9" creationId="{EE74AD70-F2BB-734D-B341-9CB9C96FD28C}"/>
          </ac:picMkLst>
        </pc:picChg>
        <pc:picChg chg="add del mod">
          <ac:chgData name="Narang, Sonali" userId="9e80b397-6e2f-49b1-9374-ccdad8589140" providerId="ADAL" clId="{08EB3AD7-677B-AA4A-90AD-5577AE246557}" dt="2021-06-02T21:19:36.010" v="709"/>
          <ac:picMkLst>
            <pc:docMk/>
            <pc:sldMk cId="2209615388" sldId="260"/>
            <ac:picMk id="10" creationId="{14E6AEB6-B313-074B-8CE9-C2AE543115C7}"/>
          </ac:picMkLst>
        </pc:picChg>
        <pc:picChg chg="add del">
          <ac:chgData name="Narang, Sonali" userId="9e80b397-6e2f-49b1-9374-ccdad8589140" providerId="ADAL" clId="{08EB3AD7-677B-AA4A-90AD-5577AE246557}" dt="2021-07-12T18:45:20.376" v="7132"/>
          <ac:picMkLst>
            <pc:docMk/>
            <pc:sldMk cId="2209615388" sldId="260"/>
            <ac:picMk id="1026" creationId="{61021FE8-B9DB-A945-B028-320F0A6FCA8E}"/>
          </ac:picMkLst>
        </pc:picChg>
      </pc:sldChg>
      <pc:sldChg chg="addSp delSp modSp mod ord addCm delCm modNotesTx">
        <pc:chgData name="Narang, Sonali" userId="9e80b397-6e2f-49b1-9374-ccdad8589140" providerId="ADAL" clId="{08EB3AD7-677B-AA4A-90AD-5577AE246557}" dt="2021-08-17T17:31:26.452" v="10197" actId="478"/>
        <pc:sldMkLst>
          <pc:docMk/>
          <pc:sldMk cId="304432944" sldId="261"/>
        </pc:sldMkLst>
        <pc:spChg chg="mod">
          <ac:chgData name="Narang, Sonali" userId="9e80b397-6e2f-49b1-9374-ccdad8589140" providerId="ADAL" clId="{08EB3AD7-677B-AA4A-90AD-5577AE246557}" dt="2021-06-22T18:55:56.145" v="1147" actId="20577"/>
          <ac:spMkLst>
            <pc:docMk/>
            <pc:sldMk cId="304432944" sldId="261"/>
            <ac:spMk id="4" creationId="{F6669B9D-B042-D548-BD0F-97015091799B}"/>
          </ac:spMkLst>
        </pc:spChg>
        <pc:spChg chg="mod">
          <ac:chgData name="Narang, Sonali" userId="9e80b397-6e2f-49b1-9374-ccdad8589140" providerId="ADAL" clId="{08EB3AD7-677B-AA4A-90AD-5577AE246557}" dt="2021-06-28T18:19:08.489" v="2155" actId="12788"/>
          <ac:spMkLst>
            <pc:docMk/>
            <pc:sldMk cId="304432944" sldId="261"/>
            <ac:spMk id="5" creationId="{FAFFEC37-A0C5-5846-8534-22E3DEF6CEF4}"/>
          </ac:spMkLst>
        </pc:spChg>
        <pc:spChg chg="mod">
          <ac:chgData name="Narang, Sonali" userId="9e80b397-6e2f-49b1-9374-ccdad8589140" providerId="ADAL" clId="{08EB3AD7-677B-AA4A-90AD-5577AE246557}" dt="2021-06-28T18:19:36.259" v="2162" actId="1037"/>
          <ac:spMkLst>
            <pc:docMk/>
            <pc:sldMk cId="304432944" sldId="261"/>
            <ac:spMk id="6" creationId="{41464C80-B659-484D-A16F-8018DEC5471A}"/>
          </ac:spMkLst>
        </pc:spChg>
        <pc:spChg chg="mod">
          <ac:chgData name="Narang, Sonali" userId="9e80b397-6e2f-49b1-9374-ccdad8589140" providerId="ADAL" clId="{08EB3AD7-677B-AA4A-90AD-5577AE246557}" dt="2021-07-09T15:36:16.767" v="3722" actId="1036"/>
          <ac:spMkLst>
            <pc:docMk/>
            <pc:sldMk cId="304432944" sldId="261"/>
            <ac:spMk id="7" creationId="{4C5F5CAE-FBFD-964D-A356-746AAC86DC9E}"/>
          </ac:spMkLst>
        </pc:spChg>
        <pc:spChg chg="mod">
          <ac:chgData name="Narang, Sonali" userId="9e80b397-6e2f-49b1-9374-ccdad8589140" providerId="ADAL" clId="{08EB3AD7-677B-AA4A-90AD-5577AE246557}" dt="2021-07-09T19:56:28.361" v="4943" actId="1076"/>
          <ac:spMkLst>
            <pc:docMk/>
            <pc:sldMk cId="304432944" sldId="261"/>
            <ac:spMk id="8" creationId="{8A9BAE78-C4FF-1843-94F6-3410EB884848}"/>
          </ac:spMkLst>
        </pc:spChg>
        <pc:spChg chg="add mod">
          <ac:chgData name="Narang, Sonali" userId="9e80b397-6e2f-49b1-9374-ccdad8589140" providerId="ADAL" clId="{08EB3AD7-677B-AA4A-90AD-5577AE246557}" dt="2021-06-22T18:53:46.381" v="1126" actId="167"/>
          <ac:spMkLst>
            <pc:docMk/>
            <pc:sldMk cId="304432944" sldId="261"/>
            <ac:spMk id="10" creationId="{DC3E85FA-F9BB-1247-8A41-06F6C4619766}"/>
          </ac:spMkLst>
        </pc:spChg>
        <pc:spChg chg="add mod">
          <ac:chgData name="Narang, Sonali" userId="9e80b397-6e2f-49b1-9374-ccdad8589140" providerId="ADAL" clId="{08EB3AD7-677B-AA4A-90AD-5577AE246557}" dt="2021-06-22T18:53:46.381" v="1126" actId="167"/>
          <ac:spMkLst>
            <pc:docMk/>
            <pc:sldMk cId="304432944" sldId="261"/>
            <ac:spMk id="11" creationId="{BA8E0E7C-4866-3341-9790-F6A504F8B1DA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15" creationId="{2539947D-3C59-1643-9AF9-65BA773F6762}"/>
          </ac:spMkLst>
        </pc:spChg>
        <pc:spChg chg="mod">
          <ac:chgData name="Narang, Sonali" userId="9e80b397-6e2f-49b1-9374-ccdad8589140" providerId="ADAL" clId="{08EB3AD7-677B-AA4A-90AD-5577AE246557}" dt="2021-08-16T18:24:23.791" v="9700" actId="20577"/>
          <ac:spMkLst>
            <pc:docMk/>
            <pc:sldMk cId="304432944" sldId="261"/>
            <ac:spMk id="19" creationId="{9C3527B8-AD10-5F47-B874-3C5CA59A0BD8}"/>
          </ac:spMkLst>
        </pc:spChg>
        <pc:spChg chg="mod">
          <ac:chgData name="Narang, Sonali" userId="9e80b397-6e2f-49b1-9374-ccdad8589140" providerId="ADAL" clId="{08EB3AD7-677B-AA4A-90AD-5577AE246557}" dt="2021-08-16T18:24:28.528" v="9705" actId="20577"/>
          <ac:spMkLst>
            <pc:docMk/>
            <pc:sldMk cId="304432944" sldId="261"/>
            <ac:spMk id="20" creationId="{A579CCAF-0E25-9149-9A3B-E72B667C87C2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22" creationId="{A37C095F-BFDB-5045-85E2-5F52720B5876}"/>
          </ac:spMkLst>
        </pc:spChg>
        <pc:spChg chg="del mod">
          <ac:chgData name="Narang, Sonali" userId="9e80b397-6e2f-49b1-9374-ccdad8589140" providerId="ADAL" clId="{08EB3AD7-677B-AA4A-90AD-5577AE246557}" dt="2021-06-23T14:59:23.803" v="1356" actId="21"/>
          <ac:spMkLst>
            <pc:docMk/>
            <pc:sldMk cId="304432944" sldId="261"/>
            <ac:spMk id="23" creationId="{F57846DD-5300-E645-8B07-3500BCB61EE3}"/>
          </ac:spMkLst>
        </pc:spChg>
        <pc:spChg chg="mod">
          <ac:chgData name="Narang, Sonali" userId="9e80b397-6e2f-49b1-9374-ccdad8589140" providerId="ADAL" clId="{08EB3AD7-677B-AA4A-90AD-5577AE246557}" dt="2021-06-24T16:25:47.057" v="1862" actId="1076"/>
          <ac:spMkLst>
            <pc:docMk/>
            <pc:sldMk cId="304432944" sldId="261"/>
            <ac:spMk id="24" creationId="{E2CDCB57-DC12-4E44-97F4-CC262715A954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25" creationId="{F789DAC4-C723-4147-B1D9-819786DB3087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29" creationId="{47A8D577-04EC-F448-9156-9475FC3695A3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0" creationId="{0982CCF2-0701-8C45-AFB3-61858D893AAB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4" creationId="{EB2F7C07-51C8-9A49-9370-CFB9B8295D46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5" creationId="{05AA4F0F-8389-FD47-945E-4961340788BF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6" creationId="{332E7840-D045-9F47-BB95-221903FBA3D0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7" creationId="{F6CA434E-C4C9-1541-89EE-76B5718A74BC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8" creationId="{7AC95396-EEDB-C441-A46C-6861227F4AB8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39" creationId="{86908706-9EE9-454B-B637-0B3C3DA66DB4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0" creationId="{FAD19561-E6EA-E843-AA31-9681B6B0F78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1" creationId="{726A363A-36B2-954B-8048-DE686EADDC33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2" creationId="{FF0E7C4B-236C-074C-BC33-26981DDE1A11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3" creationId="{7B4E7C26-23E8-384D-8A8D-4BA462D9D5E7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4" creationId="{B89A617D-B572-E74F-8274-930D6F8BBCB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5" creationId="{5C5D8E25-4367-914F-9395-D4085940D2BF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6" creationId="{42CFB575-4F6F-AE46-BC94-7985EE42A517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7" creationId="{835BD6BD-E621-F24C-90E8-47642B7B2312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8" creationId="{8F04C6D4-C448-134E-A908-94FE183506E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49" creationId="{9A429D1A-8C07-6C4F-A3A3-07ADF5D74E96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0" creationId="{3AC59E26-2802-DE40-B13A-E2C99D563F56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1" creationId="{5AFCF914-D2D2-D14D-B29B-B4E88AB34773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2" creationId="{E0677B2C-D7AD-CF4D-B0BC-454E8447EE5B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3" creationId="{4FC79A3E-0543-C546-85FA-C4A6052A1C97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4" creationId="{500D6F93-B479-8246-B0F4-ACDEB980C791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5" creationId="{B8E183F8-97A1-1E44-81D7-7E47B5312783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59" creationId="{34CAB1AE-D8E6-5E44-9E67-0394EB7B5030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0" creationId="{ABE2C50F-974C-C140-949E-88D2936E422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1" creationId="{E470FBE3-ABE9-664A-AC34-EB4BC9D175D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2" creationId="{6A04C46B-4AC8-3B49-94E3-F38B6ADC4D0C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3" creationId="{819F5060-5F65-9044-9BBC-1E09F8BE95F1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4" creationId="{532FFAB3-22BF-9B46-96F3-1AFAF96BA1CD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5" creationId="{3B112381-35E1-854E-BB15-534296A90AEF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6" creationId="{F9F29120-7693-6D41-8473-7E86FC87F32D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7" creationId="{FAD94841-507F-BC4E-9790-60406DE9D060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8" creationId="{B79A5F6D-0350-5840-B4A1-373CED3E84F9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69" creationId="{7B270A5E-8C03-B34B-A0F7-5BEEBB5B0E8C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0" creationId="{FC41846C-E0DB-224F-9D42-F1428D725EFC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1" creationId="{1933FC97-560D-B146-80E1-A6BC6F2B1433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2" creationId="{75BFE5BF-A228-3945-9914-C3F7F87BDD7C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3" creationId="{31D69A35-B4E4-BA45-94FA-0B377FF9D451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4" creationId="{50F33AD8-183D-734D-8B5A-DC7C5962F9CB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5" creationId="{53F0DB92-B311-1348-BF51-2CF8664400A2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6" creationId="{476E6013-9A66-0243-856B-1A2F5F6203B7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7" creationId="{C59A0FB5-5096-6549-BC6F-32F9D2DEB68E}"/>
          </ac:spMkLst>
        </pc:spChg>
        <pc:spChg chg="mod">
          <ac:chgData name="Narang, Sonali" userId="9e80b397-6e2f-49b1-9374-ccdad8589140" providerId="ADAL" clId="{08EB3AD7-677B-AA4A-90AD-5577AE246557}" dt="2021-06-22T18:54:22.151" v="1133"/>
          <ac:spMkLst>
            <pc:docMk/>
            <pc:sldMk cId="304432944" sldId="261"/>
            <ac:spMk id="78" creationId="{77C8933F-8737-694B-B13B-BCDB214D9021}"/>
          </ac:spMkLst>
        </pc:spChg>
        <pc:spChg chg="add del mod">
          <ac:chgData name="Narang, Sonali" userId="9e80b397-6e2f-49b1-9374-ccdad8589140" providerId="ADAL" clId="{08EB3AD7-677B-AA4A-90AD-5577AE246557}" dt="2021-06-22T20:38:32.408" v="1277"/>
          <ac:spMkLst>
            <pc:docMk/>
            <pc:sldMk cId="304432944" sldId="261"/>
            <ac:spMk id="79" creationId="{4CBB71E5-D218-9144-9DC7-517657092418}"/>
          </ac:spMkLst>
        </pc:spChg>
        <pc:spChg chg="mod">
          <ac:chgData name="Narang, Sonali" userId="9e80b397-6e2f-49b1-9374-ccdad8589140" providerId="ADAL" clId="{08EB3AD7-677B-AA4A-90AD-5577AE246557}" dt="2021-06-24T19:14:56.856" v="1876" actId="207"/>
          <ac:spMkLst>
            <pc:docMk/>
            <pc:sldMk cId="304432944" sldId="261"/>
            <ac:spMk id="82" creationId="{E66D4D0E-8277-2242-BD48-20F1E3E5CF61}"/>
          </ac:spMkLst>
        </pc:spChg>
        <pc:spChg chg="mod">
          <ac:chgData name="Narang, Sonali" userId="9e80b397-6e2f-49b1-9374-ccdad8589140" providerId="ADAL" clId="{08EB3AD7-677B-AA4A-90AD-5577AE246557}" dt="2021-06-24T19:15:02.047" v="1877" actId="207"/>
          <ac:spMkLst>
            <pc:docMk/>
            <pc:sldMk cId="304432944" sldId="261"/>
            <ac:spMk id="83" creationId="{B11AE3FB-32F1-FC49-8B26-022E18B0808F}"/>
          </ac:spMkLst>
        </pc:spChg>
        <pc:spChg chg="mod">
          <ac:chgData name="Narang, Sonali" userId="9e80b397-6e2f-49b1-9374-ccdad8589140" providerId="ADAL" clId="{08EB3AD7-677B-AA4A-90AD-5577AE246557}" dt="2021-06-22T20:57:29.138" v="1289"/>
          <ac:spMkLst>
            <pc:docMk/>
            <pc:sldMk cId="304432944" sldId="261"/>
            <ac:spMk id="86" creationId="{93956C7C-D4C6-C947-8C9C-9F499B98D065}"/>
          </ac:spMkLst>
        </pc:spChg>
        <pc:spChg chg="mod">
          <ac:chgData name="Narang, Sonali" userId="9e80b397-6e2f-49b1-9374-ccdad8589140" providerId="ADAL" clId="{08EB3AD7-677B-AA4A-90AD-5577AE246557}" dt="2021-06-22T20:57:29.138" v="1289"/>
          <ac:spMkLst>
            <pc:docMk/>
            <pc:sldMk cId="304432944" sldId="261"/>
            <ac:spMk id="87" creationId="{C30ADF83-A6D4-8440-95DF-FAA9D9E729F2}"/>
          </ac:spMkLst>
        </pc:spChg>
        <pc:spChg chg="mod">
          <ac:chgData name="Narang, Sonali" userId="9e80b397-6e2f-49b1-9374-ccdad8589140" providerId="ADAL" clId="{08EB3AD7-677B-AA4A-90AD-5577AE246557}" dt="2021-06-30T20:07:00.480" v="3308"/>
          <ac:spMkLst>
            <pc:docMk/>
            <pc:sldMk cId="304432944" sldId="261"/>
            <ac:spMk id="90" creationId="{F921C694-468A-FC4F-AF5B-46741D7B1A09}"/>
          </ac:spMkLst>
        </pc:spChg>
        <pc:spChg chg="add mod">
          <ac:chgData name="Narang, Sonali" userId="9e80b397-6e2f-49b1-9374-ccdad8589140" providerId="ADAL" clId="{08EB3AD7-677B-AA4A-90AD-5577AE246557}" dt="2021-06-24T16:25:35.592" v="1861" actId="1076"/>
          <ac:spMkLst>
            <pc:docMk/>
            <pc:sldMk cId="304432944" sldId="261"/>
            <ac:spMk id="91" creationId="{C0EB8FE3-59EE-6C4C-A6D1-AF2E6FB2C92B}"/>
          </ac:spMkLst>
        </pc:spChg>
        <pc:spChg chg="mod">
          <ac:chgData name="Narang, Sonali" userId="9e80b397-6e2f-49b1-9374-ccdad8589140" providerId="ADAL" clId="{08EB3AD7-677B-AA4A-90AD-5577AE246557}" dt="2021-06-30T20:07:00.480" v="3308"/>
          <ac:spMkLst>
            <pc:docMk/>
            <pc:sldMk cId="304432944" sldId="261"/>
            <ac:spMk id="93" creationId="{AF8DE709-4EC5-EE40-9435-2739E0BD9589}"/>
          </ac:spMkLst>
        </pc:spChg>
        <pc:spChg chg="mod">
          <ac:chgData name="Narang, Sonali" userId="9e80b397-6e2f-49b1-9374-ccdad8589140" providerId="ADAL" clId="{08EB3AD7-677B-AA4A-90AD-5577AE246557}" dt="2021-06-30T20:08:14.741" v="3322"/>
          <ac:spMkLst>
            <pc:docMk/>
            <pc:sldMk cId="304432944" sldId="261"/>
            <ac:spMk id="97" creationId="{75A16AAE-6787-2642-A67F-3ED9396180F7}"/>
          </ac:spMkLst>
        </pc:spChg>
        <pc:spChg chg="mod">
          <ac:chgData name="Narang, Sonali" userId="9e80b397-6e2f-49b1-9374-ccdad8589140" providerId="ADAL" clId="{08EB3AD7-677B-AA4A-90AD-5577AE246557}" dt="2021-06-30T20:08:14.741" v="3322"/>
          <ac:spMkLst>
            <pc:docMk/>
            <pc:sldMk cId="304432944" sldId="261"/>
            <ac:spMk id="98" creationId="{8F858A97-7F3C-E448-972E-CC029FC7DBA3}"/>
          </ac:spMkLst>
        </pc:spChg>
        <pc:spChg chg="mod">
          <ac:chgData name="Narang, Sonali" userId="9e80b397-6e2f-49b1-9374-ccdad8589140" providerId="ADAL" clId="{08EB3AD7-677B-AA4A-90AD-5577AE246557}" dt="2021-08-11T16:56:27.481" v="9174" actId="403"/>
          <ac:spMkLst>
            <pc:docMk/>
            <pc:sldMk cId="304432944" sldId="261"/>
            <ac:spMk id="100" creationId="{3B5D127A-428F-4042-BCC2-9E8F059C51B3}"/>
          </ac:spMkLst>
        </pc:spChg>
        <pc:spChg chg="mod">
          <ac:chgData name="Narang, Sonali" userId="9e80b397-6e2f-49b1-9374-ccdad8589140" providerId="ADAL" clId="{08EB3AD7-677B-AA4A-90AD-5577AE246557}" dt="2021-08-11T17:19:00.301" v="9177" actId="1076"/>
          <ac:spMkLst>
            <pc:docMk/>
            <pc:sldMk cId="304432944" sldId="261"/>
            <ac:spMk id="101" creationId="{47F0FE4C-B016-C341-8786-52AD684AE3ED}"/>
          </ac:spMkLst>
        </pc:spChg>
        <pc:spChg chg="mod">
          <ac:chgData name="Narang, Sonali" userId="9e80b397-6e2f-49b1-9374-ccdad8589140" providerId="ADAL" clId="{08EB3AD7-677B-AA4A-90AD-5577AE246557}" dt="2021-08-11T16:56:27.481" v="9174" actId="403"/>
          <ac:spMkLst>
            <pc:docMk/>
            <pc:sldMk cId="304432944" sldId="261"/>
            <ac:spMk id="104" creationId="{7726C90C-1F04-A640-AA6C-83C454C92995}"/>
          </ac:spMkLst>
        </pc:spChg>
        <pc:spChg chg="mod">
          <ac:chgData name="Narang, Sonali" userId="9e80b397-6e2f-49b1-9374-ccdad8589140" providerId="ADAL" clId="{08EB3AD7-677B-AA4A-90AD-5577AE246557}" dt="2021-08-11T16:56:27.481" v="9174" actId="403"/>
          <ac:spMkLst>
            <pc:docMk/>
            <pc:sldMk cId="304432944" sldId="261"/>
            <ac:spMk id="105" creationId="{51BB1815-6319-DB40-818F-060A9AF1EE16}"/>
          </ac:spMkLst>
        </pc:spChg>
        <pc:spChg chg="mod">
          <ac:chgData name="Narang, Sonali" userId="9e80b397-6e2f-49b1-9374-ccdad8589140" providerId="ADAL" clId="{08EB3AD7-677B-AA4A-90AD-5577AE246557}" dt="2021-08-11T16:56:51.543" v="9176" actId="1076"/>
          <ac:spMkLst>
            <pc:docMk/>
            <pc:sldMk cId="304432944" sldId="261"/>
            <ac:spMk id="106" creationId="{B34ED9DE-28E0-D044-829E-976F2794AE84}"/>
          </ac:spMkLst>
        </pc:spChg>
        <pc:spChg chg="mod">
          <ac:chgData name="Narang, Sonali" userId="9e80b397-6e2f-49b1-9374-ccdad8589140" providerId="ADAL" clId="{08EB3AD7-677B-AA4A-90AD-5577AE246557}" dt="2021-08-11T16:56:27.481" v="9174" actId="403"/>
          <ac:spMkLst>
            <pc:docMk/>
            <pc:sldMk cId="304432944" sldId="261"/>
            <ac:spMk id="107" creationId="{455F0347-D905-9445-AA06-67A51B2A45A4}"/>
          </ac:spMkLst>
        </pc:spChg>
        <pc:spChg chg="mod">
          <ac:chgData name="Narang, Sonali" userId="9e80b397-6e2f-49b1-9374-ccdad8589140" providerId="ADAL" clId="{08EB3AD7-677B-AA4A-90AD-5577AE246557}" dt="2021-08-11T16:56:27.481" v="9174" actId="403"/>
          <ac:spMkLst>
            <pc:docMk/>
            <pc:sldMk cId="304432944" sldId="261"/>
            <ac:spMk id="108" creationId="{AC76007E-224F-624D-B856-2DB90AB1AA31}"/>
          </ac:spMkLst>
        </pc:spChg>
        <pc:spChg chg="mod">
          <ac:chgData name="Narang, Sonali" userId="9e80b397-6e2f-49b1-9374-ccdad8589140" providerId="ADAL" clId="{08EB3AD7-677B-AA4A-90AD-5577AE246557}" dt="2021-08-11T16:56:43.531" v="9175" actId="1076"/>
          <ac:spMkLst>
            <pc:docMk/>
            <pc:sldMk cId="304432944" sldId="261"/>
            <ac:spMk id="109" creationId="{4A0E863B-4BD3-BE42-8D6C-66340353A5EE}"/>
          </ac:spMkLst>
        </pc:spChg>
        <pc:spChg chg="mod">
          <ac:chgData name="Narang, Sonali" userId="9e80b397-6e2f-49b1-9374-ccdad8589140" providerId="ADAL" clId="{08EB3AD7-677B-AA4A-90AD-5577AE246557}" dt="2021-07-09T16:26:45.151" v="4069" actId="1038"/>
          <ac:spMkLst>
            <pc:docMk/>
            <pc:sldMk cId="304432944" sldId="261"/>
            <ac:spMk id="111" creationId="{AD04270C-7202-4E40-B9FE-494522BBB0DC}"/>
          </ac:spMkLst>
        </pc:spChg>
        <pc:spChg chg="mod">
          <ac:chgData name="Narang, Sonali" userId="9e80b397-6e2f-49b1-9374-ccdad8589140" providerId="ADAL" clId="{08EB3AD7-677B-AA4A-90AD-5577AE246557}" dt="2021-07-09T16:22:27.422" v="3996" actId="20577"/>
          <ac:spMkLst>
            <pc:docMk/>
            <pc:sldMk cId="304432944" sldId="261"/>
            <ac:spMk id="112" creationId="{24B22166-6C38-3D43-BB8A-513C99BA3323}"/>
          </ac:spMkLst>
        </pc:spChg>
        <pc:spChg chg="mod">
          <ac:chgData name="Narang, Sonali" userId="9e80b397-6e2f-49b1-9374-ccdad8589140" providerId="ADAL" clId="{08EB3AD7-677B-AA4A-90AD-5577AE246557}" dt="2021-07-09T16:22:11.566" v="3989" actId="20577"/>
          <ac:spMkLst>
            <pc:docMk/>
            <pc:sldMk cId="304432944" sldId="261"/>
            <ac:spMk id="113" creationId="{63986CBD-3F17-AB49-BC7D-43D48D035FF0}"/>
          </ac:spMkLst>
        </pc:spChg>
        <pc:spChg chg="mod">
          <ac:chgData name="Narang, Sonali" userId="9e80b397-6e2f-49b1-9374-ccdad8589140" providerId="ADAL" clId="{08EB3AD7-677B-AA4A-90AD-5577AE246557}" dt="2021-07-09T16:26:45.151" v="4069" actId="1038"/>
          <ac:spMkLst>
            <pc:docMk/>
            <pc:sldMk cId="304432944" sldId="261"/>
            <ac:spMk id="114" creationId="{D04CF2B8-E549-AF4E-903C-EF23CA9E1408}"/>
          </ac:spMkLst>
        </pc:spChg>
        <pc:spChg chg="mod">
          <ac:chgData name="Narang, Sonali" userId="9e80b397-6e2f-49b1-9374-ccdad8589140" providerId="ADAL" clId="{08EB3AD7-677B-AA4A-90AD-5577AE246557}" dt="2021-07-09T16:27:15.216" v="4078" actId="1038"/>
          <ac:spMkLst>
            <pc:docMk/>
            <pc:sldMk cId="304432944" sldId="261"/>
            <ac:spMk id="115" creationId="{81848D19-B612-C640-BAE6-9C81149AD2EF}"/>
          </ac:spMkLst>
        </pc:spChg>
        <pc:spChg chg="mod">
          <ac:chgData name="Narang, Sonali" userId="9e80b397-6e2f-49b1-9374-ccdad8589140" providerId="ADAL" clId="{08EB3AD7-677B-AA4A-90AD-5577AE246557}" dt="2021-07-09T16:21:43.695" v="3977" actId="20577"/>
          <ac:spMkLst>
            <pc:docMk/>
            <pc:sldMk cId="304432944" sldId="261"/>
            <ac:spMk id="116" creationId="{9DB988ED-131B-D046-BA03-2125580A0847}"/>
          </ac:spMkLst>
        </pc:spChg>
        <pc:spChg chg="add del mod">
          <ac:chgData name="Narang, Sonali" userId="9e80b397-6e2f-49b1-9374-ccdad8589140" providerId="ADAL" clId="{08EB3AD7-677B-AA4A-90AD-5577AE246557}" dt="2021-06-24T16:18:38.101" v="1847" actId="478"/>
          <ac:spMkLst>
            <pc:docMk/>
            <pc:sldMk cId="304432944" sldId="261"/>
            <ac:spMk id="117" creationId="{1ABD8087-0FA4-504A-80D6-E3E6AADF9770}"/>
          </ac:spMkLst>
        </pc:spChg>
        <pc:spChg chg="mod">
          <ac:chgData name="Narang, Sonali" userId="9e80b397-6e2f-49b1-9374-ccdad8589140" providerId="ADAL" clId="{08EB3AD7-677B-AA4A-90AD-5577AE246557}" dt="2021-07-09T16:26:45.151" v="4069" actId="1038"/>
          <ac:spMkLst>
            <pc:docMk/>
            <pc:sldMk cId="304432944" sldId="261"/>
            <ac:spMk id="117" creationId="{F9B5D567-0CB7-A841-888D-C0B695F19E17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18" creationId="{1715E921-C6DE-434D-9C64-6C25BAC4FF34}"/>
          </ac:spMkLst>
        </pc:spChg>
        <pc:spChg chg="add del mod">
          <ac:chgData name="Narang, Sonali" userId="9e80b397-6e2f-49b1-9374-ccdad8589140" providerId="ADAL" clId="{08EB3AD7-677B-AA4A-90AD-5577AE246557}" dt="2021-06-28T17:54:03.757" v="2128" actId="478"/>
          <ac:spMkLst>
            <pc:docMk/>
            <pc:sldMk cId="304432944" sldId="261"/>
            <ac:spMk id="118" creationId="{D37A5D9F-13CD-9448-87CF-0963D3E63E5D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19" creationId="{215A97AD-D080-5E42-93E6-4752AB79CC84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20" creationId="{178368C9-9F60-1E4D-93BE-721F4443E806}"/>
          </ac:spMkLst>
        </pc:spChg>
        <pc:spChg chg="mod">
          <ac:chgData name="Narang, Sonali" userId="9e80b397-6e2f-49b1-9374-ccdad8589140" providerId="ADAL" clId="{08EB3AD7-677B-AA4A-90AD-5577AE246557}" dt="2021-07-09T16:27:05.137" v="4076" actId="1037"/>
          <ac:spMkLst>
            <pc:docMk/>
            <pc:sldMk cId="304432944" sldId="261"/>
            <ac:spMk id="123" creationId="{B3823858-7B66-DB40-807B-68A48D9401F2}"/>
          </ac:spMkLst>
        </pc:spChg>
        <pc:spChg chg="add mod">
          <ac:chgData name="Narang, Sonali" userId="9e80b397-6e2f-49b1-9374-ccdad8589140" providerId="ADAL" clId="{08EB3AD7-677B-AA4A-90AD-5577AE246557}" dt="2021-08-16T21:35:27.721" v="10157" actId="1037"/>
          <ac:spMkLst>
            <pc:docMk/>
            <pc:sldMk cId="304432944" sldId="261"/>
            <ac:spMk id="124" creationId="{2BE84DAC-7C05-C445-9DD3-6B3EE69AFBF9}"/>
          </ac:spMkLst>
        </pc:spChg>
        <pc:spChg chg="add mod">
          <ac:chgData name="Narang, Sonali" userId="9e80b397-6e2f-49b1-9374-ccdad8589140" providerId="ADAL" clId="{08EB3AD7-677B-AA4A-90AD-5577AE246557}" dt="2021-08-16T21:35:15.176" v="10112" actId="20577"/>
          <ac:spMkLst>
            <pc:docMk/>
            <pc:sldMk cId="304432944" sldId="261"/>
            <ac:spMk id="125" creationId="{F77578BF-D28B-AC46-B202-F16CA20F451A}"/>
          </ac:spMkLst>
        </pc:spChg>
        <pc:spChg chg="mod">
          <ac:chgData name="Narang, Sonali" userId="9e80b397-6e2f-49b1-9374-ccdad8589140" providerId="ADAL" clId="{08EB3AD7-677B-AA4A-90AD-5577AE246557}" dt="2021-07-09T16:26:22.423" v="4065" actId="20577"/>
          <ac:spMkLst>
            <pc:docMk/>
            <pc:sldMk cId="304432944" sldId="261"/>
            <ac:spMk id="126" creationId="{0351ACDA-127B-1B42-A858-42E97EA78BCF}"/>
          </ac:spMkLst>
        </pc:spChg>
        <pc:spChg chg="mod">
          <ac:chgData name="Narang, Sonali" userId="9e80b397-6e2f-49b1-9374-ccdad8589140" providerId="ADAL" clId="{08EB3AD7-677B-AA4A-90AD-5577AE246557}" dt="2021-07-09T16:27:21.693" v="4081" actId="1038"/>
          <ac:spMkLst>
            <pc:docMk/>
            <pc:sldMk cId="304432944" sldId="261"/>
            <ac:spMk id="127" creationId="{27C06EB3-4571-5B4C-A4BD-E011A38FFF39}"/>
          </ac:spMkLst>
        </pc:spChg>
        <pc:spChg chg="mod">
          <ac:chgData name="Narang, Sonali" userId="9e80b397-6e2f-49b1-9374-ccdad8589140" providerId="ADAL" clId="{08EB3AD7-677B-AA4A-90AD-5577AE246557}" dt="2021-07-09T16:27:05.137" v="4076" actId="1037"/>
          <ac:spMkLst>
            <pc:docMk/>
            <pc:sldMk cId="304432944" sldId="261"/>
            <ac:spMk id="128" creationId="{E7AF0AE9-DFFE-5B45-A2CF-00954B090534}"/>
          </ac:spMkLst>
        </pc:spChg>
        <pc:spChg chg="mod">
          <ac:chgData name="Narang, Sonali" userId="9e80b397-6e2f-49b1-9374-ccdad8589140" providerId="ADAL" clId="{08EB3AD7-677B-AA4A-90AD-5577AE246557}" dt="2021-07-09T16:27:15.216" v="4078" actId="1038"/>
          <ac:spMkLst>
            <pc:docMk/>
            <pc:sldMk cId="304432944" sldId="261"/>
            <ac:spMk id="129" creationId="{19C1E20C-BA67-054F-81F2-DAEF8FBF7991}"/>
          </ac:spMkLst>
        </pc:spChg>
        <pc:spChg chg="mod">
          <ac:chgData name="Narang, Sonali" userId="9e80b397-6e2f-49b1-9374-ccdad8589140" providerId="ADAL" clId="{08EB3AD7-677B-AA4A-90AD-5577AE246557}" dt="2021-07-09T16:25:38.630" v="4048" actId="20577"/>
          <ac:spMkLst>
            <pc:docMk/>
            <pc:sldMk cId="304432944" sldId="261"/>
            <ac:spMk id="130" creationId="{B9ADA41D-B3EE-3041-8297-C0ED42A6B6C4}"/>
          </ac:spMkLst>
        </pc:spChg>
        <pc:spChg chg="mod">
          <ac:chgData name="Narang, Sonali" userId="9e80b397-6e2f-49b1-9374-ccdad8589140" providerId="ADAL" clId="{08EB3AD7-677B-AA4A-90AD-5577AE246557}" dt="2021-07-09T16:27:05.137" v="4076" actId="1037"/>
          <ac:spMkLst>
            <pc:docMk/>
            <pc:sldMk cId="304432944" sldId="261"/>
            <ac:spMk id="131" creationId="{CA07DA15-0E26-F047-A47D-795CAAE6BECE}"/>
          </ac:spMkLst>
        </pc:spChg>
        <pc:spChg chg="add del mod">
          <ac:chgData name="Narang, Sonali" userId="9e80b397-6e2f-49b1-9374-ccdad8589140" providerId="ADAL" clId="{08EB3AD7-677B-AA4A-90AD-5577AE246557}" dt="2021-06-28T19:07:16.233" v="2261"/>
          <ac:spMkLst>
            <pc:docMk/>
            <pc:sldMk cId="304432944" sldId="261"/>
            <ac:spMk id="132" creationId="{11DA2B68-FA2F-2040-A5B0-B14B67E5A890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32" creationId="{B51EAF12-ABF1-5D4E-B034-C69D63226622}"/>
          </ac:spMkLst>
        </pc:spChg>
        <pc:spChg chg="add del mod">
          <ac:chgData name="Narang, Sonali" userId="9e80b397-6e2f-49b1-9374-ccdad8589140" providerId="ADAL" clId="{08EB3AD7-677B-AA4A-90AD-5577AE246557}" dt="2021-06-30T18:13:23.738" v="3086" actId="478"/>
          <ac:spMkLst>
            <pc:docMk/>
            <pc:sldMk cId="304432944" sldId="261"/>
            <ac:spMk id="133" creationId="{7F71DD6E-D22A-D242-A20C-FD4213144084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33" creationId="{D88936E1-8652-714B-8218-9BCD4E0621EC}"/>
          </ac:spMkLst>
        </pc:spChg>
        <pc:spChg chg="add del mod">
          <ac:chgData name="Narang, Sonali" userId="9e80b397-6e2f-49b1-9374-ccdad8589140" providerId="ADAL" clId="{08EB3AD7-677B-AA4A-90AD-5577AE246557}" dt="2021-06-30T20:06:46.510" v="3305" actId="478"/>
          <ac:spMkLst>
            <pc:docMk/>
            <pc:sldMk cId="304432944" sldId="261"/>
            <ac:spMk id="134" creationId="{8B8F2094-C633-C148-9C44-E2191D02F77E}"/>
          </ac:spMkLst>
        </pc:spChg>
        <pc:spChg chg="mod">
          <ac:chgData name="Narang, Sonali" userId="9e80b397-6e2f-49b1-9374-ccdad8589140" providerId="ADAL" clId="{08EB3AD7-677B-AA4A-90AD-5577AE246557}" dt="2021-07-09T14:44:08.088" v="3392"/>
          <ac:spMkLst>
            <pc:docMk/>
            <pc:sldMk cId="304432944" sldId="261"/>
            <ac:spMk id="134" creationId="{DD7F12C0-67FA-6F48-BBE7-C0C2C20042A0}"/>
          </ac:spMkLst>
        </pc:spChg>
        <pc:spChg chg="add mod">
          <ac:chgData name="Narang, Sonali" userId="9e80b397-6e2f-49b1-9374-ccdad8589140" providerId="ADAL" clId="{08EB3AD7-677B-AA4A-90AD-5577AE246557}" dt="2021-07-09T16:36:01.100" v="4218" actId="1035"/>
          <ac:spMkLst>
            <pc:docMk/>
            <pc:sldMk cId="304432944" sldId="261"/>
            <ac:spMk id="136" creationId="{BA883394-F0A8-E845-B831-F239A987755D}"/>
          </ac:spMkLst>
        </pc:spChg>
        <pc:spChg chg="add mod">
          <ac:chgData name="Narang, Sonali" userId="9e80b397-6e2f-49b1-9374-ccdad8589140" providerId="ADAL" clId="{08EB3AD7-677B-AA4A-90AD-5577AE246557}" dt="2021-06-30T17:47:37.332" v="2975" actId="2085"/>
          <ac:spMkLst>
            <pc:docMk/>
            <pc:sldMk cId="304432944" sldId="261"/>
            <ac:spMk id="137" creationId="{05CB187A-0463-C344-86A8-5B816F0D0139}"/>
          </ac:spMkLst>
        </pc:spChg>
        <pc:spChg chg="add mod">
          <ac:chgData name="Narang, Sonali" userId="9e80b397-6e2f-49b1-9374-ccdad8589140" providerId="ADAL" clId="{08EB3AD7-677B-AA4A-90AD-5577AE246557}" dt="2021-07-09T16:36:07.711" v="4221" actId="1037"/>
          <ac:spMkLst>
            <pc:docMk/>
            <pc:sldMk cId="304432944" sldId="261"/>
            <ac:spMk id="137" creationId="{AD281FCB-E4AC-B948-9060-294C12B48D82}"/>
          </ac:spMkLst>
        </pc:spChg>
        <pc:spChg chg="add mod">
          <ac:chgData name="Narang, Sonali" userId="9e80b397-6e2f-49b1-9374-ccdad8589140" providerId="ADAL" clId="{08EB3AD7-677B-AA4A-90AD-5577AE246557}" dt="2021-07-09T16:35:57.508" v="4216" actId="1035"/>
          <ac:spMkLst>
            <pc:docMk/>
            <pc:sldMk cId="304432944" sldId="261"/>
            <ac:spMk id="138" creationId="{3FF9DF43-BC9E-FB43-96AF-B230E03C3A1C}"/>
          </ac:spMkLst>
        </pc:spChg>
        <pc:spChg chg="add mod">
          <ac:chgData name="Narang, Sonali" userId="9e80b397-6e2f-49b1-9374-ccdad8589140" providerId="ADAL" clId="{08EB3AD7-677B-AA4A-90AD-5577AE246557}" dt="2021-07-09T16:35:57.508" v="4216" actId="1035"/>
          <ac:spMkLst>
            <pc:docMk/>
            <pc:sldMk cId="304432944" sldId="261"/>
            <ac:spMk id="139" creationId="{A33BD1F8-AA85-D747-9935-CE633047EC0B}"/>
          </ac:spMkLst>
        </pc:spChg>
        <pc:spChg chg="add mod">
          <ac:chgData name="Narang, Sonali" userId="9e80b397-6e2f-49b1-9374-ccdad8589140" providerId="ADAL" clId="{08EB3AD7-677B-AA4A-90AD-5577AE246557}" dt="2021-07-09T19:56:25.843" v="4937" actId="1036"/>
          <ac:spMkLst>
            <pc:docMk/>
            <pc:sldMk cId="304432944" sldId="261"/>
            <ac:spMk id="140" creationId="{49E0728B-A1EC-C644-A30B-FE916A6C0713}"/>
          </ac:spMkLst>
        </pc:spChg>
        <pc:spChg chg="add mod">
          <ac:chgData name="Narang, Sonali" userId="9e80b397-6e2f-49b1-9374-ccdad8589140" providerId="ADAL" clId="{08EB3AD7-677B-AA4A-90AD-5577AE246557}" dt="2021-07-09T19:56:25.843" v="4937" actId="1036"/>
          <ac:spMkLst>
            <pc:docMk/>
            <pc:sldMk cId="304432944" sldId="261"/>
            <ac:spMk id="141" creationId="{756A42E8-CEA9-C84D-9136-ACF2C7A77DE1}"/>
          </ac:spMkLst>
        </pc:spChg>
        <pc:spChg chg="add del mod">
          <ac:chgData name="Narang, Sonali" userId="9e80b397-6e2f-49b1-9374-ccdad8589140" providerId="ADAL" clId="{08EB3AD7-677B-AA4A-90AD-5577AE246557}" dt="2021-07-12T19:01:47.945" v="7148" actId="478"/>
          <ac:spMkLst>
            <pc:docMk/>
            <pc:sldMk cId="304432944" sldId="261"/>
            <ac:spMk id="146" creationId="{DFF8C0C0-FD7F-3545-8CC1-C4D0DF7B0267}"/>
          </ac:spMkLst>
        </pc:spChg>
        <pc:spChg chg="add del mod">
          <ac:chgData name="Narang, Sonali" userId="9e80b397-6e2f-49b1-9374-ccdad8589140" providerId="ADAL" clId="{08EB3AD7-677B-AA4A-90AD-5577AE246557}" dt="2021-08-16T19:19:14.560" v="9871" actId="478"/>
          <ac:spMkLst>
            <pc:docMk/>
            <pc:sldMk cId="304432944" sldId="261"/>
            <ac:spMk id="154" creationId="{2D811C5B-8B16-EB4C-99ED-D8C24CD670D0}"/>
          </ac:spMkLst>
        </pc:spChg>
        <pc:grpChg chg="add del mod">
          <ac:chgData name="Narang, Sonali" userId="9e80b397-6e2f-49b1-9374-ccdad8589140" providerId="ADAL" clId="{08EB3AD7-677B-AA4A-90AD-5577AE246557}" dt="2021-06-22T18:55:13.133" v="1137" actId="21"/>
          <ac:grpSpMkLst>
            <pc:docMk/>
            <pc:sldMk cId="304432944" sldId="261"/>
            <ac:grpSpMk id="2" creationId="{88553BD8-E8BF-D047-91E9-813D3B13E177}"/>
          </ac:grpSpMkLst>
        </pc:grpChg>
        <pc:grpChg chg="add mod">
          <ac:chgData name="Narang, Sonali" userId="9e80b397-6e2f-49b1-9374-ccdad8589140" providerId="ADAL" clId="{08EB3AD7-677B-AA4A-90AD-5577AE246557}" dt="2021-06-23T21:24:41.905" v="1485" actId="1076"/>
          <ac:grpSpMkLst>
            <pc:docMk/>
            <pc:sldMk cId="304432944" sldId="261"/>
            <ac:grpSpMk id="12" creationId="{779BCE3A-9D78-7C4D-85AE-9EC9F3D34640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16" creationId="{B425CB2F-6B89-D04D-A163-EBF1E2DEDC25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17" creationId="{F425166C-5437-984A-A7B3-4182A8479184}"/>
          </ac:grpSpMkLst>
        </pc:grpChg>
        <pc:grpChg chg="add del mod">
          <ac:chgData name="Narang, Sonali" userId="9e80b397-6e2f-49b1-9374-ccdad8589140" providerId="ADAL" clId="{08EB3AD7-677B-AA4A-90AD-5577AE246557}" dt="2021-07-09T16:29:03.379" v="4107" actId="478"/>
          <ac:grpSpMkLst>
            <pc:docMk/>
            <pc:sldMk cId="304432944" sldId="261"/>
            <ac:grpSpMk id="28" creationId="{807FD0AF-CC2C-7D42-9553-CBC0A150976F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31" creationId="{DBFF0662-508D-8F46-B376-97EF220DD389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32" creationId="{D05DE583-750E-5742-A541-A212301A561B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33" creationId="{8A200F0C-CDDC-7E4A-9DA2-000DAD3EE7E8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56" creationId="{2976E1AE-911B-2B4F-A577-F1298AD4E64E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57" creationId="{BB0727AD-E987-D947-B29A-4F689342C3E5}"/>
          </ac:grpSpMkLst>
        </pc:grpChg>
        <pc:grpChg chg="mod">
          <ac:chgData name="Narang, Sonali" userId="9e80b397-6e2f-49b1-9374-ccdad8589140" providerId="ADAL" clId="{08EB3AD7-677B-AA4A-90AD-5577AE246557}" dt="2021-06-22T18:54:22.151" v="1133"/>
          <ac:grpSpMkLst>
            <pc:docMk/>
            <pc:sldMk cId="304432944" sldId="261"/>
            <ac:grpSpMk id="58" creationId="{E85385D9-7AF9-A749-9586-60FA2D330FE3}"/>
          </ac:grpSpMkLst>
        </pc:grpChg>
        <pc:grpChg chg="add del mod">
          <ac:chgData name="Narang, Sonali" userId="9e80b397-6e2f-49b1-9374-ccdad8589140" providerId="ADAL" clId="{08EB3AD7-677B-AA4A-90AD-5577AE246557}" dt="2021-07-09T16:29:03.379" v="4107" actId="478"/>
          <ac:grpSpMkLst>
            <pc:docMk/>
            <pc:sldMk cId="304432944" sldId="261"/>
            <ac:grpSpMk id="79" creationId="{09F4B6F6-A8B8-CA45-9451-548E224FA6E4}"/>
          </ac:grpSpMkLst>
        </pc:grpChg>
        <pc:grpChg chg="add del mod">
          <ac:chgData name="Narang, Sonali" userId="9e80b397-6e2f-49b1-9374-ccdad8589140" providerId="ADAL" clId="{08EB3AD7-677B-AA4A-90AD-5577AE246557}" dt="2021-07-09T16:29:03.379" v="4107" actId="478"/>
          <ac:grpSpMkLst>
            <pc:docMk/>
            <pc:sldMk cId="304432944" sldId="261"/>
            <ac:grpSpMk id="80" creationId="{759B12D9-EEED-264D-8230-ED9F00FA9C90}"/>
          </ac:grpSpMkLst>
        </pc:grpChg>
        <pc:grpChg chg="add del mod">
          <ac:chgData name="Narang, Sonali" userId="9e80b397-6e2f-49b1-9374-ccdad8589140" providerId="ADAL" clId="{08EB3AD7-677B-AA4A-90AD-5577AE246557}" dt="2021-06-30T20:06:49.059" v="3306" actId="478"/>
          <ac:grpSpMkLst>
            <pc:docMk/>
            <pc:sldMk cId="304432944" sldId="261"/>
            <ac:grpSpMk id="80" creationId="{9D40E91D-9CB6-3A40-B14E-D6DCD1771E96}"/>
          </ac:grpSpMkLst>
        </pc:grpChg>
        <pc:grpChg chg="add del mod">
          <ac:chgData name="Narang, Sonali" userId="9e80b397-6e2f-49b1-9374-ccdad8589140" providerId="ADAL" clId="{08EB3AD7-677B-AA4A-90AD-5577AE246557}" dt="2021-06-22T21:08:07.970" v="1338" actId="21"/>
          <ac:grpSpMkLst>
            <pc:docMk/>
            <pc:sldMk cId="304432944" sldId="261"/>
            <ac:grpSpMk id="84" creationId="{AD393CE7-B13F-5B47-897A-81D6A8C21DEE}"/>
          </ac:grpSpMkLst>
        </pc:grpChg>
        <pc:grpChg chg="add del mod">
          <ac:chgData name="Narang, Sonali" userId="9e80b397-6e2f-49b1-9374-ccdad8589140" providerId="ADAL" clId="{08EB3AD7-677B-AA4A-90AD-5577AE246557}" dt="2021-07-09T14:52:15.298" v="3472" actId="21"/>
          <ac:grpSpMkLst>
            <pc:docMk/>
            <pc:sldMk cId="304432944" sldId="261"/>
            <ac:grpSpMk id="88" creationId="{A4E9B41A-8165-364E-884A-1587E27CF457}"/>
          </ac:grpSpMkLst>
        </pc:grpChg>
        <pc:grpChg chg="add del mod">
          <ac:chgData name="Narang, Sonali" userId="9e80b397-6e2f-49b1-9374-ccdad8589140" providerId="ADAL" clId="{08EB3AD7-677B-AA4A-90AD-5577AE246557}" dt="2021-07-09T14:45:43.679" v="3464" actId="21"/>
          <ac:grpSpMkLst>
            <pc:docMk/>
            <pc:sldMk cId="304432944" sldId="261"/>
            <ac:grpSpMk id="95" creationId="{80FFA08A-7312-C64B-8FAB-26EA18CA62C3}"/>
          </ac:grpSpMkLst>
        </pc:grpChg>
        <pc:grpChg chg="add mod">
          <ac:chgData name="Narang, Sonali" userId="9e80b397-6e2f-49b1-9374-ccdad8589140" providerId="ADAL" clId="{08EB3AD7-677B-AA4A-90AD-5577AE246557}" dt="2021-08-16T21:35:21.411" v="10124" actId="1037"/>
          <ac:grpSpMkLst>
            <pc:docMk/>
            <pc:sldMk cId="304432944" sldId="261"/>
            <ac:grpSpMk id="99" creationId="{EF961429-6A7A-714D-AAED-DF577F155CDA}"/>
          </ac:grpSpMkLst>
        </pc:grpChg>
        <pc:grpChg chg="mod">
          <ac:chgData name="Narang, Sonali" userId="9e80b397-6e2f-49b1-9374-ccdad8589140" providerId="ADAL" clId="{08EB3AD7-677B-AA4A-90AD-5577AE246557}" dt="2021-07-09T14:44:08.088" v="3392"/>
          <ac:grpSpMkLst>
            <pc:docMk/>
            <pc:sldMk cId="304432944" sldId="261"/>
            <ac:grpSpMk id="102" creationId="{38C4B5E3-0967-BC43-9413-83E53DB85FDC}"/>
          </ac:grpSpMkLst>
        </pc:grpChg>
        <pc:grpChg chg="mod">
          <ac:chgData name="Narang, Sonali" userId="9e80b397-6e2f-49b1-9374-ccdad8589140" providerId="ADAL" clId="{08EB3AD7-677B-AA4A-90AD-5577AE246557}" dt="2021-07-09T14:44:08.088" v="3392"/>
          <ac:grpSpMkLst>
            <pc:docMk/>
            <pc:sldMk cId="304432944" sldId="261"/>
            <ac:grpSpMk id="103" creationId="{33E40813-4184-9040-B458-D417EC6A7499}"/>
          </ac:grpSpMkLst>
        </pc:grpChg>
        <pc:grpChg chg="mod">
          <ac:chgData name="Narang, Sonali" userId="9e80b397-6e2f-49b1-9374-ccdad8589140" providerId="ADAL" clId="{08EB3AD7-677B-AA4A-90AD-5577AE246557}" dt="2021-07-09T14:44:08.088" v="3392"/>
          <ac:grpSpMkLst>
            <pc:docMk/>
            <pc:sldMk cId="304432944" sldId="261"/>
            <ac:grpSpMk id="110" creationId="{B82BBB12-EE0A-F147-9C67-9A4C1C068B4A}"/>
          </ac:grpSpMkLst>
        </pc:grpChg>
        <pc:grpChg chg="add mod">
          <ac:chgData name="Narang, Sonali" userId="9e80b397-6e2f-49b1-9374-ccdad8589140" providerId="ADAL" clId="{08EB3AD7-677B-AA4A-90AD-5577AE246557}" dt="2021-07-09T16:37:05.638" v="4231" actId="1076"/>
          <ac:grpSpMkLst>
            <pc:docMk/>
            <pc:sldMk cId="304432944" sldId="261"/>
            <ac:grpSpMk id="121" creationId="{D382BF2F-F6F7-0546-8A3A-3F285CDE1EF7}"/>
          </ac:grpSpMkLst>
        </pc:grpChg>
        <pc:grpChg chg="mod">
          <ac:chgData name="Narang, Sonali" userId="9e80b397-6e2f-49b1-9374-ccdad8589140" providerId="ADAL" clId="{08EB3AD7-677B-AA4A-90AD-5577AE246557}" dt="2021-07-09T14:44:08.088" v="3392"/>
          <ac:grpSpMkLst>
            <pc:docMk/>
            <pc:sldMk cId="304432944" sldId="261"/>
            <ac:grpSpMk id="122" creationId="{DC7340C0-6EC8-CE44-A03D-71357883128D}"/>
          </ac:grpSpMkLst>
        </pc:grpChg>
        <pc:grpChg chg="add del">
          <ac:chgData name="Narang, Sonali" userId="9e80b397-6e2f-49b1-9374-ccdad8589140" providerId="ADAL" clId="{08EB3AD7-677B-AA4A-90AD-5577AE246557}" dt="2021-06-30T17:48:49.773" v="2977" actId="478"/>
          <ac:grpSpMkLst>
            <pc:docMk/>
            <pc:sldMk cId="304432944" sldId="261"/>
            <ac:grpSpMk id="138" creationId="{FB7F0CEB-ED00-1E49-B726-B19D435597B9}"/>
          </ac:grpSpMkLst>
        </pc:grpChg>
        <pc:grpChg chg="add mod">
          <ac:chgData name="Narang, Sonali" userId="9e80b397-6e2f-49b1-9374-ccdad8589140" providerId="ADAL" clId="{08EB3AD7-677B-AA4A-90AD-5577AE246557}" dt="2021-07-09T19:56:27.644" v="4941" actId="1076"/>
          <ac:grpSpMkLst>
            <pc:docMk/>
            <pc:sldMk cId="304432944" sldId="261"/>
            <ac:grpSpMk id="142" creationId="{DFC3FF12-35BE-6D41-8314-C8F8C7DA6614}"/>
          </ac:grpSpMkLst>
        </pc:grpChg>
        <pc:grpChg chg="add mod">
          <ac:chgData name="Narang, Sonali" userId="9e80b397-6e2f-49b1-9374-ccdad8589140" providerId="ADAL" clId="{08EB3AD7-677B-AA4A-90AD-5577AE246557}" dt="2021-07-09T19:56:29.029" v="4944" actId="1076"/>
          <ac:grpSpMkLst>
            <pc:docMk/>
            <pc:sldMk cId="304432944" sldId="261"/>
            <ac:grpSpMk id="143" creationId="{5CD3143B-E8B4-6941-ADC1-31DDC1651046}"/>
          </ac:grpSpMkLst>
        </pc:grpChg>
        <pc:grpChg chg="add mod">
          <ac:chgData name="Narang, Sonali" userId="9e80b397-6e2f-49b1-9374-ccdad8589140" providerId="ADAL" clId="{08EB3AD7-677B-AA4A-90AD-5577AE246557}" dt="2021-07-09T16:38:38.773" v="4233" actId="14100"/>
          <ac:grpSpMkLst>
            <pc:docMk/>
            <pc:sldMk cId="304432944" sldId="261"/>
            <ac:grpSpMk id="144" creationId="{76FD492A-A603-C049-9A9D-FD0E9004D645}"/>
          </ac:grpSpMkLst>
        </pc:grpChg>
        <pc:picChg chg="add del mod">
          <ac:chgData name="Narang, Sonali" userId="9e80b397-6e2f-49b1-9374-ccdad8589140" providerId="ADAL" clId="{08EB3AD7-677B-AA4A-90AD-5577AE246557}" dt="2021-08-11T16:51:28.316" v="9083" actId="478"/>
          <ac:picMkLst>
            <pc:docMk/>
            <pc:sldMk cId="304432944" sldId="261"/>
            <ac:picMk id="3" creationId="{0D80451A-BE63-5849-B0BC-146F78F2AE42}"/>
          </ac:picMkLst>
        </pc:picChg>
        <pc:picChg chg="add del mod">
          <ac:chgData name="Narang, Sonali" userId="9e80b397-6e2f-49b1-9374-ccdad8589140" providerId="ADAL" clId="{08EB3AD7-677B-AA4A-90AD-5577AE246557}" dt="2021-06-02T21:49:33.979" v="743" actId="21"/>
          <ac:picMkLst>
            <pc:docMk/>
            <pc:sldMk cId="304432944" sldId="261"/>
            <ac:picMk id="3" creationId="{2CB82003-9564-1647-99B5-F64998589DB4}"/>
          </ac:picMkLst>
        </pc:picChg>
        <pc:picChg chg="add del mod">
          <ac:chgData name="Narang, Sonali" userId="9e80b397-6e2f-49b1-9374-ccdad8589140" providerId="ADAL" clId="{08EB3AD7-677B-AA4A-90AD-5577AE246557}" dt="2021-07-09T16:29:07.573" v="4109" actId="478"/>
          <ac:picMkLst>
            <pc:docMk/>
            <pc:sldMk cId="304432944" sldId="261"/>
            <ac:picMk id="3" creationId="{5FB7A703-B1D4-1D48-A599-3CA29DB92B7C}"/>
          </ac:picMkLst>
        </pc:picChg>
        <pc:picChg chg="add del mod modCrop">
          <ac:chgData name="Narang, Sonali" userId="9e80b397-6e2f-49b1-9374-ccdad8589140" providerId="ADAL" clId="{08EB3AD7-677B-AA4A-90AD-5577AE246557}" dt="2021-06-22T21:05:34.145" v="1322" actId="478"/>
          <ac:picMkLst>
            <pc:docMk/>
            <pc:sldMk cId="304432944" sldId="261"/>
            <ac:picMk id="3" creationId="{70AD59E7-3F50-064B-B000-EFB434617E6A}"/>
          </ac:picMkLst>
        </pc:picChg>
        <pc:picChg chg="add mod">
          <ac:chgData name="Narang, Sonali" userId="9e80b397-6e2f-49b1-9374-ccdad8589140" providerId="ADAL" clId="{08EB3AD7-677B-AA4A-90AD-5577AE246557}" dt="2021-06-22T18:53:46.381" v="1126" actId="167"/>
          <ac:picMkLst>
            <pc:docMk/>
            <pc:sldMk cId="304432944" sldId="261"/>
            <ac:picMk id="9" creationId="{0E9A9558-13A8-5348-B9BB-6DF84170CA45}"/>
          </ac:picMkLst>
        </pc:picChg>
        <pc:picChg chg="add del mod modCrop">
          <ac:chgData name="Narang, Sonali" userId="9e80b397-6e2f-49b1-9374-ccdad8589140" providerId="ADAL" clId="{08EB3AD7-677B-AA4A-90AD-5577AE246557}" dt="2021-08-11T16:53:19.844" v="9101" actId="478"/>
          <ac:picMkLst>
            <pc:docMk/>
            <pc:sldMk cId="304432944" sldId="261"/>
            <ac:picMk id="10" creationId="{25B2B9FC-2A2B-F149-931C-B36126EFD19B}"/>
          </ac:picMkLst>
        </pc:picChg>
        <pc:picChg chg="add del mod">
          <ac:chgData name="Narang, Sonali" userId="9e80b397-6e2f-49b1-9374-ccdad8589140" providerId="ADAL" clId="{08EB3AD7-677B-AA4A-90AD-5577AE246557}" dt="2021-07-09T16:29:08.902" v="4110" actId="478"/>
          <ac:picMkLst>
            <pc:docMk/>
            <pc:sldMk cId="304432944" sldId="261"/>
            <ac:picMk id="10" creationId="{B66606ED-C552-FC4D-B4D4-195A82D34382}"/>
          </ac:picMkLst>
        </pc:picChg>
        <pc:picChg chg="mod">
          <ac:chgData name="Narang, Sonali" userId="9e80b397-6e2f-49b1-9374-ccdad8589140" providerId="ADAL" clId="{08EB3AD7-677B-AA4A-90AD-5577AE246557}" dt="2021-06-22T18:54:22.151" v="1133"/>
          <ac:picMkLst>
            <pc:docMk/>
            <pc:sldMk cId="304432944" sldId="261"/>
            <ac:picMk id="21" creationId="{13F5BA0C-5C9F-4648-803C-C9E13A5294BB}"/>
          </ac:picMkLst>
        </pc:picChg>
        <pc:picChg chg="add del mod">
          <ac:chgData name="Narang, Sonali" userId="9e80b397-6e2f-49b1-9374-ccdad8589140" providerId="ADAL" clId="{08EB3AD7-677B-AA4A-90AD-5577AE246557}" dt="2021-07-09T16:29:06.096" v="4108" actId="478"/>
          <ac:picMkLst>
            <pc:docMk/>
            <pc:sldMk cId="304432944" sldId="261"/>
            <ac:picMk id="23" creationId="{89A78520-BAA9-F246-AC48-38C016C8FFEF}"/>
          </ac:picMkLst>
        </pc:picChg>
        <pc:picChg chg="add mod modCrop">
          <ac:chgData name="Narang, Sonali" userId="9e80b397-6e2f-49b1-9374-ccdad8589140" providerId="ADAL" clId="{08EB3AD7-677B-AA4A-90AD-5577AE246557}" dt="2021-08-11T16:55:43.107" v="9170" actId="1076"/>
          <ac:picMkLst>
            <pc:docMk/>
            <pc:sldMk cId="304432944" sldId="261"/>
            <ac:picMk id="23" creationId="{E250E272-FAAA-694B-BE89-06E1DA073D8A}"/>
          </ac:picMkLst>
        </pc:picChg>
        <pc:picChg chg="mod">
          <ac:chgData name="Narang, Sonali" userId="9e80b397-6e2f-49b1-9374-ccdad8589140" providerId="ADAL" clId="{08EB3AD7-677B-AA4A-90AD-5577AE246557}" dt="2021-06-22T18:54:22.151" v="1133"/>
          <ac:picMkLst>
            <pc:docMk/>
            <pc:sldMk cId="304432944" sldId="261"/>
            <ac:picMk id="26" creationId="{C918579D-1435-9D4F-99E7-EE4E71397736}"/>
          </ac:picMkLst>
        </pc:picChg>
        <pc:picChg chg="mod">
          <ac:chgData name="Narang, Sonali" userId="9e80b397-6e2f-49b1-9374-ccdad8589140" providerId="ADAL" clId="{08EB3AD7-677B-AA4A-90AD-5577AE246557}" dt="2021-06-23T14:59:30.371" v="1357" actId="1076"/>
          <ac:picMkLst>
            <pc:docMk/>
            <pc:sldMk cId="304432944" sldId="261"/>
            <ac:picMk id="27" creationId="{E372F79D-D151-0743-9C54-26592FD5D690}"/>
          </ac:picMkLst>
        </pc:picChg>
        <pc:picChg chg="del mod">
          <ac:chgData name="Narang, Sonali" userId="9e80b397-6e2f-49b1-9374-ccdad8589140" providerId="ADAL" clId="{08EB3AD7-677B-AA4A-90AD-5577AE246557}" dt="2021-06-23T14:59:23.803" v="1356" actId="21"/>
          <ac:picMkLst>
            <pc:docMk/>
            <pc:sldMk cId="304432944" sldId="261"/>
            <ac:picMk id="28" creationId="{CE83FFCD-BB96-2D44-A7C3-FFC78A6F3E90}"/>
          </ac:picMkLst>
        </pc:picChg>
        <pc:picChg chg="mod">
          <ac:chgData name="Narang, Sonali" userId="9e80b397-6e2f-49b1-9374-ccdad8589140" providerId="ADAL" clId="{08EB3AD7-677B-AA4A-90AD-5577AE246557}" dt="2021-06-22T20:56:37.650" v="1282"/>
          <ac:picMkLst>
            <pc:docMk/>
            <pc:sldMk cId="304432944" sldId="261"/>
            <ac:picMk id="81" creationId="{52461587-D2B7-2345-A3E4-B590F4531E4F}"/>
          </ac:picMkLst>
        </pc:picChg>
        <pc:picChg chg="add mod">
          <ac:chgData name="Narang, Sonali" userId="9e80b397-6e2f-49b1-9374-ccdad8589140" providerId="ADAL" clId="{08EB3AD7-677B-AA4A-90AD-5577AE246557}" dt="2021-07-09T19:55:53.599" v="4932" actId="1036"/>
          <ac:picMkLst>
            <pc:docMk/>
            <pc:sldMk cId="304432944" sldId="261"/>
            <ac:picMk id="82" creationId="{FE8B488A-A58B-8E44-81F3-C8B8558396DF}"/>
          </ac:picMkLst>
        </pc:picChg>
        <pc:picChg chg="add mod modCrop">
          <ac:chgData name="Narang, Sonali" userId="9e80b397-6e2f-49b1-9374-ccdad8589140" providerId="ADAL" clId="{08EB3AD7-677B-AA4A-90AD-5577AE246557}" dt="2021-08-16T21:17:23.470" v="10078" actId="1076"/>
          <ac:picMkLst>
            <pc:docMk/>
            <pc:sldMk cId="304432944" sldId="261"/>
            <ac:picMk id="83" creationId="{E83C2341-AFC0-E647-883F-50A935BC9461}"/>
          </ac:picMkLst>
        </pc:picChg>
        <pc:picChg chg="add mod">
          <ac:chgData name="Narang, Sonali" userId="9e80b397-6e2f-49b1-9374-ccdad8589140" providerId="ADAL" clId="{08EB3AD7-677B-AA4A-90AD-5577AE246557}" dt="2021-07-09T16:29:42.077" v="4117" actId="1076"/>
          <ac:picMkLst>
            <pc:docMk/>
            <pc:sldMk cId="304432944" sldId="261"/>
            <ac:picMk id="84" creationId="{03D820CD-A076-A141-9879-1A2C60FB339A}"/>
          </ac:picMkLst>
        </pc:picChg>
        <pc:picChg chg="mod">
          <ac:chgData name="Narang, Sonali" userId="9e80b397-6e2f-49b1-9374-ccdad8589140" providerId="ADAL" clId="{08EB3AD7-677B-AA4A-90AD-5577AE246557}" dt="2021-06-22T20:57:29.138" v="1289"/>
          <ac:picMkLst>
            <pc:docMk/>
            <pc:sldMk cId="304432944" sldId="261"/>
            <ac:picMk id="85" creationId="{4A934935-2DA6-5D4E-BEC3-83E2D4C9A3C7}"/>
          </ac:picMkLst>
        </pc:picChg>
        <pc:picChg chg="add mod">
          <ac:chgData name="Narang, Sonali" userId="9e80b397-6e2f-49b1-9374-ccdad8589140" providerId="ADAL" clId="{08EB3AD7-677B-AA4A-90AD-5577AE246557}" dt="2021-07-09T16:29:42.077" v="4117" actId="1076"/>
          <ac:picMkLst>
            <pc:docMk/>
            <pc:sldMk cId="304432944" sldId="261"/>
            <ac:picMk id="86" creationId="{2F1099FF-8133-104F-9D64-85C7E0B75CA2}"/>
          </ac:picMkLst>
        </pc:picChg>
        <pc:picChg chg="add del mod">
          <ac:chgData name="Narang, Sonali" userId="9e80b397-6e2f-49b1-9374-ccdad8589140" providerId="ADAL" clId="{08EB3AD7-677B-AA4A-90AD-5577AE246557}" dt="2021-07-09T15:28:46.056" v="3697" actId="21"/>
          <ac:picMkLst>
            <pc:docMk/>
            <pc:sldMk cId="304432944" sldId="261"/>
            <ac:picMk id="87" creationId="{02F82FA8-7001-8D42-9132-F91F2D6877B2}"/>
          </ac:picMkLst>
        </pc:picChg>
        <pc:picChg chg="add mod modCrop">
          <ac:chgData name="Narang, Sonali" userId="9e80b397-6e2f-49b1-9374-ccdad8589140" providerId="ADAL" clId="{08EB3AD7-677B-AA4A-90AD-5577AE246557}" dt="2021-08-16T21:17:29.768" v="10080" actId="167"/>
          <ac:picMkLst>
            <pc:docMk/>
            <pc:sldMk cId="304432944" sldId="261"/>
            <ac:picMk id="87" creationId="{9B85B853-9D5C-E446-A2C0-6709A7356383}"/>
          </ac:picMkLst>
        </pc:picChg>
        <pc:picChg chg="add del mod">
          <ac:chgData name="Narang, Sonali" userId="9e80b397-6e2f-49b1-9374-ccdad8589140" providerId="ADAL" clId="{08EB3AD7-677B-AA4A-90AD-5577AE246557}" dt="2021-06-22T21:08:07.970" v="1338" actId="21"/>
          <ac:picMkLst>
            <pc:docMk/>
            <pc:sldMk cId="304432944" sldId="261"/>
            <ac:picMk id="88" creationId="{A37BEA85-AE92-E24B-9242-1B5A1A3156B7}"/>
          </ac:picMkLst>
        </pc:picChg>
        <pc:picChg chg="add mod modCrop">
          <ac:chgData name="Narang, Sonali" userId="9e80b397-6e2f-49b1-9374-ccdad8589140" providerId="ADAL" clId="{08EB3AD7-677B-AA4A-90AD-5577AE246557}" dt="2021-08-16T21:17:25.298" v="10079" actId="1076"/>
          <ac:picMkLst>
            <pc:docMk/>
            <pc:sldMk cId="304432944" sldId="261"/>
            <ac:picMk id="89" creationId="{5A8B936A-A824-FD4A-97C9-35C12FAA0A4D}"/>
          </ac:picMkLst>
        </pc:picChg>
        <pc:picChg chg="mod">
          <ac:chgData name="Narang, Sonali" userId="9e80b397-6e2f-49b1-9374-ccdad8589140" providerId="ADAL" clId="{08EB3AD7-677B-AA4A-90AD-5577AE246557}" dt="2021-06-30T20:07:00.480" v="3308"/>
          <ac:picMkLst>
            <pc:docMk/>
            <pc:sldMk cId="304432944" sldId="261"/>
            <ac:picMk id="89" creationId="{A410A9DD-3C42-9141-85DD-B6A3280A43C9}"/>
          </ac:picMkLst>
        </pc:picChg>
        <pc:picChg chg="add del mod">
          <ac:chgData name="Narang, Sonali" userId="9e80b397-6e2f-49b1-9374-ccdad8589140" providerId="ADAL" clId="{08EB3AD7-677B-AA4A-90AD-5577AE246557}" dt="2021-06-22T21:08:07.970" v="1338" actId="21"/>
          <ac:picMkLst>
            <pc:docMk/>
            <pc:sldMk cId="304432944" sldId="261"/>
            <ac:picMk id="90" creationId="{C09D803E-DF8E-4E47-8BBB-A69A8013668F}"/>
          </ac:picMkLst>
        </pc:picChg>
        <pc:picChg chg="add mod">
          <ac:chgData name="Narang, Sonali" userId="9e80b397-6e2f-49b1-9374-ccdad8589140" providerId="ADAL" clId="{08EB3AD7-677B-AA4A-90AD-5577AE246557}" dt="2021-06-24T16:25:26.651" v="1860" actId="1076"/>
          <ac:picMkLst>
            <pc:docMk/>
            <pc:sldMk cId="304432944" sldId="261"/>
            <ac:picMk id="92" creationId="{0EF3325A-D681-A242-A168-7196E1949CD8}"/>
          </ac:picMkLst>
        </pc:picChg>
        <pc:picChg chg="add del mod">
          <ac:chgData name="Narang, Sonali" userId="9e80b397-6e2f-49b1-9374-ccdad8589140" providerId="ADAL" clId="{08EB3AD7-677B-AA4A-90AD-5577AE246557}" dt="2021-07-09T15:28:46.056" v="3697" actId="21"/>
          <ac:picMkLst>
            <pc:docMk/>
            <pc:sldMk cId="304432944" sldId="261"/>
            <ac:picMk id="94" creationId="{A58B8D7A-8B3E-0145-8E98-9AA02E1ED52C}"/>
          </ac:picMkLst>
        </pc:picChg>
        <pc:picChg chg="add del mod">
          <ac:chgData name="Narang, Sonali" userId="9e80b397-6e2f-49b1-9374-ccdad8589140" providerId="ADAL" clId="{08EB3AD7-677B-AA4A-90AD-5577AE246557}" dt="2021-06-23T21:13:06.094" v="1438" actId="478"/>
          <ac:picMkLst>
            <pc:docMk/>
            <pc:sldMk cId="304432944" sldId="261"/>
            <ac:picMk id="94" creationId="{CEA71F14-13C9-0F4D-87D2-1D6AEA35C5FD}"/>
          </ac:picMkLst>
        </pc:picChg>
        <pc:picChg chg="mod">
          <ac:chgData name="Narang, Sonali" userId="9e80b397-6e2f-49b1-9374-ccdad8589140" providerId="ADAL" clId="{08EB3AD7-677B-AA4A-90AD-5577AE246557}" dt="2021-06-30T20:08:14.741" v="3322"/>
          <ac:picMkLst>
            <pc:docMk/>
            <pc:sldMk cId="304432944" sldId="261"/>
            <ac:picMk id="96" creationId="{AAD9C699-B8E6-0E43-9E10-D0DFE7AEE14D}"/>
          </ac:picMkLst>
        </pc:picChg>
        <pc:picChg chg="add del mod modCrop">
          <ac:chgData name="Narang, Sonali" userId="9e80b397-6e2f-49b1-9374-ccdad8589140" providerId="ADAL" clId="{08EB3AD7-677B-AA4A-90AD-5577AE246557}" dt="2021-06-23T21:13:06.094" v="1438" actId="478"/>
          <ac:picMkLst>
            <pc:docMk/>
            <pc:sldMk cId="304432944" sldId="261"/>
            <ac:picMk id="96" creationId="{F57A649C-8F6B-E646-8A4C-9DDB4C720E43}"/>
          </ac:picMkLst>
        </pc:picChg>
        <pc:picChg chg="add del mod modCrop">
          <ac:chgData name="Narang, Sonali" userId="9e80b397-6e2f-49b1-9374-ccdad8589140" providerId="ADAL" clId="{08EB3AD7-677B-AA4A-90AD-5577AE246557}" dt="2021-06-23T21:13:06.094" v="1438" actId="478"/>
          <ac:picMkLst>
            <pc:docMk/>
            <pc:sldMk cId="304432944" sldId="261"/>
            <ac:picMk id="98" creationId="{2323E4D9-800F-A54D-8BD1-1545E775D46B}"/>
          </ac:picMkLst>
        </pc:picChg>
        <pc:picChg chg="add del mod modCrop">
          <ac:chgData name="Narang, Sonali" userId="9e80b397-6e2f-49b1-9374-ccdad8589140" providerId="ADAL" clId="{08EB3AD7-677B-AA4A-90AD-5577AE246557}" dt="2021-06-23T21:13:06.094" v="1438" actId="478"/>
          <ac:picMkLst>
            <pc:docMk/>
            <pc:sldMk cId="304432944" sldId="261"/>
            <ac:picMk id="100" creationId="{07104984-6093-EE46-BF51-59E621B58A6E}"/>
          </ac:picMkLst>
        </pc:picChg>
        <pc:picChg chg="add del mod modCrop">
          <ac:chgData name="Narang, Sonali" userId="9e80b397-6e2f-49b1-9374-ccdad8589140" providerId="ADAL" clId="{08EB3AD7-677B-AA4A-90AD-5577AE246557}" dt="2021-06-23T21:13:06.094" v="1438" actId="478"/>
          <ac:picMkLst>
            <pc:docMk/>
            <pc:sldMk cId="304432944" sldId="261"/>
            <ac:picMk id="102" creationId="{A2F170F4-42D9-3546-9FE5-AC36FC650AFC}"/>
          </ac:picMkLst>
        </pc:picChg>
        <pc:picChg chg="add del mod">
          <ac:chgData name="Narang, Sonali" userId="9e80b397-6e2f-49b1-9374-ccdad8589140" providerId="ADAL" clId="{08EB3AD7-677B-AA4A-90AD-5577AE246557}" dt="2021-06-23T21:13:19.003" v="1442" actId="478"/>
          <ac:picMkLst>
            <pc:docMk/>
            <pc:sldMk cId="304432944" sldId="261"/>
            <ac:picMk id="104" creationId="{73BC6BF1-3137-E248-AC3D-838C27764729}"/>
          </ac:picMkLst>
        </pc:picChg>
        <pc:picChg chg="add del mod">
          <ac:chgData name="Narang, Sonali" userId="9e80b397-6e2f-49b1-9374-ccdad8589140" providerId="ADAL" clId="{08EB3AD7-677B-AA4A-90AD-5577AE246557}" dt="2021-06-28T18:18:10.834" v="2143" actId="478"/>
          <ac:picMkLst>
            <pc:docMk/>
            <pc:sldMk cId="304432944" sldId="261"/>
            <ac:picMk id="106" creationId="{94C4F868-B81D-4544-A223-83760A676894}"/>
          </ac:picMkLst>
        </pc:picChg>
        <pc:picChg chg="add del mod">
          <ac:chgData name="Narang, Sonali" userId="9e80b397-6e2f-49b1-9374-ccdad8589140" providerId="ADAL" clId="{08EB3AD7-677B-AA4A-90AD-5577AE246557}" dt="2021-06-24T14:19:18.206" v="1613" actId="478"/>
          <ac:picMkLst>
            <pc:docMk/>
            <pc:sldMk cId="304432944" sldId="261"/>
            <ac:picMk id="108" creationId="{853AEFCF-8128-CD4E-8B51-F2799A98E31A}"/>
          </ac:picMkLst>
        </pc:picChg>
        <pc:picChg chg="add del mod">
          <ac:chgData name="Narang, Sonali" userId="9e80b397-6e2f-49b1-9374-ccdad8589140" providerId="ADAL" clId="{08EB3AD7-677B-AA4A-90AD-5577AE246557}" dt="2021-06-24T14:19:18.206" v="1613" actId="478"/>
          <ac:picMkLst>
            <pc:docMk/>
            <pc:sldMk cId="304432944" sldId="261"/>
            <ac:picMk id="110" creationId="{53EB689B-910E-344E-93B0-F3F2B694D665}"/>
          </ac:picMkLst>
        </pc:picChg>
        <pc:picChg chg="add del mod">
          <ac:chgData name="Narang, Sonali" userId="9e80b397-6e2f-49b1-9374-ccdad8589140" providerId="ADAL" clId="{08EB3AD7-677B-AA4A-90AD-5577AE246557}" dt="2021-06-24T14:19:18.206" v="1613" actId="478"/>
          <ac:picMkLst>
            <pc:docMk/>
            <pc:sldMk cId="304432944" sldId="261"/>
            <ac:picMk id="112" creationId="{2799296B-306F-8A44-AAF4-E0419816223A}"/>
          </ac:picMkLst>
        </pc:picChg>
        <pc:picChg chg="add del mod">
          <ac:chgData name="Narang, Sonali" userId="9e80b397-6e2f-49b1-9374-ccdad8589140" providerId="ADAL" clId="{08EB3AD7-677B-AA4A-90AD-5577AE246557}" dt="2021-06-30T20:06:46.510" v="3305" actId="478"/>
          <ac:picMkLst>
            <pc:docMk/>
            <pc:sldMk cId="304432944" sldId="261"/>
            <ac:picMk id="114" creationId="{CD79A9EC-0F7C-6141-93B3-F5755D6371C7}"/>
          </ac:picMkLst>
        </pc:picChg>
        <pc:picChg chg="add del mod">
          <ac:chgData name="Narang, Sonali" userId="9e80b397-6e2f-49b1-9374-ccdad8589140" providerId="ADAL" clId="{08EB3AD7-677B-AA4A-90AD-5577AE246557}" dt="2021-06-30T20:06:46.510" v="3305" actId="478"/>
          <ac:picMkLst>
            <pc:docMk/>
            <pc:sldMk cId="304432944" sldId="261"/>
            <ac:picMk id="116" creationId="{66C157FD-9F4F-EE4C-9C7A-F66F0D902C3A}"/>
          </ac:picMkLst>
        </pc:picChg>
        <pc:picChg chg="add del mod">
          <ac:chgData name="Narang, Sonali" userId="9e80b397-6e2f-49b1-9374-ccdad8589140" providerId="ADAL" clId="{08EB3AD7-677B-AA4A-90AD-5577AE246557}" dt="2021-06-24T19:08:57.222" v="1865" actId="478"/>
          <ac:picMkLst>
            <pc:docMk/>
            <pc:sldMk cId="304432944" sldId="261"/>
            <ac:picMk id="120" creationId="{91494BF9-099A-8345-BF75-22BC101A4F3C}"/>
          </ac:picMkLst>
        </pc:picChg>
        <pc:picChg chg="add del mod">
          <ac:chgData name="Narang, Sonali" userId="9e80b397-6e2f-49b1-9374-ccdad8589140" providerId="ADAL" clId="{08EB3AD7-677B-AA4A-90AD-5577AE246557}" dt="2021-06-30T17:45:53.768" v="2952" actId="478"/>
          <ac:picMkLst>
            <pc:docMk/>
            <pc:sldMk cId="304432944" sldId="261"/>
            <ac:picMk id="123" creationId="{07A94748-F60A-914A-A31D-CA4CE390CE09}"/>
          </ac:picMkLst>
        </pc:picChg>
        <pc:picChg chg="add del mod">
          <ac:chgData name="Narang, Sonali" userId="9e80b397-6e2f-49b1-9374-ccdad8589140" providerId="ADAL" clId="{08EB3AD7-677B-AA4A-90AD-5577AE246557}" dt="2021-06-28T17:56:51.709" v="2129" actId="478"/>
          <ac:picMkLst>
            <pc:docMk/>
            <pc:sldMk cId="304432944" sldId="261"/>
            <ac:picMk id="127" creationId="{858BF5D2-7254-AC45-8682-9B7649D4514A}"/>
          </ac:picMkLst>
        </pc:picChg>
        <pc:picChg chg="add del mod">
          <ac:chgData name="Narang, Sonali" userId="9e80b397-6e2f-49b1-9374-ccdad8589140" providerId="ADAL" clId="{08EB3AD7-677B-AA4A-90AD-5577AE246557}" dt="2021-06-30T20:06:46.510" v="3305" actId="478"/>
          <ac:picMkLst>
            <pc:docMk/>
            <pc:sldMk cId="304432944" sldId="261"/>
            <ac:picMk id="129" creationId="{DF6D8667-B0FC-0B48-BF67-B478D0A1D9FE}"/>
          </ac:picMkLst>
        </pc:picChg>
        <pc:picChg chg="add del mod">
          <ac:chgData name="Narang, Sonali" userId="9e80b397-6e2f-49b1-9374-ccdad8589140" providerId="ADAL" clId="{08EB3AD7-677B-AA4A-90AD-5577AE246557}" dt="2021-06-30T20:06:46.510" v="3305" actId="478"/>
          <ac:picMkLst>
            <pc:docMk/>
            <pc:sldMk cId="304432944" sldId="261"/>
            <ac:picMk id="131" creationId="{585BBCE9-E794-B048-BA15-834FAA88DA95}"/>
          </ac:picMkLst>
        </pc:picChg>
        <pc:picChg chg="add del mod">
          <ac:chgData name="Narang, Sonali" userId="9e80b397-6e2f-49b1-9374-ccdad8589140" providerId="ADAL" clId="{08EB3AD7-677B-AA4A-90AD-5577AE246557}" dt="2021-08-11T14:44:32.454" v="9045" actId="21"/>
          <ac:picMkLst>
            <pc:docMk/>
            <pc:sldMk cId="304432944" sldId="261"/>
            <ac:picMk id="135" creationId="{C1DD6B1A-CD00-9740-A997-5544BE4267DB}"/>
          </ac:picMkLst>
        </pc:picChg>
        <pc:picChg chg="add mod">
          <ac:chgData name="Narang, Sonali" userId="9e80b397-6e2f-49b1-9374-ccdad8589140" providerId="ADAL" clId="{08EB3AD7-677B-AA4A-90AD-5577AE246557}" dt="2021-06-30T17:46:50.366" v="2964" actId="14100"/>
          <ac:picMkLst>
            <pc:docMk/>
            <pc:sldMk cId="304432944" sldId="261"/>
            <ac:picMk id="136" creationId="{ECBA0530-E2F7-DA41-8A73-ECC2412F96EA}"/>
          </ac:picMkLst>
        </pc:picChg>
        <pc:picChg chg="add del mod">
          <ac:chgData name="Narang, Sonali" userId="9e80b397-6e2f-49b1-9374-ccdad8589140" providerId="ADAL" clId="{08EB3AD7-677B-AA4A-90AD-5577AE246557}" dt="2021-06-30T20:06:46.510" v="3305" actId="478"/>
          <ac:picMkLst>
            <pc:docMk/>
            <pc:sldMk cId="304432944" sldId="261"/>
            <ac:picMk id="140" creationId="{748372BC-B499-D54F-AD17-E2DD1116980C}"/>
          </ac:picMkLst>
        </pc:picChg>
        <pc:picChg chg="add del mod">
          <ac:chgData name="Narang, Sonali" userId="9e80b397-6e2f-49b1-9374-ccdad8589140" providerId="ADAL" clId="{08EB3AD7-677B-AA4A-90AD-5577AE246557}" dt="2021-07-09T16:33:32.992" v="4195" actId="478"/>
          <ac:picMkLst>
            <pc:docMk/>
            <pc:sldMk cId="304432944" sldId="261"/>
            <ac:picMk id="145" creationId="{026681E4-EA5C-4840-9F2D-45BC834A755C}"/>
          </ac:picMkLst>
        </pc:picChg>
        <pc:picChg chg="add del mod">
          <ac:chgData name="Narang, Sonali" userId="9e80b397-6e2f-49b1-9374-ccdad8589140" providerId="ADAL" clId="{08EB3AD7-677B-AA4A-90AD-5577AE246557}" dt="2021-08-11T14:44:29.742" v="9043"/>
          <ac:picMkLst>
            <pc:docMk/>
            <pc:sldMk cId="304432944" sldId="261"/>
            <ac:picMk id="145" creationId="{ADD6F4DD-97BA-C24F-B5C1-1820B41753B7}"/>
          </ac:picMkLst>
        </pc:picChg>
        <pc:picChg chg="add del mod">
          <ac:chgData name="Narang, Sonali" userId="9e80b397-6e2f-49b1-9374-ccdad8589140" providerId="ADAL" clId="{08EB3AD7-677B-AA4A-90AD-5577AE246557}" dt="2021-08-11T16:47:34.621" v="9074" actId="478"/>
          <ac:picMkLst>
            <pc:docMk/>
            <pc:sldMk cId="304432944" sldId="261"/>
            <ac:picMk id="146" creationId="{BC8B8D42-D169-F548-9C1C-7FB104C4AD42}"/>
          </ac:picMkLst>
        </pc:picChg>
        <pc:picChg chg="add del mod">
          <ac:chgData name="Narang, Sonali" userId="9e80b397-6e2f-49b1-9374-ccdad8589140" providerId="ADAL" clId="{08EB3AD7-677B-AA4A-90AD-5577AE246557}" dt="2021-08-17T17:31:26.452" v="10197" actId="478"/>
          <ac:picMkLst>
            <pc:docMk/>
            <pc:sldMk cId="304432944" sldId="261"/>
            <ac:picMk id="147" creationId="{E54A9BAB-5867-A74B-8B5B-133CF6B9B28B}"/>
          </ac:picMkLst>
        </pc:picChg>
        <pc:picChg chg="add del mod">
          <ac:chgData name="Narang, Sonali" userId="9e80b397-6e2f-49b1-9374-ccdad8589140" providerId="ADAL" clId="{08EB3AD7-677B-AA4A-90AD-5577AE246557}" dt="2021-08-16T20:45:40.434" v="9874" actId="478"/>
          <ac:picMkLst>
            <pc:docMk/>
            <pc:sldMk cId="304432944" sldId="261"/>
            <ac:picMk id="148" creationId="{2AC8EDF0-D1FB-D94E-ACAD-4FAE184FE831}"/>
          </ac:picMkLst>
        </pc:picChg>
        <pc:picChg chg="add del mod">
          <ac:chgData name="Narang, Sonali" userId="9e80b397-6e2f-49b1-9374-ccdad8589140" providerId="ADAL" clId="{08EB3AD7-677B-AA4A-90AD-5577AE246557}" dt="2021-08-16T20:45:40.434" v="9874" actId="478"/>
          <ac:picMkLst>
            <pc:docMk/>
            <pc:sldMk cId="304432944" sldId="261"/>
            <ac:picMk id="150" creationId="{A7D980D6-80FD-6945-934A-1A181415B5DB}"/>
          </ac:picMkLst>
        </pc:picChg>
        <pc:picChg chg="add del mod">
          <ac:chgData name="Narang, Sonali" userId="9e80b397-6e2f-49b1-9374-ccdad8589140" providerId="ADAL" clId="{08EB3AD7-677B-AA4A-90AD-5577AE246557}" dt="2021-08-16T20:45:40.434" v="9874" actId="478"/>
          <ac:picMkLst>
            <pc:docMk/>
            <pc:sldMk cId="304432944" sldId="261"/>
            <ac:picMk id="152" creationId="{59066A3A-2DFF-CD45-B93D-84B671761BC1}"/>
          </ac:picMkLst>
        </pc:picChg>
        <pc:picChg chg="add del mod">
          <ac:chgData name="Narang, Sonali" userId="9e80b397-6e2f-49b1-9374-ccdad8589140" providerId="ADAL" clId="{08EB3AD7-677B-AA4A-90AD-5577AE246557}" dt="2021-07-12T19:35:32.197" v="7332"/>
          <ac:picMkLst>
            <pc:docMk/>
            <pc:sldMk cId="304432944" sldId="261"/>
            <ac:picMk id="153" creationId="{F3F05B65-FFE4-5948-ADC6-F23B54A8B84C}"/>
          </ac:picMkLst>
        </pc:picChg>
        <pc:cxnChg chg="mod">
          <ac:chgData name="Narang, Sonali" userId="9e80b397-6e2f-49b1-9374-ccdad8589140" providerId="ADAL" clId="{08EB3AD7-677B-AA4A-90AD-5577AE246557}" dt="2021-06-22T18:54:22.151" v="1133"/>
          <ac:cxnSpMkLst>
            <pc:docMk/>
            <pc:sldMk cId="304432944" sldId="261"/>
            <ac:cxnSpMk id="13" creationId="{A6426A3B-54F7-4C4C-B2A1-0B09F8D9CA38}"/>
          </ac:cxnSpMkLst>
        </pc:cxnChg>
        <pc:cxnChg chg="mod">
          <ac:chgData name="Narang, Sonali" userId="9e80b397-6e2f-49b1-9374-ccdad8589140" providerId="ADAL" clId="{08EB3AD7-677B-AA4A-90AD-5577AE246557}" dt="2021-06-22T18:54:22.151" v="1133"/>
          <ac:cxnSpMkLst>
            <pc:docMk/>
            <pc:sldMk cId="304432944" sldId="261"/>
            <ac:cxnSpMk id="14" creationId="{49383B7A-DB11-BD4B-849A-F17469574CFB}"/>
          </ac:cxnSpMkLst>
        </pc:cxnChg>
        <pc:cxnChg chg="mod">
          <ac:chgData name="Narang, Sonali" userId="9e80b397-6e2f-49b1-9374-ccdad8589140" providerId="ADAL" clId="{08EB3AD7-677B-AA4A-90AD-5577AE246557}" dt="2021-06-22T18:54:22.151" v="1133"/>
          <ac:cxnSpMkLst>
            <pc:docMk/>
            <pc:sldMk cId="304432944" sldId="261"/>
            <ac:cxnSpMk id="18" creationId="{32CF7A3C-6E49-FC42-B6F9-D9BCB1AE3715}"/>
          </ac:cxnSpMkLst>
        </pc:cxnChg>
      </pc:sldChg>
      <pc:sldChg chg="del">
        <pc:chgData name="Narang, Sonali" userId="9e80b397-6e2f-49b1-9374-ccdad8589140" providerId="ADAL" clId="{08EB3AD7-677B-AA4A-90AD-5577AE246557}" dt="2021-06-28T19:44:39.313" v="2532" actId="2696"/>
        <pc:sldMkLst>
          <pc:docMk/>
          <pc:sldMk cId="4098972693" sldId="262"/>
        </pc:sldMkLst>
      </pc:sldChg>
      <pc:sldChg chg="add del">
        <pc:chgData name="Narang, Sonali" userId="9e80b397-6e2f-49b1-9374-ccdad8589140" providerId="ADAL" clId="{08EB3AD7-677B-AA4A-90AD-5577AE246557}" dt="2021-06-22T21:07:41.046" v="1331" actId="2890"/>
        <pc:sldMkLst>
          <pc:docMk/>
          <pc:sldMk cId="336547165" sldId="263"/>
        </pc:sldMkLst>
      </pc:sldChg>
      <pc:sldChg chg="addSp delSp modSp new del mod addCm delCm">
        <pc:chgData name="Narang, Sonali" userId="9e80b397-6e2f-49b1-9374-ccdad8589140" providerId="ADAL" clId="{08EB3AD7-677B-AA4A-90AD-5577AE246557}" dt="2021-07-09T19:51:40.370" v="4918" actId="2696"/>
        <pc:sldMkLst>
          <pc:docMk/>
          <pc:sldMk cId="466182377" sldId="263"/>
        </pc:sldMkLst>
        <pc:spChg chg="del">
          <ac:chgData name="Narang, Sonali" userId="9e80b397-6e2f-49b1-9374-ccdad8589140" providerId="ADAL" clId="{08EB3AD7-677B-AA4A-90AD-5577AE246557}" dt="2021-06-22T21:07:49.235" v="1333" actId="478"/>
          <ac:spMkLst>
            <pc:docMk/>
            <pc:sldMk cId="466182377" sldId="263"/>
            <ac:spMk id="2" creationId="{D1F784BE-0BDF-B74C-8E0F-BE4717353FD6}"/>
          </ac:spMkLst>
        </pc:spChg>
        <pc:spChg chg="add del mod">
          <ac:chgData name="Narang, Sonali" userId="9e80b397-6e2f-49b1-9374-ccdad8589140" providerId="ADAL" clId="{08EB3AD7-677B-AA4A-90AD-5577AE246557}" dt="2021-07-09T19:51:17.131" v="4910" actId="478"/>
          <ac:spMkLst>
            <pc:docMk/>
            <pc:sldMk cId="466182377" sldId="263"/>
            <ac:spMk id="2" creationId="{F85CCAEF-1A56-784C-834F-9CE2E9D28314}"/>
          </ac:spMkLst>
        </pc:spChg>
        <pc:spChg chg="del">
          <ac:chgData name="Narang, Sonali" userId="9e80b397-6e2f-49b1-9374-ccdad8589140" providerId="ADAL" clId="{08EB3AD7-677B-AA4A-90AD-5577AE246557}" dt="2021-06-22T21:07:49.235" v="1333" actId="478"/>
          <ac:spMkLst>
            <pc:docMk/>
            <pc:sldMk cId="466182377" sldId="263"/>
            <ac:spMk id="3" creationId="{ED363812-A710-D240-B800-BF8208F01FB9}"/>
          </ac:spMkLst>
        </pc:spChg>
        <pc:spChg chg="mod">
          <ac:chgData name="Narang, Sonali" userId="9e80b397-6e2f-49b1-9374-ccdad8589140" providerId="ADAL" clId="{08EB3AD7-677B-AA4A-90AD-5577AE246557}" dt="2021-06-22T21:08:09.428" v="1339"/>
          <ac:spMkLst>
            <pc:docMk/>
            <pc:sldMk cId="466182377" sldId="263"/>
            <ac:spMk id="6" creationId="{2C9F93CF-178F-954F-BB45-C917F829D99B}"/>
          </ac:spMkLst>
        </pc:spChg>
        <pc:spChg chg="mod">
          <ac:chgData name="Narang, Sonali" userId="9e80b397-6e2f-49b1-9374-ccdad8589140" providerId="ADAL" clId="{08EB3AD7-677B-AA4A-90AD-5577AE246557}" dt="2021-06-22T21:08:09.428" v="1339"/>
          <ac:spMkLst>
            <pc:docMk/>
            <pc:sldMk cId="466182377" sldId="263"/>
            <ac:spMk id="7" creationId="{B5A270A8-E476-324A-99CB-4F74F09FA0C5}"/>
          </ac:spMkLst>
        </pc:spChg>
        <pc:spChg chg="add mod">
          <ac:chgData name="Narang, Sonali" userId="9e80b397-6e2f-49b1-9374-ccdad8589140" providerId="ADAL" clId="{08EB3AD7-677B-AA4A-90AD-5577AE246557}" dt="2021-06-30T17:14:25.998" v="2928" actId="1076"/>
          <ac:spMkLst>
            <pc:docMk/>
            <pc:sldMk cId="466182377" sldId="263"/>
            <ac:spMk id="10" creationId="{27ADF062-ED6E-E546-B526-DABC103236B1}"/>
          </ac:spMkLst>
        </pc:spChg>
        <pc:spChg chg="add mod">
          <ac:chgData name="Narang, Sonali" userId="9e80b397-6e2f-49b1-9374-ccdad8589140" providerId="ADAL" clId="{08EB3AD7-677B-AA4A-90AD-5577AE246557}" dt="2021-06-30T17:14:38.420" v="2932" actId="1076"/>
          <ac:spMkLst>
            <pc:docMk/>
            <pc:sldMk cId="466182377" sldId="263"/>
            <ac:spMk id="11" creationId="{3F052E65-49A4-0B4D-B130-F0B07EE20512}"/>
          </ac:spMkLst>
        </pc:spChg>
        <pc:spChg chg="add mod">
          <ac:chgData name="Narang, Sonali" userId="9e80b397-6e2f-49b1-9374-ccdad8589140" providerId="ADAL" clId="{08EB3AD7-677B-AA4A-90AD-5577AE246557}" dt="2021-06-30T17:15:03.028" v="2943" actId="20577"/>
          <ac:spMkLst>
            <pc:docMk/>
            <pc:sldMk cId="466182377" sldId="263"/>
            <ac:spMk id="12" creationId="{1C17E9E4-B7DD-B641-B172-460286E7B2B1}"/>
          </ac:spMkLst>
        </pc:spChg>
        <pc:spChg chg="add mod">
          <ac:chgData name="Narang, Sonali" userId="9e80b397-6e2f-49b1-9374-ccdad8589140" providerId="ADAL" clId="{08EB3AD7-677B-AA4A-90AD-5577AE246557}" dt="2021-06-30T17:15:04.669" v="2945" actId="20577"/>
          <ac:spMkLst>
            <pc:docMk/>
            <pc:sldMk cId="466182377" sldId="263"/>
            <ac:spMk id="13" creationId="{2CB1A016-509C-1E48-84A7-32C040EFF61B}"/>
          </ac:spMkLst>
        </pc:spChg>
        <pc:spChg chg="add mod">
          <ac:chgData name="Narang, Sonali" userId="9e80b397-6e2f-49b1-9374-ccdad8589140" providerId="ADAL" clId="{08EB3AD7-677B-AA4A-90AD-5577AE246557}" dt="2021-07-09T14:53:34.092" v="3485" actId="20577"/>
          <ac:spMkLst>
            <pc:docMk/>
            <pc:sldMk cId="466182377" sldId="263"/>
            <ac:spMk id="14" creationId="{86B3955B-34ED-E242-BD90-F207EED87A06}"/>
          </ac:spMkLst>
        </pc:spChg>
        <pc:spChg chg="add del mod">
          <ac:chgData name="Narang, Sonali" userId="9e80b397-6e2f-49b1-9374-ccdad8589140" providerId="ADAL" clId="{08EB3AD7-677B-AA4A-90AD-5577AE246557}" dt="2021-07-09T19:51:19.656" v="4911" actId="21"/>
          <ac:spMkLst>
            <pc:docMk/>
            <pc:sldMk cId="466182377" sldId="263"/>
            <ac:spMk id="15" creationId="{F4AC6DCC-C0AD-B648-B85A-789894A3DFEB}"/>
          </ac:spMkLst>
        </pc:spChg>
        <pc:spChg chg="add del mod">
          <ac:chgData name="Narang, Sonali" userId="9e80b397-6e2f-49b1-9374-ccdad8589140" providerId="ADAL" clId="{08EB3AD7-677B-AA4A-90AD-5577AE246557}" dt="2021-06-28T17:33:19.386" v="1997" actId="478"/>
          <ac:spMkLst>
            <pc:docMk/>
            <pc:sldMk cId="466182377" sldId="263"/>
            <ac:spMk id="16" creationId="{EE41181E-AA97-6C43-B85C-C892B9A4E166}"/>
          </ac:spMkLst>
        </pc:spChg>
        <pc:spChg chg="add mod">
          <ac:chgData name="Narang, Sonali" userId="9e80b397-6e2f-49b1-9374-ccdad8589140" providerId="ADAL" clId="{08EB3AD7-677B-AA4A-90AD-5577AE246557}" dt="2021-06-30T16:01:22.150" v="2772" actId="1076"/>
          <ac:spMkLst>
            <pc:docMk/>
            <pc:sldMk cId="466182377" sldId="263"/>
            <ac:spMk id="17" creationId="{C633E975-7556-014E-9513-15F2B2C7EBB4}"/>
          </ac:spMkLst>
        </pc:spChg>
        <pc:spChg chg="add mod">
          <ac:chgData name="Narang, Sonali" userId="9e80b397-6e2f-49b1-9374-ccdad8589140" providerId="ADAL" clId="{08EB3AD7-677B-AA4A-90AD-5577AE246557}" dt="2021-06-28T17:50:03.833" v="2115" actId="1076"/>
          <ac:spMkLst>
            <pc:docMk/>
            <pc:sldMk cId="466182377" sldId="263"/>
            <ac:spMk id="18" creationId="{D823BF4B-3852-0C48-AB74-B50D88938248}"/>
          </ac:spMkLst>
        </pc:spChg>
        <pc:spChg chg="add del mod">
          <ac:chgData name="Narang, Sonali" userId="9e80b397-6e2f-49b1-9374-ccdad8589140" providerId="ADAL" clId="{08EB3AD7-677B-AA4A-90AD-5577AE246557}" dt="2021-06-28T17:48:07.948" v="2085" actId="478"/>
          <ac:spMkLst>
            <pc:docMk/>
            <pc:sldMk cId="466182377" sldId="263"/>
            <ac:spMk id="19" creationId="{D2863887-A82A-5346-BEB5-4FC9221FAD60}"/>
          </ac:spMkLst>
        </pc:spChg>
        <pc:spChg chg="add del mod">
          <ac:chgData name="Narang, Sonali" userId="9e80b397-6e2f-49b1-9374-ccdad8589140" providerId="ADAL" clId="{08EB3AD7-677B-AA4A-90AD-5577AE246557}" dt="2021-06-28T17:48:06.641" v="2084"/>
          <ac:spMkLst>
            <pc:docMk/>
            <pc:sldMk cId="466182377" sldId="263"/>
            <ac:spMk id="20" creationId="{2C454721-6642-5941-B839-95B87AEEB24C}"/>
          </ac:spMkLst>
        </pc:spChg>
        <pc:spChg chg="add mod">
          <ac:chgData name="Narang, Sonali" userId="9e80b397-6e2f-49b1-9374-ccdad8589140" providerId="ADAL" clId="{08EB3AD7-677B-AA4A-90AD-5577AE246557}" dt="2021-06-28T17:49:09.710" v="2099" actId="1038"/>
          <ac:spMkLst>
            <pc:docMk/>
            <pc:sldMk cId="466182377" sldId="263"/>
            <ac:spMk id="21" creationId="{FB7011F1-A5DD-3D45-8559-0164B37F0C0A}"/>
          </ac:spMkLst>
        </pc:spChg>
        <pc:spChg chg="add del mod">
          <ac:chgData name="Narang, Sonali" userId="9e80b397-6e2f-49b1-9374-ccdad8589140" providerId="ADAL" clId="{08EB3AD7-677B-AA4A-90AD-5577AE246557}" dt="2021-06-29T23:03:36.788" v="2561" actId="478"/>
          <ac:spMkLst>
            <pc:docMk/>
            <pc:sldMk cId="466182377" sldId="263"/>
            <ac:spMk id="24" creationId="{071C545E-754E-294C-94DF-9E6BB0B825C9}"/>
          </ac:spMkLst>
        </pc:spChg>
        <pc:spChg chg="add del mod">
          <ac:chgData name="Narang, Sonali" userId="9e80b397-6e2f-49b1-9374-ccdad8589140" providerId="ADAL" clId="{08EB3AD7-677B-AA4A-90AD-5577AE246557}" dt="2021-06-30T17:15:07.478" v="2946" actId="478"/>
          <ac:spMkLst>
            <pc:docMk/>
            <pc:sldMk cId="466182377" sldId="263"/>
            <ac:spMk id="25" creationId="{C4CD77B2-FEBA-154E-B5FE-9EBD3E85932D}"/>
          </ac:spMkLst>
        </pc:spChg>
        <pc:spChg chg="add del mod">
          <ac:chgData name="Narang, Sonali" userId="9e80b397-6e2f-49b1-9374-ccdad8589140" providerId="ADAL" clId="{08EB3AD7-677B-AA4A-90AD-5577AE246557}" dt="2021-06-30T16:53:16.791" v="2902" actId="478"/>
          <ac:spMkLst>
            <pc:docMk/>
            <pc:sldMk cId="466182377" sldId="263"/>
            <ac:spMk id="27" creationId="{36F45C34-C77C-674E-9091-066FD25770FE}"/>
          </ac:spMkLst>
        </pc:spChg>
        <pc:spChg chg="add mod">
          <ac:chgData name="Narang, Sonali" userId="9e80b397-6e2f-49b1-9374-ccdad8589140" providerId="ADAL" clId="{08EB3AD7-677B-AA4A-90AD-5577AE246557}" dt="2021-06-30T15:59:46.704" v="2716" actId="1076"/>
          <ac:spMkLst>
            <pc:docMk/>
            <pc:sldMk cId="466182377" sldId="263"/>
            <ac:spMk id="28" creationId="{B19B170C-D4D1-7145-B559-3074D7DDBD3B}"/>
          </ac:spMkLst>
        </pc:spChg>
        <pc:spChg chg="add mod">
          <ac:chgData name="Narang, Sonali" userId="9e80b397-6e2f-49b1-9374-ccdad8589140" providerId="ADAL" clId="{08EB3AD7-677B-AA4A-90AD-5577AE246557}" dt="2021-06-30T15:59:46.704" v="2716" actId="1076"/>
          <ac:spMkLst>
            <pc:docMk/>
            <pc:sldMk cId="466182377" sldId="263"/>
            <ac:spMk id="29" creationId="{8CA47026-FE15-854A-86AA-10E730A7D06B}"/>
          </ac:spMkLst>
        </pc:spChg>
        <pc:spChg chg="add mod">
          <ac:chgData name="Narang, Sonali" userId="9e80b397-6e2f-49b1-9374-ccdad8589140" providerId="ADAL" clId="{08EB3AD7-677B-AA4A-90AD-5577AE246557}" dt="2021-06-30T16:01:11.758" v="2771" actId="1076"/>
          <ac:spMkLst>
            <pc:docMk/>
            <pc:sldMk cId="466182377" sldId="263"/>
            <ac:spMk id="30" creationId="{F87766C8-1FD3-2845-A091-C4A327C9B336}"/>
          </ac:spMkLst>
        </pc:spChg>
        <pc:spChg chg="add mod">
          <ac:chgData name="Narang, Sonali" userId="9e80b397-6e2f-49b1-9374-ccdad8589140" providerId="ADAL" clId="{08EB3AD7-677B-AA4A-90AD-5577AE246557}" dt="2021-06-30T16:01:07.732" v="2770" actId="1076"/>
          <ac:spMkLst>
            <pc:docMk/>
            <pc:sldMk cId="466182377" sldId="263"/>
            <ac:spMk id="31" creationId="{254DEEE4-BF8E-F547-8D1D-E6245D86D928}"/>
          </ac:spMkLst>
        </pc:spChg>
        <pc:spChg chg="add mod">
          <ac:chgData name="Narang, Sonali" userId="9e80b397-6e2f-49b1-9374-ccdad8589140" providerId="ADAL" clId="{08EB3AD7-677B-AA4A-90AD-5577AE246557}" dt="2021-06-30T15:59:46.704" v="2716" actId="1076"/>
          <ac:spMkLst>
            <pc:docMk/>
            <pc:sldMk cId="466182377" sldId="263"/>
            <ac:spMk id="32" creationId="{274838C3-AC7F-5C46-AE6C-E3DFA8BDDF1E}"/>
          </ac:spMkLst>
        </pc:spChg>
        <pc:spChg chg="add mod">
          <ac:chgData name="Narang, Sonali" userId="9e80b397-6e2f-49b1-9374-ccdad8589140" providerId="ADAL" clId="{08EB3AD7-677B-AA4A-90AD-5577AE246557}" dt="2021-06-30T15:59:46.704" v="2716" actId="1076"/>
          <ac:spMkLst>
            <pc:docMk/>
            <pc:sldMk cId="466182377" sldId="263"/>
            <ac:spMk id="33" creationId="{ADAFBE6D-1B12-384D-A829-143742A4D886}"/>
          </ac:spMkLst>
        </pc:spChg>
        <pc:spChg chg="add del mod">
          <ac:chgData name="Narang, Sonali" userId="9e80b397-6e2f-49b1-9374-ccdad8589140" providerId="ADAL" clId="{08EB3AD7-677B-AA4A-90AD-5577AE246557}" dt="2021-06-30T15:59:50.734" v="2718" actId="478"/>
          <ac:spMkLst>
            <pc:docMk/>
            <pc:sldMk cId="466182377" sldId="263"/>
            <ac:spMk id="34" creationId="{6DF14C4E-3759-A749-9C79-5DDC13221FB4}"/>
          </ac:spMkLst>
        </pc:spChg>
        <pc:spChg chg="add mod">
          <ac:chgData name="Narang, Sonali" userId="9e80b397-6e2f-49b1-9374-ccdad8589140" providerId="ADAL" clId="{08EB3AD7-677B-AA4A-90AD-5577AE246557}" dt="2021-06-30T16:00:30.418" v="2759" actId="20577"/>
          <ac:spMkLst>
            <pc:docMk/>
            <pc:sldMk cId="466182377" sldId="263"/>
            <ac:spMk id="35" creationId="{2CFCAA67-3B31-1C46-B20A-5E69BC3D6678}"/>
          </ac:spMkLst>
        </pc:spChg>
        <pc:spChg chg="add mod">
          <ac:chgData name="Narang, Sonali" userId="9e80b397-6e2f-49b1-9374-ccdad8589140" providerId="ADAL" clId="{08EB3AD7-677B-AA4A-90AD-5577AE246557}" dt="2021-06-30T16:00:39.092" v="2761" actId="1076"/>
          <ac:spMkLst>
            <pc:docMk/>
            <pc:sldMk cId="466182377" sldId="263"/>
            <ac:spMk id="36" creationId="{5D9A96F0-7091-A14E-B856-FC46F6B98500}"/>
          </ac:spMkLst>
        </pc:spChg>
        <pc:spChg chg="add mod">
          <ac:chgData name="Narang, Sonali" userId="9e80b397-6e2f-49b1-9374-ccdad8589140" providerId="ADAL" clId="{08EB3AD7-677B-AA4A-90AD-5577AE246557}" dt="2021-06-30T16:00:42.386" v="2763" actId="1076"/>
          <ac:spMkLst>
            <pc:docMk/>
            <pc:sldMk cId="466182377" sldId="263"/>
            <ac:spMk id="37" creationId="{8457FA25-EEF5-6948-B09D-C2C652B7CEC5}"/>
          </ac:spMkLst>
        </pc:spChg>
        <pc:spChg chg="add mod">
          <ac:chgData name="Narang, Sonali" userId="9e80b397-6e2f-49b1-9374-ccdad8589140" providerId="ADAL" clId="{08EB3AD7-677B-AA4A-90AD-5577AE246557}" dt="2021-06-30T16:00:48.648" v="2765" actId="1076"/>
          <ac:spMkLst>
            <pc:docMk/>
            <pc:sldMk cId="466182377" sldId="263"/>
            <ac:spMk id="38" creationId="{5E325A63-CF98-A244-9D76-242350C18E9C}"/>
          </ac:spMkLst>
        </pc:spChg>
        <pc:spChg chg="add mod">
          <ac:chgData name="Narang, Sonali" userId="9e80b397-6e2f-49b1-9374-ccdad8589140" providerId="ADAL" clId="{08EB3AD7-677B-AA4A-90AD-5577AE246557}" dt="2021-06-30T16:00:52.395" v="2767" actId="1076"/>
          <ac:spMkLst>
            <pc:docMk/>
            <pc:sldMk cId="466182377" sldId="263"/>
            <ac:spMk id="39" creationId="{0138DCF2-9498-8545-92A0-5934249AB492}"/>
          </ac:spMkLst>
        </pc:spChg>
        <pc:spChg chg="add mod">
          <ac:chgData name="Narang, Sonali" userId="9e80b397-6e2f-49b1-9374-ccdad8589140" providerId="ADAL" clId="{08EB3AD7-677B-AA4A-90AD-5577AE246557}" dt="2021-06-30T16:00:56.657" v="2769" actId="1076"/>
          <ac:spMkLst>
            <pc:docMk/>
            <pc:sldMk cId="466182377" sldId="263"/>
            <ac:spMk id="40" creationId="{9B36C757-D692-1742-AB87-A4CF2A488829}"/>
          </ac:spMkLst>
        </pc:spChg>
        <pc:spChg chg="add del mod">
          <ac:chgData name="Narang, Sonali" userId="9e80b397-6e2f-49b1-9374-ccdad8589140" providerId="ADAL" clId="{08EB3AD7-677B-AA4A-90AD-5577AE246557}" dt="2021-07-09T19:51:14.695" v="4909" actId="478"/>
          <ac:spMkLst>
            <pc:docMk/>
            <pc:sldMk cId="466182377" sldId="263"/>
            <ac:spMk id="43" creationId="{1DFB525D-DE49-3640-BED2-CEA1D261844C}"/>
          </ac:spMkLst>
        </pc:spChg>
        <pc:spChg chg="add del mod">
          <ac:chgData name="Narang, Sonali" userId="9e80b397-6e2f-49b1-9374-ccdad8589140" providerId="ADAL" clId="{08EB3AD7-677B-AA4A-90AD-5577AE246557}" dt="2021-07-09T19:51:14.695" v="4909" actId="478"/>
          <ac:spMkLst>
            <pc:docMk/>
            <pc:sldMk cId="466182377" sldId="263"/>
            <ac:spMk id="44" creationId="{9F860339-B991-1B46-8B8D-2831B17A928D}"/>
          </ac:spMkLst>
        </pc:spChg>
        <pc:spChg chg="add mod">
          <ac:chgData name="Narang, Sonali" userId="9e80b397-6e2f-49b1-9374-ccdad8589140" providerId="ADAL" clId="{08EB3AD7-677B-AA4A-90AD-5577AE246557}" dt="2021-06-30T16:03:31.924" v="2795" actId="1076"/>
          <ac:spMkLst>
            <pc:docMk/>
            <pc:sldMk cId="466182377" sldId="263"/>
            <ac:spMk id="45" creationId="{FB86EE18-0A22-1647-BE4D-62023C326310}"/>
          </ac:spMkLst>
        </pc:spChg>
        <pc:spChg chg="add del mod">
          <ac:chgData name="Narang, Sonali" userId="9e80b397-6e2f-49b1-9374-ccdad8589140" providerId="ADAL" clId="{08EB3AD7-677B-AA4A-90AD-5577AE246557}" dt="2021-06-30T16:03:40.823" v="2798"/>
          <ac:spMkLst>
            <pc:docMk/>
            <pc:sldMk cId="466182377" sldId="263"/>
            <ac:spMk id="47" creationId="{6DA2A997-5EF3-B248-9DD8-B267F9274256}"/>
          </ac:spMkLst>
        </pc:spChg>
        <pc:spChg chg="add mod">
          <ac:chgData name="Narang, Sonali" userId="9e80b397-6e2f-49b1-9374-ccdad8589140" providerId="ADAL" clId="{08EB3AD7-677B-AA4A-90AD-5577AE246557}" dt="2021-06-30T17:15:22.827" v="2951" actId="20577"/>
          <ac:spMkLst>
            <pc:docMk/>
            <pc:sldMk cId="466182377" sldId="263"/>
            <ac:spMk id="48" creationId="{D5A219BE-6CF6-8E45-A4E2-F1A0D7957DBB}"/>
          </ac:spMkLst>
        </pc:spChg>
        <pc:spChg chg="add del mod">
          <ac:chgData name="Narang, Sonali" userId="9e80b397-6e2f-49b1-9374-ccdad8589140" providerId="ADAL" clId="{08EB3AD7-677B-AA4A-90AD-5577AE246557}" dt="2021-07-09T19:48:49.855" v="4876" actId="478"/>
          <ac:spMkLst>
            <pc:docMk/>
            <pc:sldMk cId="466182377" sldId="263"/>
            <ac:spMk id="51" creationId="{6E5DF521-CB20-BA4E-89F7-61D12F1F42DD}"/>
          </ac:spMkLst>
        </pc:spChg>
        <pc:spChg chg="add del mod">
          <ac:chgData name="Narang, Sonali" userId="9e80b397-6e2f-49b1-9374-ccdad8589140" providerId="ADAL" clId="{08EB3AD7-677B-AA4A-90AD-5577AE246557}" dt="2021-07-09T19:48:41.712" v="4874" actId="478"/>
          <ac:spMkLst>
            <pc:docMk/>
            <pc:sldMk cId="466182377" sldId="263"/>
            <ac:spMk id="54" creationId="{9BB45163-2451-C84B-9D73-01E559EC07A0}"/>
          </ac:spMkLst>
        </pc:spChg>
        <pc:spChg chg="add mod">
          <ac:chgData name="Narang, Sonali" userId="9e80b397-6e2f-49b1-9374-ccdad8589140" providerId="ADAL" clId="{08EB3AD7-677B-AA4A-90AD-5577AE246557}" dt="2021-06-30T17:14:49.150" v="2938" actId="1076"/>
          <ac:spMkLst>
            <pc:docMk/>
            <pc:sldMk cId="466182377" sldId="263"/>
            <ac:spMk id="56" creationId="{2E38D342-D57F-914A-9BBB-C58994D3359D}"/>
          </ac:spMkLst>
        </pc:spChg>
        <pc:spChg chg="add del mod">
          <ac:chgData name="Narang, Sonali" userId="9e80b397-6e2f-49b1-9374-ccdad8589140" providerId="ADAL" clId="{08EB3AD7-677B-AA4A-90AD-5577AE246557}" dt="2021-06-30T18:12:59.678" v="3076" actId="478"/>
          <ac:spMkLst>
            <pc:docMk/>
            <pc:sldMk cId="466182377" sldId="263"/>
            <ac:spMk id="58" creationId="{42FE6330-F27F-9F4D-ABF3-4F0DDE920B5E}"/>
          </ac:spMkLst>
        </pc:spChg>
        <pc:spChg chg="add del mod">
          <ac:chgData name="Narang, Sonali" userId="9e80b397-6e2f-49b1-9374-ccdad8589140" providerId="ADAL" clId="{08EB3AD7-677B-AA4A-90AD-5577AE246557}" dt="2021-06-30T18:12:59.678" v="3076" actId="478"/>
          <ac:spMkLst>
            <pc:docMk/>
            <pc:sldMk cId="466182377" sldId="263"/>
            <ac:spMk id="59" creationId="{5F8F65CB-D16D-6D49-9E7D-D8192E6573D9}"/>
          </ac:spMkLst>
        </pc:spChg>
        <pc:spChg chg="add del mod">
          <ac:chgData name="Narang, Sonali" userId="9e80b397-6e2f-49b1-9374-ccdad8589140" providerId="ADAL" clId="{08EB3AD7-677B-AA4A-90AD-5577AE246557}" dt="2021-06-30T18:12:59.678" v="3076" actId="478"/>
          <ac:spMkLst>
            <pc:docMk/>
            <pc:sldMk cId="466182377" sldId="263"/>
            <ac:spMk id="60" creationId="{DB2889F7-86CA-6648-BE61-E3561A54D0DB}"/>
          </ac:spMkLst>
        </pc:spChg>
        <pc:spChg chg="add del mod">
          <ac:chgData name="Narang, Sonali" userId="9e80b397-6e2f-49b1-9374-ccdad8589140" providerId="ADAL" clId="{08EB3AD7-677B-AA4A-90AD-5577AE246557}" dt="2021-07-09T19:51:05.764" v="4906" actId="21"/>
          <ac:spMkLst>
            <pc:docMk/>
            <pc:sldMk cId="466182377" sldId="263"/>
            <ac:spMk id="61" creationId="{AF760C04-6FEF-AD45-93D2-41874E8F1718}"/>
          </ac:spMkLst>
        </pc:spChg>
        <pc:spChg chg="add del mod">
          <ac:chgData name="Narang, Sonali" userId="9e80b397-6e2f-49b1-9374-ccdad8589140" providerId="ADAL" clId="{08EB3AD7-677B-AA4A-90AD-5577AE246557}" dt="2021-06-30T20:09:36.891" v="3342" actId="478"/>
          <ac:spMkLst>
            <pc:docMk/>
            <pc:sldMk cId="466182377" sldId="263"/>
            <ac:spMk id="62" creationId="{31AC5B95-276C-FA4A-91D0-DC76F2F15B6E}"/>
          </ac:spMkLst>
        </pc:spChg>
        <pc:grpChg chg="add del mod">
          <ac:chgData name="Narang, Sonali" userId="9e80b397-6e2f-49b1-9374-ccdad8589140" providerId="ADAL" clId="{08EB3AD7-677B-AA4A-90AD-5577AE246557}" dt="2021-06-30T20:06:57.750" v="3307" actId="21"/>
          <ac:grpSpMkLst>
            <pc:docMk/>
            <pc:sldMk cId="466182377" sldId="263"/>
            <ac:grpSpMk id="4" creationId="{AA7883E0-ACD3-FB4A-B419-C85E5FB291F4}"/>
          </ac:grpSpMkLst>
        </pc:grpChg>
        <pc:grpChg chg="add mod">
          <ac:chgData name="Narang, Sonali" userId="9e80b397-6e2f-49b1-9374-ccdad8589140" providerId="ADAL" clId="{08EB3AD7-677B-AA4A-90AD-5577AE246557}" dt="2021-06-29T21:00:17.800" v="2541" actId="1076"/>
          <ac:grpSpMkLst>
            <pc:docMk/>
            <pc:sldMk cId="466182377" sldId="263"/>
            <ac:grpSpMk id="22" creationId="{E4285898-C7C3-A044-B038-F28112F5D88A}"/>
          </ac:grpSpMkLst>
        </pc:grpChg>
        <pc:grpChg chg="add mod">
          <ac:chgData name="Narang, Sonali" userId="9e80b397-6e2f-49b1-9374-ccdad8589140" providerId="ADAL" clId="{08EB3AD7-677B-AA4A-90AD-5577AE246557}" dt="2021-06-30T16:52:10.107" v="2890" actId="1076"/>
          <ac:grpSpMkLst>
            <pc:docMk/>
            <pc:sldMk cId="466182377" sldId="263"/>
            <ac:grpSpMk id="26" creationId="{C8E00522-8E7D-B347-8BA5-88BC70D2C082}"/>
          </ac:grpSpMkLst>
        </pc:grpChg>
        <pc:grpChg chg="add del mod">
          <ac:chgData name="Narang, Sonali" userId="9e80b397-6e2f-49b1-9374-ccdad8589140" providerId="ADAL" clId="{08EB3AD7-677B-AA4A-90AD-5577AE246557}" dt="2021-07-09T19:50:18.697" v="4888" actId="478"/>
          <ac:grpSpMkLst>
            <pc:docMk/>
            <pc:sldMk cId="466182377" sldId="263"/>
            <ac:grpSpMk id="46" creationId="{7A1E15E0-D4F7-9743-BC7A-B7BFB5C7E2D1}"/>
          </ac:grpSpMkLst>
        </pc:grpChg>
        <pc:grpChg chg="add del mod">
          <ac:chgData name="Narang, Sonali" userId="9e80b397-6e2f-49b1-9374-ccdad8589140" providerId="ADAL" clId="{08EB3AD7-677B-AA4A-90AD-5577AE246557}" dt="2021-07-09T19:50:26.338" v="4889" actId="21"/>
          <ac:grpSpMkLst>
            <pc:docMk/>
            <pc:sldMk cId="466182377" sldId="263"/>
            <ac:grpSpMk id="53" creationId="{6918E680-89FC-004E-B3B5-272AC8204D88}"/>
          </ac:grpSpMkLst>
        </pc:grpChg>
        <pc:graphicFrameChg chg="add del mod">
          <ac:chgData name="Narang, Sonali" userId="9e80b397-6e2f-49b1-9374-ccdad8589140" providerId="ADAL" clId="{08EB3AD7-677B-AA4A-90AD-5577AE246557}" dt="2021-06-28T18:36:01.357" v="2165"/>
          <ac:graphicFrameMkLst>
            <pc:docMk/>
            <pc:sldMk cId="466182377" sldId="263"/>
            <ac:graphicFrameMk id="23" creationId="{385C3F83-C713-FE4C-89B8-2EDA7EE996B2}"/>
          </ac:graphicFrameMkLst>
        </pc:graphicFrameChg>
        <pc:graphicFrameChg chg="add del mod modGraphic">
          <ac:chgData name="Narang, Sonali" userId="9e80b397-6e2f-49b1-9374-ccdad8589140" providerId="ADAL" clId="{08EB3AD7-677B-AA4A-90AD-5577AE246557}" dt="2021-06-30T18:12:59.678" v="3076" actId="478"/>
          <ac:graphicFrameMkLst>
            <pc:docMk/>
            <pc:sldMk cId="466182377" sldId="263"/>
            <ac:graphicFrameMk id="57" creationId="{1FEAA276-5325-FE41-90A7-1C24F1493D30}"/>
          </ac:graphicFrameMkLst>
        </pc:graphicFrameChg>
        <pc:picChg chg="mod">
          <ac:chgData name="Narang, Sonali" userId="9e80b397-6e2f-49b1-9374-ccdad8589140" providerId="ADAL" clId="{08EB3AD7-677B-AA4A-90AD-5577AE246557}" dt="2021-06-22T21:08:09.428" v="1339"/>
          <ac:picMkLst>
            <pc:docMk/>
            <pc:sldMk cId="466182377" sldId="263"/>
            <ac:picMk id="5" creationId="{556357D5-A532-E444-BFE2-F859A1B8D36B}"/>
          </ac:picMkLst>
        </pc:picChg>
        <pc:picChg chg="add del mod">
          <ac:chgData name="Narang, Sonali" userId="9e80b397-6e2f-49b1-9374-ccdad8589140" providerId="ADAL" clId="{08EB3AD7-677B-AA4A-90AD-5577AE246557}" dt="2021-06-30T20:06:57.750" v="3307" actId="21"/>
          <ac:picMkLst>
            <pc:docMk/>
            <pc:sldMk cId="466182377" sldId="263"/>
            <ac:picMk id="8" creationId="{44187A84-5385-C443-B167-260D4BF2E26C}"/>
          </ac:picMkLst>
        </pc:picChg>
        <pc:picChg chg="add mod modCrop">
          <ac:chgData name="Narang, Sonali" userId="9e80b397-6e2f-49b1-9374-ccdad8589140" providerId="ADAL" clId="{08EB3AD7-677B-AA4A-90AD-5577AE246557}" dt="2021-06-30T15:58:07.716" v="2610" actId="732"/>
          <ac:picMkLst>
            <pc:docMk/>
            <pc:sldMk cId="466182377" sldId="263"/>
            <ac:picMk id="9" creationId="{3EA76372-42AF-B94C-A41F-0911CB818312}"/>
          </ac:picMkLst>
        </pc:picChg>
        <pc:picChg chg="add del mod modCrop">
          <ac:chgData name="Narang, Sonali" userId="9e80b397-6e2f-49b1-9374-ccdad8589140" providerId="ADAL" clId="{08EB3AD7-677B-AA4A-90AD-5577AE246557}" dt="2021-07-09T19:50:18.697" v="4888" actId="478"/>
          <ac:picMkLst>
            <pc:docMk/>
            <pc:sldMk cId="466182377" sldId="263"/>
            <ac:picMk id="42" creationId="{774F4B24-2113-A547-8D53-8C727031EC29}"/>
          </ac:picMkLst>
        </pc:picChg>
        <pc:picChg chg="add del mod">
          <ac:chgData name="Narang, Sonali" userId="9e80b397-6e2f-49b1-9374-ccdad8589140" providerId="ADAL" clId="{08EB3AD7-677B-AA4A-90AD-5577AE246557}" dt="2021-07-09T19:51:24.867" v="4913" actId="21"/>
          <ac:picMkLst>
            <pc:docMk/>
            <pc:sldMk cId="466182377" sldId="263"/>
            <ac:picMk id="47" creationId="{FE98D0C4-0142-4145-95D5-6A025D2AADB2}"/>
          </ac:picMkLst>
        </pc:picChg>
        <pc:picChg chg="add del mod">
          <ac:chgData name="Narang, Sonali" userId="9e80b397-6e2f-49b1-9374-ccdad8589140" providerId="ADAL" clId="{08EB3AD7-677B-AA4A-90AD-5577AE246557}" dt="2021-07-09T19:48:39.312" v="4873" actId="478"/>
          <ac:picMkLst>
            <pc:docMk/>
            <pc:sldMk cId="466182377" sldId="263"/>
            <ac:picMk id="49" creationId="{1C4E7963-FD0D-AF4E-97FA-2BF6788A1423}"/>
          </ac:picMkLst>
        </pc:picChg>
        <pc:picChg chg="add del mod">
          <ac:chgData name="Narang, Sonali" userId="9e80b397-6e2f-49b1-9374-ccdad8589140" providerId="ADAL" clId="{08EB3AD7-677B-AA4A-90AD-5577AE246557}" dt="2021-07-09T19:49:39.386" v="4882" actId="21"/>
          <ac:picMkLst>
            <pc:docMk/>
            <pc:sldMk cId="466182377" sldId="263"/>
            <ac:picMk id="50" creationId="{5DC4EDBC-F3BD-D049-9A9F-C627FF7EA100}"/>
          </ac:picMkLst>
        </pc:picChg>
        <pc:picChg chg="add del mod">
          <ac:chgData name="Narang, Sonali" userId="9e80b397-6e2f-49b1-9374-ccdad8589140" providerId="ADAL" clId="{08EB3AD7-677B-AA4A-90AD-5577AE246557}" dt="2021-07-09T19:49:39.386" v="4882" actId="21"/>
          <ac:picMkLst>
            <pc:docMk/>
            <pc:sldMk cId="466182377" sldId="263"/>
            <ac:picMk id="52" creationId="{B2638490-BA91-C84F-A685-FE47DD699623}"/>
          </ac:picMkLst>
        </pc:picChg>
        <pc:picChg chg="add del mod">
          <ac:chgData name="Narang, Sonali" userId="9e80b397-6e2f-49b1-9374-ccdad8589140" providerId="ADAL" clId="{08EB3AD7-677B-AA4A-90AD-5577AE246557}" dt="2021-06-30T20:06:57.750" v="3307" actId="21"/>
          <ac:picMkLst>
            <pc:docMk/>
            <pc:sldMk cId="466182377" sldId="263"/>
            <ac:picMk id="55" creationId="{77F231A5-442D-204C-AEA9-151FA90F9316}"/>
          </ac:picMkLst>
        </pc:picChg>
      </pc:sldChg>
      <pc:sldChg chg="add del">
        <pc:chgData name="Narang, Sonali" userId="9e80b397-6e2f-49b1-9374-ccdad8589140" providerId="ADAL" clId="{08EB3AD7-677B-AA4A-90AD-5577AE246557}" dt="2021-06-22T21:07:39.265" v="1330" actId="2890"/>
        <pc:sldMkLst>
          <pc:docMk/>
          <pc:sldMk cId="2730284628" sldId="264"/>
        </pc:sldMkLst>
      </pc:sldChg>
      <pc:sldChg chg="addSp delSp modSp add del mod">
        <pc:chgData name="Narang, Sonali" userId="9e80b397-6e2f-49b1-9374-ccdad8589140" providerId="ADAL" clId="{08EB3AD7-677B-AA4A-90AD-5577AE246557}" dt="2021-07-09T17:02:51.187" v="4475" actId="2696"/>
        <pc:sldMkLst>
          <pc:docMk/>
          <pc:sldMk cId="3129527176" sldId="264"/>
        </pc:sldMkLst>
        <pc:spChg chg="mod">
          <ac:chgData name="Narang, Sonali" userId="9e80b397-6e2f-49b1-9374-ccdad8589140" providerId="ADAL" clId="{08EB3AD7-677B-AA4A-90AD-5577AE246557}" dt="2021-06-24T14:22:03.567" v="1650" actId="20577"/>
          <ac:spMkLst>
            <pc:docMk/>
            <pc:sldMk cId="3129527176" sldId="264"/>
            <ac:spMk id="4" creationId="{F6669B9D-B042-D548-BD0F-97015091799B}"/>
          </ac:spMkLst>
        </pc:spChg>
        <pc:spChg chg="del mod">
          <ac:chgData name="Narang, Sonali" userId="9e80b397-6e2f-49b1-9374-ccdad8589140" providerId="ADAL" clId="{08EB3AD7-677B-AA4A-90AD-5577AE246557}" dt="2021-06-24T14:18:56.727" v="1610" actId="478"/>
          <ac:spMkLst>
            <pc:docMk/>
            <pc:sldMk cId="3129527176" sldId="264"/>
            <ac:spMk id="91" creationId="{C0EB8FE3-59EE-6C4C-A6D1-AF2E6FB2C92B}"/>
          </ac:spMkLst>
        </pc:spChg>
        <pc:spChg chg="del">
          <ac:chgData name="Narang, Sonali" userId="9e80b397-6e2f-49b1-9374-ccdad8589140" providerId="ADAL" clId="{08EB3AD7-677B-AA4A-90AD-5577AE246557}" dt="2021-06-24T14:18:49.012" v="1606" actId="478"/>
          <ac:spMkLst>
            <pc:docMk/>
            <pc:sldMk cId="3129527176" sldId="264"/>
            <ac:spMk id="117" creationId="{1ABD8087-0FA4-504A-80D6-E3E6AADF9770}"/>
          </ac:spMkLst>
        </pc:spChg>
        <pc:grpChg chg="del">
          <ac:chgData name="Narang, Sonali" userId="9e80b397-6e2f-49b1-9374-ccdad8589140" providerId="ADAL" clId="{08EB3AD7-677B-AA4A-90AD-5577AE246557}" dt="2021-06-24T14:18:52.150" v="1607" actId="478"/>
          <ac:grpSpMkLst>
            <pc:docMk/>
            <pc:sldMk cId="3129527176" sldId="264"/>
            <ac:grpSpMk id="12" creationId="{779BCE3A-9D78-7C4D-85AE-9EC9F3D34640}"/>
          </ac:grpSpMkLst>
        </pc:grpChg>
        <pc:grpChg chg="del">
          <ac:chgData name="Narang, Sonali" userId="9e80b397-6e2f-49b1-9374-ccdad8589140" providerId="ADAL" clId="{08EB3AD7-677B-AA4A-90AD-5577AE246557}" dt="2021-06-24T14:18:52.150" v="1607" actId="478"/>
          <ac:grpSpMkLst>
            <pc:docMk/>
            <pc:sldMk cId="3129527176" sldId="264"/>
            <ac:grpSpMk id="80" creationId="{9D40E91D-9CB6-3A40-B14E-D6DCD1771E96}"/>
          </ac:grpSpMkLst>
        </pc:grpChg>
        <pc:picChg chg="add del mod">
          <ac:chgData name="Narang, Sonali" userId="9e80b397-6e2f-49b1-9374-ccdad8589140" providerId="ADAL" clId="{08EB3AD7-677B-AA4A-90AD-5577AE246557}" dt="2021-07-09T16:33:38.555" v="4197" actId="478"/>
          <ac:picMkLst>
            <pc:docMk/>
            <pc:sldMk cId="3129527176" sldId="264"/>
            <ac:picMk id="85" creationId="{A0D2DA4B-D7EA-F643-956E-5D7234F9A328}"/>
          </ac:picMkLst>
        </pc:picChg>
        <pc:picChg chg="add del mod">
          <ac:chgData name="Narang, Sonali" userId="9e80b397-6e2f-49b1-9374-ccdad8589140" providerId="ADAL" clId="{08EB3AD7-677B-AA4A-90AD-5577AE246557}" dt="2021-07-09T16:33:38.555" v="4197" actId="478"/>
          <ac:picMkLst>
            <pc:docMk/>
            <pc:sldMk cId="3129527176" sldId="264"/>
            <ac:picMk id="86" creationId="{4A0A1992-283F-CA47-B853-A23B5AD7D1B3}"/>
          </ac:picMkLst>
        </pc:picChg>
        <pc:picChg chg="del">
          <ac:chgData name="Narang, Sonali" userId="9e80b397-6e2f-49b1-9374-ccdad8589140" providerId="ADAL" clId="{08EB3AD7-677B-AA4A-90AD-5577AE246557}" dt="2021-06-24T14:18:55.036" v="1609" actId="478"/>
          <ac:picMkLst>
            <pc:docMk/>
            <pc:sldMk cId="3129527176" sldId="264"/>
            <ac:picMk id="92" creationId="{0EF3325A-D681-A242-A168-7196E1949CD8}"/>
          </ac:picMkLst>
        </pc:picChg>
        <pc:picChg chg="del">
          <ac:chgData name="Narang, Sonali" userId="9e80b397-6e2f-49b1-9374-ccdad8589140" providerId="ADAL" clId="{08EB3AD7-677B-AA4A-90AD-5577AE246557}" dt="2021-06-24T14:18:52.150" v="1607" actId="478"/>
          <ac:picMkLst>
            <pc:docMk/>
            <pc:sldMk cId="3129527176" sldId="264"/>
            <ac:picMk id="106" creationId="{94C4F868-B81D-4544-A223-83760A676894}"/>
          </ac:picMkLst>
        </pc:picChg>
        <pc:picChg chg="del mod">
          <ac:chgData name="Narang, Sonali" userId="9e80b397-6e2f-49b1-9374-ccdad8589140" providerId="ADAL" clId="{08EB3AD7-677B-AA4A-90AD-5577AE246557}" dt="2021-07-09T16:33:46.320" v="4198" actId="21"/>
          <ac:picMkLst>
            <pc:docMk/>
            <pc:sldMk cId="3129527176" sldId="264"/>
            <ac:picMk id="108" creationId="{853AEFCF-8128-CD4E-8B51-F2799A98E31A}"/>
          </ac:picMkLst>
        </pc:picChg>
        <pc:picChg chg="del mod">
          <ac:chgData name="Narang, Sonali" userId="9e80b397-6e2f-49b1-9374-ccdad8589140" providerId="ADAL" clId="{08EB3AD7-677B-AA4A-90AD-5577AE246557}" dt="2021-07-09T16:33:46.320" v="4198" actId="21"/>
          <ac:picMkLst>
            <pc:docMk/>
            <pc:sldMk cId="3129527176" sldId="264"/>
            <ac:picMk id="110" creationId="{53EB689B-910E-344E-93B0-F3F2B694D665}"/>
          </ac:picMkLst>
        </pc:picChg>
        <pc:picChg chg="del mod">
          <ac:chgData name="Narang, Sonali" userId="9e80b397-6e2f-49b1-9374-ccdad8589140" providerId="ADAL" clId="{08EB3AD7-677B-AA4A-90AD-5577AE246557}" dt="2021-07-09T16:33:46.320" v="4198" actId="21"/>
          <ac:picMkLst>
            <pc:docMk/>
            <pc:sldMk cId="3129527176" sldId="264"/>
            <ac:picMk id="112" creationId="{2799296B-306F-8A44-AAF4-E0419816223A}"/>
          </ac:picMkLst>
        </pc:picChg>
        <pc:picChg chg="del">
          <ac:chgData name="Narang, Sonali" userId="9e80b397-6e2f-49b1-9374-ccdad8589140" providerId="ADAL" clId="{08EB3AD7-677B-AA4A-90AD-5577AE246557}" dt="2021-06-24T14:21:27.746" v="1630" actId="478"/>
          <ac:picMkLst>
            <pc:docMk/>
            <pc:sldMk cId="3129527176" sldId="264"/>
            <ac:picMk id="114" creationId="{CD79A9EC-0F7C-6141-93B3-F5755D6371C7}"/>
          </ac:picMkLst>
        </pc:picChg>
        <pc:picChg chg="del">
          <ac:chgData name="Narang, Sonali" userId="9e80b397-6e2f-49b1-9374-ccdad8589140" providerId="ADAL" clId="{08EB3AD7-677B-AA4A-90AD-5577AE246557}" dt="2021-06-24T14:21:27.746" v="1630" actId="478"/>
          <ac:picMkLst>
            <pc:docMk/>
            <pc:sldMk cId="3129527176" sldId="264"/>
            <ac:picMk id="116" creationId="{66C157FD-9F4F-EE4C-9C7A-F66F0D902C3A}"/>
          </ac:picMkLst>
        </pc:picChg>
      </pc:sldChg>
      <pc:sldChg chg="addSp delSp modSp add del mod">
        <pc:chgData name="Narang, Sonali" userId="9e80b397-6e2f-49b1-9374-ccdad8589140" providerId="ADAL" clId="{08EB3AD7-677B-AA4A-90AD-5577AE246557}" dt="2021-06-30T20:09:57.213" v="3388" actId="2696"/>
        <pc:sldMkLst>
          <pc:docMk/>
          <pc:sldMk cId="2892711252" sldId="265"/>
        </pc:sldMkLst>
        <pc:spChg chg="del">
          <ac:chgData name="Narang, Sonali" userId="9e80b397-6e2f-49b1-9374-ccdad8589140" providerId="ADAL" clId="{08EB3AD7-677B-AA4A-90AD-5577AE246557}" dt="2021-06-30T18:10:55.927" v="3046" actId="478"/>
          <ac:spMkLst>
            <pc:docMk/>
            <pc:sldMk cId="2892711252" sldId="265"/>
            <ac:spMk id="10" creationId="{27ADF062-ED6E-E546-B526-DABC103236B1}"/>
          </ac:spMkLst>
        </pc:spChg>
        <pc:spChg chg="del">
          <ac:chgData name="Narang, Sonali" userId="9e80b397-6e2f-49b1-9374-ccdad8589140" providerId="ADAL" clId="{08EB3AD7-677B-AA4A-90AD-5577AE246557}" dt="2021-06-30T18:10:55.927" v="3046" actId="478"/>
          <ac:spMkLst>
            <pc:docMk/>
            <pc:sldMk cId="2892711252" sldId="265"/>
            <ac:spMk id="11" creationId="{3F052E65-49A4-0B4D-B130-F0B07EE20512}"/>
          </ac:spMkLst>
        </pc:spChg>
        <pc:spChg chg="del">
          <ac:chgData name="Narang, Sonali" userId="9e80b397-6e2f-49b1-9374-ccdad8589140" providerId="ADAL" clId="{08EB3AD7-677B-AA4A-90AD-5577AE246557}" dt="2021-06-30T18:10:55.927" v="3046" actId="478"/>
          <ac:spMkLst>
            <pc:docMk/>
            <pc:sldMk cId="2892711252" sldId="265"/>
            <ac:spMk id="12" creationId="{1C17E9E4-B7DD-B641-B172-460286E7B2B1}"/>
          </ac:spMkLst>
        </pc:spChg>
        <pc:spChg chg="del">
          <ac:chgData name="Narang, Sonali" userId="9e80b397-6e2f-49b1-9374-ccdad8589140" providerId="ADAL" clId="{08EB3AD7-677B-AA4A-90AD-5577AE246557}" dt="2021-06-30T18:10:55.927" v="3046" actId="478"/>
          <ac:spMkLst>
            <pc:docMk/>
            <pc:sldMk cId="2892711252" sldId="265"/>
            <ac:spMk id="13" creationId="{2CB1A016-509C-1E48-84A7-32C040EFF61B}"/>
          </ac:spMkLst>
        </pc:spChg>
        <pc:spChg chg="mod">
          <ac:chgData name="Narang, Sonali" userId="9e80b397-6e2f-49b1-9374-ccdad8589140" providerId="ADAL" clId="{08EB3AD7-677B-AA4A-90AD-5577AE246557}" dt="2021-06-30T18:10:53.259" v="3045" actId="1076"/>
          <ac:spMkLst>
            <pc:docMk/>
            <pc:sldMk cId="2892711252" sldId="265"/>
            <ac:spMk id="14" creationId="{86B3955B-34ED-E242-BD90-F207EED87A06}"/>
          </ac:spMkLst>
        </pc:spChg>
        <pc:spChg chg="mod">
          <ac:chgData name="Narang, Sonali" userId="9e80b397-6e2f-49b1-9374-ccdad8589140" providerId="ADAL" clId="{08EB3AD7-677B-AA4A-90AD-5577AE246557}" dt="2021-06-30T18:12:50.990" v="3075" actId="1076"/>
          <ac:spMkLst>
            <pc:docMk/>
            <pc:sldMk cId="2892711252" sldId="265"/>
            <ac:spMk id="15" creationId="{F4AC6DCC-C0AD-B648-B85A-789894A3DFEB}"/>
          </ac:spMkLst>
        </pc:spChg>
        <pc:spChg chg="add mod">
          <ac:chgData name="Narang, Sonali" userId="9e80b397-6e2f-49b1-9374-ccdad8589140" providerId="ADAL" clId="{08EB3AD7-677B-AA4A-90AD-5577AE246557}" dt="2021-06-30T19:30:54.668" v="3185" actId="1076"/>
          <ac:spMkLst>
            <pc:docMk/>
            <pc:sldMk cId="2892711252" sldId="265"/>
            <ac:spMk id="16" creationId="{D98B4213-1EC1-7745-AB79-D3916AF37402}"/>
          </ac:spMkLst>
        </pc:spChg>
        <pc:spChg chg="del">
          <ac:chgData name="Narang, Sonali" userId="9e80b397-6e2f-49b1-9374-ccdad8589140" providerId="ADAL" clId="{08EB3AD7-677B-AA4A-90AD-5577AE246557}" dt="2021-06-30T18:10:48.423" v="3043" actId="478"/>
          <ac:spMkLst>
            <pc:docMk/>
            <pc:sldMk cId="2892711252" sldId="265"/>
            <ac:spMk id="43" creationId="{1DFB525D-DE49-3640-BED2-CEA1D261844C}"/>
          </ac:spMkLst>
        </pc:spChg>
        <pc:spChg chg="del">
          <ac:chgData name="Narang, Sonali" userId="9e80b397-6e2f-49b1-9374-ccdad8589140" providerId="ADAL" clId="{08EB3AD7-677B-AA4A-90AD-5577AE246557}" dt="2021-06-30T18:10:48.423" v="3043" actId="478"/>
          <ac:spMkLst>
            <pc:docMk/>
            <pc:sldMk cId="2892711252" sldId="265"/>
            <ac:spMk id="44" creationId="{9F860339-B991-1B46-8B8D-2831B17A928D}"/>
          </ac:spMkLst>
        </pc:spChg>
        <pc:spChg chg="del">
          <ac:chgData name="Narang, Sonali" userId="9e80b397-6e2f-49b1-9374-ccdad8589140" providerId="ADAL" clId="{08EB3AD7-677B-AA4A-90AD-5577AE246557}" dt="2021-06-30T18:10:55.927" v="3046" actId="478"/>
          <ac:spMkLst>
            <pc:docMk/>
            <pc:sldMk cId="2892711252" sldId="265"/>
            <ac:spMk id="48" creationId="{D5A219BE-6CF6-8E45-A4E2-F1A0D7957DBB}"/>
          </ac:spMkLst>
        </pc:spChg>
        <pc:spChg chg="del mod">
          <ac:chgData name="Narang, Sonali" userId="9e80b397-6e2f-49b1-9374-ccdad8589140" providerId="ADAL" clId="{08EB3AD7-677B-AA4A-90AD-5577AE246557}" dt="2021-06-30T18:10:59.879" v="3048" actId="478"/>
          <ac:spMkLst>
            <pc:docMk/>
            <pc:sldMk cId="2892711252" sldId="265"/>
            <ac:spMk id="56" creationId="{2E38D342-D57F-914A-9BBB-C58994D3359D}"/>
          </ac:spMkLst>
        </pc:spChg>
        <pc:spChg chg="mod">
          <ac:chgData name="Narang, Sonali" userId="9e80b397-6e2f-49b1-9374-ccdad8589140" providerId="ADAL" clId="{08EB3AD7-677B-AA4A-90AD-5577AE246557}" dt="2021-06-30T18:11:18.840" v="3054" actId="1076"/>
          <ac:spMkLst>
            <pc:docMk/>
            <pc:sldMk cId="2892711252" sldId="265"/>
            <ac:spMk id="58" creationId="{42FE6330-F27F-9F4D-ABF3-4F0DDE920B5E}"/>
          </ac:spMkLst>
        </pc:spChg>
        <pc:spChg chg="mod">
          <ac:chgData name="Narang, Sonali" userId="9e80b397-6e2f-49b1-9374-ccdad8589140" providerId="ADAL" clId="{08EB3AD7-677B-AA4A-90AD-5577AE246557}" dt="2021-06-30T18:11:30.294" v="3059" actId="1076"/>
          <ac:spMkLst>
            <pc:docMk/>
            <pc:sldMk cId="2892711252" sldId="265"/>
            <ac:spMk id="59" creationId="{5F8F65CB-D16D-6D49-9E7D-D8192E6573D9}"/>
          </ac:spMkLst>
        </pc:spChg>
        <pc:spChg chg="mod">
          <ac:chgData name="Narang, Sonali" userId="9e80b397-6e2f-49b1-9374-ccdad8589140" providerId="ADAL" clId="{08EB3AD7-677B-AA4A-90AD-5577AE246557}" dt="2021-06-30T18:11:30.294" v="3059" actId="1076"/>
          <ac:spMkLst>
            <pc:docMk/>
            <pc:sldMk cId="2892711252" sldId="265"/>
            <ac:spMk id="60" creationId="{DB2889F7-86CA-6648-BE61-E3561A54D0DB}"/>
          </ac:spMkLst>
        </pc:spChg>
        <pc:grpChg chg="del mod">
          <ac:chgData name="Narang, Sonali" userId="9e80b397-6e2f-49b1-9374-ccdad8589140" providerId="ADAL" clId="{08EB3AD7-677B-AA4A-90AD-5577AE246557}" dt="2021-06-30T18:10:42.214" v="3042" actId="478"/>
          <ac:grpSpMkLst>
            <pc:docMk/>
            <pc:sldMk cId="2892711252" sldId="265"/>
            <ac:grpSpMk id="4" creationId="{AA7883E0-ACD3-FB4A-B419-C85E5FB291F4}"/>
          </ac:grpSpMkLst>
        </pc:grpChg>
        <pc:grpChg chg="del">
          <ac:chgData name="Narang, Sonali" userId="9e80b397-6e2f-49b1-9374-ccdad8589140" providerId="ADAL" clId="{08EB3AD7-677B-AA4A-90AD-5577AE246557}" dt="2021-06-30T18:10:42.214" v="3042" actId="478"/>
          <ac:grpSpMkLst>
            <pc:docMk/>
            <pc:sldMk cId="2892711252" sldId="265"/>
            <ac:grpSpMk id="53" creationId="{6918E680-89FC-004E-B3B5-272AC8204D88}"/>
          </ac:grpSpMkLst>
        </pc:grpChg>
        <pc:graphicFrameChg chg="add mod modGraphic">
          <ac:chgData name="Narang, Sonali" userId="9e80b397-6e2f-49b1-9374-ccdad8589140" providerId="ADAL" clId="{08EB3AD7-677B-AA4A-90AD-5577AE246557}" dt="2021-06-30T18:12:08.715" v="3063" actId="122"/>
          <ac:graphicFrameMkLst>
            <pc:docMk/>
            <pc:sldMk cId="2892711252" sldId="265"/>
            <ac:graphicFrameMk id="2" creationId="{26F72761-0B23-614D-9181-7E8955D6B646}"/>
          </ac:graphicFrameMkLst>
        </pc:graphicFrameChg>
        <pc:graphicFrameChg chg="add mod modGraphic">
          <ac:chgData name="Narang, Sonali" userId="9e80b397-6e2f-49b1-9374-ccdad8589140" providerId="ADAL" clId="{08EB3AD7-677B-AA4A-90AD-5577AE246557}" dt="2021-06-30T18:12:36.721" v="3073" actId="255"/>
          <ac:graphicFrameMkLst>
            <pc:docMk/>
            <pc:sldMk cId="2892711252" sldId="265"/>
            <ac:graphicFrameMk id="3" creationId="{74722DCB-6DA6-FB42-890F-064F1DF597FB}"/>
          </ac:graphicFrameMkLst>
        </pc:graphicFrameChg>
        <pc:graphicFrameChg chg="mod modGraphic">
          <ac:chgData name="Narang, Sonali" userId="9e80b397-6e2f-49b1-9374-ccdad8589140" providerId="ADAL" clId="{08EB3AD7-677B-AA4A-90AD-5577AE246557}" dt="2021-06-30T18:12:43.229" v="3074" actId="1076"/>
          <ac:graphicFrameMkLst>
            <pc:docMk/>
            <pc:sldMk cId="2892711252" sldId="265"/>
            <ac:graphicFrameMk id="57" creationId="{1FEAA276-5325-FE41-90A7-1C24F1493D30}"/>
          </ac:graphicFrameMkLst>
        </pc:graphicFrameChg>
        <pc:picChg chg="del">
          <ac:chgData name="Narang, Sonali" userId="9e80b397-6e2f-49b1-9374-ccdad8589140" providerId="ADAL" clId="{08EB3AD7-677B-AA4A-90AD-5577AE246557}" dt="2021-06-30T18:10:42.214" v="3042" actId="478"/>
          <ac:picMkLst>
            <pc:docMk/>
            <pc:sldMk cId="2892711252" sldId="265"/>
            <ac:picMk id="8" creationId="{44187A84-5385-C443-B167-260D4BF2E26C}"/>
          </ac:picMkLst>
        </pc:picChg>
        <pc:picChg chg="del">
          <ac:chgData name="Narang, Sonali" userId="9e80b397-6e2f-49b1-9374-ccdad8589140" providerId="ADAL" clId="{08EB3AD7-677B-AA4A-90AD-5577AE246557}" dt="2021-06-30T18:10:42.214" v="3042" actId="478"/>
          <ac:picMkLst>
            <pc:docMk/>
            <pc:sldMk cId="2892711252" sldId="265"/>
            <ac:picMk id="50" creationId="{5DC4EDBC-F3BD-D049-9A9F-C627FF7EA100}"/>
          </ac:picMkLst>
        </pc:picChg>
        <pc:picChg chg="del">
          <ac:chgData name="Narang, Sonali" userId="9e80b397-6e2f-49b1-9374-ccdad8589140" providerId="ADAL" clId="{08EB3AD7-677B-AA4A-90AD-5577AE246557}" dt="2021-06-30T18:10:42.214" v="3042" actId="478"/>
          <ac:picMkLst>
            <pc:docMk/>
            <pc:sldMk cId="2892711252" sldId="265"/>
            <ac:picMk id="52" creationId="{B2638490-BA91-C84F-A685-FE47DD699623}"/>
          </ac:picMkLst>
        </pc:picChg>
        <pc:picChg chg="del">
          <ac:chgData name="Narang, Sonali" userId="9e80b397-6e2f-49b1-9374-ccdad8589140" providerId="ADAL" clId="{08EB3AD7-677B-AA4A-90AD-5577AE246557}" dt="2021-06-30T18:10:42.214" v="3042" actId="478"/>
          <ac:picMkLst>
            <pc:docMk/>
            <pc:sldMk cId="2892711252" sldId="265"/>
            <ac:picMk id="55" creationId="{77F231A5-442D-204C-AEA9-151FA90F9316}"/>
          </ac:picMkLst>
        </pc:picChg>
      </pc:sldChg>
      <pc:sldChg chg="addSp delSp modSp add mod ord modNotesTx">
        <pc:chgData name="Narang, Sonali" userId="9e80b397-6e2f-49b1-9374-ccdad8589140" providerId="ADAL" clId="{08EB3AD7-677B-AA4A-90AD-5577AE246557}" dt="2021-08-17T19:41:23.265" v="10239" actId="1076"/>
        <pc:sldMkLst>
          <pc:docMk/>
          <pc:sldMk cId="2188698368" sldId="266"/>
        </pc:sldMkLst>
        <pc:spChg chg="mod">
          <ac:chgData name="Narang, Sonali" userId="9e80b397-6e2f-49b1-9374-ccdad8589140" providerId="ADAL" clId="{08EB3AD7-677B-AA4A-90AD-5577AE246557}" dt="2021-07-09T21:12:10.514" v="5473" actId="20577"/>
          <ac:spMkLst>
            <pc:docMk/>
            <pc:sldMk cId="2188698368" sldId="266"/>
            <ac:spMk id="4" creationId="{F6669B9D-B042-D548-BD0F-97015091799B}"/>
          </ac:spMkLst>
        </pc:spChg>
        <pc:spChg chg="mod">
          <ac:chgData name="Narang, Sonali" userId="9e80b397-6e2f-49b1-9374-ccdad8589140" providerId="ADAL" clId="{08EB3AD7-677B-AA4A-90AD-5577AE246557}" dt="2021-07-09T20:38:25.485" v="5234" actId="1076"/>
          <ac:spMkLst>
            <pc:docMk/>
            <pc:sldMk cId="2188698368" sldId="266"/>
            <ac:spMk id="8" creationId="{8A9BAE78-C4FF-1843-94F6-3410EB884848}"/>
          </ac:spMkLst>
        </pc:spChg>
        <pc:spChg chg="add del mod">
          <ac:chgData name="Narang, Sonali" userId="9e80b397-6e2f-49b1-9374-ccdad8589140" providerId="ADAL" clId="{08EB3AD7-677B-AA4A-90AD-5577AE246557}" dt="2021-07-28T16:43:46.810" v="9038" actId="478"/>
          <ac:spMkLst>
            <pc:docMk/>
            <pc:sldMk cId="2188698368" sldId="266"/>
            <ac:spMk id="10" creationId="{B4AA902B-49F0-3042-A3FC-ABB3FC0B5D41}"/>
          </ac:spMkLst>
        </pc:spChg>
        <pc:spChg chg="mod">
          <ac:chgData name="Narang, Sonali" userId="9e80b397-6e2f-49b1-9374-ccdad8589140" providerId="ADAL" clId="{08EB3AD7-677B-AA4A-90AD-5577AE246557}" dt="2021-07-09T20:35:43.624" v="5188" actId="20577"/>
          <ac:spMkLst>
            <pc:docMk/>
            <pc:sldMk cId="2188698368" sldId="266"/>
            <ac:spMk id="87" creationId="{1C02B2D7-E6F9-2745-ACD1-727D530B8505}"/>
          </ac:spMkLst>
        </pc:spChg>
        <pc:spChg chg="mod">
          <ac:chgData name="Narang, Sonali" userId="9e80b397-6e2f-49b1-9374-ccdad8589140" providerId="ADAL" clId="{08EB3AD7-677B-AA4A-90AD-5577AE246557}" dt="2021-07-09T20:35:53.025" v="5194" actId="20577"/>
          <ac:spMkLst>
            <pc:docMk/>
            <pc:sldMk cId="2188698368" sldId="266"/>
            <ac:spMk id="88" creationId="{47F4AB0E-002C-BA48-93DA-3C2A7B667614}"/>
          </ac:spMkLst>
        </pc:spChg>
        <pc:spChg chg="mod">
          <ac:chgData name="Narang, Sonali" userId="9e80b397-6e2f-49b1-9374-ccdad8589140" providerId="ADAL" clId="{08EB3AD7-677B-AA4A-90AD-5577AE246557}" dt="2021-07-09T20:35:57.844" v="5206" actId="20577"/>
          <ac:spMkLst>
            <pc:docMk/>
            <pc:sldMk cId="2188698368" sldId="266"/>
            <ac:spMk id="89" creationId="{590FCFF2-EA85-9943-BE3F-73672A01D9D9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0" creationId="{AA0F7CA5-547C-774C-8799-04FBD85CA1AC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3" creationId="{1474EFCA-DF89-BC4A-8CDC-A4B2CD6B9A1E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4" creationId="{73DAFEF0-F863-2140-8338-D1FD5E549FA1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5" creationId="{CBBA16A2-1AE7-204C-BD81-DA9F73C669AD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6" creationId="{6AA303B2-30ED-0449-9ACA-96251CB2F195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7" creationId="{50B3EA30-6C58-6543-B246-A80ED4035EAE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8" creationId="{73E7E69B-8771-7B43-B94B-32E3F23608F2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99" creationId="{86640634-D03F-5448-B9DB-4535E92E07DD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100" creationId="{2A73A197-F427-774B-97D8-C42CA70C3940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103" creationId="{8FAED76B-6482-5D44-B02D-1371AD589F4A}"/>
          </ac:spMkLst>
        </pc:spChg>
        <pc:spChg chg="mod">
          <ac:chgData name="Narang, Sonali" userId="9e80b397-6e2f-49b1-9374-ccdad8589140" providerId="ADAL" clId="{08EB3AD7-677B-AA4A-90AD-5577AE246557}" dt="2021-07-28T16:16:11.793" v="9020" actId="1035"/>
          <ac:spMkLst>
            <pc:docMk/>
            <pc:sldMk cId="2188698368" sldId="266"/>
            <ac:spMk id="105" creationId="{E5F2FE95-FDB3-CC4B-81A3-AF7A80B7E5DF}"/>
          </ac:spMkLst>
        </pc:spChg>
        <pc:spChg chg="mod">
          <ac:chgData name="Narang, Sonali" userId="9e80b397-6e2f-49b1-9374-ccdad8589140" providerId="ADAL" clId="{08EB3AD7-677B-AA4A-90AD-5577AE246557}" dt="2021-07-28T16:16:18.685" v="9023" actId="1035"/>
          <ac:spMkLst>
            <pc:docMk/>
            <pc:sldMk cId="2188698368" sldId="266"/>
            <ac:spMk id="106" creationId="{A342B350-914C-6241-AE5A-E475C1B70ABF}"/>
          </ac:spMkLst>
        </pc:spChg>
        <pc:spChg chg="mod">
          <ac:chgData name="Narang, Sonali" userId="9e80b397-6e2f-49b1-9374-ccdad8589140" providerId="ADAL" clId="{08EB3AD7-677B-AA4A-90AD-5577AE246557}" dt="2021-07-09T19:50:27.738" v="4890"/>
          <ac:spMkLst>
            <pc:docMk/>
            <pc:sldMk cId="2188698368" sldId="266"/>
            <ac:spMk id="108" creationId="{4A6CF136-6F82-BC4B-A543-750211DD6F62}"/>
          </ac:spMkLst>
        </pc:spChg>
        <pc:spChg chg="add del mod">
          <ac:chgData name="Narang, Sonali" userId="9e80b397-6e2f-49b1-9374-ccdad8589140" providerId="ADAL" clId="{08EB3AD7-677B-AA4A-90AD-5577AE246557}" dt="2021-08-17T19:41:23.265" v="10239" actId="1076"/>
          <ac:spMkLst>
            <pc:docMk/>
            <pc:sldMk cId="2188698368" sldId="266"/>
            <ac:spMk id="109" creationId="{BEE82DA0-23D4-9844-9F18-D3B4989D6DF5}"/>
          </ac:spMkLst>
        </pc:spChg>
        <pc:spChg chg="add del mod">
          <ac:chgData name="Narang, Sonali" userId="9e80b397-6e2f-49b1-9374-ccdad8589140" providerId="ADAL" clId="{08EB3AD7-677B-AA4A-90AD-5577AE246557}" dt="2021-07-12T18:54:52.802" v="7135" actId="478"/>
          <ac:spMkLst>
            <pc:docMk/>
            <pc:sldMk cId="2188698368" sldId="266"/>
            <ac:spMk id="110" creationId="{6E11855E-82D6-7547-87A3-918182AECF5A}"/>
          </ac:spMkLst>
        </pc:spChg>
        <pc:spChg chg="add del mod">
          <ac:chgData name="Narang, Sonali" userId="9e80b397-6e2f-49b1-9374-ccdad8589140" providerId="ADAL" clId="{08EB3AD7-677B-AA4A-90AD-5577AE246557}" dt="2021-08-17T17:53:56.552" v="10238" actId="478"/>
          <ac:spMkLst>
            <pc:docMk/>
            <pc:sldMk cId="2188698368" sldId="266"/>
            <ac:spMk id="112" creationId="{9121F24E-B37D-D941-967B-D084FE40232E}"/>
          </ac:spMkLst>
        </pc:spChg>
        <pc:spChg chg="mod">
          <ac:chgData name="Narang, Sonali" userId="9e80b397-6e2f-49b1-9374-ccdad8589140" providerId="ADAL" clId="{08EB3AD7-677B-AA4A-90AD-5577AE246557}" dt="2021-07-09T21:10:48.647" v="5467" actId="1076"/>
          <ac:spMkLst>
            <pc:docMk/>
            <pc:sldMk cId="2188698368" sldId="266"/>
            <ac:spMk id="124" creationId="{2BE84DAC-7C05-C445-9DD3-6B3EE69AFBF9}"/>
          </ac:spMkLst>
        </pc:spChg>
        <pc:spChg chg="del mod">
          <ac:chgData name="Narang, Sonali" userId="9e80b397-6e2f-49b1-9374-ccdad8589140" providerId="ADAL" clId="{08EB3AD7-677B-AA4A-90AD-5577AE246557}" dt="2021-07-09T20:38:31.206" v="5235" actId="478"/>
          <ac:spMkLst>
            <pc:docMk/>
            <pc:sldMk cId="2188698368" sldId="266"/>
            <ac:spMk id="125" creationId="{F77578BF-D28B-AC46-B202-F16CA20F451A}"/>
          </ac:spMkLst>
        </pc:spChg>
        <pc:spChg chg="add del">
          <ac:chgData name="Narang, Sonali" userId="9e80b397-6e2f-49b1-9374-ccdad8589140" providerId="ADAL" clId="{08EB3AD7-677B-AA4A-90AD-5577AE246557}" dt="2021-07-09T21:10:49.404" v="5469" actId="21"/>
          <ac:spMkLst>
            <pc:docMk/>
            <pc:sldMk cId="2188698368" sldId="266"/>
            <ac:spMk id="134" creationId="{8B8F2094-C633-C148-9C44-E2191D02F77E}"/>
          </ac:spMkLst>
        </pc:spChg>
        <pc:grpChg chg="del">
          <ac:chgData name="Narang, Sonali" userId="9e80b397-6e2f-49b1-9374-ccdad8589140" providerId="ADAL" clId="{08EB3AD7-677B-AA4A-90AD-5577AE246557}" dt="2021-06-30T20:08:11.291" v="3321" actId="21"/>
          <ac:grpSpMkLst>
            <pc:docMk/>
            <pc:sldMk cId="2188698368" sldId="266"/>
            <ac:grpSpMk id="80" creationId="{9D40E91D-9CB6-3A40-B14E-D6DCD1771E96}"/>
          </ac:grpSpMkLst>
        </pc:grpChg>
        <pc:grpChg chg="add mod">
          <ac:chgData name="Narang, Sonali" userId="9e80b397-6e2f-49b1-9374-ccdad8589140" providerId="ADAL" clId="{08EB3AD7-677B-AA4A-90AD-5577AE246557}" dt="2021-07-12T19:08:29.677" v="7162" actId="1076"/>
          <ac:grpSpMkLst>
            <pc:docMk/>
            <pc:sldMk cId="2188698368" sldId="266"/>
            <ac:grpSpMk id="85" creationId="{D7BDA1D2-D9CA-734B-A971-54235A3C5910}"/>
          </ac:grpSpMkLst>
        </pc:grpChg>
        <pc:grpChg chg="mod">
          <ac:chgData name="Narang, Sonali" userId="9e80b397-6e2f-49b1-9374-ccdad8589140" providerId="ADAL" clId="{08EB3AD7-677B-AA4A-90AD-5577AE246557}" dt="2021-07-09T19:50:27.738" v="4890"/>
          <ac:grpSpMkLst>
            <pc:docMk/>
            <pc:sldMk cId="2188698368" sldId="266"/>
            <ac:grpSpMk id="86" creationId="{C59F9C8E-C1D6-3B4A-A659-14307C592AA3}"/>
          </ac:grpSpMkLst>
        </pc:grpChg>
        <pc:grpChg chg="del mod">
          <ac:chgData name="Narang, Sonali" userId="9e80b397-6e2f-49b1-9374-ccdad8589140" providerId="ADAL" clId="{08EB3AD7-677B-AA4A-90AD-5577AE246557}" dt="2021-07-09T20:36:00.951" v="5207" actId="478"/>
          <ac:grpSpMkLst>
            <pc:docMk/>
            <pc:sldMk cId="2188698368" sldId="266"/>
            <ac:grpSpMk id="101" creationId="{1668BCF1-684C-9E42-AE55-D4A2D353666C}"/>
          </ac:grpSpMkLst>
        </pc:grpChg>
        <pc:grpChg chg="del mod">
          <ac:chgData name="Narang, Sonali" userId="9e80b397-6e2f-49b1-9374-ccdad8589140" providerId="ADAL" clId="{08EB3AD7-677B-AA4A-90AD-5577AE246557}" dt="2021-07-09T20:35:13.075" v="5134" actId="478"/>
          <ac:grpSpMkLst>
            <pc:docMk/>
            <pc:sldMk cId="2188698368" sldId="266"/>
            <ac:grpSpMk id="104" creationId="{C910F44D-ACA7-0C4B-B535-358FF0D3C5C9}"/>
          </ac:grpSpMkLst>
        </pc:grpChg>
        <pc:grpChg chg="del mod">
          <ac:chgData name="Narang, Sonali" userId="9e80b397-6e2f-49b1-9374-ccdad8589140" providerId="ADAL" clId="{08EB3AD7-677B-AA4A-90AD-5577AE246557}" dt="2021-07-09T16:45:54.529" v="4363" actId="478"/>
          <ac:grpSpMkLst>
            <pc:docMk/>
            <pc:sldMk cId="2188698368" sldId="266"/>
            <ac:grpSpMk id="121" creationId="{D382BF2F-F6F7-0546-8A3A-3F285CDE1EF7}"/>
          </ac:grpSpMkLst>
        </pc:grpChg>
        <pc:picChg chg="add del mod">
          <ac:chgData name="Narang, Sonali" userId="9e80b397-6e2f-49b1-9374-ccdad8589140" providerId="ADAL" clId="{08EB3AD7-677B-AA4A-90AD-5577AE246557}" dt="2021-07-28T16:15:19.764" v="9005" actId="478"/>
          <ac:picMkLst>
            <pc:docMk/>
            <pc:sldMk cId="2188698368" sldId="266"/>
            <ac:picMk id="3" creationId="{CAC8D62E-451C-1742-B184-7F1195AB5E47}"/>
          </ac:picMkLst>
        </pc:picChg>
        <pc:picChg chg="add mod modCrop">
          <ac:chgData name="Narang, Sonali" userId="9e80b397-6e2f-49b1-9374-ccdad8589140" providerId="ADAL" clId="{08EB3AD7-677B-AA4A-90AD-5577AE246557}" dt="2021-07-28T16:37:03.036" v="9036" actId="732"/>
          <ac:picMkLst>
            <pc:docMk/>
            <pc:sldMk cId="2188698368" sldId="266"/>
            <ac:picMk id="9" creationId="{6ABD3AA5-95E6-6D4B-84AF-F0F5C645343C}"/>
          </ac:picMkLst>
        </pc:picChg>
        <pc:picChg chg="add mod">
          <ac:chgData name="Narang, Sonali" userId="9e80b397-6e2f-49b1-9374-ccdad8589140" providerId="ADAL" clId="{08EB3AD7-677B-AA4A-90AD-5577AE246557}" dt="2021-07-09T20:38:45.189" v="5242" actId="1076"/>
          <ac:picMkLst>
            <pc:docMk/>
            <pc:sldMk cId="2188698368" sldId="266"/>
            <ac:picMk id="83" creationId="{A2DC379C-9BE3-8847-8A10-2744CD535286}"/>
          </ac:picMkLst>
        </pc:picChg>
        <pc:picChg chg="add mod">
          <ac:chgData name="Narang, Sonali" userId="9e80b397-6e2f-49b1-9374-ccdad8589140" providerId="ADAL" clId="{08EB3AD7-677B-AA4A-90AD-5577AE246557}" dt="2021-07-09T20:38:45.189" v="5242" actId="1076"/>
          <ac:picMkLst>
            <pc:docMk/>
            <pc:sldMk cId="2188698368" sldId="266"/>
            <ac:picMk id="84" creationId="{4D67AF32-BEDD-0B4F-8E91-8B21283BC598}"/>
          </ac:picMkLst>
        </pc:picChg>
        <pc:picChg chg="del mod">
          <ac:chgData name="Narang, Sonali" userId="9e80b397-6e2f-49b1-9374-ccdad8589140" providerId="ADAL" clId="{08EB3AD7-677B-AA4A-90AD-5577AE246557}" dt="2021-07-09T20:36:00.951" v="5207" actId="478"/>
          <ac:picMkLst>
            <pc:docMk/>
            <pc:sldMk cId="2188698368" sldId="266"/>
            <ac:picMk id="102" creationId="{FD3861A7-2A85-A84F-9481-9B743B9AF473}"/>
          </ac:picMkLst>
        </pc:picChg>
        <pc:picChg chg="del mod">
          <ac:chgData name="Narang, Sonali" userId="9e80b397-6e2f-49b1-9374-ccdad8589140" providerId="ADAL" clId="{08EB3AD7-677B-AA4A-90AD-5577AE246557}" dt="2021-07-09T20:35:13.075" v="5134" actId="478"/>
          <ac:picMkLst>
            <pc:docMk/>
            <pc:sldMk cId="2188698368" sldId="266"/>
            <ac:picMk id="107" creationId="{5D0EDBED-E3E3-4C46-8BC7-A77B29ADB298}"/>
          </ac:picMkLst>
        </pc:picChg>
        <pc:picChg chg="add mod">
          <ac:chgData name="Narang, Sonali" userId="9e80b397-6e2f-49b1-9374-ccdad8589140" providerId="ADAL" clId="{08EB3AD7-677B-AA4A-90AD-5577AE246557}" dt="2021-07-12T18:20:15.191" v="7096" actId="1076"/>
          <ac:picMkLst>
            <pc:docMk/>
            <pc:sldMk cId="2188698368" sldId="266"/>
            <ac:picMk id="111" creationId="{20BB0087-4AF3-7B49-A354-5C3664D1250B}"/>
          </ac:picMkLst>
        </pc:picChg>
        <pc:picChg chg="mod">
          <ac:chgData name="Narang, Sonali" userId="9e80b397-6e2f-49b1-9374-ccdad8589140" providerId="ADAL" clId="{08EB3AD7-677B-AA4A-90AD-5577AE246557}" dt="2021-07-09T20:38:45.189" v="5242" actId="1076"/>
          <ac:picMkLst>
            <pc:docMk/>
            <pc:sldMk cId="2188698368" sldId="266"/>
            <ac:picMk id="114" creationId="{CD79A9EC-0F7C-6141-93B3-F5755D6371C7}"/>
          </ac:picMkLst>
        </pc:picChg>
        <pc:picChg chg="mod">
          <ac:chgData name="Narang, Sonali" userId="9e80b397-6e2f-49b1-9374-ccdad8589140" providerId="ADAL" clId="{08EB3AD7-677B-AA4A-90AD-5577AE246557}" dt="2021-07-09T20:38:45.189" v="5242" actId="1076"/>
          <ac:picMkLst>
            <pc:docMk/>
            <pc:sldMk cId="2188698368" sldId="266"/>
            <ac:picMk id="116" creationId="{66C157FD-9F4F-EE4C-9C7A-F66F0D902C3A}"/>
          </ac:picMkLst>
        </pc:picChg>
        <pc:picChg chg="del">
          <ac:chgData name="Narang, Sonali" userId="9e80b397-6e2f-49b1-9374-ccdad8589140" providerId="ADAL" clId="{08EB3AD7-677B-AA4A-90AD-5577AE246557}" dt="2021-07-09T19:50:07.269" v="4885" actId="21"/>
          <ac:picMkLst>
            <pc:docMk/>
            <pc:sldMk cId="2188698368" sldId="266"/>
            <ac:picMk id="129" creationId="{DF6D8667-B0FC-0B48-BF67-B478D0A1D9FE}"/>
          </ac:picMkLst>
        </pc:picChg>
        <pc:picChg chg="mod">
          <ac:chgData name="Narang, Sonali" userId="9e80b397-6e2f-49b1-9374-ccdad8589140" providerId="ADAL" clId="{08EB3AD7-677B-AA4A-90AD-5577AE246557}" dt="2021-07-09T20:38:52.214" v="5243" actId="1076"/>
          <ac:picMkLst>
            <pc:docMk/>
            <pc:sldMk cId="2188698368" sldId="266"/>
            <ac:picMk id="131" creationId="{585BBCE9-E794-B048-BA15-834FAA88DA95}"/>
          </ac:picMkLst>
        </pc:picChg>
        <pc:picChg chg="mod">
          <ac:chgData name="Narang, Sonali" userId="9e80b397-6e2f-49b1-9374-ccdad8589140" providerId="ADAL" clId="{08EB3AD7-677B-AA4A-90AD-5577AE246557}" dt="2021-07-12T18:54:56.156" v="7137" actId="1076"/>
          <ac:picMkLst>
            <pc:docMk/>
            <pc:sldMk cId="2188698368" sldId="266"/>
            <ac:picMk id="140" creationId="{748372BC-B499-D54F-AD17-E2DD1116980C}"/>
          </ac:picMkLst>
        </pc:picChg>
      </pc:sldChg>
      <pc:sldChg chg="addSp delSp modSp add del mod modNotesTx">
        <pc:chgData name="Narang, Sonali" userId="9e80b397-6e2f-49b1-9374-ccdad8589140" providerId="ADAL" clId="{08EB3AD7-677B-AA4A-90AD-5577AE246557}" dt="2021-08-17T17:31:43.248" v="10237" actId="1076"/>
        <pc:sldMkLst>
          <pc:docMk/>
          <pc:sldMk cId="743684689" sldId="267"/>
        </pc:sldMkLst>
        <pc:spChg chg="add del mod">
          <ac:chgData name="Narang, Sonali" userId="9e80b397-6e2f-49b1-9374-ccdad8589140" providerId="ADAL" clId="{08EB3AD7-677B-AA4A-90AD-5577AE246557}" dt="2021-08-17T17:31:15.858" v="10196"/>
          <ac:spMkLst>
            <pc:docMk/>
            <pc:sldMk cId="743684689" sldId="267"/>
            <ac:spMk id="2" creationId="{5A86F87B-E4F3-B249-9B85-1F48EFD079BB}"/>
          </ac:spMkLst>
        </pc:spChg>
        <pc:spChg chg="mod">
          <ac:chgData name="Narang, Sonali" userId="9e80b397-6e2f-49b1-9374-ccdad8589140" providerId="ADAL" clId="{08EB3AD7-677B-AA4A-90AD-5577AE246557}" dt="2021-07-09T14:53:13.637" v="3480" actId="20577"/>
          <ac:spMkLst>
            <pc:docMk/>
            <pc:sldMk cId="743684689" sldId="267"/>
            <ac:spMk id="4" creationId="{F6669B9D-B042-D548-BD0F-97015091799B}"/>
          </ac:spMkLst>
        </pc:spChg>
        <pc:spChg chg="mod">
          <ac:chgData name="Narang, Sonali" userId="9e80b397-6e2f-49b1-9374-ccdad8589140" providerId="ADAL" clId="{08EB3AD7-677B-AA4A-90AD-5577AE246557}" dt="2021-07-09T16:42:30.330" v="4329" actId="12789"/>
          <ac:spMkLst>
            <pc:docMk/>
            <pc:sldMk cId="743684689" sldId="267"/>
            <ac:spMk id="5" creationId="{FAFFEC37-A0C5-5846-8534-22E3DEF6CEF4}"/>
          </ac:spMkLst>
        </pc:spChg>
        <pc:spChg chg="mod">
          <ac:chgData name="Narang, Sonali" userId="9e80b397-6e2f-49b1-9374-ccdad8589140" providerId="ADAL" clId="{08EB3AD7-677B-AA4A-90AD-5577AE246557}" dt="2021-08-16T18:12:44.282" v="9681" actId="1037"/>
          <ac:spMkLst>
            <pc:docMk/>
            <pc:sldMk cId="743684689" sldId="267"/>
            <ac:spMk id="6" creationId="{41464C80-B659-484D-A16F-8018DEC5471A}"/>
          </ac:spMkLst>
        </pc:spChg>
        <pc:spChg chg="mod">
          <ac:chgData name="Narang, Sonali" userId="9e80b397-6e2f-49b1-9374-ccdad8589140" providerId="ADAL" clId="{08EB3AD7-677B-AA4A-90AD-5577AE246557}" dt="2021-08-16T18:12:46.692" v="9687" actId="1037"/>
          <ac:spMkLst>
            <pc:docMk/>
            <pc:sldMk cId="743684689" sldId="267"/>
            <ac:spMk id="7" creationId="{4C5F5CAE-FBFD-964D-A356-746AAC86DC9E}"/>
          </ac:spMkLst>
        </pc:spChg>
        <pc:spChg chg="mod">
          <ac:chgData name="Narang, Sonali" userId="9e80b397-6e2f-49b1-9374-ccdad8589140" providerId="ADAL" clId="{08EB3AD7-677B-AA4A-90AD-5577AE246557}" dt="2021-07-09T17:16:09.683" v="4647" actId="1036"/>
          <ac:spMkLst>
            <pc:docMk/>
            <pc:sldMk cId="743684689" sldId="267"/>
            <ac:spMk id="8" creationId="{8A9BAE78-C4FF-1843-94F6-3410EB884848}"/>
          </ac:spMkLst>
        </pc:spChg>
        <pc:spChg chg="add mod">
          <ac:chgData name="Narang, Sonali" userId="9e80b397-6e2f-49b1-9374-ccdad8589140" providerId="ADAL" clId="{08EB3AD7-677B-AA4A-90AD-5577AE246557}" dt="2021-08-17T17:31:43.248" v="10237" actId="1076"/>
          <ac:spMkLst>
            <pc:docMk/>
            <pc:sldMk cId="743684689" sldId="267"/>
            <ac:spMk id="9" creationId="{2395522A-CD93-9340-9E6D-567013DF6E38}"/>
          </ac:spMkLst>
        </pc:spChg>
        <pc:spChg chg="mod">
          <ac:chgData name="Narang, Sonali" userId="9e80b397-6e2f-49b1-9374-ccdad8589140" providerId="ADAL" clId="{08EB3AD7-677B-AA4A-90AD-5577AE246557}" dt="2021-07-09T15:28:58.378" v="3701"/>
          <ac:spMkLst>
            <pc:docMk/>
            <pc:sldMk cId="743684689" sldId="267"/>
            <ac:spMk id="103" creationId="{8F75153E-0955-4D48-916E-7CDFB4050E40}"/>
          </ac:spMkLst>
        </pc:spChg>
        <pc:spChg chg="mod">
          <ac:chgData name="Narang, Sonali" userId="9e80b397-6e2f-49b1-9374-ccdad8589140" providerId="ADAL" clId="{08EB3AD7-677B-AA4A-90AD-5577AE246557}" dt="2021-07-09T15:28:58.378" v="3701"/>
          <ac:spMkLst>
            <pc:docMk/>
            <pc:sldMk cId="743684689" sldId="267"/>
            <ac:spMk id="104" creationId="{6E00B29D-CF7C-8442-99DE-73BC85713ADE}"/>
          </ac:spMkLst>
        </pc:spChg>
        <pc:spChg chg="mod">
          <ac:chgData name="Narang, Sonali" userId="9e80b397-6e2f-49b1-9374-ccdad8589140" providerId="ADAL" clId="{08EB3AD7-677B-AA4A-90AD-5577AE246557}" dt="2021-07-09T16:40:24.504" v="4275"/>
          <ac:spMkLst>
            <pc:docMk/>
            <pc:sldMk cId="743684689" sldId="267"/>
            <ac:spMk id="111" creationId="{F05E3EC8-897C-2842-A5A9-456611C6D89C}"/>
          </ac:spMkLst>
        </pc:spChg>
        <pc:spChg chg="mod">
          <ac:chgData name="Narang, Sonali" userId="9e80b397-6e2f-49b1-9374-ccdad8589140" providerId="ADAL" clId="{08EB3AD7-677B-AA4A-90AD-5577AE246557}" dt="2021-07-09T16:40:24.504" v="4275"/>
          <ac:spMkLst>
            <pc:docMk/>
            <pc:sldMk cId="743684689" sldId="267"/>
            <ac:spMk id="112" creationId="{3A58D88B-E9D6-074B-A313-10BBC0BC5B3B}"/>
          </ac:spMkLst>
        </pc:spChg>
        <pc:spChg chg="mod">
          <ac:chgData name="Narang, Sonali" userId="9e80b397-6e2f-49b1-9374-ccdad8589140" providerId="ADAL" clId="{08EB3AD7-677B-AA4A-90AD-5577AE246557}" dt="2021-07-09T16:40:24.892" v="4276"/>
          <ac:spMkLst>
            <pc:docMk/>
            <pc:sldMk cId="743684689" sldId="267"/>
            <ac:spMk id="115" creationId="{0C8325D4-F321-3E4A-9DBF-946133A365DB}"/>
          </ac:spMkLst>
        </pc:spChg>
        <pc:spChg chg="mod">
          <ac:chgData name="Narang, Sonali" userId="9e80b397-6e2f-49b1-9374-ccdad8589140" providerId="ADAL" clId="{08EB3AD7-677B-AA4A-90AD-5577AE246557}" dt="2021-07-09T16:40:24.892" v="4276"/>
          <ac:spMkLst>
            <pc:docMk/>
            <pc:sldMk cId="743684689" sldId="267"/>
            <ac:spMk id="116" creationId="{3DEB3984-FD30-CB40-9079-F6EDB12688FB}"/>
          </ac:spMkLst>
        </pc:spChg>
        <pc:spChg chg="mod">
          <ac:chgData name="Narang, Sonali" userId="9e80b397-6e2f-49b1-9374-ccdad8589140" providerId="ADAL" clId="{08EB3AD7-677B-AA4A-90AD-5577AE246557}" dt="2021-07-09T17:39:54.076" v="4829" actId="12788"/>
          <ac:spMkLst>
            <pc:docMk/>
            <pc:sldMk cId="743684689" sldId="267"/>
            <ac:spMk id="118" creationId="{C3CF0403-57AD-E940-9D71-A1337FB188ED}"/>
          </ac:spMkLst>
        </pc:spChg>
        <pc:spChg chg="mod">
          <ac:chgData name="Narang, Sonali" userId="9e80b397-6e2f-49b1-9374-ccdad8589140" providerId="ADAL" clId="{08EB3AD7-677B-AA4A-90AD-5577AE246557}" dt="2021-07-09T17:40:03.709" v="4830" actId="12788"/>
          <ac:spMkLst>
            <pc:docMk/>
            <pc:sldMk cId="743684689" sldId="267"/>
            <ac:spMk id="119" creationId="{F96847DC-C3E6-5F43-B748-6197693F0C5F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23" creationId="{621E773B-4B95-674F-AB79-EF48BC6CDAD4}"/>
          </ac:spMkLst>
        </pc:spChg>
        <pc:spChg chg="mod">
          <ac:chgData name="Narang, Sonali" userId="9e80b397-6e2f-49b1-9374-ccdad8589140" providerId="ADAL" clId="{08EB3AD7-677B-AA4A-90AD-5577AE246557}" dt="2021-07-09T16:43:42.620" v="4350" actId="1035"/>
          <ac:spMkLst>
            <pc:docMk/>
            <pc:sldMk cId="743684689" sldId="267"/>
            <ac:spMk id="124" creationId="{2BE84DAC-7C05-C445-9DD3-6B3EE69AFBF9}"/>
          </ac:spMkLst>
        </pc:spChg>
        <pc:spChg chg="mod">
          <ac:chgData name="Narang, Sonali" userId="9e80b397-6e2f-49b1-9374-ccdad8589140" providerId="ADAL" clId="{08EB3AD7-677B-AA4A-90AD-5577AE246557}" dt="2021-07-09T16:44:05.282" v="4352" actId="1076"/>
          <ac:spMkLst>
            <pc:docMk/>
            <pc:sldMk cId="743684689" sldId="267"/>
            <ac:spMk id="125" creationId="{F77578BF-D28B-AC46-B202-F16CA20F451A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26" creationId="{0C98D5E6-37F3-B94F-A94A-957FBD8BC8D8}"/>
          </ac:spMkLst>
        </pc:spChg>
        <pc:spChg chg="mod">
          <ac:chgData name="Narang, Sonali" userId="9e80b397-6e2f-49b1-9374-ccdad8589140" providerId="ADAL" clId="{08EB3AD7-677B-AA4A-90AD-5577AE246557}" dt="2021-07-09T17:39:54.076" v="4829" actId="12788"/>
          <ac:spMkLst>
            <pc:docMk/>
            <pc:sldMk cId="743684689" sldId="267"/>
            <ac:spMk id="127" creationId="{94889990-09DE-4F40-B40A-C999655F9C08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28" creationId="{A6A057D2-5FF7-4149-94F5-B140DE2FABD5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29" creationId="{F119B312-680E-2C4F-B5C8-8938B9E422AB}"/>
          </ac:spMkLst>
        </pc:spChg>
        <pc:spChg chg="mod">
          <ac:chgData name="Narang, Sonali" userId="9e80b397-6e2f-49b1-9374-ccdad8589140" providerId="ADAL" clId="{08EB3AD7-677B-AA4A-90AD-5577AE246557}" dt="2021-07-09T17:40:03.709" v="4830" actId="12788"/>
          <ac:spMkLst>
            <pc:docMk/>
            <pc:sldMk cId="743684689" sldId="267"/>
            <ac:spMk id="130" creationId="{B1493AFF-CA4E-6F4D-A0BA-1B90E4BA8A6E}"/>
          </ac:spMkLst>
        </pc:spChg>
        <pc:spChg chg="mod">
          <ac:chgData name="Narang, Sonali" userId="9e80b397-6e2f-49b1-9374-ccdad8589140" providerId="ADAL" clId="{08EB3AD7-677B-AA4A-90AD-5577AE246557}" dt="2021-07-09T17:39:54.076" v="4829" actId="12788"/>
          <ac:spMkLst>
            <pc:docMk/>
            <pc:sldMk cId="743684689" sldId="267"/>
            <ac:spMk id="132" creationId="{3CD13E06-7D4C-224D-980C-8E0D51122946}"/>
          </ac:spMkLst>
        </pc:spChg>
        <pc:spChg chg="mod">
          <ac:chgData name="Narang, Sonali" userId="9e80b397-6e2f-49b1-9374-ccdad8589140" providerId="ADAL" clId="{08EB3AD7-677B-AA4A-90AD-5577AE246557}" dt="2021-07-09T17:39:40.824" v="4828" actId="20577"/>
          <ac:spMkLst>
            <pc:docMk/>
            <pc:sldMk cId="743684689" sldId="267"/>
            <ac:spMk id="133" creationId="{BB1E1D0F-4EA7-F544-900F-1F4F59DF6703}"/>
          </ac:spMkLst>
        </pc:spChg>
        <pc:spChg chg="mod">
          <ac:chgData name="Narang, Sonali" userId="9e80b397-6e2f-49b1-9374-ccdad8589140" providerId="ADAL" clId="{08EB3AD7-677B-AA4A-90AD-5577AE246557}" dt="2021-07-09T17:39:27.307" v="4822" actId="20577"/>
          <ac:spMkLst>
            <pc:docMk/>
            <pc:sldMk cId="743684689" sldId="267"/>
            <ac:spMk id="134" creationId="{8E520FDD-2A21-874C-BDC8-030D9B94DD72}"/>
          </ac:spMkLst>
        </pc:spChg>
        <pc:spChg chg="mod">
          <ac:chgData name="Narang, Sonali" userId="9e80b397-6e2f-49b1-9374-ccdad8589140" providerId="ADAL" clId="{08EB3AD7-677B-AA4A-90AD-5577AE246557}" dt="2021-07-09T17:39:54.076" v="4829" actId="12788"/>
          <ac:spMkLst>
            <pc:docMk/>
            <pc:sldMk cId="743684689" sldId="267"/>
            <ac:spMk id="135" creationId="{F0695B3C-37EB-364C-B85D-C1CFDFF15F2F}"/>
          </ac:spMkLst>
        </pc:spChg>
        <pc:spChg chg="mod">
          <ac:chgData name="Narang, Sonali" userId="9e80b397-6e2f-49b1-9374-ccdad8589140" providerId="ADAL" clId="{08EB3AD7-677B-AA4A-90AD-5577AE246557}" dt="2021-07-09T17:38:14.032" v="4804" actId="20577"/>
          <ac:spMkLst>
            <pc:docMk/>
            <pc:sldMk cId="743684689" sldId="267"/>
            <ac:spMk id="136" creationId="{7BA734D9-1292-B040-BE44-09C087C7A082}"/>
          </ac:spMkLst>
        </pc:spChg>
        <pc:spChg chg="mod">
          <ac:chgData name="Narang, Sonali" userId="9e80b397-6e2f-49b1-9374-ccdad8589140" providerId="ADAL" clId="{08EB3AD7-677B-AA4A-90AD-5577AE246557}" dt="2021-07-09T17:38:23.746" v="4810" actId="20577"/>
          <ac:spMkLst>
            <pc:docMk/>
            <pc:sldMk cId="743684689" sldId="267"/>
            <ac:spMk id="137" creationId="{72728502-C49A-1D4E-8A34-7FA18ED858C4}"/>
          </ac:spMkLst>
        </pc:spChg>
        <pc:spChg chg="mod">
          <ac:chgData name="Narang, Sonali" userId="9e80b397-6e2f-49b1-9374-ccdad8589140" providerId="ADAL" clId="{08EB3AD7-677B-AA4A-90AD-5577AE246557}" dt="2021-07-09T17:39:54.076" v="4829" actId="12788"/>
          <ac:spMkLst>
            <pc:docMk/>
            <pc:sldMk cId="743684689" sldId="267"/>
            <ac:spMk id="138" creationId="{AC1F1303-B8E9-4D48-B01F-9715C278E40D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39" creationId="{5F5D34B7-9211-A24D-86FE-1AA2CE828CDB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40" creationId="{BB59C36B-03AF-B944-9655-17F26C6A722B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41" creationId="{A1C7852E-A1F3-5440-9C5F-CABED7B457DF}"/>
          </ac:spMkLst>
        </pc:spChg>
        <pc:spChg chg="mod">
          <ac:chgData name="Narang, Sonali" userId="9e80b397-6e2f-49b1-9374-ccdad8589140" providerId="ADAL" clId="{08EB3AD7-677B-AA4A-90AD-5577AE246557}" dt="2021-07-09T17:40:03.709" v="4830" actId="12788"/>
          <ac:spMkLst>
            <pc:docMk/>
            <pc:sldMk cId="743684689" sldId="267"/>
            <ac:spMk id="143" creationId="{CDB74C8A-8DFE-7246-A4E5-82AC375D6524}"/>
          </ac:spMkLst>
        </pc:spChg>
        <pc:spChg chg="mod">
          <ac:chgData name="Narang, Sonali" userId="9e80b397-6e2f-49b1-9374-ccdad8589140" providerId="ADAL" clId="{08EB3AD7-677B-AA4A-90AD-5577AE246557}" dt="2021-07-09T17:36:47.311" v="4741" actId="20577"/>
          <ac:spMkLst>
            <pc:docMk/>
            <pc:sldMk cId="743684689" sldId="267"/>
            <ac:spMk id="144" creationId="{563E4695-FACC-A643-BBE8-1CC93B44D1BA}"/>
          </ac:spMkLst>
        </pc:spChg>
        <pc:spChg chg="mod">
          <ac:chgData name="Narang, Sonali" userId="9e80b397-6e2f-49b1-9374-ccdad8589140" providerId="ADAL" clId="{08EB3AD7-677B-AA4A-90AD-5577AE246557}" dt="2021-07-09T17:36:12.961" v="4733" actId="20577"/>
          <ac:spMkLst>
            <pc:docMk/>
            <pc:sldMk cId="743684689" sldId="267"/>
            <ac:spMk id="145" creationId="{D890D106-88F0-AD48-A6DD-50F067183F9D}"/>
          </ac:spMkLst>
        </pc:spChg>
        <pc:spChg chg="mod">
          <ac:chgData name="Narang, Sonali" userId="9e80b397-6e2f-49b1-9374-ccdad8589140" providerId="ADAL" clId="{08EB3AD7-677B-AA4A-90AD-5577AE246557}" dt="2021-07-09T17:40:03.709" v="4830" actId="12788"/>
          <ac:spMkLst>
            <pc:docMk/>
            <pc:sldMk cId="743684689" sldId="267"/>
            <ac:spMk id="146" creationId="{E2932365-5FC6-AA44-B04E-AE3D6664BA4E}"/>
          </ac:spMkLst>
        </pc:spChg>
        <pc:spChg chg="mod">
          <ac:chgData name="Narang, Sonali" userId="9e80b397-6e2f-49b1-9374-ccdad8589140" providerId="ADAL" clId="{08EB3AD7-677B-AA4A-90AD-5577AE246557}" dt="2021-07-09T17:35:37.025" v="4717" actId="20577"/>
          <ac:spMkLst>
            <pc:docMk/>
            <pc:sldMk cId="743684689" sldId="267"/>
            <ac:spMk id="147" creationId="{9A109801-764A-424C-A341-23242F15F561}"/>
          </ac:spMkLst>
        </pc:spChg>
        <pc:spChg chg="mod">
          <ac:chgData name="Narang, Sonali" userId="9e80b397-6e2f-49b1-9374-ccdad8589140" providerId="ADAL" clId="{08EB3AD7-677B-AA4A-90AD-5577AE246557}" dt="2021-07-09T17:35:44.512" v="4720" actId="20577"/>
          <ac:spMkLst>
            <pc:docMk/>
            <pc:sldMk cId="743684689" sldId="267"/>
            <ac:spMk id="148" creationId="{EA11B04E-C8FF-4842-9F12-E83E6092CA91}"/>
          </ac:spMkLst>
        </pc:spChg>
        <pc:spChg chg="mod">
          <ac:chgData name="Narang, Sonali" userId="9e80b397-6e2f-49b1-9374-ccdad8589140" providerId="ADAL" clId="{08EB3AD7-677B-AA4A-90AD-5577AE246557}" dt="2021-07-09T17:40:03.709" v="4830" actId="12788"/>
          <ac:spMkLst>
            <pc:docMk/>
            <pc:sldMk cId="743684689" sldId="267"/>
            <ac:spMk id="149" creationId="{D8349D72-B0AA-8340-BEDB-964FDDBD372D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50" creationId="{FBE03226-AE8E-AF42-8BBD-E1FDA5B497F8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51" creationId="{0CBB35CC-33A4-0B4F-870C-2374E6EF5CB8}"/>
          </ac:spMkLst>
        </pc:spChg>
        <pc:spChg chg="mod">
          <ac:chgData name="Narang, Sonali" userId="9e80b397-6e2f-49b1-9374-ccdad8589140" providerId="ADAL" clId="{08EB3AD7-677B-AA4A-90AD-5577AE246557}" dt="2021-07-09T16:43:09.880" v="4336"/>
          <ac:spMkLst>
            <pc:docMk/>
            <pc:sldMk cId="743684689" sldId="267"/>
            <ac:spMk id="152" creationId="{76912FDE-67EB-554E-B5D2-687F992A13CE}"/>
          </ac:spMkLst>
        </pc:spChg>
        <pc:spChg chg="add mod">
          <ac:chgData name="Narang, Sonali" userId="9e80b397-6e2f-49b1-9374-ccdad8589140" providerId="ADAL" clId="{08EB3AD7-677B-AA4A-90AD-5577AE246557}" dt="2021-07-09T16:44:33.829" v="4361" actId="20577"/>
          <ac:spMkLst>
            <pc:docMk/>
            <pc:sldMk cId="743684689" sldId="267"/>
            <ac:spMk id="153" creationId="{42BD9612-09AD-BC49-A911-D0B444BC90EF}"/>
          </ac:spMkLst>
        </pc:spChg>
        <pc:spChg chg="add mod">
          <ac:chgData name="Narang, Sonali" userId="9e80b397-6e2f-49b1-9374-ccdad8589140" providerId="ADAL" clId="{08EB3AD7-677B-AA4A-90AD-5577AE246557}" dt="2021-07-09T17:16:58.416" v="4661" actId="20577"/>
          <ac:spMkLst>
            <pc:docMk/>
            <pc:sldMk cId="743684689" sldId="267"/>
            <ac:spMk id="154" creationId="{12466E3D-96F0-1147-A8D5-E41BDDDE3141}"/>
          </ac:spMkLst>
        </pc:spChg>
        <pc:spChg chg="add mod">
          <ac:chgData name="Narang, Sonali" userId="9e80b397-6e2f-49b1-9374-ccdad8589140" providerId="ADAL" clId="{08EB3AD7-677B-AA4A-90AD-5577AE246557}" dt="2021-07-09T17:16:55.484" v="4657" actId="20577"/>
          <ac:spMkLst>
            <pc:docMk/>
            <pc:sldMk cId="743684689" sldId="267"/>
            <ac:spMk id="155" creationId="{A41771F1-4833-2A41-857A-45FD2362FFD8}"/>
          </ac:spMkLst>
        </pc:spChg>
        <pc:spChg chg="add mod">
          <ac:chgData name="Narang, Sonali" userId="9e80b397-6e2f-49b1-9374-ccdad8589140" providerId="ADAL" clId="{08EB3AD7-677B-AA4A-90AD-5577AE246557}" dt="2021-07-09T17:17:11.726" v="4674" actId="20577"/>
          <ac:spMkLst>
            <pc:docMk/>
            <pc:sldMk cId="743684689" sldId="267"/>
            <ac:spMk id="156" creationId="{13F57F0A-976D-E44E-91DF-1D0D9A74C9A1}"/>
          </ac:spMkLst>
        </pc:spChg>
        <pc:spChg chg="add mod">
          <ac:chgData name="Narang, Sonali" userId="9e80b397-6e2f-49b1-9374-ccdad8589140" providerId="ADAL" clId="{08EB3AD7-677B-AA4A-90AD-5577AE246557}" dt="2021-07-09T17:17:07.948" v="4668" actId="20577"/>
          <ac:spMkLst>
            <pc:docMk/>
            <pc:sldMk cId="743684689" sldId="267"/>
            <ac:spMk id="157" creationId="{2F58EB7B-74DF-024F-B99E-B97D3491C4D9}"/>
          </ac:spMkLst>
        </pc:spChg>
        <pc:spChg chg="add mod">
          <ac:chgData name="Narang, Sonali" userId="9e80b397-6e2f-49b1-9374-ccdad8589140" providerId="ADAL" clId="{08EB3AD7-677B-AA4A-90AD-5577AE246557}" dt="2021-07-09T17:17:28.451" v="4694" actId="1038"/>
          <ac:spMkLst>
            <pc:docMk/>
            <pc:sldMk cId="743684689" sldId="267"/>
            <ac:spMk id="158" creationId="{552E2A6E-C6EB-8340-B84D-3139C3B59F3C}"/>
          </ac:spMkLst>
        </pc:spChg>
        <pc:spChg chg="add mod">
          <ac:chgData name="Narang, Sonali" userId="9e80b397-6e2f-49b1-9374-ccdad8589140" providerId="ADAL" clId="{08EB3AD7-677B-AA4A-90AD-5577AE246557}" dt="2021-07-09T17:17:20.033" v="4681" actId="20577"/>
          <ac:spMkLst>
            <pc:docMk/>
            <pc:sldMk cId="743684689" sldId="267"/>
            <ac:spMk id="159" creationId="{93093DBD-5CBD-EB47-A02E-ABFB0D272C54}"/>
          </ac:spMkLst>
        </pc:spChg>
        <pc:spChg chg="add del mod">
          <ac:chgData name="Narang, Sonali" userId="9e80b397-6e2f-49b1-9374-ccdad8589140" providerId="ADAL" clId="{08EB3AD7-677B-AA4A-90AD-5577AE246557}" dt="2021-08-17T17:29:57.987" v="10171" actId="478"/>
          <ac:spMkLst>
            <pc:docMk/>
            <pc:sldMk cId="743684689" sldId="267"/>
            <ac:spMk id="172" creationId="{3DC25CA3-3169-F044-BB17-9BCC3A1FCC02}"/>
          </ac:spMkLst>
        </pc:spChg>
        <pc:spChg chg="add del mod">
          <ac:chgData name="Narang, Sonali" userId="9e80b397-6e2f-49b1-9374-ccdad8589140" providerId="ADAL" clId="{08EB3AD7-677B-AA4A-90AD-5577AE246557}" dt="2021-07-12T15:55:09.599" v="6909" actId="478"/>
          <ac:spMkLst>
            <pc:docMk/>
            <pc:sldMk cId="743684689" sldId="267"/>
            <ac:spMk id="173" creationId="{173173B7-6583-1047-95B6-D51CBB3E2663}"/>
          </ac:spMkLst>
        </pc:spChg>
        <pc:spChg chg="add del mod">
          <ac:chgData name="Narang, Sonali" userId="9e80b397-6e2f-49b1-9374-ccdad8589140" providerId="ADAL" clId="{08EB3AD7-677B-AA4A-90AD-5577AE246557}" dt="2021-07-12T18:54:46.724" v="7133" actId="21"/>
          <ac:spMkLst>
            <pc:docMk/>
            <pc:sldMk cId="743684689" sldId="267"/>
            <ac:spMk id="174" creationId="{FDC21ECC-9DFC-CF4B-86CB-6EE5614213EB}"/>
          </ac:spMkLst>
        </pc:spChg>
        <pc:spChg chg="add mod">
          <ac:chgData name="Narang, Sonali" userId="9e80b397-6e2f-49b1-9374-ccdad8589140" providerId="ADAL" clId="{08EB3AD7-677B-AA4A-90AD-5577AE246557}" dt="2021-08-16T22:06:45.111" v="10159" actId="1076"/>
          <ac:spMkLst>
            <pc:docMk/>
            <pc:sldMk cId="743684689" sldId="267"/>
            <ac:spMk id="175" creationId="{6DB4CC1F-44E0-784A-8E95-0054829DDB67}"/>
          </ac:spMkLst>
        </pc:spChg>
        <pc:spChg chg="add mod">
          <ac:chgData name="Narang, Sonali" userId="9e80b397-6e2f-49b1-9374-ccdad8589140" providerId="ADAL" clId="{08EB3AD7-677B-AA4A-90AD-5577AE246557}" dt="2021-08-16T22:06:44.604" v="10158" actId="1076"/>
          <ac:spMkLst>
            <pc:docMk/>
            <pc:sldMk cId="743684689" sldId="267"/>
            <ac:spMk id="176" creationId="{9FA30454-C308-294C-8E43-A31F1FDCB395}"/>
          </ac:spMkLst>
        </pc:spChg>
        <pc:grpChg chg="add mod">
          <ac:chgData name="Narang, Sonali" userId="9e80b397-6e2f-49b1-9374-ccdad8589140" providerId="ADAL" clId="{08EB3AD7-677B-AA4A-90AD-5577AE246557}" dt="2021-07-09T17:16:09.683" v="4647" actId="1036"/>
          <ac:grpSpMkLst>
            <pc:docMk/>
            <pc:sldMk cId="743684689" sldId="267"/>
            <ac:grpSpMk id="28" creationId="{93914C90-1944-5F48-8DBD-1C5C8C5416FC}"/>
          </ac:grpSpMkLst>
        </pc:grpChg>
        <pc:grpChg chg="add mod">
          <ac:chgData name="Narang, Sonali" userId="9e80b397-6e2f-49b1-9374-ccdad8589140" providerId="ADAL" clId="{08EB3AD7-677B-AA4A-90AD-5577AE246557}" dt="2021-07-09T17:16:09.683" v="4647" actId="1036"/>
          <ac:grpSpMkLst>
            <pc:docMk/>
            <pc:sldMk cId="743684689" sldId="267"/>
            <ac:grpSpMk id="79" creationId="{ECB34D7D-4B4C-0247-A1C3-B0B54BCB2CB6}"/>
          </ac:grpSpMkLst>
        </pc:grpChg>
        <pc:grpChg chg="add mod">
          <ac:chgData name="Narang, Sonali" userId="9e80b397-6e2f-49b1-9374-ccdad8589140" providerId="ADAL" clId="{08EB3AD7-677B-AA4A-90AD-5577AE246557}" dt="2021-07-09T17:16:09.683" v="4647" actId="1036"/>
          <ac:grpSpMkLst>
            <pc:docMk/>
            <pc:sldMk cId="743684689" sldId="267"/>
            <ac:grpSpMk id="80" creationId="{65CB00CD-5C89-6D44-9656-518239B36C6F}"/>
          </ac:grpSpMkLst>
        </pc:grpChg>
        <pc:grpChg chg="del">
          <ac:chgData name="Narang, Sonali" userId="9e80b397-6e2f-49b1-9374-ccdad8589140" providerId="ADAL" clId="{08EB3AD7-677B-AA4A-90AD-5577AE246557}" dt="2021-07-09T14:53:17.479" v="3483" actId="478"/>
          <ac:grpSpMkLst>
            <pc:docMk/>
            <pc:sldMk cId="743684689" sldId="267"/>
            <ac:grpSpMk id="88" creationId="{A4E9B41A-8165-364E-884A-1587E27CF457}"/>
          </ac:grpSpMkLst>
        </pc:grpChg>
        <pc:grpChg chg="del">
          <ac:chgData name="Narang, Sonali" userId="9e80b397-6e2f-49b1-9374-ccdad8589140" providerId="ADAL" clId="{08EB3AD7-677B-AA4A-90AD-5577AE246557}" dt="2021-07-09T14:53:15.640" v="3482" actId="478"/>
          <ac:grpSpMkLst>
            <pc:docMk/>
            <pc:sldMk cId="743684689" sldId="267"/>
            <ac:grpSpMk id="95" creationId="{80FFA08A-7312-C64B-8FAB-26EA18CA62C3}"/>
          </ac:grpSpMkLst>
        </pc:grpChg>
        <pc:grpChg chg="add del mod">
          <ac:chgData name="Narang, Sonali" userId="9e80b397-6e2f-49b1-9374-ccdad8589140" providerId="ADAL" clId="{08EB3AD7-677B-AA4A-90AD-5577AE246557}" dt="2021-07-09T17:11:08.215" v="4479" actId="478"/>
          <ac:grpSpMkLst>
            <pc:docMk/>
            <pc:sldMk cId="743684689" sldId="267"/>
            <ac:grpSpMk id="101" creationId="{84E5883C-09A2-364E-9FD2-9ECB9D50C2D9}"/>
          </ac:grpSpMkLst>
        </pc:grpChg>
        <pc:grpChg chg="add del mod">
          <ac:chgData name="Narang, Sonali" userId="9e80b397-6e2f-49b1-9374-ccdad8589140" providerId="ADAL" clId="{08EB3AD7-677B-AA4A-90AD-5577AE246557}" dt="2021-07-09T17:11:08.215" v="4479" actId="478"/>
          <ac:grpSpMkLst>
            <pc:docMk/>
            <pc:sldMk cId="743684689" sldId="267"/>
            <ac:grpSpMk id="109" creationId="{6109E3E9-9FC0-6145-B932-D92FCA129516}"/>
          </ac:grpSpMkLst>
        </pc:grpChg>
        <pc:grpChg chg="add del mod">
          <ac:chgData name="Narang, Sonali" userId="9e80b397-6e2f-49b1-9374-ccdad8589140" providerId="ADAL" clId="{08EB3AD7-677B-AA4A-90AD-5577AE246557}" dt="2021-07-09T17:11:08.215" v="4479" actId="478"/>
          <ac:grpSpMkLst>
            <pc:docMk/>
            <pc:sldMk cId="743684689" sldId="267"/>
            <ac:grpSpMk id="113" creationId="{C7B7A058-AA7A-134B-8643-DC4AF62E31C8}"/>
          </ac:grpSpMkLst>
        </pc:grpChg>
        <pc:grpChg chg="add mod">
          <ac:chgData name="Narang, Sonali" userId="9e80b397-6e2f-49b1-9374-ccdad8589140" providerId="ADAL" clId="{08EB3AD7-677B-AA4A-90AD-5577AE246557}" dt="2021-07-09T17:02:25.165" v="4470" actId="1076"/>
          <ac:grpSpMkLst>
            <pc:docMk/>
            <pc:sldMk cId="743684689" sldId="267"/>
            <ac:grpSpMk id="117" creationId="{B05B94FA-BBA9-A64D-8CA4-F0D3B7616FE1}"/>
          </ac:grpSpMkLst>
        </pc:grpChg>
        <pc:grpChg chg="mod">
          <ac:chgData name="Narang, Sonali" userId="9e80b397-6e2f-49b1-9374-ccdad8589140" providerId="ADAL" clId="{08EB3AD7-677B-AA4A-90AD-5577AE246557}" dt="2021-07-09T16:43:09.880" v="4336"/>
          <ac:grpSpMkLst>
            <pc:docMk/>
            <pc:sldMk cId="743684689" sldId="267"/>
            <ac:grpSpMk id="120" creationId="{C7A0A53E-6C94-2B45-B2FC-28B94995A2B0}"/>
          </ac:grpSpMkLst>
        </pc:grpChg>
        <pc:grpChg chg="del mod">
          <ac:chgData name="Narang, Sonali" userId="9e80b397-6e2f-49b1-9374-ccdad8589140" providerId="ADAL" clId="{08EB3AD7-677B-AA4A-90AD-5577AE246557}" dt="2021-07-09T14:53:15.640" v="3482" actId="478"/>
          <ac:grpSpMkLst>
            <pc:docMk/>
            <pc:sldMk cId="743684689" sldId="267"/>
            <ac:grpSpMk id="121" creationId="{D382BF2F-F6F7-0546-8A3A-3F285CDE1EF7}"/>
          </ac:grpSpMkLst>
        </pc:grpChg>
        <pc:grpChg chg="mod">
          <ac:chgData name="Narang, Sonali" userId="9e80b397-6e2f-49b1-9374-ccdad8589140" providerId="ADAL" clId="{08EB3AD7-677B-AA4A-90AD-5577AE246557}" dt="2021-07-09T16:43:09.880" v="4336"/>
          <ac:grpSpMkLst>
            <pc:docMk/>
            <pc:sldMk cId="743684689" sldId="267"/>
            <ac:grpSpMk id="122" creationId="{4781E364-BD05-7144-B954-37AD5DE3C8E4}"/>
          </ac:grpSpMkLst>
        </pc:grpChg>
        <pc:grpChg chg="mod">
          <ac:chgData name="Narang, Sonali" userId="9e80b397-6e2f-49b1-9374-ccdad8589140" providerId="ADAL" clId="{08EB3AD7-677B-AA4A-90AD-5577AE246557}" dt="2021-07-09T16:43:09.880" v="4336"/>
          <ac:grpSpMkLst>
            <pc:docMk/>
            <pc:sldMk cId="743684689" sldId="267"/>
            <ac:grpSpMk id="131" creationId="{DDA3E6E9-5AB7-4D4F-89F3-C74A093B01CD}"/>
          </ac:grpSpMkLst>
        </pc:grpChg>
        <pc:grpChg chg="mod">
          <ac:chgData name="Narang, Sonali" userId="9e80b397-6e2f-49b1-9374-ccdad8589140" providerId="ADAL" clId="{08EB3AD7-677B-AA4A-90AD-5577AE246557}" dt="2021-07-09T16:43:09.880" v="4336"/>
          <ac:grpSpMkLst>
            <pc:docMk/>
            <pc:sldMk cId="743684689" sldId="267"/>
            <ac:grpSpMk id="142" creationId="{E1D76884-114D-384D-B006-E9035BFAFF23}"/>
          </ac:grpSpMkLst>
        </pc:grpChg>
        <pc:picChg chg="add mod">
          <ac:chgData name="Narang, Sonali" userId="9e80b397-6e2f-49b1-9374-ccdad8589140" providerId="ADAL" clId="{08EB3AD7-677B-AA4A-90AD-5577AE246557}" dt="2021-07-09T17:15:05.396" v="4624" actId="1036"/>
          <ac:picMkLst>
            <pc:docMk/>
            <pc:sldMk cId="743684689" sldId="267"/>
            <ac:picMk id="3" creationId="{E5B348BC-38F3-B749-A9C7-3DD0ADAED608}"/>
          </ac:picMkLst>
        </pc:picChg>
        <pc:picChg chg="add mod">
          <ac:chgData name="Narang, Sonali" userId="9e80b397-6e2f-49b1-9374-ccdad8589140" providerId="ADAL" clId="{08EB3AD7-677B-AA4A-90AD-5577AE246557}" dt="2021-07-09T17:15:05.396" v="4624" actId="1036"/>
          <ac:picMkLst>
            <pc:docMk/>
            <pc:sldMk cId="743684689" sldId="267"/>
            <ac:picMk id="10" creationId="{66154BB9-FD0B-DC42-ACFF-EF6790A445B6}"/>
          </ac:picMkLst>
        </pc:picChg>
        <pc:picChg chg="add mod">
          <ac:chgData name="Narang, Sonali" userId="9e80b397-6e2f-49b1-9374-ccdad8589140" providerId="ADAL" clId="{08EB3AD7-677B-AA4A-90AD-5577AE246557}" dt="2021-07-09T17:15:05.396" v="4624" actId="1036"/>
          <ac:picMkLst>
            <pc:docMk/>
            <pc:sldMk cId="743684689" sldId="267"/>
            <ac:picMk id="23" creationId="{FDFC2BCD-7568-3543-98D3-DAC26CA57430}"/>
          </ac:picMkLst>
        </pc:picChg>
        <pc:picChg chg="add mod">
          <ac:chgData name="Narang, Sonali" userId="9e80b397-6e2f-49b1-9374-ccdad8589140" providerId="ADAL" clId="{08EB3AD7-677B-AA4A-90AD-5577AE246557}" dt="2021-08-17T17:30:03.674" v="10173" actId="1076"/>
          <ac:picMkLst>
            <pc:docMk/>
            <pc:sldMk cId="743684689" sldId="267"/>
            <ac:picMk id="63" creationId="{F2221C12-094C-AD43-99ED-F4C4EE93B505}"/>
          </ac:picMkLst>
        </pc:picChg>
        <pc:picChg chg="add del mod">
          <ac:chgData name="Narang, Sonali" userId="9e80b397-6e2f-49b1-9374-ccdad8589140" providerId="ADAL" clId="{08EB3AD7-677B-AA4A-90AD-5577AE246557}" dt="2021-07-09T19:44:46.879" v="4844" actId="478"/>
          <ac:picMkLst>
            <pc:docMk/>
            <pc:sldMk cId="743684689" sldId="267"/>
            <ac:picMk id="82" creationId="{3ABFBB90-B81D-C946-8D0E-22DD7E7FFB9B}"/>
          </ac:picMkLst>
        </pc:picChg>
        <pc:picChg chg="add del mod">
          <ac:chgData name="Narang, Sonali" userId="9e80b397-6e2f-49b1-9374-ccdad8589140" providerId="ADAL" clId="{08EB3AD7-677B-AA4A-90AD-5577AE246557}" dt="2021-07-09T19:44:46.879" v="4844" actId="478"/>
          <ac:picMkLst>
            <pc:docMk/>
            <pc:sldMk cId="743684689" sldId="267"/>
            <ac:picMk id="84" creationId="{79F09566-DC23-BB47-98D6-0D222039A29E}"/>
          </ac:picMkLst>
        </pc:picChg>
        <pc:picChg chg="add del mod">
          <ac:chgData name="Narang, Sonali" userId="9e80b397-6e2f-49b1-9374-ccdad8589140" providerId="ADAL" clId="{08EB3AD7-677B-AA4A-90AD-5577AE246557}" dt="2021-07-09T19:44:46.879" v="4844" actId="478"/>
          <ac:picMkLst>
            <pc:docMk/>
            <pc:sldMk cId="743684689" sldId="267"/>
            <ac:picMk id="86" creationId="{20CC7E1F-A143-144D-9010-9F0DC3123785}"/>
          </ac:picMkLst>
        </pc:picChg>
        <pc:picChg chg="del">
          <ac:chgData name="Narang, Sonali" userId="9e80b397-6e2f-49b1-9374-ccdad8589140" providerId="ADAL" clId="{08EB3AD7-677B-AA4A-90AD-5577AE246557}" dt="2021-07-09T14:53:17.479" v="3483" actId="478"/>
          <ac:picMkLst>
            <pc:docMk/>
            <pc:sldMk cId="743684689" sldId="267"/>
            <ac:picMk id="87" creationId="{02F82FA8-7001-8D42-9132-F91F2D6877B2}"/>
          </ac:picMkLst>
        </pc:picChg>
        <pc:picChg chg="del">
          <ac:chgData name="Narang, Sonali" userId="9e80b397-6e2f-49b1-9374-ccdad8589140" providerId="ADAL" clId="{08EB3AD7-677B-AA4A-90AD-5577AE246557}" dt="2021-07-09T14:53:17.479" v="3483" actId="478"/>
          <ac:picMkLst>
            <pc:docMk/>
            <pc:sldMk cId="743684689" sldId="267"/>
            <ac:picMk id="94" creationId="{A58B8D7A-8B3E-0145-8E98-9AA02E1ED52C}"/>
          </ac:picMkLst>
        </pc:picChg>
        <pc:picChg chg="add mod">
          <ac:chgData name="Narang, Sonali" userId="9e80b397-6e2f-49b1-9374-ccdad8589140" providerId="ADAL" clId="{08EB3AD7-677B-AA4A-90AD-5577AE246557}" dt="2021-08-16T18:12:53.824" v="9690" actId="14100"/>
          <ac:picMkLst>
            <pc:docMk/>
            <pc:sldMk cId="743684689" sldId="267"/>
            <ac:picMk id="99" creationId="{D6F82ACC-3C2B-E44A-8008-570B303FD297}"/>
          </ac:picMkLst>
        </pc:picChg>
        <pc:picChg chg="add del mod">
          <ac:chgData name="Narang, Sonali" userId="9e80b397-6e2f-49b1-9374-ccdad8589140" providerId="ADAL" clId="{08EB3AD7-677B-AA4A-90AD-5577AE246557}" dt="2021-07-09T19:35:32.959" v="4842" actId="478"/>
          <ac:picMkLst>
            <pc:docMk/>
            <pc:sldMk cId="743684689" sldId="267"/>
            <ac:picMk id="100" creationId="{C7750BD0-4FAB-ED4D-BE21-4557E5BB5E79}"/>
          </ac:picMkLst>
        </pc:picChg>
        <pc:picChg chg="mod">
          <ac:chgData name="Narang, Sonali" userId="9e80b397-6e2f-49b1-9374-ccdad8589140" providerId="ADAL" clId="{08EB3AD7-677B-AA4A-90AD-5577AE246557}" dt="2021-07-09T15:28:58.378" v="3701"/>
          <ac:picMkLst>
            <pc:docMk/>
            <pc:sldMk cId="743684689" sldId="267"/>
            <ac:picMk id="102" creationId="{0DB1C8B7-E0DB-9F4C-94B2-F623241FFC17}"/>
          </ac:picMkLst>
        </pc:picChg>
        <pc:picChg chg="add mod">
          <ac:chgData name="Narang, Sonali" userId="9e80b397-6e2f-49b1-9374-ccdad8589140" providerId="ADAL" clId="{08EB3AD7-677B-AA4A-90AD-5577AE246557}" dt="2021-08-16T18:12:39.349" v="9670" actId="1076"/>
          <ac:picMkLst>
            <pc:docMk/>
            <pc:sldMk cId="743684689" sldId="267"/>
            <ac:picMk id="105" creationId="{97BF178D-FAD3-E44E-B50E-E66B7B262246}"/>
          </ac:picMkLst>
        </pc:picChg>
        <pc:picChg chg="add del mod">
          <ac:chgData name="Narang, Sonali" userId="9e80b397-6e2f-49b1-9374-ccdad8589140" providerId="ADAL" clId="{08EB3AD7-677B-AA4A-90AD-5577AE246557}" dt="2021-07-12T18:42:56.156" v="7105" actId="478"/>
          <ac:picMkLst>
            <pc:docMk/>
            <pc:sldMk cId="743684689" sldId="267"/>
            <ac:picMk id="106" creationId="{592C5E4C-7D59-714A-B688-CECF7993B597}"/>
          </ac:picMkLst>
        </pc:picChg>
        <pc:picChg chg="add del mod">
          <ac:chgData name="Narang, Sonali" userId="9e80b397-6e2f-49b1-9374-ccdad8589140" providerId="ADAL" clId="{08EB3AD7-677B-AA4A-90AD-5577AE246557}" dt="2021-07-09T19:35:32.959" v="4842" actId="478"/>
          <ac:picMkLst>
            <pc:docMk/>
            <pc:sldMk cId="743684689" sldId="267"/>
            <ac:picMk id="107" creationId="{9AED350D-6828-6F4A-AEC3-C0EA889CCA7B}"/>
          </ac:picMkLst>
        </pc:picChg>
        <pc:picChg chg="add del mod">
          <ac:chgData name="Narang, Sonali" userId="9e80b397-6e2f-49b1-9374-ccdad8589140" providerId="ADAL" clId="{08EB3AD7-677B-AA4A-90AD-5577AE246557}" dt="2021-07-09T19:35:32.959" v="4842" actId="478"/>
          <ac:picMkLst>
            <pc:docMk/>
            <pc:sldMk cId="743684689" sldId="267"/>
            <ac:picMk id="108" creationId="{D9E21E11-5D4A-0747-BA1B-068CEA77BF5C}"/>
          </ac:picMkLst>
        </pc:picChg>
        <pc:picChg chg="mod">
          <ac:chgData name="Narang, Sonali" userId="9e80b397-6e2f-49b1-9374-ccdad8589140" providerId="ADAL" clId="{08EB3AD7-677B-AA4A-90AD-5577AE246557}" dt="2021-07-09T16:40:24.504" v="4275"/>
          <ac:picMkLst>
            <pc:docMk/>
            <pc:sldMk cId="743684689" sldId="267"/>
            <ac:picMk id="110" creationId="{11577677-59D5-3A4B-869E-7A454BD68A8C}"/>
          </ac:picMkLst>
        </pc:picChg>
        <pc:picChg chg="mod">
          <ac:chgData name="Narang, Sonali" userId="9e80b397-6e2f-49b1-9374-ccdad8589140" providerId="ADAL" clId="{08EB3AD7-677B-AA4A-90AD-5577AE246557}" dt="2021-07-09T16:40:24.892" v="4276"/>
          <ac:picMkLst>
            <pc:docMk/>
            <pc:sldMk cId="743684689" sldId="267"/>
            <ac:picMk id="114" creationId="{FCC4BE08-2C48-8848-80D0-7EC673FCD84D}"/>
          </ac:picMkLst>
        </pc:picChg>
        <pc:picChg chg="add del mod">
          <ac:chgData name="Narang, Sonali" userId="9e80b397-6e2f-49b1-9374-ccdad8589140" providerId="ADAL" clId="{08EB3AD7-677B-AA4A-90AD-5577AE246557}" dt="2021-07-09T19:45:06.920" v="4851" actId="478"/>
          <ac:picMkLst>
            <pc:docMk/>
            <pc:sldMk cId="743684689" sldId="267"/>
            <ac:picMk id="161" creationId="{E63A9F06-5488-FD4D-B64B-78B6BBFE2E86}"/>
          </ac:picMkLst>
        </pc:picChg>
        <pc:picChg chg="add del mod">
          <ac:chgData name="Narang, Sonali" userId="9e80b397-6e2f-49b1-9374-ccdad8589140" providerId="ADAL" clId="{08EB3AD7-677B-AA4A-90AD-5577AE246557}" dt="2021-07-09T19:45:32.340" v="4852" actId="478"/>
          <ac:picMkLst>
            <pc:docMk/>
            <pc:sldMk cId="743684689" sldId="267"/>
            <ac:picMk id="163" creationId="{439489CC-E67B-964F-BEDC-A1671A29FF20}"/>
          </ac:picMkLst>
        </pc:picChg>
        <pc:picChg chg="add del mod">
          <ac:chgData name="Narang, Sonali" userId="9e80b397-6e2f-49b1-9374-ccdad8589140" providerId="ADAL" clId="{08EB3AD7-677B-AA4A-90AD-5577AE246557}" dt="2021-07-09T19:45:32.340" v="4852" actId="478"/>
          <ac:picMkLst>
            <pc:docMk/>
            <pc:sldMk cId="743684689" sldId="267"/>
            <ac:picMk id="165" creationId="{7DCEBEC4-3F89-CC46-A6F0-2A1302DA63B4}"/>
          </ac:picMkLst>
        </pc:picChg>
        <pc:picChg chg="add mod">
          <ac:chgData name="Narang, Sonali" userId="9e80b397-6e2f-49b1-9374-ccdad8589140" providerId="ADAL" clId="{08EB3AD7-677B-AA4A-90AD-5577AE246557}" dt="2021-08-17T17:30:19.445" v="10175" actId="1076"/>
          <ac:picMkLst>
            <pc:docMk/>
            <pc:sldMk cId="743684689" sldId="267"/>
            <ac:picMk id="167" creationId="{58CAA980-D1E6-AA4C-A334-C0D57A74D895}"/>
          </ac:picMkLst>
        </pc:picChg>
        <pc:picChg chg="add mod">
          <ac:chgData name="Narang, Sonali" userId="9e80b397-6e2f-49b1-9374-ccdad8589140" providerId="ADAL" clId="{08EB3AD7-677B-AA4A-90AD-5577AE246557}" dt="2021-08-16T18:12:18.574" v="9667" actId="1038"/>
          <ac:picMkLst>
            <pc:docMk/>
            <pc:sldMk cId="743684689" sldId="267"/>
            <ac:picMk id="169" creationId="{5A30999A-89D7-8C40-9571-87F0979C7EAA}"/>
          </ac:picMkLst>
        </pc:picChg>
        <pc:picChg chg="add mod">
          <ac:chgData name="Narang, Sonali" userId="9e80b397-6e2f-49b1-9374-ccdad8589140" providerId="ADAL" clId="{08EB3AD7-677B-AA4A-90AD-5577AE246557}" dt="2021-08-16T18:12:18.574" v="9667" actId="1038"/>
          <ac:picMkLst>
            <pc:docMk/>
            <pc:sldMk cId="743684689" sldId="267"/>
            <ac:picMk id="171" creationId="{9C4DDE62-3BC7-ED45-A82E-A3C21D506B79}"/>
          </ac:picMkLst>
        </pc:picChg>
      </pc:sldChg>
      <pc:sldChg chg="addSp delSp modSp add mod ord">
        <pc:chgData name="Narang, Sonali" userId="9e80b397-6e2f-49b1-9374-ccdad8589140" providerId="ADAL" clId="{08EB3AD7-677B-AA4A-90AD-5577AE246557}" dt="2021-08-16T17:30:44.229" v="9323" actId="21"/>
        <pc:sldMkLst>
          <pc:docMk/>
          <pc:sldMk cId="2124429" sldId="268"/>
        </pc:sldMkLst>
        <pc:spChg chg="add del mod">
          <ac:chgData name="Narang, Sonali" userId="9e80b397-6e2f-49b1-9374-ccdad8589140" providerId="ADAL" clId="{08EB3AD7-677B-AA4A-90AD-5577AE246557}" dt="2021-08-16T15:40:04.088" v="9236" actId="478"/>
          <ac:spMkLst>
            <pc:docMk/>
            <pc:sldMk cId="2124429" sldId="268"/>
            <ac:spMk id="2" creationId="{DA8AA03B-1DE7-A746-A44E-0CD889795F37}"/>
          </ac:spMkLst>
        </pc:spChg>
        <pc:spChg chg="add mod">
          <ac:chgData name="Narang, Sonali" userId="9e80b397-6e2f-49b1-9374-ccdad8589140" providerId="ADAL" clId="{08EB3AD7-677B-AA4A-90AD-5577AE246557}" dt="2021-08-16T15:40:12.105" v="9254" actId="1076"/>
          <ac:spMkLst>
            <pc:docMk/>
            <pc:sldMk cId="2124429" sldId="268"/>
            <ac:spMk id="3" creationId="{9DD290A2-FA79-CB4D-9BE8-A7AB77AC725D}"/>
          </ac:spMkLst>
        </pc:spChg>
        <pc:spChg chg="mod">
          <ac:chgData name="Narang, Sonali" userId="9e80b397-6e2f-49b1-9374-ccdad8589140" providerId="ADAL" clId="{08EB3AD7-677B-AA4A-90AD-5577AE246557}" dt="2021-07-09T14:45:45.443" v="3465"/>
          <ac:spMkLst>
            <pc:docMk/>
            <pc:sldMk cId="2124429" sldId="268"/>
            <ac:spMk id="14" creationId="{A654A5D4-90A9-8841-AA5F-7FE765440620}"/>
          </ac:spMkLst>
        </pc:spChg>
        <pc:spChg chg="mod">
          <ac:chgData name="Narang, Sonali" userId="9e80b397-6e2f-49b1-9374-ccdad8589140" providerId="ADAL" clId="{08EB3AD7-677B-AA4A-90AD-5577AE246557}" dt="2021-07-09T14:45:45.443" v="3465"/>
          <ac:spMkLst>
            <pc:docMk/>
            <pc:sldMk cId="2124429" sldId="268"/>
            <ac:spMk id="15" creationId="{AB0F983E-D14E-144C-85AC-1B9B0598118F}"/>
          </ac:spMkLst>
        </pc:spChg>
        <pc:spChg chg="mod">
          <ac:chgData name="Narang, Sonali" userId="9e80b397-6e2f-49b1-9374-ccdad8589140" providerId="ADAL" clId="{08EB3AD7-677B-AA4A-90AD-5577AE246557}" dt="2021-07-09T14:52:16.863" v="3473"/>
          <ac:spMkLst>
            <pc:docMk/>
            <pc:sldMk cId="2124429" sldId="268"/>
            <ac:spMk id="18" creationId="{C816F89C-B2EC-6C42-BBC5-39ED21201143}"/>
          </ac:spMkLst>
        </pc:spChg>
        <pc:spChg chg="mod">
          <ac:chgData name="Narang, Sonali" userId="9e80b397-6e2f-49b1-9374-ccdad8589140" providerId="ADAL" clId="{08EB3AD7-677B-AA4A-90AD-5577AE246557}" dt="2021-07-09T14:52:16.863" v="3473"/>
          <ac:spMkLst>
            <pc:docMk/>
            <pc:sldMk cId="2124429" sldId="268"/>
            <ac:spMk id="19" creationId="{4CF17335-7E42-AE4A-ADD0-AB415FD85279}"/>
          </ac:spMkLst>
        </pc:spChg>
        <pc:grpChg chg="add del mod">
          <ac:chgData name="Narang, Sonali" userId="9e80b397-6e2f-49b1-9374-ccdad8589140" providerId="ADAL" clId="{08EB3AD7-677B-AA4A-90AD-5577AE246557}" dt="2021-07-09T20:20:49.732" v="5128" actId="478"/>
          <ac:grpSpMkLst>
            <pc:docMk/>
            <pc:sldMk cId="2124429" sldId="268"/>
            <ac:grpSpMk id="12" creationId="{CC0B8596-B79C-244E-9DA9-A4C84E005070}"/>
          </ac:grpSpMkLst>
        </pc:grpChg>
        <pc:grpChg chg="add del mod">
          <ac:chgData name="Narang, Sonali" userId="9e80b397-6e2f-49b1-9374-ccdad8589140" providerId="ADAL" clId="{08EB3AD7-677B-AA4A-90AD-5577AE246557}" dt="2021-07-09T15:28:56.641" v="3700" actId="21"/>
          <ac:grpSpMkLst>
            <pc:docMk/>
            <pc:sldMk cId="2124429" sldId="268"/>
            <ac:grpSpMk id="16" creationId="{45A08A11-E1DA-E241-95A3-0A1923BEFCB2}"/>
          </ac:grpSpMkLst>
        </pc:grpChg>
        <pc:picChg chg="add mod">
          <ac:chgData name="Narang, Sonali" userId="9e80b397-6e2f-49b1-9374-ccdad8589140" providerId="ADAL" clId="{08EB3AD7-677B-AA4A-90AD-5577AE246557}" dt="2021-08-16T15:40:05.661" v="9237" actId="1076"/>
          <ac:picMkLst>
            <pc:docMk/>
            <pc:sldMk cId="2124429" sldId="268"/>
            <ac:picMk id="9" creationId="{DDFA2D53-1007-6348-BFE3-B6FA0F6BC498}"/>
          </ac:picMkLst>
        </pc:picChg>
        <pc:picChg chg="add del mod">
          <ac:chgData name="Narang, Sonali" userId="9e80b397-6e2f-49b1-9374-ccdad8589140" providerId="ADAL" clId="{08EB3AD7-677B-AA4A-90AD-5577AE246557}" dt="2021-08-16T17:30:44.229" v="9323" actId="21"/>
          <ac:picMkLst>
            <pc:docMk/>
            <pc:sldMk cId="2124429" sldId="268"/>
            <ac:picMk id="11" creationId="{D1E872C1-3B99-7C42-A128-8165D4035442}"/>
          </ac:picMkLst>
        </pc:picChg>
        <pc:picChg chg="add del mod modCrop">
          <ac:chgData name="Narang, Sonali" userId="9e80b397-6e2f-49b1-9374-ccdad8589140" providerId="ADAL" clId="{08EB3AD7-677B-AA4A-90AD-5577AE246557}" dt="2021-08-16T17:30:44.229" v="9323" actId="21"/>
          <ac:picMkLst>
            <pc:docMk/>
            <pc:sldMk cId="2124429" sldId="268"/>
            <ac:picMk id="12" creationId="{C223308D-B9D5-744E-B57A-93572221F887}"/>
          </ac:picMkLst>
        </pc:picChg>
        <pc:picChg chg="mod">
          <ac:chgData name="Narang, Sonali" userId="9e80b397-6e2f-49b1-9374-ccdad8589140" providerId="ADAL" clId="{08EB3AD7-677B-AA4A-90AD-5577AE246557}" dt="2021-07-09T14:45:45.443" v="3465"/>
          <ac:picMkLst>
            <pc:docMk/>
            <pc:sldMk cId="2124429" sldId="268"/>
            <ac:picMk id="13" creationId="{C4477A14-33BC-484A-9A9F-31403D58799F}"/>
          </ac:picMkLst>
        </pc:picChg>
        <pc:picChg chg="mod">
          <ac:chgData name="Narang, Sonali" userId="9e80b397-6e2f-49b1-9374-ccdad8589140" providerId="ADAL" clId="{08EB3AD7-677B-AA4A-90AD-5577AE246557}" dt="2021-07-09T14:52:16.863" v="3473"/>
          <ac:picMkLst>
            <pc:docMk/>
            <pc:sldMk cId="2124429" sldId="268"/>
            <ac:picMk id="17" creationId="{D6035B93-72F1-8744-B5C5-B519D1DEF895}"/>
          </ac:picMkLst>
        </pc:picChg>
        <pc:picChg chg="add del mod">
          <ac:chgData name="Narang, Sonali" userId="9e80b397-6e2f-49b1-9374-ccdad8589140" providerId="ADAL" clId="{08EB3AD7-677B-AA4A-90AD-5577AE246557}" dt="2021-08-16T15:40:04.088" v="9236" actId="478"/>
          <ac:picMkLst>
            <pc:docMk/>
            <pc:sldMk cId="2124429" sldId="268"/>
            <ac:picMk id="85" creationId="{A0D2DA4B-D7EA-F643-956E-5D7234F9A328}"/>
          </ac:picMkLst>
        </pc:picChg>
        <pc:picChg chg="del mod">
          <ac:chgData name="Narang, Sonali" userId="9e80b397-6e2f-49b1-9374-ccdad8589140" providerId="ADAL" clId="{08EB3AD7-677B-AA4A-90AD-5577AE246557}" dt="2021-07-09T14:46:01.749" v="3467" actId="21"/>
          <ac:picMkLst>
            <pc:docMk/>
            <pc:sldMk cId="2124429" sldId="268"/>
            <ac:picMk id="86" creationId="{4A0A1992-283F-CA47-B853-A23B5AD7D1B3}"/>
          </ac:picMkLst>
        </pc:picChg>
        <pc:picChg chg="del">
          <ac:chgData name="Narang, Sonali" userId="9e80b397-6e2f-49b1-9374-ccdad8589140" providerId="ADAL" clId="{08EB3AD7-677B-AA4A-90AD-5577AE246557}" dt="2021-07-09T14:45:29.622" v="3459" actId="478"/>
          <ac:picMkLst>
            <pc:docMk/>
            <pc:sldMk cId="2124429" sldId="268"/>
            <ac:picMk id="108" creationId="{853AEFCF-8128-CD4E-8B51-F2799A98E31A}"/>
          </ac:picMkLst>
        </pc:picChg>
        <pc:picChg chg="del">
          <ac:chgData name="Narang, Sonali" userId="9e80b397-6e2f-49b1-9374-ccdad8589140" providerId="ADAL" clId="{08EB3AD7-677B-AA4A-90AD-5577AE246557}" dt="2021-07-09T14:45:29.622" v="3459" actId="478"/>
          <ac:picMkLst>
            <pc:docMk/>
            <pc:sldMk cId="2124429" sldId="268"/>
            <ac:picMk id="110" creationId="{53EB689B-910E-344E-93B0-F3F2B694D665}"/>
          </ac:picMkLst>
        </pc:picChg>
        <pc:picChg chg="del">
          <ac:chgData name="Narang, Sonali" userId="9e80b397-6e2f-49b1-9374-ccdad8589140" providerId="ADAL" clId="{08EB3AD7-677B-AA4A-90AD-5577AE246557}" dt="2021-07-09T14:45:29.622" v="3459" actId="478"/>
          <ac:picMkLst>
            <pc:docMk/>
            <pc:sldMk cId="2124429" sldId="268"/>
            <ac:picMk id="112" creationId="{2799296B-306F-8A44-AAF4-E0419816223A}"/>
          </ac:picMkLst>
        </pc:picChg>
      </pc:sldChg>
      <pc:sldChg chg="addSp delSp modSp new mod ord">
        <pc:chgData name="Narang, Sonali" userId="9e80b397-6e2f-49b1-9374-ccdad8589140" providerId="ADAL" clId="{08EB3AD7-677B-AA4A-90AD-5577AE246557}" dt="2021-07-28T16:16:40.163" v="9032" actId="1076"/>
        <pc:sldMkLst>
          <pc:docMk/>
          <pc:sldMk cId="2720918902" sldId="269"/>
        </pc:sldMkLst>
        <pc:spChg chg="del">
          <ac:chgData name="Narang, Sonali" userId="9e80b397-6e2f-49b1-9374-ccdad8589140" providerId="ADAL" clId="{08EB3AD7-677B-AA4A-90AD-5577AE246557}" dt="2021-07-12T19:08:39.661" v="7164" actId="478"/>
          <ac:spMkLst>
            <pc:docMk/>
            <pc:sldMk cId="2720918902" sldId="269"/>
            <ac:spMk id="2" creationId="{B4C4BA18-E5EC-9A4B-8227-5165A8B49AD8}"/>
          </ac:spMkLst>
        </pc:spChg>
        <pc:spChg chg="del">
          <ac:chgData name="Narang, Sonali" userId="9e80b397-6e2f-49b1-9374-ccdad8589140" providerId="ADAL" clId="{08EB3AD7-677B-AA4A-90AD-5577AE246557}" dt="2021-07-12T19:08:39.661" v="7164" actId="478"/>
          <ac:spMkLst>
            <pc:docMk/>
            <pc:sldMk cId="2720918902" sldId="269"/>
            <ac:spMk id="3" creationId="{20B0E73E-4207-1143-AAE8-1A4C21A0B061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6" creationId="{970A4E89-1A63-8E44-89D5-506F8C279ECE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7" creationId="{C3F1D4BB-4A9B-E44E-834D-D65B9E850604}"/>
          </ac:spMkLst>
        </pc:spChg>
        <pc:spChg chg="mod">
          <ac:chgData name="Narang, Sonali" userId="9e80b397-6e2f-49b1-9374-ccdad8589140" providerId="ADAL" clId="{08EB3AD7-677B-AA4A-90AD-5577AE246557}" dt="2021-07-12T19:11:27.310" v="7315" actId="1076"/>
          <ac:spMkLst>
            <pc:docMk/>
            <pc:sldMk cId="2720918902" sldId="269"/>
            <ac:spMk id="8" creationId="{02316F5F-D139-F34F-9A6F-BE99A40595D3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9" creationId="{A1EB94F1-BE0B-B04A-A6B6-D61EDBB64FEF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0" creationId="{B73A992F-16C3-0C43-B13C-2B42694B893A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1" creationId="{6A492B61-3804-4A41-83E4-2A7CC245E80C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2" creationId="{05AEBF4B-ACA8-B14E-9D98-3ADDBC829601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3" creationId="{EA85D800-0002-824C-817B-DCA44509796C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4" creationId="{C28A42D3-6C6C-6D48-8457-6B732B0ED0FF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5" creationId="{34CE6572-CB1E-5D41-8C3F-13AC13D26F0F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6" creationId="{4406059B-8D33-3A41-8CE9-132DBF96C686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7" creationId="{88CC1ADD-A1BE-2E41-9E37-3102CA21F9E5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8" creationId="{F0A694AA-4931-C243-998E-397D4E89E98E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19" creationId="{312CD9BC-D574-8945-9EE0-BEFE79A70A5E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20" creationId="{D3805A3A-4A91-8A48-B2CE-EF39B603A7B6}"/>
          </ac:spMkLst>
        </pc:spChg>
        <pc:spChg chg="mod">
          <ac:chgData name="Narang, Sonali" userId="9e80b397-6e2f-49b1-9374-ccdad8589140" providerId="ADAL" clId="{08EB3AD7-677B-AA4A-90AD-5577AE246557}" dt="2021-07-12T19:08:36.493" v="7163"/>
          <ac:spMkLst>
            <pc:docMk/>
            <pc:sldMk cId="2720918902" sldId="269"/>
            <ac:spMk id="21" creationId="{C570B7C6-09F6-394A-B070-AAE7CFED5F41}"/>
          </ac:spMkLst>
        </pc:spChg>
        <pc:spChg chg="add del mod">
          <ac:chgData name="Narang, Sonali" userId="9e80b397-6e2f-49b1-9374-ccdad8589140" providerId="ADAL" clId="{08EB3AD7-677B-AA4A-90AD-5577AE246557}" dt="2021-07-12T19:08:57.501" v="7172"/>
          <ac:spMkLst>
            <pc:docMk/>
            <pc:sldMk cId="2720918902" sldId="269"/>
            <ac:spMk id="23" creationId="{5A21BCD9-A22E-AB4D-8A2E-2EF0DF70924B}"/>
          </ac:spMkLst>
        </pc:spChg>
        <pc:spChg chg="add mod">
          <ac:chgData name="Narang, Sonali" userId="9e80b397-6e2f-49b1-9374-ccdad8589140" providerId="ADAL" clId="{08EB3AD7-677B-AA4A-90AD-5577AE246557}" dt="2021-07-12T19:10:07.595" v="7233" actId="20577"/>
          <ac:spMkLst>
            <pc:docMk/>
            <pc:sldMk cId="2720918902" sldId="269"/>
            <ac:spMk id="26" creationId="{4AA2B0E0-9E04-1748-82E6-C76635F8D162}"/>
          </ac:spMkLst>
        </pc:spChg>
        <pc:spChg chg="add mod">
          <ac:chgData name="Narang, Sonali" userId="9e80b397-6e2f-49b1-9374-ccdad8589140" providerId="ADAL" clId="{08EB3AD7-677B-AA4A-90AD-5577AE246557}" dt="2021-07-12T19:09:57.916" v="7212" actId="20577"/>
          <ac:spMkLst>
            <pc:docMk/>
            <pc:sldMk cId="2720918902" sldId="269"/>
            <ac:spMk id="27" creationId="{0D94C0A7-0AEB-3D47-9BC0-55F5364A8EF3}"/>
          </ac:spMkLst>
        </pc:spChg>
        <pc:spChg chg="add del mod">
          <ac:chgData name="Narang, Sonali" userId="9e80b397-6e2f-49b1-9374-ccdad8589140" providerId="ADAL" clId="{08EB3AD7-677B-AA4A-90AD-5577AE246557}" dt="2021-07-12T19:09:42.298" v="7187"/>
          <ac:spMkLst>
            <pc:docMk/>
            <pc:sldMk cId="2720918902" sldId="269"/>
            <ac:spMk id="28" creationId="{75FC5F5E-84BE-4B4E-9DAC-9C6AAEFEB1B4}"/>
          </ac:spMkLst>
        </pc:spChg>
        <pc:spChg chg="add del mod">
          <ac:chgData name="Narang, Sonali" userId="9e80b397-6e2f-49b1-9374-ccdad8589140" providerId="ADAL" clId="{08EB3AD7-677B-AA4A-90AD-5577AE246557}" dt="2021-07-12T19:09:42.298" v="7187"/>
          <ac:spMkLst>
            <pc:docMk/>
            <pc:sldMk cId="2720918902" sldId="269"/>
            <ac:spMk id="29" creationId="{FFAC3E6C-F869-5841-82D4-5B3268B97C4D}"/>
          </ac:spMkLst>
        </pc:spChg>
        <pc:spChg chg="add mod">
          <ac:chgData name="Narang, Sonali" userId="9e80b397-6e2f-49b1-9374-ccdad8589140" providerId="ADAL" clId="{08EB3AD7-677B-AA4A-90AD-5577AE246557}" dt="2021-07-12T19:10:17.464" v="7251" actId="20577"/>
          <ac:spMkLst>
            <pc:docMk/>
            <pc:sldMk cId="2720918902" sldId="269"/>
            <ac:spMk id="30" creationId="{9F4469E9-F3F6-2246-A6BF-786873C72E08}"/>
          </ac:spMkLst>
        </pc:spChg>
        <pc:spChg chg="add mod">
          <ac:chgData name="Narang, Sonali" userId="9e80b397-6e2f-49b1-9374-ccdad8589140" providerId="ADAL" clId="{08EB3AD7-677B-AA4A-90AD-5577AE246557}" dt="2021-07-12T19:10:22.872" v="7269" actId="20577"/>
          <ac:spMkLst>
            <pc:docMk/>
            <pc:sldMk cId="2720918902" sldId="269"/>
            <ac:spMk id="31" creationId="{ECDA0C85-B876-244E-9A92-1F9DEFEB0495}"/>
          </ac:spMkLst>
        </pc:spChg>
        <pc:spChg chg="add mod">
          <ac:chgData name="Narang, Sonali" userId="9e80b397-6e2f-49b1-9374-ccdad8589140" providerId="ADAL" clId="{08EB3AD7-677B-AA4A-90AD-5577AE246557}" dt="2021-07-12T19:10:41.993" v="7277" actId="20577"/>
          <ac:spMkLst>
            <pc:docMk/>
            <pc:sldMk cId="2720918902" sldId="269"/>
            <ac:spMk id="32" creationId="{CF84F454-6117-B94C-B4C9-DA16C5CC7620}"/>
          </ac:spMkLst>
        </pc:spChg>
        <pc:spChg chg="add mod">
          <ac:chgData name="Narang, Sonali" userId="9e80b397-6e2f-49b1-9374-ccdad8589140" providerId="ADAL" clId="{08EB3AD7-677B-AA4A-90AD-5577AE246557}" dt="2021-07-12T19:11:01.887" v="7312" actId="1076"/>
          <ac:spMkLst>
            <pc:docMk/>
            <pc:sldMk cId="2720918902" sldId="269"/>
            <ac:spMk id="33" creationId="{3DB50601-7070-8147-BF34-C28C10DE4EF7}"/>
          </ac:spMkLst>
        </pc:spChg>
        <pc:spChg chg="add mod">
          <ac:chgData name="Narang, Sonali" userId="9e80b397-6e2f-49b1-9374-ccdad8589140" providerId="ADAL" clId="{08EB3AD7-677B-AA4A-90AD-5577AE246557}" dt="2021-07-12T19:10:55.686" v="7309" actId="20577"/>
          <ac:spMkLst>
            <pc:docMk/>
            <pc:sldMk cId="2720918902" sldId="269"/>
            <ac:spMk id="34" creationId="{201BD6FB-B29D-6F4F-9FD1-82E81832B7AF}"/>
          </ac:spMkLst>
        </pc:spChg>
        <pc:spChg chg="add mod">
          <ac:chgData name="Narang, Sonali" userId="9e80b397-6e2f-49b1-9374-ccdad8589140" providerId="ADAL" clId="{08EB3AD7-677B-AA4A-90AD-5577AE246557}" dt="2021-07-12T19:10:35.911" v="7271" actId="1076"/>
          <ac:spMkLst>
            <pc:docMk/>
            <pc:sldMk cId="2720918902" sldId="269"/>
            <ac:spMk id="35" creationId="{719E90AD-4A7B-854D-83F7-D84D25D8F9C2}"/>
          </ac:spMkLst>
        </pc:spChg>
        <pc:spChg chg="add mod">
          <ac:chgData name="Narang, Sonali" userId="9e80b397-6e2f-49b1-9374-ccdad8589140" providerId="ADAL" clId="{08EB3AD7-677B-AA4A-90AD-5577AE246557}" dt="2021-07-12T19:10:35.911" v="7271" actId="1076"/>
          <ac:spMkLst>
            <pc:docMk/>
            <pc:sldMk cId="2720918902" sldId="269"/>
            <ac:spMk id="36" creationId="{C71CD2D3-7D44-F340-B1C8-3A86FB15BA85}"/>
          </ac:spMkLst>
        </pc:spChg>
        <pc:spChg chg="add mod">
          <ac:chgData name="Narang, Sonali" userId="9e80b397-6e2f-49b1-9374-ccdad8589140" providerId="ADAL" clId="{08EB3AD7-677B-AA4A-90AD-5577AE246557}" dt="2021-07-12T19:10:35.911" v="7271" actId="1076"/>
          <ac:spMkLst>
            <pc:docMk/>
            <pc:sldMk cId="2720918902" sldId="269"/>
            <ac:spMk id="37" creationId="{7C05ACB9-A94F-A842-B1F1-066896F0F3C5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38" creationId="{B722EF19-0AA9-2746-96CA-C445738BD6DB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39" creationId="{93C6A577-2A8E-F14F-841E-A61A2CBA925C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40" creationId="{F46EE902-9FAA-2E40-8033-C85265F25903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41" creationId="{8D406CD7-682B-FD41-8863-186D408A7EBE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42" creationId="{B7BD1451-A2CC-154C-8A1E-07A76EB37568}"/>
          </ac:spMkLst>
        </pc:spChg>
        <pc:spChg chg="add mod">
          <ac:chgData name="Narang, Sonali" userId="9e80b397-6e2f-49b1-9374-ccdad8589140" providerId="ADAL" clId="{08EB3AD7-677B-AA4A-90AD-5577AE246557}" dt="2021-07-12T19:11:12.942" v="7314" actId="1076"/>
          <ac:spMkLst>
            <pc:docMk/>
            <pc:sldMk cId="2720918902" sldId="269"/>
            <ac:spMk id="43" creationId="{5C52D3DA-6F43-1948-A778-94F6E4E9E14F}"/>
          </ac:spMkLst>
        </pc:spChg>
        <pc:grpChg chg="add mod">
          <ac:chgData name="Narang, Sonali" userId="9e80b397-6e2f-49b1-9374-ccdad8589140" providerId="ADAL" clId="{08EB3AD7-677B-AA4A-90AD-5577AE246557}" dt="2021-07-12T19:08:51.456" v="7169" actId="1076"/>
          <ac:grpSpMkLst>
            <pc:docMk/>
            <pc:sldMk cId="2720918902" sldId="269"/>
            <ac:grpSpMk id="4" creationId="{38EA236B-FA62-104C-88BA-1A393570B00A}"/>
          </ac:grpSpMkLst>
        </pc:grpChg>
        <pc:grpChg chg="mod">
          <ac:chgData name="Narang, Sonali" userId="9e80b397-6e2f-49b1-9374-ccdad8589140" providerId="ADAL" clId="{08EB3AD7-677B-AA4A-90AD-5577AE246557}" dt="2021-07-12T19:08:36.493" v="7163"/>
          <ac:grpSpMkLst>
            <pc:docMk/>
            <pc:sldMk cId="2720918902" sldId="269"/>
            <ac:grpSpMk id="5" creationId="{6DCC46AD-D93C-3F4E-8E9E-922953C291ED}"/>
          </ac:grpSpMkLst>
        </pc:grpChg>
        <pc:picChg chg="add mod">
          <ac:chgData name="Narang, Sonali" userId="9e80b397-6e2f-49b1-9374-ccdad8589140" providerId="ADAL" clId="{08EB3AD7-677B-AA4A-90AD-5577AE246557}" dt="2021-07-28T16:16:40.163" v="9032" actId="1076"/>
          <ac:picMkLst>
            <pc:docMk/>
            <pc:sldMk cId="2720918902" sldId="269"/>
            <ac:picMk id="3" creationId="{B45809F1-FAC9-F94B-9E9F-CB796333E5D3}"/>
          </ac:picMkLst>
        </pc:picChg>
        <pc:picChg chg="add del mod">
          <ac:chgData name="Narang, Sonali" userId="9e80b397-6e2f-49b1-9374-ccdad8589140" providerId="ADAL" clId="{08EB3AD7-677B-AA4A-90AD-5577AE246557}" dt="2021-07-28T16:16:26.841" v="9024" actId="478"/>
          <ac:picMkLst>
            <pc:docMk/>
            <pc:sldMk cId="2720918902" sldId="269"/>
            <ac:picMk id="22" creationId="{D762258A-76C2-6741-AB0C-923591796ACC}"/>
          </ac:picMkLst>
        </pc:picChg>
        <pc:picChg chg="add mod">
          <ac:chgData name="Narang, Sonali" userId="9e80b397-6e2f-49b1-9374-ccdad8589140" providerId="ADAL" clId="{08EB3AD7-677B-AA4A-90AD-5577AE246557}" dt="2021-07-12T19:09:41.152" v="7186" actId="1076"/>
          <ac:picMkLst>
            <pc:docMk/>
            <pc:sldMk cId="2720918902" sldId="269"/>
            <ac:picMk id="24" creationId="{0304240D-4AFD-094E-A8F4-9549ABFF67CC}"/>
          </ac:picMkLst>
        </pc:picChg>
        <pc:picChg chg="add mod">
          <ac:chgData name="Narang, Sonali" userId="9e80b397-6e2f-49b1-9374-ccdad8589140" providerId="ADAL" clId="{08EB3AD7-677B-AA4A-90AD-5577AE246557}" dt="2021-07-12T19:09:29.800" v="7181" actId="1076"/>
          <ac:picMkLst>
            <pc:docMk/>
            <pc:sldMk cId="2720918902" sldId="269"/>
            <ac:picMk id="25" creationId="{F5335663-2747-3B40-A677-7A33B0BD5B41}"/>
          </ac:picMkLst>
        </pc:picChg>
      </pc:sldChg>
      <pc:sldChg chg="new del">
        <pc:chgData name="Narang, Sonali" userId="9e80b397-6e2f-49b1-9374-ccdad8589140" providerId="ADAL" clId="{08EB3AD7-677B-AA4A-90AD-5577AE246557}" dt="2021-07-09T15:27:51.319" v="3693" actId="680"/>
        <pc:sldMkLst>
          <pc:docMk/>
          <pc:sldMk cId="3205661288" sldId="269"/>
        </pc:sldMkLst>
      </pc:sldChg>
      <pc:sldChg chg="addSp delSp modSp add mod">
        <pc:chgData name="Narang, Sonali" userId="9e80b397-6e2f-49b1-9374-ccdad8589140" providerId="ADAL" clId="{08EB3AD7-677B-AA4A-90AD-5577AE246557}" dt="2021-08-16T20:59:40.564" v="10052" actId="1035"/>
        <pc:sldMkLst>
          <pc:docMk/>
          <pc:sldMk cId="3689715634" sldId="270"/>
        </pc:sldMkLst>
        <pc:spChg chg="mod">
          <ac:chgData name="Narang, Sonali" userId="9e80b397-6e2f-49b1-9374-ccdad8589140" providerId="ADAL" clId="{08EB3AD7-677B-AA4A-90AD-5577AE246557}" dt="2021-08-16T20:59:32.695" v="10041" actId="1037"/>
          <ac:spMkLst>
            <pc:docMk/>
            <pc:sldMk cId="3689715634" sldId="270"/>
            <ac:spMk id="7" creationId="{4C5F5CAE-FBFD-964D-A356-746AAC86DC9E}"/>
          </ac:spMkLst>
        </pc:spChg>
        <pc:spChg chg="mod">
          <ac:chgData name="Narang, Sonali" userId="9e80b397-6e2f-49b1-9374-ccdad8589140" providerId="ADAL" clId="{08EB3AD7-677B-AA4A-90AD-5577AE246557}" dt="2021-08-16T18:11:25.320" v="9656" actId="1076"/>
          <ac:spMkLst>
            <pc:docMk/>
            <pc:sldMk cId="3689715634" sldId="270"/>
            <ac:spMk id="32" creationId="{2863401C-2050-2E40-AE5C-C6CDD3A8A7D4}"/>
          </ac:spMkLst>
        </pc:spChg>
        <pc:spChg chg="mod">
          <ac:chgData name="Narang, Sonali" userId="9e80b397-6e2f-49b1-9374-ccdad8589140" providerId="ADAL" clId="{08EB3AD7-677B-AA4A-90AD-5577AE246557}" dt="2021-08-16T17:54:22.478" v="9644" actId="1038"/>
          <ac:spMkLst>
            <pc:docMk/>
            <pc:sldMk cId="3689715634" sldId="270"/>
            <ac:spMk id="34" creationId="{6D8F17D5-0D48-D240-A514-46DF3B792DB3}"/>
          </ac:spMkLst>
        </pc:spChg>
        <pc:spChg chg="mod">
          <ac:chgData name="Narang, Sonali" userId="9e80b397-6e2f-49b1-9374-ccdad8589140" providerId="ADAL" clId="{08EB3AD7-677B-AA4A-90AD-5577AE246557}" dt="2021-08-16T17:54:18.171" v="9636" actId="1038"/>
          <ac:spMkLst>
            <pc:docMk/>
            <pc:sldMk cId="3689715634" sldId="270"/>
            <ac:spMk id="35" creationId="{8E47D5FA-094C-AB4F-997F-C3C0BB4C2B2E}"/>
          </ac:spMkLst>
        </pc:spChg>
        <pc:spChg chg="mod">
          <ac:chgData name="Narang, Sonali" userId="9e80b397-6e2f-49b1-9374-ccdad8589140" providerId="ADAL" clId="{08EB3AD7-677B-AA4A-90AD-5577AE246557}" dt="2021-08-16T17:54:49.100" v="9653" actId="1037"/>
          <ac:spMkLst>
            <pc:docMk/>
            <pc:sldMk cId="3689715634" sldId="270"/>
            <ac:spMk id="88" creationId="{DF3993D3-72E7-E54E-97D3-9D84F59F5654}"/>
          </ac:spMkLst>
        </pc:spChg>
        <pc:spChg chg="mod">
          <ac:chgData name="Narang, Sonali" userId="9e80b397-6e2f-49b1-9374-ccdad8589140" providerId="ADAL" clId="{08EB3AD7-677B-AA4A-90AD-5577AE246557}" dt="2021-08-16T17:54:45.897" v="9651" actId="1038"/>
          <ac:spMkLst>
            <pc:docMk/>
            <pc:sldMk cId="3689715634" sldId="270"/>
            <ac:spMk id="89" creationId="{9795E54A-2B4A-9D4B-8972-CBAED713A584}"/>
          </ac:spMkLst>
        </pc:spChg>
        <pc:spChg chg="mod">
          <ac:chgData name="Narang, Sonali" userId="9e80b397-6e2f-49b1-9374-ccdad8589140" providerId="ADAL" clId="{08EB3AD7-677B-AA4A-90AD-5577AE246557}" dt="2021-08-16T17:54:38.641" v="9649" actId="1036"/>
          <ac:spMkLst>
            <pc:docMk/>
            <pc:sldMk cId="3689715634" sldId="270"/>
            <ac:spMk id="90" creationId="{D21843D8-B24B-7440-962B-0D5326402052}"/>
          </ac:spMkLst>
        </pc:spChg>
        <pc:spChg chg="mod">
          <ac:chgData name="Narang, Sonali" userId="9e80b397-6e2f-49b1-9374-ccdad8589140" providerId="ADAL" clId="{08EB3AD7-677B-AA4A-90AD-5577AE246557}" dt="2021-08-16T17:54:49.100" v="9653" actId="1037"/>
          <ac:spMkLst>
            <pc:docMk/>
            <pc:sldMk cId="3689715634" sldId="270"/>
            <ac:spMk id="93" creationId="{64285D9B-FC68-FC4E-A8AE-A691F45F91D3}"/>
          </ac:spMkLst>
        </pc:spChg>
        <pc:spChg chg="mod">
          <ac:chgData name="Narang, Sonali" userId="9e80b397-6e2f-49b1-9374-ccdad8589140" providerId="ADAL" clId="{08EB3AD7-677B-AA4A-90AD-5577AE246557}" dt="2021-08-16T17:54:45.897" v="9651" actId="1038"/>
          <ac:spMkLst>
            <pc:docMk/>
            <pc:sldMk cId="3689715634" sldId="270"/>
            <ac:spMk id="94" creationId="{779ED364-B947-4649-AC6C-67DBDCE196B9}"/>
          </ac:spMkLst>
        </pc:spChg>
        <pc:spChg chg="mod">
          <ac:chgData name="Narang, Sonali" userId="9e80b397-6e2f-49b1-9374-ccdad8589140" providerId="ADAL" clId="{08EB3AD7-677B-AA4A-90AD-5577AE246557}" dt="2021-08-16T17:54:38.641" v="9649" actId="1036"/>
          <ac:spMkLst>
            <pc:docMk/>
            <pc:sldMk cId="3689715634" sldId="270"/>
            <ac:spMk id="95" creationId="{6DD283A0-4643-074E-A722-EACAC130A59D}"/>
          </ac:spMkLst>
        </pc:spChg>
        <pc:spChg chg="mod">
          <ac:chgData name="Narang, Sonali" userId="9e80b397-6e2f-49b1-9374-ccdad8589140" providerId="ADAL" clId="{08EB3AD7-677B-AA4A-90AD-5577AE246557}" dt="2021-08-16T17:52:29.333" v="9610" actId="1037"/>
          <ac:spMkLst>
            <pc:docMk/>
            <pc:sldMk cId="3689715634" sldId="270"/>
            <ac:spMk id="192" creationId="{25C68709-E17A-6242-8480-1FEF3D96B0E3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08" creationId="{5AAA3738-0827-F143-BC69-115B044D6A54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09" creationId="{2A7FFDBD-47AE-F348-BDF8-7B989EDF33E6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11" creationId="{7B8F5364-A815-E24B-8386-43A6BD235DE9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16" creationId="{96339A84-2EB3-0849-9F1B-BB418CC800E1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17" creationId="{93831466-4D43-A544-89B6-90D09022AF89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18" creationId="{F9A66AD9-BAD2-BC43-86FF-3A00AB2B3A03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19" creationId="{A04674AE-2738-844E-B880-B0CD5469C686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0" creationId="{2ECD72AD-9C83-F04D-A92D-C47BA93A3C40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1" creationId="{CD21A19F-E21F-D142-971D-91DCA98B50DB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2" creationId="{2801199B-BE2E-CA42-82B3-C70806A45E1E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3" creationId="{E2E07B56-F8C7-134E-AFA3-8074713BB833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4" creationId="{686CDC3B-15FD-3240-9D21-4835BAE832BE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5" creationId="{F6DA13B4-4706-8846-9104-944C40BD1130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6" creationId="{EAEC98EB-3C93-0A4A-9E30-1EE79A8D5047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7" creationId="{F07E6E0A-BA2F-6B44-8F87-0DA6E841649E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8" creationId="{01CA1951-FF10-224C-A3D7-7AE1368A8FF7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29" creationId="{4F4B96D0-C739-2743-9912-524D90486257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30" creationId="{A84F3475-66EB-5445-8407-DEC868BE2C03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31" creationId="{F6211086-B408-074B-B11D-347723036BD9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32" creationId="{0BA08D14-2D06-B14D-866B-3DA172931C27}"/>
          </ac:spMkLst>
        </pc:spChg>
        <pc:spChg chg="mod">
          <ac:chgData name="Narang, Sonali" userId="9e80b397-6e2f-49b1-9374-ccdad8589140" providerId="ADAL" clId="{08EB3AD7-677B-AA4A-90AD-5577AE246557}" dt="2021-08-16T17:52:02.896" v="9595"/>
          <ac:spMkLst>
            <pc:docMk/>
            <pc:sldMk cId="3689715634" sldId="270"/>
            <ac:spMk id="233" creationId="{620C5770-2A81-144E-AEA8-C596E7DA942B}"/>
          </ac:spMkLst>
        </pc:spChg>
        <pc:grpChg chg="add mod">
          <ac:chgData name="Narang, Sonali" userId="9e80b397-6e2f-49b1-9374-ccdad8589140" providerId="ADAL" clId="{08EB3AD7-677B-AA4A-90AD-5577AE246557}" dt="2021-08-16T17:53:53.230" v="9628" actId="1036"/>
          <ac:grpSpMkLst>
            <pc:docMk/>
            <pc:sldMk cId="3689715634" sldId="270"/>
            <ac:grpSpMk id="6" creationId="{81DE8D28-94A4-0F42-AB8C-7C1692E7040B}"/>
          </ac:grpSpMkLst>
        </pc:grpChg>
        <pc:grpChg chg="mod">
          <ac:chgData name="Narang, Sonali" userId="9e80b397-6e2f-49b1-9374-ccdad8589140" providerId="ADAL" clId="{08EB3AD7-677B-AA4A-90AD-5577AE246557}" dt="2021-08-16T20:59:35.322" v="10047" actId="1038"/>
          <ac:grpSpMkLst>
            <pc:docMk/>
            <pc:sldMk cId="3689715634" sldId="270"/>
            <ac:grpSpMk id="10" creationId="{D88D7517-4649-454B-B33B-40859B6B3E1E}"/>
          </ac:grpSpMkLst>
        </pc:grpChg>
        <pc:grpChg chg="add del 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0" creationId="{4A113A93-4C9C-3949-B1DB-412F52E05721}"/>
          </ac:grpSpMkLst>
        </pc:grpChg>
        <pc:grpChg chg="mod">
          <ac:chgData name="Narang, Sonali" userId="9e80b397-6e2f-49b1-9374-ccdad8589140" providerId="ADAL" clId="{08EB3AD7-677B-AA4A-90AD-5577AE246557}" dt="2021-08-16T18:11:31.317" v="9657" actId="1076"/>
          <ac:grpSpMkLst>
            <pc:docMk/>
            <pc:sldMk cId="3689715634" sldId="270"/>
            <ac:grpSpMk id="96" creationId="{F3AA89EB-F925-3649-A3BE-B492BEBFEFFB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07" creationId="{2D28F141-FC80-C847-8AF0-B6A0CA712B66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10" creationId="{99F4887F-A04F-7B47-8E22-5061C9D7EECD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12" creationId="{65340C33-6E35-284F-B225-05EB6466C85A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13" creationId="{3EE05FE6-C08E-5441-9D88-BF399B13C98E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14" creationId="{500CB809-E30F-4B4C-BA46-E1D06C568E06}"/>
          </ac:grpSpMkLst>
        </pc:grpChg>
        <pc:grpChg chg="mod">
          <ac:chgData name="Narang, Sonali" userId="9e80b397-6e2f-49b1-9374-ccdad8589140" providerId="ADAL" clId="{08EB3AD7-677B-AA4A-90AD-5577AE246557}" dt="2021-08-16T17:52:02.896" v="9595"/>
          <ac:grpSpMkLst>
            <pc:docMk/>
            <pc:sldMk cId="3689715634" sldId="270"/>
            <ac:grpSpMk id="215" creationId="{41C2F825-F13A-D243-AC4B-8F5401AE67DC}"/>
          </ac:grpSpMkLst>
        </pc:grpChg>
        <pc:picChg chg="add del">
          <ac:chgData name="Narang, Sonali" userId="9e80b397-6e2f-49b1-9374-ccdad8589140" providerId="ADAL" clId="{08EB3AD7-677B-AA4A-90AD-5577AE246557}" dt="2021-08-16T17:49:56.602" v="9573"/>
          <ac:picMkLst>
            <pc:docMk/>
            <pc:sldMk cId="3689715634" sldId="270"/>
            <ac:picMk id="2" creationId="{E35654FA-4B8E-C04E-8D5F-24F0A2D8CA84}"/>
          </ac:picMkLst>
        </pc:picChg>
        <pc:picChg chg="add mod modCrop">
          <ac:chgData name="Narang, Sonali" userId="9e80b397-6e2f-49b1-9374-ccdad8589140" providerId="ADAL" clId="{08EB3AD7-677B-AA4A-90AD-5577AE246557}" dt="2021-08-16T17:52:49.625" v="9612" actId="1036"/>
          <ac:picMkLst>
            <pc:docMk/>
            <pc:sldMk cId="3689715634" sldId="270"/>
            <ac:picMk id="3" creationId="{9F5D92FD-2305-EE4A-A124-E707A2D070F7}"/>
          </ac:picMkLst>
        </pc:picChg>
        <pc:picChg chg="add del mod">
          <ac:chgData name="Narang, Sonali" userId="9e80b397-6e2f-49b1-9374-ccdad8589140" providerId="ADAL" clId="{08EB3AD7-677B-AA4A-90AD-5577AE246557}" dt="2021-08-16T20:57:49.823" v="9987" actId="478"/>
          <ac:picMkLst>
            <pc:docMk/>
            <pc:sldMk cId="3689715634" sldId="270"/>
            <ac:picMk id="11" creationId="{0809CD46-A3BF-C640-94F3-4F5E02308C97}"/>
          </ac:picMkLst>
        </pc:picChg>
        <pc:picChg chg="add mod">
          <ac:chgData name="Narang, Sonali" userId="9e80b397-6e2f-49b1-9374-ccdad8589140" providerId="ADAL" clId="{08EB3AD7-677B-AA4A-90AD-5577AE246557}" dt="2021-08-16T20:59:40.564" v="10052" actId="1035"/>
          <ac:picMkLst>
            <pc:docMk/>
            <pc:sldMk cId="3689715634" sldId="270"/>
            <ac:picMk id="12" creationId="{6F3D5D04-082E-A94E-B674-0CC25F5EF539}"/>
          </ac:picMkLst>
        </pc:picChg>
        <pc:picChg chg="del">
          <ac:chgData name="Narang, Sonali" userId="9e80b397-6e2f-49b1-9374-ccdad8589140" providerId="ADAL" clId="{08EB3AD7-677B-AA4A-90AD-5577AE246557}" dt="2021-08-16T17:51:35.060" v="9589" actId="478"/>
          <ac:picMkLst>
            <pc:docMk/>
            <pc:sldMk cId="3689715634" sldId="270"/>
            <ac:picMk id="13" creationId="{ADF3F9FF-BAA5-444E-A368-F85CD5ED5512}"/>
          </ac:picMkLst>
        </pc:picChg>
        <pc:picChg chg="del mod">
          <ac:chgData name="Narang, Sonali" userId="9e80b397-6e2f-49b1-9374-ccdad8589140" providerId="ADAL" clId="{08EB3AD7-677B-AA4A-90AD-5577AE246557}" dt="2021-08-16T18:35:51.474" v="9723" actId="478"/>
          <ac:picMkLst>
            <pc:docMk/>
            <pc:sldMk cId="3689715634" sldId="270"/>
            <ac:picMk id="21" creationId="{8DC8A9F5-026A-0D4A-A691-B6079224F482}"/>
          </ac:picMkLst>
        </pc:picChg>
        <pc:picChg chg="mod">
          <ac:chgData name="Narang, Sonali" userId="9e80b397-6e2f-49b1-9374-ccdad8589140" providerId="ADAL" clId="{08EB3AD7-677B-AA4A-90AD-5577AE246557}" dt="2021-08-16T18:11:35.578" v="9662" actId="1038"/>
          <ac:picMkLst>
            <pc:docMk/>
            <pc:sldMk cId="3689715634" sldId="270"/>
            <ac:picMk id="23" creationId="{F4E04DD6-E91E-DA48-812D-B7942BE0CA2A}"/>
          </ac:picMkLst>
        </pc:picChg>
        <pc:picChg chg="add mod modCrop">
          <ac:chgData name="Narang, Sonali" userId="9e80b397-6e2f-49b1-9374-ccdad8589140" providerId="ADAL" clId="{08EB3AD7-677B-AA4A-90AD-5577AE246557}" dt="2021-08-16T18:18:57.538" v="9694"/>
          <ac:picMkLst>
            <pc:docMk/>
            <pc:sldMk cId="3689715634" sldId="270"/>
            <ac:picMk id="117" creationId="{4C378CC0-9B72-BB4B-81F3-7A43F6FB23A0}"/>
          </ac:picMkLst>
        </pc:picChg>
        <pc:picChg chg="add mod">
          <ac:chgData name="Narang, Sonali" userId="9e80b397-6e2f-49b1-9374-ccdad8589140" providerId="ADAL" clId="{08EB3AD7-677B-AA4A-90AD-5577AE246557}" dt="2021-08-16T18:39:44.279" v="9796" actId="12788"/>
          <ac:picMkLst>
            <pc:docMk/>
            <pc:sldMk cId="3689715634" sldId="270"/>
            <ac:picMk id="119" creationId="{49F46577-C9D3-1B41-9090-7C81FC720B1E}"/>
          </ac:picMkLst>
        </pc:picChg>
        <pc:picChg chg="add mod">
          <ac:chgData name="Narang, Sonali" userId="9e80b397-6e2f-49b1-9374-ccdad8589140" providerId="ADAL" clId="{08EB3AD7-677B-AA4A-90AD-5577AE246557}" dt="2021-08-16T18:39:44.279" v="9796" actId="12788"/>
          <ac:picMkLst>
            <pc:docMk/>
            <pc:sldMk cId="3689715634" sldId="270"/>
            <ac:picMk id="120" creationId="{F74CFB0B-61C9-F640-9317-B8984AD45800}"/>
          </ac:picMkLst>
        </pc:picChg>
        <pc:picChg chg="add mod">
          <ac:chgData name="Narang, Sonali" userId="9e80b397-6e2f-49b1-9374-ccdad8589140" providerId="ADAL" clId="{08EB3AD7-677B-AA4A-90AD-5577AE246557}" dt="2021-08-16T18:41:40.180" v="9797" actId="14100"/>
          <ac:picMkLst>
            <pc:docMk/>
            <pc:sldMk cId="3689715634" sldId="270"/>
            <ac:picMk id="121" creationId="{6C6532E8-B1B8-D14C-9198-7E75AFE7A9DE}"/>
          </ac:picMkLst>
        </pc:picChg>
        <pc:picChg chg="del">
          <ac:chgData name="Narang, Sonali" userId="9e80b397-6e2f-49b1-9374-ccdad8589140" providerId="ADAL" clId="{08EB3AD7-677B-AA4A-90AD-5577AE246557}" dt="2021-08-16T17:51:43.693" v="9591" actId="478"/>
          <ac:picMkLst>
            <pc:docMk/>
            <pc:sldMk cId="3689715634" sldId="270"/>
            <ac:picMk id="188" creationId="{EE2FBEFD-5454-8441-B026-E0C9439B8CA3}"/>
          </ac:picMkLst>
        </pc:picChg>
        <pc:cxnChg chg="mod">
          <ac:chgData name="Narang, Sonali" userId="9e80b397-6e2f-49b1-9374-ccdad8589140" providerId="ADAL" clId="{08EB3AD7-677B-AA4A-90AD-5577AE246557}" dt="2021-08-16T17:52:02.896" v="9595"/>
          <ac:cxnSpMkLst>
            <pc:docMk/>
            <pc:sldMk cId="3689715634" sldId="270"/>
            <ac:cxnSpMk id="234" creationId="{17B48C50-2AA1-9645-9914-3CC324B1A9FC}"/>
          </ac:cxnSpMkLst>
        </pc:cxnChg>
        <pc:cxnChg chg="mod">
          <ac:chgData name="Narang, Sonali" userId="9e80b397-6e2f-49b1-9374-ccdad8589140" providerId="ADAL" clId="{08EB3AD7-677B-AA4A-90AD-5577AE246557}" dt="2021-08-16T17:52:02.896" v="9595"/>
          <ac:cxnSpMkLst>
            <pc:docMk/>
            <pc:sldMk cId="3689715634" sldId="270"/>
            <ac:cxnSpMk id="235" creationId="{A445F44A-CE5F-6B47-A31A-A6C88ED4D220}"/>
          </ac:cxnSpMkLst>
        </pc:cxnChg>
        <pc:cxnChg chg="mod">
          <ac:chgData name="Narang, Sonali" userId="9e80b397-6e2f-49b1-9374-ccdad8589140" providerId="ADAL" clId="{08EB3AD7-677B-AA4A-90AD-5577AE246557}" dt="2021-08-16T17:52:02.896" v="9595"/>
          <ac:cxnSpMkLst>
            <pc:docMk/>
            <pc:sldMk cId="3689715634" sldId="270"/>
            <ac:cxnSpMk id="236" creationId="{6BC29306-5CCB-AB48-9073-8B44A653415F}"/>
          </ac:cxnSpMkLst>
        </pc:cxnChg>
      </pc:sldChg>
      <pc:sldChg chg="addSp delSp modSp add mod">
        <pc:chgData name="Narang, Sonali" userId="9e80b397-6e2f-49b1-9374-ccdad8589140" providerId="ADAL" clId="{08EB3AD7-677B-AA4A-90AD-5577AE246557}" dt="2021-08-17T17:29:45.028" v="10168" actId="21"/>
        <pc:sldMkLst>
          <pc:docMk/>
          <pc:sldMk cId="2499962631" sldId="271"/>
        </pc:sldMkLst>
        <pc:picChg chg="add mod modCrop">
          <ac:chgData name="Narang, Sonali" userId="9e80b397-6e2f-49b1-9374-ccdad8589140" providerId="ADAL" clId="{08EB3AD7-677B-AA4A-90AD-5577AE246557}" dt="2021-08-16T21:21:02.143" v="10110" actId="1076"/>
          <ac:picMkLst>
            <pc:docMk/>
            <pc:sldMk cId="2499962631" sldId="271"/>
            <ac:picMk id="3" creationId="{82228A92-5E0D-5E4B-87A2-F9CCCA129DED}"/>
          </ac:picMkLst>
        </pc:picChg>
        <pc:picChg chg="add mod modCrop">
          <ac:chgData name="Narang, Sonali" userId="9e80b397-6e2f-49b1-9374-ccdad8589140" providerId="ADAL" clId="{08EB3AD7-677B-AA4A-90AD-5577AE246557}" dt="2021-08-16T21:21:00.371" v="10109" actId="1076"/>
          <ac:picMkLst>
            <pc:docMk/>
            <pc:sldMk cId="2499962631" sldId="271"/>
            <ac:picMk id="10" creationId="{272DF27B-4777-434D-AEE7-A62CA5338473}"/>
          </ac:picMkLst>
        </pc:picChg>
        <pc:picChg chg="add mod">
          <ac:chgData name="Narang, Sonali" userId="9e80b397-6e2f-49b1-9374-ccdad8589140" providerId="ADAL" clId="{08EB3AD7-677B-AA4A-90AD-5577AE246557}" dt="2021-08-16T21:20:57.045" v="10108" actId="1076"/>
          <ac:picMkLst>
            <pc:docMk/>
            <pc:sldMk cId="2499962631" sldId="271"/>
            <ac:picMk id="81" creationId="{C5CC3F26-2070-C346-92D8-18EC76E60F2C}"/>
          </ac:picMkLst>
        </pc:picChg>
        <pc:picChg chg="del">
          <ac:chgData name="Narang, Sonali" userId="9e80b397-6e2f-49b1-9374-ccdad8589140" providerId="ADAL" clId="{08EB3AD7-677B-AA4A-90AD-5577AE246557}" dt="2021-08-16T21:19:13.957" v="10083" actId="478"/>
          <ac:picMkLst>
            <pc:docMk/>
            <pc:sldMk cId="2499962631" sldId="271"/>
            <ac:picMk id="83" creationId="{E83C2341-AFC0-E647-883F-50A935BC9461}"/>
          </ac:picMkLst>
        </pc:picChg>
        <pc:picChg chg="del">
          <ac:chgData name="Narang, Sonali" userId="9e80b397-6e2f-49b1-9374-ccdad8589140" providerId="ADAL" clId="{08EB3AD7-677B-AA4A-90AD-5577AE246557}" dt="2021-08-16T21:19:13.957" v="10083" actId="478"/>
          <ac:picMkLst>
            <pc:docMk/>
            <pc:sldMk cId="2499962631" sldId="271"/>
            <ac:picMk id="87" creationId="{9B85B853-9D5C-E446-A2C0-6709A7356383}"/>
          </ac:picMkLst>
        </pc:picChg>
        <pc:picChg chg="add del mod">
          <ac:chgData name="Narang, Sonali" userId="9e80b397-6e2f-49b1-9374-ccdad8589140" providerId="ADAL" clId="{08EB3AD7-677B-AA4A-90AD-5577AE246557}" dt="2021-08-17T17:29:45.028" v="10168" actId="21"/>
          <ac:picMkLst>
            <pc:docMk/>
            <pc:sldMk cId="2499962631" sldId="271"/>
            <ac:picMk id="88" creationId="{986C3E8E-7064-1740-A585-B4F90B3F3C10}"/>
          </ac:picMkLst>
        </pc:picChg>
        <pc:picChg chg="del">
          <ac:chgData name="Narang, Sonali" userId="9e80b397-6e2f-49b1-9374-ccdad8589140" providerId="ADAL" clId="{08EB3AD7-677B-AA4A-90AD-5577AE246557}" dt="2021-08-16T21:19:13.957" v="10083" actId="478"/>
          <ac:picMkLst>
            <pc:docMk/>
            <pc:sldMk cId="2499962631" sldId="271"/>
            <ac:picMk id="89" creationId="{5A8B936A-A824-FD4A-97C9-35C12FAA0A4D}"/>
          </ac:picMkLst>
        </pc:picChg>
      </pc:sldChg>
    </pc:docChg>
  </pc:docChgLst>
  <pc:docChgLst>
    <pc:chgData name="Narang, Sonali" userId="9e80b397-6e2f-49b1-9374-ccdad8589140" providerId="ADAL" clId="{EA661601-9742-7540-8562-E8A6C95A1393}"/>
    <pc:docChg chg="undo redo custSel addSld delSld modSld sldOrd">
      <pc:chgData name="Narang, Sonali" userId="9e80b397-6e2f-49b1-9374-ccdad8589140" providerId="ADAL" clId="{EA661601-9742-7540-8562-E8A6C95A1393}" dt="2021-08-31T19:48:49.674" v="1490" actId="20578"/>
      <pc:docMkLst>
        <pc:docMk/>
      </pc:docMkLst>
      <pc:sldChg chg="addSp delSp modSp del mod addCm delCm">
        <pc:chgData name="Narang, Sonali" userId="9e80b397-6e2f-49b1-9374-ccdad8589140" providerId="ADAL" clId="{EA661601-9742-7540-8562-E8A6C95A1393}" dt="2021-08-30T15:43:35.058" v="621" actId="2696"/>
        <pc:sldMkLst>
          <pc:docMk/>
          <pc:sldMk cId="3911031167" sldId="256"/>
        </pc:sldMkLst>
        <pc:picChg chg="add del">
          <ac:chgData name="Narang, Sonali" userId="9e80b397-6e2f-49b1-9374-ccdad8589140" providerId="ADAL" clId="{EA661601-9742-7540-8562-E8A6C95A1393}" dt="2021-08-30T15:27:38.014" v="505" actId="478"/>
          <ac:picMkLst>
            <pc:docMk/>
            <pc:sldMk cId="3911031167" sldId="256"/>
            <ac:picMk id="2" creationId="{5AA166C9-8C8A-8A49-BB0C-80DCE9F41940}"/>
          </ac:picMkLst>
        </pc:picChg>
        <pc:picChg chg="add del mod modCrop">
          <ac:chgData name="Narang, Sonali" userId="9e80b397-6e2f-49b1-9374-ccdad8589140" providerId="ADAL" clId="{EA661601-9742-7540-8562-E8A6C95A1393}" dt="2021-08-30T15:29:06.510" v="514" actId="21"/>
          <ac:picMkLst>
            <pc:docMk/>
            <pc:sldMk cId="3911031167" sldId="256"/>
            <ac:picMk id="3" creationId="{46919FA5-8047-5646-A170-435897B36204}"/>
          </ac:picMkLst>
        </pc:picChg>
        <pc:picChg chg="add del mod">
          <ac:chgData name="Narang, Sonali" userId="9e80b397-6e2f-49b1-9374-ccdad8589140" providerId="ADAL" clId="{EA661601-9742-7540-8562-E8A6C95A1393}" dt="2021-08-30T15:29:05.215" v="513" actId="478"/>
          <ac:picMkLst>
            <pc:docMk/>
            <pc:sldMk cId="3911031167" sldId="256"/>
            <ac:picMk id="120" creationId="{1283CBB0-9985-3A42-B0AA-519F364B6074}"/>
          </ac:picMkLst>
        </pc:picChg>
      </pc:sldChg>
      <pc:sldChg chg="addSp delSp modSp mod">
        <pc:chgData name="Narang, Sonali" userId="9e80b397-6e2f-49b1-9374-ccdad8589140" providerId="ADAL" clId="{EA661601-9742-7540-8562-E8A6C95A1393}" dt="2021-08-31T19:18:50.053" v="1483" actId="1076"/>
        <pc:sldMkLst>
          <pc:docMk/>
          <pc:sldMk cId="1854626235" sldId="257"/>
        </pc:sldMkLst>
        <pc:spChg chg="add del mod">
          <ac:chgData name="Narang, Sonali" userId="9e80b397-6e2f-49b1-9374-ccdad8589140" providerId="ADAL" clId="{EA661601-9742-7540-8562-E8A6C95A1393}" dt="2021-08-30T16:37:16.236" v="692" actId="478"/>
          <ac:spMkLst>
            <pc:docMk/>
            <pc:sldMk cId="1854626235" sldId="257"/>
            <ac:spMk id="20" creationId="{47B150BC-8659-8549-A10E-149EDBB83B50}"/>
          </ac:spMkLst>
        </pc:spChg>
        <pc:spChg chg="add mod">
          <ac:chgData name="Narang, Sonali" userId="9e80b397-6e2f-49b1-9374-ccdad8589140" providerId="ADAL" clId="{EA661601-9742-7540-8562-E8A6C95A1393}" dt="2021-08-30T17:18:20.618" v="1048" actId="20577"/>
          <ac:spMkLst>
            <pc:docMk/>
            <pc:sldMk cId="1854626235" sldId="257"/>
            <ac:spMk id="21" creationId="{6DE5BA81-9EFB-494A-B561-0386C22C9665}"/>
          </ac:spMkLst>
        </pc:spChg>
        <pc:spChg chg="add mod">
          <ac:chgData name="Narang, Sonali" userId="9e80b397-6e2f-49b1-9374-ccdad8589140" providerId="ADAL" clId="{EA661601-9742-7540-8562-E8A6C95A1393}" dt="2021-08-31T19:18:50.053" v="1483" actId="1076"/>
          <ac:spMkLst>
            <pc:docMk/>
            <pc:sldMk cId="1854626235" sldId="257"/>
            <ac:spMk id="22" creationId="{501252A5-9627-6A46-9C1C-D13750DE3409}"/>
          </ac:spMkLst>
        </pc:spChg>
        <pc:spChg chg="mod">
          <ac:chgData name="Narang, Sonali" userId="9e80b397-6e2f-49b1-9374-ccdad8589140" providerId="ADAL" clId="{EA661601-9742-7540-8562-E8A6C95A1393}" dt="2021-08-30T16:23:14.421" v="650" actId="1036"/>
          <ac:spMkLst>
            <pc:docMk/>
            <pc:sldMk cId="1854626235" sldId="257"/>
            <ac:spMk id="71" creationId="{BDCB7AA1-749D-8C43-AF10-858D8E39FF31}"/>
          </ac:spMkLst>
        </pc:spChg>
        <pc:spChg chg="add mod">
          <ac:chgData name="Narang, Sonali" userId="9e80b397-6e2f-49b1-9374-ccdad8589140" providerId="ADAL" clId="{EA661601-9742-7540-8562-E8A6C95A1393}" dt="2021-08-30T16:38:49.859" v="748" actId="12789"/>
          <ac:spMkLst>
            <pc:docMk/>
            <pc:sldMk cId="1854626235" sldId="257"/>
            <ac:spMk id="72" creationId="{90CCFF70-1378-6D43-8667-AD3C3AF3C177}"/>
          </ac:spMkLst>
        </pc:spChg>
        <pc:spChg chg="add mod">
          <ac:chgData name="Narang, Sonali" userId="9e80b397-6e2f-49b1-9374-ccdad8589140" providerId="ADAL" clId="{EA661601-9742-7540-8562-E8A6C95A1393}" dt="2021-08-30T16:38:49.859" v="748" actId="12789"/>
          <ac:spMkLst>
            <pc:docMk/>
            <pc:sldMk cId="1854626235" sldId="257"/>
            <ac:spMk id="73" creationId="{3402C79D-781C-C242-A2D1-8D957E624560}"/>
          </ac:spMkLst>
        </pc:spChg>
        <pc:spChg chg="add mod">
          <ac:chgData name="Narang, Sonali" userId="9e80b397-6e2f-49b1-9374-ccdad8589140" providerId="ADAL" clId="{EA661601-9742-7540-8562-E8A6C95A1393}" dt="2021-08-30T16:38:49.859" v="748" actId="12789"/>
          <ac:spMkLst>
            <pc:docMk/>
            <pc:sldMk cId="1854626235" sldId="257"/>
            <ac:spMk id="74" creationId="{967BEA32-0C48-ED4C-9910-D7EDEDCC141D}"/>
          </ac:spMkLst>
        </pc:spChg>
        <pc:spChg chg="add mod">
          <ac:chgData name="Narang, Sonali" userId="9e80b397-6e2f-49b1-9374-ccdad8589140" providerId="ADAL" clId="{EA661601-9742-7540-8562-E8A6C95A1393}" dt="2021-08-30T16:38:25.876" v="742" actId="12789"/>
          <ac:spMkLst>
            <pc:docMk/>
            <pc:sldMk cId="1854626235" sldId="257"/>
            <ac:spMk id="75" creationId="{BEDFAA73-9606-8641-B6B3-F2F0790E86F0}"/>
          </ac:spMkLst>
        </pc:spChg>
        <pc:spChg chg="add mod">
          <ac:chgData name="Narang, Sonali" userId="9e80b397-6e2f-49b1-9374-ccdad8589140" providerId="ADAL" clId="{EA661601-9742-7540-8562-E8A6C95A1393}" dt="2021-08-30T16:38:25.876" v="742" actId="12789"/>
          <ac:spMkLst>
            <pc:docMk/>
            <pc:sldMk cId="1854626235" sldId="257"/>
            <ac:spMk id="76" creationId="{2027CEAE-7CD6-1546-8D11-7908F5DCCD3D}"/>
          </ac:spMkLst>
        </pc:spChg>
        <pc:spChg chg="add mod">
          <ac:chgData name="Narang, Sonali" userId="9e80b397-6e2f-49b1-9374-ccdad8589140" providerId="ADAL" clId="{EA661601-9742-7540-8562-E8A6C95A1393}" dt="2021-08-30T16:38:25.876" v="742" actId="12789"/>
          <ac:spMkLst>
            <pc:docMk/>
            <pc:sldMk cId="1854626235" sldId="257"/>
            <ac:spMk id="77" creationId="{82B08ED5-E6CD-A443-A30D-B56A41AA48D5}"/>
          </ac:spMkLst>
        </pc:spChg>
        <pc:spChg chg="add del">
          <ac:chgData name="Narang, Sonali" userId="9e80b397-6e2f-49b1-9374-ccdad8589140" providerId="ADAL" clId="{EA661601-9742-7540-8562-E8A6C95A1393}" dt="2021-08-30T16:23:33.981" v="654" actId="478"/>
          <ac:spMkLst>
            <pc:docMk/>
            <pc:sldMk cId="1854626235" sldId="257"/>
            <ac:spMk id="113" creationId="{426C9910-5D3A-7B42-9C66-E53AF38D5621}"/>
          </ac:spMkLst>
        </pc:spChg>
        <pc:picChg chg="add del mod">
          <ac:chgData name="Narang, Sonali" userId="9e80b397-6e2f-49b1-9374-ccdad8589140" providerId="ADAL" clId="{EA661601-9742-7540-8562-E8A6C95A1393}" dt="2021-08-30T16:32:27.171" v="667" actId="478"/>
          <ac:picMkLst>
            <pc:docMk/>
            <pc:sldMk cId="1854626235" sldId="257"/>
            <ac:picMk id="3" creationId="{CFFD15A9-DA45-E04F-A731-C723E349233D}"/>
          </ac:picMkLst>
        </pc:picChg>
        <pc:picChg chg="add del mod">
          <ac:chgData name="Narang, Sonali" userId="9e80b397-6e2f-49b1-9374-ccdad8589140" providerId="ADAL" clId="{EA661601-9742-7540-8562-E8A6C95A1393}" dt="2021-08-30T16:32:27.171" v="667" actId="478"/>
          <ac:picMkLst>
            <pc:docMk/>
            <pc:sldMk cId="1854626235" sldId="257"/>
            <ac:picMk id="10" creationId="{58EB3DF1-41A5-C84B-8ED8-EB87A0E0FB9B}"/>
          </ac:picMkLst>
        </pc:picChg>
        <pc:picChg chg="add del mod">
          <ac:chgData name="Narang, Sonali" userId="9e80b397-6e2f-49b1-9374-ccdad8589140" providerId="ADAL" clId="{EA661601-9742-7540-8562-E8A6C95A1393}" dt="2021-08-30T16:32:27.171" v="667" actId="478"/>
          <ac:picMkLst>
            <pc:docMk/>
            <pc:sldMk cId="1854626235" sldId="257"/>
            <ac:picMk id="12" creationId="{ECE34117-04CB-824F-A310-CC4D8F787E79}"/>
          </ac:picMkLst>
        </pc:picChg>
        <pc:picChg chg="add mod">
          <ac:chgData name="Narang, Sonali" userId="9e80b397-6e2f-49b1-9374-ccdad8589140" providerId="ADAL" clId="{EA661601-9742-7540-8562-E8A6C95A1393}" dt="2021-08-30T16:34:18.365" v="686" actId="1076"/>
          <ac:picMkLst>
            <pc:docMk/>
            <pc:sldMk cId="1854626235" sldId="257"/>
            <ac:picMk id="15" creationId="{0C43366B-74AB-8345-B18D-005DC6F48F33}"/>
          </ac:picMkLst>
        </pc:picChg>
        <pc:picChg chg="add mod">
          <ac:chgData name="Narang, Sonali" userId="9e80b397-6e2f-49b1-9374-ccdad8589140" providerId="ADAL" clId="{EA661601-9742-7540-8562-E8A6C95A1393}" dt="2021-08-30T16:34:23.927" v="688" actId="1076"/>
          <ac:picMkLst>
            <pc:docMk/>
            <pc:sldMk cId="1854626235" sldId="257"/>
            <ac:picMk id="17" creationId="{53A6B32B-C740-944C-8420-B07C6C3D680F}"/>
          </ac:picMkLst>
        </pc:picChg>
        <pc:picChg chg="add mod">
          <ac:chgData name="Narang, Sonali" userId="9e80b397-6e2f-49b1-9374-ccdad8589140" providerId="ADAL" clId="{EA661601-9742-7540-8562-E8A6C95A1393}" dt="2021-08-30T16:34:28.872" v="690" actId="1076"/>
          <ac:picMkLst>
            <pc:docMk/>
            <pc:sldMk cId="1854626235" sldId="257"/>
            <ac:picMk id="19" creationId="{CE56F4A1-920C-8541-8AA7-1EEC1D2CABE5}"/>
          </ac:picMkLst>
        </pc:picChg>
      </pc:sldChg>
      <pc:sldChg chg="addSp modSp mod ord">
        <pc:chgData name="Narang, Sonali" userId="9e80b397-6e2f-49b1-9374-ccdad8589140" providerId="ADAL" clId="{EA661601-9742-7540-8562-E8A6C95A1393}" dt="2021-08-31T15:44:46.215" v="1295" actId="1076"/>
        <pc:sldMkLst>
          <pc:docMk/>
          <pc:sldMk cId="1155223781" sldId="258"/>
        </pc:sldMkLst>
        <pc:spChg chg="add mod">
          <ac:chgData name="Narang, Sonali" userId="9e80b397-6e2f-49b1-9374-ccdad8589140" providerId="ADAL" clId="{EA661601-9742-7540-8562-E8A6C95A1393}" dt="2021-08-31T15:44:46.215" v="1295" actId="1076"/>
          <ac:spMkLst>
            <pc:docMk/>
            <pc:sldMk cId="1155223781" sldId="258"/>
            <ac:spMk id="12" creationId="{804B0FA4-BEC3-674A-8EFA-E6EB5541FC86}"/>
          </ac:spMkLst>
        </pc:spChg>
        <pc:picChg chg="add mod">
          <ac:chgData name="Narang, Sonali" userId="9e80b397-6e2f-49b1-9374-ccdad8589140" providerId="ADAL" clId="{EA661601-9742-7540-8562-E8A6C95A1393}" dt="2021-08-31T15:44:46.215" v="1295" actId="1076"/>
          <ac:picMkLst>
            <pc:docMk/>
            <pc:sldMk cId="1155223781" sldId="258"/>
            <ac:picMk id="3" creationId="{D49EBF3A-936F-A84B-BFCB-0F6E673B1E30}"/>
          </ac:picMkLst>
        </pc:picChg>
      </pc:sldChg>
      <pc:sldChg chg="modSp mod">
        <pc:chgData name="Narang, Sonali" userId="9e80b397-6e2f-49b1-9374-ccdad8589140" providerId="ADAL" clId="{EA661601-9742-7540-8562-E8A6C95A1393}" dt="2021-08-25T16:48:07.642" v="351" actId="20577"/>
        <pc:sldMkLst>
          <pc:docMk/>
          <pc:sldMk cId="209215240" sldId="259"/>
        </pc:sldMkLst>
        <pc:spChg chg="mod">
          <ac:chgData name="Narang, Sonali" userId="9e80b397-6e2f-49b1-9374-ccdad8589140" providerId="ADAL" clId="{EA661601-9742-7540-8562-E8A6C95A1393}" dt="2021-08-25T16:48:07.642" v="351" actId="20577"/>
          <ac:spMkLst>
            <pc:docMk/>
            <pc:sldMk cId="209215240" sldId="259"/>
            <ac:spMk id="4" creationId="{F6669B9D-B042-D548-BD0F-97015091799B}"/>
          </ac:spMkLst>
        </pc:spChg>
      </pc:sldChg>
      <pc:sldChg chg="addSp delSp modSp mod ord addCm delCm">
        <pc:chgData name="Narang, Sonali" userId="9e80b397-6e2f-49b1-9374-ccdad8589140" providerId="ADAL" clId="{EA661601-9742-7540-8562-E8A6C95A1393}" dt="2021-08-30T14:54:10.244" v="428" actId="20578"/>
        <pc:sldMkLst>
          <pc:docMk/>
          <pc:sldMk cId="2209615388" sldId="260"/>
        </pc:sldMkLst>
        <pc:spChg chg="mod">
          <ac:chgData name="Narang, Sonali" userId="9e80b397-6e2f-49b1-9374-ccdad8589140" providerId="ADAL" clId="{EA661601-9742-7540-8562-E8A6C95A1393}" dt="2021-08-25T16:47:51.946" v="349" actId="20577"/>
          <ac:spMkLst>
            <pc:docMk/>
            <pc:sldMk cId="2209615388" sldId="260"/>
            <ac:spMk id="4" creationId="{F6669B9D-B042-D548-BD0F-97015091799B}"/>
          </ac:spMkLst>
        </pc:spChg>
        <pc:spChg chg="mod">
          <ac:chgData name="Narang, Sonali" userId="9e80b397-6e2f-49b1-9374-ccdad8589140" providerId="ADAL" clId="{EA661601-9742-7540-8562-E8A6C95A1393}" dt="2021-08-25T16:46:58.435" v="314" actId="1076"/>
          <ac:spMkLst>
            <pc:docMk/>
            <pc:sldMk cId="2209615388" sldId="260"/>
            <ac:spMk id="5" creationId="{FAFFEC37-A0C5-5846-8534-22E3DEF6CEF4}"/>
          </ac:spMkLst>
        </pc:spChg>
        <pc:spChg chg="mod">
          <ac:chgData name="Narang, Sonali" userId="9e80b397-6e2f-49b1-9374-ccdad8589140" providerId="ADAL" clId="{EA661601-9742-7540-8562-E8A6C95A1393}" dt="2021-08-25T16:47:03.157" v="315" actId="1076"/>
          <ac:spMkLst>
            <pc:docMk/>
            <pc:sldMk cId="2209615388" sldId="260"/>
            <ac:spMk id="6" creationId="{41464C80-B659-484D-A16F-8018DEC5471A}"/>
          </ac:spMkLst>
        </pc:spChg>
        <pc:spChg chg="mod">
          <ac:chgData name="Narang, Sonali" userId="9e80b397-6e2f-49b1-9374-ccdad8589140" providerId="ADAL" clId="{EA661601-9742-7540-8562-E8A6C95A1393}" dt="2021-08-25T16:47:11.028" v="316" actId="1076"/>
          <ac:spMkLst>
            <pc:docMk/>
            <pc:sldMk cId="2209615388" sldId="260"/>
            <ac:spMk id="7" creationId="{4C5F5CAE-FBFD-964D-A356-746AAC86DC9E}"/>
          </ac:spMkLst>
        </pc:spChg>
        <pc:spChg chg="mod">
          <ac:chgData name="Narang, Sonali" userId="9e80b397-6e2f-49b1-9374-ccdad8589140" providerId="ADAL" clId="{EA661601-9742-7540-8562-E8A6C95A1393}" dt="2021-08-25T16:47:36.975" v="335" actId="1076"/>
          <ac:spMkLst>
            <pc:docMk/>
            <pc:sldMk cId="2209615388" sldId="260"/>
            <ac:spMk id="8" creationId="{8A9BAE78-C4FF-1843-94F6-3410EB884848}"/>
          </ac:spMkLst>
        </pc:spChg>
        <pc:spChg chg="del">
          <ac:chgData name="Narang, Sonali" userId="9e80b397-6e2f-49b1-9374-ccdad8589140" providerId="ADAL" clId="{EA661601-9742-7540-8562-E8A6C95A1393}" dt="2021-08-23T20:03:45.544" v="221" actId="478"/>
          <ac:spMkLst>
            <pc:docMk/>
            <pc:sldMk cId="2209615388" sldId="260"/>
            <ac:spMk id="10" creationId="{5BCE36BA-509D-494A-96F7-EBB2E2AD0A92}"/>
          </ac:spMkLst>
        </pc:spChg>
        <pc:picChg chg="mod">
          <ac:chgData name="Narang, Sonali" userId="9e80b397-6e2f-49b1-9374-ccdad8589140" providerId="ADAL" clId="{EA661601-9742-7540-8562-E8A6C95A1393}" dt="2021-08-25T16:47:40.894" v="336" actId="1076"/>
          <ac:picMkLst>
            <pc:docMk/>
            <pc:sldMk cId="2209615388" sldId="260"/>
            <ac:picMk id="2" creationId="{FFF37771-971D-4C4C-B781-0D37188A46A1}"/>
          </ac:picMkLst>
        </pc:picChg>
        <pc:picChg chg="mod">
          <ac:chgData name="Narang, Sonali" userId="9e80b397-6e2f-49b1-9374-ccdad8589140" providerId="ADAL" clId="{EA661601-9742-7540-8562-E8A6C95A1393}" dt="2021-08-25T16:47:40.894" v="336" actId="1076"/>
          <ac:picMkLst>
            <pc:docMk/>
            <pc:sldMk cId="2209615388" sldId="260"/>
            <ac:picMk id="3" creationId="{969BAEF7-6218-824D-A489-ADB0661F7F74}"/>
          </ac:picMkLst>
        </pc:picChg>
        <pc:picChg chg="mod">
          <ac:chgData name="Narang, Sonali" userId="9e80b397-6e2f-49b1-9374-ccdad8589140" providerId="ADAL" clId="{EA661601-9742-7540-8562-E8A6C95A1393}" dt="2021-08-25T16:47:40.894" v="336" actId="1076"/>
          <ac:picMkLst>
            <pc:docMk/>
            <pc:sldMk cId="2209615388" sldId="260"/>
            <ac:picMk id="9" creationId="{EE74AD70-F2BB-734D-B341-9CB9C96FD28C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1" creationId="{360F0190-AC51-DD4F-A85A-3A17C0E17B8A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2" creationId="{586F5557-2C65-A74F-B317-8E0706626B84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3" creationId="{AC373017-3803-E844-AEF9-7AA58D31C509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5" creationId="{102B2DA4-BF6C-B44F-BFD4-34128031542E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7" creationId="{52D1DD20-D46E-6048-80AC-3F937064F5A2}"/>
          </ac:picMkLst>
        </pc:picChg>
        <pc:picChg chg="add mod">
          <ac:chgData name="Narang, Sonali" userId="9e80b397-6e2f-49b1-9374-ccdad8589140" providerId="ADAL" clId="{EA661601-9742-7540-8562-E8A6C95A1393}" dt="2021-08-25T16:47:28.986" v="334" actId="167"/>
          <ac:picMkLst>
            <pc:docMk/>
            <pc:sldMk cId="2209615388" sldId="260"/>
            <ac:picMk id="19" creationId="{FDFCA230-8A82-9B4E-BD87-36E627CB71AB}"/>
          </ac:picMkLst>
        </pc:picChg>
        <pc:picChg chg="add mod modCrop">
          <ac:chgData name="Narang, Sonali" userId="9e80b397-6e2f-49b1-9374-ccdad8589140" providerId="ADAL" clId="{EA661601-9742-7540-8562-E8A6C95A1393}" dt="2021-08-25T16:46:54.135" v="313" actId="167"/>
          <ac:picMkLst>
            <pc:docMk/>
            <pc:sldMk cId="2209615388" sldId="260"/>
            <ac:picMk id="21" creationId="{BC034324-62BB-9447-8AFF-4381E3007CAF}"/>
          </ac:picMkLst>
        </pc:picChg>
        <pc:picChg chg="add mod modCrop">
          <ac:chgData name="Narang, Sonali" userId="9e80b397-6e2f-49b1-9374-ccdad8589140" providerId="ADAL" clId="{EA661601-9742-7540-8562-E8A6C95A1393}" dt="2021-08-25T16:46:49.231" v="312" actId="408"/>
          <ac:picMkLst>
            <pc:docMk/>
            <pc:sldMk cId="2209615388" sldId="260"/>
            <ac:picMk id="23" creationId="{5101B775-381A-5A4C-B599-B67845C018C5}"/>
          </ac:picMkLst>
        </pc:picChg>
        <pc:picChg chg="add mod">
          <ac:chgData name="Narang, Sonali" userId="9e80b397-6e2f-49b1-9374-ccdad8589140" providerId="ADAL" clId="{EA661601-9742-7540-8562-E8A6C95A1393}" dt="2021-08-25T16:46:49.231" v="312" actId="408"/>
          <ac:picMkLst>
            <pc:docMk/>
            <pc:sldMk cId="2209615388" sldId="260"/>
            <ac:picMk id="25" creationId="{823F62DB-3D92-A444-92E1-A60A5115EFD6}"/>
          </ac:picMkLst>
        </pc:picChg>
      </pc:sldChg>
      <pc:sldChg chg="add del">
        <pc:chgData name="Narang, Sonali" userId="9e80b397-6e2f-49b1-9374-ccdad8589140" providerId="ADAL" clId="{EA661601-9742-7540-8562-E8A6C95A1393}" dt="2021-08-23T17:43:08.706" v="2" actId="2696"/>
        <pc:sldMkLst>
          <pc:docMk/>
          <pc:sldMk cId="304432944" sldId="261"/>
        </pc:sldMkLst>
      </pc:sldChg>
      <pc:sldChg chg="addSp delSp modSp del mod">
        <pc:chgData name="Narang, Sonali" userId="9e80b397-6e2f-49b1-9374-ccdad8589140" providerId="ADAL" clId="{EA661601-9742-7540-8562-E8A6C95A1393}" dt="2021-08-30T17:29:11.290" v="1151" actId="2696"/>
        <pc:sldMkLst>
          <pc:docMk/>
          <pc:sldMk cId="2188698368" sldId="266"/>
        </pc:sldMkLst>
        <pc:spChg chg="mod">
          <ac:chgData name="Narang, Sonali" userId="9e80b397-6e2f-49b1-9374-ccdad8589140" providerId="ADAL" clId="{EA661601-9742-7540-8562-E8A6C95A1393}" dt="2021-08-23T19:41:59.939" v="184" actId="1038"/>
          <ac:spMkLst>
            <pc:docMk/>
            <pc:sldMk cId="2188698368" sldId="266"/>
            <ac:spMk id="6" creationId="{41464C80-B659-484D-A16F-8018DEC5471A}"/>
          </ac:spMkLst>
        </pc:spChg>
        <pc:spChg chg="del">
          <ac:chgData name="Narang, Sonali" userId="9e80b397-6e2f-49b1-9374-ccdad8589140" providerId="ADAL" clId="{EA661601-9742-7540-8562-E8A6C95A1393}" dt="2021-08-23T19:08:53.580" v="143" actId="478"/>
          <ac:spMkLst>
            <pc:docMk/>
            <pc:sldMk cId="2188698368" sldId="266"/>
            <ac:spMk id="109" creationId="{BEE82DA0-23D4-9844-9F18-D3B4989D6DF5}"/>
          </ac:spMkLst>
        </pc:spChg>
        <pc:picChg chg="add del">
          <ac:chgData name="Narang, Sonali" userId="9e80b397-6e2f-49b1-9374-ccdad8589140" providerId="ADAL" clId="{EA661601-9742-7540-8562-E8A6C95A1393}" dt="2021-08-30T17:06:49.252" v="797" actId="478"/>
          <ac:picMkLst>
            <pc:docMk/>
            <pc:sldMk cId="2188698368" sldId="266"/>
            <ac:picMk id="2" creationId="{87DC89C9-A99E-DC48-AA62-4F2EC703646C}"/>
          </ac:picMkLst>
        </pc:picChg>
        <pc:picChg chg="add mod">
          <ac:chgData name="Narang, Sonali" userId="9e80b397-6e2f-49b1-9374-ccdad8589140" providerId="ADAL" clId="{EA661601-9742-7540-8562-E8A6C95A1393}" dt="2021-08-23T19:41:56.611" v="176" actId="1038"/>
          <ac:picMkLst>
            <pc:docMk/>
            <pc:sldMk cId="2188698368" sldId="266"/>
            <ac:picMk id="3" creationId="{8D46FA96-CD3D-0047-90E5-A1D1D7788A8F}"/>
          </ac:picMkLst>
        </pc:picChg>
        <pc:picChg chg="add mod">
          <ac:chgData name="Narang, Sonali" userId="9e80b397-6e2f-49b1-9374-ccdad8589140" providerId="ADAL" clId="{EA661601-9742-7540-8562-E8A6C95A1393}" dt="2021-08-23T19:47:20.017" v="207" actId="1076"/>
          <ac:picMkLst>
            <pc:docMk/>
            <pc:sldMk cId="2188698368" sldId="266"/>
            <ac:picMk id="12" creationId="{29BE988C-D668-BD46-A177-BE08A2B0066A}"/>
          </ac:picMkLst>
        </pc:picChg>
        <pc:picChg chg="add mod">
          <ac:chgData name="Narang, Sonali" userId="9e80b397-6e2f-49b1-9374-ccdad8589140" providerId="ADAL" clId="{EA661601-9742-7540-8562-E8A6C95A1393}" dt="2021-08-23T19:47:17" v="206" actId="1076"/>
          <ac:picMkLst>
            <pc:docMk/>
            <pc:sldMk cId="2188698368" sldId="266"/>
            <ac:picMk id="14" creationId="{0DA86CA6-7473-6B4E-BF22-0884298EE04F}"/>
          </ac:picMkLst>
        </pc:picChg>
        <pc:picChg chg="add mod">
          <ac:chgData name="Narang, Sonali" userId="9e80b397-6e2f-49b1-9374-ccdad8589140" providerId="ADAL" clId="{EA661601-9742-7540-8562-E8A6C95A1393}" dt="2021-08-23T19:47:12.762" v="205" actId="1076"/>
          <ac:picMkLst>
            <pc:docMk/>
            <pc:sldMk cId="2188698368" sldId="266"/>
            <ac:picMk id="16" creationId="{0431DD33-487F-1744-895E-CD1CBD9FCEF2}"/>
          </ac:picMkLst>
        </pc:picChg>
        <pc:picChg chg="add del mod">
          <ac:chgData name="Narang, Sonali" userId="9e80b397-6e2f-49b1-9374-ccdad8589140" providerId="ADAL" clId="{EA661601-9742-7540-8562-E8A6C95A1393}" dt="2021-08-23T20:03:33.083" v="218" actId="21"/>
          <ac:picMkLst>
            <pc:docMk/>
            <pc:sldMk cId="2188698368" sldId="266"/>
            <ac:picMk id="18" creationId="{92ABA05B-FAFF-AD42-BDC7-C569EE080BD6}"/>
          </ac:picMkLst>
        </pc:picChg>
        <pc:picChg chg="add del mod">
          <ac:chgData name="Narang, Sonali" userId="9e80b397-6e2f-49b1-9374-ccdad8589140" providerId="ADAL" clId="{EA661601-9742-7540-8562-E8A6C95A1393}" dt="2021-08-23T20:03:33.083" v="218" actId="21"/>
          <ac:picMkLst>
            <pc:docMk/>
            <pc:sldMk cId="2188698368" sldId="266"/>
            <ac:picMk id="20" creationId="{4A95339B-9530-A641-A458-55A70953BDBA}"/>
          </ac:picMkLst>
        </pc:picChg>
        <pc:picChg chg="add del mod">
          <ac:chgData name="Narang, Sonali" userId="9e80b397-6e2f-49b1-9374-ccdad8589140" providerId="ADAL" clId="{EA661601-9742-7540-8562-E8A6C95A1393}" dt="2021-08-23T20:03:33.083" v="218" actId="21"/>
          <ac:picMkLst>
            <pc:docMk/>
            <pc:sldMk cId="2188698368" sldId="266"/>
            <ac:picMk id="22" creationId="{8FA6F6C9-FE95-DD4C-935E-6E3B5DD445B0}"/>
          </ac:picMkLst>
        </pc:picChg>
        <pc:picChg chg="mod">
          <ac:chgData name="Narang, Sonali" userId="9e80b397-6e2f-49b1-9374-ccdad8589140" providerId="ADAL" clId="{EA661601-9742-7540-8562-E8A6C95A1393}" dt="2021-08-23T19:41:56.611" v="176" actId="1038"/>
          <ac:picMkLst>
            <pc:docMk/>
            <pc:sldMk cId="2188698368" sldId="266"/>
            <ac:picMk id="83" creationId="{A2DC379C-9BE3-8847-8A10-2744CD535286}"/>
          </ac:picMkLst>
        </pc:picChg>
        <pc:picChg chg="del">
          <ac:chgData name="Narang, Sonali" userId="9e80b397-6e2f-49b1-9374-ccdad8589140" providerId="ADAL" clId="{EA661601-9742-7540-8562-E8A6C95A1393}" dt="2021-08-23T19:08:54.504" v="144" actId="478"/>
          <ac:picMkLst>
            <pc:docMk/>
            <pc:sldMk cId="2188698368" sldId="266"/>
            <ac:picMk id="84" creationId="{4D67AF32-BEDD-0B4F-8E91-8B21283BC598}"/>
          </ac:picMkLst>
        </pc:picChg>
        <pc:picChg chg="mod">
          <ac:chgData name="Narang, Sonali" userId="9e80b397-6e2f-49b1-9374-ccdad8589140" providerId="ADAL" clId="{EA661601-9742-7540-8562-E8A6C95A1393}" dt="2021-08-23T19:41:56.611" v="176" actId="1038"/>
          <ac:picMkLst>
            <pc:docMk/>
            <pc:sldMk cId="2188698368" sldId="266"/>
            <ac:picMk id="111" creationId="{20BB0087-4AF3-7B49-A354-5C3664D1250B}"/>
          </ac:picMkLst>
        </pc:picChg>
        <pc:picChg chg="mod">
          <ac:chgData name="Narang, Sonali" userId="9e80b397-6e2f-49b1-9374-ccdad8589140" providerId="ADAL" clId="{EA661601-9742-7540-8562-E8A6C95A1393}" dt="2021-08-23T19:41:56.611" v="176" actId="1038"/>
          <ac:picMkLst>
            <pc:docMk/>
            <pc:sldMk cId="2188698368" sldId="266"/>
            <ac:picMk id="114" creationId="{CD79A9EC-0F7C-6141-93B3-F5755D6371C7}"/>
          </ac:picMkLst>
        </pc:picChg>
        <pc:picChg chg="mod">
          <ac:chgData name="Narang, Sonali" userId="9e80b397-6e2f-49b1-9374-ccdad8589140" providerId="ADAL" clId="{EA661601-9742-7540-8562-E8A6C95A1393}" dt="2021-08-23T19:41:56.611" v="176" actId="1038"/>
          <ac:picMkLst>
            <pc:docMk/>
            <pc:sldMk cId="2188698368" sldId="266"/>
            <ac:picMk id="116" creationId="{66C157FD-9F4F-EE4C-9C7A-F66F0D902C3A}"/>
          </ac:picMkLst>
        </pc:picChg>
      </pc:sldChg>
      <pc:sldChg chg="addSp delSp modSp mod ord">
        <pc:chgData name="Narang, Sonali" userId="9e80b397-6e2f-49b1-9374-ccdad8589140" providerId="ADAL" clId="{EA661601-9742-7540-8562-E8A6C95A1393}" dt="2021-08-31T19:48:49.674" v="1490" actId="20578"/>
        <pc:sldMkLst>
          <pc:docMk/>
          <pc:sldMk cId="743684689" sldId="267"/>
        </pc:sldMkLst>
        <pc:spChg chg="mod">
          <ac:chgData name="Narang, Sonali" userId="9e80b397-6e2f-49b1-9374-ccdad8589140" providerId="ADAL" clId="{EA661601-9742-7540-8562-E8A6C95A1393}" dt="2021-08-31T18:42:36.229" v="1453" actId="1076"/>
          <ac:spMkLst>
            <pc:docMk/>
            <pc:sldMk cId="743684689" sldId="267"/>
            <ac:spMk id="9" creationId="{2395522A-CD93-9340-9E6D-567013DF6E38}"/>
          </ac:spMkLst>
        </pc:spChg>
        <pc:spChg chg="mod">
          <ac:chgData name="Narang, Sonali" userId="9e80b397-6e2f-49b1-9374-ccdad8589140" providerId="ADAL" clId="{EA661601-9742-7540-8562-E8A6C95A1393}" dt="2021-08-30T17:27:24.998" v="1149" actId="1038"/>
          <ac:spMkLst>
            <pc:docMk/>
            <pc:sldMk cId="743684689" sldId="267"/>
            <ac:spMk id="127" creationId="{94889990-09DE-4F40-B40A-C999655F9C08}"/>
          </ac:spMkLst>
        </pc:spChg>
        <pc:spChg chg="mod">
          <ac:chgData name="Narang, Sonali" userId="9e80b397-6e2f-49b1-9374-ccdad8589140" providerId="ADAL" clId="{EA661601-9742-7540-8562-E8A6C95A1393}" dt="2021-08-30T17:27:18.332" v="1146" actId="1038"/>
          <ac:spMkLst>
            <pc:docMk/>
            <pc:sldMk cId="743684689" sldId="267"/>
            <ac:spMk id="130" creationId="{B1493AFF-CA4E-6F4D-A0BA-1B90E4BA8A6E}"/>
          </ac:spMkLst>
        </pc:spChg>
        <pc:spChg chg="mod">
          <ac:chgData name="Narang, Sonali" userId="9e80b397-6e2f-49b1-9374-ccdad8589140" providerId="ADAL" clId="{EA661601-9742-7540-8562-E8A6C95A1393}" dt="2021-08-30T17:26:49.608" v="1123" actId="1037"/>
          <ac:spMkLst>
            <pc:docMk/>
            <pc:sldMk cId="743684689" sldId="267"/>
            <ac:spMk id="136" creationId="{7BA734D9-1292-B040-BE44-09C087C7A082}"/>
          </ac:spMkLst>
        </pc:spChg>
        <pc:spChg chg="mod">
          <ac:chgData name="Narang, Sonali" userId="9e80b397-6e2f-49b1-9374-ccdad8589140" providerId="ADAL" clId="{EA661601-9742-7540-8562-E8A6C95A1393}" dt="2021-08-30T17:26:53.386" v="1130" actId="1037"/>
          <ac:spMkLst>
            <pc:docMk/>
            <pc:sldMk cId="743684689" sldId="267"/>
            <ac:spMk id="137" creationId="{72728502-C49A-1D4E-8A34-7FA18ED858C4}"/>
          </ac:spMkLst>
        </pc:spChg>
        <pc:spChg chg="mod">
          <ac:chgData name="Narang, Sonali" userId="9e80b397-6e2f-49b1-9374-ccdad8589140" providerId="ADAL" clId="{EA661601-9742-7540-8562-E8A6C95A1393}" dt="2021-08-30T17:27:10.745" v="1142" actId="1037"/>
          <ac:spMkLst>
            <pc:docMk/>
            <pc:sldMk cId="743684689" sldId="267"/>
            <ac:spMk id="147" creationId="{9A109801-764A-424C-A341-23242F15F561}"/>
          </ac:spMkLst>
        </pc:spChg>
        <pc:spChg chg="mod">
          <ac:chgData name="Narang, Sonali" userId="9e80b397-6e2f-49b1-9374-ccdad8589140" providerId="ADAL" clId="{EA661601-9742-7540-8562-E8A6C95A1393}" dt="2021-08-30T17:27:07.943" v="1137" actId="1038"/>
          <ac:spMkLst>
            <pc:docMk/>
            <pc:sldMk cId="743684689" sldId="267"/>
            <ac:spMk id="148" creationId="{EA11B04E-C8FF-4842-9F12-E83E6092CA91}"/>
          </ac:spMkLst>
        </pc:spChg>
        <pc:spChg chg="add del mod">
          <ac:chgData name="Narang, Sonali" userId="9e80b397-6e2f-49b1-9374-ccdad8589140" providerId="ADAL" clId="{EA661601-9742-7540-8562-E8A6C95A1393}" dt="2021-08-30T14:54:17.555" v="432" actId="478"/>
          <ac:spMkLst>
            <pc:docMk/>
            <pc:sldMk cId="743684689" sldId="267"/>
            <ac:spMk id="175" creationId="{6DB4CC1F-44E0-784A-8E95-0054829DDB67}"/>
          </ac:spMkLst>
        </pc:spChg>
        <pc:spChg chg="add del mod">
          <ac:chgData name="Narang, Sonali" userId="9e80b397-6e2f-49b1-9374-ccdad8589140" providerId="ADAL" clId="{EA661601-9742-7540-8562-E8A6C95A1393}" dt="2021-08-30T14:54:17.327" v="431" actId="478"/>
          <ac:spMkLst>
            <pc:docMk/>
            <pc:sldMk cId="743684689" sldId="267"/>
            <ac:spMk id="176" creationId="{9FA30454-C308-294C-8E43-A31F1FDCB395}"/>
          </ac:spMkLst>
        </pc:spChg>
        <pc:grpChg chg="mod">
          <ac:chgData name="Narang, Sonali" userId="9e80b397-6e2f-49b1-9374-ccdad8589140" providerId="ADAL" clId="{EA661601-9742-7540-8562-E8A6C95A1393}" dt="2021-08-30T13:49:36.400" v="408" actId="1038"/>
          <ac:grpSpMkLst>
            <pc:docMk/>
            <pc:sldMk cId="743684689" sldId="267"/>
            <ac:grpSpMk id="28" creationId="{93914C90-1944-5F48-8DBD-1C5C8C5416FC}"/>
          </ac:grpSpMkLst>
        </pc:grpChg>
        <pc:graphicFrameChg chg="add del mod">
          <ac:chgData name="Narang, Sonali" userId="9e80b397-6e2f-49b1-9374-ccdad8589140" providerId="ADAL" clId="{EA661601-9742-7540-8562-E8A6C95A1393}" dt="2021-08-30T18:43:00.595" v="1217" actId="478"/>
          <ac:graphicFrameMkLst>
            <pc:docMk/>
            <pc:sldMk cId="743684689" sldId="267"/>
            <ac:graphicFrameMk id="14" creationId="{AA3B6375-ACC6-8B49-8855-2AE35EB6061A}"/>
          </ac:graphicFrameMkLst>
        </pc:graphicFrameChg>
        <pc:picChg chg="add mod">
          <ac:chgData name="Narang, Sonali" userId="9e80b397-6e2f-49b1-9374-ccdad8589140" providerId="ADAL" clId="{EA661601-9742-7540-8562-E8A6C95A1393}" dt="2021-08-30T18:41:01.063" v="1192" actId="1076"/>
          <ac:picMkLst>
            <pc:docMk/>
            <pc:sldMk cId="743684689" sldId="267"/>
            <ac:picMk id="11" creationId="{D902ECD4-3975-734B-BF76-59FF156155C0}"/>
          </ac:picMkLst>
        </pc:picChg>
        <pc:picChg chg="add mod">
          <ac:chgData name="Narang, Sonali" userId="9e80b397-6e2f-49b1-9374-ccdad8589140" providerId="ADAL" clId="{EA661601-9742-7540-8562-E8A6C95A1393}" dt="2021-08-30T18:40:47.282" v="1189" actId="1076"/>
          <ac:picMkLst>
            <pc:docMk/>
            <pc:sldMk cId="743684689" sldId="267"/>
            <ac:picMk id="13" creationId="{8E13C50A-DD07-A546-AF0A-4883E062BFDF}"/>
          </ac:picMkLst>
        </pc:picChg>
        <pc:picChg chg="add mod">
          <ac:chgData name="Narang, Sonali" userId="9e80b397-6e2f-49b1-9374-ccdad8589140" providerId="ADAL" clId="{EA661601-9742-7540-8562-E8A6C95A1393}" dt="2021-08-31T18:39:07.251" v="1445" actId="1076"/>
          <ac:picMkLst>
            <pc:docMk/>
            <pc:sldMk cId="743684689" sldId="267"/>
            <ac:picMk id="16" creationId="{C9CE085B-61F2-AA4B-8F58-F88F0A94B661}"/>
          </ac:picMkLst>
        </pc:picChg>
        <pc:picChg chg="add mod">
          <ac:chgData name="Narang, Sonali" userId="9e80b397-6e2f-49b1-9374-ccdad8589140" providerId="ADAL" clId="{EA661601-9742-7540-8562-E8A6C95A1393}" dt="2021-08-31T18:38:56.856" v="1444" actId="1076"/>
          <ac:picMkLst>
            <pc:docMk/>
            <pc:sldMk cId="743684689" sldId="267"/>
            <ac:picMk id="18" creationId="{047CD297-ED95-FF4A-ABA6-C68E93587F01}"/>
          </ac:picMkLst>
        </pc:picChg>
        <pc:picChg chg="add mod">
          <ac:chgData name="Narang, Sonali" userId="9e80b397-6e2f-49b1-9374-ccdad8589140" providerId="ADAL" clId="{EA661601-9742-7540-8562-E8A6C95A1393}" dt="2021-08-31T18:38:44.256" v="1437" actId="1076"/>
          <ac:picMkLst>
            <pc:docMk/>
            <pc:sldMk cId="743684689" sldId="267"/>
            <ac:picMk id="20" creationId="{351CFE50-BCA5-774A-BD56-C164E68885EE}"/>
          </ac:picMkLst>
        </pc:picChg>
        <pc:picChg chg="add mod">
          <ac:chgData name="Narang, Sonali" userId="9e80b397-6e2f-49b1-9374-ccdad8589140" providerId="ADAL" clId="{EA661601-9742-7540-8562-E8A6C95A1393}" dt="2021-08-31T18:38:51.691" v="1442" actId="1076"/>
          <ac:picMkLst>
            <pc:docMk/>
            <pc:sldMk cId="743684689" sldId="267"/>
            <ac:picMk id="22" creationId="{AD59D98B-8498-654C-B0A9-3852F301B65D}"/>
          </ac:picMkLst>
        </pc:picChg>
        <pc:picChg chg="add mod">
          <ac:chgData name="Narang, Sonali" userId="9e80b397-6e2f-49b1-9374-ccdad8589140" providerId="ADAL" clId="{EA661601-9742-7540-8562-E8A6C95A1393}" dt="2021-08-31T18:38:44.256" v="1437" actId="1076"/>
          <ac:picMkLst>
            <pc:docMk/>
            <pc:sldMk cId="743684689" sldId="267"/>
            <ac:picMk id="25" creationId="{56B83F54-5D58-2144-825D-4F6099AE3C05}"/>
          </ac:picMkLst>
        </pc:picChg>
        <pc:picChg chg="add mod">
          <ac:chgData name="Narang, Sonali" userId="9e80b397-6e2f-49b1-9374-ccdad8589140" providerId="ADAL" clId="{EA661601-9742-7540-8562-E8A6C95A1393}" dt="2021-08-31T18:38:49.536" v="1441" actId="1076"/>
          <ac:picMkLst>
            <pc:docMk/>
            <pc:sldMk cId="743684689" sldId="267"/>
            <ac:picMk id="27" creationId="{85D9C7E0-5A68-6842-880B-6B71D11E29BE}"/>
          </ac:picMkLst>
        </pc:picChg>
        <pc:picChg chg="mod">
          <ac:chgData name="Narang, Sonali" userId="9e80b397-6e2f-49b1-9374-ccdad8589140" providerId="ADAL" clId="{EA661601-9742-7540-8562-E8A6C95A1393}" dt="2021-08-31T18:39:57.381" v="1447" actId="1076"/>
          <ac:picMkLst>
            <pc:docMk/>
            <pc:sldMk cId="743684689" sldId="267"/>
            <ac:picMk id="63" creationId="{F2221C12-094C-AD43-99ED-F4C4EE93B505}"/>
          </ac:picMkLst>
        </pc:picChg>
        <pc:picChg chg="del">
          <ac:chgData name="Narang, Sonali" userId="9e80b397-6e2f-49b1-9374-ccdad8589140" providerId="ADAL" clId="{EA661601-9742-7540-8562-E8A6C95A1393}" dt="2021-08-27T18:21:38.510" v="352" actId="478"/>
          <ac:picMkLst>
            <pc:docMk/>
            <pc:sldMk cId="743684689" sldId="267"/>
            <ac:picMk id="99" creationId="{D6F82ACC-3C2B-E44A-8008-570B303FD297}"/>
          </ac:picMkLst>
        </pc:picChg>
        <pc:picChg chg="mod">
          <ac:chgData name="Narang, Sonali" userId="9e80b397-6e2f-49b1-9374-ccdad8589140" providerId="ADAL" clId="{EA661601-9742-7540-8562-E8A6C95A1393}" dt="2021-08-30T18:41:03.048" v="1193" actId="1076"/>
          <ac:picMkLst>
            <pc:docMk/>
            <pc:sldMk cId="743684689" sldId="267"/>
            <ac:picMk id="105" creationId="{97BF178D-FAD3-E44E-B50E-E66B7B262246}"/>
          </ac:picMkLst>
        </pc:picChg>
        <pc:picChg chg="add del">
          <ac:chgData name="Narang, Sonali" userId="9e80b397-6e2f-49b1-9374-ccdad8589140" providerId="ADAL" clId="{EA661601-9742-7540-8562-E8A6C95A1393}" dt="2021-08-30T14:57:21.846" v="493" actId="21"/>
          <ac:picMkLst>
            <pc:docMk/>
            <pc:sldMk cId="743684689" sldId="267"/>
            <ac:picMk id="167" creationId="{58CAA980-D1E6-AA4C-A334-C0D57A74D895}"/>
          </ac:picMkLst>
        </pc:picChg>
        <pc:picChg chg="add del">
          <ac:chgData name="Narang, Sonali" userId="9e80b397-6e2f-49b1-9374-ccdad8589140" providerId="ADAL" clId="{EA661601-9742-7540-8562-E8A6C95A1393}" dt="2021-08-30T14:57:21.846" v="493" actId="21"/>
          <ac:picMkLst>
            <pc:docMk/>
            <pc:sldMk cId="743684689" sldId="267"/>
            <ac:picMk id="169" creationId="{5A30999A-89D7-8C40-9571-87F0979C7EAA}"/>
          </ac:picMkLst>
        </pc:picChg>
        <pc:picChg chg="add del">
          <ac:chgData name="Narang, Sonali" userId="9e80b397-6e2f-49b1-9374-ccdad8589140" providerId="ADAL" clId="{EA661601-9742-7540-8562-E8A6C95A1393}" dt="2021-08-30T14:57:21.846" v="493" actId="21"/>
          <ac:picMkLst>
            <pc:docMk/>
            <pc:sldMk cId="743684689" sldId="267"/>
            <ac:picMk id="171" creationId="{9C4DDE62-3BC7-ED45-A82E-A3C21D506B79}"/>
          </ac:picMkLst>
        </pc:picChg>
      </pc:sldChg>
      <pc:sldChg chg="addSp delSp modSp mod ord">
        <pc:chgData name="Narang, Sonali" userId="9e80b397-6e2f-49b1-9374-ccdad8589140" providerId="ADAL" clId="{EA661601-9742-7540-8562-E8A6C95A1393}" dt="2021-08-30T14:57:15.924" v="492"/>
        <pc:sldMkLst>
          <pc:docMk/>
          <pc:sldMk cId="2124429" sldId="268"/>
        </pc:sldMkLst>
        <pc:spChg chg="add del">
          <ac:chgData name="Narang, Sonali" userId="9e80b397-6e2f-49b1-9374-ccdad8589140" providerId="ADAL" clId="{EA661601-9742-7540-8562-E8A6C95A1393}" dt="2021-08-30T14:57:11.270" v="483" actId="478"/>
          <ac:spMkLst>
            <pc:docMk/>
            <pc:sldMk cId="2124429" sldId="268"/>
            <ac:spMk id="3" creationId="{9DD290A2-FA79-CB4D-9BE8-A7AB77AC725D}"/>
          </ac:spMkLst>
        </pc:spChg>
        <pc:spChg chg="mod">
          <ac:chgData name="Narang, Sonali" userId="9e80b397-6e2f-49b1-9374-ccdad8589140" providerId="ADAL" clId="{EA661601-9742-7540-8562-E8A6C95A1393}" dt="2021-08-30T14:57:11.735" v="484" actId="1076"/>
          <ac:spMkLst>
            <pc:docMk/>
            <pc:sldMk cId="2124429" sldId="268"/>
            <ac:spMk id="6" creationId="{41464C80-B659-484D-A16F-8018DEC5471A}"/>
          </ac:spMkLst>
        </pc:spChg>
        <pc:spChg chg="mod">
          <ac:chgData name="Narang, Sonali" userId="9e80b397-6e2f-49b1-9374-ccdad8589140" providerId="ADAL" clId="{EA661601-9742-7540-8562-E8A6C95A1393}" dt="2021-08-30T14:57:13.116" v="487" actId="1036"/>
          <ac:spMkLst>
            <pc:docMk/>
            <pc:sldMk cId="2124429" sldId="268"/>
            <ac:spMk id="7" creationId="{4C5F5CAE-FBFD-964D-A356-746AAC86DC9E}"/>
          </ac:spMkLst>
        </pc:spChg>
        <pc:spChg chg="mod">
          <ac:chgData name="Narang, Sonali" userId="9e80b397-6e2f-49b1-9374-ccdad8589140" providerId="ADAL" clId="{EA661601-9742-7540-8562-E8A6C95A1393}" dt="2021-08-30T14:57:14.469" v="489" actId="1076"/>
          <ac:spMkLst>
            <pc:docMk/>
            <pc:sldMk cId="2124429" sldId="268"/>
            <ac:spMk id="8" creationId="{8A9BAE78-C4FF-1843-94F6-3410EB884848}"/>
          </ac:spMkLst>
        </pc:spChg>
        <pc:picChg chg="mod">
          <ac:chgData name="Narang, Sonali" userId="9e80b397-6e2f-49b1-9374-ccdad8589140" providerId="ADAL" clId="{EA661601-9742-7540-8562-E8A6C95A1393}" dt="2021-08-30T14:57:12.652" v="486" actId="1076"/>
          <ac:picMkLst>
            <pc:docMk/>
            <pc:sldMk cId="2124429" sldId="268"/>
            <ac:picMk id="9" creationId="{DDFA2D53-1007-6348-BFE3-B6FA0F6BC498}"/>
          </ac:picMkLst>
        </pc:picChg>
        <pc:picChg chg="add del mod">
          <ac:chgData name="Narang, Sonali" userId="9e80b397-6e2f-49b1-9374-ccdad8589140" providerId="ADAL" clId="{EA661601-9742-7540-8562-E8A6C95A1393}" dt="2021-08-30T14:57:15.924" v="492"/>
          <ac:picMkLst>
            <pc:docMk/>
            <pc:sldMk cId="2124429" sldId="268"/>
            <ac:picMk id="10" creationId="{C8BB70C4-3C65-5A4C-BB59-0344F1FBC7DD}"/>
          </ac:picMkLst>
        </pc:picChg>
        <pc:picChg chg="add del mod">
          <ac:chgData name="Narang, Sonali" userId="9e80b397-6e2f-49b1-9374-ccdad8589140" providerId="ADAL" clId="{EA661601-9742-7540-8562-E8A6C95A1393}" dt="2021-08-30T14:57:15.924" v="492"/>
          <ac:picMkLst>
            <pc:docMk/>
            <pc:sldMk cId="2124429" sldId="268"/>
            <ac:picMk id="11" creationId="{D7BFDD88-98D7-CF4C-9C78-64102B3A73D6}"/>
          </ac:picMkLst>
        </pc:picChg>
        <pc:picChg chg="add del mod">
          <ac:chgData name="Narang, Sonali" userId="9e80b397-6e2f-49b1-9374-ccdad8589140" providerId="ADAL" clId="{EA661601-9742-7540-8562-E8A6C95A1393}" dt="2021-08-30T14:57:15.924" v="492"/>
          <ac:picMkLst>
            <pc:docMk/>
            <pc:sldMk cId="2124429" sldId="268"/>
            <ac:picMk id="12" creationId="{68343C9B-21D0-A347-83F2-5E8167A214D5}"/>
          </ac:picMkLst>
        </pc:picChg>
      </pc:sldChg>
      <pc:sldChg chg="addSp delSp modSp mod addCm delCm">
        <pc:chgData name="Narang, Sonali" userId="9e80b397-6e2f-49b1-9374-ccdad8589140" providerId="ADAL" clId="{EA661601-9742-7540-8562-E8A6C95A1393}" dt="2021-08-31T19:41:53.687" v="1488" actId="1076"/>
        <pc:sldMkLst>
          <pc:docMk/>
          <pc:sldMk cId="3689715634" sldId="270"/>
        </pc:sldMkLst>
        <pc:spChg chg="mod">
          <ac:chgData name="Narang, Sonali" userId="9e80b397-6e2f-49b1-9374-ccdad8589140" providerId="ADAL" clId="{EA661601-9742-7540-8562-E8A6C95A1393}" dt="2021-08-30T21:54:19.430" v="1226" actId="1076"/>
          <ac:spMkLst>
            <pc:docMk/>
            <pc:sldMk cId="3689715634" sldId="270"/>
            <ac:spMk id="36" creationId="{75B14C61-810F-134B-AC0D-0C1FD0CAB17A}"/>
          </ac:spMkLst>
        </pc:spChg>
        <pc:spChg chg="mod">
          <ac:chgData name="Narang, Sonali" userId="9e80b397-6e2f-49b1-9374-ccdad8589140" providerId="ADAL" clId="{EA661601-9742-7540-8562-E8A6C95A1393}" dt="2021-08-30T21:54:18.736" v="1225" actId="1076"/>
          <ac:spMkLst>
            <pc:docMk/>
            <pc:sldMk cId="3689715634" sldId="270"/>
            <ac:spMk id="59" creationId="{1C85DEE8-F315-5047-B7B7-8827D96395BE}"/>
          </ac:spMkLst>
        </pc:spChg>
        <pc:spChg chg="mod">
          <ac:chgData name="Narang, Sonali" userId="9e80b397-6e2f-49b1-9374-ccdad8589140" providerId="ADAL" clId="{EA661601-9742-7540-8562-E8A6C95A1393}" dt="2021-08-30T15:34:01.455" v="540" actId="1076"/>
          <ac:spMkLst>
            <pc:docMk/>
            <pc:sldMk cId="3689715634" sldId="270"/>
            <ac:spMk id="178" creationId="{24504B2C-9F67-184D-9FAF-0C1CF83269D2}"/>
          </ac:spMkLst>
        </pc:spChg>
        <pc:spChg chg="mod">
          <ac:chgData name="Narang, Sonali" userId="9e80b397-6e2f-49b1-9374-ccdad8589140" providerId="ADAL" clId="{EA661601-9742-7540-8562-E8A6C95A1393}" dt="2021-08-30T16:23:17.857" v="653" actId="1036"/>
          <ac:spMkLst>
            <pc:docMk/>
            <pc:sldMk cId="3689715634" sldId="270"/>
            <ac:spMk id="192" creationId="{25C68709-E17A-6242-8480-1FEF3D96B0E3}"/>
          </ac:spMkLst>
        </pc:spChg>
        <pc:grpChg chg="del">
          <ac:chgData name="Narang, Sonali" userId="9e80b397-6e2f-49b1-9374-ccdad8589140" providerId="ADAL" clId="{EA661601-9742-7540-8562-E8A6C95A1393}" dt="2021-08-30T15:39:28.185" v="588" actId="478"/>
          <ac:grpSpMkLst>
            <pc:docMk/>
            <pc:sldMk cId="3689715634" sldId="270"/>
            <ac:grpSpMk id="6" creationId="{81DE8D28-94A4-0F42-AB8C-7C1692E7040B}"/>
          </ac:grpSpMkLst>
        </pc:grpChg>
        <pc:grpChg chg="add del mod">
          <ac:chgData name="Narang, Sonali" userId="9e80b397-6e2f-49b1-9374-ccdad8589140" providerId="ADAL" clId="{EA661601-9742-7540-8562-E8A6C95A1393}" dt="2021-08-30T21:54:21.887" v="1229" actId="164"/>
          <ac:grpSpMkLst>
            <pc:docMk/>
            <pc:sldMk cId="3689715634" sldId="270"/>
            <ac:grpSpMk id="15" creationId="{C66EC165-C2EB-2E48-BC1B-117099DA5832}"/>
          </ac:grpSpMkLst>
        </pc:grpChg>
        <pc:grpChg chg="topLvl">
          <ac:chgData name="Narang, Sonali" userId="9e80b397-6e2f-49b1-9374-ccdad8589140" providerId="ADAL" clId="{EA661601-9742-7540-8562-E8A6C95A1393}" dt="2021-08-30T21:54:21.887" v="1229" actId="164"/>
          <ac:grpSpMkLst>
            <pc:docMk/>
            <pc:sldMk cId="3689715634" sldId="270"/>
            <ac:grpSpMk id="20" creationId="{4A113A93-4C9C-3949-B1DB-412F52E05721}"/>
          </ac:grpSpMkLst>
        </pc:grpChg>
        <pc:grpChg chg="add del mod">
          <ac:chgData name="Narang, Sonali" userId="9e80b397-6e2f-49b1-9374-ccdad8589140" providerId="ADAL" clId="{EA661601-9742-7540-8562-E8A6C95A1393}" dt="2021-08-30T21:54:20.855" v="1228" actId="164"/>
          <ac:grpSpMkLst>
            <pc:docMk/>
            <pc:sldMk cId="3689715634" sldId="270"/>
            <ac:grpSpMk id="21" creationId="{68E4F7F9-811C-6A4F-A14A-9D22F5E2C595}"/>
          </ac:grpSpMkLst>
        </pc:grpChg>
        <pc:grpChg chg="topLvl">
          <ac:chgData name="Narang, Sonali" userId="9e80b397-6e2f-49b1-9374-ccdad8589140" providerId="ADAL" clId="{EA661601-9742-7540-8562-E8A6C95A1393}" dt="2021-08-30T21:54:20.855" v="1228" actId="164"/>
          <ac:grpSpMkLst>
            <pc:docMk/>
            <pc:sldMk cId="3689715634" sldId="270"/>
            <ac:grpSpMk id="22" creationId="{617CA9D0-AC14-7E48-AE00-CE1CFE9310EF}"/>
          </ac:grpSpMkLst>
        </pc:grpChg>
        <pc:grpChg chg="add">
          <ac:chgData name="Narang, Sonali" userId="9e80b397-6e2f-49b1-9374-ccdad8589140" providerId="ADAL" clId="{EA661601-9742-7540-8562-E8A6C95A1393}" dt="2021-08-30T21:54:29.643" v="1231" actId="164"/>
          <ac:grpSpMkLst>
            <pc:docMk/>
            <pc:sldMk cId="3689715634" sldId="270"/>
            <ac:grpSpMk id="24" creationId="{1C799EA5-FBE0-5B46-813F-EF20A1A81420}"/>
          </ac:grpSpMkLst>
        </pc:grpChg>
        <pc:grpChg chg="add">
          <ac:chgData name="Narang, Sonali" userId="9e80b397-6e2f-49b1-9374-ccdad8589140" providerId="ADAL" clId="{EA661601-9742-7540-8562-E8A6C95A1393}" dt="2021-08-30T21:54:34.806" v="1232" actId="164"/>
          <ac:grpSpMkLst>
            <pc:docMk/>
            <pc:sldMk cId="3689715634" sldId="270"/>
            <ac:grpSpMk id="25" creationId="{209DE69F-C181-9B41-A954-044CD88589A7}"/>
          </ac:grpSpMkLst>
        </pc:grpChg>
        <pc:picChg chg="del">
          <ac:chgData name="Narang, Sonali" userId="9e80b397-6e2f-49b1-9374-ccdad8589140" providerId="ADAL" clId="{EA661601-9742-7540-8562-E8A6C95A1393}" dt="2021-08-30T15:39:24.037" v="587" actId="478"/>
          <ac:picMkLst>
            <pc:docMk/>
            <pc:sldMk cId="3689715634" sldId="270"/>
            <ac:picMk id="3" creationId="{9F5D92FD-2305-EE4A-A124-E707A2D070F7}"/>
          </ac:picMkLst>
        </pc:picChg>
        <pc:picChg chg="add del mod">
          <ac:chgData name="Narang, Sonali" userId="9e80b397-6e2f-49b1-9374-ccdad8589140" providerId="ADAL" clId="{EA661601-9742-7540-8562-E8A6C95A1393}" dt="2021-08-30T15:36:19.714" v="552" actId="21"/>
          <ac:picMkLst>
            <pc:docMk/>
            <pc:sldMk cId="3689715634" sldId="270"/>
            <ac:picMk id="9" creationId="{E2D4E568-1F1F-7E42-84CC-CCC9C91DCF6C}"/>
          </ac:picMkLst>
        </pc:picChg>
        <pc:picChg chg="mod">
          <ac:chgData name="Narang, Sonali" userId="9e80b397-6e2f-49b1-9374-ccdad8589140" providerId="ADAL" clId="{EA661601-9742-7540-8562-E8A6C95A1393}" dt="2021-08-31T19:41:53.687" v="1488" actId="1076"/>
          <ac:picMkLst>
            <pc:docMk/>
            <pc:sldMk cId="3689715634" sldId="270"/>
            <ac:picMk id="12" creationId="{6F3D5D04-082E-A94E-B674-0CC25F5EF539}"/>
          </ac:picMkLst>
        </pc:picChg>
        <pc:picChg chg="add del mod">
          <ac:chgData name="Narang, Sonali" userId="9e80b397-6e2f-49b1-9374-ccdad8589140" providerId="ADAL" clId="{EA661601-9742-7540-8562-E8A6C95A1393}" dt="2021-08-30T15:36:19.714" v="552" actId="21"/>
          <ac:picMkLst>
            <pc:docMk/>
            <pc:sldMk cId="3689715634" sldId="270"/>
            <ac:picMk id="13" creationId="{573DE429-3BA2-014E-B214-9DE967091DDC}"/>
          </ac:picMkLst>
        </pc:picChg>
        <pc:picChg chg="del topLvl">
          <ac:chgData name="Narang, Sonali" userId="9e80b397-6e2f-49b1-9374-ccdad8589140" providerId="ADAL" clId="{EA661601-9742-7540-8562-E8A6C95A1393}" dt="2021-08-30T15:39:28.185" v="588" actId="478"/>
          <ac:picMkLst>
            <pc:docMk/>
            <pc:sldMk cId="3689715634" sldId="270"/>
            <ac:picMk id="117" creationId="{4C378CC0-9B72-BB4B-81F3-7A43F6FB23A0}"/>
          </ac:picMkLst>
        </pc:picChg>
        <pc:picChg chg="add del">
          <ac:chgData name="Narang, Sonali" userId="9e80b397-6e2f-49b1-9374-ccdad8589140" providerId="ADAL" clId="{EA661601-9742-7540-8562-E8A6C95A1393}" dt="2021-08-30T21:54:22.729" v="1230" actId="478"/>
          <ac:picMkLst>
            <pc:docMk/>
            <pc:sldMk cId="3689715634" sldId="270"/>
            <ac:picMk id="119" creationId="{49F46577-C9D3-1B41-9090-7C81FC720B1E}"/>
          </ac:picMkLst>
        </pc:picChg>
        <pc:picChg chg="add del">
          <ac:chgData name="Narang, Sonali" userId="9e80b397-6e2f-49b1-9374-ccdad8589140" providerId="ADAL" clId="{EA661601-9742-7540-8562-E8A6C95A1393}" dt="2021-08-30T21:54:22.729" v="1230" actId="478"/>
          <ac:picMkLst>
            <pc:docMk/>
            <pc:sldMk cId="3689715634" sldId="270"/>
            <ac:picMk id="120" creationId="{F74CFB0B-61C9-F640-9317-B8984AD45800}"/>
          </ac:picMkLst>
        </pc:picChg>
        <pc:picChg chg="add del">
          <ac:chgData name="Narang, Sonali" userId="9e80b397-6e2f-49b1-9374-ccdad8589140" providerId="ADAL" clId="{EA661601-9742-7540-8562-E8A6C95A1393}" dt="2021-08-30T21:54:22.729" v="1230" actId="478"/>
          <ac:picMkLst>
            <pc:docMk/>
            <pc:sldMk cId="3689715634" sldId="270"/>
            <ac:picMk id="121" creationId="{6C6532E8-B1B8-D14C-9198-7E75AFE7A9DE}"/>
          </ac:picMkLst>
        </pc:picChg>
        <pc:picChg chg="add del mod modCrop">
          <ac:chgData name="Narang, Sonali" userId="9e80b397-6e2f-49b1-9374-ccdad8589140" providerId="ADAL" clId="{EA661601-9742-7540-8562-E8A6C95A1393}" dt="2021-08-30T15:32:15.969" v="534" actId="478"/>
          <ac:picMkLst>
            <pc:docMk/>
            <pc:sldMk cId="3689715634" sldId="270"/>
            <ac:picMk id="122" creationId="{362FA696-39FB-4A40-99E2-9EB233D05113}"/>
          </ac:picMkLst>
        </pc:picChg>
        <pc:picChg chg="add del mod modCrop">
          <ac:chgData name="Narang, Sonali" userId="9e80b397-6e2f-49b1-9374-ccdad8589140" providerId="ADAL" clId="{EA661601-9742-7540-8562-E8A6C95A1393}" dt="2021-08-30T15:32:18.293" v="535" actId="478"/>
          <ac:picMkLst>
            <pc:docMk/>
            <pc:sldMk cId="3689715634" sldId="270"/>
            <ac:picMk id="123" creationId="{563FDFDA-E7CF-704E-9D22-EB6FA459A567}"/>
          </ac:picMkLst>
        </pc:picChg>
        <pc:picChg chg="add mod topLvl">
          <ac:chgData name="Narang, Sonali" userId="9e80b397-6e2f-49b1-9374-ccdad8589140" providerId="ADAL" clId="{EA661601-9742-7540-8562-E8A6C95A1393}" dt="2021-08-30T21:54:20.855" v="1228" actId="164"/>
          <ac:picMkLst>
            <pc:docMk/>
            <pc:sldMk cId="3689715634" sldId="270"/>
            <ac:picMk id="125" creationId="{72C96116-8331-E341-911D-46E23A1123BE}"/>
          </ac:picMkLst>
        </pc:picChg>
        <pc:picChg chg="add mod topLvl">
          <ac:chgData name="Narang, Sonali" userId="9e80b397-6e2f-49b1-9374-ccdad8589140" providerId="ADAL" clId="{EA661601-9742-7540-8562-E8A6C95A1393}" dt="2021-08-30T21:54:20.855" v="1228" actId="164"/>
          <ac:picMkLst>
            <pc:docMk/>
            <pc:sldMk cId="3689715634" sldId="270"/>
            <ac:picMk id="126" creationId="{F0FE44C6-5464-6A4F-BD87-C6D89F98996E}"/>
          </ac:picMkLst>
        </pc:picChg>
        <pc:picChg chg="add mod topLvl">
          <ac:chgData name="Narang, Sonali" userId="9e80b397-6e2f-49b1-9374-ccdad8589140" providerId="ADAL" clId="{EA661601-9742-7540-8562-E8A6C95A1393}" dt="2021-08-30T21:54:21.887" v="1229" actId="164"/>
          <ac:picMkLst>
            <pc:docMk/>
            <pc:sldMk cId="3689715634" sldId="270"/>
            <ac:picMk id="127" creationId="{816C88E5-C8A7-C14C-8432-4348C73D0702}"/>
          </ac:picMkLst>
        </pc:picChg>
        <pc:picChg chg="add mod topLvl">
          <ac:chgData name="Narang, Sonali" userId="9e80b397-6e2f-49b1-9374-ccdad8589140" providerId="ADAL" clId="{EA661601-9742-7540-8562-E8A6C95A1393}" dt="2021-08-30T21:54:21.887" v="1229" actId="164"/>
          <ac:picMkLst>
            <pc:docMk/>
            <pc:sldMk cId="3689715634" sldId="270"/>
            <ac:picMk id="128" creationId="{82958D01-6DDE-B046-84AB-7B026820D360}"/>
          </ac:picMkLst>
        </pc:picChg>
        <pc:picChg chg="del">
          <ac:chgData name="Narang, Sonali" userId="9e80b397-6e2f-49b1-9374-ccdad8589140" providerId="ADAL" clId="{EA661601-9742-7540-8562-E8A6C95A1393}" dt="2021-08-30T15:40:30.265" v="599" actId="478"/>
          <ac:picMkLst>
            <pc:docMk/>
            <pc:sldMk cId="3689715634" sldId="270"/>
            <ac:picMk id="187" creationId="{BB6CA039-90F7-E447-92C7-22DE6A1790B6}"/>
          </ac:picMkLst>
        </pc:picChg>
      </pc:sldChg>
      <pc:sldChg chg="addSp delSp modSp mod ord addCm delCm">
        <pc:chgData name="Narang, Sonali" userId="9e80b397-6e2f-49b1-9374-ccdad8589140" providerId="ADAL" clId="{EA661601-9742-7540-8562-E8A6C95A1393}" dt="2021-08-31T19:48:49.674" v="1490" actId="20578"/>
        <pc:sldMkLst>
          <pc:docMk/>
          <pc:sldMk cId="2499962631" sldId="271"/>
        </pc:sldMkLst>
        <pc:spChg chg="mod">
          <ac:chgData name="Narang, Sonali" userId="9e80b397-6e2f-49b1-9374-ccdad8589140" providerId="ADAL" clId="{EA661601-9742-7540-8562-E8A6C95A1393}" dt="2021-08-23T17:43:17.031" v="9" actId="20577"/>
          <ac:spMkLst>
            <pc:docMk/>
            <pc:sldMk cId="2499962631" sldId="271"/>
            <ac:spMk id="124" creationId="{2BE84DAC-7C05-C445-9DD3-6B3EE69AFBF9}"/>
          </ac:spMkLst>
        </pc:spChg>
        <pc:spChg chg="mod">
          <ac:chgData name="Narang, Sonali" userId="9e80b397-6e2f-49b1-9374-ccdad8589140" providerId="ADAL" clId="{EA661601-9742-7540-8562-E8A6C95A1393}" dt="2021-08-23T17:49:57.702" v="57" actId="1036"/>
          <ac:spMkLst>
            <pc:docMk/>
            <pc:sldMk cId="2499962631" sldId="271"/>
            <ac:spMk id="125" creationId="{F77578BF-D28B-AC46-B202-F16CA20F451A}"/>
          </ac:spMkLst>
        </pc:spChg>
        <pc:picChg chg="add mod modCrop">
          <ac:chgData name="Narang, Sonali" userId="9e80b397-6e2f-49b1-9374-ccdad8589140" providerId="ADAL" clId="{EA661601-9742-7540-8562-E8A6C95A1393}" dt="2021-08-31T14:32:03.380" v="1257" actId="1076"/>
          <ac:picMkLst>
            <pc:docMk/>
            <pc:sldMk cId="2499962631" sldId="271"/>
            <ac:picMk id="3" creationId="{53187E55-07DD-3246-8247-1478200BEFB7}"/>
          </ac:picMkLst>
        </pc:picChg>
        <pc:picChg chg="del mod">
          <ac:chgData name="Narang, Sonali" userId="9e80b397-6e2f-49b1-9374-ccdad8589140" providerId="ADAL" clId="{EA661601-9742-7540-8562-E8A6C95A1393}" dt="2021-08-23T17:43:33.649" v="10" actId="478"/>
          <ac:picMkLst>
            <pc:docMk/>
            <pc:sldMk cId="2499962631" sldId="271"/>
            <ac:picMk id="3" creationId="{82228A92-5E0D-5E4B-87A2-F9CCCA129DED}"/>
          </ac:picMkLst>
        </pc:picChg>
        <pc:picChg chg="add del mod">
          <ac:chgData name="Narang, Sonali" userId="9e80b397-6e2f-49b1-9374-ccdad8589140" providerId="ADAL" clId="{EA661601-9742-7540-8562-E8A6C95A1393}" dt="2021-08-23T17:51:03.015" v="61" actId="478"/>
          <ac:picMkLst>
            <pc:docMk/>
            <pc:sldMk cId="2499962631" sldId="271"/>
            <ac:picMk id="9" creationId="{0CFAEBC5-A0FE-D346-8137-3156619B51B8}"/>
          </ac:picMkLst>
        </pc:picChg>
        <pc:picChg chg="del">
          <ac:chgData name="Narang, Sonali" userId="9e80b397-6e2f-49b1-9374-ccdad8589140" providerId="ADAL" clId="{EA661601-9742-7540-8562-E8A6C95A1393}" dt="2021-08-23T17:43:33.649" v="10" actId="478"/>
          <ac:picMkLst>
            <pc:docMk/>
            <pc:sldMk cId="2499962631" sldId="271"/>
            <ac:picMk id="10" creationId="{272DF27B-4777-434D-AEE7-A62CA5338473}"/>
          </ac:picMkLst>
        </pc:picChg>
        <pc:picChg chg="del">
          <ac:chgData name="Narang, Sonali" userId="9e80b397-6e2f-49b1-9374-ccdad8589140" providerId="ADAL" clId="{EA661601-9742-7540-8562-E8A6C95A1393}" dt="2021-08-23T17:43:33.649" v="10" actId="478"/>
          <ac:picMkLst>
            <pc:docMk/>
            <pc:sldMk cId="2499962631" sldId="271"/>
            <ac:picMk id="81" creationId="{C5CC3F26-2070-C346-92D8-18EC76E60F2C}"/>
          </ac:picMkLst>
        </pc:picChg>
        <pc:picChg chg="add del mod">
          <ac:chgData name="Narang, Sonali" userId="9e80b397-6e2f-49b1-9374-ccdad8589140" providerId="ADAL" clId="{EA661601-9742-7540-8562-E8A6C95A1393}" dt="2021-08-23T17:51:03.015" v="61" actId="478"/>
          <ac:picMkLst>
            <pc:docMk/>
            <pc:sldMk cId="2499962631" sldId="271"/>
            <ac:picMk id="83" creationId="{94D9EB99-EFFF-6B47-97E7-FADED43AB481}"/>
          </ac:picMkLst>
        </pc:picChg>
        <pc:picChg chg="add del mod">
          <ac:chgData name="Narang, Sonali" userId="9e80b397-6e2f-49b1-9374-ccdad8589140" providerId="ADAL" clId="{EA661601-9742-7540-8562-E8A6C95A1393}" dt="2021-08-23T17:51:03.015" v="61" actId="478"/>
          <ac:picMkLst>
            <pc:docMk/>
            <pc:sldMk cId="2499962631" sldId="271"/>
            <ac:picMk id="87" creationId="{563A5226-3CD4-E34E-88A2-089E0D0BBCB4}"/>
          </ac:picMkLst>
        </pc:picChg>
        <pc:picChg chg="add del mod">
          <ac:chgData name="Narang, Sonali" userId="9e80b397-6e2f-49b1-9374-ccdad8589140" providerId="ADAL" clId="{EA661601-9742-7540-8562-E8A6C95A1393}" dt="2021-08-23T18:30:17.665" v="102" actId="478"/>
          <ac:picMkLst>
            <pc:docMk/>
            <pc:sldMk cId="2499962631" sldId="271"/>
            <ac:picMk id="89" creationId="{59736E5C-7B3F-8B4F-84E6-0F76F83CA686}"/>
          </ac:picMkLst>
        </pc:picChg>
        <pc:picChg chg="add del mod">
          <ac:chgData name="Narang, Sonali" userId="9e80b397-6e2f-49b1-9374-ccdad8589140" providerId="ADAL" clId="{EA661601-9742-7540-8562-E8A6C95A1393}" dt="2021-08-23T18:30:17.665" v="102" actId="478"/>
          <ac:picMkLst>
            <pc:docMk/>
            <pc:sldMk cId="2499962631" sldId="271"/>
            <ac:picMk id="93" creationId="{8DA39DCA-EEB8-A844-A72B-928D30A2D9C6}"/>
          </ac:picMkLst>
        </pc:picChg>
        <pc:picChg chg="add del mod">
          <ac:chgData name="Narang, Sonali" userId="9e80b397-6e2f-49b1-9374-ccdad8589140" providerId="ADAL" clId="{EA661601-9742-7540-8562-E8A6C95A1393}" dt="2021-08-23T18:30:17.665" v="102" actId="478"/>
          <ac:picMkLst>
            <pc:docMk/>
            <pc:sldMk cId="2499962631" sldId="271"/>
            <ac:picMk id="95" creationId="{138BB06F-19A2-4940-B6B6-72375DCA2C3D}"/>
          </ac:picMkLst>
        </pc:picChg>
        <pc:picChg chg="add mod">
          <ac:chgData name="Narang, Sonali" userId="9e80b397-6e2f-49b1-9374-ccdad8589140" providerId="ADAL" clId="{EA661601-9742-7540-8562-E8A6C95A1393}" dt="2021-08-23T18:31:45.026" v="128" actId="1037"/>
          <ac:picMkLst>
            <pc:docMk/>
            <pc:sldMk cId="2499962631" sldId="271"/>
            <ac:picMk id="97" creationId="{496F82D1-7791-9F4A-889D-254975963C79}"/>
          </ac:picMkLst>
        </pc:picChg>
        <pc:picChg chg="add mod">
          <ac:chgData name="Narang, Sonali" userId="9e80b397-6e2f-49b1-9374-ccdad8589140" providerId="ADAL" clId="{EA661601-9742-7540-8562-E8A6C95A1393}" dt="2021-08-23T18:31:45.026" v="128" actId="1037"/>
          <ac:picMkLst>
            <pc:docMk/>
            <pc:sldMk cId="2499962631" sldId="271"/>
            <ac:picMk id="135" creationId="{1CE96486-20BC-7F41-87D0-558C44F962B1}"/>
          </ac:picMkLst>
        </pc:picChg>
        <pc:picChg chg="add mod">
          <ac:chgData name="Narang, Sonali" userId="9e80b397-6e2f-49b1-9374-ccdad8589140" providerId="ADAL" clId="{EA661601-9742-7540-8562-E8A6C95A1393}" dt="2021-08-23T18:31:45.026" v="128" actId="1037"/>
          <ac:picMkLst>
            <pc:docMk/>
            <pc:sldMk cId="2499962631" sldId="271"/>
            <ac:picMk id="146" creationId="{1F8E9A21-BFDE-7249-AA98-3227C29281B5}"/>
          </ac:picMkLst>
        </pc:picChg>
        <pc:picChg chg="add del mod modCrop">
          <ac:chgData name="Narang, Sonali" userId="9e80b397-6e2f-49b1-9374-ccdad8589140" providerId="ADAL" clId="{EA661601-9742-7540-8562-E8A6C95A1393}" dt="2021-08-31T14:31:17.382" v="1245" actId="478"/>
          <ac:picMkLst>
            <pc:docMk/>
            <pc:sldMk cId="2499962631" sldId="271"/>
            <ac:picMk id="148" creationId="{CD9893D1-9711-424B-87B9-76E81CD25E27}"/>
          </ac:picMkLst>
        </pc:picChg>
        <pc:cxnChg chg="mod">
          <ac:chgData name="Narang, Sonali" userId="9e80b397-6e2f-49b1-9374-ccdad8589140" providerId="ADAL" clId="{EA661601-9742-7540-8562-E8A6C95A1393}" dt="2021-08-30T13:48:24.453" v="407" actId="1037"/>
          <ac:cxnSpMkLst>
            <pc:docMk/>
            <pc:sldMk cId="2499962631" sldId="271"/>
            <ac:cxnSpMk id="14" creationId="{49383B7A-DB11-BD4B-849A-F17469574CFB}"/>
          </ac:cxnSpMkLst>
        </pc:cxnChg>
        <pc:cxnChg chg="mod">
          <ac:chgData name="Narang, Sonali" userId="9e80b397-6e2f-49b1-9374-ccdad8589140" providerId="ADAL" clId="{EA661601-9742-7540-8562-E8A6C95A1393}" dt="2021-08-30T13:48:24.453" v="407" actId="1037"/>
          <ac:cxnSpMkLst>
            <pc:docMk/>
            <pc:sldMk cId="2499962631" sldId="271"/>
            <ac:cxnSpMk id="18" creationId="{32CF7A3C-6E49-FC42-B6F9-D9BCB1AE3715}"/>
          </ac:cxnSpMkLst>
        </pc:cxnChg>
      </pc:sldChg>
      <pc:sldChg chg="addSp delSp modSp add del mod">
        <pc:chgData name="Narang, Sonali" userId="9e80b397-6e2f-49b1-9374-ccdad8589140" providerId="ADAL" clId="{EA661601-9742-7540-8562-E8A6C95A1393}" dt="2021-08-30T17:28:44.792" v="1150" actId="2696"/>
        <pc:sldMkLst>
          <pc:docMk/>
          <pc:sldMk cId="3096844307" sldId="272"/>
        </pc:sldMkLst>
        <pc:spChg chg="add del mod">
          <ac:chgData name="Narang, Sonali" userId="9e80b397-6e2f-49b1-9374-ccdad8589140" providerId="ADAL" clId="{EA661601-9742-7540-8562-E8A6C95A1393}" dt="2021-08-30T17:17:49.815" v="1006" actId="478"/>
          <ac:spMkLst>
            <pc:docMk/>
            <pc:sldMk cId="3096844307" sldId="272"/>
            <ac:spMk id="13" creationId="{98D25F1C-9074-9343-8FDD-516B3668BB52}"/>
          </ac:spMkLst>
        </pc:spChg>
        <pc:spChg chg="add mod">
          <ac:chgData name="Narang, Sonali" userId="9e80b397-6e2f-49b1-9374-ccdad8589140" providerId="ADAL" clId="{EA661601-9742-7540-8562-E8A6C95A1393}" dt="2021-08-30T17:18:28.693" v="1071" actId="20577"/>
          <ac:spMkLst>
            <pc:docMk/>
            <pc:sldMk cId="3096844307" sldId="272"/>
            <ac:spMk id="16" creationId="{3B9A4072-7418-FD42-847E-1A06F6DE96E9}"/>
          </ac:spMkLst>
        </pc:spChg>
        <pc:picChg chg="add mod">
          <ac:chgData name="Narang, Sonali" userId="9e80b397-6e2f-49b1-9374-ccdad8589140" providerId="ADAL" clId="{EA661601-9742-7540-8562-E8A6C95A1393}" dt="2021-08-30T17:17:16.020" v="997" actId="167"/>
          <ac:picMkLst>
            <pc:docMk/>
            <pc:sldMk cId="3096844307" sldId="272"/>
            <ac:picMk id="3" creationId="{95C82592-8D49-2C4E-9C1C-B6BDD6571E49}"/>
          </ac:picMkLst>
        </pc:picChg>
        <pc:picChg chg="add mod">
          <ac:chgData name="Narang, Sonali" userId="9e80b397-6e2f-49b1-9374-ccdad8589140" providerId="ADAL" clId="{EA661601-9742-7540-8562-E8A6C95A1393}" dt="2021-08-30T17:17:26.615" v="1000" actId="167"/>
          <ac:picMkLst>
            <pc:docMk/>
            <pc:sldMk cId="3096844307" sldId="272"/>
            <ac:picMk id="10" creationId="{A568A7D6-B56A-944D-80CF-34ACF87DDFAF}"/>
          </ac:picMkLst>
        </pc:picChg>
        <pc:picChg chg="add mod">
          <ac:chgData name="Narang, Sonali" userId="9e80b397-6e2f-49b1-9374-ccdad8589140" providerId="ADAL" clId="{EA661601-9742-7540-8562-E8A6C95A1393}" dt="2021-08-30T17:17:37.076" v="1003" actId="167"/>
          <ac:picMkLst>
            <pc:docMk/>
            <pc:sldMk cId="3096844307" sldId="272"/>
            <ac:picMk id="12" creationId="{673B192C-5DD9-584A-BCE1-8FB1EF934662}"/>
          </ac:picMkLst>
        </pc:picChg>
        <pc:picChg chg="del">
          <ac:chgData name="Narang, Sonali" userId="9e80b397-6e2f-49b1-9374-ccdad8589140" providerId="ADAL" clId="{EA661601-9742-7540-8562-E8A6C95A1393}" dt="2021-08-30T17:17:18.895" v="998" actId="478"/>
          <ac:picMkLst>
            <pc:docMk/>
            <pc:sldMk cId="3096844307" sldId="272"/>
            <ac:picMk id="15" creationId="{0C43366B-74AB-8345-B18D-005DC6F48F33}"/>
          </ac:picMkLst>
        </pc:picChg>
        <pc:picChg chg="del">
          <ac:chgData name="Narang, Sonali" userId="9e80b397-6e2f-49b1-9374-ccdad8589140" providerId="ADAL" clId="{EA661601-9742-7540-8562-E8A6C95A1393}" dt="2021-08-30T17:17:29.100" v="1001" actId="478"/>
          <ac:picMkLst>
            <pc:docMk/>
            <pc:sldMk cId="3096844307" sldId="272"/>
            <ac:picMk id="17" creationId="{53A6B32B-C740-944C-8420-B07C6C3D680F}"/>
          </ac:picMkLst>
        </pc:picChg>
        <pc:picChg chg="del">
          <ac:chgData name="Narang, Sonali" userId="9e80b397-6e2f-49b1-9374-ccdad8589140" providerId="ADAL" clId="{EA661601-9742-7540-8562-E8A6C95A1393}" dt="2021-08-30T17:17:38.688" v="1004" actId="478"/>
          <ac:picMkLst>
            <pc:docMk/>
            <pc:sldMk cId="3096844307" sldId="272"/>
            <ac:picMk id="19" creationId="{CE56F4A1-920C-8541-8AA7-1EEC1D2CABE5}"/>
          </ac:picMkLst>
        </pc:picChg>
      </pc:sldChg>
      <pc:sldChg chg="addSp delSp modSp new del mod addCm delCm">
        <pc:chgData name="Narang, Sonali" userId="9e80b397-6e2f-49b1-9374-ccdad8589140" providerId="ADAL" clId="{EA661601-9742-7540-8562-E8A6C95A1393}" dt="2021-08-30T15:42:20.471" v="620" actId="2696"/>
        <pc:sldMkLst>
          <pc:docMk/>
          <pc:sldMk cId="3423724634" sldId="272"/>
        </pc:sldMkLst>
        <pc:spChg chg="del">
          <ac:chgData name="Narang, Sonali" userId="9e80b397-6e2f-49b1-9374-ccdad8589140" providerId="ADAL" clId="{EA661601-9742-7540-8562-E8A6C95A1393}" dt="2021-08-30T15:36:25.229" v="554" actId="478"/>
          <ac:spMkLst>
            <pc:docMk/>
            <pc:sldMk cId="3423724634" sldId="272"/>
            <ac:spMk id="2" creationId="{41BBB968-8ADE-F94E-8BC0-2F24950E4482}"/>
          </ac:spMkLst>
        </pc:spChg>
        <pc:spChg chg="del">
          <ac:chgData name="Narang, Sonali" userId="9e80b397-6e2f-49b1-9374-ccdad8589140" providerId="ADAL" clId="{EA661601-9742-7540-8562-E8A6C95A1393}" dt="2021-08-30T15:36:25.229" v="554" actId="478"/>
          <ac:spMkLst>
            <pc:docMk/>
            <pc:sldMk cId="3423724634" sldId="272"/>
            <ac:spMk id="3" creationId="{3A458576-91A6-0345-9F79-470C20336D46}"/>
          </ac:spMkLst>
        </pc:spChg>
        <pc:picChg chg="add del mod modCrop">
          <ac:chgData name="Narang, Sonali" userId="9e80b397-6e2f-49b1-9374-ccdad8589140" providerId="ADAL" clId="{EA661601-9742-7540-8562-E8A6C95A1393}" dt="2021-08-30T15:40:46.161" v="602" actId="21"/>
          <ac:picMkLst>
            <pc:docMk/>
            <pc:sldMk cId="3423724634" sldId="272"/>
            <ac:picMk id="4" creationId="{6D7E542B-B653-BA47-8A0D-CE785F03296B}"/>
          </ac:picMkLst>
        </pc:picChg>
        <pc:picChg chg="add del mod modCrop">
          <ac:chgData name="Narang, Sonali" userId="9e80b397-6e2f-49b1-9374-ccdad8589140" providerId="ADAL" clId="{EA661601-9742-7540-8562-E8A6C95A1393}" dt="2021-08-30T15:40:42.911" v="601" actId="478"/>
          <ac:picMkLst>
            <pc:docMk/>
            <pc:sldMk cId="3423724634" sldId="272"/>
            <ac:picMk id="5" creationId="{849CEB29-A02B-8742-A3FD-C892087CBC85}"/>
          </ac:picMkLst>
        </pc:picChg>
        <pc:picChg chg="add del mod modCrop">
          <ac:chgData name="Narang, Sonali" userId="9e80b397-6e2f-49b1-9374-ccdad8589140" providerId="ADAL" clId="{EA661601-9742-7540-8562-E8A6C95A1393}" dt="2021-08-30T15:40:42.911" v="601" actId="478"/>
          <ac:picMkLst>
            <pc:docMk/>
            <pc:sldMk cId="3423724634" sldId="272"/>
            <ac:picMk id="6" creationId="{2375BBC4-770F-5C4A-AE0C-CDD632D51FBB}"/>
          </ac:picMkLst>
        </pc:picChg>
        <pc:picChg chg="add del mod modCrop">
          <ac:chgData name="Narang, Sonali" userId="9e80b397-6e2f-49b1-9374-ccdad8589140" providerId="ADAL" clId="{EA661601-9742-7540-8562-E8A6C95A1393}" dt="2021-08-30T15:40:46.161" v="602" actId="21"/>
          <ac:picMkLst>
            <pc:docMk/>
            <pc:sldMk cId="3423724634" sldId="272"/>
            <ac:picMk id="7" creationId="{76E12E99-7CD6-3748-8C51-9B5EE873763F}"/>
          </ac:picMkLst>
        </pc:picChg>
      </pc:sldChg>
      <pc:sldChg chg="addSp delSp modSp add mod addCm delCm">
        <pc:chgData name="Narang, Sonali" userId="9e80b397-6e2f-49b1-9374-ccdad8589140" providerId="ADAL" clId="{EA661601-9742-7540-8562-E8A6C95A1393}" dt="2021-08-31T14:17:03.772" v="1244" actId="20577"/>
        <pc:sldMkLst>
          <pc:docMk/>
          <pc:sldMk cId="1184752330" sldId="273"/>
        </pc:sldMkLst>
        <pc:spChg chg="mod">
          <ac:chgData name="Narang, Sonali" userId="9e80b397-6e2f-49b1-9374-ccdad8589140" providerId="ADAL" clId="{EA661601-9742-7540-8562-E8A6C95A1393}" dt="2021-08-31T14:16:25.870" v="1241" actId="1036"/>
          <ac:spMkLst>
            <pc:docMk/>
            <pc:sldMk cId="1184752330" sldId="273"/>
            <ac:spMk id="8" creationId="{8A9BAE78-C4FF-1843-94F6-3410EB884848}"/>
          </ac:spMkLst>
        </pc:spChg>
        <pc:spChg chg="mod topLvl">
          <ac:chgData name="Narang, Sonali" userId="9e80b397-6e2f-49b1-9374-ccdad8589140" providerId="ADAL" clId="{EA661601-9742-7540-8562-E8A6C95A1393}" dt="2021-08-30T17:22:25.264" v="1110" actId="1036"/>
          <ac:spMkLst>
            <pc:docMk/>
            <pc:sldMk cId="1184752330" sldId="273"/>
            <ac:spMk id="40" creationId="{9ACE9BB7-C1A6-4747-9A29-1C755FE1EF09}"/>
          </ac:spMkLst>
        </pc:spChg>
        <pc:spChg chg="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42" creationId="{586D2C07-43BD-674E-8670-F415A603FC18}"/>
          </ac:spMkLst>
        </pc:spChg>
        <pc:spChg chg="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43" creationId="{BC04EACA-A3F9-A64E-8194-0AF470BA470B}"/>
          </ac:spMkLst>
        </pc:spChg>
        <pc:spChg chg="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45" creationId="{52854BEA-A841-C541-9BDB-3534AD57CF6D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0" creationId="{41FA0B44-8D4E-5141-8AAB-AA4C3562F115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1" creationId="{3AD7E4D9-1F9F-C443-9273-05C030F70764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2" creationId="{C953A091-A83C-4C4A-A990-D10CBDA3183B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3" creationId="{77A26114-D485-F84D-8F9E-43CFA19FCDE1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4" creationId="{94DDE2E6-61E5-0F4F-A4B5-3D9AB22A1036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5" creationId="{4767BCA4-8360-404C-97EA-49E8FFDEE08C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6" creationId="{9890DFFC-0DED-E44B-A90B-3FFF3C0F90BC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7" creationId="{76E1F1FD-06B0-6547-BD6B-14F1741E9D4D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8" creationId="{B527EAB8-A491-9A49-A837-4597CC6EDFFB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59" creationId="{F5343E56-5AB9-4643-966A-9415202676ED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0" creationId="{2E551203-BEE9-134D-B52A-8E6C97FFF434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1" creationId="{03539B19-0A39-034B-B8D6-B4427B91EAA2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2" creationId="{E34B4F51-3643-A74D-80A1-5023A0647A07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3" creationId="{BDCF652B-10E5-384E-9800-40B94388F3FD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4" creationId="{89822E66-4B71-2D47-AA75-3CDA65A9F817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5" creationId="{A5A3FBA1-6D19-1D4E-9103-C96B40F85495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6" creationId="{A1D23703-22A8-434E-82B0-13CE3CBCFA39}"/>
          </ac:spMkLst>
        </pc:spChg>
        <pc:spChg chg="mod">
          <ac:chgData name="Narang, Sonali" userId="9e80b397-6e2f-49b1-9374-ccdad8589140" providerId="ADAL" clId="{EA661601-9742-7540-8562-E8A6C95A1393}" dt="2021-08-30T17:13:16.256" v="961" actId="12788"/>
          <ac:spMkLst>
            <pc:docMk/>
            <pc:sldMk cId="1184752330" sldId="273"/>
            <ac:spMk id="67" creationId="{48D0553B-E67C-6D45-AF87-78A3531955EB}"/>
          </ac:spMkLst>
        </pc:spChg>
        <pc:spChg chg="add 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71" creationId="{15E605BC-C521-0E49-B85F-7424DAAEDA88}"/>
          </ac:spMkLst>
        </pc:spChg>
        <pc:spChg chg="add mod topLvl">
          <ac:chgData name="Narang, Sonali" userId="9e80b397-6e2f-49b1-9374-ccdad8589140" providerId="ADAL" clId="{EA661601-9742-7540-8562-E8A6C95A1393}" dt="2021-08-31T14:17:03.772" v="1244" actId="20577"/>
          <ac:spMkLst>
            <pc:docMk/>
            <pc:sldMk cId="1184752330" sldId="273"/>
            <ac:spMk id="72" creationId="{BC006CCF-9B02-9B46-94F0-DCD7741D2F7E}"/>
          </ac:spMkLst>
        </pc:spChg>
        <pc:spChg chg="add 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73" creationId="{7B423F8B-C33F-224B-BB3D-A3730D994396}"/>
          </ac:spMkLst>
        </pc:spChg>
        <pc:spChg chg="add 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74" creationId="{ECBE0B4D-5D08-E443-BF7C-57D733E156EC}"/>
          </ac:spMkLst>
        </pc:spChg>
        <pc:spChg chg="add mod topLvl">
          <ac:chgData name="Narang, Sonali" userId="9e80b397-6e2f-49b1-9374-ccdad8589140" providerId="ADAL" clId="{EA661601-9742-7540-8562-E8A6C95A1393}" dt="2021-08-30T17:14:23.189" v="976" actId="164"/>
          <ac:spMkLst>
            <pc:docMk/>
            <pc:sldMk cId="1184752330" sldId="273"/>
            <ac:spMk id="75" creationId="{DEBFD38B-9515-5C4A-BE67-EA963808359F}"/>
          </ac:spMkLst>
        </pc:spChg>
        <pc:spChg chg="del">
          <ac:chgData name="Narang, Sonali" userId="9e80b397-6e2f-49b1-9374-ccdad8589140" providerId="ADAL" clId="{EA661601-9742-7540-8562-E8A6C95A1393}" dt="2021-08-30T17:06:33.585" v="796" actId="478"/>
          <ac:spMkLst>
            <pc:docMk/>
            <pc:sldMk cId="1184752330" sldId="273"/>
            <ac:spMk id="103" creationId="{8FAED76B-6482-5D44-B02D-1371AD589F4A}"/>
          </ac:spMkLst>
        </pc:spChg>
        <pc:spChg chg="del">
          <ac:chgData name="Narang, Sonali" userId="9e80b397-6e2f-49b1-9374-ccdad8589140" providerId="ADAL" clId="{EA661601-9742-7540-8562-E8A6C95A1393}" dt="2021-08-30T17:06:25.086" v="794" actId="478"/>
          <ac:spMkLst>
            <pc:docMk/>
            <pc:sldMk cId="1184752330" sldId="273"/>
            <ac:spMk id="124" creationId="{2BE84DAC-7C05-C445-9DD3-6B3EE69AFBF9}"/>
          </ac:spMkLst>
        </pc:spChg>
        <pc:grpChg chg="add del">
          <ac:chgData name="Narang, Sonali" userId="9e80b397-6e2f-49b1-9374-ccdad8589140" providerId="ADAL" clId="{EA661601-9742-7540-8562-E8A6C95A1393}" dt="2021-08-30T17:14:23.189" v="976" actId="164"/>
          <ac:grpSpMkLst>
            <pc:docMk/>
            <pc:sldMk cId="1184752330" sldId="273"/>
            <ac:grpSpMk id="10" creationId="{2D79D96B-9918-434B-9E3B-4EB81BD6A6B7}"/>
          </ac:grpSpMkLst>
        </pc:grpChg>
        <pc:grpChg chg="add mod">
          <ac:chgData name="Narang, Sonali" userId="9e80b397-6e2f-49b1-9374-ccdad8589140" providerId="ADAL" clId="{EA661601-9742-7540-8562-E8A6C95A1393}" dt="2021-08-30T17:22:22.401" v="1105" actId="1036"/>
          <ac:grpSpMkLst>
            <pc:docMk/>
            <pc:sldMk cId="1184752330" sldId="273"/>
            <ac:grpSpMk id="11" creationId="{C32B8FC9-55A4-D644-ADCA-CF6BCE435857}"/>
          </ac:grpSpMkLst>
        </pc:grpChg>
        <pc:grpChg chg="add del mod">
          <ac:chgData name="Narang, Sonali" userId="9e80b397-6e2f-49b1-9374-ccdad8589140" providerId="ADAL" clId="{EA661601-9742-7540-8562-E8A6C95A1393}" dt="2021-08-30T17:07:29.804" v="801" actId="165"/>
          <ac:grpSpMkLst>
            <pc:docMk/>
            <pc:sldMk cId="1184752330" sldId="273"/>
            <ac:grpSpMk id="39" creationId="{6D7D06FC-B8B6-3144-8986-152D0677268C}"/>
          </ac:grpSpMkLst>
        </pc:grpChg>
        <pc:grpChg chg="del mod topLvl">
          <ac:chgData name="Narang, Sonali" userId="9e80b397-6e2f-49b1-9374-ccdad8589140" providerId="ADAL" clId="{EA661601-9742-7540-8562-E8A6C95A1393}" dt="2021-08-30T17:07:36.090" v="802" actId="165"/>
          <ac:grpSpMkLst>
            <pc:docMk/>
            <pc:sldMk cId="1184752330" sldId="273"/>
            <ac:grpSpMk id="41" creationId="{4708B5DA-CBB3-ED4B-8763-9365AB163803}"/>
          </ac:grpSpMkLst>
        </pc:grpChg>
        <pc:grpChg chg="del mod topLvl">
          <ac:chgData name="Narang, Sonali" userId="9e80b397-6e2f-49b1-9374-ccdad8589140" providerId="ADAL" clId="{EA661601-9742-7540-8562-E8A6C95A1393}" dt="2021-08-30T17:08:03.580" v="810" actId="478"/>
          <ac:grpSpMkLst>
            <pc:docMk/>
            <pc:sldMk cId="1184752330" sldId="273"/>
            <ac:grpSpMk id="44" creationId="{F362D13D-B2E8-E242-B643-C8237824E3A7}"/>
          </ac:grpSpMkLst>
        </pc:grpChg>
        <pc:grpChg chg="mod topLvl">
          <ac:chgData name="Narang, Sonali" userId="9e80b397-6e2f-49b1-9374-ccdad8589140" providerId="ADAL" clId="{EA661601-9742-7540-8562-E8A6C95A1393}" dt="2021-08-30T17:14:23.189" v="976" actId="164"/>
          <ac:grpSpMkLst>
            <pc:docMk/>
            <pc:sldMk cId="1184752330" sldId="273"/>
            <ac:grpSpMk id="46" creationId="{FDF1CC30-04B0-F14A-93B7-1E5553400BC0}"/>
          </ac:grpSpMkLst>
        </pc:grpChg>
        <pc:grpChg chg="mod">
          <ac:chgData name="Narang, Sonali" userId="9e80b397-6e2f-49b1-9374-ccdad8589140" providerId="ADAL" clId="{EA661601-9742-7540-8562-E8A6C95A1393}" dt="2021-08-30T17:07:03.325" v="798"/>
          <ac:grpSpMkLst>
            <pc:docMk/>
            <pc:sldMk cId="1184752330" sldId="273"/>
            <ac:grpSpMk id="47" creationId="{EBFB8CEB-05AA-FA41-8B50-5B2C155AE75E}"/>
          </ac:grpSpMkLst>
        </pc:grpChg>
        <pc:grpChg chg="mod">
          <ac:chgData name="Narang, Sonali" userId="9e80b397-6e2f-49b1-9374-ccdad8589140" providerId="ADAL" clId="{EA661601-9742-7540-8562-E8A6C95A1393}" dt="2021-08-30T17:07:03.325" v="798"/>
          <ac:grpSpMkLst>
            <pc:docMk/>
            <pc:sldMk cId="1184752330" sldId="273"/>
            <ac:grpSpMk id="48" creationId="{759F61A0-5B58-4D43-84F5-BBBBF2C9F3AC}"/>
          </ac:grpSpMkLst>
        </pc:grpChg>
        <pc:grpChg chg="mod">
          <ac:chgData name="Narang, Sonali" userId="9e80b397-6e2f-49b1-9374-ccdad8589140" providerId="ADAL" clId="{EA661601-9742-7540-8562-E8A6C95A1393}" dt="2021-08-30T17:07:03.325" v="798"/>
          <ac:grpSpMkLst>
            <pc:docMk/>
            <pc:sldMk cId="1184752330" sldId="273"/>
            <ac:grpSpMk id="49" creationId="{3AA42896-925B-6B49-AE3F-4920DC7BEE3F}"/>
          </ac:grpSpMkLst>
        </pc:grpChg>
        <pc:picChg chg="mod topLvl modCrop">
          <ac:chgData name="Narang, Sonali" userId="9e80b397-6e2f-49b1-9374-ccdad8589140" providerId="ADAL" clId="{EA661601-9742-7540-8562-E8A6C95A1393}" dt="2021-08-30T17:14:51.507" v="978" actId="732"/>
          <ac:picMkLst>
            <pc:docMk/>
            <pc:sldMk cId="1184752330" sldId="273"/>
            <ac:picMk id="2" creationId="{87DC89C9-A99E-DC48-AA62-4F2EC703646C}"/>
          </ac:picMkLst>
        </pc:picChg>
        <pc:picChg chg="mod">
          <ac:chgData name="Narang, Sonali" userId="9e80b397-6e2f-49b1-9374-ccdad8589140" providerId="ADAL" clId="{EA661601-9742-7540-8562-E8A6C95A1393}" dt="2021-08-30T17:21:51.949" v="1090" actId="1076"/>
          <ac:picMkLst>
            <pc:docMk/>
            <pc:sldMk cId="1184752330" sldId="273"/>
            <ac:picMk id="3" creationId="{8D46FA96-CD3D-0047-90E5-A1D1D7788A8F}"/>
          </ac:picMkLst>
        </pc:picChg>
        <pc:picChg chg="mod">
          <ac:chgData name="Narang, Sonali" userId="9e80b397-6e2f-49b1-9374-ccdad8589140" providerId="ADAL" clId="{EA661601-9742-7540-8562-E8A6C95A1393}" dt="2021-08-30T17:20:48.931" v="1087" actId="1076"/>
          <ac:picMkLst>
            <pc:docMk/>
            <pc:sldMk cId="1184752330" sldId="273"/>
            <ac:picMk id="9" creationId="{6ABD3AA5-95E6-6D4B-84AF-F0F5C645343C}"/>
          </ac:picMkLst>
        </pc:picChg>
        <pc:picChg chg="del mod">
          <ac:chgData name="Narang, Sonali" userId="9e80b397-6e2f-49b1-9374-ccdad8589140" providerId="ADAL" clId="{EA661601-9742-7540-8562-E8A6C95A1393}" dt="2021-08-30T17:22:09.249" v="1094" actId="478"/>
          <ac:picMkLst>
            <pc:docMk/>
            <pc:sldMk cId="1184752330" sldId="273"/>
            <ac:picMk id="12" creationId="{29BE988C-D668-BD46-A177-BE08A2B0066A}"/>
          </ac:picMkLst>
        </pc:picChg>
        <pc:picChg chg="del mod">
          <ac:chgData name="Narang, Sonali" userId="9e80b397-6e2f-49b1-9374-ccdad8589140" providerId="ADAL" clId="{EA661601-9742-7540-8562-E8A6C95A1393}" dt="2021-08-30T17:22:09.249" v="1094" actId="478"/>
          <ac:picMkLst>
            <pc:docMk/>
            <pc:sldMk cId="1184752330" sldId="273"/>
            <ac:picMk id="14" creationId="{0DA86CA6-7473-6B4E-BF22-0884298EE04F}"/>
          </ac:picMkLst>
        </pc:picChg>
        <pc:picChg chg="add del mod">
          <ac:chgData name="Narang, Sonali" userId="9e80b397-6e2f-49b1-9374-ccdad8589140" providerId="ADAL" clId="{EA661601-9742-7540-8562-E8A6C95A1393}" dt="2021-08-30T18:27:24.133" v="1164" actId="478"/>
          <ac:picMkLst>
            <pc:docMk/>
            <pc:sldMk cId="1184752330" sldId="273"/>
            <ac:picMk id="15" creationId="{AB68D0C4-3F81-BF4F-889B-510BF8E9A8A6}"/>
          </ac:picMkLst>
        </pc:picChg>
        <pc:picChg chg="mod">
          <ac:chgData name="Narang, Sonali" userId="9e80b397-6e2f-49b1-9374-ccdad8589140" providerId="ADAL" clId="{EA661601-9742-7540-8562-E8A6C95A1393}" dt="2021-08-30T17:25:42.986" v="1111" actId="1076"/>
          <ac:picMkLst>
            <pc:docMk/>
            <pc:sldMk cId="1184752330" sldId="273"/>
            <ac:picMk id="16" creationId="{0431DD33-487F-1744-895E-CD1CBD9FCEF2}"/>
          </ac:picMkLst>
        </pc:picChg>
        <pc:picChg chg="add mod">
          <ac:chgData name="Narang, Sonali" userId="9e80b397-6e2f-49b1-9374-ccdad8589140" providerId="ADAL" clId="{EA661601-9742-7540-8562-E8A6C95A1393}" dt="2021-08-30T18:27:51.006" v="1176" actId="1038"/>
          <ac:picMkLst>
            <pc:docMk/>
            <pc:sldMk cId="1184752330" sldId="273"/>
            <ac:picMk id="18" creationId="{280D59A3-8DC1-994E-9BAD-746BF4A9F461}"/>
          </ac:picMkLst>
        </pc:picChg>
        <pc:picChg chg="add mod topLvl modCrop">
          <ac:chgData name="Narang, Sonali" userId="9e80b397-6e2f-49b1-9374-ccdad8589140" providerId="ADAL" clId="{EA661601-9742-7540-8562-E8A6C95A1393}" dt="2021-08-30T17:14:23.189" v="976" actId="164"/>
          <ac:picMkLst>
            <pc:docMk/>
            <pc:sldMk cId="1184752330" sldId="273"/>
            <ac:picMk id="38" creationId="{B4F7EF10-B507-0941-9B89-74FF265424BD}"/>
          </ac:picMkLst>
        </pc:picChg>
        <pc:picChg chg="add del mod">
          <ac:chgData name="Narang, Sonali" userId="9e80b397-6e2f-49b1-9374-ccdad8589140" providerId="ADAL" clId="{EA661601-9742-7540-8562-E8A6C95A1393}" dt="2021-08-30T18:21:11.601" v="1152" actId="478"/>
          <ac:picMkLst>
            <pc:docMk/>
            <pc:sldMk cId="1184752330" sldId="273"/>
            <ac:picMk id="78" creationId="{4D545F81-F7AF-E34F-A0D6-7829AC1F53AF}"/>
          </ac:picMkLst>
        </pc:picChg>
        <pc:picChg chg="mod">
          <ac:chgData name="Narang, Sonali" userId="9e80b397-6e2f-49b1-9374-ccdad8589140" providerId="ADAL" clId="{EA661601-9742-7540-8562-E8A6C95A1393}" dt="2021-08-30T17:21:54.324" v="1091" actId="1076"/>
          <ac:picMkLst>
            <pc:docMk/>
            <pc:sldMk cId="1184752330" sldId="273"/>
            <ac:picMk id="83" creationId="{A2DC379C-9BE3-8847-8A10-2744CD535286}"/>
          </ac:picMkLst>
        </pc:picChg>
        <pc:picChg chg="mod">
          <ac:chgData name="Narang, Sonali" userId="9e80b397-6e2f-49b1-9374-ccdad8589140" providerId="ADAL" clId="{EA661601-9742-7540-8562-E8A6C95A1393}" dt="2021-08-30T17:25:42.986" v="1111" actId="1076"/>
          <ac:picMkLst>
            <pc:docMk/>
            <pc:sldMk cId="1184752330" sldId="273"/>
            <ac:picMk id="111" creationId="{20BB0087-4AF3-7B49-A354-5C3664D1250B}"/>
          </ac:picMkLst>
        </pc:picChg>
        <pc:picChg chg="mod">
          <ac:chgData name="Narang, Sonali" userId="9e80b397-6e2f-49b1-9374-ccdad8589140" providerId="ADAL" clId="{EA661601-9742-7540-8562-E8A6C95A1393}" dt="2021-08-30T17:21:48.493" v="1089" actId="1076"/>
          <ac:picMkLst>
            <pc:docMk/>
            <pc:sldMk cId="1184752330" sldId="273"/>
            <ac:picMk id="114" creationId="{CD79A9EC-0F7C-6141-93B3-F5755D6371C7}"/>
          </ac:picMkLst>
        </pc:picChg>
        <pc:picChg chg="mod">
          <ac:chgData name="Narang, Sonali" userId="9e80b397-6e2f-49b1-9374-ccdad8589140" providerId="ADAL" clId="{EA661601-9742-7540-8562-E8A6C95A1393}" dt="2021-08-30T17:21:46.306" v="1088" actId="1076"/>
          <ac:picMkLst>
            <pc:docMk/>
            <pc:sldMk cId="1184752330" sldId="273"/>
            <ac:picMk id="116" creationId="{66C157FD-9F4F-EE4C-9C7A-F66F0D902C3A}"/>
          </ac:picMkLst>
        </pc:picChg>
        <pc:picChg chg="del">
          <ac:chgData name="Narang, Sonali" userId="9e80b397-6e2f-49b1-9374-ccdad8589140" providerId="ADAL" clId="{EA661601-9742-7540-8562-E8A6C95A1393}" dt="2021-08-30T17:04:15.046" v="766" actId="21"/>
          <ac:picMkLst>
            <pc:docMk/>
            <pc:sldMk cId="1184752330" sldId="273"/>
            <ac:picMk id="140" creationId="{748372BC-B499-D54F-AD17-E2DD1116980C}"/>
          </ac:picMkLst>
        </pc:picChg>
        <pc:cxnChg chg="del mod">
          <ac:chgData name="Narang, Sonali" userId="9e80b397-6e2f-49b1-9374-ccdad8589140" providerId="ADAL" clId="{EA661601-9742-7540-8562-E8A6C95A1393}" dt="2021-08-30T17:08:03.580" v="810" actId="478"/>
          <ac:cxnSpMkLst>
            <pc:docMk/>
            <pc:sldMk cId="1184752330" sldId="273"/>
            <ac:cxnSpMk id="68" creationId="{F8DE896F-F8D1-FB4E-B321-289CE41AF0DB}"/>
          </ac:cxnSpMkLst>
        </pc:cxnChg>
        <pc:cxnChg chg="del mod topLvl">
          <ac:chgData name="Narang, Sonali" userId="9e80b397-6e2f-49b1-9374-ccdad8589140" providerId="ADAL" clId="{EA661601-9742-7540-8562-E8A6C95A1393}" dt="2021-08-30T17:08:03.580" v="810" actId="478"/>
          <ac:cxnSpMkLst>
            <pc:docMk/>
            <pc:sldMk cId="1184752330" sldId="273"/>
            <ac:cxnSpMk id="69" creationId="{6865D394-1469-2844-BBF1-55A8D869502D}"/>
          </ac:cxnSpMkLst>
        </pc:cxnChg>
        <pc:cxnChg chg="del mod topLvl">
          <ac:chgData name="Narang, Sonali" userId="9e80b397-6e2f-49b1-9374-ccdad8589140" providerId="ADAL" clId="{EA661601-9742-7540-8562-E8A6C95A1393}" dt="2021-08-30T17:08:03.580" v="810" actId="478"/>
          <ac:cxnSpMkLst>
            <pc:docMk/>
            <pc:sldMk cId="1184752330" sldId="273"/>
            <ac:cxnSpMk id="70" creationId="{06EEA95D-B268-8542-A73B-0090E1AF6DA3}"/>
          </ac:cxnSpMkLst>
        </pc:cxnChg>
      </pc:sldChg>
      <pc:sldChg chg="addSp delSp modSp add mod">
        <pc:chgData name="Narang, Sonali" userId="9e80b397-6e2f-49b1-9374-ccdad8589140" providerId="ADAL" clId="{EA661601-9742-7540-8562-E8A6C95A1393}" dt="2021-08-31T16:44:04.359" v="1408" actId="1076"/>
        <pc:sldMkLst>
          <pc:docMk/>
          <pc:sldMk cId="3544397231" sldId="274"/>
        </pc:sldMkLst>
        <pc:spChg chg="mod">
          <ac:chgData name="Narang, Sonali" userId="9e80b397-6e2f-49b1-9374-ccdad8589140" providerId="ADAL" clId="{EA661601-9742-7540-8562-E8A6C95A1393}" dt="2021-08-31T16:42:45.299" v="1350" actId="1076"/>
          <ac:spMkLst>
            <pc:docMk/>
            <pc:sldMk cId="3544397231" sldId="274"/>
            <ac:spMk id="6" creationId="{41464C80-B659-484D-A16F-8018DEC5471A}"/>
          </ac:spMkLst>
        </pc:spChg>
        <pc:spChg chg="mod">
          <ac:chgData name="Narang, Sonali" userId="9e80b397-6e2f-49b1-9374-ccdad8589140" providerId="ADAL" clId="{EA661601-9742-7540-8562-E8A6C95A1393}" dt="2021-08-31T16:44:04.359" v="1408" actId="1076"/>
          <ac:spMkLst>
            <pc:docMk/>
            <pc:sldMk cId="3544397231" sldId="274"/>
            <ac:spMk id="7" creationId="{4C5F5CAE-FBFD-964D-A356-746AAC86DC9E}"/>
          </ac:spMkLst>
        </pc:spChg>
        <pc:spChg chg="add mod">
          <ac:chgData name="Narang, Sonali" userId="9e80b397-6e2f-49b1-9374-ccdad8589140" providerId="ADAL" clId="{EA661601-9742-7540-8562-E8A6C95A1393}" dt="2021-08-31T16:43:17.425" v="1385" actId="1076"/>
          <ac:spMkLst>
            <pc:docMk/>
            <pc:sldMk cId="3544397231" sldId="274"/>
            <ac:spMk id="37" creationId="{437F56E8-F3ED-ED45-8A3B-134C0DCCA9C5}"/>
          </ac:spMkLst>
        </pc:spChg>
        <pc:spChg chg="add mod">
          <ac:chgData name="Narang, Sonali" userId="9e80b397-6e2f-49b1-9374-ccdad8589140" providerId="ADAL" clId="{EA661601-9742-7540-8562-E8A6C95A1393}" dt="2021-08-31T16:43:28.241" v="1396" actId="20577"/>
          <ac:spMkLst>
            <pc:docMk/>
            <pc:sldMk cId="3544397231" sldId="274"/>
            <ac:spMk id="38" creationId="{044CCEFD-5A6D-EA47-A900-ADAF7364694A}"/>
          </ac:spMkLst>
        </pc:spChg>
        <pc:picChg chg="del">
          <ac:chgData name="Narang, Sonali" userId="9e80b397-6e2f-49b1-9374-ccdad8589140" providerId="ADAL" clId="{EA661601-9742-7540-8562-E8A6C95A1393}" dt="2021-08-31T16:41:10.096" v="1297" actId="478"/>
          <ac:picMkLst>
            <pc:docMk/>
            <pc:sldMk cId="3544397231" sldId="274"/>
            <ac:picMk id="2" creationId="{FFF37771-971D-4C4C-B781-0D37188A46A1}"/>
          </ac:picMkLst>
        </pc:picChg>
        <pc:picChg chg="del">
          <ac:chgData name="Narang, Sonali" userId="9e80b397-6e2f-49b1-9374-ccdad8589140" providerId="ADAL" clId="{EA661601-9742-7540-8562-E8A6C95A1393}" dt="2021-08-31T16:41:10.096" v="1297" actId="478"/>
          <ac:picMkLst>
            <pc:docMk/>
            <pc:sldMk cId="3544397231" sldId="274"/>
            <ac:picMk id="3" creationId="{969BAEF7-6218-824D-A489-ADB0661F7F74}"/>
          </ac:picMkLst>
        </pc:picChg>
        <pc:picChg chg="del">
          <ac:chgData name="Narang, Sonali" userId="9e80b397-6e2f-49b1-9374-ccdad8589140" providerId="ADAL" clId="{EA661601-9742-7540-8562-E8A6C95A1393}" dt="2021-08-31T16:41:10.096" v="1297" actId="478"/>
          <ac:picMkLst>
            <pc:docMk/>
            <pc:sldMk cId="3544397231" sldId="274"/>
            <ac:picMk id="9" creationId="{EE74AD70-F2BB-734D-B341-9CB9C96FD28C}"/>
          </ac:picMkLst>
        </pc:picChg>
        <pc:picChg chg="del">
          <ac:chgData name="Narang, Sonali" userId="9e80b397-6e2f-49b1-9374-ccdad8589140" providerId="ADAL" clId="{EA661601-9742-7540-8562-E8A6C95A1393}" dt="2021-08-31T16:41:18.957" v="1298" actId="478"/>
          <ac:picMkLst>
            <pc:docMk/>
            <pc:sldMk cId="3544397231" sldId="274"/>
            <ac:picMk id="11" creationId="{360F0190-AC51-DD4F-A85A-3A17C0E17B8A}"/>
          </ac:picMkLst>
        </pc:picChg>
        <pc:picChg chg="del">
          <ac:chgData name="Narang, Sonali" userId="9e80b397-6e2f-49b1-9374-ccdad8589140" providerId="ADAL" clId="{EA661601-9742-7540-8562-E8A6C95A1393}" dt="2021-08-31T16:41:18.957" v="1298" actId="478"/>
          <ac:picMkLst>
            <pc:docMk/>
            <pc:sldMk cId="3544397231" sldId="274"/>
            <ac:picMk id="12" creationId="{586F5557-2C65-A74F-B317-8E0706626B84}"/>
          </ac:picMkLst>
        </pc:picChg>
        <pc:picChg chg="del">
          <ac:chgData name="Narang, Sonali" userId="9e80b397-6e2f-49b1-9374-ccdad8589140" providerId="ADAL" clId="{EA661601-9742-7540-8562-E8A6C95A1393}" dt="2021-08-31T16:41:18.957" v="1298" actId="478"/>
          <ac:picMkLst>
            <pc:docMk/>
            <pc:sldMk cId="3544397231" sldId="274"/>
            <ac:picMk id="13" creationId="{AC373017-3803-E844-AEF9-7AA58D31C509}"/>
          </ac:picMkLst>
        </pc:picChg>
        <pc:picChg chg="add del mod">
          <ac:chgData name="Narang, Sonali" userId="9e80b397-6e2f-49b1-9374-ccdad8589140" providerId="ADAL" clId="{EA661601-9742-7540-8562-E8A6C95A1393}" dt="2021-08-31T16:41:44.051" v="1316" actId="931"/>
          <ac:picMkLst>
            <pc:docMk/>
            <pc:sldMk cId="3544397231" sldId="274"/>
            <ac:picMk id="14" creationId="{3DE880CA-5E71-1849-B81B-C5B96B7CBAA6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15" creationId="{102B2DA4-BF6C-B44F-BFD4-34128031542E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17" creationId="{52D1DD20-D46E-6048-80AC-3F937064F5A2}"/>
          </ac:picMkLst>
        </pc:picChg>
        <pc:picChg chg="add del mod">
          <ac:chgData name="Narang, Sonali" userId="9e80b397-6e2f-49b1-9374-ccdad8589140" providerId="ADAL" clId="{EA661601-9742-7540-8562-E8A6C95A1393}" dt="2021-08-31T16:41:43.638" v="1315" actId="931"/>
          <ac:picMkLst>
            <pc:docMk/>
            <pc:sldMk cId="3544397231" sldId="274"/>
            <ac:picMk id="18" creationId="{1459AD1F-079C-044D-B20E-DB9B49FA8C83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19" creationId="{FDFCA230-8A82-9B4E-BD87-36E627CB71AB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21" creationId="{BC034324-62BB-9447-8AFF-4381E3007CAF}"/>
          </ac:picMkLst>
        </pc:picChg>
        <pc:picChg chg="add del mod">
          <ac:chgData name="Narang, Sonali" userId="9e80b397-6e2f-49b1-9374-ccdad8589140" providerId="ADAL" clId="{EA661601-9742-7540-8562-E8A6C95A1393}" dt="2021-08-31T16:41:43.219" v="1314" actId="931"/>
          <ac:picMkLst>
            <pc:docMk/>
            <pc:sldMk cId="3544397231" sldId="274"/>
            <ac:picMk id="22" creationId="{3D24DA9D-7514-CA4B-99D3-867E23846383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23" creationId="{5101B775-381A-5A4C-B599-B67845C018C5}"/>
          </ac:picMkLst>
        </pc:picChg>
        <pc:picChg chg="add del">
          <ac:chgData name="Narang, Sonali" userId="9e80b397-6e2f-49b1-9374-ccdad8589140" providerId="ADAL" clId="{EA661601-9742-7540-8562-E8A6C95A1393}" dt="2021-08-31T16:41:45.702" v="1318" actId="478"/>
          <ac:picMkLst>
            <pc:docMk/>
            <pc:sldMk cId="3544397231" sldId="274"/>
            <ac:picMk id="25" creationId="{823F62DB-3D92-A444-92E1-A60A5115EFD6}"/>
          </ac:picMkLst>
        </pc:picChg>
        <pc:picChg chg="add del mod">
          <ac:chgData name="Narang, Sonali" userId="9e80b397-6e2f-49b1-9374-ccdad8589140" providerId="ADAL" clId="{EA661601-9742-7540-8562-E8A6C95A1393}" dt="2021-08-31T16:41:42.840" v="1313" actId="931"/>
          <ac:picMkLst>
            <pc:docMk/>
            <pc:sldMk cId="3544397231" sldId="274"/>
            <ac:picMk id="26" creationId="{4E1213A0-62DE-6E49-B4AE-6DFBB7FC1821}"/>
          </ac:picMkLst>
        </pc:picChg>
        <pc:picChg chg="add del mod">
          <ac:chgData name="Narang, Sonali" userId="9e80b397-6e2f-49b1-9374-ccdad8589140" providerId="ADAL" clId="{EA661601-9742-7540-8562-E8A6C95A1393}" dt="2021-08-31T16:41:42.474" v="1312" actId="931"/>
          <ac:picMkLst>
            <pc:docMk/>
            <pc:sldMk cId="3544397231" sldId="274"/>
            <ac:picMk id="28" creationId="{B128A2FC-2ECA-994B-A4F6-C7F27C4EFFCB}"/>
          </ac:picMkLst>
        </pc:picChg>
        <pc:picChg chg="add del mod">
          <ac:chgData name="Narang, Sonali" userId="9e80b397-6e2f-49b1-9374-ccdad8589140" providerId="ADAL" clId="{EA661601-9742-7540-8562-E8A6C95A1393}" dt="2021-08-31T16:41:41.839" v="1311" actId="931"/>
          <ac:picMkLst>
            <pc:docMk/>
            <pc:sldMk cId="3544397231" sldId="274"/>
            <ac:picMk id="30" creationId="{52282CEC-A915-2048-9380-61835C8A5D5D}"/>
          </ac:picMkLst>
        </pc:picChg>
        <pc:picChg chg="add mod">
          <ac:chgData name="Narang, Sonali" userId="9e80b397-6e2f-49b1-9374-ccdad8589140" providerId="ADAL" clId="{EA661601-9742-7540-8562-E8A6C95A1393}" dt="2021-08-31T16:43:20.253" v="1387" actId="1076"/>
          <ac:picMkLst>
            <pc:docMk/>
            <pc:sldMk cId="3544397231" sldId="274"/>
            <ac:picMk id="32" creationId="{F7389F9A-5849-C64D-A270-03EBB6117295}"/>
          </ac:picMkLst>
        </pc:picChg>
        <pc:picChg chg="add mod">
          <ac:chgData name="Narang, Sonali" userId="9e80b397-6e2f-49b1-9374-ccdad8589140" providerId="ADAL" clId="{EA661601-9742-7540-8562-E8A6C95A1393}" dt="2021-08-31T16:43:07.655" v="1380" actId="1035"/>
          <ac:picMkLst>
            <pc:docMk/>
            <pc:sldMk cId="3544397231" sldId="274"/>
            <ac:picMk id="34" creationId="{B2553D5E-D948-404C-9AB8-1B3B93CE29C8}"/>
          </ac:picMkLst>
        </pc:picChg>
        <pc:picChg chg="add mod">
          <ac:chgData name="Narang, Sonali" userId="9e80b397-6e2f-49b1-9374-ccdad8589140" providerId="ADAL" clId="{EA661601-9742-7540-8562-E8A6C95A1393}" dt="2021-08-31T16:43:07.655" v="1380" actId="1035"/>
          <ac:picMkLst>
            <pc:docMk/>
            <pc:sldMk cId="3544397231" sldId="274"/>
            <ac:picMk id="36" creationId="{4590FA56-9DDA-3F46-8637-910FCE03B039}"/>
          </ac:picMkLst>
        </pc:picChg>
        <pc:picChg chg="add mod">
          <ac:chgData name="Narang, Sonali" userId="9e80b397-6e2f-49b1-9374-ccdad8589140" providerId="ADAL" clId="{EA661601-9742-7540-8562-E8A6C95A1393}" dt="2021-08-31T16:43:49.619" v="1405" actId="1076"/>
          <ac:picMkLst>
            <pc:docMk/>
            <pc:sldMk cId="3544397231" sldId="274"/>
            <ac:picMk id="40" creationId="{9CE7E99D-E1A2-0947-9967-83934FC780F1}"/>
          </ac:picMkLst>
        </pc:picChg>
        <pc:picChg chg="add mod">
          <ac:chgData name="Narang, Sonali" userId="9e80b397-6e2f-49b1-9374-ccdad8589140" providerId="ADAL" clId="{EA661601-9742-7540-8562-E8A6C95A1393}" dt="2021-08-31T16:43:53.493" v="1406" actId="1076"/>
          <ac:picMkLst>
            <pc:docMk/>
            <pc:sldMk cId="3544397231" sldId="274"/>
            <ac:picMk id="42" creationId="{AEC2CF48-D058-634B-B9BD-C9F45C6B2AA3}"/>
          </ac:picMkLst>
        </pc:picChg>
        <pc:picChg chg="add mod">
          <ac:chgData name="Narang, Sonali" userId="9e80b397-6e2f-49b1-9374-ccdad8589140" providerId="ADAL" clId="{EA661601-9742-7540-8562-E8A6C95A1393}" dt="2021-08-31T16:43:56.314" v="1407" actId="1076"/>
          <ac:picMkLst>
            <pc:docMk/>
            <pc:sldMk cId="3544397231" sldId="274"/>
            <ac:picMk id="44" creationId="{9F6EEE26-A4BA-D942-B01D-508167E407B0}"/>
          </ac:picMkLst>
        </pc:picChg>
      </pc:sldChg>
      <pc:sldChg chg="add del">
        <pc:chgData name="Narang, Sonali" userId="9e80b397-6e2f-49b1-9374-ccdad8589140" providerId="ADAL" clId="{EA661601-9742-7540-8562-E8A6C95A1393}" dt="2021-08-31T16:41:21.144" v="1300"/>
        <pc:sldMkLst>
          <pc:docMk/>
          <pc:sldMk cId="2945653576" sldId="275"/>
        </pc:sldMkLst>
      </pc:sldChg>
    </pc:docChg>
  </pc:docChgLst>
  <pc:docChgLst>
    <pc:chgData name="Narang, Sonali" userId="9e80b397-6e2f-49b1-9374-ccdad8589140" providerId="ADAL" clId="{A759B0D2-6A44-994A-98DB-9F991BFBBF7F}"/>
    <pc:docChg chg="undo custSel modSld">
      <pc:chgData name="Narang, Sonali" userId="9e80b397-6e2f-49b1-9374-ccdad8589140" providerId="ADAL" clId="{A759B0D2-6A44-994A-98DB-9F991BFBBF7F}" dt="2022-09-27T20:33:37.765" v="328" actId="20577"/>
      <pc:docMkLst>
        <pc:docMk/>
      </pc:docMkLst>
      <pc:sldChg chg="delSp modSp mod modNotesTx">
        <pc:chgData name="Narang, Sonali" userId="9e80b397-6e2f-49b1-9374-ccdad8589140" providerId="ADAL" clId="{A759B0D2-6A44-994A-98DB-9F991BFBBF7F}" dt="2022-09-27T20:19:51.840" v="191" actId="20577"/>
        <pc:sldMkLst>
          <pc:docMk/>
          <pc:sldMk cId="743684689" sldId="267"/>
        </pc:sldMkLst>
        <pc:spChg chg="mod">
          <ac:chgData name="Narang, Sonali" userId="9e80b397-6e2f-49b1-9374-ccdad8589140" providerId="ADAL" clId="{A759B0D2-6A44-994A-98DB-9F991BFBBF7F}" dt="2022-09-27T20:18:22.642" v="135" actId="1038"/>
          <ac:spMkLst>
            <pc:docMk/>
            <pc:sldMk cId="743684689" sldId="267"/>
            <ac:spMk id="6" creationId="{41464C80-B659-484D-A16F-8018DEC5471A}"/>
          </ac:spMkLst>
        </pc:spChg>
        <pc:spChg chg="mod">
          <ac:chgData name="Narang, Sonali" userId="9e80b397-6e2f-49b1-9374-ccdad8589140" providerId="ADAL" clId="{A759B0D2-6A44-994A-98DB-9F991BFBBF7F}" dt="2022-09-27T20:17:50.221" v="94" actId="1076"/>
          <ac:spMkLst>
            <pc:docMk/>
            <pc:sldMk cId="743684689" sldId="267"/>
            <ac:spMk id="8" creationId="{8A9BAE78-C4FF-1843-94F6-3410EB884848}"/>
          </ac:spMkLst>
        </pc:spChg>
        <pc:spChg chg="mod">
          <ac:chgData name="Narang, Sonali" userId="9e80b397-6e2f-49b1-9374-ccdad8589140" providerId="ADAL" clId="{A759B0D2-6A44-994A-98DB-9F991BFBBF7F}" dt="2022-09-27T20:19:01.774" v="163" actId="20577"/>
          <ac:spMkLst>
            <pc:docMk/>
            <pc:sldMk cId="743684689" sldId="267"/>
            <ac:spMk id="46" creationId="{7406AFD2-D7AD-D246-9AA9-8D2A7E07C320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19" creationId="{F96847DC-C3E6-5F43-B748-6197693F0C5F}"/>
          </ac:spMkLst>
        </pc:spChg>
        <pc:spChg chg="del">
          <ac:chgData name="Narang, Sonali" userId="9e80b397-6e2f-49b1-9374-ccdad8589140" providerId="ADAL" clId="{A759B0D2-6A44-994A-98DB-9F991BFBBF7F}" dt="2022-09-27T20:16:24.742" v="83" actId="478"/>
          <ac:spMkLst>
            <pc:docMk/>
            <pc:sldMk cId="743684689" sldId="267"/>
            <ac:spMk id="124" creationId="{2BE84DAC-7C05-C445-9DD3-6B3EE69AFBF9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28" creationId="{A6A057D2-5FF7-4149-94F5-B140DE2FABD5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29" creationId="{F119B312-680E-2C4F-B5C8-8938B9E422AB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30" creationId="{B1493AFF-CA4E-6F4D-A0BA-1B90E4BA8A6E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3" creationId="{CDB74C8A-8DFE-7246-A4E5-82AC375D6524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4" creationId="{563E4695-FACC-A643-BBE8-1CC93B44D1BA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5" creationId="{D890D106-88F0-AD48-A6DD-50F067183F9D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6" creationId="{E2932365-5FC6-AA44-B04E-AE3D6664BA4E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7" creationId="{9A109801-764A-424C-A341-23242F15F561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8" creationId="{EA11B04E-C8FF-4842-9F12-E83E6092CA91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49" creationId="{D8349D72-B0AA-8340-BEDB-964FDDBD372D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50" creationId="{FBE03226-AE8E-AF42-8BBD-E1FDA5B497F8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51" creationId="{0CBB35CC-33A4-0B4F-870C-2374E6EF5CB8}"/>
          </ac:spMkLst>
        </pc:spChg>
        <pc:spChg chg="mod">
          <ac:chgData name="Narang, Sonali" userId="9e80b397-6e2f-49b1-9374-ccdad8589140" providerId="ADAL" clId="{A759B0D2-6A44-994A-98DB-9F991BFBBF7F}" dt="2022-09-27T20:18:47.893" v="161" actId="1038"/>
          <ac:spMkLst>
            <pc:docMk/>
            <pc:sldMk cId="743684689" sldId="267"/>
            <ac:spMk id="152" creationId="{76912FDE-67EB-554E-B5D2-687F992A13CE}"/>
          </ac:spMkLst>
        </pc:spChg>
        <pc:spChg chg="mod">
          <ac:chgData name="Narang, Sonali" userId="9e80b397-6e2f-49b1-9374-ccdad8589140" providerId="ADAL" clId="{A759B0D2-6A44-994A-98DB-9F991BFBBF7F}" dt="2022-09-27T20:19:04.377" v="165" actId="20577"/>
          <ac:spMkLst>
            <pc:docMk/>
            <pc:sldMk cId="743684689" sldId="267"/>
            <ac:spMk id="156" creationId="{8FF60A7D-1E41-ED47-BB8F-AFE0553750EE}"/>
          </ac:spMkLst>
        </pc:spChg>
        <pc:spChg chg="del">
          <ac:chgData name="Narang, Sonali" userId="9e80b397-6e2f-49b1-9374-ccdad8589140" providerId="ADAL" clId="{A759B0D2-6A44-994A-98DB-9F991BFBBF7F}" dt="2022-09-27T20:16:24.742" v="83" actId="478"/>
          <ac:spMkLst>
            <pc:docMk/>
            <pc:sldMk cId="743684689" sldId="267"/>
            <ac:spMk id="184" creationId="{2211BE2A-B3C4-3947-903A-B3BD8653BA07}"/>
          </ac:spMkLst>
        </pc:spChg>
        <pc:spChg chg="del">
          <ac:chgData name="Narang, Sonali" userId="9e80b397-6e2f-49b1-9374-ccdad8589140" providerId="ADAL" clId="{A759B0D2-6A44-994A-98DB-9F991BFBBF7F}" dt="2022-09-27T20:16:24.742" v="83" actId="478"/>
          <ac:spMkLst>
            <pc:docMk/>
            <pc:sldMk cId="743684689" sldId="267"/>
            <ac:spMk id="185" creationId="{274343EA-8BC8-C547-A442-AED8B4EEC35F}"/>
          </ac:spMkLst>
        </pc:spChg>
        <pc:spChg chg="del">
          <ac:chgData name="Narang, Sonali" userId="9e80b397-6e2f-49b1-9374-ccdad8589140" providerId="ADAL" clId="{A759B0D2-6A44-994A-98DB-9F991BFBBF7F}" dt="2022-09-27T20:16:24.742" v="83" actId="478"/>
          <ac:spMkLst>
            <pc:docMk/>
            <pc:sldMk cId="743684689" sldId="267"/>
            <ac:spMk id="186" creationId="{DEE549CB-B869-D941-8A58-37313ADE2F43}"/>
          </ac:spMkLst>
        </pc:spChg>
        <pc:grpChg chg="mod">
          <ac:chgData name="Narang, Sonali" userId="9e80b397-6e2f-49b1-9374-ccdad8589140" providerId="ADAL" clId="{A759B0D2-6A44-994A-98DB-9F991BFBBF7F}" dt="2022-09-27T20:18:26.951" v="136" actId="14100"/>
          <ac:grpSpMkLst>
            <pc:docMk/>
            <pc:sldMk cId="743684689" sldId="267"/>
            <ac:grpSpMk id="2" creationId="{8807552B-1B5C-D249-A86E-05B6502AFE00}"/>
          </ac:grpSpMkLst>
        </pc:grpChg>
        <pc:grpChg chg="mod">
          <ac:chgData name="Narang, Sonali" userId="9e80b397-6e2f-49b1-9374-ccdad8589140" providerId="ADAL" clId="{A759B0D2-6A44-994A-98DB-9F991BFBBF7F}" dt="2022-09-27T20:18:02.342" v="96" actId="1076"/>
          <ac:grpSpMkLst>
            <pc:docMk/>
            <pc:sldMk cId="743684689" sldId="267"/>
            <ac:grpSpMk id="117" creationId="{B05B94FA-BBA9-A64D-8CA4-F0D3B7616FE1}"/>
          </ac:grpSpMkLst>
        </pc:grpChg>
        <pc:picChg chg="mod">
          <ac:chgData name="Narang, Sonali" userId="9e80b397-6e2f-49b1-9374-ccdad8589140" providerId="ADAL" clId="{A759B0D2-6A44-994A-98DB-9F991BFBBF7F}" dt="2022-09-27T20:18:15.358" v="118" actId="14100"/>
          <ac:picMkLst>
            <pc:docMk/>
            <pc:sldMk cId="743684689" sldId="267"/>
            <ac:picMk id="7" creationId="{54B78F49-DB33-4142-8248-E58CCA1F65B8}"/>
          </ac:picMkLst>
        </pc:picChg>
        <pc:picChg chg="del">
          <ac:chgData name="Narang, Sonali" userId="9e80b397-6e2f-49b1-9374-ccdad8589140" providerId="ADAL" clId="{A759B0D2-6A44-994A-98DB-9F991BFBBF7F}" dt="2022-09-27T20:16:24.742" v="83" actId="478"/>
          <ac:picMkLst>
            <pc:docMk/>
            <pc:sldMk cId="743684689" sldId="267"/>
            <ac:picMk id="167" creationId="{58CAA980-D1E6-AA4C-A334-C0D57A74D895}"/>
          </ac:picMkLst>
        </pc:picChg>
        <pc:picChg chg="del">
          <ac:chgData name="Narang, Sonali" userId="9e80b397-6e2f-49b1-9374-ccdad8589140" providerId="ADAL" clId="{A759B0D2-6A44-994A-98DB-9F991BFBBF7F}" dt="2022-09-27T20:16:24.742" v="83" actId="478"/>
          <ac:picMkLst>
            <pc:docMk/>
            <pc:sldMk cId="743684689" sldId="267"/>
            <ac:picMk id="169" creationId="{5A30999A-89D7-8C40-9571-87F0979C7EAA}"/>
          </ac:picMkLst>
        </pc:picChg>
        <pc:picChg chg="del">
          <ac:chgData name="Narang, Sonali" userId="9e80b397-6e2f-49b1-9374-ccdad8589140" providerId="ADAL" clId="{A759B0D2-6A44-994A-98DB-9F991BFBBF7F}" dt="2022-09-27T20:16:24.742" v="83" actId="478"/>
          <ac:picMkLst>
            <pc:docMk/>
            <pc:sldMk cId="743684689" sldId="267"/>
            <ac:picMk id="171" creationId="{9C4DDE62-3BC7-ED45-A82E-A3C21D506B79}"/>
          </ac:picMkLst>
        </pc:picChg>
        <pc:picChg chg="mod">
          <ac:chgData name="Narang, Sonali" userId="9e80b397-6e2f-49b1-9374-ccdad8589140" providerId="ADAL" clId="{A759B0D2-6A44-994A-98DB-9F991BFBBF7F}" dt="2022-09-27T20:18:19.167" v="120" actId="1076"/>
          <ac:picMkLst>
            <pc:docMk/>
            <pc:sldMk cId="743684689" sldId="267"/>
            <ac:picMk id="188" creationId="{9087D8BC-5ADD-E842-9EC0-9741E41D32B0}"/>
          </ac:picMkLst>
        </pc:picChg>
      </pc:sldChg>
      <pc:sldChg chg="addSp delSp modSp mod modNotesTx">
        <pc:chgData name="Narang, Sonali" userId="9e80b397-6e2f-49b1-9374-ccdad8589140" providerId="ADAL" clId="{A759B0D2-6A44-994A-98DB-9F991BFBBF7F}" dt="2022-09-27T20:33:37.765" v="328" actId="20577"/>
        <pc:sldMkLst>
          <pc:docMk/>
          <pc:sldMk cId="3214590643" sldId="280"/>
        </pc:sldMkLst>
        <pc:spChg chg="mod">
          <ac:chgData name="Narang, Sonali" userId="9e80b397-6e2f-49b1-9374-ccdad8589140" providerId="ADAL" clId="{A759B0D2-6A44-994A-98DB-9F991BFBBF7F}" dt="2022-09-27T20:32:03.181" v="206" actId="20577"/>
          <ac:spMkLst>
            <pc:docMk/>
            <pc:sldMk cId="3214590643" sldId="280"/>
            <ac:spMk id="15" creationId="{211CF65A-99E6-4C44-981B-639900C416DF}"/>
          </ac:spMkLst>
        </pc:spChg>
        <pc:spChg chg="del mod">
          <ac:chgData name="Narang, Sonali" userId="9e80b397-6e2f-49b1-9374-ccdad8589140" providerId="ADAL" clId="{A759B0D2-6A44-994A-98DB-9F991BFBBF7F}" dt="2022-09-27T20:28:33.226" v="199" actId="21"/>
          <ac:spMkLst>
            <pc:docMk/>
            <pc:sldMk cId="3214590643" sldId="280"/>
            <ac:spMk id="46" creationId="{BC4BD7F9-9550-3841-BBB5-1A58285A1D88}"/>
          </ac:spMkLst>
        </pc:spChg>
        <pc:spChg chg="mod">
          <ac:chgData name="Narang, Sonali" userId="9e80b397-6e2f-49b1-9374-ccdad8589140" providerId="ADAL" clId="{A759B0D2-6A44-994A-98DB-9F991BFBBF7F}" dt="2022-09-27T20:32:06.210" v="208" actId="20577"/>
          <ac:spMkLst>
            <pc:docMk/>
            <pc:sldMk cId="3214590643" sldId="280"/>
            <ac:spMk id="69" creationId="{54A5D94C-10A5-B344-9D6B-7B82866EB4D4}"/>
          </ac:spMkLst>
        </pc:spChg>
        <pc:spChg chg="mod">
          <ac:chgData name="Narang, Sonali" userId="9e80b397-6e2f-49b1-9374-ccdad8589140" providerId="ADAL" clId="{A759B0D2-6A44-994A-98DB-9F991BFBBF7F}" dt="2022-09-27T20:32:46.407" v="237" actId="20577"/>
          <ac:spMkLst>
            <pc:docMk/>
            <pc:sldMk cId="3214590643" sldId="280"/>
            <ac:spMk id="76" creationId="{CF41EF2A-279F-1E46-A78F-FE9B71283731}"/>
          </ac:spMkLst>
        </pc:spChg>
        <pc:spChg chg="mod">
          <ac:chgData name="Narang, Sonali" userId="9e80b397-6e2f-49b1-9374-ccdad8589140" providerId="ADAL" clId="{A759B0D2-6A44-994A-98DB-9F991BFBBF7F}" dt="2022-09-27T20:32:59.243" v="263" actId="20577"/>
          <ac:spMkLst>
            <pc:docMk/>
            <pc:sldMk cId="3214590643" sldId="280"/>
            <ac:spMk id="77" creationId="{C08735D1-87D4-424C-8AA2-049A8E71D39F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86" creationId="{31FF7BEE-129B-9446-89F3-01C23AD35DF5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87" creationId="{98132429-950D-5C4F-B717-C51F57AC46CD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88" creationId="{E1124F83-F456-2040-AD95-09C17D00B972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89" creationId="{F32C7DFB-C4A9-BF49-89D4-BA9CA1525190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0" creationId="{A9C45E7E-365F-7347-AAF4-FB739A5603B9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1" creationId="{7DE334F5-C2B2-734F-B115-33D44D6E518E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2" creationId="{39533448-707E-3240-9609-CE24D6C3C7E6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3" creationId="{673A7F73-543E-1846-B34C-B972E198719E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4" creationId="{18570F01-7936-3640-9957-BAD8076D875C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5" creationId="{E98F5661-3EED-4E4D-8ECB-4D2F2B3EA3AD}"/>
          </ac:spMkLst>
        </pc:spChg>
        <pc:spChg chg="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99" creationId="{DB473C6F-7489-8B42-B146-06989C65C93C}"/>
          </ac:spMkLst>
        </pc:spChg>
        <pc:spChg chg="add mod">
          <ac:chgData name="Narang, Sonali" userId="9e80b397-6e2f-49b1-9374-ccdad8589140" providerId="ADAL" clId="{A759B0D2-6A44-994A-98DB-9F991BFBBF7F}" dt="2022-09-27T20:28:08.530" v="197"/>
          <ac:spMkLst>
            <pc:docMk/>
            <pc:sldMk cId="3214590643" sldId="280"/>
            <ac:spMk id="101" creationId="{EA90A211-5E05-9F41-92A8-6A970CFF3284}"/>
          </ac:spMkLst>
        </pc:spChg>
        <pc:grpChg chg="mod">
          <ac:chgData name="Narang, Sonali" userId="9e80b397-6e2f-49b1-9374-ccdad8589140" providerId="ADAL" clId="{A759B0D2-6A44-994A-98DB-9F991BFBBF7F}" dt="2022-09-27T20:28:28.215" v="198" actId="1076"/>
          <ac:grpSpMkLst>
            <pc:docMk/>
            <pc:sldMk cId="3214590643" sldId="280"/>
            <ac:grpSpMk id="8" creationId="{45FEEB36-25D9-5F49-85E7-2D0851625267}"/>
          </ac:grpSpMkLst>
        </pc:grpChg>
        <pc:grpChg chg="mod">
          <ac:chgData name="Narang, Sonali" userId="9e80b397-6e2f-49b1-9374-ccdad8589140" providerId="ADAL" clId="{A759B0D2-6A44-994A-98DB-9F991BFBBF7F}" dt="2022-09-27T20:28:28.215" v="198" actId="1076"/>
          <ac:grpSpMkLst>
            <pc:docMk/>
            <pc:sldMk cId="3214590643" sldId="280"/>
            <ac:grpSpMk id="9" creationId="{C7F38601-1F0A-4A4B-9DDB-F655C1D9971E}"/>
          </ac:grpSpMkLst>
        </pc:grpChg>
        <pc:grpChg chg="del mod">
          <ac:chgData name="Narang, Sonali" userId="9e80b397-6e2f-49b1-9374-ccdad8589140" providerId="ADAL" clId="{A759B0D2-6A44-994A-98DB-9F991BFBBF7F}" dt="2022-09-27T20:28:33.226" v="199" actId="21"/>
          <ac:grpSpMkLst>
            <pc:docMk/>
            <pc:sldMk cId="3214590643" sldId="280"/>
            <ac:grpSpMk id="47" creationId="{4B802D37-9378-E54E-99B5-1E00E308EBB8}"/>
          </ac:grpSpMkLst>
        </pc:grpChg>
        <pc:grpChg chg="add mod">
          <ac:chgData name="Narang, Sonali" userId="9e80b397-6e2f-49b1-9374-ccdad8589140" providerId="ADAL" clId="{A759B0D2-6A44-994A-98DB-9F991BFBBF7F}" dt="2022-09-27T20:28:08.530" v="197"/>
          <ac:grpSpMkLst>
            <pc:docMk/>
            <pc:sldMk cId="3214590643" sldId="280"/>
            <ac:grpSpMk id="96" creationId="{E84710AF-8788-CA41-82EA-72DCA5410BAD}"/>
          </ac:grpSpMkLst>
        </pc:grpChg>
        <pc:graphicFrameChg chg="mod modGraphic">
          <ac:chgData name="Narang, Sonali" userId="9e80b397-6e2f-49b1-9374-ccdad8589140" providerId="ADAL" clId="{A759B0D2-6A44-994A-98DB-9F991BFBBF7F}" dt="2022-09-27T20:28:28.215" v="198" actId="1076"/>
          <ac:graphicFrameMkLst>
            <pc:docMk/>
            <pc:sldMk cId="3214590643" sldId="280"/>
            <ac:graphicFrameMk id="67" creationId="{D446A5C9-0020-E549-88A4-B747B41C87E5}"/>
          </ac:graphicFrameMkLst>
        </pc:graphicFrameChg>
        <pc:picChg chg="del mod">
          <ac:chgData name="Narang, Sonali" userId="9e80b397-6e2f-49b1-9374-ccdad8589140" providerId="ADAL" clId="{A759B0D2-6A44-994A-98DB-9F991BFBBF7F}" dt="2022-09-27T20:28:33.226" v="199" actId="21"/>
          <ac:picMkLst>
            <pc:docMk/>
            <pc:sldMk cId="3214590643" sldId="280"/>
            <ac:picMk id="3" creationId="{4E5F250C-B970-F74D-9C24-941D57EE1E17}"/>
          </ac:picMkLst>
        </pc:picChg>
        <pc:picChg chg="del mod">
          <ac:chgData name="Narang, Sonali" userId="9e80b397-6e2f-49b1-9374-ccdad8589140" providerId="ADAL" clId="{A759B0D2-6A44-994A-98DB-9F991BFBBF7F}" dt="2022-09-27T20:28:33.226" v="199" actId="21"/>
          <ac:picMkLst>
            <pc:docMk/>
            <pc:sldMk cId="3214590643" sldId="280"/>
            <ac:picMk id="5" creationId="{4A0CFB63-C7C0-7D4D-A844-75A0A5C142C2}"/>
          </ac:picMkLst>
        </pc:picChg>
        <pc:picChg chg="del mod">
          <ac:chgData name="Narang, Sonali" userId="9e80b397-6e2f-49b1-9374-ccdad8589140" providerId="ADAL" clId="{A759B0D2-6A44-994A-98DB-9F991BFBBF7F}" dt="2022-09-27T20:28:33.226" v="199" actId="21"/>
          <ac:picMkLst>
            <pc:docMk/>
            <pc:sldMk cId="3214590643" sldId="280"/>
            <ac:picMk id="7" creationId="{99E36C8A-0E2D-5741-B832-D5F914AF5CF6}"/>
          </ac:picMkLst>
        </pc:picChg>
        <pc:picChg chg="mod">
          <ac:chgData name="Narang, Sonali" userId="9e80b397-6e2f-49b1-9374-ccdad8589140" providerId="ADAL" clId="{A759B0D2-6A44-994A-98DB-9F991BFBBF7F}" dt="2022-09-27T20:28:08.530" v="197"/>
          <ac:picMkLst>
            <pc:docMk/>
            <pc:sldMk cId="3214590643" sldId="280"/>
            <ac:picMk id="97" creationId="{D2D1FFEE-234E-BF47-852C-230108065F9B}"/>
          </ac:picMkLst>
        </pc:picChg>
        <pc:picChg chg="mod">
          <ac:chgData name="Narang, Sonali" userId="9e80b397-6e2f-49b1-9374-ccdad8589140" providerId="ADAL" clId="{A759B0D2-6A44-994A-98DB-9F991BFBBF7F}" dt="2022-09-27T20:28:08.530" v="197"/>
          <ac:picMkLst>
            <pc:docMk/>
            <pc:sldMk cId="3214590643" sldId="280"/>
            <ac:picMk id="98" creationId="{AB1E9DA8-DC0B-2748-B80C-A2A3B1BFCA26}"/>
          </ac:picMkLst>
        </pc:picChg>
        <pc:picChg chg="add mod">
          <ac:chgData name="Narang, Sonali" userId="9e80b397-6e2f-49b1-9374-ccdad8589140" providerId="ADAL" clId="{A759B0D2-6A44-994A-98DB-9F991BFBBF7F}" dt="2022-09-27T20:28:08.530" v="197"/>
          <ac:picMkLst>
            <pc:docMk/>
            <pc:sldMk cId="3214590643" sldId="280"/>
            <ac:picMk id="100" creationId="{51977BA7-167C-3448-9E08-BBE2D736A61B}"/>
          </ac:picMkLst>
        </pc:picChg>
      </pc:sldChg>
      <pc:sldChg chg="modSp mod modNotesTx">
        <pc:chgData name="Narang, Sonali" userId="9e80b397-6e2f-49b1-9374-ccdad8589140" providerId="ADAL" clId="{A759B0D2-6A44-994A-98DB-9F991BFBBF7F}" dt="2022-09-15T18:09:08.822" v="49" actId="20577"/>
        <pc:sldMkLst>
          <pc:docMk/>
          <pc:sldMk cId="2292075898" sldId="290"/>
        </pc:sldMkLst>
        <pc:spChg chg="mod">
          <ac:chgData name="Narang, Sonali" userId="9e80b397-6e2f-49b1-9374-ccdad8589140" providerId="ADAL" clId="{A759B0D2-6A44-994A-98DB-9F991BFBBF7F}" dt="2022-09-15T18:07:53.469" v="20" actId="20577"/>
          <ac:spMkLst>
            <pc:docMk/>
            <pc:sldMk cId="2292075898" sldId="290"/>
            <ac:spMk id="7" creationId="{CB9C2CA2-B854-C447-B990-0E438B105C86}"/>
          </ac:spMkLst>
        </pc:spChg>
        <pc:graphicFrameChg chg="mod modGraphic">
          <ac:chgData name="Narang, Sonali" userId="9e80b397-6e2f-49b1-9374-ccdad8589140" providerId="ADAL" clId="{A759B0D2-6A44-994A-98DB-9F991BFBBF7F}" dt="2022-09-15T18:09:08.822" v="49" actId="20577"/>
          <ac:graphicFrameMkLst>
            <pc:docMk/>
            <pc:sldMk cId="2292075898" sldId="290"/>
            <ac:graphicFrameMk id="16" creationId="{14172837-94DE-3847-8367-932256827593}"/>
          </ac:graphicFrameMkLst>
        </pc:graphicFrameChg>
      </pc:sldChg>
      <pc:sldChg chg="modSp mod modNotesTx">
        <pc:chgData name="Narang, Sonali" userId="9e80b397-6e2f-49b1-9374-ccdad8589140" providerId="ADAL" clId="{A759B0D2-6A44-994A-98DB-9F991BFBBF7F}" dt="2022-09-15T18:09:15.730" v="52" actId="20577"/>
        <pc:sldMkLst>
          <pc:docMk/>
          <pc:sldMk cId="2574176189" sldId="294"/>
        </pc:sldMkLst>
        <pc:spChg chg="mod">
          <ac:chgData name="Narang, Sonali" userId="9e80b397-6e2f-49b1-9374-ccdad8589140" providerId="ADAL" clId="{A759B0D2-6A44-994A-98DB-9F991BFBBF7F}" dt="2022-09-15T18:08:32.315" v="38" actId="1037"/>
          <ac:spMkLst>
            <pc:docMk/>
            <pc:sldMk cId="2574176189" sldId="294"/>
            <ac:spMk id="17" creationId="{02C42890-6447-EB45-84F5-FDC1189AED29}"/>
          </ac:spMkLst>
        </pc:spChg>
        <pc:spChg chg="mod">
          <ac:chgData name="Narang, Sonali" userId="9e80b397-6e2f-49b1-9374-ccdad8589140" providerId="ADAL" clId="{A759B0D2-6A44-994A-98DB-9F991BFBBF7F}" dt="2022-09-15T18:08:32.315" v="38" actId="1037"/>
          <ac:spMkLst>
            <pc:docMk/>
            <pc:sldMk cId="2574176189" sldId="294"/>
            <ac:spMk id="19" creationId="{AD1A0C94-7B28-0C42-873A-DD66B1F10735}"/>
          </ac:spMkLst>
        </pc:spChg>
        <pc:graphicFrameChg chg="mod modGraphic">
          <ac:chgData name="Narang, Sonali" userId="9e80b397-6e2f-49b1-9374-ccdad8589140" providerId="ADAL" clId="{A759B0D2-6A44-994A-98DB-9F991BFBBF7F}" dt="2022-09-15T18:08:52.960" v="44" actId="207"/>
          <ac:graphicFrameMkLst>
            <pc:docMk/>
            <pc:sldMk cId="2574176189" sldId="294"/>
            <ac:graphicFrameMk id="10" creationId="{2AD806D8-8056-A543-AE25-457F49328268}"/>
          </ac:graphicFrameMkLst>
        </pc:graphicFrameChg>
        <pc:graphicFrameChg chg="mod modGraphic">
          <ac:chgData name="Narang, Sonali" userId="9e80b397-6e2f-49b1-9374-ccdad8589140" providerId="ADAL" clId="{A759B0D2-6A44-994A-98DB-9F991BFBBF7F}" dt="2022-09-15T18:09:03.910" v="47" actId="207"/>
          <ac:graphicFrameMkLst>
            <pc:docMk/>
            <pc:sldMk cId="2574176189" sldId="294"/>
            <ac:graphicFrameMk id="11" creationId="{B8484720-E1AE-8F49-B5E4-BD103B77A2DC}"/>
          </ac:graphicFrameMkLst>
        </pc:graphicFrameChg>
      </pc:sldChg>
    </pc:docChg>
  </pc:docChgLst>
  <pc:docChgLst>
    <pc:chgData name="Narang, Sonali" userId="9e80b397-6e2f-49b1-9374-ccdad8589140" providerId="ADAL" clId="{5D363520-F4C4-684A-BE7B-C8FFAAD0DE41}"/>
    <pc:docChg chg="undo custSel addSld delSld modSld sldOrd">
      <pc:chgData name="Narang, Sonali" userId="9e80b397-6e2f-49b1-9374-ccdad8589140" providerId="ADAL" clId="{5D363520-F4C4-684A-BE7B-C8FFAAD0DE41}" dt="2022-11-19T23:54:18.112" v="1806" actId="20577"/>
      <pc:docMkLst>
        <pc:docMk/>
      </pc:docMkLst>
      <pc:sldChg chg="delSp modSp mod modNotesTx">
        <pc:chgData name="Narang, Sonali" userId="9e80b397-6e2f-49b1-9374-ccdad8589140" providerId="ADAL" clId="{5D363520-F4C4-684A-BE7B-C8FFAAD0DE41}" dt="2022-11-15T15:58:10.488" v="248" actId="20577"/>
        <pc:sldMkLst>
          <pc:docMk/>
          <pc:sldMk cId="1155223781" sldId="258"/>
        </pc:sldMkLst>
        <pc:spChg chg="mod">
          <ac:chgData name="Narang, Sonali" userId="9e80b397-6e2f-49b1-9374-ccdad8589140" providerId="ADAL" clId="{5D363520-F4C4-684A-BE7B-C8FFAAD0DE41}" dt="2022-11-09T21:58:39.678" v="28" actId="20577"/>
          <ac:spMkLst>
            <pc:docMk/>
            <pc:sldMk cId="1155223781" sldId="258"/>
            <ac:spMk id="4" creationId="{F6669B9D-B042-D548-BD0F-97015091799B}"/>
          </ac:spMkLst>
        </pc:spChg>
        <pc:spChg chg="del">
          <ac:chgData name="Narang, Sonali" userId="9e80b397-6e2f-49b1-9374-ccdad8589140" providerId="ADAL" clId="{5D363520-F4C4-684A-BE7B-C8FFAAD0DE41}" dt="2022-11-15T15:48:30.200" v="219" actId="478"/>
          <ac:spMkLst>
            <pc:docMk/>
            <pc:sldMk cId="1155223781" sldId="258"/>
            <ac:spMk id="6" creationId="{41464C80-B659-484D-A16F-8018DEC5471A}"/>
          </ac:spMkLst>
        </pc:spChg>
        <pc:spChg chg="del">
          <ac:chgData name="Narang, Sonali" userId="9e80b397-6e2f-49b1-9374-ccdad8589140" providerId="ADAL" clId="{5D363520-F4C4-684A-BE7B-C8FFAAD0DE41}" dt="2022-11-15T15:48:07.914" v="215" actId="478"/>
          <ac:spMkLst>
            <pc:docMk/>
            <pc:sldMk cId="1155223781" sldId="258"/>
            <ac:spMk id="7" creationId="{4C5F5CAE-FBFD-964D-A356-746AAC86DC9E}"/>
          </ac:spMkLst>
        </pc:spChg>
        <pc:grpChg chg="del">
          <ac:chgData name="Narang, Sonali" userId="9e80b397-6e2f-49b1-9374-ccdad8589140" providerId="ADAL" clId="{5D363520-F4C4-684A-BE7B-C8FFAAD0DE41}" dt="2022-11-15T15:48:30.200" v="219" actId="478"/>
          <ac:grpSpMkLst>
            <pc:docMk/>
            <pc:sldMk cId="1155223781" sldId="258"/>
            <ac:grpSpMk id="29" creationId="{70F7DDDB-B9EC-E547-B6B0-91E941A82272}"/>
          </ac:grpSpMkLst>
        </pc:grpChg>
        <pc:grpChg chg="del">
          <ac:chgData name="Narang, Sonali" userId="9e80b397-6e2f-49b1-9374-ccdad8589140" providerId="ADAL" clId="{5D363520-F4C4-684A-BE7B-C8FFAAD0DE41}" dt="2022-11-15T15:48:07.914" v="215" actId="478"/>
          <ac:grpSpMkLst>
            <pc:docMk/>
            <pc:sldMk cId="1155223781" sldId="258"/>
            <ac:grpSpMk id="37" creationId="{18F2BF47-01C1-9943-91C5-2F27A02846EF}"/>
          </ac:grpSpMkLst>
        </pc:grpChg>
        <pc:grpChg chg="del">
          <ac:chgData name="Narang, Sonali" userId="9e80b397-6e2f-49b1-9374-ccdad8589140" providerId="ADAL" clId="{5D363520-F4C4-684A-BE7B-C8FFAAD0DE41}" dt="2022-11-15T15:48:07.914" v="215" actId="478"/>
          <ac:grpSpMkLst>
            <pc:docMk/>
            <pc:sldMk cId="1155223781" sldId="258"/>
            <ac:grpSpMk id="38" creationId="{40166CFF-AC69-6A4E-8878-A501979896E9}"/>
          </ac:grpSpMkLst>
        </pc:grpChg>
        <pc:grpChg chg="del">
          <ac:chgData name="Narang, Sonali" userId="9e80b397-6e2f-49b1-9374-ccdad8589140" providerId="ADAL" clId="{5D363520-F4C4-684A-BE7B-C8FFAAD0DE41}" dt="2022-11-15T15:48:07.914" v="215" actId="478"/>
          <ac:grpSpMkLst>
            <pc:docMk/>
            <pc:sldMk cId="1155223781" sldId="258"/>
            <ac:grpSpMk id="42" creationId="{8569B67D-0077-EE47-A463-17B089D8789E}"/>
          </ac:grpSpMkLst>
        </pc:grpChg>
        <pc:picChg chg="del">
          <ac:chgData name="Narang, Sonali" userId="9e80b397-6e2f-49b1-9374-ccdad8589140" providerId="ADAL" clId="{5D363520-F4C4-684A-BE7B-C8FFAAD0DE41}" dt="2022-11-15T15:48:30.200" v="219" actId="478"/>
          <ac:picMkLst>
            <pc:docMk/>
            <pc:sldMk cId="1155223781" sldId="258"/>
            <ac:picMk id="8" creationId="{0AB5AC39-6BB3-9C42-81CF-A8B498911692}"/>
          </ac:picMkLst>
        </pc:picChg>
      </pc:sldChg>
      <pc:sldChg chg="addSp delSp modSp mod modNotesTx">
        <pc:chgData name="Narang, Sonali" userId="9e80b397-6e2f-49b1-9374-ccdad8589140" providerId="ADAL" clId="{5D363520-F4C4-684A-BE7B-C8FFAAD0DE41}" dt="2022-11-15T16:00:05.008" v="262" actId="20577"/>
        <pc:sldMkLst>
          <pc:docMk/>
          <pc:sldMk cId="743684689" sldId="267"/>
        </pc:sldMkLst>
        <pc:spChg chg="del">
          <ac:chgData name="Narang, Sonali" userId="9e80b397-6e2f-49b1-9374-ccdad8589140" providerId="ADAL" clId="{5D363520-F4C4-684A-BE7B-C8FFAAD0DE41}" dt="2022-11-09T21:58:52.961" v="33" actId="478"/>
          <ac:spMkLst>
            <pc:docMk/>
            <pc:sldMk cId="743684689" sldId="267"/>
            <ac:spMk id="4" creationId="{F6669B9D-B042-D548-BD0F-97015091799B}"/>
          </ac:spMkLst>
        </pc:spChg>
        <pc:spChg chg="add mod">
          <ac:chgData name="Narang, Sonali" userId="9e80b397-6e2f-49b1-9374-ccdad8589140" providerId="ADAL" clId="{5D363520-F4C4-684A-BE7B-C8FFAAD0DE41}" dt="2022-11-15T15:53:49.373" v="234" actId="20577"/>
          <ac:spMkLst>
            <pc:docMk/>
            <pc:sldMk cId="743684689" sldId="267"/>
            <ac:spMk id="167" creationId="{191EF0D9-34ED-2B46-B150-9606975E2917}"/>
          </ac:spMkLst>
        </pc:spChg>
      </pc:sldChg>
      <pc:sldChg chg="addSp delSp modSp mod modNotesTx">
        <pc:chgData name="Narang, Sonali" userId="9e80b397-6e2f-49b1-9374-ccdad8589140" providerId="ADAL" clId="{5D363520-F4C4-684A-BE7B-C8FFAAD0DE41}" dt="2022-11-15T17:00:28.904" v="624" actId="1037"/>
        <pc:sldMkLst>
          <pc:docMk/>
          <pc:sldMk cId="2078269342" sldId="277"/>
        </pc:sldMkLst>
        <pc:spChg chg="add del mod">
          <ac:chgData name="Narang, Sonali" userId="9e80b397-6e2f-49b1-9374-ccdad8589140" providerId="ADAL" clId="{5D363520-F4C4-684A-BE7B-C8FFAAD0DE41}" dt="2022-11-15T16:59:20.207" v="611" actId="478"/>
          <ac:spMkLst>
            <pc:docMk/>
            <pc:sldMk cId="2078269342" sldId="277"/>
            <ac:spMk id="2" creationId="{62D30B64-4555-3148-B0CB-880A9CA9B0C9}"/>
          </ac:spMkLst>
        </pc:spChg>
        <pc:spChg chg="del">
          <ac:chgData name="Narang, Sonali" userId="9e80b397-6e2f-49b1-9374-ccdad8589140" providerId="ADAL" clId="{5D363520-F4C4-684A-BE7B-C8FFAAD0DE41}" dt="2022-11-09T21:58:47.930" v="29" actId="478"/>
          <ac:spMkLst>
            <pc:docMk/>
            <pc:sldMk cId="2078269342" sldId="277"/>
            <ac:spMk id="4" creationId="{F6669B9D-B042-D548-BD0F-97015091799B}"/>
          </ac:spMkLst>
        </pc:spChg>
        <pc:spChg chg="del">
          <ac:chgData name="Narang, Sonali" userId="9e80b397-6e2f-49b1-9374-ccdad8589140" providerId="ADAL" clId="{5D363520-F4C4-684A-BE7B-C8FFAAD0DE41}" dt="2022-11-15T15:50:09.836" v="220" actId="478"/>
          <ac:spMkLst>
            <pc:docMk/>
            <pc:sldMk cId="2078269342" sldId="277"/>
            <ac:spMk id="7" creationId="{4C5F5CAE-FBFD-964D-A356-746AAC86DC9E}"/>
          </ac:spMkLst>
        </pc:spChg>
        <pc:spChg chg="mod">
          <ac:chgData name="Narang, Sonali" userId="9e80b397-6e2f-49b1-9374-ccdad8589140" providerId="ADAL" clId="{5D363520-F4C4-684A-BE7B-C8FFAAD0DE41}" dt="2022-11-15T15:50:20.777" v="223" actId="20577"/>
          <ac:spMkLst>
            <pc:docMk/>
            <pc:sldMk cId="2078269342" sldId="277"/>
            <ac:spMk id="30" creationId="{655ACA25-EBE0-DD45-930F-AD76C4C0A2A8}"/>
          </ac:spMkLst>
        </pc:spChg>
        <pc:spChg chg="mod">
          <ac:chgData name="Narang, Sonali" userId="9e80b397-6e2f-49b1-9374-ccdad8589140" providerId="ADAL" clId="{5D363520-F4C4-684A-BE7B-C8FFAAD0DE41}" dt="2022-11-15T17:00:28.904" v="624" actId="1037"/>
          <ac:spMkLst>
            <pc:docMk/>
            <pc:sldMk cId="2078269342" sldId="277"/>
            <ac:spMk id="43" creationId="{80550978-24C0-3343-83A5-8C1A9BAE7634}"/>
          </ac:spMkLst>
        </pc:spChg>
        <pc:spChg chg="mod">
          <ac:chgData name="Narang, Sonali" userId="9e80b397-6e2f-49b1-9374-ccdad8589140" providerId="ADAL" clId="{5D363520-F4C4-684A-BE7B-C8FFAAD0DE41}" dt="2022-11-15T16:59:41.943" v="614" actId="20577"/>
          <ac:spMkLst>
            <pc:docMk/>
            <pc:sldMk cId="2078269342" sldId="277"/>
            <ac:spMk id="44" creationId="{1DCDF1E7-F2D5-7040-8B69-A9D74ED63E9D}"/>
          </ac:spMkLst>
        </pc:spChg>
        <pc:spChg chg="mod">
          <ac:chgData name="Narang, Sonali" userId="9e80b397-6e2f-49b1-9374-ccdad8589140" providerId="ADAL" clId="{5D363520-F4C4-684A-BE7B-C8FFAAD0DE41}" dt="2022-11-15T17:00:23.028" v="620" actId="20577"/>
          <ac:spMkLst>
            <pc:docMk/>
            <pc:sldMk cId="2078269342" sldId="277"/>
            <ac:spMk id="45" creationId="{0EECBD3B-E09F-6A4A-85ED-701545048DDA}"/>
          </ac:spMkLst>
        </pc:spChg>
        <pc:spChg chg="mod">
          <ac:chgData name="Narang, Sonali" userId="9e80b397-6e2f-49b1-9374-ccdad8589140" providerId="ADAL" clId="{5D363520-F4C4-684A-BE7B-C8FFAAD0DE41}" dt="2022-11-15T16:42:39.616" v="478" actId="20577"/>
          <ac:spMkLst>
            <pc:docMk/>
            <pc:sldMk cId="2078269342" sldId="277"/>
            <ac:spMk id="46" creationId="{DA1162E1-4AFD-CB46-A7EE-BE6EE201DCAB}"/>
          </ac:spMkLst>
        </pc:spChg>
        <pc:spChg chg="mod">
          <ac:chgData name="Narang, Sonali" userId="9e80b397-6e2f-49b1-9374-ccdad8589140" providerId="ADAL" clId="{5D363520-F4C4-684A-BE7B-C8FFAAD0DE41}" dt="2022-11-15T16:42:50.610" v="482" actId="20577"/>
          <ac:spMkLst>
            <pc:docMk/>
            <pc:sldMk cId="2078269342" sldId="277"/>
            <ac:spMk id="47" creationId="{EA48E1D2-7D85-BC4B-8305-622111AA60CF}"/>
          </ac:spMkLst>
        </pc:spChg>
        <pc:spChg chg="mod">
          <ac:chgData name="Narang, Sonali" userId="9e80b397-6e2f-49b1-9374-ccdad8589140" providerId="ADAL" clId="{5D363520-F4C4-684A-BE7B-C8FFAAD0DE41}" dt="2022-11-15T16:42:55.704" v="484" actId="20577"/>
          <ac:spMkLst>
            <pc:docMk/>
            <pc:sldMk cId="2078269342" sldId="277"/>
            <ac:spMk id="48" creationId="{B4179409-2FD8-7C4E-AC9F-D25DB456593D}"/>
          </ac:spMkLst>
        </pc:spChg>
        <pc:spChg chg="mod">
          <ac:chgData name="Narang, Sonali" userId="9e80b397-6e2f-49b1-9374-ccdad8589140" providerId="ADAL" clId="{5D363520-F4C4-684A-BE7B-C8FFAAD0DE41}" dt="2022-11-15T16:42:59.194" v="486" actId="20577"/>
          <ac:spMkLst>
            <pc:docMk/>
            <pc:sldMk cId="2078269342" sldId="277"/>
            <ac:spMk id="49" creationId="{1F5B7F0C-765C-174A-8D4A-2F5F300226DF}"/>
          </ac:spMkLst>
        </pc:spChg>
        <pc:spChg chg="mod">
          <ac:chgData name="Narang, Sonali" userId="9e80b397-6e2f-49b1-9374-ccdad8589140" providerId="ADAL" clId="{5D363520-F4C4-684A-BE7B-C8FFAAD0DE41}" dt="2022-11-15T16:58:32.455" v="600" actId="1038"/>
          <ac:spMkLst>
            <pc:docMk/>
            <pc:sldMk cId="2078269342" sldId="277"/>
            <ac:spMk id="54" creationId="{630EF4BB-5676-3B48-8C65-19F74E7421C4}"/>
          </ac:spMkLst>
        </pc:spChg>
        <pc:spChg chg="mod">
          <ac:chgData name="Narang, Sonali" userId="9e80b397-6e2f-49b1-9374-ccdad8589140" providerId="ADAL" clId="{5D363520-F4C4-684A-BE7B-C8FFAAD0DE41}" dt="2022-11-15T16:59:17.970" v="610" actId="20577"/>
          <ac:spMkLst>
            <pc:docMk/>
            <pc:sldMk cId="2078269342" sldId="277"/>
            <ac:spMk id="55" creationId="{F988E475-74C4-3C4F-9891-2EA2F939D523}"/>
          </ac:spMkLst>
        </pc:spChg>
        <pc:spChg chg="mod">
          <ac:chgData name="Narang, Sonali" userId="9e80b397-6e2f-49b1-9374-ccdad8589140" providerId="ADAL" clId="{5D363520-F4C4-684A-BE7B-C8FFAAD0DE41}" dt="2022-11-15T16:58:55.173" v="607" actId="1037"/>
          <ac:spMkLst>
            <pc:docMk/>
            <pc:sldMk cId="2078269342" sldId="277"/>
            <ac:spMk id="56" creationId="{D63EC677-39AE-414C-9352-563C974F82EA}"/>
          </ac:spMkLst>
        </pc:spChg>
        <pc:spChg chg="mod">
          <ac:chgData name="Narang, Sonali" userId="9e80b397-6e2f-49b1-9374-ccdad8589140" providerId="ADAL" clId="{5D363520-F4C4-684A-BE7B-C8FFAAD0DE41}" dt="2022-11-15T16:44:47.693" v="541" actId="20577"/>
          <ac:spMkLst>
            <pc:docMk/>
            <pc:sldMk cId="2078269342" sldId="277"/>
            <ac:spMk id="57" creationId="{057C0F8D-04C2-0542-8ABC-5B2FE168C537}"/>
          </ac:spMkLst>
        </pc:spChg>
        <pc:spChg chg="mod">
          <ac:chgData name="Narang, Sonali" userId="9e80b397-6e2f-49b1-9374-ccdad8589140" providerId="ADAL" clId="{5D363520-F4C4-684A-BE7B-C8FFAAD0DE41}" dt="2022-11-15T16:44:59.922" v="554" actId="20577"/>
          <ac:spMkLst>
            <pc:docMk/>
            <pc:sldMk cId="2078269342" sldId="277"/>
            <ac:spMk id="58" creationId="{5BD00D48-3568-4142-9CE5-0DD04E862D3C}"/>
          </ac:spMkLst>
        </pc:spChg>
        <pc:spChg chg="mod">
          <ac:chgData name="Narang, Sonali" userId="9e80b397-6e2f-49b1-9374-ccdad8589140" providerId="ADAL" clId="{5D363520-F4C4-684A-BE7B-C8FFAAD0DE41}" dt="2022-11-15T16:45:19.305" v="562" actId="20577"/>
          <ac:spMkLst>
            <pc:docMk/>
            <pc:sldMk cId="2078269342" sldId="277"/>
            <ac:spMk id="59" creationId="{EB23BEA0-6350-324D-A12E-7DEB49AF3BE8}"/>
          </ac:spMkLst>
        </pc:spChg>
        <pc:spChg chg="mod">
          <ac:chgData name="Narang, Sonali" userId="9e80b397-6e2f-49b1-9374-ccdad8589140" providerId="ADAL" clId="{5D363520-F4C4-684A-BE7B-C8FFAAD0DE41}" dt="2022-11-15T16:44:56.142" v="550" actId="20577"/>
          <ac:spMkLst>
            <pc:docMk/>
            <pc:sldMk cId="2078269342" sldId="277"/>
            <ac:spMk id="60" creationId="{E62460AA-D9B6-E345-A0C7-8FBD7230EDC2}"/>
          </ac:spMkLst>
        </pc:spChg>
        <pc:spChg chg="add mod">
          <ac:chgData name="Narang, Sonali" userId="9e80b397-6e2f-49b1-9374-ccdad8589140" providerId="ADAL" clId="{5D363520-F4C4-684A-BE7B-C8FFAAD0DE41}" dt="2022-11-09T21:58:49.858" v="32" actId="20577"/>
          <ac:spMkLst>
            <pc:docMk/>
            <pc:sldMk cId="2078269342" sldId="277"/>
            <ac:spMk id="64" creationId="{0FF0436D-644E-C145-81B0-37451A47E26F}"/>
          </ac:spMkLst>
        </pc:spChg>
        <pc:spChg chg="mod">
          <ac:chgData name="Narang, Sonali" userId="9e80b397-6e2f-49b1-9374-ccdad8589140" providerId="ADAL" clId="{5D363520-F4C4-684A-BE7B-C8FFAAD0DE41}" dt="2022-11-15T15:50:22.718" v="225" actId="20577"/>
          <ac:spMkLst>
            <pc:docMk/>
            <pc:sldMk cId="2078269342" sldId="277"/>
            <ac:spMk id="72" creationId="{6EFCDAB7-F8A1-714A-A38C-A603CDFDE6F4}"/>
          </ac:spMkLst>
        </pc:spChg>
        <pc:picChg chg="del">
          <ac:chgData name="Narang, Sonali" userId="9e80b397-6e2f-49b1-9374-ccdad8589140" providerId="ADAL" clId="{5D363520-F4C4-684A-BE7B-C8FFAAD0DE41}" dt="2022-11-15T15:50:09.836" v="220" actId="478"/>
          <ac:picMkLst>
            <pc:docMk/>
            <pc:sldMk cId="2078269342" sldId="277"/>
            <ac:picMk id="3" creationId="{D75D91E9-A6E3-954D-BBBF-1D7A25FDD5A8}"/>
          </ac:picMkLst>
        </pc:picChg>
        <pc:picChg chg="del">
          <ac:chgData name="Narang, Sonali" userId="9e80b397-6e2f-49b1-9374-ccdad8589140" providerId="ADAL" clId="{5D363520-F4C4-684A-BE7B-C8FFAAD0DE41}" dt="2022-11-15T15:50:09.836" v="220" actId="478"/>
          <ac:picMkLst>
            <pc:docMk/>
            <pc:sldMk cId="2078269342" sldId="277"/>
            <ac:picMk id="8" creationId="{265E80FB-967E-E641-AA0E-27C00D11414A}"/>
          </ac:picMkLst>
        </pc:picChg>
        <pc:picChg chg="del">
          <ac:chgData name="Narang, Sonali" userId="9e80b397-6e2f-49b1-9374-ccdad8589140" providerId="ADAL" clId="{5D363520-F4C4-684A-BE7B-C8FFAAD0DE41}" dt="2022-11-15T15:50:09.836" v="220" actId="478"/>
          <ac:picMkLst>
            <pc:docMk/>
            <pc:sldMk cId="2078269342" sldId="277"/>
            <ac:picMk id="10" creationId="{76101781-C7BE-9C42-8B1A-22F8C263577B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12" creationId="{8544D0DE-07B5-0C4E-8D80-A066A3CEBF40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14" creationId="{747B9748-FCBA-2D4D-AF34-AB1604BF7918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16" creationId="{F9797EBE-C2C2-ED45-8D6F-C95776584471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18" creationId="{6821CDC2-5374-8348-98F5-C090BA03C8B8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20" creationId="{E3C6EA1D-E6B3-B943-9F00-A3F1DA6DE0DC}"/>
          </ac:picMkLst>
        </pc:picChg>
        <pc:picChg chg="mod">
          <ac:chgData name="Narang, Sonali" userId="9e80b397-6e2f-49b1-9374-ccdad8589140" providerId="ADAL" clId="{5D363520-F4C4-684A-BE7B-C8FFAAD0DE41}" dt="2022-11-15T15:50:15.740" v="221" actId="1076"/>
          <ac:picMkLst>
            <pc:docMk/>
            <pc:sldMk cId="2078269342" sldId="277"/>
            <ac:picMk id="22" creationId="{C217648D-794D-E743-9395-81F06061CB77}"/>
          </ac:picMkLst>
        </pc:picChg>
      </pc:sldChg>
      <pc:sldChg chg="addSp delSp modSp mod modNotesTx">
        <pc:chgData name="Narang, Sonali" userId="9e80b397-6e2f-49b1-9374-ccdad8589140" providerId="ADAL" clId="{5D363520-F4C4-684A-BE7B-C8FFAAD0DE41}" dt="2022-11-19T23:38:42.221" v="1753" actId="20577"/>
        <pc:sldMkLst>
          <pc:docMk/>
          <pc:sldMk cId="3214590643" sldId="280"/>
        </pc:sldMkLst>
        <pc:spChg chg="mod">
          <ac:chgData name="Narang, Sonali" userId="9e80b397-6e2f-49b1-9374-ccdad8589140" providerId="ADAL" clId="{5D363520-F4C4-684A-BE7B-C8FFAAD0DE41}" dt="2022-11-17T19:48:04.027" v="1479" actId="1035"/>
          <ac:spMkLst>
            <pc:docMk/>
            <pc:sldMk cId="3214590643" sldId="280"/>
            <ac:spMk id="15" creationId="{211CF65A-99E6-4C44-981B-639900C416DF}"/>
          </ac:spMkLst>
        </pc:spChg>
        <pc:spChg chg="del">
          <ac:chgData name="Narang, Sonali" userId="9e80b397-6e2f-49b1-9374-ccdad8589140" providerId="ADAL" clId="{5D363520-F4C4-684A-BE7B-C8FFAAD0DE41}" dt="2022-11-09T21:58:59.626" v="37" actId="478"/>
          <ac:spMkLst>
            <pc:docMk/>
            <pc:sldMk cId="3214590643" sldId="280"/>
            <ac:spMk id="45" creationId="{A37EFDC5-08ED-BB45-B24A-B00535A392F0}"/>
          </ac:spMkLst>
        </pc:spChg>
        <pc:spChg chg="mod">
          <ac:chgData name="Narang, Sonali" userId="9e80b397-6e2f-49b1-9374-ccdad8589140" providerId="ADAL" clId="{5D363520-F4C4-684A-BE7B-C8FFAAD0DE41}" dt="2022-11-17T19:02:39.845" v="1011" actId="1076"/>
          <ac:spMkLst>
            <pc:docMk/>
            <pc:sldMk cId="3214590643" sldId="280"/>
            <ac:spMk id="69" creationId="{54A5D94C-10A5-B344-9D6B-7B82866EB4D4}"/>
          </ac:spMkLst>
        </pc:spChg>
        <pc:spChg chg="mod">
          <ac:chgData name="Narang, Sonali" userId="9e80b397-6e2f-49b1-9374-ccdad8589140" providerId="ADAL" clId="{5D363520-F4C4-684A-BE7B-C8FFAAD0DE41}" dt="2022-11-15T19:30:10.092" v="706" actId="1076"/>
          <ac:spMkLst>
            <pc:docMk/>
            <pc:sldMk cId="3214590643" sldId="280"/>
            <ac:spMk id="77" creationId="{C08735D1-87D4-424C-8AA2-049A8E71D39F}"/>
          </ac:spMkLst>
        </pc:spChg>
        <pc:spChg chg="add mod">
          <ac:chgData name="Narang, Sonali" userId="9e80b397-6e2f-49b1-9374-ccdad8589140" providerId="ADAL" clId="{5D363520-F4C4-684A-BE7B-C8FFAAD0DE41}" dt="2022-11-15T15:53:55.718" v="240" actId="20577"/>
          <ac:spMkLst>
            <pc:docMk/>
            <pc:sldMk cId="3214590643" sldId="280"/>
            <ac:spMk id="102" creationId="{932011D5-5984-3D42-9F5D-4591319CF1BC}"/>
          </ac:spMkLst>
        </pc:spChg>
        <pc:spChg chg="add mod">
          <ac:chgData name="Narang, Sonali" userId="9e80b397-6e2f-49b1-9374-ccdad8589140" providerId="ADAL" clId="{5D363520-F4C4-684A-BE7B-C8FFAAD0DE41}" dt="2022-11-17T19:46:04.583" v="1472" actId="1076"/>
          <ac:spMkLst>
            <pc:docMk/>
            <pc:sldMk cId="3214590643" sldId="280"/>
            <ac:spMk id="103" creationId="{C524469F-7B39-5143-95EF-1EF31E96A1FB}"/>
          </ac:spMkLst>
        </pc:spChg>
        <pc:spChg chg="del mod">
          <ac:chgData name="Narang, Sonali" userId="9e80b397-6e2f-49b1-9374-ccdad8589140" providerId="ADAL" clId="{5D363520-F4C4-684A-BE7B-C8FFAAD0DE41}" dt="2022-11-17T19:03:06.611" v="1014" actId="478"/>
          <ac:spMkLst>
            <pc:docMk/>
            <pc:sldMk cId="3214590643" sldId="280"/>
            <ac:spMk id="108" creationId="{51DE9FAB-17EA-8F49-9F4C-7C9A79A5C442}"/>
          </ac:spMkLst>
        </pc:spChg>
        <pc:spChg chg="del mod">
          <ac:chgData name="Narang, Sonali" userId="9e80b397-6e2f-49b1-9374-ccdad8589140" providerId="ADAL" clId="{5D363520-F4C4-684A-BE7B-C8FFAAD0DE41}" dt="2022-11-17T19:03:06.611" v="1014" actId="478"/>
          <ac:spMkLst>
            <pc:docMk/>
            <pc:sldMk cId="3214590643" sldId="280"/>
            <ac:spMk id="109" creationId="{80940B7A-D958-7349-AF0C-4CC26273D179}"/>
          </ac:spMkLst>
        </pc:spChg>
        <pc:spChg chg="del mod">
          <ac:chgData name="Narang, Sonali" userId="9e80b397-6e2f-49b1-9374-ccdad8589140" providerId="ADAL" clId="{5D363520-F4C4-684A-BE7B-C8FFAAD0DE41}" dt="2022-11-17T19:03:06.611" v="1014" actId="478"/>
          <ac:spMkLst>
            <pc:docMk/>
            <pc:sldMk cId="3214590643" sldId="280"/>
            <ac:spMk id="110" creationId="{72693F8D-2D73-1E4D-82BB-300B46E7B1B8}"/>
          </ac:spMkLst>
        </pc:spChg>
        <pc:spChg chg="mod">
          <ac:chgData name="Narang, Sonali" userId="9e80b397-6e2f-49b1-9374-ccdad8589140" providerId="ADAL" clId="{5D363520-F4C4-684A-BE7B-C8FFAAD0DE41}" dt="2022-11-17T19:17:37.395" v="1290" actId="20577"/>
          <ac:spMkLst>
            <pc:docMk/>
            <pc:sldMk cId="3214590643" sldId="280"/>
            <ac:spMk id="111" creationId="{53318B41-504B-B144-AC51-FA97F8B54C4A}"/>
          </ac:spMkLst>
        </pc:spChg>
        <pc:spChg chg="mod">
          <ac:chgData name="Narang, Sonali" userId="9e80b397-6e2f-49b1-9374-ccdad8589140" providerId="ADAL" clId="{5D363520-F4C4-684A-BE7B-C8FFAAD0DE41}" dt="2022-11-17T19:16:58.923" v="1260" actId="20577"/>
          <ac:spMkLst>
            <pc:docMk/>
            <pc:sldMk cId="3214590643" sldId="280"/>
            <ac:spMk id="112" creationId="{93B3F9F7-DB3A-274F-BEDE-F1E34EF70732}"/>
          </ac:spMkLst>
        </pc:spChg>
        <pc:spChg chg="del mod">
          <ac:chgData name="Narang, Sonali" userId="9e80b397-6e2f-49b1-9374-ccdad8589140" providerId="ADAL" clId="{5D363520-F4C4-684A-BE7B-C8FFAAD0DE41}" dt="2022-11-17T19:03:08.848" v="1015" actId="478"/>
          <ac:spMkLst>
            <pc:docMk/>
            <pc:sldMk cId="3214590643" sldId="280"/>
            <ac:spMk id="113" creationId="{9332713F-7A3D-4B4D-ABF6-DAB546034A63}"/>
          </ac:spMkLst>
        </pc:spChg>
        <pc:spChg chg="del mod">
          <ac:chgData name="Narang, Sonali" userId="9e80b397-6e2f-49b1-9374-ccdad8589140" providerId="ADAL" clId="{5D363520-F4C4-684A-BE7B-C8FFAAD0DE41}" dt="2022-11-17T19:03:08.848" v="1015" actId="478"/>
          <ac:spMkLst>
            <pc:docMk/>
            <pc:sldMk cId="3214590643" sldId="280"/>
            <ac:spMk id="114" creationId="{0A7BCDA6-0471-9547-B5D3-878E061072D9}"/>
          </ac:spMkLst>
        </pc:spChg>
        <pc:spChg chg="del mod">
          <ac:chgData name="Narang, Sonali" userId="9e80b397-6e2f-49b1-9374-ccdad8589140" providerId="ADAL" clId="{5D363520-F4C4-684A-BE7B-C8FFAAD0DE41}" dt="2022-11-17T19:14:13.085" v="1063" actId="478"/>
          <ac:spMkLst>
            <pc:docMk/>
            <pc:sldMk cId="3214590643" sldId="280"/>
            <ac:spMk id="115" creationId="{361FD0A6-0D4E-364D-B2A0-BAF68E692CA4}"/>
          </ac:spMkLst>
        </pc:spChg>
        <pc:spChg chg="del mod">
          <ac:chgData name="Narang, Sonali" userId="9e80b397-6e2f-49b1-9374-ccdad8589140" providerId="ADAL" clId="{5D363520-F4C4-684A-BE7B-C8FFAAD0DE41}" dt="2022-11-17T19:14:13.085" v="1063" actId="478"/>
          <ac:spMkLst>
            <pc:docMk/>
            <pc:sldMk cId="3214590643" sldId="280"/>
            <ac:spMk id="116" creationId="{62E8F42A-EE34-B945-8AAD-654FE5BFFA17}"/>
          </ac:spMkLst>
        </pc:spChg>
        <pc:spChg chg="del mod">
          <ac:chgData name="Narang, Sonali" userId="9e80b397-6e2f-49b1-9374-ccdad8589140" providerId="ADAL" clId="{5D363520-F4C4-684A-BE7B-C8FFAAD0DE41}" dt="2022-11-17T19:14:13.085" v="1063" actId="478"/>
          <ac:spMkLst>
            <pc:docMk/>
            <pc:sldMk cId="3214590643" sldId="280"/>
            <ac:spMk id="117" creationId="{6D138AC6-2AAF-B34F-A746-1B9A6172B3E6}"/>
          </ac:spMkLst>
        </pc:spChg>
        <pc:spChg chg="del mod">
          <ac:chgData name="Narang, Sonali" userId="9e80b397-6e2f-49b1-9374-ccdad8589140" providerId="ADAL" clId="{5D363520-F4C4-684A-BE7B-C8FFAAD0DE41}" dt="2022-11-17T19:14:13.085" v="1063" actId="478"/>
          <ac:spMkLst>
            <pc:docMk/>
            <pc:sldMk cId="3214590643" sldId="280"/>
            <ac:spMk id="118" creationId="{4923B6F3-9B81-0649-9663-A65E793AC3B6}"/>
          </ac:spMkLst>
        </pc:spChg>
        <pc:spChg chg="del mod">
          <ac:chgData name="Narang, Sonali" userId="9e80b397-6e2f-49b1-9374-ccdad8589140" providerId="ADAL" clId="{5D363520-F4C4-684A-BE7B-C8FFAAD0DE41}" dt="2022-11-17T19:14:13.085" v="1063" actId="478"/>
          <ac:spMkLst>
            <pc:docMk/>
            <pc:sldMk cId="3214590643" sldId="280"/>
            <ac:spMk id="119" creationId="{7F848482-5B20-1E42-84E6-9ECBD59705B9}"/>
          </ac:spMkLst>
        </pc:spChg>
        <pc:spChg chg="mod">
          <ac:chgData name="Narang, Sonali" userId="9e80b397-6e2f-49b1-9374-ccdad8589140" providerId="ADAL" clId="{5D363520-F4C4-684A-BE7B-C8FFAAD0DE41}" dt="2022-11-17T19:15:35.340" v="1174" actId="1038"/>
          <ac:spMkLst>
            <pc:docMk/>
            <pc:sldMk cId="3214590643" sldId="280"/>
            <ac:spMk id="120" creationId="{149CE117-2F97-BE41-B9B1-0A88A7CFF94B}"/>
          </ac:spMkLst>
        </pc:spChg>
        <pc:spChg chg="mod">
          <ac:chgData name="Narang, Sonali" userId="9e80b397-6e2f-49b1-9374-ccdad8589140" providerId="ADAL" clId="{5D363520-F4C4-684A-BE7B-C8FFAAD0DE41}" dt="2022-11-17T19:15:35.340" v="1174" actId="1038"/>
          <ac:spMkLst>
            <pc:docMk/>
            <pc:sldMk cId="3214590643" sldId="280"/>
            <ac:spMk id="121" creationId="{4EC79739-F225-794F-B456-C11CF7D8A425}"/>
          </ac:spMkLst>
        </pc:spChg>
        <pc:spChg chg="mod">
          <ac:chgData name="Narang, Sonali" userId="9e80b397-6e2f-49b1-9374-ccdad8589140" providerId="ADAL" clId="{5D363520-F4C4-684A-BE7B-C8FFAAD0DE41}" dt="2022-11-17T19:16:26.601" v="1248" actId="1038"/>
          <ac:spMkLst>
            <pc:docMk/>
            <pc:sldMk cId="3214590643" sldId="280"/>
            <ac:spMk id="122" creationId="{063D0F29-595A-5745-A8F5-9E79874654FB}"/>
          </ac:spMkLst>
        </pc:spChg>
        <pc:spChg chg="mod">
          <ac:chgData name="Narang, Sonali" userId="9e80b397-6e2f-49b1-9374-ccdad8589140" providerId="ADAL" clId="{5D363520-F4C4-684A-BE7B-C8FFAAD0DE41}" dt="2022-11-17T19:16:23.584" v="1245" actId="1037"/>
          <ac:spMkLst>
            <pc:docMk/>
            <pc:sldMk cId="3214590643" sldId="280"/>
            <ac:spMk id="123" creationId="{ED369E92-6F2F-D24B-BA3E-32F8EB21C4C8}"/>
          </ac:spMkLst>
        </pc:spChg>
        <pc:spChg chg="mod">
          <ac:chgData name="Narang, Sonali" userId="9e80b397-6e2f-49b1-9374-ccdad8589140" providerId="ADAL" clId="{5D363520-F4C4-684A-BE7B-C8FFAAD0DE41}" dt="2022-11-17T19:16:06.766" v="1231" actId="20577"/>
          <ac:spMkLst>
            <pc:docMk/>
            <pc:sldMk cId="3214590643" sldId="280"/>
            <ac:spMk id="124" creationId="{55DEAE7D-3547-D343-8D37-A11C727AC319}"/>
          </ac:spMkLst>
        </pc:spChg>
        <pc:spChg chg="mod">
          <ac:chgData name="Narang, Sonali" userId="9e80b397-6e2f-49b1-9374-ccdad8589140" providerId="ADAL" clId="{5D363520-F4C4-684A-BE7B-C8FFAAD0DE41}" dt="2022-11-17T19:02:46.261" v="1012"/>
          <ac:spMkLst>
            <pc:docMk/>
            <pc:sldMk cId="3214590643" sldId="280"/>
            <ac:spMk id="125" creationId="{97AC7DAA-D560-B640-A206-399BF69A0F6B}"/>
          </ac:spMkLst>
        </pc:spChg>
        <pc:spChg chg="mod">
          <ac:chgData name="Narang, Sonali" userId="9e80b397-6e2f-49b1-9374-ccdad8589140" providerId="ADAL" clId="{5D363520-F4C4-684A-BE7B-C8FFAAD0DE41}" dt="2022-11-17T19:02:46.261" v="1012"/>
          <ac:spMkLst>
            <pc:docMk/>
            <pc:sldMk cId="3214590643" sldId="280"/>
            <ac:spMk id="126" creationId="{AD8EE96D-5B42-104B-91D9-DDA3B074307D}"/>
          </ac:spMkLst>
        </pc:spChg>
        <pc:spChg chg="mod">
          <ac:chgData name="Narang, Sonali" userId="9e80b397-6e2f-49b1-9374-ccdad8589140" providerId="ADAL" clId="{5D363520-F4C4-684A-BE7B-C8FFAAD0DE41}" dt="2022-11-17T19:16:10.943" v="1233" actId="1035"/>
          <ac:spMkLst>
            <pc:docMk/>
            <pc:sldMk cId="3214590643" sldId="280"/>
            <ac:spMk id="127" creationId="{20EC3CEE-0315-0748-99AA-B088914FED6D}"/>
          </ac:spMkLst>
        </pc:spChg>
        <pc:spChg chg="mod">
          <ac:chgData name="Narang, Sonali" userId="9e80b397-6e2f-49b1-9374-ccdad8589140" providerId="ADAL" clId="{5D363520-F4C4-684A-BE7B-C8FFAAD0DE41}" dt="2022-11-17T19:11:29.321" v="1062" actId="20577"/>
          <ac:spMkLst>
            <pc:docMk/>
            <pc:sldMk cId="3214590643" sldId="280"/>
            <ac:spMk id="128" creationId="{9A0613BB-AFED-884D-B33A-7A0BE45A5258}"/>
          </ac:spMkLst>
        </pc:spChg>
        <pc:spChg chg="mod">
          <ac:chgData name="Narang, Sonali" userId="9e80b397-6e2f-49b1-9374-ccdad8589140" providerId="ADAL" clId="{5D363520-F4C4-684A-BE7B-C8FFAAD0DE41}" dt="2022-11-17T19:11:02.370" v="1050" actId="20577"/>
          <ac:spMkLst>
            <pc:docMk/>
            <pc:sldMk cId="3214590643" sldId="280"/>
            <ac:spMk id="129" creationId="{665B94A2-879D-4C46-A438-BD46AECA53FA}"/>
          </ac:spMkLst>
        </pc:spChg>
        <pc:spChg chg="add del mod">
          <ac:chgData name="Narang, Sonali" userId="9e80b397-6e2f-49b1-9374-ccdad8589140" providerId="ADAL" clId="{5D363520-F4C4-684A-BE7B-C8FFAAD0DE41}" dt="2022-11-17T19:28:06.954" v="1330" actId="478"/>
          <ac:spMkLst>
            <pc:docMk/>
            <pc:sldMk cId="3214590643" sldId="280"/>
            <ac:spMk id="130" creationId="{06D5B42B-504D-A74B-99CD-30CA78C1A614}"/>
          </ac:spMkLst>
        </pc:spChg>
        <pc:spChg chg="add del mod">
          <ac:chgData name="Narang, Sonali" userId="9e80b397-6e2f-49b1-9374-ccdad8589140" providerId="ADAL" clId="{5D363520-F4C4-684A-BE7B-C8FFAAD0DE41}" dt="2022-11-17T19:14:53.569" v="1145"/>
          <ac:spMkLst>
            <pc:docMk/>
            <pc:sldMk cId="3214590643" sldId="280"/>
            <ac:spMk id="131" creationId="{EE482824-6CE4-E742-9F03-2E74E0BD2EE3}"/>
          </ac:spMkLst>
        </pc:spChg>
        <pc:spChg chg="add del mod">
          <ac:chgData name="Narang, Sonali" userId="9e80b397-6e2f-49b1-9374-ccdad8589140" providerId="ADAL" clId="{5D363520-F4C4-684A-BE7B-C8FFAAD0DE41}" dt="2022-11-17T19:28:04.423" v="1329" actId="478"/>
          <ac:spMkLst>
            <pc:docMk/>
            <pc:sldMk cId="3214590643" sldId="280"/>
            <ac:spMk id="132" creationId="{2ECF0B64-1CD4-2640-AE0C-7127DB207BF6}"/>
          </ac:spMkLst>
        </pc:spChg>
        <pc:spChg chg="add del mod">
          <ac:chgData name="Narang, Sonali" userId="9e80b397-6e2f-49b1-9374-ccdad8589140" providerId="ADAL" clId="{5D363520-F4C4-684A-BE7B-C8FFAAD0DE41}" dt="2022-11-17T19:28:06.954" v="1330" actId="478"/>
          <ac:spMkLst>
            <pc:docMk/>
            <pc:sldMk cId="3214590643" sldId="280"/>
            <ac:spMk id="133" creationId="{1E28AB7A-2222-3243-AD36-28A39A1DFE53}"/>
          </ac:spMkLst>
        </pc:spChg>
        <pc:spChg chg="add del mod">
          <ac:chgData name="Narang, Sonali" userId="9e80b397-6e2f-49b1-9374-ccdad8589140" providerId="ADAL" clId="{5D363520-F4C4-684A-BE7B-C8FFAAD0DE41}" dt="2022-11-17T19:28:06.954" v="1330" actId="478"/>
          <ac:spMkLst>
            <pc:docMk/>
            <pc:sldMk cId="3214590643" sldId="280"/>
            <ac:spMk id="134" creationId="{8D766EEC-F41E-9A41-8D43-9D56BC8992B5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39" creationId="{43D60666-4B2E-144E-84A4-728D971EAEBC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40" creationId="{C6CBC246-2D86-1A45-8296-CC730188A683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41" creationId="{429A8F6B-CC3E-A04A-8593-D8B35B56A36F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42" creationId="{BCD68B4F-0E4D-654C-9E4D-A0D5E23EE202}"/>
          </ac:spMkLst>
        </pc:spChg>
        <pc:spChg chg="mod">
          <ac:chgData name="Narang, Sonali" userId="9e80b397-6e2f-49b1-9374-ccdad8589140" providerId="ADAL" clId="{5D363520-F4C4-684A-BE7B-C8FFAAD0DE41}" dt="2022-11-17T19:43:04.861" v="1394" actId="20577"/>
          <ac:spMkLst>
            <pc:docMk/>
            <pc:sldMk cId="3214590643" sldId="280"/>
            <ac:spMk id="143" creationId="{79E235A0-D70D-7B49-9FCE-62D52E3601B9}"/>
          </ac:spMkLst>
        </pc:spChg>
        <pc:spChg chg="mod">
          <ac:chgData name="Narang, Sonali" userId="9e80b397-6e2f-49b1-9374-ccdad8589140" providerId="ADAL" clId="{5D363520-F4C4-684A-BE7B-C8FFAAD0DE41}" dt="2022-11-17T19:43:32.133" v="1416" actId="20577"/>
          <ac:spMkLst>
            <pc:docMk/>
            <pc:sldMk cId="3214590643" sldId="280"/>
            <ac:spMk id="144" creationId="{9F4AC888-8CB6-4643-9E0C-660B922E0DD7}"/>
          </ac:spMkLst>
        </pc:spChg>
        <pc:spChg chg="mod">
          <ac:chgData name="Narang, Sonali" userId="9e80b397-6e2f-49b1-9374-ccdad8589140" providerId="ADAL" clId="{5D363520-F4C4-684A-BE7B-C8FFAAD0DE41}" dt="2022-11-17T19:44:33.841" v="1462" actId="20577"/>
          <ac:spMkLst>
            <pc:docMk/>
            <pc:sldMk cId="3214590643" sldId="280"/>
            <ac:spMk id="145" creationId="{91731961-45C1-614A-B971-70333CB0A9AD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46" creationId="{5CDDAF81-4F02-E84F-987E-C67FBB5A98B1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47" creationId="{AA5E49B3-9B6C-2C41-8F26-E8E5F8394DE2}"/>
          </ac:spMkLst>
        </pc:spChg>
        <pc:spChg chg="mod">
          <ac:chgData name="Narang, Sonali" userId="9e80b397-6e2f-49b1-9374-ccdad8589140" providerId="ADAL" clId="{5D363520-F4C4-684A-BE7B-C8FFAAD0DE41}" dt="2022-11-17T19:43:54.467" v="1436" actId="1038"/>
          <ac:spMkLst>
            <pc:docMk/>
            <pc:sldMk cId="3214590643" sldId="280"/>
            <ac:spMk id="148" creationId="{E9EA1C38-366A-BA4B-8940-DC2D7466529E}"/>
          </ac:spMkLst>
        </pc:spChg>
        <pc:spChg chg="mod">
          <ac:chgData name="Narang, Sonali" userId="9e80b397-6e2f-49b1-9374-ccdad8589140" providerId="ADAL" clId="{5D363520-F4C4-684A-BE7B-C8FFAAD0DE41}" dt="2022-11-17T19:43:49.460" v="1431" actId="20577"/>
          <ac:spMkLst>
            <pc:docMk/>
            <pc:sldMk cId="3214590643" sldId="280"/>
            <ac:spMk id="149" creationId="{ED307F8D-00DC-8F46-BD7C-61F37500DBA7}"/>
          </ac:spMkLst>
        </pc:spChg>
        <pc:spChg chg="mod">
          <ac:chgData name="Narang, Sonali" userId="9e80b397-6e2f-49b1-9374-ccdad8589140" providerId="ADAL" clId="{5D363520-F4C4-684A-BE7B-C8FFAAD0DE41}" dt="2022-11-17T19:43:44.292" v="1423" actId="1038"/>
          <ac:spMkLst>
            <pc:docMk/>
            <pc:sldMk cId="3214590643" sldId="280"/>
            <ac:spMk id="150" creationId="{9A2A1648-161F-C942-9DEA-5765BED056FC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51" creationId="{5AB9BF58-A18F-5D47-9552-F75BFC703481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52" creationId="{A448C62F-F5EA-0A41-9524-D66AC6139F9F}"/>
          </ac:spMkLst>
        </pc:spChg>
        <pc:spChg chg="mod">
          <ac:chgData name="Narang, Sonali" userId="9e80b397-6e2f-49b1-9374-ccdad8589140" providerId="ADAL" clId="{5D363520-F4C4-684A-BE7B-C8FFAAD0DE41}" dt="2022-11-17T19:43:57.860" v="1440" actId="1038"/>
          <ac:spMkLst>
            <pc:docMk/>
            <pc:sldMk cId="3214590643" sldId="280"/>
            <ac:spMk id="153" creationId="{BF750A16-F6EC-DD40-B5F1-EB0EBE8640EC}"/>
          </ac:spMkLst>
        </pc:spChg>
        <pc:spChg chg="mod">
          <ac:chgData name="Narang, Sonali" userId="9e80b397-6e2f-49b1-9374-ccdad8589140" providerId="ADAL" clId="{5D363520-F4C4-684A-BE7B-C8FFAAD0DE41}" dt="2022-11-17T19:41:59.815" v="1362" actId="1037"/>
          <ac:spMkLst>
            <pc:docMk/>
            <pc:sldMk cId="3214590643" sldId="280"/>
            <ac:spMk id="154" creationId="{55F01235-8F41-6C47-96BA-C4C4A1B8A46C}"/>
          </ac:spMkLst>
        </pc:spChg>
        <pc:spChg chg="mod">
          <ac:chgData name="Narang, Sonali" userId="9e80b397-6e2f-49b1-9374-ccdad8589140" providerId="ADAL" clId="{5D363520-F4C4-684A-BE7B-C8FFAAD0DE41}" dt="2022-11-17T19:43:27.125" v="1404" actId="20577"/>
          <ac:spMkLst>
            <pc:docMk/>
            <pc:sldMk cId="3214590643" sldId="280"/>
            <ac:spMk id="155" creationId="{F17A74A0-6FA2-084F-9A9C-6CF976D8666B}"/>
          </ac:spMkLst>
        </pc:spChg>
        <pc:spChg chg="mod">
          <ac:chgData name="Narang, Sonali" userId="9e80b397-6e2f-49b1-9374-ccdad8589140" providerId="ADAL" clId="{5D363520-F4C4-684A-BE7B-C8FFAAD0DE41}" dt="2022-11-17T19:44:02.109" v="1442" actId="1038"/>
          <ac:spMkLst>
            <pc:docMk/>
            <pc:sldMk cId="3214590643" sldId="280"/>
            <ac:spMk id="156" creationId="{312944C8-9520-554B-A06F-ACD8A371CB72}"/>
          </ac:spMkLst>
        </pc:spChg>
        <pc:spChg chg="mod">
          <ac:chgData name="Narang, Sonali" userId="9e80b397-6e2f-49b1-9374-ccdad8589140" providerId="ADAL" clId="{5D363520-F4C4-684A-BE7B-C8FFAAD0DE41}" dt="2022-11-17T19:28:11.318" v="1331"/>
          <ac:spMkLst>
            <pc:docMk/>
            <pc:sldMk cId="3214590643" sldId="280"/>
            <ac:spMk id="157" creationId="{E4893F48-0257-DE4F-A170-96AEE994A408}"/>
          </ac:spMkLst>
        </pc:spChg>
        <pc:spChg chg="mod">
          <ac:chgData name="Narang, Sonali" userId="9e80b397-6e2f-49b1-9374-ccdad8589140" providerId="ADAL" clId="{5D363520-F4C4-684A-BE7B-C8FFAAD0DE41}" dt="2022-11-17T19:44:04.493" v="1450" actId="1038"/>
          <ac:spMkLst>
            <pc:docMk/>
            <pc:sldMk cId="3214590643" sldId="280"/>
            <ac:spMk id="158" creationId="{52793C0E-80BD-3048-98BE-AF0F6F537B26}"/>
          </ac:spMkLst>
        </pc:spChg>
        <pc:spChg chg="mod">
          <ac:chgData name="Narang, Sonali" userId="9e80b397-6e2f-49b1-9374-ccdad8589140" providerId="ADAL" clId="{5D363520-F4C4-684A-BE7B-C8FFAAD0DE41}" dt="2022-11-17T19:44:06.702" v="1454" actId="1037"/>
          <ac:spMkLst>
            <pc:docMk/>
            <pc:sldMk cId="3214590643" sldId="280"/>
            <ac:spMk id="159" creationId="{8D28C8FF-7970-9043-AE03-A8469B0F285A}"/>
          </ac:spMkLst>
        </pc:spChg>
        <pc:spChg chg="mod">
          <ac:chgData name="Narang, Sonali" userId="9e80b397-6e2f-49b1-9374-ccdad8589140" providerId="ADAL" clId="{5D363520-F4C4-684A-BE7B-C8FFAAD0DE41}" dt="2022-11-17T19:42:08.670" v="1371" actId="20577"/>
          <ac:spMkLst>
            <pc:docMk/>
            <pc:sldMk cId="3214590643" sldId="280"/>
            <ac:spMk id="160" creationId="{D2AA627C-A9FF-E741-86BB-318526E915F6}"/>
          </ac:spMkLst>
        </pc:spChg>
        <pc:spChg chg="add del mod">
          <ac:chgData name="Narang, Sonali" userId="9e80b397-6e2f-49b1-9374-ccdad8589140" providerId="ADAL" clId="{5D363520-F4C4-684A-BE7B-C8FFAAD0DE41}" dt="2022-11-17T19:48:11.685" v="1482" actId="478"/>
          <ac:spMkLst>
            <pc:docMk/>
            <pc:sldMk cId="3214590643" sldId="280"/>
            <ac:spMk id="161" creationId="{E2A2286E-805D-C349-967C-A819315E978C}"/>
          </ac:spMkLst>
        </pc:spChg>
        <pc:grpChg chg="add del mod">
          <ac:chgData name="Narang, Sonali" userId="9e80b397-6e2f-49b1-9374-ccdad8589140" providerId="ADAL" clId="{5D363520-F4C4-684A-BE7B-C8FFAAD0DE41}" dt="2022-11-17T19:28:04.423" v="1329" actId="478"/>
          <ac:grpSpMkLst>
            <pc:docMk/>
            <pc:sldMk cId="3214590643" sldId="280"/>
            <ac:grpSpMk id="104" creationId="{3A93682E-D07F-4940-BA42-F53F48221C08}"/>
          </ac:grpSpMkLst>
        </pc:grpChg>
        <pc:grpChg chg="mod">
          <ac:chgData name="Narang, Sonali" userId="9e80b397-6e2f-49b1-9374-ccdad8589140" providerId="ADAL" clId="{5D363520-F4C4-684A-BE7B-C8FFAAD0DE41}" dt="2022-11-17T19:02:46.261" v="1012"/>
          <ac:grpSpMkLst>
            <pc:docMk/>
            <pc:sldMk cId="3214590643" sldId="280"/>
            <ac:grpSpMk id="105" creationId="{65D330A6-BA6F-1044-90CB-90C5AD92A2CB}"/>
          </ac:grpSpMkLst>
        </pc:grpChg>
        <pc:grpChg chg="mod">
          <ac:chgData name="Narang, Sonali" userId="9e80b397-6e2f-49b1-9374-ccdad8589140" providerId="ADAL" clId="{5D363520-F4C4-684A-BE7B-C8FFAAD0DE41}" dt="2022-11-17T19:02:46.261" v="1012"/>
          <ac:grpSpMkLst>
            <pc:docMk/>
            <pc:sldMk cId="3214590643" sldId="280"/>
            <ac:grpSpMk id="106" creationId="{E51010E8-16B7-BD45-B82E-AC8E31880C83}"/>
          </ac:grpSpMkLst>
        </pc:grpChg>
        <pc:grpChg chg="del mod">
          <ac:chgData name="Narang, Sonali" userId="9e80b397-6e2f-49b1-9374-ccdad8589140" providerId="ADAL" clId="{5D363520-F4C4-684A-BE7B-C8FFAAD0DE41}" dt="2022-11-17T19:14:13.085" v="1063" actId="478"/>
          <ac:grpSpMkLst>
            <pc:docMk/>
            <pc:sldMk cId="3214590643" sldId="280"/>
            <ac:grpSpMk id="107" creationId="{77DD4BF8-02F5-EE4E-B52D-700AAE231473}"/>
          </ac:grpSpMkLst>
        </pc:grpChg>
        <pc:grpChg chg="add mod">
          <ac:chgData name="Narang, Sonali" userId="9e80b397-6e2f-49b1-9374-ccdad8589140" providerId="ADAL" clId="{5D363520-F4C4-684A-BE7B-C8FFAAD0DE41}" dt="2022-11-17T19:28:16.400" v="1332" actId="1076"/>
          <ac:grpSpMkLst>
            <pc:docMk/>
            <pc:sldMk cId="3214590643" sldId="280"/>
            <ac:grpSpMk id="135" creationId="{8CA133E6-E3C9-BB43-8D57-2016E6FB1AB3}"/>
          </ac:grpSpMkLst>
        </pc:grpChg>
        <pc:grpChg chg="mod">
          <ac:chgData name="Narang, Sonali" userId="9e80b397-6e2f-49b1-9374-ccdad8589140" providerId="ADAL" clId="{5D363520-F4C4-684A-BE7B-C8FFAAD0DE41}" dt="2022-11-17T19:28:11.318" v="1331"/>
          <ac:grpSpMkLst>
            <pc:docMk/>
            <pc:sldMk cId="3214590643" sldId="280"/>
            <ac:grpSpMk id="136" creationId="{AD495C56-B52E-404F-B63C-1104810C5EC7}"/>
          </ac:grpSpMkLst>
        </pc:grpChg>
        <pc:grpChg chg="mod">
          <ac:chgData name="Narang, Sonali" userId="9e80b397-6e2f-49b1-9374-ccdad8589140" providerId="ADAL" clId="{5D363520-F4C4-684A-BE7B-C8FFAAD0DE41}" dt="2022-11-17T19:28:11.318" v="1331"/>
          <ac:grpSpMkLst>
            <pc:docMk/>
            <pc:sldMk cId="3214590643" sldId="280"/>
            <ac:grpSpMk id="137" creationId="{E92498C4-5F39-7E40-91CB-B44FCF823018}"/>
          </ac:grpSpMkLst>
        </pc:grpChg>
        <pc:grpChg chg="mod">
          <ac:chgData name="Narang, Sonali" userId="9e80b397-6e2f-49b1-9374-ccdad8589140" providerId="ADAL" clId="{5D363520-F4C4-684A-BE7B-C8FFAAD0DE41}" dt="2022-11-17T19:28:11.318" v="1331"/>
          <ac:grpSpMkLst>
            <pc:docMk/>
            <pc:sldMk cId="3214590643" sldId="280"/>
            <ac:grpSpMk id="138" creationId="{5F605E37-53AA-7346-AB2C-AA825010906C}"/>
          </ac:grpSpMkLst>
        </pc:grpChg>
        <pc:graphicFrameChg chg="mod">
          <ac:chgData name="Narang, Sonali" userId="9e80b397-6e2f-49b1-9374-ccdad8589140" providerId="ADAL" clId="{5D363520-F4C4-684A-BE7B-C8FFAAD0DE41}" dt="2022-11-17T19:02:39.845" v="1011" actId="1076"/>
          <ac:graphicFrameMkLst>
            <pc:docMk/>
            <pc:sldMk cId="3214590643" sldId="280"/>
            <ac:graphicFrameMk id="67" creationId="{D446A5C9-0020-E549-88A4-B747B41C87E5}"/>
          </ac:graphicFrameMkLst>
        </pc:graphicFrameChg>
      </pc:sldChg>
      <pc:sldChg chg="addSp delSp modSp mod ord modNotesTx">
        <pc:chgData name="Narang, Sonali" userId="9e80b397-6e2f-49b1-9374-ccdad8589140" providerId="ADAL" clId="{5D363520-F4C4-684A-BE7B-C8FFAAD0DE41}" dt="2022-11-19T23:13:12.475" v="1546" actId="20577"/>
        <pc:sldMkLst>
          <pc:docMk/>
          <pc:sldMk cId="2292075898" sldId="290"/>
        </pc:sldMkLst>
        <pc:spChg chg="del">
          <ac:chgData name="Narang, Sonali" userId="9e80b397-6e2f-49b1-9374-ccdad8589140" providerId="ADAL" clId="{5D363520-F4C4-684A-BE7B-C8FFAAD0DE41}" dt="2022-11-09T21:59:34.623" v="58" actId="478"/>
          <ac:spMkLst>
            <pc:docMk/>
            <pc:sldMk cId="2292075898" sldId="290"/>
            <ac:spMk id="4" creationId="{F6669B9D-B042-D548-BD0F-97015091799B}"/>
          </ac:spMkLst>
        </pc:spChg>
        <pc:spChg chg="add mod">
          <ac:chgData name="Narang, Sonali" userId="9e80b397-6e2f-49b1-9374-ccdad8589140" providerId="ADAL" clId="{5D363520-F4C4-684A-BE7B-C8FFAAD0DE41}" dt="2022-11-15T15:56:39.466" v="246" actId="20577"/>
          <ac:spMkLst>
            <pc:docMk/>
            <pc:sldMk cId="2292075898" sldId="290"/>
            <ac:spMk id="5" creationId="{2B6EBCD3-2130-FB43-8A00-E4997D60F8E3}"/>
          </ac:spMkLst>
        </pc:spChg>
        <pc:spChg chg="mod">
          <ac:chgData name="Narang, Sonali" userId="9e80b397-6e2f-49b1-9374-ccdad8589140" providerId="ADAL" clId="{5D363520-F4C4-684A-BE7B-C8FFAAD0DE41}" dt="2022-11-16T17:33:26.083" v="787" actId="1076"/>
          <ac:spMkLst>
            <pc:docMk/>
            <pc:sldMk cId="2292075898" sldId="290"/>
            <ac:spMk id="7" creationId="{CB9C2CA2-B854-C447-B990-0E438B105C86}"/>
          </ac:spMkLst>
        </pc:spChg>
        <pc:spChg chg="add del mod">
          <ac:chgData name="Narang, Sonali" userId="9e80b397-6e2f-49b1-9374-ccdad8589140" providerId="ADAL" clId="{5D363520-F4C4-684A-BE7B-C8FFAAD0DE41}" dt="2022-11-16T17:33:01.993" v="756" actId="478"/>
          <ac:spMkLst>
            <pc:docMk/>
            <pc:sldMk cId="2292075898" sldId="290"/>
            <ac:spMk id="9" creationId="{D341B568-23A9-664C-B985-110320242F3A}"/>
          </ac:spMkLst>
        </pc:spChg>
        <pc:spChg chg="add del mod">
          <ac:chgData name="Narang, Sonali" userId="9e80b397-6e2f-49b1-9374-ccdad8589140" providerId="ADAL" clId="{5D363520-F4C4-684A-BE7B-C8FFAAD0DE41}" dt="2022-11-16T17:33:00.040" v="755" actId="478"/>
          <ac:spMkLst>
            <pc:docMk/>
            <pc:sldMk cId="2292075898" sldId="290"/>
            <ac:spMk id="10" creationId="{C24C7839-5141-3746-9EB3-335ECFDDACF7}"/>
          </ac:spMkLst>
        </pc:spChg>
        <pc:spChg chg="add mod">
          <ac:chgData name="Narang, Sonali" userId="9e80b397-6e2f-49b1-9374-ccdad8589140" providerId="ADAL" clId="{5D363520-F4C4-684A-BE7B-C8FFAAD0DE41}" dt="2022-11-16T21:32:59.898" v="987" actId="1076"/>
          <ac:spMkLst>
            <pc:docMk/>
            <pc:sldMk cId="2292075898" sldId="290"/>
            <ac:spMk id="14" creationId="{EAF5DD9E-E0E9-F842-936C-C0BB994D92DC}"/>
          </ac:spMkLst>
        </pc:spChg>
        <pc:spChg chg="add mod">
          <ac:chgData name="Narang, Sonali" userId="9e80b397-6e2f-49b1-9374-ccdad8589140" providerId="ADAL" clId="{5D363520-F4C4-684A-BE7B-C8FFAAD0DE41}" dt="2022-11-16T17:48:40.622" v="953" actId="20577"/>
          <ac:spMkLst>
            <pc:docMk/>
            <pc:sldMk cId="2292075898" sldId="290"/>
            <ac:spMk id="15" creationId="{902614A3-B9AC-8E4A-A55E-1121105C8775}"/>
          </ac:spMkLst>
        </pc:spChg>
        <pc:graphicFrameChg chg="add del mod">
          <ac:chgData name="Narang, Sonali" userId="9e80b397-6e2f-49b1-9374-ccdad8589140" providerId="ADAL" clId="{5D363520-F4C4-684A-BE7B-C8FFAAD0DE41}" dt="2022-11-16T17:33:00.040" v="755" actId="478"/>
          <ac:graphicFrameMkLst>
            <pc:docMk/>
            <pc:sldMk cId="2292075898" sldId="290"/>
            <ac:graphicFrameMk id="6" creationId="{8E5FFB5F-2BE4-0149-9754-AAC903E76863}"/>
          </ac:graphicFrameMkLst>
        </pc:graphicFrameChg>
        <pc:graphicFrameChg chg="add del mod modGraphic">
          <ac:chgData name="Narang, Sonali" userId="9e80b397-6e2f-49b1-9374-ccdad8589140" providerId="ADAL" clId="{5D363520-F4C4-684A-BE7B-C8FFAAD0DE41}" dt="2022-11-16T17:33:00.040" v="755" actId="478"/>
          <ac:graphicFrameMkLst>
            <pc:docMk/>
            <pc:sldMk cId="2292075898" sldId="290"/>
            <ac:graphicFrameMk id="8" creationId="{1C05F2AF-940C-F245-B536-0B3D3BD7D851}"/>
          </ac:graphicFrameMkLst>
        </pc:graphicFrameChg>
        <pc:graphicFrameChg chg="mod modGraphic">
          <ac:chgData name="Narang, Sonali" userId="9e80b397-6e2f-49b1-9374-ccdad8589140" providerId="ADAL" clId="{5D363520-F4C4-684A-BE7B-C8FFAAD0DE41}" dt="2022-11-16T21:33:50.803" v="1009" actId="14100"/>
          <ac:graphicFrameMkLst>
            <pc:docMk/>
            <pc:sldMk cId="2292075898" sldId="290"/>
            <ac:graphicFrameMk id="16" creationId="{14172837-94DE-3847-8367-932256827593}"/>
          </ac:graphicFrameMkLst>
        </pc:graphicFrameChg>
        <pc:picChg chg="add mod">
          <ac:chgData name="Narang, Sonali" userId="9e80b397-6e2f-49b1-9374-ccdad8589140" providerId="ADAL" clId="{5D363520-F4C4-684A-BE7B-C8FFAAD0DE41}" dt="2022-11-16T21:32:59.898" v="987" actId="1076"/>
          <ac:picMkLst>
            <pc:docMk/>
            <pc:sldMk cId="2292075898" sldId="290"/>
            <ac:picMk id="11" creationId="{075DB4C7-4103-7040-B6A7-7295253CD116}"/>
          </ac:picMkLst>
        </pc:picChg>
        <pc:picChg chg="add mod">
          <ac:chgData name="Narang, Sonali" userId="9e80b397-6e2f-49b1-9374-ccdad8589140" providerId="ADAL" clId="{5D363520-F4C4-684A-BE7B-C8FFAAD0DE41}" dt="2022-11-16T21:32:59.898" v="987" actId="1076"/>
          <ac:picMkLst>
            <pc:docMk/>
            <pc:sldMk cId="2292075898" sldId="290"/>
            <ac:picMk id="12" creationId="{D710AF0B-5446-874A-8761-D3CC60E797B3}"/>
          </ac:picMkLst>
        </pc:picChg>
        <pc:picChg chg="add mod">
          <ac:chgData name="Narang, Sonali" userId="9e80b397-6e2f-49b1-9374-ccdad8589140" providerId="ADAL" clId="{5D363520-F4C4-684A-BE7B-C8FFAAD0DE41}" dt="2022-11-16T21:32:59.898" v="987" actId="1076"/>
          <ac:picMkLst>
            <pc:docMk/>
            <pc:sldMk cId="2292075898" sldId="290"/>
            <ac:picMk id="13" creationId="{D740E170-78A4-2845-B92D-6730F70B3F70}"/>
          </ac:picMkLst>
        </pc:picChg>
      </pc:sldChg>
      <pc:sldChg chg="addSp delSp modSp add mod modNotesTx">
        <pc:chgData name="Narang, Sonali" userId="9e80b397-6e2f-49b1-9374-ccdad8589140" providerId="ADAL" clId="{5D363520-F4C4-684A-BE7B-C8FFAAD0DE41}" dt="2022-11-15T15:59:03.015" v="258" actId="20577"/>
        <pc:sldMkLst>
          <pc:docMk/>
          <pc:sldMk cId="3617872054" sldId="291"/>
        </pc:sldMkLst>
        <pc:spChg chg="del">
          <ac:chgData name="Narang, Sonali" userId="9e80b397-6e2f-49b1-9374-ccdad8589140" providerId="ADAL" clId="{5D363520-F4C4-684A-BE7B-C8FFAAD0DE41}" dt="2022-11-14T17:59:30.746" v="175" actId="478"/>
          <ac:spMkLst>
            <pc:docMk/>
            <pc:sldMk cId="3617872054" sldId="291"/>
            <ac:spMk id="4" creationId="{E6DB8D26-08E3-FB4F-8288-7AD287BEB7C7}"/>
          </ac:spMkLst>
        </pc:spChg>
        <pc:spChg chg="add mod">
          <ac:chgData name="Narang, Sonali" userId="9e80b397-6e2f-49b1-9374-ccdad8589140" providerId="ADAL" clId="{5D363520-F4C4-684A-BE7B-C8FFAAD0DE41}" dt="2022-11-15T15:43:54.776" v="208" actId="20577"/>
          <ac:spMkLst>
            <pc:docMk/>
            <pc:sldMk cId="3617872054" sldId="291"/>
            <ac:spMk id="29" creationId="{272B8E4A-E01D-9B45-AFE2-3B49B72AC62E}"/>
          </ac:spMkLst>
        </pc:spChg>
      </pc:sldChg>
      <pc:sldChg chg="addSp delSp modSp mod modNotesTx">
        <pc:chgData name="Narang, Sonali" userId="9e80b397-6e2f-49b1-9374-ccdad8589140" providerId="ADAL" clId="{5D363520-F4C4-684A-BE7B-C8FFAAD0DE41}" dt="2022-11-15T16:00:09.508" v="266" actId="20577"/>
        <pc:sldMkLst>
          <pc:docMk/>
          <pc:sldMk cId="2985018669" sldId="292"/>
        </pc:sldMkLst>
        <pc:spChg chg="del">
          <ac:chgData name="Narang, Sonali" userId="9e80b397-6e2f-49b1-9374-ccdad8589140" providerId="ADAL" clId="{5D363520-F4C4-684A-BE7B-C8FFAAD0DE41}" dt="2022-11-09T21:59:30.365" v="54" actId="478"/>
          <ac:spMkLst>
            <pc:docMk/>
            <pc:sldMk cId="2985018669" sldId="292"/>
            <ac:spMk id="4" creationId="{F6669B9D-B042-D548-BD0F-97015091799B}"/>
          </ac:spMkLst>
        </pc:spChg>
        <pc:spChg chg="add mod">
          <ac:chgData name="Narang, Sonali" userId="9e80b397-6e2f-49b1-9374-ccdad8589140" providerId="ADAL" clId="{5D363520-F4C4-684A-BE7B-C8FFAAD0DE41}" dt="2022-11-15T15:56:36.344" v="244" actId="20577"/>
          <ac:spMkLst>
            <pc:docMk/>
            <pc:sldMk cId="2985018669" sldId="292"/>
            <ac:spMk id="5" creationId="{AB8FCA42-B1BF-A140-A0F6-ABD57267C2D7}"/>
          </ac:spMkLst>
        </pc:spChg>
      </pc:sldChg>
      <pc:sldChg chg="addSp delSp modSp mod ord modNotesTx">
        <pc:chgData name="Narang, Sonali" userId="9e80b397-6e2f-49b1-9374-ccdad8589140" providerId="ADAL" clId="{5D363520-F4C4-684A-BE7B-C8FFAAD0DE41}" dt="2022-11-19T23:54:18.112" v="1806" actId="20577"/>
        <pc:sldMkLst>
          <pc:docMk/>
          <pc:sldMk cId="2574176189" sldId="294"/>
        </pc:sldMkLst>
        <pc:spChg chg="del">
          <ac:chgData name="Narang, Sonali" userId="9e80b397-6e2f-49b1-9374-ccdad8589140" providerId="ADAL" clId="{5D363520-F4C4-684A-BE7B-C8FFAAD0DE41}" dt="2022-11-09T21:59:17.906" v="49" actId="478"/>
          <ac:spMkLst>
            <pc:docMk/>
            <pc:sldMk cId="2574176189" sldId="294"/>
            <ac:spMk id="4" creationId="{F6669B9D-B042-D548-BD0F-97015091799B}"/>
          </ac:spMkLst>
        </pc:spChg>
        <pc:spChg chg="add mod">
          <ac:chgData name="Narang, Sonali" userId="9e80b397-6e2f-49b1-9374-ccdad8589140" providerId="ADAL" clId="{5D363520-F4C4-684A-BE7B-C8FFAAD0DE41}" dt="2022-11-15T15:43:47.649" v="204" actId="20577"/>
          <ac:spMkLst>
            <pc:docMk/>
            <pc:sldMk cId="2574176189" sldId="294"/>
            <ac:spMk id="7" creationId="{CFFE0061-AF54-6D48-A9BA-8024282F038F}"/>
          </ac:spMkLst>
        </pc:spChg>
        <pc:spChg chg="mod">
          <ac:chgData name="Narang, Sonali" userId="9e80b397-6e2f-49b1-9374-ccdad8589140" providerId="ADAL" clId="{5D363520-F4C4-684A-BE7B-C8FFAAD0DE41}" dt="2022-11-15T17:22:25.441" v="671" actId="1036"/>
          <ac:spMkLst>
            <pc:docMk/>
            <pc:sldMk cId="2574176189" sldId="294"/>
            <ac:spMk id="19" creationId="{AD1A0C94-7B28-0C42-873A-DD66B1F10735}"/>
          </ac:spMkLst>
        </pc:spChg>
        <pc:graphicFrameChg chg="add del mod modGraphic">
          <ac:chgData name="Narang, Sonali" userId="9e80b397-6e2f-49b1-9374-ccdad8589140" providerId="ADAL" clId="{5D363520-F4C4-684A-BE7B-C8FFAAD0DE41}" dt="2022-11-15T16:14:53.415" v="288" actId="478"/>
          <ac:graphicFrameMkLst>
            <pc:docMk/>
            <pc:sldMk cId="2574176189" sldId="294"/>
            <ac:graphicFrameMk id="2" creationId="{BFE636B2-47A9-4041-B3C1-39F1F964D8C8}"/>
          </ac:graphicFrameMkLst>
        </pc:graphicFrameChg>
        <pc:graphicFrameChg chg="add del modGraphic">
          <ac:chgData name="Narang, Sonali" userId="9e80b397-6e2f-49b1-9374-ccdad8589140" providerId="ADAL" clId="{5D363520-F4C4-684A-BE7B-C8FFAAD0DE41}" dt="2022-11-15T17:12:55.339" v="632" actId="478"/>
          <ac:graphicFrameMkLst>
            <pc:docMk/>
            <pc:sldMk cId="2574176189" sldId="294"/>
            <ac:graphicFrameMk id="3" creationId="{918040D4-19C7-3C45-A846-79D58C579040}"/>
          </ac:graphicFrameMkLst>
        </pc:graphicFrameChg>
        <pc:graphicFrameChg chg="mod modGraphic">
          <ac:chgData name="Narang, Sonali" userId="9e80b397-6e2f-49b1-9374-ccdad8589140" providerId="ADAL" clId="{5D363520-F4C4-684A-BE7B-C8FFAAD0DE41}" dt="2022-11-19T23:53:37.091" v="1789" actId="20577"/>
          <ac:graphicFrameMkLst>
            <pc:docMk/>
            <pc:sldMk cId="2574176189" sldId="294"/>
            <ac:graphicFrameMk id="10" creationId="{2AD806D8-8056-A543-AE25-457F49328268}"/>
          </ac:graphicFrameMkLst>
        </pc:graphicFrameChg>
        <pc:graphicFrameChg chg="mod modGraphic">
          <ac:chgData name="Narang, Sonali" userId="9e80b397-6e2f-49b1-9374-ccdad8589140" providerId="ADAL" clId="{5D363520-F4C4-684A-BE7B-C8FFAAD0DE41}" dt="2022-11-19T23:54:18.112" v="1806" actId="20577"/>
          <ac:graphicFrameMkLst>
            <pc:docMk/>
            <pc:sldMk cId="2574176189" sldId="294"/>
            <ac:graphicFrameMk id="11" creationId="{B8484720-E1AE-8F49-B5E4-BD103B77A2DC}"/>
          </ac:graphicFrameMkLst>
        </pc:graphicFrameChg>
      </pc:sldChg>
      <pc:sldChg chg="add del">
        <pc:chgData name="Narang, Sonali" userId="9e80b397-6e2f-49b1-9374-ccdad8589140" providerId="ADAL" clId="{5D363520-F4C4-684A-BE7B-C8FFAAD0DE41}" dt="2022-11-09T18:38:42.332" v="1" actId="2696"/>
        <pc:sldMkLst>
          <pc:docMk/>
          <pc:sldMk cId="285676690" sldId="295"/>
        </pc:sldMkLst>
      </pc:sldChg>
      <pc:sldChg chg="addSp delSp modSp add del mod modNotesTx">
        <pc:chgData name="Narang, Sonali" userId="9e80b397-6e2f-49b1-9374-ccdad8589140" providerId="ADAL" clId="{5D363520-F4C4-684A-BE7B-C8FFAAD0DE41}" dt="2022-11-09T22:08:00.539" v="108" actId="2696"/>
        <pc:sldMkLst>
          <pc:docMk/>
          <pc:sldMk cId="597538592" sldId="295"/>
        </pc:sldMkLst>
        <pc:spChg chg="del mod">
          <ac:chgData name="Narang, Sonali" userId="9e80b397-6e2f-49b1-9374-ccdad8589140" providerId="ADAL" clId="{5D363520-F4C4-684A-BE7B-C8FFAAD0DE41}" dt="2022-11-09T21:59:06.507" v="41" actId="478"/>
          <ac:spMkLst>
            <pc:docMk/>
            <pc:sldMk cId="597538592" sldId="295"/>
            <ac:spMk id="4" creationId="{E6DB8D26-08E3-FB4F-8288-7AD287BEB7C7}"/>
          </ac:spMkLst>
        </pc:spChg>
        <pc:spChg chg="add mod">
          <ac:chgData name="Narang, Sonali" userId="9e80b397-6e2f-49b1-9374-ccdad8589140" providerId="ADAL" clId="{5D363520-F4C4-684A-BE7B-C8FFAAD0DE41}" dt="2022-11-09T21:59:08.265" v="44" actId="20577"/>
          <ac:spMkLst>
            <pc:docMk/>
            <pc:sldMk cId="597538592" sldId="295"/>
            <ac:spMk id="21" creationId="{15B8ED3D-A5E0-4048-AE36-5AB1872373E0}"/>
          </ac:spMkLst>
        </pc:spChg>
      </pc:sldChg>
      <pc:sldChg chg="addSp delSp modSp add mod modNotesTx">
        <pc:chgData name="Narang, Sonali" userId="9e80b397-6e2f-49b1-9374-ccdad8589140" providerId="ADAL" clId="{5D363520-F4C4-684A-BE7B-C8FFAAD0DE41}" dt="2022-11-15T15:59:25.676" v="260" actId="20577"/>
        <pc:sldMkLst>
          <pc:docMk/>
          <pc:sldMk cId="1438048095" sldId="295"/>
        </pc:sldMkLst>
        <pc:spChg chg="add mod">
          <ac:chgData name="Narang, Sonali" userId="9e80b397-6e2f-49b1-9374-ccdad8589140" providerId="ADAL" clId="{5D363520-F4C4-684A-BE7B-C8FFAAD0DE41}" dt="2022-11-15T15:44:00.100" v="212" actId="20577"/>
          <ac:spMkLst>
            <pc:docMk/>
            <pc:sldMk cId="1438048095" sldId="295"/>
            <ac:spMk id="16" creationId="{DD9A34E2-FB56-7543-BD51-DCD2CC285DC9}"/>
          </ac:spMkLst>
        </pc:spChg>
        <pc:spChg chg="del">
          <ac:chgData name="Narang, Sonali" userId="9e80b397-6e2f-49b1-9374-ccdad8589140" providerId="ADAL" clId="{5D363520-F4C4-684A-BE7B-C8FFAAD0DE41}" dt="2022-11-14T17:59:38.424" v="179" actId="478"/>
          <ac:spMkLst>
            <pc:docMk/>
            <pc:sldMk cId="1438048095" sldId="295"/>
            <ac:spMk id="19" creationId="{528A41FB-B654-1F42-AEF9-3BC756D8DD32}"/>
          </ac:spMkLst>
        </pc:spChg>
      </pc:sldChg>
      <pc:sldChg chg="addSp delSp modSp add del mod ord modNotesTx">
        <pc:chgData name="Narang, Sonali" userId="9e80b397-6e2f-49b1-9374-ccdad8589140" providerId="ADAL" clId="{5D363520-F4C4-684A-BE7B-C8FFAAD0DE41}" dt="2022-11-16T17:48:56.870" v="960" actId="2696"/>
        <pc:sldMkLst>
          <pc:docMk/>
          <pc:sldMk cId="17933494" sldId="296"/>
        </pc:sldMkLst>
        <pc:spChg chg="mod">
          <ac:chgData name="Narang, Sonali" userId="9e80b397-6e2f-49b1-9374-ccdad8589140" providerId="ADAL" clId="{5D363520-F4C4-684A-BE7B-C8FFAAD0DE41}" dt="2022-11-16T16:48:34.301" v="741" actId="20577"/>
          <ac:spMkLst>
            <pc:docMk/>
            <pc:sldMk cId="17933494" sldId="296"/>
            <ac:spMk id="5" creationId="{2B6EBCD3-2130-FB43-8A00-E4997D60F8E3}"/>
          </ac:spMkLst>
        </pc:spChg>
        <pc:spChg chg="del">
          <ac:chgData name="Narang, Sonali" userId="9e80b397-6e2f-49b1-9374-ccdad8589140" providerId="ADAL" clId="{5D363520-F4C4-684A-BE7B-C8FFAAD0DE41}" dt="2022-11-16T16:47:00.826" v="709" actId="478"/>
          <ac:spMkLst>
            <pc:docMk/>
            <pc:sldMk cId="17933494" sldId="296"/>
            <ac:spMk id="7" creationId="{CB9C2CA2-B854-C447-B990-0E438B105C86}"/>
          </ac:spMkLst>
        </pc:spChg>
        <pc:spChg chg="del">
          <ac:chgData name="Narang, Sonali" userId="9e80b397-6e2f-49b1-9374-ccdad8589140" providerId="ADAL" clId="{5D363520-F4C4-684A-BE7B-C8FFAAD0DE41}" dt="2022-11-16T16:47:00.826" v="709" actId="478"/>
          <ac:spMkLst>
            <pc:docMk/>
            <pc:sldMk cId="17933494" sldId="296"/>
            <ac:spMk id="9" creationId="{D341B568-23A9-664C-B985-110320242F3A}"/>
          </ac:spMkLst>
        </pc:spChg>
        <pc:spChg chg="del">
          <ac:chgData name="Narang, Sonali" userId="9e80b397-6e2f-49b1-9374-ccdad8589140" providerId="ADAL" clId="{5D363520-F4C4-684A-BE7B-C8FFAAD0DE41}" dt="2022-11-16T16:47:00.826" v="709" actId="478"/>
          <ac:spMkLst>
            <pc:docMk/>
            <pc:sldMk cId="17933494" sldId="296"/>
            <ac:spMk id="10" creationId="{C24C7839-5141-3746-9EB3-335ECFDDACF7}"/>
          </ac:spMkLst>
        </pc:spChg>
        <pc:spChg chg="add del mod">
          <ac:chgData name="Narang, Sonali" userId="9e80b397-6e2f-49b1-9374-ccdad8589140" providerId="ADAL" clId="{5D363520-F4C4-684A-BE7B-C8FFAAD0DE41}" dt="2022-11-16T16:49:02.611" v="751" actId="478"/>
          <ac:spMkLst>
            <pc:docMk/>
            <pc:sldMk cId="17933494" sldId="296"/>
            <ac:spMk id="14" creationId="{1487B38B-0D6D-CF48-8A1A-5379542574C1}"/>
          </ac:spMkLst>
        </pc:spChg>
        <pc:spChg chg="add del mod">
          <ac:chgData name="Narang, Sonali" userId="9e80b397-6e2f-49b1-9374-ccdad8589140" providerId="ADAL" clId="{5D363520-F4C4-684A-BE7B-C8FFAAD0DE41}" dt="2022-11-16T16:48:54.383" v="746"/>
          <ac:spMkLst>
            <pc:docMk/>
            <pc:sldMk cId="17933494" sldId="296"/>
            <ac:spMk id="15" creationId="{9E755D96-FAB7-B247-9164-1C4691A0B3E7}"/>
          </ac:spMkLst>
        </pc:spChg>
        <pc:spChg chg="add del mod">
          <ac:chgData name="Narang, Sonali" userId="9e80b397-6e2f-49b1-9374-ccdad8589140" providerId="ADAL" clId="{5D363520-F4C4-684A-BE7B-C8FFAAD0DE41}" dt="2022-11-16T16:48:55.971" v="748"/>
          <ac:spMkLst>
            <pc:docMk/>
            <pc:sldMk cId="17933494" sldId="296"/>
            <ac:spMk id="17" creationId="{8B5A73A6-E412-D648-829A-B58E6D30A62A}"/>
          </ac:spMkLst>
        </pc:spChg>
        <pc:spChg chg="add del mod">
          <ac:chgData name="Narang, Sonali" userId="9e80b397-6e2f-49b1-9374-ccdad8589140" providerId="ADAL" clId="{5D363520-F4C4-684A-BE7B-C8FFAAD0DE41}" dt="2022-11-16T17:48:23.367" v="945" actId="21"/>
          <ac:spMkLst>
            <pc:docMk/>
            <pc:sldMk cId="17933494" sldId="296"/>
            <ac:spMk id="18" creationId="{DF5253DA-436D-9046-ACCB-C6E15D78CDCA}"/>
          </ac:spMkLst>
        </pc:spChg>
        <pc:graphicFrameChg chg="del">
          <ac:chgData name="Narang, Sonali" userId="9e80b397-6e2f-49b1-9374-ccdad8589140" providerId="ADAL" clId="{5D363520-F4C4-684A-BE7B-C8FFAAD0DE41}" dt="2022-11-16T16:47:00.826" v="709" actId="478"/>
          <ac:graphicFrameMkLst>
            <pc:docMk/>
            <pc:sldMk cId="17933494" sldId="296"/>
            <ac:graphicFrameMk id="6" creationId="{8E5FFB5F-2BE4-0149-9754-AAC903E76863}"/>
          </ac:graphicFrameMkLst>
        </pc:graphicFrameChg>
        <pc:graphicFrameChg chg="del">
          <ac:chgData name="Narang, Sonali" userId="9e80b397-6e2f-49b1-9374-ccdad8589140" providerId="ADAL" clId="{5D363520-F4C4-684A-BE7B-C8FFAAD0DE41}" dt="2022-11-16T16:47:00.826" v="709" actId="478"/>
          <ac:graphicFrameMkLst>
            <pc:docMk/>
            <pc:sldMk cId="17933494" sldId="296"/>
            <ac:graphicFrameMk id="8" creationId="{1C05F2AF-940C-F245-B536-0B3D3BD7D851}"/>
          </ac:graphicFrameMkLst>
        </pc:graphicFrameChg>
        <pc:graphicFrameChg chg="del">
          <ac:chgData name="Narang, Sonali" userId="9e80b397-6e2f-49b1-9374-ccdad8589140" providerId="ADAL" clId="{5D363520-F4C4-684A-BE7B-C8FFAAD0DE41}" dt="2022-11-16T16:47:00.826" v="709" actId="478"/>
          <ac:graphicFrameMkLst>
            <pc:docMk/>
            <pc:sldMk cId="17933494" sldId="296"/>
            <ac:graphicFrameMk id="16" creationId="{14172837-94DE-3847-8367-932256827593}"/>
          </ac:graphicFrameMkLst>
        </pc:graphicFrameChg>
        <pc:picChg chg="add del mod modCrop">
          <ac:chgData name="Narang, Sonali" userId="9e80b397-6e2f-49b1-9374-ccdad8589140" providerId="ADAL" clId="{5D363520-F4C4-684A-BE7B-C8FFAAD0DE41}" dt="2022-11-16T17:48:23.367" v="945" actId="21"/>
          <ac:picMkLst>
            <pc:docMk/>
            <pc:sldMk cId="17933494" sldId="296"/>
            <ac:picMk id="3" creationId="{AE06D917-CF42-CE4D-AF26-60DFA171DB6D}"/>
          </ac:picMkLst>
        </pc:picChg>
        <pc:picChg chg="add del mod modCrop">
          <ac:chgData name="Narang, Sonali" userId="9e80b397-6e2f-49b1-9374-ccdad8589140" providerId="ADAL" clId="{5D363520-F4C4-684A-BE7B-C8FFAAD0DE41}" dt="2022-11-16T17:48:23.367" v="945" actId="21"/>
          <ac:picMkLst>
            <pc:docMk/>
            <pc:sldMk cId="17933494" sldId="296"/>
            <ac:picMk id="11" creationId="{CE7F90E0-8536-4B4B-87C8-0B2979C6A978}"/>
          </ac:picMkLst>
        </pc:picChg>
        <pc:picChg chg="add del mod modCrop">
          <ac:chgData name="Narang, Sonali" userId="9e80b397-6e2f-49b1-9374-ccdad8589140" providerId="ADAL" clId="{5D363520-F4C4-684A-BE7B-C8FFAAD0DE41}" dt="2022-11-16T17:48:23.367" v="945" actId="21"/>
          <ac:picMkLst>
            <pc:docMk/>
            <pc:sldMk cId="17933494" sldId="296"/>
            <ac:picMk id="13" creationId="{33CB1A5A-61F6-5143-9E37-24F83FE21AC4}"/>
          </ac:picMkLst>
        </pc:picChg>
      </pc:sldChg>
      <pc:sldChg chg="addSp delSp modSp add del mod modNotesTx">
        <pc:chgData name="Narang, Sonali" userId="9e80b397-6e2f-49b1-9374-ccdad8589140" providerId="ADAL" clId="{5D363520-F4C4-684A-BE7B-C8FFAAD0DE41}" dt="2022-11-09T22:07:40.214" v="107" actId="2696"/>
        <pc:sldMkLst>
          <pc:docMk/>
          <pc:sldMk cId="2750517281" sldId="296"/>
        </pc:sldMkLst>
        <pc:spChg chg="del mod">
          <ac:chgData name="Narang, Sonali" userId="9e80b397-6e2f-49b1-9374-ccdad8589140" providerId="ADAL" clId="{5D363520-F4C4-684A-BE7B-C8FFAAD0DE41}" dt="2022-11-09T21:59:11.080" v="45" actId="478"/>
          <ac:spMkLst>
            <pc:docMk/>
            <pc:sldMk cId="2750517281" sldId="296"/>
            <ac:spMk id="4" creationId="{E6DB8D26-08E3-FB4F-8288-7AD287BEB7C7}"/>
          </ac:spMkLst>
        </pc:spChg>
        <pc:spChg chg="del">
          <ac:chgData name="Narang, Sonali" userId="9e80b397-6e2f-49b1-9374-ccdad8589140" providerId="ADAL" clId="{5D363520-F4C4-684A-BE7B-C8FFAAD0DE41}" dt="2022-11-09T18:39:04.727" v="11" actId="478"/>
          <ac:spMkLst>
            <pc:docMk/>
            <pc:sldMk cId="2750517281" sldId="296"/>
            <ac:spMk id="18" creationId="{7ABDB245-45E3-0347-86FC-83409EDDB0A3}"/>
          </ac:spMkLst>
        </pc:spChg>
        <pc:spChg chg="add mod">
          <ac:chgData name="Narang, Sonali" userId="9e80b397-6e2f-49b1-9374-ccdad8589140" providerId="ADAL" clId="{5D363520-F4C4-684A-BE7B-C8FFAAD0DE41}" dt="2022-11-09T21:59:13.168" v="48" actId="20577"/>
          <ac:spMkLst>
            <pc:docMk/>
            <pc:sldMk cId="2750517281" sldId="296"/>
            <ac:spMk id="19" creationId="{A1F4535B-7B08-C244-A807-61F515A7880E}"/>
          </ac:spMkLst>
        </pc:spChg>
      </pc:sldChg>
    </pc:docChg>
  </pc:docChgLst>
  <pc:docChgLst>
    <pc:chgData name="Narang, Sonali" userId="9e80b397-6e2f-49b1-9374-ccdad8589140" providerId="ADAL" clId="{0A0D2314-D59C-5A4C-9E09-78A254E3BB4B}"/>
    <pc:docChg chg="undo redo custSel addSld delSld modSld sldOrd">
      <pc:chgData name="Narang, Sonali" userId="9e80b397-6e2f-49b1-9374-ccdad8589140" providerId="ADAL" clId="{0A0D2314-D59C-5A4C-9E09-78A254E3BB4B}" dt="2021-11-04T20:50:12.072" v="4701" actId="20577"/>
      <pc:docMkLst>
        <pc:docMk/>
      </pc:docMkLst>
      <pc:sldChg chg="addSp delSp modSp mod">
        <pc:chgData name="Narang, Sonali" userId="9e80b397-6e2f-49b1-9374-ccdad8589140" providerId="ADAL" clId="{0A0D2314-D59C-5A4C-9E09-78A254E3BB4B}" dt="2021-11-03T14:08:25.153" v="3771" actId="1076"/>
        <pc:sldMkLst>
          <pc:docMk/>
          <pc:sldMk cId="1854626235" sldId="257"/>
        </pc:sldMkLst>
        <pc:spChg chg="add mod">
          <ac:chgData name="Narang, Sonali" userId="9e80b397-6e2f-49b1-9374-ccdad8589140" providerId="ADAL" clId="{0A0D2314-D59C-5A4C-9E09-78A254E3BB4B}" dt="2021-11-03T14:07:40.886" v="3766" actId="2085"/>
          <ac:spMkLst>
            <pc:docMk/>
            <pc:sldMk cId="1854626235" sldId="257"/>
            <ac:spMk id="2" creationId="{8653355A-CC61-1A44-8019-616681B67BD9}"/>
          </ac:spMkLst>
        </pc:spChg>
        <pc:spChg chg="mod">
          <ac:chgData name="Narang, Sonali" userId="9e80b397-6e2f-49b1-9374-ccdad8589140" providerId="ADAL" clId="{0A0D2314-D59C-5A4C-9E09-78A254E3BB4B}" dt="2021-11-02T15:35:41.655" v="3202" actId="20577"/>
          <ac:spMkLst>
            <pc:docMk/>
            <pc:sldMk cId="1854626235" sldId="257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11-03T14:08:18.609" v="3770" actId="1076"/>
          <ac:spMkLst>
            <pc:docMk/>
            <pc:sldMk cId="1854626235" sldId="257"/>
            <ac:spMk id="5" creationId="{FAFFEC37-A0C5-5846-8534-22E3DEF6CEF4}"/>
          </ac:spMkLst>
        </pc:spChg>
        <pc:spChg chg="mod">
          <ac:chgData name="Narang, Sonali" userId="9e80b397-6e2f-49b1-9374-ccdad8589140" providerId="ADAL" clId="{0A0D2314-D59C-5A4C-9E09-78A254E3BB4B}" dt="2021-11-03T14:07:13.359" v="3763" actId="1076"/>
          <ac:spMkLst>
            <pc:docMk/>
            <pc:sldMk cId="1854626235" sldId="257"/>
            <ac:spMk id="6" creationId="{41464C80-B659-484D-A16F-8018DEC5471A}"/>
          </ac:spMkLst>
        </pc:spChg>
        <pc:spChg chg="mod">
          <ac:chgData name="Narang, Sonali" userId="9e80b397-6e2f-49b1-9374-ccdad8589140" providerId="ADAL" clId="{0A0D2314-D59C-5A4C-9E09-78A254E3BB4B}" dt="2021-10-01T16:51:49.339" v="2982" actId="20577"/>
          <ac:spMkLst>
            <pc:docMk/>
            <pc:sldMk cId="1854626235" sldId="257"/>
            <ac:spMk id="8" creationId="{8A9BAE78-C4FF-1843-94F6-3410EB884848}"/>
          </ac:spMkLst>
        </pc:spChg>
        <pc:spChg chg="del">
          <ac:chgData name="Narang, Sonali" userId="9e80b397-6e2f-49b1-9374-ccdad8589140" providerId="ADAL" clId="{0A0D2314-D59C-5A4C-9E09-78A254E3BB4B}" dt="2021-09-30T19:14:53.848" v="1995" actId="478"/>
          <ac:spMkLst>
            <pc:docMk/>
            <pc:sldMk cId="1854626235" sldId="257"/>
            <ac:spMk id="21" creationId="{6DE5BA81-9EFB-494A-B561-0386C22C9665}"/>
          </ac:spMkLst>
        </pc:spChg>
        <pc:spChg chg="del">
          <ac:chgData name="Narang, Sonali" userId="9e80b397-6e2f-49b1-9374-ccdad8589140" providerId="ADAL" clId="{0A0D2314-D59C-5A4C-9E09-78A254E3BB4B}" dt="2021-09-30T19:15:29.464" v="2083" actId="478"/>
          <ac:spMkLst>
            <pc:docMk/>
            <pc:sldMk cId="1854626235" sldId="257"/>
            <ac:spMk id="22" creationId="{501252A5-9627-6A46-9C1C-D13750DE3409}"/>
          </ac:spMkLst>
        </pc:spChg>
        <pc:spChg chg="mod">
          <ac:chgData name="Narang, Sonali" userId="9e80b397-6e2f-49b1-9374-ccdad8589140" providerId="ADAL" clId="{0A0D2314-D59C-5A4C-9E09-78A254E3BB4B}" dt="2021-10-01T16:51:42.238" v="2979" actId="20577"/>
          <ac:spMkLst>
            <pc:docMk/>
            <pc:sldMk cId="1854626235" sldId="257"/>
            <ac:spMk id="70" creationId="{B246B051-DD4B-294D-B265-38CF288C0C5A}"/>
          </ac:spMkLst>
        </pc:spChg>
        <pc:spChg chg="mod">
          <ac:chgData name="Narang, Sonali" userId="9e80b397-6e2f-49b1-9374-ccdad8589140" providerId="ADAL" clId="{0A0D2314-D59C-5A4C-9E09-78A254E3BB4B}" dt="2021-09-30T19:19:31.258" v="2202" actId="1036"/>
          <ac:spMkLst>
            <pc:docMk/>
            <pc:sldMk cId="1854626235" sldId="257"/>
            <ac:spMk id="71" creationId="{BDCB7AA1-749D-8C43-AF10-858D8E39FF31}"/>
          </ac:spMkLst>
        </pc:spChg>
        <pc:spChg chg="del">
          <ac:chgData name="Narang, Sonali" userId="9e80b397-6e2f-49b1-9374-ccdad8589140" providerId="ADAL" clId="{0A0D2314-D59C-5A4C-9E09-78A254E3BB4B}" dt="2021-09-30T19:16:31.342" v="2086" actId="478"/>
          <ac:spMkLst>
            <pc:docMk/>
            <pc:sldMk cId="1854626235" sldId="257"/>
            <ac:spMk id="72" creationId="{90CCFF70-1378-6D43-8667-AD3C3AF3C177}"/>
          </ac:spMkLst>
        </pc:spChg>
        <pc:spChg chg="mod">
          <ac:chgData name="Narang, Sonali" userId="9e80b397-6e2f-49b1-9374-ccdad8589140" providerId="ADAL" clId="{0A0D2314-D59C-5A4C-9E09-78A254E3BB4B}" dt="2021-09-30T19:25:41.215" v="2304" actId="1035"/>
          <ac:spMkLst>
            <pc:docMk/>
            <pc:sldMk cId="1854626235" sldId="257"/>
            <ac:spMk id="73" creationId="{3402C79D-781C-C242-A2D1-8D957E624560}"/>
          </ac:spMkLst>
        </pc:spChg>
        <pc:spChg chg="del">
          <ac:chgData name="Narang, Sonali" userId="9e80b397-6e2f-49b1-9374-ccdad8589140" providerId="ADAL" clId="{0A0D2314-D59C-5A4C-9E09-78A254E3BB4B}" dt="2021-09-30T19:16:29.467" v="2085" actId="478"/>
          <ac:spMkLst>
            <pc:docMk/>
            <pc:sldMk cId="1854626235" sldId="257"/>
            <ac:spMk id="74" creationId="{967BEA32-0C48-ED4C-9910-D7EDEDCC141D}"/>
          </ac:spMkLst>
        </pc:spChg>
        <pc:spChg chg="del">
          <ac:chgData name="Narang, Sonali" userId="9e80b397-6e2f-49b1-9374-ccdad8589140" providerId="ADAL" clId="{0A0D2314-D59C-5A4C-9E09-78A254E3BB4B}" dt="2021-09-30T19:16:31.342" v="2086" actId="478"/>
          <ac:spMkLst>
            <pc:docMk/>
            <pc:sldMk cId="1854626235" sldId="257"/>
            <ac:spMk id="75" creationId="{BEDFAA73-9606-8641-B6B3-F2F0790E86F0}"/>
          </ac:spMkLst>
        </pc:spChg>
        <pc:spChg chg="mod">
          <ac:chgData name="Narang, Sonali" userId="9e80b397-6e2f-49b1-9374-ccdad8589140" providerId="ADAL" clId="{0A0D2314-D59C-5A4C-9E09-78A254E3BB4B}" dt="2021-10-01T16:52:26.961" v="2984" actId="1076"/>
          <ac:spMkLst>
            <pc:docMk/>
            <pc:sldMk cId="1854626235" sldId="257"/>
            <ac:spMk id="76" creationId="{2027CEAE-7CD6-1546-8D11-7908F5DCCD3D}"/>
          </ac:spMkLst>
        </pc:spChg>
        <pc:spChg chg="del">
          <ac:chgData name="Narang, Sonali" userId="9e80b397-6e2f-49b1-9374-ccdad8589140" providerId="ADAL" clId="{0A0D2314-D59C-5A4C-9E09-78A254E3BB4B}" dt="2021-09-30T19:16:29.467" v="2085" actId="478"/>
          <ac:spMkLst>
            <pc:docMk/>
            <pc:sldMk cId="1854626235" sldId="257"/>
            <ac:spMk id="77" creationId="{82B08ED5-E6CD-A443-A30D-B56A41AA48D5}"/>
          </ac:spMkLst>
        </pc:spChg>
        <pc:spChg chg="add mod">
          <ac:chgData name="Narang, Sonali" userId="9e80b397-6e2f-49b1-9374-ccdad8589140" providerId="ADAL" clId="{0A0D2314-D59C-5A4C-9E09-78A254E3BB4B}" dt="2021-11-03T14:07:05.150" v="3762" actId="1076"/>
          <ac:spMkLst>
            <pc:docMk/>
            <pc:sldMk cId="1854626235" sldId="257"/>
            <ac:spMk id="84" creationId="{7743C0A5-2246-6E46-BF4B-6F73F99E29F8}"/>
          </ac:spMkLst>
        </pc:spChg>
        <pc:spChg chg="add mod">
          <ac:chgData name="Narang, Sonali" userId="9e80b397-6e2f-49b1-9374-ccdad8589140" providerId="ADAL" clId="{0A0D2314-D59C-5A4C-9E09-78A254E3BB4B}" dt="2021-09-30T19:32:16.427" v="2329" actId="1076"/>
          <ac:spMkLst>
            <pc:docMk/>
            <pc:sldMk cId="1854626235" sldId="257"/>
            <ac:spMk id="86" creationId="{D21029A0-FE16-1A4C-9ACD-753672358A12}"/>
          </ac:spMkLst>
        </pc:spChg>
        <pc:spChg chg="add mod">
          <ac:chgData name="Narang, Sonali" userId="9e80b397-6e2f-49b1-9374-ccdad8589140" providerId="ADAL" clId="{0A0D2314-D59C-5A4C-9E09-78A254E3BB4B}" dt="2021-10-01T16:52:30.915" v="2985" actId="1076"/>
          <ac:spMkLst>
            <pc:docMk/>
            <pc:sldMk cId="1854626235" sldId="257"/>
            <ac:spMk id="88" creationId="{764069F7-4C54-4A4E-BB12-FC6C688BF41D}"/>
          </ac:spMkLst>
        </pc:spChg>
        <pc:spChg chg="add mod">
          <ac:chgData name="Narang, Sonali" userId="9e80b397-6e2f-49b1-9374-ccdad8589140" providerId="ADAL" clId="{0A0D2314-D59C-5A4C-9E09-78A254E3BB4B}" dt="2021-10-01T16:51:20.578" v="2971" actId="1076"/>
          <ac:spMkLst>
            <pc:docMk/>
            <pc:sldMk cId="1854626235" sldId="257"/>
            <ac:spMk id="90" creationId="{5766E55B-F591-7E48-BA92-1D7B51990CBA}"/>
          </ac:spMkLst>
        </pc:spChg>
        <pc:grpChg chg="add">
          <ac:chgData name="Narang, Sonali" userId="9e80b397-6e2f-49b1-9374-ccdad8589140" providerId="ADAL" clId="{0A0D2314-D59C-5A4C-9E09-78A254E3BB4B}" dt="2021-11-03T14:07:48.123" v="3767" actId="164"/>
          <ac:grpSpMkLst>
            <pc:docMk/>
            <pc:sldMk cId="1854626235" sldId="257"/>
            <ac:grpSpMk id="9" creationId="{4C52228E-C632-F14E-B711-9D1E4A2408CE}"/>
          </ac:grpSpMkLst>
        </pc:grpChg>
        <pc:grpChg chg="mod">
          <ac:chgData name="Narang, Sonali" userId="9e80b397-6e2f-49b1-9374-ccdad8589140" providerId="ADAL" clId="{0A0D2314-D59C-5A4C-9E09-78A254E3BB4B}" dt="2021-10-01T16:51:20.578" v="2971" actId="1076"/>
          <ac:grpSpMkLst>
            <pc:docMk/>
            <pc:sldMk cId="1854626235" sldId="257"/>
            <ac:grpSpMk id="37" creationId="{083D8F37-8390-5541-85CA-5DB8B6ACA03B}"/>
          </ac:grpSpMkLst>
        </pc:grpChg>
        <pc:grpChg chg="del mod">
          <ac:chgData name="Narang, Sonali" userId="9e80b397-6e2f-49b1-9374-ccdad8589140" providerId="ADAL" clId="{0A0D2314-D59C-5A4C-9E09-78A254E3BB4B}" dt="2021-10-01T16:50:49.628" v="2963" actId="21"/>
          <ac:grpSpMkLst>
            <pc:docMk/>
            <pc:sldMk cId="1854626235" sldId="257"/>
            <ac:grpSpMk id="94" creationId="{AEE6DF85-0659-484C-AB45-73FA6E20C5C4}"/>
          </ac:grpSpMkLst>
        </pc:grpChg>
        <pc:picChg chg="add mod">
          <ac:chgData name="Narang, Sonali" userId="9e80b397-6e2f-49b1-9374-ccdad8589140" providerId="ADAL" clId="{0A0D2314-D59C-5A4C-9E09-78A254E3BB4B}" dt="2021-09-30T19:25:41.215" v="2304" actId="1035"/>
          <ac:picMkLst>
            <pc:docMk/>
            <pc:sldMk cId="1854626235" sldId="257"/>
            <ac:picMk id="3" creationId="{BD3CD7DF-0565-8E43-8606-2D54B4F82EE0}"/>
          </ac:picMkLst>
        </pc:picChg>
        <pc:picChg chg="add mod">
          <ac:chgData name="Narang, Sonali" userId="9e80b397-6e2f-49b1-9374-ccdad8589140" providerId="ADAL" clId="{0A0D2314-D59C-5A4C-9E09-78A254E3BB4B}" dt="2021-10-01T16:52:30.915" v="2985" actId="1076"/>
          <ac:picMkLst>
            <pc:docMk/>
            <pc:sldMk cId="1854626235" sldId="257"/>
            <ac:picMk id="10" creationId="{9207B711-ECE0-6148-9095-5E74B5385440}"/>
          </ac:picMkLst>
        </pc:picChg>
        <pc:picChg chg="add mod">
          <ac:chgData name="Narang, Sonali" userId="9e80b397-6e2f-49b1-9374-ccdad8589140" providerId="ADAL" clId="{0A0D2314-D59C-5A4C-9E09-78A254E3BB4B}" dt="2021-10-01T16:52:26.961" v="2984" actId="1076"/>
          <ac:picMkLst>
            <pc:docMk/>
            <pc:sldMk cId="1854626235" sldId="257"/>
            <ac:picMk id="12" creationId="{D0F39CAB-5EF2-4E4D-A638-29E753D6ECCC}"/>
          </ac:picMkLst>
        </pc:picChg>
        <pc:picChg chg="mod">
          <ac:chgData name="Narang, Sonali" userId="9e80b397-6e2f-49b1-9374-ccdad8589140" providerId="ADAL" clId="{0A0D2314-D59C-5A4C-9E09-78A254E3BB4B}" dt="2021-09-30T19:20:00.209" v="2229" actId="1036"/>
          <ac:picMkLst>
            <pc:docMk/>
            <pc:sldMk cId="1854626235" sldId="257"/>
            <ac:picMk id="14" creationId="{681572D7-6CDF-C840-9149-C3423BBB2368}"/>
          </ac:picMkLst>
        </pc:picChg>
        <pc:picChg chg="del">
          <ac:chgData name="Narang, Sonali" userId="9e80b397-6e2f-49b1-9374-ccdad8589140" providerId="ADAL" clId="{0A0D2314-D59C-5A4C-9E09-78A254E3BB4B}" dt="2021-09-30T19:16:26.063" v="2084" actId="478"/>
          <ac:picMkLst>
            <pc:docMk/>
            <pc:sldMk cId="1854626235" sldId="257"/>
            <ac:picMk id="15" creationId="{0C43366B-74AB-8345-B18D-005DC6F48F33}"/>
          </ac:picMkLst>
        </pc:picChg>
        <pc:picChg chg="del">
          <ac:chgData name="Narang, Sonali" userId="9e80b397-6e2f-49b1-9374-ccdad8589140" providerId="ADAL" clId="{0A0D2314-D59C-5A4C-9E09-78A254E3BB4B}" dt="2021-09-30T19:16:26.063" v="2084" actId="478"/>
          <ac:picMkLst>
            <pc:docMk/>
            <pc:sldMk cId="1854626235" sldId="257"/>
            <ac:picMk id="17" creationId="{53A6B32B-C740-944C-8420-B07C6C3D680F}"/>
          </ac:picMkLst>
        </pc:picChg>
        <pc:picChg chg="del">
          <ac:chgData name="Narang, Sonali" userId="9e80b397-6e2f-49b1-9374-ccdad8589140" providerId="ADAL" clId="{0A0D2314-D59C-5A4C-9E09-78A254E3BB4B}" dt="2021-09-30T19:16:26.063" v="2084" actId="478"/>
          <ac:picMkLst>
            <pc:docMk/>
            <pc:sldMk cId="1854626235" sldId="257"/>
            <ac:picMk id="19" creationId="{CE56F4A1-920C-8541-8AA7-1EEC1D2CABE5}"/>
          </ac:picMkLst>
        </pc:picChg>
        <pc:picChg chg="add mod modCrop">
          <ac:chgData name="Narang, Sonali" userId="9e80b397-6e2f-49b1-9374-ccdad8589140" providerId="ADAL" clId="{0A0D2314-D59C-5A4C-9E09-78A254E3BB4B}" dt="2021-11-03T14:06:35.487" v="3759" actId="1076"/>
          <ac:picMkLst>
            <pc:docMk/>
            <pc:sldMk cId="1854626235" sldId="257"/>
            <ac:picMk id="72" creationId="{AB1493E7-8303-BE4D-B96A-6EDA57620CCD}"/>
          </ac:picMkLst>
        </pc:picChg>
        <pc:picChg chg="mod modCrop">
          <ac:chgData name="Narang, Sonali" userId="9e80b397-6e2f-49b1-9374-ccdad8589140" providerId="ADAL" clId="{0A0D2314-D59C-5A4C-9E09-78A254E3BB4B}" dt="2021-11-03T14:06:50.116" v="3761" actId="732"/>
          <ac:picMkLst>
            <pc:docMk/>
            <pc:sldMk cId="1854626235" sldId="257"/>
            <ac:picMk id="91" creationId="{06D63945-83A0-5C46-BB62-843DD22FD7F6}"/>
          </ac:picMkLst>
        </pc:picChg>
        <pc:picChg chg="add mod">
          <ac:chgData name="Narang, Sonali" userId="9e80b397-6e2f-49b1-9374-ccdad8589140" providerId="ADAL" clId="{0A0D2314-D59C-5A4C-9E09-78A254E3BB4B}" dt="2021-10-01T16:52:34.845" v="2988" actId="1037"/>
          <ac:picMkLst>
            <pc:docMk/>
            <pc:sldMk cId="1854626235" sldId="257"/>
            <ac:picMk id="92" creationId="{C36DDAB6-9373-B94D-A081-5989767880BD}"/>
          </ac:picMkLst>
        </pc:picChg>
        <pc:picChg chg="add mod">
          <ac:chgData name="Narang, Sonali" userId="9e80b397-6e2f-49b1-9374-ccdad8589140" providerId="ADAL" clId="{0A0D2314-D59C-5A4C-9E09-78A254E3BB4B}" dt="2021-10-01T16:51:31.403" v="2975" actId="167"/>
          <ac:picMkLst>
            <pc:docMk/>
            <pc:sldMk cId="1854626235" sldId="257"/>
            <ac:picMk id="93" creationId="{8B06C99B-009E-C246-9F27-4E7DB4B9E545}"/>
          </ac:picMkLst>
        </pc:picChg>
        <pc:picChg chg="add mod">
          <ac:chgData name="Narang, Sonali" userId="9e80b397-6e2f-49b1-9374-ccdad8589140" providerId="ADAL" clId="{0A0D2314-D59C-5A4C-9E09-78A254E3BB4B}" dt="2021-10-01T16:51:33.710" v="2976" actId="167"/>
          <ac:picMkLst>
            <pc:docMk/>
            <pc:sldMk cId="1854626235" sldId="257"/>
            <ac:picMk id="95" creationId="{53B17A5D-C3AE-5544-9BBA-AFC9E02D9677}"/>
          </ac:picMkLst>
        </pc:picChg>
        <pc:picChg chg="mod">
          <ac:chgData name="Narang, Sonali" userId="9e80b397-6e2f-49b1-9374-ccdad8589140" providerId="ADAL" clId="{0A0D2314-D59C-5A4C-9E09-78A254E3BB4B}" dt="2021-10-01T16:51:20.578" v="2971" actId="1076"/>
          <ac:picMkLst>
            <pc:docMk/>
            <pc:sldMk cId="1854626235" sldId="257"/>
            <ac:picMk id="109" creationId="{83518A59-DE1F-C64E-95A4-9EE0523C4D94}"/>
          </ac:picMkLst>
        </pc:picChg>
        <pc:picChg chg="mod">
          <ac:chgData name="Narang, Sonali" userId="9e80b397-6e2f-49b1-9374-ccdad8589140" providerId="ADAL" clId="{0A0D2314-D59C-5A4C-9E09-78A254E3BB4B}" dt="2021-10-01T16:51:20.578" v="2971" actId="1076"/>
          <ac:picMkLst>
            <pc:docMk/>
            <pc:sldMk cId="1854626235" sldId="257"/>
            <ac:picMk id="111" creationId="{3DBF3880-6CBA-8041-B9CD-F2A215E3C8DD}"/>
          </ac:picMkLst>
        </pc:picChg>
        <pc:picChg chg="mod">
          <ac:chgData name="Narang, Sonali" userId="9e80b397-6e2f-49b1-9374-ccdad8589140" providerId="ADAL" clId="{0A0D2314-D59C-5A4C-9E09-78A254E3BB4B}" dt="2021-10-01T16:51:20.578" v="2971" actId="1076"/>
          <ac:picMkLst>
            <pc:docMk/>
            <pc:sldMk cId="1854626235" sldId="257"/>
            <ac:picMk id="112" creationId="{6B6DD000-238E-8F48-B8CA-73434CB731ED}"/>
          </ac:picMkLst>
        </pc:picChg>
        <pc:picChg chg="mod">
          <ac:chgData name="Narang, Sonali" userId="9e80b397-6e2f-49b1-9374-ccdad8589140" providerId="ADAL" clId="{0A0D2314-D59C-5A4C-9E09-78A254E3BB4B}" dt="2021-11-03T14:08:25.153" v="3771" actId="1076"/>
          <ac:picMkLst>
            <pc:docMk/>
            <pc:sldMk cId="1854626235" sldId="257"/>
            <ac:picMk id="117" creationId="{5AF2AB47-DAE2-F643-8CDC-5611248A02A7}"/>
          </ac:picMkLst>
        </pc:picChg>
      </pc:sldChg>
      <pc:sldChg chg="addSp delSp modSp mod ord">
        <pc:chgData name="Narang, Sonali" userId="9e80b397-6e2f-49b1-9374-ccdad8589140" providerId="ADAL" clId="{0A0D2314-D59C-5A4C-9E09-78A254E3BB4B}" dt="2021-11-04T20:50:12.072" v="4701" actId="20577"/>
        <pc:sldMkLst>
          <pc:docMk/>
          <pc:sldMk cId="1155223781" sldId="258"/>
        </pc:sldMkLst>
        <pc:spChg chg="add mod">
          <ac:chgData name="Narang, Sonali" userId="9e80b397-6e2f-49b1-9374-ccdad8589140" providerId="ADAL" clId="{0A0D2314-D59C-5A4C-9E09-78A254E3BB4B}" dt="2021-11-02T19:42:06.149" v="3722" actId="20577"/>
          <ac:spMkLst>
            <pc:docMk/>
            <pc:sldMk cId="1155223781" sldId="258"/>
            <ac:spMk id="2" creationId="{13096F00-9D05-944B-BA69-2B04C7E9EDAD}"/>
          </ac:spMkLst>
        </pc:spChg>
        <pc:spChg chg="add del mod">
          <ac:chgData name="Narang, Sonali" userId="9e80b397-6e2f-49b1-9374-ccdad8589140" providerId="ADAL" clId="{0A0D2314-D59C-5A4C-9E09-78A254E3BB4B}" dt="2021-08-31T21:14:17.286" v="1096" actId="478"/>
          <ac:spMkLst>
            <pc:docMk/>
            <pc:sldMk cId="1155223781" sldId="258"/>
            <ac:spMk id="2" creationId="{58105E8E-DBFA-DB44-8313-C55C7C956A6F}"/>
          </ac:spMkLst>
        </pc:spChg>
        <pc:spChg chg="mod">
          <ac:chgData name="Narang, Sonali" userId="9e80b397-6e2f-49b1-9374-ccdad8589140" providerId="ADAL" clId="{0A0D2314-D59C-5A4C-9E09-78A254E3BB4B}" dt="2021-11-04T20:50:12.072" v="4701" actId="20577"/>
          <ac:spMkLst>
            <pc:docMk/>
            <pc:sldMk cId="1155223781" sldId="258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11-02T15:50:13.756" v="3245" actId="1038"/>
          <ac:spMkLst>
            <pc:docMk/>
            <pc:sldMk cId="1155223781" sldId="258"/>
            <ac:spMk id="6" creationId="{41464C80-B659-484D-A16F-8018DEC5471A}"/>
          </ac:spMkLst>
        </pc:spChg>
        <pc:spChg chg="mod">
          <ac:chgData name="Narang, Sonali" userId="9e80b397-6e2f-49b1-9374-ccdad8589140" providerId="ADAL" clId="{0A0D2314-D59C-5A4C-9E09-78A254E3BB4B}" dt="2021-11-02T15:50:03.736" v="3236" actId="1035"/>
          <ac:spMkLst>
            <pc:docMk/>
            <pc:sldMk cId="1155223781" sldId="258"/>
            <ac:spMk id="7" creationId="{4C5F5CAE-FBFD-964D-A356-746AAC86DC9E}"/>
          </ac:spMkLst>
        </pc:spChg>
        <pc:spChg chg="del mod">
          <ac:chgData name="Narang, Sonali" userId="9e80b397-6e2f-49b1-9374-ccdad8589140" providerId="ADAL" clId="{0A0D2314-D59C-5A4C-9E09-78A254E3BB4B}" dt="2021-11-02T15:49:42.384" v="3223" actId="478"/>
          <ac:spMkLst>
            <pc:docMk/>
            <pc:sldMk cId="1155223781" sldId="258"/>
            <ac:spMk id="8" creationId="{8A9BAE78-C4FF-1843-94F6-3410EB884848}"/>
          </ac:spMkLst>
        </pc:spChg>
        <pc:spChg chg="del mod">
          <ac:chgData name="Narang, Sonali" userId="9e80b397-6e2f-49b1-9374-ccdad8589140" providerId="ADAL" clId="{0A0D2314-D59C-5A4C-9E09-78A254E3BB4B}" dt="2021-08-31T19:52:20.698" v="14" actId="21"/>
          <ac:spMkLst>
            <pc:docMk/>
            <pc:sldMk cId="1155223781" sldId="258"/>
            <ac:spMk id="12" creationId="{804B0FA4-BEC3-674A-8EFA-E6EB5541FC86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17" creationId="{BBD8CBF7-1C05-AF41-9BBB-F5ECF4B13F68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18" creationId="{878F966E-E941-5541-8AD0-ADD821ACF2E7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22" creationId="{4C5B584F-5881-4042-98AF-D7F43F89B509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23" creationId="{B077A992-1085-CB4A-A977-762F94B68D1C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27" creationId="{B48DE5D7-E0DD-8B4F-85AB-FA57E4486418}"/>
          </ac:spMkLst>
        </pc:spChg>
        <pc:spChg chg="mod">
          <ac:chgData name="Narang, Sonali" userId="9e80b397-6e2f-49b1-9374-ccdad8589140" providerId="ADAL" clId="{0A0D2314-D59C-5A4C-9E09-78A254E3BB4B}" dt="2021-08-31T20:00:23.774" v="219"/>
          <ac:spMkLst>
            <pc:docMk/>
            <pc:sldMk cId="1155223781" sldId="258"/>
            <ac:spMk id="28" creationId="{E8019BF5-6FE6-804C-8650-55C6137EA0E9}"/>
          </ac:spMkLst>
        </pc:spChg>
        <pc:spChg chg="add del mod">
          <ac:chgData name="Narang, Sonali" userId="9e80b397-6e2f-49b1-9374-ccdad8589140" providerId="ADAL" clId="{0A0D2314-D59C-5A4C-9E09-78A254E3BB4B}" dt="2021-11-02T15:49:59.756" v="3230" actId="478"/>
          <ac:spMkLst>
            <pc:docMk/>
            <pc:sldMk cId="1155223781" sldId="258"/>
            <ac:spMk id="30" creationId="{655ACA25-EBE0-DD45-930F-AD76C4C0A2A8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2" creationId="{8C2A0FE4-DCE7-714B-B72E-0B54F12A3880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3" creationId="{C732AF6E-A205-D849-8F98-05F27C157AE6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6" creationId="{CED63E59-2181-E94A-9EA3-55661FF9C194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7" creationId="{8B5EFF90-3ECA-284D-978F-76D7C425B772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8" creationId="{21875AB5-5E92-134A-8236-5ACF529922BA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39" creationId="{EEA44162-67BA-BE4E-87A0-CE62A3BB4A48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0" creationId="{BAF78244-5016-B14F-BF7E-14FEED12F28A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1" creationId="{04F08456-DDB3-6743-A08E-FF2AE70C5108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3" creationId="{80550978-24C0-3343-83A5-8C1A9BAE7634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4" creationId="{1DCDF1E7-F2D5-7040-8B69-A9D74ED63E9D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5" creationId="{0EECBD3B-E09F-6A4A-85ED-701545048DDA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6" creationId="{DA1162E1-4AFD-CB46-A7EE-BE6EE201DCAB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7" creationId="{EA48E1D2-7D85-BC4B-8305-622111AA60CF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8" creationId="{B4179409-2FD8-7C4E-AC9F-D25DB456593D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49" creationId="{1F5B7F0C-765C-174A-8D4A-2F5F300226DF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0" creationId="{0F0B45AA-52DB-1447-8A33-BBF5E33B5452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1" creationId="{E015A8BF-3A6B-9D4E-8103-F499E63459D8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2" creationId="{980B69CD-ADC7-284F-A16B-05F87958BC66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4" creationId="{630EF4BB-5676-3B48-8C65-19F74E7421C4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5" creationId="{F988E475-74C4-3C4F-9891-2EA2F939D523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6" creationId="{D63EC677-39AE-414C-9352-563C974F82EA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7" creationId="{057C0F8D-04C2-0542-8ABC-5B2FE168C537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8" creationId="{5BD00D48-3568-4142-9CE5-0DD04E862D3C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59" creationId="{EB23BEA0-6350-324D-A12E-7DEB49AF3BE8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60" creationId="{E62460AA-D9B6-E345-A0C7-8FBD7230EDC2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61" creationId="{FC1C0D10-87A7-4243-8678-5514D2F29956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62" creationId="{82C2B934-697C-EA44-BEC5-478C948B0590}"/>
          </ac:spMkLst>
        </pc:spChg>
        <pc:spChg chg="mod">
          <ac:chgData name="Narang, Sonali" userId="9e80b397-6e2f-49b1-9374-ccdad8589140" providerId="ADAL" clId="{0A0D2314-D59C-5A4C-9E09-78A254E3BB4B}" dt="2021-08-31T20:03:30.939" v="266"/>
          <ac:spMkLst>
            <pc:docMk/>
            <pc:sldMk cId="1155223781" sldId="258"/>
            <ac:spMk id="63" creationId="{C9C6D42A-C6D9-7849-8C5B-4178D8D71A28}"/>
          </ac:spMkLst>
        </pc:spChg>
        <pc:grpChg chg="add del mod">
          <ac:chgData name="Narang, Sonali" userId="9e80b397-6e2f-49b1-9374-ccdad8589140" providerId="ADAL" clId="{0A0D2314-D59C-5A4C-9E09-78A254E3BB4B}" dt="2021-08-31T21:13:27.381" v="1083" actId="478"/>
          <ac:grpSpMkLst>
            <pc:docMk/>
            <pc:sldMk cId="1155223781" sldId="258"/>
            <ac:grpSpMk id="14" creationId="{86D7D6E9-6736-D243-B10A-A0E8A40C0FDA}"/>
          </ac:grpSpMkLst>
        </pc:grpChg>
        <pc:grpChg chg="mod">
          <ac:chgData name="Narang, Sonali" userId="9e80b397-6e2f-49b1-9374-ccdad8589140" providerId="ADAL" clId="{0A0D2314-D59C-5A4C-9E09-78A254E3BB4B}" dt="2021-08-31T20:00:23.774" v="219"/>
          <ac:grpSpMkLst>
            <pc:docMk/>
            <pc:sldMk cId="1155223781" sldId="258"/>
            <ac:grpSpMk id="16" creationId="{140C3F92-990D-8442-AA05-B4737244BEDA}"/>
          </ac:grpSpMkLst>
        </pc:grpChg>
        <pc:grpChg chg="add del mod">
          <ac:chgData name="Narang, Sonali" userId="9e80b397-6e2f-49b1-9374-ccdad8589140" providerId="ADAL" clId="{0A0D2314-D59C-5A4C-9E09-78A254E3BB4B}" dt="2021-08-31T21:13:27.381" v="1083" actId="478"/>
          <ac:grpSpMkLst>
            <pc:docMk/>
            <pc:sldMk cId="1155223781" sldId="258"/>
            <ac:grpSpMk id="19" creationId="{6FB40037-B603-9443-A847-58CB44679B55}"/>
          </ac:grpSpMkLst>
        </pc:grpChg>
        <pc:grpChg chg="mod">
          <ac:chgData name="Narang, Sonali" userId="9e80b397-6e2f-49b1-9374-ccdad8589140" providerId="ADAL" clId="{0A0D2314-D59C-5A4C-9E09-78A254E3BB4B}" dt="2021-08-31T20:00:23.774" v="219"/>
          <ac:grpSpMkLst>
            <pc:docMk/>
            <pc:sldMk cId="1155223781" sldId="258"/>
            <ac:grpSpMk id="21" creationId="{71FDB170-95C4-3F41-A7F7-0DB5E53A97D8}"/>
          </ac:grpSpMkLst>
        </pc:grpChg>
        <pc:grpChg chg="add del mod">
          <ac:chgData name="Narang, Sonali" userId="9e80b397-6e2f-49b1-9374-ccdad8589140" providerId="ADAL" clId="{0A0D2314-D59C-5A4C-9E09-78A254E3BB4B}" dt="2021-08-31T21:13:27.381" v="1083" actId="478"/>
          <ac:grpSpMkLst>
            <pc:docMk/>
            <pc:sldMk cId="1155223781" sldId="258"/>
            <ac:grpSpMk id="24" creationId="{27C39882-C3D6-6943-83E0-2D2C3AC6B4EE}"/>
          </ac:grpSpMkLst>
        </pc:grpChg>
        <pc:grpChg chg="mod">
          <ac:chgData name="Narang, Sonali" userId="9e80b397-6e2f-49b1-9374-ccdad8589140" providerId="ADAL" clId="{0A0D2314-D59C-5A4C-9E09-78A254E3BB4B}" dt="2021-08-31T20:00:23.774" v="219"/>
          <ac:grpSpMkLst>
            <pc:docMk/>
            <pc:sldMk cId="1155223781" sldId="258"/>
            <ac:grpSpMk id="26" creationId="{A41E4998-C619-524B-8914-B19A9F67619C}"/>
          </ac:grpSpMkLst>
        </pc:grpChg>
        <pc:grpChg chg="add del mod">
          <ac:chgData name="Narang, Sonali" userId="9e80b397-6e2f-49b1-9374-ccdad8589140" providerId="ADAL" clId="{0A0D2314-D59C-5A4C-9E09-78A254E3BB4B}" dt="2021-08-31T21:13:27.381" v="1083" actId="478"/>
          <ac:grpSpMkLst>
            <pc:docMk/>
            <pc:sldMk cId="1155223781" sldId="258"/>
            <ac:grpSpMk id="31" creationId="{D470D811-2477-3546-A8D8-048846B3651A}"/>
          </ac:grpSpMkLst>
        </pc:grpChg>
        <pc:grpChg chg="mod">
          <ac:chgData name="Narang, Sonali" userId="9e80b397-6e2f-49b1-9374-ccdad8589140" providerId="ADAL" clId="{0A0D2314-D59C-5A4C-9E09-78A254E3BB4B}" dt="2021-08-31T20:03:30.939" v="266"/>
          <ac:grpSpMkLst>
            <pc:docMk/>
            <pc:sldMk cId="1155223781" sldId="258"/>
            <ac:grpSpMk id="34" creationId="{88C754A9-AA55-D74F-8DE3-1C8CF5775FCB}"/>
          </ac:grpSpMkLst>
        </pc:grpChg>
        <pc:grpChg chg="mod">
          <ac:chgData name="Narang, Sonali" userId="9e80b397-6e2f-49b1-9374-ccdad8589140" providerId="ADAL" clId="{0A0D2314-D59C-5A4C-9E09-78A254E3BB4B}" dt="2021-08-31T20:03:30.939" v="266"/>
          <ac:grpSpMkLst>
            <pc:docMk/>
            <pc:sldMk cId="1155223781" sldId="258"/>
            <ac:grpSpMk id="35" creationId="{BF559D91-1CC8-3C4E-BAB1-6D863937C698}"/>
          </ac:grpSpMkLst>
        </pc:grpChg>
        <pc:grpChg chg="mod">
          <ac:chgData name="Narang, Sonali" userId="9e80b397-6e2f-49b1-9374-ccdad8589140" providerId="ADAL" clId="{0A0D2314-D59C-5A4C-9E09-78A254E3BB4B}" dt="2021-08-31T20:03:30.939" v="266"/>
          <ac:grpSpMkLst>
            <pc:docMk/>
            <pc:sldMk cId="1155223781" sldId="258"/>
            <ac:grpSpMk id="42" creationId="{C0BD0F15-50EB-F241-90E6-7D10B0342F29}"/>
          </ac:grpSpMkLst>
        </pc:grpChg>
        <pc:grpChg chg="mod">
          <ac:chgData name="Narang, Sonali" userId="9e80b397-6e2f-49b1-9374-ccdad8589140" providerId="ADAL" clId="{0A0D2314-D59C-5A4C-9E09-78A254E3BB4B}" dt="2021-08-31T20:03:30.939" v="266"/>
          <ac:grpSpMkLst>
            <pc:docMk/>
            <pc:sldMk cId="1155223781" sldId="258"/>
            <ac:grpSpMk id="53" creationId="{C4E9D8D4-FC13-7D45-B882-3D7E3B934C3E}"/>
          </ac:grpSpMkLst>
        </pc:grpChg>
        <pc:picChg chg="del mod">
          <ac:chgData name="Narang, Sonali" userId="9e80b397-6e2f-49b1-9374-ccdad8589140" providerId="ADAL" clId="{0A0D2314-D59C-5A4C-9E09-78A254E3BB4B}" dt="2021-08-31T19:52:20.698" v="14" actId="21"/>
          <ac:picMkLst>
            <pc:docMk/>
            <pc:sldMk cId="1155223781" sldId="258"/>
            <ac:picMk id="3" creationId="{D49EBF3A-936F-A84B-BFCB-0F6E673B1E30}"/>
          </ac:picMkLst>
        </pc:picChg>
        <pc:picChg chg="mod">
          <ac:chgData name="Narang, Sonali" userId="9e80b397-6e2f-49b1-9374-ccdad8589140" providerId="ADAL" clId="{0A0D2314-D59C-5A4C-9E09-78A254E3BB4B}" dt="2021-08-31T19:57:33.654" v="151" actId="1076"/>
          <ac:picMkLst>
            <pc:docMk/>
            <pc:sldMk cId="1155223781" sldId="258"/>
            <ac:picMk id="9" creationId="{CE344B95-A4B4-8E48-8BA1-DBCEB948F1E4}"/>
          </ac:picMkLst>
        </pc:picChg>
        <pc:picChg chg="mod">
          <ac:chgData name="Narang, Sonali" userId="9e80b397-6e2f-49b1-9374-ccdad8589140" providerId="ADAL" clId="{0A0D2314-D59C-5A4C-9E09-78A254E3BB4B}" dt="2021-11-02T15:50:10.232" v="3237" actId="1076"/>
          <ac:picMkLst>
            <pc:docMk/>
            <pc:sldMk cId="1155223781" sldId="258"/>
            <ac:picMk id="10" creationId="{8F08C599-E1EB-3044-A41D-ED696091AEE1}"/>
          </ac:picMkLst>
        </pc:picChg>
        <pc:picChg chg="mod">
          <ac:chgData name="Narang, Sonali" userId="9e80b397-6e2f-49b1-9374-ccdad8589140" providerId="ADAL" clId="{0A0D2314-D59C-5A4C-9E09-78A254E3BB4B}" dt="2021-11-02T15:50:10.232" v="3237" actId="1076"/>
          <ac:picMkLst>
            <pc:docMk/>
            <pc:sldMk cId="1155223781" sldId="258"/>
            <ac:picMk id="11" creationId="{49516C8B-9616-3B4D-A203-229E3B7B51D9}"/>
          </ac:picMkLst>
        </pc:picChg>
        <pc:picChg chg="add del mod">
          <ac:chgData name="Narang, Sonali" userId="9e80b397-6e2f-49b1-9374-ccdad8589140" providerId="ADAL" clId="{0A0D2314-D59C-5A4C-9E09-78A254E3BB4B}" dt="2021-11-02T15:49:49.452" v="3228" actId="478"/>
          <ac:picMkLst>
            <pc:docMk/>
            <pc:sldMk cId="1155223781" sldId="258"/>
            <ac:picMk id="13" creationId="{A153BDA0-96B4-6B49-9040-4624ADB95ED3}"/>
          </ac:picMkLst>
        </pc:picChg>
        <pc:picChg chg="mod">
          <ac:chgData name="Narang, Sonali" userId="9e80b397-6e2f-49b1-9374-ccdad8589140" providerId="ADAL" clId="{0A0D2314-D59C-5A4C-9E09-78A254E3BB4B}" dt="2021-08-31T20:00:23.774" v="219"/>
          <ac:picMkLst>
            <pc:docMk/>
            <pc:sldMk cId="1155223781" sldId="258"/>
            <ac:picMk id="15" creationId="{FF5D0901-4885-4B41-A2F6-D45CB0AB4EFD}"/>
          </ac:picMkLst>
        </pc:picChg>
        <pc:picChg chg="mod">
          <ac:chgData name="Narang, Sonali" userId="9e80b397-6e2f-49b1-9374-ccdad8589140" providerId="ADAL" clId="{0A0D2314-D59C-5A4C-9E09-78A254E3BB4B}" dt="2021-08-31T20:00:23.774" v="219"/>
          <ac:picMkLst>
            <pc:docMk/>
            <pc:sldMk cId="1155223781" sldId="258"/>
            <ac:picMk id="20" creationId="{EA6DC1A4-E7E3-6E4F-A761-4DEEC6DFC0BB}"/>
          </ac:picMkLst>
        </pc:picChg>
        <pc:picChg chg="mod">
          <ac:chgData name="Narang, Sonali" userId="9e80b397-6e2f-49b1-9374-ccdad8589140" providerId="ADAL" clId="{0A0D2314-D59C-5A4C-9E09-78A254E3BB4B}" dt="2021-08-31T20:00:23.774" v="219"/>
          <ac:picMkLst>
            <pc:docMk/>
            <pc:sldMk cId="1155223781" sldId="258"/>
            <ac:picMk id="25" creationId="{47AAE066-6BE5-CE40-85DF-F811520DF86F}"/>
          </ac:picMkLst>
        </pc:picChg>
        <pc:picChg chg="add del mod">
          <ac:chgData name="Narang, Sonali" userId="9e80b397-6e2f-49b1-9374-ccdad8589140" providerId="ADAL" clId="{0A0D2314-D59C-5A4C-9E09-78A254E3BB4B}" dt="2021-08-31T21:13:27.381" v="1083" actId="478"/>
          <ac:picMkLst>
            <pc:docMk/>
            <pc:sldMk cId="1155223781" sldId="258"/>
            <ac:picMk id="29" creationId="{C6A5DB04-6ED8-E242-A11D-80CB8283A7EA}"/>
          </ac:picMkLst>
        </pc:picChg>
        <pc:picChg chg="add mod">
          <ac:chgData name="Narang, Sonali" userId="9e80b397-6e2f-49b1-9374-ccdad8589140" providerId="ADAL" clId="{0A0D2314-D59C-5A4C-9E09-78A254E3BB4B}" dt="2021-11-02T15:49:55.718" v="3229" actId="1076"/>
          <ac:picMkLst>
            <pc:docMk/>
            <pc:sldMk cId="1155223781" sldId="258"/>
            <ac:picMk id="64" creationId="{F64170D4-AD39-6E41-B3C6-F2183A925A2E}"/>
          </ac:picMkLst>
        </pc:picChg>
        <pc:picChg chg="add mod">
          <ac:chgData name="Narang, Sonali" userId="9e80b397-6e2f-49b1-9374-ccdad8589140" providerId="ADAL" clId="{0A0D2314-D59C-5A4C-9E09-78A254E3BB4B}" dt="2021-11-02T15:49:55.718" v="3229" actId="1076"/>
          <ac:picMkLst>
            <pc:docMk/>
            <pc:sldMk cId="1155223781" sldId="258"/>
            <ac:picMk id="65" creationId="{F660B100-D24F-D145-8E9B-D3B0C1D6ED83}"/>
          </ac:picMkLst>
        </pc:picChg>
        <pc:picChg chg="add mod">
          <ac:chgData name="Narang, Sonali" userId="9e80b397-6e2f-49b1-9374-ccdad8589140" providerId="ADAL" clId="{0A0D2314-D59C-5A4C-9E09-78A254E3BB4B}" dt="2021-11-02T15:49:55.718" v="3229" actId="1076"/>
          <ac:picMkLst>
            <pc:docMk/>
            <pc:sldMk cId="1155223781" sldId="258"/>
            <ac:picMk id="66" creationId="{DA560F45-414B-1D48-AB88-6A33A254C80C}"/>
          </ac:picMkLst>
        </pc:picChg>
      </pc:sldChg>
      <pc:sldChg chg="addSp modSp del mod">
        <pc:chgData name="Narang, Sonali" userId="9e80b397-6e2f-49b1-9374-ccdad8589140" providerId="ADAL" clId="{0A0D2314-D59C-5A4C-9E09-78A254E3BB4B}" dt="2021-09-01T21:36:54.861" v="1717" actId="2696"/>
        <pc:sldMkLst>
          <pc:docMk/>
          <pc:sldMk cId="209215240" sldId="259"/>
        </pc:sldMkLst>
        <pc:spChg chg="add mod">
          <ac:chgData name="Narang, Sonali" userId="9e80b397-6e2f-49b1-9374-ccdad8589140" providerId="ADAL" clId="{0A0D2314-D59C-5A4C-9E09-78A254E3BB4B}" dt="2021-08-31T19:52:23.612" v="16" actId="1076"/>
          <ac:spMkLst>
            <pc:docMk/>
            <pc:sldMk cId="209215240" sldId="259"/>
            <ac:spMk id="16" creationId="{0F6A42A7-6B13-0C48-A262-028D2B1C86F7}"/>
          </ac:spMkLst>
        </pc:spChg>
        <pc:picChg chg="mod">
          <ac:chgData name="Narang, Sonali" userId="9e80b397-6e2f-49b1-9374-ccdad8589140" providerId="ADAL" clId="{0A0D2314-D59C-5A4C-9E09-78A254E3BB4B}" dt="2021-09-01T21:36:26.388" v="1715" actId="1076"/>
          <ac:picMkLst>
            <pc:docMk/>
            <pc:sldMk cId="209215240" sldId="259"/>
            <ac:picMk id="13" creationId="{C8748E8A-87FA-1D4C-A3AD-8DA8B7A14462}"/>
          </ac:picMkLst>
        </pc:picChg>
        <pc:picChg chg="add mod">
          <ac:chgData name="Narang, Sonali" userId="9e80b397-6e2f-49b1-9374-ccdad8589140" providerId="ADAL" clId="{0A0D2314-D59C-5A4C-9E09-78A254E3BB4B}" dt="2021-08-31T19:52:23.612" v="16" actId="1076"/>
          <ac:picMkLst>
            <pc:docMk/>
            <pc:sldMk cId="209215240" sldId="259"/>
            <ac:picMk id="15" creationId="{5717CA67-8BAC-F645-BC94-7938FC447866}"/>
          </ac:picMkLst>
        </pc:picChg>
      </pc:sldChg>
      <pc:sldChg chg="addSp delSp modSp del mod">
        <pc:chgData name="Narang, Sonali" userId="9e80b397-6e2f-49b1-9374-ccdad8589140" providerId="ADAL" clId="{0A0D2314-D59C-5A4C-9E09-78A254E3BB4B}" dt="2021-09-01T21:36:59.509" v="1720" actId="2696"/>
        <pc:sldMkLst>
          <pc:docMk/>
          <pc:sldMk cId="2209615388" sldId="260"/>
        </pc:sldMkLst>
        <pc:picChg chg="del">
          <ac:chgData name="Narang, Sonali" userId="9e80b397-6e2f-49b1-9374-ccdad8589140" providerId="ADAL" clId="{0A0D2314-D59C-5A4C-9E09-78A254E3BB4B}" dt="2021-08-31T21:17:35.306" v="1143" actId="478"/>
          <ac:picMkLst>
            <pc:docMk/>
            <pc:sldMk cId="2209615388" sldId="260"/>
            <ac:picMk id="15" creationId="{102B2DA4-BF6C-B44F-BFD4-34128031542E}"/>
          </ac:picMkLst>
        </pc:picChg>
        <pc:picChg chg="del">
          <ac:chgData name="Narang, Sonali" userId="9e80b397-6e2f-49b1-9374-ccdad8589140" providerId="ADAL" clId="{0A0D2314-D59C-5A4C-9E09-78A254E3BB4B}" dt="2021-08-31T21:17:35.306" v="1143" actId="478"/>
          <ac:picMkLst>
            <pc:docMk/>
            <pc:sldMk cId="2209615388" sldId="260"/>
            <ac:picMk id="17" creationId="{52D1DD20-D46E-6048-80AC-3F937064F5A2}"/>
          </ac:picMkLst>
        </pc:picChg>
        <pc:picChg chg="del">
          <ac:chgData name="Narang, Sonali" userId="9e80b397-6e2f-49b1-9374-ccdad8589140" providerId="ADAL" clId="{0A0D2314-D59C-5A4C-9E09-78A254E3BB4B}" dt="2021-08-31T21:17:35.306" v="1143" actId="478"/>
          <ac:picMkLst>
            <pc:docMk/>
            <pc:sldMk cId="2209615388" sldId="260"/>
            <ac:picMk id="19" creationId="{FDFCA230-8A82-9B4E-BD87-36E627CB71AB}"/>
          </ac:picMkLst>
        </pc:picChg>
        <pc:picChg chg="add del mod">
          <ac:chgData name="Narang, Sonali" userId="9e80b397-6e2f-49b1-9374-ccdad8589140" providerId="ADAL" clId="{0A0D2314-D59C-5A4C-9E09-78A254E3BB4B}" dt="2021-08-31T21:13:44.326" v="1087" actId="21"/>
          <ac:picMkLst>
            <pc:docMk/>
            <pc:sldMk cId="2209615388" sldId="260"/>
            <ac:picMk id="20" creationId="{81CB6257-ACC5-C64E-84A3-CDD9F88A058C}"/>
          </ac:picMkLst>
        </pc:picChg>
        <pc:picChg chg="del mod">
          <ac:chgData name="Narang, Sonali" userId="9e80b397-6e2f-49b1-9374-ccdad8589140" providerId="ADAL" clId="{0A0D2314-D59C-5A4C-9E09-78A254E3BB4B}" dt="2021-08-31T20:06:45.985" v="324" actId="21"/>
          <ac:picMkLst>
            <pc:docMk/>
            <pc:sldMk cId="2209615388" sldId="260"/>
            <ac:picMk id="21" creationId="{BC034324-62BB-9447-8AFF-4381E3007CAF}"/>
          </ac:picMkLst>
        </pc:picChg>
        <pc:picChg chg="add del mod">
          <ac:chgData name="Narang, Sonali" userId="9e80b397-6e2f-49b1-9374-ccdad8589140" providerId="ADAL" clId="{0A0D2314-D59C-5A4C-9E09-78A254E3BB4B}" dt="2021-08-31T21:13:44.326" v="1087" actId="21"/>
          <ac:picMkLst>
            <pc:docMk/>
            <pc:sldMk cId="2209615388" sldId="260"/>
            <ac:picMk id="22" creationId="{AF5A2D61-97DF-0E41-AFD2-ECD4D77016E1}"/>
          </ac:picMkLst>
        </pc:picChg>
        <pc:picChg chg="del">
          <ac:chgData name="Narang, Sonali" userId="9e80b397-6e2f-49b1-9374-ccdad8589140" providerId="ADAL" clId="{0A0D2314-D59C-5A4C-9E09-78A254E3BB4B}" dt="2021-08-31T20:06:45.985" v="324" actId="21"/>
          <ac:picMkLst>
            <pc:docMk/>
            <pc:sldMk cId="2209615388" sldId="260"/>
            <ac:picMk id="23" creationId="{5101B775-381A-5A4C-B599-B67845C018C5}"/>
          </ac:picMkLst>
        </pc:picChg>
        <pc:picChg chg="add del mod">
          <ac:chgData name="Narang, Sonali" userId="9e80b397-6e2f-49b1-9374-ccdad8589140" providerId="ADAL" clId="{0A0D2314-D59C-5A4C-9E09-78A254E3BB4B}" dt="2021-08-31T21:13:44.326" v="1087" actId="21"/>
          <ac:picMkLst>
            <pc:docMk/>
            <pc:sldMk cId="2209615388" sldId="260"/>
            <ac:picMk id="24" creationId="{0DF2ED38-B033-3D40-AFD8-90F5D5D0F77E}"/>
          </ac:picMkLst>
        </pc:picChg>
        <pc:picChg chg="del">
          <ac:chgData name="Narang, Sonali" userId="9e80b397-6e2f-49b1-9374-ccdad8589140" providerId="ADAL" clId="{0A0D2314-D59C-5A4C-9E09-78A254E3BB4B}" dt="2021-08-31T20:06:45.985" v="324" actId="21"/>
          <ac:picMkLst>
            <pc:docMk/>
            <pc:sldMk cId="2209615388" sldId="260"/>
            <ac:picMk id="25" creationId="{823F62DB-3D92-A444-92E1-A60A5115EFD6}"/>
          </ac:picMkLst>
        </pc:picChg>
      </pc:sldChg>
      <pc:sldChg chg="delSp modSp mod ord">
        <pc:chgData name="Narang, Sonali" userId="9e80b397-6e2f-49b1-9374-ccdad8589140" providerId="ADAL" clId="{0A0D2314-D59C-5A4C-9E09-78A254E3BB4B}" dt="2021-11-04T20:50:00.936" v="4687" actId="20577"/>
        <pc:sldMkLst>
          <pc:docMk/>
          <pc:sldMk cId="743684689" sldId="267"/>
        </pc:sldMkLst>
        <pc:spChg chg="mod">
          <ac:chgData name="Narang, Sonali" userId="9e80b397-6e2f-49b1-9374-ccdad8589140" providerId="ADAL" clId="{0A0D2314-D59C-5A4C-9E09-78A254E3BB4B}" dt="2021-11-04T20:50:00.936" v="4687" actId="20577"/>
          <ac:spMkLst>
            <pc:docMk/>
            <pc:sldMk cId="743684689" sldId="267"/>
            <ac:spMk id="4" creationId="{F6669B9D-B042-D548-BD0F-97015091799B}"/>
          </ac:spMkLst>
        </pc:spChg>
        <pc:spChg chg="del">
          <ac:chgData name="Narang, Sonali" userId="9e80b397-6e2f-49b1-9374-ccdad8589140" providerId="ADAL" clId="{0A0D2314-D59C-5A4C-9E09-78A254E3BB4B}" dt="2021-09-30T21:45:30.621" v="2770" actId="478"/>
          <ac:spMkLst>
            <pc:docMk/>
            <pc:sldMk cId="743684689" sldId="267"/>
            <ac:spMk id="7" creationId="{4C5F5CAE-FBFD-964D-A356-746AAC86DC9E}"/>
          </ac:spMkLst>
        </pc:spChg>
        <pc:spChg chg="mod">
          <ac:chgData name="Narang, Sonali" userId="9e80b397-6e2f-49b1-9374-ccdad8589140" providerId="ADAL" clId="{0A0D2314-D59C-5A4C-9E09-78A254E3BB4B}" dt="2021-09-30T21:45:33.437" v="2772" actId="20577"/>
          <ac:spMkLst>
            <pc:docMk/>
            <pc:sldMk cId="743684689" sldId="267"/>
            <ac:spMk id="8" creationId="{8A9BAE78-C4FF-1843-94F6-3410EB884848}"/>
          </ac:spMkLst>
        </pc:spChg>
        <pc:spChg chg="del">
          <ac:chgData name="Narang, Sonali" userId="9e80b397-6e2f-49b1-9374-ccdad8589140" providerId="ADAL" clId="{0A0D2314-D59C-5A4C-9E09-78A254E3BB4B}" dt="2021-09-01T21:35:42.449" v="1713" actId="478"/>
          <ac:spMkLst>
            <pc:docMk/>
            <pc:sldMk cId="743684689" sldId="267"/>
            <ac:spMk id="9" creationId="{2395522A-CD93-9340-9E6D-567013DF6E38}"/>
          </ac:spMkLst>
        </pc:spChg>
        <pc:spChg chg="mod">
          <ac:chgData name="Narang, Sonali" userId="9e80b397-6e2f-49b1-9374-ccdad8589140" providerId="ADAL" clId="{0A0D2314-D59C-5A4C-9E09-78A254E3BB4B}" dt="2021-09-30T21:45:35.342" v="2774" actId="20577"/>
          <ac:spMkLst>
            <pc:docMk/>
            <pc:sldMk cId="743684689" sldId="267"/>
            <ac:spMk id="124" creationId="{2BE84DAC-7C05-C445-9DD3-6B3EE69AFBF9}"/>
          </ac:spMkLst>
        </pc:spChg>
        <pc:spChg chg="mod">
          <ac:chgData name="Narang, Sonali" userId="9e80b397-6e2f-49b1-9374-ccdad8589140" providerId="ADAL" clId="{0A0D2314-D59C-5A4C-9E09-78A254E3BB4B}" dt="2021-09-30T21:45:37.689" v="2776" actId="20577"/>
          <ac:spMkLst>
            <pc:docMk/>
            <pc:sldMk cId="743684689" sldId="267"/>
            <ac:spMk id="125" creationId="{F77578BF-D28B-AC46-B202-F16CA20F451A}"/>
          </ac:spMkLst>
        </pc:spChg>
        <pc:spChg chg="del">
          <ac:chgData name="Narang, Sonali" userId="9e80b397-6e2f-49b1-9374-ccdad8589140" providerId="ADAL" clId="{0A0D2314-D59C-5A4C-9E09-78A254E3BB4B}" dt="2021-09-30T19:21:29.294" v="2234" actId="478"/>
          <ac:spMkLst>
            <pc:docMk/>
            <pc:sldMk cId="743684689" sldId="267"/>
            <ac:spMk id="153" creationId="{42BD9612-09AD-BC49-A911-D0B444BC90EF}"/>
          </ac:spMkLst>
        </pc:spChg>
        <pc:picChg chg="del">
          <ac:chgData name="Narang, Sonali" userId="9e80b397-6e2f-49b1-9374-ccdad8589140" providerId="ADAL" clId="{0A0D2314-D59C-5A4C-9E09-78A254E3BB4B}" dt="2021-09-30T21:44:25.621" v="2730" actId="21"/>
          <ac:picMkLst>
            <pc:docMk/>
            <pc:sldMk cId="743684689" sldId="267"/>
            <ac:picMk id="11" creationId="{D902ECD4-3975-734B-BF76-59FF156155C0}"/>
          </ac:picMkLst>
        </pc:picChg>
        <pc:picChg chg="mod">
          <ac:chgData name="Narang, Sonali" userId="9e80b397-6e2f-49b1-9374-ccdad8589140" providerId="ADAL" clId="{0A0D2314-D59C-5A4C-9E09-78A254E3BB4B}" dt="2021-09-30T21:45:27.814" v="2769" actId="167"/>
          <ac:picMkLst>
            <pc:docMk/>
            <pc:sldMk cId="743684689" sldId="267"/>
            <ac:picMk id="13" creationId="{8E13C50A-DD07-A546-AF0A-4883E062BFDF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16" creationId="{C9CE085B-61F2-AA4B-8F58-F88F0A94B661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18" creationId="{047CD297-ED95-FF4A-ABA6-C68E93587F01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20" creationId="{351CFE50-BCA5-774A-BD56-C164E68885EE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22" creationId="{AD59D98B-8498-654C-B0A9-3852F301B65D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25" creationId="{56B83F54-5D58-2144-825D-4F6099AE3C05}"/>
          </ac:picMkLst>
        </pc:picChg>
        <pc:picChg chg="del">
          <ac:chgData name="Narang, Sonali" userId="9e80b397-6e2f-49b1-9374-ccdad8589140" providerId="ADAL" clId="{0A0D2314-D59C-5A4C-9E09-78A254E3BB4B}" dt="2021-09-30T19:21:29.294" v="2234" actId="478"/>
          <ac:picMkLst>
            <pc:docMk/>
            <pc:sldMk cId="743684689" sldId="267"/>
            <ac:picMk id="27" creationId="{85D9C7E0-5A68-6842-880B-6B71D11E29BE}"/>
          </ac:picMkLst>
        </pc:picChg>
        <pc:picChg chg="del">
          <ac:chgData name="Narang, Sonali" userId="9e80b397-6e2f-49b1-9374-ccdad8589140" providerId="ADAL" clId="{0A0D2314-D59C-5A4C-9E09-78A254E3BB4B}" dt="2021-09-01T21:35:44.324" v="1714" actId="478"/>
          <ac:picMkLst>
            <pc:docMk/>
            <pc:sldMk cId="743684689" sldId="267"/>
            <ac:picMk id="63" creationId="{F2221C12-094C-AD43-99ED-F4C4EE93B505}"/>
          </ac:picMkLst>
        </pc:picChg>
        <pc:picChg chg="mod">
          <ac:chgData name="Narang, Sonali" userId="9e80b397-6e2f-49b1-9374-ccdad8589140" providerId="ADAL" clId="{0A0D2314-D59C-5A4C-9E09-78A254E3BB4B}" dt="2021-09-30T19:22:08.755" v="2241" actId="1076"/>
          <ac:picMkLst>
            <pc:docMk/>
            <pc:sldMk cId="743684689" sldId="267"/>
            <ac:picMk id="167" creationId="{58CAA980-D1E6-AA4C-A334-C0D57A74D895}"/>
          </ac:picMkLst>
        </pc:picChg>
        <pc:picChg chg="mod">
          <ac:chgData name="Narang, Sonali" userId="9e80b397-6e2f-49b1-9374-ccdad8589140" providerId="ADAL" clId="{0A0D2314-D59C-5A4C-9E09-78A254E3BB4B}" dt="2021-09-30T19:22:02.093" v="2240" actId="1076"/>
          <ac:picMkLst>
            <pc:docMk/>
            <pc:sldMk cId="743684689" sldId="267"/>
            <ac:picMk id="169" creationId="{5A30999A-89D7-8C40-9571-87F0979C7EAA}"/>
          </ac:picMkLst>
        </pc:picChg>
        <pc:picChg chg="mod">
          <ac:chgData name="Narang, Sonali" userId="9e80b397-6e2f-49b1-9374-ccdad8589140" providerId="ADAL" clId="{0A0D2314-D59C-5A4C-9E09-78A254E3BB4B}" dt="2021-09-30T19:21:58.775" v="2239" actId="14100"/>
          <ac:picMkLst>
            <pc:docMk/>
            <pc:sldMk cId="743684689" sldId="267"/>
            <ac:picMk id="171" creationId="{9C4DDE62-3BC7-ED45-A82E-A3C21D506B79}"/>
          </ac:picMkLst>
        </pc:picChg>
      </pc:sldChg>
      <pc:sldChg chg="delSp del mod">
        <pc:chgData name="Narang, Sonali" userId="9e80b397-6e2f-49b1-9374-ccdad8589140" providerId="ADAL" clId="{0A0D2314-D59C-5A4C-9E09-78A254E3BB4B}" dt="2021-08-31T21:13:00.549" v="1078" actId="2696"/>
        <pc:sldMkLst>
          <pc:docMk/>
          <pc:sldMk cId="2124429" sldId="268"/>
        </pc:sldMkLst>
        <pc:spChg chg="del">
          <ac:chgData name="Narang, Sonali" userId="9e80b397-6e2f-49b1-9374-ccdad8589140" providerId="ADAL" clId="{0A0D2314-D59C-5A4C-9E09-78A254E3BB4B}" dt="2021-08-31T21:12:58.917" v="1077" actId="478"/>
          <ac:spMkLst>
            <pc:docMk/>
            <pc:sldMk cId="2124429" sldId="268"/>
            <ac:spMk id="3" creationId="{9DD290A2-FA79-CB4D-9BE8-A7AB77AC725D}"/>
          </ac:spMkLst>
        </pc:spChg>
        <pc:picChg chg="del">
          <ac:chgData name="Narang, Sonali" userId="9e80b397-6e2f-49b1-9374-ccdad8589140" providerId="ADAL" clId="{0A0D2314-D59C-5A4C-9E09-78A254E3BB4B}" dt="2021-08-31T21:12:57.266" v="1076" actId="21"/>
          <ac:picMkLst>
            <pc:docMk/>
            <pc:sldMk cId="2124429" sldId="268"/>
            <ac:picMk id="9" creationId="{DDFA2D53-1007-6348-BFE3-B6FA0F6BC498}"/>
          </ac:picMkLst>
        </pc:picChg>
      </pc:sldChg>
      <pc:sldChg chg="addSp delSp modSp mod">
        <pc:chgData name="Narang, Sonali" userId="9e80b397-6e2f-49b1-9374-ccdad8589140" providerId="ADAL" clId="{0A0D2314-D59C-5A4C-9E09-78A254E3BB4B}" dt="2021-10-01T14:08:54.254" v="2959" actId="478"/>
        <pc:sldMkLst>
          <pc:docMk/>
          <pc:sldMk cId="2720918902" sldId="269"/>
        </pc:sldMkLst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26" creationId="{4AA2B0E0-9E04-1748-82E6-C76635F8D162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27" creationId="{0D94C0A7-0AEB-3D47-9BC0-55F5364A8EF3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0" creationId="{9F4469E9-F3F6-2246-A6BF-786873C72E08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1" creationId="{ECDA0C85-B876-244E-9A92-1F9DEFEB0495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2" creationId="{CF84F454-6117-B94C-B4C9-DA16C5CC7620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3" creationId="{3DB50601-7070-8147-BF34-C28C10DE4EF7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4" creationId="{201BD6FB-B29D-6F4F-9FD1-82E81832B7AF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5" creationId="{719E90AD-4A7B-854D-83F7-D84D25D8F9C2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6" creationId="{C71CD2D3-7D44-F340-B1C8-3A86FB15BA85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7" creationId="{7C05ACB9-A94F-A842-B1F1-066896F0F3C5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8" creationId="{B722EF19-0AA9-2746-96CA-C445738BD6DB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39" creationId="{93C6A577-2A8E-F14F-841E-A61A2CBA925C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40" creationId="{F46EE902-9FAA-2E40-8033-C85265F25903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41" creationId="{8D406CD7-682B-FD41-8863-186D408A7EBE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42" creationId="{B7BD1451-A2CC-154C-8A1E-07A76EB37568}"/>
          </ac:spMkLst>
        </pc:spChg>
        <pc:spChg chg="del mod">
          <ac:chgData name="Narang, Sonali" userId="9e80b397-6e2f-49b1-9374-ccdad8589140" providerId="ADAL" clId="{0A0D2314-D59C-5A4C-9E09-78A254E3BB4B}" dt="2021-10-01T14:08:54.254" v="2959" actId="478"/>
          <ac:spMkLst>
            <pc:docMk/>
            <pc:sldMk cId="2720918902" sldId="269"/>
            <ac:spMk id="43" creationId="{5C52D3DA-6F43-1948-A778-94F6E4E9E14F}"/>
          </ac:spMkLst>
        </pc:spChg>
        <pc:spChg chg="add mod">
          <ac:chgData name="Narang, Sonali" userId="9e80b397-6e2f-49b1-9374-ccdad8589140" providerId="ADAL" clId="{0A0D2314-D59C-5A4C-9E09-78A254E3BB4B}" dt="2021-09-30T21:46:26.779" v="2785"/>
          <ac:spMkLst>
            <pc:docMk/>
            <pc:sldMk cId="2720918902" sldId="269"/>
            <ac:spMk id="45" creationId="{A37EFDC5-08ED-BB45-B24A-B00535A392F0}"/>
          </ac:spMkLst>
        </pc:spChg>
        <pc:grpChg chg="mod">
          <ac:chgData name="Narang, Sonali" userId="9e80b397-6e2f-49b1-9374-ccdad8589140" providerId="ADAL" clId="{0A0D2314-D59C-5A4C-9E09-78A254E3BB4B}" dt="2021-09-30T21:46:10.661" v="2778" actId="1076"/>
          <ac:grpSpMkLst>
            <pc:docMk/>
            <pc:sldMk cId="2720918902" sldId="269"/>
            <ac:grpSpMk id="4" creationId="{38EA236B-FA62-104C-88BA-1A393570B00A}"/>
          </ac:grpSpMkLst>
        </pc:grpChg>
        <pc:picChg chg="mod">
          <ac:chgData name="Narang, Sonali" userId="9e80b397-6e2f-49b1-9374-ccdad8589140" providerId="ADAL" clId="{0A0D2314-D59C-5A4C-9E09-78A254E3BB4B}" dt="2021-09-30T21:46:10.661" v="2778" actId="1076"/>
          <ac:picMkLst>
            <pc:docMk/>
            <pc:sldMk cId="2720918902" sldId="269"/>
            <ac:picMk id="3" creationId="{B45809F1-FAC9-F94B-9E9F-CB796333E5D3}"/>
          </ac:picMkLst>
        </pc:picChg>
        <pc:picChg chg="del mod">
          <ac:chgData name="Narang, Sonali" userId="9e80b397-6e2f-49b1-9374-ccdad8589140" providerId="ADAL" clId="{0A0D2314-D59C-5A4C-9E09-78A254E3BB4B}" dt="2021-10-01T14:08:47.885" v="2958" actId="478"/>
          <ac:picMkLst>
            <pc:docMk/>
            <pc:sldMk cId="2720918902" sldId="269"/>
            <ac:picMk id="24" creationId="{0304240D-4AFD-094E-A8F4-9549ABFF67CC}"/>
          </ac:picMkLst>
        </pc:picChg>
        <pc:picChg chg="del mod">
          <ac:chgData name="Narang, Sonali" userId="9e80b397-6e2f-49b1-9374-ccdad8589140" providerId="ADAL" clId="{0A0D2314-D59C-5A4C-9E09-78A254E3BB4B}" dt="2021-10-01T14:08:47.885" v="2958" actId="478"/>
          <ac:picMkLst>
            <pc:docMk/>
            <pc:sldMk cId="2720918902" sldId="269"/>
            <ac:picMk id="25" creationId="{F5335663-2747-3B40-A677-7A33B0BD5B41}"/>
          </ac:picMkLst>
        </pc:picChg>
        <pc:picChg chg="add mod">
          <ac:chgData name="Narang, Sonali" userId="9e80b397-6e2f-49b1-9374-ccdad8589140" providerId="ADAL" clId="{0A0D2314-D59C-5A4C-9E09-78A254E3BB4B}" dt="2021-09-30T21:46:17.743" v="2783" actId="1076"/>
          <ac:picMkLst>
            <pc:docMk/>
            <pc:sldMk cId="2720918902" sldId="269"/>
            <ac:picMk id="44" creationId="{555A226D-A762-2B4C-BFBA-33F0EFDAC963}"/>
          </ac:picMkLst>
        </pc:picChg>
      </pc:sldChg>
      <pc:sldChg chg="addSp delSp modSp mod addCm delCm modNotesTx">
        <pc:chgData name="Narang, Sonali" userId="9e80b397-6e2f-49b1-9374-ccdad8589140" providerId="ADAL" clId="{0A0D2314-D59C-5A4C-9E09-78A254E3BB4B}" dt="2021-11-03T16:43:12.356" v="4064" actId="478"/>
        <pc:sldMkLst>
          <pc:docMk/>
          <pc:sldMk cId="3689715634" sldId="270"/>
        </pc:sldMkLst>
        <pc:spChg chg="add del mod">
          <ac:chgData name="Narang, Sonali" userId="9e80b397-6e2f-49b1-9374-ccdad8589140" providerId="ADAL" clId="{0A0D2314-D59C-5A4C-9E09-78A254E3BB4B}" dt="2021-09-02T17:29:06.185" v="1733" actId="478"/>
          <ac:spMkLst>
            <pc:docMk/>
            <pc:sldMk cId="3689715634" sldId="270"/>
            <ac:spMk id="2" creationId="{524ED1FE-FBA6-8D49-8DFD-C88B864005E8}"/>
          </ac:spMkLst>
        </pc:spChg>
        <pc:spChg chg="add del mod">
          <ac:chgData name="Narang, Sonali" userId="9e80b397-6e2f-49b1-9374-ccdad8589140" providerId="ADAL" clId="{0A0D2314-D59C-5A4C-9E09-78A254E3BB4B}" dt="2021-08-31T20:07:32.688" v="332" actId="21"/>
          <ac:spMkLst>
            <pc:docMk/>
            <pc:sldMk cId="3689715634" sldId="270"/>
            <ac:spMk id="3" creationId="{CD697086-6CF5-9441-8B32-ACBD236EA2D7}"/>
          </ac:spMkLst>
        </pc:spChg>
        <pc:spChg chg="mod">
          <ac:chgData name="Narang, Sonali" userId="9e80b397-6e2f-49b1-9374-ccdad8589140" providerId="ADAL" clId="{0A0D2314-D59C-5A4C-9E09-78A254E3BB4B}" dt="2021-08-31T19:56:06.521" v="138" actId="20577"/>
          <ac:spMkLst>
            <pc:docMk/>
            <pc:sldMk cId="3689715634" sldId="270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11-02T15:26:42.030" v="3145" actId="1038"/>
          <ac:spMkLst>
            <pc:docMk/>
            <pc:sldMk cId="3689715634" sldId="270"/>
            <ac:spMk id="5" creationId="{FAFFEC37-A0C5-5846-8534-22E3DEF6CEF4}"/>
          </ac:spMkLst>
        </pc:spChg>
        <pc:spChg chg="add del mod">
          <ac:chgData name="Narang, Sonali" userId="9e80b397-6e2f-49b1-9374-ccdad8589140" providerId="ADAL" clId="{0A0D2314-D59C-5A4C-9E09-78A254E3BB4B}" dt="2021-08-31T20:24:24.288" v="428" actId="478"/>
          <ac:spMkLst>
            <pc:docMk/>
            <pc:sldMk cId="3689715634" sldId="270"/>
            <ac:spMk id="6" creationId="{876ED236-F9D4-8E41-B05D-70A292439A8B}"/>
          </ac:spMkLst>
        </pc:spChg>
        <pc:spChg chg="mod">
          <ac:chgData name="Narang, Sonali" userId="9e80b397-6e2f-49b1-9374-ccdad8589140" providerId="ADAL" clId="{0A0D2314-D59C-5A4C-9E09-78A254E3BB4B}" dt="2021-11-02T15:26:55.268" v="3156" actId="1038"/>
          <ac:spMkLst>
            <pc:docMk/>
            <pc:sldMk cId="3689715634" sldId="270"/>
            <ac:spMk id="7" creationId="{4C5F5CAE-FBFD-964D-A356-746AAC86DC9E}"/>
          </ac:spMkLst>
        </pc:spChg>
        <pc:spChg chg="mod">
          <ac:chgData name="Narang, Sonali" userId="9e80b397-6e2f-49b1-9374-ccdad8589140" providerId="ADAL" clId="{0A0D2314-D59C-5A4C-9E09-78A254E3BB4B}" dt="2021-11-02T15:26:42.030" v="3145" actId="1038"/>
          <ac:spMkLst>
            <pc:docMk/>
            <pc:sldMk cId="3689715634" sldId="270"/>
            <ac:spMk id="8" creationId="{8A9BAE78-C4FF-1843-94F6-3410EB884848}"/>
          </ac:spMkLst>
        </pc:spChg>
        <pc:spChg chg="add del mod">
          <ac:chgData name="Narang, Sonali" userId="9e80b397-6e2f-49b1-9374-ccdad8589140" providerId="ADAL" clId="{0A0D2314-D59C-5A4C-9E09-78A254E3BB4B}" dt="2021-08-31T20:58:25.819" v="747" actId="478"/>
          <ac:spMkLst>
            <pc:docMk/>
            <pc:sldMk cId="3689715634" sldId="270"/>
            <ac:spMk id="21" creationId="{84A5F866-395C-2541-9F0A-E07C99A5FC00}"/>
          </ac:spMkLst>
        </pc:spChg>
        <pc:spChg chg="add del mod">
          <ac:chgData name="Narang, Sonali" userId="9e80b397-6e2f-49b1-9374-ccdad8589140" providerId="ADAL" clId="{0A0D2314-D59C-5A4C-9E09-78A254E3BB4B}" dt="2021-08-31T20:35:21.789" v="630" actId="767"/>
          <ac:spMkLst>
            <pc:docMk/>
            <pc:sldMk cId="3689715634" sldId="270"/>
            <ac:spMk id="26" creationId="{134587AC-EA00-4544-A190-42BB3EEA5246}"/>
          </ac:spMkLst>
        </pc:spChg>
        <pc:spChg chg="add del">
          <ac:chgData name="Narang, Sonali" userId="9e80b397-6e2f-49b1-9374-ccdad8589140" providerId="ADAL" clId="{0A0D2314-D59C-5A4C-9E09-78A254E3BB4B}" dt="2021-08-31T20:45:16.247" v="721" actId="478"/>
          <ac:spMkLst>
            <pc:docMk/>
            <pc:sldMk cId="3689715634" sldId="270"/>
            <ac:spMk id="27" creationId="{8FF38824-4351-704D-A76B-9CAE18D05D84}"/>
          </ac:spMkLst>
        </pc:spChg>
        <pc:spChg chg="add del">
          <ac:chgData name="Narang, Sonali" userId="9e80b397-6e2f-49b1-9374-ccdad8589140" providerId="ADAL" clId="{0A0D2314-D59C-5A4C-9E09-78A254E3BB4B}" dt="2021-08-31T20:45:27.356" v="723" actId="478"/>
          <ac:spMkLst>
            <pc:docMk/>
            <pc:sldMk cId="3689715634" sldId="270"/>
            <ac:spMk id="28" creationId="{8FE5F1F7-2F04-9F47-B0F6-15BA40EAEB40}"/>
          </ac:spMkLst>
        </pc:spChg>
        <pc:spChg chg="add del mod">
          <ac:chgData name="Narang, Sonali" userId="9e80b397-6e2f-49b1-9374-ccdad8589140" providerId="ADAL" clId="{0A0D2314-D59C-5A4C-9E09-78A254E3BB4B}" dt="2021-08-31T21:03:19.934" v="969" actId="478"/>
          <ac:spMkLst>
            <pc:docMk/>
            <pc:sldMk cId="3689715634" sldId="270"/>
            <ac:spMk id="29" creationId="{794AC2A9-38B1-AE46-A5FF-AD9B9888153A}"/>
          </ac:spMkLst>
        </pc:spChg>
        <pc:spChg chg="mod">
          <ac:chgData name="Narang, Sonali" userId="9e80b397-6e2f-49b1-9374-ccdad8589140" providerId="ADAL" clId="{0A0D2314-D59C-5A4C-9E09-78A254E3BB4B}" dt="2021-11-02T15:26:55.268" v="3156" actId="1038"/>
          <ac:spMkLst>
            <pc:docMk/>
            <pc:sldMk cId="3689715634" sldId="270"/>
            <ac:spMk id="32" creationId="{2863401C-2050-2E40-AE5C-C6CDD3A8A7D4}"/>
          </ac:spMkLst>
        </pc:spChg>
        <pc:spChg chg="mod">
          <ac:chgData name="Narang, Sonali" userId="9e80b397-6e2f-49b1-9374-ccdad8589140" providerId="ADAL" clId="{0A0D2314-D59C-5A4C-9E09-78A254E3BB4B}" dt="2021-11-02T14:33:37.922" v="3013" actId="1037"/>
          <ac:spMkLst>
            <pc:docMk/>
            <pc:sldMk cId="3689715634" sldId="270"/>
            <ac:spMk id="34" creationId="{6D8F17D5-0D48-D240-A514-46DF3B792DB3}"/>
          </ac:spMkLst>
        </pc:spChg>
        <pc:spChg chg="mod">
          <ac:chgData name="Narang, Sonali" userId="9e80b397-6e2f-49b1-9374-ccdad8589140" providerId="ADAL" clId="{0A0D2314-D59C-5A4C-9E09-78A254E3BB4B}" dt="2021-11-02T14:33:31.849" v="3011" actId="1037"/>
          <ac:spMkLst>
            <pc:docMk/>
            <pc:sldMk cId="3689715634" sldId="270"/>
            <ac:spMk id="35" creationId="{8E47D5FA-094C-AB4F-997F-C3C0BB4C2B2E}"/>
          </ac:spMkLst>
        </pc:spChg>
        <pc:spChg chg="mod">
          <ac:chgData name="Narang, Sonali" userId="9e80b397-6e2f-49b1-9374-ccdad8589140" providerId="ADAL" clId="{0A0D2314-D59C-5A4C-9E09-78A254E3BB4B}" dt="2021-11-02T15:26:42.030" v="3145" actId="1038"/>
          <ac:spMkLst>
            <pc:docMk/>
            <pc:sldMk cId="3689715634" sldId="270"/>
            <ac:spMk id="36" creationId="{75B14C61-810F-134B-AC0D-0C1FD0CAB17A}"/>
          </ac:spMkLst>
        </pc:spChg>
        <pc:spChg chg="add del mod">
          <ac:chgData name="Narang, Sonali" userId="9e80b397-6e2f-49b1-9374-ccdad8589140" providerId="ADAL" clId="{0A0D2314-D59C-5A4C-9E09-78A254E3BB4B}" dt="2021-08-31T20:59:52.962" v="865" actId="478"/>
          <ac:spMkLst>
            <pc:docMk/>
            <pc:sldMk cId="3689715634" sldId="270"/>
            <ac:spMk id="37" creationId="{F48412B0-01DB-9948-B265-CFE422407869}"/>
          </ac:spMkLst>
        </pc:spChg>
        <pc:spChg chg="add mod">
          <ac:chgData name="Narang, Sonali" userId="9e80b397-6e2f-49b1-9374-ccdad8589140" providerId="ADAL" clId="{0A0D2314-D59C-5A4C-9E09-78A254E3BB4B}" dt="2021-08-31T21:06:10.065" v="1032" actId="12788"/>
          <ac:spMkLst>
            <pc:docMk/>
            <pc:sldMk cId="3689715634" sldId="270"/>
            <ac:spMk id="39" creationId="{73F52EA2-7E20-3A46-BF75-DECF1ECCDCA5}"/>
          </ac:spMkLst>
        </pc:spChg>
        <pc:spChg chg="add del mod">
          <ac:chgData name="Narang, Sonali" userId="9e80b397-6e2f-49b1-9374-ccdad8589140" providerId="ADAL" clId="{0A0D2314-D59C-5A4C-9E09-78A254E3BB4B}" dt="2021-08-31T21:01:49.780" v="893" actId="478"/>
          <ac:spMkLst>
            <pc:docMk/>
            <pc:sldMk cId="3689715634" sldId="270"/>
            <ac:spMk id="40" creationId="{DDE1017D-589F-6142-AE8F-C7CE68261884}"/>
          </ac:spMkLst>
        </pc:spChg>
        <pc:spChg chg="mod">
          <ac:chgData name="Narang, Sonali" userId="9e80b397-6e2f-49b1-9374-ccdad8589140" providerId="ADAL" clId="{0A0D2314-D59C-5A4C-9E09-78A254E3BB4B}" dt="2021-08-31T20:26:24.751" v="480" actId="207"/>
          <ac:spMkLst>
            <pc:docMk/>
            <pc:sldMk cId="3689715634" sldId="270"/>
            <ac:spMk id="42" creationId="{A774F168-515F-0F4B-A943-698B1719F653}"/>
          </ac:spMkLst>
        </pc:spChg>
        <pc:spChg chg="add del mod">
          <ac:chgData name="Narang, Sonali" userId="9e80b397-6e2f-49b1-9374-ccdad8589140" providerId="ADAL" clId="{0A0D2314-D59C-5A4C-9E09-78A254E3BB4B}" dt="2021-09-01T20:26:13.507" v="1434" actId="478"/>
          <ac:spMkLst>
            <pc:docMk/>
            <pc:sldMk cId="3689715634" sldId="270"/>
            <ac:spMk id="43" creationId="{4E6C34E1-99B1-BA48-8ECA-5F1DBA16529A}"/>
          </ac:spMkLst>
        </pc:spChg>
        <pc:spChg chg="add mod">
          <ac:chgData name="Narang, Sonali" userId="9e80b397-6e2f-49b1-9374-ccdad8589140" providerId="ADAL" clId="{0A0D2314-D59C-5A4C-9E09-78A254E3BB4B}" dt="2021-09-02T17:39:40.802" v="1789" actId="207"/>
          <ac:spMkLst>
            <pc:docMk/>
            <pc:sldMk cId="3689715634" sldId="270"/>
            <ac:spMk id="51" creationId="{9E2A7A01-5E47-C848-9E82-B956E434911B}"/>
          </ac:spMkLst>
        </pc:spChg>
        <pc:spChg chg="mod">
          <ac:chgData name="Narang, Sonali" userId="9e80b397-6e2f-49b1-9374-ccdad8589140" providerId="ADAL" clId="{0A0D2314-D59C-5A4C-9E09-78A254E3BB4B}" dt="2021-11-02T15:26:55.268" v="3156" actId="1038"/>
          <ac:spMkLst>
            <pc:docMk/>
            <pc:sldMk cId="3689715634" sldId="270"/>
            <ac:spMk id="59" creationId="{1C85DEE8-F315-5047-B7B7-8827D96395BE}"/>
          </ac:spMkLst>
        </pc:spChg>
        <pc:spChg chg="mod">
          <ac:chgData name="Narang, Sonali" userId="9e80b397-6e2f-49b1-9374-ccdad8589140" providerId="ADAL" clId="{0A0D2314-D59C-5A4C-9E09-78A254E3BB4B}" dt="2021-08-31T20:26:24.751" v="480" actId="207"/>
          <ac:spMkLst>
            <pc:docMk/>
            <pc:sldMk cId="3689715634" sldId="270"/>
            <ac:spMk id="60" creationId="{AA6BA435-EFC0-064C-8CE6-058DB76F21BE}"/>
          </ac:spMkLst>
        </pc:spChg>
        <pc:spChg chg="mod">
          <ac:chgData name="Narang, Sonali" userId="9e80b397-6e2f-49b1-9374-ccdad8589140" providerId="ADAL" clId="{0A0D2314-D59C-5A4C-9E09-78A254E3BB4B}" dt="2021-08-31T20:26:24.751" v="480" actId="207"/>
          <ac:spMkLst>
            <pc:docMk/>
            <pc:sldMk cId="3689715634" sldId="270"/>
            <ac:spMk id="61" creationId="{9A62A9C2-4EF2-9E4B-BF75-4AEEEA3A3F38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77" creationId="{829F8CA4-F2B1-A94C-ADAB-084FEE65D57A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78" creationId="{33106EAB-B2B4-4F48-946F-B59E0F97AE4F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79" creationId="{002FC599-E5C1-884F-8CEA-4E88BA053BA6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80" creationId="{4DF10DAC-EC31-254C-99AE-C63A1157B74B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81" creationId="{AA9A73F8-BDAB-1C4A-8603-A1FF2F61F8F5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82" creationId="{461E613F-A24C-1543-B732-CD8561548007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83" creationId="{EBDBC63E-5AB8-174A-BB1F-F7D914A08173}"/>
          </ac:spMkLst>
        </pc:spChg>
        <pc:spChg chg="mod">
          <ac:chgData name="Narang, Sonali" userId="9e80b397-6e2f-49b1-9374-ccdad8589140" providerId="ADAL" clId="{0A0D2314-D59C-5A4C-9E09-78A254E3BB4B}" dt="2021-08-31T20:26:34.557" v="481" actId="207"/>
          <ac:spMkLst>
            <pc:docMk/>
            <pc:sldMk cId="3689715634" sldId="270"/>
            <ac:spMk id="84" creationId="{ABEEDABF-87C6-6E47-925F-190934716B1A}"/>
          </ac:spMkLst>
        </pc:spChg>
        <pc:spChg chg="mod">
          <ac:chgData name="Narang, Sonali" userId="9e80b397-6e2f-49b1-9374-ccdad8589140" providerId="ADAL" clId="{0A0D2314-D59C-5A4C-9E09-78A254E3BB4B}" dt="2021-08-31T20:26:34.557" v="481" actId="207"/>
          <ac:spMkLst>
            <pc:docMk/>
            <pc:sldMk cId="3689715634" sldId="270"/>
            <ac:spMk id="85" creationId="{0E49EB75-1683-9842-98B6-DEFCB88FE517}"/>
          </ac:spMkLst>
        </pc:spChg>
        <pc:spChg chg="mod">
          <ac:chgData name="Narang, Sonali" userId="9e80b397-6e2f-49b1-9374-ccdad8589140" providerId="ADAL" clId="{0A0D2314-D59C-5A4C-9E09-78A254E3BB4B}" dt="2021-08-31T20:26:34.557" v="481" actId="207"/>
          <ac:spMkLst>
            <pc:docMk/>
            <pc:sldMk cId="3689715634" sldId="270"/>
            <ac:spMk id="86" creationId="{C9AD06DF-9752-2B4B-A2F9-94821FA7A939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93" creationId="{64285D9B-FC68-FC4E-A8AE-A691F45F91D3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94" creationId="{779ED364-B947-4649-AC6C-67DBDCE196B9}"/>
          </ac:spMkLst>
        </pc:spChg>
        <pc:spChg chg="mod">
          <ac:chgData name="Narang, Sonali" userId="9e80b397-6e2f-49b1-9374-ccdad8589140" providerId="ADAL" clId="{0A0D2314-D59C-5A4C-9E09-78A254E3BB4B}" dt="2021-08-31T19:55:06.128" v="134" actId="1037"/>
          <ac:spMkLst>
            <pc:docMk/>
            <pc:sldMk cId="3689715634" sldId="270"/>
            <ac:spMk id="95" creationId="{6DD283A0-4643-074E-A722-EACAC130A59D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24" creationId="{B23F7538-E8A8-CC40-A117-196EA9C2ACE1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32" creationId="{F0403695-AD5B-9047-8D05-54346F3F120D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36" creationId="{9A9CF7D7-0D48-D043-BB37-5753524DD92B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37" creationId="{FC560F8A-A1EE-C647-AA5D-17B7F2C0F448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39" creationId="{FE0FD528-1245-F14D-AB89-4DFD4EF28ADA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40" creationId="{7E0A8E22-7013-7A4F-8D7D-18E045FC74A0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41" creationId="{F00BFF25-4547-7142-A56A-EC7337477F73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44" creationId="{5FCB19E8-7E4E-9642-AB00-A99D96D59684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45" creationId="{8F29B37B-156F-694D-A339-8025AE60D4B8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49" creationId="{470B4D70-8F9B-A145-8C6F-56AA5F38EA82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50" creationId="{96090C8E-D773-6A41-99CA-0DBDB8915E72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51" creationId="{96351EF7-130F-5745-8550-0E125D4A2660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56" creationId="{6144D5A7-177A-2249-859E-3D7B885FC027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66" creationId="{191813A5-20BE-C344-95C8-FA01F56C9914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67" creationId="{2A901228-C2CB-674F-A8E6-CA5D0B4A47D9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68" creationId="{4E47A89F-0DE6-1242-BAFC-8D1AE01C361F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69" creationId="{5486342B-C30C-F546-B62F-8DA753AD748C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0" creationId="{616C7D43-7EB6-C44C-A9DD-21BA83A70CCB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1" creationId="{36F8D3FC-32FB-1A4C-A9B6-A856B1866E91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2" creationId="{3F37522B-FC9F-3A4F-83AB-A143AE7607F5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3" creationId="{FD66ED2E-18FC-2841-AC37-AB88755817CF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4" creationId="{B77BE25F-E898-1044-9363-72612FA91FFA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5" creationId="{C0D3769C-94E8-4148-9CB4-C5D295EE7E12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6" creationId="{34AA1C5A-7C3E-394D-8AE4-CFE58FC6C99F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7" creationId="{9F540659-5FAD-4E4A-B32C-97CDADF346B6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79" creationId="{BC95457B-7010-3146-8AE4-C7E5D5F50B1A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0" creationId="{CCE1272A-9C36-A346-88A6-D717B5D2A9F8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1" creationId="{B3A331DA-04FF-2242-A5F1-900558D382D9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2" creationId="{6E1FC018-637A-DD45-B7BA-0989FA78FBC6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3" creationId="{D95A63C1-EFC0-8047-B140-344843A82E7B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4" creationId="{CBBEB65C-0B2E-4B4C-B4AB-A9302D4BE246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8" creationId="{DEED389C-ED74-C047-BB06-A1A7254A6EAD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89" creationId="{193882B9-A2A5-0740-B0C3-4E860AE6CF87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90" creationId="{AA597927-0156-7940-AA7B-9E532BBC24AB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191" creationId="{5BD8C462-331F-3848-A13F-17FA4BD62FD7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37" creationId="{326BD118-D012-0E49-9FD4-24726A366775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38" creationId="{138CC95D-4E71-CB43-97B6-C57B77A27223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39" creationId="{1937FA0E-6652-7F4F-B6B6-4E1D63304F90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0" creationId="{C1772F08-6BE6-7742-B4F7-BBE8D9553B02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1" creationId="{B43FE6F3-535C-BF41-BA1C-6DA8E15173F0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2" creationId="{7A1997C9-EE3B-6641-A7FF-A44629BC2173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3" creationId="{0745A6CC-1E16-4D44-A892-759D74AD2D27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4" creationId="{BBCA8CB8-C781-3C4F-B02E-9E40B89C94D0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5" creationId="{8CA6C6C0-C678-484E-88FF-04E9986B8FAA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6" creationId="{1D4AFF91-5114-2541-945C-9C8B343D3E7E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7" creationId="{BC9E7717-DDE5-D442-9A31-A865DA9F44BE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8" creationId="{B3EF87E3-5756-2444-A2EB-3BD31BE1BC99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49" creationId="{1AE193AC-B053-1746-8002-4FB3BB4DB3E1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50" creationId="{320F4740-B1A7-634D-A280-6747D29B6401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51" creationId="{4A99B960-2241-8B44-89DB-5E638C0DD45C}"/>
          </ac:spMkLst>
        </pc:spChg>
        <pc:spChg chg="mod">
          <ac:chgData name="Narang, Sonali" userId="9e80b397-6e2f-49b1-9374-ccdad8589140" providerId="ADAL" clId="{0A0D2314-D59C-5A4C-9E09-78A254E3BB4B}" dt="2021-08-31T19:51:49.591" v="4"/>
          <ac:spMkLst>
            <pc:docMk/>
            <pc:sldMk cId="3689715634" sldId="270"/>
            <ac:spMk id="252" creationId="{05C49839-5E70-9246-8371-A0E772CDB077}"/>
          </ac:spMkLst>
        </pc:spChg>
        <pc:spChg chg="add mod">
          <ac:chgData name="Narang, Sonali" userId="9e80b397-6e2f-49b1-9374-ccdad8589140" providerId="ADAL" clId="{0A0D2314-D59C-5A4C-9E09-78A254E3BB4B}" dt="2021-09-02T17:42:56.016" v="1902" actId="1038"/>
          <ac:spMkLst>
            <pc:docMk/>
            <pc:sldMk cId="3689715634" sldId="270"/>
            <ac:spMk id="253" creationId="{AB8B75A2-6482-504E-B0D8-BEE868264A10}"/>
          </ac:spMkLst>
        </pc:spChg>
        <pc:spChg chg="add mod">
          <ac:chgData name="Narang, Sonali" userId="9e80b397-6e2f-49b1-9374-ccdad8589140" providerId="ADAL" clId="{0A0D2314-D59C-5A4C-9E09-78A254E3BB4B}" dt="2021-11-02T15:26:23.067" v="3136" actId="1076"/>
          <ac:spMkLst>
            <pc:docMk/>
            <pc:sldMk cId="3689715634" sldId="270"/>
            <ac:spMk id="254" creationId="{90B8E414-E61D-C54E-870F-4AA87CD05251}"/>
          </ac:spMkLst>
        </pc:spChg>
        <pc:spChg chg="add mod">
          <ac:chgData name="Narang, Sonali" userId="9e80b397-6e2f-49b1-9374-ccdad8589140" providerId="ADAL" clId="{0A0D2314-D59C-5A4C-9E09-78A254E3BB4B}" dt="2021-09-02T17:42:59.257" v="1909" actId="1038"/>
          <ac:spMkLst>
            <pc:docMk/>
            <pc:sldMk cId="3689715634" sldId="270"/>
            <ac:spMk id="258" creationId="{5DDF1B8D-8C73-DA43-A850-4409A0D356A4}"/>
          </ac:spMkLst>
        </pc:spChg>
        <pc:spChg chg="add mod">
          <ac:chgData name="Narang, Sonali" userId="9e80b397-6e2f-49b1-9374-ccdad8589140" providerId="ADAL" clId="{0A0D2314-D59C-5A4C-9E09-78A254E3BB4B}" dt="2021-11-02T15:26:42.030" v="3145" actId="1038"/>
          <ac:spMkLst>
            <pc:docMk/>
            <pc:sldMk cId="3689715634" sldId="270"/>
            <ac:spMk id="259" creationId="{B6297CA1-726C-9C44-8F9B-04A44BC1D29F}"/>
          </ac:spMkLst>
        </pc:spChg>
        <pc:spChg chg="add mod">
          <ac:chgData name="Narang, Sonali" userId="9e80b397-6e2f-49b1-9374-ccdad8589140" providerId="ADAL" clId="{0A0D2314-D59C-5A4C-9E09-78A254E3BB4B}" dt="2021-08-31T21:04:45.608" v="995" actId="1037"/>
          <ac:spMkLst>
            <pc:docMk/>
            <pc:sldMk cId="3689715634" sldId="270"/>
            <ac:spMk id="260" creationId="{C198BCF7-9062-8A4A-B1C5-FD5D4CC3A09E}"/>
          </ac:spMkLst>
        </pc:spChg>
        <pc:spChg chg="add mod">
          <ac:chgData name="Narang, Sonali" userId="9e80b397-6e2f-49b1-9374-ccdad8589140" providerId="ADAL" clId="{0A0D2314-D59C-5A4C-9E09-78A254E3BB4B}" dt="2021-08-31T21:04:45.608" v="995" actId="1037"/>
          <ac:spMkLst>
            <pc:docMk/>
            <pc:sldMk cId="3689715634" sldId="270"/>
            <ac:spMk id="261" creationId="{A47E8EA5-1950-3241-914C-578B367C6302}"/>
          </ac:spMkLst>
        </pc:spChg>
        <pc:spChg chg="add mod">
          <ac:chgData name="Narang, Sonali" userId="9e80b397-6e2f-49b1-9374-ccdad8589140" providerId="ADAL" clId="{0A0D2314-D59C-5A4C-9E09-78A254E3BB4B}" dt="2021-08-31T21:04:45.608" v="995" actId="1037"/>
          <ac:spMkLst>
            <pc:docMk/>
            <pc:sldMk cId="3689715634" sldId="270"/>
            <ac:spMk id="262" creationId="{D420C948-EB53-834C-A869-9E33124430A9}"/>
          </ac:spMkLst>
        </pc:spChg>
        <pc:spChg chg="add del mod">
          <ac:chgData name="Narang, Sonali" userId="9e80b397-6e2f-49b1-9374-ccdad8589140" providerId="ADAL" clId="{0A0D2314-D59C-5A4C-9E09-78A254E3BB4B}" dt="2021-08-31T20:33:34.145" v="517"/>
          <ac:spMkLst>
            <pc:docMk/>
            <pc:sldMk cId="3689715634" sldId="270"/>
            <ac:spMk id="263" creationId="{0FD06498-8A55-1245-88DE-D4CFB28CC505}"/>
          </ac:spMkLst>
        </pc:spChg>
        <pc:spChg chg="add del mod">
          <ac:chgData name="Narang, Sonali" userId="9e80b397-6e2f-49b1-9374-ccdad8589140" providerId="ADAL" clId="{0A0D2314-D59C-5A4C-9E09-78A254E3BB4B}" dt="2021-08-31T20:58:25.819" v="747" actId="478"/>
          <ac:spMkLst>
            <pc:docMk/>
            <pc:sldMk cId="3689715634" sldId="270"/>
            <ac:spMk id="264" creationId="{FB4A5A2C-4D33-7247-9266-8C7467144324}"/>
          </ac:spMkLst>
        </pc:spChg>
        <pc:spChg chg="add del mod">
          <ac:chgData name="Narang, Sonali" userId="9e80b397-6e2f-49b1-9374-ccdad8589140" providerId="ADAL" clId="{0A0D2314-D59C-5A4C-9E09-78A254E3BB4B}" dt="2021-08-31T20:34:35.056" v="616"/>
          <ac:spMkLst>
            <pc:docMk/>
            <pc:sldMk cId="3689715634" sldId="270"/>
            <ac:spMk id="265" creationId="{C5A9F71C-D05C-7B49-A307-C30C2A1DB846}"/>
          </ac:spMkLst>
        </pc:spChg>
        <pc:spChg chg="add del mod">
          <ac:chgData name="Narang, Sonali" userId="9e80b397-6e2f-49b1-9374-ccdad8589140" providerId="ADAL" clId="{0A0D2314-D59C-5A4C-9E09-78A254E3BB4B}" dt="2021-08-31T20:34:35.056" v="616"/>
          <ac:spMkLst>
            <pc:docMk/>
            <pc:sldMk cId="3689715634" sldId="270"/>
            <ac:spMk id="266" creationId="{BBC4FA43-E694-3246-830F-C4575A85ED0E}"/>
          </ac:spMkLst>
        </pc:spChg>
        <pc:spChg chg="add del mod">
          <ac:chgData name="Narang, Sonali" userId="9e80b397-6e2f-49b1-9374-ccdad8589140" providerId="ADAL" clId="{0A0D2314-D59C-5A4C-9E09-78A254E3BB4B}" dt="2021-08-31T20:34:34.035" v="614"/>
          <ac:spMkLst>
            <pc:docMk/>
            <pc:sldMk cId="3689715634" sldId="270"/>
            <ac:spMk id="267" creationId="{DF62C808-7286-ED4E-B1BA-B93BC728CA28}"/>
          </ac:spMkLst>
        </pc:spChg>
        <pc:spChg chg="add del mod">
          <ac:chgData name="Narang, Sonali" userId="9e80b397-6e2f-49b1-9374-ccdad8589140" providerId="ADAL" clId="{0A0D2314-D59C-5A4C-9E09-78A254E3BB4B}" dt="2021-08-31T20:34:34.035" v="614"/>
          <ac:spMkLst>
            <pc:docMk/>
            <pc:sldMk cId="3689715634" sldId="270"/>
            <ac:spMk id="268" creationId="{4FDDA5D0-E383-3347-96A8-3C2631EB220A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69" creationId="{9351BF92-66A5-B541-A7A1-8563299ADCF9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0" creationId="{4E6B3DB5-3F00-AB49-8717-F72CCC8D8002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1" creationId="{031B2DF3-EB18-E549-B531-2F1599A5E643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2" creationId="{E197A545-EC7B-154A-A179-5BCB03A49504}"/>
          </ac:spMkLst>
        </pc:spChg>
        <pc:spChg chg="add del mod">
          <ac:chgData name="Narang, Sonali" userId="9e80b397-6e2f-49b1-9374-ccdad8589140" providerId="ADAL" clId="{0A0D2314-D59C-5A4C-9E09-78A254E3BB4B}" dt="2021-08-31T20:35:31.714" v="634"/>
          <ac:spMkLst>
            <pc:docMk/>
            <pc:sldMk cId="3689715634" sldId="270"/>
            <ac:spMk id="273" creationId="{25A1A055-139D-B34C-BD58-B3F595AA633E}"/>
          </ac:spMkLst>
        </pc:spChg>
        <pc:spChg chg="add del mod">
          <ac:chgData name="Narang, Sonali" userId="9e80b397-6e2f-49b1-9374-ccdad8589140" providerId="ADAL" clId="{0A0D2314-D59C-5A4C-9E09-78A254E3BB4B}" dt="2021-08-31T20:35:31.714" v="634"/>
          <ac:spMkLst>
            <pc:docMk/>
            <pc:sldMk cId="3689715634" sldId="270"/>
            <ac:spMk id="274" creationId="{76870958-FE64-6149-81F2-0EA25DC52FAF}"/>
          </ac:spMkLst>
        </pc:spChg>
        <pc:spChg chg="add del mod topLvl">
          <ac:chgData name="Narang, Sonali" userId="9e80b397-6e2f-49b1-9374-ccdad8589140" providerId="ADAL" clId="{0A0D2314-D59C-5A4C-9E09-78A254E3BB4B}" dt="2021-08-31T20:58:31.024" v="749" actId="478"/>
          <ac:spMkLst>
            <pc:docMk/>
            <pc:sldMk cId="3689715634" sldId="270"/>
            <ac:spMk id="275" creationId="{83DF7325-EFA6-8942-B344-4460A835FB14}"/>
          </ac:spMkLst>
        </pc:spChg>
        <pc:spChg chg="add del mod topLvl">
          <ac:chgData name="Narang, Sonali" userId="9e80b397-6e2f-49b1-9374-ccdad8589140" providerId="ADAL" clId="{0A0D2314-D59C-5A4C-9E09-78A254E3BB4B}" dt="2021-08-31T20:58:31.024" v="749" actId="478"/>
          <ac:spMkLst>
            <pc:docMk/>
            <pc:sldMk cId="3689715634" sldId="270"/>
            <ac:spMk id="276" creationId="{E237D35B-23C1-BA4D-9EDB-6A0BAA0B8E07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7" creationId="{9EDAEE26-8FEE-A741-AD93-F01E7CDF84A2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8" creationId="{72654F7B-FE26-9E4E-A832-E1311A0E54AD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79" creationId="{BE11FBE7-B296-5C41-99B7-1DB41B41ACB3}"/>
          </ac:spMkLst>
        </pc:spChg>
        <pc:spChg chg="add del mod">
          <ac:chgData name="Narang, Sonali" userId="9e80b397-6e2f-49b1-9374-ccdad8589140" providerId="ADAL" clId="{0A0D2314-D59C-5A4C-9E09-78A254E3BB4B}" dt="2021-08-31T20:36:47.918" v="662" actId="478"/>
          <ac:spMkLst>
            <pc:docMk/>
            <pc:sldMk cId="3689715634" sldId="270"/>
            <ac:spMk id="280" creationId="{BCB059BE-AA4A-C641-AF60-AE25BBBC329E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1" creationId="{381B379C-FFF4-BA43-AEF0-CE7C6697B0FE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2" creationId="{3C802D84-B84D-0747-8B5B-8E8FC7BACCF9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3" creationId="{DD3271AB-36F4-7F47-8663-05C1F492CE6B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4" creationId="{B1C534DB-1CA0-ED4D-BB4B-72C6294CE9FF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5" creationId="{877F2108-C3D8-1A47-86DE-4DECB9C0F296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6" creationId="{1C4D78E5-F968-A44B-A56C-055FE3833277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7" creationId="{E67230A0-7B55-234A-88CC-199B5A39C83C}"/>
          </ac:spMkLst>
        </pc:spChg>
        <pc:spChg chg="add mod">
          <ac:chgData name="Narang, Sonali" userId="9e80b397-6e2f-49b1-9374-ccdad8589140" providerId="ADAL" clId="{0A0D2314-D59C-5A4C-9E09-78A254E3BB4B}" dt="2021-08-31T20:42:17.467" v="719" actId="1035"/>
          <ac:spMkLst>
            <pc:docMk/>
            <pc:sldMk cId="3689715634" sldId="270"/>
            <ac:spMk id="288" creationId="{F3069952-00F2-AD4B-8D28-B630F6698C88}"/>
          </ac:spMkLst>
        </pc:spChg>
        <pc:spChg chg="add mod">
          <ac:chgData name="Narang, Sonali" userId="9e80b397-6e2f-49b1-9374-ccdad8589140" providerId="ADAL" clId="{0A0D2314-D59C-5A4C-9E09-78A254E3BB4B}" dt="2021-08-31T21:04:39.621" v="985" actId="1035"/>
          <ac:spMkLst>
            <pc:docMk/>
            <pc:sldMk cId="3689715634" sldId="270"/>
            <ac:spMk id="289" creationId="{5393357C-F158-BB43-A636-47F449139315}"/>
          </ac:spMkLst>
        </pc:spChg>
        <pc:spChg chg="add mod">
          <ac:chgData name="Narang, Sonali" userId="9e80b397-6e2f-49b1-9374-ccdad8589140" providerId="ADAL" clId="{0A0D2314-D59C-5A4C-9E09-78A254E3BB4B}" dt="2021-08-31T21:04:39.621" v="985" actId="1035"/>
          <ac:spMkLst>
            <pc:docMk/>
            <pc:sldMk cId="3689715634" sldId="270"/>
            <ac:spMk id="290" creationId="{3E0B9113-4DAE-A840-BC76-D7196CD198DE}"/>
          </ac:spMkLst>
        </pc:spChg>
        <pc:spChg chg="add del mod">
          <ac:chgData name="Narang, Sonali" userId="9e80b397-6e2f-49b1-9374-ccdad8589140" providerId="ADAL" clId="{0A0D2314-D59C-5A4C-9E09-78A254E3BB4B}" dt="2021-08-31T20:41:15.474" v="679"/>
          <ac:spMkLst>
            <pc:docMk/>
            <pc:sldMk cId="3689715634" sldId="270"/>
            <ac:spMk id="291" creationId="{1D25DE52-F7C5-3E42-9142-E406CAA94503}"/>
          </ac:spMkLst>
        </pc:spChg>
        <pc:spChg chg="add del mod">
          <ac:chgData name="Narang, Sonali" userId="9e80b397-6e2f-49b1-9374-ccdad8589140" providerId="ADAL" clId="{0A0D2314-D59C-5A4C-9E09-78A254E3BB4B}" dt="2021-08-31T20:41:15.474" v="679"/>
          <ac:spMkLst>
            <pc:docMk/>
            <pc:sldMk cId="3689715634" sldId="270"/>
            <ac:spMk id="292" creationId="{E28AFC10-D596-024A-8F4F-DD2B8B38FB83}"/>
          </ac:spMkLst>
        </pc:spChg>
        <pc:spChg chg="add mod">
          <ac:chgData name="Narang, Sonali" userId="9e80b397-6e2f-49b1-9374-ccdad8589140" providerId="ADAL" clId="{0A0D2314-D59C-5A4C-9E09-78A254E3BB4B}" dt="2021-08-31T21:04:39.621" v="985" actId="1035"/>
          <ac:spMkLst>
            <pc:docMk/>
            <pc:sldMk cId="3689715634" sldId="270"/>
            <ac:spMk id="293" creationId="{4EE90425-0A72-754E-ACCB-959D95FCE75E}"/>
          </ac:spMkLst>
        </pc:spChg>
        <pc:spChg chg="add mod">
          <ac:chgData name="Narang, Sonali" userId="9e80b397-6e2f-49b1-9374-ccdad8589140" providerId="ADAL" clId="{0A0D2314-D59C-5A4C-9E09-78A254E3BB4B}" dt="2021-08-31T21:04:39.621" v="985" actId="1035"/>
          <ac:spMkLst>
            <pc:docMk/>
            <pc:sldMk cId="3689715634" sldId="270"/>
            <ac:spMk id="294" creationId="{8DAA89E3-717C-F243-AB6B-7639F441D1BA}"/>
          </ac:spMkLst>
        </pc:spChg>
        <pc:spChg chg="add del mod">
          <ac:chgData name="Narang, Sonali" userId="9e80b397-6e2f-49b1-9374-ccdad8589140" providerId="ADAL" clId="{0A0D2314-D59C-5A4C-9E09-78A254E3BB4B}" dt="2021-08-31T20:59:09.420" v="757" actId="478"/>
          <ac:spMkLst>
            <pc:docMk/>
            <pc:sldMk cId="3689715634" sldId="270"/>
            <ac:spMk id="295" creationId="{719EDAC4-CE43-5D4A-B654-16CF956A17E2}"/>
          </ac:spMkLst>
        </pc:spChg>
        <pc:spChg chg="add del mod">
          <ac:chgData name="Narang, Sonali" userId="9e80b397-6e2f-49b1-9374-ccdad8589140" providerId="ADAL" clId="{0A0D2314-D59C-5A4C-9E09-78A254E3BB4B}" dt="2021-08-31T20:59:09.420" v="757" actId="478"/>
          <ac:spMkLst>
            <pc:docMk/>
            <pc:sldMk cId="3689715634" sldId="270"/>
            <ac:spMk id="296" creationId="{D49670B4-9E2F-9248-9115-B3D20F7F87A8}"/>
          </ac:spMkLst>
        </pc:spChg>
        <pc:spChg chg="add mod">
          <ac:chgData name="Narang, Sonali" userId="9e80b397-6e2f-49b1-9374-ccdad8589140" providerId="ADAL" clId="{0A0D2314-D59C-5A4C-9E09-78A254E3BB4B}" dt="2021-08-31T21:06:16.864" v="1033" actId="12788"/>
          <ac:spMkLst>
            <pc:docMk/>
            <pc:sldMk cId="3689715634" sldId="270"/>
            <ac:spMk id="297" creationId="{4D149848-106E-B94B-866B-A10BCE3DB2C1}"/>
          </ac:spMkLst>
        </pc:spChg>
        <pc:spChg chg="add mod">
          <ac:chgData name="Narang, Sonali" userId="9e80b397-6e2f-49b1-9374-ccdad8589140" providerId="ADAL" clId="{0A0D2314-D59C-5A4C-9E09-78A254E3BB4B}" dt="2021-08-31T21:06:22.063" v="1034" actId="12788"/>
          <ac:spMkLst>
            <pc:docMk/>
            <pc:sldMk cId="3689715634" sldId="270"/>
            <ac:spMk id="298" creationId="{DD6272FD-A8E8-9644-967A-E54BB8B88ADA}"/>
          </ac:spMkLst>
        </pc:spChg>
        <pc:spChg chg="add mod">
          <ac:chgData name="Narang, Sonali" userId="9e80b397-6e2f-49b1-9374-ccdad8589140" providerId="ADAL" clId="{0A0D2314-D59C-5A4C-9E09-78A254E3BB4B}" dt="2021-08-31T21:06:28.376" v="1035" actId="12788"/>
          <ac:spMkLst>
            <pc:docMk/>
            <pc:sldMk cId="3689715634" sldId="270"/>
            <ac:spMk id="299" creationId="{6411F9AF-0562-D146-A306-8C36AECFFD17}"/>
          </ac:spMkLst>
        </pc:spChg>
        <pc:spChg chg="add del mod">
          <ac:chgData name="Narang, Sonali" userId="9e80b397-6e2f-49b1-9374-ccdad8589140" providerId="ADAL" clId="{0A0D2314-D59C-5A4C-9E09-78A254E3BB4B}" dt="2021-08-31T21:00:40.876" v="879"/>
          <ac:spMkLst>
            <pc:docMk/>
            <pc:sldMk cId="3689715634" sldId="270"/>
            <ac:spMk id="300" creationId="{E6331209-8A15-AB40-A678-24E91B88867F}"/>
          </ac:spMkLst>
        </pc:spChg>
        <pc:spChg chg="add del mod">
          <ac:chgData name="Narang, Sonali" userId="9e80b397-6e2f-49b1-9374-ccdad8589140" providerId="ADAL" clId="{0A0D2314-D59C-5A4C-9E09-78A254E3BB4B}" dt="2021-08-31T21:00:40.876" v="879"/>
          <ac:spMkLst>
            <pc:docMk/>
            <pc:sldMk cId="3689715634" sldId="270"/>
            <ac:spMk id="301" creationId="{AC33091D-5560-B245-9BC1-4DAEECB4FF08}"/>
          </ac:spMkLst>
        </pc:spChg>
        <pc:spChg chg="add mod">
          <ac:chgData name="Narang, Sonali" userId="9e80b397-6e2f-49b1-9374-ccdad8589140" providerId="ADAL" clId="{0A0D2314-D59C-5A4C-9E09-78A254E3BB4B}" dt="2021-08-31T21:06:10.065" v="1032" actId="12788"/>
          <ac:spMkLst>
            <pc:docMk/>
            <pc:sldMk cId="3689715634" sldId="270"/>
            <ac:spMk id="302" creationId="{9B983567-F763-634B-8011-1389294D1AF7}"/>
          </ac:spMkLst>
        </pc:spChg>
        <pc:spChg chg="add mod">
          <ac:chgData name="Narang, Sonali" userId="9e80b397-6e2f-49b1-9374-ccdad8589140" providerId="ADAL" clId="{0A0D2314-D59C-5A4C-9E09-78A254E3BB4B}" dt="2021-08-31T21:06:16.864" v="1033" actId="12788"/>
          <ac:spMkLst>
            <pc:docMk/>
            <pc:sldMk cId="3689715634" sldId="270"/>
            <ac:spMk id="303" creationId="{F10777A8-71F2-9D4B-8777-B61E3778DE58}"/>
          </ac:spMkLst>
        </pc:spChg>
        <pc:spChg chg="add mod">
          <ac:chgData name="Narang, Sonali" userId="9e80b397-6e2f-49b1-9374-ccdad8589140" providerId="ADAL" clId="{0A0D2314-D59C-5A4C-9E09-78A254E3BB4B}" dt="2021-08-31T21:06:22.063" v="1034" actId="12788"/>
          <ac:spMkLst>
            <pc:docMk/>
            <pc:sldMk cId="3689715634" sldId="270"/>
            <ac:spMk id="304" creationId="{682015EA-986A-8C40-BAF0-1AFAF64922BF}"/>
          </ac:spMkLst>
        </pc:spChg>
        <pc:spChg chg="add mod">
          <ac:chgData name="Narang, Sonali" userId="9e80b397-6e2f-49b1-9374-ccdad8589140" providerId="ADAL" clId="{0A0D2314-D59C-5A4C-9E09-78A254E3BB4B}" dt="2021-08-31T21:06:28.376" v="1035" actId="12788"/>
          <ac:spMkLst>
            <pc:docMk/>
            <pc:sldMk cId="3689715634" sldId="270"/>
            <ac:spMk id="305" creationId="{F0D22AD7-9A66-C348-89B9-16373EF2CF28}"/>
          </ac:spMkLst>
        </pc:spChg>
        <pc:spChg chg="add mod">
          <ac:chgData name="Narang, Sonali" userId="9e80b397-6e2f-49b1-9374-ccdad8589140" providerId="ADAL" clId="{0A0D2314-D59C-5A4C-9E09-78A254E3BB4B}" dt="2021-08-31T21:06:10.065" v="1032" actId="12788"/>
          <ac:spMkLst>
            <pc:docMk/>
            <pc:sldMk cId="3689715634" sldId="270"/>
            <ac:spMk id="306" creationId="{1D48EA2E-0AE7-BD47-8F51-E85EF59BD238}"/>
          </ac:spMkLst>
        </pc:spChg>
        <pc:spChg chg="add mod">
          <ac:chgData name="Narang, Sonali" userId="9e80b397-6e2f-49b1-9374-ccdad8589140" providerId="ADAL" clId="{0A0D2314-D59C-5A4C-9E09-78A254E3BB4B}" dt="2021-08-31T21:06:16.864" v="1033" actId="12788"/>
          <ac:spMkLst>
            <pc:docMk/>
            <pc:sldMk cId="3689715634" sldId="270"/>
            <ac:spMk id="307" creationId="{5E3303B2-12D3-B741-B59F-F5CD2EDF1BF1}"/>
          </ac:spMkLst>
        </pc:spChg>
        <pc:spChg chg="add mod">
          <ac:chgData name="Narang, Sonali" userId="9e80b397-6e2f-49b1-9374-ccdad8589140" providerId="ADAL" clId="{0A0D2314-D59C-5A4C-9E09-78A254E3BB4B}" dt="2021-08-31T21:06:22.063" v="1034" actId="12788"/>
          <ac:spMkLst>
            <pc:docMk/>
            <pc:sldMk cId="3689715634" sldId="270"/>
            <ac:spMk id="308" creationId="{24515F9E-F226-5747-B91A-CB6F165E8313}"/>
          </ac:spMkLst>
        </pc:spChg>
        <pc:spChg chg="add mod">
          <ac:chgData name="Narang, Sonali" userId="9e80b397-6e2f-49b1-9374-ccdad8589140" providerId="ADAL" clId="{0A0D2314-D59C-5A4C-9E09-78A254E3BB4B}" dt="2021-08-31T21:06:28.376" v="1035" actId="12788"/>
          <ac:spMkLst>
            <pc:docMk/>
            <pc:sldMk cId="3689715634" sldId="270"/>
            <ac:spMk id="309" creationId="{75F458E9-11E1-5F4B-93CC-8F5057F10BCF}"/>
          </ac:spMkLst>
        </pc:spChg>
        <pc:spChg chg="add mod">
          <ac:chgData name="Narang, Sonali" userId="9e80b397-6e2f-49b1-9374-ccdad8589140" providerId="ADAL" clId="{0A0D2314-D59C-5A4C-9E09-78A254E3BB4B}" dt="2021-08-31T21:05:17.011" v="1025" actId="1036"/>
          <ac:spMkLst>
            <pc:docMk/>
            <pc:sldMk cId="3689715634" sldId="270"/>
            <ac:spMk id="310" creationId="{5453D535-8C47-8045-BEE0-60E9025AA019}"/>
          </ac:spMkLst>
        </pc:spChg>
        <pc:spChg chg="add mod">
          <ac:chgData name="Narang, Sonali" userId="9e80b397-6e2f-49b1-9374-ccdad8589140" providerId="ADAL" clId="{0A0D2314-D59C-5A4C-9E09-78A254E3BB4B}" dt="2021-08-31T21:05:17.011" v="1025" actId="1036"/>
          <ac:spMkLst>
            <pc:docMk/>
            <pc:sldMk cId="3689715634" sldId="270"/>
            <ac:spMk id="311" creationId="{DE739C9D-A5AE-FB4B-8600-C8CA5E54E6AA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12" creationId="{ABB99236-9992-4743-8EBE-B4E070E31B71}"/>
          </ac:spMkLst>
        </pc:spChg>
        <pc:spChg chg="add mod">
          <ac:chgData name="Narang, Sonali" userId="9e80b397-6e2f-49b1-9374-ccdad8589140" providerId="ADAL" clId="{0A0D2314-D59C-5A4C-9E09-78A254E3BB4B}" dt="2021-09-01T20:50:27.569" v="1649" actId="1076"/>
          <ac:spMkLst>
            <pc:docMk/>
            <pc:sldMk cId="3689715634" sldId="270"/>
            <ac:spMk id="313" creationId="{77EB7DE1-4B2A-A64B-B44B-752A49DCAA70}"/>
          </ac:spMkLst>
        </pc:spChg>
        <pc:spChg chg="add del mod">
          <ac:chgData name="Narang, Sonali" userId="9e80b397-6e2f-49b1-9374-ccdad8589140" providerId="ADAL" clId="{0A0D2314-D59C-5A4C-9E09-78A254E3BB4B}" dt="2021-08-31T21:07:07.832" v="1039"/>
          <ac:spMkLst>
            <pc:docMk/>
            <pc:sldMk cId="3689715634" sldId="270"/>
            <ac:spMk id="314" creationId="{59A98F62-FF8F-A949-8318-E80B10358B5B}"/>
          </ac:spMkLst>
        </pc:spChg>
        <pc:spChg chg="add mod">
          <ac:chgData name="Narang, Sonali" userId="9e80b397-6e2f-49b1-9374-ccdad8589140" providerId="ADAL" clId="{0A0D2314-D59C-5A4C-9E09-78A254E3BB4B}" dt="2021-09-01T20:38:08.116" v="1608" actId="1076"/>
          <ac:spMkLst>
            <pc:docMk/>
            <pc:sldMk cId="3689715634" sldId="270"/>
            <ac:spMk id="315" creationId="{6839DAF5-9F48-7641-A931-804708791D93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17" creationId="{DC26A5C6-17EB-3549-9961-DDC92F33224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18" creationId="{38033B51-E48F-5945-949F-08E5367A7E4C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1" creationId="{E5BE8DED-7164-0843-BEC6-19F558EF25F3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2" creationId="{15F17905-97CA-BA48-8D21-7473ED903C00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3" creationId="{C0CE3CE7-15C3-394E-9213-553127E34B35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4" creationId="{B326A5EB-97E5-5646-A67D-F57544157132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5" creationId="{2228C839-819E-854D-A1B9-F2A9A7AAA776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6" creationId="{BEBA21F5-AB8F-3B4E-813B-3958A063D178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8" creationId="{4ABD894A-D4D2-6640-A8E3-D037B832C8B4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29" creationId="{B853F2F0-5DC0-B141-A76C-F4A062A8B7A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0" creationId="{76C052DF-ED1E-C347-B9B3-EE708070A292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1" creationId="{F0CF9124-EBAB-F342-88DD-29F92E27BB3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2" creationId="{28E3F9BC-6262-E242-8CE2-D7F81FED5C18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3" creationId="{608E6DD3-9A84-864F-B3B7-8B4976DB329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4" creationId="{08D81313-DED4-344D-B4D5-1B3F59921B5D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5" creationId="{3E2EE895-9EA5-BF41-9347-7B3838482F00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6" creationId="{E9C524AD-4B85-7047-9DDE-32F6C1910F2F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7" creationId="{80998923-3D27-2141-9574-140823B97ECF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39" creationId="{C12703FF-BD7C-DB45-BEEA-D1EC6C99D3BF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0" creationId="{7590DD72-C9FF-5745-82DA-B3575C7D2CE3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1" creationId="{82261A65-FE66-4747-9073-DEBA071346B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2" creationId="{0F04FDF7-266E-2248-AE96-61A682B36D93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3" creationId="{3EAEB71E-84D7-1743-A777-BAF7FB8F69F3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4" creationId="{6E857772-A274-1242-8492-57CE6EBD88F6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5" creationId="{EC20E3F2-A4CC-9640-A764-592174C196C1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6" creationId="{73E9104A-3EF0-0A40-A9A9-F6408F340116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7" creationId="{E4FD8BFE-7666-F24B-B5FE-B2141F0CA4CE}"/>
          </ac:spMkLst>
        </pc:spChg>
        <pc:spChg chg="mod">
          <ac:chgData name="Narang, Sonali" userId="9e80b397-6e2f-49b1-9374-ccdad8589140" providerId="ADAL" clId="{0A0D2314-D59C-5A4C-9E09-78A254E3BB4B}" dt="2021-09-01T20:29:33.345" v="1490"/>
          <ac:spMkLst>
            <pc:docMk/>
            <pc:sldMk cId="3689715634" sldId="270"/>
            <ac:spMk id="348" creationId="{8678ABF6-BF0F-D94B-8D57-463A5B997FFE}"/>
          </ac:spMkLst>
        </pc:spChg>
        <pc:spChg chg="add mod">
          <ac:chgData name="Narang, Sonali" userId="9e80b397-6e2f-49b1-9374-ccdad8589140" providerId="ADAL" clId="{0A0D2314-D59C-5A4C-9E09-78A254E3BB4B}" dt="2021-09-01T20:38:17.224" v="1609" actId="1076"/>
          <ac:spMkLst>
            <pc:docMk/>
            <pc:sldMk cId="3689715634" sldId="270"/>
            <ac:spMk id="349" creationId="{B284D717-6899-BD4A-9C17-92A5C79601A4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2" creationId="{379A5418-0E89-D844-B7FF-C6B4B29344FD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3" creationId="{5A42789A-FAFE-E146-94FD-4A73FB5F6F05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4" creationId="{AB76E6A2-9C4C-5148-9DBB-0D59EE70DD3E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5" creationId="{D9375BB2-126F-9449-949B-3B28757B31BC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6" creationId="{AB71242E-B111-534E-91D1-C3D3BDA97407}"/>
          </ac:spMkLst>
        </pc:spChg>
        <pc:spChg chg="add mod">
          <ac:chgData name="Narang, Sonali" userId="9e80b397-6e2f-49b1-9374-ccdad8589140" providerId="ADAL" clId="{0A0D2314-D59C-5A4C-9E09-78A254E3BB4B}" dt="2021-09-01T20:36:51.702" v="1594" actId="465"/>
          <ac:spMkLst>
            <pc:docMk/>
            <pc:sldMk cId="3689715634" sldId="270"/>
            <ac:spMk id="357" creationId="{867BDA95-4AAB-584E-80E8-1C4B3090CB4D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58" creationId="{E60E4747-9010-3741-B4A6-87B13A58E8E3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59" creationId="{A2D8F18B-EC5B-D04C-AA40-73CED36864D7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60" creationId="{7A5B1FF4-1F95-ED4B-9D2C-976127AB747A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61" creationId="{2DC0C7B8-605B-2947-BA0A-CF28CD5F915B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62" creationId="{71919466-52A1-5B4F-8DC6-28712232305C}"/>
          </ac:spMkLst>
        </pc:spChg>
        <pc:spChg chg="add mod">
          <ac:chgData name="Narang, Sonali" userId="9e80b397-6e2f-49b1-9374-ccdad8589140" providerId="ADAL" clId="{0A0D2314-D59C-5A4C-9E09-78A254E3BB4B}" dt="2021-09-01T20:37:08.441" v="1597" actId="1076"/>
          <ac:spMkLst>
            <pc:docMk/>
            <pc:sldMk cId="3689715634" sldId="270"/>
            <ac:spMk id="363" creationId="{2588EBF6-5822-694D-9D92-05C63559D696}"/>
          </ac:spMkLst>
        </pc:spChg>
        <pc:spChg chg="add mod">
          <ac:chgData name="Narang, Sonali" userId="9e80b397-6e2f-49b1-9374-ccdad8589140" providerId="ADAL" clId="{0A0D2314-D59C-5A4C-9E09-78A254E3BB4B}" dt="2021-09-02T17:42:29.052" v="1865" actId="1035"/>
          <ac:spMkLst>
            <pc:docMk/>
            <pc:sldMk cId="3689715634" sldId="270"/>
            <ac:spMk id="364" creationId="{46AF8751-42C1-C242-A60E-5FECA6CB32E9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65" creationId="{61734530-E9B0-D647-8250-EB2CD18F7145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66" creationId="{8DD9B441-31E2-0D49-A9DA-50E53075A0A1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67" creationId="{4CC8B660-CCBF-0649-9AFD-105F3D569422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68" creationId="{A88BD4E5-5C34-4747-81C8-B3E5D23AA437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69" creationId="{B46FDF36-65FD-734F-A543-DA3F799ED5E7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0" creationId="{7EE1444E-7499-BB4B-9361-8F74896A9345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1" creationId="{41114D15-C59C-8B46-BB3E-9EB866410106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2" creationId="{880DEDF1-C6E4-4A4E-AB1C-78C9732BEFD5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3" creationId="{0DF03628-7569-F94D-8F88-9F2347E91737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4" creationId="{74E59F51-D65E-AB47-9C51-8F7E64826BCB}"/>
          </ac:spMkLst>
        </pc:spChg>
        <pc:spChg chg="add mod">
          <ac:chgData name="Narang, Sonali" userId="9e80b397-6e2f-49b1-9374-ccdad8589140" providerId="ADAL" clId="{0A0D2314-D59C-5A4C-9E09-78A254E3BB4B}" dt="2021-11-02T15:28:32.443" v="3200" actId="1038"/>
          <ac:spMkLst>
            <pc:docMk/>
            <pc:sldMk cId="3689715634" sldId="270"/>
            <ac:spMk id="375" creationId="{D72D11F1-4BAB-5B42-BADE-4D5E76BE5E70}"/>
          </ac:spMkLst>
        </pc:spChg>
        <pc:grpChg chg="mod">
          <ac:chgData name="Narang, Sonali" userId="9e80b397-6e2f-49b1-9374-ccdad8589140" providerId="ADAL" clId="{0A0D2314-D59C-5A4C-9E09-78A254E3BB4B}" dt="2021-09-02T17:42:56.016" v="1902" actId="1038"/>
          <ac:grpSpMkLst>
            <pc:docMk/>
            <pc:sldMk cId="3689715634" sldId="270"/>
            <ac:grpSpMk id="10" creationId="{D88D7517-4649-454B-B33B-40859B6B3E1E}"/>
          </ac:grpSpMkLst>
        </pc:grpChg>
        <pc:grpChg chg="del">
          <ac:chgData name="Narang, Sonali" userId="9e80b397-6e2f-49b1-9374-ccdad8589140" providerId="ADAL" clId="{0A0D2314-D59C-5A4C-9E09-78A254E3BB4B}" dt="2021-08-31T19:53:34.725" v="61" actId="478"/>
          <ac:grpSpMkLst>
            <pc:docMk/>
            <pc:sldMk cId="3689715634" sldId="270"/>
            <ac:grpSpMk id="24" creationId="{1C799EA5-FBE0-5B46-813F-EF20A1A81420}"/>
          </ac:grpSpMkLst>
        </pc:grpChg>
        <pc:grpChg chg="del">
          <ac:chgData name="Narang, Sonali" userId="9e80b397-6e2f-49b1-9374-ccdad8589140" providerId="ADAL" clId="{0A0D2314-D59C-5A4C-9E09-78A254E3BB4B}" dt="2021-08-31T19:53:34.725" v="61" actId="478"/>
          <ac:grpSpMkLst>
            <pc:docMk/>
            <pc:sldMk cId="3689715634" sldId="270"/>
            <ac:grpSpMk id="25" creationId="{209DE69F-C181-9B41-A954-044CD88589A7}"/>
          </ac:grpSpMkLst>
        </pc:grpChg>
        <pc:grpChg chg="add del mod">
          <ac:chgData name="Narang, Sonali" userId="9e80b397-6e2f-49b1-9374-ccdad8589140" providerId="ADAL" clId="{0A0D2314-D59C-5A4C-9E09-78A254E3BB4B}" dt="2021-08-31T20:58:31.024" v="749" actId="478"/>
          <ac:grpSpMkLst>
            <pc:docMk/>
            <pc:sldMk cId="3689715634" sldId="270"/>
            <ac:grpSpMk id="30" creationId="{285BA8FD-C5ED-0D4C-9782-BB9D820496BA}"/>
          </ac:grpSpMkLst>
        </pc:grpChg>
        <pc:grpChg chg="add del">
          <ac:chgData name="Narang, Sonali" userId="9e80b397-6e2f-49b1-9374-ccdad8589140" providerId="ADAL" clId="{0A0D2314-D59C-5A4C-9E09-78A254E3BB4B}" dt="2021-08-31T20:58:29.041" v="748" actId="478"/>
          <ac:grpSpMkLst>
            <pc:docMk/>
            <pc:sldMk cId="3689715634" sldId="270"/>
            <ac:grpSpMk id="31" creationId="{206E2753-3E65-6C4C-9C9C-57E34CE88F41}"/>
          </ac:grpSpMkLst>
        </pc:grpChg>
        <pc:grpChg chg="add del mod">
          <ac:chgData name="Narang, Sonali" userId="9e80b397-6e2f-49b1-9374-ccdad8589140" providerId="ADAL" clId="{0A0D2314-D59C-5A4C-9E09-78A254E3BB4B}" dt="2021-08-31T20:58:29.041" v="748" actId="478"/>
          <ac:grpSpMkLst>
            <pc:docMk/>
            <pc:sldMk cId="3689715634" sldId="270"/>
            <ac:grpSpMk id="33" creationId="{D99F6AF7-FF55-4642-8B4D-2DEC66AA1350}"/>
          </ac:grpSpMkLst>
        </pc:grpChg>
        <pc:grpChg chg="add del mod">
          <ac:chgData name="Narang, Sonali" userId="9e80b397-6e2f-49b1-9374-ccdad8589140" providerId="ADAL" clId="{0A0D2314-D59C-5A4C-9E09-78A254E3BB4B}" dt="2021-11-03T16:43:12.356" v="4064" actId="478"/>
          <ac:grpSpMkLst>
            <pc:docMk/>
            <pc:sldMk cId="3689715634" sldId="270"/>
            <ac:grpSpMk id="41" creationId="{632D9D10-8AFF-124D-8358-7B9E576BBF36}"/>
          </ac:grpSpMkLst>
        </pc:grpChg>
        <pc:grpChg chg="add mod">
          <ac:chgData name="Narang, Sonali" userId="9e80b397-6e2f-49b1-9374-ccdad8589140" providerId="ADAL" clId="{0A0D2314-D59C-5A4C-9E09-78A254E3BB4B}" dt="2021-11-02T15:26:00.641" v="3125" actId="1035"/>
          <ac:grpSpMkLst>
            <pc:docMk/>
            <pc:sldMk cId="3689715634" sldId="270"/>
            <ac:grpSpMk id="46" creationId="{1D656AA7-BF93-324F-8145-84031443819A}"/>
          </ac:grpSpMkLst>
        </pc:grpChg>
        <pc:grpChg chg="add mod">
          <ac:chgData name="Narang, Sonali" userId="9e80b397-6e2f-49b1-9374-ccdad8589140" providerId="ADAL" clId="{0A0D2314-D59C-5A4C-9E09-78A254E3BB4B}" dt="2021-11-02T15:26:00.641" v="3125" actId="1035"/>
          <ac:grpSpMkLst>
            <pc:docMk/>
            <pc:sldMk cId="3689715634" sldId="270"/>
            <ac:grpSpMk id="47" creationId="{145390D4-7335-A243-9C78-692A14A8C962}"/>
          </ac:grpSpMkLst>
        </pc:grpChg>
        <pc:grpChg chg="add mod">
          <ac:chgData name="Narang, Sonali" userId="9e80b397-6e2f-49b1-9374-ccdad8589140" providerId="ADAL" clId="{0A0D2314-D59C-5A4C-9E09-78A254E3BB4B}" dt="2021-09-02T17:40:34.393" v="1813" actId="1037"/>
          <ac:grpSpMkLst>
            <pc:docMk/>
            <pc:sldMk cId="3689715634" sldId="270"/>
            <ac:grpSpMk id="52" creationId="{121D36F1-E530-9740-9DD6-FFD6045456A1}"/>
          </ac:grpSpMkLst>
        </pc:grpChg>
        <pc:grpChg chg="add del mod">
          <ac:chgData name="Narang, Sonali" userId="9e80b397-6e2f-49b1-9374-ccdad8589140" providerId="ADAL" clId="{0A0D2314-D59C-5A4C-9E09-78A254E3BB4B}" dt="2021-11-02T15:20:38.417" v="3057" actId="478"/>
          <ac:grpSpMkLst>
            <pc:docMk/>
            <pc:sldMk cId="3689715634" sldId="270"/>
            <ac:grpSpMk id="55" creationId="{C48484BF-FA3D-5C4E-8FDE-5FA0BF6F602C}"/>
          </ac:grpSpMkLst>
        </pc:grpChg>
        <pc:grpChg chg="mod">
          <ac:chgData name="Narang, Sonali" userId="9e80b397-6e2f-49b1-9374-ccdad8589140" providerId="ADAL" clId="{0A0D2314-D59C-5A4C-9E09-78A254E3BB4B}" dt="2021-11-02T15:26:18.073" v="3135" actId="1038"/>
          <ac:grpSpMkLst>
            <pc:docMk/>
            <pc:sldMk cId="3689715634" sldId="270"/>
            <ac:grpSpMk id="96" creationId="{F3AA89EB-F925-3649-A3BE-B492BEBFEFFB}"/>
          </ac:grpSpMkLst>
        </pc:grpChg>
        <pc:grpChg chg="add mod">
          <ac:chgData name="Narang, Sonali" userId="9e80b397-6e2f-49b1-9374-ccdad8589140" providerId="ADAL" clId="{0A0D2314-D59C-5A4C-9E09-78A254E3BB4B}" dt="2021-08-31T19:58:38.167" v="165" actId="1076"/>
          <ac:grpSpMkLst>
            <pc:docMk/>
            <pc:sldMk cId="3689715634" sldId="270"/>
            <ac:grpSpMk id="122" creationId="{239EC649-4054-9B49-9002-BC392B726FB3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23" creationId="{7C13DB68-C53B-EC42-812E-C4159D83C6AB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33" creationId="{497978F6-6248-0448-BDB6-E930C0A72DC5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34" creationId="{6ADD9F58-CF53-6949-9EF6-BD4229FB636E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46" creationId="{B901738C-025B-3743-85CC-6F9FA17C0389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47" creationId="{A59F7185-D039-AA4D-9E54-8587A4AB6665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48" creationId="{286E0120-519E-C641-B03F-ABF9A696ADD0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85" creationId="{336C0266-122B-3F45-AA85-12F09DDD0A00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86" creationId="{E3610C00-C173-6143-9E74-979DF156322F}"/>
          </ac:grpSpMkLst>
        </pc:grpChg>
        <pc:grpChg chg="mod">
          <ac:chgData name="Narang, Sonali" userId="9e80b397-6e2f-49b1-9374-ccdad8589140" providerId="ADAL" clId="{0A0D2314-D59C-5A4C-9E09-78A254E3BB4B}" dt="2021-08-31T19:51:49.591" v="4"/>
          <ac:grpSpMkLst>
            <pc:docMk/>
            <pc:sldMk cId="3689715634" sldId="270"/>
            <ac:grpSpMk id="187" creationId="{92ACC8F8-83AD-C846-A9E0-D13727C22868}"/>
          </ac:grpSpMkLst>
        </pc:grpChg>
        <pc:grpChg chg="add del mod">
          <ac:chgData name="Narang, Sonali" userId="9e80b397-6e2f-49b1-9374-ccdad8589140" providerId="ADAL" clId="{0A0D2314-D59C-5A4C-9E09-78A254E3BB4B}" dt="2021-09-01T20:29:34.596" v="1491"/>
          <ac:grpSpMkLst>
            <pc:docMk/>
            <pc:sldMk cId="3689715634" sldId="270"/>
            <ac:grpSpMk id="316" creationId="{C4352ECC-D79F-8044-91DB-992A58F2125A}"/>
          </ac:grpSpMkLst>
        </pc:grpChg>
        <pc:grpChg chg="mod">
          <ac:chgData name="Narang, Sonali" userId="9e80b397-6e2f-49b1-9374-ccdad8589140" providerId="ADAL" clId="{0A0D2314-D59C-5A4C-9E09-78A254E3BB4B}" dt="2021-09-01T20:29:33.345" v="1490"/>
          <ac:grpSpMkLst>
            <pc:docMk/>
            <pc:sldMk cId="3689715634" sldId="270"/>
            <ac:grpSpMk id="319" creationId="{45FE2832-267B-5C48-AB29-68E088C89CB9}"/>
          </ac:grpSpMkLst>
        </pc:grpChg>
        <pc:grpChg chg="mod">
          <ac:chgData name="Narang, Sonali" userId="9e80b397-6e2f-49b1-9374-ccdad8589140" providerId="ADAL" clId="{0A0D2314-D59C-5A4C-9E09-78A254E3BB4B}" dt="2021-09-01T20:29:33.345" v="1490"/>
          <ac:grpSpMkLst>
            <pc:docMk/>
            <pc:sldMk cId="3689715634" sldId="270"/>
            <ac:grpSpMk id="320" creationId="{631F38F8-8F7B-6E45-83D9-0A27A8D4DE4A}"/>
          </ac:grpSpMkLst>
        </pc:grpChg>
        <pc:grpChg chg="mod">
          <ac:chgData name="Narang, Sonali" userId="9e80b397-6e2f-49b1-9374-ccdad8589140" providerId="ADAL" clId="{0A0D2314-D59C-5A4C-9E09-78A254E3BB4B}" dt="2021-09-01T20:29:33.345" v="1490"/>
          <ac:grpSpMkLst>
            <pc:docMk/>
            <pc:sldMk cId="3689715634" sldId="270"/>
            <ac:grpSpMk id="327" creationId="{DA90C16D-C8E8-A842-B121-031809249AB8}"/>
          </ac:grpSpMkLst>
        </pc:grpChg>
        <pc:grpChg chg="mod">
          <ac:chgData name="Narang, Sonali" userId="9e80b397-6e2f-49b1-9374-ccdad8589140" providerId="ADAL" clId="{0A0D2314-D59C-5A4C-9E09-78A254E3BB4B}" dt="2021-09-01T20:29:33.345" v="1490"/>
          <ac:grpSpMkLst>
            <pc:docMk/>
            <pc:sldMk cId="3689715634" sldId="270"/>
            <ac:grpSpMk id="338" creationId="{C38E10FD-AB72-5F40-AEA4-94BB3BC0E2E5}"/>
          </ac:grpSpMkLst>
        </pc:grpChg>
        <pc:picChg chg="add del mod modCrop">
          <ac:chgData name="Narang, Sonali" userId="9e80b397-6e2f-49b1-9374-ccdad8589140" providerId="ADAL" clId="{0A0D2314-D59C-5A4C-9E09-78A254E3BB4B}" dt="2021-11-02T15:23:25.022" v="3089" actId="478"/>
          <ac:picMkLst>
            <pc:docMk/>
            <pc:sldMk cId="3689715634" sldId="270"/>
            <ac:picMk id="9" creationId="{6650C3C0-812F-A34E-ADD3-2CDF0B5EF55B}"/>
          </ac:picMkLst>
        </pc:picChg>
        <pc:picChg chg="add del mod modCrop">
          <ac:chgData name="Narang, Sonali" userId="9e80b397-6e2f-49b1-9374-ccdad8589140" providerId="ADAL" clId="{0A0D2314-D59C-5A4C-9E09-78A254E3BB4B}" dt="2021-08-31T20:23:28.025" v="427" actId="478"/>
          <ac:picMkLst>
            <pc:docMk/>
            <pc:sldMk cId="3689715634" sldId="270"/>
            <ac:picMk id="11" creationId="{E982DD7B-3823-3746-A1E8-F2F275EFB3A2}"/>
          </ac:picMkLst>
        </pc:picChg>
        <pc:picChg chg="add mod modCrop">
          <ac:chgData name="Narang, Sonali" userId="9e80b397-6e2f-49b1-9374-ccdad8589140" providerId="ADAL" clId="{0A0D2314-D59C-5A4C-9E09-78A254E3BB4B}" dt="2021-11-02T15:27:44.401" v="3169" actId="1076"/>
          <ac:picMkLst>
            <pc:docMk/>
            <pc:sldMk cId="3689715634" sldId="270"/>
            <ac:picMk id="12" creationId="{28C8A256-08EE-4349-B43E-6F7FEDDEA277}"/>
          </ac:picMkLst>
        </pc:picChg>
        <pc:picChg chg="del">
          <ac:chgData name="Narang, Sonali" userId="9e80b397-6e2f-49b1-9374-ccdad8589140" providerId="ADAL" clId="{0A0D2314-D59C-5A4C-9E09-78A254E3BB4B}" dt="2021-08-31T19:51:52.968" v="5" actId="21"/>
          <ac:picMkLst>
            <pc:docMk/>
            <pc:sldMk cId="3689715634" sldId="270"/>
            <ac:picMk id="12" creationId="{6F3D5D04-082E-A94E-B674-0CC25F5EF539}"/>
          </ac:picMkLst>
        </pc:picChg>
        <pc:picChg chg="add mod modCrop">
          <ac:chgData name="Narang, Sonali" userId="9e80b397-6e2f-49b1-9374-ccdad8589140" providerId="ADAL" clId="{0A0D2314-D59C-5A4C-9E09-78A254E3BB4B}" dt="2021-11-02T15:27:18.767" v="3163" actId="1037"/>
          <ac:picMkLst>
            <pc:docMk/>
            <pc:sldMk cId="3689715634" sldId="270"/>
            <ac:picMk id="15" creationId="{0E21C0CF-B23A-2F45-AD3C-0305B7C37521}"/>
          </ac:picMkLst>
        </pc:picChg>
        <pc:picChg chg="del mod">
          <ac:chgData name="Narang, Sonali" userId="9e80b397-6e2f-49b1-9374-ccdad8589140" providerId="ADAL" clId="{0A0D2314-D59C-5A4C-9E09-78A254E3BB4B}" dt="2021-08-31T20:02:15.929" v="232" actId="478"/>
          <ac:picMkLst>
            <pc:docMk/>
            <pc:sldMk cId="3689715634" sldId="270"/>
            <ac:picMk id="23" creationId="{F4E04DD6-E91E-DA48-812D-B7942BE0CA2A}"/>
          </ac:picMkLst>
        </pc:picChg>
        <pc:picChg chg="add mod modCrop">
          <ac:chgData name="Narang, Sonali" userId="9e80b397-6e2f-49b1-9374-ccdad8589140" providerId="ADAL" clId="{0A0D2314-D59C-5A4C-9E09-78A254E3BB4B}" dt="2021-09-01T20:33:50.901" v="1557" actId="1076"/>
          <ac:picMkLst>
            <pc:docMk/>
            <pc:sldMk cId="3689715634" sldId="270"/>
            <ac:picMk id="44" creationId="{45F9C4F8-7759-4642-9E93-C322F93DD2DA}"/>
          </ac:picMkLst>
        </pc:picChg>
        <pc:picChg chg="add mod modCrop">
          <ac:chgData name="Narang, Sonali" userId="9e80b397-6e2f-49b1-9374-ccdad8589140" providerId="ADAL" clId="{0A0D2314-D59C-5A4C-9E09-78A254E3BB4B}" dt="2021-09-01T20:34:03.373" v="1559" actId="1076"/>
          <ac:picMkLst>
            <pc:docMk/>
            <pc:sldMk cId="3689715634" sldId="270"/>
            <ac:picMk id="45" creationId="{583C3CDA-E65C-DA47-BFAF-ADC04F7DE9AF}"/>
          </ac:picMkLst>
        </pc:picChg>
        <pc:picChg chg="add del mod">
          <ac:chgData name="Narang, Sonali" userId="9e80b397-6e2f-49b1-9374-ccdad8589140" providerId="ADAL" clId="{0A0D2314-D59C-5A4C-9E09-78A254E3BB4B}" dt="2021-09-02T17:29:55.894" v="1742" actId="478"/>
          <ac:picMkLst>
            <pc:docMk/>
            <pc:sldMk cId="3689715634" sldId="270"/>
            <ac:picMk id="49" creationId="{86C2995C-5E9B-F448-8E20-3AE5A468AE77}"/>
          </ac:picMkLst>
        </pc:picChg>
        <pc:picChg chg="add mod">
          <ac:chgData name="Narang, Sonali" userId="9e80b397-6e2f-49b1-9374-ccdad8589140" providerId="ADAL" clId="{0A0D2314-D59C-5A4C-9E09-78A254E3BB4B}" dt="2021-09-02T17:39:17.097" v="1783" actId="1076"/>
          <ac:picMkLst>
            <pc:docMk/>
            <pc:sldMk cId="3689715634" sldId="270"/>
            <ac:picMk id="50" creationId="{6B3F6CBA-A5F9-924B-8310-6AAB1482AEC6}"/>
          </ac:picMkLst>
        </pc:picChg>
        <pc:picChg chg="add mod modCrop">
          <ac:chgData name="Narang, Sonali" userId="9e80b397-6e2f-49b1-9374-ccdad8589140" providerId="ADAL" clId="{0A0D2314-D59C-5A4C-9E09-78A254E3BB4B}" dt="2021-09-02T17:40:29.054" v="1811" actId="732"/>
          <ac:picMkLst>
            <pc:docMk/>
            <pc:sldMk cId="3689715634" sldId="270"/>
            <ac:picMk id="54" creationId="{F028A583-1B1F-534A-B5D7-49A98482016C}"/>
          </ac:picMkLst>
        </pc:picChg>
        <pc:picChg chg="del">
          <ac:chgData name="Narang, Sonali" userId="9e80b397-6e2f-49b1-9374-ccdad8589140" providerId="ADAL" clId="{0A0D2314-D59C-5A4C-9E09-78A254E3BB4B}" dt="2021-08-31T19:53:34.725" v="61" actId="478"/>
          <ac:picMkLst>
            <pc:docMk/>
            <pc:sldMk cId="3689715634" sldId="270"/>
            <ac:picMk id="119" creationId="{49F46577-C9D3-1B41-9090-7C81FC720B1E}"/>
          </ac:picMkLst>
        </pc:picChg>
        <pc:picChg chg="del">
          <ac:chgData name="Narang, Sonali" userId="9e80b397-6e2f-49b1-9374-ccdad8589140" providerId="ADAL" clId="{0A0D2314-D59C-5A4C-9E09-78A254E3BB4B}" dt="2021-08-31T19:53:34.725" v="61" actId="478"/>
          <ac:picMkLst>
            <pc:docMk/>
            <pc:sldMk cId="3689715634" sldId="270"/>
            <ac:picMk id="120" creationId="{F74CFB0B-61C9-F640-9317-B8984AD45800}"/>
          </ac:picMkLst>
        </pc:picChg>
        <pc:picChg chg="del">
          <ac:chgData name="Narang, Sonali" userId="9e80b397-6e2f-49b1-9374-ccdad8589140" providerId="ADAL" clId="{0A0D2314-D59C-5A4C-9E09-78A254E3BB4B}" dt="2021-08-31T19:53:34.725" v="61" actId="478"/>
          <ac:picMkLst>
            <pc:docMk/>
            <pc:sldMk cId="3689715634" sldId="270"/>
            <ac:picMk id="121" creationId="{6C6532E8-B1B8-D14C-9198-7E75AFE7A9DE}"/>
          </ac:picMkLst>
        </pc:picChg>
        <pc:picChg chg="mod">
          <ac:chgData name="Narang, Sonali" userId="9e80b397-6e2f-49b1-9374-ccdad8589140" providerId="ADAL" clId="{0A0D2314-D59C-5A4C-9E09-78A254E3BB4B}" dt="2021-08-31T19:51:49.591" v="4"/>
          <ac:picMkLst>
            <pc:docMk/>
            <pc:sldMk cId="3689715634" sldId="270"/>
            <ac:picMk id="129" creationId="{B0F792E7-B882-3E44-A0DE-5A8104EE8479}"/>
          </ac:picMkLst>
        </pc:picChg>
        <pc:picChg chg="mod">
          <ac:chgData name="Narang, Sonali" userId="9e80b397-6e2f-49b1-9374-ccdad8589140" providerId="ADAL" clId="{0A0D2314-D59C-5A4C-9E09-78A254E3BB4B}" dt="2021-08-31T19:51:49.591" v="4"/>
          <ac:picMkLst>
            <pc:docMk/>
            <pc:sldMk cId="3689715634" sldId="270"/>
            <ac:picMk id="138" creationId="{0A4C2E55-3F88-1A47-B4F1-1D1EF8D53A08}"/>
          </ac:picMkLst>
        </pc:picChg>
        <pc:picChg chg="mod">
          <ac:chgData name="Narang, Sonali" userId="9e80b397-6e2f-49b1-9374-ccdad8589140" providerId="ADAL" clId="{0A0D2314-D59C-5A4C-9E09-78A254E3BB4B}" dt="2021-08-31T19:51:49.591" v="4"/>
          <ac:picMkLst>
            <pc:docMk/>
            <pc:sldMk cId="3689715634" sldId="270"/>
            <ac:picMk id="142" creationId="{84ED2F54-6C51-1B4F-B4DE-9B25C5508A73}"/>
          </ac:picMkLst>
        </pc:picChg>
        <pc:picChg chg="mod">
          <ac:chgData name="Narang, Sonali" userId="9e80b397-6e2f-49b1-9374-ccdad8589140" providerId="ADAL" clId="{0A0D2314-D59C-5A4C-9E09-78A254E3BB4B}" dt="2021-08-31T19:51:49.591" v="4"/>
          <ac:picMkLst>
            <pc:docMk/>
            <pc:sldMk cId="3689715634" sldId="270"/>
            <ac:picMk id="143" creationId="{A47EF50E-E2E9-4849-AB8E-424B95974F50}"/>
          </ac:picMkLst>
        </pc:picChg>
        <pc:picChg chg="add mod modCrop">
          <ac:chgData name="Narang, Sonali" userId="9e80b397-6e2f-49b1-9374-ccdad8589140" providerId="ADAL" clId="{0A0D2314-D59C-5A4C-9E09-78A254E3BB4B}" dt="2021-11-02T15:27:47.483" v="3174" actId="1037"/>
          <ac:picMkLst>
            <pc:docMk/>
            <pc:sldMk cId="3689715634" sldId="270"/>
            <ac:picMk id="192" creationId="{EC366B67-B3CE-5749-AB74-BC5A19C67D22}"/>
          </ac:picMkLst>
        </pc:picChg>
        <pc:picChg chg="add del mod">
          <ac:chgData name="Narang, Sonali" userId="9e80b397-6e2f-49b1-9374-ccdad8589140" providerId="ADAL" clId="{0A0D2314-D59C-5A4C-9E09-78A254E3BB4B}" dt="2021-08-31T21:11:50.287" v="1064" actId="21"/>
          <ac:picMkLst>
            <pc:docMk/>
            <pc:sldMk cId="3689715634" sldId="270"/>
            <ac:picMk id="255" creationId="{33EE4828-CCD1-4249-BA6C-6D1280C85CF2}"/>
          </ac:picMkLst>
        </pc:picChg>
        <pc:picChg chg="add del mod">
          <ac:chgData name="Narang, Sonali" userId="9e80b397-6e2f-49b1-9374-ccdad8589140" providerId="ADAL" clId="{0A0D2314-D59C-5A4C-9E09-78A254E3BB4B}" dt="2021-08-31T21:11:50.287" v="1064" actId="21"/>
          <ac:picMkLst>
            <pc:docMk/>
            <pc:sldMk cId="3689715634" sldId="270"/>
            <ac:picMk id="256" creationId="{3B9550FE-22FF-3043-9CAF-6F0C92E7BF34}"/>
          </ac:picMkLst>
        </pc:picChg>
        <pc:picChg chg="add del mod">
          <ac:chgData name="Narang, Sonali" userId="9e80b397-6e2f-49b1-9374-ccdad8589140" providerId="ADAL" clId="{0A0D2314-D59C-5A4C-9E09-78A254E3BB4B}" dt="2021-08-31T21:11:50.287" v="1064" actId="21"/>
          <ac:picMkLst>
            <pc:docMk/>
            <pc:sldMk cId="3689715634" sldId="270"/>
            <ac:picMk id="257" creationId="{15665700-9F79-304C-91AD-BCBD760376FE}"/>
          </ac:picMkLst>
        </pc:picChg>
        <pc:picChg chg="add mod modCrop">
          <ac:chgData name="Narang, Sonali" userId="9e80b397-6e2f-49b1-9374-ccdad8589140" providerId="ADAL" clId="{0A0D2314-D59C-5A4C-9E09-78A254E3BB4B}" dt="2021-09-01T20:33:50.901" v="1557" actId="1076"/>
          <ac:picMkLst>
            <pc:docMk/>
            <pc:sldMk cId="3689715634" sldId="270"/>
            <ac:picMk id="350" creationId="{04585CD6-CFC4-E542-B9D6-CF23C5C8D7F6}"/>
          </ac:picMkLst>
        </pc:picChg>
        <pc:picChg chg="add mod modCrop">
          <ac:chgData name="Narang, Sonali" userId="9e80b397-6e2f-49b1-9374-ccdad8589140" providerId="ADAL" clId="{0A0D2314-D59C-5A4C-9E09-78A254E3BB4B}" dt="2021-09-01T20:33:54.913" v="1558" actId="1076"/>
          <ac:picMkLst>
            <pc:docMk/>
            <pc:sldMk cId="3689715634" sldId="270"/>
            <ac:picMk id="351" creationId="{50747652-4CDB-D741-ADF4-E1FA3601696A}"/>
          </ac:picMkLst>
        </pc:picChg>
        <pc:cxnChg chg="add del">
          <ac:chgData name="Narang, Sonali" userId="9e80b397-6e2f-49b1-9374-ccdad8589140" providerId="ADAL" clId="{0A0D2314-D59C-5A4C-9E09-78A254E3BB4B}" dt="2021-11-02T14:33:17.957" v="2997" actId="11529"/>
          <ac:cxnSpMkLst>
            <pc:docMk/>
            <pc:sldMk cId="3689715634" sldId="270"/>
            <ac:cxnSpMk id="3" creationId="{674FA4FF-EDFA-694A-B273-A9D79CF5F518}"/>
          </ac:cxnSpMkLst>
        </pc:cxnChg>
        <pc:cxnChg chg="mod">
          <ac:chgData name="Narang, Sonali" userId="9e80b397-6e2f-49b1-9374-ccdad8589140" providerId="ADAL" clId="{0A0D2314-D59C-5A4C-9E09-78A254E3BB4B}" dt="2021-08-31T19:51:49.591" v="4"/>
          <ac:cxnSpMkLst>
            <pc:docMk/>
            <pc:sldMk cId="3689715634" sldId="270"/>
            <ac:cxnSpMk id="130" creationId="{D127FA20-59CF-AF4C-A355-72D556FF9D43}"/>
          </ac:cxnSpMkLst>
        </pc:cxnChg>
        <pc:cxnChg chg="mod">
          <ac:chgData name="Narang, Sonali" userId="9e80b397-6e2f-49b1-9374-ccdad8589140" providerId="ADAL" clId="{0A0D2314-D59C-5A4C-9E09-78A254E3BB4B}" dt="2021-08-31T19:51:49.591" v="4"/>
          <ac:cxnSpMkLst>
            <pc:docMk/>
            <pc:sldMk cId="3689715634" sldId="270"/>
            <ac:cxnSpMk id="131" creationId="{4AC924D3-9FF2-BC4E-A7B0-E41570383C00}"/>
          </ac:cxnSpMkLst>
        </pc:cxnChg>
        <pc:cxnChg chg="mod">
          <ac:chgData name="Narang, Sonali" userId="9e80b397-6e2f-49b1-9374-ccdad8589140" providerId="ADAL" clId="{0A0D2314-D59C-5A4C-9E09-78A254E3BB4B}" dt="2021-08-31T19:51:49.591" v="4"/>
          <ac:cxnSpMkLst>
            <pc:docMk/>
            <pc:sldMk cId="3689715634" sldId="270"/>
            <ac:cxnSpMk id="135" creationId="{1B6C8F03-B833-244A-9EDE-4128B1822E3A}"/>
          </ac:cxnSpMkLst>
        </pc:cxnChg>
      </pc:sldChg>
      <pc:sldChg chg="addSp delSp modSp del mod ord">
        <pc:chgData name="Narang, Sonali" userId="9e80b397-6e2f-49b1-9374-ccdad8589140" providerId="ADAL" clId="{0A0D2314-D59C-5A4C-9E09-78A254E3BB4B}" dt="2021-09-01T21:36:55.396" v="1718" actId="2696"/>
        <pc:sldMkLst>
          <pc:docMk/>
          <pc:sldMk cId="2499962631" sldId="271"/>
        </pc:sldMkLst>
        <pc:grpChg chg="del">
          <ac:chgData name="Narang, Sonali" userId="9e80b397-6e2f-49b1-9374-ccdad8589140" providerId="ADAL" clId="{0A0D2314-D59C-5A4C-9E09-78A254E3BB4B}" dt="2021-08-31T20:03:25.675" v="265" actId="21"/>
          <ac:grpSpMkLst>
            <pc:docMk/>
            <pc:sldMk cId="2499962631" sldId="271"/>
            <ac:grpSpMk id="99" creationId="{EF961429-6A7A-714D-AAED-DF577F155CDA}"/>
          </ac:grpSpMkLst>
        </pc:grpChg>
        <pc:grpChg chg="add del mod">
          <ac:chgData name="Narang, Sonali" userId="9e80b397-6e2f-49b1-9374-ccdad8589140" providerId="ADAL" clId="{0A0D2314-D59C-5A4C-9E09-78A254E3BB4B}" dt="2021-08-31T20:00:15.713" v="218" actId="478"/>
          <ac:grpSpMkLst>
            <pc:docMk/>
            <pc:sldMk cId="2499962631" sldId="271"/>
            <ac:grpSpMk id="121" creationId="{D382BF2F-F6F7-0546-8A3A-3F285CDE1EF7}"/>
          </ac:grpSpMkLst>
        </pc:grpChg>
        <pc:grpChg chg="del">
          <ac:chgData name="Narang, Sonali" userId="9e80b397-6e2f-49b1-9374-ccdad8589140" providerId="ADAL" clId="{0A0D2314-D59C-5A4C-9E09-78A254E3BB4B}" dt="2021-08-31T20:03:21.133" v="264" actId="478"/>
          <ac:grpSpMkLst>
            <pc:docMk/>
            <pc:sldMk cId="2499962631" sldId="271"/>
            <ac:grpSpMk id="142" creationId="{DFC3FF12-35BE-6D41-8314-C8F8C7DA6614}"/>
          </ac:grpSpMkLst>
        </pc:grpChg>
        <pc:grpChg chg="del">
          <ac:chgData name="Narang, Sonali" userId="9e80b397-6e2f-49b1-9374-ccdad8589140" providerId="ADAL" clId="{0A0D2314-D59C-5A4C-9E09-78A254E3BB4B}" dt="2021-08-31T20:03:21.133" v="264" actId="478"/>
          <ac:grpSpMkLst>
            <pc:docMk/>
            <pc:sldMk cId="2499962631" sldId="271"/>
            <ac:grpSpMk id="143" creationId="{5CD3143B-E8B4-6941-ADC1-31DDC1651046}"/>
          </ac:grpSpMkLst>
        </pc:grpChg>
        <pc:grpChg chg="del">
          <ac:chgData name="Narang, Sonali" userId="9e80b397-6e2f-49b1-9374-ccdad8589140" providerId="ADAL" clId="{0A0D2314-D59C-5A4C-9E09-78A254E3BB4B}" dt="2021-08-31T20:03:21.133" v="264" actId="478"/>
          <ac:grpSpMkLst>
            <pc:docMk/>
            <pc:sldMk cId="2499962631" sldId="271"/>
            <ac:grpSpMk id="144" creationId="{76FD492A-A603-C049-9A9D-FD0E9004D645}"/>
          </ac:grpSpMkLst>
        </pc:grpChg>
        <pc:picChg chg="del">
          <ac:chgData name="Narang, Sonali" userId="9e80b397-6e2f-49b1-9374-ccdad8589140" providerId="ADAL" clId="{0A0D2314-D59C-5A4C-9E09-78A254E3BB4B}" dt="2021-09-01T21:36:44.875" v="1716" actId="478"/>
          <ac:picMkLst>
            <pc:docMk/>
            <pc:sldMk cId="2499962631" sldId="271"/>
            <ac:picMk id="3" creationId="{53187E55-07DD-3246-8247-1478200BEFB7}"/>
          </ac:picMkLst>
        </pc:picChg>
        <pc:picChg chg="del">
          <ac:chgData name="Narang, Sonali" userId="9e80b397-6e2f-49b1-9374-ccdad8589140" providerId="ADAL" clId="{0A0D2314-D59C-5A4C-9E09-78A254E3BB4B}" dt="2021-08-31T20:03:21.133" v="264" actId="478"/>
          <ac:picMkLst>
            <pc:docMk/>
            <pc:sldMk cId="2499962631" sldId="271"/>
            <ac:picMk id="23" creationId="{E250E272-FAAA-694B-BE89-06E1DA073D8A}"/>
          </ac:picMkLst>
        </pc:picChg>
        <pc:picChg chg="del">
          <ac:chgData name="Narang, Sonali" userId="9e80b397-6e2f-49b1-9374-ccdad8589140" providerId="ADAL" clId="{0A0D2314-D59C-5A4C-9E09-78A254E3BB4B}" dt="2021-09-01T21:36:44.875" v="1716" actId="478"/>
          <ac:picMkLst>
            <pc:docMk/>
            <pc:sldMk cId="2499962631" sldId="271"/>
            <ac:picMk id="97" creationId="{496F82D1-7791-9F4A-889D-254975963C79}"/>
          </ac:picMkLst>
        </pc:picChg>
        <pc:picChg chg="del">
          <ac:chgData name="Narang, Sonali" userId="9e80b397-6e2f-49b1-9374-ccdad8589140" providerId="ADAL" clId="{0A0D2314-D59C-5A4C-9E09-78A254E3BB4B}" dt="2021-09-01T21:36:44.875" v="1716" actId="478"/>
          <ac:picMkLst>
            <pc:docMk/>
            <pc:sldMk cId="2499962631" sldId="271"/>
            <ac:picMk id="135" creationId="{1CE96486-20BC-7F41-87D0-558C44F962B1}"/>
          </ac:picMkLst>
        </pc:picChg>
        <pc:picChg chg="del">
          <ac:chgData name="Narang, Sonali" userId="9e80b397-6e2f-49b1-9374-ccdad8589140" providerId="ADAL" clId="{0A0D2314-D59C-5A4C-9E09-78A254E3BB4B}" dt="2021-09-01T21:36:44.875" v="1716" actId="478"/>
          <ac:picMkLst>
            <pc:docMk/>
            <pc:sldMk cId="2499962631" sldId="271"/>
            <ac:picMk id="146" creationId="{1F8E9A21-BFDE-7249-AA98-3227C29281B5}"/>
          </ac:picMkLst>
        </pc:picChg>
      </pc:sldChg>
      <pc:sldChg chg="delSp modSp del mod">
        <pc:chgData name="Narang, Sonali" userId="9e80b397-6e2f-49b1-9374-ccdad8589140" providerId="ADAL" clId="{0A0D2314-D59C-5A4C-9E09-78A254E3BB4B}" dt="2021-09-30T21:46:28.435" v="2786" actId="2696"/>
        <pc:sldMkLst>
          <pc:docMk/>
          <pc:sldMk cId="1184752330" sldId="273"/>
        </pc:sldMkLst>
        <pc:spChg chg="del mod">
          <ac:chgData name="Narang, Sonali" userId="9e80b397-6e2f-49b1-9374-ccdad8589140" providerId="ADAL" clId="{0A0D2314-D59C-5A4C-9E09-78A254E3BB4B}" dt="2021-09-30T21:46:25.565" v="2784" actId="21"/>
          <ac:spMkLst>
            <pc:docMk/>
            <pc:sldMk cId="1184752330" sldId="273"/>
            <ac:spMk id="4" creationId="{F6669B9D-B042-D548-BD0F-97015091799B}"/>
          </ac:spMkLst>
        </pc:spChg>
        <pc:spChg chg="del">
          <ac:chgData name="Narang, Sonali" userId="9e80b397-6e2f-49b1-9374-ccdad8589140" providerId="ADAL" clId="{0A0D2314-D59C-5A4C-9E09-78A254E3BB4B}" dt="2021-09-30T19:24:55.158" v="2273" actId="478"/>
          <ac:spMkLst>
            <pc:docMk/>
            <pc:sldMk cId="1184752330" sldId="273"/>
            <ac:spMk id="8" creationId="{8A9BAE78-C4FF-1843-94F6-3410EB884848}"/>
          </ac:spMkLst>
        </pc:spChg>
        <pc:grpChg chg="del">
          <ac:chgData name="Narang, Sonali" userId="9e80b397-6e2f-49b1-9374-ccdad8589140" providerId="ADAL" clId="{0A0D2314-D59C-5A4C-9E09-78A254E3BB4B}" dt="2021-09-30T19:24:52.940" v="2272" actId="478"/>
          <ac:grpSpMkLst>
            <pc:docMk/>
            <pc:sldMk cId="1184752330" sldId="273"/>
            <ac:grpSpMk id="11" creationId="{C32B8FC9-55A4-D644-ADCA-CF6BCE435857}"/>
          </ac:grpSpMkLst>
        </pc:grpChg>
        <pc:grpChg chg="mod">
          <ac:chgData name="Narang, Sonali" userId="9e80b397-6e2f-49b1-9374-ccdad8589140" providerId="ADAL" clId="{0A0D2314-D59C-5A4C-9E09-78A254E3BB4B}" dt="2021-09-30T19:25:03.126" v="2275" actId="1076"/>
          <ac:grpSpMkLst>
            <pc:docMk/>
            <pc:sldMk cId="1184752330" sldId="273"/>
            <ac:grpSpMk id="85" creationId="{D7BDA1D2-D9CA-734B-A971-54235A3C5910}"/>
          </ac:grpSpMkLst>
        </pc:grp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3" creationId="{8D46FA96-CD3D-0047-90E5-A1D1D7788A8F}"/>
          </ac:picMkLst>
        </pc:picChg>
        <pc:picChg chg="mod">
          <ac:chgData name="Narang, Sonali" userId="9e80b397-6e2f-49b1-9374-ccdad8589140" providerId="ADAL" clId="{0A0D2314-D59C-5A4C-9E09-78A254E3BB4B}" dt="2021-09-30T19:25:03.126" v="2275" actId="1076"/>
          <ac:picMkLst>
            <pc:docMk/>
            <pc:sldMk cId="1184752330" sldId="273"/>
            <ac:picMk id="9" creationId="{6ABD3AA5-95E6-6D4B-84AF-F0F5C645343C}"/>
          </ac:picMkLst>
        </pc:pic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16" creationId="{0431DD33-487F-1744-895E-CD1CBD9FCEF2}"/>
          </ac:picMkLst>
        </pc:picChg>
        <pc:picChg chg="del">
          <ac:chgData name="Narang, Sonali" userId="9e80b397-6e2f-49b1-9374-ccdad8589140" providerId="ADAL" clId="{0A0D2314-D59C-5A4C-9E09-78A254E3BB4B}" dt="2021-09-30T21:46:01.143" v="2777" actId="21"/>
          <ac:picMkLst>
            <pc:docMk/>
            <pc:sldMk cId="1184752330" sldId="273"/>
            <ac:picMk id="18" creationId="{280D59A3-8DC1-994E-9BAD-746BF4A9F461}"/>
          </ac:picMkLst>
        </pc:pic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83" creationId="{A2DC379C-9BE3-8847-8A10-2744CD535286}"/>
          </ac:picMkLst>
        </pc:pic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111" creationId="{20BB0087-4AF3-7B49-A354-5C3664D1250B}"/>
          </ac:picMkLst>
        </pc:pic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114" creationId="{CD79A9EC-0F7C-6141-93B3-F5755D6371C7}"/>
          </ac:picMkLst>
        </pc:picChg>
        <pc:picChg chg="del">
          <ac:chgData name="Narang, Sonali" userId="9e80b397-6e2f-49b1-9374-ccdad8589140" providerId="ADAL" clId="{0A0D2314-D59C-5A4C-9E09-78A254E3BB4B}" dt="2021-09-30T19:24:50.594" v="2271" actId="478"/>
          <ac:picMkLst>
            <pc:docMk/>
            <pc:sldMk cId="1184752330" sldId="273"/>
            <ac:picMk id="116" creationId="{66C157FD-9F4F-EE4C-9C7A-F66F0D902C3A}"/>
          </ac:picMkLst>
        </pc:picChg>
        <pc:picChg chg="del">
          <ac:chgData name="Narang, Sonali" userId="9e80b397-6e2f-49b1-9374-ccdad8589140" providerId="ADAL" clId="{0A0D2314-D59C-5A4C-9E09-78A254E3BB4B}" dt="2021-09-30T19:24:57.631" v="2274" actId="478"/>
          <ac:picMkLst>
            <pc:docMk/>
            <pc:sldMk cId="1184752330" sldId="273"/>
            <ac:picMk id="131" creationId="{585BBCE9-E794-B048-BA15-834FAA88DA95}"/>
          </ac:picMkLst>
        </pc:picChg>
      </pc:sldChg>
      <pc:sldChg chg="del">
        <pc:chgData name="Narang, Sonali" userId="9e80b397-6e2f-49b1-9374-ccdad8589140" providerId="ADAL" clId="{0A0D2314-D59C-5A4C-9E09-78A254E3BB4B}" dt="2021-09-01T21:36:57.305" v="1719" actId="2696"/>
        <pc:sldMkLst>
          <pc:docMk/>
          <pc:sldMk cId="3544397231" sldId="274"/>
        </pc:sldMkLst>
      </pc:sldChg>
      <pc:sldChg chg="addSp delSp modSp add del mod modNotesTx">
        <pc:chgData name="Narang, Sonali" userId="9e80b397-6e2f-49b1-9374-ccdad8589140" providerId="ADAL" clId="{0A0D2314-D59C-5A4C-9E09-78A254E3BB4B}" dt="2021-09-01T20:23:08.094" v="1429" actId="2696"/>
        <pc:sldMkLst>
          <pc:docMk/>
          <pc:sldMk cId="3076891634" sldId="275"/>
        </pc:sldMkLst>
        <pc:spChg chg="add mod">
          <ac:chgData name="Narang, Sonali" userId="9e80b397-6e2f-49b1-9374-ccdad8589140" providerId="ADAL" clId="{0A0D2314-D59C-5A4C-9E09-78A254E3BB4B}" dt="2021-09-01T20:07:03.367" v="1283" actId="1076"/>
          <ac:spMkLst>
            <pc:docMk/>
            <pc:sldMk cId="3076891634" sldId="275"/>
            <ac:spMk id="2" creationId="{3367D373-6BB0-4246-A264-BF1E1254F9FB}"/>
          </ac:spMkLst>
        </pc:spChg>
        <pc:spChg chg="mod">
          <ac:chgData name="Narang, Sonali" userId="9e80b397-6e2f-49b1-9374-ccdad8589140" providerId="ADAL" clId="{0A0D2314-D59C-5A4C-9E09-78A254E3BB4B}" dt="2021-09-01T20:07:31.820" v="1285" actId="1076"/>
          <ac:spMkLst>
            <pc:docMk/>
            <pc:sldMk cId="3076891634" sldId="275"/>
            <ac:spMk id="8" creationId="{8A9BAE78-C4FF-1843-94F6-3410EB884848}"/>
          </ac:spMkLst>
        </pc:spChg>
        <pc:spChg chg="mod">
          <ac:chgData name="Narang, Sonali" userId="9e80b397-6e2f-49b1-9374-ccdad8589140" providerId="ADAL" clId="{0A0D2314-D59C-5A4C-9E09-78A254E3BB4B}" dt="2021-09-01T20:07:25.378" v="1284" actId="1076"/>
          <ac:spMkLst>
            <pc:docMk/>
            <pc:sldMk cId="3076891634" sldId="275"/>
            <ac:spMk id="32" creationId="{2863401C-2050-2E40-AE5C-C6CDD3A8A7D4}"/>
          </ac:spMkLst>
        </pc:spChg>
        <pc:spChg chg="mod">
          <ac:chgData name="Narang, Sonali" userId="9e80b397-6e2f-49b1-9374-ccdad8589140" providerId="ADAL" clId="{0A0D2314-D59C-5A4C-9E09-78A254E3BB4B}" dt="2021-09-01T20:07:48.736" v="1286" actId="1076"/>
          <ac:spMkLst>
            <pc:docMk/>
            <pc:sldMk cId="3076891634" sldId="275"/>
            <ac:spMk id="36" creationId="{75B14C61-810F-134B-AC0D-0C1FD0CAB17A}"/>
          </ac:spMkLst>
        </pc:spChg>
        <pc:spChg chg="add del mod">
          <ac:chgData name="Narang, Sonali" userId="9e80b397-6e2f-49b1-9374-ccdad8589140" providerId="ADAL" clId="{0A0D2314-D59C-5A4C-9E09-78A254E3BB4B}" dt="2021-09-01T20:05:57.719" v="1256" actId="478"/>
          <ac:spMkLst>
            <pc:docMk/>
            <pc:sldMk cId="3076891634" sldId="275"/>
            <ac:spMk id="122" creationId="{1617DB45-6AA5-A642-A7AB-AEA1AC75BE70}"/>
          </ac:spMkLst>
        </pc:spChg>
        <pc:grpChg chg="del mod">
          <ac:chgData name="Narang, Sonali" userId="9e80b397-6e2f-49b1-9374-ccdad8589140" providerId="ADAL" clId="{0A0D2314-D59C-5A4C-9E09-78A254E3BB4B}" dt="2021-08-31T19:59:48.774" v="214" actId="478"/>
          <ac:grpSpMkLst>
            <pc:docMk/>
            <pc:sldMk cId="3076891634" sldId="275"/>
            <ac:grpSpMk id="10" creationId="{D88D7517-4649-454B-B33B-40859B6B3E1E}"/>
          </ac:grpSpMkLst>
        </pc:grpChg>
        <pc:grpChg chg="del">
          <ac:chgData name="Narang, Sonali" userId="9e80b397-6e2f-49b1-9374-ccdad8589140" providerId="ADAL" clId="{0A0D2314-D59C-5A4C-9E09-78A254E3BB4B}" dt="2021-08-31T20:12:16.125" v="392" actId="478"/>
          <ac:grpSpMkLst>
            <pc:docMk/>
            <pc:sldMk cId="3076891634" sldId="275"/>
            <ac:grpSpMk id="24" creationId="{1C799EA5-FBE0-5B46-813F-EF20A1A81420}"/>
          </ac:grpSpMkLst>
        </pc:grpChg>
        <pc:grpChg chg="del">
          <ac:chgData name="Narang, Sonali" userId="9e80b397-6e2f-49b1-9374-ccdad8589140" providerId="ADAL" clId="{0A0D2314-D59C-5A4C-9E09-78A254E3BB4B}" dt="2021-08-31T20:12:16.125" v="392" actId="478"/>
          <ac:grpSpMkLst>
            <pc:docMk/>
            <pc:sldMk cId="3076891634" sldId="275"/>
            <ac:grpSpMk id="25" creationId="{209DE69F-C181-9B41-A954-044CD88589A7}"/>
          </ac:grpSpMkLst>
        </pc:grpChg>
        <pc:grpChg chg="del mod">
          <ac:chgData name="Narang, Sonali" userId="9e80b397-6e2f-49b1-9374-ccdad8589140" providerId="ADAL" clId="{0A0D2314-D59C-5A4C-9E09-78A254E3BB4B}" dt="2021-08-31T19:59:48.774" v="214" actId="478"/>
          <ac:grpSpMkLst>
            <pc:docMk/>
            <pc:sldMk cId="3076891634" sldId="275"/>
            <ac:grpSpMk id="96" creationId="{F3AA89EB-F925-3649-A3BE-B492BEBFEFFB}"/>
          </ac:grpSpMkLst>
        </pc:grpChg>
        <pc:picChg chg="add del mod">
          <ac:chgData name="Narang, Sonali" userId="9e80b397-6e2f-49b1-9374-ccdad8589140" providerId="ADAL" clId="{0A0D2314-D59C-5A4C-9E09-78A254E3BB4B}" dt="2021-09-01T19:51:03.297" v="1217" actId="478"/>
          <ac:picMkLst>
            <pc:docMk/>
            <pc:sldMk cId="3076891634" sldId="275"/>
            <ac:picMk id="6" creationId="{1749B81E-0A07-594B-9F15-E6ABDB6DEDB9}"/>
          </ac:picMkLst>
        </pc:picChg>
        <pc:picChg chg="add del mod">
          <ac:chgData name="Narang, Sonali" userId="9e80b397-6e2f-49b1-9374-ccdad8589140" providerId="ADAL" clId="{0A0D2314-D59C-5A4C-9E09-78A254E3BB4B}" dt="2021-09-01T19:51:03.297" v="1217" actId="478"/>
          <ac:picMkLst>
            <pc:docMk/>
            <pc:sldMk cId="3076891634" sldId="275"/>
            <ac:picMk id="11" creationId="{52E56985-14DE-6148-9A7A-5542314FCA1C}"/>
          </ac:picMkLst>
        </pc:picChg>
        <pc:picChg chg="del mod">
          <ac:chgData name="Narang, Sonali" userId="9e80b397-6e2f-49b1-9374-ccdad8589140" providerId="ADAL" clId="{0A0D2314-D59C-5A4C-9E09-78A254E3BB4B}" dt="2021-08-31T19:59:48.774" v="214" actId="478"/>
          <ac:picMkLst>
            <pc:docMk/>
            <pc:sldMk cId="3076891634" sldId="275"/>
            <ac:picMk id="12" creationId="{6F3D5D04-082E-A94E-B674-0CC25F5EF539}"/>
          </ac:picMkLst>
        </pc:picChg>
        <pc:picChg chg="add del mod">
          <ac:chgData name="Narang, Sonali" userId="9e80b397-6e2f-49b1-9374-ccdad8589140" providerId="ADAL" clId="{0A0D2314-D59C-5A4C-9E09-78A254E3BB4B}" dt="2021-09-01T19:51:03.297" v="1217" actId="478"/>
          <ac:picMkLst>
            <pc:docMk/>
            <pc:sldMk cId="3076891634" sldId="275"/>
            <ac:picMk id="15" creationId="{4FDDD49B-2118-B644-950D-C4E0E45E956D}"/>
          </ac:picMkLst>
        </pc:picChg>
        <pc:picChg chg="del mod">
          <ac:chgData name="Narang, Sonali" userId="9e80b397-6e2f-49b1-9374-ccdad8589140" providerId="ADAL" clId="{0A0D2314-D59C-5A4C-9E09-78A254E3BB4B}" dt="2021-08-31T19:59:48.774" v="214" actId="478"/>
          <ac:picMkLst>
            <pc:docMk/>
            <pc:sldMk cId="3076891634" sldId="275"/>
            <ac:picMk id="23" creationId="{F4E04DD6-E91E-DA48-812D-B7942BE0CA2A}"/>
          </ac:picMkLst>
        </pc:picChg>
        <pc:picChg chg="add mod">
          <ac:chgData name="Narang, Sonali" userId="9e80b397-6e2f-49b1-9374-ccdad8589140" providerId="ADAL" clId="{0A0D2314-D59C-5A4C-9E09-78A254E3BB4B}" dt="2021-09-01T19:52:28.049" v="1255" actId="1076"/>
          <ac:picMkLst>
            <pc:docMk/>
            <pc:sldMk cId="3076891634" sldId="275"/>
            <ac:picMk id="26" creationId="{6622012E-829C-D245-ACED-5089C4B5C9C4}"/>
          </ac:picMkLst>
        </pc:picChg>
        <pc:picChg chg="add mod">
          <ac:chgData name="Narang, Sonali" userId="9e80b397-6e2f-49b1-9374-ccdad8589140" providerId="ADAL" clId="{0A0D2314-D59C-5A4C-9E09-78A254E3BB4B}" dt="2021-09-01T19:52:28.049" v="1255" actId="1076"/>
          <ac:picMkLst>
            <pc:docMk/>
            <pc:sldMk cId="3076891634" sldId="275"/>
            <ac:picMk id="28" creationId="{E4F0C550-AE7A-2142-8FFA-261CC21C45B1}"/>
          </ac:picMkLst>
        </pc:picChg>
        <pc:picChg chg="add mod">
          <ac:chgData name="Narang, Sonali" userId="9e80b397-6e2f-49b1-9374-ccdad8589140" providerId="ADAL" clId="{0A0D2314-D59C-5A4C-9E09-78A254E3BB4B}" dt="2021-09-01T19:52:28.049" v="1255" actId="1076"/>
          <ac:picMkLst>
            <pc:docMk/>
            <pc:sldMk cId="3076891634" sldId="275"/>
            <ac:picMk id="30" creationId="{E442FC1C-4929-E044-99A7-21D2850971B1}"/>
          </ac:picMkLst>
        </pc:picChg>
        <pc:picChg chg="add mod">
          <ac:chgData name="Narang, Sonali" userId="9e80b397-6e2f-49b1-9374-ccdad8589140" providerId="ADAL" clId="{0A0D2314-D59C-5A4C-9E09-78A254E3BB4B}" dt="2021-09-01T20:07:54.927" v="1287" actId="1076"/>
          <ac:picMkLst>
            <pc:docMk/>
            <pc:sldMk cId="3076891634" sldId="275"/>
            <ac:picMk id="33" creationId="{0FBF3EDC-FFCA-A645-A7E9-3E1E055E9B34}"/>
          </ac:picMkLst>
        </pc:picChg>
        <pc:picChg chg="add mod">
          <ac:chgData name="Narang, Sonali" userId="9e80b397-6e2f-49b1-9374-ccdad8589140" providerId="ADAL" clId="{0A0D2314-D59C-5A4C-9E09-78A254E3BB4B}" dt="2021-09-01T20:07:54.927" v="1287" actId="1076"/>
          <ac:picMkLst>
            <pc:docMk/>
            <pc:sldMk cId="3076891634" sldId="275"/>
            <ac:picMk id="39" creationId="{3034700E-7CF2-964B-B2C1-E6B2E0CF2815}"/>
          </ac:picMkLst>
        </pc:picChg>
        <pc:picChg chg="add mod">
          <ac:chgData name="Narang, Sonali" userId="9e80b397-6e2f-49b1-9374-ccdad8589140" providerId="ADAL" clId="{0A0D2314-D59C-5A4C-9E09-78A254E3BB4B}" dt="2021-09-01T20:07:54.927" v="1287" actId="1076"/>
          <ac:picMkLst>
            <pc:docMk/>
            <pc:sldMk cId="3076891634" sldId="275"/>
            <ac:picMk id="41" creationId="{BAB6122B-96E2-5343-939D-30AD2FCD8704}"/>
          </ac:picMkLst>
        </pc:picChg>
        <pc:picChg chg="del">
          <ac:chgData name="Narang, Sonali" userId="9e80b397-6e2f-49b1-9374-ccdad8589140" providerId="ADAL" clId="{0A0D2314-D59C-5A4C-9E09-78A254E3BB4B}" dt="2021-08-31T20:12:16.125" v="392" actId="478"/>
          <ac:picMkLst>
            <pc:docMk/>
            <pc:sldMk cId="3076891634" sldId="275"/>
            <ac:picMk id="119" creationId="{49F46577-C9D3-1B41-9090-7C81FC720B1E}"/>
          </ac:picMkLst>
        </pc:picChg>
        <pc:picChg chg="del">
          <ac:chgData name="Narang, Sonali" userId="9e80b397-6e2f-49b1-9374-ccdad8589140" providerId="ADAL" clId="{0A0D2314-D59C-5A4C-9E09-78A254E3BB4B}" dt="2021-08-31T20:12:16.125" v="392" actId="478"/>
          <ac:picMkLst>
            <pc:docMk/>
            <pc:sldMk cId="3076891634" sldId="275"/>
            <ac:picMk id="120" creationId="{F74CFB0B-61C9-F640-9317-B8984AD45800}"/>
          </ac:picMkLst>
        </pc:picChg>
        <pc:picChg chg="del">
          <ac:chgData name="Narang, Sonali" userId="9e80b397-6e2f-49b1-9374-ccdad8589140" providerId="ADAL" clId="{0A0D2314-D59C-5A4C-9E09-78A254E3BB4B}" dt="2021-08-31T20:12:16.125" v="392" actId="478"/>
          <ac:picMkLst>
            <pc:docMk/>
            <pc:sldMk cId="3076891634" sldId="275"/>
            <ac:picMk id="121" creationId="{6C6532E8-B1B8-D14C-9198-7E75AFE7A9DE}"/>
          </ac:picMkLst>
        </pc:picChg>
        <pc:picChg chg="add del mod">
          <ac:chgData name="Narang, Sonali" userId="9e80b397-6e2f-49b1-9374-ccdad8589140" providerId="ADAL" clId="{0A0D2314-D59C-5A4C-9E09-78A254E3BB4B}" dt="2021-09-01T19:48:08.495" v="1151" actId="478"/>
          <ac:picMkLst>
            <pc:docMk/>
            <pc:sldMk cId="3076891634" sldId="275"/>
            <ac:picMk id="123" creationId="{9D927E72-BB13-0841-A7A3-F413B53B1109}"/>
          </ac:picMkLst>
        </pc:picChg>
        <pc:picChg chg="add del mod">
          <ac:chgData name="Narang, Sonali" userId="9e80b397-6e2f-49b1-9374-ccdad8589140" providerId="ADAL" clId="{0A0D2314-D59C-5A4C-9E09-78A254E3BB4B}" dt="2021-09-01T19:48:08.495" v="1151" actId="478"/>
          <ac:picMkLst>
            <pc:docMk/>
            <pc:sldMk cId="3076891634" sldId="275"/>
            <ac:picMk id="124" creationId="{E8381E6A-4887-A442-884D-7CB9E2B9B504}"/>
          </ac:picMkLst>
        </pc:picChg>
        <pc:picChg chg="add del mod">
          <ac:chgData name="Narang, Sonali" userId="9e80b397-6e2f-49b1-9374-ccdad8589140" providerId="ADAL" clId="{0A0D2314-D59C-5A4C-9E09-78A254E3BB4B}" dt="2021-09-01T19:48:08.495" v="1151" actId="478"/>
          <ac:picMkLst>
            <pc:docMk/>
            <pc:sldMk cId="3076891634" sldId="275"/>
            <ac:picMk id="129" creationId="{644D9913-3055-4D47-9E8D-0FDC5B15F856}"/>
          </ac:picMkLst>
        </pc:picChg>
        <pc:picChg chg="add del mod">
          <ac:chgData name="Narang, Sonali" userId="9e80b397-6e2f-49b1-9374-ccdad8589140" providerId="ADAL" clId="{0A0D2314-D59C-5A4C-9E09-78A254E3BB4B}" dt="2021-08-31T21:16:19.824" v="1142" actId="478"/>
          <ac:picMkLst>
            <pc:docMk/>
            <pc:sldMk cId="3076891634" sldId="275"/>
            <ac:picMk id="130" creationId="{E9C222D0-FAE7-0446-B577-C56031A1BEDE}"/>
          </ac:picMkLst>
        </pc:picChg>
      </pc:sldChg>
      <pc:sldChg chg="addSp delSp modSp add mod">
        <pc:chgData name="Narang, Sonali" userId="9e80b397-6e2f-49b1-9374-ccdad8589140" providerId="ADAL" clId="{0A0D2314-D59C-5A4C-9E09-78A254E3BB4B}" dt="2021-11-04T19:39:15.941" v="4652" actId="20577"/>
        <pc:sldMkLst>
          <pc:docMk/>
          <pc:sldMk cId="454596918" sldId="276"/>
        </pc:sldMkLst>
        <pc:spChg chg="mod">
          <ac:chgData name="Narang, Sonali" userId="9e80b397-6e2f-49b1-9374-ccdad8589140" providerId="ADAL" clId="{0A0D2314-D59C-5A4C-9E09-78A254E3BB4B}" dt="2021-09-30T21:45:07.160" v="2761" actId="1037"/>
          <ac:spMkLst>
            <pc:docMk/>
            <pc:sldMk cId="454596918" sldId="276"/>
            <ac:spMk id="5" creationId="{FAFFEC37-A0C5-5846-8534-22E3DEF6CEF4}"/>
          </ac:spMkLst>
        </pc:spChg>
        <pc:spChg chg="mod">
          <ac:chgData name="Narang, Sonali" userId="9e80b397-6e2f-49b1-9374-ccdad8589140" providerId="ADAL" clId="{0A0D2314-D59C-5A4C-9E09-78A254E3BB4B}" dt="2021-09-30T21:44:49.975" v="2735" actId="1076"/>
          <ac:spMkLst>
            <pc:docMk/>
            <pc:sldMk cId="454596918" sldId="276"/>
            <ac:spMk id="7" creationId="{4C5F5CAE-FBFD-964D-A356-746AAC86DC9E}"/>
          </ac:spMkLst>
        </pc:spChg>
        <pc:spChg chg="mod">
          <ac:chgData name="Narang, Sonali" userId="9e80b397-6e2f-49b1-9374-ccdad8589140" providerId="ADAL" clId="{0A0D2314-D59C-5A4C-9E09-78A254E3BB4B}" dt="2021-09-30T21:45:02.257" v="2753" actId="1037"/>
          <ac:spMkLst>
            <pc:docMk/>
            <pc:sldMk cId="454596918" sldId="276"/>
            <ac:spMk id="8" creationId="{8A9BAE78-C4FF-1843-94F6-3410EB884848}"/>
          </ac:spMkLst>
        </pc:spChg>
        <pc:spChg chg="del mod">
          <ac:chgData name="Narang, Sonali" userId="9e80b397-6e2f-49b1-9374-ccdad8589140" providerId="ADAL" clId="{0A0D2314-D59C-5A4C-9E09-78A254E3BB4B}" dt="2021-09-30T21:18:28.609" v="2644" actId="478"/>
          <ac:spMkLst>
            <pc:docMk/>
            <pc:sldMk cId="454596918" sldId="276"/>
            <ac:spMk id="32" creationId="{2863401C-2050-2E40-AE5C-C6CDD3A8A7D4}"/>
          </ac:spMkLst>
        </pc:spChg>
        <pc:spChg chg="mod">
          <ac:chgData name="Narang, Sonali" userId="9e80b397-6e2f-49b1-9374-ccdad8589140" providerId="ADAL" clId="{0A0D2314-D59C-5A4C-9E09-78A254E3BB4B}" dt="2021-11-02T15:37:06.557" v="3216" actId="20577"/>
          <ac:spMkLst>
            <pc:docMk/>
            <pc:sldMk cId="454596918" sldId="276"/>
            <ac:spMk id="36" creationId="{75B14C61-810F-134B-AC0D-0C1FD0CAB17A}"/>
          </ac:spMkLst>
        </pc:spChg>
        <pc:spChg chg="mod">
          <ac:chgData name="Narang, Sonali" userId="9e80b397-6e2f-49b1-9374-ccdad8589140" providerId="ADAL" clId="{0A0D2314-D59C-5A4C-9E09-78A254E3BB4B}" dt="2021-11-02T15:37:07.962" v="3218" actId="20577"/>
          <ac:spMkLst>
            <pc:docMk/>
            <pc:sldMk cId="454596918" sldId="276"/>
            <ac:spMk id="59" creationId="{1C85DEE8-F315-5047-B7B7-8827D96395BE}"/>
          </ac:spMkLst>
        </pc:spChg>
        <pc:spChg chg="add mod">
          <ac:chgData name="Narang, Sonali" userId="9e80b397-6e2f-49b1-9374-ccdad8589140" providerId="ADAL" clId="{0A0D2314-D59C-5A4C-9E09-78A254E3BB4B}" dt="2021-11-04T19:39:15.941" v="4652" actId="20577"/>
          <ac:spMkLst>
            <pc:docMk/>
            <pc:sldMk cId="454596918" sldId="276"/>
            <ac:spMk id="80" creationId="{28D38C57-B22A-6B41-AD79-1CA71ACA6A49}"/>
          </ac:spMkLst>
        </pc:spChg>
        <pc:spChg chg="add mod">
          <ac:chgData name="Narang, Sonali" userId="9e80b397-6e2f-49b1-9374-ccdad8589140" providerId="ADAL" clId="{0A0D2314-D59C-5A4C-9E09-78A254E3BB4B}" dt="2021-11-04T19:39:11.701" v="4648" actId="20577"/>
          <ac:spMkLst>
            <pc:docMk/>
            <pc:sldMk cId="454596918" sldId="276"/>
            <ac:spMk id="81" creationId="{BFDA3492-5E10-ED45-A723-BF91EA0B4F44}"/>
          </ac:spMkLst>
        </pc:spChg>
        <pc:spChg chg="add mod">
          <ac:chgData name="Narang, Sonali" userId="9e80b397-6e2f-49b1-9374-ccdad8589140" providerId="ADAL" clId="{0A0D2314-D59C-5A4C-9E09-78A254E3BB4B}" dt="2021-09-30T21:45:13.272" v="2764" actId="1036"/>
          <ac:spMkLst>
            <pc:docMk/>
            <pc:sldMk cId="454596918" sldId="276"/>
            <ac:spMk id="88" creationId="{450581AC-1A52-B042-8CFD-0D1AB13EB01E}"/>
          </ac:spMkLst>
        </pc:spChg>
        <pc:spChg chg="del">
          <ac:chgData name="Narang, Sonali" userId="9e80b397-6e2f-49b1-9374-ccdad8589140" providerId="ADAL" clId="{0A0D2314-D59C-5A4C-9E09-78A254E3BB4B}" dt="2021-08-31T20:13:14.196" v="413" actId="478"/>
          <ac:spMkLst>
            <pc:docMk/>
            <pc:sldMk cId="454596918" sldId="276"/>
            <ac:spMk id="122" creationId="{1617DB45-6AA5-A642-A7AB-AEA1AC75BE70}"/>
          </ac:spMkLst>
        </pc:spChg>
        <pc:grpChg chg="mod">
          <ac:chgData name="Narang, Sonali" userId="9e80b397-6e2f-49b1-9374-ccdad8589140" providerId="ADAL" clId="{0A0D2314-D59C-5A4C-9E09-78A254E3BB4B}" dt="2021-11-04T19:36:29.559" v="4642" actId="1076"/>
          <ac:grpSpMkLst>
            <pc:docMk/>
            <pc:sldMk cId="454596918" sldId="276"/>
            <ac:grpSpMk id="24" creationId="{1C799EA5-FBE0-5B46-813F-EF20A1A81420}"/>
          </ac:grpSpMkLst>
        </pc:grpChg>
        <pc:grpChg chg="mod">
          <ac:chgData name="Narang, Sonali" userId="9e80b397-6e2f-49b1-9374-ccdad8589140" providerId="ADAL" clId="{0A0D2314-D59C-5A4C-9E09-78A254E3BB4B}" dt="2021-11-04T19:36:40.164" v="4644" actId="1076"/>
          <ac:grpSpMkLst>
            <pc:docMk/>
            <pc:sldMk cId="454596918" sldId="276"/>
            <ac:grpSpMk id="25" creationId="{209DE69F-C181-9B41-A954-044CD88589A7}"/>
          </ac:grpSpMkLst>
        </pc:grpChg>
        <pc:picChg chg="add mod modCrop">
          <ac:chgData name="Narang, Sonali" userId="9e80b397-6e2f-49b1-9374-ccdad8589140" providerId="ADAL" clId="{0A0D2314-D59C-5A4C-9E09-78A254E3BB4B}" dt="2021-09-30T21:21:29.013" v="2690" actId="1036"/>
          <ac:picMkLst>
            <pc:docMk/>
            <pc:sldMk cId="454596918" sldId="276"/>
            <ac:picMk id="3" creationId="{891FE0AC-8ED7-4848-8237-AF85468F7E28}"/>
          </ac:picMkLst>
        </pc:picChg>
        <pc:picChg chg="add mod">
          <ac:chgData name="Narang, Sonali" userId="9e80b397-6e2f-49b1-9374-ccdad8589140" providerId="ADAL" clId="{0A0D2314-D59C-5A4C-9E09-78A254E3BB4B}" dt="2021-11-02T17:03:52.884" v="3276" actId="1076"/>
          <ac:picMkLst>
            <pc:docMk/>
            <pc:sldMk cId="454596918" sldId="276"/>
            <ac:picMk id="6" creationId="{179D512F-EFF3-A14A-8AD8-0EF69CE85A7B}"/>
          </ac:picMkLst>
        </pc:picChg>
        <pc:picChg chg="add mod modCrop">
          <ac:chgData name="Narang, Sonali" userId="9e80b397-6e2f-49b1-9374-ccdad8589140" providerId="ADAL" clId="{0A0D2314-D59C-5A4C-9E09-78A254E3BB4B}" dt="2021-09-30T21:21:29.013" v="2690" actId="1036"/>
          <ac:picMkLst>
            <pc:docMk/>
            <pc:sldMk cId="454596918" sldId="276"/>
            <ac:picMk id="9" creationId="{E2A187F8-372D-4244-927F-D2CFCE5636A6}"/>
          </ac:picMkLst>
        </pc:picChg>
        <pc:picChg chg="add mod modCrop">
          <ac:chgData name="Narang, Sonali" userId="9e80b397-6e2f-49b1-9374-ccdad8589140" providerId="ADAL" clId="{0A0D2314-D59C-5A4C-9E09-78A254E3BB4B}" dt="2021-09-30T21:21:29.013" v="2690" actId="1036"/>
          <ac:picMkLst>
            <pc:docMk/>
            <pc:sldMk cId="454596918" sldId="276"/>
            <ac:picMk id="11" creationId="{FE67D655-CDFC-1648-BF25-A33327F76990}"/>
          </ac:picMkLst>
        </pc:picChg>
        <pc:picChg chg="add mod">
          <ac:chgData name="Narang, Sonali" userId="9e80b397-6e2f-49b1-9374-ccdad8589140" providerId="ADAL" clId="{0A0D2314-D59C-5A4C-9E09-78A254E3BB4B}" dt="2021-11-02T17:05:21.793" v="3283" actId="1076"/>
          <ac:picMkLst>
            <pc:docMk/>
            <pc:sldMk cId="454596918" sldId="276"/>
            <ac:picMk id="12" creationId="{29B679E3-3B24-D449-AD45-AA101DE16CCE}"/>
          </ac:picMkLst>
        </pc:picChg>
        <pc:picChg chg="add del mod">
          <ac:chgData name="Narang, Sonali" userId="9e80b397-6e2f-49b1-9374-ccdad8589140" providerId="ADAL" clId="{0A0D2314-D59C-5A4C-9E09-78A254E3BB4B}" dt="2021-11-02T17:06:12.536" v="3284" actId="478"/>
          <ac:picMkLst>
            <pc:docMk/>
            <pc:sldMk cId="454596918" sldId="276"/>
            <ac:picMk id="13" creationId="{663AE82A-B6C1-FB49-A171-0ECA459C0548}"/>
          </ac:picMkLst>
        </pc:picChg>
        <pc:picChg chg="add del mod">
          <ac:chgData name="Narang, Sonali" userId="9e80b397-6e2f-49b1-9374-ccdad8589140" providerId="ADAL" clId="{0A0D2314-D59C-5A4C-9E09-78A254E3BB4B}" dt="2021-11-02T17:03:33.028" v="3271" actId="478"/>
          <ac:picMkLst>
            <pc:docMk/>
            <pc:sldMk cId="454596918" sldId="276"/>
            <ac:picMk id="15" creationId="{B72FA063-27E1-5A42-A654-950616FA5B73}"/>
          </ac:picMkLst>
        </pc:picChg>
        <pc:picChg chg="add mod">
          <ac:chgData name="Narang, Sonali" userId="9e80b397-6e2f-49b1-9374-ccdad8589140" providerId="ADAL" clId="{0A0D2314-D59C-5A4C-9E09-78A254E3BB4B}" dt="2021-11-02T17:06:30.123" v="3290" actId="1076"/>
          <ac:picMkLst>
            <pc:docMk/>
            <pc:sldMk cId="454596918" sldId="276"/>
            <ac:picMk id="21" creationId="{212D3512-6F35-B14B-9D2B-C83017203A6D}"/>
          </ac:picMkLst>
        </pc:picChg>
        <pc:picChg chg="add del mod">
          <ac:chgData name="Narang, Sonali" userId="9e80b397-6e2f-49b1-9374-ccdad8589140" providerId="ADAL" clId="{0A0D2314-D59C-5A4C-9E09-78A254E3BB4B}" dt="2021-11-02T17:04:59.101" v="3277" actId="478"/>
          <ac:picMkLst>
            <pc:docMk/>
            <pc:sldMk cId="454596918" sldId="276"/>
            <ac:picMk id="23" creationId="{E7922452-DEE7-CE4F-B921-8AF68ABA96B1}"/>
          </ac:picMkLst>
        </pc:picChg>
        <pc:picChg chg="add mod">
          <ac:chgData name="Narang, Sonali" userId="9e80b397-6e2f-49b1-9374-ccdad8589140" providerId="ADAL" clId="{0A0D2314-D59C-5A4C-9E09-78A254E3BB4B}" dt="2021-09-30T21:45:03.946" v="2755" actId="1076"/>
          <ac:picMkLst>
            <pc:docMk/>
            <pc:sldMk cId="454596918" sldId="276"/>
            <ac:picMk id="95" creationId="{FE3DA984-9E5D-B94A-9937-57A51C53C87F}"/>
          </ac:picMkLst>
        </pc:picChg>
        <pc:picChg chg="del">
          <ac:chgData name="Narang, Sonali" userId="9e80b397-6e2f-49b1-9374-ccdad8589140" providerId="ADAL" clId="{0A0D2314-D59C-5A4C-9E09-78A254E3BB4B}" dt="2021-09-02T13:58:30.906" v="1721" actId="478"/>
          <ac:picMkLst>
            <pc:docMk/>
            <pc:sldMk cId="454596918" sldId="276"/>
            <ac:picMk id="119" creationId="{49F46577-C9D3-1B41-9090-7C81FC720B1E}"/>
          </ac:picMkLst>
        </pc:picChg>
        <pc:picChg chg="del">
          <ac:chgData name="Narang, Sonali" userId="9e80b397-6e2f-49b1-9374-ccdad8589140" providerId="ADAL" clId="{0A0D2314-D59C-5A4C-9E09-78A254E3BB4B}" dt="2021-09-02T13:58:30.906" v="1721" actId="478"/>
          <ac:picMkLst>
            <pc:docMk/>
            <pc:sldMk cId="454596918" sldId="276"/>
            <ac:picMk id="120" creationId="{F74CFB0B-61C9-F640-9317-B8984AD45800}"/>
          </ac:picMkLst>
        </pc:picChg>
        <pc:picChg chg="del">
          <ac:chgData name="Narang, Sonali" userId="9e80b397-6e2f-49b1-9374-ccdad8589140" providerId="ADAL" clId="{0A0D2314-D59C-5A4C-9E09-78A254E3BB4B}" dt="2021-09-02T13:58:30.906" v="1721" actId="478"/>
          <ac:picMkLst>
            <pc:docMk/>
            <pc:sldMk cId="454596918" sldId="276"/>
            <ac:picMk id="121" creationId="{6C6532E8-B1B8-D14C-9198-7E75AFE7A9DE}"/>
          </ac:picMkLst>
        </pc:picChg>
        <pc:picChg chg="del">
          <ac:chgData name="Narang, Sonali" userId="9e80b397-6e2f-49b1-9374-ccdad8589140" providerId="ADAL" clId="{0A0D2314-D59C-5A4C-9E09-78A254E3BB4B}" dt="2021-08-31T20:13:14.196" v="413" actId="478"/>
          <ac:picMkLst>
            <pc:docMk/>
            <pc:sldMk cId="454596918" sldId="276"/>
            <ac:picMk id="123" creationId="{9D927E72-BB13-0841-A7A3-F413B53B1109}"/>
          </ac:picMkLst>
        </pc:picChg>
        <pc:picChg chg="del">
          <ac:chgData name="Narang, Sonali" userId="9e80b397-6e2f-49b1-9374-ccdad8589140" providerId="ADAL" clId="{0A0D2314-D59C-5A4C-9E09-78A254E3BB4B}" dt="2021-08-31T20:13:14.196" v="413" actId="478"/>
          <ac:picMkLst>
            <pc:docMk/>
            <pc:sldMk cId="454596918" sldId="276"/>
            <ac:picMk id="124" creationId="{E8381E6A-4887-A442-884D-7CB9E2B9B504}"/>
          </ac:picMkLst>
        </pc:picChg>
        <pc:picChg chg="mod">
          <ac:chgData name="Narang, Sonali" userId="9e80b397-6e2f-49b1-9374-ccdad8589140" providerId="ADAL" clId="{0A0D2314-D59C-5A4C-9E09-78A254E3BB4B}" dt="2021-09-30T19:09:34.848" v="1922" actId="339"/>
          <ac:picMkLst>
            <pc:docMk/>
            <pc:sldMk cId="454596918" sldId="276"/>
            <ac:picMk id="125" creationId="{72C96116-8331-E341-911D-46E23A1123BE}"/>
          </ac:picMkLst>
        </pc:picChg>
        <pc:picChg chg="mod">
          <ac:chgData name="Narang, Sonali" userId="9e80b397-6e2f-49b1-9374-ccdad8589140" providerId="ADAL" clId="{0A0D2314-D59C-5A4C-9E09-78A254E3BB4B}" dt="2021-09-30T19:09:45.152" v="1923" actId="339"/>
          <ac:picMkLst>
            <pc:docMk/>
            <pc:sldMk cId="454596918" sldId="276"/>
            <ac:picMk id="126" creationId="{F0FE44C6-5464-6A4F-BD87-C6D89F98996E}"/>
          </ac:picMkLst>
        </pc:picChg>
        <pc:picChg chg="mod">
          <ac:chgData name="Narang, Sonali" userId="9e80b397-6e2f-49b1-9374-ccdad8589140" providerId="ADAL" clId="{0A0D2314-D59C-5A4C-9E09-78A254E3BB4B}" dt="2021-09-30T19:09:53.041" v="1924" actId="339"/>
          <ac:picMkLst>
            <pc:docMk/>
            <pc:sldMk cId="454596918" sldId="276"/>
            <ac:picMk id="127" creationId="{816C88E5-C8A7-C14C-8432-4348C73D0702}"/>
          </ac:picMkLst>
        </pc:picChg>
        <pc:picChg chg="mod">
          <ac:chgData name="Narang, Sonali" userId="9e80b397-6e2f-49b1-9374-ccdad8589140" providerId="ADAL" clId="{0A0D2314-D59C-5A4C-9E09-78A254E3BB4B}" dt="2021-09-30T19:09:53.041" v="1924" actId="339"/>
          <ac:picMkLst>
            <pc:docMk/>
            <pc:sldMk cId="454596918" sldId="276"/>
            <ac:picMk id="128" creationId="{82958D01-6DDE-B046-84AB-7B026820D360}"/>
          </ac:picMkLst>
        </pc:picChg>
        <pc:picChg chg="del">
          <ac:chgData name="Narang, Sonali" userId="9e80b397-6e2f-49b1-9374-ccdad8589140" providerId="ADAL" clId="{0A0D2314-D59C-5A4C-9E09-78A254E3BB4B}" dt="2021-08-31T20:13:14.196" v="413" actId="478"/>
          <ac:picMkLst>
            <pc:docMk/>
            <pc:sldMk cId="454596918" sldId="276"/>
            <ac:picMk id="129" creationId="{644D9913-3055-4D47-9E8D-0FDC5B15F856}"/>
          </ac:picMkLst>
        </pc:picChg>
      </pc:sldChg>
      <pc:sldChg chg="addSp delSp modSp add mod ord">
        <pc:chgData name="Narang, Sonali" userId="9e80b397-6e2f-49b1-9374-ccdad8589140" providerId="ADAL" clId="{0A0D2314-D59C-5A4C-9E09-78A254E3BB4B}" dt="2021-11-04T20:50:08.417" v="4694" actId="20577"/>
        <pc:sldMkLst>
          <pc:docMk/>
          <pc:sldMk cId="2078269342" sldId="277"/>
        </pc:sldMkLst>
        <pc:spChg chg="mod">
          <ac:chgData name="Narang, Sonali" userId="9e80b397-6e2f-49b1-9374-ccdad8589140" providerId="ADAL" clId="{0A0D2314-D59C-5A4C-9E09-78A254E3BB4B}" dt="2021-11-04T20:50:08.417" v="4694" actId="20577"/>
          <ac:spMkLst>
            <pc:docMk/>
            <pc:sldMk cId="2078269342" sldId="277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11-02T17:10:47.901" v="3348" actId="12788"/>
          <ac:spMkLst>
            <pc:docMk/>
            <pc:sldMk cId="2078269342" sldId="277"/>
            <ac:spMk id="5" creationId="{FAFFEC37-A0C5-5846-8534-22E3DEF6CEF4}"/>
          </ac:spMkLst>
        </pc:spChg>
        <pc:spChg chg="del mod">
          <ac:chgData name="Narang, Sonali" userId="9e80b397-6e2f-49b1-9374-ccdad8589140" providerId="ADAL" clId="{0A0D2314-D59C-5A4C-9E09-78A254E3BB4B}" dt="2021-11-02T17:10:31.342" v="3343" actId="478"/>
          <ac:spMkLst>
            <pc:docMk/>
            <pc:sldMk cId="2078269342" sldId="277"/>
            <ac:spMk id="6" creationId="{41464C80-B659-484D-A16F-8018DEC5471A}"/>
          </ac:spMkLst>
        </pc:spChg>
        <pc:spChg chg="mod">
          <ac:chgData name="Narang, Sonali" userId="9e80b397-6e2f-49b1-9374-ccdad8589140" providerId="ADAL" clId="{0A0D2314-D59C-5A4C-9E09-78A254E3BB4B}" dt="2021-11-02T17:10:47.901" v="3348" actId="12788"/>
          <ac:spMkLst>
            <pc:docMk/>
            <pc:sldMk cId="2078269342" sldId="277"/>
            <ac:spMk id="7" creationId="{4C5F5CAE-FBFD-964D-A356-746AAC86DC9E}"/>
          </ac:spMkLst>
        </pc:spChg>
        <pc:spChg chg="del">
          <ac:chgData name="Narang, Sonali" userId="9e80b397-6e2f-49b1-9374-ccdad8589140" providerId="ADAL" clId="{0A0D2314-D59C-5A4C-9E09-78A254E3BB4B}" dt="2021-08-31T21:13:16.093" v="1082" actId="478"/>
          <ac:spMkLst>
            <pc:docMk/>
            <pc:sldMk cId="2078269342" sldId="277"/>
            <ac:spMk id="8" creationId="{8A9BAE78-C4FF-1843-94F6-3410EB884848}"/>
          </ac:spMkLst>
        </pc:spChg>
        <pc:spChg chg="mod">
          <ac:chgData name="Narang, Sonali" userId="9e80b397-6e2f-49b1-9374-ccdad8589140" providerId="ADAL" clId="{0A0D2314-D59C-5A4C-9E09-78A254E3BB4B}" dt="2021-11-02T17:10:47.901" v="3348" actId="12788"/>
          <ac:spMkLst>
            <pc:docMk/>
            <pc:sldMk cId="2078269342" sldId="277"/>
            <ac:spMk id="30" creationId="{655ACA25-EBE0-DD45-930F-AD76C4C0A2A8}"/>
          </ac:spMkLst>
        </pc:spChg>
        <pc:spChg chg="add mod">
          <ac:chgData name="Narang, Sonali" userId="9e80b397-6e2f-49b1-9374-ccdad8589140" providerId="ADAL" clId="{0A0D2314-D59C-5A4C-9E09-78A254E3BB4B}" dt="2021-11-02T17:11:02.224" v="3352" actId="20577"/>
          <ac:spMkLst>
            <pc:docMk/>
            <pc:sldMk cId="2078269342" sldId="277"/>
            <ac:spMk id="65" creationId="{2EDEF6A0-F103-5349-A53F-A2BE3FD1BBD5}"/>
          </ac:spMkLst>
        </pc:spChg>
        <pc:grpChg chg="mod">
          <ac:chgData name="Narang, Sonali" userId="9e80b397-6e2f-49b1-9374-ccdad8589140" providerId="ADAL" clId="{0A0D2314-D59C-5A4C-9E09-78A254E3BB4B}" dt="2021-08-31T21:12:46.966" v="1074" actId="1076"/>
          <ac:grpSpMkLst>
            <pc:docMk/>
            <pc:sldMk cId="2078269342" sldId="277"/>
            <ac:grpSpMk id="14" creationId="{86D7D6E9-6736-D243-B10A-A0E8A40C0FDA}"/>
          </ac:grpSpMkLst>
        </pc:grpChg>
        <pc:grpChg chg="mod">
          <ac:chgData name="Narang, Sonali" userId="9e80b397-6e2f-49b1-9374-ccdad8589140" providerId="ADAL" clId="{0A0D2314-D59C-5A4C-9E09-78A254E3BB4B}" dt="2021-08-31T21:12:46.966" v="1074" actId="1076"/>
          <ac:grpSpMkLst>
            <pc:docMk/>
            <pc:sldMk cId="2078269342" sldId="277"/>
            <ac:grpSpMk id="19" creationId="{6FB40037-B603-9443-A847-58CB44679B55}"/>
          </ac:grpSpMkLst>
        </pc:grpChg>
        <pc:grpChg chg="mod">
          <ac:chgData name="Narang, Sonali" userId="9e80b397-6e2f-49b1-9374-ccdad8589140" providerId="ADAL" clId="{0A0D2314-D59C-5A4C-9E09-78A254E3BB4B}" dt="2021-08-31T21:12:46.966" v="1074" actId="1076"/>
          <ac:grpSpMkLst>
            <pc:docMk/>
            <pc:sldMk cId="2078269342" sldId="277"/>
            <ac:grpSpMk id="24" creationId="{27C39882-C3D6-6943-83E0-2D2C3AC6B4EE}"/>
          </ac:grpSpMkLst>
        </pc:grpChg>
        <pc:grpChg chg="mod">
          <ac:chgData name="Narang, Sonali" userId="9e80b397-6e2f-49b1-9374-ccdad8589140" providerId="ADAL" clId="{0A0D2314-D59C-5A4C-9E09-78A254E3BB4B}" dt="2021-08-31T21:12:50.887" v="1075" actId="1076"/>
          <ac:grpSpMkLst>
            <pc:docMk/>
            <pc:sldMk cId="2078269342" sldId="277"/>
            <ac:grpSpMk id="31" creationId="{D470D811-2477-3546-A8D8-048846B3651A}"/>
          </ac:grpSpMkLst>
        </pc:grpChg>
        <pc:picChg chg="del mod">
          <ac:chgData name="Narang, Sonali" userId="9e80b397-6e2f-49b1-9374-ccdad8589140" providerId="ADAL" clId="{0A0D2314-D59C-5A4C-9E09-78A254E3BB4B}" dt="2021-08-31T21:12:34.499" v="1070" actId="478"/>
          <ac:picMkLst>
            <pc:docMk/>
            <pc:sldMk cId="2078269342" sldId="277"/>
            <ac:picMk id="9" creationId="{CE344B95-A4B4-8E48-8BA1-DBCEB948F1E4}"/>
          </ac:picMkLst>
        </pc:picChg>
        <pc:picChg chg="del">
          <ac:chgData name="Narang, Sonali" userId="9e80b397-6e2f-49b1-9374-ccdad8589140" providerId="ADAL" clId="{0A0D2314-D59C-5A4C-9E09-78A254E3BB4B}" dt="2021-08-31T21:12:34.499" v="1070" actId="478"/>
          <ac:picMkLst>
            <pc:docMk/>
            <pc:sldMk cId="2078269342" sldId="277"/>
            <ac:picMk id="10" creationId="{8F08C599-E1EB-3044-A41D-ED696091AEE1}"/>
          </ac:picMkLst>
        </pc:picChg>
        <pc:picChg chg="del">
          <ac:chgData name="Narang, Sonali" userId="9e80b397-6e2f-49b1-9374-ccdad8589140" providerId="ADAL" clId="{0A0D2314-D59C-5A4C-9E09-78A254E3BB4B}" dt="2021-08-31T21:12:37.050" v="1071" actId="478"/>
          <ac:picMkLst>
            <pc:docMk/>
            <pc:sldMk cId="2078269342" sldId="277"/>
            <ac:picMk id="11" creationId="{49516C8B-9616-3B4D-A203-229E3B7B51D9}"/>
          </ac:picMkLst>
        </pc:picChg>
        <pc:picChg chg="del">
          <ac:chgData name="Narang, Sonali" userId="9e80b397-6e2f-49b1-9374-ccdad8589140" providerId="ADAL" clId="{0A0D2314-D59C-5A4C-9E09-78A254E3BB4B}" dt="2021-08-31T21:12:34.499" v="1070" actId="478"/>
          <ac:picMkLst>
            <pc:docMk/>
            <pc:sldMk cId="2078269342" sldId="277"/>
            <ac:picMk id="13" creationId="{A153BDA0-96B4-6B49-9040-4624ADB95ED3}"/>
          </ac:picMkLst>
        </pc:picChg>
        <pc:picChg chg="del mod">
          <ac:chgData name="Narang, Sonali" userId="9e80b397-6e2f-49b1-9374-ccdad8589140" providerId="ADAL" clId="{0A0D2314-D59C-5A4C-9E09-78A254E3BB4B}" dt="2021-11-02T17:10:23.477" v="3341" actId="478"/>
          <ac:picMkLst>
            <pc:docMk/>
            <pc:sldMk cId="2078269342" sldId="277"/>
            <ac:picMk id="29" creationId="{C6A5DB04-6ED8-E242-A11D-80CB8283A7EA}"/>
          </ac:picMkLst>
        </pc:picChg>
        <pc:picChg chg="add mod">
          <ac:chgData name="Narang, Sonali" userId="9e80b397-6e2f-49b1-9374-ccdad8589140" providerId="ADAL" clId="{0A0D2314-D59C-5A4C-9E09-78A254E3BB4B}" dt="2021-11-02T17:10:26.419" v="3342" actId="1076"/>
          <ac:picMkLst>
            <pc:docMk/>
            <pc:sldMk cId="2078269342" sldId="277"/>
            <ac:picMk id="64" creationId="{BDC1A47A-9479-3E4D-A349-CF06699F2793}"/>
          </ac:picMkLst>
        </pc:picChg>
        <pc:picChg chg="add mod">
          <ac:chgData name="Narang, Sonali" userId="9e80b397-6e2f-49b1-9374-ccdad8589140" providerId="ADAL" clId="{0A0D2314-D59C-5A4C-9E09-78A254E3BB4B}" dt="2021-11-02T17:12:17.557" v="3383" actId="1076"/>
          <ac:picMkLst>
            <pc:docMk/>
            <pc:sldMk cId="2078269342" sldId="277"/>
            <ac:picMk id="66" creationId="{3947B4BD-5497-734B-B72A-856B61E23828}"/>
          </ac:picMkLst>
        </pc:picChg>
        <pc:picChg chg="add mod modCrop">
          <ac:chgData name="Narang, Sonali" userId="9e80b397-6e2f-49b1-9374-ccdad8589140" providerId="ADAL" clId="{0A0D2314-D59C-5A4C-9E09-78A254E3BB4B}" dt="2021-11-02T17:12:17.557" v="3383" actId="1076"/>
          <ac:picMkLst>
            <pc:docMk/>
            <pc:sldMk cId="2078269342" sldId="277"/>
            <ac:picMk id="67" creationId="{35277A42-A4F2-E644-8DD1-70306EA4FB98}"/>
          </ac:picMkLst>
        </pc:picChg>
        <pc:picChg chg="add mod modCrop">
          <ac:chgData name="Narang, Sonali" userId="9e80b397-6e2f-49b1-9374-ccdad8589140" providerId="ADAL" clId="{0A0D2314-D59C-5A4C-9E09-78A254E3BB4B}" dt="2021-11-02T17:12:17.557" v="3383" actId="1076"/>
          <ac:picMkLst>
            <pc:docMk/>
            <pc:sldMk cId="2078269342" sldId="277"/>
            <ac:picMk id="68" creationId="{8F8E5938-471E-244A-AC6A-995ED39B84DC}"/>
          </ac:picMkLst>
        </pc:picChg>
      </pc:sldChg>
      <pc:sldChg chg="addSp delSp modSp add del mod">
        <pc:chgData name="Narang, Sonali" userId="9e80b397-6e2f-49b1-9374-ccdad8589140" providerId="ADAL" clId="{0A0D2314-D59C-5A4C-9E09-78A254E3BB4B}" dt="2021-11-03T20:18:41.070" v="4501" actId="2696"/>
        <pc:sldMkLst>
          <pc:docMk/>
          <pc:sldMk cId="3525632952" sldId="278"/>
        </pc:sldMkLst>
        <pc:spChg chg="del mod">
          <ac:chgData name="Narang, Sonali" userId="9e80b397-6e2f-49b1-9374-ccdad8589140" providerId="ADAL" clId="{0A0D2314-D59C-5A4C-9E09-78A254E3BB4B}" dt="2021-09-30T20:32:48.983" v="2446" actId="478"/>
          <ac:spMkLst>
            <pc:docMk/>
            <pc:sldMk cId="3525632952" sldId="278"/>
            <ac:spMk id="2" creationId="{3367D373-6BB0-4246-A264-BF1E1254F9FB}"/>
          </ac:spMkLst>
        </pc:spChg>
        <pc:spChg chg="add mod">
          <ac:chgData name="Narang, Sonali" userId="9e80b397-6e2f-49b1-9374-ccdad8589140" providerId="ADAL" clId="{0A0D2314-D59C-5A4C-9E09-78A254E3BB4B}" dt="2021-11-02T15:53:38.356" v="3270" actId="1076"/>
          <ac:spMkLst>
            <pc:docMk/>
            <pc:sldMk cId="3525632952" sldId="278"/>
            <ac:spMk id="2" creationId="{B058617F-5D67-A542-BF8F-7129F45BDF88}"/>
          </ac:spMkLst>
        </pc:spChg>
        <pc:spChg chg="add del mod">
          <ac:chgData name="Narang, Sonali" userId="9e80b397-6e2f-49b1-9374-ccdad8589140" providerId="ADAL" clId="{0A0D2314-D59C-5A4C-9E09-78A254E3BB4B}" dt="2021-11-03T18:08:46.624" v="4145" actId="478"/>
          <ac:spMkLst>
            <pc:docMk/>
            <pc:sldMk cId="3525632952" sldId="278"/>
            <ac:spMk id="3" creationId="{3D536C0D-B6EE-4C4D-872C-A592A4BEC993}"/>
          </ac:spMkLst>
        </pc:spChg>
        <pc:spChg chg="mod">
          <ac:chgData name="Narang, Sonali" userId="9e80b397-6e2f-49b1-9374-ccdad8589140" providerId="ADAL" clId="{0A0D2314-D59C-5A4C-9E09-78A254E3BB4B}" dt="2021-09-01T21:35:00.262" v="1684" actId="20577"/>
          <ac:spMkLst>
            <pc:docMk/>
            <pc:sldMk cId="3525632952" sldId="278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11-02T17:09:56.252" v="3333" actId="1038"/>
          <ac:spMkLst>
            <pc:docMk/>
            <pc:sldMk cId="3525632952" sldId="278"/>
            <ac:spMk id="5" creationId="{FAFFEC37-A0C5-5846-8534-22E3DEF6CEF4}"/>
          </ac:spMkLst>
        </pc:spChg>
        <pc:spChg chg="mod">
          <ac:chgData name="Narang, Sonali" userId="9e80b397-6e2f-49b1-9374-ccdad8589140" providerId="ADAL" clId="{0A0D2314-D59C-5A4C-9E09-78A254E3BB4B}" dt="2021-11-02T17:10:10.778" v="3340" actId="1076"/>
          <ac:spMkLst>
            <pc:docMk/>
            <pc:sldMk cId="3525632952" sldId="278"/>
            <ac:spMk id="7" creationId="{4C5F5CAE-FBFD-964D-A356-746AAC86DC9E}"/>
          </ac:spMkLst>
        </pc:spChg>
        <pc:spChg chg="mod">
          <ac:chgData name="Narang, Sonali" userId="9e80b397-6e2f-49b1-9374-ccdad8589140" providerId="ADAL" clId="{0A0D2314-D59C-5A4C-9E09-78A254E3BB4B}" dt="2021-11-02T17:09:51.719" v="3325" actId="1037"/>
          <ac:spMkLst>
            <pc:docMk/>
            <pc:sldMk cId="3525632952" sldId="278"/>
            <ac:spMk id="8" creationId="{8A9BAE78-C4FF-1843-94F6-3410EB884848}"/>
          </ac:spMkLst>
        </pc:spChg>
        <pc:spChg chg="add mod">
          <ac:chgData name="Narang, Sonali" userId="9e80b397-6e2f-49b1-9374-ccdad8589140" providerId="ADAL" clId="{0A0D2314-D59C-5A4C-9E09-78A254E3BB4B}" dt="2021-09-30T20:36:37.969" v="2528" actId="1035"/>
          <ac:spMkLst>
            <pc:docMk/>
            <pc:sldMk cId="3525632952" sldId="278"/>
            <ac:spMk id="22" creationId="{815B8AA3-2588-D94F-B9D1-7042D5C89A34}"/>
          </ac:spMkLst>
        </pc:spChg>
        <pc:spChg chg="add mod">
          <ac:chgData name="Narang, Sonali" userId="9e80b397-6e2f-49b1-9374-ccdad8589140" providerId="ADAL" clId="{0A0D2314-D59C-5A4C-9E09-78A254E3BB4B}" dt="2021-11-02T14:34:54.529" v="3054" actId="20577"/>
          <ac:spMkLst>
            <pc:docMk/>
            <pc:sldMk cId="3525632952" sldId="278"/>
            <ac:spMk id="29" creationId="{E4C2B977-FA04-3F48-B9BD-9F31456B3DDF}"/>
          </ac:spMkLst>
        </pc:spChg>
        <pc:spChg chg="add mod">
          <ac:chgData name="Narang, Sonali" userId="9e80b397-6e2f-49b1-9374-ccdad8589140" providerId="ADAL" clId="{0A0D2314-D59C-5A4C-9E09-78A254E3BB4B}" dt="2021-11-02T14:34:57.092" v="3056" actId="20577"/>
          <ac:spMkLst>
            <pc:docMk/>
            <pc:sldMk cId="3525632952" sldId="278"/>
            <ac:spMk id="31" creationId="{8EF461AC-923C-4449-8C5F-E3BB3E1A2E00}"/>
          </ac:spMkLst>
        </pc:spChg>
        <pc:spChg chg="mod">
          <ac:chgData name="Narang, Sonali" userId="9e80b397-6e2f-49b1-9374-ccdad8589140" providerId="ADAL" clId="{0A0D2314-D59C-5A4C-9E09-78A254E3BB4B}" dt="2021-11-02T17:10:10.778" v="3340" actId="1076"/>
          <ac:spMkLst>
            <pc:docMk/>
            <pc:sldMk cId="3525632952" sldId="278"/>
            <ac:spMk id="32" creationId="{2863401C-2050-2E40-AE5C-C6CDD3A8A7D4}"/>
          </ac:spMkLst>
        </pc:spChg>
        <pc:spChg chg="del mod">
          <ac:chgData name="Narang, Sonali" userId="9e80b397-6e2f-49b1-9374-ccdad8589140" providerId="ADAL" clId="{0A0D2314-D59C-5A4C-9E09-78A254E3BB4B}" dt="2021-09-30T20:32:31.770" v="2439" actId="478"/>
          <ac:spMkLst>
            <pc:docMk/>
            <pc:sldMk cId="3525632952" sldId="278"/>
            <ac:spMk id="36" creationId="{75B14C61-810F-134B-AC0D-0C1FD0CAB17A}"/>
          </ac:spMkLst>
        </pc:spChg>
        <pc:spChg chg="del mod">
          <ac:chgData name="Narang, Sonali" userId="9e80b397-6e2f-49b1-9374-ccdad8589140" providerId="ADAL" clId="{0A0D2314-D59C-5A4C-9E09-78A254E3BB4B}" dt="2021-09-30T20:32:31.770" v="2439" actId="478"/>
          <ac:spMkLst>
            <pc:docMk/>
            <pc:sldMk cId="3525632952" sldId="278"/>
            <ac:spMk id="59" creationId="{1C85DEE8-F315-5047-B7B7-8827D96395BE}"/>
          </ac:spMkLst>
        </pc:spChg>
        <pc:picChg chg="add mod modCrop">
          <ac:chgData name="Narang, Sonali" userId="9e80b397-6e2f-49b1-9374-ccdad8589140" providerId="ADAL" clId="{0A0D2314-D59C-5A4C-9E09-78A254E3BB4B}" dt="2021-09-30T20:36:37.969" v="2528" actId="1035"/>
          <ac:picMkLst>
            <pc:docMk/>
            <pc:sldMk cId="3525632952" sldId="278"/>
            <ac:picMk id="6" creationId="{07A34510-79AF-D945-8CDE-E6C2A3F41F8A}"/>
          </ac:picMkLst>
        </pc:picChg>
        <pc:picChg chg="add del mod">
          <ac:chgData name="Narang, Sonali" userId="9e80b397-6e2f-49b1-9374-ccdad8589140" providerId="ADAL" clId="{0A0D2314-D59C-5A4C-9E09-78A254E3BB4B}" dt="2021-11-02T17:11:07.601" v="3354" actId="21"/>
          <ac:picMkLst>
            <pc:docMk/>
            <pc:sldMk cId="3525632952" sldId="278"/>
            <ac:picMk id="9" creationId="{6BD1FE19-4740-7E40-B5CA-3165A31B78F0}"/>
          </ac:picMkLst>
        </pc:picChg>
        <pc:picChg chg="add mod modCrop">
          <ac:chgData name="Narang, Sonali" userId="9e80b397-6e2f-49b1-9374-ccdad8589140" providerId="ADAL" clId="{0A0D2314-D59C-5A4C-9E09-78A254E3BB4B}" dt="2021-09-30T20:36:37.969" v="2528" actId="1035"/>
          <ac:picMkLst>
            <pc:docMk/>
            <pc:sldMk cId="3525632952" sldId="278"/>
            <ac:picMk id="10" creationId="{EA3B9FA7-8C12-3D46-A087-17F1BE11CF56}"/>
          </ac:picMkLst>
        </pc:picChg>
        <pc:picChg chg="add mod modCrop">
          <ac:chgData name="Narang, Sonali" userId="9e80b397-6e2f-49b1-9374-ccdad8589140" providerId="ADAL" clId="{0A0D2314-D59C-5A4C-9E09-78A254E3BB4B}" dt="2021-09-30T20:36:37.969" v="2528" actId="1035"/>
          <ac:picMkLst>
            <pc:docMk/>
            <pc:sldMk cId="3525632952" sldId="278"/>
            <ac:picMk id="12" creationId="{676E61DD-D5A0-DD48-9AC2-F419B394C32F}"/>
          </ac:picMkLst>
        </pc:picChg>
        <pc:picChg chg="add del mod">
          <ac:chgData name="Narang, Sonali" userId="9e80b397-6e2f-49b1-9374-ccdad8589140" providerId="ADAL" clId="{0A0D2314-D59C-5A4C-9E09-78A254E3BB4B}" dt="2021-11-02T17:11:07.601" v="3354" actId="21"/>
          <ac:picMkLst>
            <pc:docMk/>
            <pc:sldMk cId="3525632952" sldId="278"/>
            <ac:picMk id="13" creationId="{7E45C966-EFC9-3943-93C8-7EC4AE9E8EB2}"/>
          </ac:picMkLst>
        </pc:picChg>
        <pc:picChg chg="add mod">
          <ac:chgData name="Narang, Sonali" userId="9e80b397-6e2f-49b1-9374-ccdad8589140" providerId="ADAL" clId="{0A0D2314-D59C-5A4C-9E09-78A254E3BB4B}" dt="2021-11-03T18:09:36.829" v="4162" actId="1076"/>
          <ac:picMkLst>
            <pc:docMk/>
            <pc:sldMk cId="3525632952" sldId="278"/>
            <ac:picMk id="14" creationId="{4A2BE57C-7646-934A-8FEC-4BD94BAF6E9A}"/>
          </ac:picMkLst>
        </pc:picChg>
        <pc:picChg chg="add del mod">
          <ac:chgData name="Narang, Sonali" userId="9e80b397-6e2f-49b1-9374-ccdad8589140" providerId="ADAL" clId="{0A0D2314-D59C-5A4C-9E09-78A254E3BB4B}" dt="2021-11-02T17:11:07.601" v="3354" actId="21"/>
          <ac:picMkLst>
            <pc:docMk/>
            <pc:sldMk cId="3525632952" sldId="278"/>
            <ac:picMk id="15" creationId="{4AC1244C-DA35-7D47-BB54-0DF532F9E0BF}"/>
          </ac:picMkLst>
        </pc:picChg>
        <pc:picChg chg="add mod">
          <ac:chgData name="Narang, Sonali" userId="9e80b397-6e2f-49b1-9374-ccdad8589140" providerId="ADAL" clId="{0A0D2314-D59C-5A4C-9E09-78A254E3BB4B}" dt="2021-11-03T18:09:36.829" v="4162" actId="1076"/>
          <ac:picMkLst>
            <pc:docMk/>
            <pc:sldMk cId="3525632952" sldId="278"/>
            <ac:picMk id="17" creationId="{44BA04FC-FAF2-FD4D-84D5-8165C87A11B2}"/>
          </ac:picMkLst>
        </pc:picChg>
        <pc:picChg chg="add del mod">
          <ac:chgData name="Narang, Sonali" userId="9e80b397-6e2f-49b1-9374-ccdad8589140" providerId="ADAL" clId="{0A0D2314-D59C-5A4C-9E09-78A254E3BB4B}" dt="2021-09-30T20:56:44.709" v="2570" actId="478"/>
          <ac:picMkLst>
            <pc:docMk/>
            <pc:sldMk cId="3525632952" sldId="278"/>
            <ac:picMk id="17" creationId="{4744DAF0-D5E6-944C-8AD9-32C341D2CF29}"/>
          </ac:picMkLst>
        </pc:picChg>
        <pc:picChg chg="add mod">
          <ac:chgData name="Narang, Sonali" userId="9e80b397-6e2f-49b1-9374-ccdad8589140" providerId="ADAL" clId="{0A0D2314-D59C-5A4C-9E09-78A254E3BB4B}" dt="2021-11-03T18:09:36.829" v="4162" actId="1076"/>
          <ac:picMkLst>
            <pc:docMk/>
            <pc:sldMk cId="3525632952" sldId="278"/>
            <ac:picMk id="19" creationId="{43FAA709-337E-CD45-B8D6-5D30C3A09556}"/>
          </ac:picMkLst>
        </pc:picChg>
        <pc:picChg chg="add del mod">
          <ac:chgData name="Narang, Sonali" userId="9e80b397-6e2f-49b1-9374-ccdad8589140" providerId="ADAL" clId="{0A0D2314-D59C-5A4C-9E09-78A254E3BB4B}" dt="2021-09-30T20:56:44.709" v="2570" actId="478"/>
          <ac:picMkLst>
            <pc:docMk/>
            <pc:sldMk cId="3525632952" sldId="278"/>
            <ac:picMk id="19" creationId="{5EF8881E-54EB-F140-A6EE-EC34FB129B0E}"/>
          </ac:picMkLst>
        </pc:picChg>
        <pc:picChg chg="add mod">
          <ac:chgData name="Narang, Sonali" userId="9e80b397-6e2f-49b1-9374-ccdad8589140" providerId="ADAL" clId="{0A0D2314-D59C-5A4C-9E09-78A254E3BB4B}" dt="2021-11-03T18:21:21.858" v="4181" actId="1076"/>
          <ac:picMkLst>
            <pc:docMk/>
            <pc:sldMk cId="3525632952" sldId="278"/>
            <ac:picMk id="21" creationId="{A940D900-68A7-BE40-8332-C3901FA700AB}"/>
          </ac:picMkLst>
        </pc:picChg>
        <pc:picChg chg="add del mod">
          <ac:chgData name="Narang, Sonali" userId="9e80b397-6e2f-49b1-9374-ccdad8589140" providerId="ADAL" clId="{0A0D2314-D59C-5A4C-9E09-78A254E3BB4B}" dt="2021-09-30T20:56:44.709" v="2570" actId="478"/>
          <ac:picMkLst>
            <pc:docMk/>
            <pc:sldMk cId="3525632952" sldId="278"/>
            <ac:picMk id="21" creationId="{C3BCCD25-870C-DB43-A1DE-C7691B25899F}"/>
          </ac:picMkLst>
        </pc:picChg>
        <pc:picChg chg="add del mod">
          <ac:chgData name="Narang, Sonali" userId="9e80b397-6e2f-49b1-9374-ccdad8589140" providerId="ADAL" clId="{0A0D2314-D59C-5A4C-9E09-78A254E3BB4B}" dt="2021-11-03T18:08:49.558" v="4146" actId="478"/>
          <ac:picMkLst>
            <pc:docMk/>
            <pc:sldMk cId="3525632952" sldId="278"/>
            <ac:picMk id="24" creationId="{26424F45-C4AC-6847-ACAA-49D1259C940A}"/>
          </ac:picMkLst>
        </pc:picChg>
        <pc:picChg chg="add mod">
          <ac:chgData name="Narang, Sonali" userId="9e80b397-6e2f-49b1-9374-ccdad8589140" providerId="ADAL" clId="{0A0D2314-D59C-5A4C-9E09-78A254E3BB4B}" dt="2021-11-03T18:21:31.654" v="4182" actId="1076"/>
          <ac:picMkLst>
            <pc:docMk/>
            <pc:sldMk cId="3525632952" sldId="278"/>
            <ac:picMk id="25" creationId="{CF5D0863-3F9E-0146-BBBB-4F71A4C01A81}"/>
          </ac:picMkLst>
        </pc:picChg>
        <pc:picChg chg="mod">
          <ac:chgData name="Narang, Sonali" userId="9e80b397-6e2f-49b1-9374-ccdad8589140" providerId="ADAL" clId="{0A0D2314-D59C-5A4C-9E09-78A254E3BB4B}" dt="2021-11-02T17:09:51.719" v="3325" actId="1037"/>
          <ac:picMkLst>
            <pc:docMk/>
            <pc:sldMk cId="3525632952" sldId="278"/>
            <ac:picMk id="26" creationId="{6622012E-829C-D245-ACED-5089C4B5C9C4}"/>
          </ac:picMkLst>
        </pc:picChg>
        <pc:picChg chg="add del mod">
          <ac:chgData name="Narang, Sonali" userId="9e80b397-6e2f-49b1-9374-ccdad8589140" providerId="ADAL" clId="{0A0D2314-D59C-5A4C-9E09-78A254E3BB4B}" dt="2021-11-03T18:08:49.558" v="4146" actId="478"/>
          <ac:picMkLst>
            <pc:docMk/>
            <pc:sldMk cId="3525632952" sldId="278"/>
            <ac:picMk id="27" creationId="{69E2C356-D7CC-304D-96C2-2468CBB62710}"/>
          </ac:picMkLst>
        </pc:picChg>
        <pc:picChg chg="mod">
          <ac:chgData name="Narang, Sonali" userId="9e80b397-6e2f-49b1-9374-ccdad8589140" providerId="ADAL" clId="{0A0D2314-D59C-5A4C-9E09-78A254E3BB4B}" dt="2021-11-02T17:09:51.719" v="3325" actId="1037"/>
          <ac:picMkLst>
            <pc:docMk/>
            <pc:sldMk cId="3525632952" sldId="278"/>
            <ac:picMk id="28" creationId="{E4F0C550-AE7A-2142-8FFA-261CC21C45B1}"/>
          </ac:picMkLst>
        </pc:picChg>
        <pc:picChg chg="mod">
          <ac:chgData name="Narang, Sonali" userId="9e80b397-6e2f-49b1-9374-ccdad8589140" providerId="ADAL" clId="{0A0D2314-D59C-5A4C-9E09-78A254E3BB4B}" dt="2021-11-02T17:09:51.719" v="3325" actId="1037"/>
          <ac:picMkLst>
            <pc:docMk/>
            <pc:sldMk cId="3525632952" sldId="278"/>
            <ac:picMk id="30" creationId="{E442FC1C-4929-E044-99A7-21D2850971B1}"/>
          </ac:picMkLst>
        </pc:picChg>
        <pc:picChg chg="del">
          <ac:chgData name="Narang, Sonali" userId="9e80b397-6e2f-49b1-9374-ccdad8589140" providerId="ADAL" clId="{0A0D2314-D59C-5A4C-9E09-78A254E3BB4B}" dt="2021-09-01T20:09:46.563" v="1289" actId="478"/>
          <ac:picMkLst>
            <pc:docMk/>
            <pc:sldMk cId="3525632952" sldId="278"/>
            <ac:picMk id="33" creationId="{0FBF3EDC-FFCA-A645-A7E9-3E1E055E9B34}"/>
          </ac:picMkLst>
        </pc:picChg>
        <pc:picChg chg="add mod">
          <ac:chgData name="Narang, Sonali" userId="9e80b397-6e2f-49b1-9374-ccdad8589140" providerId="ADAL" clId="{0A0D2314-D59C-5A4C-9E09-78A254E3BB4B}" dt="2021-11-02T17:09:56.252" v="3333" actId="1038"/>
          <ac:picMkLst>
            <pc:docMk/>
            <pc:sldMk cId="3525632952" sldId="278"/>
            <ac:picMk id="33" creationId="{4A396834-A78E-BA4E-B81C-727FA6F833D7}"/>
          </ac:picMkLst>
        </pc:picChg>
        <pc:picChg chg="add del mod">
          <ac:chgData name="Narang, Sonali" userId="9e80b397-6e2f-49b1-9374-ccdad8589140" providerId="ADAL" clId="{0A0D2314-D59C-5A4C-9E09-78A254E3BB4B}" dt="2021-11-03T18:08:49.558" v="4146" actId="478"/>
          <ac:picMkLst>
            <pc:docMk/>
            <pc:sldMk cId="3525632952" sldId="278"/>
            <ac:picMk id="34" creationId="{8422AC0C-5BCB-274A-8438-2458FDE08EA1}"/>
          </ac:picMkLst>
        </pc:picChg>
        <pc:picChg chg="add mod">
          <ac:chgData name="Narang, Sonali" userId="9e80b397-6e2f-49b1-9374-ccdad8589140" providerId="ADAL" clId="{0A0D2314-D59C-5A4C-9E09-78A254E3BB4B}" dt="2021-11-03T18:17:21.198" v="4177" actId="1035"/>
          <ac:picMkLst>
            <pc:docMk/>
            <pc:sldMk cId="3525632952" sldId="278"/>
            <ac:picMk id="36" creationId="{FADD3DC1-0765-3942-A3B5-F0B230C93712}"/>
          </ac:picMkLst>
        </pc:picChg>
        <pc:picChg chg="add del mod">
          <ac:chgData name="Narang, Sonali" userId="9e80b397-6e2f-49b1-9374-ccdad8589140" providerId="ADAL" clId="{0A0D2314-D59C-5A4C-9E09-78A254E3BB4B}" dt="2021-11-03T18:16:32.631" v="4163" actId="478"/>
          <ac:picMkLst>
            <pc:docMk/>
            <pc:sldMk cId="3525632952" sldId="278"/>
            <ac:picMk id="37" creationId="{7268739B-9970-2847-8373-CED017843C2A}"/>
          </ac:picMkLst>
        </pc:picChg>
        <pc:picChg chg="del">
          <ac:chgData name="Narang, Sonali" userId="9e80b397-6e2f-49b1-9374-ccdad8589140" providerId="ADAL" clId="{0A0D2314-D59C-5A4C-9E09-78A254E3BB4B}" dt="2021-09-01T20:09:46.563" v="1289" actId="478"/>
          <ac:picMkLst>
            <pc:docMk/>
            <pc:sldMk cId="3525632952" sldId="278"/>
            <ac:picMk id="39" creationId="{3034700E-7CF2-964B-B2C1-E6B2E0CF2815}"/>
          </ac:picMkLst>
        </pc:picChg>
        <pc:picChg chg="add del mod">
          <ac:chgData name="Narang, Sonali" userId="9e80b397-6e2f-49b1-9374-ccdad8589140" providerId="ADAL" clId="{0A0D2314-D59C-5A4C-9E09-78A254E3BB4B}" dt="2021-11-03T18:16:32.631" v="4163" actId="478"/>
          <ac:picMkLst>
            <pc:docMk/>
            <pc:sldMk cId="3525632952" sldId="278"/>
            <ac:picMk id="39" creationId="{4DCF8216-C56A-714E-B6FF-3B446B5CA587}"/>
          </ac:picMkLst>
        </pc:picChg>
        <pc:picChg chg="add del mod">
          <ac:chgData name="Narang, Sonali" userId="9e80b397-6e2f-49b1-9374-ccdad8589140" providerId="ADAL" clId="{0A0D2314-D59C-5A4C-9E09-78A254E3BB4B}" dt="2021-11-03T18:16:32.631" v="4163" actId="478"/>
          <ac:picMkLst>
            <pc:docMk/>
            <pc:sldMk cId="3525632952" sldId="278"/>
            <ac:picMk id="41" creationId="{46724EC6-E0D5-F042-811C-37303F4D2F95}"/>
          </ac:picMkLst>
        </pc:picChg>
        <pc:picChg chg="del">
          <ac:chgData name="Narang, Sonali" userId="9e80b397-6e2f-49b1-9374-ccdad8589140" providerId="ADAL" clId="{0A0D2314-D59C-5A4C-9E09-78A254E3BB4B}" dt="2021-09-01T20:09:46.563" v="1289" actId="478"/>
          <ac:picMkLst>
            <pc:docMk/>
            <pc:sldMk cId="3525632952" sldId="278"/>
            <ac:picMk id="41" creationId="{BAB6122B-96E2-5343-939D-30AD2FCD8704}"/>
          </ac:picMkLst>
        </pc:picChg>
      </pc:sldChg>
      <pc:sldChg chg="addSp delSp modSp add mod ord">
        <pc:chgData name="Narang, Sonali" userId="9e80b397-6e2f-49b1-9374-ccdad8589140" providerId="ADAL" clId="{0A0D2314-D59C-5A4C-9E09-78A254E3BB4B}" dt="2021-11-02T15:35:45.821" v="3204" actId="20577"/>
        <pc:sldMkLst>
          <pc:docMk/>
          <pc:sldMk cId="3296066017" sldId="279"/>
        </pc:sldMkLst>
        <pc:spChg chg="mod">
          <ac:chgData name="Narang, Sonali" userId="9e80b397-6e2f-49b1-9374-ccdad8589140" providerId="ADAL" clId="{0A0D2314-D59C-5A4C-9E09-78A254E3BB4B}" dt="2021-11-02T15:35:45.821" v="3204" actId="20577"/>
          <ac:spMkLst>
            <pc:docMk/>
            <pc:sldMk cId="3296066017" sldId="279"/>
            <ac:spMk id="4" creationId="{F6669B9D-B042-D548-BD0F-97015091799B}"/>
          </ac:spMkLst>
        </pc:spChg>
        <pc:spChg chg="mod">
          <ac:chgData name="Narang, Sonali" userId="9e80b397-6e2f-49b1-9374-ccdad8589140" providerId="ADAL" clId="{0A0D2314-D59C-5A4C-9E09-78A254E3BB4B}" dt="2021-09-30T22:26:46.750" v="2937" actId="1076"/>
          <ac:spMkLst>
            <pc:docMk/>
            <pc:sldMk cId="3296066017" sldId="279"/>
            <ac:spMk id="8" creationId="{8A9BAE78-C4FF-1843-94F6-3410EB884848}"/>
          </ac:spMkLst>
        </pc:spChg>
        <pc:spChg chg="add mod">
          <ac:chgData name="Narang, Sonali" userId="9e80b397-6e2f-49b1-9374-ccdad8589140" providerId="ADAL" clId="{0A0D2314-D59C-5A4C-9E09-78A254E3BB4B}" dt="2021-09-30T22:26:46.750" v="2937" actId="1076"/>
          <ac:spMkLst>
            <pc:docMk/>
            <pc:sldMk cId="3296066017" sldId="279"/>
            <ac:spMk id="91" creationId="{2BE97283-F355-544F-BB87-4A197097EE8C}"/>
          </ac:spMkLst>
        </pc:spChg>
        <pc:spChg chg="add mod">
          <ac:chgData name="Narang, Sonali" userId="9e80b397-6e2f-49b1-9374-ccdad8589140" providerId="ADAL" clId="{0A0D2314-D59C-5A4C-9E09-78A254E3BB4B}" dt="2021-09-30T22:26:34.995" v="2936" actId="1076"/>
          <ac:spMkLst>
            <pc:docMk/>
            <pc:sldMk cId="3296066017" sldId="279"/>
            <ac:spMk id="92" creationId="{B168996F-E829-2D46-B390-6FC40E645DA3}"/>
          </ac:spMkLst>
        </pc:spChg>
        <pc:grpChg chg="mod">
          <ac:chgData name="Narang, Sonali" userId="9e80b397-6e2f-49b1-9374-ccdad8589140" providerId="ADAL" clId="{0A0D2314-D59C-5A4C-9E09-78A254E3BB4B}" dt="2021-09-30T22:26:46.750" v="2937" actId="1076"/>
          <ac:grpSpMkLst>
            <pc:docMk/>
            <pc:sldMk cId="3296066017" sldId="279"/>
            <ac:grpSpMk id="11" creationId="{C32B8FC9-55A4-D644-ADCA-CF6BCE435857}"/>
          </ac:grpSpMkLst>
        </pc:grpChg>
        <pc:grpChg chg="del">
          <ac:chgData name="Narang, Sonali" userId="9e80b397-6e2f-49b1-9374-ccdad8589140" providerId="ADAL" clId="{0A0D2314-D59C-5A4C-9E09-78A254E3BB4B}" dt="2021-09-30T19:10:50.764" v="1927" actId="478"/>
          <ac:grpSpMkLst>
            <pc:docMk/>
            <pc:sldMk cId="3296066017" sldId="279"/>
            <ac:grpSpMk id="85" creationId="{D7BDA1D2-D9CA-734B-A971-54235A3C5910}"/>
          </ac:grpSpMkLst>
        </pc:grpChg>
        <pc:picChg chg="del mod">
          <ac:chgData name="Narang, Sonali" userId="9e80b397-6e2f-49b1-9374-ccdad8589140" providerId="ADAL" clId="{0A0D2314-D59C-5A4C-9E09-78A254E3BB4B}" dt="2021-09-30T22:16:21.305" v="2810" actId="478"/>
          <ac:picMkLst>
            <pc:docMk/>
            <pc:sldMk cId="3296066017" sldId="279"/>
            <ac:picMk id="3" creationId="{8D46FA96-CD3D-0047-90E5-A1D1D7788A8F}"/>
          </ac:picMkLst>
        </pc:picChg>
        <pc:picChg chg="del">
          <ac:chgData name="Narang, Sonali" userId="9e80b397-6e2f-49b1-9374-ccdad8589140" providerId="ADAL" clId="{0A0D2314-D59C-5A4C-9E09-78A254E3BB4B}" dt="2021-09-30T19:10:50.764" v="1927" actId="478"/>
          <ac:picMkLst>
            <pc:docMk/>
            <pc:sldMk cId="3296066017" sldId="279"/>
            <ac:picMk id="9" creationId="{6ABD3AA5-95E6-6D4B-84AF-F0F5C645343C}"/>
          </ac:picMkLst>
        </pc:picChg>
        <pc:picChg chg="add mod">
          <ac:chgData name="Narang, Sonali" userId="9e80b397-6e2f-49b1-9374-ccdad8589140" providerId="ADAL" clId="{0A0D2314-D59C-5A4C-9E09-78A254E3BB4B}" dt="2021-09-30T22:10:54.266" v="2792" actId="167"/>
          <ac:picMkLst>
            <pc:docMk/>
            <pc:sldMk cId="3296066017" sldId="279"/>
            <ac:picMk id="12" creationId="{CD0563F0-C751-FC47-8AE6-EFC466272C78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14" creationId="{6070D443-9118-C64A-8D4B-BFD2145101A2}"/>
          </ac:picMkLst>
        </pc:picChg>
        <pc:picChg chg="del mod">
          <ac:chgData name="Narang, Sonali" userId="9e80b397-6e2f-49b1-9374-ccdad8589140" providerId="ADAL" clId="{0A0D2314-D59C-5A4C-9E09-78A254E3BB4B}" dt="2021-09-30T22:15:34.324" v="2793" actId="478"/>
          <ac:picMkLst>
            <pc:docMk/>
            <pc:sldMk cId="3296066017" sldId="279"/>
            <ac:picMk id="16" creationId="{0431DD33-487F-1744-895E-CD1CBD9FCEF2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17" creationId="{F1479E0E-DE22-3247-BA7A-0EE44F1C0BDF}"/>
          </ac:picMkLst>
        </pc:picChg>
        <pc:picChg chg="del">
          <ac:chgData name="Narang, Sonali" userId="9e80b397-6e2f-49b1-9374-ccdad8589140" providerId="ADAL" clId="{0A0D2314-D59C-5A4C-9E09-78A254E3BB4B}" dt="2021-09-30T19:10:52.797" v="1928" actId="478"/>
          <ac:picMkLst>
            <pc:docMk/>
            <pc:sldMk cId="3296066017" sldId="279"/>
            <ac:picMk id="18" creationId="{280D59A3-8DC1-994E-9BAD-746BF4A9F461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20" creationId="{88777090-38D1-6244-B6C3-BB2AA0287F67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22" creationId="{94CF07BF-7E1E-A840-A390-E6AB8098EEC1}"/>
          </ac:picMkLst>
        </pc:picChg>
        <pc:picChg chg="add del mod">
          <ac:chgData name="Narang, Sonali" userId="9e80b397-6e2f-49b1-9374-ccdad8589140" providerId="ADAL" clId="{0A0D2314-D59C-5A4C-9E09-78A254E3BB4B}" dt="2021-09-30T22:22:56.955" v="2838" actId="478"/>
          <ac:picMkLst>
            <pc:docMk/>
            <pc:sldMk cId="3296066017" sldId="279"/>
            <ac:picMk id="24" creationId="{A6C1172D-C7D4-7E40-B485-7134F034CDB9}"/>
          </ac:picMkLst>
        </pc:picChg>
        <pc:picChg chg="add del mod">
          <ac:chgData name="Narang, Sonali" userId="9e80b397-6e2f-49b1-9374-ccdad8589140" providerId="ADAL" clId="{0A0D2314-D59C-5A4C-9E09-78A254E3BB4B}" dt="2021-09-30T22:22:56.955" v="2838" actId="478"/>
          <ac:picMkLst>
            <pc:docMk/>
            <pc:sldMk cId="3296066017" sldId="279"/>
            <ac:picMk id="26" creationId="{85CBDE9A-06E8-864B-86B9-5B1FD1151523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28" creationId="{92DBD7F4-68D2-694A-B1BF-835D829C0F20}"/>
          </ac:picMkLst>
        </pc:picChg>
        <pc:picChg chg="add mod">
          <ac:chgData name="Narang, Sonali" userId="9e80b397-6e2f-49b1-9374-ccdad8589140" providerId="ADAL" clId="{0A0D2314-D59C-5A4C-9E09-78A254E3BB4B}" dt="2021-09-30T22:25:21.496" v="2860" actId="408"/>
          <ac:picMkLst>
            <pc:docMk/>
            <pc:sldMk cId="3296066017" sldId="279"/>
            <ac:picMk id="30" creationId="{A16034B0-4FAA-0F49-A8E9-45440EBC751E}"/>
          </ac:picMkLst>
        </pc:picChg>
        <pc:picChg chg="del mod">
          <ac:chgData name="Narang, Sonali" userId="9e80b397-6e2f-49b1-9374-ccdad8589140" providerId="ADAL" clId="{0A0D2314-D59C-5A4C-9E09-78A254E3BB4B}" dt="2021-09-30T22:16:21.305" v="2810" actId="478"/>
          <ac:picMkLst>
            <pc:docMk/>
            <pc:sldMk cId="3296066017" sldId="279"/>
            <ac:picMk id="83" creationId="{A2DC379C-9BE3-8847-8A10-2744CD535286}"/>
          </ac:picMkLst>
        </pc:picChg>
        <pc:picChg chg="del mod">
          <ac:chgData name="Narang, Sonali" userId="9e80b397-6e2f-49b1-9374-ccdad8589140" providerId="ADAL" clId="{0A0D2314-D59C-5A4C-9E09-78A254E3BB4B}" dt="2021-09-30T22:15:34.324" v="2793" actId="478"/>
          <ac:picMkLst>
            <pc:docMk/>
            <pc:sldMk cId="3296066017" sldId="279"/>
            <ac:picMk id="111" creationId="{20BB0087-4AF3-7B49-A354-5C3664D1250B}"/>
          </ac:picMkLst>
        </pc:picChg>
        <pc:picChg chg="del mod">
          <ac:chgData name="Narang, Sonali" userId="9e80b397-6e2f-49b1-9374-ccdad8589140" providerId="ADAL" clId="{0A0D2314-D59C-5A4C-9E09-78A254E3BB4B}" dt="2021-09-30T22:16:22.631" v="2811" actId="478"/>
          <ac:picMkLst>
            <pc:docMk/>
            <pc:sldMk cId="3296066017" sldId="279"/>
            <ac:picMk id="114" creationId="{CD79A9EC-0F7C-6141-93B3-F5755D6371C7}"/>
          </ac:picMkLst>
        </pc:picChg>
        <pc:picChg chg="del mod">
          <ac:chgData name="Narang, Sonali" userId="9e80b397-6e2f-49b1-9374-ccdad8589140" providerId="ADAL" clId="{0A0D2314-D59C-5A4C-9E09-78A254E3BB4B}" dt="2021-09-30T22:16:22.631" v="2811" actId="478"/>
          <ac:picMkLst>
            <pc:docMk/>
            <pc:sldMk cId="3296066017" sldId="279"/>
            <ac:picMk id="116" creationId="{66C157FD-9F4F-EE4C-9C7A-F66F0D902C3A}"/>
          </ac:picMkLst>
        </pc:picChg>
      </pc:sldChg>
      <pc:sldChg chg="addSp delSp modSp add mod ord">
        <pc:chgData name="Narang, Sonali" userId="9e80b397-6e2f-49b1-9374-ccdad8589140" providerId="ADAL" clId="{0A0D2314-D59C-5A4C-9E09-78A254E3BB4B}" dt="2021-11-04T20:49:56.274" v="4676" actId="20577"/>
        <pc:sldMkLst>
          <pc:docMk/>
          <pc:sldMk cId="3214590643" sldId="280"/>
        </pc:sldMkLst>
        <pc:spChg chg="del mod">
          <ac:chgData name="Narang, Sonali" userId="9e80b397-6e2f-49b1-9374-ccdad8589140" providerId="ADAL" clId="{0A0D2314-D59C-5A4C-9E09-78A254E3BB4B}" dt="2021-09-30T22:30:37.586" v="2947" actId="478"/>
          <ac:spMkLst>
            <pc:docMk/>
            <pc:sldMk cId="3214590643" sldId="280"/>
            <ac:spMk id="26" creationId="{4AA2B0E0-9E04-1748-82E6-C76635F8D162}"/>
          </ac:spMkLst>
        </pc:spChg>
        <pc:spChg chg="del">
          <ac:chgData name="Narang, Sonali" userId="9e80b397-6e2f-49b1-9374-ccdad8589140" providerId="ADAL" clId="{0A0D2314-D59C-5A4C-9E09-78A254E3BB4B}" dt="2021-09-30T22:30:37.586" v="2947" actId="478"/>
          <ac:spMkLst>
            <pc:docMk/>
            <pc:sldMk cId="3214590643" sldId="280"/>
            <ac:spMk id="27" creationId="{0D94C0A7-0AEB-3D47-9BC0-55F5364A8EF3}"/>
          </ac:spMkLst>
        </pc:spChg>
        <pc:spChg chg="del">
          <ac:chgData name="Narang, Sonali" userId="9e80b397-6e2f-49b1-9374-ccdad8589140" providerId="ADAL" clId="{0A0D2314-D59C-5A4C-9E09-78A254E3BB4B}" dt="2021-09-30T22:30:37.586" v="2947" actId="478"/>
          <ac:spMkLst>
            <pc:docMk/>
            <pc:sldMk cId="3214590643" sldId="280"/>
            <ac:spMk id="30" creationId="{9F4469E9-F3F6-2246-A6BF-786873C72E08}"/>
          </ac:spMkLst>
        </pc:spChg>
        <pc:spChg chg="del">
          <ac:chgData name="Narang, Sonali" userId="9e80b397-6e2f-49b1-9374-ccdad8589140" providerId="ADAL" clId="{0A0D2314-D59C-5A4C-9E09-78A254E3BB4B}" dt="2021-09-30T22:30:37.586" v="2947" actId="478"/>
          <ac:spMkLst>
            <pc:docMk/>
            <pc:sldMk cId="3214590643" sldId="280"/>
            <ac:spMk id="31" creationId="{ECDA0C85-B876-244E-9A92-1F9DEFEB0495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2" creationId="{CF84F454-6117-B94C-B4C9-DA16C5CC7620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3" creationId="{3DB50601-7070-8147-BF34-C28C10DE4EF7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4" creationId="{201BD6FB-B29D-6F4F-9FD1-82E81832B7AF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5" creationId="{719E90AD-4A7B-854D-83F7-D84D25D8F9C2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6" creationId="{C71CD2D3-7D44-F340-B1C8-3A86FB15BA85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7" creationId="{7C05ACB9-A94F-A842-B1F1-066896F0F3C5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8" creationId="{B722EF19-0AA9-2746-96CA-C445738BD6DB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39" creationId="{93C6A577-2A8E-F14F-841E-A61A2CBA925C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40" creationId="{F46EE902-9FAA-2E40-8033-C85265F25903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41" creationId="{8D406CD7-682B-FD41-8863-186D408A7EBE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42" creationId="{B7BD1451-A2CC-154C-8A1E-07A76EB37568}"/>
          </ac:spMkLst>
        </pc:spChg>
        <pc:spChg chg="del">
          <ac:chgData name="Narang, Sonali" userId="9e80b397-6e2f-49b1-9374-ccdad8589140" providerId="ADAL" clId="{0A0D2314-D59C-5A4C-9E09-78A254E3BB4B}" dt="2021-09-30T22:30:26.842" v="2943" actId="478"/>
          <ac:spMkLst>
            <pc:docMk/>
            <pc:sldMk cId="3214590643" sldId="280"/>
            <ac:spMk id="43" creationId="{5C52D3DA-6F43-1948-A778-94F6E4E9E14F}"/>
          </ac:spMkLst>
        </pc:spChg>
        <pc:spChg chg="mod">
          <ac:chgData name="Narang, Sonali" userId="9e80b397-6e2f-49b1-9374-ccdad8589140" providerId="ADAL" clId="{0A0D2314-D59C-5A4C-9E09-78A254E3BB4B}" dt="2021-11-04T20:49:56.274" v="4676" actId="20577"/>
          <ac:spMkLst>
            <pc:docMk/>
            <pc:sldMk cId="3214590643" sldId="280"/>
            <ac:spMk id="45" creationId="{A37EFDC5-08ED-BB45-B24A-B00535A392F0}"/>
          </ac:spMkLst>
        </pc:spChg>
        <pc:spChg chg="add mod">
          <ac:chgData name="Narang, Sonali" userId="9e80b397-6e2f-49b1-9374-ccdad8589140" providerId="ADAL" clId="{0A0D2314-D59C-5A4C-9E09-78A254E3BB4B}" dt="2021-09-30T22:30:57.994" v="2953"/>
          <ac:spMkLst>
            <pc:docMk/>
            <pc:sldMk cId="3214590643" sldId="280"/>
            <ac:spMk id="46" creationId="{BC4BD7F9-9550-3841-BBB5-1A58285A1D88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2" creationId="{13D20ECD-75DA-CB48-AB73-27583AD256B3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3" creationId="{72B26A3D-2449-094B-918A-006D11D011C7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4" creationId="{084ECCF1-F533-6F4A-9C79-1AAA859168B6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5" creationId="{EC16123A-63C0-9E49-A1F8-E06C9FD3873D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6" creationId="{66A1DC14-DA92-D74F-8544-24D33215BD1A}"/>
          </ac:spMkLst>
        </pc:spChg>
        <pc:spChg chg="mod">
          <ac:chgData name="Narang, Sonali" userId="9e80b397-6e2f-49b1-9374-ccdad8589140" providerId="ADAL" clId="{0A0D2314-D59C-5A4C-9E09-78A254E3BB4B}" dt="2021-10-01T16:50:50.933" v="2964"/>
          <ac:spMkLst>
            <pc:docMk/>
            <pc:sldMk cId="3214590643" sldId="280"/>
            <ac:spMk id="57" creationId="{15A87318-8965-524D-9D27-FA6E4D625EA4}"/>
          </ac:spMkLst>
        </pc:spChg>
        <pc:grpChg chg="del mod">
          <ac:chgData name="Narang, Sonali" userId="9e80b397-6e2f-49b1-9374-ccdad8589140" providerId="ADAL" clId="{0A0D2314-D59C-5A4C-9E09-78A254E3BB4B}" dt="2021-09-30T22:30:30.919" v="2945" actId="478"/>
          <ac:grpSpMkLst>
            <pc:docMk/>
            <pc:sldMk cId="3214590643" sldId="280"/>
            <ac:grpSpMk id="4" creationId="{38EA236B-FA62-104C-88BA-1A393570B00A}"/>
          </ac:grpSpMkLst>
        </pc:grpChg>
        <pc:grpChg chg="add mod">
          <ac:chgData name="Narang, Sonali" userId="9e80b397-6e2f-49b1-9374-ccdad8589140" providerId="ADAL" clId="{0A0D2314-D59C-5A4C-9E09-78A254E3BB4B}" dt="2021-10-01T16:50:53.844" v="2965" actId="1076"/>
          <ac:grpSpMkLst>
            <pc:docMk/>
            <pc:sldMk cId="3214590643" sldId="280"/>
            <ac:grpSpMk id="47" creationId="{4B802D37-9378-E54E-99B5-1E00E308EBB8}"/>
          </ac:grpSpMkLst>
        </pc:grpChg>
        <pc:picChg chg="del">
          <ac:chgData name="Narang, Sonali" userId="9e80b397-6e2f-49b1-9374-ccdad8589140" providerId="ADAL" clId="{0A0D2314-D59C-5A4C-9E09-78A254E3BB4B}" dt="2021-09-30T22:30:18.394" v="2939" actId="478"/>
          <ac:picMkLst>
            <pc:docMk/>
            <pc:sldMk cId="3214590643" sldId="280"/>
            <ac:picMk id="3" creationId="{B45809F1-FAC9-F94B-9E9F-CB796333E5D3}"/>
          </ac:picMkLst>
        </pc:picChg>
        <pc:picChg chg="del">
          <ac:chgData name="Narang, Sonali" userId="9e80b397-6e2f-49b1-9374-ccdad8589140" providerId="ADAL" clId="{0A0D2314-D59C-5A4C-9E09-78A254E3BB4B}" dt="2021-09-30T22:30:18.394" v="2939" actId="478"/>
          <ac:picMkLst>
            <pc:docMk/>
            <pc:sldMk cId="3214590643" sldId="280"/>
            <ac:picMk id="24" creationId="{0304240D-4AFD-094E-A8F4-9549ABFF67CC}"/>
          </ac:picMkLst>
        </pc:picChg>
        <pc:picChg chg="del">
          <ac:chgData name="Narang, Sonali" userId="9e80b397-6e2f-49b1-9374-ccdad8589140" providerId="ADAL" clId="{0A0D2314-D59C-5A4C-9E09-78A254E3BB4B}" dt="2021-09-30T22:30:18.394" v="2939" actId="478"/>
          <ac:picMkLst>
            <pc:docMk/>
            <pc:sldMk cId="3214590643" sldId="280"/>
            <ac:picMk id="25" creationId="{F5335663-2747-3B40-A677-7A33B0BD5B41}"/>
          </ac:picMkLst>
        </pc:picChg>
        <pc:picChg chg="del">
          <ac:chgData name="Narang, Sonali" userId="9e80b397-6e2f-49b1-9374-ccdad8589140" providerId="ADAL" clId="{0A0D2314-D59C-5A4C-9E09-78A254E3BB4B}" dt="2021-09-30T22:30:23.683" v="2942" actId="478"/>
          <ac:picMkLst>
            <pc:docMk/>
            <pc:sldMk cId="3214590643" sldId="280"/>
            <ac:picMk id="44" creationId="{555A226D-A762-2B4C-BFBA-33F0EFDAC963}"/>
          </ac:picMkLst>
        </pc:picChg>
        <pc:picChg chg="mod">
          <ac:chgData name="Narang, Sonali" userId="9e80b397-6e2f-49b1-9374-ccdad8589140" providerId="ADAL" clId="{0A0D2314-D59C-5A4C-9E09-78A254E3BB4B}" dt="2021-10-01T16:50:50.933" v="2964"/>
          <ac:picMkLst>
            <pc:docMk/>
            <pc:sldMk cId="3214590643" sldId="280"/>
            <ac:picMk id="48" creationId="{71EC7F28-AF86-854B-AEC4-D136C4D112AF}"/>
          </ac:picMkLst>
        </pc:picChg>
        <pc:picChg chg="mod">
          <ac:chgData name="Narang, Sonali" userId="9e80b397-6e2f-49b1-9374-ccdad8589140" providerId="ADAL" clId="{0A0D2314-D59C-5A4C-9E09-78A254E3BB4B}" dt="2021-10-01T16:50:50.933" v="2964"/>
          <ac:picMkLst>
            <pc:docMk/>
            <pc:sldMk cId="3214590643" sldId="280"/>
            <ac:picMk id="49" creationId="{320DEF64-F03D-F749-82F9-2F66ECE826C5}"/>
          </ac:picMkLst>
        </pc:picChg>
        <pc:picChg chg="mod">
          <ac:chgData name="Narang, Sonali" userId="9e80b397-6e2f-49b1-9374-ccdad8589140" providerId="ADAL" clId="{0A0D2314-D59C-5A4C-9E09-78A254E3BB4B}" dt="2021-10-01T16:50:50.933" v="2964"/>
          <ac:picMkLst>
            <pc:docMk/>
            <pc:sldMk cId="3214590643" sldId="280"/>
            <ac:picMk id="50" creationId="{EC1A4915-BF55-6D40-8B7A-411B554E98BC}"/>
          </ac:picMkLst>
        </pc:picChg>
        <pc:picChg chg="mod">
          <ac:chgData name="Narang, Sonali" userId="9e80b397-6e2f-49b1-9374-ccdad8589140" providerId="ADAL" clId="{0A0D2314-D59C-5A4C-9E09-78A254E3BB4B}" dt="2021-10-01T16:50:50.933" v="2964"/>
          <ac:picMkLst>
            <pc:docMk/>
            <pc:sldMk cId="3214590643" sldId="280"/>
            <ac:picMk id="51" creationId="{4B809755-A9B7-254D-B48B-424B311B6CF3}"/>
          </ac:picMkLst>
        </pc:picChg>
      </pc:sldChg>
      <pc:sldChg chg="addSp delSp modSp add mod ord">
        <pc:chgData name="Narang, Sonali" userId="9e80b397-6e2f-49b1-9374-ccdad8589140" providerId="ADAL" clId="{0A0D2314-D59C-5A4C-9E09-78A254E3BB4B}" dt="2021-11-03T14:33:20.762" v="3919" actId="20577"/>
        <pc:sldMkLst>
          <pc:docMk/>
          <pc:sldMk cId="539443018" sldId="281"/>
        </pc:sldMkLst>
        <pc:spChg chg="add mod">
          <ac:chgData name="Narang, Sonali" userId="9e80b397-6e2f-49b1-9374-ccdad8589140" providerId="ADAL" clId="{0A0D2314-D59C-5A4C-9E09-78A254E3BB4B}" dt="2021-11-03T14:33:20.762" v="3919" actId="20577"/>
          <ac:spMkLst>
            <pc:docMk/>
            <pc:sldMk cId="539443018" sldId="281"/>
            <ac:spMk id="3" creationId="{819B3CA7-FF66-D04B-A23A-A9764FB17EA4}"/>
          </ac:spMkLst>
        </pc:spChg>
        <pc:spChg chg="add del">
          <ac:chgData name="Narang, Sonali" userId="9e80b397-6e2f-49b1-9374-ccdad8589140" providerId="ADAL" clId="{0A0D2314-D59C-5A4C-9E09-78A254E3BB4B}" dt="2021-11-02T15:37:14.100" v="3221" actId="22"/>
          <ac:spMkLst>
            <pc:docMk/>
            <pc:sldMk cId="539443018" sldId="281"/>
            <ac:spMk id="16" creationId="{0D854DED-D914-A540-852C-E94C80408A08}"/>
          </ac:spMkLst>
        </pc:spChg>
        <pc:spChg chg="add mod">
          <ac:chgData name="Narang, Sonali" userId="9e80b397-6e2f-49b1-9374-ccdad8589140" providerId="ADAL" clId="{0A0D2314-D59C-5A4C-9E09-78A254E3BB4B}" dt="2021-11-02T15:52:07.942" v="3255" actId="12788"/>
          <ac:spMkLst>
            <pc:docMk/>
            <pc:sldMk cId="539443018" sldId="281"/>
            <ac:spMk id="17" creationId="{E45D6726-42ED-614F-ABA3-4FFC2E3999BE}"/>
          </ac:spMkLst>
        </pc:spChg>
        <pc:spChg chg="add del mod">
          <ac:chgData name="Narang, Sonali" userId="9e80b397-6e2f-49b1-9374-ccdad8589140" providerId="ADAL" clId="{0A0D2314-D59C-5A4C-9E09-78A254E3BB4B}" dt="2021-11-02T15:52:47.767" v="3268" actId="478"/>
          <ac:spMkLst>
            <pc:docMk/>
            <pc:sldMk cId="539443018" sldId="281"/>
            <ac:spMk id="18" creationId="{2361F0A2-E114-2B4F-A0BE-632A67C2238A}"/>
          </ac:spMkLst>
        </pc:spChg>
        <pc:spChg chg="add mod">
          <ac:chgData name="Narang, Sonali" userId="9e80b397-6e2f-49b1-9374-ccdad8589140" providerId="ADAL" clId="{0A0D2314-D59C-5A4C-9E09-78A254E3BB4B}" dt="2021-11-02T17:37:45.255" v="3538" actId="1036"/>
          <ac:spMkLst>
            <pc:docMk/>
            <pc:sldMk cId="539443018" sldId="281"/>
            <ac:spMk id="19" creationId="{424268A8-EAFB-1440-B224-100A4FAE616F}"/>
          </ac:spMkLst>
        </pc:spChg>
        <pc:spChg chg="add mod">
          <ac:chgData name="Narang, Sonali" userId="9e80b397-6e2f-49b1-9374-ccdad8589140" providerId="ADAL" clId="{0A0D2314-D59C-5A4C-9E09-78A254E3BB4B}" dt="2021-11-02T17:37:45.255" v="3538" actId="1036"/>
          <ac:spMkLst>
            <pc:docMk/>
            <pc:sldMk cId="539443018" sldId="281"/>
            <ac:spMk id="26" creationId="{582E48A0-98F5-5147-B0F7-81FC68C3CE07}"/>
          </ac:spMkLst>
        </pc:spChg>
        <pc:spChg chg="add mod">
          <ac:chgData name="Narang, Sonali" userId="9e80b397-6e2f-49b1-9374-ccdad8589140" providerId="ADAL" clId="{0A0D2314-D59C-5A4C-9E09-78A254E3BB4B}" dt="2021-11-02T17:37:31.128" v="3521" actId="1076"/>
          <ac:spMkLst>
            <pc:docMk/>
            <pc:sldMk cId="539443018" sldId="281"/>
            <ac:spMk id="27" creationId="{F3520D55-6519-8141-AFD0-370D291E5F3A}"/>
          </ac:spMkLst>
        </pc:spChg>
        <pc:spChg chg="add del mod">
          <ac:chgData name="Narang, Sonali" userId="9e80b397-6e2f-49b1-9374-ccdad8589140" providerId="ADAL" clId="{0A0D2314-D59C-5A4C-9E09-78A254E3BB4B}" dt="2021-11-03T14:24:14.035" v="3811"/>
          <ac:spMkLst>
            <pc:docMk/>
            <pc:sldMk cId="539443018" sldId="281"/>
            <ac:spMk id="28" creationId="{5B54FCB6-CD50-8742-A8D4-81194DDE8973}"/>
          </ac:spMkLst>
        </pc:spChg>
        <pc:spChg chg="mod">
          <ac:chgData name="Narang, Sonali" userId="9e80b397-6e2f-49b1-9374-ccdad8589140" providerId="ADAL" clId="{0A0D2314-D59C-5A4C-9E09-78A254E3BB4B}" dt="2021-11-02T15:36:03.711" v="3212" actId="20577"/>
          <ac:spMkLst>
            <pc:docMk/>
            <pc:sldMk cId="539443018" sldId="281"/>
            <ac:spMk id="45" creationId="{A37EFDC5-08ED-BB45-B24A-B00535A392F0}"/>
          </ac:spMkLst>
        </pc:spChg>
        <pc:spChg chg="del">
          <ac:chgData name="Narang, Sonali" userId="9e80b397-6e2f-49b1-9374-ccdad8589140" providerId="ADAL" clId="{0A0D2314-D59C-5A4C-9E09-78A254E3BB4B}" dt="2021-11-02T15:37:12.238" v="3219" actId="478"/>
          <ac:spMkLst>
            <pc:docMk/>
            <pc:sldMk cId="539443018" sldId="281"/>
            <ac:spMk id="46" creationId="{BC4BD7F9-9550-3841-BBB5-1A58285A1D88}"/>
          </ac:spMkLst>
        </pc:spChg>
        <pc:grpChg chg="del mod">
          <ac:chgData name="Narang, Sonali" userId="9e80b397-6e2f-49b1-9374-ccdad8589140" providerId="ADAL" clId="{0A0D2314-D59C-5A4C-9E09-78A254E3BB4B}" dt="2021-11-02T15:36:05.845" v="3214" actId="478"/>
          <ac:grpSpMkLst>
            <pc:docMk/>
            <pc:sldMk cId="539443018" sldId="281"/>
            <ac:grpSpMk id="47" creationId="{4B802D37-9378-E54E-99B5-1E00E308EBB8}"/>
          </ac:grpSpMkLst>
        </pc:grp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5" creationId="{9CC3C8AB-0331-3840-BE9E-E0D60CE1E3FC}"/>
          </ac:picMkLst>
        </pc:pic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7" creationId="{67C0CC22-7300-7841-9378-3F20FC74AFB9}"/>
          </ac:picMkLst>
        </pc:pic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9" creationId="{30EC5094-9B3C-7C46-825F-42C49F571C22}"/>
          </ac:picMkLst>
        </pc:pic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11" creationId="{444D8936-B0F8-F248-9AEA-EA4463C182D2}"/>
          </ac:picMkLst>
        </pc:pic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13" creationId="{A6FA2EDE-7D67-8649-97E9-A0C73E157665}"/>
          </ac:picMkLst>
        </pc:picChg>
        <pc:picChg chg="add mod">
          <ac:chgData name="Narang, Sonali" userId="9e80b397-6e2f-49b1-9374-ccdad8589140" providerId="ADAL" clId="{0A0D2314-D59C-5A4C-9E09-78A254E3BB4B}" dt="2021-11-03T14:25:18.723" v="3839" actId="1076"/>
          <ac:picMkLst>
            <pc:docMk/>
            <pc:sldMk cId="539443018" sldId="281"/>
            <ac:picMk id="15" creationId="{C4CD79B4-4B2F-B140-B8B1-452B15CB81A3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0" creationId="{65BE8057-D708-9C42-B43E-E48FA26CE76C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1" creationId="{2D6973A4-5D96-D149-A6D6-95565719DD13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2" creationId="{771582DF-8CCD-FB48-BC9F-65D254C666A0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3" creationId="{016F8335-5BE6-8941-BE94-AECE882EE03A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4" creationId="{F67D2662-BACA-DD46-AD27-1351A30BFA27}"/>
          </ac:picMkLst>
        </pc:picChg>
        <pc:picChg chg="add del mod">
          <ac:chgData name="Narang, Sonali" userId="9e80b397-6e2f-49b1-9374-ccdad8589140" providerId="ADAL" clId="{0A0D2314-D59C-5A4C-9E09-78A254E3BB4B}" dt="2021-11-03T14:21:53.833" v="3773" actId="478"/>
          <ac:picMkLst>
            <pc:docMk/>
            <pc:sldMk cId="539443018" sldId="281"/>
            <ac:picMk id="25" creationId="{527339FB-5861-A84B-839A-66C5C7C355B8}"/>
          </ac:picMkLst>
        </pc:picChg>
      </pc:sldChg>
      <pc:sldChg chg="addSp delSp modSp add mod">
        <pc:chgData name="Narang, Sonali" userId="9e80b397-6e2f-49b1-9374-ccdad8589140" providerId="ADAL" clId="{0A0D2314-D59C-5A4C-9E09-78A254E3BB4B}" dt="2021-11-03T20:24:06.392" v="4622" actId="20577"/>
        <pc:sldMkLst>
          <pc:docMk/>
          <pc:sldMk cId="2795549752" sldId="282"/>
        </pc:sldMkLst>
        <pc:spChg chg="mod">
          <ac:chgData name="Narang, Sonali" userId="9e80b397-6e2f-49b1-9374-ccdad8589140" providerId="ADAL" clId="{0A0D2314-D59C-5A4C-9E09-78A254E3BB4B}" dt="2021-11-03T20:24:06.392" v="4622" actId="20577"/>
          <ac:spMkLst>
            <pc:docMk/>
            <pc:sldMk cId="2795549752" sldId="282"/>
            <ac:spMk id="3" creationId="{819B3CA7-FF66-D04B-A23A-A9764FB17EA4}"/>
          </ac:spMkLst>
        </pc:spChg>
        <pc:spChg chg="add mod">
          <ac:chgData name="Narang, Sonali" userId="9e80b397-6e2f-49b1-9374-ccdad8589140" providerId="ADAL" clId="{0A0D2314-D59C-5A4C-9E09-78A254E3BB4B}" dt="2021-11-03T20:23:09.162" v="4542" actId="207"/>
          <ac:spMkLst>
            <pc:docMk/>
            <pc:sldMk cId="2795549752" sldId="282"/>
            <ac:spMk id="37" creationId="{84AA7C95-7A99-3244-9020-5265E17B76CE}"/>
          </ac:spMkLst>
        </pc:sp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4" creationId="{5545EA01-02C8-C14F-B87F-AA3D42DFC498}"/>
          </ac:picMkLst>
        </pc:pic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6" creationId="{908EF18F-76FC-214C-8868-63513D6759E0}"/>
          </ac:picMkLst>
        </pc:pic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8" creationId="{A54CB23C-0DE8-7846-AD80-B7F14481E3D7}"/>
          </ac:picMkLst>
        </pc:pic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10" creationId="{03662B50-9879-9043-BD79-ABBE911A9710}"/>
          </ac:picMkLst>
        </pc:pic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12" creationId="{E5A1ECD6-2FDF-7946-9EA0-DC6200266DBA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14" creationId="{A2ABC069-ABC2-2F43-AF8A-6285DF8AFEF3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15" creationId="{767B2597-8D12-D54D-8F7D-2EF83856F195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16" creationId="{48149386-C306-4A4D-AF6B-FBF26DE34C26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18" creationId="{16F207A2-5417-FD42-9A88-28A4BCD6AE90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0" creationId="{65BE8057-D708-9C42-B43E-E48FA26CE76C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1" creationId="{2D6973A4-5D96-D149-A6D6-95565719DD13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2" creationId="{771582DF-8CCD-FB48-BC9F-65D254C666A0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3" creationId="{016F8335-5BE6-8941-BE94-AECE882EE03A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4" creationId="{F67D2662-BACA-DD46-AD27-1351A30BFA27}"/>
          </ac:picMkLst>
        </pc:picChg>
        <pc:picChg chg="del">
          <ac:chgData name="Narang, Sonali" userId="9e80b397-6e2f-49b1-9374-ccdad8589140" providerId="ADAL" clId="{0A0D2314-D59C-5A4C-9E09-78A254E3BB4B}" dt="2021-11-03T14:24:37.740" v="3815" actId="478"/>
          <ac:picMkLst>
            <pc:docMk/>
            <pc:sldMk cId="2795549752" sldId="282"/>
            <ac:picMk id="25" creationId="{527339FB-5861-A84B-839A-66C5C7C355B8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28" creationId="{03E0C4D0-8D4E-D543-8367-769EBBE50873}"/>
          </ac:picMkLst>
        </pc:picChg>
        <pc:picChg chg="add del mod">
          <ac:chgData name="Narang, Sonali" userId="9e80b397-6e2f-49b1-9374-ccdad8589140" providerId="ADAL" clId="{0A0D2314-D59C-5A4C-9E09-78A254E3BB4B}" dt="2021-11-03T14:25:27.387" v="3840" actId="478"/>
          <ac:picMkLst>
            <pc:docMk/>
            <pc:sldMk cId="2795549752" sldId="282"/>
            <ac:picMk id="29" creationId="{54BEB80B-2AB8-6149-9623-91136B2C3745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0" creationId="{4B19876A-48CF-2A45-BAC3-F68D60047F88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1" creationId="{C5B028DE-C13A-E24C-A3A8-3492CDC9B73C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2" creationId="{5CCD376B-74E3-B041-9F88-B47ADA6E9EB6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3" creationId="{A2DEE04E-C618-984D-851B-161B60037A53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4" creationId="{F7DC5067-9B0C-874D-B6FD-9F6FC4113055}"/>
          </ac:picMkLst>
        </pc:picChg>
        <pc:picChg chg="add del mod">
          <ac:chgData name="Narang, Sonali" userId="9e80b397-6e2f-49b1-9374-ccdad8589140" providerId="ADAL" clId="{0A0D2314-D59C-5A4C-9E09-78A254E3BB4B}" dt="2021-11-03T16:16:40.646" v="3945" actId="478"/>
          <ac:picMkLst>
            <pc:docMk/>
            <pc:sldMk cId="2795549752" sldId="282"/>
            <ac:picMk id="35" creationId="{A0B6C7B6-6DE3-1E4F-A661-31C20C8973FE}"/>
          </ac:picMkLst>
        </pc:picChg>
        <pc:picChg chg="add mod">
          <ac:chgData name="Narang, Sonali" userId="9e80b397-6e2f-49b1-9374-ccdad8589140" providerId="ADAL" clId="{0A0D2314-D59C-5A4C-9E09-78A254E3BB4B}" dt="2021-11-03T16:16:36.106" v="3944" actId="167"/>
          <ac:picMkLst>
            <pc:docMk/>
            <pc:sldMk cId="2795549752" sldId="282"/>
            <ac:picMk id="36" creationId="{7AAF5A3C-4CC4-B644-9E7A-899F148CD272}"/>
          </ac:picMkLst>
        </pc:picChg>
      </pc:sldChg>
      <pc:sldChg chg="addSp delSp modSp add mod">
        <pc:chgData name="Narang, Sonali" userId="9e80b397-6e2f-49b1-9374-ccdad8589140" providerId="ADAL" clId="{0A0D2314-D59C-5A4C-9E09-78A254E3BB4B}" dt="2021-11-03T20:07:28.858" v="4361" actId="20577"/>
        <pc:sldMkLst>
          <pc:docMk/>
          <pc:sldMk cId="3858847110" sldId="283"/>
        </pc:sldMkLst>
        <pc:spChg chg="add del mod">
          <ac:chgData name="Narang, Sonali" userId="9e80b397-6e2f-49b1-9374-ccdad8589140" providerId="ADAL" clId="{0A0D2314-D59C-5A4C-9E09-78A254E3BB4B}" dt="2021-11-03T16:48:40.930" v="4107" actId="478"/>
          <ac:spMkLst>
            <pc:docMk/>
            <pc:sldMk cId="3858847110" sldId="283"/>
            <ac:spMk id="11" creationId="{4EDEB0ED-9B1B-7C4E-A0BD-7BFB3424BB63}"/>
          </ac:spMkLst>
        </pc:spChg>
        <pc:spChg chg="add mod">
          <ac:chgData name="Narang, Sonali" userId="9e80b397-6e2f-49b1-9374-ccdad8589140" providerId="ADAL" clId="{0A0D2314-D59C-5A4C-9E09-78A254E3BB4B}" dt="2021-11-03T20:07:28.858" v="4361" actId="20577"/>
          <ac:spMkLst>
            <pc:docMk/>
            <pc:sldMk cId="3858847110" sldId="283"/>
            <ac:spMk id="17" creationId="{3EA8DCC5-919A-2147-8AF5-DF44E483E631}"/>
          </ac:spMkLst>
        </pc:spChg>
        <pc:spChg chg="add del mod topLvl">
          <ac:chgData name="Narang, Sonali" userId="9e80b397-6e2f-49b1-9374-ccdad8589140" providerId="ADAL" clId="{0A0D2314-D59C-5A4C-9E09-78A254E3BB4B}" dt="2021-11-03T16:48:40.930" v="4107" actId="478"/>
          <ac:spMkLst>
            <pc:docMk/>
            <pc:sldMk cId="3858847110" sldId="283"/>
            <ac:spMk id="193" creationId="{F979C000-D317-844C-AB54-4B3A37A3246F}"/>
          </ac:spMkLst>
        </pc:spChg>
        <pc:spChg chg="add mod">
          <ac:chgData name="Narang, Sonali" userId="9e80b397-6e2f-49b1-9374-ccdad8589140" providerId="ADAL" clId="{0A0D2314-D59C-5A4C-9E09-78A254E3BB4B}" dt="2021-11-03T16:49:06.766" v="4126" actId="1037"/>
          <ac:spMkLst>
            <pc:docMk/>
            <pc:sldMk cId="3858847110" sldId="283"/>
            <ac:spMk id="194" creationId="{3170EA98-5640-0947-A4D8-630167A82A03}"/>
          </ac:spMkLst>
        </pc:spChg>
        <pc:spChg chg="add mod">
          <ac:chgData name="Narang, Sonali" userId="9e80b397-6e2f-49b1-9374-ccdad8589140" providerId="ADAL" clId="{0A0D2314-D59C-5A4C-9E09-78A254E3BB4B}" dt="2021-11-03T16:49:06.766" v="4126" actId="1037"/>
          <ac:spMkLst>
            <pc:docMk/>
            <pc:sldMk cId="3858847110" sldId="283"/>
            <ac:spMk id="195" creationId="{FF52FEE5-75BD-674F-A978-E2D7333E9018}"/>
          </ac:spMkLst>
        </pc:spChg>
        <pc:spChg chg="add mod">
          <ac:chgData name="Narang, Sonali" userId="9e80b397-6e2f-49b1-9374-ccdad8589140" providerId="ADAL" clId="{0A0D2314-D59C-5A4C-9E09-78A254E3BB4B}" dt="2021-11-03T16:49:06.766" v="4126" actId="1037"/>
          <ac:spMkLst>
            <pc:docMk/>
            <pc:sldMk cId="3858847110" sldId="283"/>
            <ac:spMk id="196" creationId="{F1DC4803-2E99-7B4B-90F5-271C86F60DC2}"/>
          </ac:spMkLst>
        </pc:spChg>
        <pc:spChg chg="add mod">
          <ac:chgData name="Narang, Sonali" userId="9e80b397-6e2f-49b1-9374-ccdad8589140" providerId="ADAL" clId="{0A0D2314-D59C-5A4C-9E09-78A254E3BB4B}" dt="2021-11-03T16:51:24.668" v="4143" actId="1038"/>
          <ac:spMkLst>
            <pc:docMk/>
            <pc:sldMk cId="3858847110" sldId="283"/>
            <ac:spMk id="198" creationId="{1E3656E2-2A51-6549-830A-E0860E7C85B7}"/>
          </ac:spMkLst>
        </pc:spChg>
        <pc:spChg chg="add mod">
          <ac:chgData name="Narang, Sonali" userId="9e80b397-6e2f-49b1-9374-ccdad8589140" providerId="ADAL" clId="{0A0D2314-D59C-5A4C-9E09-78A254E3BB4B}" dt="2021-11-03T16:51:24.668" v="4143" actId="1038"/>
          <ac:spMkLst>
            <pc:docMk/>
            <pc:sldMk cId="3858847110" sldId="283"/>
            <ac:spMk id="199" creationId="{68F5D353-7669-E84D-95CB-AEDD4C89E83B}"/>
          </ac:spMkLst>
        </pc:spChg>
        <pc:spChg chg="mod">
          <ac:chgData name="Narang, Sonali" userId="9e80b397-6e2f-49b1-9374-ccdad8589140" providerId="ADAL" clId="{0A0D2314-D59C-5A4C-9E09-78A254E3BB4B}" dt="2021-11-03T16:44:59.103" v="4078" actId="1076"/>
          <ac:spMkLst>
            <pc:docMk/>
            <pc:sldMk cId="3858847110" sldId="283"/>
            <ac:spMk id="312" creationId="{ABB99236-9992-4743-8EBE-B4E070E31B71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65" creationId="{61734530-E9B0-D647-8250-EB2CD18F7145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66" creationId="{8DD9B441-31E2-0D49-A9DA-50E53075A0A1}"/>
          </ac:spMkLst>
        </pc:spChg>
        <pc:spChg chg="del">
          <ac:chgData name="Narang, Sonali" userId="9e80b397-6e2f-49b1-9374-ccdad8589140" providerId="ADAL" clId="{0A0D2314-D59C-5A4C-9E09-78A254E3BB4B}" dt="2021-11-03T16:43:23.262" v="4068" actId="478"/>
          <ac:spMkLst>
            <pc:docMk/>
            <pc:sldMk cId="3858847110" sldId="283"/>
            <ac:spMk id="367" creationId="{4CC8B660-CCBF-0649-9AFD-105F3D569422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68" creationId="{A88BD4E5-5C34-4747-81C8-B3E5D23AA437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69" creationId="{B46FDF36-65FD-734F-A543-DA3F799ED5E7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70" creationId="{7EE1444E-7499-BB4B-9361-8F74896A9345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71" creationId="{41114D15-C59C-8B46-BB3E-9EB866410106}"/>
          </ac:spMkLst>
        </pc:spChg>
        <pc:spChg chg="del">
          <ac:chgData name="Narang, Sonali" userId="9e80b397-6e2f-49b1-9374-ccdad8589140" providerId="ADAL" clId="{0A0D2314-D59C-5A4C-9E09-78A254E3BB4B}" dt="2021-11-03T16:43:23.262" v="4068" actId="478"/>
          <ac:spMkLst>
            <pc:docMk/>
            <pc:sldMk cId="3858847110" sldId="283"/>
            <ac:spMk id="372" creationId="{880DEDF1-C6E4-4A4E-AB1C-78C9732BEFD5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73" creationId="{0DF03628-7569-F94D-8F88-9F2347E91737}"/>
          </ac:spMkLst>
        </pc:spChg>
        <pc:spChg chg="del">
          <ac:chgData name="Narang, Sonali" userId="9e80b397-6e2f-49b1-9374-ccdad8589140" providerId="ADAL" clId="{0A0D2314-D59C-5A4C-9E09-78A254E3BB4B}" dt="2021-11-03T16:43:21.519" v="4067" actId="478"/>
          <ac:spMkLst>
            <pc:docMk/>
            <pc:sldMk cId="3858847110" sldId="283"/>
            <ac:spMk id="374" creationId="{74E59F51-D65E-AB47-9C51-8F7E64826BCB}"/>
          </ac:spMkLst>
        </pc:spChg>
        <pc:spChg chg="del">
          <ac:chgData name="Narang, Sonali" userId="9e80b397-6e2f-49b1-9374-ccdad8589140" providerId="ADAL" clId="{0A0D2314-D59C-5A4C-9E09-78A254E3BB4B}" dt="2021-11-03T16:43:23.262" v="4068" actId="478"/>
          <ac:spMkLst>
            <pc:docMk/>
            <pc:sldMk cId="3858847110" sldId="283"/>
            <ac:spMk id="375" creationId="{D72D11F1-4BAB-5B42-BADE-4D5E76BE5E70}"/>
          </ac:spMkLst>
        </pc:spChg>
        <pc:grpChg chg="add del mod">
          <ac:chgData name="Narang, Sonali" userId="9e80b397-6e2f-49b1-9374-ccdad8589140" providerId="ADAL" clId="{0A0D2314-D59C-5A4C-9E09-78A254E3BB4B}" dt="2021-11-03T16:48:40.930" v="4107" actId="478"/>
          <ac:grpSpMkLst>
            <pc:docMk/>
            <pc:sldMk cId="3858847110" sldId="283"/>
            <ac:grpSpMk id="13" creationId="{AE65DEBF-402F-8944-92F4-08487346259C}"/>
          </ac:grpSpMkLst>
        </pc:grpChg>
        <pc:grpChg chg="add mod">
          <ac:chgData name="Narang, Sonali" userId="9e80b397-6e2f-49b1-9374-ccdad8589140" providerId="ADAL" clId="{0A0D2314-D59C-5A4C-9E09-78A254E3BB4B}" dt="2021-11-03T16:50:00.532" v="4138" actId="1076"/>
          <ac:grpSpMkLst>
            <pc:docMk/>
            <pc:sldMk cId="3858847110" sldId="283"/>
            <ac:grpSpMk id="16" creationId="{58DB6EAF-55BB-A84E-BB46-C61DAC1C6351}"/>
          </ac:grpSpMkLst>
        </pc:grpChg>
        <pc:grpChg chg="del">
          <ac:chgData name="Narang, Sonali" userId="9e80b397-6e2f-49b1-9374-ccdad8589140" providerId="ADAL" clId="{0A0D2314-D59C-5A4C-9E09-78A254E3BB4B}" dt="2021-11-03T16:43:18.418" v="4066" actId="478"/>
          <ac:grpSpMkLst>
            <pc:docMk/>
            <pc:sldMk cId="3858847110" sldId="283"/>
            <ac:grpSpMk id="41" creationId="{632D9D10-8AFF-124D-8358-7B9E576BBF36}"/>
          </ac:grpSpMkLst>
        </pc:grpChg>
        <pc:picChg chg="add del mod">
          <ac:chgData name="Narang, Sonali" userId="9e80b397-6e2f-49b1-9374-ccdad8589140" providerId="ADAL" clId="{0A0D2314-D59C-5A4C-9E09-78A254E3BB4B}" dt="2021-11-03T16:43:48.616" v="4077" actId="478"/>
          <ac:picMkLst>
            <pc:docMk/>
            <pc:sldMk cId="3858847110" sldId="283"/>
            <ac:picMk id="3" creationId="{CE252114-0A4C-CD4A-88B0-CCB658C3F636}"/>
          </ac:picMkLst>
        </pc:picChg>
        <pc:picChg chg="add mod topLvl modCrop">
          <ac:chgData name="Narang, Sonali" userId="9e80b397-6e2f-49b1-9374-ccdad8589140" providerId="ADAL" clId="{0A0D2314-D59C-5A4C-9E09-78A254E3BB4B}" dt="2021-11-03T16:49:55.827" v="4137" actId="1035"/>
          <ac:picMkLst>
            <pc:docMk/>
            <pc:sldMk cId="3858847110" sldId="283"/>
            <ac:picMk id="9" creationId="{E181CE47-AFDF-9D42-9092-D68576E07B87}"/>
          </ac:picMkLst>
        </pc:picChg>
        <pc:picChg chg="add mod modCrop">
          <ac:chgData name="Narang, Sonali" userId="9e80b397-6e2f-49b1-9374-ccdad8589140" providerId="ADAL" clId="{0A0D2314-D59C-5A4C-9E09-78A254E3BB4B}" dt="2021-11-03T16:49:06.766" v="4126" actId="1037"/>
          <ac:picMkLst>
            <pc:docMk/>
            <pc:sldMk cId="3858847110" sldId="283"/>
            <ac:picMk id="197" creationId="{04900471-6903-234E-B618-857449153541}"/>
          </ac:picMkLst>
        </pc:picChg>
      </pc:sldChg>
      <pc:sldChg chg="addSp delSp modSp add mod">
        <pc:chgData name="Narang, Sonali" userId="9e80b397-6e2f-49b1-9374-ccdad8589140" providerId="ADAL" clId="{0A0D2314-D59C-5A4C-9E09-78A254E3BB4B}" dt="2021-11-04T16:10:45.386" v="4640" actId="1076"/>
        <pc:sldMkLst>
          <pc:docMk/>
          <pc:sldMk cId="4004272488" sldId="284"/>
        </pc:sldMkLst>
        <pc:spChg chg="del">
          <ac:chgData name="Narang, Sonali" userId="9e80b397-6e2f-49b1-9374-ccdad8589140" providerId="ADAL" clId="{0A0D2314-D59C-5A4C-9E09-78A254E3BB4B}" dt="2021-11-03T18:57:07.569" v="4184" actId="478"/>
          <ac:spMkLst>
            <pc:docMk/>
            <pc:sldMk cId="4004272488" sldId="284"/>
            <ac:spMk id="2" creationId="{B058617F-5D67-A542-BF8F-7129F45BDF88}"/>
          </ac:spMkLst>
        </pc:spChg>
        <pc:spChg chg="add mod">
          <ac:chgData name="Narang, Sonali" userId="9e80b397-6e2f-49b1-9374-ccdad8589140" providerId="ADAL" clId="{0A0D2314-D59C-5A4C-9E09-78A254E3BB4B}" dt="2021-11-04T16:10:45.386" v="4640" actId="1076"/>
          <ac:spMkLst>
            <pc:docMk/>
            <pc:sldMk cId="4004272488" sldId="284"/>
            <ac:spMk id="35" creationId="{035B29FF-8D31-C74D-84CD-B2F72D9111E7}"/>
          </ac:spMkLst>
        </pc:spChg>
        <pc:picChg chg="add mod">
          <ac:chgData name="Narang, Sonali" userId="9e80b397-6e2f-49b1-9374-ccdad8589140" providerId="ADAL" clId="{0A0D2314-D59C-5A4C-9E09-78A254E3BB4B}" dt="2021-11-03T19:01:54.482" v="4208" actId="12789"/>
          <ac:picMkLst>
            <pc:docMk/>
            <pc:sldMk cId="4004272488" sldId="284"/>
            <ac:picMk id="9" creationId="{582BC744-B55E-444D-9186-996C5EEEF91A}"/>
          </ac:picMkLst>
        </pc:picChg>
        <pc:picChg chg="add mod">
          <ac:chgData name="Narang, Sonali" userId="9e80b397-6e2f-49b1-9374-ccdad8589140" providerId="ADAL" clId="{0A0D2314-D59C-5A4C-9E09-78A254E3BB4B}" dt="2021-11-03T19:01:54.482" v="4208" actId="12789"/>
          <ac:picMkLst>
            <pc:docMk/>
            <pc:sldMk cId="4004272488" sldId="284"/>
            <ac:picMk id="13" creationId="{1700A0E7-E7CE-114B-A2B5-15E8E6D46524}"/>
          </ac:picMkLst>
        </pc:picChg>
        <pc:picChg chg="del">
          <ac:chgData name="Narang, Sonali" userId="9e80b397-6e2f-49b1-9374-ccdad8589140" providerId="ADAL" clId="{0A0D2314-D59C-5A4C-9E09-78A254E3BB4B}" dt="2021-11-03T18:59:15.374" v="4203" actId="478"/>
          <ac:picMkLst>
            <pc:docMk/>
            <pc:sldMk cId="4004272488" sldId="284"/>
            <ac:picMk id="14" creationId="{4A2BE57C-7646-934A-8FEC-4BD94BAF6E9A}"/>
          </ac:picMkLst>
        </pc:picChg>
        <pc:picChg chg="add mod">
          <ac:chgData name="Narang, Sonali" userId="9e80b397-6e2f-49b1-9374-ccdad8589140" providerId="ADAL" clId="{0A0D2314-D59C-5A4C-9E09-78A254E3BB4B}" dt="2021-11-03T19:01:54.482" v="4208" actId="12789"/>
          <ac:picMkLst>
            <pc:docMk/>
            <pc:sldMk cId="4004272488" sldId="284"/>
            <ac:picMk id="16" creationId="{49314A01-A50F-FE40-ACB7-0D83933DE24E}"/>
          </ac:picMkLst>
        </pc:picChg>
        <pc:picChg chg="del">
          <ac:chgData name="Narang, Sonali" userId="9e80b397-6e2f-49b1-9374-ccdad8589140" providerId="ADAL" clId="{0A0D2314-D59C-5A4C-9E09-78A254E3BB4B}" dt="2021-11-03T18:59:15.374" v="4203" actId="478"/>
          <ac:picMkLst>
            <pc:docMk/>
            <pc:sldMk cId="4004272488" sldId="284"/>
            <ac:picMk id="17" creationId="{44BA04FC-FAF2-FD4D-84D5-8165C87A11B2}"/>
          </ac:picMkLst>
        </pc:picChg>
        <pc:picChg chg="del">
          <ac:chgData name="Narang, Sonali" userId="9e80b397-6e2f-49b1-9374-ccdad8589140" providerId="ADAL" clId="{0A0D2314-D59C-5A4C-9E09-78A254E3BB4B}" dt="2021-11-03T18:59:15.374" v="4203" actId="478"/>
          <ac:picMkLst>
            <pc:docMk/>
            <pc:sldMk cId="4004272488" sldId="284"/>
            <ac:picMk id="19" creationId="{43FAA709-337E-CD45-B8D6-5D30C3A09556}"/>
          </ac:picMkLst>
        </pc:picChg>
        <pc:picChg chg="add mod">
          <ac:chgData name="Narang, Sonali" userId="9e80b397-6e2f-49b1-9374-ccdad8589140" providerId="ADAL" clId="{0A0D2314-D59C-5A4C-9E09-78A254E3BB4B}" dt="2021-11-03T19:04:10.094" v="4222" actId="12789"/>
          <ac:picMkLst>
            <pc:docMk/>
            <pc:sldMk cId="4004272488" sldId="284"/>
            <ac:picMk id="20" creationId="{7BB6B16B-28D9-194D-87FA-A12DE15B0D69}"/>
          </ac:picMkLst>
        </pc:picChg>
        <pc:picChg chg="del">
          <ac:chgData name="Narang, Sonali" userId="9e80b397-6e2f-49b1-9374-ccdad8589140" providerId="ADAL" clId="{0A0D2314-D59C-5A4C-9E09-78A254E3BB4B}" dt="2021-11-03T18:57:12.790" v="4185" actId="478"/>
          <ac:picMkLst>
            <pc:docMk/>
            <pc:sldMk cId="4004272488" sldId="284"/>
            <ac:picMk id="21" creationId="{A940D900-68A7-BE40-8332-C3901FA700AB}"/>
          </ac:picMkLst>
        </pc:picChg>
        <pc:picChg chg="add mod">
          <ac:chgData name="Narang, Sonali" userId="9e80b397-6e2f-49b1-9374-ccdad8589140" providerId="ADAL" clId="{0A0D2314-D59C-5A4C-9E09-78A254E3BB4B}" dt="2021-11-03T19:04:10.094" v="4222" actId="12789"/>
          <ac:picMkLst>
            <pc:docMk/>
            <pc:sldMk cId="4004272488" sldId="284"/>
            <ac:picMk id="24" creationId="{4061DD9D-7877-F24B-BD70-11D9D12D2A5F}"/>
          </ac:picMkLst>
        </pc:picChg>
        <pc:picChg chg="del">
          <ac:chgData name="Narang, Sonali" userId="9e80b397-6e2f-49b1-9374-ccdad8589140" providerId="ADAL" clId="{0A0D2314-D59C-5A4C-9E09-78A254E3BB4B}" dt="2021-11-03T18:57:12.790" v="4185" actId="478"/>
          <ac:picMkLst>
            <pc:docMk/>
            <pc:sldMk cId="4004272488" sldId="284"/>
            <ac:picMk id="25" creationId="{CF5D0863-3F9E-0146-BBBB-4F71A4C01A81}"/>
          </ac:picMkLst>
        </pc:picChg>
        <pc:picChg chg="add mod">
          <ac:chgData name="Narang, Sonali" userId="9e80b397-6e2f-49b1-9374-ccdad8589140" providerId="ADAL" clId="{0A0D2314-D59C-5A4C-9E09-78A254E3BB4B}" dt="2021-11-03T19:04:10.094" v="4222" actId="12789"/>
          <ac:picMkLst>
            <pc:docMk/>
            <pc:sldMk cId="4004272488" sldId="284"/>
            <ac:picMk id="34" creationId="{2A40C706-D4BB-D74C-BE24-A8B4D915A296}"/>
          </ac:picMkLst>
        </pc:picChg>
        <pc:picChg chg="del">
          <ac:chgData name="Narang, Sonali" userId="9e80b397-6e2f-49b1-9374-ccdad8589140" providerId="ADAL" clId="{0A0D2314-D59C-5A4C-9E09-78A254E3BB4B}" dt="2021-11-03T18:57:12.790" v="4185" actId="478"/>
          <ac:picMkLst>
            <pc:docMk/>
            <pc:sldMk cId="4004272488" sldId="284"/>
            <ac:picMk id="36" creationId="{FADD3DC1-0765-3942-A3B5-F0B230C93712}"/>
          </ac:picMkLst>
        </pc:picChg>
      </pc:sldChg>
      <pc:sldChg chg="addSp delSp modSp add mod ord">
        <pc:chgData name="Narang, Sonali" userId="9e80b397-6e2f-49b1-9374-ccdad8589140" providerId="ADAL" clId="{0A0D2314-D59C-5A4C-9E09-78A254E3BB4B}" dt="2021-11-04T20:49:39.526" v="4669" actId="20578"/>
        <pc:sldMkLst>
          <pc:docMk/>
          <pc:sldMk cId="2252998334" sldId="285"/>
        </pc:sldMkLst>
        <pc:spChg chg="mod">
          <ac:chgData name="Narang, Sonali" userId="9e80b397-6e2f-49b1-9374-ccdad8589140" providerId="ADAL" clId="{0A0D2314-D59C-5A4C-9E09-78A254E3BB4B}" dt="2021-11-04T20:49:08.663" v="4666" actId="20577"/>
          <ac:spMkLst>
            <pc:docMk/>
            <pc:sldMk cId="2252998334" sldId="285"/>
            <ac:spMk id="4" creationId="{F6669B9D-B042-D548-BD0F-97015091799B}"/>
          </ac:spMkLst>
        </pc:spChg>
        <pc:spChg chg="del">
          <ac:chgData name="Narang, Sonali" userId="9e80b397-6e2f-49b1-9374-ccdad8589140" providerId="ADAL" clId="{0A0D2314-D59C-5A4C-9E09-78A254E3BB4B}" dt="2021-11-03T20:46:08.773" v="4635" actId="478"/>
          <ac:spMkLst>
            <pc:docMk/>
            <pc:sldMk cId="2252998334" sldId="285"/>
            <ac:spMk id="7" creationId="{4C5F5CAE-FBFD-964D-A356-746AAC86DC9E}"/>
          </ac:spMkLst>
        </pc:spChg>
        <pc:spChg chg="del">
          <ac:chgData name="Narang, Sonali" userId="9e80b397-6e2f-49b1-9374-ccdad8589140" providerId="ADAL" clId="{0A0D2314-D59C-5A4C-9E09-78A254E3BB4B}" dt="2021-11-03T20:46:05.745" v="4634" actId="478"/>
          <ac:spMkLst>
            <pc:docMk/>
            <pc:sldMk cId="2252998334" sldId="285"/>
            <ac:spMk id="8" creationId="{8A9BAE78-C4FF-1843-94F6-3410EB884848}"/>
          </ac:spMkLst>
        </pc:spChg>
        <pc:spChg chg="del">
          <ac:chgData name="Narang, Sonali" userId="9e80b397-6e2f-49b1-9374-ccdad8589140" providerId="ADAL" clId="{0A0D2314-D59C-5A4C-9E09-78A254E3BB4B}" dt="2021-11-03T20:45:23.732" v="4624" actId="478"/>
          <ac:spMkLst>
            <pc:docMk/>
            <pc:sldMk cId="2252998334" sldId="285"/>
            <ac:spMk id="91" creationId="{2BE97283-F355-544F-BB87-4A197097EE8C}"/>
          </ac:spMkLst>
        </pc:spChg>
        <pc:spChg chg="del">
          <ac:chgData name="Narang, Sonali" userId="9e80b397-6e2f-49b1-9374-ccdad8589140" providerId="ADAL" clId="{0A0D2314-D59C-5A4C-9E09-78A254E3BB4B}" dt="2021-11-03T20:45:23.732" v="4624" actId="478"/>
          <ac:spMkLst>
            <pc:docMk/>
            <pc:sldMk cId="2252998334" sldId="285"/>
            <ac:spMk id="92" creationId="{B168996F-E829-2D46-B390-6FC40E645DA3}"/>
          </ac:spMkLst>
        </pc:spChg>
        <pc:grpChg chg="del">
          <ac:chgData name="Narang, Sonali" userId="9e80b397-6e2f-49b1-9374-ccdad8589140" providerId="ADAL" clId="{0A0D2314-D59C-5A4C-9E09-78A254E3BB4B}" dt="2021-11-03T20:46:05.745" v="4634" actId="478"/>
          <ac:grpSpMkLst>
            <pc:docMk/>
            <pc:sldMk cId="2252998334" sldId="285"/>
            <ac:grpSpMk id="11" creationId="{C32B8FC9-55A4-D644-ADCA-CF6BCE435857}"/>
          </ac:grpSpMkLst>
        </pc:grpChg>
        <pc:picChg chg="add mod">
          <ac:chgData name="Narang, Sonali" userId="9e80b397-6e2f-49b1-9374-ccdad8589140" providerId="ADAL" clId="{0A0D2314-D59C-5A4C-9E09-78A254E3BB4B}" dt="2021-11-03T20:46:18.671" v="4638" actId="1076"/>
          <ac:picMkLst>
            <pc:docMk/>
            <pc:sldMk cId="2252998334" sldId="285"/>
            <ac:picMk id="9" creationId="{FBB68F08-64CC-564C-BE82-2B24199B4BD0}"/>
          </ac:picMkLst>
        </pc:picChg>
        <pc:picChg chg="mod">
          <ac:chgData name="Narang, Sonali" userId="9e80b397-6e2f-49b1-9374-ccdad8589140" providerId="ADAL" clId="{0A0D2314-D59C-5A4C-9E09-78A254E3BB4B}" dt="2021-11-03T20:45:27.820" v="4625" actId="1076"/>
          <ac:picMkLst>
            <pc:docMk/>
            <pc:sldMk cId="2252998334" sldId="285"/>
            <ac:picMk id="12" creationId="{CD0563F0-C751-FC47-8AE6-EFC466272C78}"/>
          </ac:picMkLst>
        </pc:picChg>
        <pc:picChg chg="add mod">
          <ac:chgData name="Narang, Sonali" userId="9e80b397-6e2f-49b1-9374-ccdad8589140" providerId="ADAL" clId="{0A0D2314-D59C-5A4C-9E09-78A254E3BB4B}" dt="2021-11-03T20:46:19.570" v="4639" actId="1076"/>
          <ac:picMkLst>
            <pc:docMk/>
            <pc:sldMk cId="2252998334" sldId="285"/>
            <ac:picMk id="13" creationId="{1C6603AB-6BB9-3C48-887A-598542F56407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14" creationId="{6070D443-9118-C64A-8D4B-BFD2145101A2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17" creationId="{F1479E0E-DE22-3247-BA7A-0EE44F1C0BDF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20" creationId="{88777090-38D1-6244-B6C3-BB2AA0287F67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22" creationId="{94CF07BF-7E1E-A840-A390-E6AB8098EEC1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28" creationId="{92DBD7F4-68D2-694A-B1BF-835D829C0F20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30" creationId="{A16034B0-4FAA-0F49-A8E9-45440EBC751E}"/>
          </ac:picMkLst>
        </pc:picChg>
        <pc:picChg chg="del">
          <ac:chgData name="Narang, Sonali" userId="9e80b397-6e2f-49b1-9374-ccdad8589140" providerId="ADAL" clId="{0A0D2314-D59C-5A4C-9E09-78A254E3BB4B}" dt="2021-11-03T20:45:23.732" v="4624" actId="478"/>
          <ac:picMkLst>
            <pc:docMk/>
            <pc:sldMk cId="2252998334" sldId="285"/>
            <ac:picMk id="131" creationId="{585BBCE9-E794-B048-BA15-834FAA88DA95}"/>
          </ac:picMkLst>
        </pc:picChg>
      </pc:sldChg>
      <pc:sldChg chg="addSp delSp modSp add del mod">
        <pc:chgData name="Narang, Sonali" userId="9e80b397-6e2f-49b1-9374-ccdad8589140" providerId="ADAL" clId="{0A0D2314-D59C-5A4C-9E09-78A254E3BB4B}" dt="2021-11-03T20:18:36.932" v="4500" actId="2696"/>
        <pc:sldMkLst>
          <pc:docMk/>
          <pc:sldMk cId="3865927926" sldId="285"/>
        </pc:sldMkLst>
        <pc:picChg chg="add mod">
          <ac:chgData name="Narang, Sonali" userId="9e80b397-6e2f-49b1-9374-ccdad8589140" providerId="ADAL" clId="{0A0D2314-D59C-5A4C-9E09-78A254E3BB4B}" dt="2021-11-03T19:10:36.381" v="4235" actId="1076"/>
          <ac:picMkLst>
            <pc:docMk/>
            <pc:sldMk cId="3865927926" sldId="285"/>
            <ac:picMk id="3" creationId="{51CD8913-41D8-0544-BF7A-72A4601A86FB}"/>
          </ac:picMkLst>
        </pc:picChg>
        <pc:picChg chg="del">
          <ac:chgData name="Narang, Sonali" userId="9e80b397-6e2f-49b1-9374-ccdad8589140" providerId="ADAL" clId="{0A0D2314-D59C-5A4C-9E09-78A254E3BB4B}" dt="2021-11-03T19:11:15.378" v="4236" actId="478"/>
          <ac:picMkLst>
            <pc:docMk/>
            <pc:sldMk cId="3865927926" sldId="285"/>
            <ac:picMk id="9" creationId="{582BC744-B55E-444D-9186-996C5EEEF91A}"/>
          </ac:picMkLst>
        </pc:picChg>
        <pc:picChg chg="del">
          <ac:chgData name="Narang, Sonali" userId="9e80b397-6e2f-49b1-9374-ccdad8589140" providerId="ADAL" clId="{0A0D2314-D59C-5A4C-9E09-78A254E3BB4B}" dt="2021-11-03T19:11:17.042" v="4237" actId="478"/>
          <ac:picMkLst>
            <pc:docMk/>
            <pc:sldMk cId="3865927926" sldId="285"/>
            <ac:picMk id="13" creationId="{1700A0E7-E7CE-114B-A2B5-15E8E6D46524}"/>
          </ac:picMkLst>
        </pc:picChg>
        <pc:picChg chg="add mod">
          <ac:chgData name="Narang, Sonali" userId="9e80b397-6e2f-49b1-9374-ccdad8589140" providerId="ADAL" clId="{0A0D2314-D59C-5A4C-9E09-78A254E3BB4B}" dt="2021-11-03T19:10:17.863" v="4233" actId="12789"/>
          <ac:picMkLst>
            <pc:docMk/>
            <pc:sldMk cId="3865927926" sldId="285"/>
            <ac:picMk id="14" creationId="{F4F5A9F3-6288-A445-81CE-2ACF8DCA4C76}"/>
          </ac:picMkLst>
        </pc:picChg>
        <pc:picChg chg="del">
          <ac:chgData name="Narang, Sonali" userId="9e80b397-6e2f-49b1-9374-ccdad8589140" providerId="ADAL" clId="{0A0D2314-D59C-5A4C-9E09-78A254E3BB4B}" dt="2021-11-03T19:11:17.042" v="4237" actId="478"/>
          <ac:picMkLst>
            <pc:docMk/>
            <pc:sldMk cId="3865927926" sldId="285"/>
            <ac:picMk id="16" creationId="{49314A01-A50F-FE40-ACB7-0D83933DE24E}"/>
          </ac:picMkLst>
        </pc:picChg>
        <pc:picChg chg="add mod">
          <ac:chgData name="Narang, Sonali" userId="9e80b397-6e2f-49b1-9374-ccdad8589140" providerId="ADAL" clId="{0A0D2314-D59C-5A4C-9E09-78A254E3BB4B}" dt="2021-11-03T19:10:24.624" v="4234" actId="1076"/>
          <ac:picMkLst>
            <pc:docMk/>
            <pc:sldMk cId="3865927926" sldId="285"/>
            <ac:picMk id="17" creationId="{8841888E-5E45-714B-9C52-AFEC303492F2}"/>
          </ac:picMkLst>
        </pc:picChg>
        <pc:picChg chg="del">
          <ac:chgData name="Narang, Sonali" userId="9e80b397-6e2f-49b1-9374-ccdad8589140" providerId="ADAL" clId="{0A0D2314-D59C-5A4C-9E09-78A254E3BB4B}" dt="2021-11-03T19:09:41.694" v="4224" actId="478"/>
          <ac:picMkLst>
            <pc:docMk/>
            <pc:sldMk cId="3865927926" sldId="285"/>
            <ac:picMk id="20" creationId="{7BB6B16B-28D9-194D-87FA-A12DE15B0D69}"/>
          </ac:picMkLst>
        </pc:picChg>
        <pc:picChg chg="del">
          <ac:chgData name="Narang, Sonali" userId="9e80b397-6e2f-49b1-9374-ccdad8589140" providerId="ADAL" clId="{0A0D2314-D59C-5A4C-9E09-78A254E3BB4B}" dt="2021-11-03T19:09:41.694" v="4224" actId="478"/>
          <ac:picMkLst>
            <pc:docMk/>
            <pc:sldMk cId="3865927926" sldId="285"/>
            <ac:picMk id="24" creationId="{4061DD9D-7877-F24B-BD70-11D9D12D2A5F}"/>
          </ac:picMkLst>
        </pc:picChg>
        <pc:picChg chg="add mod">
          <ac:chgData name="Narang, Sonali" userId="9e80b397-6e2f-49b1-9374-ccdad8589140" providerId="ADAL" clId="{0A0D2314-D59C-5A4C-9E09-78A254E3BB4B}" dt="2021-11-03T19:12:10.264" v="4244" actId="1076"/>
          <ac:picMkLst>
            <pc:docMk/>
            <pc:sldMk cId="3865927926" sldId="285"/>
            <ac:picMk id="25" creationId="{06C520ED-4BAB-454E-BE84-6A2E55F58378}"/>
          </ac:picMkLst>
        </pc:picChg>
        <pc:picChg chg="del">
          <ac:chgData name="Narang, Sonali" userId="9e80b397-6e2f-49b1-9374-ccdad8589140" providerId="ADAL" clId="{0A0D2314-D59C-5A4C-9E09-78A254E3BB4B}" dt="2021-11-03T19:09:41.694" v="4224" actId="478"/>
          <ac:picMkLst>
            <pc:docMk/>
            <pc:sldMk cId="3865927926" sldId="285"/>
            <ac:picMk id="34" creationId="{2A40C706-D4BB-D74C-BE24-A8B4D915A296}"/>
          </ac:picMkLst>
        </pc:picChg>
        <pc:picChg chg="add mod">
          <ac:chgData name="Narang, Sonali" userId="9e80b397-6e2f-49b1-9374-ccdad8589140" providerId="ADAL" clId="{0A0D2314-D59C-5A4C-9E09-78A254E3BB4B}" dt="2021-11-03T19:12:14.534" v="4245" actId="1076"/>
          <ac:picMkLst>
            <pc:docMk/>
            <pc:sldMk cId="3865927926" sldId="285"/>
            <ac:picMk id="35" creationId="{7C719382-2986-4745-A602-F4F1A5803526}"/>
          </ac:picMkLst>
        </pc:picChg>
      </pc:sldChg>
    </pc:docChg>
  </pc:docChgLst>
  <pc:docChgLst>
    <pc:chgData name="Narang, Sonali" userId="9e80b397-6e2f-49b1-9374-ccdad8589140" providerId="ADAL" clId="{9E7D9E33-8DDE-5D4E-8E42-EA964D3967CF}"/>
    <pc:docChg chg="undo custSel modSld">
      <pc:chgData name="Narang, Sonali" userId="9e80b397-6e2f-49b1-9374-ccdad8589140" providerId="ADAL" clId="{9E7D9E33-8DDE-5D4E-8E42-EA964D3967CF}" dt="2023-01-19T20:45:10.794" v="158" actId="20577"/>
      <pc:docMkLst>
        <pc:docMk/>
      </pc:docMkLst>
      <pc:sldChg chg="modSp mod modNotesTx">
        <pc:chgData name="Narang, Sonali" userId="9e80b397-6e2f-49b1-9374-ccdad8589140" providerId="ADAL" clId="{9E7D9E33-8DDE-5D4E-8E42-EA964D3967CF}" dt="2023-01-19T20:42:26.017" v="19" actId="20577"/>
        <pc:sldMkLst>
          <pc:docMk/>
          <pc:sldMk cId="1155223781" sldId="258"/>
        </pc:sldMkLst>
        <pc:spChg chg="mod">
          <ac:chgData name="Narang, Sonali" userId="9e80b397-6e2f-49b1-9374-ccdad8589140" providerId="ADAL" clId="{9E7D9E33-8DDE-5D4E-8E42-EA964D3967CF}" dt="2023-01-19T20:42:11.475" v="10" actId="20577"/>
          <ac:spMkLst>
            <pc:docMk/>
            <pc:sldMk cId="1155223781" sldId="258"/>
            <ac:spMk id="4" creationId="{F6669B9D-B042-D548-BD0F-97015091799B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4:11.578" v="105" actId="20577"/>
        <pc:sldMkLst>
          <pc:docMk/>
          <pc:sldMk cId="743684689" sldId="267"/>
        </pc:sldMkLst>
        <pc:spChg chg="mod">
          <ac:chgData name="Narang, Sonali" userId="9e80b397-6e2f-49b1-9374-ccdad8589140" providerId="ADAL" clId="{9E7D9E33-8DDE-5D4E-8E42-EA964D3967CF}" dt="2023-01-19T20:44:04.225" v="100" actId="20577"/>
          <ac:spMkLst>
            <pc:docMk/>
            <pc:sldMk cId="743684689" sldId="267"/>
            <ac:spMk id="167" creationId="{191EF0D9-34ED-2B46-B150-9606975E2917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3:04.533" v="39" actId="20577"/>
        <pc:sldMkLst>
          <pc:docMk/>
          <pc:sldMk cId="2078269342" sldId="277"/>
        </pc:sldMkLst>
        <pc:spChg chg="mod">
          <ac:chgData name="Narang, Sonali" userId="9e80b397-6e2f-49b1-9374-ccdad8589140" providerId="ADAL" clId="{9E7D9E33-8DDE-5D4E-8E42-EA964D3967CF}" dt="2023-01-19T20:42:57.385" v="28" actId="20577"/>
          <ac:spMkLst>
            <pc:docMk/>
            <pc:sldMk cId="2078269342" sldId="277"/>
            <ac:spMk id="64" creationId="{0FF0436D-644E-C145-81B0-37451A47E26F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4:36.283" v="124" actId="20577"/>
        <pc:sldMkLst>
          <pc:docMk/>
          <pc:sldMk cId="3214590643" sldId="280"/>
        </pc:sldMkLst>
        <pc:spChg chg="mod">
          <ac:chgData name="Narang, Sonali" userId="9e80b397-6e2f-49b1-9374-ccdad8589140" providerId="ADAL" clId="{9E7D9E33-8DDE-5D4E-8E42-EA964D3967CF}" dt="2023-01-19T20:44:29.744" v="114" actId="20577"/>
          <ac:spMkLst>
            <pc:docMk/>
            <pc:sldMk cId="3214590643" sldId="280"/>
            <ac:spMk id="102" creationId="{932011D5-5984-3D42-9F5D-4591319CF1BC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5:10.794" v="158" actId="20577"/>
        <pc:sldMkLst>
          <pc:docMk/>
          <pc:sldMk cId="2292075898" sldId="290"/>
        </pc:sldMkLst>
        <pc:spChg chg="mod">
          <ac:chgData name="Narang, Sonali" userId="9e80b397-6e2f-49b1-9374-ccdad8589140" providerId="ADAL" clId="{9E7D9E33-8DDE-5D4E-8E42-EA964D3967CF}" dt="2023-01-19T20:45:10.794" v="158" actId="20577"/>
          <ac:spMkLst>
            <pc:docMk/>
            <pc:sldMk cId="2292075898" sldId="290"/>
            <ac:spMk id="5" creationId="{2B6EBCD3-2130-FB43-8A00-E4997D60F8E3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3:36.956" v="75" actId="20577"/>
        <pc:sldMkLst>
          <pc:docMk/>
          <pc:sldMk cId="3617872054" sldId="291"/>
        </pc:sldMkLst>
        <pc:spChg chg="mod">
          <ac:chgData name="Narang, Sonali" userId="9e80b397-6e2f-49b1-9374-ccdad8589140" providerId="ADAL" clId="{9E7D9E33-8DDE-5D4E-8E42-EA964D3967CF}" dt="2023-01-19T20:43:31.784" v="72" actId="20577"/>
          <ac:spMkLst>
            <pc:docMk/>
            <pc:sldMk cId="3617872054" sldId="291"/>
            <ac:spMk id="29" creationId="{272B8E4A-E01D-9B45-AFE2-3B49B72AC62E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4:58.399" v="144" actId="20577"/>
        <pc:sldMkLst>
          <pc:docMk/>
          <pc:sldMk cId="2985018669" sldId="292"/>
        </pc:sldMkLst>
        <pc:spChg chg="mod">
          <ac:chgData name="Narang, Sonali" userId="9e80b397-6e2f-49b1-9374-ccdad8589140" providerId="ADAL" clId="{9E7D9E33-8DDE-5D4E-8E42-EA964D3967CF}" dt="2023-01-19T20:44:53.464" v="141" actId="20577"/>
          <ac:spMkLst>
            <pc:docMk/>
            <pc:sldMk cId="2985018669" sldId="292"/>
            <ac:spMk id="5" creationId="{AB8FCA42-B1BF-A140-A0F6-ABD57267C2D7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3:24.473" v="53" actId="20577"/>
        <pc:sldMkLst>
          <pc:docMk/>
          <pc:sldMk cId="2574176189" sldId="294"/>
        </pc:sldMkLst>
        <pc:spChg chg="mod">
          <ac:chgData name="Narang, Sonali" userId="9e80b397-6e2f-49b1-9374-ccdad8589140" providerId="ADAL" clId="{9E7D9E33-8DDE-5D4E-8E42-EA964D3967CF}" dt="2023-01-19T20:43:24.473" v="53" actId="20577"/>
          <ac:spMkLst>
            <pc:docMk/>
            <pc:sldMk cId="2574176189" sldId="294"/>
            <ac:spMk id="7" creationId="{CFFE0061-AF54-6D48-A9BA-8024282F038F}"/>
          </ac:spMkLst>
        </pc:spChg>
      </pc:sldChg>
      <pc:sldChg chg="modSp mod modNotesTx">
        <pc:chgData name="Narang, Sonali" userId="9e80b397-6e2f-49b1-9374-ccdad8589140" providerId="ADAL" clId="{9E7D9E33-8DDE-5D4E-8E42-EA964D3967CF}" dt="2023-01-19T20:43:50.942" v="89" actId="20577"/>
        <pc:sldMkLst>
          <pc:docMk/>
          <pc:sldMk cId="1438048095" sldId="295"/>
        </pc:sldMkLst>
        <pc:spChg chg="mod">
          <ac:chgData name="Narang, Sonali" userId="9e80b397-6e2f-49b1-9374-ccdad8589140" providerId="ADAL" clId="{9E7D9E33-8DDE-5D4E-8E42-EA964D3967CF}" dt="2023-01-19T20:43:44.540" v="86" actId="20577"/>
          <ac:spMkLst>
            <pc:docMk/>
            <pc:sldMk cId="1438048095" sldId="295"/>
            <ac:spMk id="16" creationId="{DD9A34E2-FB56-7543-BD51-DCD2CC285DC9}"/>
          </ac:spMkLst>
        </pc:spChg>
      </pc:sldChg>
    </pc:docChg>
  </pc:docChgLst>
  <pc:docChgLst>
    <pc:chgData name="Narang, Sonali" userId="9e80b397-6e2f-49b1-9374-ccdad8589140" providerId="ADAL" clId="{EE43CF42-9091-0948-8ABB-0345272F62C4}"/>
    <pc:docChg chg="undo redo custSel delSld modSld">
      <pc:chgData name="Narang, Sonali" userId="9e80b397-6e2f-49b1-9374-ccdad8589140" providerId="ADAL" clId="{EE43CF42-9091-0948-8ABB-0345272F62C4}" dt="2022-02-23T20:23:53.865" v="3083" actId="20577"/>
      <pc:docMkLst>
        <pc:docMk/>
      </pc:docMkLst>
      <pc:sldChg chg="addSp delSp modSp mod modNotesTx">
        <pc:chgData name="Narang, Sonali" userId="9e80b397-6e2f-49b1-9374-ccdad8589140" providerId="ADAL" clId="{EE43CF42-9091-0948-8ABB-0345272F62C4}" dt="2022-02-23T20:10:37.936" v="3079" actId="113"/>
        <pc:sldMkLst>
          <pc:docMk/>
          <pc:sldMk cId="1155223781" sldId="258"/>
        </pc:sldMkLst>
        <pc:spChg chg="mod">
          <ac:chgData name="Narang, Sonali" userId="9e80b397-6e2f-49b1-9374-ccdad8589140" providerId="ADAL" clId="{EE43CF42-9091-0948-8ABB-0345272F62C4}" dt="2022-02-23T20:10:37.936" v="3079" actId="113"/>
          <ac:spMkLst>
            <pc:docMk/>
            <pc:sldMk cId="1155223781" sldId="258"/>
            <ac:spMk id="5" creationId="{FAFFEC37-A0C5-5846-8534-22E3DEF6CEF4}"/>
          </ac:spMkLst>
        </pc:spChg>
        <pc:spChg chg="mod">
          <ac:chgData name="Narang, Sonali" userId="9e80b397-6e2f-49b1-9374-ccdad8589140" providerId="ADAL" clId="{EE43CF42-9091-0948-8ABB-0345272F62C4}" dt="2022-02-23T20:10:37.936" v="3079" actId="113"/>
          <ac:spMkLst>
            <pc:docMk/>
            <pc:sldMk cId="1155223781" sldId="258"/>
            <ac:spMk id="6" creationId="{41464C80-B659-484D-A16F-8018DEC5471A}"/>
          </ac:spMkLst>
        </pc:spChg>
        <pc:spChg chg="mod">
          <ac:chgData name="Narang, Sonali" userId="9e80b397-6e2f-49b1-9374-ccdad8589140" providerId="ADAL" clId="{EE43CF42-9091-0948-8ABB-0345272F62C4}" dt="2022-02-23T20:10:37.936" v="3079" actId="113"/>
          <ac:spMkLst>
            <pc:docMk/>
            <pc:sldMk cId="1155223781" sldId="258"/>
            <ac:spMk id="7" creationId="{4C5F5CAE-FBFD-964D-A356-746AAC86DC9E}"/>
          </ac:spMkLst>
        </pc:spChg>
        <pc:spChg chg="add del mod">
          <ac:chgData name="Narang, Sonali" userId="9e80b397-6e2f-49b1-9374-ccdad8589140" providerId="ADAL" clId="{EE43CF42-9091-0948-8ABB-0345272F62C4}" dt="2022-02-14T20:30:59.500" v="2181" actId="478"/>
          <ac:spMkLst>
            <pc:docMk/>
            <pc:sldMk cId="1155223781" sldId="258"/>
            <ac:spMk id="13" creationId="{D9D5C911-3184-0545-9AC1-EE4EB84B2558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14" creationId="{9482EB10-BC65-7742-9F9A-C8E6179C9F00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15" creationId="{B882E5B6-51CB-0E4E-98CD-A1543D1D9B29}"/>
          </ac:spMkLst>
        </pc:spChg>
        <pc:spChg chg="add del mod">
          <ac:chgData name="Narang, Sonali" userId="9e80b397-6e2f-49b1-9374-ccdad8589140" providerId="ADAL" clId="{EE43CF42-9091-0948-8ABB-0345272F62C4}" dt="2022-02-14T20:30:59.500" v="2181" actId="478"/>
          <ac:spMkLst>
            <pc:docMk/>
            <pc:sldMk cId="1155223781" sldId="258"/>
            <ac:spMk id="16" creationId="{35F81A31-F341-414D-BCD0-9BC3DBE5BF14}"/>
          </ac:spMkLst>
        </pc:spChg>
        <pc:spChg chg="add del mod">
          <ac:chgData name="Narang, Sonali" userId="9e80b397-6e2f-49b1-9374-ccdad8589140" providerId="ADAL" clId="{EE43CF42-9091-0948-8ABB-0345272F62C4}" dt="2022-02-14T20:30:59.500" v="2181" actId="478"/>
          <ac:spMkLst>
            <pc:docMk/>
            <pc:sldMk cId="1155223781" sldId="258"/>
            <ac:spMk id="17" creationId="{5CE8FFDC-3654-8040-86C3-8F53F037A5AE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18" creationId="{367D5BDE-1C52-044D-8DF4-14BCB0ED0FB9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19" creationId="{C7082FB9-D9DD-9B46-AB0D-77C63E208142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20" creationId="{44EFDA2E-01BB-5C4D-BFA4-1B654C633262}"/>
          </ac:spMkLst>
        </pc:spChg>
        <pc:spChg chg="add mod">
          <ac:chgData name="Narang, Sonali" userId="9e80b397-6e2f-49b1-9374-ccdad8589140" providerId="ADAL" clId="{EE43CF42-9091-0948-8ABB-0345272F62C4}" dt="2022-02-14T20:38:32.794" v="2333" actId="1076"/>
          <ac:spMkLst>
            <pc:docMk/>
            <pc:sldMk cId="1155223781" sldId="258"/>
            <ac:spMk id="21" creationId="{FB6E0053-C3C0-954D-BD99-12FE11770FF5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2" creationId="{A213DA13-9A0F-094F-B9BB-3833A654F806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3" creationId="{276AAB1C-9B21-624A-86D0-3955181A06CB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4" creationId="{678B4FA7-538E-1B4B-96E0-2825C9C14C3E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5" creationId="{96BA6AB2-3E59-4E49-A7B2-C2C829B1304A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6" creationId="{3FA6B5BD-099D-0A4E-89E1-6DD379FE4966}"/>
          </ac:spMkLst>
        </pc:spChg>
        <pc:spChg chg="add mod">
          <ac:chgData name="Narang, Sonali" userId="9e80b397-6e2f-49b1-9374-ccdad8589140" providerId="ADAL" clId="{EE43CF42-9091-0948-8ABB-0345272F62C4}" dt="2022-02-14T20:38:43.681" v="2334" actId="1076"/>
          <ac:spMkLst>
            <pc:docMk/>
            <pc:sldMk cId="1155223781" sldId="258"/>
            <ac:spMk id="27" creationId="{2C0D8070-7A7B-AD49-BEFD-379D5F209C30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1" creationId="{0277FEDF-F9D9-6646-B3AE-0577C6D0A4E5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2" creationId="{DD3B71C5-63C4-9A4E-B9E8-48BA183A2733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3" creationId="{3A625BF6-F4DC-B840-B7B1-195A5D97A316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4" creationId="{E0CB58FF-AA16-8B46-BA34-A9E03598E3C0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5" creationId="{7CD68B35-8C02-F04C-946C-DACA785D3773}"/>
          </ac:spMkLst>
        </pc:spChg>
        <pc:spChg chg="add mod">
          <ac:chgData name="Narang, Sonali" userId="9e80b397-6e2f-49b1-9374-ccdad8589140" providerId="ADAL" clId="{EE43CF42-9091-0948-8ABB-0345272F62C4}" dt="2022-02-14T20:37:21.340" v="2277" actId="465"/>
          <ac:spMkLst>
            <pc:docMk/>
            <pc:sldMk cId="1155223781" sldId="258"/>
            <ac:spMk id="36" creationId="{93CD5B23-1D64-BB47-A2DB-669B7E5879CE}"/>
          </ac:spMkLst>
        </pc:spChg>
        <pc:spChg chg="add mod">
          <ac:chgData name="Narang, Sonali" userId="9e80b397-6e2f-49b1-9374-ccdad8589140" providerId="ADAL" clId="{EE43CF42-9091-0948-8ABB-0345272F62C4}" dt="2022-02-14T20:39:06.008" v="2352" actId="1076"/>
          <ac:spMkLst>
            <pc:docMk/>
            <pc:sldMk cId="1155223781" sldId="258"/>
            <ac:spMk id="39" creationId="{615175B2-CF24-AF43-B914-20CEEE9156C6}"/>
          </ac:spMkLst>
        </pc:spChg>
        <pc:spChg chg="add mod">
          <ac:chgData name="Narang, Sonali" userId="9e80b397-6e2f-49b1-9374-ccdad8589140" providerId="ADAL" clId="{EE43CF42-9091-0948-8ABB-0345272F62C4}" dt="2022-02-14T20:39:14.531" v="2354" actId="1076"/>
          <ac:spMkLst>
            <pc:docMk/>
            <pc:sldMk cId="1155223781" sldId="258"/>
            <ac:spMk id="40" creationId="{134EB545-047E-6E46-A6D1-645262A03BB8}"/>
          </ac:spMkLst>
        </pc:spChg>
        <pc:spChg chg="add mod">
          <ac:chgData name="Narang, Sonali" userId="9e80b397-6e2f-49b1-9374-ccdad8589140" providerId="ADAL" clId="{EE43CF42-9091-0948-8ABB-0345272F62C4}" dt="2022-02-14T20:39:09.280" v="2353" actId="1076"/>
          <ac:spMkLst>
            <pc:docMk/>
            <pc:sldMk cId="1155223781" sldId="258"/>
            <ac:spMk id="41" creationId="{9B48354B-0F90-A347-9E91-3B09AFE68A60}"/>
          </ac:spMkLst>
        </pc:spChg>
        <pc:grpChg chg="add">
          <ac:chgData name="Narang, Sonali" userId="9e80b397-6e2f-49b1-9374-ccdad8589140" providerId="ADAL" clId="{EE43CF42-9091-0948-8ABB-0345272F62C4}" dt="2022-02-14T20:33:11.402" v="2226" actId="164"/>
          <ac:grpSpMkLst>
            <pc:docMk/>
            <pc:sldMk cId="1155223781" sldId="258"/>
            <ac:grpSpMk id="2" creationId="{97DF425C-8C95-EF48-AE1B-9A37CA1698E0}"/>
          </ac:grpSpMkLst>
        </pc:grpChg>
        <pc:grpChg chg="add mod">
          <ac:chgData name="Narang, Sonali" userId="9e80b397-6e2f-49b1-9374-ccdad8589140" providerId="ADAL" clId="{EE43CF42-9091-0948-8ABB-0345272F62C4}" dt="2022-02-14T20:35:24.516" v="2254" actId="1076"/>
          <ac:grpSpMkLst>
            <pc:docMk/>
            <pc:sldMk cId="1155223781" sldId="258"/>
            <ac:grpSpMk id="8" creationId="{F0573D55-2BC4-0041-9C05-358981365A10}"/>
          </ac:grpSpMkLst>
        </pc:grpChg>
        <pc:grpChg chg="add">
          <ac:chgData name="Narang, Sonali" userId="9e80b397-6e2f-49b1-9374-ccdad8589140" providerId="ADAL" clId="{EE43CF42-9091-0948-8ABB-0345272F62C4}" dt="2022-02-14T20:33:21.382" v="2228" actId="164"/>
          <ac:grpSpMkLst>
            <pc:docMk/>
            <pc:sldMk cId="1155223781" sldId="258"/>
            <ac:grpSpMk id="12" creationId="{94EF64BB-6C18-C844-ADCD-FA540E5D2A21}"/>
          </ac:grpSpMkLst>
        </pc:grpChg>
        <pc:grpChg chg="add mod">
          <ac:chgData name="Narang, Sonali" userId="9e80b397-6e2f-49b1-9374-ccdad8589140" providerId="ADAL" clId="{EE43CF42-9091-0948-8ABB-0345272F62C4}" dt="2022-02-14T20:37:21.340" v="2277" actId="465"/>
          <ac:grpSpMkLst>
            <pc:docMk/>
            <pc:sldMk cId="1155223781" sldId="258"/>
            <ac:grpSpMk id="28" creationId="{CA437E1D-3E32-224B-8381-A52A0269057D}"/>
          </ac:grpSpMkLst>
        </pc:grpChg>
        <pc:grpChg chg="add mod">
          <ac:chgData name="Narang, Sonali" userId="9e80b397-6e2f-49b1-9374-ccdad8589140" providerId="ADAL" clId="{EE43CF42-9091-0948-8ABB-0345272F62C4}" dt="2022-02-14T20:37:27.691" v="2278" actId="1076"/>
          <ac:grpSpMkLst>
            <pc:docMk/>
            <pc:sldMk cId="1155223781" sldId="258"/>
            <ac:grpSpMk id="29" creationId="{70F7DDDB-B9EC-E547-B6B0-91E941A82272}"/>
          </ac:grpSpMkLst>
        </pc:grpChg>
        <pc:grpChg chg="add">
          <ac:chgData name="Narang, Sonali" userId="9e80b397-6e2f-49b1-9374-ccdad8589140" providerId="ADAL" clId="{EE43CF42-9091-0948-8ABB-0345272F62C4}" dt="2022-02-14T20:39:31.646" v="2355" actId="164"/>
          <ac:grpSpMkLst>
            <pc:docMk/>
            <pc:sldMk cId="1155223781" sldId="258"/>
            <ac:grpSpMk id="30" creationId="{4F417D1A-6ED4-324C-9FBD-E75CD252B780}"/>
          </ac:grpSpMkLst>
        </pc:grpChg>
        <pc:grpChg chg="add">
          <ac:chgData name="Narang, Sonali" userId="9e80b397-6e2f-49b1-9374-ccdad8589140" providerId="ADAL" clId="{EE43CF42-9091-0948-8ABB-0345272F62C4}" dt="2022-02-14T20:39:36.747" v="2356" actId="164"/>
          <ac:grpSpMkLst>
            <pc:docMk/>
            <pc:sldMk cId="1155223781" sldId="258"/>
            <ac:grpSpMk id="37" creationId="{18F2BF47-01C1-9943-91C5-2F27A02846EF}"/>
          </ac:grpSpMkLst>
        </pc:grpChg>
        <pc:grpChg chg="add">
          <ac:chgData name="Narang, Sonali" userId="9e80b397-6e2f-49b1-9374-ccdad8589140" providerId="ADAL" clId="{EE43CF42-9091-0948-8ABB-0345272F62C4}" dt="2022-02-14T20:39:43.179" v="2357" actId="164"/>
          <ac:grpSpMkLst>
            <pc:docMk/>
            <pc:sldMk cId="1155223781" sldId="258"/>
            <ac:grpSpMk id="38" creationId="{40166CFF-AC69-6A4E-8878-A501979896E9}"/>
          </ac:grpSpMkLst>
        </pc:grpChg>
        <pc:grpChg chg="add">
          <ac:chgData name="Narang, Sonali" userId="9e80b397-6e2f-49b1-9374-ccdad8589140" providerId="ADAL" clId="{EE43CF42-9091-0948-8ABB-0345272F62C4}" dt="2022-02-14T20:39:46.013" v="2358" actId="164"/>
          <ac:grpSpMkLst>
            <pc:docMk/>
            <pc:sldMk cId="1155223781" sldId="258"/>
            <ac:grpSpMk id="42" creationId="{8569B67D-0077-EE47-A463-17B089D8789E}"/>
          </ac:grpSpMkLst>
        </pc:grpChg>
        <pc:picChg chg="mod modCrop">
          <ac:chgData name="Narang, Sonali" userId="9e80b397-6e2f-49b1-9374-ccdad8589140" providerId="ADAL" clId="{EE43CF42-9091-0948-8ABB-0345272F62C4}" dt="2022-02-14T20:31:53.275" v="2209" actId="732"/>
          <ac:picMkLst>
            <pc:docMk/>
            <pc:sldMk cId="1155223781" sldId="258"/>
            <ac:picMk id="3" creationId="{EA617364-550B-E04F-924F-48C74EA2D11B}"/>
          </ac:picMkLst>
        </pc:picChg>
        <pc:picChg chg="mod modCrop">
          <ac:chgData name="Narang, Sonali" userId="9e80b397-6e2f-49b1-9374-ccdad8589140" providerId="ADAL" clId="{EE43CF42-9091-0948-8ABB-0345272F62C4}" dt="2022-02-14T20:31:49.728" v="2208" actId="732"/>
          <ac:picMkLst>
            <pc:docMk/>
            <pc:sldMk cId="1155223781" sldId="258"/>
            <ac:picMk id="9" creationId="{CE344B95-A4B4-8E48-8BA1-DBCEB948F1E4}"/>
          </ac:picMkLst>
        </pc:picChg>
        <pc:picChg chg="mod modCrop">
          <ac:chgData name="Narang, Sonali" userId="9e80b397-6e2f-49b1-9374-ccdad8589140" providerId="ADAL" clId="{EE43CF42-9091-0948-8ABB-0345272F62C4}" dt="2022-02-14T20:37:21.340" v="2277" actId="465"/>
          <ac:picMkLst>
            <pc:docMk/>
            <pc:sldMk cId="1155223781" sldId="258"/>
            <ac:picMk id="11" creationId="{49516C8B-9616-3B4D-A203-229E3B7B51D9}"/>
          </ac:picMkLst>
        </pc:picChg>
        <pc:picChg chg="mod modCrop">
          <ac:chgData name="Narang, Sonali" userId="9e80b397-6e2f-49b1-9374-ccdad8589140" providerId="ADAL" clId="{EE43CF42-9091-0948-8ABB-0345272F62C4}" dt="2022-02-14T20:38:58.023" v="2349" actId="732"/>
          <ac:picMkLst>
            <pc:docMk/>
            <pc:sldMk cId="1155223781" sldId="258"/>
            <ac:picMk id="64" creationId="{F64170D4-AD39-6E41-B3C6-F2183A925A2E}"/>
          </ac:picMkLst>
        </pc:picChg>
        <pc:picChg chg="mod modCrop">
          <ac:chgData name="Narang, Sonali" userId="9e80b397-6e2f-49b1-9374-ccdad8589140" providerId="ADAL" clId="{EE43CF42-9091-0948-8ABB-0345272F62C4}" dt="2022-02-14T20:39:00.528" v="2350" actId="732"/>
          <ac:picMkLst>
            <pc:docMk/>
            <pc:sldMk cId="1155223781" sldId="258"/>
            <ac:picMk id="65" creationId="{F660B100-D24F-D145-8E9B-D3B0C1D6ED83}"/>
          </ac:picMkLst>
        </pc:picChg>
        <pc:picChg chg="mod modCrop">
          <ac:chgData name="Narang, Sonali" userId="9e80b397-6e2f-49b1-9374-ccdad8589140" providerId="ADAL" clId="{EE43CF42-9091-0948-8ABB-0345272F62C4}" dt="2022-02-14T20:39:02.862" v="2351" actId="732"/>
          <ac:picMkLst>
            <pc:docMk/>
            <pc:sldMk cId="1155223781" sldId="258"/>
            <ac:picMk id="66" creationId="{DA560F45-414B-1D48-AB88-6A33A254C80C}"/>
          </ac:picMkLst>
        </pc:picChg>
      </pc:sldChg>
      <pc:sldChg chg="addSp delSp modSp mod modNotesTx">
        <pc:chgData name="Narang, Sonali" userId="9e80b397-6e2f-49b1-9374-ccdad8589140" providerId="ADAL" clId="{EE43CF42-9091-0948-8ABB-0345272F62C4}" dt="2022-02-23T20:10:18.468" v="3077" actId="113"/>
        <pc:sldMkLst>
          <pc:docMk/>
          <pc:sldMk cId="743684689" sldId="267"/>
        </pc:sldMkLst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5" creationId="{FAFFEC37-A0C5-5846-8534-22E3DEF6CEF4}"/>
          </ac:spMkLst>
        </pc:spChg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6" creationId="{41464C80-B659-484D-A16F-8018DEC5471A}"/>
          </ac:spMkLst>
        </pc:spChg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8" creationId="{8A9BAE78-C4FF-1843-94F6-3410EB884848}"/>
          </ac:spMkLst>
        </pc:spChg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46" creationId="{7406AFD2-D7AD-D246-9AA9-8D2A7E07C320}"/>
          </ac:spMkLst>
        </pc:spChg>
        <pc:spChg chg="mod">
          <ac:chgData name="Narang, Sonali" userId="9e80b397-6e2f-49b1-9374-ccdad8589140" providerId="ADAL" clId="{EE43CF42-9091-0948-8ABB-0345272F62C4}" dt="2022-02-14T22:27:00.473" v="3030" actId="1035"/>
          <ac:spMkLst>
            <pc:docMk/>
            <pc:sldMk cId="743684689" sldId="267"/>
            <ac:spMk id="51" creationId="{3DC1E52F-7BDC-4948-9DE5-37F95C21CFF5}"/>
          </ac:spMkLst>
        </pc:spChg>
        <pc:spChg chg="mod">
          <ac:chgData name="Narang, Sonali" userId="9e80b397-6e2f-49b1-9374-ccdad8589140" providerId="ADAL" clId="{EE43CF42-9091-0948-8ABB-0345272F62C4}" dt="2022-02-14T22:24:24.362" v="2935" actId="20577"/>
          <ac:spMkLst>
            <pc:docMk/>
            <pc:sldMk cId="743684689" sldId="267"/>
            <ac:spMk id="62" creationId="{008CC80B-AD7B-3B4B-B365-D9A219690DD0}"/>
          </ac:spMkLst>
        </pc:spChg>
        <pc:spChg chg="mod">
          <ac:chgData name="Narang, Sonali" userId="9e80b397-6e2f-49b1-9374-ccdad8589140" providerId="ADAL" clId="{EE43CF42-9091-0948-8ABB-0345272F62C4}" dt="2022-02-14T22:24:12.066" v="2927" actId="167"/>
          <ac:spMkLst>
            <pc:docMk/>
            <pc:sldMk cId="743684689" sldId="267"/>
            <ac:spMk id="63" creationId="{5DBBA057-028F-2A4D-A2D1-E9A292BFBEDC}"/>
          </ac:spMkLst>
        </pc:spChg>
        <pc:spChg chg="mod">
          <ac:chgData name="Narang, Sonali" userId="9e80b397-6e2f-49b1-9374-ccdad8589140" providerId="ADAL" clId="{EE43CF42-9091-0948-8ABB-0345272F62C4}" dt="2022-02-14T22:24:43.365" v="2943" actId="20577"/>
          <ac:spMkLst>
            <pc:docMk/>
            <pc:sldMk cId="743684689" sldId="267"/>
            <ac:spMk id="64" creationId="{3C5275DE-15D5-944A-BF18-C25EB54256A3}"/>
          </ac:spMkLst>
        </pc:spChg>
        <pc:spChg chg="mod">
          <ac:chgData name="Narang, Sonali" userId="9e80b397-6e2f-49b1-9374-ccdad8589140" providerId="ADAL" clId="{EE43CF42-9091-0948-8ABB-0345272F62C4}" dt="2022-02-14T22:24:34.874" v="2937" actId="167"/>
          <ac:spMkLst>
            <pc:docMk/>
            <pc:sldMk cId="743684689" sldId="267"/>
            <ac:spMk id="65" creationId="{3519DE9C-2C2D-5E4F-B21C-6308A8A7F671}"/>
          </ac:spMkLst>
        </pc:spChg>
        <pc:spChg chg="mod">
          <ac:chgData name="Narang, Sonali" userId="9e80b397-6e2f-49b1-9374-ccdad8589140" providerId="ADAL" clId="{EE43CF42-9091-0948-8ABB-0345272F62C4}" dt="2022-02-14T22:24:48.856" v="2950" actId="20577"/>
          <ac:spMkLst>
            <pc:docMk/>
            <pc:sldMk cId="743684689" sldId="267"/>
            <ac:spMk id="66" creationId="{616CE034-C8F4-B544-8DB0-72348E38F909}"/>
          </ac:spMkLst>
        </pc:spChg>
        <pc:spChg chg="mod">
          <ac:chgData name="Narang, Sonali" userId="9e80b397-6e2f-49b1-9374-ccdad8589140" providerId="ADAL" clId="{EE43CF42-9091-0948-8ABB-0345272F62C4}" dt="2022-02-14T22:24:39.415" v="2938" actId="167"/>
          <ac:spMkLst>
            <pc:docMk/>
            <pc:sldMk cId="743684689" sldId="267"/>
            <ac:spMk id="67" creationId="{7FBA2917-AE7F-3540-9A34-3C4717C59740}"/>
          </ac:spMkLst>
        </pc:spChg>
        <pc:spChg chg="mod">
          <ac:chgData name="Narang, Sonali" userId="9e80b397-6e2f-49b1-9374-ccdad8589140" providerId="ADAL" clId="{EE43CF42-9091-0948-8ABB-0345272F62C4}" dt="2022-02-14T22:25:06.042" v="2959" actId="20577"/>
          <ac:spMkLst>
            <pc:docMk/>
            <pc:sldMk cId="743684689" sldId="267"/>
            <ac:spMk id="68" creationId="{D4250405-AA09-784A-BF06-EBB7DDB57018}"/>
          </ac:spMkLst>
        </pc:spChg>
        <pc:spChg chg="mod">
          <ac:chgData name="Narang, Sonali" userId="9e80b397-6e2f-49b1-9374-ccdad8589140" providerId="ADAL" clId="{EE43CF42-9091-0948-8ABB-0345272F62C4}" dt="2022-02-14T22:24:59.443" v="2953" actId="167"/>
          <ac:spMkLst>
            <pc:docMk/>
            <pc:sldMk cId="743684689" sldId="267"/>
            <ac:spMk id="69" creationId="{4639790B-F989-7641-916A-C42A2505F7DA}"/>
          </ac:spMkLst>
        </pc:spChg>
        <pc:spChg chg="mod">
          <ac:chgData name="Narang, Sonali" userId="9e80b397-6e2f-49b1-9374-ccdad8589140" providerId="ADAL" clId="{EE43CF42-9091-0948-8ABB-0345272F62C4}" dt="2022-02-14T22:25:14.446" v="2964" actId="20577"/>
          <ac:spMkLst>
            <pc:docMk/>
            <pc:sldMk cId="743684689" sldId="267"/>
            <ac:spMk id="70" creationId="{A8F9C39B-5458-E543-B00C-2DFBCF182CD3}"/>
          </ac:spMkLst>
        </pc:spChg>
        <pc:spChg chg="mod">
          <ac:chgData name="Narang, Sonali" userId="9e80b397-6e2f-49b1-9374-ccdad8589140" providerId="ADAL" clId="{EE43CF42-9091-0948-8ABB-0345272F62C4}" dt="2022-02-14T22:25:02.142" v="2954" actId="167"/>
          <ac:spMkLst>
            <pc:docMk/>
            <pc:sldMk cId="743684689" sldId="267"/>
            <ac:spMk id="71" creationId="{2ECD01C8-AE64-6E47-8E26-7A0A59BFA6CB}"/>
          </ac:spMkLst>
        </pc:spChg>
        <pc:spChg chg="mod">
          <ac:chgData name="Narang, Sonali" userId="9e80b397-6e2f-49b1-9374-ccdad8589140" providerId="ADAL" clId="{EE43CF42-9091-0948-8ABB-0345272F62C4}" dt="2022-02-14T22:25:17.596" v="2969" actId="20577"/>
          <ac:spMkLst>
            <pc:docMk/>
            <pc:sldMk cId="743684689" sldId="267"/>
            <ac:spMk id="72" creationId="{DB8DB24E-1586-6D4B-9B3B-112D95E4DEDF}"/>
          </ac:spMkLst>
        </pc:spChg>
        <pc:spChg chg="mod">
          <ac:chgData name="Narang, Sonali" userId="9e80b397-6e2f-49b1-9374-ccdad8589140" providerId="ADAL" clId="{EE43CF42-9091-0948-8ABB-0345272F62C4}" dt="2022-02-14T22:22:12.470" v="2834" actId="20577"/>
          <ac:spMkLst>
            <pc:docMk/>
            <pc:sldMk cId="743684689" sldId="267"/>
            <ac:spMk id="73" creationId="{3B3DC107-C9A4-6A4C-ABB9-D1FCC6B206C9}"/>
          </ac:spMkLst>
        </pc:spChg>
        <pc:spChg chg="mod">
          <ac:chgData name="Narang, Sonali" userId="9e80b397-6e2f-49b1-9374-ccdad8589140" providerId="ADAL" clId="{EE43CF42-9091-0948-8ABB-0345272F62C4}" dt="2022-02-14T22:25:35.349" v="2976" actId="20577"/>
          <ac:spMkLst>
            <pc:docMk/>
            <pc:sldMk cId="743684689" sldId="267"/>
            <ac:spMk id="74" creationId="{C50D725F-417E-B943-87F7-274B35C4F12F}"/>
          </ac:spMkLst>
        </pc:spChg>
        <pc:spChg chg="mod">
          <ac:chgData name="Narang, Sonali" userId="9e80b397-6e2f-49b1-9374-ccdad8589140" providerId="ADAL" clId="{EE43CF42-9091-0948-8ABB-0345272F62C4}" dt="2022-02-14T22:25:32.235" v="2971" actId="167"/>
          <ac:spMkLst>
            <pc:docMk/>
            <pc:sldMk cId="743684689" sldId="267"/>
            <ac:spMk id="75" creationId="{F6589498-EFE2-0049-83E8-89DE06232865}"/>
          </ac:spMkLst>
        </pc:spChg>
        <pc:spChg chg="mod">
          <ac:chgData name="Narang, Sonali" userId="9e80b397-6e2f-49b1-9374-ccdad8589140" providerId="ADAL" clId="{EE43CF42-9091-0948-8ABB-0345272F62C4}" dt="2022-02-14T22:25:41.679" v="2983" actId="20577"/>
          <ac:spMkLst>
            <pc:docMk/>
            <pc:sldMk cId="743684689" sldId="267"/>
            <ac:spMk id="76" creationId="{C5B1814D-BB1D-B94C-A9C4-25B3B028FBEC}"/>
          </ac:spMkLst>
        </pc:spChg>
        <pc:spChg chg="mod">
          <ac:chgData name="Narang, Sonali" userId="9e80b397-6e2f-49b1-9374-ccdad8589140" providerId="ADAL" clId="{EE43CF42-9091-0948-8ABB-0345272F62C4}" dt="2022-02-14T22:25:28.279" v="2970" actId="167"/>
          <ac:spMkLst>
            <pc:docMk/>
            <pc:sldMk cId="743684689" sldId="267"/>
            <ac:spMk id="77" creationId="{8096DF66-1FF1-184B-A7A9-1AEB77C3B759}"/>
          </ac:spMkLst>
        </pc:spChg>
        <pc:spChg chg="mod">
          <ac:chgData name="Narang, Sonali" userId="9e80b397-6e2f-49b1-9374-ccdad8589140" providerId="ADAL" clId="{EE43CF42-9091-0948-8ABB-0345272F62C4}" dt="2022-02-14T22:22:47.486" v="2857" actId="20577"/>
          <ac:spMkLst>
            <pc:docMk/>
            <pc:sldMk cId="743684689" sldId="267"/>
            <ac:spMk id="78" creationId="{4DA9D2B5-4025-C947-AEC5-4C7C16C9CAD0}"/>
          </ac:spMkLst>
        </pc:spChg>
        <pc:spChg chg="mod">
          <ac:chgData name="Narang, Sonali" userId="9e80b397-6e2f-49b1-9374-ccdad8589140" providerId="ADAL" clId="{EE43CF42-9091-0948-8ABB-0345272F62C4}" dt="2022-02-14T22:22:19.272" v="2852" actId="20577"/>
          <ac:spMkLst>
            <pc:docMk/>
            <pc:sldMk cId="743684689" sldId="267"/>
            <ac:spMk id="79" creationId="{744EA697-ADEA-4E4E-859E-B78371D40548}"/>
          </ac:spMkLst>
        </pc:spChg>
        <pc:spChg chg="mod">
          <ac:chgData name="Narang, Sonali" userId="9e80b397-6e2f-49b1-9374-ccdad8589140" providerId="ADAL" clId="{EE43CF42-9091-0948-8ABB-0345272F62C4}" dt="2022-02-14T22:27:08.709" v="3035" actId="1035"/>
          <ac:spMkLst>
            <pc:docMk/>
            <pc:sldMk cId="743684689" sldId="267"/>
            <ac:spMk id="87" creationId="{7D455060-65F7-4D46-9804-B4FB7F442D6E}"/>
          </ac:spMkLst>
        </pc:spChg>
        <pc:spChg chg="mod">
          <ac:chgData name="Narang, Sonali" userId="9e80b397-6e2f-49b1-9374-ccdad8589140" providerId="ADAL" clId="{EE43CF42-9091-0948-8ABB-0345272F62C4}" dt="2022-02-14T22:25:56.576" v="2990" actId="20577"/>
          <ac:spMkLst>
            <pc:docMk/>
            <pc:sldMk cId="743684689" sldId="267"/>
            <ac:spMk id="97" creationId="{C39DCFF4-724B-2949-94D6-1E0DE5CF23D1}"/>
          </ac:spMkLst>
        </pc:spChg>
        <pc:spChg chg="mod">
          <ac:chgData name="Narang, Sonali" userId="9e80b397-6e2f-49b1-9374-ccdad8589140" providerId="ADAL" clId="{EE43CF42-9091-0948-8ABB-0345272F62C4}" dt="2022-02-14T22:25:51.034" v="2984" actId="167"/>
          <ac:spMkLst>
            <pc:docMk/>
            <pc:sldMk cId="743684689" sldId="267"/>
            <ac:spMk id="98" creationId="{C2CA281F-B6A5-3F40-ACD6-D50702AD9BA5}"/>
          </ac:spMkLst>
        </pc:spChg>
        <pc:spChg chg="mod">
          <ac:chgData name="Narang, Sonali" userId="9e80b397-6e2f-49b1-9374-ccdad8589140" providerId="ADAL" clId="{EE43CF42-9091-0948-8ABB-0345272F62C4}" dt="2022-02-14T22:26:00.613" v="2995" actId="20577"/>
          <ac:spMkLst>
            <pc:docMk/>
            <pc:sldMk cId="743684689" sldId="267"/>
            <ac:spMk id="99" creationId="{137FC4AE-285A-5746-9A12-C235BD471414}"/>
          </ac:spMkLst>
        </pc:spChg>
        <pc:spChg chg="mod">
          <ac:chgData name="Narang, Sonali" userId="9e80b397-6e2f-49b1-9374-ccdad8589140" providerId="ADAL" clId="{EE43CF42-9091-0948-8ABB-0345272F62C4}" dt="2022-02-14T22:25:52.791" v="2985" actId="167"/>
          <ac:spMkLst>
            <pc:docMk/>
            <pc:sldMk cId="743684689" sldId="267"/>
            <ac:spMk id="100" creationId="{EBCB1240-7411-9549-995B-E33A30CBFC6A}"/>
          </ac:spMkLst>
        </pc:spChg>
        <pc:spChg chg="mod">
          <ac:chgData name="Narang, Sonali" userId="9e80b397-6e2f-49b1-9374-ccdad8589140" providerId="ADAL" clId="{EE43CF42-9091-0948-8ABB-0345272F62C4}" dt="2022-02-14T22:23:38.880" v="2921" actId="20577"/>
          <ac:spMkLst>
            <pc:docMk/>
            <pc:sldMk cId="743684689" sldId="267"/>
            <ac:spMk id="101" creationId="{060EB9F8-8173-8043-8791-E4C6FFE56A3D}"/>
          </ac:spMkLst>
        </pc:spChg>
        <pc:spChg chg="mod">
          <ac:chgData name="Narang, Sonali" userId="9e80b397-6e2f-49b1-9374-ccdad8589140" providerId="ADAL" clId="{EE43CF42-9091-0948-8ABB-0345272F62C4}" dt="2022-02-14T22:23:04.669" v="2875" actId="20577"/>
          <ac:spMkLst>
            <pc:docMk/>
            <pc:sldMk cId="743684689" sldId="267"/>
            <ac:spMk id="102" creationId="{C82F29F0-F277-4F42-B50B-721D77CD7627}"/>
          </ac:spMkLst>
        </pc:spChg>
        <pc:spChg chg="mod">
          <ac:chgData name="Narang, Sonali" userId="9e80b397-6e2f-49b1-9374-ccdad8589140" providerId="ADAL" clId="{EE43CF42-9091-0948-8ABB-0345272F62C4}" dt="2022-02-14T22:26:09.776" v="3002" actId="20577"/>
          <ac:spMkLst>
            <pc:docMk/>
            <pc:sldMk cId="743684689" sldId="267"/>
            <ac:spMk id="103" creationId="{B6F44F49-84C3-624F-9F39-FADD8171C11E}"/>
          </ac:spMkLst>
        </pc:spChg>
        <pc:spChg chg="mod">
          <ac:chgData name="Narang, Sonali" userId="9e80b397-6e2f-49b1-9374-ccdad8589140" providerId="ADAL" clId="{EE43CF42-9091-0948-8ABB-0345272F62C4}" dt="2022-02-14T22:26:07.079" v="2997" actId="167"/>
          <ac:spMkLst>
            <pc:docMk/>
            <pc:sldMk cId="743684689" sldId="267"/>
            <ac:spMk id="104" creationId="{85888F3A-72FB-5241-9B90-AB298A33B860}"/>
          </ac:spMkLst>
        </pc:spChg>
        <pc:spChg chg="mod">
          <ac:chgData name="Narang, Sonali" userId="9e80b397-6e2f-49b1-9374-ccdad8589140" providerId="ADAL" clId="{EE43CF42-9091-0948-8ABB-0345272F62C4}" dt="2022-02-14T22:26:13.672" v="3007" actId="20577"/>
          <ac:spMkLst>
            <pc:docMk/>
            <pc:sldMk cId="743684689" sldId="267"/>
            <ac:spMk id="106" creationId="{A8E12618-19A1-7842-8970-AF43031F6909}"/>
          </ac:spMkLst>
        </pc:spChg>
        <pc:spChg chg="mod">
          <ac:chgData name="Narang, Sonali" userId="9e80b397-6e2f-49b1-9374-ccdad8589140" providerId="ADAL" clId="{EE43CF42-9091-0948-8ABB-0345272F62C4}" dt="2022-02-14T22:26:04.601" v="2996" actId="167"/>
          <ac:spMkLst>
            <pc:docMk/>
            <pc:sldMk cId="743684689" sldId="267"/>
            <ac:spMk id="107" creationId="{EDE1D43B-5367-FC44-9DCD-AF4A03695A4A}"/>
          </ac:spMkLst>
        </pc:spChg>
        <pc:spChg chg="mod">
          <ac:chgData name="Narang, Sonali" userId="9e80b397-6e2f-49b1-9374-ccdad8589140" providerId="ADAL" clId="{EE43CF42-9091-0948-8ABB-0345272F62C4}" dt="2022-02-14T22:23:45.863" v="2926" actId="20577"/>
          <ac:spMkLst>
            <pc:docMk/>
            <pc:sldMk cId="743684689" sldId="267"/>
            <ac:spMk id="108" creationId="{8167A3AE-7BEF-C746-A4ED-F77F76FA965B}"/>
          </ac:spMkLst>
        </pc:spChg>
        <pc:spChg chg="mod">
          <ac:chgData name="Narang, Sonali" userId="9e80b397-6e2f-49b1-9374-ccdad8589140" providerId="ADAL" clId="{EE43CF42-9091-0948-8ABB-0345272F62C4}" dt="2022-02-14T22:23:14.351" v="2893" actId="20577"/>
          <ac:spMkLst>
            <pc:docMk/>
            <pc:sldMk cId="743684689" sldId="267"/>
            <ac:spMk id="109" creationId="{7ABF4552-62FD-6940-9B65-36FB2B13F39F}"/>
          </ac:spMkLst>
        </pc:spChg>
        <pc:spChg chg="mod">
          <ac:chgData name="Narang, Sonali" userId="9e80b397-6e2f-49b1-9374-ccdad8589140" providerId="ADAL" clId="{EE43CF42-9091-0948-8ABB-0345272F62C4}" dt="2022-02-14T22:26:20.208" v="3013" actId="20577"/>
          <ac:spMkLst>
            <pc:docMk/>
            <pc:sldMk cId="743684689" sldId="267"/>
            <ac:spMk id="110" creationId="{CA36ADBD-1903-2B4B-AC83-214AEF895EF8}"/>
          </ac:spMkLst>
        </pc:spChg>
        <pc:spChg chg="mod">
          <ac:chgData name="Narang, Sonali" userId="9e80b397-6e2f-49b1-9374-ccdad8589140" providerId="ADAL" clId="{EE43CF42-9091-0948-8ABB-0345272F62C4}" dt="2022-02-14T22:23:17.072" v="2899" actId="20577"/>
          <ac:spMkLst>
            <pc:docMk/>
            <pc:sldMk cId="743684689" sldId="267"/>
            <ac:spMk id="111" creationId="{F173ECB2-4EA2-CB40-A5F6-C1D3EB3ECF84}"/>
          </ac:spMkLst>
        </pc:spChg>
        <pc:spChg chg="mod">
          <ac:chgData name="Narang, Sonali" userId="9e80b397-6e2f-49b1-9374-ccdad8589140" providerId="ADAL" clId="{EE43CF42-9091-0948-8ABB-0345272F62C4}" dt="2022-02-14T22:26:54.038" v="3026" actId="20577"/>
          <ac:spMkLst>
            <pc:docMk/>
            <pc:sldMk cId="743684689" sldId="267"/>
            <ac:spMk id="112" creationId="{E23EFC05-2819-244C-84FE-31783BCEB84E}"/>
          </ac:spMkLst>
        </pc:spChg>
        <pc:spChg chg="mod">
          <ac:chgData name="Narang, Sonali" userId="9e80b397-6e2f-49b1-9374-ccdad8589140" providerId="ADAL" clId="{EE43CF42-9091-0948-8ABB-0345272F62C4}" dt="2022-02-14T22:26:16.064" v="3008" actId="167"/>
          <ac:spMkLst>
            <pc:docMk/>
            <pc:sldMk cId="743684689" sldId="267"/>
            <ac:spMk id="113" creationId="{CB910B2A-B222-FA4F-A7D3-F35F11D500C5}"/>
          </ac:spMkLst>
        </pc:spChg>
        <pc:spChg chg="mod">
          <ac:chgData name="Narang, Sonali" userId="9e80b397-6e2f-49b1-9374-ccdad8589140" providerId="ADAL" clId="{EE43CF42-9091-0948-8ABB-0345272F62C4}" dt="2022-02-14T22:23:24.516" v="2916" actId="20577"/>
          <ac:spMkLst>
            <pc:docMk/>
            <pc:sldMk cId="743684689" sldId="267"/>
            <ac:spMk id="114" creationId="{B2DA6B96-6B6A-C347-AD82-2A6BB57B1A2B}"/>
          </ac:spMkLst>
        </pc:spChg>
        <pc:spChg chg="mod">
          <ac:chgData name="Narang, Sonali" userId="9e80b397-6e2f-49b1-9374-ccdad8589140" providerId="ADAL" clId="{EE43CF42-9091-0948-8ABB-0345272F62C4}" dt="2022-02-14T22:26:21.944" v="3014" actId="167"/>
          <ac:spMkLst>
            <pc:docMk/>
            <pc:sldMk cId="743684689" sldId="267"/>
            <ac:spMk id="115" creationId="{0B07479E-3209-1A49-BF13-446F1AB34C60}"/>
          </ac:spMkLst>
        </pc:spChg>
        <pc:spChg chg="mod">
          <ac:chgData name="Narang, Sonali" userId="9e80b397-6e2f-49b1-9374-ccdad8589140" providerId="ADAL" clId="{EE43CF42-9091-0948-8ABB-0345272F62C4}" dt="2022-02-14T20:40:28.377" v="2364" actId="20577"/>
          <ac:spMkLst>
            <pc:docMk/>
            <pc:sldMk cId="743684689" sldId="267"/>
            <ac:spMk id="123" creationId="{621E773B-4B95-674F-AB79-EF48BC6CDAD4}"/>
          </ac:spMkLst>
        </pc:spChg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124" creationId="{2BE84DAC-7C05-C445-9DD3-6B3EE69AFBF9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25" creationId="{31CC80EA-68AA-1246-831B-C9466B421AD1}"/>
          </ac:spMkLst>
        </pc:spChg>
        <pc:spChg chg="mod">
          <ac:chgData name="Narang, Sonali" userId="9e80b397-6e2f-49b1-9374-ccdad8589140" providerId="ADAL" clId="{EE43CF42-9091-0948-8ABB-0345272F62C4}" dt="2022-02-14T20:40:25.490" v="2363" actId="20577"/>
          <ac:spMkLst>
            <pc:docMk/>
            <pc:sldMk cId="743684689" sldId="267"/>
            <ac:spMk id="128" creationId="{A6A057D2-5FF7-4149-94F5-B140DE2FABD5}"/>
          </ac:spMkLst>
        </pc:spChg>
        <pc:spChg chg="mod">
          <ac:chgData name="Narang, Sonali" userId="9e80b397-6e2f-49b1-9374-ccdad8589140" providerId="ADAL" clId="{EE43CF42-9091-0948-8ABB-0345272F62C4}" dt="2022-02-23T20:09:37.854" v="3074" actId="207"/>
          <ac:spMkLst>
            <pc:docMk/>
            <pc:sldMk cId="743684689" sldId="267"/>
            <ac:spMk id="139" creationId="{5F5D34B7-9211-A24D-86FE-1AA2CE828CDB}"/>
          </ac:spMkLst>
        </pc:spChg>
        <pc:spChg chg="mod">
          <ac:chgData name="Narang, Sonali" userId="9e80b397-6e2f-49b1-9374-ccdad8589140" providerId="ADAL" clId="{EE43CF42-9091-0948-8ABB-0345272F62C4}" dt="2022-02-23T20:09:37.854" v="3074" actId="207"/>
          <ac:spMkLst>
            <pc:docMk/>
            <pc:sldMk cId="743684689" sldId="267"/>
            <ac:spMk id="140" creationId="{BB59C36B-03AF-B944-9655-17F26C6A722B}"/>
          </ac:spMkLst>
        </pc:spChg>
        <pc:spChg chg="mod">
          <ac:chgData name="Narang, Sonali" userId="9e80b397-6e2f-49b1-9374-ccdad8589140" providerId="ADAL" clId="{EE43CF42-9091-0948-8ABB-0345272F62C4}" dt="2022-02-23T20:09:37.854" v="3074" actId="207"/>
          <ac:spMkLst>
            <pc:docMk/>
            <pc:sldMk cId="743684689" sldId="267"/>
            <ac:spMk id="141" creationId="{A1C7852E-A1F3-5440-9C5F-CABED7B457DF}"/>
          </ac:spMkLst>
        </pc:spChg>
        <pc:spChg chg="mod">
          <ac:chgData name="Narang, Sonali" userId="9e80b397-6e2f-49b1-9374-ccdad8589140" providerId="ADAL" clId="{EE43CF42-9091-0948-8ABB-0345272F62C4}" dt="2022-02-23T20:09:44.185" v="3075" actId="207"/>
          <ac:spMkLst>
            <pc:docMk/>
            <pc:sldMk cId="743684689" sldId="267"/>
            <ac:spMk id="150" creationId="{FBE03226-AE8E-AF42-8BBD-E1FDA5B497F8}"/>
          </ac:spMkLst>
        </pc:spChg>
        <pc:spChg chg="mod">
          <ac:chgData name="Narang, Sonali" userId="9e80b397-6e2f-49b1-9374-ccdad8589140" providerId="ADAL" clId="{EE43CF42-9091-0948-8ABB-0345272F62C4}" dt="2022-02-23T20:09:44.185" v="3075" actId="207"/>
          <ac:spMkLst>
            <pc:docMk/>
            <pc:sldMk cId="743684689" sldId="267"/>
            <ac:spMk id="151" creationId="{0CBB35CC-33A4-0B4F-870C-2374E6EF5CB8}"/>
          </ac:spMkLst>
        </pc:spChg>
        <pc:spChg chg="mod">
          <ac:chgData name="Narang, Sonali" userId="9e80b397-6e2f-49b1-9374-ccdad8589140" providerId="ADAL" clId="{EE43CF42-9091-0948-8ABB-0345272F62C4}" dt="2022-02-23T20:09:44.185" v="3075" actId="207"/>
          <ac:spMkLst>
            <pc:docMk/>
            <pc:sldMk cId="743684689" sldId="267"/>
            <ac:spMk id="152" creationId="{76912FDE-67EB-554E-B5D2-687F992A13CE}"/>
          </ac:spMkLst>
        </pc:spChg>
        <pc:spChg chg="mod">
          <ac:chgData name="Narang, Sonali" userId="9e80b397-6e2f-49b1-9374-ccdad8589140" providerId="ADAL" clId="{EE43CF42-9091-0948-8ABB-0345272F62C4}" dt="2022-02-14T22:27:04.060" v="3033" actId="1035"/>
          <ac:spMkLst>
            <pc:docMk/>
            <pc:sldMk cId="743684689" sldId="267"/>
            <ac:spMk id="155" creationId="{015E078D-E107-AA44-B5C6-75D51E21ED5C}"/>
          </ac:spMkLst>
        </pc:spChg>
        <pc:spChg chg="mod">
          <ac:chgData name="Narang, Sonali" userId="9e80b397-6e2f-49b1-9374-ccdad8589140" providerId="ADAL" clId="{EE43CF42-9091-0948-8ABB-0345272F62C4}" dt="2022-02-23T20:10:18.468" v="3077" actId="113"/>
          <ac:spMkLst>
            <pc:docMk/>
            <pc:sldMk cId="743684689" sldId="267"/>
            <ac:spMk id="156" creationId="{8FF60A7D-1E41-ED47-BB8F-AFE0553750EE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57" creationId="{EF5E8005-4D94-B645-A731-525F33F4AF83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58" creationId="{9DC8E996-F342-6F43-8A1F-87B9163E9F08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59" creationId="{81CDB253-98F2-B048-A60F-2051FC8064B6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0" creationId="{B7B6C043-CB99-0548-99C5-C5BF6F7F0E10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1" creationId="{C92CD139-7A4F-074F-9B11-813B677A7F71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2" creationId="{72258CDC-D46B-4B41-8F28-312A9FCBFAE1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3" creationId="{EF0562B4-4FBF-0047-AE83-873C8BC9352C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4" creationId="{066E00D7-5A33-5F47-98AB-8E919E74A450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5" creationId="{DBEBBA82-6229-BE4D-A207-C21FFC331C37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66" creationId="{BD56A46C-7DC3-7A41-9022-E9C01235C5F4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0" creationId="{C7FE3F48-B831-AB43-9F0C-FD06DA2D32AF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2" creationId="{0322FD70-D32A-7847-81F8-BB8BBA59267A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3" creationId="{6184D6B6-105B-1643-80BF-DC6F61E8C6EA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4" creationId="{65416C77-851F-BE47-A685-0928BBA6790A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5" creationId="{726968A5-6281-AF4F-833A-289691405BD3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6" creationId="{97E63656-AA1C-DE45-A14B-BD2D9B9FCC5A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7" creationId="{AF2C768B-A8EE-7146-8BC4-C884E81C4317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8" creationId="{2421F6B7-954A-3543-B405-A5F221D1B481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79" creationId="{7C590E2D-F2AD-BC46-9C88-1C23F7F2F04B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80" creationId="{81D081E9-938D-024A-BA6C-D7AAD6703702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81" creationId="{F9EF7862-283C-DF4D-9A73-A7CAEA349412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82" creationId="{B76DF5F5-8AE5-8E4D-B27F-899DD2797EFB}"/>
          </ac:spMkLst>
        </pc:spChg>
        <pc:spChg chg="add mod topLvl">
          <ac:chgData name="Narang, Sonali" userId="9e80b397-6e2f-49b1-9374-ccdad8589140" providerId="ADAL" clId="{EE43CF42-9091-0948-8ABB-0345272F62C4}" dt="2022-02-14T22:20:19.723" v="2771" actId="164"/>
          <ac:spMkLst>
            <pc:docMk/>
            <pc:sldMk cId="743684689" sldId="267"/>
            <ac:spMk id="183" creationId="{0D05662D-AB8E-AF4B-9962-2332AA9CCA76}"/>
          </ac:spMkLst>
        </pc:spChg>
        <pc:spChg chg="add mod">
          <ac:chgData name="Narang, Sonali" userId="9e80b397-6e2f-49b1-9374-ccdad8589140" providerId="ADAL" clId="{EE43CF42-9091-0948-8ABB-0345272F62C4}" dt="2022-02-14T22:21:44.994" v="2798" actId="1076"/>
          <ac:spMkLst>
            <pc:docMk/>
            <pc:sldMk cId="743684689" sldId="267"/>
            <ac:spMk id="184" creationId="{2211BE2A-B3C4-3947-903A-B3BD8653BA07}"/>
          </ac:spMkLst>
        </pc:spChg>
        <pc:spChg chg="add mod">
          <ac:chgData name="Narang, Sonali" userId="9e80b397-6e2f-49b1-9374-ccdad8589140" providerId="ADAL" clId="{EE43CF42-9091-0948-8ABB-0345272F62C4}" dt="2022-02-14T22:41:48.450" v="3049" actId="1076"/>
          <ac:spMkLst>
            <pc:docMk/>
            <pc:sldMk cId="743684689" sldId="267"/>
            <ac:spMk id="185" creationId="{274343EA-8BC8-C547-A442-AED8B4EEC35F}"/>
          </ac:spMkLst>
        </pc:spChg>
        <pc:spChg chg="add mod">
          <ac:chgData name="Narang, Sonali" userId="9e80b397-6e2f-49b1-9374-ccdad8589140" providerId="ADAL" clId="{EE43CF42-9091-0948-8ABB-0345272F62C4}" dt="2022-02-14T22:21:44.994" v="2798" actId="1076"/>
          <ac:spMkLst>
            <pc:docMk/>
            <pc:sldMk cId="743684689" sldId="267"/>
            <ac:spMk id="186" creationId="{DEE549CB-B869-D941-8A58-37313ADE2F43}"/>
          </ac:spMkLst>
        </pc:spChg>
        <pc:spChg chg="add del">
          <ac:chgData name="Narang, Sonali" userId="9e80b397-6e2f-49b1-9374-ccdad8589140" providerId="ADAL" clId="{EE43CF42-9091-0948-8ABB-0345272F62C4}" dt="2022-02-14T22:35:24.502" v="3037" actId="22"/>
          <ac:spMkLst>
            <pc:docMk/>
            <pc:sldMk cId="743684689" sldId="267"/>
            <ac:spMk id="187" creationId="{70D40CFE-0275-9E45-8CA3-E667AEFB9067}"/>
          </ac:spMkLst>
        </pc:spChg>
        <pc:grpChg chg="add del mod">
          <ac:chgData name="Narang, Sonali" userId="9e80b397-6e2f-49b1-9374-ccdad8589140" providerId="ADAL" clId="{EE43CF42-9091-0948-8ABB-0345272F62C4}" dt="2022-02-14T22:20:23.248" v="2772" actId="164"/>
          <ac:grpSpMkLst>
            <pc:docMk/>
            <pc:sldMk cId="743684689" sldId="267"/>
            <ac:grpSpMk id="2" creationId="{8807552B-1B5C-D249-A86E-05B6502AFE00}"/>
          </ac:grpSpMkLst>
        </pc:grpChg>
        <pc:grpChg chg="mod">
          <ac:chgData name="Narang, Sonali" userId="9e80b397-6e2f-49b1-9374-ccdad8589140" providerId="ADAL" clId="{EE43CF42-9091-0948-8ABB-0345272F62C4}" dt="2022-02-14T22:26:47.988" v="3022" actId="1035"/>
          <ac:grpSpMkLst>
            <pc:docMk/>
            <pc:sldMk cId="743684689" sldId="267"/>
            <ac:grpSpMk id="47" creationId="{72F4671B-3E29-E441-A783-B731F5D5E901}"/>
          </ac:grpSpMkLst>
        </pc:grpChg>
        <pc:picChg chg="add mod modCrop">
          <ac:chgData name="Narang, Sonali" userId="9e80b397-6e2f-49b1-9374-ccdad8589140" providerId="ADAL" clId="{EE43CF42-9091-0948-8ABB-0345272F62C4}" dt="2022-02-14T22:41:47.656" v="3048" actId="732"/>
          <ac:picMkLst>
            <pc:docMk/>
            <pc:sldMk cId="743684689" sldId="267"/>
            <ac:picMk id="7" creationId="{54B78F49-DB33-4142-8248-E58CCA1F65B8}"/>
          </ac:picMkLst>
        </pc:picChg>
        <pc:picChg chg="mod topLvl modCrop">
          <ac:chgData name="Narang, Sonali" userId="9e80b397-6e2f-49b1-9374-ccdad8589140" providerId="ADAL" clId="{EE43CF42-9091-0948-8ABB-0345272F62C4}" dt="2022-02-14T22:20:19.723" v="2771" actId="164"/>
          <ac:picMkLst>
            <pc:docMk/>
            <pc:sldMk cId="743684689" sldId="267"/>
            <ac:picMk id="13" creationId="{8E13C50A-DD07-A546-AF0A-4883E062BFDF}"/>
          </ac:picMkLst>
        </pc:picChg>
        <pc:picChg chg="del">
          <ac:chgData name="Narang, Sonali" userId="9e80b397-6e2f-49b1-9374-ccdad8589140" providerId="ADAL" clId="{EE43CF42-9091-0948-8ABB-0345272F62C4}" dt="2022-02-14T22:41:08.693" v="3038" actId="478"/>
          <ac:picMkLst>
            <pc:docMk/>
            <pc:sldMk cId="743684689" sldId="267"/>
            <ac:picMk id="105" creationId="{97BF178D-FAD3-E44E-B50E-E66B7B262246}"/>
          </ac:picMkLst>
        </pc:picChg>
        <pc:picChg chg="mod modCrop">
          <ac:chgData name="Narang, Sonali" userId="9e80b397-6e2f-49b1-9374-ccdad8589140" providerId="ADAL" clId="{EE43CF42-9091-0948-8ABB-0345272F62C4}" dt="2022-02-14T22:21:44.994" v="2798" actId="1076"/>
          <ac:picMkLst>
            <pc:docMk/>
            <pc:sldMk cId="743684689" sldId="267"/>
            <ac:picMk id="167" creationId="{58CAA980-D1E6-AA4C-A334-C0D57A74D895}"/>
          </ac:picMkLst>
        </pc:picChg>
        <pc:picChg chg="add del mod">
          <ac:chgData name="Narang, Sonali" userId="9e80b397-6e2f-49b1-9374-ccdad8589140" providerId="ADAL" clId="{EE43CF42-9091-0948-8ABB-0345272F62C4}" dt="2022-02-14T22:10:47.906" v="2656"/>
          <ac:picMkLst>
            <pc:docMk/>
            <pc:sldMk cId="743684689" sldId="267"/>
            <ac:picMk id="168" creationId="{D2C92B33-E6A9-9741-8CFA-F46B757ACD71}"/>
          </ac:picMkLst>
        </pc:picChg>
        <pc:picChg chg="mod modCrop">
          <ac:chgData name="Narang, Sonali" userId="9e80b397-6e2f-49b1-9374-ccdad8589140" providerId="ADAL" clId="{EE43CF42-9091-0948-8ABB-0345272F62C4}" dt="2022-02-14T22:21:44.994" v="2798" actId="1076"/>
          <ac:picMkLst>
            <pc:docMk/>
            <pc:sldMk cId="743684689" sldId="267"/>
            <ac:picMk id="169" creationId="{5A30999A-89D7-8C40-9571-87F0979C7EAA}"/>
          </ac:picMkLst>
        </pc:picChg>
        <pc:picChg chg="mod modCrop">
          <ac:chgData name="Narang, Sonali" userId="9e80b397-6e2f-49b1-9374-ccdad8589140" providerId="ADAL" clId="{EE43CF42-9091-0948-8ABB-0345272F62C4}" dt="2022-02-14T22:21:44.994" v="2798" actId="1076"/>
          <ac:picMkLst>
            <pc:docMk/>
            <pc:sldMk cId="743684689" sldId="267"/>
            <ac:picMk id="171" creationId="{9C4DDE62-3BC7-ED45-A82E-A3C21D506B79}"/>
          </ac:picMkLst>
        </pc:picChg>
        <pc:picChg chg="add mod modCrop">
          <ac:chgData name="Narang, Sonali" userId="9e80b397-6e2f-49b1-9374-ccdad8589140" providerId="ADAL" clId="{EE43CF42-9091-0948-8ABB-0345272F62C4}" dt="2022-02-14T22:42:03.339" v="3053" actId="1076"/>
          <ac:picMkLst>
            <pc:docMk/>
            <pc:sldMk cId="743684689" sldId="267"/>
            <ac:picMk id="188" creationId="{9087D8BC-5ADD-E842-9EC0-9741E41D32B0}"/>
          </ac:picMkLst>
        </pc:picChg>
      </pc:sldChg>
      <pc:sldChg chg="addSp delSp modSp mod modNotesTx">
        <pc:chgData name="Narang, Sonali" userId="9e80b397-6e2f-49b1-9374-ccdad8589140" providerId="ADAL" clId="{EE43CF42-9091-0948-8ABB-0345272F62C4}" dt="2022-02-23T20:10:31.196" v="3078" actId="113"/>
        <pc:sldMkLst>
          <pc:docMk/>
          <pc:sldMk cId="2078269342" sldId="277"/>
        </pc:sldMkLst>
        <pc:spChg chg="mod">
          <ac:chgData name="Narang, Sonali" userId="9e80b397-6e2f-49b1-9374-ccdad8589140" providerId="ADAL" clId="{EE43CF42-9091-0948-8ABB-0345272F62C4}" dt="2022-02-23T20:10:31.196" v="3078" actId="113"/>
          <ac:spMkLst>
            <pc:docMk/>
            <pc:sldMk cId="2078269342" sldId="277"/>
            <ac:spMk id="5" creationId="{FAFFEC37-A0C5-5846-8534-22E3DEF6CEF4}"/>
          </ac:spMkLst>
        </pc:spChg>
        <pc:spChg chg="mod">
          <ac:chgData name="Narang, Sonali" userId="9e80b397-6e2f-49b1-9374-ccdad8589140" providerId="ADAL" clId="{EE43CF42-9091-0948-8ABB-0345272F62C4}" dt="2022-02-23T20:10:31.196" v="3078" actId="113"/>
          <ac:spMkLst>
            <pc:docMk/>
            <pc:sldMk cId="2078269342" sldId="277"/>
            <ac:spMk id="7" creationId="{4C5F5CAE-FBFD-964D-A356-746AAC86DC9E}"/>
          </ac:spMkLst>
        </pc:spChg>
        <pc:spChg chg="mod">
          <ac:chgData name="Narang, Sonali" userId="9e80b397-6e2f-49b1-9374-ccdad8589140" providerId="ADAL" clId="{EE43CF42-9091-0948-8ABB-0345272F62C4}" dt="2022-02-23T20:10:31.196" v="3078" actId="113"/>
          <ac:spMkLst>
            <pc:docMk/>
            <pc:sldMk cId="2078269342" sldId="277"/>
            <ac:spMk id="30" creationId="{655ACA25-EBE0-DD45-930F-AD76C4C0A2A8}"/>
          </ac:spMkLst>
        </pc:spChg>
        <pc:spChg chg="mod">
          <ac:chgData name="Narang, Sonali" userId="9e80b397-6e2f-49b1-9374-ccdad8589140" providerId="ADAL" clId="{EE43CF42-9091-0948-8ABB-0345272F62C4}" dt="2022-02-14T20:40:10.140" v="2359" actId="20577"/>
          <ac:spMkLst>
            <pc:docMk/>
            <pc:sldMk cId="2078269342" sldId="277"/>
            <ac:spMk id="36" creationId="{CED63E59-2181-E94A-9EA3-55661FF9C194}"/>
          </ac:spMkLst>
        </pc:spChg>
        <pc:spChg chg="mod">
          <ac:chgData name="Narang, Sonali" userId="9e80b397-6e2f-49b1-9374-ccdad8589140" providerId="ADAL" clId="{EE43CF42-9091-0948-8ABB-0345272F62C4}" dt="2022-02-14T20:40:14.304" v="2362" actId="20577"/>
          <ac:spMkLst>
            <pc:docMk/>
            <pc:sldMk cId="2078269342" sldId="277"/>
            <ac:spMk id="39" creationId="{EEA44162-67BA-BE4E-87A0-CE62A3BB4A48}"/>
          </ac:spMkLst>
        </pc:spChg>
        <pc:spChg chg="mod">
          <ac:chgData name="Narang, Sonali" userId="9e80b397-6e2f-49b1-9374-ccdad8589140" providerId="ADAL" clId="{EE43CF42-9091-0948-8ABB-0345272F62C4}" dt="2022-02-23T20:10:31.196" v="3078" actId="113"/>
          <ac:spMkLst>
            <pc:docMk/>
            <pc:sldMk cId="2078269342" sldId="277"/>
            <ac:spMk id="72" creationId="{6EFCDAB7-F8A1-714A-A38C-A603CDFDE6F4}"/>
          </ac:spMkLst>
        </pc:spChg>
        <pc:picChg chg="add mod">
          <ac:chgData name="Narang, Sonali" userId="9e80b397-6e2f-49b1-9374-ccdad8589140" providerId="ADAL" clId="{EE43CF42-9091-0948-8ABB-0345272F62C4}" dt="2022-02-14T21:23:07.940" v="2405" actId="14100"/>
          <ac:picMkLst>
            <pc:docMk/>
            <pc:sldMk cId="2078269342" sldId="277"/>
            <ac:picMk id="3" creationId="{D75D91E9-A6E3-954D-BBBF-1D7A25FDD5A8}"/>
          </ac:picMkLst>
        </pc:picChg>
        <pc:picChg chg="add mod modCrop">
          <ac:chgData name="Narang, Sonali" userId="9e80b397-6e2f-49b1-9374-ccdad8589140" providerId="ADAL" clId="{EE43CF42-9091-0948-8ABB-0345272F62C4}" dt="2022-02-14T21:23:07.940" v="2405" actId="14100"/>
          <ac:picMkLst>
            <pc:docMk/>
            <pc:sldMk cId="2078269342" sldId="277"/>
            <ac:picMk id="8" creationId="{265E80FB-967E-E641-AA0E-27C00D11414A}"/>
          </ac:picMkLst>
        </pc:picChg>
        <pc:picChg chg="add mod modCrop">
          <ac:chgData name="Narang, Sonali" userId="9e80b397-6e2f-49b1-9374-ccdad8589140" providerId="ADAL" clId="{EE43CF42-9091-0948-8ABB-0345272F62C4}" dt="2022-02-14T21:23:07.940" v="2405" actId="14100"/>
          <ac:picMkLst>
            <pc:docMk/>
            <pc:sldMk cId="2078269342" sldId="277"/>
            <ac:picMk id="10" creationId="{76101781-C7BE-9C42-8B1A-22F8C263577B}"/>
          </ac:picMkLst>
        </pc:picChg>
        <pc:picChg chg="add mod">
          <ac:chgData name="Narang, Sonali" userId="9e80b397-6e2f-49b1-9374-ccdad8589140" providerId="ADAL" clId="{EE43CF42-9091-0948-8ABB-0345272F62C4}" dt="2022-02-14T21:23:12.834" v="2406" actId="1076"/>
          <ac:picMkLst>
            <pc:docMk/>
            <pc:sldMk cId="2078269342" sldId="277"/>
            <ac:picMk id="12" creationId="{8544D0DE-07B5-0C4E-8D80-A066A3CEBF40}"/>
          </ac:picMkLst>
        </pc:picChg>
        <pc:picChg chg="add mod">
          <ac:chgData name="Narang, Sonali" userId="9e80b397-6e2f-49b1-9374-ccdad8589140" providerId="ADAL" clId="{EE43CF42-9091-0948-8ABB-0345272F62C4}" dt="2022-02-14T21:23:12.834" v="2406" actId="1076"/>
          <ac:picMkLst>
            <pc:docMk/>
            <pc:sldMk cId="2078269342" sldId="277"/>
            <ac:picMk id="14" creationId="{747B9748-FCBA-2D4D-AF34-AB1604BF7918}"/>
          </ac:picMkLst>
        </pc:picChg>
        <pc:picChg chg="add mod">
          <ac:chgData name="Narang, Sonali" userId="9e80b397-6e2f-49b1-9374-ccdad8589140" providerId="ADAL" clId="{EE43CF42-9091-0948-8ABB-0345272F62C4}" dt="2022-02-14T21:23:12.834" v="2406" actId="1076"/>
          <ac:picMkLst>
            <pc:docMk/>
            <pc:sldMk cId="2078269342" sldId="277"/>
            <ac:picMk id="16" creationId="{F9797EBE-C2C2-ED45-8D6F-C95776584471}"/>
          </ac:picMkLst>
        </pc:picChg>
        <pc:picChg chg="add mod modCrop">
          <ac:chgData name="Narang, Sonali" userId="9e80b397-6e2f-49b1-9374-ccdad8589140" providerId="ADAL" clId="{EE43CF42-9091-0948-8ABB-0345272F62C4}" dt="2022-02-14T21:31:00.404" v="2429" actId="12789"/>
          <ac:picMkLst>
            <pc:docMk/>
            <pc:sldMk cId="2078269342" sldId="277"/>
            <ac:picMk id="18" creationId="{6821CDC2-5374-8348-98F5-C090BA03C8B8}"/>
          </ac:picMkLst>
        </pc:picChg>
        <pc:picChg chg="add mod">
          <ac:chgData name="Narang, Sonali" userId="9e80b397-6e2f-49b1-9374-ccdad8589140" providerId="ADAL" clId="{EE43CF42-9091-0948-8ABB-0345272F62C4}" dt="2022-02-14T21:31:00.404" v="2429" actId="12789"/>
          <ac:picMkLst>
            <pc:docMk/>
            <pc:sldMk cId="2078269342" sldId="277"/>
            <ac:picMk id="20" creationId="{E3C6EA1D-E6B3-B943-9F00-A3F1DA6DE0DC}"/>
          </ac:picMkLst>
        </pc:picChg>
        <pc:picChg chg="add mod modCrop">
          <ac:chgData name="Narang, Sonali" userId="9e80b397-6e2f-49b1-9374-ccdad8589140" providerId="ADAL" clId="{EE43CF42-9091-0948-8ABB-0345272F62C4}" dt="2022-02-14T21:31:00.404" v="2429" actId="12789"/>
          <ac:picMkLst>
            <pc:docMk/>
            <pc:sldMk cId="2078269342" sldId="277"/>
            <ac:picMk id="22" creationId="{C217648D-794D-E743-9395-81F06061CB77}"/>
          </ac:picMkLst>
        </pc:picChg>
        <pc:picChg chg="del">
          <ac:chgData name="Narang, Sonali" userId="9e80b397-6e2f-49b1-9374-ccdad8589140" providerId="ADAL" clId="{EE43CF42-9091-0948-8ABB-0345272F62C4}" dt="2022-02-14T21:20:09" v="2365" actId="478"/>
          <ac:picMkLst>
            <pc:docMk/>
            <pc:sldMk cId="2078269342" sldId="277"/>
            <ac:picMk id="66" creationId="{3947B4BD-5497-734B-B72A-856B61E23828}"/>
          </ac:picMkLst>
        </pc:picChg>
        <pc:picChg chg="del">
          <ac:chgData name="Narang, Sonali" userId="9e80b397-6e2f-49b1-9374-ccdad8589140" providerId="ADAL" clId="{EE43CF42-9091-0948-8ABB-0345272F62C4}" dt="2022-02-14T21:20:09" v="2365" actId="478"/>
          <ac:picMkLst>
            <pc:docMk/>
            <pc:sldMk cId="2078269342" sldId="277"/>
            <ac:picMk id="67" creationId="{35277A42-A4F2-E644-8DD1-70306EA4FB98}"/>
          </ac:picMkLst>
        </pc:picChg>
        <pc:picChg chg="del">
          <ac:chgData name="Narang, Sonali" userId="9e80b397-6e2f-49b1-9374-ccdad8589140" providerId="ADAL" clId="{EE43CF42-9091-0948-8ABB-0345272F62C4}" dt="2022-02-14T21:20:09" v="2365" actId="478"/>
          <ac:picMkLst>
            <pc:docMk/>
            <pc:sldMk cId="2078269342" sldId="277"/>
            <ac:picMk id="68" creationId="{8F8E5938-471E-244A-AC6A-995ED39B84DC}"/>
          </ac:picMkLst>
        </pc:picChg>
        <pc:picChg chg="del mod">
          <ac:chgData name="Narang, Sonali" userId="9e80b397-6e2f-49b1-9374-ccdad8589140" providerId="ADAL" clId="{EE43CF42-9091-0948-8ABB-0345272F62C4}" dt="2022-02-14T21:29:35.572" v="2408" actId="478"/>
          <ac:picMkLst>
            <pc:docMk/>
            <pc:sldMk cId="2078269342" sldId="277"/>
            <ac:picMk id="69" creationId="{6B3A249F-75CB-FC48-8C84-664E3D850410}"/>
          </ac:picMkLst>
        </pc:picChg>
        <pc:picChg chg="del mod">
          <ac:chgData name="Narang, Sonali" userId="9e80b397-6e2f-49b1-9374-ccdad8589140" providerId="ADAL" clId="{EE43CF42-9091-0948-8ABB-0345272F62C4}" dt="2022-02-14T21:29:35.572" v="2408" actId="478"/>
          <ac:picMkLst>
            <pc:docMk/>
            <pc:sldMk cId="2078269342" sldId="277"/>
            <ac:picMk id="70" creationId="{FF23310C-2E41-8843-8460-13FAE233DEF8}"/>
          </ac:picMkLst>
        </pc:picChg>
        <pc:picChg chg="del mod">
          <ac:chgData name="Narang, Sonali" userId="9e80b397-6e2f-49b1-9374-ccdad8589140" providerId="ADAL" clId="{EE43CF42-9091-0948-8ABB-0345272F62C4}" dt="2022-02-14T21:29:35.572" v="2408" actId="478"/>
          <ac:picMkLst>
            <pc:docMk/>
            <pc:sldMk cId="2078269342" sldId="277"/>
            <ac:picMk id="71" creationId="{0E8A457F-217F-2E4E-8670-43D6977E3918}"/>
          </ac:picMkLst>
        </pc:picChg>
        <pc:picChg chg="del">
          <ac:chgData name="Narang, Sonali" userId="9e80b397-6e2f-49b1-9374-ccdad8589140" providerId="ADAL" clId="{EE43CF42-9091-0948-8ABB-0345272F62C4}" dt="2022-02-14T21:21:42.152" v="2388" actId="478"/>
          <ac:picMkLst>
            <pc:docMk/>
            <pc:sldMk cId="2078269342" sldId="277"/>
            <ac:picMk id="73" creationId="{ECEFC19C-720B-AE4D-99C2-274672AB20E1}"/>
          </ac:picMkLst>
        </pc:picChg>
        <pc:picChg chg="del">
          <ac:chgData name="Narang, Sonali" userId="9e80b397-6e2f-49b1-9374-ccdad8589140" providerId="ADAL" clId="{EE43CF42-9091-0948-8ABB-0345272F62C4}" dt="2022-02-14T21:21:42.152" v="2388" actId="478"/>
          <ac:picMkLst>
            <pc:docMk/>
            <pc:sldMk cId="2078269342" sldId="277"/>
            <ac:picMk id="74" creationId="{FBB6F25E-F52E-B649-96A1-89ECC153CB27}"/>
          </ac:picMkLst>
        </pc:picChg>
        <pc:picChg chg="del">
          <ac:chgData name="Narang, Sonali" userId="9e80b397-6e2f-49b1-9374-ccdad8589140" providerId="ADAL" clId="{EE43CF42-9091-0948-8ABB-0345272F62C4}" dt="2022-02-14T21:21:42.152" v="2388" actId="478"/>
          <ac:picMkLst>
            <pc:docMk/>
            <pc:sldMk cId="2078269342" sldId="277"/>
            <ac:picMk id="75" creationId="{6D93B34D-FCFC-2347-8BDA-8740FF1F0AAA}"/>
          </ac:picMkLst>
        </pc:picChg>
      </pc:sldChg>
      <pc:sldChg chg="addSp delSp modSp mod modNotesTx">
        <pc:chgData name="Narang, Sonali" userId="9e80b397-6e2f-49b1-9374-ccdad8589140" providerId="ADAL" clId="{EE43CF42-9091-0948-8ABB-0345272F62C4}" dt="2022-02-23T20:10:07.067" v="3076" actId="113"/>
        <pc:sldMkLst>
          <pc:docMk/>
          <pc:sldMk cId="3214590643" sldId="280"/>
        </pc:sldMkLst>
        <pc:spChg chg="add mod">
          <ac:chgData name="Narang, Sonali" userId="9e80b397-6e2f-49b1-9374-ccdad8589140" providerId="ADAL" clId="{EE43CF42-9091-0948-8ABB-0345272F62C4}" dt="2022-02-23T20:10:07.067" v="3076" actId="113"/>
          <ac:spMkLst>
            <pc:docMk/>
            <pc:sldMk cId="3214590643" sldId="280"/>
            <ac:spMk id="15" creationId="{211CF65A-99E6-4C44-981B-639900C416DF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16" creationId="{9AA6DA1A-547E-E740-A7DE-4D3E9428D975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18" creationId="{4F6AE7EB-A8AE-B644-8BB7-1B67E1711E92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19" creationId="{3CDF3DE4-E6F5-904E-AEEF-2E2F33090B72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0" creationId="{EB145670-1380-FE4E-ACD7-79EE88439C49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1" creationId="{0B792D0C-8BB4-0947-A07E-FF2D1DBB8E0C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2" creationId="{39D15BCD-BAC2-8A4A-8156-F8FFD32CE0F9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4" creationId="{3F1B4E8E-B17F-9E4E-906D-FFE732068496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5" creationId="{CF0DECC4-F8AB-FB4C-8F96-C830577BECAB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6" creationId="{83DB0F14-0C77-0F4A-91C4-2709D28EEA0D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7" creationId="{74E22AC0-F636-2146-859F-B102168AE2E1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28" creationId="{B33B62D2-AC5B-0242-BF3A-1C97B6BF1228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0" creationId="{E11FA34D-9614-344A-BCBF-FED727435BDE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1" creationId="{C083AFDE-C178-344F-94FD-C06F72BD234D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2" creationId="{DC271ED5-F9FF-F64D-AA83-F38CB338BD83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3" creationId="{87A1685E-C5EA-7A47-A785-D0CB8A327AD8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4" creationId="{36C70D3D-7105-194B-BD2A-5AC21746DB94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35" creationId="{9625F34A-7DD6-174C-A63F-5A24459FC847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7" creationId="{1CF48F7B-8158-FF47-85DB-E99F16DDCB79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8" creationId="{D206E14B-98ED-0D43-A87A-B941379DD1E0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39" creationId="{FC226FCE-F2D8-5046-B8D3-4EC2E26FF608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40" creationId="{9DD9F170-0333-4A4B-95B4-14358B29DAF3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41" creationId="{9B73E9B4-C677-D443-BB1A-9F7D71615ECD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43" creationId="{D04D9EE2-FE6A-5746-BEFF-4E576038BE0D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44" creationId="{E1BEE2DB-BCB1-DA45-8BAF-ADBA597400A1}"/>
          </ac:spMkLst>
        </pc:spChg>
        <pc:spChg chg="mod">
          <ac:chgData name="Narang, Sonali" userId="9e80b397-6e2f-49b1-9374-ccdad8589140" providerId="ADAL" clId="{EE43CF42-9091-0948-8ABB-0345272F62C4}" dt="2022-02-23T20:10:07.067" v="3076" actId="113"/>
          <ac:spMkLst>
            <pc:docMk/>
            <pc:sldMk cId="3214590643" sldId="280"/>
            <ac:spMk id="46" creationId="{BC4BD7F9-9550-3841-BBB5-1A58285A1D88}"/>
          </ac:spMkLst>
        </pc:spChg>
        <pc:spChg chg="mod">
          <ac:chgData name="Narang, Sonali" userId="9e80b397-6e2f-49b1-9374-ccdad8589140" providerId="ADAL" clId="{EE43CF42-9091-0948-8ABB-0345272F62C4}" dt="2022-02-14T21:40:30.666" v="2582" actId="207"/>
          <ac:spMkLst>
            <pc:docMk/>
            <pc:sldMk cId="3214590643" sldId="280"/>
            <ac:spMk id="52" creationId="{13D20ECD-75DA-CB48-AB73-27583AD256B3}"/>
          </ac:spMkLst>
        </pc:spChg>
        <pc:spChg chg="mod">
          <ac:chgData name="Narang, Sonali" userId="9e80b397-6e2f-49b1-9374-ccdad8589140" providerId="ADAL" clId="{EE43CF42-9091-0948-8ABB-0345272F62C4}" dt="2022-02-14T21:40:22.703" v="2581" actId="207"/>
          <ac:spMkLst>
            <pc:docMk/>
            <pc:sldMk cId="3214590643" sldId="280"/>
            <ac:spMk id="53" creationId="{72B26A3D-2449-094B-918A-006D11D011C7}"/>
          </ac:spMkLst>
        </pc:spChg>
        <pc:spChg chg="mod">
          <ac:chgData name="Narang, Sonali" userId="9e80b397-6e2f-49b1-9374-ccdad8589140" providerId="ADAL" clId="{EE43CF42-9091-0948-8ABB-0345272F62C4}" dt="2022-02-14T21:40:30.666" v="2582" actId="207"/>
          <ac:spMkLst>
            <pc:docMk/>
            <pc:sldMk cId="3214590643" sldId="280"/>
            <ac:spMk id="54" creationId="{084ECCF1-F533-6F4A-9C79-1AAA859168B6}"/>
          </ac:spMkLst>
        </pc:spChg>
        <pc:spChg chg="mod">
          <ac:chgData name="Narang, Sonali" userId="9e80b397-6e2f-49b1-9374-ccdad8589140" providerId="ADAL" clId="{EE43CF42-9091-0948-8ABB-0345272F62C4}" dt="2022-02-14T21:40:22.703" v="2581" actId="207"/>
          <ac:spMkLst>
            <pc:docMk/>
            <pc:sldMk cId="3214590643" sldId="280"/>
            <ac:spMk id="55" creationId="{EC16123A-63C0-9E49-A1F8-E06C9FD3873D}"/>
          </ac:spMkLst>
        </pc:spChg>
        <pc:spChg chg="mod">
          <ac:chgData name="Narang, Sonali" userId="9e80b397-6e2f-49b1-9374-ccdad8589140" providerId="ADAL" clId="{EE43CF42-9091-0948-8ABB-0345272F62C4}" dt="2022-02-14T21:40:30.666" v="2582" actId="207"/>
          <ac:spMkLst>
            <pc:docMk/>
            <pc:sldMk cId="3214590643" sldId="280"/>
            <ac:spMk id="56" creationId="{66A1DC14-DA92-D74F-8544-24D33215BD1A}"/>
          </ac:spMkLst>
        </pc:spChg>
        <pc:spChg chg="mod">
          <ac:chgData name="Narang, Sonali" userId="9e80b397-6e2f-49b1-9374-ccdad8589140" providerId="ADAL" clId="{EE43CF42-9091-0948-8ABB-0345272F62C4}" dt="2022-02-14T21:40:37.704" v="2587" actId="1038"/>
          <ac:spMkLst>
            <pc:docMk/>
            <pc:sldMk cId="3214590643" sldId="280"/>
            <ac:spMk id="57" creationId="{15A87318-8965-524D-9D27-FA6E4D625EA4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58" creationId="{4CF07939-36EC-684E-9F19-5CAD2E31195E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59" creationId="{F3B7F0C1-9559-A743-A25F-003C1BBD2C6A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0" creationId="{9EDC8C42-EAA1-1E45-B8B0-BFACC421DFEF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2" creationId="{E0E6A408-7609-1549-AC8A-7D56D481A972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3" creationId="{21B8414A-D65A-D24B-AC3E-BE249551AE15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4" creationId="{AA9347AF-3E7F-3442-84C0-0DF8EE048072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5" creationId="{892435A8-3EEC-0247-84E8-267CC82FC3EB}"/>
          </ac:spMkLst>
        </pc:spChg>
        <pc:spChg chg="mod">
          <ac:chgData name="Narang, Sonali" userId="9e80b397-6e2f-49b1-9374-ccdad8589140" providerId="ADAL" clId="{EE43CF42-9091-0948-8ABB-0345272F62C4}" dt="2022-02-14T19:47:26.002" v="1332"/>
          <ac:spMkLst>
            <pc:docMk/>
            <pc:sldMk cId="3214590643" sldId="280"/>
            <ac:spMk id="66" creationId="{ECF4078B-AF88-A841-924D-3124928EB857}"/>
          </ac:spMkLst>
        </pc:spChg>
        <pc:spChg chg="add mod">
          <ac:chgData name="Narang, Sonali" userId="9e80b397-6e2f-49b1-9374-ccdad8589140" providerId="ADAL" clId="{EE43CF42-9091-0948-8ABB-0345272F62C4}" dt="2022-02-23T20:10:07.067" v="3076" actId="113"/>
          <ac:spMkLst>
            <pc:docMk/>
            <pc:sldMk cId="3214590643" sldId="280"/>
            <ac:spMk id="69" creationId="{54A5D94C-10A5-B344-9D6B-7B82866EB4D4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0" creationId="{377EBF6C-532D-DD4F-934A-DD0A580780F0}"/>
          </ac:spMkLst>
        </pc:spChg>
        <pc:spChg chg="add mod">
          <ac:chgData name="Narang, Sonali" userId="9e80b397-6e2f-49b1-9374-ccdad8589140" providerId="ADAL" clId="{EE43CF42-9091-0948-8ABB-0345272F62C4}" dt="2022-02-14T21:45:58.081" v="2594" actId="20577"/>
          <ac:spMkLst>
            <pc:docMk/>
            <pc:sldMk cId="3214590643" sldId="280"/>
            <ac:spMk id="71" creationId="{0D6959C8-9056-B741-AB9C-8C48753F1A02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2" creationId="{B2F32DEB-08D1-A849-A53F-996DAE002B3E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3" creationId="{F63242C5-E386-4B4F-AB32-C1E8C438E4B7}"/>
          </ac:spMkLst>
        </pc:spChg>
        <pc:spChg chg="add mod">
          <ac:chgData name="Narang, Sonali" userId="9e80b397-6e2f-49b1-9374-ccdad8589140" providerId="ADAL" clId="{EE43CF42-9091-0948-8ABB-0345272F62C4}" dt="2022-02-14T21:46:01.441" v="2595" actId="20577"/>
          <ac:spMkLst>
            <pc:docMk/>
            <pc:sldMk cId="3214590643" sldId="280"/>
            <ac:spMk id="74" creationId="{8700B1DC-6B41-9143-A97A-706F7BC32A05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5" creationId="{D18304B1-A221-7541-91E3-0B91523E4049}"/>
          </ac:spMkLst>
        </pc:spChg>
        <pc:spChg chg="add mod">
          <ac:chgData name="Narang, Sonali" userId="9e80b397-6e2f-49b1-9374-ccdad8589140" providerId="ADAL" clId="{EE43CF42-9091-0948-8ABB-0345272F62C4}" dt="2022-02-14T21:41:14.809" v="2591" actId="1076"/>
          <ac:spMkLst>
            <pc:docMk/>
            <pc:sldMk cId="3214590643" sldId="280"/>
            <ac:spMk id="76" creationId="{CF41EF2A-279F-1E46-A78F-FE9B71283731}"/>
          </ac:spMkLst>
        </pc:spChg>
        <pc:spChg chg="add mod">
          <ac:chgData name="Narang, Sonali" userId="9e80b397-6e2f-49b1-9374-ccdad8589140" providerId="ADAL" clId="{EE43CF42-9091-0948-8ABB-0345272F62C4}" dt="2022-02-14T21:41:14.809" v="2591" actId="1076"/>
          <ac:spMkLst>
            <pc:docMk/>
            <pc:sldMk cId="3214590643" sldId="280"/>
            <ac:spMk id="77" creationId="{C08735D1-87D4-424C-8AA2-049A8E71D39F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8" creationId="{4B150F7E-E14F-884B-AF56-AD0D66EDEC4B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79" creationId="{AC1565AC-A829-BE45-81CF-A7A15D14E1E8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0" creationId="{0DFF70DA-3C3E-C444-ABBB-DEE4C6F12A89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1" creationId="{4887F105-3363-884D-927F-1B7D4BBA0D0C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2" creationId="{98D110E3-594F-BE4F-911B-8C04AA0C0A83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3" creationId="{44A86E99-D8B2-414B-9E43-8E13C16A108C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4" creationId="{DB9D99CF-E5B2-7B4E-A02F-503EA7742BF6}"/>
          </ac:spMkLst>
        </pc:spChg>
        <pc:spChg chg="add mod">
          <ac:chgData name="Narang, Sonali" userId="9e80b397-6e2f-49b1-9374-ccdad8589140" providerId="ADAL" clId="{EE43CF42-9091-0948-8ABB-0345272F62C4}" dt="2022-02-14T19:47:35.356" v="1334" actId="1076"/>
          <ac:spMkLst>
            <pc:docMk/>
            <pc:sldMk cId="3214590643" sldId="280"/>
            <ac:spMk id="85" creationId="{A2A1EFDB-1747-2143-B850-6C497E66EA58}"/>
          </ac:spMkLst>
        </pc:spChg>
        <pc:grpChg chg="add mod">
          <ac:chgData name="Narang, Sonali" userId="9e80b397-6e2f-49b1-9374-ccdad8589140" providerId="ADAL" clId="{EE43CF42-9091-0948-8ABB-0345272F62C4}" dt="2022-02-14T21:41:14.809" v="2591" actId="1076"/>
          <ac:grpSpMkLst>
            <pc:docMk/>
            <pc:sldMk cId="3214590643" sldId="280"/>
            <ac:grpSpMk id="8" creationId="{45FEEB36-25D9-5F49-85E7-2D0851625267}"/>
          </ac:grpSpMkLst>
        </pc:grpChg>
        <pc:grpChg chg="add mod">
          <ac:chgData name="Narang, Sonali" userId="9e80b397-6e2f-49b1-9374-ccdad8589140" providerId="ADAL" clId="{EE43CF42-9091-0948-8ABB-0345272F62C4}" dt="2022-02-14T21:41:14.809" v="2591" actId="1076"/>
          <ac:grpSpMkLst>
            <pc:docMk/>
            <pc:sldMk cId="3214590643" sldId="280"/>
            <ac:grpSpMk id="9" creationId="{C7F38601-1F0A-4A4B-9DDB-F655C1D9971E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17" creationId="{573ABB7A-0782-1644-85BA-ED76A40FE3C1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23" creationId="{B9AAD83E-AF17-A14E-86B8-693AB429AD58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29" creationId="{68E65BB8-C2F9-894D-857D-C6EDBEF9C86B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36" creationId="{8E30931A-6B51-454A-B3A5-0D0EDDA4E58D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42" creationId="{FD1DE14A-3BA9-8246-877B-49D04AB878B7}"/>
          </ac:grpSpMkLst>
        </pc:grpChg>
        <pc:grpChg chg="mod">
          <ac:chgData name="Narang, Sonali" userId="9e80b397-6e2f-49b1-9374-ccdad8589140" providerId="ADAL" clId="{EE43CF42-9091-0948-8ABB-0345272F62C4}" dt="2022-02-14T21:37:46.011" v="2431" actId="1076"/>
          <ac:grpSpMkLst>
            <pc:docMk/>
            <pc:sldMk cId="3214590643" sldId="280"/>
            <ac:grpSpMk id="47" creationId="{4B802D37-9378-E54E-99B5-1E00E308EBB8}"/>
          </ac:grpSpMkLst>
        </pc:grpChg>
        <pc:grpChg chg="add mod">
          <ac:chgData name="Narang, Sonali" userId="9e80b397-6e2f-49b1-9374-ccdad8589140" providerId="ADAL" clId="{EE43CF42-9091-0948-8ABB-0345272F62C4}" dt="2022-02-14T19:47:35.356" v="1334" actId="1076"/>
          <ac:grpSpMkLst>
            <pc:docMk/>
            <pc:sldMk cId="3214590643" sldId="280"/>
            <ac:grpSpMk id="61" creationId="{8AC76810-FF5B-6642-944E-F61FEFF0D008}"/>
          </ac:grpSpMkLst>
        </pc:grpChg>
        <pc:graphicFrameChg chg="add mod modGraphic">
          <ac:chgData name="Narang, Sonali" userId="9e80b397-6e2f-49b1-9374-ccdad8589140" providerId="ADAL" clId="{EE43CF42-9091-0948-8ABB-0345272F62C4}" dt="2022-02-14T21:41:22.847" v="2592" actId="1076"/>
          <ac:graphicFrameMkLst>
            <pc:docMk/>
            <pc:sldMk cId="3214590643" sldId="280"/>
            <ac:graphicFrameMk id="67" creationId="{D446A5C9-0020-E549-88A4-B747B41C87E5}"/>
          </ac:graphicFrameMkLst>
        </pc:graphicFrameChg>
        <pc:graphicFrameChg chg="add del mod modGraphic">
          <ac:chgData name="Narang, Sonali" userId="9e80b397-6e2f-49b1-9374-ccdad8589140" providerId="ADAL" clId="{EE43CF42-9091-0948-8ABB-0345272F62C4}" dt="2022-02-14T20:03:08.895" v="1610" actId="478"/>
          <ac:graphicFrameMkLst>
            <pc:docMk/>
            <pc:sldMk cId="3214590643" sldId="280"/>
            <ac:graphicFrameMk id="68" creationId="{9D2FB34E-D294-3D47-AEA2-9F98BD2790E4}"/>
          </ac:graphicFrameMkLst>
        </pc:graphicFrameChg>
        <pc:picChg chg="add mod modCrop">
          <ac:chgData name="Narang, Sonali" userId="9e80b397-6e2f-49b1-9374-ccdad8589140" providerId="ADAL" clId="{EE43CF42-9091-0948-8ABB-0345272F62C4}" dt="2022-02-14T21:39:36.750" v="2462" actId="167"/>
          <ac:picMkLst>
            <pc:docMk/>
            <pc:sldMk cId="3214590643" sldId="280"/>
            <ac:picMk id="3" creationId="{4E5F250C-B970-F74D-9C24-941D57EE1E17}"/>
          </ac:picMkLst>
        </pc:picChg>
        <pc:picChg chg="add mod modCrop">
          <ac:chgData name="Narang, Sonali" userId="9e80b397-6e2f-49b1-9374-ccdad8589140" providerId="ADAL" clId="{EE43CF42-9091-0948-8ABB-0345272F62C4}" dt="2022-02-14T21:39:36.750" v="2462" actId="167"/>
          <ac:picMkLst>
            <pc:docMk/>
            <pc:sldMk cId="3214590643" sldId="280"/>
            <ac:picMk id="5" creationId="{4A0CFB63-C7C0-7D4D-A844-75A0A5C142C2}"/>
          </ac:picMkLst>
        </pc:picChg>
        <pc:picChg chg="add mod">
          <ac:chgData name="Narang, Sonali" userId="9e80b397-6e2f-49b1-9374-ccdad8589140" providerId="ADAL" clId="{EE43CF42-9091-0948-8ABB-0345272F62C4}" dt="2022-02-14T21:39:36.750" v="2462" actId="167"/>
          <ac:picMkLst>
            <pc:docMk/>
            <pc:sldMk cId="3214590643" sldId="280"/>
            <ac:picMk id="7" creationId="{99E36C8A-0E2D-5741-B832-D5F914AF5CF6}"/>
          </ac:picMkLst>
        </pc:picChg>
        <pc:picChg chg="del">
          <ac:chgData name="Narang, Sonali" userId="9e80b397-6e2f-49b1-9374-ccdad8589140" providerId="ADAL" clId="{EE43CF42-9091-0948-8ABB-0345272F62C4}" dt="2022-02-14T21:37:48.645" v="2432" actId="478"/>
          <ac:picMkLst>
            <pc:docMk/>
            <pc:sldMk cId="3214590643" sldId="280"/>
            <ac:picMk id="48" creationId="{71EC7F28-AF86-854B-AEC4-D136C4D112AF}"/>
          </ac:picMkLst>
        </pc:picChg>
        <pc:picChg chg="del">
          <ac:chgData name="Narang, Sonali" userId="9e80b397-6e2f-49b1-9374-ccdad8589140" providerId="ADAL" clId="{EE43CF42-9091-0948-8ABB-0345272F62C4}" dt="2022-02-14T21:37:48.645" v="2432" actId="478"/>
          <ac:picMkLst>
            <pc:docMk/>
            <pc:sldMk cId="3214590643" sldId="280"/>
            <ac:picMk id="49" creationId="{320DEF64-F03D-F749-82F9-2F66ECE826C5}"/>
          </ac:picMkLst>
        </pc:picChg>
        <pc:picChg chg="del">
          <ac:chgData name="Narang, Sonali" userId="9e80b397-6e2f-49b1-9374-ccdad8589140" providerId="ADAL" clId="{EE43CF42-9091-0948-8ABB-0345272F62C4}" dt="2022-02-14T21:37:48.645" v="2432" actId="478"/>
          <ac:picMkLst>
            <pc:docMk/>
            <pc:sldMk cId="3214590643" sldId="280"/>
            <ac:picMk id="50" creationId="{EC1A4915-BF55-6D40-8B7A-411B554E98BC}"/>
          </ac:picMkLst>
        </pc:picChg>
        <pc:picChg chg="del">
          <ac:chgData name="Narang, Sonali" userId="9e80b397-6e2f-49b1-9374-ccdad8589140" providerId="ADAL" clId="{EE43CF42-9091-0948-8ABB-0345272F62C4}" dt="2022-02-14T21:37:53.535" v="2433" actId="478"/>
          <ac:picMkLst>
            <pc:docMk/>
            <pc:sldMk cId="3214590643" sldId="280"/>
            <ac:picMk id="51" creationId="{4B809755-A9B7-254D-B48B-424B311B6CF3}"/>
          </ac:picMkLst>
        </pc:picChg>
      </pc:sldChg>
      <pc:sldChg chg="del">
        <pc:chgData name="Narang, Sonali" userId="9e80b397-6e2f-49b1-9374-ccdad8589140" providerId="ADAL" clId="{EE43CF42-9091-0948-8ABB-0345272F62C4}" dt="2022-02-10T19:27:25.888" v="46" actId="2696"/>
        <pc:sldMkLst>
          <pc:docMk/>
          <pc:sldMk cId="3228625230" sldId="289"/>
        </pc:sldMkLst>
      </pc:sldChg>
      <pc:sldChg chg="modSp mod modNotesTx">
        <pc:chgData name="Narang, Sonali" userId="9e80b397-6e2f-49b1-9374-ccdad8589140" providerId="ADAL" clId="{EE43CF42-9091-0948-8ABB-0345272F62C4}" dt="2022-02-23T20:23:36.664" v="3081" actId="20577"/>
        <pc:sldMkLst>
          <pc:docMk/>
          <pc:sldMk cId="2292075898" sldId="290"/>
        </pc:sldMkLst>
        <pc:spChg chg="mod">
          <ac:chgData name="Narang, Sonali" userId="9e80b397-6e2f-49b1-9374-ccdad8589140" providerId="ADAL" clId="{EE43CF42-9091-0948-8ABB-0345272F62C4}" dt="2022-02-21T00:27:49.748" v="3071" actId="20577"/>
          <ac:spMkLst>
            <pc:docMk/>
            <pc:sldMk cId="2292075898" sldId="290"/>
            <ac:spMk id="4" creationId="{F6669B9D-B042-D548-BD0F-97015091799B}"/>
          </ac:spMkLst>
        </pc:spChg>
      </pc:sldChg>
      <pc:sldChg chg="modSp del mod modNotesTx">
        <pc:chgData name="Narang, Sonali" userId="9e80b397-6e2f-49b1-9374-ccdad8589140" providerId="ADAL" clId="{EE43CF42-9091-0948-8ABB-0345272F62C4}" dt="2022-02-21T00:27:42.606" v="3067" actId="2696"/>
        <pc:sldMkLst>
          <pc:docMk/>
          <pc:sldMk cId="2856672376" sldId="291"/>
        </pc:sldMkLst>
        <pc:spChg chg="mod">
          <ac:chgData name="Narang, Sonali" userId="9e80b397-6e2f-49b1-9374-ccdad8589140" providerId="ADAL" clId="{EE43CF42-9091-0948-8ABB-0345272F62C4}" dt="2022-02-10T19:27:48.215" v="48" actId="1076"/>
          <ac:spMkLst>
            <pc:docMk/>
            <pc:sldMk cId="2856672376" sldId="291"/>
            <ac:spMk id="12" creationId="{31606FD8-5728-9D4A-95DD-454ACBFD8CA6}"/>
          </ac:spMkLst>
        </pc:spChg>
        <pc:spChg chg="mod">
          <ac:chgData name="Narang, Sonali" userId="9e80b397-6e2f-49b1-9374-ccdad8589140" providerId="ADAL" clId="{EE43CF42-9091-0948-8ABB-0345272F62C4}" dt="2022-02-10T19:27:48.215" v="48" actId="1076"/>
          <ac:spMkLst>
            <pc:docMk/>
            <pc:sldMk cId="2856672376" sldId="291"/>
            <ac:spMk id="13" creationId="{11A1380E-3E08-254E-96AE-9121C17A4CBD}"/>
          </ac:spMkLst>
        </pc:spChg>
        <pc:graphicFrameChg chg="mod modGraphic">
          <ac:chgData name="Narang, Sonali" userId="9e80b397-6e2f-49b1-9374-ccdad8589140" providerId="ADAL" clId="{EE43CF42-9091-0948-8ABB-0345272F62C4}" dt="2022-02-18T13:52:08.177" v="3056" actId="20577"/>
          <ac:graphicFrameMkLst>
            <pc:docMk/>
            <pc:sldMk cId="2856672376" sldId="291"/>
            <ac:graphicFrameMk id="10" creationId="{DF601479-C34D-1449-B26E-C8EB919E8EE6}"/>
          </ac:graphicFrameMkLst>
        </pc:graphicFrameChg>
        <pc:graphicFrameChg chg="mod modGraphic">
          <ac:chgData name="Narang, Sonali" userId="9e80b397-6e2f-49b1-9374-ccdad8589140" providerId="ADAL" clId="{EE43CF42-9091-0948-8ABB-0345272F62C4}" dt="2022-02-18T13:52:22.545" v="3066" actId="20577"/>
          <ac:graphicFrameMkLst>
            <pc:docMk/>
            <pc:sldMk cId="2856672376" sldId="291"/>
            <ac:graphicFrameMk id="11" creationId="{B692A8E4-A415-F14E-8B83-E4DD77BD84F0}"/>
          </ac:graphicFrameMkLst>
        </pc:graphicFrameChg>
      </pc:sldChg>
      <pc:sldChg chg="modSp mod modNotesTx">
        <pc:chgData name="Narang, Sonali" userId="9e80b397-6e2f-49b1-9374-ccdad8589140" providerId="ADAL" clId="{EE43CF42-9091-0948-8ABB-0345272F62C4}" dt="2022-02-23T20:23:53.865" v="3083" actId="20577"/>
        <pc:sldMkLst>
          <pc:docMk/>
          <pc:sldMk cId="2985018669" sldId="292"/>
        </pc:sldMkLst>
        <pc:spChg chg="mod">
          <ac:chgData name="Narang, Sonali" userId="9e80b397-6e2f-49b1-9374-ccdad8589140" providerId="ADAL" clId="{EE43CF42-9091-0948-8ABB-0345272F62C4}" dt="2022-02-21T00:27:45.630" v="3069" actId="20577"/>
          <ac:spMkLst>
            <pc:docMk/>
            <pc:sldMk cId="2985018669" sldId="292"/>
            <ac:spMk id="4" creationId="{F6669B9D-B042-D548-BD0F-97015091799B}"/>
          </ac:spMkLst>
        </pc:spChg>
        <pc:spChg chg="mod">
          <ac:chgData name="Narang, Sonali" userId="9e80b397-6e2f-49b1-9374-ccdad8589140" providerId="ADAL" clId="{EE43CF42-9091-0948-8ABB-0345272F62C4}" dt="2022-02-10T19:27:53.841" v="49" actId="1076"/>
          <ac:spMkLst>
            <pc:docMk/>
            <pc:sldMk cId="2985018669" sldId="292"/>
            <ac:spMk id="7" creationId="{CB9C2CA2-B854-C447-B990-0E438B105C86}"/>
          </ac:spMkLst>
        </pc:spChg>
      </pc:sldChg>
      <pc:sldChg chg="modNotesTx">
        <pc:chgData name="Narang, Sonali" userId="9e80b397-6e2f-49b1-9374-ccdad8589140" providerId="ADAL" clId="{EE43CF42-9091-0948-8ABB-0345272F62C4}" dt="2022-02-14T20:05:46.295" v="1873" actId="20577"/>
        <pc:sldMkLst>
          <pc:docMk/>
          <pc:sldMk cId="2574176189" sldId="294"/>
        </pc:sldMkLst>
      </pc:sldChg>
      <pc:sldChg chg="addSp delSp modSp del mod">
        <pc:chgData name="Narang, Sonali" userId="9e80b397-6e2f-49b1-9374-ccdad8589140" providerId="ADAL" clId="{EE43CF42-9091-0948-8ABB-0345272F62C4}" dt="2022-02-14T19:47:47.041" v="1339" actId="2696"/>
        <pc:sldMkLst>
          <pc:docMk/>
          <pc:sldMk cId="4154367766" sldId="295"/>
        </pc:sldMkLst>
        <pc:spChg chg="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15" creationId="{41475153-9CCC-1C49-81B0-27247F124E6D}"/>
          </ac:spMkLst>
        </pc:spChg>
        <pc:spChg chg="del">
          <ac:chgData name="Narang, Sonali" userId="9e80b397-6e2f-49b1-9374-ccdad8589140" providerId="ADAL" clId="{EE43CF42-9091-0948-8ABB-0345272F62C4}" dt="2022-02-11T17:15:41.505" v="76" actId="478"/>
          <ac:spMkLst>
            <pc:docMk/>
            <pc:sldMk cId="4154367766" sldId="295"/>
            <ac:spMk id="22" creationId="{B1BB7369-2013-E24A-B30C-28378B7018C1}"/>
          </ac:spMkLst>
        </pc:spChg>
        <pc:spChg chg="del mod">
          <ac:chgData name="Narang, Sonali" userId="9e80b397-6e2f-49b1-9374-ccdad8589140" providerId="ADAL" clId="{EE43CF42-9091-0948-8ABB-0345272F62C4}" dt="2022-02-11T18:23:38.573" v="289" actId="478"/>
          <ac:spMkLst>
            <pc:docMk/>
            <pc:sldMk cId="4154367766" sldId="295"/>
            <ac:spMk id="23" creationId="{E7E24790-13CF-854B-9A4A-E42EE3056D34}"/>
          </ac:spMkLst>
        </pc:spChg>
        <pc:spChg chg="del">
          <ac:chgData name="Narang, Sonali" userId="9e80b397-6e2f-49b1-9374-ccdad8589140" providerId="ADAL" clId="{EE43CF42-9091-0948-8ABB-0345272F62C4}" dt="2022-02-11T17:15:41.505" v="76" actId="478"/>
          <ac:spMkLst>
            <pc:docMk/>
            <pc:sldMk cId="4154367766" sldId="295"/>
            <ac:spMk id="24" creationId="{8F8114E8-A901-F14A-8FF5-35B3C135810E}"/>
          </ac:spMkLst>
        </pc:spChg>
        <pc:spChg chg="del">
          <ac:chgData name="Narang, Sonali" userId="9e80b397-6e2f-49b1-9374-ccdad8589140" providerId="ADAL" clId="{EE43CF42-9091-0948-8ABB-0345272F62C4}" dt="2022-02-11T17:15:41.505" v="76" actId="478"/>
          <ac:spMkLst>
            <pc:docMk/>
            <pc:sldMk cId="4154367766" sldId="295"/>
            <ac:spMk id="25" creationId="{77F91B42-3441-7A46-8B49-D253FA8EA588}"/>
          </ac:spMkLst>
        </pc:spChg>
        <pc:spChg chg="del">
          <ac:chgData name="Narang, Sonali" userId="9e80b397-6e2f-49b1-9374-ccdad8589140" providerId="ADAL" clId="{EE43CF42-9091-0948-8ABB-0345272F62C4}" dt="2022-02-10T19:18:10.276" v="12" actId="21"/>
          <ac:spMkLst>
            <pc:docMk/>
            <pc:sldMk cId="4154367766" sldId="295"/>
            <ac:spMk id="26" creationId="{E2024997-0160-E54E-8E02-2782E50AEC23}"/>
          </ac:spMkLst>
        </pc:spChg>
        <pc:spChg chg="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46" creationId="{BC4BD7F9-9550-3841-BBB5-1A58285A1D88}"/>
          </ac:spMkLst>
        </pc:spChg>
        <pc:spChg chg="add del mod">
          <ac:chgData name="Narang, Sonali" userId="9e80b397-6e2f-49b1-9374-ccdad8589140" providerId="ADAL" clId="{EE43CF42-9091-0948-8ABB-0345272F62C4}" dt="2022-02-11T18:21:55.555" v="251" actId="478"/>
          <ac:spMkLst>
            <pc:docMk/>
            <pc:sldMk cId="4154367766" sldId="295"/>
            <ac:spMk id="52" creationId="{B01520C8-1E2F-D047-AF98-0A201DF1B975}"/>
          </ac:spMkLst>
        </pc:spChg>
        <pc:spChg chg="add del mod">
          <ac:chgData name="Narang, Sonali" userId="9e80b397-6e2f-49b1-9374-ccdad8589140" providerId="ADAL" clId="{EE43CF42-9091-0948-8ABB-0345272F62C4}" dt="2022-02-11T18:21:55.555" v="251" actId="478"/>
          <ac:spMkLst>
            <pc:docMk/>
            <pc:sldMk cId="4154367766" sldId="295"/>
            <ac:spMk id="53" creationId="{ACEF01A8-EF81-A049-80A5-2683CA634801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4" creationId="{4798F880-BCBC-0D4E-90E4-5BA126897CF0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5" creationId="{58CE4741-6EC9-1B4C-A5A5-A6C3BC7924FF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6" creationId="{C3CE1154-B548-1D49-BCC9-30FF94F87974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7" creationId="{280DCD09-D18B-D845-9FEF-4C93E7400D9B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8" creationId="{7E1FC74A-77C0-FB4A-ABB3-F1936FFB7E08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59" creationId="{1BD377E3-AFD9-FF42-A180-B886443C39CF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0" creationId="{0F86524A-6586-C045-A3AF-0299903185AB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1" creationId="{76A7EC39-8B1B-2447-B19E-B08E95B32F7D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2" creationId="{B131C179-897B-564B-9440-50F2A94FF9DE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3" creationId="{AF904615-DF73-F740-ACD8-06109D17C6BF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4" creationId="{0B6B4852-22E0-D54F-B425-E8DCABFB7579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5" creationId="{007C0416-A2FB-8646-9C21-C4BE90E5B4BE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6" creationId="{C07803C1-F5CD-A741-8C9E-0E6CE43F612D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7" creationId="{61B5B1BE-4D8D-614E-9295-E92874A822C0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8" creationId="{BF98CAC3-3237-E84C-8711-BA5455EB443D}"/>
          </ac:spMkLst>
        </pc:spChg>
        <pc:spChg chg="add 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69" creationId="{F60D0E96-EDBF-0140-9D71-16CC86E30AEF}"/>
          </ac:spMkLst>
        </pc:spChg>
        <pc:spChg chg="del mod">
          <ac:chgData name="Narang, Sonali" userId="9e80b397-6e2f-49b1-9374-ccdad8589140" providerId="ADAL" clId="{EE43CF42-9091-0948-8ABB-0345272F62C4}" dt="2022-02-11T17:15:02.763" v="50" actId="478"/>
          <ac:spMkLst>
            <pc:docMk/>
            <pc:sldMk cId="4154367766" sldId="295"/>
            <ac:spMk id="70" creationId="{F91B81AD-A47C-3741-A21D-BD8E4AF3372B}"/>
          </ac:spMkLst>
        </pc:spChg>
        <pc:spChg chg="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71" creationId="{6C9E9C38-430D-6B4D-8D7A-964AAF818C18}"/>
          </ac:spMkLst>
        </pc:spChg>
        <pc:spChg chg="mod">
          <ac:chgData name="Narang, Sonali" userId="9e80b397-6e2f-49b1-9374-ccdad8589140" providerId="ADAL" clId="{EE43CF42-9091-0948-8ABB-0345272F62C4}" dt="2022-02-11T17:16:52.313" v="110" actId="1038"/>
          <ac:spMkLst>
            <pc:docMk/>
            <pc:sldMk cId="4154367766" sldId="295"/>
            <ac:spMk id="77" creationId="{856BFEB2-255E-D34D-BBFB-000EB719D7D4}"/>
          </ac:spMkLst>
        </pc:spChg>
        <pc:spChg chg="del mod">
          <ac:chgData name="Narang, Sonali" userId="9e80b397-6e2f-49b1-9374-ccdad8589140" providerId="ADAL" clId="{EE43CF42-9091-0948-8ABB-0345272F62C4}" dt="2022-02-10T19:24:02.202" v="14" actId="478"/>
          <ac:spMkLst>
            <pc:docMk/>
            <pc:sldMk cId="4154367766" sldId="295"/>
            <ac:spMk id="78" creationId="{5CF15D04-924B-9E45-B013-9F8B35A58231}"/>
          </ac:spMkLst>
        </pc:spChg>
        <pc:spChg chg="del mod">
          <ac:chgData name="Narang, Sonali" userId="9e80b397-6e2f-49b1-9374-ccdad8589140" providerId="ADAL" clId="{EE43CF42-9091-0948-8ABB-0345272F62C4}" dt="2022-02-11T18:23:38.573" v="289" actId="478"/>
          <ac:spMkLst>
            <pc:docMk/>
            <pc:sldMk cId="4154367766" sldId="295"/>
            <ac:spMk id="79" creationId="{E4CF7FFC-E10C-4C44-B383-ED58BE00B4E0}"/>
          </ac:spMkLst>
        </pc:spChg>
        <pc:spChg chg="del mod">
          <ac:chgData name="Narang, Sonali" userId="9e80b397-6e2f-49b1-9374-ccdad8589140" providerId="ADAL" clId="{EE43CF42-9091-0948-8ABB-0345272F62C4}" dt="2022-02-10T19:24:02.202" v="14" actId="478"/>
          <ac:spMkLst>
            <pc:docMk/>
            <pc:sldMk cId="4154367766" sldId="295"/>
            <ac:spMk id="80" creationId="{79E5D586-C2E2-3542-9BF0-2287D94CE67D}"/>
          </ac:spMkLst>
        </pc:spChg>
        <pc:spChg chg="del mod">
          <ac:chgData name="Narang, Sonali" userId="9e80b397-6e2f-49b1-9374-ccdad8589140" providerId="ADAL" clId="{EE43CF42-9091-0948-8ABB-0345272F62C4}" dt="2022-02-10T19:24:02.202" v="14" actId="478"/>
          <ac:spMkLst>
            <pc:docMk/>
            <pc:sldMk cId="4154367766" sldId="295"/>
            <ac:spMk id="81" creationId="{9D428634-13C9-9D47-8CDA-D13551AF8DE0}"/>
          </ac:spMkLst>
        </pc:spChg>
        <pc:spChg chg="del">
          <ac:chgData name="Narang, Sonali" userId="9e80b397-6e2f-49b1-9374-ccdad8589140" providerId="ADAL" clId="{EE43CF42-9091-0948-8ABB-0345272F62C4}" dt="2022-02-10T19:18:10.276" v="12" actId="21"/>
          <ac:spMkLst>
            <pc:docMk/>
            <pc:sldMk cId="4154367766" sldId="295"/>
            <ac:spMk id="82" creationId="{144A4486-8816-5044-8E19-E653E7D0ED7C}"/>
          </ac:spMkLst>
        </pc:spChg>
        <pc:spChg chg="mod">
          <ac:chgData name="Narang, Sonali" userId="9e80b397-6e2f-49b1-9374-ccdad8589140" providerId="ADAL" clId="{EE43CF42-9091-0948-8ABB-0345272F62C4}" dt="2022-02-11T17:16:48.908" v="108" actId="1038"/>
          <ac:spMkLst>
            <pc:docMk/>
            <pc:sldMk cId="4154367766" sldId="295"/>
            <ac:spMk id="94" creationId="{A7B58F4A-C041-6141-9BED-A5BFF240A9C9}"/>
          </ac:spMkLst>
        </pc:spChg>
        <pc:spChg chg="mod">
          <ac:chgData name="Narang, Sonali" userId="9e80b397-6e2f-49b1-9374-ccdad8589140" providerId="ADAL" clId="{EE43CF42-9091-0948-8ABB-0345272F62C4}" dt="2022-02-11T17:16:43.586" v="105" actId="1038"/>
          <ac:spMkLst>
            <pc:docMk/>
            <pc:sldMk cId="4154367766" sldId="295"/>
            <ac:spMk id="100" creationId="{49F4B43C-8A99-404D-BC76-1CEB9F23406A}"/>
          </ac:spMkLst>
        </pc:spChg>
        <pc:spChg chg="del mod">
          <ac:chgData name="Narang, Sonali" userId="9e80b397-6e2f-49b1-9374-ccdad8589140" providerId="ADAL" clId="{EE43CF42-9091-0948-8ABB-0345272F62C4}" dt="2022-02-11T17:15:02.763" v="50" actId="478"/>
          <ac:spMkLst>
            <pc:docMk/>
            <pc:sldMk cId="4154367766" sldId="295"/>
            <ac:spMk id="113" creationId="{1E4826DE-E84B-C644-AE98-3284FD9DA61B}"/>
          </ac:spMkLst>
        </pc:spChg>
        <pc:spChg chg="del mod">
          <ac:chgData name="Narang, Sonali" userId="9e80b397-6e2f-49b1-9374-ccdad8589140" providerId="ADAL" clId="{EE43CF42-9091-0948-8ABB-0345272F62C4}" dt="2022-02-14T19:47:23.419" v="1331" actId="21"/>
          <ac:spMkLst>
            <pc:docMk/>
            <pc:sldMk cId="4154367766" sldId="295"/>
            <ac:spMk id="114" creationId="{3A736F9A-10B2-FE40-82FF-D51AB6E0A5AB}"/>
          </ac:spMkLst>
        </pc:s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16" creationId="{0B88348C-71F4-034E-8BE6-1DA8AF48B28B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27" creationId="{AD28354D-0D05-EA4B-9A5D-6F5E44A0A0C2}"/>
          </ac:grpSpMkLst>
        </pc:gr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33" creationId="{47DF78CB-368F-0E4F-B327-B5A2B29E1E61}"/>
          </ac:grpSpMkLst>
        </pc:gr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39" creationId="{40AAC5F9-F9A3-1140-A1BF-041C11BD5737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58" creationId="{1166626B-BD7B-DC42-B837-7CEBE44A472A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64" creationId="{2EB8E366-B7F2-414A-A21E-7D31542517D8}"/>
          </ac:grpSpMkLst>
        </pc:gr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72" creationId="{FD67D9FC-2896-D947-AB6A-0B8F0EC147EE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83" creationId="{A8ACB6FC-C43F-A342-B4DB-E35FCF33D311}"/>
          </ac:grpSpMkLst>
        </pc:gr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89" creationId="{37E7C870-E43B-5C45-9C11-E8E988931DE2}"/>
          </ac:grpSpMkLst>
        </pc:grpChg>
        <pc:grpChg chg="del mod">
          <ac:chgData name="Narang, Sonali" userId="9e80b397-6e2f-49b1-9374-ccdad8589140" providerId="ADAL" clId="{EE43CF42-9091-0948-8ABB-0345272F62C4}" dt="2022-02-14T19:47:23.419" v="1331" actId="21"/>
          <ac:grpSpMkLst>
            <pc:docMk/>
            <pc:sldMk cId="4154367766" sldId="295"/>
            <ac:grpSpMk id="95" creationId="{62FA0AC6-043A-1849-846C-CC8017806BE8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101" creationId="{6D8B34DB-0B4E-9B44-BE56-D647F7073658}"/>
          </ac:grpSpMkLst>
        </pc:grpChg>
        <pc:grpChg chg="del">
          <ac:chgData name="Narang, Sonali" userId="9e80b397-6e2f-49b1-9374-ccdad8589140" providerId="ADAL" clId="{EE43CF42-9091-0948-8ABB-0345272F62C4}" dt="2022-02-10T19:18:10.276" v="12" actId="21"/>
          <ac:grpSpMkLst>
            <pc:docMk/>
            <pc:sldMk cId="4154367766" sldId="295"/>
            <ac:grpSpMk id="107" creationId="{0BA70FBE-9434-184B-B402-887547386963}"/>
          </ac:grpSpMkLst>
        </pc:grpChg>
        <pc:graphicFrameChg chg="del mod modGraphic">
          <ac:chgData name="Narang, Sonali" userId="9e80b397-6e2f-49b1-9374-ccdad8589140" providerId="ADAL" clId="{EE43CF42-9091-0948-8ABB-0345272F62C4}" dt="2022-02-14T19:47:23.419" v="1331" actId="21"/>
          <ac:graphicFrameMkLst>
            <pc:docMk/>
            <pc:sldMk cId="4154367766" sldId="295"/>
            <ac:graphicFrameMk id="2" creationId="{C2C8F5CF-E830-0B44-BA36-6BE96741738C}"/>
          </ac:graphicFrameMkLst>
        </pc:graphicFrameChg>
        <pc:graphicFrameChg chg="del mod modGraphic">
          <ac:chgData name="Narang, Sonali" userId="9e80b397-6e2f-49b1-9374-ccdad8589140" providerId="ADAL" clId="{EE43CF42-9091-0948-8ABB-0345272F62C4}" dt="2022-02-14T19:47:23.419" v="1331" actId="21"/>
          <ac:graphicFrameMkLst>
            <pc:docMk/>
            <pc:sldMk cId="4154367766" sldId="295"/>
            <ac:graphicFrameMk id="154" creationId="{3CC96BEF-FBBA-2C44-8E69-3D45840055E1}"/>
          </ac:graphicFrameMkLst>
        </pc:graphicFrameChg>
      </pc:sldChg>
    </pc:docChg>
  </pc:docChgLst>
  <pc:docChgLst>
    <pc:chgData name="Narang, Sonali" userId="9e80b397-6e2f-49b1-9374-ccdad8589140" providerId="ADAL" clId="{8CD0D053-ACF7-084A-967B-8933658524DF}"/>
    <pc:docChg chg="undo redo custSel addSld delSld modSld sldOrd">
      <pc:chgData name="Narang, Sonali" userId="9e80b397-6e2f-49b1-9374-ccdad8589140" providerId="ADAL" clId="{8CD0D053-ACF7-084A-967B-8933658524DF}" dt="2021-12-17T14:20:21.194" v="1212" actId="20577"/>
      <pc:docMkLst>
        <pc:docMk/>
      </pc:docMkLst>
      <pc:sldChg chg="del">
        <pc:chgData name="Narang, Sonali" userId="9e80b397-6e2f-49b1-9374-ccdad8589140" providerId="ADAL" clId="{8CD0D053-ACF7-084A-967B-8933658524DF}" dt="2021-12-06T16:47:03.863" v="0" actId="2696"/>
        <pc:sldMkLst>
          <pc:docMk/>
          <pc:sldMk cId="1854626235" sldId="257"/>
        </pc:sldMkLst>
      </pc:sldChg>
      <pc:sldChg chg="delSp mod">
        <pc:chgData name="Narang, Sonali" userId="9e80b397-6e2f-49b1-9374-ccdad8589140" providerId="ADAL" clId="{8CD0D053-ACF7-084A-967B-8933658524DF}" dt="2021-12-06T19:36:42.659" v="486" actId="478"/>
        <pc:sldMkLst>
          <pc:docMk/>
          <pc:sldMk cId="1155223781" sldId="258"/>
        </pc:sldMkLst>
        <pc:spChg chg="del">
          <ac:chgData name="Narang, Sonali" userId="9e80b397-6e2f-49b1-9374-ccdad8589140" providerId="ADAL" clId="{8CD0D053-ACF7-084A-967B-8933658524DF}" dt="2021-12-06T19:36:42.659" v="486" actId="478"/>
          <ac:spMkLst>
            <pc:docMk/>
            <pc:sldMk cId="1155223781" sldId="258"/>
            <ac:spMk id="15" creationId="{9A26DAF7-4AE4-234D-A980-14F8878AB7B7}"/>
          </ac:spMkLst>
        </pc:spChg>
        <pc:picChg chg="del">
          <ac:chgData name="Narang, Sonali" userId="9e80b397-6e2f-49b1-9374-ccdad8589140" providerId="ADAL" clId="{8CD0D053-ACF7-084A-967B-8933658524DF}" dt="2021-12-06T19:36:39.880" v="485" actId="478"/>
          <ac:picMkLst>
            <pc:docMk/>
            <pc:sldMk cId="1155223781" sldId="258"/>
            <ac:picMk id="14" creationId="{97488199-8FF7-4A42-B148-0C15F8B3E126}"/>
          </ac:picMkLst>
        </pc:picChg>
      </pc:sldChg>
      <pc:sldChg chg="delSp mod">
        <pc:chgData name="Narang, Sonali" userId="9e80b397-6e2f-49b1-9374-ccdad8589140" providerId="ADAL" clId="{8CD0D053-ACF7-084A-967B-8933658524DF}" dt="2021-12-14T22:04:10.460" v="883" actId="478"/>
        <pc:sldMkLst>
          <pc:docMk/>
          <pc:sldMk cId="743684689" sldId="267"/>
        </pc:sldMkLst>
        <pc:spChg chg="del">
          <ac:chgData name="Narang, Sonali" userId="9e80b397-6e2f-49b1-9374-ccdad8589140" providerId="ADAL" clId="{8CD0D053-ACF7-084A-967B-8933658524DF}" dt="2021-12-14T22:04:10.460" v="883" actId="478"/>
          <ac:spMkLst>
            <pc:docMk/>
            <pc:sldMk cId="743684689" sldId="267"/>
            <ac:spMk id="61" creationId="{70A48721-2BC2-9244-9AEB-337662624A03}"/>
          </ac:spMkLst>
        </pc:spChg>
        <pc:picChg chg="del">
          <ac:chgData name="Narang, Sonali" userId="9e80b397-6e2f-49b1-9374-ccdad8589140" providerId="ADAL" clId="{8CD0D053-ACF7-084A-967B-8933658524DF}" dt="2021-12-14T22:04:10.460" v="883" actId="478"/>
          <ac:picMkLst>
            <pc:docMk/>
            <pc:sldMk cId="743684689" sldId="267"/>
            <ac:picMk id="58" creationId="{C7001BD1-4EB1-EC4E-B296-37C694FBD138}"/>
          </ac:picMkLst>
        </pc:picChg>
        <pc:picChg chg="del">
          <ac:chgData name="Narang, Sonali" userId="9e80b397-6e2f-49b1-9374-ccdad8589140" providerId="ADAL" clId="{8CD0D053-ACF7-084A-967B-8933658524DF}" dt="2021-12-14T22:04:10.460" v="883" actId="478"/>
          <ac:picMkLst>
            <pc:docMk/>
            <pc:sldMk cId="743684689" sldId="267"/>
            <ac:picMk id="59" creationId="{C102C116-1F08-9540-A57A-4BCAAD3C4325}"/>
          </ac:picMkLst>
        </pc:picChg>
        <pc:picChg chg="del">
          <ac:chgData name="Narang, Sonali" userId="9e80b397-6e2f-49b1-9374-ccdad8589140" providerId="ADAL" clId="{8CD0D053-ACF7-084A-967B-8933658524DF}" dt="2021-12-14T22:04:10.460" v="883" actId="478"/>
          <ac:picMkLst>
            <pc:docMk/>
            <pc:sldMk cId="743684689" sldId="267"/>
            <ac:picMk id="60" creationId="{1F2B4104-CFDC-8645-9E46-63B2C37E19DC}"/>
          </ac:picMkLst>
        </pc:picChg>
      </pc:sldChg>
      <pc:sldChg chg="del">
        <pc:chgData name="Narang, Sonali" userId="9e80b397-6e2f-49b1-9374-ccdad8589140" providerId="ADAL" clId="{8CD0D053-ACF7-084A-967B-8933658524DF}" dt="2021-12-06T16:47:03.863" v="0" actId="2696"/>
        <pc:sldMkLst>
          <pc:docMk/>
          <pc:sldMk cId="454596918" sldId="276"/>
        </pc:sldMkLst>
      </pc:sldChg>
      <pc:sldChg chg="del">
        <pc:chgData name="Narang, Sonali" userId="9e80b397-6e2f-49b1-9374-ccdad8589140" providerId="ADAL" clId="{8CD0D053-ACF7-084A-967B-8933658524DF}" dt="2021-12-06T16:47:03.863" v="0" actId="2696"/>
        <pc:sldMkLst>
          <pc:docMk/>
          <pc:sldMk cId="3296066017" sldId="279"/>
        </pc:sldMkLst>
      </pc:sldChg>
      <pc:sldChg chg="modSp mod">
        <pc:chgData name="Narang, Sonali" userId="9e80b397-6e2f-49b1-9374-ccdad8589140" providerId="ADAL" clId="{8CD0D053-ACF7-084A-967B-8933658524DF}" dt="2021-12-15T20:45:05.637" v="1192" actId="1076"/>
        <pc:sldMkLst>
          <pc:docMk/>
          <pc:sldMk cId="3214590643" sldId="280"/>
        </pc:sldMkLst>
        <pc:grpChg chg="mod">
          <ac:chgData name="Narang, Sonali" userId="9e80b397-6e2f-49b1-9374-ccdad8589140" providerId="ADAL" clId="{8CD0D053-ACF7-084A-967B-8933658524DF}" dt="2021-12-15T20:45:01.795" v="1191" actId="1076"/>
          <ac:grpSpMkLst>
            <pc:docMk/>
            <pc:sldMk cId="3214590643" sldId="280"/>
            <ac:grpSpMk id="47" creationId="{4B802D37-9378-E54E-99B5-1E00E308EBB8}"/>
          </ac:grpSpMkLst>
        </pc:grpChg>
        <pc:picChg chg="mod">
          <ac:chgData name="Narang, Sonali" userId="9e80b397-6e2f-49b1-9374-ccdad8589140" providerId="ADAL" clId="{8CD0D053-ACF7-084A-967B-8933658524DF}" dt="2021-12-15T20:45:05.637" v="1192" actId="1076"/>
          <ac:picMkLst>
            <pc:docMk/>
            <pc:sldMk cId="3214590643" sldId="280"/>
            <ac:picMk id="50" creationId="{EC1A4915-BF55-6D40-8B7A-411B554E98BC}"/>
          </ac:picMkLst>
        </pc:picChg>
      </pc:sldChg>
      <pc:sldChg chg="del">
        <pc:chgData name="Narang, Sonali" userId="9e80b397-6e2f-49b1-9374-ccdad8589140" providerId="ADAL" clId="{8CD0D053-ACF7-084A-967B-8933658524DF}" dt="2021-12-06T16:47:03.863" v="0" actId="2696"/>
        <pc:sldMkLst>
          <pc:docMk/>
          <pc:sldMk cId="3858847110" sldId="283"/>
        </pc:sldMkLst>
      </pc:sldChg>
      <pc:sldChg chg="del">
        <pc:chgData name="Narang, Sonali" userId="9e80b397-6e2f-49b1-9374-ccdad8589140" providerId="ADAL" clId="{8CD0D053-ACF7-084A-967B-8933658524DF}" dt="2021-12-06T16:47:03.863" v="0" actId="2696"/>
        <pc:sldMkLst>
          <pc:docMk/>
          <pc:sldMk cId="4004272488" sldId="284"/>
        </pc:sldMkLst>
      </pc:sldChg>
      <pc:sldChg chg="addSp delSp modSp mod">
        <pc:chgData name="Narang, Sonali" userId="9e80b397-6e2f-49b1-9374-ccdad8589140" providerId="ADAL" clId="{8CD0D053-ACF7-084A-967B-8933658524DF}" dt="2021-12-15T20:05:09.830" v="1190" actId="478"/>
        <pc:sldMkLst>
          <pc:docMk/>
          <pc:sldMk cId="2252998334" sldId="285"/>
        </pc:sldMkLst>
        <pc:spChg chg="del">
          <ac:chgData name="Narang, Sonali" userId="9e80b397-6e2f-49b1-9374-ccdad8589140" providerId="ADAL" clId="{8CD0D053-ACF7-084A-967B-8933658524DF}" dt="2021-12-15T17:59:16.771" v="1188" actId="478"/>
          <ac:spMkLst>
            <pc:docMk/>
            <pc:sldMk cId="2252998334" sldId="285"/>
            <ac:spMk id="6" creationId="{41464C80-B659-484D-A16F-8018DEC5471A}"/>
          </ac:spMkLst>
        </pc:spChg>
        <pc:picChg chg="add del mod">
          <ac:chgData name="Narang, Sonali" userId="9e80b397-6e2f-49b1-9374-ccdad8589140" providerId="ADAL" clId="{8CD0D053-ACF7-084A-967B-8933658524DF}" dt="2021-12-15T20:05:09.830" v="1190" actId="478"/>
          <ac:picMkLst>
            <pc:docMk/>
            <pc:sldMk cId="2252998334" sldId="285"/>
            <ac:picMk id="8" creationId="{299DC029-2A7F-D744-88A7-2EE6B4A52DFD}"/>
          </ac:picMkLst>
        </pc:picChg>
        <pc:picChg chg="del mod">
          <ac:chgData name="Narang, Sonali" userId="9e80b397-6e2f-49b1-9374-ccdad8589140" providerId="ADAL" clId="{8CD0D053-ACF7-084A-967B-8933658524DF}" dt="2021-12-15T17:59:09.437" v="1185" actId="478"/>
          <ac:picMkLst>
            <pc:docMk/>
            <pc:sldMk cId="2252998334" sldId="285"/>
            <ac:picMk id="9" creationId="{FBB68F08-64CC-564C-BE82-2B24199B4BD0}"/>
          </ac:picMkLst>
        </pc:picChg>
        <pc:picChg chg="add del mod">
          <ac:chgData name="Narang, Sonali" userId="9e80b397-6e2f-49b1-9374-ccdad8589140" providerId="ADAL" clId="{8CD0D053-ACF7-084A-967B-8933658524DF}" dt="2021-12-15T20:05:09.830" v="1190" actId="478"/>
          <ac:picMkLst>
            <pc:docMk/>
            <pc:sldMk cId="2252998334" sldId="285"/>
            <ac:picMk id="10" creationId="{40EA60E7-7F6A-144A-A90B-56183E79DDD5}"/>
          </ac:picMkLst>
        </pc:picChg>
        <pc:picChg chg="add del mod">
          <ac:chgData name="Narang, Sonali" userId="9e80b397-6e2f-49b1-9374-ccdad8589140" providerId="ADAL" clId="{8CD0D053-ACF7-084A-967B-8933658524DF}" dt="2021-12-15T20:05:09.830" v="1190" actId="478"/>
          <ac:picMkLst>
            <pc:docMk/>
            <pc:sldMk cId="2252998334" sldId="285"/>
            <ac:picMk id="11" creationId="{82A65562-041B-B946-958E-3822349A6D33}"/>
          </ac:picMkLst>
        </pc:picChg>
        <pc:picChg chg="del mod">
          <ac:chgData name="Narang, Sonali" userId="9e80b397-6e2f-49b1-9374-ccdad8589140" providerId="ADAL" clId="{8CD0D053-ACF7-084A-967B-8933658524DF}" dt="2021-12-15T17:59:09.437" v="1185" actId="478"/>
          <ac:picMkLst>
            <pc:docMk/>
            <pc:sldMk cId="2252998334" sldId="285"/>
            <ac:picMk id="12" creationId="{CD0563F0-C751-FC47-8AE6-EFC466272C78}"/>
          </ac:picMkLst>
        </pc:picChg>
        <pc:picChg chg="del mod">
          <ac:chgData name="Narang, Sonali" userId="9e80b397-6e2f-49b1-9374-ccdad8589140" providerId="ADAL" clId="{8CD0D053-ACF7-084A-967B-8933658524DF}" dt="2021-12-15T17:59:09.437" v="1185" actId="478"/>
          <ac:picMkLst>
            <pc:docMk/>
            <pc:sldMk cId="2252998334" sldId="285"/>
            <ac:picMk id="13" creationId="{1C6603AB-6BB9-3C48-887A-598542F56407}"/>
          </ac:picMkLst>
        </pc:picChg>
      </pc:sldChg>
      <pc:sldChg chg="del">
        <pc:chgData name="Narang, Sonali" userId="9e80b397-6e2f-49b1-9374-ccdad8589140" providerId="ADAL" clId="{8CD0D053-ACF7-084A-967B-8933658524DF}" dt="2021-12-14T22:03:47.430" v="882" actId="2696"/>
        <pc:sldMkLst>
          <pc:docMk/>
          <pc:sldMk cId="1525852547" sldId="287"/>
        </pc:sldMkLst>
      </pc:sldChg>
      <pc:sldChg chg="addSp delSp modSp mod ord">
        <pc:chgData name="Narang, Sonali" userId="9e80b397-6e2f-49b1-9374-ccdad8589140" providerId="ADAL" clId="{8CD0D053-ACF7-084A-967B-8933658524DF}" dt="2021-12-14T21:59:35.769" v="881" actId="20577"/>
        <pc:sldMkLst>
          <pc:docMk/>
          <pc:sldMk cId="4017312032" sldId="288"/>
        </pc:sldMkLst>
        <pc:spChg chg="mod">
          <ac:chgData name="Narang, Sonali" userId="9e80b397-6e2f-49b1-9374-ccdad8589140" providerId="ADAL" clId="{8CD0D053-ACF7-084A-967B-8933658524DF}" dt="2021-12-14T21:59:35.769" v="881" actId="20577"/>
          <ac:spMkLst>
            <pc:docMk/>
            <pc:sldMk cId="4017312032" sldId="288"/>
            <ac:spMk id="4" creationId="{F6669B9D-B042-D548-BD0F-97015091799B}"/>
          </ac:spMkLst>
        </pc:spChg>
        <pc:spChg chg="mod">
          <ac:chgData name="Narang, Sonali" userId="9e80b397-6e2f-49b1-9374-ccdad8589140" providerId="ADAL" clId="{8CD0D053-ACF7-084A-967B-8933658524DF}" dt="2021-12-06T16:57:47.365" v="48" actId="166"/>
          <ac:spMkLst>
            <pc:docMk/>
            <pc:sldMk cId="4017312032" sldId="288"/>
            <ac:spMk id="7" creationId="{4C5F5CAE-FBFD-964D-A356-746AAC86DC9E}"/>
          </ac:spMkLst>
        </pc:spChg>
        <pc:spChg chg="mod">
          <ac:chgData name="Narang, Sonali" userId="9e80b397-6e2f-49b1-9374-ccdad8589140" providerId="ADAL" clId="{8CD0D053-ACF7-084A-967B-8933658524DF}" dt="2021-12-06T18:00:24.169" v="85" actId="1076"/>
          <ac:spMkLst>
            <pc:docMk/>
            <pc:sldMk cId="4017312032" sldId="288"/>
            <ac:spMk id="25" creationId="{6593D040-450B-C74A-8B7E-FF945A3E00B1}"/>
          </ac:spMkLst>
        </pc:spChg>
        <pc:spChg chg="add mod">
          <ac:chgData name="Narang, Sonali" userId="9e80b397-6e2f-49b1-9374-ccdad8589140" providerId="ADAL" clId="{8CD0D053-ACF7-084A-967B-8933658524DF}" dt="2021-12-06T19:34:37.994" v="451" actId="1038"/>
          <ac:spMkLst>
            <pc:docMk/>
            <pc:sldMk cId="4017312032" sldId="288"/>
            <ac:spMk id="34" creationId="{004AA04E-FC0B-DB46-9DE6-3C5810F21D71}"/>
          </ac:spMkLst>
        </pc:spChg>
        <pc:spChg chg="add del mod">
          <ac:chgData name="Narang, Sonali" userId="9e80b397-6e2f-49b1-9374-ccdad8589140" providerId="ADAL" clId="{8CD0D053-ACF7-084A-967B-8933658524DF}" dt="2021-12-06T19:30:57.491" v="404" actId="478"/>
          <ac:spMkLst>
            <pc:docMk/>
            <pc:sldMk cId="4017312032" sldId="288"/>
            <ac:spMk id="35" creationId="{F1B56A75-F7A3-3140-B4F1-499B2AA1F578}"/>
          </ac:spMkLst>
        </pc:spChg>
        <pc:spChg chg="add mod">
          <ac:chgData name="Narang, Sonali" userId="9e80b397-6e2f-49b1-9374-ccdad8589140" providerId="ADAL" clId="{8CD0D053-ACF7-084A-967B-8933658524DF}" dt="2021-12-08T20:11:03.005" v="806" actId="20577"/>
          <ac:spMkLst>
            <pc:docMk/>
            <pc:sldMk cId="4017312032" sldId="288"/>
            <ac:spMk id="50" creationId="{F16A1FEC-9E57-A543-86B4-5DB7BD7F48A3}"/>
          </ac:spMkLst>
        </pc:spChg>
        <pc:spChg chg="mod">
          <ac:chgData name="Narang, Sonali" userId="9e80b397-6e2f-49b1-9374-ccdad8589140" providerId="ADAL" clId="{8CD0D053-ACF7-084A-967B-8933658524DF}" dt="2021-12-06T17:52:16.601" v="73" actId="1076"/>
          <ac:spMkLst>
            <pc:docMk/>
            <pc:sldMk cId="4017312032" sldId="288"/>
            <ac:spMk id="101" creationId="{B8264B62-3E19-2049-91A6-C9AD5F1A87C2}"/>
          </ac:spMkLst>
        </pc:spChg>
        <pc:spChg chg="add del">
          <ac:chgData name="Narang, Sonali" userId="9e80b397-6e2f-49b1-9374-ccdad8589140" providerId="ADAL" clId="{8CD0D053-ACF7-084A-967B-8933658524DF}" dt="2021-12-06T16:58:40.665" v="62" actId="478"/>
          <ac:spMkLst>
            <pc:docMk/>
            <pc:sldMk cId="4017312032" sldId="288"/>
            <ac:spMk id="143" creationId="{20129D71-3918-E547-A9C5-11F1801D30D0}"/>
          </ac:spMkLst>
        </pc:spChg>
        <pc:spChg chg="add del">
          <ac:chgData name="Narang, Sonali" userId="9e80b397-6e2f-49b1-9374-ccdad8589140" providerId="ADAL" clId="{8CD0D053-ACF7-084A-967B-8933658524DF}" dt="2021-12-06T16:58:40.665" v="62" actId="478"/>
          <ac:spMkLst>
            <pc:docMk/>
            <pc:sldMk cId="4017312032" sldId="288"/>
            <ac:spMk id="144" creationId="{04F4E0B9-91A9-A04B-A9CF-77FA1F46893D}"/>
          </ac:spMkLst>
        </pc:spChg>
        <pc:spChg chg="add del mod">
          <ac:chgData name="Narang, Sonali" userId="9e80b397-6e2f-49b1-9374-ccdad8589140" providerId="ADAL" clId="{8CD0D053-ACF7-084A-967B-8933658524DF}" dt="2021-12-06T19:31:39.733" v="407" actId="478"/>
          <ac:spMkLst>
            <pc:docMk/>
            <pc:sldMk cId="4017312032" sldId="288"/>
            <ac:spMk id="145" creationId="{58C6D6E7-5376-8247-90FE-13ED6E414D6E}"/>
          </ac:spMkLst>
        </pc:spChg>
        <pc:graphicFrameChg chg="add del mod modGraphic">
          <ac:chgData name="Narang, Sonali" userId="9e80b397-6e2f-49b1-9374-ccdad8589140" providerId="ADAL" clId="{8CD0D053-ACF7-084A-967B-8933658524DF}" dt="2021-12-06T19:28:18.946" v="372" actId="478"/>
          <ac:graphicFrameMkLst>
            <pc:docMk/>
            <pc:sldMk cId="4017312032" sldId="288"/>
            <ac:graphicFrameMk id="23" creationId="{0759C56F-7A2A-C44B-B409-4AB318968FB8}"/>
          </ac:graphicFrameMkLst>
        </pc:graphicFrameChg>
        <pc:graphicFrameChg chg="add del mod modGraphic">
          <ac:chgData name="Narang, Sonali" userId="9e80b397-6e2f-49b1-9374-ccdad8589140" providerId="ADAL" clId="{8CD0D053-ACF7-084A-967B-8933658524DF}" dt="2021-12-06T19:28:18.946" v="372" actId="478"/>
          <ac:graphicFrameMkLst>
            <pc:docMk/>
            <pc:sldMk cId="4017312032" sldId="288"/>
            <ac:graphicFrameMk id="29" creationId="{BC405748-4B2C-FA41-AF30-80A906608DE3}"/>
          </ac:graphicFrameMkLst>
        </pc:graphicFrameChg>
        <pc:picChg chg="add del mod modCrop">
          <ac:chgData name="Narang, Sonali" userId="9e80b397-6e2f-49b1-9374-ccdad8589140" providerId="ADAL" clId="{8CD0D053-ACF7-084A-967B-8933658524DF}" dt="2021-12-06T17:54:28.871" v="82" actId="478"/>
          <ac:picMkLst>
            <pc:docMk/>
            <pc:sldMk cId="4017312032" sldId="288"/>
            <ac:picMk id="3" creationId="{5161AB0A-12D7-6B4E-8B27-E075227AA43F}"/>
          </ac:picMkLst>
        </pc:picChg>
        <pc:picChg chg="add del mod">
          <ac:chgData name="Narang, Sonali" userId="9e80b397-6e2f-49b1-9374-ccdad8589140" providerId="ADAL" clId="{8CD0D053-ACF7-084A-967B-8933658524DF}" dt="2021-12-06T17:54:28.871" v="82" actId="478"/>
          <ac:picMkLst>
            <pc:docMk/>
            <pc:sldMk cId="4017312032" sldId="288"/>
            <ac:picMk id="8" creationId="{94FA24C7-6B2E-074C-9D24-81AF7E6661FB}"/>
          </ac:picMkLst>
        </pc:picChg>
        <pc:picChg chg="add del mod modCrop">
          <ac:chgData name="Narang, Sonali" userId="9e80b397-6e2f-49b1-9374-ccdad8589140" providerId="ADAL" clId="{8CD0D053-ACF7-084A-967B-8933658524DF}" dt="2021-12-06T17:54:28.871" v="82" actId="478"/>
          <ac:picMkLst>
            <pc:docMk/>
            <pc:sldMk cId="4017312032" sldId="288"/>
            <ac:picMk id="10" creationId="{8565E828-F21C-864D-96B3-FC8D4750141B}"/>
          </ac:picMkLst>
        </pc:picChg>
        <pc:picChg chg="add mod modCrop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12" creationId="{7C85399F-93F3-C340-B67F-8D7FCB06AC64}"/>
          </ac:picMkLst>
        </pc:picChg>
        <pc:picChg chg="add mod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14" creationId="{79FC27D1-6AEB-2C4F-8603-86553948EE98}"/>
          </ac:picMkLst>
        </pc:picChg>
        <pc:picChg chg="add mod modCrop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16" creationId="{51D04699-A84F-3C44-81DE-0A05F5CBDCCD}"/>
          </ac:picMkLst>
        </pc:picChg>
        <pc:picChg chg="add mod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18" creationId="{B459A2BC-8172-5F41-881F-534AA8597A5E}"/>
          </ac:picMkLst>
        </pc:picChg>
        <pc:picChg chg="add mod modCrop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20" creationId="{D8C3B42D-60C4-C141-A8FF-5F319D258264}"/>
          </ac:picMkLst>
        </pc:picChg>
        <pc:picChg chg="add mod modCrop">
          <ac:chgData name="Narang, Sonali" userId="9e80b397-6e2f-49b1-9374-ccdad8589140" providerId="ADAL" clId="{8CD0D053-ACF7-084A-967B-8933658524DF}" dt="2021-12-06T19:30:03.774" v="392" actId="1076"/>
          <ac:picMkLst>
            <pc:docMk/>
            <pc:sldMk cId="4017312032" sldId="288"/>
            <ac:picMk id="22" creationId="{ACB215F7-DBEF-F943-978A-ECD3D03D267B}"/>
          </ac:picMkLst>
        </pc:picChg>
        <pc:picChg chg="add del mod">
          <ac:chgData name="Narang, Sonali" userId="9e80b397-6e2f-49b1-9374-ccdad8589140" providerId="ADAL" clId="{8CD0D053-ACF7-084A-967B-8933658524DF}" dt="2021-12-06T19:28:27.330" v="375" actId="478"/>
          <ac:picMkLst>
            <pc:docMk/>
            <pc:sldMk cId="4017312032" sldId="288"/>
            <ac:picMk id="26" creationId="{81E14873-A3E2-B046-9EEB-0BDADE7B9C4E}"/>
          </ac:picMkLst>
        </pc:picChg>
        <pc:picChg chg="add del mod modCrop">
          <ac:chgData name="Narang, Sonali" userId="9e80b397-6e2f-49b1-9374-ccdad8589140" providerId="ADAL" clId="{8CD0D053-ACF7-084A-967B-8933658524DF}" dt="2021-12-06T19:32:27.290" v="408" actId="478"/>
          <ac:picMkLst>
            <pc:docMk/>
            <pc:sldMk cId="4017312032" sldId="288"/>
            <ac:picMk id="28" creationId="{0FFEBF70-22DE-0E48-9A74-4E215E458C82}"/>
          </ac:picMkLst>
        </pc:picChg>
        <pc:picChg chg="add mod modCrop">
          <ac:chgData name="Narang, Sonali" userId="9e80b397-6e2f-49b1-9374-ccdad8589140" providerId="ADAL" clId="{8CD0D053-ACF7-084A-967B-8933658524DF}" dt="2021-12-08T20:10:16.972" v="783" actId="14100"/>
          <ac:picMkLst>
            <pc:docMk/>
            <pc:sldMk cId="4017312032" sldId="288"/>
            <ac:picMk id="31" creationId="{8A85A67A-DC94-2640-87C6-C68EDF20F6A7}"/>
          </ac:picMkLst>
        </pc:picChg>
        <pc:picChg chg="add del mod">
          <ac:chgData name="Narang, Sonali" userId="9e80b397-6e2f-49b1-9374-ccdad8589140" providerId="ADAL" clId="{8CD0D053-ACF7-084A-967B-8933658524DF}" dt="2021-12-06T20:41:14.674" v="667" actId="478"/>
          <ac:picMkLst>
            <pc:docMk/>
            <pc:sldMk cId="4017312032" sldId="288"/>
            <ac:picMk id="33" creationId="{FC43895D-BA45-AD43-8C20-B194BE24FDFB}"/>
          </ac:picMkLst>
        </pc:picChg>
        <pc:picChg chg="add del mod">
          <ac:chgData name="Narang, Sonali" userId="9e80b397-6e2f-49b1-9374-ccdad8589140" providerId="ADAL" clId="{8CD0D053-ACF7-084A-967B-8933658524DF}" dt="2021-12-06T20:41:14.674" v="667" actId="478"/>
          <ac:picMkLst>
            <pc:docMk/>
            <pc:sldMk cId="4017312032" sldId="288"/>
            <ac:picMk id="37" creationId="{87F202CB-8444-6146-981C-0D15E07E4CA3}"/>
          </ac:picMkLst>
        </pc:picChg>
        <pc:picChg chg="add del mod">
          <ac:chgData name="Narang, Sonali" userId="9e80b397-6e2f-49b1-9374-ccdad8589140" providerId="ADAL" clId="{8CD0D053-ACF7-084A-967B-8933658524DF}" dt="2021-12-06T20:41:14.674" v="667" actId="478"/>
          <ac:picMkLst>
            <pc:docMk/>
            <pc:sldMk cId="4017312032" sldId="288"/>
            <ac:picMk id="39" creationId="{08C412D4-306D-FC46-9B55-1D8F9291E6EE}"/>
          </ac:picMkLst>
        </pc:picChg>
        <pc:picChg chg="add mod modCrop">
          <ac:chgData name="Narang, Sonali" userId="9e80b397-6e2f-49b1-9374-ccdad8589140" providerId="ADAL" clId="{8CD0D053-ACF7-084A-967B-8933658524DF}" dt="2021-12-08T20:10:45.506" v="802" actId="167"/>
          <ac:picMkLst>
            <pc:docMk/>
            <pc:sldMk cId="4017312032" sldId="288"/>
            <ac:picMk id="41" creationId="{3B056186-E9DD-8345-8734-D5AE672DFCAF}"/>
          </ac:picMkLst>
        </pc:picChg>
        <pc:picChg chg="add mod modCrop">
          <ac:chgData name="Narang, Sonali" userId="9e80b397-6e2f-49b1-9374-ccdad8589140" providerId="ADAL" clId="{8CD0D053-ACF7-084A-967B-8933658524DF}" dt="2021-12-08T20:10:45.506" v="802" actId="167"/>
          <ac:picMkLst>
            <pc:docMk/>
            <pc:sldMk cId="4017312032" sldId="288"/>
            <ac:picMk id="43" creationId="{12747D23-0D83-A347-9C44-9049103FF625}"/>
          </ac:picMkLst>
        </pc:picChg>
        <pc:picChg chg="add mod modCrop">
          <ac:chgData name="Narang, Sonali" userId="9e80b397-6e2f-49b1-9374-ccdad8589140" providerId="ADAL" clId="{8CD0D053-ACF7-084A-967B-8933658524DF}" dt="2021-12-08T20:10:45.506" v="802" actId="167"/>
          <ac:picMkLst>
            <pc:docMk/>
            <pc:sldMk cId="4017312032" sldId="288"/>
            <ac:picMk id="45" creationId="{A0835A77-6770-AD4E-91EB-2FE22B8B1E90}"/>
          </ac:picMkLst>
        </pc:picChg>
        <pc:picChg chg="add del mod">
          <ac:chgData name="Narang, Sonali" userId="9e80b397-6e2f-49b1-9374-ccdad8589140" providerId="ADAL" clId="{8CD0D053-ACF7-084A-967B-8933658524DF}" dt="2021-12-09T17:20:30.172" v="810"/>
          <ac:picMkLst>
            <pc:docMk/>
            <pc:sldMk cId="4017312032" sldId="288"/>
            <ac:picMk id="47" creationId="{3C9386E9-0B23-4849-A690-CCCA2A99AAAD}"/>
          </ac:picMkLst>
        </pc:picChg>
        <pc:picChg chg="add del mod">
          <ac:chgData name="Narang, Sonali" userId="9e80b397-6e2f-49b1-9374-ccdad8589140" providerId="ADAL" clId="{8CD0D053-ACF7-084A-967B-8933658524DF}" dt="2021-12-09T17:20:30.172" v="810"/>
          <ac:picMkLst>
            <pc:docMk/>
            <pc:sldMk cId="4017312032" sldId="288"/>
            <ac:picMk id="49" creationId="{FB747560-1962-2C43-8B68-89E27B252682}"/>
          </ac:picMkLst>
        </pc:picChg>
      </pc:sldChg>
      <pc:sldChg chg="addSp delSp modSp add mod ord">
        <pc:chgData name="Narang, Sonali" userId="9e80b397-6e2f-49b1-9374-ccdad8589140" providerId="ADAL" clId="{8CD0D053-ACF7-084A-967B-8933658524DF}" dt="2021-12-15T17:19:42.014" v="1032" actId="21"/>
        <pc:sldMkLst>
          <pc:docMk/>
          <pc:sldMk cId="3228625230" sldId="289"/>
        </pc:sldMkLst>
        <pc:spChg chg="add del mod">
          <ac:chgData name="Narang, Sonali" userId="9e80b397-6e2f-49b1-9374-ccdad8589140" providerId="ADAL" clId="{8CD0D053-ACF7-084A-967B-8933658524DF}" dt="2021-12-15T17:03:14.264" v="886" actId="478"/>
          <ac:spMkLst>
            <pc:docMk/>
            <pc:sldMk cId="3228625230" sldId="289"/>
            <ac:spMk id="2" creationId="{C1DD6046-F23B-D243-A327-EE74908E6C8A}"/>
          </ac:spMkLst>
        </pc:spChg>
        <pc:spChg chg="mod">
          <ac:chgData name="Narang, Sonali" userId="9e80b397-6e2f-49b1-9374-ccdad8589140" providerId="ADAL" clId="{8CD0D053-ACF7-084A-967B-8933658524DF}" dt="2021-12-07T17:09:42.369" v="735" actId="20577"/>
          <ac:spMkLst>
            <pc:docMk/>
            <pc:sldMk cId="3228625230" sldId="289"/>
            <ac:spMk id="4" creationId="{F6669B9D-B042-D548-BD0F-97015091799B}"/>
          </ac:spMkLst>
        </pc:spChg>
        <pc:spChg chg="mod">
          <ac:chgData name="Narang, Sonali" userId="9e80b397-6e2f-49b1-9374-ccdad8589140" providerId="ADAL" clId="{8CD0D053-ACF7-084A-967B-8933658524DF}" dt="2021-12-06T20:10:53.643" v="546" actId="1076"/>
          <ac:spMkLst>
            <pc:docMk/>
            <pc:sldMk cId="3228625230" sldId="289"/>
            <ac:spMk id="7" creationId="{4C5F5CAE-FBFD-964D-A356-746AAC86DC9E}"/>
          </ac:spMkLst>
        </pc:spChg>
        <pc:spChg chg="add mod">
          <ac:chgData name="Narang, Sonali" userId="9e80b397-6e2f-49b1-9374-ccdad8589140" providerId="ADAL" clId="{8CD0D053-ACF7-084A-967B-8933658524DF}" dt="2021-12-06T20:11:42.028" v="649" actId="1038"/>
          <ac:spMkLst>
            <pc:docMk/>
            <pc:sldMk cId="3228625230" sldId="289"/>
            <ac:spMk id="17" creationId="{02C42890-6447-EB45-84F5-FDC1189AED29}"/>
          </ac:spMkLst>
        </pc:spChg>
        <pc:spChg chg="add mod">
          <ac:chgData name="Narang, Sonali" userId="9e80b397-6e2f-49b1-9374-ccdad8589140" providerId="ADAL" clId="{8CD0D053-ACF7-084A-967B-8933658524DF}" dt="2021-12-06T20:11:56.416" v="658" actId="1076"/>
          <ac:spMkLst>
            <pc:docMk/>
            <pc:sldMk cId="3228625230" sldId="289"/>
            <ac:spMk id="19" creationId="{AD1A0C94-7B28-0C42-873A-DD66B1F10735}"/>
          </ac:spMkLst>
        </pc:spChg>
        <pc:spChg chg="del">
          <ac:chgData name="Narang, Sonali" userId="9e80b397-6e2f-49b1-9374-ccdad8589140" providerId="ADAL" clId="{8CD0D053-ACF7-084A-967B-8933658524DF}" dt="2021-12-06T19:33:59.967" v="440" actId="478"/>
          <ac:spMkLst>
            <pc:docMk/>
            <pc:sldMk cId="3228625230" sldId="289"/>
            <ac:spMk id="101" creationId="{B8264B62-3E19-2049-91A6-C9AD5F1A87C2}"/>
          </ac:spMkLst>
        </pc:spChg>
        <pc:spChg chg="del">
          <ac:chgData name="Narang, Sonali" userId="9e80b397-6e2f-49b1-9374-ccdad8589140" providerId="ADAL" clId="{8CD0D053-ACF7-084A-967B-8933658524DF}" dt="2021-12-06T19:33:51.046" v="437" actId="478"/>
          <ac:spMkLst>
            <pc:docMk/>
            <pc:sldMk cId="3228625230" sldId="289"/>
            <ac:spMk id="145" creationId="{58C6D6E7-5376-8247-90FE-13ED6E414D6E}"/>
          </ac:spMkLst>
        </pc:spChg>
        <pc:graphicFrameChg chg="add del mod modGraphic">
          <ac:chgData name="Narang, Sonali" userId="9e80b397-6e2f-49b1-9374-ccdad8589140" providerId="ADAL" clId="{8CD0D053-ACF7-084A-967B-8933658524DF}" dt="2021-12-15T17:19:42.014" v="1032" actId="21"/>
          <ac:graphicFrameMkLst>
            <pc:docMk/>
            <pc:sldMk cId="3228625230" sldId="289"/>
            <ac:graphicFrameMk id="11" creationId="{C3945AA5-2CEA-2443-AEAB-176A004E34C8}"/>
          </ac:graphicFrameMkLst>
        </pc:graphicFrameChg>
        <pc:graphicFrameChg chg="mod modGraphic">
          <ac:chgData name="Narang, Sonali" userId="9e80b397-6e2f-49b1-9374-ccdad8589140" providerId="ADAL" clId="{8CD0D053-ACF7-084A-967B-8933658524DF}" dt="2021-12-09T19:00:08.769" v="866" actId="20577"/>
          <ac:graphicFrameMkLst>
            <pc:docMk/>
            <pc:sldMk cId="3228625230" sldId="289"/>
            <ac:graphicFrameMk id="23" creationId="{0759C56F-7A2A-C44B-B409-4AB318968FB8}"/>
          </ac:graphicFrameMkLst>
        </pc:graphicFrameChg>
        <pc:graphicFrameChg chg="mod modGraphic">
          <ac:chgData name="Narang, Sonali" userId="9e80b397-6e2f-49b1-9374-ccdad8589140" providerId="ADAL" clId="{8CD0D053-ACF7-084A-967B-8933658524DF}" dt="2021-12-09T19:00:05.509" v="852" actId="20577"/>
          <ac:graphicFrameMkLst>
            <pc:docMk/>
            <pc:sldMk cId="3228625230" sldId="289"/>
            <ac:graphicFrameMk id="29" creationId="{BC405748-4B2C-FA41-AF30-80A906608DE3}"/>
          </ac:graphicFrameMkLst>
        </pc:graphicFrame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12" creationId="{7C85399F-93F3-C340-B67F-8D7FCB06AC64}"/>
          </ac:picMkLst>
        </pc:pic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14" creationId="{79FC27D1-6AEB-2C4F-8603-86553948EE98}"/>
          </ac:picMkLst>
        </pc:pic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16" creationId="{51D04699-A84F-3C44-81DE-0A05F5CBDCCD}"/>
          </ac:picMkLst>
        </pc:pic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18" creationId="{B459A2BC-8172-5F41-881F-534AA8597A5E}"/>
          </ac:picMkLst>
        </pc:pic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20" creationId="{D8C3B42D-60C4-C141-A8FF-5F319D258264}"/>
          </ac:picMkLst>
        </pc:picChg>
        <pc:picChg chg="del">
          <ac:chgData name="Narang, Sonali" userId="9e80b397-6e2f-49b1-9374-ccdad8589140" providerId="ADAL" clId="{8CD0D053-ACF7-084A-967B-8933658524DF}" dt="2021-12-06T19:28:12.397" v="371" actId="478"/>
          <ac:picMkLst>
            <pc:docMk/>
            <pc:sldMk cId="3228625230" sldId="289"/>
            <ac:picMk id="22" creationId="{ACB215F7-DBEF-F943-978A-ECD3D03D267B}"/>
          </ac:picMkLst>
        </pc:picChg>
      </pc:sldChg>
      <pc:sldChg chg="addSp delSp modSp add mod ord">
        <pc:chgData name="Narang, Sonali" userId="9e80b397-6e2f-49b1-9374-ccdad8589140" providerId="ADAL" clId="{8CD0D053-ACF7-084A-967B-8933658524DF}" dt="2021-12-17T14:20:21.194" v="1212" actId="20577"/>
        <pc:sldMkLst>
          <pc:docMk/>
          <pc:sldMk cId="2292075898" sldId="290"/>
        </pc:sldMkLst>
        <pc:spChg chg="mod">
          <ac:chgData name="Narang, Sonali" userId="9e80b397-6e2f-49b1-9374-ccdad8589140" providerId="ADAL" clId="{8CD0D053-ACF7-084A-967B-8933658524DF}" dt="2021-12-15T17:18:38.276" v="999" actId="1076"/>
          <ac:spMkLst>
            <pc:docMk/>
            <pc:sldMk cId="2292075898" sldId="290"/>
            <ac:spMk id="6" creationId="{41464C80-B659-484D-A16F-8018DEC5471A}"/>
          </ac:spMkLst>
        </pc:spChg>
        <pc:spChg chg="add mod topLvl">
          <ac:chgData name="Narang, Sonali" userId="9e80b397-6e2f-49b1-9374-ccdad8589140" providerId="ADAL" clId="{8CD0D053-ACF7-084A-967B-8933658524DF}" dt="2021-12-15T17:35:59.053" v="1105" actId="165"/>
          <ac:spMkLst>
            <pc:docMk/>
            <pc:sldMk cId="2292075898" sldId="290"/>
            <ac:spMk id="14" creationId="{32BF80A4-94CE-B84E-AA4F-8B6700FF56A3}"/>
          </ac:spMkLst>
        </pc:spChg>
        <pc:spChg chg="add mod topLvl">
          <ac:chgData name="Narang, Sonali" userId="9e80b397-6e2f-49b1-9374-ccdad8589140" providerId="ADAL" clId="{8CD0D053-ACF7-084A-967B-8933658524DF}" dt="2021-12-15T17:35:59.053" v="1105" actId="165"/>
          <ac:spMkLst>
            <pc:docMk/>
            <pc:sldMk cId="2292075898" sldId="290"/>
            <ac:spMk id="15" creationId="{9A8A3B8B-9778-FA42-9C46-006F0C7C23A4}"/>
          </ac:spMkLst>
        </pc:spChg>
        <pc:spChg chg="add mod topLvl">
          <ac:chgData name="Narang, Sonali" userId="9e80b397-6e2f-49b1-9374-ccdad8589140" providerId="ADAL" clId="{8CD0D053-ACF7-084A-967B-8933658524DF}" dt="2021-12-15T17:36:04.332" v="1106" actId="165"/>
          <ac:spMkLst>
            <pc:docMk/>
            <pc:sldMk cId="2292075898" sldId="290"/>
            <ac:spMk id="19" creationId="{16033834-004C-3A4D-9FB3-F89BFC05F8D8}"/>
          </ac:spMkLst>
        </pc:spChg>
        <pc:spChg chg="add mod topLvl">
          <ac:chgData name="Narang, Sonali" userId="9e80b397-6e2f-49b1-9374-ccdad8589140" providerId="ADAL" clId="{8CD0D053-ACF7-084A-967B-8933658524DF}" dt="2021-12-15T17:36:51.359" v="1142" actId="1037"/>
          <ac:spMkLst>
            <pc:docMk/>
            <pc:sldMk cId="2292075898" sldId="290"/>
            <ac:spMk id="20" creationId="{A772E4AF-5CB9-0445-9B5C-A48D1894885D}"/>
          </ac:spMkLst>
        </pc:spChg>
        <pc:spChg chg="add mod">
          <ac:chgData name="Narang, Sonali" userId="9e80b397-6e2f-49b1-9374-ccdad8589140" providerId="ADAL" clId="{8CD0D053-ACF7-084A-967B-8933658524DF}" dt="2021-12-15T17:37:15.883" v="1160" actId="20577"/>
          <ac:spMkLst>
            <pc:docMk/>
            <pc:sldMk cId="2292075898" sldId="290"/>
            <ac:spMk id="29" creationId="{6DE777E4-0E78-5748-98C2-6D8A189FA44F}"/>
          </ac:spMkLst>
        </pc:spChg>
        <pc:spChg chg="add mod">
          <ac:chgData name="Narang, Sonali" userId="9e80b397-6e2f-49b1-9374-ccdad8589140" providerId="ADAL" clId="{8CD0D053-ACF7-084A-967B-8933658524DF}" dt="2021-12-15T17:37:09.534" v="1154" actId="20577"/>
          <ac:spMkLst>
            <pc:docMk/>
            <pc:sldMk cId="2292075898" sldId="290"/>
            <ac:spMk id="30" creationId="{EB954CE7-58C5-7244-A98A-7B0AD3957226}"/>
          </ac:spMkLst>
        </pc:spChg>
        <pc:grpChg chg="add del mod">
          <ac:chgData name="Narang, Sonali" userId="9e80b397-6e2f-49b1-9374-ccdad8589140" providerId="ADAL" clId="{8CD0D053-ACF7-084A-967B-8933658524DF}" dt="2021-12-15T17:35:59.053" v="1105" actId="165"/>
          <ac:grpSpMkLst>
            <pc:docMk/>
            <pc:sldMk cId="2292075898" sldId="290"/>
            <ac:grpSpMk id="21" creationId="{4029B25D-75C8-4B44-B6FE-CCBC5D030F14}"/>
          </ac:grpSpMkLst>
        </pc:grpChg>
        <pc:grpChg chg="add del mod">
          <ac:chgData name="Narang, Sonali" userId="9e80b397-6e2f-49b1-9374-ccdad8589140" providerId="ADAL" clId="{8CD0D053-ACF7-084A-967B-8933658524DF}" dt="2021-12-15T17:36:04.332" v="1106" actId="165"/>
          <ac:grpSpMkLst>
            <pc:docMk/>
            <pc:sldMk cId="2292075898" sldId="290"/>
            <ac:grpSpMk id="22" creationId="{C89E08ED-7D3C-4640-A785-D45F61207C3D}"/>
          </ac:grpSpMkLst>
        </pc:grpChg>
        <pc:grpChg chg="add del mod">
          <ac:chgData name="Narang, Sonali" userId="9e80b397-6e2f-49b1-9374-ccdad8589140" providerId="ADAL" clId="{8CD0D053-ACF7-084A-967B-8933658524DF}" dt="2021-12-15T17:40:32.469" v="1169" actId="478"/>
          <ac:grpSpMkLst>
            <pc:docMk/>
            <pc:sldMk cId="2292075898" sldId="290"/>
            <ac:grpSpMk id="31" creationId="{725E3FBE-8906-3549-8249-0581DDBDC007}"/>
          </ac:grpSpMkLst>
        </pc:grpChg>
        <pc:grpChg chg="add del mod">
          <ac:chgData name="Narang, Sonali" userId="9e80b397-6e2f-49b1-9374-ccdad8589140" providerId="ADAL" clId="{8CD0D053-ACF7-084A-967B-8933658524DF}" dt="2021-12-15T17:40:32.469" v="1169" actId="478"/>
          <ac:grpSpMkLst>
            <pc:docMk/>
            <pc:sldMk cId="2292075898" sldId="290"/>
            <ac:grpSpMk id="32" creationId="{31F4E677-ED3A-2344-A81A-DB2CEE0B16D2}"/>
          </ac:grpSpMkLst>
        </pc:grpChg>
        <pc:grpChg chg="add del mod">
          <ac:chgData name="Narang, Sonali" userId="9e80b397-6e2f-49b1-9374-ccdad8589140" providerId="ADAL" clId="{8CD0D053-ACF7-084A-967B-8933658524DF}" dt="2021-12-15T17:40:32.469" v="1169" actId="478"/>
          <ac:grpSpMkLst>
            <pc:docMk/>
            <pc:sldMk cId="2292075898" sldId="290"/>
            <ac:grpSpMk id="33" creationId="{9D2B34BD-E30E-4840-8A12-B119532E3639}"/>
          </ac:grpSpMkLst>
        </pc:grpChg>
        <pc:graphicFrameChg chg="add mod modGraphic">
          <ac:chgData name="Narang, Sonali" userId="9e80b397-6e2f-49b1-9374-ccdad8589140" providerId="ADAL" clId="{8CD0D053-ACF7-084A-967B-8933658524DF}" dt="2021-12-17T14:20:21.194" v="1212" actId="20577"/>
          <ac:graphicFrameMkLst>
            <pc:docMk/>
            <pc:sldMk cId="2292075898" sldId="290"/>
            <ac:graphicFrameMk id="16" creationId="{14172837-94DE-3847-8367-932256827593}"/>
          </ac:graphicFrameMkLst>
        </pc:graphicFrameChg>
        <pc:picChg chg="add del mod">
          <ac:chgData name="Narang, Sonali" userId="9e80b397-6e2f-49b1-9374-ccdad8589140" providerId="ADAL" clId="{8CD0D053-ACF7-084A-967B-8933658524DF}" dt="2021-12-15T17:16:15.357" v="933" actId="478"/>
          <ac:picMkLst>
            <pc:docMk/>
            <pc:sldMk cId="2292075898" sldId="290"/>
            <ac:picMk id="3" creationId="{298D6E10-87E9-DD42-A1C2-03189F0FAD7C}"/>
          </ac:picMkLst>
        </pc:picChg>
        <pc:picChg chg="add del mod">
          <ac:chgData name="Narang, Sonali" userId="9e80b397-6e2f-49b1-9374-ccdad8589140" providerId="ADAL" clId="{8CD0D053-ACF7-084A-967B-8933658524DF}" dt="2021-12-15T17:17:48.952" v="974" actId="478"/>
          <ac:picMkLst>
            <pc:docMk/>
            <pc:sldMk cId="2292075898" sldId="290"/>
            <ac:picMk id="8" creationId="{FB2830CB-E528-4140-84C1-2C8519B34825}"/>
          </ac:picMkLst>
        </pc:picChg>
        <pc:picChg chg="del">
          <ac:chgData name="Narang, Sonali" userId="9e80b397-6e2f-49b1-9374-ccdad8589140" providerId="ADAL" clId="{8CD0D053-ACF7-084A-967B-8933658524DF}" dt="2021-12-15T17:15:22.799" v="929" actId="478"/>
          <ac:picMkLst>
            <pc:docMk/>
            <pc:sldMk cId="2292075898" sldId="290"/>
            <ac:picMk id="9" creationId="{FBB68F08-64CC-564C-BE82-2B24199B4BD0}"/>
          </ac:picMkLst>
        </pc:picChg>
        <pc:picChg chg="add del mod topLvl">
          <ac:chgData name="Narang, Sonali" userId="9e80b397-6e2f-49b1-9374-ccdad8589140" providerId="ADAL" clId="{8CD0D053-ACF7-084A-967B-8933658524DF}" dt="2021-12-15T17:36:06.059" v="1107" actId="478"/>
          <ac:picMkLst>
            <pc:docMk/>
            <pc:sldMk cId="2292075898" sldId="290"/>
            <ac:picMk id="11" creationId="{B3AE415D-2D6C-A747-9112-59459EA57948}"/>
          </ac:picMkLst>
        </pc:picChg>
        <pc:picChg chg="del">
          <ac:chgData name="Narang, Sonali" userId="9e80b397-6e2f-49b1-9374-ccdad8589140" providerId="ADAL" clId="{8CD0D053-ACF7-084A-967B-8933658524DF}" dt="2021-12-15T17:15:22.799" v="929" actId="478"/>
          <ac:picMkLst>
            <pc:docMk/>
            <pc:sldMk cId="2292075898" sldId="290"/>
            <ac:picMk id="12" creationId="{CD0563F0-C751-FC47-8AE6-EFC466272C78}"/>
          </ac:picMkLst>
        </pc:picChg>
        <pc:picChg chg="del">
          <ac:chgData name="Narang, Sonali" userId="9e80b397-6e2f-49b1-9374-ccdad8589140" providerId="ADAL" clId="{8CD0D053-ACF7-084A-967B-8933658524DF}" dt="2021-12-15T17:15:22.799" v="929" actId="478"/>
          <ac:picMkLst>
            <pc:docMk/>
            <pc:sldMk cId="2292075898" sldId="290"/>
            <ac:picMk id="13" creationId="{1C6603AB-6BB9-3C48-887A-598542F56407}"/>
          </ac:picMkLst>
        </pc:picChg>
        <pc:picChg chg="add del mod topLvl">
          <ac:chgData name="Narang, Sonali" userId="9e80b397-6e2f-49b1-9374-ccdad8589140" providerId="ADAL" clId="{8CD0D053-ACF7-084A-967B-8933658524DF}" dt="2021-12-15T17:36:06.059" v="1107" actId="478"/>
          <ac:picMkLst>
            <pc:docMk/>
            <pc:sldMk cId="2292075898" sldId="290"/>
            <ac:picMk id="18" creationId="{650F9E6F-45D5-814E-9027-9CE19EEE8928}"/>
          </ac:picMkLst>
        </pc:picChg>
        <pc:picChg chg="add mod">
          <ac:chgData name="Narang, Sonali" userId="9e80b397-6e2f-49b1-9374-ccdad8589140" providerId="ADAL" clId="{8CD0D053-ACF7-084A-967B-8933658524DF}" dt="2021-12-15T17:36:44.995" v="1136" actId="1038"/>
          <ac:picMkLst>
            <pc:docMk/>
            <pc:sldMk cId="2292075898" sldId="290"/>
            <ac:picMk id="24" creationId="{D0767943-EBDE-D240-AFEB-F05238DE3054}"/>
          </ac:picMkLst>
        </pc:picChg>
        <pc:picChg chg="add mod">
          <ac:chgData name="Narang, Sonali" userId="9e80b397-6e2f-49b1-9374-ccdad8589140" providerId="ADAL" clId="{8CD0D053-ACF7-084A-967B-8933658524DF}" dt="2021-12-15T17:36:44.995" v="1136" actId="1038"/>
          <ac:picMkLst>
            <pc:docMk/>
            <pc:sldMk cId="2292075898" sldId="290"/>
            <ac:picMk id="26" creationId="{4C3695C9-3BA1-2249-A1A2-22D2D09E6772}"/>
          </ac:picMkLst>
        </pc:picChg>
        <pc:picChg chg="add mod">
          <ac:chgData name="Narang, Sonali" userId="9e80b397-6e2f-49b1-9374-ccdad8589140" providerId="ADAL" clId="{8CD0D053-ACF7-084A-967B-8933658524DF}" dt="2021-12-15T17:36:44.995" v="1136" actId="1038"/>
          <ac:picMkLst>
            <pc:docMk/>
            <pc:sldMk cId="2292075898" sldId="290"/>
            <ac:picMk id="28" creationId="{7EF953D4-FB49-E149-8743-90C4CD1CEF4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08CA49-8780-2348-A359-5245F35A6545}" type="datetimeFigureOut">
              <a:rPr lang="en-US" smtClean="0"/>
              <a:t>1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A9BB06-E02B-264B-BD00-C237A1458E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7951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baseline="0" dirty="0"/>
              <a:t>Figure S1. a.</a:t>
            </a:r>
            <a:r>
              <a:rPr lang="en-US" sz="1200" b="0" baseline="0" dirty="0"/>
              <a:t> </a:t>
            </a:r>
            <a:r>
              <a:rPr lang="en-US" sz="1200" baseline="0" dirty="0"/>
              <a:t>Hi-C million read counts (left) and read percentage (right) per cell line.</a:t>
            </a:r>
            <a:r>
              <a:rPr lang="en-US" sz="1200" b="1" baseline="0" dirty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5725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2. a</a:t>
            </a:r>
            <a:r>
              <a:rPr lang="en-US" dirty="0"/>
              <a:t>. </a:t>
            </a:r>
            <a:r>
              <a:rPr lang="en-US" sz="1200" baseline="0" dirty="0"/>
              <a:t>Venn diagram showing overlap of differentially expressed genes (abs(L2FC) &gt; 0.32, p-value &lt; 0.05) between three B-ALL cell lines upon knockdown, decreased and increased genes (left and right respectively). </a:t>
            </a:r>
            <a:r>
              <a:rPr lang="en-US" sz="1200" b="1" baseline="0" dirty="0"/>
              <a:t>b</a:t>
            </a:r>
            <a:r>
              <a:rPr lang="en-US" b="1" dirty="0"/>
              <a:t>. </a:t>
            </a:r>
            <a:r>
              <a:rPr lang="en-US" dirty="0"/>
              <a:t>Volcano plots demonstrating differentially expressed genes (abs(L2FC) &gt; 0.32, p-value &lt; 0.05) highlighted by compartment switch or shift (A to more A, B to A, B to less B, or stable). </a:t>
            </a:r>
            <a:r>
              <a:rPr lang="en-US" b="1" dirty="0"/>
              <a:t>c. </a:t>
            </a:r>
            <a:r>
              <a:rPr lang="en-US" b="0" dirty="0"/>
              <a:t>Scatterplot demonstrating compartments colored by concordance score (percentage of genes with that compartment switch or shift that change in the same direction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6855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3.  </a:t>
            </a:r>
            <a:r>
              <a:rPr lang="en-US" sz="1200" kern="0" dirty="0">
                <a:solidFill>
                  <a:schemeClr val="bg1"/>
                </a:solidFill>
                <a:latin typeface="Arial"/>
              </a:rPr>
              <a:t>Rate of concordance</a:t>
            </a:r>
            <a:r>
              <a:rPr lang="en-US" b="0" dirty="0"/>
              <a:t> calculations represent the amount of upregulated and downregulated genes (abs(L2FC) &gt; 0.32, p-value &lt; 0.05) that can be explained by compartment switches and shift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8486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4. </a:t>
            </a:r>
            <a:r>
              <a:rPr lang="en-US" sz="1200" b="1" baseline="0" dirty="0"/>
              <a:t> a.</a:t>
            </a:r>
            <a:r>
              <a:rPr lang="en-US" sz="1200" b="0" baseline="0" dirty="0"/>
              <a:t> </a:t>
            </a:r>
            <a:r>
              <a:rPr lang="en-US" sz="1200" dirty="0" err="1"/>
              <a:t>Barplot</a:t>
            </a:r>
            <a:r>
              <a:rPr lang="en-US" sz="1200" dirty="0"/>
              <a:t> showing number of subcompartment calls with SNIPER for each cell line at NSD2 Low and NSD2 High.</a:t>
            </a:r>
            <a:r>
              <a:rPr lang="en-US" b="1" dirty="0"/>
              <a:t> b. </a:t>
            </a:r>
            <a:r>
              <a:rPr lang="en-US" b="0" dirty="0" err="1"/>
              <a:t>Barplots</a:t>
            </a:r>
            <a:r>
              <a:rPr lang="en-US" b="0" dirty="0"/>
              <a:t> presenting fraction of Cscore compartment calls (A or B) overlapping SNIPER subcompartment calls (A1, A2, B1, B2, and B3) </a:t>
            </a:r>
            <a:r>
              <a:rPr lang="en-US" sz="1200" dirty="0"/>
              <a:t> </a:t>
            </a:r>
            <a:r>
              <a:rPr lang="en-US" b="1" dirty="0"/>
              <a:t>c.</a:t>
            </a:r>
            <a:r>
              <a:rPr lang="en-US" dirty="0"/>
              <a:t> </a:t>
            </a:r>
            <a:r>
              <a:rPr lang="en-US" sz="1200" dirty="0" err="1"/>
              <a:t>Barplot</a:t>
            </a:r>
            <a:r>
              <a:rPr lang="en-US" sz="1200" dirty="0"/>
              <a:t> showing number of subcompartment calls with SNIPER for each cell line at NSD2 Low and NSD2 High excluding B1 subcompartment calls.</a:t>
            </a:r>
            <a:r>
              <a:rPr lang="en-US" b="1" dirty="0"/>
              <a:t> d. </a:t>
            </a:r>
            <a:r>
              <a:rPr lang="en-US" b="0" dirty="0" err="1"/>
              <a:t>Barplot</a:t>
            </a:r>
            <a:r>
              <a:rPr lang="en-US" b="0" dirty="0"/>
              <a:t> presenting number of subcompartment switches from A to B and from B to A from NS2D Low to NSD2 High in each of the cell lines. </a:t>
            </a:r>
            <a:r>
              <a:rPr lang="en-US" b="1" dirty="0"/>
              <a:t>e. </a:t>
            </a:r>
            <a:r>
              <a:rPr lang="en-US" b="0" dirty="0" err="1"/>
              <a:t>Barplots</a:t>
            </a:r>
            <a:r>
              <a:rPr lang="en-US" b="0" dirty="0"/>
              <a:t> presenting fraction of SNIPER subcompartment calls overlapping </a:t>
            </a:r>
            <a:r>
              <a:rPr lang="en-US" b="0" dirty="0" err="1"/>
              <a:t>cscore</a:t>
            </a:r>
            <a:r>
              <a:rPr lang="en-US" b="0" dirty="0"/>
              <a:t> compartment switches and shifts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26590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5. </a:t>
            </a:r>
            <a:r>
              <a:rPr lang="en-US" sz="1200" b="1" baseline="0" dirty="0"/>
              <a:t> a. </a:t>
            </a:r>
            <a:r>
              <a:rPr lang="en-US" dirty="0"/>
              <a:t>Correlation boxplots of SNIPER </a:t>
            </a:r>
            <a:r>
              <a:rPr lang="en-US" dirty="0" err="1"/>
              <a:t>subcompartments</a:t>
            </a:r>
            <a:r>
              <a:rPr lang="en-US" dirty="0"/>
              <a:t> and gene expression changes (abs(L2FC) &gt; 0.32, p-value 0.05) for each cell line from NSD2 Low to NSD2 High. </a:t>
            </a:r>
            <a:r>
              <a:rPr lang="en-US" b="1" dirty="0"/>
              <a:t>b. </a:t>
            </a:r>
            <a:r>
              <a:rPr lang="en-US" dirty="0"/>
              <a:t>Volcano plots demonstrate differentially expressed genes (abs(L2FC) &gt; 0.32, p-value &lt; 0.05) highlighted by subcompartment switches and shift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6456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6. a.</a:t>
            </a:r>
            <a:r>
              <a:rPr lang="en-US" b="0" dirty="0"/>
              <a:t> </a:t>
            </a:r>
            <a:r>
              <a:rPr lang="en-US" dirty="0"/>
              <a:t>PCA of ATAC-seq peaks for each cell line identifies three distinct clusters which are cell line-specific. </a:t>
            </a:r>
            <a:r>
              <a:rPr lang="en-US" b="1" dirty="0"/>
              <a:t>b. </a:t>
            </a:r>
            <a:r>
              <a:rPr lang="en-US" dirty="0"/>
              <a:t>Heat map representation of ATAC-seq results generated with </a:t>
            </a:r>
            <a:r>
              <a:rPr lang="en-US" dirty="0" err="1"/>
              <a:t>DiffBind</a:t>
            </a:r>
            <a:r>
              <a:rPr lang="en-US" dirty="0"/>
              <a:t>. </a:t>
            </a:r>
            <a:r>
              <a:rPr lang="en-US" b="1" dirty="0"/>
              <a:t>c.</a:t>
            </a:r>
            <a:r>
              <a:rPr lang="en-US" dirty="0"/>
              <a:t> Venn Diagram showing overlap of differentially accessible regions between three B-ALL cell lines downregulated and upregulated (top and bottom respectively; (FDR &lt; 0.01, abs(log2(fold change)) &gt; 1). </a:t>
            </a:r>
            <a:r>
              <a:rPr lang="en-US" sz="1200" b="1" baseline="0" dirty="0"/>
              <a:t>d. </a:t>
            </a:r>
            <a:r>
              <a:rPr lang="en-US" sz="1200" baseline="0" dirty="0"/>
              <a:t>Example of B to A compartment shift shared by all three cell lines at the NEO1 locus showing concordance with gene expression and chromatin accessibility. </a:t>
            </a:r>
            <a:r>
              <a:rPr lang="en-US" sz="1200" b="1" baseline="0" dirty="0"/>
              <a:t>e.</a:t>
            </a:r>
            <a:r>
              <a:rPr lang="en-US" sz="1200" baseline="0" dirty="0"/>
              <a:t> Example of B to A compartment shift specific to RS4;11 cell line at the PRDM8 locus showing concordance with gene expression and chromatin accessibility.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2064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baseline="0" dirty="0"/>
              <a:t>Figure S7.</a:t>
            </a:r>
            <a:r>
              <a:rPr lang="en-US" b="1" dirty="0"/>
              <a:t> a. </a:t>
            </a:r>
            <a:r>
              <a:rPr lang="en-US" dirty="0"/>
              <a:t>Heatmap representation of mean intra-TAD activity per cell line. </a:t>
            </a:r>
            <a:r>
              <a:rPr lang="en-US" b="1" dirty="0"/>
              <a:t>b.</a:t>
            </a:r>
            <a:r>
              <a:rPr lang="en-US" dirty="0"/>
              <a:t> Bar plot showing number of TAD activity changes per cell line (abs(L2FC) &gt; 0.25, FDR &lt; 0.01).</a:t>
            </a:r>
            <a:r>
              <a:rPr lang="en-US" sz="1200" b="0" baseline="0" dirty="0"/>
              <a:t> </a:t>
            </a:r>
            <a:r>
              <a:rPr lang="en-US" sz="1200" b="1" baseline="0" dirty="0"/>
              <a:t>c. </a:t>
            </a:r>
            <a:r>
              <a:rPr lang="en-US" b="0" dirty="0"/>
              <a:t>Venn diagrams demonstrating significant overlap of patient NSD2-High upregulated genes and cell line NSD2-High upregulated genes and insignificant overlap of patient NSD2-High downregulated genes and cell line NSD2-High upregulated genes (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e-tailed Fisher’s exact test)</a:t>
            </a:r>
            <a:r>
              <a:rPr lang="en-US" b="0" dirty="0"/>
              <a:t>. The last row presents insignificant overlap of genes upregulated in 9 matched D/R patient pairs with no NSD2 mutation (NSD2 Low) and cell line NSD2-High upregulated genes with a B to A compartment switch or shift. </a:t>
            </a:r>
            <a:r>
              <a:rPr lang="en-US" b="1" dirty="0"/>
              <a:t>d. </a:t>
            </a:r>
            <a:r>
              <a:rPr lang="en-US" b="0" dirty="0"/>
              <a:t>Table presenting percentage of patient NSD2-High upregulated genes overlapping a compartment switch/shift from any of the three cell lines. </a:t>
            </a:r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83007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8.  </a:t>
            </a:r>
            <a:r>
              <a:rPr lang="en-US" b="0" dirty="0"/>
              <a:t>Table presents patient information associated with the three matched diagnosis-relapse pairs acquired from COG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12427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9.  a. </a:t>
            </a:r>
            <a:r>
              <a:rPr lang="en-US" sz="12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Rate of concordance</a:t>
            </a:r>
            <a:r>
              <a:rPr lang="en-US" b="0" dirty="0"/>
              <a:t> calculations present the number of genes upregulated in expression, increased in H3K36me2 </a:t>
            </a:r>
            <a:r>
              <a:rPr lang="en-US" b="0" dirty="0" err="1"/>
              <a:t>ChIP</a:t>
            </a:r>
            <a:r>
              <a:rPr lang="en-US" b="0" dirty="0"/>
              <a:t>-seq peaks, and B to A compartment shifts and switches for the RCH, RS4;11, and SEM cell lines. </a:t>
            </a:r>
            <a:r>
              <a:rPr lang="en-US" b="1" dirty="0"/>
              <a:t>b. </a:t>
            </a:r>
            <a:r>
              <a:rPr lang="en-US" dirty="0"/>
              <a:t>Association </a:t>
            </a:r>
            <a:r>
              <a:rPr lang="en-US" dirty="0" err="1"/>
              <a:t>barplots</a:t>
            </a:r>
            <a:r>
              <a:rPr lang="en-US" dirty="0"/>
              <a:t> showing fraction of differential H3K36me2 chip-seq peaks (decreased, increased, and stable) that overlap changes in intra-TAD activity (increased, decreased, and stable TADs)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A9BB06-E02B-264B-BD00-C237A1458E05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5503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358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605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737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712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81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796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967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67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453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7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32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53DB3-4289-6044-8846-FB55A95D0CF1}" type="datetimeFigureOut">
              <a:rPr lang="en-US" smtClean="0"/>
              <a:t>1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7C2E7-1EAB-5343-902D-42DED6461F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810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4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9CDA57FA-1198-9B4F-940C-7903153641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017"/>
          <a:stretch/>
        </p:blipFill>
        <p:spPr>
          <a:xfrm>
            <a:off x="3839228" y="301714"/>
            <a:ext cx="2156620" cy="2567912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85FB7F86-5BAF-D041-8C2E-CAE9C81D11A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017"/>
          <a:stretch/>
        </p:blipFill>
        <p:spPr>
          <a:xfrm>
            <a:off x="848040" y="301714"/>
            <a:ext cx="2156620" cy="25679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6669B9D-B042-D548-BD0F-97015091799B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AFFEC37-A0C5-5846-8534-22E3DEF6CEF4}"/>
              </a:ext>
            </a:extLst>
          </p:cNvPr>
          <p:cNvSpPr txBox="1"/>
          <p:nvPr/>
        </p:nvSpPr>
        <p:spPr>
          <a:xfrm>
            <a:off x="157506" y="35942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7DF425C-8C95-EF48-AE1B-9A37CA1698E0}"/>
              </a:ext>
            </a:extLst>
          </p:cNvPr>
          <p:cNvGrpSpPr/>
          <p:nvPr/>
        </p:nvGrpSpPr>
        <p:grpSpPr>
          <a:xfrm>
            <a:off x="84689" y="823951"/>
            <a:ext cx="785793" cy="1710874"/>
            <a:chOff x="84689" y="823951"/>
            <a:chExt cx="785793" cy="1710874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482EB10-BC65-7742-9F9A-C8E6179C9F00}"/>
                </a:ext>
              </a:extLst>
            </p:cNvPr>
            <p:cNvSpPr txBox="1"/>
            <p:nvPr/>
          </p:nvSpPr>
          <p:spPr>
            <a:xfrm>
              <a:off x="147207" y="823951"/>
              <a:ext cx="630301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882E5B6-51CB-0E4E-98CD-A1543D1D9B29}"/>
                </a:ext>
              </a:extLst>
            </p:cNvPr>
            <p:cNvSpPr txBox="1"/>
            <p:nvPr/>
          </p:nvSpPr>
          <p:spPr>
            <a:xfrm>
              <a:off x="158427" y="1115291"/>
              <a:ext cx="652743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67D5BDE-1C52-044D-8DF4-14BCB0ED0FB9}"/>
                </a:ext>
              </a:extLst>
            </p:cNvPr>
            <p:cNvSpPr txBox="1"/>
            <p:nvPr/>
          </p:nvSpPr>
          <p:spPr>
            <a:xfrm>
              <a:off x="84689" y="1406631"/>
              <a:ext cx="752129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7082FB9-D9DD-9B46-AB0D-77C63E208142}"/>
                </a:ext>
              </a:extLst>
            </p:cNvPr>
            <p:cNvSpPr txBox="1"/>
            <p:nvPr/>
          </p:nvSpPr>
          <p:spPr>
            <a:xfrm>
              <a:off x="95911" y="1697971"/>
              <a:ext cx="774571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4EFDA2E-01BB-5C4D-BFA4-1B654C633262}"/>
                </a:ext>
              </a:extLst>
            </p:cNvPr>
            <p:cNvSpPr txBox="1"/>
            <p:nvPr/>
          </p:nvSpPr>
          <p:spPr>
            <a:xfrm>
              <a:off x="153619" y="1989311"/>
              <a:ext cx="628698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B6E0053-C3C0-954D-BD99-12FE11770FF5}"/>
                </a:ext>
              </a:extLst>
            </p:cNvPr>
            <p:cNvSpPr txBox="1"/>
            <p:nvPr/>
          </p:nvSpPr>
          <p:spPr>
            <a:xfrm>
              <a:off x="164839" y="2280653"/>
              <a:ext cx="651140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94EF64BB-6C18-C844-ADCD-FA540E5D2A21}"/>
              </a:ext>
            </a:extLst>
          </p:cNvPr>
          <p:cNvGrpSpPr/>
          <p:nvPr/>
        </p:nvGrpSpPr>
        <p:grpSpPr>
          <a:xfrm>
            <a:off x="3098237" y="823951"/>
            <a:ext cx="785793" cy="1710874"/>
            <a:chOff x="3098237" y="823951"/>
            <a:chExt cx="785793" cy="171087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213DA13-9A0F-094F-B9BB-3833A654F806}"/>
                </a:ext>
              </a:extLst>
            </p:cNvPr>
            <p:cNvSpPr txBox="1"/>
            <p:nvPr/>
          </p:nvSpPr>
          <p:spPr>
            <a:xfrm>
              <a:off x="3160755" y="823951"/>
              <a:ext cx="630301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76AAB1C-9B21-624A-86D0-3955181A06CB}"/>
                </a:ext>
              </a:extLst>
            </p:cNvPr>
            <p:cNvSpPr txBox="1"/>
            <p:nvPr/>
          </p:nvSpPr>
          <p:spPr>
            <a:xfrm>
              <a:off x="3171975" y="1115291"/>
              <a:ext cx="652743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78B4FA7-538E-1B4B-96E0-2825C9C14C3E}"/>
                </a:ext>
              </a:extLst>
            </p:cNvPr>
            <p:cNvSpPr txBox="1"/>
            <p:nvPr/>
          </p:nvSpPr>
          <p:spPr>
            <a:xfrm>
              <a:off x="3098237" y="1406631"/>
              <a:ext cx="752129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6BA6AB2-3E59-4E49-A7B2-C2C829B1304A}"/>
                </a:ext>
              </a:extLst>
            </p:cNvPr>
            <p:cNvSpPr txBox="1"/>
            <p:nvPr/>
          </p:nvSpPr>
          <p:spPr>
            <a:xfrm>
              <a:off x="3109459" y="1697971"/>
              <a:ext cx="774571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FA6B5BD-099D-0A4E-89E1-6DD379FE4966}"/>
                </a:ext>
              </a:extLst>
            </p:cNvPr>
            <p:cNvSpPr txBox="1"/>
            <p:nvPr/>
          </p:nvSpPr>
          <p:spPr>
            <a:xfrm>
              <a:off x="3167167" y="1989311"/>
              <a:ext cx="628698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0D8070-7A7B-AD49-BEFD-379D5F209C30}"/>
                </a:ext>
              </a:extLst>
            </p:cNvPr>
            <p:cNvSpPr txBox="1"/>
            <p:nvPr/>
          </p:nvSpPr>
          <p:spPr>
            <a:xfrm>
              <a:off x="3178387" y="2280653"/>
              <a:ext cx="651140" cy="2541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55223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6821CDC2-5374-8348-98F5-C090BA03C8B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1846"/>
          <a:stretch/>
        </p:blipFill>
        <p:spPr>
          <a:xfrm>
            <a:off x="185508" y="4570630"/>
            <a:ext cx="1911026" cy="162588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E3C6EA1D-E6B3-B943-9F00-A3F1DA6DE0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5299" y="4570630"/>
            <a:ext cx="2167842" cy="162588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217648D-794D-E743-9395-81F06061CB7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1846"/>
          <a:stretch/>
        </p:blipFill>
        <p:spPr>
          <a:xfrm>
            <a:off x="2360403" y="4570630"/>
            <a:ext cx="1911026" cy="162588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AFFEC37-A0C5-5846-8534-22E3DEF6CEF4}"/>
              </a:ext>
            </a:extLst>
          </p:cNvPr>
          <p:cNvSpPr txBox="1"/>
          <p:nvPr/>
        </p:nvSpPr>
        <p:spPr>
          <a:xfrm>
            <a:off x="60435" y="35942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55ACA25-EBE0-DD45-930F-AD76C4C0A2A8}"/>
              </a:ext>
            </a:extLst>
          </p:cNvPr>
          <p:cNvSpPr txBox="1"/>
          <p:nvPr/>
        </p:nvSpPr>
        <p:spPr>
          <a:xfrm>
            <a:off x="65244" y="235796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D470D811-2477-3546-A8D8-048846B3651A}"/>
              </a:ext>
            </a:extLst>
          </p:cNvPr>
          <p:cNvGrpSpPr/>
          <p:nvPr/>
        </p:nvGrpSpPr>
        <p:grpSpPr>
          <a:xfrm>
            <a:off x="0" y="434492"/>
            <a:ext cx="3894152" cy="1828335"/>
            <a:chOff x="2680962" y="5177979"/>
            <a:chExt cx="3894152" cy="1828335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C2A0FE4-DCE7-714B-B72E-0B54F12A3880}"/>
                </a:ext>
              </a:extLst>
            </p:cNvPr>
            <p:cNvSpPr txBox="1"/>
            <p:nvPr/>
          </p:nvSpPr>
          <p:spPr>
            <a:xfrm>
              <a:off x="3297414" y="6698537"/>
              <a:ext cx="6174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ecreased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732AF6E-A205-D849-8F98-05F27C157AE6}"/>
                </a:ext>
              </a:extLst>
            </p:cNvPr>
            <p:cNvSpPr txBox="1"/>
            <p:nvPr/>
          </p:nvSpPr>
          <p:spPr>
            <a:xfrm>
              <a:off x="5349465" y="6694114"/>
              <a:ext cx="6174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increased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88C754A9-AA55-D74F-8DE3-1C8CF5775FCB}"/>
                </a:ext>
              </a:extLst>
            </p:cNvPr>
            <p:cNvGrpSpPr/>
            <p:nvPr/>
          </p:nvGrpSpPr>
          <p:grpSpPr>
            <a:xfrm>
              <a:off x="4957992" y="5405279"/>
              <a:ext cx="1325311" cy="1241267"/>
              <a:chOff x="720599" y="5725595"/>
              <a:chExt cx="1325311" cy="1241267"/>
            </a:xfrm>
          </p:grpSpPr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C4E9D8D4-FC13-7D45-B882-3D7E3B934C3E}"/>
                  </a:ext>
                </a:extLst>
              </p:cNvPr>
              <p:cNvGrpSpPr/>
              <p:nvPr/>
            </p:nvGrpSpPr>
            <p:grpSpPr>
              <a:xfrm>
                <a:off x="720599" y="5725595"/>
                <a:ext cx="1325311" cy="1241267"/>
                <a:chOff x="759244" y="5782804"/>
                <a:chExt cx="2871223" cy="2707894"/>
              </a:xfrm>
            </p:grpSpPr>
            <p:sp>
              <p:nvSpPr>
                <p:cNvPr id="61" name="Freeform 60">
                  <a:extLst>
                    <a:ext uri="{FF2B5EF4-FFF2-40B4-BE49-F238E27FC236}">
                      <a16:creationId xmlns:a16="http://schemas.microsoft.com/office/drawing/2014/main" id="{FC1C0D10-87A7-4243-8678-5514D2F29956}"/>
                    </a:ext>
                  </a:extLst>
                </p:cNvPr>
                <p:cNvSpPr/>
                <p:nvPr/>
              </p:nvSpPr>
              <p:spPr>
                <a:xfrm>
                  <a:off x="1280456" y="5782804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243841" tIns="320040" rIns="243839" bIns="685800" numCol="1" spcCol="1270" anchor="ctr" anchorCtr="0">
                  <a:noAutofit/>
                </a:bodyPr>
                <a:lstStyle/>
                <a:p>
                  <a:pPr marL="0" lvl="0" indent="0" algn="ctr" defTabSz="20447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4600" kern="1200"/>
                </a:p>
              </p:txBody>
            </p:sp>
            <p:sp>
              <p:nvSpPr>
                <p:cNvPr id="62" name="Freeform 61">
                  <a:extLst>
                    <a:ext uri="{FF2B5EF4-FFF2-40B4-BE49-F238E27FC236}">
                      <a16:creationId xmlns:a16="http://schemas.microsoft.com/office/drawing/2014/main" id="{82C2B934-697C-EA44-BEC5-478C948B0590}"/>
                    </a:ext>
                  </a:extLst>
                </p:cNvPr>
                <p:cNvSpPr/>
                <p:nvPr/>
              </p:nvSpPr>
              <p:spPr>
                <a:xfrm>
                  <a:off x="1801667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559308" tIns="472440" rIns="172212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  <p:sp>
              <p:nvSpPr>
                <p:cNvPr id="63" name="Freeform 62">
                  <a:extLst>
                    <a:ext uri="{FF2B5EF4-FFF2-40B4-BE49-F238E27FC236}">
                      <a16:creationId xmlns:a16="http://schemas.microsoft.com/office/drawing/2014/main" id="{C9C6D42A-C6D9-7849-8C5B-4178D8D71A28}"/>
                    </a:ext>
                  </a:extLst>
                </p:cNvPr>
                <p:cNvSpPr/>
                <p:nvPr/>
              </p:nvSpPr>
              <p:spPr>
                <a:xfrm>
                  <a:off x="759244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172212" tIns="472440" rIns="559308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</p:grp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30EF4BB-5676-3B48-8C65-19F74E7421C4}"/>
                  </a:ext>
                </a:extLst>
              </p:cNvPr>
              <p:cNvSpPr txBox="1"/>
              <p:nvPr/>
            </p:nvSpPr>
            <p:spPr>
              <a:xfrm>
                <a:off x="1217057" y="586679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66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F988E475-74C4-3C4F-9891-2EA2F939D523}"/>
                  </a:ext>
                </a:extLst>
              </p:cNvPr>
              <p:cNvSpPr txBox="1"/>
              <p:nvPr/>
            </p:nvSpPr>
            <p:spPr>
              <a:xfrm>
                <a:off x="849061" y="652175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74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D63EC677-39AE-414C-9352-563C974F82EA}"/>
                  </a:ext>
                </a:extLst>
              </p:cNvPr>
              <p:cNvSpPr txBox="1"/>
              <p:nvPr/>
            </p:nvSpPr>
            <p:spPr>
              <a:xfrm>
                <a:off x="1598254" y="652175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6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057C0F8D-04C2-0542-8ABC-5B2FE168C537}"/>
                  </a:ext>
                </a:extLst>
              </p:cNvPr>
              <p:cNvSpPr txBox="1"/>
              <p:nvPr/>
            </p:nvSpPr>
            <p:spPr>
              <a:xfrm>
                <a:off x="1227863" y="628461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5BD00D48-3568-4142-9CE5-0DD04E862D3C}"/>
                  </a:ext>
                </a:extLst>
              </p:cNvPr>
              <p:cNvSpPr txBox="1"/>
              <p:nvPr/>
            </p:nvSpPr>
            <p:spPr>
              <a:xfrm>
                <a:off x="1486299" y="618032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B23BEA0-6350-324D-A12E-7DEB49AF3BE8}"/>
                  </a:ext>
                </a:extLst>
              </p:cNvPr>
              <p:cNvSpPr txBox="1"/>
              <p:nvPr/>
            </p:nvSpPr>
            <p:spPr>
              <a:xfrm>
                <a:off x="1002297" y="618199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97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E62460AA-D9B6-E345-A0C7-8FBD7230EDC2}"/>
                  </a:ext>
                </a:extLst>
              </p:cNvPr>
              <p:cNvSpPr txBox="1"/>
              <p:nvPr/>
            </p:nvSpPr>
            <p:spPr>
              <a:xfrm>
                <a:off x="1197783" y="656178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2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BF559D91-1CC8-3C4E-BAB1-6D863937C698}"/>
                </a:ext>
              </a:extLst>
            </p:cNvPr>
            <p:cNvGrpSpPr/>
            <p:nvPr/>
          </p:nvGrpSpPr>
          <p:grpSpPr>
            <a:xfrm>
              <a:off x="2935820" y="5397065"/>
              <a:ext cx="1325311" cy="1241267"/>
              <a:chOff x="720599" y="5725595"/>
              <a:chExt cx="1325311" cy="1241267"/>
            </a:xfrm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C0BD0F15-50EB-F241-90E6-7D10B0342F29}"/>
                  </a:ext>
                </a:extLst>
              </p:cNvPr>
              <p:cNvGrpSpPr/>
              <p:nvPr/>
            </p:nvGrpSpPr>
            <p:grpSpPr>
              <a:xfrm>
                <a:off x="720599" y="5725595"/>
                <a:ext cx="1325311" cy="1241267"/>
                <a:chOff x="759244" y="5782804"/>
                <a:chExt cx="2871223" cy="2707894"/>
              </a:xfrm>
            </p:grpSpPr>
            <p:sp>
              <p:nvSpPr>
                <p:cNvPr id="50" name="Freeform 49">
                  <a:extLst>
                    <a:ext uri="{FF2B5EF4-FFF2-40B4-BE49-F238E27FC236}">
                      <a16:creationId xmlns:a16="http://schemas.microsoft.com/office/drawing/2014/main" id="{0F0B45AA-52DB-1447-8A33-BBF5E33B5452}"/>
                    </a:ext>
                  </a:extLst>
                </p:cNvPr>
                <p:cNvSpPr/>
                <p:nvPr/>
              </p:nvSpPr>
              <p:spPr>
                <a:xfrm>
                  <a:off x="1280456" y="5782804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243841" tIns="320040" rIns="243839" bIns="685800" numCol="1" spcCol="1270" anchor="ctr" anchorCtr="0">
                  <a:noAutofit/>
                </a:bodyPr>
                <a:lstStyle/>
                <a:p>
                  <a:pPr marL="0" lvl="0" indent="0" algn="ctr" defTabSz="20447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4600" kern="1200"/>
                </a:p>
              </p:txBody>
            </p:sp>
            <p:sp>
              <p:nvSpPr>
                <p:cNvPr id="51" name="Freeform 50">
                  <a:extLst>
                    <a:ext uri="{FF2B5EF4-FFF2-40B4-BE49-F238E27FC236}">
                      <a16:creationId xmlns:a16="http://schemas.microsoft.com/office/drawing/2014/main" id="{E015A8BF-3A6B-9D4E-8103-F499E63459D8}"/>
                    </a:ext>
                  </a:extLst>
                </p:cNvPr>
                <p:cNvSpPr/>
                <p:nvPr/>
              </p:nvSpPr>
              <p:spPr>
                <a:xfrm>
                  <a:off x="1801667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559308" tIns="472440" rIns="172212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  <p:sp>
              <p:nvSpPr>
                <p:cNvPr id="52" name="Freeform 51">
                  <a:extLst>
                    <a:ext uri="{FF2B5EF4-FFF2-40B4-BE49-F238E27FC236}">
                      <a16:creationId xmlns:a16="http://schemas.microsoft.com/office/drawing/2014/main" id="{980B69CD-ADC7-284F-A16B-05F87958BC66}"/>
                    </a:ext>
                  </a:extLst>
                </p:cNvPr>
                <p:cNvSpPr/>
                <p:nvPr/>
              </p:nvSpPr>
              <p:spPr>
                <a:xfrm>
                  <a:off x="759244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172212" tIns="472440" rIns="559308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</p:grp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0550978-24C0-3343-83A5-8C1A9BAE7634}"/>
                  </a:ext>
                </a:extLst>
              </p:cNvPr>
              <p:cNvSpPr txBox="1"/>
              <p:nvPr/>
            </p:nvSpPr>
            <p:spPr>
              <a:xfrm>
                <a:off x="1187973" y="5866790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350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DCDF1E7-F2D5-7040-8B69-A9D74ED63E9D}"/>
                  </a:ext>
                </a:extLst>
              </p:cNvPr>
              <p:cNvSpPr txBox="1"/>
              <p:nvPr/>
            </p:nvSpPr>
            <p:spPr>
              <a:xfrm>
                <a:off x="849061" y="652175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9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0EECBD3B-E09F-6A4A-85ED-701545048DDA}"/>
                  </a:ext>
                </a:extLst>
              </p:cNvPr>
              <p:cNvSpPr txBox="1"/>
              <p:nvPr/>
            </p:nvSpPr>
            <p:spPr>
              <a:xfrm>
                <a:off x="1606353" y="652175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6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A1162E1-4AFD-CB46-A7EE-BE6EE201DCAB}"/>
                  </a:ext>
                </a:extLst>
              </p:cNvPr>
              <p:cNvSpPr txBox="1"/>
              <p:nvPr/>
            </p:nvSpPr>
            <p:spPr>
              <a:xfrm>
                <a:off x="1221119" y="630072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A48E1D2-7D85-BC4B-8305-622111AA60CF}"/>
                  </a:ext>
                </a:extLst>
              </p:cNvPr>
              <p:cNvSpPr txBox="1"/>
              <p:nvPr/>
            </p:nvSpPr>
            <p:spPr>
              <a:xfrm>
                <a:off x="1470115" y="618032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B4179409-2FD8-7C4E-AC9F-D25DB456593D}"/>
                  </a:ext>
                </a:extLst>
              </p:cNvPr>
              <p:cNvSpPr txBox="1"/>
              <p:nvPr/>
            </p:nvSpPr>
            <p:spPr>
              <a:xfrm>
                <a:off x="969929" y="618199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7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1F5B7F0C-765C-174A-8D4A-2F5F300226DF}"/>
                  </a:ext>
                </a:extLst>
              </p:cNvPr>
              <p:cNvSpPr txBox="1"/>
              <p:nvPr/>
            </p:nvSpPr>
            <p:spPr>
              <a:xfrm>
                <a:off x="1218053" y="657657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8</a:t>
                </a:r>
              </a:p>
            </p:txBody>
          </p: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ED63E59-2181-E94A-9EA3-55661FF9C194}"/>
                </a:ext>
              </a:extLst>
            </p:cNvPr>
            <p:cNvSpPr txBox="1"/>
            <p:nvPr/>
          </p:nvSpPr>
          <p:spPr>
            <a:xfrm>
              <a:off x="4067622" y="6523436"/>
              <a:ext cx="4828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B5EFF90-3ECA-284D-978F-76D7C425B772}"/>
                </a:ext>
              </a:extLst>
            </p:cNvPr>
            <p:cNvSpPr txBox="1"/>
            <p:nvPr/>
          </p:nvSpPr>
          <p:spPr>
            <a:xfrm>
              <a:off x="2680962" y="6523436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1875AB5-5E92-134A-8236-5ACF529922BA}"/>
                </a:ext>
              </a:extLst>
            </p:cNvPr>
            <p:cNvSpPr txBox="1"/>
            <p:nvPr/>
          </p:nvSpPr>
          <p:spPr>
            <a:xfrm>
              <a:off x="3433662" y="5177979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EA44162-67BA-BE4E-87A0-CE62A3BB4A48}"/>
                </a:ext>
              </a:extLst>
            </p:cNvPr>
            <p:cNvSpPr txBox="1"/>
            <p:nvPr/>
          </p:nvSpPr>
          <p:spPr>
            <a:xfrm>
              <a:off x="6092290" y="6523436"/>
              <a:ext cx="4828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AF78244-5016-B14F-BF7E-14FEED12F28A}"/>
                </a:ext>
              </a:extLst>
            </p:cNvPr>
            <p:cNvSpPr txBox="1"/>
            <p:nvPr/>
          </p:nvSpPr>
          <p:spPr>
            <a:xfrm>
              <a:off x="4705630" y="6523436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4F08456-DDB3-6743-A08E-FF2AE70C5108}"/>
                </a:ext>
              </a:extLst>
            </p:cNvPr>
            <p:cNvSpPr txBox="1"/>
            <p:nvPr/>
          </p:nvSpPr>
          <p:spPr>
            <a:xfrm>
              <a:off x="5466076" y="5178836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6EFCDAB7-F8A1-714A-A38C-A603CDFDE6F4}"/>
              </a:ext>
            </a:extLst>
          </p:cNvPr>
          <p:cNvSpPr txBox="1"/>
          <p:nvPr/>
        </p:nvSpPr>
        <p:spPr>
          <a:xfrm>
            <a:off x="60435" y="43633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544D0DE-07B5-0C4E-8D80-A066A3CEBF4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56665" y="2549007"/>
            <a:ext cx="2052697" cy="179611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47B9748-FCBA-2D4D-AF34-AB1604BF79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8030" y="2549007"/>
            <a:ext cx="2052697" cy="179611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9797EBE-C2C2-ED45-8D6F-C9577658447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35299" y="2549007"/>
            <a:ext cx="2052697" cy="1796110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0FF0436D-644E-C145-81B0-37451A47E26F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078269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02C42890-6447-EB45-84F5-FDC1189AED29}"/>
              </a:ext>
            </a:extLst>
          </p:cNvPr>
          <p:cNvSpPr txBox="1"/>
          <p:nvPr/>
        </p:nvSpPr>
        <p:spPr>
          <a:xfrm>
            <a:off x="2000409" y="248688"/>
            <a:ext cx="3270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Rate of concordance</a:t>
            </a: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D9D9D6">
                    <a:lumMod val="10000"/>
                  </a:srgbClr>
                </a:solidFill>
                <a:effectLst/>
                <a:uLnTx/>
                <a:uFillTx/>
                <a:latin typeface="Arial"/>
              </a:rPr>
              <a:t> </a:t>
            </a: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calculation for upregulated gene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D1A0C94-7B28-0C42-873A-DD66B1F10735}"/>
              </a:ext>
            </a:extLst>
          </p:cNvPr>
          <p:cNvSpPr txBox="1"/>
          <p:nvPr/>
        </p:nvSpPr>
        <p:spPr>
          <a:xfrm>
            <a:off x="1918655" y="2643130"/>
            <a:ext cx="34339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Rate of concordance</a:t>
            </a: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D9D9D6">
                    <a:lumMod val="10000"/>
                  </a:srgbClr>
                </a:solidFill>
                <a:effectLst/>
                <a:uLnTx/>
                <a:uFillTx/>
                <a:latin typeface="Arial"/>
              </a:rPr>
              <a:t> </a:t>
            </a: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calculation for downregulated gene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graphicFrame>
        <p:nvGraphicFramePr>
          <p:cNvPr id="10" name="Table 23">
            <a:extLst>
              <a:ext uri="{FF2B5EF4-FFF2-40B4-BE49-F238E27FC236}">
                <a16:creationId xmlns:a16="http://schemas.microsoft.com/office/drawing/2014/main" id="{2AD806D8-8056-A543-AE25-457F493282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1944102"/>
              </p:ext>
            </p:extLst>
          </p:nvPr>
        </p:nvGraphicFramePr>
        <p:xfrm>
          <a:off x="763797" y="533654"/>
          <a:ext cx="5467984" cy="19163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1976924001"/>
                    </a:ext>
                  </a:extLst>
                </a:gridCol>
                <a:gridCol w="1069588">
                  <a:extLst>
                    <a:ext uri="{9D8B030D-6E8A-4147-A177-3AD203B41FA5}">
                      <a16:colId xmlns:a16="http://schemas.microsoft.com/office/drawing/2014/main" val="3810481429"/>
                    </a:ext>
                  </a:extLst>
                </a:gridCol>
                <a:gridCol w="735980">
                  <a:extLst>
                    <a:ext uri="{9D8B030D-6E8A-4147-A177-3AD203B41FA5}">
                      <a16:colId xmlns:a16="http://schemas.microsoft.com/office/drawing/2014/main" val="3932890503"/>
                    </a:ext>
                  </a:extLst>
                </a:gridCol>
                <a:gridCol w="998260">
                  <a:extLst>
                    <a:ext uri="{9D8B030D-6E8A-4147-A177-3AD203B41FA5}">
                      <a16:colId xmlns:a16="http://schemas.microsoft.com/office/drawing/2014/main" val="2902263390"/>
                    </a:ext>
                  </a:extLst>
                </a:gridCol>
                <a:gridCol w="701372">
                  <a:extLst>
                    <a:ext uri="{9D8B030D-6E8A-4147-A177-3AD203B41FA5}">
                      <a16:colId xmlns:a16="http://schemas.microsoft.com/office/drawing/2014/main" val="2457409837"/>
                    </a:ext>
                  </a:extLst>
                </a:gridCol>
                <a:gridCol w="1086484">
                  <a:extLst>
                    <a:ext uri="{9D8B030D-6E8A-4147-A177-3AD203B41FA5}">
                      <a16:colId xmlns:a16="http://schemas.microsoft.com/office/drawing/2014/main" val="2394041421"/>
                    </a:ext>
                  </a:extLst>
                </a:gridCol>
              </a:tblGrid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ell lin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#gene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es within BA Switch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0" dirty="0">
                          <a:solidFill>
                            <a:schemeClr val="bg1"/>
                          </a:solidFill>
                          <a:latin typeface="Arial"/>
                        </a:rPr>
                        <a:t>Rate of concordance</a:t>
                      </a:r>
                      <a:r>
                        <a:rPr kumimoji="0" lang="en-US" sz="10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uLnTx/>
                          <a:uFillTx/>
                          <a:latin typeface="Arial"/>
                        </a:rPr>
                        <a:t> </a:t>
                      </a:r>
                      <a:endParaRPr lang="en-US" sz="10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es within Switch + Shift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0" dirty="0">
                          <a:solidFill>
                            <a:schemeClr val="bg1"/>
                          </a:solidFill>
                          <a:latin typeface="Arial"/>
                        </a:rPr>
                        <a:t>Rate of concordance</a:t>
                      </a:r>
                      <a:r>
                        <a:rPr kumimoji="0" lang="en-US" sz="10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uLnTx/>
                          <a:uFillTx/>
                          <a:latin typeface="Arial"/>
                        </a:rPr>
                        <a:t> </a:t>
                      </a:r>
                      <a:endParaRPr lang="en-US" sz="10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87094260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CH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8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7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4825542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S4;1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40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38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20730845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EM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3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86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45316931"/>
                  </a:ext>
                </a:extLst>
              </a:tr>
            </a:tbl>
          </a:graphicData>
        </a:graphic>
      </p:graphicFrame>
      <p:graphicFrame>
        <p:nvGraphicFramePr>
          <p:cNvPr id="11" name="Table 23">
            <a:extLst>
              <a:ext uri="{FF2B5EF4-FFF2-40B4-BE49-F238E27FC236}">
                <a16:creationId xmlns:a16="http://schemas.microsoft.com/office/drawing/2014/main" id="{B8484720-E1AE-8F49-B5E4-BD103B77A2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4151907"/>
              </p:ext>
            </p:extLst>
          </p:nvPr>
        </p:nvGraphicFramePr>
        <p:xfrm>
          <a:off x="763797" y="2928096"/>
          <a:ext cx="5467984" cy="19163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1976924001"/>
                    </a:ext>
                  </a:extLst>
                </a:gridCol>
                <a:gridCol w="1069588">
                  <a:extLst>
                    <a:ext uri="{9D8B030D-6E8A-4147-A177-3AD203B41FA5}">
                      <a16:colId xmlns:a16="http://schemas.microsoft.com/office/drawing/2014/main" val="3810481429"/>
                    </a:ext>
                  </a:extLst>
                </a:gridCol>
                <a:gridCol w="735980">
                  <a:extLst>
                    <a:ext uri="{9D8B030D-6E8A-4147-A177-3AD203B41FA5}">
                      <a16:colId xmlns:a16="http://schemas.microsoft.com/office/drawing/2014/main" val="3932890503"/>
                    </a:ext>
                  </a:extLst>
                </a:gridCol>
                <a:gridCol w="998260">
                  <a:extLst>
                    <a:ext uri="{9D8B030D-6E8A-4147-A177-3AD203B41FA5}">
                      <a16:colId xmlns:a16="http://schemas.microsoft.com/office/drawing/2014/main" val="2902263390"/>
                    </a:ext>
                  </a:extLst>
                </a:gridCol>
                <a:gridCol w="701372">
                  <a:extLst>
                    <a:ext uri="{9D8B030D-6E8A-4147-A177-3AD203B41FA5}">
                      <a16:colId xmlns:a16="http://schemas.microsoft.com/office/drawing/2014/main" val="2457409837"/>
                    </a:ext>
                  </a:extLst>
                </a:gridCol>
                <a:gridCol w="1086484">
                  <a:extLst>
                    <a:ext uri="{9D8B030D-6E8A-4147-A177-3AD203B41FA5}">
                      <a16:colId xmlns:a16="http://schemas.microsoft.com/office/drawing/2014/main" val="2394041421"/>
                    </a:ext>
                  </a:extLst>
                </a:gridCol>
              </a:tblGrid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ell lin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#gene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es within AB Switch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0" dirty="0">
                          <a:solidFill>
                            <a:schemeClr val="bg1"/>
                          </a:solidFill>
                          <a:latin typeface="Arial"/>
                        </a:rPr>
                        <a:t>Rate of concordance</a:t>
                      </a:r>
                      <a:r>
                        <a:rPr kumimoji="0" lang="en-US" sz="10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uLnTx/>
                          <a:uFillTx/>
                          <a:latin typeface="Arial"/>
                        </a:rPr>
                        <a:t> </a:t>
                      </a:r>
                      <a:endParaRPr lang="en-US" sz="10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es within Switch + Shift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0" dirty="0">
                          <a:solidFill>
                            <a:schemeClr val="bg1"/>
                          </a:solidFill>
                          <a:latin typeface="Arial"/>
                        </a:rPr>
                        <a:t>Rate of concordance</a:t>
                      </a:r>
                      <a:r>
                        <a:rPr kumimoji="0" lang="en-US" sz="10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uLnTx/>
                          <a:uFillTx/>
                          <a:latin typeface="Arial"/>
                        </a:rPr>
                        <a:t> </a:t>
                      </a:r>
                      <a:endParaRPr lang="en-US" sz="10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87094260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CH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4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40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4825542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S4;1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7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8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20730845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EM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4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1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4531693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FFE0061-AF54-6D48-A9BA-8024282F038F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574176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AA4F6DC1-5634-0A4B-9AAC-2897FB84DBD6}"/>
              </a:ext>
            </a:extLst>
          </p:cNvPr>
          <p:cNvGrpSpPr/>
          <p:nvPr/>
        </p:nvGrpSpPr>
        <p:grpSpPr>
          <a:xfrm>
            <a:off x="2705922" y="5294377"/>
            <a:ext cx="2063864" cy="1656623"/>
            <a:chOff x="2552525" y="5298886"/>
            <a:chExt cx="2063864" cy="165662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0B4BD4E-2746-9B42-A09E-FA61C10AEC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28810"/>
            <a:stretch/>
          </p:blipFill>
          <p:spPr>
            <a:xfrm>
              <a:off x="2552525" y="5298886"/>
              <a:ext cx="2063864" cy="1656623"/>
            </a:xfrm>
            <a:prstGeom prst="rect">
              <a:avLst/>
            </a:prstGeom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2CCD6832-A608-B94F-B368-06B478B6F32C}"/>
                </a:ext>
              </a:extLst>
            </p:cNvPr>
            <p:cNvSpPr/>
            <p:nvPr/>
          </p:nvSpPr>
          <p:spPr>
            <a:xfrm>
              <a:off x="4414488" y="5519056"/>
              <a:ext cx="201901" cy="11221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6495A0BB-9D1E-9346-856E-9599C7FEF6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1441" y="7102633"/>
            <a:ext cx="2899090" cy="165662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7E8FE41-310A-1A41-8F23-0701B87DB1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1561" y="5358404"/>
            <a:ext cx="1890565" cy="216064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8C0479B-C7BE-7B49-9E1C-E70C8AAE9E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310" y="2814014"/>
            <a:ext cx="2586379" cy="19397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9737A1B-430D-3F46-8DC4-88C680E069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00041" y="533036"/>
            <a:ext cx="2074171" cy="138278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C18FDBF1-E8D4-CC43-832D-2481BD1ED61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4238" y="555254"/>
            <a:ext cx="2586379" cy="193978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8F59749-C1AB-8842-8E5D-10F8182D1581}"/>
              </a:ext>
            </a:extLst>
          </p:cNvPr>
          <p:cNvSpPr txBox="1"/>
          <p:nvPr/>
        </p:nvSpPr>
        <p:spPr>
          <a:xfrm>
            <a:off x="53286" y="21791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7CC7D2-CE13-5243-8886-0D58B76729B5}"/>
              </a:ext>
            </a:extLst>
          </p:cNvPr>
          <p:cNvSpPr txBox="1"/>
          <p:nvPr/>
        </p:nvSpPr>
        <p:spPr>
          <a:xfrm>
            <a:off x="2737034" y="22574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4AEF0E5-A741-D34C-9E70-A78F6FEDFD11}"/>
              </a:ext>
            </a:extLst>
          </p:cNvPr>
          <p:cNvSpPr txBox="1"/>
          <p:nvPr/>
        </p:nvSpPr>
        <p:spPr>
          <a:xfrm>
            <a:off x="32210" y="24250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AD63DCC-D8CC-9B47-9D05-30ACE625044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36837" y="533036"/>
            <a:ext cx="2074171" cy="13827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34A1994-ECDE-3F4F-949E-91ED19FFF13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00040" y="3371018"/>
            <a:ext cx="2074171" cy="138278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E63E240-491F-6141-BD01-44018B888EF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00041" y="1957051"/>
            <a:ext cx="2074171" cy="13827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78BE93C-92DF-5A44-B273-D7C2172FC60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36837" y="1933029"/>
            <a:ext cx="2074171" cy="13827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B0A4098-FCFF-FD43-AE98-D291A2E5728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736836" y="3371018"/>
            <a:ext cx="2074171" cy="138278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3F23F631-1461-C24D-86E8-2E92B154C4B5}"/>
              </a:ext>
            </a:extLst>
          </p:cNvPr>
          <p:cNvSpPr txBox="1"/>
          <p:nvPr/>
        </p:nvSpPr>
        <p:spPr>
          <a:xfrm>
            <a:off x="32210" y="483496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047339D-3152-FF4A-817A-C3E38ADDC1D3}"/>
              </a:ext>
            </a:extLst>
          </p:cNvPr>
          <p:cNvSpPr txBox="1"/>
          <p:nvPr/>
        </p:nvSpPr>
        <p:spPr>
          <a:xfrm>
            <a:off x="2650970" y="48349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79E7FF1-C2F7-1B46-A3AC-3C72513D9817}"/>
              </a:ext>
            </a:extLst>
          </p:cNvPr>
          <p:cNvSpPr txBox="1"/>
          <p:nvPr/>
        </p:nvSpPr>
        <p:spPr>
          <a:xfrm>
            <a:off x="519325" y="248688"/>
            <a:ext cx="1938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SNIPER subcompartment call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E7EAA3F-DC00-AF44-BFBE-BDC6301C1F28}"/>
              </a:ext>
            </a:extLst>
          </p:cNvPr>
          <p:cNvSpPr txBox="1"/>
          <p:nvPr/>
        </p:nvSpPr>
        <p:spPr>
          <a:xfrm>
            <a:off x="3008148" y="248688"/>
            <a:ext cx="36984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SNIPER subcompartment calls and Cscore compartment call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2080093-95A0-B54A-9415-8EC09FE0F7E0}"/>
              </a:ext>
            </a:extLst>
          </p:cNvPr>
          <p:cNvSpPr txBox="1"/>
          <p:nvPr/>
        </p:nvSpPr>
        <p:spPr>
          <a:xfrm>
            <a:off x="342775" y="2484633"/>
            <a:ext cx="23631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SNIPER subcompartment calls w/o B1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A27BAAB-5F1A-3940-B4F9-0A9683CE00A1}"/>
              </a:ext>
            </a:extLst>
          </p:cNvPr>
          <p:cNvSpPr txBox="1"/>
          <p:nvPr/>
        </p:nvSpPr>
        <p:spPr>
          <a:xfrm>
            <a:off x="395907" y="4872719"/>
            <a:ext cx="1681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SNIPER subcompartment 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switche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D83FCE6-7969-A94F-9AC9-CE18C4F0CCD1}"/>
              </a:ext>
            </a:extLst>
          </p:cNvPr>
          <p:cNvSpPr txBox="1"/>
          <p:nvPr/>
        </p:nvSpPr>
        <p:spPr>
          <a:xfrm>
            <a:off x="3541441" y="4872719"/>
            <a:ext cx="26357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Cscore compartment switches/shifts and SNIPER subcompartment switches 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D9E7CD0A-D8D6-CD47-ABFD-754241EB4CC6}"/>
              </a:ext>
            </a:extLst>
          </p:cNvPr>
          <p:cNvGrpSpPr/>
          <p:nvPr/>
        </p:nvGrpSpPr>
        <p:grpSpPr>
          <a:xfrm>
            <a:off x="4736836" y="5294377"/>
            <a:ext cx="1890566" cy="1656623"/>
            <a:chOff x="4267200" y="5312054"/>
            <a:chExt cx="1890566" cy="1656623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0CA056B-2EAD-2049-8195-B5B04620AE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4487" r="30301"/>
            <a:stretch/>
          </p:blipFill>
          <p:spPr>
            <a:xfrm>
              <a:off x="4267200" y="5312054"/>
              <a:ext cx="1890566" cy="1656623"/>
            </a:xfrm>
            <a:prstGeom prst="rect">
              <a:avLst/>
            </a:prstGeom>
          </p:spPr>
        </p:pic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A0401B2-F783-4443-A4B9-F880FBACA49E}"/>
                </a:ext>
              </a:extLst>
            </p:cNvPr>
            <p:cNvSpPr/>
            <p:nvPr/>
          </p:nvSpPr>
          <p:spPr>
            <a:xfrm>
              <a:off x="5970895" y="5507276"/>
              <a:ext cx="186871" cy="11221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272B8E4A-E01D-9B45-AFE2-3B49B72AC62E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6178720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8F59749-C1AB-8842-8E5D-10F8182D1581}"/>
              </a:ext>
            </a:extLst>
          </p:cNvPr>
          <p:cNvSpPr txBox="1"/>
          <p:nvPr/>
        </p:nvSpPr>
        <p:spPr>
          <a:xfrm>
            <a:off x="53286" y="21791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7CC7D2-CE13-5243-8886-0D58B76729B5}"/>
              </a:ext>
            </a:extLst>
          </p:cNvPr>
          <p:cNvSpPr txBox="1"/>
          <p:nvPr/>
        </p:nvSpPr>
        <p:spPr>
          <a:xfrm>
            <a:off x="39816" y="232189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A3956C8-9D0E-B549-AC74-16312A109C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7229" y="561580"/>
            <a:ext cx="1389888" cy="173736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1E21C62-E457-2148-AE8C-C0014E0967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338" y="561580"/>
            <a:ext cx="1389888" cy="173736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9508BAF-010E-6249-9CF4-3BEE9A1809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1369" y="561580"/>
            <a:ext cx="1389888" cy="173736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62F4D90D-CFE3-BD4C-BCB0-651C7EFD04CD}"/>
              </a:ext>
            </a:extLst>
          </p:cNvPr>
          <p:cNvSpPr txBox="1"/>
          <p:nvPr/>
        </p:nvSpPr>
        <p:spPr>
          <a:xfrm>
            <a:off x="1032282" y="253803"/>
            <a:ext cx="3320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Gene Expression SNIPER subcompartment Correlation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3F589E1-85A2-314A-A4FC-D94095B7F878}"/>
              </a:ext>
            </a:extLst>
          </p:cNvPr>
          <p:cNvSpPr txBox="1"/>
          <p:nvPr/>
        </p:nvSpPr>
        <p:spPr>
          <a:xfrm>
            <a:off x="1872883" y="2400080"/>
            <a:ext cx="3374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Gene Expression SNIPER subcompartment volcano plot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4BFE96-7809-3645-9B31-B072490246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27646" y="2749066"/>
            <a:ext cx="2001721" cy="175150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110B22-3E7E-E148-841A-969B053F48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27646" y="4643429"/>
            <a:ext cx="2001721" cy="175150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27FC2E2-14FE-CE41-B456-798A8421284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7268" y="4643429"/>
            <a:ext cx="2001721" cy="175150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FDC724C-3EFF-5046-9570-20731B653B7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92457" y="4644091"/>
            <a:ext cx="2001721" cy="175150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9790569-AB5F-794C-985F-BFACF4467D2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92457" y="2749066"/>
            <a:ext cx="2001721" cy="175150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48146AE-5D32-A74B-BA46-E25DD6A8929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7269" y="2749066"/>
            <a:ext cx="2001721" cy="175150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D9A34E2-FB56-7543-BD51-DCD2CC285DC9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14380480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4B78F49-DB33-4142-8248-E58CCA1F65B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6809"/>
          <a:stretch/>
        </p:blipFill>
        <p:spPr>
          <a:xfrm>
            <a:off x="0" y="302356"/>
            <a:ext cx="2200126" cy="215066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AFFEC37-A0C5-5846-8534-22E3DEF6CEF4}"/>
              </a:ext>
            </a:extLst>
          </p:cNvPr>
          <p:cNvSpPr txBox="1"/>
          <p:nvPr/>
        </p:nvSpPr>
        <p:spPr>
          <a:xfrm>
            <a:off x="45195" y="24305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464C80-B659-484D-A16F-8018DEC5471A}"/>
              </a:ext>
            </a:extLst>
          </p:cNvPr>
          <p:cNvSpPr txBox="1"/>
          <p:nvPr/>
        </p:nvSpPr>
        <p:spPr>
          <a:xfrm>
            <a:off x="2912259" y="2430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B05B94FA-BBA9-A64D-8CA4-F0D3B7616FE1}"/>
              </a:ext>
            </a:extLst>
          </p:cNvPr>
          <p:cNvGrpSpPr/>
          <p:nvPr/>
        </p:nvGrpSpPr>
        <p:grpSpPr>
          <a:xfrm>
            <a:off x="351163" y="2530500"/>
            <a:ext cx="4139372" cy="1952099"/>
            <a:chOff x="2680962" y="5161936"/>
            <a:chExt cx="4139372" cy="1952099"/>
          </a:xfrm>
        </p:grpSpPr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C3CF0403-57AD-E940-9D71-A1337FB188ED}"/>
                </a:ext>
              </a:extLst>
            </p:cNvPr>
            <p:cNvSpPr txBox="1"/>
            <p:nvPr/>
          </p:nvSpPr>
          <p:spPr>
            <a:xfrm>
              <a:off x="3153146" y="6698537"/>
              <a:ext cx="90601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decreased</a:t>
              </a:r>
            </a:p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ccessibility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96847DC-C3E6-5F43-B748-6197693F0C5F}"/>
                </a:ext>
              </a:extLst>
            </p:cNvPr>
            <p:cNvSpPr txBox="1"/>
            <p:nvPr/>
          </p:nvSpPr>
          <p:spPr>
            <a:xfrm>
              <a:off x="5342864" y="6685450"/>
              <a:ext cx="90601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ncreased</a:t>
              </a:r>
            </a:p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ccessibility</a:t>
              </a:r>
            </a:p>
          </p:txBody>
        </p: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C7A0A53E-6C94-2B45-B2FC-28B94995A2B0}"/>
                </a:ext>
              </a:extLst>
            </p:cNvPr>
            <p:cNvGrpSpPr/>
            <p:nvPr/>
          </p:nvGrpSpPr>
          <p:grpSpPr>
            <a:xfrm>
              <a:off x="5076574" y="5397064"/>
              <a:ext cx="1325311" cy="1241268"/>
              <a:chOff x="839181" y="5717380"/>
              <a:chExt cx="1325311" cy="1241268"/>
            </a:xfrm>
          </p:grpSpPr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E1D76884-114D-384D-B006-E9035BFAFF23}"/>
                  </a:ext>
                </a:extLst>
              </p:cNvPr>
              <p:cNvGrpSpPr/>
              <p:nvPr/>
            </p:nvGrpSpPr>
            <p:grpSpPr>
              <a:xfrm>
                <a:off x="839181" y="5717380"/>
                <a:ext cx="1325311" cy="1241268"/>
                <a:chOff x="1016149" y="5764882"/>
                <a:chExt cx="2871220" cy="2707896"/>
              </a:xfrm>
            </p:grpSpPr>
            <p:sp>
              <p:nvSpPr>
                <p:cNvPr id="150" name="Freeform 149">
                  <a:extLst>
                    <a:ext uri="{FF2B5EF4-FFF2-40B4-BE49-F238E27FC236}">
                      <a16:creationId xmlns:a16="http://schemas.microsoft.com/office/drawing/2014/main" id="{FBE03226-AE8E-AF42-8BBD-E1FDA5B497F8}"/>
                    </a:ext>
                  </a:extLst>
                </p:cNvPr>
                <p:cNvSpPr/>
                <p:nvPr/>
              </p:nvSpPr>
              <p:spPr>
                <a:xfrm>
                  <a:off x="1537361" y="5764882"/>
                  <a:ext cx="1828798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243841" tIns="320040" rIns="243839" bIns="685800" numCol="1" spcCol="1270" anchor="ctr" anchorCtr="0">
                  <a:noAutofit/>
                </a:bodyPr>
                <a:lstStyle/>
                <a:p>
                  <a:pPr marL="0" lvl="0" indent="0" algn="ctr" defTabSz="20447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4600" kern="1200"/>
                </a:p>
              </p:txBody>
            </p:sp>
            <p:sp>
              <p:nvSpPr>
                <p:cNvPr id="151" name="Freeform 150">
                  <a:extLst>
                    <a:ext uri="{FF2B5EF4-FFF2-40B4-BE49-F238E27FC236}">
                      <a16:creationId xmlns:a16="http://schemas.microsoft.com/office/drawing/2014/main" id="{0CBB35CC-33A4-0B4F-870C-2374E6EF5CB8}"/>
                    </a:ext>
                  </a:extLst>
                </p:cNvPr>
                <p:cNvSpPr/>
                <p:nvPr/>
              </p:nvSpPr>
              <p:spPr>
                <a:xfrm>
                  <a:off x="2058569" y="664397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559308" tIns="472440" rIns="172212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  <p:sp>
              <p:nvSpPr>
                <p:cNvPr id="152" name="Freeform 151">
                  <a:extLst>
                    <a:ext uri="{FF2B5EF4-FFF2-40B4-BE49-F238E27FC236}">
                      <a16:creationId xmlns:a16="http://schemas.microsoft.com/office/drawing/2014/main" id="{76912FDE-67EB-554E-B5D2-687F992A13CE}"/>
                    </a:ext>
                  </a:extLst>
                </p:cNvPr>
                <p:cNvSpPr/>
                <p:nvPr/>
              </p:nvSpPr>
              <p:spPr>
                <a:xfrm>
                  <a:off x="1016149" y="6643975"/>
                  <a:ext cx="1828798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A10503">
                    <a:alpha val="50196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172212" tIns="472440" rIns="559308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/>
                </a:p>
              </p:txBody>
            </p:sp>
          </p:grp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CDB74C8A-8DFE-7246-A4E5-82AC375D6524}"/>
                  </a:ext>
                </a:extLst>
              </p:cNvPr>
              <p:cNvSpPr txBox="1"/>
              <p:nvPr/>
            </p:nvSpPr>
            <p:spPr>
              <a:xfrm>
                <a:off x="1317592" y="585857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32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563E4695-FACC-A643-BBE8-1CC93B44D1BA}"/>
                  </a:ext>
                </a:extLst>
              </p:cNvPr>
              <p:cNvSpPr txBox="1"/>
              <p:nvPr/>
            </p:nvSpPr>
            <p:spPr>
              <a:xfrm>
                <a:off x="967643" y="6513540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99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D890D106-88F0-AD48-A6DD-50F067183F9D}"/>
                  </a:ext>
                </a:extLst>
              </p:cNvPr>
              <p:cNvSpPr txBox="1"/>
              <p:nvPr/>
            </p:nvSpPr>
            <p:spPr>
              <a:xfrm>
                <a:off x="1709904" y="65135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6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E2932365-5FC6-AA44-B04E-AE3D6664BA4E}"/>
                  </a:ext>
                </a:extLst>
              </p:cNvPr>
              <p:cNvSpPr txBox="1"/>
              <p:nvPr/>
            </p:nvSpPr>
            <p:spPr>
              <a:xfrm>
                <a:off x="1375300" y="627640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9A109801-764A-424C-A341-23242F15F561}"/>
                  </a:ext>
                </a:extLst>
              </p:cNvPr>
              <p:cNvSpPr txBox="1"/>
              <p:nvPr/>
            </p:nvSpPr>
            <p:spPr>
              <a:xfrm>
                <a:off x="1571751" y="615885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EA11B04E-C8FF-4842-9F12-E83E6092CA91}"/>
                  </a:ext>
                </a:extLst>
              </p:cNvPr>
              <p:cNvSpPr txBox="1"/>
              <p:nvPr/>
            </p:nvSpPr>
            <p:spPr>
              <a:xfrm>
                <a:off x="1160635" y="616052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D8349D72-B0AA-8340-BEDB-964FDDBD372D}"/>
                  </a:ext>
                </a:extLst>
              </p:cNvPr>
              <p:cNvSpPr txBox="1"/>
              <p:nvPr/>
            </p:nvSpPr>
            <p:spPr>
              <a:xfrm>
                <a:off x="1346446" y="655357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</a:p>
            </p:txBody>
          </p:sp>
        </p:grp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4781E364-BD05-7144-B954-37AD5DE3C8E4}"/>
                </a:ext>
              </a:extLst>
            </p:cNvPr>
            <p:cNvGrpSpPr/>
            <p:nvPr/>
          </p:nvGrpSpPr>
          <p:grpSpPr>
            <a:xfrm>
              <a:off x="2935820" y="5397065"/>
              <a:ext cx="1325311" cy="1241267"/>
              <a:chOff x="720599" y="5725595"/>
              <a:chExt cx="1325311" cy="1241267"/>
            </a:xfrm>
          </p:grpSpPr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DDA3E6E9-5AB7-4D4F-89F3-C74A093B01CD}"/>
                  </a:ext>
                </a:extLst>
              </p:cNvPr>
              <p:cNvGrpSpPr/>
              <p:nvPr/>
            </p:nvGrpSpPr>
            <p:grpSpPr>
              <a:xfrm>
                <a:off x="720599" y="5725595"/>
                <a:ext cx="1325311" cy="1241267"/>
                <a:chOff x="759244" y="5782804"/>
                <a:chExt cx="2871223" cy="2707894"/>
              </a:xfrm>
            </p:grpSpPr>
            <p:sp>
              <p:nvSpPr>
                <p:cNvPr id="139" name="Freeform 138">
                  <a:extLst>
                    <a:ext uri="{FF2B5EF4-FFF2-40B4-BE49-F238E27FC236}">
                      <a16:creationId xmlns:a16="http://schemas.microsoft.com/office/drawing/2014/main" id="{5F5D34B7-9211-A24D-86FE-1AA2CE828CDB}"/>
                    </a:ext>
                  </a:extLst>
                </p:cNvPr>
                <p:cNvSpPr/>
                <p:nvPr/>
              </p:nvSpPr>
              <p:spPr>
                <a:xfrm>
                  <a:off x="1280456" y="5782804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243841" tIns="320040" rIns="243839" bIns="685800" numCol="1" spcCol="1270" anchor="ctr" anchorCtr="0">
                  <a:noAutofit/>
                </a:bodyPr>
                <a:lstStyle/>
                <a:p>
                  <a:pPr marL="0" lvl="0" indent="0" algn="ctr" defTabSz="20447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4600" kern="1200">
                    <a:solidFill>
                      <a:srgbClr val="181C9A"/>
                    </a:solidFill>
                  </a:endParaRPr>
                </a:p>
              </p:txBody>
            </p:sp>
            <p:sp>
              <p:nvSpPr>
                <p:cNvPr id="140" name="Freeform 139">
                  <a:extLst>
                    <a:ext uri="{FF2B5EF4-FFF2-40B4-BE49-F238E27FC236}">
                      <a16:creationId xmlns:a16="http://schemas.microsoft.com/office/drawing/2014/main" id="{BB59C36B-03AF-B944-9655-17F26C6A722B}"/>
                    </a:ext>
                  </a:extLst>
                </p:cNvPr>
                <p:cNvSpPr/>
                <p:nvPr/>
              </p:nvSpPr>
              <p:spPr>
                <a:xfrm>
                  <a:off x="1801667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559308" tIns="472440" rIns="172212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>
                    <a:solidFill>
                      <a:srgbClr val="181C9A"/>
                    </a:solidFill>
                  </a:endParaRPr>
                </a:p>
              </p:txBody>
            </p:sp>
            <p:sp>
              <p:nvSpPr>
                <p:cNvPr id="141" name="Freeform 140">
                  <a:extLst>
                    <a:ext uri="{FF2B5EF4-FFF2-40B4-BE49-F238E27FC236}">
                      <a16:creationId xmlns:a16="http://schemas.microsoft.com/office/drawing/2014/main" id="{A1C7852E-A1F3-5440-9C5F-CABED7B457DF}"/>
                    </a:ext>
                  </a:extLst>
                </p:cNvPr>
                <p:cNvSpPr/>
                <p:nvPr/>
              </p:nvSpPr>
              <p:spPr>
                <a:xfrm>
                  <a:off x="759244" y="6661897"/>
                  <a:ext cx="1828800" cy="1828801"/>
                </a:xfrm>
                <a:custGeom>
                  <a:avLst/>
                  <a:gdLst>
                    <a:gd name="connsiteX0" fmla="*/ 0 w 1828800"/>
                    <a:gd name="connsiteY0" fmla="*/ 914400 h 1828800"/>
                    <a:gd name="connsiteX1" fmla="*/ 914400 w 1828800"/>
                    <a:gd name="connsiteY1" fmla="*/ 0 h 1828800"/>
                    <a:gd name="connsiteX2" fmla="*/ 1828800 w 1828800"/>
                    <a:gd name="connsiteY2" fmla="*/ 914400 h 1828800"/>
                    <a:gd name="connsiteX3" fmla="*/ 914400 w 1828800"/>
                    <a:gd name="connsiteY3" fmla="*/ 1828800 h 1828800"/>
                    <a:gd name="connsiteX4" fmla="*/ 0 w 1828800"/>
                    <a:gd name="connsiteY4" fmla="*/ 914400 h 1828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0" h="1828800">
                      <a:moveTo>
                        <a:pt x="0" y="914400"/>
                      </a:moveTo>
                      <a:cubicBezTo>
                        <a:pt x="0" y="409391"/>
                        <a:pt x="409391" y="0"/>
                        <a:pt x="914400" y="0"/>
                      </a:cubicBezTo>
                      <a:cubicBezTo>
                        <a:pt x="1419409" y="0"/>
                        <a:pt x="1828800" y="409391"/>
                        <a:pt x="1828800" y="914400"/>
                      </a:cubicBezTo>
                      <a:cubicBezTo>
                        <a:pt x="1828800" y="1419409"/>
                        <a:pt x="1419409" y="1828800"/>
                        <a:pt x="914400" y="1828800"/>
                      </a:cubicBezTo>
                      <a:cubicBezTo>
                        <a:pt x="409391" y="1828800"/>
                        <a:pt x="0" y="1419409"/>
                        <a:pt x="0" y="914400"/>
                      </a:cubicBezTo>
                      <a:close/>
                    </a:path>
                  </a:pathLst>
                </a:custGeom>
                <a:solidFill>
                  <a:srgbClr val="181C9A">
                    <a:alpha val="50000"/>
                  </a:srgbClr>
                </a:solidFill>
              </p:spPr>
              <p:style>
                <a:lnRef idx="2">
                  <a:schemeClr val="lt1">
                    <a:hueOff val="0"/>
                    <a:satOff val="0"/>
                    <a:lumOff val="0"/>
                    <a:alphaOff val="0"/>
                  </a:schemeClr>
                </a:lnRef>
                <a:fillRef idx="1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fillRef>
                <a:effectRef idx="0">
                  <a:schemeClr val="accent1">
                    <a:alpha val="50000"/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/>
                </a:fontRef>
              </p:style>
              <p:txBody>
                <a:bodyPr spcFirstLastPara="0" vert="horz" wrap="square" lIns="172212" tIns="472440" rIns="559308" bIns="350520" numCol="1" spcCol="1270" anchor="ctr" anchorCtr="0">
                  <a:noAutofit/>
                </a:bodyPr>
                <a:lstStyle/>
                <a:p>
                  <a:pPr marL="0" lvl="0" indent="0" algn="ctr" defTabSz="1689100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  <a:buNone/>
                  </a:pPr>
                  <a:endParaRPr lang="en-US" sz="3800" kern="1200">
                    <a:solidFill>
                      <a:srgbClr val="181C9A"/>
                    </a:solidFill>
                  </a:endParaRPr>
                </a:p>
              </p:txBody>
            </p:sp>
          </p:grp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3CD13E06-7D4C-224D-980C-8E0D51122946}"/>
                  </a:ext>
                </a:extLst>
              </p:cNvPr>
              <p:cNvSpPr txBox="1"/>
              <p:nvPr/>
            </p:nvSpPr>
            <p:spPr>
              <a:xfrm>
                <a:off x="1154330" y="5866790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1507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BB1E1D0F-4EA7-F544-900F-1F4F59DF6703}"/>
                  </a:ext>
                </a:extLst>
              </p:cNvPr>
              <p:cNvSpPr txBox="1"/>
              <p:nvPr/>
            </p:nvSpPr>
            <p:spPr>
              <a:xfrm>
                <a:off x="849061" y="6521755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30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8E520FDD-2A21-874C-BDC8-030D9B94DD72}"/>
                  </a:ext>
                </a:extLst>
              </p:cNvPr>
              <p:cNvSpPr txBox="1"/>
              <p:nvPr/>
            </p:nvSpPr>
            <p:spPr>
              <a:xfrm>
                <a:off x="1571752" y="6521755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818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F0695B3C-37EB-364C-B85D-C1CFDFF15F2F}"/>
                  </a:ext>
                </a:extLst>
              </p:cNvPr>
              <p:cNvSpPr txBox="1"/>
              <p:nvPr/>
            </p:nvSpPr>
            <p:spPr>
              <a:xfrm>
                <a:off x="1212038" y="630072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39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7BA734D9-1292-B040-BE44-09C087C7A082}"/>
                  </a:ext>
                </a:extLst>
              </p:cNvPr>
              <p:cNvSpPr txBox="1"/>
              <p:nvPr/>
            </p:nvSpPr>
            <p:spPr>
              <a:xfrm>
                <a:off x="1417107" y="6153819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361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72728502-C49A-1D4E-8A34-7FA18ED858C4}"/>
                  </a:ext>
                </a:extLst>
              </p:cNvPr>
              <p:cNvSpPr txBox="1"/>
              <p:nvPr/>
            </p:nvSpPr>
            <p:spPr>
              <a:xfrm>
                <a:off x="963303" y="615548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34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AC1F1303-B8E9-4D48-B01F-9715C278E40D}"/>
                  </a:ext>
                </a:extLst>
              </p:cNvPr>
              <p:cNvSpPr txBox="1"/>
              <p:nvPr/>
            </p:nvSpPr>
            <p:spPr>
              <a:xfrm>
                <a:off x="1240892" y="657657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</a:p>
            </p:txBody>
          </p:sp>
        </p:grp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21E773B-4B95-674F-AB79-EF48BC6CDAD4}"/>
                </a:ext>
              </a:extLst>
            </p:cNvPr>
            <p:cNvSpPr txBox="1"/>
            <p:nvPr/>
          </p:nvSpPr>
          <p:spPr>
            <a:xfrm>
              <a:off x="4067622" y="6523436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0C98D5E6-37F3-B94F-A94A-957FBD8BC8D8}"/>
                </a:ext>
              </a:extLst>
            </p:cNvPr>
            <p:cNvSpPr txBox="1"/>
            <p:nvPr/>
          </p:nvSpPr>
          <p:spPr>
            <a:xfrm>
              <a:off x="2680962" y="6523436"/>
              <a:ext cx="47641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94889990-09DE-4F40-B40A-C999655F9C08}"/>
                </a:ext>
              </a:extLst>
            </p:cNvPr>
            <p:cNvSpPr txBox="1"/>
            <p:nvPr/>
          </p:nvSpPr>
          <p:spPr>
            <a:xfrm>
              <a:off x="3373772" y="5170151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A6A057D2-5FF7-4149-94F5-B140DE2FABD5}"/>
                </a:ext>
              </a:extLst>
            </p:cNvPr>
            <p:cNvSpPr txBox="1"/>
            <p:nvPr/>
          </p:nvSpPr>
          <p:spPr>
            <a:xfrm>
              <a:off x="6210872" y="6515221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F119B312-680E-2C4F-B5C8-8938B9E422AB}"/>
                </a:ext>
              </a:extLst>
            </p:cNvPr>
            <p:cNvSpPr txBox="1"/>
            <p:nvPr/>
          </p:nvSpPr>
          <p:spPr>
            <a:xfrm>
              <a:off x="4824212" y="6515221"/>
              <a:ext cx="47641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B1493AFF-CA4E-6F4D-A0BA-1B90E4BA8A6E}"/>
                </a:ext>
              </a:extLst>
            </p:cNvPr>
            <p:cNvSpPr txBox="1"/>
            <p:nvPr/>
          </p:nvSpPr>
          <p:spPr>
            <a:xfrm>
              <a:off x="5521376" y="5161936"/>
              <a:ext cx="4780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A9BAE78-C4FF-1843-94F6-3410EB884848}"/>
              </a:ext>
            </a:extLst>
          </p:cNvPr>
          <p:cNvSpPr txBox="1"/>
          <p:nvPr/>
        </p:nvSpPr>
        <p:spPr>
          <a:xfrm>
            <a:off x="76734" y="2482255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406AFD2-D7AD-D246-9AA9-8D2A7E07C320}"/>
              </a:ext>
            </a:extLst>
          </p:cNvPr>
          <p:cNvSpPr txBox="1"/>
          <p:nvPr/>
        </p:nvSpPr>
        <p:spPr>
          <a:xfrm>
            <a:off x="67111" y="449819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72F4671B-3E29-E441-A783-B731F5D5E901}"/>
              </a:ext>
            </a:extLst>
          </p:cNvPr>
          <p:cNvGrpSpPr/>
          <p:nvPr/>
        </p:nvGrpSpPr>
        <p:grpSpPr>
          <a:xfrm>
            <a:off x="393667" y="4588965"/>
            <a:ext cx="5359862" cy="1988492"/>
            <a:chOff x="328" y="6644253"/>
            <a:chExt cx="5573758" cy="2438451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8353435A-B3A6-014B-967B-C88517259C26}"/>
                </a:ext>
              </a:extLst>
            </p:cNvPr>
            <p:cNvGrpSpPr/>
            <p:nvPr/>
          </p:nvGrpSpPr>
          <p:grpSpPr>
            <a:xfrm>
              <a:off x="328" y="6644253"/>
              <a:ext cx="5573758" cy="2289890"/>
              <a:chOff x="120904" y="6644253"/>
              <a:chExt cx="5573758" cy="2289890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3DC1E52F-7BDC-4948-9DE5-37F95C21CFF5}"/>
                  </a:ext>
                </a:extLst>
              </p:cNvPr>
              <p:cNvSpPr txBox="1"/>
              <p:nvPr/>
            </p:nvSpPr>
            <p:spPr>
              <a:xfrm>
                <a:off x="2364850" y="6746274"/>
                <a:ext cx="15440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tx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r15:72,203,837-74,728,215</a:t>
                </a:r>
              </a:p>
            </p:txBody>
          </p:sp>
          <p:pic>
            <p:nvPicPr>
              <p:cNvPr id="52" name="Picture 51" descr="Graphical user interface, application, table, Excel&#10;&#10;Description automatically generated">
                <a:extLst>
                  <a:ext uri="{FF2B5EF4-FFF2-40B4-BE49-F238E27FC236}">
                    <a16:creationId xmlns:a16="http://schemas.microsoft.com/office/drawing/2014/main" id="{00564066-F251-9840-88E1-AAEF38995D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6400" t="31875" r="-1" b="8059"/>
              <a:stretch/>
            </p:blipFill>
            <p:spPr>
              <a:xfrm>
                <a:off x="818110" y="6978073"/>
                <a:ext cx="4876552" cy="187113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4C92F8FB-9650-F447-9ED4-B59DA4B731D3}"/>
                  </a:ext>
                </a:extLst>
              </p:cNvPr>
              <p:cNvGrpSpPr/>
              <p:nvPr/>
            </p:nvGrpSpPr>
            <p:grpSpPr>
              <a:xfrm>
                <a:off x="120904" y="6644253"/>
                <a:ext cx="767288" cy="2289890"/>
                <a:chOff x="120904" y="6644253"/>
                <a:chExt cx="767288" cy="2289890"/>
              </a:xfrm>
            </p:grpSpPr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23898AA4-4694-8F48-A89B-066AE54A2C04}"/>
                    </a:ext>
                  </a:extLst>
                </p:cNvPr>
                <p:cNvSpPr txBox="1"/>
                <p:nvPr/>
              </p:nvSpPr>
              <p:spPr>
                <a:xfrm rot="16200000">
                  <a:off x="-236137" y="8248049"/>
                  <a:ext cx="99108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NA-seq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83B2DBA8-FFD7-164B-9FF1-C92D53D3F37A}"/>
                    </a:ext>
                  </a:extLst>
                </p:cNvPr>
                <p:cNvSpPr txBox="1"/>
                <p:nvPr/>
              </p:nvSpPr>
              <p:spPr>
                <a:xfrm rot="16200000">
                  <a:off x="-410411" y="7175568"/>
                  <a:ext cx="133962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/B CScore </a:t>
                  </a:r>
                </a:p>
                <a:p>
                  <a:pPr algn="ctr"/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mpartments</a:t>
                  </a:r>
                </a:p>
              </p:txBody>
            </p:sp>
            <p:grpSp>
              <p:nvGrpSpPr>
                <p:cNvPr id="56" name="Group 55">
                  <a:extLst>
                    <a:ext uri="{FF2B5EF4-FFF2-40B4-BE49-F238E27FC236}">
                      <a16:creationId xmlns:a16="http://schemas.microsoft.com/office/drawing/2014/main" id="{B7CBFF5F-968F-7746-9568-E836F0C492B3}"/>
                    </a:ext>
                  </a:extLst>
                </p:cNvPr>
                <p:cNvGrpSpPr/>
                <p:nvPr/>
              </p:nvGrpSpPr>
              <p:grpSpPr>
                <a:xfrm>
                  <a:off x="412054" y="6986978"/>
                  <a:ext cx="34" cy="1848945"/>
                  <a:chOff x="412054" y="6986978"/>
                  <a:chExt cx="34" cy="1848945"/>
                </a:xfrm>
              </p:grpSpPr>
              <p:cxnSp>
                <p:nvCxnSpPr>
                  <p:cNvPr id="80" name="Straight Connector 79">
                    <a:extLst>
                      <a:ext uri="{FF2B5EF4-FFF2-40B4-BE49-F238E27FC236}">
                        <a16:creationId xmlns:a16="http://schemas.microsoft.com/office/drawing/2014/main" id="{02726A21-ADD2-1243-8977-5A81647739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88" y="6986978"/>
                    <a:ext cx="0" cy="5853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Straight Connector 80">
                    <a:extLst>
                      <a:ext uri="{FF2B5EF4-FFF2-40B4-BE49-F238E27FC236}">
                        <a16:creationId xmlns:a16="http://schemas.microsoft.com/office/drawing/2014/main" id="{79072AE3-9898-A948-BFAA-5649EB750C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54" y="8261967"/>
                    <a:ext cx="0" cy="5739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Straight Connector 81">
                    <a:extLst>
                      <a:ext uri="{FF2B5EF4-FFF2-40B4-BE49-F238E27FC236}">
                        <a16:creationId xmlns:a16="http://schemas.microsoft.com/office/drawing/2014/main" id="{7F37C0B0-D99F-C641-A6F6-8728D64CAA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58" y="7598318"/>
                    <a:ext cx="0" cy="63430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7798ACCC-F8D8-874E-9E93-D76E785A287B}"/>
                    </a:ext>
                  </a:extLst>
                </p:cNvPr>
                <p:cNvSpPr txBox="1"/>
                <p:nvPr/>
              </p:nvSpPr>
              <p:spPr>
                <a:xfrm rot="16200000">
                  <a:off x="-233767" y="7671864"/>
                  <a:ext cx="98634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AC-seq</a:t>
                  </a:r>
                </a:p>
              </p:txBody>
            </p:sp>
            <p:grpSp>
              <p:nvGrpSpPr>
                <p:cNvPr id="58" name="Group 57">
                  <a:extLst>
                    <a:ext uri="{FF2B5EF4-FFF2-40B4-BE49-F238E27FC236}">
                      <a16:creationId xmlns:a16="http://schemas.microsoft.com/office/drawing/2014/main" id="{3B2404E4-5C64-0E43-8BC4-0B24252A2615}"/>
                    </a:ext>
                  </a:extLst>
                </p:cNvPr>
                <p:cNvGrpSpPr/>
                <p:nvPr/>
              </p:nvGrpSpPr>
              <p:grpSpPr>
                <a:xfrm>
                  <a:off x="389434" y="6921238"/>
                  <a:ext cx="498758" cy="2012905"/>
                  <a:chOff x="389434" y="6921238"/>
                  <a:chExt cx="498758" cy="2012905"/>
                </a:xfrm>
              </p:grpSpPr>
              <p:grpSp>
                <p:nvGrpSpPr>
                  <p:cNvPr id="59" name="Group 58">
                    <a:extLst>
                      <a:ext uri="{FF2B5EF4-FFF2-40B4-BE49-F238E27FC236}">
                        <a16:creationId xmlns:a16="http://schemas.microsoft.com/office/drawing/2014/main" id="{E465CCA1-C5D9-D141-8BF4-96B89AE53A9B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8181981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75" name="TextBox 74">
                      <a:extLst>
                        <a:ext uri="{FF2B5EF4-FFF2-40B4-BE49-F238E27FC236}">
                          <a16:creationId xmlns:a16="http://schemas.microsoft.com/office/drawing/2014/main" id="{F6589498-EFE2-0049-83E8-89DE062328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8096DF66-1FF1-184B-A7A9-1AEB77C3B7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74" name="TextBox 73">
                      <a:extLst>
                        <a:ext uri="{FF2B5EF4-FFF2-40B4-BE49-F238E27FC236}">
                          <a16:creationId xmlns:a16="http://schemas.microsoft.com/office/drawing/2014/main" id="{C50D725F-417E-B943-87F7-274B35C4F12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C5B1814D-BB1D-B94C-A9C4-25B3B028FBE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4DA9D2B5-4025-C947-AEC5-4C7C16C9CA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744EA697-ADEA-4E4E-859E-B78371D4054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  <p:grpSp>
                <p:nvGrpSpPr>
                  <p:cNvPr id="60" name="Group 59">
                    <a:extLst>
                      <a:ext uri="{FF2B5EF4-FFF2-40B4-BE49-F238E27FC236}">
                        <a16:creationId xmlns:a16="http://schemas.microsoft.com/office/drawing/2014/main" id="{0A84E679-B4D7-3749-9D0C-10EF203144F0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7558655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2ECD01C8-AE64-6E47-8E26-7A0A59BFA6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69" name="TextBox 68">
                      <a:extLst>
                        <a:ext uri="{FF2B5EF4-FFF2-40B4-BE49-F238E27FC236}">
                          <a16:creationId xmlns:a16="http://schemas.microsoft.com/office/drawing/2014/main" id="{4639790B-F989-7641-916A-C42A2505F7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D4250405-AA09-784A-BF06-EBB7DDB570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70" name="TextBox 69">
                      <a:extLst>
                        <a:ext uri="{FF2B5EF4-FFF2-40B4-BE49-F238E27FC236}">
                          <a16:creationId xmlns:a16="http://schemas.microsoft.com/office/drawing/2014/main" id="{A8F9C39B-5458-E543-B00C-2DFBCF182C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72" name="TextBox 71">
                      <a:extLst>
                        <a:ext uri="{FF2B5EF4-FFF2-40B4-BE49-F238E27FC236}">
                          <a16:creationId xmlns:a16="http://schemas.microsoft.com/office/drawing/2014/main" id="{DB8DB24E-1586-6D4B-9B3B-112D95E4DE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3B3DC107-C9A4-6A4C-ABB9-D1FCC6B206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  <p:grpSp>
                <p:nvGrpSpPr>
                  <p:cNvPr id="61" name="Group 60">
                    <a:extLst>
                      <a:ext uri="{FF2B5EF4-FFF2-40B4-BE49-F238E27FC236}">
                        <a16:creationId xmlns:a16="http://schemas.microsoft.com/office/drawing/2014/main" id="{CE7F5AC8-809A-254F-BBB3-E289ED48B5D7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6921238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67" name="TextBox 66">
                      <a:extLst>
                        <a:ext uri="{FF2B5EF4-FFF2-40B4-BE49-F238E27FC236}">
                          <a16:creationId xmlns:a16="http://schemas.microsoft.com/office/drawing/2014/main" id="{7FBA2917-AE7F-3540-9A34-3C4717C5974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65" name="TextBox 64">
                      <a:extLst>
                        <a:ext uri="{FF2B5EF4-FFF2-40B4-BE49-F238E27FC236}">
                          <a16:creationId xmlns:a16="http://schemas.microsoft.com/office/drawing/2014/main" id="{3519DE9C-2C2D-5E4F-B21C-6308A8A7F67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64" name="TextBox 63">
                      <a:extLst>
                        <a:ext uri="{FF2B5EF4-FFF2-40B4-BE49-F238E27FC236}">
                          <a16:creationId xmlns:a16="http://schemas.microsoft.com/office/drawing/2014/main" id="{3C5275DE-15D5-944A-BF18-C25EB54256A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5DBBA057-028F-2A4D-A2D1-E9A292BFBED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id="{008CC80B-AD7B-3B4B-B365-D9A219690D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66" name="TextBox 65">
                      <a:extLst>
                        <a:ext uri="{FF2B5EF4-FFF2-40B4-BE49-F238E27FC236}">
                          <a16:creationId xmlns:a16="http://schemas.microsoft.com/office/drawing/2014/main" id="{616CE034-C8F4-B544-8DB0-72348E38F90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</p:grpSp>
          </p:grpSp>
        </p:grpSp>
        <p:pic>
          <p:nvPicPr>
            <p:cNvPr id="49" name="Picture 48" descr="Graphical user interface, Excel&#10;&#10;Description automatically generated">
              <a:extLst>
                <a:ext uri="{FF2B5EF4-FFF2-40B4-BE49-F238E27FC236}">
                  <a16:creationId xmlns:a16="http://schemas.microsoft.com/office/drawing/2014/main" id="{9228088B-A4B5-8B4A-8ADF-FF44F32E2E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976" t="94467"/>
            <a:stretch/>
          </p:blipFill>
          <p:spPr>
            <a:xfrm>
              <a:off x="698674" y="8894280"/>
              <a:ext cx="4875412" cy="188424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prstMaterial="matte"/>
          </p:spPr>
        </p:pic>
        <p:pic>
          <p:nvPicPr>
            <p:cNvPr id="50" name="Picture 49" descr="Graphical user interface, Excel&#10;&#10;Description automatically generated">
              <a:extLst>
                <a:ext uri="{FF2B5EF4-FFF2-40B4-BE49-F238E27FC236}">
                  <a16:creationId xmlns:a16="http://schemas.microsoft.com/office/drawing/2014/main" id="{67014982-76D6-8545-874F-8FB4823B39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976" t="27890" b="6850"/>
            <a:stretch/>
          </p:blipFill>
          <p:spPr>
            <a:xfrm>
              <a:off x="698675" y="6974792"/>
              <a:ext cx="4875411" cy="1871131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prstMaterial="matte"/>
          </p:spPr>
        </p:pic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6241C5F6-3B10-7F49-951A-CDB5F3FFB077}"/>
              </a:ext>
            </a:extLst>
          </p:cNvPr>
          <p:cNvGrpSpPr/>
          <p:nvPr/>
        </p:nvGrpSpPr>
        <p:grpSpPr>
          <a:xfrm>
            <a:off x="399677" y="6672847"/>
            <a:ext cx="5353852" cy="1992952"/>
            <a:chOff x="-1775" y="4306427"/>
            <a:chExt cx="5567508" cy="2443920"/>
          </a:xfrm>
        </p:grpSpPr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7DF3C250-3AC0-9841-B117-20058CF34CDD}"/>
                </a:ext>
              </a:extLst>
            </p:cNvPr>
            <p:cNvGrpSpPr/>
            <p:nvPr/>
          </p:nvGrpSpPr>
          <p:grpSpPr>
            <a:xfrm>
              <a:off x="-1775" y="4306427"/>
              <a:ext cx="3749769" cy="2289890"/>
              <a:chOff x="119302" y="4302276"/>
              <a:chExt cx="3749769" cy="2289890"/>
            </a:xfrm>
          </p:grpSpPr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D455060-65F7-4D46-9804-B4FB7F442D6E}"/>
                  </a:ext>
                </a:extLst>
              </p:cNvPr>
              <p:cNvSpPr txBox="1"/>
              <p:nvPr/>
            </p:nvSpPr>
            <p:spPr>
              <a:xfrm>
                <a:off x="2382767" y="4426842"/>
                <a:ext cx="1486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tx2">
                        <a:lumMod val="1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r4:80,946,631-81,452,783</a:t>
                </a:r>
              </a:p>
            </p:txBody>
          </p: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19AF269D-AB89-0343-BE43-14FA37865E59}"/>
                  </a:ext>
                </a:extLst>
              </p:cNvPr>
              <p:cNvGrpSpPr/>
              <p:nvPr/>
            </p:nvGrpSpPr>
            <p:grpSpPr>
              <a:xfrm>
                <a:off x="119302" y="4302276"/>
                <a:ext cx="767288" cy="2289890"/>
                <a:chOff x="120904" y="6644253"/>
                <a:chExt cx="767288" cy="2289890"/>
              </a:xfrm>
            </p:grpSpPr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15C47B12-63E2-F540-8D30-0211D8944BB2}"/>
                    </a:ext>
                  </a:extLst>
                </p:cNvPr>
                <p:cNvSpPr txBox="1"/>
                <p:nvPr/>
              </p:nvSpPr>
              <p:spPr>
                <a:xfrm rot="16200000">
                  <a:off x="-236137" y="8248049"/>
                  <a:ext cx="99108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NA-seq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AA4238D3-0811-0145-B827-EF55DE96E183}"/>
                    </a:ext>
                  </a:extLst>
                </p:cNvPr>
                <p:cNvSpPr txBox="1"/>
                <p:nvPr/>
              </p:nvSpPr>
              <p:spPr>
                <a:xfrm rot="16200000">
                  <a:off x="-410411" y="7175568"/>
                  <a:ext cx="133962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/B CScore </a:t>
                  </a:r>
                </a:p>
                <a:p>
                  <a:pPr algn="ctr"/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mpartments</a:t>
                  </a:r>
                </a:p>
              </p:txBody>
            </p:sp>
            <p:grpSp>
              <p:nvGrpSpPr>
                <p:cNvPr id="91" name="Group 90">
                  <a:extLst>
                    <a:ext uri="{FF2B5EF4-FFF2-40B4-BE49-F238E27FC236}">
                      <a16:creationId xmlns:a16="http://schemas.microsoft.com/office/drawing/2014/main" id="{8171CC8E-B8D7-0441-9EF2-EDBD81C88077}"/>
                    </a:ext>
                  </a:extLst>
                </p:cNvPr>
                <p:cNvGrpSpPr/>
                <p:nvPr/>
              </p:nvGrpSpPr>
              <p:grpSpPr>
                <a:xfrm>
                  <a:off x="412054" y="6986978"/>
                  <a:ext cx="34" cy="1848945"/>
                  <a:chOff x="412054" y="6986978"/>
                  <a:chExt cx="34" cy="1848945"/>
                </a:xfrm>
              </p:grpSpPr>
              <p:cxnSp>
                <p:nvCxnSpPr>
                  <p:cNvPr id="116" name="Straight Connector 115">
                    <a:extLst>
                      <a:ext uri="{FF2B5EF4-FFF2-40B4-BE49-F238E27FC236}">
                        <a16:creationId xmlns:a16="http://schemas.microsoft.com/office/drawing/2014/main" id="{549ACEAA-DD9B-1743-8EF5-638D8166CEC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88" y="6986978"/>
                    <a:ext cx="0" cy="5853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Straight Connector 120">
                    <a:extLst>
                      <a:ext uri="{FF2B5EF4-FFF2-40B4-BE49-F238E27FC236}">
                        <a16:creationId xmlns:a16="http://schemas.microsoft.com/office/drawing/2014/main" id="{8F1FF133-BC51-1A4B-B0C1-EBDCCE727E2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54" y="8261967"/>
                    <a:ext cx="0" cy="5739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3" name="Straight Connector 152">
                    <a:extLst>
                      <a:ext uri="{FF2B5EF4-FFF2-40B4-BE49-F238E27FC236}">
                        <a16:creationId xmlns:a16="http://schemas.microsoft.com/office/drawing/2014/main" id="{82885967-112C-8E4B-A863-B154AEC3EFB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2058" y="7598318"/>
                    <a:ext cx="0" cy="63430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850A082D-9372-204B-82B0-DD4D68670ED2}"/>
                    </a:ext>
                  </a:extLst>
                </p:cNvPr>
                <p:cNvSpPr txBox="1"/>
                <p:nvPr/>
              </p:nvSpPr>
              <p:spPr>
                <a:xfrm rot="16200000">
                  <a:off x="-233767" y="7671864"/>
                  <a:ext cx="98634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chemeClr val="tx2">
                          <a:lumMod val="1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AC-seq</a:t>
                  </a:r>
                </a:p>
              </p:txBody>
            </p:sp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1451406E-6E92-0846-BBCF-EEE310B209B2}"/>
                    </a:ext>
                  </a:extLst>
                </p:cNvPr>
                <p:cNvGrpSpPr/>
                <p:nvPr/>
              </p:nvGrpSpPr>
              <p:grpSpPr>
                <a:xfrm>
                  <a:off x="389434" y="6921238"/>
                  <a:ext cx="498758" cy="2012905"/>
                  <a:chOff x="389434" y="6921238"/>
                  <a:chExt cx="498758" cy="2012905"/>
                </a:xfrm>
              </p:grpSpPr>
              <p:grpSp>
                <p:nvGrpSpPr>
                  <p:cNvPr id="94" name="Group 93">
                    <a:extLst>
                      <a:ext uri="{FF2B5EF4-FFF2-40B4-BE49-F238E27FC236}">
                        <a16:creationId xmlns:a16="http://schemas.microsoft.com/office/drawing/2014/main" id="{ACA21D39-DCE5-9D44-8996-20C1E00E6107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8181981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0B07479E-3209-1A49-BF13-446F1AB34C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13" name="TextBox 112">
                      <a:extLst>
                        <a:ext uri="{FF2B5EF4-FFF2-40B4-BE49-F238E27FC236}">
                          <a16:creationId xmlns:a16="http://schemas.microsoft.com/office/drawing/2014/main" id="{CB910B2A-B222-FA4F-A7D3-F35F11D500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110" name="TextBox 109">
                      <a:extLst>
                        <a:ext uri="{FF2B5EF4-FFF2-40B4-BE49-F238E27FC236}">
                          <a16:creationId xmlns:a16="http://schemas.microsoft.com/office/drawing/2014/main" id="{CA36ADBD-1903-2B4B-AC83-214AEF895E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11" name="TextBox 110">
                      <a:extLst>
                        <a:ext uri="{FF2B5EF4-FFF2-40B4-BE49-F238E27FC236}">
                          <a16:creationId xmlns:a16="http://schemas.microsoft.com/office/drawing/2014/main" id="{F173ECB2-4EA2-CB40-A5F6-C1D3EB3ECF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E23EFC05-2819-244C-84FE-31783BCEB84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114" name="TextBox 113">
                      <a:extLst>
                        <a:ext uri="{FF2B5EF4-FFF2-40B4-BE49-F238E27FC236}">
                          <a16:creationId xmlns:a16="http://schemas.microsoft.com/office/drawing/2014/main" id="{B2DA6B96-6B6A-C347-AD82-2A6BB57B1A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  <p:grpSp>
                <p:nvGrpSpPr>
                  <p:cNvPr id="95" name="Group 94">
                    <a:extLst>
                      <a:ext uri="{FF2B5EF4-FFF2-40B4-BE49-F238E27FC236}">
                        <a16:creationId xmlns:a16="http://schemas.microsoft.com/office/drawing/2014/main" id="{B23C864D-88F5-D446-A798-48CE658DFDCB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7558655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104" name="TextBox 103">
                      <a:extLst>
                        <a:ext uri="{FF2B5EF4-FFF2-40B4-BE49-F238E27FC236}">
                          <a16:creationId xmlns:a16="http://schemas.microsoft.com/office/drawing/2014/main" id="{85888F3A-72FB-5241-9B90-AB298A33B8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07" name="TextBox 106">
                      <a:extLst>
                        <a:ext uri="{FF2B5EF4-FFF2-40B4-BE49-F238E27FC236}">
                          <a16:creationId xmlns:a16="http://schemas.microsoft.com/office/drawing/2014/main" id="{EDE1D43B-5367-FC44-9DCD-AF4A03695A4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103" name="TextBox 102">
                      <a:extLst>
                        <a:ext uri="{FF2B5EF4-FFF2-40B4-BE49-F238E27FC236}">
                          <a16:creationId xmlns:a16="http://schemas.microsoft.com/office/drawing/2014/main" id="{B6F44F49-84C3-624F-9F39-FADD8171C11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06" name="TextBox 105">
                      <a:extLst>
                        <a:ext uri="{FF2B5EF4-FFF2-40B4-BE49-F238E27FC236}">
                          <a16:creationId xmlns:a16="http://schemas.microsoft.com/office/drawing/2014/main" id="{A8E12618-19A1-7842-8970-AF43031F690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108" name="TextBox 107">
                      <a:extLst>
                        <a:ext uri="{FF2B5EF4-FFF2-40B4-BE49-F238E27FC236}">
                          <a16:creationId xmlns:a16="http://schemas.microsoft.com/office/drawing/2014/main" id="{8167A3AE-7BEF-C746-A4ED-F77F76FA96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09" name="TextBox 108">
                      <a:extLst>
                        <a:ext uri="{FF2B5EF4-FFF2-40B4-BE49-F238E27FC236}">
                          <a16:creationId xmlns:a16="http://schemas.microsoft.com/office/drawing/2014/main" id="{7ABF4552-62FD-6940-9B65-36FB2B13F3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  <p:grpSp>
                <p:nvGrpSpPr>
                  <p:cNvPr id="96" name="Group 95">
                    <a:extLst>
                      <a:ext uri="{FF2B5EF4-FFF2-40B4-BE49-F238E27FC236}">
                        <a16:creationId xmlns:a16="http://schemas.microsoft.com/office/drawing/2014/main" id="{03E00FA7-E4B1-AD49-BE12-115AD712F718}"/>
                      </a:ext>
                    </a:extLst>
                  </p:cNvPr>
                  <p:cNvGrpSpPr/>
                  <p:nvPr/>
                </p:nvGrpSpPr>
                <p:grpSpPr>
                  <a:xfrm>
                    <a:off x="389434" y="6921238"/>
                    <a:ext cx="498758" cy="752162"/>
                    <a:chOff x="1702523" y="3518897"/>
                    <a:chExt cx="683459" cy="1015184"/>
                  </a:xfrm>
                </p:grpSpPr>
                <p:sp>
                  <p:nvSpPr>
                    <p:cNvPr id="100" name="TextBox 99">
                      <a:extLst>
                        <a:ext uri="{FF2B5EF4-FFF2-40B4-BE49-F238E27FC236}">
                          <a16:creationId xmlns:a16="http://schemas.microsoft.com/office/drawing/2014/main" id="{EBCB1240-7411-9549-995B-E33A30CBFC6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795325"/>
                      <a:ext cx="68345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High</a:t>
                      </a:r>
                    </a:p>
                  </p:txBody>
                </p:sp>
                <p:sp>
                  <p:nvSpPr>
                    <p:cNvPr id="98" name="TextBox 97">
                      <a:extLst>
                        <a:ext uri="{FF2B5EF4-FFF2-40B4-BE49-F238E27FC236}">
                          <a16:creationId xmlns:a16="http://schemas.microsoft.com/office/drawing/2014/main" id="{C2CA281F-B6A5-3F40-ACD6-D50702AD9B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518897"/>
                      <a:ext cx="61036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97" name="TextBox 96">
                      <a:extLst>
                        <a:ext uri="{FF2B5EF4-FFF2-40B4-BE49-F238E27FC236}">
                          <a16:creationId xmlns:a16="http://schemas.microsoft.com/office/drawing/2014/main" id="{C39DCFF4-724B-2949-94D6-1E0DE5CF23D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6658" y="3657113"/>
                      <a:ext cx="594373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CH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99" name="TextBox 98">
                      <a:extLst>
                        <a:ext uri="{FF2B5EF4-FFF2-40B4-BE49-F238E27FC236}">
                          <a16:creationId xmlns:a16="http://schemas.microsoft.com/office/drawing/2014/main" id="{137FC4AE-285A-5746-9A12-C235BD4714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523" y="3933544"/>
                      <a:ext cx="66747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RS411.Low</a:t>
                      </a:r>
                    </a:p>
                  </p:txBody>
                </p:sp>
                <p:sp>
                  <p:nvSpPr>
                    <p:cNvPr id="101" name="TextBox 100">
                      <a:extLst>
                        <a:ext uri="{FF2B5EF4-FFF2-40B4-BE49-F238E27FC236}">
                          <a16:creationId xmlns:a16="http://schemas.microsoft.com/office/drawing/2014/main" id="{060EB9F8-8173-8043-8791-E4C6FFE56A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209975"/>
                      <a:ext cx="603510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Low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  <p:sp>
                  <p:nvSpPr>
                    <p:cNvPr id="102" name="TextBox 101">
                      <a:extLst>
                        <a:ext uri="{FF2B5EF4-FFF2-40B4-BE49-F238E27FC236}">
                          <a16:creationId xmlns:a16="http://schemas.microsoft.com/office/drawing/2014/main" id="{C82F29F0-F277-4F42-B50B-721D77CD76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0288" y="4071759"/>
                      <a:ext cx="619499" cy="32410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US" sz="500" dirty="0" err="1">
                          <a:solidFill>
                            <a:schemeClr val="tx2">
                              <a:lumMod val="10000"/>
                            </a:schemeClr>
                          </a:solidFill>
                        </a:rPr>
                        <a:t>SEM.High</a:t>
                      </a:r>
                      <a:endParaRPr lang="en-US" sz="500" dirty="0">
                        <a:solidFill>
                          <a:schemeClr val="tx2">
                            <a:lumMod val="10000"/>
                          </a:schemeClr>
                        </a:solidFill>
                      </a:endParaRPr>
                    </a:p>
                  </p:txBody>
                </p:sp>
              </p:grpSp>
            </p:grpSp>
          </p:grpSp>
        </p:grpSp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0CA10CB1-EFD3-6E42-9F1B-C198814D1F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976" t="94450"/>
            <a:stretch/>
          </p:blipFill>
          <p:spPr>
            <a:xfrm>
              <a:off x="688093" y="6560682"/>
              <a:ext cx="4877640" cy="189665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prstMaterial="matte"/>
          </p:spPr>
        </p:pic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DBB4F19B-F352-7047-B6C7-C1ECFA9507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976" t="27969" b="6484"/>
            <a:stretch/>
          </p:blipFill>
          <p:spPr>
            <a:xfrm>
              <a:off x="688095" y="4658964"/>
              <a:ext cx="4877638" cy="1871392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prstMaterial="matte"/>
          </p:spPr>
        </p:pic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BBD260DC-3C03-814B-9AFA-CAC72344B1C9}"/>
              </a:ext>
            </a:extLst>
          </p:cNvPr>
          <p:cNvSpPr txBox="1"/>
          <p:nvPr/>
        </p:nvSpPr>
        <p:spPr>
          <a:xfrm>
            <a:off x="2071179" y="6614992"/>
            <a:ext cx="2603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Genome Browser tracks of the FGF5 locus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015E078D-E107-AA44-B5C6-75D51E21ED5C}"/>
              </a:ext>
            </a:extLst>
          </p:cNvPr>
          <p:cNvSpPr txBox="1"/>
          <p:nvPr/>
        </p:nvSpPr>
        <p:spPr>
          <a:xfrm>
            <a:off x="2071419" y="4510167"/>
            <a:ext cx="2624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Genome Browser tracks of the NEO1 locus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8FF60A7D-1E41-ED47-BB8F-AFE0553750EE}"/>
              </a:ext>
            </a:extLst>
          </p:cNvPr>
          <p:cNvSpPr txBox="1"/>
          <p:nvPr/>
        </p:nvSpPr>
        <p:spPr>
          <a:xfrm>
            <a:off x="71643" y="65550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807552B-1B5C-D249-A86E-05B6502AFE00}"/>
              </a:ext>
            </a:extLst>
          </p:cNvPr>
          <p:cNvGrpSpPr/>
          <p:nvPr/>
        </p:nvGrpSpPr>
        <p:grpSpPr>
          <a:xfrm>
            <a:off x="3240306" y="252163"/>
            <a:ext cx="2544894" cy="2315153"/>
            <a:chOff x="2245522" y="252164"/>
            <a:chExt cx="2260229" cy="2217534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8E13C50A-DD07-A546-AF0A-4883E062BF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15076" b="15375"/>
            <a:stretch/>
          </p:blipFill>
          <p:spPr>
            <a:xfrm>
              <a:off x="2245522" y="252164"/>
              <a:ext cx="1814796" cy="1808411"/>
            </a:xfrm>
            <a:prstGeom prst="rect">
              <a:avLst/>
            </a:prstGeom>
          </p:spPr>
        </p:pic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31CC80EA-68AA-1246-831B-C9466B421AD1}"/>
                </a:ext>
              </a:extLst>
            </p:cNvPr>
            <p:cNvSpPr txBox="1"/>
            <p:nvPr/>
          </p:nvSpPr>
          <p:spPr>
            <a:xfrm>
              <a:off x="3979645" y="1718497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-2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EF5E8005-4D94-B645-A731-525F33F4AF83}"/>
                </a:ext>
              </a:extLst>
            </p:cNvPr>
            <p:cNvSpPr txBox="1"/>
            <p:nvPr/>
          </p:nvSpPr>
          <p:spPr>
            <a:xfrm>
              <a:off x="3979645" y="1913492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-2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9DC8E996-F342-6F43-8A1F-87B9163E9F08}"/>
                </a:ext>
              </a:extLst>
            </p:cNvPr>
            <p:cNvSpPr txBox="1"/>
            <p:nvPr/>
          </p:nvSpPr>
          <p:spPr>
            <a:xfrm>
              <a:off x="3979645" y="841042"/>
              <a:ext cx="526106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-1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81CDB253-98F2-B048-A60F-2051FC8064B6}"/>
                </a:ext>
              </a:extLst>
            </p:cNvPr>
            <p:cNvSpPr txBox="1"/>
            <p:nvPr/>
          </p:nvSpPr>
          <p:spPr>
            <a:xfrm>
              <a:off x="3979645" y="1036032"/>
              <a:ext cx="468398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B7B6C043-CB99-0548-99C5-C5BF6F7F0E10}"/>
                </a:ext>
              </a:extLst>
            </p:cNvPr>
            <p:cNvSpPr txBox="1"/>
            <p:nvPr/>
          </p:nvSpPr>
          <p:spPr>
            <a:xfrm>
              <a:off x="3979645" y="1231022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-1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C92CD139-7A4F-074F-9B11-813B677A7F71}"/>
                </a:ext>
              </a:extLst>
            </p:cNvPr>
            <p:cNvSpPr txBox="1"/>
            <p:nvPr/>
          </p:nvSpPr>
          <p:spPr>
            <a:xfrm>
              <a:off x="3979645" y="1328517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-2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2258CDC-D46B-4B41-8F28-312A9FCBFAE1}"/>
                </a:ext>
              </a:extLst>
            </p:cNvPr>
            <p:cNvSpPr txBox="1"/>
            <p:nvPr/>
          </p:nvSpPr>
          <p:spPr>
            <a:xfrm>
              <a:off x="3979645" y="938537"/>
              <a:ext cx="526106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-2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EF0562B4-4FBF-0047-AE83-873C8BC9352C}"/>
                </a:ext>
              </a:extLst>
            </p:cNvPr>
            <p:cNvSpPr txBox="1"/>
            <p:nvPr/>
          </p:nvSpPr>
          <p:spPr>
            <a:xfrm>
              <a:off x="3979645" y="1133527"/>
              <a:ext cx="468398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066E00D7-5A33-5F47-98AB-8E919E74A450}"/>
                </a:ext>
              </a:extLst>
            </p:cNvPr>
            <p:cNvSpPr txBox="1"/>
            <p:nvPr/>
          </p:nvSpPr>
          <p:spPr>
            <a:xfrm>
              <a:off x="3979645" y="1426012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-1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DBEBBA82-6229-BE4D-A207-C21FFC331C37}"/>
                </a:ext>
              </a:extLst>
            </p:cNvPr>
            <p:cNvSpPr txBox="1"/>
            <p:nvPr/>
          </p:nvSpPr>
          <p:spPr>
            <a:xfrm>
              <a:off x="3979645" y="1523507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-2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BD56A46C-7DC3-7A41-9022-E9C01235C5F4}"/>
                </a:ext>
              </a:extLst>
            </p:cNvPr>
            <p:cNvSpPr txBox="1"/>
            <p:nvPr/>
          </p:nvSpPr>
          <p:spPr>
            <a:xfrm>
              <a:off x="3979645" y="1815992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-1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C7FE3F48-B831-AB43-9F0C-FD06DA2D32AF}"/>
                </a:ext>
              </a:extLst>
            </p:cNvPr>
            <p:cNvSpPr txBox="1"/>
            <p:nvPr/>
          </p:nvSpPr>
          <p:spPr>
            <a:xfrm>
              <a:off x="3979645" y="1621002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-1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322FD70-D32A-7847-81F8-BB8BBA59267A}"/>
                </a:ext>
              </a:extLst>
            </p:cNvPr>
            <p:cNvSpPr txBox="1"/>
            <p:nvPr/>
          </p:nvSpPr>
          <p:spPr>
            <a:xfrm rot="18259085">
              <a:off x="3482186" y="2098101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-2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6184D6B6-105B-1643-80BF-DC6F61E8C6EA}"/>
                </a:ext>
              </a:extLst>
            </p:cNvPr>
            <p:cNvSpPr txBox="1"/>
            <p:nvPr/>
          </p:nvSpPr>
          <p:spPr>
            <a:xfrm rot="18259085">
              <a:off x="3686725" y="2101511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-2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65416C77-851F-BE47-A685-0928BBA6790A}"/>
                </a:ext>
              </a:extLst>
            </p:cNvPr>
            <p:cNvSpPr txBox="1"/>
            <p:nvPr/>
          </p:nvSpPr>
          <p:spPr>
            <a:xfrm rot="18259085">
              <a:off x="2500461" y="2120018"/>
              <a:ext cx="526106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-1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726968A5-6281-AF4F-833A-289691405BD3}"/>
                </a:ext>
              </a:extLst>
            </p:cNvPr>
            <p:cNvSpPr txBox="1"/>
            <p:nvPr/>
          </p:nvSpPr>
          <p:spPr>
            <a:xfrm rot="18259085">
              <a:off x="2739461" y="2102485"/>
              <a:ext cx="468398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97E63656-AA1C-DE45-A14B-BD2D9B9FCC5A}"/>
                </a:ext>
              </a:extLst>
            </p:cNvPr>
            <p:cNvSpPr txBox="1"/>
            <p:nvPr/>
          </p:nvSpPr>
          <p:spPr>
            <a:xfrm rot="18259085">
              <a:off x="2956821" y="2098101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-1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AF2C768B-A8EE-7146-8BC4-C884E81C4317}"/>
                </a:ext>
              </a:extLst>
            </p:cNvPr>
            <p:cNvSpPr txBox="1"/>
            <p:nvPr/>
          </p:nvSpPr>
          <p:spPr>
            <a:xfrm rot="18259085">
              <a:off x="3061894" y="2098101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Low-2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2421F6B7-954A-3543-B405-A5F221D1B481}"/>
                </a:ext>
              </a:extLst>
            </p:cNvPr>
            <p:cNvSpPr txBox="1"/>
            <p:nvPr/>
          </p:nvSpPr>
          <p:spPr>
            <a:xfrm rot="18259085">
              <a:off x="2605534" y="2120018"/>
              <a:ext cx="526106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High-2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7C590E2D-F2AD-BC46-9C88-1C23F7F2F04B}"/>
                </a:ext>
              </a:extLst>
            </p:cNvPr>
            <p:cNvSpPr txBox="1"/>
            <p:nvPr/>
          </p:nvSpPr>
          <p:spPr>
            <a:xfrm rot="18259085">
              <a:off x="2844534" y="2102485"/>
              <a:ext cx="468398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S4;11-Low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81D081E9-938D-024A-BA6C-D7AAD6703702}"/>
                </a:ext>
              </a:extLst>
            </p:cNvPr>
            <p:cNvSpPr txBox="1"/>
            <p:nvPr/>
          </p:nvSpPr>
          <p:spPr>
            <a:xfrm rot="18259085">
              <a:off x="3161356" y="2101511"/>
              <a:ext cx="465192" cy="1732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-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F9EF7862-283C-DF4D-9A73-A7CAEA349412}"/>
                </a:ext>
              </a:extLst>
            </p:cNvPr>
            <p:cNvSpPr txBox="1"/>
            <p:nvPr/>
          </p:nvSpPr>
          <p:spPr>
            <a:xfrm rot="18259085">
              <a:off x="3266429" y="2101511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CH-High-2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B76DF5F5-8AE5-8E4D-B27F-899DD2797EFB}"/>
                </a:ext>
              </a:extLst>
            </p:cNvPr>
            <p:cNvSpPr txBox="1"/>
            <p:nvPr/>
          </p:nvSpPr>
          <p:spPr>
            <a:xfrm rot="18259085">
              <a:off x="3581648" y="2101511"/>
              <a:ext cx="465192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High-1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0D05662D-AB8E-AF4B-9962-2332AA9CCA76}"/>
                </a:ext>
              </a:extLst>
            </p:cNvPr>
            <p:cNvSpPr txBox="1"/>
            <p:nvPr/>
          </p:nvSpPr>
          <p:spPr>
            <a:xfrm rot="18259085">
              <a:off x="3377113" y="2098101"/>
              <a:ext cx="453970" cy="173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400" dirty="0">
                  <a:solidFill>
                    <a:schemeClr val="tx2">
                      <a:lumMod val="1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-Low-1</a:t>
              </a:r>
            </a:p>
          </p:txBody>
        </p:sp>
      </p:grpSp>
      <p:pic>
        <p:nvPicPr>
          <p:cNvPr id="188" name="Picture 187">
            <a:extLst>
              <a:ext uri="{FF2B5EF4-FFF2-40B4-BE49-F238E27FC236}">
                <a16:creationId xmlns:a16="http://schemas.microsoft.com/office/drawing/2014/main" id="{9087D8BC-5ADD-E842-9EC0-9741E41D32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371" t="36758" b="50518"/>
          <a:stretch/>
        </p:blipFill>
        <p:spPr>
          <a:xfrm>
            <a:off x="2200126" y="821231"/>
            <a:ext cx="700753" cy="239568"/>
          </a:xfrm>
          <a:prstGeom prst="rect">
            <a:avLst/>
          </a:prstGeom>
        </p:spPr>
      </p:pic>
      <p:sp>
        <p:nvSpPr>
          <p:cNvPr id="167" name="TextBox 166">
            <a:extLst>
              <a:ext uri="{FF2B5EF4-FFF2-40B4-BE49-F238E27FC236}">
                <a16:creationId xmlns:a16="http://schemas.microsoft.com/office/drawing/2014/main" id="{191EF0D9-34ED-2B46-B150-9606975E2917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7436846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211CF65A-99E6-4C44-981B-639900C416DF}"/>
              </a:ext>
            </a:extLst>
          </p:cNvPr>
          <p:cNvSpPr txBox="1"/>
          <p:nvPr/>
        </p:nvSpPr>
        <p:spPr>
          <a:xfrm>
            <a:off x="20389" y="26002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AA6DA1A-547E-E740-A7DE-4D3E9428D975}"/>
              </a:ext>
            </a:extLst>
          </p:cNvPr>
          <p:cNvSpPr txBox="1"/>
          <p:nvPr/>
        </p:nvSpPr>
        <p:spPr>
          <a:xfrm>
            <a:off x="3116018" y="345937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625F34A-7DD6-174C-A63F-5A24459FC847}"/>
              </a:ext>
            </a:extLst>
          </p:cNvPr>
          <p:cNvSpPr txBox="1"/>
          <p:nvPr/>
        </p:nvSpPr>
        <p:spPr>
          <a:xfrm>
            <a:off x="3116018" y="45020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67" name="Table 2">
            <a:extLst>
              <a:ext uri="{FF2B5EF4-FFF2-40B4-BE49-F238E27FC236}">
                <a16:creationId xmlns:a16="http://schemas.microsoft.com/office/drawing/2014/main" id="{D446A5C9-0020-E549-88A4-B747B41C87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3611408"/>
              </p:ext>
            </p:extLst>
          </p:nvPr>
        </p:nvGraphicFramePr>
        <p:xfrm>
          <a:off x="490650" y="7082125"/>
          <a:ext cx="3429000" cy="1071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3000">
                  <a:extLst>
                    <a:ext uri="{9D8B030D-6E8A-4147-A177-3AD203B41FA5}">
                      <a16:colId xmlns:a16="http://schemas.microsoft.com/office/drawing/2014/main" val="580218192"/>
                    </a:ext>
                  </a:extLst>
                </a:gridCol>
                <a:gridCol w="1422226">
                  <a:extLst>
                    <a:ext uri="{9D8B030D-6E8A-4147-A177-3AD203B41FA5}">
                      <a16:colId xmlns:a16="http://schemas.microsoft.com/office/drawing/2014/main" val="4211700447"/>
                    </a:ext>
                  </a:extLst>
                </a:gridCol>
                <a:gridCol w="863774">
                  <a:extLst>
                    <a:ext uri="{9D8B030D-6E8A-4147-A177-3AD203B41FA5}">
                      <a16:colId xmlns:a16="http://schemas.microsoft.com/office/drawing/2014/main" val="8073228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NSD2-High up gen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NSD2-High up gene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BA Switch + shif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492443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94%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63842164"/>
                  </a:ext>
                </a:extLst>
              </a:tr>
            </a:tbl>
          </a:graphicData>
        </a:graphic>
      </p:graphicFrame>
      <p:sp>
        <p:nvSpPr>
          <p:cNvPr id="69" name="TextBox 68">
            <a:extLst>
              <a:ext uri="{FF2B5EF4-FFF2-40B4-BE49-F238E27FC236}">
                <a16:creationId xmlns:a16="http://schemas.microsoft.com/office/drawing/2014/main" id="{54A5D94C-10A5-B344-9D6B-7B82866EB4D4}"/>
              </a:ext>
            </a:extLst>
          </p:cNvPr>
          <p:cNvSpPr txBox="1"/>
          <p:nvPr/>
        </p:nvSpPr>
        <p:spPr>
          <a:xfrm>
            <a:off x="21602" y="6968887"/>
            <a:ext cx="284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F41EF2A-279F-1E46-A78F-FE9B71283731}"/>
              </a:ext>
            </a:extLst>
          </p:cNvPr>
          <p:cNvSpPr txBox="1"/>
          <p:nvPr/>
        </p:nvSpPr>
        <p:spPr>
          <a:xfrm>
            <a:off x="489437" y="2684432"/>
            <a:ext cx="5059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verlap of patient NSD2-High upregulated genes and cell line NSD2-High upregulated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08735D1-87D4-424C-8AA2-049A8E71D39F}"/>
              </a:ext>
            </a:extLst>
          </p:cNvPr>
          <p:cNvSpPr txBox="1"/>
          <p:nvPr/>
        </p:nvSpPr>
        <p:spPr>
          <a:xfrm>
            <a:off x="593778" y="3995875"/>
            <a:ext cx="52229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verlap of patient NSD2-High downregulated genes and cell line NSD2-High upregulate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45FEEB36-25D9-5F49-85E7-2D0851625267}"/>
              </a:ext>
            </a:extLst>
          </p:cNvPr>
          <p:cNvGrpSpPr/>
          <p:nvPr/>
        </p:nvGrpSpPr>
        <p:grpSpPr>
          <a:xfrm>
            <a:off x="430717" y="3123917"/>
            <a:ext cx="5477517" cy="872167"/>
            <a:chOff x="449886" y="3125400"/>
            <a:chExt cx="5477517" cy="872167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73ABB7A-0782-1644-85BA-ED76A40FE3C1}"/>
                </a:ext>
              </a:extLst>
            </p:cNvPr>
            <p:cNvGrpSpPr/>
            <p:nvPr/>
          </p:nvGrpSpPr>
          <p:grpSpPr>
            <a:xfrm>
              <a:off x="1026668" y="3125400"/>
              <a:ext cx="1098267" cy="623891"/>
              <a:chOff x="562708" y="3071446"/>
              <a:chExt cx="1547660" cy="885092"/>
            </a:xfrm>
          </p:grpSpPr>
          <p:sp>
            <p:nvSpPr>
              <p:cNvPr id="18" name="Oval 17">
                <a:extLst>
                  <a:ext uri="{FF2B5EF4-FFF2-40B4-BE49-F238E27FC236}">
                    <a16:creationId xmlns:a16="http://schemas.microsoft.com/office/drawing/2014/main" id="{4F6AE7EB-A8AE-B644-8BB7-1B67E1711E92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3CDF3DE4-E6F5-904E-AEEF-2E2F33090B72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B145670-1380-FE4E-ACD7-79EE88439C49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58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B792D0C-8BB4-0947-A07E-FF2D1DBB8E0C}"/>
                  </a:ext>
                </a:extLst>
              </p:cNvPr>
              <p:cNvSpPr txBox="1"/>
              <p:nvPr/>
            </p:nvSpPr>
            <p:spPr>
              <a:xfrm>
                <a:off x="1551962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24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9D15BCD-BAC2-8A4A-8156-F8FFD32CE0F9}"/>
                  </a:ext>
                </a:extLst>
              </p:cNvPr>
              <p:cNvSpPr txBox="1"/>
              <p:nvPr/>
            </p:nvSpPr>
            <p:spPr>
              <a:xfrm>
                <a:off x="1108730" y="3324693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6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B9AAD83E-AF17-A14E-86B8-693AB429AD58}"/>
                </a:ext>
              </a:extLst>
            </p:cNvPr>
            <p:cNvGrpSpPr/>
            <p:nvPr/>
          </p:nvGrpSpPr>
          <p:grpSpPr>
            <a:xfrm>
              <a:off x="2626033" y="3125400"/>
              <a:ext cx="1098267" cy="623891"/>
              <a:chOff x="562708" y="3071446"/>
              <a:chExt cx="1547660" cy="885092"/>
            </a:xfrm>
          </p:grpSpPr>
          <p:sp>
            <p:nvSpPr>
              <p:cNvPr id="24" name="Oval 23">
                <a:extLst>
                  <a:ext uri="{FF2B5EF4-FFF2-40B4-BE49-F238E27FC236}">
                    <a16:creationId xmlns:a16="http://schemas.microsoft.com/office/drawing/2014/main" id="{3F1B4E8E-B17F-9E4E-906D-FFE732068496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25" name="Oval 24">
                <a:extLst>
                  <a:ext uri="{FF2B5EF4-FFF2-40B4-BE49-F238E27FC236}">
                    <a16:creationId xmlns:a16="http://schemas.microsoft.com/office/drawing/2014/main" id="{CF0DECC4-F8AB-FB4C-8F96-C830577BECAB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83DB0F14-0C77-0F4A-91C4-2709D28EEA0D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2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4E22AC0-F636-2146-859F-B102168AE2E1}"/>
                  </a:ext>
                </a:extLst>
              </p:cNvPr>
              <p:cNvSpPr txBox="1"/>
              <p:nvPr/>
            </p:nvSpPr>
            <p:spPr>
              <a:xfrm>
                <a:off x="1551962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28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33B62D2-AC5B-0242-BF3A-1C97B6BF1228}"/>
                  </a:ext>
                </a:extLst>
              </p:cNvPr>
              <p:cNvSpPr txBox="1"/>
              <p:nvPr/>
            </p:nvSpPr>
            <p:spPr>
              <a:xfrm>
                <a:off x="1108730" y="3324693"/>
                <a:ext cx="459013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68E65BB8-C2F9-894D-857D-C6EDBEF9C86B}"/>
                </a:ext>
              </a:extLst>
            </p:cNvPr>
            <p:cNvGrpSpPr/>
            <p:nvPr/>
          </p:nvGrpSpPr>
          <p:grpSpPr>
            <a:xfrm>
              <a:off x="4412903" y="3125400"/>
              <a:ext cx="1112812" cy="623891"/>
              <a:chOff x="562708" y="3071446"/>
              <a:chExt cx="1568159" cy="885092"/>
            </a:xfrm>
          </p:grpSpPr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E11FA34D-9614-344A-BCBF-FED727435BDE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C083AFDE-C178-344F-94FD-C06F72BD234D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C271ED5-F9FF-F64D-AA83-F38CB338BD83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94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87A1685E-C5EA-7A47-A785-D0CB8A327AD8}"/>
                  </a:ext>
                </a:extLst>
              </p:cNvPr>
              <p:cNvSpPr txBox="1"/>
              <p:nvPr/>
            </p:nvSpPr>
            <p:spPr>
              <a:xfrm>
                <a:off x="1473068" y="3338084"/>
                <a:ext cx="657799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33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6C70D3D-7105-194B-BD2A-5AC21746DB94}"/>
                  </a:ext>
                </a:extLst>
              </p:cNvPr>
              <p:cNvSpPr txBox="1"/>
              <p:nvPr/>
            </p:nvSpPr>
            <p:spPr>
              <a:xfrm>
                <a:off x="1056134" y="3324693"/>
                <a:ext cx="558405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</p:grp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377EBF6C-532D-DD4F-934A-DD0A580780F0}"/>
                </a:ext>
              </a:extLst>
            </p:cNvPr>
            <p:cNvSpPr txBox="1"/>
            <p:nvPr/>
          </p:nvSpPr>
          <p:spPr>
            <a:xfrm>
              <a:off x="2081262" y="3306950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D6959C8-9056-B741-AB9C-8C48753F1A02}"/>
                </a:ext>
              </a:extLst>
            </p:cNvPr>
            <p:cNvSpPr txBox="1"/>
            <p:nvPr/>
          </p:nvSpPr>
          <p:spPr>
            <a:xfrm>
              <a:off x="3693294" y="3300646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2F32DEB-08D1-A849-A53F-996DAE002B3E}"/>
                </a:ext>
              </a:extLst>
            </p:cNvPr>
            <p:cNvSpPr txBox="1"/>
            <p:nvPr/>
          </p:nvSpPr>
          <p:spPr>
            <a:xfrm>
              <a:off x="5465417" y="3288284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B150F7E-E14F-884B-AF56-AD0D66EDEC4B}"/>
                </a:ext>
              </a:extLst>
            </p:cNvPr>
            <p:cNvSpPr txBox="1"/>
            <p:nvPr/>
          </p:nvSpPr>
          <p:spPr>
            <a:xfrm>
              <a:off x="449886" y="3288284"/>
              <a:ext cx="5806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0DFF70DA-3C3E-C444-ABBB-DEE4C6F12A89}"/>
                </a:ext>
              </a:extLst>
            </p:cNvPr>
            <p:cNvSpPr txBox="1"/>
            <p:nvPr/>
          </p:nvSpPr>
          <p:spPr>
            <a:xfrm>
              <a:off x="1264992" y="3781914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1.17e-2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4887F105-3363-884D-927F-1B7D4BBA0D0C}"/>
                </a:ext>
              </a:extLst>
            </p:cNvPr>
            <p:cNvSpPr txBox="1"/>
            <p:nvPr/>
          </p:nvSpPr>
          <p:spPr>
            <a:xfrm>
              <a:off x="2947301" y="3781914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123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8D110E3-594F-BE4F-911B-8C04AA0C0A83}"/>
                </a:ext>
              </a:extLst>
            </p:cNvPr>
            <p:cNvSpPr txBox="1"/>
            <p:nvPr/>
          </p:nvSpPr>
          <p:spPr>
            <a:xfrm>
              <a:off x="4674841" y="3782123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1.89e-29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7F38601-1F0A-4A4B-9DDB-F655C1D9971E}"/>
              </a:ext>
            </a:extLst>
          </p:cNvPr>
          <p:cNvGrpSpPr/>
          <p:nvPr/>
        </p:nvGrpSpPr>
        <p:grpSpPr>
          <a:xfrm>
            <a:off x="422807" y="4378728"/>
            <a:ext cx="5516399" cy="884662"/>
            <a:chOff x="441976" y="4380211"/>
            <a:chExt cx="5516399" cy="884662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8E30931A-6B51-454A-B3A5-0D0EDDA4E58D}"/>
                </a:ext>
              </a:extLst>
            </p:cNvPr>
            <p:cNvGrpSpPr/>
            <p:nvPr/>
          </p:nvGrpSpPr>
          <p:grpSpPr>
            <a:xfrm>
              <a:off x="1026668" y="4380211"/>
              <a:ext cx="1098267" cy="623891"/>
              <a:chOff x="562708" y="3071446"/>
              <a:chExt cx="1547660" cy="885092"/>
            </a:xfrm>
          </p:grpSpPr>
          <p:sp>
            <p:nvSpPr>
              <p:cNvPr id="37" name="Oval 36">
                <a:extLst>
                  <a:ext uri="{FF2B5EF4-FFF2-40B4-BE49-F238E27FC236}">
                    <a16:creationId xmlns:a16="http://schemas.microsoft.com/office/drawing/2014/main" id="{1CF48F7B-8158-FF47-85DB-E99F16DDCB79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38" name="Oval 37">
                <a:extLst>
                  <a:ext uri="{FF2B5EF4-FFF2-40B4-BE49-F238E27FC236}">
                    <a16:creationId xmlns:a16="http://schemas.microsoft.com/office/drawing/2014/main" id="{D206E14B-98ED-0D43-A87A-B941379DD1E0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C226FCE-F2D8-5046-B8D3-4EC2E26FF608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2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DD9F170-0333-4A4B-95B4-14358B29DAF3}"/>
                  </a:ext>
                </a:extLst>
              </p:cNvPr>
              <p:cNvSpPr txBox="1"/>
              <p:nvPr/>
            </p:nvSpPr>
            <p:spPr>
              <a:xfrm>
                <a:off x="1551962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76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B73E9B4-C677-D443-BB1A-9F7D71615ECD}"/>
                  </a:ext>
                </a:extLst>
              </p:cNvPr>
              <p:cNvSpPr txBox="1"/>
              <p:nvPr/>
            </p:nvSpPr>
            <p:spPr>
              <a:xfrm>
                <a:off x="1131139" y="3324693"/>
                <a:ext cx="359621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FD1DE14A-3BA9-8246-877B-49D04AB878B7}"/>
                </a:ext>
              </a:extLst>
            </p:cNvPr>
            <p:cNvGrpSpPr/>
            <p:nvPr/>
          </p:nvGrpSpPr>
          <p:grpSpPr>
            <a:xfrm>
              <a:off x="2626033" y="4380211"/>
              <a:ext cx="1098267" cy="623891"/>
              <a:chOff x="562708" y="3071446"/>
              <a:chExt cx="1547660" cy="885092"/>
            </a:xfrm>
          </p:grpSpPr>
          <p:sp>
            <p:nvSpPr>
              <p:cNvPr id="43" name="Oval 42">
                <a:extLst>
                  <a:ext uri="{FF2B5EF4-FFF2-40B4-BE49-F238E27FC236}">
                    <a16:creationId xmlns:a16="http://schemas.microsoft.com/office/drawing/2014/main" id="{D04D9EE2-FE6A-5746-BEFF-4E576038BE0D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44" name="Oval 43">
                <a:extLst>
                  <a:ext uri="{FF2B5EF4-FFF2-40B4-BE49-F238E27FC236}">
                    <a16:creationId xmlns:a16="http://schemas.microsoft.com/office/drawing/2014/main" id="{E1BEE2DB-BCB1-DA45-8BAF-ADBA597400A1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4CF07939-36EC-684E-9F19-5CAD2E31195E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17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3B7F0C1-9559-A743-A25F-003C1BBD2C6A}"/>
                  </a:ext>
                </a:extLst>
              </p:cNvPr>
              <p:cNvSpPr txBox="1"/>
              <p:nvPr/>
            </p:nvSpPr>
            <p:spPr>
              <a:xfrm>
                <a:off x="1551962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40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9EDC8C42-EAA1-1E45-B8B0-BFACC421DFEF}"/>
                  </a:ext>
                </a:extLst>
              </p:cNvPr>
              <p:cNvSpPr txBox="1"/>
              <p:nvPr/>
            </p:nvSpPr>
            <p:spPr>
              <a:xfrm>
                <a:off x="1142343" y="3324693"/>
                <a:ext cx="359621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8AC76810-FF5B-6642-944E-F61FEFF0D008}"/>
                </a:ext>
              </a:extLst>
            </p:cNvPr>
            <p:cNvGrpSpPr/>
            <p:nvPr/>
          </p:nvGrpSpPr>
          <p:grpSpPr>
            <a:xfrm>
              <a:off x="4412903" y="4380211"/>
              <a:ext cx="1112812" cy="623891"/>
              <a:chOff x="562708" y="3071446"/>
              <a:chExt cx="1568158" cy="885092"/>
            </a:xfrm>
          </p:grpSpPr>
          <p:sp>
            <p:nvSpPr>
              <p:cNvPr id="62" name="Oval 61">
                <a:extLst>
                  <a:ext uri="{FF2B5EF4-FFF2-40B4-BE49-F238E27FC236}">
                    <a16:creationId xmlns:a16="http://schemas.microsoft.com/office/drawing/2014/main" id="{E0E6A408-7609-1549-AC8A-7D56D481A972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63" name="Oval 62">
                <a:extLst>
                  <a:ext uri="{FF2B5EF4-FFF2-40B4-BE49-F238E27FC236}">
                    <a16:creationId xmlns:a16="http://schemas.microsoft.com/office/drawing/2014/main" id="{21B8414A-D65A-D24B-AC3E-BE249551AE15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A9347AF-3E7F-3442-84C0-0DF8EE048072}"/>
                  </a:ext>
                </a:extLst>
              </p:cNvPr>
              <p:cNvSpPr txBox="1"/>
              <p:nvPr/>
            </p:nvSpPr>
            <p:spPr>
              <a:xfrm>
                <a:off x="583594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89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892435A8-3EEC-0247-84E8-267CC82FC3EB}"/>
                  </a:ext>
                </a:extLst>
              </p:cNvPr>
              <p:cNvSpPr txBox="1"/>
              <p:nvPr/>
            </p:nvSpPr>
            <p:spPr>
              <a:xfrm>
                <a:off x="1473067" y="3338084"/>
                <a:ext cx="657799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117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ECF4078B-AF88-A841-924D-3124928EB857}"/>
                  </a:ext>
                </a:extLst>
              </p:cNvPr>
              <p:cNvSpPr txBox="1"/>
              <p:nvPr/>
            </p:nvSpPr>
            <p:spPr>
              <a:xfrm>
                <a:off x="1100952" y="3324693"/>
                <a:ext cx="459014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</a:p>
            </p:txBody>
          </p: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63242C5-E386-4B4F-AB32-C1E8C438E4B7}"/>
                </a:ext>
              </a:extLst>
            </p:cNvPr>
            <p:cNvSpPr txBox="1"/>
            <p:nvPr/>
          </p:nvSpPr>
          <p:spPr>
            <a:xfrm>
              <a:off x="2112234" y="4549597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700B1DC-6B41-9143-A97A-706F7BC32A05}"/>
                </a:ext>
              </a:extLst>
            </p:cNvPr>
            <p:cNvSpPr txBox="1"/>
            <p:nvPr/>
          </p:nvSpPr>
          <p:spPr>
            <a:xfrm>
              <a:off x="3699214" y="454329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18304B1-A221-7541-91E3-0B91523E4049}"/>
                </a:ext>
              </a:extLst>
            </p:cNvPr>
            <p:cNvSpPr txBox="1"/>
            <p:nvPr/>
          </p:nvSpPr>
          <p:spPr>
            <a:xfrm>
              <a:off x="5496389" y="4530931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C1565AC-A829-BE45-81CF-A7A15D14E1E8}"/>
                </a:ext>
              </a:extLst>
            </p:cNvPr>
            <p:cNvSpPr txBox="1"/>
            <p:nvPr/>
          </p:nvSpPr>
          <p:spPr>
            <a:xfrm>
              <a:off x="441976" y="4548923"/>
              <a:ext cx="5806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4A86E99-D8B2-414B-9E43-8E13C16A108C}"/>
                </a:ext>
              </a:extLst>
            </p:cNvPr>
            <p:cNvSpPr txBox="1"/>
            <p:nvPr/>
          </p:nvSpPr>
          <p:spPr>
            <a:xfrm>
              <a:off x="1264992" y="5049220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9993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B9D99CF-E5B2-7B4E-A02F-503EA7742BF6}"/>
                </a:ext>
              </a:extLst>
            </p:cNvPr>
            <p:cNvSpPr txBox="1"/>
            <p:nvPr/>
          </p:nvSpPr>
          <p:spPr>
            <a:xfrm>
              <a:off x="2947301" y="5049220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6428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2A1EFDB-1747-2143-B850-6C497E66EA58}"/>
                </a:ext>
              </a:extLst>
            </p:cNvPr>
            <p:cNvSpPr txBox="1"/>
            <p:nvPr/>
          </p:nvSpPr>
          <p:spPr>
            <a:xfrm>
              <a:off x="4674841" y="5049429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0169</a:t>
              </a:r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31FF7BEE-129B-9446-89F3-01C23AD35DF5}"/>
              </a:ext>
            </a:extLst>
          </p:cNvPr>
          <p:cNvSpPr txBox="1"/>
          <p:nvPr/>
        </p:nvSpPr>
        <p:spPr>
          <a:xfrm>
            <a:off x="3467699" y="20911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8132429-950D-5C4F-B717-C51F57AC46CD}"/>
              </a:ext>
            </a:extLst>
          </p:cNvPr>
          <p:cNvSpPr txBox="1"/>
          <p:nvPr/>
        </p:nvSpPr>
        <p:spPr>
          <a:xfrm>
            <a:off x="3788064" y="242775"/>
            <a:ext cx="28456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TAD activity changes NSD2 Low to NSD2 High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1124F83-F456-2040-AD95-09C17D00B972}"/>
              </a:ext>
            </a:extLst>
          </p:cNvPr>
          <p:cNvSpPr txBox="1"/>
          <p:nvPr/>
        </p:nvSpPr>
        <p:spPr>
          <a:xfrm>
            <a:off x="142398" y="20420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32C7DFB-C4A9-BF49-89D4-BA9CA1525190}"/>
              </a:ext>
            </a:extLst>
          </p:cNvPr>
          <p:cNvSpPr txBox="1"/>
          <p:nvPr/>
        </p:nvSpPr>
        <p:spPr>
          <a:xfrm>
            <a:off x="483011" y="242775"/>
            <a:ext cx="2723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Heatmap of mean intra-TAD activity changes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9C45E7E-365F-7347-AAF4-FB739A5603B9}"/>
              </a:ext>
            </a:extLst>
          </p:cNvPr>
          <p:cNvSpPr txBox="1"/>
          <p:nvPr/>
        </p:nvSpPr>
        <p:spPr>
          <a:xfrm rot="18780830">
            <a:off x="1509741" y="2275756"/>
            <a:ext cx="6719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S4;11.Low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DE334F5-C2B2-734F-B115-33D44D6E518E}"/>
              </a:ext>
            </a:extLst>
          </p:cNvPr>
          <p:cNvSpPr txBox="1"/>
          <p:nvPr/>
        </p:nvSpPr>
        <p:spPr>
          <a:xfrm rot="18780830">
            <a:off x="1228198" y="2282789"/>
            <a:ext cx="6912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S4;11.High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9533448-707E-3240-9609-CE24D6C3C7E6}"/>
              </a:ext>
            </a:extLst>
          </p:cNvPr>
          <p:cNvSpPr txBox="1"/>
          <p:nvPr/>
        </p:nvSpPr>
        <p:spPr>
          <a:xfrm rot="18780830">
            <a:off x="2106488" y="2237077"/>
            <a:ext cx="5661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CH.Low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73A7F73-543E-1846-B34C-B972E198719E}"/>
              </a:ext>
            </a:extLst>
          </p:cNvPr>
          <p:cNvSpPr txBox="1"/>
          <p:nvPr/>
        </p:nvSpPr>
        <p:spPr>
          <a:xfrm rot="18780830">
            <a:off x="1824947" y="2244109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CH.High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8570F01-7936-3640-9957-BAD8076D875C}"/>
              </a:ext>
            </a:extLst>
          </p:cNvPr>
          <p:cNvSpPr txBox="1"/>
          <p:nvPr/>
        </p:nvSpPr>
        <p:spPr>
          <a:xfrm rot="18780830">
            <a:off x="1017989" y="2237663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M.Low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98F5661-3EED-4E4D-8ECB-4D2F2B3EA3AD}"/>
              </a:ext>
            </a:extLst>
          </p:cNvPr>
          <p:cNvSpPr txBox="1"/>
          <p:nvPr/>
        </p:nvSpPr>
        <p:spPr>
          <a:xfrm rot="18780830">
            <a:off x="736446" y="2244696"/>
            <a:ext cx="5870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M.High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E84710AF-8788-CA41-82EA-72DCA5410BAD}"/>
              </a:ext>
            </a:extLst>
          </p:cNvPr>
          <p:cNvGrpSpPr/>
          <p:nvPr/>
        </p:nvGrpSpPr>
        <p:grpSpPr>
          <a:xfrm>
            <a:off x="314059" y="422544"/>
            <a:ext cx="2891172" cy="1742799"/>
            <a:chOff x="314059" y="422544"/>
            <a:chExt cx="2891172" cy="1742799"/>
          </a:xfrm>
        </p:grpSpPr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D2D1FFEE-234E-BF47-852C-230108065F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612" r="67965" b="74974"/>
            <a:stretch/>
          </p:blipFill>
          <p:spPr>
            <a:xfrm>
              <a:off x="2712616" y="1126947"/>
              <a:ext cx="492615" cy="492494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AB1E9DA8-DC0B-2748-B80C-A2A3B1BFCA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3646" b="17190"/>
            <a:stretch/>
          </p:blipFill>
          <p:spPr>
            <a:xfrm>
              <a:off x="314059" y="480692"/>
              <a:ext cx="2398346" cy="1684651"/>
            </a:xfrm>
            <a:prstGeom prst="rect">
              <a:avLst/>
            </a:prstGeom>
          </p:spPr>
        </p:pic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DB473C6F-7489-8B42-B146-06989C65C93C}"/>
                </a:ext>
              </a:extLst>
            </p:cNvPr>
            <p:cNvSpPr/>
            <p:nvPr/>
          </p:nvSpPr>
          <p:spPr>
            <a:xfrm>
              <a:off x="484266" y="422544"/>
              <a:ext cx="590745" cy="41215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00" name="Picture 99">
            <a:extLst>
              <a:ext uri="{FF2B5EF4-FFF2-40B4-BE49-F238E27FC236}">
                <a16:creationId xmlns:a16="http://schemas.microsoft.com/office/drawing/2014/main" id="{51977BA7-167C-3448-9E08-BBE2D736A6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4219" y="576577"/>
            <a:ext cx="3447605" cy="1880512"/>
          </a:xfrm>
          <a:prstGeom prst="rect">
            <a:avLst/>
          </a:prstGeom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id="{EA90A211-5E05-9F41-92A8-6A970CFF3284}"/>
              </a:ext>
            </a:extLst>
          </p:cNvPr>
          <p:cNvSpPr txBox="1"/>
          <p:nvPr/>
        </p:nvSpPr>
        <p:spPr>
          <a:xfrm>
            <a:off x="2682941" y="1572969"/>
            <a:ext cx="553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mean TAD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32011D5-5984-3D42-9F5D-4591319CF1BC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524469F-7B39-5143-95EF-1EF31E96A1FB}"/>
              </a:ext>
            </a:extLst>
          </p:cNvPr>
          <p:cNvSpPr txBox="1"/>
          <p:nvPr/>
        </p:nvSpPr>
        <p:spPr>
          <a:xfrm>
            <a:off x="524078" y="5457542"/>
            <a:ext cx="5498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verlap of patient Relapse NSD2-Low upregulated genes and cell line NSD2-High upregulated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8CA133E6-E3C9-BB43-8D57-2016E6FB1AB3}"/>
              </a:ext>
            </a:extLst>
          </p:cNvPr>
          <p:cNvGrpSpPr/>
          <p:nvPr/>
        </p:nvGrpSpPr>
        <p:grpSpPr>
          <a:xfrm>
            <a:off x="422807" y="5791656"/>
            <a:ext cx="5516399" cy="884662"/>
            <a:chOff x="441976" y="4380211"/>
            <a:chExt cx="5516399" cy="884662"/>
          </a:xfrm>
        </p:grpSpPr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AD495C56-B52E-404F-B63C-1104810C5EC7}"/>
                </a:ext>
              </a:extLst>
            </p:cNvPr>
            <p:cNvGrpSpPr/>
            <p:nvPr/>
          </p:nvGrpSpPr>
          <p:grpSpPr>
            <a:xfrm>
              <a:off x="1026668" y="4380211"/>
              <a:ext cx="1091333" cy="623891"/>
              <a:chOff x="562708" y="3071446"/>
              <a:chExt cx="1537889" cy="885092"/>
            </a:xfrm>
          </p:grpSpPr>
          <p:sp>
            <p:nvSpPr>
              <p:cNvPr id="156" name="Oval 155">
                <a:extLst>
                  <a:ext uri="{FF2B5EF4-FFF2-40B4-BE49-F238E27FC236}">
                    <a16:creationId xmlns:a16="http://schemas.microsoft.com/office/drawing/2014/main" id="{312944C8-9520-554B-A06F-ACD8A371CB72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57" name="Oval 156">
                <a:extLst>
                  <a:ext uri="{FF2B5EF4-FFF2-40B4-BE49-F238E27FC236}">
                    <a16:creationId xmlns:a16="http://schemas.microsoft.com/office/drawing/2014/main" id="{E4893F48-0257-DE4F-A170-96AEE994A408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52793C0E-80BD-3048-98BE-AF0F6F537B26}"/>
                  </a:ext>
                </a:extLst>
              </p:cNvPr>
              <p:cNvSpPr txBox="1"/>
              <p:nvPr/>
            </p:nvSpPr>
            <p:spPr>
              <a:xfrm>
                <a:off x="691875" y="3338084"/>
                <a:ext cx="459014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1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8D28C8FF-7970-9043-AE03-A8469B0F285A}"/>
                  </a:ext>
                </a:extLst>
              </p:cNvPr>
              <p:cNvSpPr txBox="1"/>
              <p:nvPr/>
            </p:nvSpPr>
            <p:spPr>
              <a:xfrm>
                <a:off x="1465337" y="3338084"/>
                <a:ext cx="558406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98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D2AA627C-A9FF-E741-86BB-318526E915F6}"/>
                  </a:ext>
                </a:extLst>
              </p:cNvPr>
              <p:cNvSpPr txBox="1"/>
              <p:nvPr/>
            </p:nvSpPr>
            <p:spPr>
              <a:xfrm>
                <a:off x="1131139" y="3324693"/>
                <a:ext cx="359621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E92498C4-5F39-7E40-91CB-B44FCF823018}"/>
                </a:ext>
              </a:extLst>
            </p:cNvPr>
            <p:cNvGrpSpPr/>
            <p:nvPr/>
          </p:nvGrpSpPr>
          <p:grpSpPr>
            <a:xfrm>
              <a:off x="2626033" y="4380211"/>
              <a:ext cx="1091333" cy="623891"/>
              <a:chOff x="562708" y="3071446"/>
              <a:chExt cx="1537889" cy="885092"/>
            </a:xfrm>
          </p:grpSpPr>
          <p:sp>
            <p:nvSpPr>
              <p:cNvPr id="151" name="Oval 150">
                <a:extLst>
                  <a:ext uri="{FF2B5EF4-FFF2-40B4-BE49-F238E27FC236}">
                    <a16:creationId xmlns:a16="http://schemas.microsoft.com/office/drawing/2014/main" id="{5AB9BF58-A18F-5D47-9552-F75BFC703481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52" name="Oval 151">
                <a:extLst>
                  <a:ext uri="{FF2B5EF4-FFF2-40B4-BE49-F238E27FC236}">
                    <a16:creationId xmlns:a16="http://schemas.microsoft.com/office/drawing/2014/main" id="{A448C62F-F5EA-0A41-9524-D66AC6139F9F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BF750A16-F6EC-DD40-B5F1-EB0EBE8640EC}"/>
                  </a:ext>
                </a:extLst>
              </p:cNvPr>
              <p:cNvSpPr txBox="1"/>
              <p:nvPr/>
            </p:nvSpPr>
            <p:spPr>
              <a:xfrm>
                <a:off x="670219" y="3338084"/>
                <a:ext cx="459014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3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55F01235-8F41-6C47-96BA-C4C4A1B8A46C}"/>
                  </a:ext>
                </a:extLst>
              </p:cNvPr>
              <p:cNvSpPr txBox="1"/>
              <p:nvPr/>
            </p:nvSpPr>
            <p:spPr>
              <a:xfrm>
                <a:off x="1530306" y="3338084"/>
                <a:ext cx="459014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1</a:t>
                </a: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F17A74A0-6FA2-084F-9A9C-6CF976D8666B}"/>
                  </a:ext>
                </a:extLst>
              </p:cNvPr>
              <p:cNvSpPr txBox="1"/>
              <p:nvPr/>
            </p:nvSpPr>
            <p:spPr>
              <a:xfrm>
                <a:off x="1142343" y="3324693"/>
                <a:ext cx="359621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5F605E37-53AA-7346-AB2C-AA825010906C}"/>
                </a:ext>
              </a:extLst>
            </p:cNvPr>
            <p:cNvGrpSpPr/>
            <p:nvPr/>
          </p:nvGrpSpPr>
          <p:grpSpPr>
            <a:xfrm>
              <a:off x="4412903" y="4380211"/>
              <a:ext cx="1091332" cy="623891"/>
              <a:chOff x="562708" y="3071446"/>
              <a:chExt cx="1537889" cy="885092"/>
            </a:xfrm>
          </p:grpSpPr>
          <p:sp>
            <p:nvSpPr>
              <p:cNvPr id="146" name="Oval 145">
                <a:extLst>
                  <a:ext uri="{FF2B5EF4-FFF2-40B4-BE49-F238E27FC236}">
                    <a16:creationId xmlns:a16="http://schemas.microsoft.com/office/drawing/2014/main" id="{5CDDAF81-4F02-E84F-987E-C67FBB5A98B1}"/>
                  </a:ext>
                </a:extLst>
              </p:cNvPr>
              <p:cNvSpPr/>
              <p:nvPr/>
            </p:nvSpPr>
            <p:spPr>
              <a:xfrm>
                <a:off x="562708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3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/>
              </a:p>
            </p:txBody>
          </p:sp>
          <p:sp>
            <p:nvSpPr>
              <p:cNvPr id="147" name="Oval 146">
                <a:extLst>
                  <a:ext uri="{FF2B5EF4-FFF2-40B4-BE49-F238E27FC236}">
                    <a16:creationId xmlns:a16="http://schemas.microsoft.com/office/drawing/2014/main" id="{AA5E49B3-9B6C-2C41-8F26-E8E5F8394DE2}"/>
                  </a:ext>
                </a:extLst>
              </p:cNvPr>
              <p:cNvSpPr/>
              <p:nvPr/>
            </p:nvSpPr>
            <p:spPr>
              <a:xfrm>
                <a:off x="1174474" y="3071446"/>
                <a:ext cx="926123" cy="885092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52098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E9EA1C38-366A-BA4B-8940-DC2D7466529E}"/>
                  </a:ext>
                </a:extLst>
              </p:cNvPr>
              <p:cNvSpPr txBox="1"/>
              <p:nvPr/>
            </p:nvSpPr>
            <p:spPr>
              <a:xfrm>
                <a:off x="648563" y="3338084"/>
                <a:ext cx="459014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2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ED307F8D-00DC-8F46-BD7C-61F37500DBA7}"/>
                  </a:ext>
                </a:extLst>
              </p:cNvPr>
              <p:cNvSpPr txBox="1"/>
              <p:nvPr/>
            </p:nvSpPr>
            <p:spPr>
              <a:xfrm>
                <a:off x="1494723" y="3338084"/>
                <a:ext cx="558407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43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9A2A1648-161F-C942-9DEA-5765BED056FC}"/>
                  </a:ext>
                </a:extLst>
              </p:cNvPr>
              <p:cNvSpPr txBox="1"/>
              <p:nvPr/>
            </p:nvSpPr>
            <p:spPr>
              <a:xfrm>
                <a:off x="1144265" y="3324693"/>
                <a:ext cx="359621" cy="34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</p:grp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3D60666-4B2E-144E-84A4-728D971EAEBC}"/>
                </a:ext>
              </a:extLst>
            </p:cNvPr>
            <p:cNvSpPr txBox="1"/>
            <p:nvPr/>
          </p:nvSpPr>
          <p:spPr>
            <a:xfrm>
              <a:off x="2112234" y="4549597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CH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C6CBC246-2D86-1A45-8296-CC730188A683}"/>
                </a:ext>
              </a:extLst>
            </p:cNvPr>
            <p:cNvSpPr txBox="1"/>
            <p:nvPr/>
          </p:nvSpPr>
          <p:spPr>
            <a:xfrm>
              <a:off x="3699214" y="454329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S4;11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429A8F6B-CC3E-A04A-8593-D8B35B56A36F}"/>
                </a:ext>
              </a:extLst>
            </p:cNvPr>
            <p:cNvSpPr txBox="1"/>
            <p:nvPr/>
          </p:nvSpPr>
          <p:spPr>
            <a:xfrm>
              <a:off x="5496389" y="4530931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EM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BCD68B4F-0E4D-654C-9E4D-A0D5E23EE202}"/>
                </a:ext>
              </a:extLst>
            </p:cNvPr>
            <p:cNvSpPr txBox="1"/>
            <p:nvPr/>
          </p:nvSpPr>
          <p:spPr>
            <a:xfrm>
              <a:off x="441976" y="4548923"/>
              <a:ext cx="5806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79E235A0-D70D-7B49-9FCE-62D52E3601B9}"/>
                </a:ext>
              </a:extLst>
            </p:cNvPr>
            <p:cNvSpPr txBox="1"/>
            <p:nvPr/>
          </p:nvSpPr>
          <p:spPr>
            <a:xfrm>
              <a:off x="1264992" y="5049220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3526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F4AC888-8CB6-4643-9E0C-660B922E0DD7}"/>
                </a:ext>
              </a:extLst>
            </p:cNvPr>
            <p:cNvSpPr txBox="1"/>
            <p:nvPr/>
          </p:nvSpPr>
          <p:spPr>
            <a:xfrm>
              <a:off x="2947301" y="5049220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1.0000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91731961-45C1-614A-B971-70333CB0A9AD}"/>
                </a:ext>
              </a:extLst>
            </p:cNvPr>
            <p:cNvSpPr txBox="1"/>
            <p:nvPr/>
          </p:nvSpPr>
          <p:spPr>
            <a:xfrm>
              <a:off x="4674841" y="5049429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= 0.885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145906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B9C2CA2-B854-C447-B990-0E438B105C86}"/>
              </a:ext>
            </a:extLst>
          </p:cNvPr>
          <p:cNvSpPr txBox="1"/>
          <p:nvPr/>
        </p:nvSpPr>
        <p:spPr>
          <a:xfrm>
            <a:off x="2854963" y="307777"/>
            <a:ext cx="1148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D9D9D6">
                    <a:lumMod val="10000"/>
                  </a:srgbClr>
                </a:solidFill>
                <a:effectLst/>
                <a:uLnTx/>
                <a:uFillTx/>
                <a:latin typeface="Arial"/>
              </a:rPr>
              <a:t>Patient Samples </a:t>
            </a:r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CB22FEC9-C591-6748-8C4D-7EBE833290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782546"/>
              </p:ext>
            </p:extLst>
          </p:nvPr>
        </p:nvGraphicFramePr>
        <p:xfrm>
          <a:off x="175810" y="646401"/>
          <a:ext cx="6506379" cy="15152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90965">
                  <a:extLst>
                    <a:ext uri="{9D8B030D-6E8A-4147-A177-3AD203B41FA5}">
                      <a16:colId xmlns:a16="http://schemas.microsoft.com/office/drawing/2014/main" val="2114751408"/>
                    </a:ext>
                  </a:extLst>
                </a:gridCol>
                <a:gridCol w="638175">
                  <a:extLst>
                    <a:ext uri="{9D8B030D-6E8A-4147-A177-3AD203B41FA5}">
                      <a16:colId xmlns:a16="http://schemas.microsoft.com/office/drawing/2014/main" val="3607382309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1644006440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957391596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val="1847015653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1598725809"/>
                    </a:ext>
                  </a:extLst>
                </a:gridCol>
                <a:gridCol w="372883">
                  <a:extLst>
                    <a:ext uri="{9D8B030D-6E8A-4147-A177-3AD203B41FA5}">
                      <a16:colId xmlns:a16="http://schemas.microsoft.com/office/drawing/2014/main" val="514693119"/>
                    </a:ext>
                  </a:extLst>
                </a:gridCol>
                <a:gridCol w="417692">
                  <a:extLst>
                    <a:ext uri="{9D8B030D-6E8A-4147-A177-3AD203B41FA5}">
                      <a16:colId xmlns:a16="http://schemas.microsoft.com/office/drawing/2014/main" val="2695143058"/>
                    </a:ext>
                  </a:extLst>
                </a:gridCol>
                <a:gridCol w="542925">
                  <a:extLst>
                    <a:ext uri="{9D8B030D-6E8A-4147-A177-3AD203B41FA5}">
                      <a16:colId xmlns:a16="http://schemas.microsoft.com/office/drawing/2014/main" val="2834495873"/>
                    </a:ext>
                  </a:extLst>
                </a:gridCol>
                <a:gridCol w="742950">
                  <a:extLst>
                    <a:ext uri="{9D8B030D-6E8A-4147-A177-3AD203B41FA5}">
                      <a16:colId xmlns:a16="http://schemas.microsoft.com/office/drawing/2014/main" val="968690081"/>
                    </a:ext>
                  </a:extLst>
                </a:gridCol>
                <a:gridCol w="662389">
                  <a:extLst>
                    <a:ext uri="{9D8B030D-6E8A-4147-A177-3AD203B41FA5}">
                      <a16:colId xmlns:a16="http://schemas.microsoft.com/office/drawing/2014/main" val="2853663809"/>
                    </a:ext>
                  </a:extLst>
                </a:gridCol>
              </a:tblGrid>
              <a:tr h="378823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l_E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l_S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hange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sion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92597591"/>
                  </a:ext>
                </a:extLst>
              </a:tr>
              <a:tr h="378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ALL0454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VYI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28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099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F3_PBX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35768829"/>
                  </a:ext>
                </a:extLst>
              </a:tr>
              <a:tr h="378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ALL0575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WWL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28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099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F3_PBX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61086170"/>
                  </a:ext>
                </a:extLst>
              </a:tr>
              <a:tr h="378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ALL0688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ZX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28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sen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099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F3_PBX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403811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B8FCA42-B1BF-A140-A0F6-ABD57267C2D7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29850186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23">
            <a:extLst>
              <a:ext uri="{FF2B5EF4-FFF2-40B4-BE49-F238E27FC236}">
                <a16:creationId xmlns:a16="http://schemas.microsoft.com/office/drawing/2014/main" id="{14172837-94DE-3847-8367-9322568275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1432335"/>
              </p:ext>
            </p:extLst>
          </p:nvPr>
        </p:nvGraphicFramePr>
        <p:xfrm>
          <a:off x="530198" y="579726"/>
          <a:ext cx="5632794" cy="17994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9702">
                  <a:extLst>
                    <a:ext uri="{9D8B030D-6E8A-4147-A177-3AD203B41FA5}">
                      <a16:colId xmlns:a16="http://schemas.microsoft.com/office/drawing/2014/main" val="1976924001"/>
                    </a:ext>
                  </a:extLst>
                </a:gridCol>
                <a:gridCol w="815310">
                  <a:extLst>
                    <a:ext uri="{9D8B030D-6E8A-4147-A177-3AD203B41FA5}">
                      <a16:colId xmlns:a16="http://schemas.microsoft.com/office/drawing/2014/main" val="3810481429"/>
                    </a:ext>
                  </a:extLst>
                </a:gridCol>
                <a:gridCol w="807396">
                  <a:extLst>
                    <a:ext uri="{9D8B030D-6E8A-4147-A177-3AD203B41FA5}">
                      <a16:colId xmlns:a16="http://schemas.microsoft.com/office/drawing/2014/main" val="3932890503"/>
                    </a:ext>
                  </a:extLst>
                </a:gridCol>
                <a:gridCol w="1131935">
                  <a:extLst>
                    <a:ext uri="{9D8B030D-6E8A-4147-A177-3AD203B41FA5}">
                      <a16:colId xmlns:a16="http://schemas.microsoft.com/office/drawing/2014/main" val="2902263390"/>
                    </a:ext>
                  </a:extLst>
                </a:gridCol>
                <a:gridCol w="1129219">
                  <a:extLst>
                    <a:ext uri="{9D8B030D-6E8A-4147-A177-3AD203B41FA5}">
                      <a16:colId xmlns:a16="http://schemas.microsoft.com/office/drawing/2014/main" val="2457409837"/>
                    </a:ext>
                  </a:extLst>
                </a:gridCol>
                <a:gridCol w="1119232">
                  <a:extLst>
                    <a:ext uri="{9D8B030D-6E8A-4147-A177-3AD203B41FA5}">
                      <a16:colId xmlns:a16="http://schemas.microsoft.com/office/drawing/2014/main" val="2394041421"/>
                    </a:ext>
                  </a:extLst>
                </a:gridCol>
              </a:tblGrid>
              <a:tr h="3199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ell line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# genes upregulated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# genes + BA switch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# genes </a:t>
                      </a:r>
                    </a:p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+ BA switch + shift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# genes + </a:t>
                      </a:r>
                    </a:p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up H3K36me2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# genes + BA switch + shift  + up H3K36me2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987094260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CH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20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3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3  (15.8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8 (17.9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 (4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1564825542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RS4;1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7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2  (30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7  (15.3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 (5.2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220730845"/>
                  </a:ext>
                </a:extLst>
              </a:tr>
              <a:tr h="4050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EM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30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7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1  (26.4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4 (13.8%)</a:t>
                      </a:r>
                      <a:endParaRPr lang="en-US" sz="100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 (2.6%)</a:t>
                      </a:r>
                      <a:endParaRPr lang="en-US" sz="1000" dirty="0">
                        <a:effectLst/>
                        <a:latin typeface="+mn-lt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84531693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B9C2CA2-B854-C447-B990-0E438B105C86}"/>
              </a:ext>
            </a:extLst>
          </p:cNvPr>
          <p:cNvSpPr txBox="1"/>
          <p:nvPr/>
        </p:nvSpPr>
        <p:spPr>
          <a:xfrm>
            <a:off x="1530082" y="307777"/>
            <a:ext cx="3797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Rate of concordance</a:t>
            </a: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D9D9D6">
                    <a:lumMod val="10000"/>
                  </a:srgbClr>
                </a:solidFill>
                <a:effectLst/>
                <a:uLnTx/>
                <a:uFillTx/>
                <a:latin typeface="Arial"/>
              </a:rPr>
              <a:t> </a:t>
            </a: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calculation for H3K36me2 </a:t>
            </a:r>
            <a:r>
              <a:rPr lang="en-US" sz="1000" kern="0" dirty="0" err="1">
                <a:solidFill>
                  <a:srgbClr val="D9D9D6">
                    <a:lumMod val="10000"/>
                  </a:srgbClr>
                </a:solidFill>
                <a:latin typeface="Arial"/>
              </a:rPr>
              <a:t>ChIP</a:t>
            </a:r>
            <a:r>
              <a:rPr lang="en-US" sz="1000" kern="0" dirty="0">
                <a:solidFill>
                  <a:srgbClr val="D9D9D6">
                    <a:lumMod val="10000"/>
                  </a:srgbClr>
                </a:solidFill>
                <a:latin typeface="Arial"/>
              </a:rPr>
              <a:t>-seq peaks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D9D9D6">
                  <a:lumMod val="10000"/>
                </a:srgbClr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6EBCD3-2130-FB43-8A00-E4997D60F8E3}"/>
              </a:ext>
            </a:extLst>
          </p:cNvPr>
          <p:cNvSpPr txBox="1"/>
          <p:nvPr/>
        </p:nvSpPr>
        <p:spPr>
          <a:xfrm>
            <a:off x="2691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75DB4C7-4103-7040-B6A7-7295253CD1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1767"/>
          <a:stretch/>
        </p:blipFill>
        <p:spPr>
          <a:xfrm>
            <a:off x="187221" y="2759234"/>
            <a:ext cx="1988329" cy="14523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710AF0B-5446-874A-8761-D3CC60E797B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53" r="21282"/>
          <a:stretch/>
        </p:blipFill>
        <p:spPr>
          <a:xfrm>
            <a:off x="2199810" y="2759234"/>
            <a:ext cx="1869662" cy="14523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740E170-78A4-2845-B92D-6730F70B3F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057"/>
          <a:stretch/>
        </p:blipFill>
        <p:spPr>
          <a:xfrm>
            <a:off x="4093732" y="2759234"/>
            <a:ext cx="2413001" cy="14523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AF5DD9E-E0E9-F842-936C-C0BB994D92DC}"/>
              </a:ext>
            </a:extLst>
          </p:cNvPr>
          <p:cNvSpPr txBox="1"/>
          <p:nvPr/>
        </p:nvSpPr>
        <p:spPr>
          <a:xfrm>
            <a:off x="45195" y="254301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02614A3-B9AC-8E4A-A55E-1121105C8775}"/>
              </a:ext>
            </a:extLst>
          </p:cNvPr>
          <p:cNvSpPr txBox="1"/>
          <p:nvPr/>
        </p:nvSpPr>
        <p:spPr>
          <a:xfrm>
            <a:off x="45195" y="2462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292075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562</TotalTime>
  <Words>1431</Words>
  <Application>Microsoft Macintosh PowerPoint</Application>
  <PresentationFormat>Letter Paper (8.5x11 in)</PresentationFormat>
  <Paragraphs>380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ang, Sonali</dc:creator>
  <cp:lastModifiedBy>Narang, Sonali</cp:lastModifiedBy>
  <cp:revision>1</cp:revision>
  <dcterms:created xsi:type="dcterms:W3CDTF">2021-04-22T19:33:32Z</dcterms:created>
  <dcterms:modified xsi:type="dcterms:W3CDTF">2023-01-19T20:45:12Z</dcterms:modified>
</cp:coreProperties>
</file>